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ppt/charts/chart30.xml" ContentType="application/vnd.openxmlformats-officedocument.drawingml.chart+xml"/>
  <Override PartName="/ppt/charts/chart31.xml" ContentType="application/vnd.openxmlformats-officedocument.drawingml.chart+xml"/>
  <Override PartName="/ppt/charts/chart32.xml" ContentType="application/vnd.openxmlformats-officedocument.drawingml.chart+xml"/>
  <Override PartName="/ppt/charts/chart33.xml" ContentType="application/vnd.openxmlformats-officedocument.drawingml.chart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ppt/charts/chartEx2.xml" ContentType="application/vnd.ms-office.chartex+xml"/>
  <Override PartName="/ppt/charts/style2.xml" ContentType="application/vnd.ms-office.chartstyle+xml"/>
  <Override PartName="/ppt/charts/colors2.xml" ContentType="application/vnd.ms-office.chartcolorstyle+xml"/>
  <Override PartName="/ppt/charts/chartEx3.xml" ContentType="application/vnd.ms-office.chartex+xml"/>
  <Override PartName="/ppt/charts/style3.xml" ContentType="application/vnd.ms-office.chartstyle+xml"/>
  <Override PartName="/ppt/charts/colors3.xml" ContentType="application/vnd.ms-office.chartcolorstyle+xml"/>
  <Override PartName="/ppt/charts/chartEx4.xml" ContentType="application/vnd.ms-office.chartex+xml"/>
  <Override PartName="/ppt/charts/style4.xml" ContentType="application/vnd.ms-office.chartstyle+xml"/>
  <Override PartName="/ppt/charts/colors4.xml" ContentType="application/vnd.ms-office.chartcolorstyle+xml"/>
  <Override PartName="/ppt/charts/chartEx5.xml" ContentType="application/vnd.ms-office.chartex+xml"/>
  <Override PartName="/ppt/charts/style5.xml" ContentType="application/vnd.ms-office.chartstyle+xml"/>
  <Override PartName="/ppt/charts/colors5.xml" ContentType="application/vnd.ms-office.chartcolorstyle+xml"/>
  <Override PartName="/ppt/charts/chartEx6.xml" ContentType="application/vnd.ms-office.chartex+xml"/>
  <Override PartName="/ppt/charts/style6.xml" ContentType="application/vnd.ms-office.chartstyle+xml"/>
  <Override PartName="/ppt/charts/colors6.xml" ContentType="application/vnd.ms-office.chartcolorstyle+xml"/>
  <Override PartName="/ppt/charts/chartEx7.xml" ContentType="application/vnd.ms-office.chartex+xml"/>
  <Override PartName="/ppt/charts/style7.xml" ContentType="application/vnd.ms-office.chartstyle+xml"/>
  <Override PartName="/ppt/charts/colors7.xml" ContentType="application/vnd.ms-office.chartcolorstyle+xml"/>
  <Override PartName="/ppt/charts/chartEx8.xml" ContentType="application/vnd.ms-office.chartex+xml"/>
  <Override PartName="/ppt/charts/style8.xml" ContentType="application/vnd.ms-office.chartstyle+xml"/>
  <Override PartName="/ppt/charts/colors8.xml" ContentType="application/vnd.ms-office.chartcolorstyle+xml"/>
  <Override PartName="/ppt/charts/chartEx9.xml" ContentType="application/vnd.ms-office.chartex+xml"/>
  <Override PartName="/ppt/charts/style9.xml" ContentType="application/vnd.ms-office.chartstyle+xml"/>
  <Override PartName="/ppt/charts/colors9.xml" ContentType="application/vnd.ms-office.chartcolorstyle+xml"/>
  <Override PartName="/ppt/charts/chartEx10.xml" ContentType="application/vnd.ms-office.chartex+xml"/>
  <Override PartName="/ppt/charts/style10.xml" ContentType="application/vnd.ms-office.chartstyle+xml"/>
  <Override PartName="/ppt/charts/colors10.xml" ContentType="application/vnd.ms-office.chartcolorstyle+xml"/>
  <Override PartName="/ppt/charts/chartEx11.xml" ContentType="application/vnd.ms-office.chartex+xml"/>
  <Override PartName="/ppt/charts/style11.xml" ContentType="application/vnd.ms-office.chartstyle+xml"/>
  <Override PartName="/ppt/charts/colors11.xml" ContentType="application/vnd.ms-office.chartcolorstyle+xml"/>
  <Override PartName="/ppt/charts/chartEx12.xml" ContentType="application/vnd.ms-office.chartex+xml"/>
  <Override PartName="/ppt/charts/style12.xml" ContentType="application/vnd.ms-office.chartstyle+xml"/>
  <Override PartName="/ppt/charts/colors12.xml" ContentType="application/vnd.ms-office.chartcolorstyle+xml"/>
  <Override PartName="/ppt/charts/chartEx13.xml" ContentType="application/vnd.ms-office.chartex+xml"/>
  <Override PartName="/ppt/charts/style13.xml" ContentType="application/vnd.ms-office.chartstyle+xml"/>
  <Override PartName="/ppt/charts/colors13.xml" ContentType="application/vnd.ms-office.chartcolorstyle+xml"/>
  <Override PartName="/ppt/charts/chartEx14.xml" ContentType="application/vnd.ms-office.chartex+xml"/>
  <Override PartName="/ppt/charts/style14.xml" ContentType="application/vnd.ms-office.chartstyle+xml"/>
  <Override PartName="/ppt/charts/colors14.xml" ContentType="application/vnd.ms-office.chartcolorstyle+xml"/>
  <Override PartName="/ppt/charts/chartEx15.xml" ContentType="application/vnd.ms-office.chartex+xml"/>
  <Override PartName="/ppt/charts/style15.xml" ContentType="application/vnd.ms-office.chartstyle+xml"/>
  <Override PartName="/ppt/charts/colors15.xml" ContentType="application/vnd.ms-office.chartcolorstyle+xml"/>
  <Override PartName="/ppt/charts/chartEx16.xml" ContentType="application/vnd.ms-office.chartex+xml"/>
  <Override PartName="/ppt/charts/style16.xml" ContentType="application/vnd.ms-office.chartstyle+xml"/>
  <Override PartName="/ppt/charts/colors16.xml" ContentType="application/vnd.ms-office.chartcolorstyle+xml"/>
  <Override PartName="/ppt/charts/chartEx17.xml" ContentType="application/vnd.ms-office.chartex+xml"/>
  <Override PartName="/ppt/charts/style17.xml" ContentType="application/vnd.ms-office.chartstyle+xml"/>
  <Override PartName="/ppt/charts/colors17.xml" ContentType="application/vnd.ms-office.chartcolorstyle+xml"/>
  <Override PartName="/ppt/charts/chartEx18.xml" ContentType="application/vnd.ms-office.chartex+xml"/>
  <Override PartName="/ppt/charts/style18.xml" ContentType="application/vnd.ms-office.chartstyle+xml"/>
  <Override PartName="/ppt/charts/colors18.xml" ContentType="application/vnd.ms-office.chartcolorstyle+xml"/>
  <Override PartName="/ppt/charts/chartEx19.xml" ContentType="application/vnd.ms-office.chartex+xml"/>
  <Override PartName="/ppt/charts/style19.xml" ContentType="application/vnd.ms-office.chartstyle+xml"/>
  <Override PartName="/ppt/charts/colors19.xml" ContentType="application/vnd.ms-office.chartcolorstyle+xml"/>
  <Override PartName="/ppt/charts/chartEx20.xml" ContentType="application/vnd.ms-office.chartex+xml"/>
  <Override PartName="/ppt/charts/style20.xml" ContentType="application/vnd.ms-office.chartstyle+xml"/>
  <Override PartName="/ppt/charts/colors2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76" r:id="rId3"/>
    <p:sldId id="277" r:id="rId4"/>
    <p:sldId id="279" r:id="rId5"/>
    <p:sldId id="273" r:id="rId6"/>
    <p:sldId id="274" r:id="rId7"/>
    <p:sldId id="275" r:id="rId8"/>
  </p:sldIdLst>
  <p:sldSz cx="9906000" cy="6858000" type="A4"/>
  <p:notesSz cx="9866313" cy="67357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orient="horz" pos="432" userDrawn="1">
          <p15:clr>
            <a:srgbClr val="A4A3A4"/>
          </p15:clr>
        </p15:guide>
        <p15:guide id="3" orient="horz" pos="3984" userDrawn="1">
          <p15:clr>
            <a:srgbClr val="A4A3A4"/>
          </p15:clr>
        </p15:guide>
        <p15:guide id="4" pos="3120" userDrawn="1">
          <p15:clr>
            <a:srgbClr val="A4A3A4"/>
          </p15:clr>
        </p15:guide>
        <p15:guide id="5" pos="576" userDrawn="1">
          <p15:clr>
            <a:srgbClr val="A4A3A4"/>
          </p15:clr>
        </p15:guide>
        <p15:guide id="6" pos="1440" userDrawn="1">
          <p15:clr>
            <a:srgbClr val="A4A3A4"/>
          </p15:clr>
        </p15:guide>
        <p15:guide id="7" pos="1824" userDrawn="1">
          <p15:clr>
            <a:srgbClr val="A4A3A4"/>
          </p15:clr>
        </p15:guide>
        <p15:guide id="8" pos="1584" userDrawn="1">
          <p15:clr>
            <a:srgbClr val="A4A3A4"/>
          </p15:clr>
        </p15:guide>
        <p15:guide id="9" pos="3936" userDrawn="1">
          <p15:clr>
            <a:srgbClr val="A4A3A4"/>
          </p15:clr>
        </p15:guide>
        <p15:guide id="10" pos="4272" userDrawn="1">
          <p15:clr>
            <a:srgbClr val="A4A3A4"/>
          </p15:clr>
        </p15:guide>
        <p15:guide id="11" pos="4176" userDrawn="1">
          <p15:clr>
            <a:srgbClr val="A4A3A4"/>
          </p15:clr>
        </p15:guide>
        <p15:guide id="12" pos="4464" userDrawn="1">
          <p15:clr>
            <a:srgbClr val="A4A3A4"/>
          </p15:clr>
        </p15:guide>
        <p15:guide id="13" pos="2880" userDrawn="1">
          <p15:clr>
            <a:srgbClr val="A4A3A4"/>
          </p15:clr>
        </p15:guide>
        <p15:guide id="14" orient="horz" pos="3504" userDrawn="1">
          <p15:clr>
            <a:srgbClr val="A4A3A4"/>
          </p15:clr>
        </p15:guide>
        <p15:guide id="16" orient="horz" pos="2976" userDrawn="1">
          <p15:clr>
            <a:srgbClr val="A4A3A4"/>
          </p15:clr>
        </p15:guide>
        <p15:guide id="17" orient="horz" pos="1680" userDrawn="1">
          <p15:clr>
            <a:srgbClr val="A4A3A4"/>
          </p15:clr>
        </p15:guide>
        <p15:guide id="18" orient="horz" pos="4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529" autoAdjust="0"/>
    <p:restoredTop sz="94746" autoAdjust="0"/>
  </p:normalViewPr>
  <p:slideViewPr>
    <p:cSldViewPr showGuides="1">
      <p:cViewPr varScale="1">
        <p:scale>
          <a:sx n="70" d="100"/>
          <a:sy n="70" d="100"/>
        </p:scale>
        <p:origin x="1024" y="60"/>
      </p:cViewPr>
      <p:guideLst>
        <p:guide orient="horz" pos="2160"/>
        <p:guide orient="horz" pos="432"/>
        <p:guide orient="horz" pos="3984"/>
        <p:guide pos="3120"/>
        <p:guide pos="576"/>
        <p:guide pos="1440"/>
        <p:guide pos="1824"/>
        <p:guide pos="1584"/>
        <p:guide pos="3936"/>
        <p:guide pos="4272"/>
        <p:guide pos="4176"/>
        <p:guide pos="4464"/>
        <p:guide pos="2880"/>
        <p:guide orient="horz" pos="3504"/>
        <p:guide orient="horz" pos="2976"/>
        <p:guide orient="horz" pos="1680"/>
        <p:guide orient="horz" pos="4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6" d="100"/>
        <a:sy n="66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wner\Desktop\20180123\27.%20PK-PD%20modeling%20of%20L-OHP%20(Neuropathy)\Oxaliplatin%20Population%20PK-PD%20modeling%2020180621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wner\Desktop\20180123\27.%20PK-PD%20modeling%20of%20L-OHP%20(Neuropathy)\Oxaliplatin%20Population%20PK-PD%20modeling%2020180621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wner\Desktop\20180123\27.%20PK-PD%20modeling%20of%20L-OHP%20(Neuropathy)\Oxaliplatin%20Population%20PK-PD%20modeling%2020190712.xlsx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wner\Desktop\20180123\27.%20PK-PD%20modeling%20of%20L-OHP%20(Neuropathy)\Oxaliplatin%20Population%20PK-PD%20modeling%2020190712.xlsx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wner\Desktop\20180123\27.%20PK-PD%20modeling%20of%20L-OHP%20(Neuropathy)\Oxaliplatin%20Population%20PK-PD%20modeling%2020190712.xlsx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wner\Desktop\20180123\27.%20PK-PD%20modeling%20of%20L-OHP%20(Neuropathy)\Oxaliplatin%20Population%20PK-PD%20modeling%202019071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wner\Desktop\20180123\27.%20PK-PD%20modeling%20of%20L-OHP%20(Neuropathy)\Oxaliplatin%20Population%20PK-PD%20modeling%2020180621.xlsx" TargetMode="Externa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wner\Desktop\20180123\27.%20PK-PD%20modeling%20of%20L-OHP%20(Neuropathy)\Oxaliplatin%20Population%20PK-PD%20modeling%2020190712.xlsx" TargetMode="External"/></Relationships>
</file>

<file path=ppt/charts/_rels/chart3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wner\Desktop\20180123\27.%20PK-PD%20modeling%20of%20L-OHP%20(Neuropathy)\Oxaliplatin%20Population%20PK-PD%20modeling%2020190712.xlsx" TargetMode="External"/></Relationships>
</file>

<file path=ppt/charts/_rels/chart3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wner\Desktop\20180123\27.%20PK-PD%20modeling%20of%20L-OHP%20(Neuropathy)\Oxaliplatin%20Population%20PK-PD%20modeling%2020190712.xlsx" TargetMode="External"/></Relationships>
</file>

<file path=ppt/charts/_rels/chart3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wner\Desktop\20180123\27.%20PK-PD%20modeling%20of%20L-OHP%20(Neuropathy)\Oxaliplatin%20Population%20PK-PD%20modeling%202019071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wner\Desktop\20180123\27.%20PK-PD%20modeling%20of%20L-OHP%20(Neuropathy)\Oxaliplatin%20Population%20PK-PD%20modeling%2020180621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obuchi%20Shinji\Desktop\20180123\27.%20PK-PD%20modeling%20of%20L-OHP%20(Neuropathy)\Oxaliplatin%20Population%20PK-PD%20modeling%2020190712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obuchi%20Shinji\Desktop\20180123\27.%20PK-PD%20modeling%20of%20L-OHP%20(Neuropathy)\Oxaliplatin%20Population%20PK-PD%20modeling%2020190712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obuchi%20Shinji\Desktop\20180123\27.%20PK-PD%20modeling%20of%20L-OHP%20(Neuropathy)\Oxaliplatin%20Population%20PK-PD%20modeling%2020190712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obuchi%20Shinji\Desktop\20180123\27.%20PK-PD%20modeling%20of%20L-OHP%20(Neuropathy)\Oxaliplatin%20Population%20PK-PD%20modeling%2020190712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obuchi%20Shinji\Desktop\20180123\27.%20PK-PD%20modeling%20of%20L-OHP%20(Neuropathy)\Oxaliplatin%20Population%20PK-PD%20modeling%2020190712.xlsx" TargetMode="Externa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10.xml.rels><?xml version="1.0" encoding="UTF-8" standalone="yes"?>
<Relationships xmlns="http://schemas.openxmlformats.org/package/2006/relationships"><Relationship Id="rId3" Type="http://schemas.microsoft.com/office/2011/relationships/chartColorStyle" Target="colors10.xml"/><Relationship Id="rId2" Type="http://schemas.microsoft.com/office/2011/relationships/chartStyle" Target="style10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11.xml.rels><?xml version="1.0" encoding="UTF-8" standalone="yes"?>
<Relationships xmlns="http://schemas.openxmlformats.org/package/2006/relationships"><Relationship Id="rId3" Type="http://schemas.microsoft.com/office/2011/relationships/chartColorStyle" Target="colors11.xml"/><Relationship Id="rId2" Type="http://schemas.microsoft.com/office/2011/relationships/chartStyle" Target="style11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12.xml.rels><?xml version="1.0" encoding="UTF-8" standalone="yes"?>
<Relationships xmlns="http://schemas.openxmlformats.org/package/2006/relationships"><Relationship Id="rId3" Type="http://schemas.microsoft.com/office/2011/relationships/chartColorStyle" Target="colors12.xml"/><Relationship Id="rId2" Type="http://schemas.microsoft.com/office/2011/relationships/chartStyle" Target="style12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13.xml.rels><?xml version="1.0" encoding="UTF-8" standalone="yes"?>
<Relationships xmlns="http://schemas.openxmlformats.org/package/2006/relationships"><Relationship Id="rId3" Type="http://schemas.microsoft.com/office/2011/relationships/chartColorStyle" Target="colors13.xml"/><Relationship Id="rId2" Type="http://schemas.microsoft.com/office/2011/relationships/chartStyle" Target="style13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14.xml.rels><?xml version="1.0" encoding="UTF-8" standalone="yes"?>
<Relationships xmlns="http://schemas.openxmlformats.org/package/2006/relationships"><Relationship Id="rId3" Type="http://schemas.microsoft.com/office/2011/relationships/chartColorStyle" Target="colors14.xml"/><Relationship Id="rId2" Type="http://schemas.microsoft.com/office/2011/relationships/chartStyle" Target="style14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15.xml.rels><?xml version="1.0" encoding="UTF-8" standalone="yes"?>
<Relationships xmlns="http://schemas.openxmlformats.org/package/2006/relationships"><Relationship Id="rId3" Type="http://schemas.microsoft.com/office/2011/relationships/chartColorStyle" Target="colors15.xml"/><Relationship Id="rId2" Type="http://schemas.microsoft.com/office/2011/relationships/chartStyle" Target="style15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16.xml.rels><?xml version="1.0" encoding="UTF-8" standalone="yes"?>
<Relationships xmlns="http://schemas.openxmlformats.org/package/2006/relationships"><Relationship Id="rId3" Type="http://schemas.microsoft.com/office/2011/relationships/chartColorStyle" Target="colors16.xml"/><Relationship Id="rId2" Type="http://schemas.microsoft.com/office/2011/relationships/chartStyle" Target="style16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17.xml.rels><?xml version="1.0" encoding="UTF-8" standalone="yes"?>
<Relationships xmlns="http://schemas.openxmlformats.org/package/2006/relationships"><Relationship Id="rId3" Type="http://schemas.microsoft.com/office/2011/relationships/chartColorStyle" Target="colors17.xml"/><Relationship Id="rId2" Type="http://schemas.microsoft.com/office/2011/relationships/chartStyle" Target="style17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18.xml.rels><?xml version="1.0" encoding="UTF-8" standalone="yes"?>
<Relationships xmlns="http://schemas.openxmlformats.org/package/2006/relationships"><Relationship Id="rId3" Type="http://schemas.microsoft.com/office/2011/relationships/chartColorStyle" Target="colors18.xml"/><Relationship Id="rId2" Type="http://schemas.microsoft.com/office/2011/relationships/chartStyle" Target="style18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19.xml.rels><?xml version="1.0" encoding="UTF-8" standalone="yes"?>
<Relationships xmlns="http://schemas.openxmlformats.org/package/2006/relationships"><Relationship Id="rId3" Type="http://schemas.microsoft.com/office/2011/relationships/chartColorStyle" Target="colors19.xml"/><Relationship Id="rId2" Type="http://schemas.microsoft.com/office/2011/relationships/chartStyle" Target="style19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20.xml.rels><?xml version="1.0" encoding="UTF-8" standalone="yes"?>
<Relationships xmlns="http://schemas.openxmlformats.org/package/2006/relationships"><Relationship Id="rId3" Type="http://schemas.microsoft.com/office/2011/relationships/chartColorStyle" Target="colors20.xml"/><Relationship Id="rId2" Type="http://schemas.microsoft.com/office/2011/relationships/chartStyle" Target="style20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4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5.xml.rels><?xml version="1.0" encoding="UTF-8" standalone="yes"?>
<Relationships xmlns="http://schemas.openxmlformats.org/package/2006/relationships"><Relationship Id="rId3" Type="http://schemas.microsoft.com/office/2011/relationships/chartColorStyle" Target="colors5.xml"/><Relationship Id="rId2" Type="http://schemas.microsoft.com/office/2011/relationships/chartStyle" Target="style5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6.xml.rels><?xml version="1.0" encoding="UTF-8" standalone="yes"?>
<Relationships xmlns="http://schemas.openxmlformats.org/package/2006/relationships"><Relationship Id="rId3" Type="http://schemas.microsoft.com/office/2011/relationships/chartColorStyle" Target="colors6.xml"/><Relationship Id="rId2" Type="http://schemas.microsoft.com/office/2011/relationships/chartStyle" Target="style6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7.xml.rels><?xml version="1.0" encoding="UTF-8" standalone="yes"?>
<Relationships xmlns="http://schemas.openxmlformats.org/package/2006/relationships"><Relationship Id="rId3" Type="http://schemas.microsoft.com/office/2011/relationships/chartColorStyle" Target="colors7.xml"/><Relationship Id="rId2" Type="http://schemas.microsoft.com/office/2011/relationships/chartStyle" Target="style7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8.xml.rels><?xml version="1.0" encoding="UTF-8" standalone="yes"?>
<Relationships xmlns="http://schemas.openxmlformats.org/package/2006/relationships"><Relationship Id="rId3" Type="http://schemas.microsoft.com/office/2011/relationships/chartColorStyle" Target="colors8.xml"/><Relationship Id="rId2" Type="http://schemas.microsoft.com/office/2011/relationships/chartStyle" Target="style8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_rels/chartEx9.xml.rels><?xml version="1.0" encoding="UTF-8" standalone="yes"?>
<Relationships xmlns="http://schemas.openxmlformats.org/package/2006/relationships"><Relationship Id="rId3" Type="http://schemas.microsoft.com/office/2011/relationships/chartColorStyle" Target="colors9.xml"/><Relationship Id="rId2" Type="http://schemas.microsoft.com/office/2011/relationships/chartStyle" Target="style9.xml"/><Relationship Id="rId1" Type="http://schemas.openxmlformats.org/officeDocument/2006/relationships/oleObject" Target="file:///C:\Users\Owner\Desktop\20180123\27.%20PK-PD%20modeling%20of%20L-OHP%20(Neuropathy)\Bootstrap%2019072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966070764759556"/>
          <c:y val="5.0925881861406376E-2"/>
          <c:w val="0.79447377017786946"/>
          <c:h val="0.74203667249927097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5"/>
            <c:spPr>
              <a:noFill/>
              <a:ln w="15875">
                <a:solidFill>
                  <a:schemeClr val="tx1"/>
                </a:solidFill>
              </a:ln>
            </c:spPr>
          </c:marker>
          <c:trendline>
            <c:spPr>
              <a:ln>
                <a:noFill/>
              </a:ln>
            </c:spPr>
            <c:trendlineType val="linear"/>
            <c:dispRSqr val="0"/>
            <c:dispEq val="0"/>
          </c:trendline>
          <c:xVal>
            <c:numRef>
              <c:f>'　PK  (Pt conc.)'!$M$78:$M$210</c:f>
              <c:numCache>
                <c:formatCode>General</c:formatCode>
                <c:ptCount val="133"/>
                <c:pt idx="0">
                  <c:v>3.0640700000000001</c:v>
                </c:pt>
                <c:pt idx="1">
                  <c:v>2.5288200000000001</c:v>
                </c:pt>
                <c:pt idx="2">
                  <c:v>1.5989599999999999</c:v>
                </c:pt>
                <c:pt idx="3">
                  <c:v>0.72833999999999999</c:v>
                </c:pt>
                <c:pt idx="4">
                  <c:v>0.41703200000000001</c:v>
                </c:pt>
                <c:pt idx="5">
                  <c:v>0.26480300000000001</c:v>
                </c:pt>
                <c:pt idx="6">
                  <c:v>0.211233</c:v>
                </c:pt>
                <c:pt idx="7">
                  <c:v>3.0640700000000001</c:v>
                </c:pt>
                <c:pt idx="8">
                  <c:v>2.5288200000000001</c:v>
                </c:pt>
                <c:pt idx="9">
                  <c:v>1.5989599999999999</c:v>
                </c:pt>
                <c:pt idx="10">
                  <c:v>0.72833999999999999</c:v>
                </c:pt>
                <c:pt idx="11">
                  <c:v>0.41703200000000001</c:v>
                </c:pt>
                <c:pt idx="12">
                  <c:v>0.26480300000000001</c:v>
                </c:pt>
                <c:pt idx="13">
                  <c:v>0.211233</c:v>
                </c:pt>
                <c:pt idx="14">
                  <c:v>0.15614900000000001</c:v>
                </c:pt>
                <c:pt idx="15">
                  <c:v>0.11829000000000001</c:v>
                </c:pt>
                <c:pt idx="16">
                  <c:v>3.0640700000000001</c:v>
                </c:pt>
                <c:pt idx="17">
                  <c:v>2.5288200000000001</c:v>
                </c:pt>
                <c:pt idx="18">
                  <c:v>1.5989599999999999</c:v>
                </c:pt>
                <c:pt idx="19">
                  <c:v>0.72833999999999999</c:v>
                </c:pt>
                <c:pt idx="20">
                  <c:v>0.41703200000000001</c:v>
                </c:pt>
                <c:pt idx="21">
                  <c:v>0.26480300000000001</c:v>
                </c:pt>
                <c:pt idx="22">
                  <c:v>0.211233</c:v>
                </c:pt>
                <c:pt idx="23">
                  <c:v>0.15614900000000001</c:v>
                </c:pt>
                <c:pt idx="24">
                  <c:v>0.11829000000000001</c:v>
                </c:pt>
                <c:pt idx="25">
                  <c:v>3.0640700000000001</c:v>
                </c:pt>
                <c:pt idx="26">
                  <c:v>2.5288200000000001</c:v>
                </c:pt>
                <c:pt idx="27">
                  <c:v>1.5989599999999999</c:v>
                </c:pt>
                <c:pt idx="28">
                  <c:v>0.72833999999999999</c:v>
                </c:pt>
                <c:pt idx="29">
                  <c:v>0.41703200000000001</c:v>
                </c:pt>
                <c:pt idx="30">
                  <c:v>0.26480300000000001</c:v>
                </c:pt>
                <c:pt idx="31">
                  <c:v>0.211233</c:v>
                </c:pt>
                <c:pt idx="32">
                  <c:v>0.15614900000000001</c:v>
                </c:pt>
                <c:pt idx="33">
                  <c:v>0.11829000000000001</c:v>
                </c:pt>
                <c:pt idx="34">
                  <c:v>3.0640700000000001</c:v>
                </c:pt>
                <c:pt idx="35">
                  <c:v>2.5288200000000001</c:v>
                </c:pt>
                <c:pt idx="36">
                  <c:v>1.5989599999999999</c:v>
                </c:pt>
                <c:pt idx="37">
                  <c:v>0.72833999999999999</c:v>
                </c:pt>
                <c:pt idx="38">
                  <c:v>0.41703200000000001</c:v>
                </c:pt>
                <c:pt idx="39">
                  <c:v>0.26480300000000001</c:v>
                </c:pt>
                <c:pt idx="40">
                  <c:v>0.211233</c:v>
                </c:pt>
                <c:pt idx="41">
                  <c:v>0.15614900000000001</c:v>
                </c:pt>
                <c:pt idx="42">
                  <c:v>0.11829000000000001</c:v>
                </c:pt>
                <c:pt idx="43">
                  <c:v>3.0640700000000001</c:v>
                </c:pt>
                <c:pt idx="44">
                  <c:v>2.5288200000000001</c:v>
                </c:pt>
                <c:pt idx="45">
                  <c:v>1.5989599999999999</c:v>
                </c:pt>
                <c:pt idx="46">
                  <c:v>0.72833999999999999</c:v>
                </c:pt>
                <c:pt idx="47">
                  <c:v>0.41703200000000001</c:v>
                </c:pt>
                <c:pt idx="48">
                  <c:v>0.26480300000000001</c:v>
                </c:pt>
                <c:pt idx="49">
                  <c:v>0.211233</c:v>
                </c:pt>
                <c:pt idx="50">
                  <c:v>0.15614900000000001</c:v>
                </c:pt>
                <c:pt idx="51">
                  <c:v>0.11829000000000001</c:v>
                </c:pt>
                <c:pt idx="52">
                  <c:v>5.1067799999999997</c:v>
                </c:pt>
                <c:pt idx="53">
                  <c:v>4.2147100000000002</c:v>
                </c:pt>
                <c:pt idx="54">
                  <c:v>2.6649400000000001</c:v>
                </c:pt>
                <c:pt idx="55">
                  <c:v>1.2139</c:v>
                </c:pt>
                <c:pt idx="56">
                  <c:v>0.69505300000000003</c:v>
                </c:pt>
                <c:pt idx="57">
                  <c:v>0.44133800000000001</c:v>
                </c:pt>
                <c:pt idx="58">
                  <c:v>0.35205500000000001</c:v>
                </c:pt>
                <c:pt idx="59">
                  <c:v>0.26024900000000001</c:v>
                </c:pt>
                <c:pt idx="60">
                  <c:v>0.19714999999999999</c:v>
                </c:pt>
                <c:pt idx="61">
                  <c:v>5.1067799999999997</c:v>
                </c:pt>
                <c:pt idx="62">
                  <c:v>4.2147100000000002</c:v>
                </c:pt>
                <c:pt idx="63">
                  <c:v>2.6649400000000001</c:v>
                </c:pt>
                <c:pt idx="64">
                  <c:v>1.2139</c:v>
                </c:pt>
                <c:pt idx="65">
                  <c:v>0.69505300000000003</c:v>
                </c:pt>
                <c:pt idx="66">
                  <c:v>0.44133800000000001</c:v>
                </c:pt>
                <c:pt idx="67">
                  <c:v>0.35205500000000001</c:v>
                </c:pt>
                <c:pt idx="68">
                  <c:v>0.26024900000000001</c:v>
                </c:pt>
                <c:pt idx="69">
                  <c:v>0.19714999999999999</c:v>
                </c:pt>
                <c:pt idx="70">
                  <c:v>5.1067799999999997</c:v>
                </c:pt>
                <c:pt idx="71">
                  <c:v>4.2147100000000002</c:v>
                </c:pt>
                <c:pt idx="72">
                  <c:v>2.6649400000000001</c:v>
                </c:pt>
                <c:pt idx="73">
                  <c:v>1.2139</c:v>
                </c:pt>
                <c:pt idx="74">
                  <c:v>0.69505300000000003</c:v>
                </c:pt>
                <c:pt idx="75">
                  <c:v>0.44133800000000001</c:v>
                </c:pt>
                <c:pt idx="76">
                  <c:v>0.35205500000000001</c:v>
                </c:pt>
                <c:pt idx="77">
                  <c:v>0.26024900000000001</c:v>
                </c:pt>
                <c:pt idx="78">
                  <c:v>0.19714999999999999</c:v>
                </c:pt>
                <c:pt idx="79">
                  <c:v>5.1067799999999997</c:v>
                </c:pt>
                <c:pt idx="80">
                  <c:v>4.2147100000000002</c:v>
                </c:pt>
                <c:pt idx="81">
                  <c:v>2.6649400000000001</c:v>
                </c:pt>
                <c:pt idx="82">
                  <c:v>1.2139</c:v>
                </c:pt>
                <c:pt idx="83">
                  <c:v>0.69505300000000003</c:v>
                </c:pt>
                <c:pt idx="84">
                  <c:v>0.44133800000000001</c:v>
                </c:pt>
                <c:pt idx="85">
                  <c:v>0.35205500000000001</c:v>
                </c:pt>
                <c:pt idx="86">
                  <c:v>0.26024900000000001</c:v>
                </c:pt>
                <c:pt idx="87">
                  <c:v>0.19714999999999999</c:v>
                </c:pt>
                <c:pt idx="88">
                  <c:v>8.1729199999999995</c:v>
                </c:pt>
                <c:pt idx="89">
                  <c:v>6.7452500000000004</c:v>
                </c:pt>
                <c:pt idx="90">
                  <c:v>4.2649800000000004</c:v>
                </c:pt>
                <c:pt idx="91">
                  <c:v>1.9427300000000001</c:v>
                </c:pt>
                <c:pt idx="92">
                  <c:v>1.1123700000000001</c:v>
                </c:pt>
                <c:pt idx="93">
                  <c:v>0.70631999999999995</c:v>
                </c:pt>
                <c:pt idx="94">
                  <c:v>0.56343100000000002</c:v>
                </c:pt>
                <c:pt idx="95">
                  <c:v>0.41650399999999999</c:v>
                </c:pt>
                <c:pt idx="96">
                  <c:v>0.315521</c:v>
                </c:pt>
                <c:pt idx="97">
                  <c:v>8.1729199999999995</c:v>
                </c:pt>
                <c:pt idx="98">
                  <c:v>6.7452500000000004</c:v>
                </c:pt>
                <c:pt idx="99">
                  <c:v>4.2649800000000004</c:v>
                </c:pt>
                <c:pt idx="100">
                  <c:v>1.9427300000000001</c:v>
                </c:pt>
                <c:pt idx="101">
                  <c:v>1.1123700000000001</c:v>
                </c:pt>
                <c:pt idx="102">
                  <c:v>0.70631999999999995</c:v>
                </c:pt>
                <c:pt idx="103">
                  <c:v>0.56343100000000002</c:v>
                </c:pt>
                <c:pt idx="104">
                  <c:v>0.41650399999999999</c:v>
                </c:pt>
                <c:pt idx="105">
                  <c:v>0.315521</c:v>
                </c:pt>
                <c:pt idx="106">
                  <c:v>8.1729199999999995</c:v>
                </c:pt>
                <c:pt idx="107">
                  <c:v>6.7452500000000004</c:v>
                </c:pt>
                <c:pt idx="108">
                  <c:v>4.2649800000000004</c:v>
                </c:pt>
                <c:pt idx="109">
                  <c:v>1.9427300000000001</c:v>
                </c:pt>
                <c:pt idx="110">
                  <c:v>1.1123700000000001</c:v>
                </c:pt>
                <c:pt idx="111">
                  <c:v>0.70631999999999995</c:v>
                </c:pt>
                <c:pt idx="112">
                  <c:v>0.56343100000000002</c:v>
                </c:pt>
                <c:pt idx="113">
                  <c:v>0.41650399999999999</c:v>
                </c:pt>
                <c:pt idx="114">
                  <c:v>0.315521</c:v>
                </c:pt>
                <c:pt idx="115">
                  <c:v>8.1729199999999995</c:v>
                </c:pt>
                <c:pt idx="116">
                  <c:v>6.7452500000000004</c:v>
                </c:pt>
                <c:pt idx="117">
                  <c:v>4.2649800000000004</c:v>
                </c:pt>
                <c:pt idx="118">
                  <c:v>1.9427300000000001</c:v>
                </c:pt>
                <c:pt idx="119">
                  <c:v>1.1123700000000001</c:v>
                </c:pt>
                <c:pt idx="120">
                  <c:v>0.70631999999999995</c:v>
                </c:pt>
                <c:pt idx="121">
                  <c:v>0.56343100000000002</c:v>
                </c:pt>
                <c:pt idx="122">
                  <c:v>0.41650399999999999</c:v>
                </c:pt>
                <c:pt idx="123">
                  <c:v>0.315521</c:v>
                </c:pt>
                <c:pt idx="124">
                  <c:v>8.1729199999999995</c:v>
                </c:pt>
                <c:pt idx="125">
                  <c:v>6.7452500000000004</c:v>
                </c:pt>
                <c:pt idx="126">
                  <c:v>4.2649800000000004</c:v>
                </c:pt>
                <c:pt idx="127">
                  <c:v>1.9427300000000001</c:v>
                </c:pt>
                <c:pt idx="128">
                  <c:v>1.1123700000000001</c:v>
                </c:pt>
                <c:pt idx="129">
                  <c:v>0.70631999999999995</c:v>
                </c:pt>
                <c:pt idx="130">
                  <c:v>0.56343100000000002</c:v>
                </c:pt>
                <c:pt idx="131">
                  <c:v>0.41650399999999999</c:v>
                </c:pt>
                <c:pt idx="132">
                  <c:v>0.315521</c:v>
                </c:pt>
              </c:numCache>
            </c:numRef>
          </c:xVal>
          <c:yVal>
            <c:numRef>
              <c:f>'　PK  (Pt conc.)'!$O$78:$O$210</c:f>
              <c:numCache>
                <c:formatCode>General</c:formatCode>
                <c:ptCount val="133"/>
                <c:pt idx="0">
                  <c:v>1.7543599999999999</c:v>
                </c:pt>
                <c:pt idx="1">
                  <c:v>1.1293599999999999</c:v>
                </c:pt>
                <c:pt idx="2">
                  <c:v>0.88196600000000003</c:v>
                </c:pt>
                <c:pt idx="3">
                  <c:v>0.163216</c:v>
                </c:pt>
                <c:pt idx="4">
                  <c:v>0.11569</c:v>
                </c:pt>
                <c:pt idx="5">
                  <c:v>6.0351599999999998E-2</c:v>
                </c:pt>
                <c:pt idx="6">
                  <c:v>4.3424499999999998E-2</c:v>
                </c:pt>
                <c:pt idx="7">
                  <c:v>1.7413400000000001</c:v>
                </c:pt>
                <c:pt idx="8">
                  <c:v>1.63066</c:v>
                </c:pt>
                <c:pt idx="9">
                  <c:v>0.88196600000000003</c:v>
                </c:pt>
                <c:pt idx="10">
                  <c:v>0.86243499999999995</c:v>
                </c:pt>
                <c:pt idx="11">
                  <c:v>0.32858100000000001</c:v>
                </c:pt>
                <c:pt idx="12">
                  <c:v>0.26347700000000002</c:v>
                </c:pt>
                <c:pt idx="13">
                  <c:v>9.7460900000000003E-2</c:v>
                </c:pt>
                <c:pt idx="14">
                  <c:v>5.1887999999999997E-2</c:v>
                </c:pt>
                <c:pt idx="15">
                  <c:v>2.1940100000000001E-2</c:v>
                </c:pt>
                <c:pt idx="16">
                  <c:v>2.4063599999999998</c:v>
                </c:pt>
                <c:pt idx="17">
                  <c:v>2.07612</c:v>
                </c:pt>
                <c:pt idx="18">
                  <c:v>1.7343900000000001</c:v>
                </c:pt>
                <c:pt idx="19">
                  <c:v>1.33236</c:v>
                </c:pt>
                <c:pt idx="20">
                  <c:v>1.0968800000000001</c:v>
                </c:pt>
                <c:pt idx="21">
                  <c:v>0.98775800000000002</c:v>
                </c:pt>
                <c:pt idx="22">
                  <c:v>0.671875</c:v>
                </c:pt>
                <c:pt idx="23">
                  <c:v>0.470858</c:v>
                </c:pt>
                <c:pt idx="24">
                  <c:v>0.38183699999999998</c:v>
                </c:pt>
                <c:pt idx="25">
                  <c:v>1.56209</c:v>
                </c:pt>
                <c:pt idx="26">
                  <c:v>0.94755500000000004</c:v>
                </c:pt>
                <c:pt idx="27">
                  <c:v>0.56275200000000003</c:v>
                </c:pt>
                <c:pt idx="28">
                  <c:v>0.39332299999999998</c:v>
                </c:pt>
                <c:pt idx="29">
                  <c:v>0.39045200000000002</c:v>
                </c:pt>
                <c:pt idx="30">
                  <c:v>0.38183699999999998</c:v>
                </c:pt>
                <c:pt idx="31">
                  <c:v>0.36173499999999997</c:v>
                </c:pt>
                <c:pt idx="32">
                  <c:v>0.22647999999999999</c:v>
                </c:pt>
                <c:pt idx="33">
                  <c:v>0.22245899999999999</c:v>
                </c:pt>
                <c:pt idx="34">
                  <c:v>1.9848600000000001</c:v>
                </c:pt>
                <c:pt idx="35">
                  <c:v>1.9075599999999999</c:v>
                </c:pt>
                <c:pt idx="36">
                  <c:v>1.1413500000000001</c:v>
                </c:pt>
                <c:pt idx="37">
                  <c:v>0.616147</c:v>
                </c:pt>
                <c:pt idx="38">
                  <c:v>0.41152300000000003</c:v>
                </c:pt>
                <c:pt idx="39">
                  <c:v>0.37059799999999998</c:v>
                </c:pt>
                <c:pt idx="40">
                  <c:v>0.28647400000000001</c:v>
                </c:pt>
                <c:pt idx="41">
                  <c:v>0.198713</c:v>
                </c:pt>
                <c:pt idx="42">
                  <c:v>0.18416199999999999</c:v>
                </c:pt>
                <c:pt idx="43">
                  <c:v>2.4554900000000002</c:v>
                </c:pt>
                <c:pt idx="44">
                  <c:v>1.9371100000000001</c:v>
                </c:pt>
                <c:pt idx="45">
                  <c:v>1.09588</c:v>
                </c:pt>
                <c:pt idx="46">
                  <c:v>0.89125299999999996</c:v>
                </c:pt>
                <c:pt idx="47">
                  <c:v>0.377419</c:v>
                </c:pt>
                <c:pt idx="48">
                  <c:v>0.34558800000000001</c:v>
                </c:pt>
                <c:pt idx="49">
                  <c:v>0.30920999999999998</c:v>
                </c:pt>
                <c:pt idx="50">
                  <c:v>0.19780400000000001</c:v>
                </c:pt>
                <c:pt idx="51">
                  <c:v>0.15824299999999999</c:v>
                </c:pt>
                <c:pt idx="52">
                  <c:v>7.0873999999999997</c:v>
                </c:pt>
                <c:pt idx="53">
                  <c:v>4.51051</c:v>
                </c:pt>
                <c:pt idx="54">
                  <c:v>3.1206700000000001</c:v>
                </c:pt>
                <c:pt idx="55">
                  <c:v>0.62826700000000002</c:v>
                </c:pt>
                <c:pt idx="56">
                  <c:v>0.47196399999999999</c:v>
                </c:pt>
                <c:pt idx="57">
                  <c:v>0.32664399999999999</c:v>
                </c:pt>
                <c:pt idx="58">
                  <c:v>0.15682199999999999</c:v>
                </c:pt>
                <c:pt idx="59">
                  <c:v>0.13189799999999999</c:v>
                </c:pt>
                <c:pt idx="60">
                  <c:v>0.101482</c:v>
                </c:pt>
                <c:pt idx="61">
                  <c:v>8.35473</c:v>
                </c:pt>
                <c:pt idx="62">
                  <c:v>2.68133</c:v>
                </c:pt>
                <c:pt idx="63">
                  <c:v>1.3717600000000001</c:v>
                </c:pt>
                <c:pt idx="64">
                  <c:v>1.3379700000000001</c:v>
                </c:pt>
                <c:pt idx="65">
                  <c:v>0.69585799999999998</c:v>
                </c:pt>
                <c:pt idx="66">
                  <c:v>0.245535</c:v>
                </c:pt>
                <c:pt idx="67">
                  <c:v>0.22483500000000001</c:v>
                </c:pt>
                <c:pt idx="68">
                  <c:v>0.17160800000000001</c:v>
                </c:pt>
                <c:pt idx="69">
                  <c:v>0.115423</c:v>
                </c:pt>
                <c:pt idx="70">
                  <c:v>5.26959</c:v>
                </c:pt>
                <c:pt idx="71">
                  <c:v>6.3686699999999998</c:v>
                </c:pt>
                <c:pt idx="72">
                  <c:v>3.3606600000000002</c:v>
                </c:pt>
                <c:pt idx="73">
                  <c:v>1.3553200000000001</c:v>
                </c:pt>
                <c:pt idx="74">
                  <c:v>0.63995299999999999</c:v>
                </c:pt>
                <c:pt idx="75">
                  <c:v>0.30155100000000001</c:v>
                </c:pt>
                <c:pt idx="76">
                  <c:v>0.31504900000000002</c:v>
                </c:pt>
                <c:pt idx="77">
                  <c:v>0.314085</c:v>
                </c:pt>
                <c:pt idx="78">
                  <c:v>0.33529500000000001</c:v>
                </c:pt>
                <c:pt idx="79">
                  <c:v>9.4923800000000007</c:v>
                </c:pt>
                <c:pt idx="80">
                  <c:v>8.82714</c:v>
                </c:pt>
                <c:pt idx="81">
                  <c:v>4.4693800000000001</c:v>
                </c:pt>
                <c:pt idx="82">
                  <c:v>1.60599</c:v>
                </c:pt>
                <c:pt idx="83">
                  <c:v>0.953287</c:v>
                </c:pt>
                <c:pt idx="84">
                  <c:v>0.58210600000000001</c:v>
                </c:pt>
                <c:pt idx="85">
                  <c:v>0.48280299999999998</c:v>
                </c:pt>
                <c:pt idx="86">
                  <c:v>0.23502799999999999</c:v>
                </c:pt>
                <c:pt idx="87">
                  <c:v>0.35168500000000003</c:v>
                </c:pt>
                <c:pt idx="88">
                  <c:v>11.5932</c:v>
                </c:pt>
                <c:pt idx="89">
                  <c:v>8.7101299999999995</c:v>
                </c:pt>
                <c:pt idx="90">
                  <c:v>5.7202999999999999</c:v>
                </c:pt>
                <c:pt idx="91">
                  <c:v>2.9867499999999998</c:v>
                </c:pt>
                <c:pt idx="92">
                  <c:v>0.68565299999999996</c:v>
                </c:pt>
                <c:pt idx="93">
                  <c:v>0.32100099999999998</c:v>
                </c:pt>
                <c:pt idx="94">
                  <c:v>0.165103</c:v>
                </c:pt>
                <c:pt idx="95">
                  <c:v>0.18912799999999999</c:v>
                </c:pt>
                <c:pt idx="96">
                  <c:v>0.16883999999999999</c:v>
                </c:pt>
                <c:pt idx="97">
                  <c:v>16.5761</c:v>
                </c:pt>
                <c:pt idx="98">
                  <c:v>11.2906</c:v>
                </c:pt>
                <c:pt idx="99">
                  <c:v>5.6312499999999996</c:v>
                </c:pt>
                <c:pt idx="100">
                  <c:v>2.31575</c:v>
                </c:pt>
                <c:pt idx="101">
                  <c:v>0.90092000000000005</c:v>
                </c:pt>
                <c:pt idx="102">
                  <c:v>0.44070100000000001</c:v>
                </c:pt>
                <c:pt idx="103">
                  <c:v>0.291209</c:v>
                </c:pt>
                <c:pt idx="104">
                  <c:v>0.23515</c:v>
                </c:pt>
                <c:pt idx="105">
                  <c:v>0.21005699999999999</c:v>
                </c:pt>
                <c:pt idx="106">
                  <c:v>18.402799999999999</c:v>
                </c:pt>
                <c:pt idx="107">
                  <c:v>15.124700000000001</c:v>
                </c:pt>
                <c:pt idx="108">
                  <c:v>5.8883000000000001</c:v>
                </c:pt>
                <c:pt idx="109">
                  <c:v>2.99458</c:v>
                </c:pt>
                <c:pt idx="110">
                  <c:v>1.2594099999999999</c:v>
                </c:pt>
                <c:pt idx="111">
                  <c:v>0.57602200000000003</c:v>
                </c:pt>
                <c:pt idx="112">
                  <c:v>0.38862400000000002</c:v>
                </c:pt>
                <c:pt idx="113">
                  <c:v>0.25781900000000002</c:v>
                </c:pt>
                <c:pt idx="114">
                  <c:v>0.188413</c:v>
                </c:pt>
                <c:pt idx="115">
                  <c:v>5.8623200000000004</c:v>
                </c:pt>
                <c:pt idx="116">
                  <c:v>5.1441699999999999</c:v>
                </c:pt>
                <c:pt idx="117">
                  <c:v>3.0150600000000001</c:v>
                </c:pt>
                <c:pt idx="118">
                  <c:v>1.8280000000000001</c:v>
                </c:pt>
                <c:pt idx="119">
                  <c:v>1.3717600000000001</c:v>
                </c:pt>
                <c:pt idx="120">
                  <c:v>0.80146799999999996</c:v>
                </c:pt>
                <c:pt idx="121">
                  <c:v>0.66206299999999996</c:v>
                </c:pt>
                <c:pt idx="122">
                  <c:v>0.14541599999999999</c:v>
                </c:pt>
                <c:pt idx="123">
                  <c:v>0.13400999999999999</c:v>
                </c:pt>
                <c:pt idx="124">
                  <c:v>2.1359599999999999</c:v>
                </c:pt>
                <c:pt idx="125">
                  <c:v>9.4061199999999996</c:v>
                </c:pt>
                <c:pt idx="126">
                  <c:v>4.3918499999999998</c:v>
                </c:pt>
                <c:pt idx="127">
                  <c:v>2.7132999999999998</c:v>
                </c:pt>
                <c:pt idx="128">
                  <c:v>0.94921599999999995</c:v>
                </c:pt>
                <c:pt idx="129">
                  <c:v>0.92783300000000002</c:v>
                </c:pt>
                <c:pt idx="130">
                  <c:v>0.63168100000000005</c:v>
                </c:pt>
                <c:pt idx="131">
                  <c:v>0.45206499999999999</c:v>
                </c:pt>
                <c:pt idx="132">
                  <c:v>0.326975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509-451D-A11B-CF202CD80951}"/>
            </c:ext>
          </c:extLst>
        </c:ser>
        <c:ser>
          <c:idx val="1"/>
          <c:order val="1"/>
          <c:spPr>
            <a:ln w="19050">
              <a:noFill/>
            </a:ln>
          </c:spPr>
          <c:marker>
            <c:symbol val="none"/>
          </c:marker>
          <c:trendline>
            <c:trendlineType val="linear"/>
            <c:dispRSqr val="0"/>
            <c:dispEq val="0"/>
          </c:trendline>
          <c:xVal>
            <c:numRef>
              <c:f>'　PK  (Pt conc.)'!$AI$39:$AJ$39</c:f>
              <c:numCache>
                <c:formatCode>General</c:formatCode>
                <c:ptCount val="2"/>
                <c:pt idx="0">
                  <c:v>0.01</c:v>
                </c:pt>
                <c:pt idx="1">
                  <c:v>100</c:v>
                </c:pt>
              </c:numCache>
            </c:numRef>
          </c:xVal>
          <c:yVal>
            <c:numRef>
              <c:f>'　PK  (Pt conc.)'!$AI$40:$AJ$40</c:f>
              <c:numCache>
                <c:formatCode>General</c:formatCode>
                <c:ptCount val="2"/>
                <c:pt idx="0">
                  <c:v>0.01</c:v>
                </c:pt>
                <c:pt idx="1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509-451D-A11B-CF202CD809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94387792"/>
        <c:axId val="1794388336"/>
      </c:scatterChart>
      <c:valAx>
        <c:axId val="1794387792"/>
        <c:scaling>
          <c:logBase val="10"/>
          <c:orientation val="minMax"/>
          <c:max val="100"/>
          <c:min val="1.0000000000000002E-2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794388336"/>
        <c:crossesAt val="1.0000000000000002E-2"/>
        <c:crossBetween val="midCat"/>
        <c:majorUnit val="10"/>
      </c:valAx>
      <c:valAx>
        <c:axId val="1794388336"/>
        <c:scaling>
          <c:logBase val="10"/>
          <c:orientation val="minMax"/>
          <c:max val="100"/>
          <c:min val="1.0000000000000002E-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794387792"/>
        <c:crossesAt val="1.0000000000000002E-2"/>
        <c:crossBetween val="midCat"/>
        <c:majorUnit val="10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4"/>
          <c:order val="0"/>
          <c:spPr>
            <a:ln w="19050">
              <a:noFill/>
            </a:ln>
          </c:spPr>
          <c:marker>
            <c:symbol val="circle"/>
            <c:size val="8"/>
            <c:spPr>
              <a:solidFill>
                <a:schemeClr val="bg1">
                  <a:lumMod val="65000"/>
                </a:schemeClr>
              </a:solidFill>
              <a:ln w="19050">
                <a:noFill/>
              </a:ln>
            </c:spPr>
          </c:marker>
          <c:xVal>
            <c:numRef>
              <c:f>'Base model'!$C$3:$C$46</c:f>
              <c:numCache>
                <c:formatCode>General</c:formatCode>
                <c:ptCount val="44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  <c:pt idx="11">
                  <c:v>0</c:v>
                </c:pt>
                <c:pt idx="12">
                  <c:v>3</c:v>
                </c:pt>
                <c:pt idx="13">
                  <c:v>5</c:v>
                </c:pt>
                <c:pt idx="14">
                  <c:v>8</c:v>
                </c:pt>
                <c:pt idx="15">
                  <c:v>10</c:v>
                </c:pt>
                <c:pt idx="16">
                  <c:v>12</c:v>
                </c:pt>
                <c:pt idx="17">
                  <c:v>15</c:v>
                </c:pt>
                <c:pt idx="18">
                  <c:v>17</c:v>
                </c:pt>
                <c:pt idx="19">
                  <c:v>19</c:v>
                </c:pt>
                <c:pt idx="20">
                  <c:v>22</c:v>
                </c:pt>
                <c:pt idx="21">
                  <c:v>24</c:v>
                </c:pt>
                <c:pt idx="22">
                  <c:v>0</c:v>
                </c:pt>
                <c:pt idx="23">
                  <c:v>3</c:v>
                </c:pt>
                <c:pt idx="24">
                  <c:v>5</c:v>
                </c:pt>
                <c:pt idx="25">
                  <c:v>8</c:v>
                </c:pt>
                <c:pt idx="26">
                  <c:v>10</c:v>
                </c:pt>
                <c:pt idx="27">
                  <c:v>12</c:v>
                </c:pt>
                <c:pt idx="28">
                  <c:v>15</c:v>
                </c:pt>
                <c:pt idx="29">
                  <c:v>17</c:v>
                </c:pt>
                <c:pt idx="30">
                  <c:v>19</c:v>
                </c:pt>
                <c:pt idx="31">
                  <c:v>22</c:v>
                </c:pt>
                <c:pt idx="32">
                  <c:v>24</c:v>
                </c:pt>
                <c:pt idx="33">
                  <c:v>0</c:v>
                </c:pt>
                <c:pt idx="34">
                  <c:v>3</c:v>
                </c:pt>
                <c:pt idx="35">
                  <c:v>5</c:v>
                </c:pt>
                <c:pt idx="36">
                  <c:v>8</c:v>
                </c:pt>
                <c:pt idx="37">
                  <c:v>10</c:v>
                </c:pt>
                <c:pt idx="38">
                  <c:v>12</c:v>
                </c:pt>
                <c:pt idx="39">
                  <c:v>15</c:v>
                </c:pt>
                <c:pt idx="40">
                  <c:v>17</c:v>
                </c:pt>
                <c:pt idx="41">
                  <c:v>19</c:v>
                </c:pt>
                <c:pt idx="42">
                  <c:v>22</c:v>
                </c:pt>
                <c:pt idx="43">
                  <c:v>24</c:v>
                </c:pt>
              </c:numCache>
            </c:numRef>
          </c:xVal>
          <c:yVal>
            <c:numRef>
              <c:f>'Base model'!$G$3:$G$46</c:f>
              <c:numCache>
                <c:formatCode>General</c:formatCode>
                <c:ptCount val="44"/>
                <c:pt idx="0">
                  <c:v>8</c:v>
                </c:pt>
                <c:pt idx="1">
                  <c:v>8</c:v>
                </c:pt>
                <c:pt idx="2">
                  <c:v>8</c:v>
                </c:pt>
                <c:pt idx="3">
                  <c:v>8</c:v>
                </c:pt>
                <c:pt idx="4">
                  <c:v>8</c:v>
                </c:pt>
                <c:pt idx="5">
                  <c:v>10</c:v>
                </c:pt>
                <c:pt idx="6">
                  <c:v>8</c:v>
                </c:pt>
                <c:pt idx="7">
                  <c:v>8</c:v>
                </c:pt>
                <c:pt idx="8">
                  <c:v>8</c:v>
                </c:pt>
                <c:pt idx="9">
                  <c:v>8</c:v>
                </c:pt>
                <c:pt idx="10">
                  <c:v>8</c:v>
                </c:pt>
                <c:pt idx="11">
                  <c:v>10</c:v>
                </c:pt>
                <c:pt idx="12">
                  <c:v>8</c:v>
                </c:pt>
                <c:pt idx="13">
                  <c:v>8</c:v>
                </c:pt>
                <c:pt idx="14">
                  <c:v>8</c:v>
                </c:pt>
                <c:pt idx="15">
                  <c:v>8</c:v>
                </c:pt>
                <c:pt idx="16">
                  <c:v>10</c:v>
                </c:pt>
                <c:pt idx="17">
                  <c:v>8</c:v>
                </c:pt>
                <c:pt idx="18">
                  <c:v>10</c:v>
                </c:pt>
                <c:pt idx="19">
                  <c:v>8</c:v>
                </c:pt>
                <c:pt idx="20">
                  <c:v>8</c:v>
                </c:pt>
                <c:pt idx="21">
                  <c:v>8</c:v>
                </c:pt>
                <c:pt idx="22">
                  <c:v>10</c:v>
                </c:pt>
                <c:pt idx="23">
                  <c:v>6</c:v>
                </c:pt>
                <c:pt idx="24">
                  <c:v>10</c:v>
                </c:pt>
                <c:pt idx="25">
                  <c:v>8</c:v>
                </c:pt>
                <c:pt idx="26">
                  <c:v>8</c:v>
                </c:pt>
                <c:pt idx="27">
                  <c:v>8</c:v>
                </c:pt>
                <c:pt idx="28">
                  <c:v>8</c:v>
                </c:pt>
                <c:pt idx="29">
                  <c:v>8</c:v>
                </c:pt>
                <c:pt idx="30">
                  <c:v>8</c:v>
                </c:pt>
                <c:pt idx="31">
                  <c:v>8</c:v>
                </c:pt>
                <c:pt idx="32">
                  <c:v>8</c:v>
                </c:pt>
                <c:pt idx="33">
                  <c:v>8</c:v>
                </c:pt>
                <c:pt idx="34">
                  <c:v>8</c:v>
                </c:pt>
                <c:pt idx="35">
                  <c:v>8</c:v>
                </c:pt>
                <c:pt idx="36">
                  <c:v>10</c:v>
                </c:pt>
                <c:pt idx="37">
                  <c:v>6</c:v>
                </c:pt>
                <c:pt idx="38">
                  <c:v>6</c:v>
                </c:pt>
                <c:pt idx="39">
                  <c:v>8</c:v>
                </c:pt>
                <c:pt idx="40">
                  <c:v>6</c:v>
                </c:pt>
                <c:pt idx="41">
                  <c:v>8</c:v>
                </c:pt>
                <c:pt idx="42">
                  <c:v>10</c:v>
                </c:pt>
                <c:pt idx="43">
                  <c:v>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1AE-4BCA-802C-ECD526D0760C}"/>
            </c:ext>
          </c:extLst>
        </c:ser>
        <c:ser>
          <c:idx val="5"/>
          <c:order val="1"/>
          <c:spPr>
            <a:ln w="31750">
              <a:solidFill>
                <a:schemeClr val="bg1">
                  <a:lumMod val="65000"/>
                </a:schemeClr>
              </a:solidFill>
            </a:ln>
          </c:spPr>
          <c:marker>
            <c:symbol val="none"/>
          </c:marker>
          <c:xVal>
            <c:numRef>
              <c:f>'Base model'!$C$3:$C$13</c:f>
              <c:numCache>
                <c:formatCode>General</c:formatCode>
                <c:ptCount val="11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</c:numCache>
            </c:numRef>
          </c:xVal>
          <c:yVal>
            <c:numRef>
              <c:f>'Base model'!$E$3:$E$13</c:f>
              <c:numCache>
                <c:formatCode>General</c:formatCode>
                <c:ptCount val="11"/>
                <c:pt idx="0">
                  <c:v>8</c:v>
                </c:pt>
                <c:pt idx="1">
                  <c:v>8</c:v>
                </c:pt>
                <c:pt idx="2">
                  <c:v>8</c:v>
                </c:pt>
                <c:pt idx="3">
                  <c:v>8</c:v>
                </c:pt>
                <c:pt idx="4">
                  <c:v>8</c:v>
                </c:pt>
                <c:pt idx="5">
                  <c:v>8</c:v>
                </c:pt>
                <c:pt idx="6">
                  <c:v>8</c:v>
                </c:pt>
                <c:pt idx="7">
                  <c:v>8</c:v>
                </c:pt>
                <c:pt idx="8">
                  <c:v>8</c:v>
                </c:pt>
                <c:pt idx="9">
                  <c:v>8</c:v>
                </c:pt>
                <c:pt idx="10">
                  <c:v>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1AE-4BCA-802C-ECD526D076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8"/>
            <c:spPr>
              <a:solidFill>
                <a:srgbClr val="0070C0"/>
              </a:solidFill>
              <a:ln>
                <a:noFill/>
              </a:ln>
            </c:spPr>
          </c:marker>
          <c:xVal>
            <c:numRef>
              <c:f>'Base model'!$C$47:$C$90</c:f>
              <c:numCache>
                <c:formatCode>General</c:formatCode>
                <c:ptCount val="44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  <c:pt idx="11">
                  <c:v>0</c:v>
                </c:pt>
                <c:pt idx="12">
                  <c:v>3</c:v>
                </c:pt>
                <c:pt idx="13">
                  <c:v>5</c:v>
                </c:pt>
                <c:pt idx="14">
                  <c:v>8</c:v>
                </c:pt>
                <c:pt idx="15">
                  <c:v>10</c:v>
                </c:pt>
                <c:pt idx="16">
                  <c:v>12</c:v>
                </c:pt>
                <c:pt idx="17">
                  <c:v>15</c:v>
                </c:pt>
                <c:pt idx="18">
                  <c:v>17</c:v>
                </c:pt>
                <c:pt idx="19">
                  <c:v>19</c:v>
                </c:pt>
                <c:pt idx="20">
                  <c:v>22</c:v>
                </c:pt>
                <c:pt idx="21">
                  <c:v>24</c:v>
                </c:pt>
                <c:pt idx="22">
                  <c:v>0</c:v>
                </c:pt>
                <c:pt idx="23">
                  <c:v>3</c:v>
                </c:pt>
                <c:pt idx="24">
                  <c:v>5</c:v>
                </c:pt>
                <c:pt idx="25">
                  <c:v>8</c:v>
                </c:pt>
                <c:pt idx="26">
                  <c:v>10</c:v>
                </c:pt>
                <c:pt idx="27">
                  <c:v>12</c:v>
                </c:pt>
                <c:pt idx="28">
                  <c:v>15</c:v>
                </c:pt>
                <c:pt idx="29">
                  <c:v>17</c:v>
                </c:pt>
                <c:pt idx="30">
                  <c:v>19</c:v>
                </c:pt>
                <c:pt idx="31">
                  <c:v>22</c:v>
                </c:pt>
                <c:pt idx="32">
                  <c:v>24</c:v>
                </c:pt>
                <c:pt idx="33">
                  <c:v>0</c:v>
                </c:pt>
                <c:pt idx="34">
                  <c:v>3</c:v>
                </c:pt>
                <c:pt idx="35">
                  <c:v>5</c:v>
                </c:pt>
                <c:pt idx="36">
                  <c:v>8</c:v>
                </c:pt>
                <c:pt idx="37">
                  <c:v>10</c:v>
                </c:pt>
                <c:pt idx="38">
                  <c:v>12</c:v>
                </c:pt>
                <c:pt idx="39">
                  <c:v>15</c:v>
                </c:pt>
                <c:pt idx="40">
                  <c:v>17</c:v>
                </c:pt>
                <c:pt idx="41">
                  <c:v>19</c:v>
                </c:pt>
                <c:pt idx="42">
                  <c:v>22</c:v>
                </c:pt>
                <c:pt idx="43">
                  <c:v>24</c:v>
                </c:pt>
              </c:numCache>
            </c:numRef>
          </c:xVal>
          <c:yVal>
            <c:numRef>
              <c:f>'Base model'!$G$47:$G$90</c:f>
              <c:numCache>
                <c:formatCode>General</c:formatCode>
                <c:ptCount val="44"/>
                <c:pt idx="0">
                  <c:v>10</c:v>
                </c:pt>
                <c:pt idx="1">
                  <c:v>8</c:v>
                </c:pt>
                <c:pt idx="2">
                  <c:v>6</c:v>
                </c:pt>
                <c:pt idx="3">
                  <c:v>8</c:v>
                </c:pt>
                <c:pt idx="4">
                  <c:v>8</c:v>
                </c:pt>
                <c:pt idx="5">
                  <c:v>10</c:v>
                </c:pt>
                <c:pt idx="6">
                  <c:v>6</c:v>
                </c:pt>
                <c:pt idx="7">
                  <c:v>8</c:v>
                </c:pt>
                <c:pt idx="8">
                  <c:v>8</c:v>
                </c:pt>
                <c:pt idx="9">
                  <c:v>6</c:v>
                </c:pt>
                <c:pt idx="10">
                  <c:v>8</c:v>
                </c:pt>
                <c:pt idx="11">
                  <c:v>10</c:v>
                </c:pt>
                <c:pt idx="12">
                  <c:v>10</c:v>
                </c:pt>
                <c:pt idx="13">
                  <c:v>8</c:v>
                </c:pt>
                <c:pt idx="14">
                  <c:v>8</c:v>
                </c:pt>
                <c:pt idx="15">
                  <c:v>8</c:v>
                </c:pt>
                <c:pt idx="16">
                  <c:v>6</c:v>
                </c:pt>
                <c:pt idx="17">
                  <c:v>8</c:v>
                </c:pt>
                <c:pt idx="18">
                  <c:v>6</c:v>
                </c:pt>
                <c:pt idx="19">
                  <c:v>6</c:v>
                </c:pt>
                <c:pt idx="20">
                  <c:v>8</c:v>
                </c:pt>
                <c:pt idx="21">
                  <c:v>8</c:v>
                </c:pt>
                <c:pt idx="22">
                  <c:v>8</c:v>
                </c:pt>
                <c:pt idx="23">
                  <c:v>6</c:v>
                </c:pt>
                <c:pt idx="24">
                  <c:v>6</c:v>
                </c:pt>
                <c:pt idx="25">
                  <c:v>6</c:v>
                </c:pt>
                <c:pt idx="26">
                  <c:v>6</c:v>
                </c:pt>
                <c:pt idx="27">
                  <c:v>6</c:v>
                </c:pt>
                <c:pt idx="28">
                  <c:v>8</c:v>
                </c:pt>
                <c:pt idx="29">
                  <c:v>6</c:v>
                </c:pt>
                <c:pt idx="30">
                  <c:v>6</c:v>
                </c:pt>
                <c:pt idx="31">
                  <c:v>8</c:v>
                </c:pt>
                <c:pt idx="32">
                  <c:v>6</c:v>
                </c:pt>
                <c:pt idx="33">
                  <c:v>8</c:v>
                </c:pt>
                <c:pt idx="34">
                  <c:v>8</c:v>
                </c:pt>
                <c:pt idx="35">
                  <c:v>8</c:v>
                </c:pt>
                <c:pt idx="36">
                  <c:v>6</c:v>
                </c:pt>
                <c:pt idx="37">
                  <c:v>6</c:v>
                </c:pt>
                <c:pt idx="38">
                  <c:v>6</c:v>
                </c:pt>
                <c:pt idx="39">
                  <c:v>8</c:v>
                </c:pt>
                <c:pt idx="40">
                  <c:v>6</c:v>
                </c:pt>
                <c:pt idx="41">
                  <c:v>10</c:v>
                </c:pt>
                <c:pt idx="42">
                  <c:v>6</c:v>
                </c:pt>
                <c:pt idx="43">
                  <c:v>1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4C2-4628-A87A-17A852390BB1}"/>
            </c:ext>
          </c:extLst>
        </c:ser>
        <c:ser>
          <c:idx val="1"/>
          <c:order val="1"/>
          <c:spPr>
            <a:ln w="31750">
              <a:solidFill>
                <a:srgbClr val="0070C0"/>
              </a:solidFill>
            </a:ln>
          </c:spPr>
          <c:marker>
            <c:symbol val="none"/>
          </c:marker>
          <c:xVal>
            <c:numRef>
              <c:f>'Base model'!$C$47:$C$57</c:f>
              <c:numCache>
                <c:formatCode>General</c:formatCode>
                <c:ptCount val="11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</c:numCache>
            </c:numRef>
          </c:xVal>
          <c:yVal>
            <c:numRef>
              <c:f>'Base model'!$E$47:$E$57</c:f>
              <c:numCache>
                <c:formatCode>General</c:formatCode>
                <c:ptCount val="11"/>
                <c:pt idx="0">
                  <c:v>8</c:v>
                </c:pt>
                <c:pt idx="1">
                  <c:v>7.2513500000000004</c:v>
                </c:pt>
                <c:pt idx="2">
                  <c:v>7.2682900000000004</c:v>
                </c:pt>
                <c:pt idx="3">
                  <c:v>6.5269899999999996</c:v>
                </c:pt>
                <c:pt idx="4">
                  <c:v>6.5603199999999999</c:v>
                </c:pt>
                <c:pt idx="5">
                  <c:v>6.5929000000000002</c:v>
                </c:pt>
                <c:pt idx="6">
                  <c:v>5.8743999999999996</c:v>
                </c:pt>
                <c:pt idx="7">
                  <c:v>5.9224899999999998</c:v>
                </c:pt>
                <c:pt idx="8">
                  <c:v>5.9695</c:v>
                </c:pt>
                <c:pt idx="9">
                  <c:v>5.2720399999999996</c:v>
                </c:pt>
                <c:pt idx="10">
                  <c:v>5.33375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4C2-4628-A87A-17A852390B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1"/>
          <c:order val="0"/>
          <c:spPr>
            <a:ln w="19050">
              <a:noFill/>
            </a:ln>
          </c:spPr>
          <c:marker>
            <c:symbol val="circle"/>
            <c:size val="8"/>
            <c:spPr>
              <a:solidFill>
                <a:srgbClr val="00B050"/>
              </a:solidFill>
              <a:ln>
                <a:noFill/>
              </a:ln>
            </c:spPr>
          </c:marker>
          <c:xVal>
            <c:numRef>
              <c:f>'Base model'!$C$91:$C$159</c:f>
              <c:numCache>
                <c:formatCode>General</c:formatCode>
                <c:ptCount val="69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  <c:pt idx="11">
                  <c:v>0</c:v>
                </c:pt>
                <c:pt idx="12">
                  <c:v>3</c:v>
                </c:pt>
                <c:pt idx="13">
                  <c:v>5</c:v>
                </c:pt>
                <c:pt idx="14">
                  <c:v>8</c:v>
                </c:pt>
                <c:pt idx="15">
                  <c:v>10</c:v>
                </c:pt>
                <c:pt idx="16">
                  <c:v>12</c:v>
                </c:pt>
                <c:pt idx="17">
                  <c:v>15</c:v>
                </c:pt>
                <c:pt idx="18">
                  <c:v>17</c:v>
                </c:pt>
                <c:pt idx="19">
                  <c:v>19</c:v>
                </c:pt>
                <c:pt idx="20">
                  <c:v>22</c:v>
                </c:pt>
                <c:pt idx="21">
                  <c:v>24</c:v>
                </c:pt>
                <c:pt idx="22">
                  <c:v>0</c:v>
                </c:pt>
                <c:pt idx="23">
                  <c:v>3</c:v>
                </c:pt>
                <c:pt idx="24">
                  <c:v>5</c:v>
                </c:pt>
                <c:pt idx="25">
                  <c:v>8</c:v>
                </c:pt>
                <c:pt idx="26">
                  <c:v>10</c:v>
                </c:pt>
                <c:pt idx="27">
                  <c:v>12</c:v>
                </c:pt>
                <c:pt idx="28">
                  <c:v>15</c:v>
                </c:pt>
                <c:pt idx="29">
                  <c:v>17</c:v>
                </c:pt>
                <c:pt idx="30">
                  <c:v>19</c:v>
                </c:pt>
                <c:pt idx="31">
                  <c:v>22</c:v>
                </c:pt>
                <c:pt idx="32">
                  <c:v>24</c:v>
                </c:pt>
                <c:pt idx="33">
                  <c:v>0</c:v>
                </c:pt>
                <c:pt idx="34">
                  <c:v>3</c:v>
                </c:pt>
                <c:pt idx="35">
                  <c:v>5</c:v>
                </c:pt>
                <c:pt idx="36">
                  <c:v>8</c:v>
                </c:pt>
                <c:pt idx="37">
                  <c:v>10</c:v>
                </c:pt>
                <c:pt idx="38">
                  <c:v>12</c:v>
                </c:pt>
                <c:pt idx="39">
                  <c:v>15</c:v>
                </c:pt>
                <c:pt idx="40">
                  <c:v>17</c:v>
                </c:pt>
                <c:pt idx="41">
                  <c:v>19</c:v>
                </c:pt>
                <c:pt idx="42">
                  <c:v>22</c:v>
                </c:pt>
                <c:pt idx="43">
                  <c:v>24</c:v>
                </c:pt>
                <c:pt idx="44">
                  <c:v>26</c:v>
                </c:pt>
                <c:pt idx="45">
                  <c:v>0</c:v>
                </c:pt>
                <c:pt idx="46">
                  <c:v>3</c:v>
                </c:pt>
                <c:pt idx="47">
                  <c:v>5</c:v>
                </c:pt>
                <c:pt idx="48">
                  <c:v>8</c:v>
                </c:pt>
                <c:pt idx="49">
                  <c:v>10</c:v>
                </c:pt>
                <c:pt idx="50">
                  <c:v>12</c:v>
                </c:pt>
                <c:pt idx="51">
                  <c:v>15</c:v>
                </c:pt>
                <c:pt idx="52">
                  <c:v>17</c:v>
                </c:pt>
                <c:pt idx="53">
                  <c:v>19</c:v>
                </c:pt>
                <c:pt idx="54">
                  <c:v>22</c:v>
                </c:pt>
                <c:pt idx="55">
                  <c:v>24</c:v>
                </c:pt>
                <c:pt idx="56">
                  <c:v>26</c:v>
                </c:pt>
                <c:pt idx="57">
                  <c:v>0</c:v>
                </c:pt>
                <c:pt idx="58">
                  <c:v>3</c:v>
                </c:pt>
                <c:pt idx="59">
                  <c:v>5</c:v>
                </c:pt>
                <c:pt idx="60">
                  <c:v>8</c:v>
                </c:pt>
                <c:pt idx="61">
                  <c:v>10</c:v>
                </c:pt>
                <c:pt idx="62">
                  <c:v>12</c:v>
                </c:pt>
                <c:pt idx="63">
                  <c:v>15</c:v>
                </c:pt>
                <c:pt idx="64">
                  <c:v>17</c:v>
                </c:pt>
                <c:pt idx="65">
                  <c:v>19</c:v>
                </c:pt>
                <c:pt idx="66">
                  <c:v>22</c:v>
                </c:pt>
                <c:pt idx="67">
                  <c:v>24</c:v>
                </c:pt>
                <c:pt idx="68">
                  <c:v>26</c:v>
                </c:pt>
              </c:numCache>
            </c:numRef>
          </c:xVal>
          <c:yVal>
            <c:numRef>
              <c:f>'Base model'!$G$91:$G$159</c:f>
              <c:numCache>
                <c:formatCode>General</c:formatCode>
                <c:ptCount val="69"/>
                <c:pt idx="0">
                  <c:v>8</c:v>
                </c:pt>
                <c:pt idx="1">
                  <c:v>8</c:v>
                </c:pt>
                <c:pt idx="2">
                  <c:v>6</c:v>
                </c:pt>
                <c:pt idx="3">
                  <c:v>6</c:v>
                </c:pt>
                <c:pt idx="4">
                  <c:v>4</c:v>
                </c:pt>
                <c:pt idx="5">
                  <c:v>2</c:v>
                </c:pt>
                <c:pt idx="6">
                  <c:v>2</c:v>
                </c:pt>
                <c:pt idx="7">
                  <c:v>0.16</c:v>
                </c:pt>
                <c:pt idx="8">
                  <c:v>7.0000000000000007E-2</c:v>
                </c:pt>
                <c:pt idx="9">
                  <c:v>7.0000000000000007E-2</c:v>
                </c:pt>
                <c:pt idx="10">
                  <c:v>8.0000000000000002E-3</c:v>
                </c:pt>
                <c:pt idx="11">
                  <c:v>10</c:v>
                </c:pt>
                <c:pt idx="12">
                  <c:v>8</c:v>
                </c:pt>
                <c:pt idx="13">
                  <c:v>6</c:v>
                </c:pt>
                <c:pt idx="14">
                  <c:v>6</c:v>
                </c:pt>
                <c:pt idx="15">
                  <c:v>2</c:v>
                </c:pt>
                <c:pt idx="16">
                  <c:v>0.02</c:v>
                </c:pt>
                <c:pt idx="17">
                  <c:v>0.02</c:v>
                </c:pt>
                <c:pt idx="18">
                  <c:v>0.02</c:v>
                </c:pt>
                <c:pt idx="19">
                  <c:v>0.02</c:v>
                </c:pt>
                <c:pt idx="20">
                  <c:v>7.0000000000000007E-2</c:v>
                </c:pt>
                <c:pt idx="21">
                  <c:v>8.0000000000000002E-3</c:v>
                </c:pt>
                <c:pt idx="22">
                  <c:v>8</c:v>
                </c:pt>
                <c:pt idx="23">
                  <c:v>8</c:v>
                </c:pt>
                <c:pt idx="24">
                  <c:v>8</c:v>
                </c:pt>
                <c:pt idx="25">
                  <c:v>8</c:v>
                </c:pt>
                <c:pt idx="26">
                  <c:v>4</c:v>
                </c:pt>
                <c:pt idx="27">
                  <c:v>2</c:v>
                </c:pt>
                <c:pt idx="28">
                  <c:v>1.4</c:v>
                </c:pt>
                <c:pt idx="29">
                  <c:v>0.16</c:v>
                </c:pt>
                <c:pt idx="30">
                  <c:v>0.02</c:v>
                </c:pt>
                <c:pt idx="31">
                  <c:v>7.0000000000000007E-2</c:v>
                </c:pt>
                <c:pt idx="32">
                  <c:v>8.0000000000000002E-3</c:v>
                </c:pt>
                <c:pt idx="33">
                  <c:v>10</c:v>
                </c:pt>
                <c:pt idx="34">
                  <c:v>10</c:v>
                </c:pt>
                <c:pt idx="35">
                  <c:v>6</c:v>
                </c:pt>
                <c:pt idx="36">
                  <c:v>8</c:v>
                </c:pt>
                <c:pt idx="37">
                  <c:v>4</c:v>
                </c:pt>
                <c:pt idx="38">
                  <c:v>4</c:v>
                </c:pt>
                <c:pt idx="39">
                  <c:v>2</c:v>
                </c:pt>
                <c:pt idx="40">
                  <c:v>2</c:v>
                </c:pt>
                <c:pt idx="41">
                  <c:v>0.4</c:v>
                </c:pt>
                <c:pt idx="42">
                  <c:v>0.16</c:v>
                </c:pt>
                <c:pt idx="43">
                  <c:v>0.16</c:v>
                </c:pt>
                <c:pt idx="44">
                  <c:v>0.16</c:v>
                </c:pt>
                <c:pt idx="45">
                  <c:v>8</c:v>
                </c:pt>
                <c:pt idx="46">
                  <c:v>4</c:v>
                </c:pt>
                <c:pt idx="47">
                  <c:v>8</c:v>
                </c:pt>
                <c:pt idx="48">
                  <c:v>6</c:v>
                </c:pt>
                <c:pt idx="49">
                  <c:v>4</c:v>
                </c:pt>
                <c:pt idx="50">
                  <c:v>2</c:v>
                </c:pt>
                <c:pt idx="51">
                  <c:v>1.4</c:v>
                </c:pt>
                <c:pt idx="52">
                  <c:v>1</c:v>
                </c:pt>
                <c:pt idx="53">
                  <c:v>0.4</c:v>
                </c:pt>
                <c:pt idx="54">
                  <c:v>0.4</c:v>
                </c:pt>
                <c:pt idx="55">
                  <c:v>0.4</c:v>
                </c:pt>
                <c:pt idx="56">
                  <c:v>0.16</c:v>
                </c:pt>
                <c:pt idx="57">
                  <c:v>6</c:v>
                </c:pt>
                <c:pt idx="58">
                  <c:v>10</c:v>
                </c:pt>
                <c:pt idx="59">
                  <c:v>8</c:v>
                </c:pt>
                <c:pt idx="60">
                  <c:v>8</c:v>
                </c:pt>
                <c:pt idx="61">
                  <c:v>2</c:v>
                </c:pt>
                <c:pt idx="62">
                  <c:v>2</c:v>
                </c:pt>
                <c:pt idx="63">
                  <c:v>1</c:v>
                </c:pt>
                <c:pt idx="64">
                  <c:v>1</c:v>
                </c:pt>
                <c:pt idx="65">
                  <c:v>0.16</c:v>
                </c:pt>
                <c:pt idx="66">
                  <c:v>0.4</c:v>
                </c:pt>
                <c:pt idx="67">
                  <c:v>0.4</c:v>
                </c:pt>
                <c:pt idx="68">
                  <c:v>0.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23A-4243-BA64-B4535A8A71BE}"/>
            </c:ext>
          </c:extLst>
        </c:ser>
        <c:ser>
          <c:idx val="0"/>
          <c:order val="1"/>
          <c:spPr>
            <a:ln w="31750">
              <a:solidFill>
                <a:srgbClr val="00B050"/>
              </a:solidFill>
            </a:ln>
          </c:spPr>
          <c:marker>
            <c:symbol val="none"/>
          </c:marker>
          <c:xVal>
            <c:numRef>
              <c:f>'Base model'!$C$91:$C$101</c:f>
              <c:numCache>
                <c:formatCode>General</c:formatCode>
                <c:ptCount val="11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</c:numCache>
            </c:numRef>
          </c:xVal>
          <c:yVal>
            <c:numRef>
              <c:f>'Base model'!$E$91:$E$101</c:f>
              <c:numCache>
                <c:formatCode>General</c:formatCode>
                <c:ptCount val="11"/>
                <c:pt idx="0">
                  <c:v>8</c:v>
                </c:pt>
                <c:pt idx="1">
                  <c:v>6.5843600000000002</c:v>
                </c:pt>
                <c:pt idx="2">
                  <c:v>6.61639</c:v>
                </c:pt>
                <c:pt idx="3">
                  <c:v>5.2146699999999999</c:v>
                </c:pt>
                <c:pt idx="4">
                  <c:v>5.2776899999999998</c:v>
                </c:pt>
                <c:pt idx="5">
                  <c:v>5.3392900000000001</c:v>
                </c:pt>
                <c:pt idx="6">
                  <c:v>3.9806699999999999</c:v>
                </c:pt>
                <c:pt idx="7">
                  <c:v>4.0716099999999997</c:v>
                </c:pt>
                <c:pt idx="8">
                  <c:v>4.1604999999999999</c:v>
                </c:pt>
                <c:pt idx="9">
                  <c:v>2.8416600000000001</c:v>
                </c:pt>
                <c:pt idx="10">
                  <c:v>2.95836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23A-4243-BA64-B4535A8A71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2"/>
          <c:order val="0"/>
          <c:spPr>
            <a:ln w="19050">
              <a:noFill/>
            </a:ln>
          </c:spPr>
          <c:marker>
            <c:symbol val="circle"/>
            <c:size val="8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'Base model'!$C$160:$C$226</c:f>
              <c:numCache>
                <c:formatCode>General</c:formatCode>
                <c:ptCount val="67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0</c:v>
                </c:pt>
                <c:pt idx="11">
                  <c:v>3</c:v>
                </c:pt>
                <c:pt idx="12">
                  <c:v>5</c:v>
                </c:pt>
                <c:pt idx="13">
                  <c:v>8</c:v>
                </c:pt>
                <c:pt idx="14">
                  <c:v>10</c:v>
                </c:pt>
                <c:pt idx="15">
                  <c:v>12</c:v>
                </c:pt>
                <c:pt idx="16">
                  <c:v>15</c:v>
                </c:pt>
                <c:pt idx="17">
                  <c:v>17</c:v>
                </c:pt>
                <c:pt idx="18">
                  <c:v>19</c:v>
                </c:pt>
                <c:pt idx="19">
                  <c:v>22</c:v>
                </c:pt>
                <c:pt idx="20">
                  <c:v>0</c:v>
                </c:pt>
                <c:pt idx="21">
                  <c:v>3</c:v>
                </c:pt>
                <c:pt idx="22">
                  <c:v>5</c:v>
                </c:pt>
                <c:pt idx="23">
                  <c:v>8</c:v>
                </c:pt>
                <c:pt idx="24">
                  <c:v>10</c:v>
                </c:pt>
                <c:pt idx="25">
                  <c:v>12</c:v>
                </c:pt>
                <c:pt idx="26">
                  <c:v>15</c:v>
                </c:pt>
                <c:pt idx="27">
                  <c:v>17</c:v>
                </c:pt>
                <c:pt idx="28">
                  <c:v>0</c:v>
                </c:pt>
                <c:pt idx="29">
                  <c:v>3</c:v>
                </c:pt>
                <c:pt idx="30">
                  <c:v>5</c:v>
                </c:pt>
                <c:pt idx="31">
                  <c:v>8</c:v>
                </c:pt>
                <c:pt idx="32">
                  <c:v>10</c:v>
                </c:pt>
                <c:pt idx="33">
                  <c:v>12</c:v>
                </c:pt>
                <c:pt idx="34">
                  <c:v>15</c:v>
                </c:pt>
                <c:pt idx="35">
                  <c:v>17</c:v>
                </c:pt>
                <c:pt idx="36">
                  <c:v>0</c:v>
                </c:pt>
                <c:pt idx="37">
                  <c:v>3</c:v>
                </c:pt>
                <c:pt idx="38">
                  <c:v>5</c:v>
                </c:pt>
                <c:pt idx="39">
                  <c:v>8</c:v>
                </c:pt>
                <c:pt idx="40">
                  <c:v>10</c:v>
                </c:pt>
                <c:pt idx="41">
                  <c:v>12</c:v>
                </c:pt>
                <c:pt idx="42">
                  <c:v>15</c:v>
                </c:pt>
                <c:pt idx="43">
                  <c:v>17</c:v>
                </c:pt>
                <c:pt idx="44">
                  <c:v>19</c:v>
                </c:pt>
                <c:pt idx="45">
                  <c:v>22</c:v>
                </c:pt>
                <c:pt idx="46">
                  <c:v>0</c:v>
                </c:pt>
                <c:pt idx="47">
                  <c:v>3</c:v>
                </c:pt>
                <c:pt idx="48">
                  <c:v>5</c:v>
                </c:pt>
                <c:pt idx="49">
                  <c:v>8</c:v>
                </c:pt>
                <c:pt idx="50">
                  <c:v>10</c:v>
                </c:pt>
                <c:pt idx="51">
                  <c:v>12</c:v>
                </c:pt>
                <c:pt idx="52">
                  <c:v>15</c:v>
                </c:pt>
                <c:pt idx="53">
                  <c:v>17</c:v>
                </c:pt>
                <c:pt idx="54">
                  <c:v>19</c:v>
                </c:pt>
                <c:pt idx="55">
                  <c:v>22</c:v>
                </c:pt>
                <c:pt idx="56">
                  <c:v>0</c:v>
                </c:pt>
                <c:pt idx="57">
                  <c:v>3</c:v>
                </c:pt>
                <c:pt idx="58">
                  <c:v>5</c:v>
                </c:pt>
                <c:pt idx="59">
                  <c:v>8</c:v>
                </c:pt>
                <c:pt idx="60">
                  <c:v>10</c:v>
                </c:pt>
                <c:pt idx="61">
                  <c:v>12</c:v>
                </c:pt>
                <c:pt idx="62">
                  <c:v>15</c:v>
                </c:pt>
                <c:pt idx="63">
                  <c:v>17</c:v>
                </c:pt>
                <c:pt idx="64">
                  <c:v>19</c:v>
                </c:pt>
                <c:pt idx="65">
                  <c:v>22</c:v>
                </c:pt>
                <c:pt idx="66">
                  <c:v>22</c:v>
                </c:pt>
              </c:numCache>
            </c:numRef>
          </c:xVal>
          <c:yVal>
            <c:numRef>
              <c:f>'Base model'!$G$160:$G$226</c:f>
              <c:numCache>
                <c:formatCode>General</c:formatCode>
                <c:ptCount val="67"/>
                <c:pt idx="0">
                  <c:v>8</c:v>
                </c:pt>
                <c:pt idx="1">
                  <c:v>8</c:v>
                </c:pt>
                <c:pt idx="2">
                  <c:v>6</c:v>
                </c:pt>
                <c:pt idx="3">
                  <c:v>4</c:v>
                </c:pt>
                <c:pt idx="4">
                  <c:v>2</c:v>
                </c:pt>
                <c:pt idx="5">
                  <c:v>2</c:v>
                </c:pt>
                <c:pt idx="6">
                  <c:v>1.4</c:v>
                </c:pt>
                <c:pt idx="7">
                  <c:v>1</c:v>
                </c:pt>
                <c:pt idx="8">
                  <c:v>0.02</c:v>
                </c:pt>
                <c:pt idx="9">
                  <c:v>0.02</c:v>
                </c:pt>
                <c:pt idx="10">
                  <c:v>8</c:v>
                </c:pt>
                <c:pt idx="11">
                  <c:v>8</c:v>
                </c:pt>
                <c:pt idx="12">
                  <c:v>4</c:v>
                </c:pt>
                <c:pt idx="13">
                  <c:v>4</c:v>
                </c:pt>
                <c:pt idx="14">
                  <c:v>2</c:v>
                </c:pt>
                <c:pt idx="15">
                  <c:v>1.4</c:v>
                </c:pt>
                <c:pt idx="16">
                  <c:v>0.16</c:v>
                </c:pt>
                <c:pt idx="17">
                  <c:v>0.16</c:v>
                </c:pt>
                <c:pt idx="18">
                  <c:v>0.02</c:v>
                </c:pt>
                <c:pt idx="19">
                  <c:v>0.02</c:v>
                </c:pt>
                <c:pt idx="20">
                  <c:v>6</c:v>
                </c:pt>
                <c:pt idx="21">
                  <c:v>8</c:v>
                </c:pt>
                <c:pt idx="22">
                  <c:v>6</c:v>
                </c:pt>
                <c:pt idx="23">
                  <c:v>6</c:v>
                </c:pt>
                <c:pt idx="24">
                  <c:v>1.4</c:v>
                </c:pt>
                <c:pt idx="25">
                  <c:v>2</c:v>
                </c:pt>
                <c:pt idx="26">
                  <c:v>1.4</c:v>
                </c:pt>
                <c:pt idx="27">
                  <c:v>1.4</c:v>
                </c:pt>
                <c:pt idx="28">
                  <c:v>8</c:v>
                </c:pt>
                <c:pt idx="29">
                  <c:v>8</c:v>
                </c:pt>
                <c:pt idx="30">
                  <c:v>6</c:v>
                </c:pt>
                <c:pt idx="31">
                  <c:v>6</c:v>
                </c:pt>
                <c:pt idx="32">
                  <c:v>4</c:v>
                </c:pt>
                <c:pt idx="33">
                  <c:v>1.4</c:v>
                </c:pt>
                <c:pt idx="34">
                  <c:v>1.4</c:v>
                </c:pt>
                <c:pt idx="35">
                  <c:v>1.4</c:v>
                </c:pt>
                <c:pt idx="36">
                  <c:v>10</c:v>
                </c:pt>
                <c:pt idx="37">
                  <c:v>6</c:v>
                </c:pt>
                <c:pt idx="38">
                  <c:v>10</c:v>
                </c:pt>
                <c:pt idx="39">
                  <c:v>10</c:v>
                </c:pt>
                <c:pt idx="40">
                  <c:v>1.4</c:v>
                </c:pt>
                <c:pt idx="41">
                  <c:v>1</c:v>
                </c:pt>
                <c:pt idx="42">
                  <c:v>2</c:v>
                </c:pt>
                <c:pt idx="43">
                  <c:v>0.4</c:v>
                </c:pt>
                <c:pt idx="44">
                  <c:v>0.4</c:v>
                </c:pt>
                <c:pt idx="45">
                  <c:v>0.16</c:v>
                </c:pt>
                <c:pt idx="46">
                  <c:v>8</c:v>
                </c:pt>
                <c:pt idx="47">
                  <c:v>6</c:v>
                </c:pt>
                <c:pt idx="48">
                  <c:v>6</c:v>
                </c:pt>
                <c:pt idx="49">
                  <c:v>6</c:v>
                </c:pt>
                <c:pt idx="50">
                  <c:v>4</c:v>
                </c:pt>
                <c:pt idx="51">
                  <c:v>1</c:v>
                </c:pt>
                <c:pt idx="52">
                  <c:v>1.4</c:v>
                </c:pt>
                <c:pt idx="53">
                  <c:v>0.4</c:v>
                </c:pt>
                <c:pt idx="54">
                  <c:v>0.16</c:v>
                </c:pt>
                <c:pt idx="55">
                  <c:v>7.0000000000000007E-2</c:v>
                </c:pt>
                <c:pt idx="56">
                  <c:v>8</c:v>
                </c:pt>
                <c:pt idx="57">
                  <c:v>10</c:v>
                </c:pt>
                <c:pt idx="58">
                  <c:v>4</c:v>
                </c:pt>
                <c:pt idx="59">
                  <c:v>6</c:v>
                </c:pt>
                <c:pt idx="60">
                  <c:v>1.4</c:v>
                </c:pt>
                <c:pt idx="61">
                  <c:v>1</c:v>
                </c:pt>
                <c:pt idx="62">
                  <c:v>1</c:v>
                </c:pt>
                <c:pt idx="63">
                  <c:v>0.4</c:v>
                </c:pt>
                <c:pt idx="64">
                  <c:v>0.4</c:v>
                </c:pt>
                <c:pt idx="65">
                  <c:v>0.16</c:v>
                </c:pt>
                <c:pt idx="66">
                  <c:v>2.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8CA-47E2-B539-3FBE0DF66EC0}"/>
            </c:ext>
          </c:extLst>
        </c:ser>
        <c:ser>
          <c:idx val="0"/>
          <c:order val="1"/>
          <c:spPr>
            <a:ln w="31750">
              <a:solidFill>
                <a:srgbClr val="FF0000"/>
              </a:solidFill>
            </a:ln>
          </c:spPr>
          <c:marker>
            <c:symbol val="none"/>
          </c:marker>
          <c:xVal>
            <c:numRef>
              <c:f>'Base model'!$C$160:$C$169</c:f>
              <c:numCache>
                <c:formatCode>General</c:formatCode>
                <c:ptCount val="10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</c:numCache>
            </c:numRef>
          </c:xVal>
          <c:yVal>
            <c:numRef>
              <c:f>'Base model'!$E$160:$E$169</c:f>
              <c:numCache>
                <c:formatCode>General</c:formatCode>
                <c:ptCount val="10"/>
                <c:pt idx="0">
                  <c:v>8</c:v>
                </c:pt>
                <c:pt idx="1">
                  <c:v>5.8065899999999999</c:v>
                </c:pt>
                <c:pt idx="2">
                  <c:v>5.8562200000000004</c:v>
                </c:pt>
                <c:pt idx="3">
                  <c:v>3.68438</c:v>
                </c:pt>
                <c:pt idx="4">
                  <c:v>3.7820299999999998</c:v>
                </c:pt>
                <c:pt idx="5">
                  <c:v>3.8774600000000001</c:v>
                </c:pt>
                <c:pt idx="6">
                  <c:v>1.7724</c:v>
                </c:pt>
                <c:pt idx="7">
                  <c:v>1.9133100000000001</c:v>
                </c:pt>
                <c:pt idx="8">
                  <c:v>2.0510299999999999</c:v>
                </c:pt>
                <c:pt idx="9">
                  <c:v>8.0000000000000002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8CA-47E2-B539-3FBE0DF66E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2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4"/>
          <c:order val="0"/>
          <c:spPr>
            <a:ln w="19050">
              <a:noFill/>
            </a:ln>
          </c:spPr>
          <c:marker>
            <c:symbol val="circle"/>
            <c:size val="8"/>
            <c:spPr>
              <a:solidFill>
                <a:schemeClr val="bg1">
                  <a:lumMod val="65000"/>
                </a:schemeClr>
              </a:solidFill>
              <a:ln w="19050">
                <a:noFill/>
              </a:ln>
            </c:spPr>
          </c:marker>
          <c:xVal>
            <c:numRef>
              <c:f>'Sigmoid Emax model'!$C$3:$C$46</c:f>
              <c:numCache>
                <c:formatCode>General</c:formatCode>
                <c:ptCount val="44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  <c:pt idx="11">
                  <c:v>0</c:v>
                </c:pt>
                <c:pt idx="12">
                  <c:v>3</c:v>
                </c:pt>
                <c:pt idx="13">
                  <c:v>5</c:v>
                </c:pt>
                <c:pt idx="14">
                  <c:v>8</c:v>
                </c:pt>
                <c:pt idx="15">
                  <c:v>10</c:v>
                </c:pt>
                <c:pt idx="16">
                  <c:v>12</c:v>
                </c:pt>
                <c:pt idx="17">
                  <c:v>15</c:v>
                </c:pt>
                <c:pt idx="18">
                  <c:v>17</c:v>
                </c:pt>
                <c:pt idx="19">
                  <c:v>19</c:v>
                </c:pt>
                <c:pt idx="20">
                  <c:v>22</c:v>
                </c:pt>
                <c:pt idx="21">
                  <c:v>24</c:v>
                </c:pt>
                <c:pt idx="22">
                  <c:v>0</c:v>
                </c:pt>
                <c:pt idx="23">
                  <c:v>3</c:v>
                </c:pt>
                <c:pt idx="24">
                  <c:v>5</c:v>
                </c:pt>
                <c:pt idx="25">
                  <c:v>8</c:v>
                </c:pt>
                <c:pt idx="26">
                  <c:v>10</c:v>
                </c:pt>
                <c:pt idx="27">
                  <c:v>12</c:v>
                </c:pt>
                <c:pt idx="28">
                  <c:v>15</c:v>
                </c:pt>
                <c:pt idx="29">
                  <c:v>17</c:v>
                </c:pt>
                <c:pt idx="30">
                  <c:v>19</c:v>
                </c:pt>
                <c:pt idx="31">
                  <c:v>22</c:v>
                </c:pt>
                <c:pt idx="32">
                  <c:v>24</c:v>
                </c:pt>
                <c:pt idx="33">
                  <c:v>0</c:v>
                </c:pt>
                <c:pt idx="34">
                  <c:v>3</c:v>
                </c:pt>
                <c:pt idx="35">
                  <c:v>5</c:v>
                </c:pt>
                <c:pt idx="36">
                  <c:v>8</c:v>
                </c:pt>
                <c:pt idx="37">
                  <c:v>10</c:v>
                </c:pt>
                <c:pt idx="38">
                  <c:v>12</c:v>
                </c:pt>
                <c:pt idx="39">
                  <c:v>15</c:v>
                </c:pt>
                <c:pt idx="40">
                  <c:v>17</c:v>
                </c:pt>
                <c:pt idx="41">
                  <c:v>19</c:v>
                </c:pt>
                <c:pt idx="42">
                  <c:v>22</c:v>
                </c:pt>
                <c:pt idx="43">
                  <c:v>24</c:v>
                </c:pt>
              </c:numCache>
            </c:numRef>
          </c:xVal>
          <c:yVal>
            <c:numRef>
              <c:f>'Sigmoid Emax model'!$G$3:$G$46</c:f>
              <c:numCache>
                <c:formatCode>General</c:formatCode>
                <c:ptCount val="44"/>
                <c:pt idx="0">
                  <c:v>8</c:v>
                </c:pt>
                <c:pt idx="1">
                  <c:v>8</c:v>
                </c:pt>
                <c:pt idx="2">
                  <c:v>8</c:v>
                </c:pt>
                <c:pt idx="3">
                  <c:v>8</c:v>
                </c:pt>
                <c:pt idx="4">
                  <c:v>8</c:v>
                </c:pt>
                <c:pt idx="5">
                  <c:v>10</c:v>
                </c:pt>
                <c:pt idx="6">
                  <c:v>8</c:v>
                </c:pt>
                <c:pt idx="7">
                  <c:v>8</c:v>
                </c:pt>
                <c:pt idx="8">
                  <c:v>8</c:v>
                </c:pt>
                <c:pt idx="9">
                  <c:v>8</c:v>
                </c:pt>
                <c:pt idx="10">
                  <c:v>8</c:v>
                </c:pt>
                <c:pt idx="11">
                  <c:v>10</c:v>
                </c:pt>
                <c:pt idx="12">
                  <c:v>8</c:v>
                </c:pt>
                <c:pt idx="13">
                  <c:v>8</c:v>
                </c:pt>
                <c:pt idx="14">
                  <c:v>8</c:v>
                </c:pt>
                <c:pt idx="15">
                  <c:v>8</c:v>
                </c:pt>
                <c:pt idx="16">
                  <c:v>10</c:v>
                </c:pt>
                <c:pt idx="17">
                  <c:v>8</c:v>
                </c:pt>
                <c:pt idx="18">
                  <c:v>10</c:v>
                </c:pt>
                <c:pt idx="19">
                  <c:v>8</c:v>
                </c:pt>
                <c:pt idx="20">
                  <c:v>8</c:v>
                </c:pt>
                <c:pt idx="21">
                  <c:v>8</c:v>
                </c:pt>
                <c:pt idx="22">
                  <c:v>10</c:v>
                </c:pt>
                <c:pt idx="23">
                  <c:v>6</c:v>
                </c:pt>
                <c:pt idx="24">
                  <c:v>10</c:v>
                </c:pt>
                <c:pt idx="25">
                  <c:v>8</c:v>
                </c:pt>
                <c:pt idx="26">
                  <c:v>8</c:v>
                </c:pt>
                <c:pt idx="27">
                  <c:v>8</c:v>
                </c:pt>
                <c:pt idx="28">
                  <c:v>8</c:v>
                </c:pt>
                <c:pt idx="29">
                  <c:v>8</c:v>
                </c:pt>
                <c:pt idx="30">
                  <c:v>8</c:v>
                </c:pt>
                <c:pt idx="31">
                  <c:v>8</c:v>
                </c:pt>
                <c:pt idx="32">
                  <c:v>8</c:v>
                </c:pt>
                <c:pt idx="33">
                  <c:v>8</c:v>
                </c:pt>
                <c:pt idx="34">
                  <c:v>8</c:v>
                </c:pt>
                <c:pt idx="35">
                  <c:v>8</c:v>
                </c:pt>
                <c:pt idx="36">
                  <c:v>10</c:v>
                </c:pt>
                <c:pt idx="37">
                  <c:v>6</c:v>
                </c:pt>
                <c:pt idx="38">
                  <c:v>6</c:v>
                </c:pt>
                <c:pt idx="39">
                  <c:v>8</c:v>
                </c:pt>
                <c:pt idx="40">
                  <c:v>6</c:v>
                </c:pt>
                <c:pt idx="41">
                  <c:v>8</c:v>
                </c:pt>
                <c:pt idx="42">
                  <c:v>10</c:v>
                </c:pt>
                <c:pt idx="43">
                  <c:v>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6A4-4648-9BC8-4556FF6C6804}"/>
            </c:ext>
          </c:extLst>
        </c:ser>
        <c:ser>
          <c:idx val="5"/>
          <c:order val="1"/>
          <c:spPr>
            <a:ln w="31750">
              <a:solidFill>
                <a:schemeClr val="bg1">
                  <a:lumMod val="65000"/>
                </a:schemeClr>
              </a:solidFill>
            </a:ln>
          </c:spPr>
          <c:marker>
            <c:symbol val="none"/>
          </c:marker>
          <c:xVal>
            <c:numRef>
              <c:f>'Sigmoid Emax model'!$C$3:$C$13</c:f>
              <c:numCache>
                <c:formatCode>General</c:formatCode>
                <c:ptCount val="11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</c:numCache>
            </c:numRef>
          </c:xVal>
          <c:yVal>
            <c:numRef>
              <c:f>'Sigmoid Emax model'!$E$3:$E$13</c:f>
              <c:numCache>
                <c:formatCode>General</c:formatCode>
                <c:ptCount val="11"/>
                <c:pt idx="0">
                  <c:v>8</c:v>
                </c:pt>
                <c:pt idx="1">
                  <c:v>8</c:v>
                </c:pt>
                <c:pt idx="2">
                  <c:v>8</c:v>
                </c:pt>
                <c:pt idx="3">
                  <c:v>8</c:v>
                </c:pt>
                <c:pt idx="4">
                  <c:v>8</c:v>
                </c:pt>
                <c:pt idx="5">
                  <c:v>8</c:v>
                </c:pt>
                <c:pt idx="6">
                  <c:v>8</c:v>
                </c:pt>
                <c:pt idx="7">
                  <c:v>8</c:v>
                </c:pt>
                <c:pt idx="8">
                  <c:v>8</c:v>
                </c:pt>
                <c:pt idx="9">
                  <c:v>8</c:v>
                </c:pt>
                <c:pt idx="10">
                  <c:v>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6A4-4648-9BC8-4556FF6C68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8"/>
            <c:spPr>
              <a:solidFill>
                <a:srgbClr val="0070C0"/>
              </a:solidFill>
              <a:ln>
                <a:noFill/>
              </a:ln>
            </c:spPr>
          </c:marker>
          <c:xVal>
            <c:numRef>
              <c:f>'Sigmoid Emax model'!$C$47:$C$90</c:f>
              <c:numCache>
                <c:formatCode>General</c:formatCode>
                <c:ptCount val="44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  <c:pt idx="11">
                  <c:v>0</c:v>
                </c:pt>
                <c:pt idx="12">
                  <c:v>3</c:v>
                </c:pt>
                <c:pt idx="13">
                  <c:v>5</c:v>
                </c:pt>
                <c:pt idx="14">
                  <c:v>8</c:v>
                </c:pt>
                <c:pt idx="15">
                  <c:v>10</c:v>
                </c:pt>
                <c:pt idx="16">
                  <c:v>12</c:v>
                </c:pt>
                <c:pt idx="17">
                  <c:v>15</c:v>
                </c:pt>
                <c:pt idx="18">
                  <c:v>17</c:v>
                </c:pt>
                <c:pt idx="19">
                  <c:v>19</c:v>
                </c:pt>
                <c:pt idx="20">
                  <c:v>22</c:v>
                </c:pt>
                <c:pt idx="21">
                  <c:v>24</c:v>
                </c:pt>
                <c:pt idx="22">
                  <c:v>0</c:v>
                </c:pt>
                <c:pt idx="23">
                  <c:v>3</c:v>
                </c:pt>
                <c:pt idx="24">
                  <c:v>5</c:v>
                </c:pt>
                <c:pt idx="25">
                  <c:v>8</c:v>
                </c:pt>
                <c:pt idx="26">
                  <c:v>10</c:v>
                </c:pt>
                <c:pt idx="27">
                  <c:v>12</c:v>
                </c:pt>
                <c:pt idx="28">
                  <c:v>15</c:v>
                </c:pt>
                <c:pt idx="29">
                  <c:v>17</c:v>
                </c:pt>
                <c:pt idx="30">
                  <c:v>19</c:v>
                </c:pt>
                <c:pt idx="31">
                  <c:v>22</c:v>
                </c:pt>
                <c:pt idx="32">
                  <c:v>24</c:v>
                </c:pt>
                <c:pt idx="33">
                  <c:v>0</c:v>
                </c:pt>
                <c:pt idx="34">
                  <c:v>3</c:v>
                </c:pt>
                <c:pt idx="35">
                  <c:v>5</c:v>
                </c:pt>
                <c:pt idx="36">
                  <c:v>8</c:v>
                </c:pt>
                <c:pt idx="37">
                  <c:v>10</c:v>
                </c:pt>
                <c:pt idx="38">
                  <c:v>12</c:v>
                </c:pt>
                <c:pt idx="39">
                  <c:v>15</c:v>
                </c:pt>
                <c:pt idx="40">
                  <c:v>17</c:v>
                </c:pt>
                <c:pt idx="41">
                  <c:v>19</c:v>
                </c:pt>
                <c:pt idx="42">
                  <c:v>22</c:v>
                </c:pt>
                <c:pt idx="43">
                  <c:v>24</c:v>
                </c:pt>
              </c:numCache>
            </c:numRef>
          </c:xVal>
          <c:yVal>
            <c:numRef>
              <c:f>'Sigmoid Emax model'!$G$47:$G$90</c:f>
              <c:numCache>
                <c:formatCode>General</c:formatCode>
                <c:ptCount val="44"/>
                <c:pt idx="0">
                  <c:v>10</c:v>
                </c:pt>
                <c:pt idx="1">
                  <c:v>8</c:v>
                </c:pt>
                <c:pt idx="2">
                  <c:v>6</c:v>
                </c:pt>
                <c:pt idx="3">
                  <c:v>8</c:v>
                </c:pt>
                <c:pt idx="4">
                  <c:v>8</c:v>
                </c:pt>
                <c:pt idx="5">
                  <c:v>10</c:v>
                </c:pt>
                <c:pt idx="6">
                  <c:v>6</c:v>
                </c:pt>
                <c:pt idx="7">
                  <c:v>8</c:v>
                </c:pt>
                <c:pt idx="8">
                  <c:v>8</c:v>
                </c:pt>
                <c:pt idx="9">
                  <c:v>6</c:v>
                </c:pt>
                <c:pt idx="10">
                  <c:v>8</c:v>
                </c:pt>
                <c:pt idx="11">
                  <c:v>10</c:v>
                </c:pt>
                <c:pt idx="12">
                  <c:v>10</c:v>
                </c:pt>
                <c:pt idx="13">
                  <c:v>8</c:v>
                </c:pt>
                <c:pt idx="14">
                  <c:v>8</c:v>
                </c:pt>
                <c:pt idx="15">
                  <c:v>8</c:v>
                </c:pt>
                <c:pt idx="16">
                  <c:v>6</c:v>
                </c:pt>
                <c:pt idx="17">
                  <c:v>8</c:v>
                </c:pt>
                <c:pt idx="18">
                  <c:v>6</c:v>
                </c:pt>
                <c:pt idx="19">
                  <c:v>6</c:v>
                </c:pt>
                <c:pt idx="20">
                  <c:v>8</c:v>
                </c:pt>
                <c:pt idx="21">
                  <c:v>8</c:v>
                </c:pt>
                <c:pt idx="22">
                  <c:v>8</c:v>
                </c:pt>
                <c:pt idx="23">
                  <c:v>6</c:v>
                </c:pt>
                <c:pt idx="24">
                  <c:v>6</c:v>
                </c:pt>
                <c:pt idx="25">
                  <c:v>6</c:v>
                </c:pt>
                <c:pt idx="26">
                  <c:v>6</c:v>
                </c:pt>
                <c:pt idx="27">
                  <c:v>6</c:v>
                </c:pt>
                <c:pt idx="28">
                  <c:v>8</c:v>
                </c:pt>
                <c:pt idx="29">
                  <c:v>6</c:v>
                </c:pt>
                <c:pt idx="30">
                  <c:v>6</c:v>
                </c:pt>
                <c:pt idx="31">
                  <c:v>8</c:v>
                </c:pt>
                <c:pt idx="32">
                  <c:v>6</c:v>
                </c:pt>
                <c:pt idx="33">
                  <c:v>8</c:v>
                </c:pt>
                <c:pt idx="34">
                  <c:v>8</c:v>
                </c:pt>
                <c:pt idx="35">
                  <c:v>8</c:v>
                </c:pt>
                <c:pt idx="36">
                  <c:v>6</c:v>
                </c:pt>
                <c:pt idx="37">
                  <c:v>6</c:v>
                </c:pt>
                <c:pt idx="38">
                  <c:v>6</c:v>
                </c:pt>
                <c:pt idx="39">
                  <c:v>8</c:v>
                </c:pt>
                <c:pt idx="40">
                  <c:v>6</c:v>
                </c:pt>
                <c:pt idx="41">
                  <c:v>10</c:v>
                </c:pt>
                <c:pt idx="42">
                  <c:v>6</c:v>
                </c:pt>
                <c:pt idx="43">
                  <c:v>1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DE0-4681-A4F4-2D91FAD7E35B}"/>
            </c:ext>
          </c:extLst>
        </c:ser>
        <c:ser>
          <c:idx val="1"/>
          <c:order val="1"/>
          <c:spPr>
            <a:ln w="31750">
              <a:solidFill>
                <a:srgbClr val="0070C0"/>
              </a:solidFill>
            </a:ln>
          </c:spPr>
          <c:marker>
            <c:symbol val="none"/>
          </c:marker>
          <c:xVal>
            <c:numRef>
              <c:f>'Sigmoid Emax model'!$C$47:$C$57</c:f>
              <c:numCache>
                <c:formatCode>General</c:formatCode>
                <c:ptCount val="11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</c:numCache>
            </c:numRef>
          </c:xVal>
          <c:yVal>
            <c:numRef>
              <c:f>'Sigmoid Emax model'!$E$47:$E$57</c:f>
              <c:numCache>
                <c:formatCode>General</c:formatCode>
                <c:ptCount val="11"/>
                <c:pt idx="0">
                  <c:v>8</c:v>
                </c:pt>
                <c:pt idx="1">
                  <c:v>7.1739199999999999</c:v>
                </c:pt>
                <c:pt idx="2">
                  <c:v>7.17455</c:v>
                </c:pt>
                <c:pt idx="3">
                  <c:v>6.3487799999999996</c:v>
                </c:pt>
                <c:pt idx="4">
                  <c:v>6.3500399999999999</c:v>
                </c:pt>
                <c:pt idx="5">
                  <c:v>6.3513000000000002</c:v>
                </c:pt>
                <c:pt idx="6">
                  <c:v>5.5264800000000003</c:v>
                </c:pt>
                <c:pt idx="7">
                  <c:v>5.5283699999999998</c:v>
                </c:pt>
                <c:pt idx="8">
                  <c:v>5.5302499999999997</c:v>
                </c:pt>
                <c:pt idx="9">
                  <c:v>4.7063699999999997</c:v>
                </c:pt>
                <c:pt idx="10">
                  <c:v>4.708879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DE0-4681-A4F4-2D91FAD7E3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1"/>
          <c:order val="0"/>
          <c:spPr>
            <a:ln w="19050">
              <a:noFill/>
            </a:ln>
          </c:spPr>
          <c:marker>
            <c:symbol val="circle"/>
            <c:size val="8"/>
            <c:spPr>
              <a:solidFill>
                <a:srgbClr val="00B050"/>
              </a:solidFill>
              <a:ln>
                <a:noFill/>
              </a:ln>
            </c:spPr>
          </c:marker>
          <c:xVal>
            <c:numRef>
              <c:f>'Sigmoid Emax model'!$C$91:$C$159</c:f>
              <c:numCache>
                <c:formatCode>General</c:formatCode>
                <c:ptCount val="69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  <c:pt idx="11">
                  <c:v>0</c:v>
                </c:pt>
                <c:pt idx="12">
                  <c:v>3</c:v>
                </c:pt>
                <c:pt idx="13">
                  <c:v>5</c:v>
                </c:pt>
                <c:pt idx="14">
                  <c:v>8</c:v>
                </c:pt>
                <c:pt idx="15">
                  <c:v>10</c:v>
                </c:pt>
                <c:pt idx="16">
                  <c:v>12</c:v>
                </c:pt>
                <c:pt idx="17">
                  <c:v>15</c:v>
                </c:pt>
                <c:pt idx="18">
                  <c:v>17</c:v>
                </c:pt>
                <c:pt idx="19">
                  <c:v>19</c:v>
                </c:pt>
                <c:pt idx="20">
                  <c:v>22</c:v>
                </c:pt>
                <c:pt idx="21">
                  <c:v>24</c:v>
                </c:pt>
                <c:pt idx="22">
                  <c:v>0</c:v>
                </c:pt>
                <c:pt idx="23">
                  <c:v>3</c:v>
                </c:pt>
                <c:pt idx="24">
                  <c:v>5</c:v>
                </c:pt>
                <c:pt idx="25">
                  <c:v>8</c:v>
                </c:pt>
                <c:pt idx="26">
                  <c:v>10</c:v>
                </c:pt>
                <c:pt idx="27">
                  <c:v>12</c:v>
                </c:pt>
                <c:pt idx="28">
                  <c:v>15</c:v>
                </c:pt>
                <c:pt idx="29">
                  <c:v>17</c:v>
                </c:pt>
                <c:pt idx="30">
                  <c:v>19</c:v>
                </c:pt>
                <c:pt idx="31">
                  <c:v>22</c:v>
                </c:pt>
                <c:pt idx="32">
                  <c:v>24</c:v>
                </c:pt>
                <c:pt idx="33">
                  <c:v>0</c:v>
                </c:pt>
                <c:pt idx="34">
                  <c:v>3</c:v>
                </c:pt>
                <c:pt idx="35">
                  <c:v>5</c:v>
                </c:pt>
                <c:pt idx="36">
                  <c:v>8</c:v>
                </c:pt>
                <c:pt idx="37">
                  <c:v>10</c:v>
                </c:pt>
                <c:pt idx="38">
                  <c:v>12</c:v>
                </c:pt>
                <c:pt idx="39">
                  <c:v>15</c:v>
                </c:pt>
                <c:pt idx="40">
                  <c:v>17</c:v>
                </c:pt>
                <c:pt idx="41">
                  <c:v>19</c:v>
                </c:pt>
                <c:pt idx="42">
                  <c:v>22</c:v>
                </c:pt>
                <c:pt idx="43">
                  <c:v>24</c:v>
                </c:pt>
                <c:pt idx="44">
                  <c:v>26</c:v>
                </c:pt>
                <c:pt idx="45">
                  <c:v>0</c:v>
                </c:pt>
                <c:pt idx="46">
                  <c:v>3</c:v>
                </c:pt>
                <c:pt idx="47">
                  <c:v>5</c:v>
                </c:pt>
                <c:pt idx="48">
                  <c:v>8</c:v>
                </c:pt>
                <c:pt idx="49">
                  <c:v>10</c:v>
                </c:pt>
                <c:pt idx="50">
                  <c:v>12</c:v>
                </c:pt>
                <c:pt idx="51">
                  <c:v>15</c:v>
                </c:pt>
                <c:pt idx="52">
                  <c:v>17</c:v>
                </c:pt>
                <c:pt idx="53">
                  <c:v>19</c:v>
                </c:pt>
                <c:pt idx="54">
                  <c:v>22</c:v>
                </c:pt>
                <c:pt idx="55">
                  <c:v>24</c:v>
                </c:pt>
                <c:pt idx="56">
                  <c:v>26</c:v>
                </c:pt>
                <c:pt idx="57">
                  <c:v>0</c:v>
                </c:pt>
                <c:pt idx="58">
                  <c:v>3</c:v>
                </c:pt>
                <c:pt idx="59">
                  <c:v>5</c:v>
                </c:pt>
                <c:pt idx="60">
                  <c:v>8</c:v>
                </c:pt>
                <c:pt idx="61">
                  <c:v>10</c:v>
                </c:pt>
                <c:pt idx="62">
                  <c:v>12</c:v>
                </c:pt>
                <c:pt idx="63">
                  <c:v>15</c:v>
                </c:pt>
                <c:pt idx="64">
                  <c:v>17</c:v>
                </c:pt>
                <c:pt idx="65">
                  <c:v>19</c:v>
                </c:pt>
                <c:pt idx="66">
                  <c:v>22</c:v>
                </c:pt>
                <c:pt idx="67">
                  <c:v>24</c:v>
                </c:pt>
                <c:pt idx="68">
                  <c:v>26</c:v>
                </c:pt>
              </c:numCache>
            </c:numRef>
          </c:xVal>
          <c:yVal>
            <c:numRef>
              <c:f>'Sigmoid Emax model'!$G$91:$G$159</c:f>
              <c:numCache>
                <c:formatCode>General</c:formatCode>
                <c:ptCount val="69"/>
                <c:pt idx="0">
                  <c:v>8</c:v>
                </c:pt>
                <c:pt idx="1">
                  <c:v>8</c:v>
                </c:pt>
                <c:pt idx="2">
                  <c:v>6</c:v>
                </c:pt>
                <c:pt idx="3">
                  <c:v>6</c:v>
                </c:pt>
                <c:pt idx="4">
                  <c:v>4</c:v>
                </c:pt>
                <c:pt idx="5">
                  <c:v>2</c:v>
                </c:pt>
                <c:pt idx="6">
                  <c:v>2</c:v>
                </c:pt>
                <c:pt idx="7">
                  <c:v>0.16</c:v>
                </c:pt>
                <c:pt idx="8">
                  <c:v>7.0000000000000007E-2</c:v>
                </c:pt>
                <c:pt idx="9">
                  <c:v>7.0000000000000007E-2</c:v>
                </c:pt>
                <c:pt idx="10">
                  <c:v>8.0000000000000002E-3</c:v>
                </c:pt>
                <c:pt idx="11">
                  <c:v>10</c:v>
                </c:pt>
                <c:pt idx="12">
                  <c:v>8</c:v>
                </c:pt>
                <c:pt idx="13">
                  <c:v>6</c:v>
                </c:pt>
                <c:pt idx="14">
                  <c:v>6</c:v>
                </c:pt>
                <c:pt idx="15">
                  <c:v>2</c:v>
                </c:pt>
                <c:pt idx="16">
                  <c:v>0.02</c:v>
                </c:pt>
                <c:pt idx="17">
                  <c:v>0.02</c:v>
                </c:pt>
                <c:pt idx="18">
                  <c:v>0.02</c:v>
                </c:pt>
                <c:pt idx="19">
                  <c:v>0.02</c:v>
                </c:pt>
                <c:pt idx="20">
                  <c:v>7.0000000000000007E-2</c:v>
                </c:pt>
                <c:pt idx="21">
                  <c:v>8.0000000000000002E-3</c:v>
                </c:pt>
                <c:pt idx="22">
                  <c:v>8</c:v>
                </c:pt>
                <c:pt idx="23">
                  <c:v>8</c:v>
                </c:pt>
                <c:pt idx="24">
                  <c:v>8</c:v>
                </c:pt>
                <c:pt idx="25">
                  <c:v>8</c:v>
                </c:pt>
                <c:pt idx="26">
                  <c:v>4</c:v>
                </c:pt>
                <c:pt idx="27">
                  <c:v>2</c:v>
                </c:pt>
                <c:pt idx="28">
                  <c:v>1.4</c:v>
                </c:pt>
                <c:pt idx="29">
                  <c:v>0.16</c:v>
                </c:pt>
                <c:pt idx="30">
                  <c:v>0.02</c:v>
                </c:pt>
                <c:pt idx="31">
                  <c:v>7.0000000000000007E-2</c:v>
                </c:pt>
                <c:pt idx="32">
                  <c:v>8.0000000000000002E-3</c:v>
                </c:pt>
                <c:pt idx="33">
                  <c:v>10</c:v>
                </c:pt>
                <c:pt idx="34">
                  <c:v>10</c:v>
                </c:pt>
                <c:pt idx="35">
                  <c:v>6</c:v>
                </c:pt>
                <c:pt idx="36">
                  <c:v>8</c:v>
                </c:pt>
                <c:pt idx="37">
                  <c:v>4</c:v>
                </c:pt>
                <c:pt idx="38">
                  <c:v>4</c:v>
                </c:pt>
                <c:pt idx="39">
                  <c:v>2</c:v>
                </c:pt>
                <c:pt idx="40">
                  <c:v>2</c:v>
                </c:pt>
                <c:pt idx="41">
                  <c:v>0.4</c:v>
                </c:pt>
                <c:pt idx="42">
                  <c:v>0.16</c:v>
                </c:pt>
                <c:pt idx="43">
                  <c:v>0.16</c:v>
                </c:pt>
                <c:pt idx="44">
                  <c:v>0.16</c:v>
                </c:pt>
                <c:pt idx="45">
                  <c:v>8</c:v>
                </c:pt>
                <c:pt idx="46">
                  <c:v>4</c:v>
                </c:pt>
                <c:pt idx="47">
                  <c:v>8</c:v>
                </c:pt>
                <c:pt idx="48">
                  <c:v>6</c:v>
                </c:pt>
                <c:pt idx="49">
                  <c:v>4</c:v>
                </c:pt>
                <c:pt idx="50">
                  <c:v>2</c:v>
                </c:pt>
                <c:pt idx="51">
                  <c:v>1.4</c:v>
                </c:pt>
                <c:pt idx="52">
                  <c:v>1</c:v>
                </c:pt>
                <c:pt idx="53">
                  <c:v>0.4</c:v>
                </c:pt>
                <c:pt idx="54">
                  <c:v>0.4</c:v>
                </c:pt>
                <c:pt idx="55">
                  <c:v>0.4</c:v>
                </c:pt>
                <c:pt idx="56">
                  <c:v>0.16</c:v>
                </c:pt>
                <c:pt idx="57">
                  <c:v>6</c:v>
                </c:pt>
                <c:pt idx="58">
                  <c:v>10</c:v>
                </c:pt>
                <c:pt idx="59">
                  <c:v>8</c:v>
                </c:pt>
                <c:pt idx="60">
                  <c:v>8</c:v>
                </c:pt>
                <c:pt idx="61">
                  <c:v>2</c:v>
                </c:pt>
                <c:pt idx="62">
                  <c:v>2</c:v>
                </c:pt>
                <c:pt idx="63">
                  <c:v>1</c:v>
                </c:pt>
                <c:pt idx="64">
                  <c:v>1</c:v>
                </c:pt>
                <c:pt idx="65">
                  <c:v>0.16</c:v>
                </c:pt>
                <c:pt idx="66">
                  <c:v>0.4</c:v>
                </c:pt>
                <c:pt idx="67">
                  <c:v>0.4</c:v>
                </c:pt>
                <c:pt idx="68">
                  <c:v>0.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935-4035-8175-62DC3D4E9321}"/>
            </c:ext>
          </c:extLst>
        </c:ser>
        <c:ser>
          <c:idx val="0"/>
          <c:order val="1"/>
          <c:spPr>
            <a:ln w="31750">
              <a:solidFill>
                <a:srgbClr val="00B050"/>
              </a:solidFill>
            </a:ln>
          </c:spPr>
          <c:marker>
            <c:symbol val="none"/>
          </c:marker>
          <c:xVal>
            <c:numRef>
              <c:f>'Sigmoid Emax model'!$C$91:$C$101</c:f>
              <c:numCache>
                <c:formatCode>General</c:formatCode>
                <c:ptCount val="11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</c:numCache>
            </c:numRef>
          </c:xVal>
          <c:yVal>
            <c:numRef>
              <c:f>'Sigmoid Emax model'!$E$91:$E$101</c:f>
              <c:numCache>
                <c:formatCode>General</c:formatCode>
                <c:ptCount val="11"/>
                <c:pt idx="0">
                  <c:v>8</c:v>
                </c:pt>
                <c:pt idx="1">
                  <c:v>6.5590200000000003</c:v>
                </c:pt>
                <c:pt idx="2">
                  <c:v>6.5601200000000004</c:v>
                </c:pt>
                <c:pt idx="3">
                  <c:v>5.1196799999999998</c:v>
                </c:pt>
                <c:pt idx="4">
                  <c:v>5.12188</c:v>
                </c:pt>
                <c:pt idx="5">
                  <c:v>5.1240800000000002</c:v>
                </c:pt>
                <c:pt idx="6">
                  <c:v>3.6852900000000002</c:v>
                </c:pt>
                <c:pt idx="7">
                  <c:v>3.68858</c:v>
                </c:pt>
                <c:pt idx="8">
                  <c:v>3.6918700000000002</c:v>
                </c:pt>
                <c:pt idx="9">
                  <c:v>2.2547199999999998</c:v>
                </c:pt>
                <c:pt idx="10">
                  <c:v>2.25911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935-4035-8175-62DC3D4E93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2"/>
          <c:order val="0"/>
          <c:spPr>
            <a:ln w="19050">
              <a:noFill/>
            </a:ln>
          </c:spPr>
          <c:marker>
            <c:symbol val="circle"/>
            <c:size val="8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'Sigmoid Emax model'!$C$160:$C$226</c:f>
              <c:numCache>
                <c:formatCode>General</c:formatCode>
                <c:ptCount val="67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0</c:v>
                </c:pt>
                <c:pt idx="11">
                  <c:v>3</c:v>
                </c:pt>
                <c:pt idx="12">
                  <c:v>5</c:v>
                </c:pt>
                <c:pt idx="13">
                  <c:v>8</c:v>
                </c:pt>
                <c:pt idx="14">
                  <c:v>10</c:v>
                </c:pt>
                <c:pt idx="15">
                  <c:v>12</c:v>
                </c:pt>
                <c:pt idx="16">
                  <c:v>15</c:v>
                </c:pt>
                <c:pt idx="17">
                  <c:v>17</c:v>
                </c:pt>
                <c:pt idx="18">
                  <c:v>19</c:v>
                </c:pt>
                <c:pt idx="19">
                  <c:v>22</c:v>
                </c:pt>
                <c:pt idx="20">
                  <c:v>0</c:v>
                </c:pt>
                <c:pt idx="21">
                  <c:v>3</c:v>
                </c:pt>
                <c:pt idx="22">
                  <c:v>5</c:v>
                </c:pt>
                <c:pt idx="23">
                  <c:v>8</c:v>
                </c:pt>
                <c:pt idx="24">
                  <c:v>10</c:v>
                </c:pt>
                <c:pt idx="25">
                  <c:v>12</c:v>
                </c:pt>
                <c:pt idx="26">
                  <c:v>15</c:v>
                </c:pt>
                <c:pt idx="27">
                  <c:v>17</c:v>
                </c:pt>
                <c:pt idx="28">
                  <c:v>0</c:v>
                </c:pt>
                <c:pt idx="29">
                  <c:v>3</c:v>
                </c:pt>
                <c:pt idx="30">
                  <c:v>5</c:v>
                </c:pt>
                <c:pt idx="31">
                  <c:v>8</c:v>
                </c:pt>
                <c:pt idx="32">
                  <c:v>10</c:v>
                </c:pt>
                <c:pt idx="33">
                  <c:v>12</c:v>
                </c:pt>
                <c:pt idx="34">
                  <c:v>15</c:v>
                </c:pt>
                <c:pt idx="35">
                  <c:v>17</c:v>
                </c:pt>
                <c:pt idx="36">
                  <c:v>0</c:v>
                </c:pt>
                <c:pt idx="37">
                  <c:v>3</c:v>
                </c:pt>
                <c:pt idx="38">
                  <c:v>5</c:v>
                </c:pt>
                <c:pt idx="39">
                  <c:v>8</c:v>
                </c:pt>
                <c:pt idx="40">
                  <c:v>10</c:v>
                </c:pt>
                <c:pt idx="41">
                  <c:v>12</c:v>
                </c:pt>
                <c:pt idx="42">
                  <c:v>15</c:v>
                </c:pt>
                <c:pt idx="43">
                  <c:v>17</c:v>
                </c:pt>
                <c:pt idx="44">
                  <c:v>19</c:v>
                </c:pt>
                <c:pt idx="45">
                  <c:v>22</c:v>
                </c:pt>
                <c:pt idx="46">
                  <c:v>0</c:v>
                </c:pt>
                <c:pt idx="47">
                  <c:v>3</c:v>
                </c:pt>
                <c:pt idx="48">
                  <c:v>5</c:v>
                </c:pt>
                <c:pt idx="49">
                  <c:v>8</c:v>
                </c:pt>
                <c:pt idx="50">
                  <c:v>10</c:v>
                </c:pt>
                <c:pt idx="51">
                  <c:v>12</c:v>
                </c:pt>
                <c:pt idx="52">
                  <c:v>15</c:v>
                </c:pt>
                <c:pt idx="53">
                  <c:v>17</c:v>
                </c:pt>
                <c:pt idx="54">
                  <c:v>19</c:v>
                </c:pt>
                <c:pt idx="55">
                  <c:v>22</c:v>
                </c:pt>
                <c:pt idx="56">
                  <c:v>0</c:v>
                </c:pt>
                <c:pt idx="57">
                  <c:v>3</c:v>
                </c:pt>
                <c:pt idx="58">
                  <c:v>5</c:v>
                </c:pt>
                <c:pt idx="59">
                  <c:v>8</c:v>
                </c:pt>
                <c:pt idx="60">
                  <c:v>10</c:v>
                </c:pt>
                <c:pt idx="61">
                  <c:v>12</c:v>
                </c:pt>
                <c:pt idx="62">
                  <c:v>15</c:v>
                </c:pt>
                <c:pt idx="63">
                  <c:v>17</c:v>
                </c:pt>
                <c:pt idx="64">
                  <c:v>19</c:v>
                </c:pt>
                <c:pt idx="65">
                  <c:v>22</c:v>
                </c:pt>
                <c:pt idx="66">
                  <c:v>22</c:v>
                </c:pt>
              </c:numCache>
            </c:numRef>
          </c:xVal>
          <c:yVal>
            <c:numRef>
              <c:f>'Sigmoid Emax model'!$G$160:$G$226</c:f>
              <c:numCache>
                <c:formatCode>General</c:formatCode>
                <c:ptCount val="67"/>
                <c:pt idx="0">
                  <c:v>8</c:v>
                </c:pt>
                <c:pt idx="1">
                  <c:v>8</c:v>
                </c:pt>
                <c:pt idx="2">
                  <c:v>6</c:v>
                </c:pt>
                <c:pt idx="3">
                  <c:v>4</c:v>
                </c:pt>
                <c:pt idx="4">
                  <c:v>2</c:v>
                </c:pt>
                <c:pt idx="5">
                  <c:v>2</c:v>
                </c:pt>
                <c:pt idx="6">
                  <c:v>1.4</c:v>
                </c:pt>
                <c:pt idx="7">
                  <c:v>1</c:v>
                </c:pt>
                <c:pt idx="8">
                  <c:v>0.02</c:v>
                </c:pt>
                <c:pt idx="9">
                  <c:v>0.02</c:v>
                </c:pt>
                <c:pt idx="10">
                  <c:v>8</c:v>
                </c:pt>
                <c:pt idx="11">
                  <c:v>8</c:v>
                </c:pt>
                <c:pt idx="12">
                  <c:v>4</c:v>
                </c:pt>
                <c:pt idx="13">
                  <c:v>4</c:v>
                </c:pt>
                <c:pt idx="14">
                  <c:v>2</c:v>
                </c:pt>
                <c:pt idx="15">
                  <c:v>1.4</c:v>
                </c:pt>
                <c:pt idx="16">
                  <c:v>0.16</c:v>
                </c:pt>
                <c:pt idx="17">
                  <c:v>0.16</c:v>
                </c:pt>
                <c:pt idx="18">
                  <c:v>0.02</c:v>
                </c:pt>
                <c:pt idx="19">
                  <c:v>0.02</c:v>
                </c:pt>
                <c:pt idx="20">
                  <c:v>6</c:v>
                </c:pt>
                <c:pt idx="21">
                  <c:v>8</c:v>
                </c:pt>
                <c:pt idx="22">
                  <c:v>6</c:v>
                </c:pt>
                <c:pt idx="23">
                  <c:v>6</c:v>
                </c:pt>
                <c:pt idx="24">
                  <c:v>1.4</c:v>
                </c:pt>
                <c:pt idx="25">
                  <c:v>2</c:v>
                </c:pt>
                <c:pt idx="26">
                  <c:v>1.4</c:v>
                </c:pt>
                <c:pt idx="27">
                  <c:v>1.4</c:v>
                </c:pt>
                <c:pt idx="28">
                  <c:v>8</c:v>
                </c:pt>
                <c:pt idx="29">
                  <c:v>8</c:v>
                </c:pt>
                <c:pt idx="30">
                  <c:v>6</c:v>
                </c:pt>
                <c:pt idx="31">
                  <c:v>6</c:v>
                </c:pt>
                <c:pt idx="32">
                  <c:v>4</c:v>
                </c:pt>
                <c:pt idx="33">
                  <c:v>1.4</c:v>
                </c:pt>
                <c:pt idx="34">
                  <c:v>1.4</c:v>
                </c:pt>
                <c:pt idx="35">
                  <c:v>1.4</c:v>
                </c:pt>
                <c:pt idx="36">
                  <c:v>10</c:v>
                </c:pt>
                <c:pt idx="37">
                  <c:v>6</c:v>
                </c:pt>
                <c:pt idx="38">
                  <c:v>10</c:v>
                </c:pt>
                <c:pt idx="39">
                  <c:v>10</c:v>
                </c:pt>
                <c:pt idx="40">
                  <c:v>1.4</c:v>
                </c:pt>
                <c:pt idx="41">
                  <c:v>1</c:v>
                </c:pt>
                <c:pt idx="42">
                  <c:v>2</c:v>
                </c:pt>
                <c:pt idx="43">
                  <c:v>0.4</c:v>
                </c:pt>
                <c:pt idx="44">
                  <c:v>0.4</c:v>
                </c:pt>
                <c:pt idx="45">
                  <c:v>0.16</c:v>
                </c:pt>
                <c:pt idx="46">
                  <c:v>8</c:v>
                </c:pt>
                <c:pt idx="47">
                  <c:v>6</c:v>
                </c:pt>
                <c:pt idx="48">
                  <c:v>6</c:v>
                </c:pt>
                <c:pt idx="49">
                  <c:v>6</c:v>
                </c:pt>
                <c:pt idx="50">
                  <c:v>4</c:v>
                </c:pt>
                <c:pt idx="51">
                  <c:v>1</c:v>
                </c:pt>
                <c:pt idx="52">
                  <c:v>1.4</c:v>
                </c:pt>
                <c:pt idx="53">
                  <c:v>0.4</c:v>
                </c:pt>
                <c:pt idx="54">
                  <c:v>0.16</c:v>
                </c:pt>
                <c:pt idx="55">
                  <c:v>7.0000000000000007E-2</c:v>
                </c:pt>
                <c:pt idx="56">
                  <c:v>8</c:v>
                </c:pt>
                <c:pt idx="57">
                  <c:v>10</c:v>
                </c:pt>
                <c:pt idx="58">
                  <c:v>4</c:v>
                </c:pt>
                <c:pt idx="59">
                  <c:v>6</c:v>
                </c:pt>
                <c:pt idx="60">
                  <c:v>1.4</c:v>
                </c:pt>
                <c:pt idx="61">
                  <c:v>1</c:v>
                </c:pt>
                <c:pt idx="62">
                  <c:v>1</c:v>
                </c:pt>
                <c:pt idx="63">
                  <c:v>0.4</c:v>
                </c:pt>
                <c:pt idx="64">
                  <c:v>0.4</c:v>
                </c:pt>
                <c:pt idx="65">
                  <c:v>0.16</c:v>
                </c:pt>
                <c:pt idx="66">
                  <c:v>2.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891-4761-B7DA-F5CD5C27C8DE}"/>
            </c:ext>
          </c:extLst>
        </c:ser>
        <c:ser>
          <c:idx val="0"/>
          <c:order val="1"/>
          <c:spPr>
            <a:ln w="31750">
              <a:solidFill>
                <a:srgbClr val="FF0000"/>
              </a:solidFill>
            </a:ln>
          </c:spPr>
          <c:marker>
            <c:symbol val="none"/>
          </c:marker>
          <c:xVal>
            <c:numRef>
              <c:f>'Sigmoid Emax model'!$C$160:$C$169</c:f>
              <c:numCache>
                <c:formatCode>General</c:formatCode>
                <c:ptCount val="10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</c:numCache>
            </c:numRef>
          </c:xVal>
          <c:yVal>
            <c:numRef>
              <c:f>'Sigmoid Emax model'!$E$160:$E$169</c:f>
              <c:numCache>
                <c:formatCode>General</c:formatCode>
                <c:ptCount val="10"/>
                <c:pt idx="0">
                  <c:v>8</c:v>
                </c:pt>
                <c:pt idx="1">
                  <c:v>5.9942799999999998</c:v>
                </c:pt>
                <c:pt idx="2">
                  <c:v>5.9958099999999996</c:v>
                </c:pt>
                <c:pt idx="3">
                  <c:v>3.9908399999999999</c:v>
                </c:pt>
                <c:pt idx="4">
                  <c:v>3.9939100000000001</c:v>
                </c:pt>
                <c:pt idx="5">
                  <c:v>3.9969700000000001</c:v>
                </c:pt>
                <c:pt idx="6">
                  <c:v>1.9942899999999999</c:v>
                </c:pt>
                <c:pt idx="7">
                  <c:v>1.99888</c:v>
                </c:pt>
                <c:pt idx="8">
                  <c:v>2.00346</c:v>
                </c:pt>
                <c:pt idx="9">
                  <c:v>8.0000000000000002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891-4761-B7DA-F5CD5C27C8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4"/>
          <c:order val="0"/>
          <c:spPr>
            <a:ln w="19050">
              <a:noFill/>
            </a:ln>
          </c:spPr>
          <c:marker>
            <c:symbol val="circle"/>
            <c:size val="8"/>
            <c:spPr>
              <a:solidFill>
                <a:schemeClr val="bg1">
                  <a:lumMod val="65000"/>
                </a:schemeClr>
              </a:solidFill>
              <a:ln w="19050">
                <a:noFill/>
              </a:ln>
            </c:spPr>
          </c:marker>
          <c:xVal>
            <c:numRef>
              <c:f>'Transit model n=1'!$C$3:$C$46</c:f>
              <c:numCache>
                <c:formatCode>General</c:formatCode>
                <c:ptCount val="44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  <c:pt idx="11">
                  <c:v>0</c:v>
                </c:pt>
                <c:pt idx="12">
                  <c:v>3</c:v>
                </c:pt>
                <c:pt idx="13">
                  <c:v>5</c:v>
                </c:pt>
                <c:pt idx="14">
                  <c:v>8</c:v>
                </c:pt>
                <c:pt idx="15">
                  <c:v>10</c:v>
                </c:pt>
                <c:pt idx="16">
                  <c:v>12</c:v>
                </c:pt>
                <c:pt idx="17">
                  <c:v>15</c:v>
                </c:pt>
                <c:pt idx="18">
                  <c:v>17</c:v>
                </c:pt>
                <c:pt idx="19">
                  <c:v>19</c:v>
                </c:pt>
                <c:pt idx="20">
                  <c:v>22</c:v>
                </c:pt>
                <c:pt idx="21">
                  <c:v>24</c:v>
                </c:pt>
                <c:pt idx="22">
                  <c:v>0</c:v>
                </c:pt>
                <c:pt idx="23">
                  <c:v>3</c:v>
                </c:pt>
                <c:pt idx="24">
                  <c:v>5</c:v>
                </c:pt>
                <c:pt idx="25">
                  <c:v>8</c:v>
                </c:pt>
                <c:pt idx="26">
                  <c:v>10</c:v>
                </c:pt>
                <c:pt idx="27">
                  <c:v>12</c:v>
                </c:pt>
                <c:pt idx="28">
                  <c:v>15</c:v>
                </c:pt>
                <c:pt idx="29">
                  <c:v>17</c:v>
                </c:pt>
                <c:pt idx="30">
                  <c:v>19</c:v>
                </c:pt>
                <c:pt idx="31">
                  <c:v>22</c:v>
                </c:pt>
                <c:pt idx="32">
                  <c:v>24</c:v>
                </c:pt>
                <c:pt idx="33">
                  <c:v>0</c:v>
                </c:pt>
                <c:pt idx="34">
                  <c:v>3</c:v>
                </c:pt>
                <c:pt idx="35">
                  <c:v>5</c:v>
                </c:pt>
                <c:pt idx="36">
                  <c:v>8</c:v>
                </c:pt>
                <c:pt idx="37">
                  <c:v>10</c:v>
                </c:pt>
                <c:pt idx="38">
                  <c:v>12</c:v>
                </c:pt>
                <c:pt idx="39">
                  <c:v>15</c:v>
                </c:pt>
                <c:pt idx="40">
                  <c:v>17</c:v>
                </c:pt>
                <c:pt idx="41">
                  <c:v>19</c:v>
                </c:pt>
                <c:pt idx="42">
                  <c:v>22</c:v>
                </c:pt>
                <c:pt idx="43">
                  <c:v>24</c:v>
                </c:pt>
              </c:numCache>
            </c:numRef>
          </c:xVal>
          <c:yVal>
            <c:numRef>
              <c:f>'Transit model n=1'!$G$3:$G$46</c:f>
              <c:numCache>
                <c:formatCode>General</c:formatCode>
                <c:ptCount val="44"/>
                <c:pt idx="0">
                  <c:v>8</c:v>
                </c:pt>
                <c:pt idx="1">
                  <c:v>8</c:v>
                </c:pt>
                <c:pt idx="2">
                  <c:v>8</c:v>
                </c:pt>
                <c:pt idx="3">
                  <c:v>8</c:v>
                </c:pt>
                <c:pt idx="4">
                  <c:v>8</c:v>
                </c:pt>
                <c:pt idx="5">
                  <c:v>10</c:v>
                </c:pt>
                <c:pt idx="6">
                  <c:v>8</c:v>
                </c:pt>
                <c:pt idx="7">
                  <c:v>8</c:v>
                </c:pt>
                <c:pt idx="8">
                  <c:v>8</c:v>
                </c:pt>
                <c:pt idx="9">
                  <c:v>8</c:v>
                </c:pt>
                <c:pt idx="10">
                  <c:v>8</c:v>
                </c:pt>
                <c:pt idx="11">
                  <c:v>10</c:v>
                </c:pt>
                <c:pt idx="12">
                  <c:v>8</c:v>
                </c:pt>
                <c:pt idx="13">
                  <c:v>8</c:v>
                </c:pt>
                <c:pt idx="14">
                  <c:v>8</c:v>
                </c:pt>
                <c:pt idx="15">
                  <c:v>8</c:v>
                </c:pt>
                <c:pt idx="16">
                  <c:v>10</c:v>
                </c:pt>
                <c:pt idx="17">
                  <c:v>8</c:v>
                </c:pt>
                <c:pt idx="18">
                  <c:v>10</c:v>
                </c:pt>
                <c:pt idx="19">
                  <c:v>8</c:v>
                </c:pt>
                <c:pt idx="20">
                  <c:v>8</c:v>
                </c:pt>
                <c:pt idx="21">
                  <c:v>8</c:v>
                </c:pt>
                <c:pt idx="22">
                  <c:v>10</c:v>
                </c:pt>
                <c:pt idx="23">
                  <c:v>6</c:v>
                </c:pt>
                <c:pt idx="24">
                  <c:v>10</c:v>
                </c:pt>
                <c:pt idx="25">
                  <c:v>8</c:v>
                </c:pt>
                <c:pt idx="26">
                  <c:v>8</c:v>
                </c:pt>
                <c:pt idx="27">
                  <c:v>8</c:v>
                </c:pt>
                <c:pt idx="28">
                  <c:v>8</c:v>
                </c:pt>
                <c:pt idx="29">
                  <c:v>8</c:v>
                </c:pt>
                <c:pt idx="30">
                  <c:v>8</c:v>
                </c:pt>
                <c:pt idx="31">
                  <c:v>8</c:v>
                </c:pt>
                <c:pt idx="32">
                  <c:v>8</c:v>
                </c:pt>
                <c:pt idx="33">
                  <c:v>8</c:v>
                </c:pt>
                <c:pt idx="34">
                  <c:v>8</c:v>
                </c:pt>
                <c:pt idx="35">
                  <c:v>8</c:v>
                </c:pt>
                <c:pt idx="36">
                  <c:v>10</c:v>
                </c:pt>
                <c:pt idx="37">
                  <c:v>6</c:v>
                </c:pt>
                <c:pt idx="38">
                  <c:v>6</c:v>
                </c:pt>
                <c:pt idx="39">
                  <c:v>8</c:v>
                </c:pt>
                <c:pt idx="40">
                  <c:v>6</c:v>
                </c:pt>
                <c:pt idx="41">
                  <c:v>8</c:v>
                </c:pt>
                <c:pt idx="42">
                  <c:v>10</c:v>
                </c:pt>
                <c:pt idx="43">
                  <c:v>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C7D-4A43-9C77-5AE0C94C746B}"/>
            </c:ext>
          </c:extLst>
        </c:ser>
        <c:ser>
          <c:idx val="5"/>
          <c:order val="1"/>
          <c:spPr>
            <a:ln w="31750">
              <a:solidFill>
                <a:schemeClr val="bg1">
                  <a:lumMod val="65000"/>
                </a:schemeClr>
              </a:solidFill>
            </a:ln>
          </c:spPr>
          <c:marker>
            <c:symbol val="none"/>
          </c:marker>
          <c:xVal>
            <c:numRef>
              <c:f>'Transit model n=1'!$C$3:$C$13</c:f>
              <c:numCache>
                <c:formatCode>General</c:formatCode>
                <c:ptCount val="11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</c:numCache>
            </c:numRef>
          </c:xVal>
          <c:yVal>
            <c:numRef>
              <c:f>'Transit model n=1'!$E$3:$E$13</c:f>
              <c:numCache>
                <c:formatCode>General</c:formatCode>
                <c:ptCount val="11"/>
                <c:pt idx="0">
                  <c:v>8</c:v>
                </c:pt>
                <c:pt idx="1">
                  <c:v>8</c:v>
                </c:pt>
                <c:pt idx="2">
                  <c:v>8</c:v>
                </c:pt>
                <c:pt idx="3">
                  <c:v>8</c:v>
                </c:pt>
                <c:pt idx="4">
                  <c:v>8</c:v>
                </c:pt>
                <c:pt idx="5">
                  <c:v>8</c:v>
                </c:pt>
                <c:pt idx="6">
                  <c:v>8</c:v>
                </c:pt>
                <c:pt idx="7">
                  <c:v>8</c:v>
                </c:pt>
                <c:pt idx="8">
                  <c:v>8</c:v>
                </c:pt>
                <c:pt idx="9">
                  <c:v>8</c:v>
                </c:pt>
                <c:pt idx="10">
                  <c:v>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C7D-4A43-9C77-5AE0C94C74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8"/>
            <c:spPr>
              <a:solidFill>
                <a:srgbClr val="0070C0"/>
              </a:solidFill>
              <a:ln>
                <a:noFill/>
              </a:ln>
            </c:spPr>
          </c:marker>
          <c:xVal>
            <c:numRef>
              <c:f>'Transit model n=1'!$C$47:$C$90</c:f>
              <c:numCache>
                <c:formatCode>General</c:formatCode>
                <c:ptCount val="44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  <c:pt idx="11">
                  <c:v>0</c:v>
                </c:pt>
                <c:pt idx="12">
                  <c:v>3</c:v>
                </c:pt>
                <c:pt idx="13">
                  <c:v>5</c:v>
                </c:pt>
                <c:pt idx="14">
                  <c:v>8</c:v>
                </c:pt>
                <c:pt idx="15">
                  <c:v>10</c:v>
                </c:pt>
                <c:pt idx="16">
                  <c:v>12</c:v>
                </c:pt>
                <c:pt idx="17">
                  <c:v>15</c:v>
                </c:pt>
                <c:pt idx="18">
                  <c:v>17</c:v>
                </c:pt>
                <c:pt idx="19">
                  <c:v>19</c:v>
                </c:pt>
                <c:pt idx="20">
                  <c:v>22</c:v>
                </c:pt>
                <c:pt idx="21">
                  <c:v>24</c:v>
                </c:pt>
                <c:pt idx="22">
                  <c:v>0</c:v>
                </c:pt>
                <c:pt idx="23">
                  <c:v>3</c:v>
                </c:pt>
                <c:pt idx="24">
                  <c:v>5</c:v>
                </c:pt>
                <c:pt idx="25">
                  <c:v>8</c:v>
                </c:pt>
                <c:pt idx="26">
                  <c:v>10</c:v>
                </c:pt>
                <c:pt idx="27">
                  <c:v>12</c:v>
                </c:pt>
                <c:pt idx="28">
                  <c:v>15</c:v>
                </c:pt>
                <c:pt idx="29">
                  <c:v>17</c:v>
                </c:pt>
                <c:pt idx="30">
                  <c:v>19</c:v>
                </c:pt>
                <c:pt idx="31">
                  <c:v>22</c:v>
                </c:pt>
                <c:pt idx="32">
                  <c:v>24</c:v>
                </c:pt>
                <c:pt idx="33">
                  <c:v>0</c:v>
                </c:pt>
                <c:pt idx="34">
                  <c:v>3</c:v>
                </c:pt>
                <c:pt idx="35">
                  <c:v>5</c:v>
                </c:pt>
                <c:pt idx="36">
                  <c:v>8</c:v>
                </c:pt>
                <c:pt idx="37">
                  <c:v>10</c:v>
                </c:pt>
                <c:pt idx="38">
                  <c:v>12</c:v>
                </c:pt>
                <c:pt idx="39">
                  <c:v>15</c:v>
                </c:pt>
                <c:pt idx="40">
                  <c:v>17</c:v>
                </c:pt>
                <c:pt idx="41">
                  <c:v>19</c:v>
                </c:pt>
                <c:pt idx="42">
                  <c:v>22</c:v>
                </c:pt>
                <c:pt idx="43">
                  <c:v>24</c:v>
                </c:pt>
              </c:numCache>
            </c:numRef>
          </c:xVal>
          <c:yVal>
            <c:numRef>
              <c:f>'Transit model n=1'!$G$47:$G$90</c:f>
              <c:numCache>
                <c:formatCode>General</c:formatCode>
                <c:ptCount val="44"/>
                <c:pt idx="0">
                  <c:v>10</c:v>
                </c:pt>
                <c:pt idx="1">
                  <c:v>8</c:v>
                </c:pt>
                <c:pt idx="2">
                  <c:v>6</c:v>
                </c:pt>
                <c:pt idx="3">
                  <c:v>8</c:v>
                </c:pt>
                <c:pt idx="4">
                  <c:v>8</c:v>
                </c:pt>
                <c:pt idx="5">
                  <c:v>10</c:v>
                </c:pt>
                <c:pt idx="6">
                  <c:v>6</c:v>
                </c:pt>
                <c:pt idx="7">
                  <c:v>8</c:v>
                </c:pt>
                <c:pt idx="8">
                  <c:v>8</c:v>
                </c:pt>
                <c:pt idx="9">
                  <c:v>6</c:v>
                </c:pt>
                <c:pt idx="10">
                  <c:v>8</c:v>
                </c:pt>
                <c:pt idx="11">
                  <c:v>10</c:v>
                </c:pt>
                <c:pt idx="12">
                  <c:v>10</c:v>
                </c:pt>
                <c:pt idx="13">
                  <c:v>8</c:v>
                </c:pt>
                <c:pt idx="14">
                  <c:v>8</c:v>
                </c:pt>
                <c:pt idx="15">
                  <c:v>8</c:v>
                </c:pt>
                <c:pt idx="16">
                  <c:v>6</c:v>
                </c:pt>
                <c:pt idx="17">
                  <c:v>8</c:v>
                </c:pt>
                <c:pt idx="18">
                  <c:v>6</c:v>
                </c:pt>
                <c:pt idx="19">
                  <c:v>6</c:v>
                </c:pt>
                <c:pt idx="20">
                  <c:v>8</c:v>
                </c:pt>
                <c:pt idx="21">
                  <c:v>8</c:v>
                </c:pt>
                <c:pt idx="22">
                  <c:v>8</c:v>
                </c:pt>
                <c:pt idx="23">
                  <c:v>6</c:v>
                </c:pt>
                <c:pt idx="24">
                  <c:v>6</c:v>
                </c:pt>
                <c:pt idx="25">
                  <c:v>6</c:v>
                </c:pt>
                <c:pt idx="26">
                  <c:v>6</c:v>
                </c:pt>
                <c:pt idx="27">
                  <c:v>6</c:v>
                </c:pt>
                <c:pt idx="28">
                  <c:v>8</c:v>
                </c:pt>
                <c:pt idx="29">
                  <c:v>6</c:v>
                </c:pt>
                <c:pt idx="30">
                  <c:v>6</c:v>
                </c:pt>
                <c:pt idx="31">
                  <c:v>8</c:v>
                </c:pt>
                <c:pt idx="32">
                  <c:v>6</c:v>
                </c:pt>
                <c:pt idx="33">
                  <c:v>8</c:v>
                </c:pt>
                <c:pt idx="34">
                  <c:v>8</c:v>
                </c:pt>
                <c:pt idx="35">
                  <c:v>8</c:v>
                </c:pt>
                <c:pt idx="36">
                  <c:v>6</c:v>
                </c:pt>
                <c:pt idx="37">
                  <c:v>6</c:v>
                </c:pt>
                <c:pt idx="38">
                  <c:v>6</c:v>
                </c:pt>
                <c:pt idx="39">
                  <c:v>8</c:v>
                </c:pt>
                <c:pt idx="40">
                  <c:v>6</c:v>
                </c:pt>
                <c:pt idx="41">
                  <c:v>10</c:v>
                </c:pt>
                <c:pt idx="42">
                  <c:v>6</c:v>
                </c:pt>
                <c:pt idx="43">
                  <c:v>1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49E-43DD-939B-277519947F7D}"/>
            </c:ext>
          </c:extLst>
        </c:ser>
        <c:ser>
          <c:idx val="1"/>
          <c:order val="1"/>
          <c:spPr>
            <a:ln w="31750">
              <a:solidFill>
                <a:srgbClr val="0070C0"/>
              </a:solidFill>
            </a:ln>
          </c:spPr>
          <c:marker>
            <c:symbol val="none"/>
          </c:marker>
          <c:xVal>
            <c:numRef>
              <c:f>'Transit model n=1'!$C$47:$C$57</c:f>
              <c:numCache>
                <c:formatCode>General</c:formatCode>
                <c:ptCount val="11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</c:numCache>
            </c:numRef>
          </c:xVal>
          <c:yVal>
            <c:numRef>
              <c:f>'Transit model n=1'!$E$47:$E$57</c:f>
              <c:numCache>
                <c:formatCode>General</c:formatCode>
                <c:ptCount val="11"/>
                <c:pt idx="0">
                  <c:v>8</c:v>
                </c:pt>
                <c:pt idx="1">
                  <c:v>7.4187500000000002</c:v>
                </c:pt>
                <c:pt idx="2">
                  <c:v>7.1814600000000004</c:v>
                </c:pt>
                <c:pt idx="3">
                  <c:v>6.7700300000000002</c:v>
                </c:pt>
                <c:pt idx="4">
                  <c:v>6.36083</c:v>
                </c:pt>
                <c:pt idx="5">
                  <c:v>6.1170200000000001</c:v>
                </c:pt>
                <c:pt idx="6">
                  <c:v>5.7490100000000002</c:v>
                </c:pt>
                <c:pt idx="7">
                  <c:v>5.39114</c:v>
                </c:pt>
                <c:pt idx="8">
                  <c:v>5.20892</c:v>
                </c:pt>
                <c:pt idx="9">
                  <c:v>4.9426399999999999</c:v>
                </c:pt>
                <c:pt idx="10">
                  <c:v>4.654169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49E-43DD-939B-277519947F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393824698951257"/>
          <c:y val="5.0925925925925923E-2"/>
          <c:w val="0.79447377017786946"/>
          <c:h val="0.74203667249927097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5"/>
            <c:spPr>
              <a:noFill/>
              <a:ln w="15875">
                <a:solidFill>
                  <a:schemeClr val="tx1"/>
                </a:solidFill>
              </a:ln>
            </c:spPr>
          </c:marker>
          <c:trendline>
            <c:spPr>
              <a:ln>
                <a:noFill/>
              </a:ln>
            </c:spPr>
            <c:trendlineType val="linear"/>
            <c:dispRSqr val="0"/>
            <c:dispEq val="0"/>
          </c:trendline>
          <c:xVal>
            <c:numRef>
              <c:f>'　PK  (Pt conc.)'!$N$78:$N$210</c:f>
              <c:numCache>
                <c:formatCode>General</c:formatCode>
                <c:ptCount val="133"/>
                <c:pt idx="0">
                  <c:v>1.70364</c:v>
                </c:pt>
                <c:pt idx="1">
                  <c:v>1.3197000000000001</c:v>
                </c:pt>
                <c:pt idx="2">
                  <c:v>0.707453</c:v>
                </c:pt>
                <c:pt idx="3">
                  <c:v>0.229042</c:v>
                </c:pt>
                <c:pt idx="4">
                  <c:v>0.10016799999999999</c:v>
                </c:pt>
                <c:pt idx="5">
                  <c:v>5.6314700000000002E-2</c:v>
                </c:pt>
                <c:pt idx="6">
                  <c:v>4.6473899999999999E-2</c:v>
                </c:pt>
                <c:pt idx="7">
                  <c:v>1.9436</c:v>
                </c:pt>
                <c:pt idx="8">
                  <c:v>1.6497599999999999</c:v>
                </c:pt>
                <c:pt idx="9">
                  <c:v>1.1329800000000001</c:v>
                </c:pt>
                <c:pt idx="10">
                  <c:v>0.614147</c:v>
                </c:pt>
                <c:pt idx="11">
                  <c:v>0.38438800000000001</c:v>
                </c:pt>
                <c:pt idx="12">
                  <c:v>0.219445</c:v>
                </c:pt>
                <c:pt idx="13">
                  <c:v>0.13373699999999999</c:v>
                </c:pt>
                <c:pt idx="14">
                  <c:v>5.1821399999999997E-2</c:v>
                </c:pt>
                <c:pt idx="15">
                  <c:v>2.0243500000000001E-2</c:v>
                </c:pt>
                <c:pt idx="16">
                  <c:v>2.70181</c:v>
                </c:pt>
                <c:pt idx="17">
                  <c:v>2.3666900000000002</c:v>
                </c:pt>
                <c:pt idx="18">
                  <c:v>1.79226</c:v>
                </c:pt>
                <c:pt idx="19">
                  <c:v>1.2419500000000001</c:v>
                </c:pt>
                <c:pt idx="20">
                  <c:v>1.00221</c:v>
                </c:pt>
                <c:pt idx="21">
                  <c:v>0.80714200000000003</c:v>
                </c:pt>
                <c:pt idx="22">
                  <c:v>0.67227700000000001</c:v>
                </c:pt>
                <c:pt idx="23">
                  <c:v>0.47307900000000003</c:v>
                </c:pt>
                <c:pt idx="24">
                  <c:v>0.33348299999999997</c:v>
                </c:pt>
                <c:pt idx="25">
                  <c:v>1.5715399999999999</c:v>
                </c:pt>
                <c:pt idx="26">
                  <c:v>1.12907</c:v>
                </c:pt>
                <c:pt idx="27">
                  <c:v>0.62575899999999995</c:v>
                </c:pt>
                <c:pt idx="28">
                  <c:v>0.410993</c:v>
                </c:pt>
                <c:pt idx="29">
                  <c:v>0.36831399999999997</c:v>
                </c:pt>
                <c:pt idx="30">
                  <c:v>0.33038800000000001</c:v>
                </c:pt>
                <c:pt idx="31">
                  <c:v>0.297541</c:v>
                </c:pt>
                <c:pt idx="32">
                  <c:v>0.24137500000000001</c:v>
                </c:pt>
                <c:pt idx="33">
                  <c:v>0.19581200000000001</c:v>
                </c:pt>
                <c:pt idx="34">
                  <c:v>2.2054999999999998</c:v>
                </c:pt>
                <c:pt idx="35">
                  <c:v>1.8057399999999999</c:v>
                </c:pt>
                <c:pt idx="36">
                  <c:v>1.1482600000000001</c:v>
                </c:pt>
                <c:pt idx="37">
                  <c:v>0.59268299999999996</c:v>
                </c:pt>
                <c:pt idx="38">
                  <c:v>0.41303699999999999</c:v>
                </c:pt>
                <c:pt idx="39">
                  <c:v>0.31988699999999998</c:v>
                </c:pt>
                <c:pt idx="40">
                  <c:v>0.27398400000000001</c:v>
                </c:pt>
                <c:pt idx="41">
                  <c:v>0.209396</c:v>
                </c:pt>
                <c:pt idx="42">
                  <c:v>0.16075700000000001</c:v>
                </c:pt>
                <c:pt idx="43">
                  <c:v>2.3843700000000001</c:v>
                </c:pt>
                <c:pt idx="44">
                  <c:v>2.00074</c:v>
                </c:pt>
                <c:pt idx="45">
                  <c:v>1.33239</c:v>
                </c:pt>
                <c:pt idx="46">
                  <c:v>0.69855299999999998</c:v>
                </c:pt>
                <c:pt idx="47">
                  <c:v>0.46140399999999998</c:v>
                </c:pt>
                <c:pt idx="48">
                  <c:v>0.32979799999999998</c:v>
                </c:pt>
                <c:pt idx="49">
                  <c:v>0.27062900000000001</c:v>
                </c:pt>
                <c:pt idx="50">
                  <c:v>0.19761600000000001</c:v>
                </c:pt>
                <c:pt idx="51">
                  <c:v>0.14616999999999999</c:v>
                </c:pt>
                <c:pt idx="52">
                  <c:v>6.01274</c:v>
                </c:pt>
                <c:pt idx="53">
                  <c:v>4.6829000000000001</c:v>
                </c:pt>
                <c:pt idx="54">
                  <c:v>2.5636100000000002</c:v>
                </c:pt>
                <c:pt idx="55">
                  <c:v>0.90144999999999997</c:v>
                </c:pt>
                <c:pt idx="56">
                  <c:v>0.43993399999999999</c:v>
                </c:pt>
                <c:pt idx="57">
                  <c:v>0.26063599999999998</c:v>
                </c:pt>
                <c:pt idx="58">
                  <c:v>0.202101</c:v>
                </c:pt>
                <c:pt idx="59">
                  <c:v>0.136992</c:v>
                </c:pt>
                <c:pt idx="60">
                  <c:v>9.4034900000000005E-2</c:v>
                </c:pt>
                <c:pt idx="61">
                  <c:v>5.9260200000000003</c:v>
                </c:pt>
                <c:pt idx="62">
                  <c:v>4.83901</c:v>
                </c:pt>
                <c:pt idx="63">
                  <c:v>2.9505599999999998</c:v>
                </c:pt>
                <c:pt idx="64">
                  <c:v>1.1890499999999999</c:v>
                </c:pt>
                <c:pt idx="65">
                  <c:v>0.57228800000000002</c:v>
                </c:pt>
                <c:pt idx="66">
                  <c:v>0.29344399999999998</c:v>
                </c:pt>
                <c:pt idx="67">
                  <c:v>0.21537800000000001</c:v>
                </c:pt>
                <c:pt idx="68">
                  <c:v>0.15595100000000001</c:v>
                </c:pt>
                <c:pt idx="69">
                  <c:v>0.118975</c:v>
                </c:pt>
                <c:pt idx="70">
                  <c:v>6.4689800000000002</c:v>
                </c:pt>
                <c:pt idx="71">
                  <c:v>5.2216199999999997</c:v>
                </c:pt>
                <c:pt idx="72">
                  <c:v>3.1076999999999999</c:v>
                </c:pt>
                <c:pt idx="73">
                  <c:v>1.23716</c:v>
                </c:pt>
                <c:pt idx="74">
                  <c:v>0.63437399999999999</c:v>
                </c:pt>
                <c:pt idx="75">
                  <c:v>0.39075900000000002</c:v>
                </c:pt>
                <c:pt idx="76">
                  <c:v>0.33333400000000002</c:v>
                </c:pt>
                <c:pt idx="77">
                  <c:v>0.29331600000000002</c:v>
                </c:pt>
                <c:pt idx="78">
                  <c:v>0.264621</c:v>
                </c:pt>
                <c:pt idx="79">
                  <c:v>8.8466100000000001</c:v>
                </c:pt>
                <c:pt idx="80">
                  <c:v>7.1737000000000002</c:v>
                </c:pt>
                <c:pt idx="81">
                  <c:v>4.3189900000000003</c:v>
                </c:pt>
                <c:pt idx="82">
                  <c:v>1.7531699999999999</c:v>
                </c:pt>
                <c:pt idx="83">
                  <c:v>0.90191299999999996</c:v>
                </c:pt>
                <c:pt idx="84">
                  <c:v>0.53769500000000003</c:v>
                </c:pt>
                <c:pt idx="85">
                  <c:v>0.43829699999999999</c:v>
                </c:pt>
                <c:pt idx="86">
                  <c:v>0.35469499999999998</c:v>
                </c:pt>
                <c:pt idx="87">
                  <c:v>0.29527500000000001</c:v>
                </c:pt>
                <c:pt idx="88">
                  <c:v>11.1021</c:v>
                </c:pt>
                <c:pt idx="89">
                  <c:v>9.0810999999999993</c:v>
                </c:pt>
                <c:pt idx="90">
                  <c:v>5.5189899999999996</c:v>
                </c:pt>
                <c:pt idx="91">
                  <c:v>2.1056699999999999</c:v>
                </c:pt>
                <c:pt idx="92">
                  <c:v>0.87828200000000001</c:v>
                </c:pt>
                <c:pt idx="93">
                  <c:v>0.33404200000000001</c:v>
                </c:pt>
                <c:pt idx="94">
                  <c:v>0.21142900000000001</c:v>
                </c:pt>
                <c:pt idx="95">
                  <c:v>0.16745399999999999</c:v>
                </c:pt>
                <c:pt idx="96">
                  <c:v>0.153226</c:v>
                </c:pt>
                <c:pt idx="97">
                  <c:v>13.1495</c:v>
                </c:pt>
                <c:pt idx="98">
                  <c:v>10.515599999999999</c:v>
                </c:pt>
                <c:pt idx="99">
                  <c:v>6.0622400000000001</c:v>
                </c:pt>
                <c:pt idx="100">
                  <c:v>2.1429</c:v>
                </c:pt>
                <c:pt idx="101">
                  <c:v>0.89327299999999998</c:v>
                </c:pt>
                <c:pt idx="102">
                  <c:v>0.40072999999999998</c:v>
                </c:pt>
                <c:pt idx="103">
                  <c:v>0.29482799999999998</c:v>
                </c:pt>
                <c:pt idx="104">
                  <c:v>0.23683100000000001</c:v>
                </c:pt>
                <c:pt idx="105">
                  <c:v>0.20160500000000001</c:v>
                </c:pt>
                <c:pt idx="106">
                  <c:v>15.3186</c:v>
                </c:pt>
                <c:pt idx="107">
                  <c:v>12.346399999999999</c:v>
                </c:pt>
                <c:pt idx="108">
                  <c:v>7.2720700000000003</c:v>
                </c:pt>
                <c:pt idx="109">
                  <c:v>2.7072099999999999</c:v>
                </c:pt>
                <c:pt idx="110">
                  <c:v>1.19235</c:v>
                </c:pt>
                <c:pt idx="111">
                  <c:v>0.54866999999999999</c:v>
                </c:pt>
                <c:pt idx="112">
                  <c:v>0.38106200000000001</c:v>
                </c:pt>
                <c:pt idx="113">
                  <c:v>0.25973299999999999</c:v>
                </c:pt>
                <c:pt idx="114">
                  <c:v>0.18767800000000001</c:v>
                </c:pt>
                <c:pt idx="115">
                  <c:v>5.9080300000000001</c:v>
                </c:pt>
                <c:pt idx="116">
                  <c:v>4.9060300000000003</c:v>
                </c:pt>
                <c:pt idx="117">
                  <c:v>3.2578499999999999</c:v>
                </c:pt>
                <c:pt idx="118">
                  <c:v>1.7947200000000001</c:v>
                </c:pt>
                <c:pt idx="119">
                  <c:v>1.21217</c:v>
                </c:pt>
                <c:pt idx="120">
                  <c:v>0.78471000000000002</c:v>
                </c:pt>
                <c:pt idx="121">
                  <c:v>0.53416799999999998</c:v>
                </c:pt>
                <c:pt idx="122">
                  <c:v>0.252774</c:v>
                </c:pt>
                <c:pt idx="123">
                  <c:v>0.119912</c:v>
                </c:pt>
                <c:pt idx="124">
                  <c:v>8.81128</c:v>
                </c:pt>
                <c:pt idx="125">
                  <c:v>7.3456599999999996</c:v>
                </c:pt>
                <c:pt idx="126">
                  <c:v>4.7553999999999998</c:v>
                </c:pt>
                <c:pt idx="127">
                  <c:v>2.24064</c:v>
                </c:pt>
                <c:pt idx="128">
                  <c:v>1.2914099999999999</c:v>
                </c:pt>
                <c:pt idx="129">
                  <c:v>0.79864400000000002</c:v>
                </c:pt>
                <c:pt idx="130">
                  <c:v>0.617456</c:v>
                </c:pt>
                <c:pt idx="131">
                  <c:v>0.43560399999999999</c:v>
                </c:pt>
                <c:pt idx="132">
                  <c:v>0.316938</c:v>
                </c:pt>
              </c:numCache>
            </c:numRef>
          </c:xVal>
          <c:yVal>
            <c:numRef>
              <c:f>'　PK  (Pt conc.)'!$O$78:$O$210</c:f>
              <c:numCache>
                <c:formatCode>General</c:formatCode>
                <c:ptCount val="133"/>
                <c:pt idx="0">
                  <c:v>1.7543599999999999</c:v>
                </c:pt>
                <c:pt idx="1">
                  <c:v>1.1293599999999999</c:v>
                </c:pt>
                <c:pt idx="2">
                  <c:v>0.88196600000000003</c:v>
                </c:pt>
                <c:pt idx="3">
                  <c:v>0.163216</c:v>
                </c:pt>
                <c:pt idx="4">
                  <c:v>0.11569</c:v>
                </c:pt>
                <c:pt idx="5">
                  <c:v>6.0351599999999998E-2</c:v>
                </c:pt>
                <c:pt idx="6">
                  <c:v>4.3424499999999998E-2</c:v>
                </c:pt>
                <c:pt idx="7">
                  <c:v>1.7413400000000001</c:v>
                </c:pt>
                <c:pt idx="8">
                  <c:v>1.63066</c:v>
                </c:pt>
                <c:pt idx="9">
                  <c:v>0.88196600000000003</c:v>
                </c:pt>
                <c:pt idx="10">
                  <c:v>0.86243499999999995</c:v>
                </c:pt>
                <c:pt idx="11">
                  <c:v>0.32858100000000001</c:v>
                </c:pt>
                <c:pt idx="12">
                  <c:v>0.26347700000000002</c:v>
                </c:pt>
                <c:pt idx="13">
                  <c:v>9.7460900000000003E-2</c:v>
                </c:pt>
                <c:pt idx="14">
                  <c:v>5.1887999999999997E-2</c:v>
                </c:pt>
                <c:pt idx="15">
                  <c:v>2.1940100000000001E-2</c:v>
                </c:pt>
                <c:pt idx="16">
                  <c:v>2.4063599999999998</c:v>
                </c:pt>
                <c:pt idx="17">
                  <c:v>2.07612</c:v>
                </c:pt>
                <c:pt idx="18">
                  <c:v>1.7343900000000001</c:v>
                </c:pt>
                <c:pt idx="19">
                  <c:v>1.33236</c:v>
                </c:pt>
                <c:pt idx="20">
                  <c:v>1.0968800000000001</c:v>
                </c:pt>
                <c:pt idx="21">
                  <c:v>0.98775800000000002</c:v>
                </c:pt>
                <c:pt idx="22">
                  <c:v>0.671875</c:v>
                </c:pt>
                <c:pt idx="23">
                  <c:v>0.470858</c:v>
                </c:pt>
                <c:pt idx="24">
                  <c:v>0.38183699999999998</c:v>
                </c:pt>
                <c:pt idx="25">
                  <c:v>1.56209</c:v>
                </c:pt>
                <c:pt idx="26">
                  <c:v>0.94755500000000004</c:v>
                </c:pt>
                <c:pt idx="27">
                  <c:v>0.56275200000000003</c:v>
                </c:pt>
                <c:pt idx="28">
                  <c:v>0.39332299999999998</c:v>
                </c:pt>
                <c:pt idx="29">
                  <c:v>0.39045200000000002</c:v>
                </c:pt>
                <c:pt idx="30">
                  <c:v>0.38183699999999998</c:v>
                </c:pt>
                <c:pt idx="31">
                  <c:v>0.36173499999999997</c:v>
                </c:pt>
                <c:pt idx="32">
                  <c:v>0.22647999999999999</c:v>
                </c:pt>
                <c:pt idx="33">
                  <c:v>0.22245899999999999</c:v>
                </c:pt>
                <c:pt idx="34">
                  <c:v>1.9848600000000001</c:v>
                </c:pt>
                <c:pt idx="35">
                  <c:v>1.9075599999999999</c:v>
                </c:pt>
                <c:pt idx="36">
                  <c:v>1.1413500000000001</c:v>
                </c:pt>
                <c:pt idx="37">
                  <c:v>0.616147</c:v>
                </c:pt>
                <c:pt idx="38">
                  <c:v>0.41152300000000003</c:v>
                </c:pt>
                <c:pt idx="39">
                  <c:v>0.37059799999999998</c:v>
                </c:pt>
                <c:pt idx="40">
                  <c:v>0.28647400000000001</c:v>
                </c:pt>
                <c:pt idx="41">
                  <c:v>0.198713</c:v>
                </c:pt>
                <c:pt idx="42">
                  <c:v>0.18416199999999999</c:v>
                </c:pt>
                <c:pt idx="43">
                  <c:v>2.4554900000000002</c:v>
                </c:pt>
                <c:pt idx="44">
                  <c:v>1.9371100000000001</c:v>
                </c:pt>
                <c:pt idx="45">
                  <c:v>1.09588</c:v>
                </c:pt>
                <c:pt idx="46">
                  <c:v>0.89125299999999996</c:v>
                </c:pt>
                <c:pt idx="47">
                  <c:v>0.377419</c:v>
                </c:pt>
                <c:pt idx="48">
                  <c:v>0.34558800000000001</c:v>
                </c:pt>
                <c:pt idx="49">
                  <c:v>0.30920999999999998</c:v>
                </c:pt>
                <c:pt idx="50">
                  <c:v>0.19780400000000001</c:v>
                </c:pt>
                <c:pt idx="51">
                  <c:v>0.15824299999999999</c:v>
                </c:pt>
                <c:pt idx="52">
                  <c:v>7.0873999999999997</c:v>
                </c:pt>
                <c:pt idx="53">
                  <c:v>4.51051</c:v>
                </c:pt>
                <c:pt idx="54">
                  <c:v>3.1206700000000001</c:v>
                </c:pt>
                <c:pt idx="55">
                  <c:v>0.62826700000000002</c:v>
                </c:pt>
                <c:pt idx="56">
                  <c:v>0.47196399999999999</c:v>
                </c:pt>
                <c:pt idx="57">
                  <c:v>0.32664399999999999</c:v>
                </c:pt>
                <c:pt idx="58">
                  <c:v>0.15682199999999999</c:v>
                </c:pt>
                <c:pt idx="59">
                  <c:v>0.13189799999999999</c:v>
                </c:pt>
                <c:pt idx="60">
                  <c:v>0.101482</c:v>
                </c:pt>
                <c:pt idx="61">
                  <c:v>8.35473</c:v>
                </c:pt>
                <c:pt idx="62">
                  <c:v>2.68133</c:v>
                </c:pt>
                <c:pt idx="63">
                  <c:v>1.3717600000000001</c:v>
                </c:pt>
                <c:pt idx="64">
                  <c:v>1.3379700000000001</c:v>
                </c:pt>
                <c:pt idx="65">
                  <c:v>0.69585799999999998</c:v>
                </c:pt>
                <c:pt idx="66">
                  <c:v>0.245535</c:v>
                </c:pt>
                <c:pt idx="67">
                  <c:v>0.22483500000000001</c:v>
                </c:pt>
                <c:pt idx="68">
                  <c:v>0.17160800000000001</c:v>
                </c:pt>
                <c:pt idx="69">
                  <c:v>0.115423</c:v>
                </c:pt>
                <c:pt idx="70">
                  <c:v>5.26959</c:v>
                </c:pt>
                <c:pt idx="71">
                  <c:v>6.3686699999999998</c:v>
                </c:pt>
                <c:pt idx="72">
                  <c:v>3.3606600000000002</c:v>
                </c:pt>
                <c:pt idx="73">
                  <c:v>1.3553200000000001</c:v>
                </c:pt>
                <c:pt idx="74">
                  <c:v>0.63995299999999999</c:v>
                </c:pt>
                <c:pt idx="75">
                  <c:v>0.30155100000000001</c:v>
                </c:pt>
                <c:pt idx="76">
                  <c:v>0.31504900000000002</c:v>
                </c:pt>
                <c:pt idx="77">
                  <c:v>0.314085</c:v>
                </c:pt>
                <c:pt idx="78">
                  <c:v>0.33529500000000001</c:v>
                </c:pt>
                <c:pt idx="79">
                  <c:v>9.4923800000000007</c:v>
                </c:pt>
                <c:pt idx="80">
                  <c:v>8.82714</c:v>
                </c:pt>
                <c:pt idx="81">
                  <c:v>4.4693800000000001</c:v>
                </c:pt>
                <c:pt idx="82">
                  <c:v>1.60599</c:v>
                </c:pt>
                <c:pt idx="83">
                  <c:v>0.953287</c:v>
                </c:pt>
                <c:pt idx="84">
                  <c:v>0.58210600000000001</c:v>
                </c:pt>
                <c:pt idx="85">
                  <c:v>0.48280299999999998</c:v>
                </c:pt>
                <c:pt idx="86">
                  <c:v>0.23502799999999999</c:v>
                </c:pt>
                <c:pt idx="87">
                  <c:v>0.35168500000000003</c:v>
                </c:pt>
                <c:pt idx="88">
                  <c:v>11.5932</c:v>
                </c:pt>
                <c:pt idx="89">
                  <c:v>8.7101299999999995</c:v>
                </c:pt>
                <c:pt idx="90">
                  <c:v>5.7202999999999999</c:v>
                </c:pt>
                <c:pt idx="91">
                  <c:v>2.9867499999999998</c:v>
                </c:pt>
                <c:pt idx="92">
                  <c:v>0.68565299999999996</c:v>
                </c:pt>
                <c:pt idx="93">
                  <c:v>0.32100099999999998</c:v>
                </c:pt>
                <c:pt idx="94">
                  <c:v>0.165103</c:v>
                </c:pt>
                <c:pt idx="95">
                  <c:v>0.18912799999999999</c:v>
                </c:pt>
                <c:pt idx="96">
                  <c:v>0.16883999999999999</c:v>
                </c:pt>
                <c:pt idx="97">
                  <c:v>16.5761</c:v>
                </c:pt>
                <c:pt idx="98">
                  <c:v>11.2906</c:v>
                </c:pt>
                <c:pt idx="99">
                  <c:v>5.6312499999999996</c:v>
                </c:pt>
                <c:pt idx="100">
                  <c:v>2.31575</c:v>
                </c:pt>
                <c:pt idx="101">
                  <c:v>0.90092000000000005</c:v>
                </c:pt>
                <c:pt idx="102">
                  <c:v>0.44070100000000001</c:v>
                </c:pt>
                <c:pt idx="103">
                  <c:v>0.291209</c:v>
                </c:pt>
                <c:pt idx="104">
                  <c:v>0.23515</c:v>
                </c:pt>
                <c:pt idx="105">
                  <c:v>0.21005699999999999</c:v>
                </c:pt>
                <c:pt idx="106">
                  <c:v>18.402799999999999</c:v>
                </c:pt>
                <c:pt idx="107">
                  <c:v>15.124700000000001</c:v>
                </c:pt>
                <c:pt idx="108">
                  <c:v>5.8883000000000001</c:v>
                </c:pt>
                <c:pt idx="109">
                  <c:v>2.99458</c:v>
                </c:pt>
                <c:pt idx="110">
                  <c:v>1.2594099999999999</c:v>
                </c:pt>
                <c:pt idx="111">
                  <c:v>0.57602200000000003</c:v>
                </c:pt>
                <c:pt idx="112">
                  <c:v>0.38862400000000002</c:v>
                </c:pt>
                <c:pt idx="113">
                  <c:v>0.25781900000000002</c:v>
                </c:pt>
                <c:pt idx="114">
                  <c:v>0.188413</c:v>
                </c:pt>
                <c:pt idx="115">
                  <c:v>5.8623200000000004</c:v>
                </c:pt>
                <c:pt idx="116">
                  <c:v>5.1441699999999999</c:v>
                </c:pt>
                <c:pt idx="117">
                  <c:v>3.0150600000000001</c:v>
                </c:pt>
                <c:pt idx="118">
                  <c:v>1.8280000000000001</c:v>
                </c:pt>
                <c:pt idx="119">
                  <c:v>1.3717600000000001</c:v>
                </c:pt>
                <c:pt idx="120">
                  <c:v>0.80146799999999996</c:v>
                </c:pt>
                <c:pt idx="121">
                  <c:v>0.66206299999999996</c:v>
                </c:pt>
                <c:pt idx="122">
                  <c:v>0.14541599999999999</c:v>
                </c:pt>
                <c:pt idx="123">
                  <c:v>0.13400999999999999</c:v>
                </c:pt>
                <c:pt idx="124">
                  <c:v>2.1359599999999999</c:v>
                </c:pt>
                <c:pt idx="125">
                  <c:v>9.4061199999999996</c:v>
                </c:pt>
                <c:pt idx="126">
                  <c:v>4.3918499999999998</c:v>
                </c:pt>
                <c:pt idx="127">
                  <c:v>2.7132999999999998</c:v>
                </c:pt>
                <c:pt idx="128">
                  <c:v>0.94921599999999995</c:v>
                </c:pt>
                <c:pt idx="129">
                  <c:v>0.92783300000000002</c:v>
                </c:pt>
                <c:pt idx="130">
                  <c:v>0.63168100000000005</c:v>
                </c:pt>
                <c:pt idx="131">
                  <c:v>0.45206499999999999</c:v>
                </c:pt>
                <c:pt idx="132">
                  <c:v>0.326975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8E0-407D-8637-8E149FC2F350}"/>
            </c:ext>
          </c:extLst>
        </c:ser>
        <c:ser>
          <c:idx val="1"/>
          <c:order val="1"/>
          <c:spPr>
            <a:ln w="19050">
              <a:noFill/>
            </a:ln>
          </c:spPr>
          <c:marker>
            <c:symbol val="none"/>
          </c:marker>
          <c:trendline>
            <c:trendlineType val="linear"/>
            <c:dispRSqr val="0"/>
            <c:dispEq val="0"/>
          </c:trendline>
          <c:xVal>
            <c:numRef>
              <c:f>'　PK  (Pt conc.)'!$AI$39:$AJ$39</c:f>
              <c:numCache>
                <c:formatCode>General</c:formatCode>
                <c:ptCount val="2"/>
                <c:pt idx="0">
                  <c:v>0.01</c:v>
                </c:pt>
                <c:pt idx="1">
                  <c:v>100</c:v>
                </c:pt>
              </c:numCache>
            </c:numRef>
          </c:xVal>
          <c:yVal>
            <c:numRef>
              <c:f>'　PK  (Pt conc.)'!$AI$40:$AJ$40</c:f>
              <c:numCache>
                <c:formatCode>General</c:formatCode>
                <c:ptCount val="2"/>
                <c:pt idx="0">
                  <c:v>0.01</c:v>
                </c:pt>
                <c:pt idx="1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8E0-407D-8637-8E149FC2F3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94380176"/>
        <c:axId val="1794385072"/>
      </c:scatterChart>
      <c:valAx>
        <c:axId val="1794380176"/>
        <c:scaling>
          <c:logBase val="10"/>
          <c:orientation val="minMax"/>
          <c:max val="100"/>
          <c:min val="1.0000000000000002E-2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794385072"/>
        <c:crossesAt val="1.0000000000000002E-2"/>
        <c:crossBetween val="midCat"/>
      </c:valAx>
      <c:valAx>
        <c:axId val="1794385072"/>
        <c:scaling>
          <c:logBase val="10"/>
          <c:orientation val="minMax"/>
          <c:max val="100"/>
          <c:min val="1.0000000000000002E-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794380176"/>
        <c:crossesAt val="1.0000000000000002E-2"/>
        <c:crossBetween val="midCat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1"/>
          <c:order val="0"/>
          <c:spPr>
            <a:ln w="19050">
              <a:noFill/>
            </a:ln>
          </c:spPr>
          <c:marker>
            <c:symbol val="circle"/>
            <c:size val="8"/>
            <c:spPr>
              <a:solidFill>
                <a:srgbClr val="00B050"/>
              </a:solidFill>
              <a:ln>
                <a:noFill/>
              </a:ln>
            </c:spPr>
          </c:marker>
          <c:xVal>
            <c:numRef>
              <c:f>'Transit model n=1'!$C$91:$C$159</c:f>
              <c:numCache>
                <c:formatCode>General</c:formatCode>
                <c:ptCount val="69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  <c:pt idx="11">
                  <c:v>0</c:v>
                </c:pt>
                <c:pt idx="12">
                  <c:v>3</c:v>
                </c:pt>
                <c:pt idx="13">
                  <c:v>5</c:v>
                </c:pt>
                <c:pt idx="14">
                  <c:v>8</c:v>
                </c:pt>
                <c:pt idx="15">
                  <c:v>10</c:v>
                </c:pt>
                <c:pt idx="16">
                  <c:v>12</c:v>
                </c:pt>
                <c:pt idx="17">
                  <c:v>15</c:v>
                </c:pt>
                <c:pt idx="18">
                  <c:v>17</c:v>
                </c:pt>
                <c:pt idx="19">
                  <c:v>19</c:v>
                </c:pt>
                <c:pt idx="20">
                  <c:v>22</c:v>
                </c:pt>
                <c:pt idx="21">
                  <c:v>24</c:v>
                </c:pt>
                <c:pt idx="22">
                  <c:v>0</c:v>
                </c:pt>
                <c:pt idx="23">
                  <c:v>3</c:v>
                </c:pt>
                <c:pt idx="24">
                  <c:v>5</c:v>
                </c:pt>
                <c:pt idx="25">
                  <c:v>8</c:v>
                </c:pt>
                <c:pt idx="26">
                  <c:v>10</c:v>
                </c:pt>
                <c:pt idx="27">
                  <c:v>12</c:v>
                </c:pt>
                <c:pt idx="28">
                  <c:v>15</c:v>
                </c:pt>
                <c:pt idx="29">
                  <c:v>17</c:v>
                </c:pt>
                <c:pt idx="30">
                  <c:v>19</c:v>
                </c:pt>
                <c:pt idx="31">
                  <c:v>22</c:v>
                </c:pt>
                <c:pt idx="32">
                  <c:v>24</c:v>
                </c:pt>
                <c:pt idx="33">
                  <c:v>0</c:v>
                </c:pt>
                <c:pt idx="34">
                  <c:v>3</c:v>
                </c:pt>
                <c:pt idx="35">
                  <c:v>5</c:v>
                </c:pt>
                <c:pt idx="36">
                  <c:v>8</c:v>
                </c:pt>
                <c:pt idx="37">
                  <c:v>10</c:v>
                </c:pt>
                <c:pt idx="38">
                  <c:v>12</c:v>
                </c:pt>
                <c:pt idx="39">
                  <c:v>15</c:v>
                </c:pt>
                <c:pt idx="40">
                  <c:v>17</c:v>
                </c:pt>
                <c:pt idx="41">
                  <c:v>19</c:v>
                </c:pt>
                <c:pt idx="42">
                  <c:v>22</c:v>
                </c:pt>
                <c:pt idx="43">
                  <c:v>24</c:v>
                </c:pt>
                <c:pt idx="44">
                  <c:v>26</c:v>
                </c:pt>
                <c:pt idx="45">
                  <c:v>0</c:v>
                </c:pt>
                <c:pt idx="46">
                  <c:v>3</c:v>
                </c:pt>
                <c:pt idx="47">
                  <c:v>5</c:v>
                </c:pt>
                <c:pt idx="48">
                  <c:v>8</c:v>
                </c:pt>
                <c:pt idx="49">
                  <c:v>10</c:v>
                </c:pt>
                <c:pt idx="50">
                  <c:v>12</c:v>
                </c:pt>
                <c:pt idx="51">
                  <c:v>15</c:v>
                </c:pt>
                <c:pt idx="52">
                  <c:v>17</c:v>
                </c:pt>
                <c:pt idx="53">
                  <c:v>19</c:v>
                </c:pt>
                <c:pt idx="54">
                  <c:v>22</c:v>
                </c:pt>
                <c:pt idx="55">
                  <c:v>24</c:v>
                </c:pt>
                <c:pt idx="56">
                  <c:v>26</c:v>
                </c:pt>
                <c:pt idx="57">
                  <c:v>0</c:v>
                </c:pt>
                <c:pt idx="58">
                  <c:v>3</c:v>
                </c:pt>
                <c:pt idx="59">
                  <c:v>5</c:v>
                </c:pt>
                <c:pt idx="60">
                  <c:v>8</c:v>
                </c:pt>
                <c:pt idx="61">
                  <c:v>10</c:v>
                </c:pt>
                <c:pt idx="62">
                  <c:v>12</c:v>
                </c:pt>
                <c:pt idx="63">
                  <c:v>15</c:v>
                </c:pt>
                <c:pt idx="64">
                  <c:v>17</c:v>
                </c:pt>
                <c:pt idx="65">
                  <c:v>19</c:v>
                </c:pt>
                <c:pt idx="66">
                  <c:v>22</c:v>
                </c:pt>
                <c:pt idx="67">
                  <c:v>24</c:v>
                </c:pt>
                <c:pt idx="68">
                  <c:v>26</c:v>
                </c:pt>
              </c:numCache>
            </c:numRef>
          </c:xVal>
          <c:yVal>
            <c:numRef>
              <c:f>'Transit model n=1'!$G$91:$G$159</c:f>
              <c:numCache>
                <c:formatCode>General</c:formatCode>
                <c:ptCount val="69"/>
                <c:pt idx="0">
                  <c:v>8</c:v>
                </c:pt>
                <c:pt idx="1">
                  <c:v>8</c:v>
                </c:pt>
                <c:pt idx="2">
                  <c:v>6</c:v>
                </c:pt>
                <c:pt idx="3">
                  <c:v>6</c:v>
                </c:pt>
                <c:pt idx="4">
                  <c:v>4</c:v>
                </c:pt>
                <c:pt idx="5">
                  <c:v>2</c:v>
                </c:pt>
                <c:pt idx="6">
                  <c:v>2</c:v>
                </c:pt>
                <c:pt idx="7">
                  <c:v>0.16</c:v>
                </c:pt>
                <c:pt idx="8">
                  <c:v>7.0000000000000007E-2</c:v>
                </c:pt>
                <c:pt idx="9">
                  <c:v>7.0000000000000007E-2</c:v>
                </c:pt>
                <c:pt idx="10">
                  <c:v>8.0000000000000002E-3</c:v>
                </c:pt>
                <c:pt idx="11">
                  <c:v>10</c:v>
                </c:pt>
                <c:pt idx="12">
                  <c:v>8</c:v>
                </c:pt>
                <c:pt idx="13">
                  <c:v>6</c:v>
                </c:pt>
                <c:pt idx="14">
                  <c:v>6</c:v>
                </c:pt>
                <c:pt idx="15">
                  <c:v>2</c:v>
                </c:pt>
                <c:pt idx="16">
                  <c:v>0.02</c:v>
                </c:pt>
                <c:pt idx="17">
                  <c:v>0.02</c:v>
                </c:pt>
                <c:pt idx="18">
                  <c:v>0.02</c:v>
                </c:pt>
                <c:pt idx="19">
                  <c:v>0.02</c:v>
                </c:pt>
                <c:pt idx="20">
                  <c:v>7.0000000000000007E-2</c:v>
                </c:pt>
                <c:pt idx="21">
                  <c:v>8.0000000000000002E-3</c:v>
                </c:pt>
                <c:pt idx="22">
                  <c:v>8</c:v>
                </c:pt>
                <c:pt idx="23">
                  <c:v>8</c:v>
                </c:pt>
                <c:pt idx="24">
                  <c:v>8</c:v>
                </c:pt>
                <c:pt idx="25">
                  <c:v>8</c:v>
                </c:pt>
                <c:pt idx="26">
                  <c:v>4</c:v>
                </c:pt>
                <c:pt idx="27">
                  <c:v>2</c:v>
                </c:pt>
                <c:pt idx="28">
                  <c:v>1.4</c:v>
                </c:pt>
                <c:pt idx="29">
                  <c:v>0.16</c:v>
                </c:pt>
                <c:pt idx="30">
                  <c:v>0.02</c:v>
                </c:pt>
                <c:pt idx="31">
                  <c:v>7.0000000000000007E-2</c:v>
                </c:pt>
                <c:pt idx="32">
                  <c:v>8.0000000000000002E-3</c:v>
                </c:pt>
                <c:pt idx="33">
                  <c:v>10</c:v>
                </c:pt>
                <c:pt idx="34">
                  <c:v>10</c:v>
                </c:pt>
                <c:pt idx="35">
                  <c:v>6</c:v>
                </c:pt>
                <c:pt idx="36">
                  <c:v>8</c:v>
                </c:pt>
                <c:pt idx="37">
                  <c:v>4</c:v>
                </c:pt>
                <c:pt idx="38">
                  <c:v>4</c:v>
                </c:pt>
                <c:pt idx="39">
                  <c:v>2</c:v>
                </c:pt>
                <c:pt idx="40">
                  <c:v>2</c:v>
                </c:pt>
                <c:pt idx="41">
                  <c:v>0.4</c:v>
                </c:pt>
                <c:pt idx="42">
                  <c:v>0.16</c:v>
                </c:pt>
                <c:pt idx="43">
                  <c:v>0.16</c:v>
                </c:pt>
                <c:pt idx="44">
                  <c:v>0.16</c:v>
                </c:pt>
                <c:pt idx="45">
                  <c:v>8</c:v>
                </c:pt>
                <c:pt idx="46">
                  <c:v>4</c:v>
                </c:pt>
                <c:pt idx="47">
                  <c:v>8</c:v>
                </c:pt>
                <c:pt idx="48">
                  <c:v>6</c:v>
                </c:pt>
                <c:pt idx="49">
                  <c:v>4</c:v>
                </c:pt>
                <c:pt idx="50">
                  <c:v>2</c:v>
                </c:pt>
                <c:pt idx="51">
                  <c:v>1.4</c:v>
                </c:pt>
                <c:pt idx="52">
                  <c:v>1</c:v>
                </c:pt>
                <c:pt idx="53">
                  <c:v>0.4</c:v>
                </c:pt>
                <c:pt idx="54">
                  <c:v>0.4</c:v>
                </c:pt>
                <c:pt idx="55">
                  <c:v>0.4</c:v>
                </c:pt>
                <c:pt idx="56">
                  <c:v>0.16</c:v>
                </c:pt>
                <c:pt idx="57">
                  <c:v>6</c:v>
                </c:pt>
                <c:pt idx="58">
                  <c:v>10</c:v>
                </c:pt>
                <c:pt idx="59">
                  <c:v>8</c:v>
                </c:pt>
                <c:pt idx="60">
                  <c:v>8</c:v>
                </c:pt>
                <c:pt idx="61">
                  <c:v>2</c:v>
                </c:pt>
                <c:pt idx="62">
                  <c:v>2</c:v>
                </c:pt>
                <c:pt idx="63">
                  <c:v>1</c:v>
                </c:pt>
                <c:pt idx="64">
                  <c:v>1</c:v>
                </c:pt>
                <c:pt idx="65">
                  <c:v>0.16</c:v>
                </c:pt>
                <c:pt idx="66">
                  <c:v>0.4</c:v>
                </c:pt>
                <c:pt idx="67">
                  <c:v>0.4</c:v>
                </c:pt>
                <c:pt idx="68">
                  <c:v>0.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C0D-45DB-B94B-D56190C30439}"/>
            </c:ext>
          </c:extLst>
        </c:ser>
        <c:ser>
          <c:idx val="0"/>
          <c:order val="1"/>
          <c:spPr>
            <a:ln w="31750">
              <a:solidFill>
                <a:srgbClr val="00B050"/>
              </a:solidFill>
            </a:ln>
          </c:spPr>
          <c:marker>
            <c:symbol val="none"/>
          </c:marker>
          <c:xVal>
            <c:numRef>
              <c:f>'Transit model n=1'!$C$91:$C$101</c:f>
              <c:numCache>
                <c:formatCode>General</c:formatCode>
                <c:ptCount val="11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</c:numCache>
            </c:numRef>
          </c:xVal>
          <c:yVal>
            <c:numRef>
              <c:f>'Transit model n=1'!$E$91:$E$101</c:f>
              <c:numCache>
                <c:formatCode>General</c:formatCode>
                <c:ptCount val="11"/>
                <c:pt idx="0">
                  <c:v>8</c:v>
                </c:pt>
                <c:pt idx="1">
                  <c:v>6.9940600000000002</c:v>
                </c:pt>
                <c:pt idx="2">
                  <c:v>6.5787300000000002</c:v>
                </c:pt>
                <c:pt idx="3">
                  <c:v>5.8690600000000002</c:v>
                </c:pt>
                <c:pt idx="4">
                  <c:v>5.1526800000000001</c:v>
                </c:pt>
                <c:pt idx="5">
                  <c:v>4.7252400000000003</c:v>
                </c:pt>
                <c:pt idx="6">
                  <c:v>4.0904800000000003</c:v>
                </c:pt>
                <c:pt idx="7">
                  <c:v>3.46319</c:v>
                </c:pt>
                <c:pt idx="8">
                  <c:v>3.1428400000000001</c:v>
                </c:pt>
                <c:pt idx="9">
                  <c:v>2.6850999999999998</c:v>
                </c:pt>
                <c:pt idx="10">
                  <c:v>2.17865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C0D-45DB-B94B-D56190C304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2"/>
          <c:order val="0"/>
          <c:spPr>
            <a:ln w="19050">
              <a:noFill/>
            </a:ln>
          </c:spPr>
          <c:marker>
            <c:symbol val="circle"/>
            <c:size val="8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'Transit model n=1'!$C$160:$C$226</c:f>
              <c:numCache>
                <c:formatCode>General</c:formatCode>
                <c:ptCount val="67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0</c:v>
                </c:pt>
                <c:pt idx="11">
                  <c:v>3</c:v>
                </c:pt>
                <c:pt idx="12">
                  <c:v>5</c:v>
                </c:pt>
                <c:pt idx="13">
                  <c:v>8</c:v>
                </c:pt>
                <c:pt idx="14">
                  <c:v>10</c:v>
                </c:pt>
                <c:pt idx="15">
                  <c:v>12</c:v>
                </c:pt>
                <c:pt idx="16">
                  <c:v>15</c:v>
                </c:pt>
                <c:pt idx="17">
                  <c:v>17</c:v>
                </c:pt>
                <c:pt idx="18">
                  <c:v>19</c:v>
                </c:pt>
                <c:pt idx="19">
                  <c:v>22</c:v>
                </c:pt>
                <c:pt idx="20">
                  <c:v>0</c:v>
                </c:pt>
                <c:pt idx="21">
                  <c:v>3</c:v>
                </c:pt>
                <c:pt idx="22">
                  <c:v>5</c:v>
                </c:pt>
                <c:pt idx="23">
                  <c:v>8</c:v>
                </c:pt>
                <c:pt idx="24">
                  <c:v>10</c:v>
                </c:pt>
                <c:pt idx="25">
                  <c:v>12</c:v>
                </c:pt>
                <c:pt idx="26">
                  <c:v>15</c:v>
                </c:pt>
                <c:pt idx="27">
                  <c:v>17</c:v>
                </c:pt>
                <c:pt idx="28">
                  <c:v>0</c:v>
                </c:pt>
                <c:pt idx="29">
                  <c:v>3</c:v>
                </c:pt>
                <c:pt idx="30">
                  <c:v>5</c:v>
                </c:pt>
                <c:pt idx="31">
                  <c:v>8</c:v>
                </c:pt>
                <c:pt idx="32">
                  <c:v>10</c:v>
                </c:pt>
                <c:pt idx="33">
                  <c:v>12</c:v>
                </c:pt>
                <c:pt idx="34">
                  <c:v>15</c:v>
                </c:pt>
                <c:pt idx="35">
                  <c:v>17</c:v>
                </c:pt>
                <c:pt idx="36">
                  <c:v>0</c:v>
                </c:pt>
                <c:pt idx="37">
                  <c:v>3</c:v>
                </c:pt>
                <c:pt idx="38">
                  <c:v>5</c:v>
                </c:pt>
                <c:pt idx="39">
                  <c:v>8</c:v>
                </c:pt>
                <c:pt idx="40">
                  <c:v>10</c:v>
                </c:pt>
                <c:pt idx="41">
                  <c:v>12</c:v>
                </c:pt>
                <c:pt idx="42">
                  <c:v>15</c:v>
                </c:pt>
                <c:pt idx="43">
                  <c:v>17</c:v>
                </c:pt>
                <c:pt idx="44">
                  <c:v>19</c:v>
                </c:pt>
                <c:pt idx="45">
                  <c:v>22</c:v>
                </c:pt>
                <c:pt idx="46">
                  <c:v>0</c:v>
                </c:pt>
                <c:pt idx="47">
                  <c:v>3</c:v>
                </c:pt>
                <c:pt idx="48">
                  <c:v>5</c:v>
                </c:pt>
                <c:pt idx="49">
                  <c:v>8</c:v>
                </c:pt>
                <c:pt idx="50">
                  <c:v>10</c:v>
                </c:pt>
                <c:pt idx="51">
                  <c:v>12</c:v>
                </c:pt>
                <c:pt idx="52">
                  <c:v>15</c:v>
                </c:pt>
                <c:pt idx="53">
                  <c:v>17</c:v>
                </c:pt>
                <c:pt idx="54">
                  <c:v>19</c:v>
                </c:pt>
                <c:pt idx="55">
                  <c:v>22</c:v>
                </c:pt>
                <c:pt idx="56">
                  <c:v>0</c:v>
                </c:pt>
                <c:pt idx="57">
                  <c:v>3</c:v>
                </c:pt>
                <c:pt idx="58">
                  <c:v>5</c:v>
                </c:pt>
                <c:pt idx="59">
                  <c:v>8</c:v>
                </c:pt>
                <c:pt idx="60">
                  <c:v>10</c:v>
                </c:pt>
                <c:pt idx="61">
                  <c:v>12</c:v>
                </c:pt>
                <c:pt idx="62">
                  <c:v>15</c:v>
                </c:pt>
                <c:pt idx="63">
                  <c:v>17</c:v>
                </c:pt>
                <c:pt idx="64">
                  <c:v>19</c:v>
                </c:pt>
                <c:pt idx="65">
                  <c:v>22</c:v>
                </c:pt>
                <c:pt idx="66">
                  <c:v>22</c:v>
                </c:pt>
              </c:numCache>
            </c:numRef>
          </c:xVal>
          <c:yVal>
            <c:numRef>
              <c:f>'Transit model n=1'!$G$160:$G$226</c:f>
              <c:numCache>
                <c:formatCode>General</c:formatCode>
                <c:ptCount val="67"/>
                <c:pt idx="0">
                  <c:v>8</c:v>
                </c:pt>
                <c:pt idx="1">
                  <c:v>8</c:v>
                </c:pt>
                <c:pt idx="2">
                  <c:v>6</c:v>
                </c:pt>
                <c:pt idx="3">
                  <c:v>4</c:v>
                </c:pt>
                <c:pt idx="4">
                  <c:v>2</c:v>
                </c:pt>
                <c:pt idx="5">
                  <c:v>2</c:v>
                </c:pt>
                <c:pt idx="6">
                  <c:v>1.4</c:v>
                </c:pt>
                <c:pt idx="7">
                  <c:v>1</c:v>
                </c:pt>
                <c:pt idx="8">
                  <c:v>0.02</c:v>
                </c:pt>
                <c:pt idx="9">
                  <c:v>0.02</c:v>
                </c:pt>
                <c:pt idx="10">
                  <c:v>8</c:v>
                </c:pt>
                <c:pt idx="11">
                  <c:v>8</c:v>
                </c:pt>
                <c:pt idx="12">
                  <c:v>4</c:v>
                </c:pt>
                <c:pt idx="13">
                  <c:v>4</c:v>
                </c:pt>
                <c:pt idx="14">
                  <c:v>2</c:v>
                </c:pt>
                <c:pt idx="15">
                  <c:v>1.4</c:v>
                </c:pt>
                <c:pt idx="16">
                  <c:v>0.16</c:v>
                </c:pt>
                <c:pt idx="17">
                  <c:v>0.16</c:v>
                </c:pt>
                <c:pt idx="18">
                  <c:v>0.02</c:v>
                </c:pt>
                <c:pt idx="19">
                  <c:v>0.02</c:v>
                </c:pt>
                <c:pt idx="20">
                  <c:v>6</c:v>
                </c:pt>
                <c:pt idx="21">
                  <c:v>8</c:v>
                </c:pt>
                <c:pt idx="22">
                  <c:v>6</c:v>
                </c:pt>
                <c:pt idx="23">
                  <c:v>6</c:v>
                </c:pt>
                <c:pt idx="24">
                  <c:v>1.4</c:v>
                </c:pt>
                <c:pt idx="25">
                  <c:v>2</c:v>
                </c:pt>
                <c:pt idx="26">
                  <c:v>1.4</c:v>
                </c:pt>
                <c:pt idx="27">
                  <c:v>1.4</c:v>
                </c:pt>
                <c:pt idx="28">
                  <c:v>8</c:v>
                </c:pt>
                <c:pt idx="29">
                  <c:v>8</c:v>
                </c:pt>
                <c:pt idx="30">
                  <c:v>6</c:v>
                </c:pt>
                <c:pt idx="31">
                  <c:v>6</c:v>
                </c:pt>
                <c:pt idx="32">
                  <c:v>4</c:v>
                </c:pt>
                <c:pt idx="33">
                  <c:v>1.4</c:v>
                </c:pt>
                <c:pt idx="34">
                  <c:v>1.4</c:v>
                </c:pt>
                <c:pt idx="35">
                  <c:v>1.4</c:v>
                </c:pt>
                <c:pt idx="36">
                  <c:v>10</c:v>
                </c:pt>
                <c:pt idx="37">
                  <c:v>6</c:v>
                </c:pt>
                <c:pt idx="38">
                  <c:v>10</c:v>
                </c:pt>
                <c:pt idx="39">
                  <c:v>10</c:v>
                </c:pt>
                <c:pt idx="40">
                  <c:v>1.4</c:v>
                </c:pt>
                <c:pt idx="41">
                  <c:v>1</c:v>
                </c:pt>
                <c:pt idx="42">
                  <c:v>2</c:v>
                </c:pt>
                <c:pt idx="43">
                  <c:v>0.4</c:v>
                </c:pt>
                <c:pt idx="44">
                  <c:v>0.4</c:v>
                </c:pt>
                <c:pt idx="45">
                  <c:v>0.16</c:v>
                </c:pt>
                <c:pt idx="46">
                  <c:v>8</c:v>
                </c:pt>
                <c:pt idx="47">
                  <c:v>6</c:v>
                </c:pt>
                <c:pt idx="48">
                  <c:v>6</c:v>
                </c:pt>
                <c:pt idx="49">
                  <c:v>6</c:v>
                </c:pt>
                <c:pt idx="50">
                  <c:v>4</c:v>
                </c:pt>
                <c:pt idx="51">
                  <c:v>1</c:v>
                </c:pt>
                <c:pt idx="52">
                  <c:v>1.4</c:v>
                </c:pt>
                <c:pt idx="53">
                  <c:v>0.4</c:v>
                </c:pt>
                <c:pt idx="54">
                  <c:v>0.16</c:v>
                </c:pt>
                <c:pt idx="55">
                  <c:v>7.0000000000000007E-2</c:v>
                </c:pt>
                <c:pt idx="56">
                  <c:v>8</c:v>
                </c:pt>
                <c:pt idx="57">
                  <c:v>10</c:v>
                </c:pt>
                <c:pt idx="58">
                  <c:v>4</c:v>
                </c:pt>
                <c:pt idx="59">
                  <c:v>6</c:v>
                </c:pt>
                <c:pt idx="60">
                  <c:v>1.4</c:v>
                </c:pt>
                <c:pt idx="61">
                  <c:v>1</c:v>
                </c:pt>
                <c:pt idx="62">
                  <c:v>1</c:v>
                </c:pt>
                <c:pt idx="63">
                  <c:v>0.4</c:v>
                </c:pt>
                <c:pt idx="64">
                  <c:v>0.4</c:v>
                </c:pt>
                <c:pt idx="65">
                  <c:v>0.16</c:v>
                </c:pt>
                <c:pt idx="66">
                  <c:v>2.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B4D-44D8-917B-11F0EF43348B}"/>
            </c:ext>
          </c:extLst>
        </c:ser>
        <c:ser>
          <c:idx val="0"/>
          <c:order val="1"/>
          <c:spPr>
            <a:ln w="31750">
              <a:solidFill>
                <a:srgbClr val="FF0000"/>
              </a:solidFill>
            </a:ln>
          </c:spPr>
          <c:marker>
            <c:symbol val="none"/>
          </c:marker>
          <c:xVal>
            <c:numRef>
              <c:f>'Transit model n=1'!$C$160:$C$169</c:f>
              <c:numCache>
                <c:formatCode>General</c:formatCode>
                <c:ptCount val="10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</c:numCache>
            </c:numRef>
          </c:xVal>
          <c:yVal>
            <c:numRef>
              <c:f>'Transit model n=1'!$E$160:$E$169</c:f>
              <c:numCache>
                <c:formatCode>General</c:formatCode>
                <c:ptCount val="10"/>
                <c:pt idx="0">
                  <c:v>8</c:v>
                </c:pt>
                <c:pt idx="1">
                  <c:v>6.61</c:v>
                </c:pt>
                <c:pt idx="2">
                  <c:v>6.0290600000000003</c:v>
                </c:pt>
                <c:pt idx="3">
                  <c:v>5.0520300000000002</c:v>
                </c:pt>
                <c:pt idx="4">
                  <c:v>4.0497699999999996</c:v>
                </c:pt>
                <c:pt idx="5">
                  <c:v>3.4508800000000002</c:v>
                </c:pt>
                <c:pt idx="6">
                  <c:v>2.5769799999999998</c:v>
                </c:pt>
                <c:pt idx="7">
                  <c:v>1.6982299999999999</c:v>
                </c:pt>
                <c:pt idx="8">
                  <c:v>1.24803</c:v>
                </c:pt>
                <c:pt idx="9">
                  <c:v>0.620203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B4D-44D8-917B-11F0EF4334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4"/>
          <c:order val="0"/>
          <c:spPr>
            <a:ln w="19050">
              <a:noFill/>
            </a:ln>
          </c:spPr>
          <c:marker>
            <c:symbol val="circle"/>
            <c:size val="8"/>
            <c:spPr>
              <a:solidFill>
                <a:schemeClr val="bg1">
                  <a:lumMod val="65000"/>
                </a:schemeClr>
              </a:solidFill>
              <a:ln w="19050">
                <a:noFill/>
              </a:ln>
            </c:spPr>
          </c:marker>
          <c:xVal>
            <c:numRef>
              <c:f>'Transit model n=6'!$C$3:$C$46</c:f>
              <c:numCache>
                <c:formatCode>General</c:formatCode>
                <c:ptCount val="44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  <c:pt idx="11">
                  <c:v>0</c:v>
                </c:pt>
                <c:pt idx="12">
                  <c:v>3</c:v>
                </c:pt>
                <c:pt idx="13">
                  <c:v>5</c:v>
                </c:pt>
                <c:pt idx="14">
                  <c:v>8</c:v>
                </c:pt>
                <c:pt idx="15">
                  <c:v>10</c:v>
                </c:pt>
                <c:pt idx="16">
                  <c:v>12</c:v>
                </c:pt>
                <c:pt idx="17">
                  <c:v>15</c:v>
                </c:pt>
                <c:pt idx="18">
                  <c:v>17</c:v>
                </c:pt>
                <c:pt idx="19">
                  <c:v>19</c:v>
                </c:pt>
                <c:pt idx="20">
                  <c:v>22</c:v>
                </c:pt>
                <c:pt idx="21">
                  <c:v>24</c:v>
                </c:pt>
                <c:pt idx="22">
                  <c:v>0</c:v>
                </c:pt>
                <c:pt idx="23">
                  <c:v>3</c:v>
                </c:pt>
                <c:pt idx="24">
                  <c:v>5</c:v>
                </c:pt>
                <c:pt idx="25">
                  <c:v>8</c:v>
                </c:pt>
                <c:pt idx="26">
                  <c:v>10</c:v>
                </c:pt>
                <c:pt idx="27">
                  <c:v>12</c:v>
                </c:pt>
                <c:pt idx="28">
                  <c:v>15</c:v>
                </c:pt>
                <c:pt idx="29">
                  <c:v>17</c:v>
                </c:pt>
                <c:pt idx="30">
                  <c:v>19</c:v>
                </c:pt>
                <c:pt idx="31">
                  <c:v>22</c:v>
                </c:pt>
                <c:pt idx="32">
                  <c:v>24</c:v>
                </c:pt>
                <c:pt idx="33">
                  <c:v>0</c:v>
                </c:pt>
                <c:pt idx="34">
                  <c:v>3</c:v>
                </c:pt>
                <c:pt idx="35">
                  <c:v>5</c:v>
                </c:pt>
                <c:pt idx="36">
                  <c:v>8</c:v>
                </c:pt>
                <c:pt idx="37">
                  <c:v>10</c:v>
                </c:pt>
                <c:pt idx="38">
                  <c:v>12</c:v>
                </c:pt>
                <c:pt idx="39">
                  <c:v>15</c:v>
                </c:pt>
                <c:pt idx="40">
                  <c:v>17</c:v>
                </c:pt>
                <c:pt idx="41">
                  <c:v>19</c:v>
                </c:pt>
                <c:pt idx="42">
                  <c:v>22</c:v>
                </c:pt>
                <c:pt idx="43">
                  <c:v>24</c:v>
                </c:pt>
              </c:numCache>
            </c:numRef>
          </c:xVal>
          <c:yVal>
            <c:numRef>
              <c:f>'Transit model n=6'!$G$3:$G$46</c:f>
              <c:numCache>
                <c:formatCode>General</c:formatCode>
                <c:ptCount val="44"/>
                <c:pt idx="0">
                  <c:v>8</c:v>
                </c:pt>
                <c:pt idx="1">
                  <c:v>8</c:v>
                </c:pt>
                <c:pt idx="2">
                  <c:v>8</c:v>
                </c:pt>
                <c:pt idx="3">
                  <c:v>8</c:v>
                </c:pt>
                <c:pt idx="4">
                  <c:v>8</c:v>
                </c:pt>
                <c:pt idx="5">
                  <c:v>10</c:v>
                </c:pt>
                <c:pt idx="6">
                  <c:v>8</c:v>
                </c:pt>
                <c:pt idx="7">
                  <c:v>8</c:v>
                </c:pt>
                <c:pt idx="8">
                  <c:v>8</c:v>
                </c:pt>
                <c:pt idx="9">
                  <c:v>8</c:v>
                </c:pt>
                <c:pt idx="10">
                  <c:v>8</c:v>
                </c:pt>
                <c:pt idx="11">
                  <c:v>10</c:v>
                </c:pt>
                <c:pt idx="12">
                  <c:v>8</c:v>
                </c:pt>
                <c:pt idx="13">
                  <c:v>8</c:v>
                </c:pt>
                <c:pt idx="14">
                  <c:v>8</c:v>
                </c:pt>
                <c:pt idx="15">
                  <c:v>8</c:v>
                </c:pt>
                <c:pt idx="16">
                  <c:v>10</c:v>
                </c:pt>
                <c:pt idx="17">
                  <c:v>8</c:v>
                </c:pt>
                <c:pt idx="18">
                  <c:v>10</c:v>
                </c:pt>
                <c:pt idx="19">
                  <c:v>8</c:v>
                </c:pt>
                <c:pt idx="20">
                  <c:v>8</c:v>
                </c:pt>
                <c:pt idx="21">
                  <c:v>8</c:v>
                </c:pt>
                <c:pt idx="22">
                  <c:v>10</c:v>
                </c:pt>
                <c:pt idx="23">
                  <c:v>6</c:v>
                </c:pt>
                <c:pt idx="24">
                  <c:v>10</c:v>
                </c:pt>
                <c:pt idx="25">
                  <c:v>8</c:v>
                </c:pt>
                <c:pt idx="26">
                  <c:v>8</c:v>
                </c:pt>
                <c:pt idx="27">
                  <c:v>8</c:v>
                </c:pt>
                <c:pt idx="28">
                  <c:v>8</c:v>
                </c:pt>
                <c:pt idx="29">
                  <c:v>8</c:v>
                </c:pt>
                <c:pt idx="30">
                  <c:v>8</c:v>
                </c:pt>
                <c:pt idx="31">
                  <c:v>8</c:v>
                </c:pt>
                <c:pt idx="32">
                  <c:v>8</c:v>
                </c:pt>
                <c:pt idx="33">
                  <c:v>8</c:v>
                </c:pt>
                <c:pt idx="34">
                  <c:v>8</c:v>
                </c:pt>
                <c:pt idx="35">
                  <c:v>8</c:v>
                </c:pt>
                <c:pt idx="36">
                  <c:v>10</c:v>
                </c:pt>
                <c:pt idx="37">
                  <c:v>6</c:v>
                </c:pt>
                <c:pt idx="38">
                  <c:v>6</c:v>
                </c:pt>
                <c:pt idx="39">
                  <c:v>8</c:v>
                </c:pt>
                <c:pt idx="40">
                  <c:v>6</c:v>
                </c:pt>
                <c:pt idx="41">
                  <c:v>8</c:v>
                </c:pt>
                <c:pt idx="42">
                  <c:v>10</c:v>
                </c:pt>
                <c:pt idx="43">
                  <c:v>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2A0-4A51-8B7E-0C9046119BAE}"/>
            </c:ext>
          </c:extLst>
        </c:ser>
        <c:ser>
          <c:idx val="5"/>
          <c:order val="1"/>
          <c:spPr>
            <a:ln w="31750">
              <a:solidFill>
                <a:schemeClr val="bg1">
                  <a:lumMod val="65000"/>
                </a:schemeClr>
              </a:solidFill>
            </a:ln>
          </c:spPr>
          <c:marker>
            <c:symbol val="none"/>
          </c:marker>
          <c:xVal>
            <c:numRef>
              <c:f>'Transit model n=6'!$C$3:$C$13</c:f>
              <c:numCache>
                <c:formatCode>General</c:formatCode>
                <c:ptCount val="11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</c:numCache>
            </c:numRef>
          </c:xVal>
          <c:yVal>
            <c:numRef>
              <c:f>'Transit model n=6'!$E$3:$E$13</c:f>
              <c:numCache>
                <c:formatCode>General</c:formatCode>
                <c:ptCount val="11"/>
                <c:pt idx="0">
                  <c:v>8</c:v>
                </c:pt>
                <c:pt idx="1">
                  <c:v>8</c:v>
                </c:pt>
                <c:pt idx="2">
                  <c:v>8</c:v>
                </c:pt>
                <c:pt idx="3">
                  <c:v>8</c:v>
                </c:pt>
                <c:pt idx="4">
                  <c:v>8</c:v>
                </c:pt>
                <c:pt idx="5">
                  <c:v>8</c:v>
                </c:pt>
                <c:pt idx="6">
                  <c:v>8</c:v>
                </c:pt>
                <c:pt idx="7">
                  <c:v>8</c:v>
                </c:pt>
                <c:pt idx="8">
                  <c:v>8</c:v>
                </c:pt>
                <c:pt idx="9">
                  <c:v>8</c:v>
                </c:pt>
                <c:pt idx="10">
                  <c:v>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2A0-4A51-8B7E-0C9046119B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8"/>
            <c:spPr>
              <a:solidFill>
                <a:srgbClr val="0070C0"/>
              </a:solidFill>
              <a:ln>
                <a:noFill/>
              </a:ln>
            </c:spPr>
          </c:marker>
          <c:xVal>
            <c:numRef>
              <c:f>'Transit model n=6'!$C$47:$C$90</c:f>
              <c:numCache>
                <c:formatCode>General</c:formatCode>
                <c:ptCount val="44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  <c:pt idx="11">
                  <c:v>0</c:v>
                </c:pt>
                <c:pt idx="12">
                  <c:v>3</c:v>
                </c:pt>
                <c:pt idx="13">
                  <c:v>5</c:v>
                </c:pt>
                <c:pt idx="14">
                  <c:v>8</c:v>
                </c:pt>
                <c:pt idx="15">
                  <c:v>10</c:v>
                </c:pt>
                <c:pt idx="16">
                  <c:v>12</c:v>
                </c:pt>
                <c:pt idx="17">
                  <c:v>15</c:v>
                </c:pt>
                <c:pt idx="18">
                  <c:v>17</c:v>
                </c:pt>
                <c:pt idx="19">
                  <c:v>19</c:v>
                </c:pt>
                <c:pt idx="20">
                  <c:v>22</c:v>
                </c:pt>
                <c:pt idx="21">
                  <c:v>24</c:v>
                </c:pt>
                <c:pt idx="22">
                  <c:v>0</c:v>
                </c:pt>
                <c:pt idx="23">
                  <c:v>3</c:v>
                </c:pt>
                <c:pt idx="24">
                  <c:v>5</c:v>
                </c:pt>
                <c:pt idx="25">
                  <c:v>8</c:v>
                </c:pt>
                <c:pt idx="26">
                  <c:v>10</c:v>
                </c:pt>
                <c:pt idx="27">
                  <c:v>12</c:v>
                </c:pt>
                <c:pt idx="28">
                  <c:v>15</c:v>
                </c:pt>
                <c:pt idx="29">
                  <c:v>17</c:v>
                </c:pt>
                <c:pt idx="30">
                  <c:v>19</c:v>
                </c:pt>
                <c:pt idx="31">
                  <c:v>22</c:v>
                </c:pt>
                <c:pt idx="32">
                  <c:v>24</c:v>
                </c:pt>
                <c:pt idx="33">
                  <c:v>0</c:v>
                </c:pt>
                <c:pt idx="34">
                  <c:v>3</c:v>
                </c:pt>
                <c:pt idx="35">
                  <c:v>5</c:v>
                </c:pt>
                <c:pt idx="36">
                  <c:v>8</c:v>
                </c:pt>
                <c:pt idx="37">
                  <c:v>10</c:v>
                </c:pt>
                <c:pt idx="38">
                  <c:v>12</c:v>
                </c:pt>
                <c:pt idx="39">
                  <c:v>15</c:v>
                </c:pt>
                <c:pt idx="40">
                  <c:v>17</c:v>
                </c:pt>
                <c:pt idx="41">
                  <c:v>19</c:v>
                </c:pt>
                <c:pt idx="42">
                  <c:v>22</c:v>
                </c:pt>
                <c:pt idx="43">
                  <c:v>24</c:v>
                </c:pt>
              </c:numCache>
            </c:numRef>
          </c:xVal>
          <c:yVal>
            <c:numRef>
              <c:f>'Transit model n=6'!$G$47:$G$90</c:f>
              <c:numCache>
                <c:formatCode>General</c:formatCode>
                <c:ptCount val="44"/>
                <c:pt idx="0">
                  <c:v>10</c:v>
                </c:pt>
                <c:pt idx="1">
                  <c:v>8</c:v>
                </c:pt>
                <c:pt idx="2">
                  <c:v>6</c:v>
                </c:pt>
                <c:pt idx="3">
                  <c:v>8</c:v>
                </c:pt>
                <c:pt idx="4">
                  <c:v>8</c:v>
                </c:pt>
                <c:pt idx="5">
                  <c:v>10</c:v>
                </c:pt>
                <c:pt idx="6">
                  <c:v>6</c:v>
                </c:pt>
                <c:pt idx="7">
                  <c:v>8</c:v>
                </c:pt>
                <c:pt idx="8">
                  <c:v>8</c:v>
                </c:pt>
                <c:pt idx="9">
                  <c:v>6</c:v>
                </c:pt>
                <c:pt idx="10">
                  <c:v>8</c:v>
                </c:pt>
                <c:pt idx="11">
                  <c:v>10</c:v>
                </c:pt>
                <c:pt idx="12">
                  <c:v>10</c:v>
                </c:pt>
                <c:pt idx="13">
                  <c:v>8</c:v>
                </c:pt>
                <c:pt idx="14">
                  <c:v>8</c:v>
                </c:pt>
                <c:pt idx="15">
                  <c:v>8</c:v>
                </c:pt>
                <c:pt idx="16">
                  <c:v>6</c:v>
                </c:pt>
                <c:pt idx="17">
                  <c:v>8</c:v>
                </c:pt>
                <c:pt idx="18">
                  <c:v>6</c:v>
                </c:pt>
                <c:pt idx="19">
                  <c:v>6</c:v>
                </c:pt>
                <c:pt idx="20">
                  <c:v>8</c:v>
                </c:pt>
                <c:pt idx="21">
                  <c:v>8</c:v>
                </c:pt>
                <c:pt idx="22">
                  <c:v>8</c:v>
                </c:pt>
                <c:pt idx="23">
                  <c:v>6</c:v>
                </c:pt>
                <c:pt idx="24">
                  <c:v>6</c:v>
                </c:pt>
                <c:pt idx="25">
                  <c:v>6</c:v>
                </c:pt>
                <c:pt idx="26">
                  <c:v>6</c:v>
                </c:pt>
                <c:pt idx="27">
                  <c:v>6</c:v>
                </c:pt>
                <c:pt idx="28">
                  <c:v>8</c:v>
                </c:pt>
                <c:pt idx="29">
                  <c:v>6</c:v>
                </c:pt>
                <c:pt idx="30">
                  <c:v>6</c:v>
                </c:pt>
                <c:pt idx="31">
                  <c:v>8</c:v>
                </c:pt>
                <c:pt idx="32">
                  <c:v>6</c:v>
                </c:pt>
                <c:pt idx="33">
                  <c:v>8</c:v>
                </c:pt>
                <c:pt idx="34">
                  <c:v>8</c:v>
                </c:pt>
                <c:pt idx="35">
                  <c:v>8</c:v>
                </c:pt>
                <c:pt idx="36">
                  <c:v>6</c:v>
                </c:pt>
                <c:pt idx="37">
                  <c:v>6</c:v>
                </c:pt>
                <c:pt idx="38">
                  <c:v>6</c:v>
                </c:pt>
                <c:pt idx="39">
                  <c:v>8</c:v>
                </c:pt>
                <c:pt idx="40">
                  <c:v>6</c:v>
                </c:pt>
                <c:pt idx="41">
                  <c:v>10</c:v>
                </c:pt>
                <c:pt idx="42">
                  <c:v>6</c:v>
                </c:pt>
                <c:pt idx="43">
                  <c:v>1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F45-4CFA-8813-14BC3473269B}"/>
            </c:ext>
          </c:extLst>
        </c:ser>
        <c:ser>
          <c:idx val="1"/>
          <c:order val="1"/>
          <c:spPr>
            <a:ln w="31750">
              <a:solidFill>
                <a:srgbClr val="0070C0"/>
              </a:solidFill>
            </a:ln>
          </c:spPr>
          <c:marker>
            <c:symbol val="none"/>
          </c:marker>
          <c:xVal>
            <c:numRef>
              <c:f>'Transit model n=6'!$C$47:$C$57</c:f>
              <c:numCache>
                <c:formatCode>General</c:formatCode>
                <c:ptCount val="11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</c:numCache>
            </c:numRef>
          </c:xVal>
          <c:yVal>
            <c:numRef>
              <c:f>'Transit model n=6'!$E$47:$E$57</c:f>
              <c:numCache>
                <c:formatCode>General</c:formatCode>
                <c:ptCount val="11"/>
                <c:pt idx="0">
                  <c:v>8</c:v>
                </c:pt>
                <c:pt idx="1">
                  <c:v>7.98705</c:v>
                </c:pt>
                <c:pt idx="2">
                  <c:v>7.87852</c:v>
                </c:pt>
                <c:pt idx="3">
                  <c:v>7.4299299999999997</c:v>
                </c:pt>
                <c:pt idx="4">
                  <c:v>7.0634399999999999</c:v>
                </c:pt>
                <c:pt idx="5">
                  <c:v>6.7098199999999997</c:v>
                </c:pt>
                <c:pt idx="6">
                  <c:v>6.2029100000000001</c:v>
                </c:pt>
                <c:pt idx="7">
                  <c:v>5.9642799999999996</c:v>
                </c:pt>
                <c:pt idx="8">
                  <c:v>5.8045999999999998</c:v>
                </c:pt>
                <c:pt idx="9">
                  <c:v>5.6040700000000001</c:v>
                </c:pt>
                <c:pt idx="10">
                  <c:v>5.538070000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F45-4CFA-8813-14BC347326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1"/>
          <c:order val="0"/>
          <c:spPr>
            <a:ln w="19050">
              <a:noFill/>
            </a:ln>
          </c:spPr>
          <c:marker>
            <c:symbol val="circle"/>
            <c:size val="8"/>
            <c:spPr>
              <a:solidFill>
                <a:srgbClr val="00B050"/>
              </a:solidFill>
              <a:ln>
                <a:noFill/>
              </a:ln>
            </c:spPr>
          </c:marker>
          <c:xVal>
            <c:numRef>
              <c:f>'Transit model n=6'!$C$91:$C$159</c:f>
              <c:numCache>
                <c:formatCode>General</c:formatCode>
                <c:ptCount val="69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  <c:pt idx="11">
                  <c:v>0</c:v>
                </c:pt>
                <c:pt idx="12">
                  <c:v>3</c:v>
                </c:pt>
                <c:pt idx="13">
                  <c:v>5</c:v>
                </c:pt>
                <c:pt idx="14">
                  <c:v>8</c:v>
                </c:pt>
                <c:pt idx="15">
                  <c:v>10</c:v>
                </c:pt>
                <c:pt idx="16">
                  <c:v>12</c:v>
                </c:pt>
                <c:pt idx="17">
                  <c:v>15</c:v>
                </c:pt>
                <c:pt idx="18">
                  <c:v>17</c:v>
                </c:pt>
                <c:pt idx="19">
                  <c:v>19</c:v>
                </c:pt>
                <c:pt idx="20">
                  <c:v>22</c:v>
                </c:pt>
                <c:pt idx="21">
                  <c:v>24</c:v>
                </c:pt>
                <c:pt idx="22">
                  <c:v>0</c:v>
                </c:pt>
                <c:pt idx="23">
                  <c:v>3</c:v>
                </c:pt>
                <c:pt idx="24">
                  <c:v>5</c:v>
                </c:pt>
                <c:pt idx="25">
                  <c:v>8</c:v>
                </c:pt>
                <c:pt idx="26">
                  <c:v>10</c:v>
                </c:pt>
                <c:pt idx="27">
                  <c:v>12</c:v>
                </c:pt>
                <c:pt idx="28">
                  <c:v>15</c:v>
                </c:pt>
                <c:pt idx="29">
                  <c:v>17</c:v>
                </c:pt>
                <c:pt idx="30">
                  <c:v>19</c:v>
                </c:pt>
                <c:pt idx="31">
                  <c:v>22</c:v>
                </c:pt>
                <c:pt idx="32">
                  <c:v>24</c:v>
                </c:pt>
                <c:pt idx="33">
                  <c:v>0</c:v>
                </c:pt>
                <c:pt idx="34">
                  <c:v>3</c:v>
                </c:pt>
                <c:pt idx="35">
                  <c:v>5</c:v>
                </c:pt>
                <c:pt idx="36">
                  <c:v>8</c:v>
                </c:pt>
                <c:pt idx="37">
                  <c:v>10</c:v>
                </c:pt>
                <c:pt idx="38">
                  <c:v>12</c:v>
                </c:pt>
                <c:pt idx="39">
                  <c:v>15</c:v>
                </c:pt>
                <c:pt idx="40">
                  <c:v>17</c:v>
                </c:pt>
                <c:pt idx="41">
                  <c:v>19</c:v>
                </c:pt>
                <c:pt idx="42">
                  <c:v>22</c:v>
                </c:pt>
                <c:pt idx="43">
                  <c:v>24</c:v>
                </c:pt>
                <c:pt idx="44">
                  <c:v>26</c:v>
                </c:pt>
                <c:pt idx="45">
                  <c:v>0</c:v>
                </c:pt>
                <c:pt idx="46">
                  <c:v>3</c:v>
                </c:pt>
                <c:pt idx="47">
                  <c:v>5</c:v>
                </c:pt>
                <c:pt idx="48">
                  <c:v>8</c:v>
                </c:pt>
                <c:pt idx="49">
                  <c:v>10</c:v>
                </c:pt>
                <c:pt idx="50">
                  <c:v>12</c:v>
                </c:pt>
                <c:pt idx="51">
                  <c:v>15</c:v>
                </c:pt>
                <c:pt idx="52">
                  <c:v>17</c:v>
                </c:pt>
                <c:pt idx="53">
                  <c:v>19</c:v>
                </c:pt>
                <c:pt idx="54">
                  <c:v>22</c:v>
                </c:pt>
                <c:pt idx="55">
                  <c:v>24</c:v>
                </c:pt>
                <c:pt idx="56">
                  <c:v>26</c:v>
                </c:pt>
                <c:pt idx="57">
                  <c:v>0</c:v>
                </c:pt>
                <c:pt idx="58">
                  <c:v>3</c:v>
                </c:pt>
                <c:pt idx="59">
                  <c:v>5</c:v>
                </c:pt>
                <c:pt idx="60">
                  <c:v>8</c:v>
                </c:pt>
                <c:pt idx="61">
                  <c:v>10</c:v>
                </c:pt>
                <c:pt idx="62">
                  <c:v>12</c:v>
                </c:pt>
                <c:pt idx="63">
                  <c:v>15</c:v>
                </c:pt>
                <c:pt idx="64">
                  <c:v>17</c:v>
                </c:pt>
                <c:pt idx="65">
                  <c:v>19</c:v>
                </c:pt>
                <c:pt idx="66">
                  <c:v>22</c:v>
                </c:pt>
                <c:pt idx="67">
                  <c:v>24</c:v>
                </c:pt>
                <c:pt idx="68">
                  <c:v>26</c:v>
                </c:pt>
              </c:numCache>
            </c:numRef>
          </c:xVal>
          <c:yVal>
            <c:numRef>
              <c:f>'Transit model n=6'!$G$91:$G$159</c:f>
              <c:numCache>
                <c:formatCode>General</c:formatCode>
                <c:ptCount val="69"/>
                <c:pt idx="0">
                  <c:v>8</c:v>
                </c:pt>
                <c:pt idx="1">
                  <c:v>8</c:v>
                </c:pt>
                <c:pt idx="2">
                  <c:v>6</c:v>
                </c:pt>
                <c:pt idx="3">
                  <c:v>6</c:v>
                </c:pt>
                <c:pt idx="4">
                  <c:v>4</c:v>
                </c:pt>
                <c:pt idx="5">
                  <c:v>2</c:v>
                </c:pt>
                <c:pt idx="6">
                  <c:v>2</c:v>
                </c:pt>
                <c:pt idx="7">
                  <c:v>0.16</c:v>
                </c:pt>
                <c:pt idx="8">
                  <c:v>7.0000000000000007E-2</c:v>
                </c:pt>
                <c:pt idx="9">
                  <c:v>7.0000000000000007E-2</c:v>
                </c:pt>
                <c:pt idx="10">
                  <c:v>8.0000000000000002E-3</c:v>
                </c:pt>
                <c:pt idx="11">
                  <c:v>10</c:v>
                </c:pt>
                <c:pt idx="12">
                  <c:v>8</c:v>
                </c:pt>
                <c:pt idx="13">
                  <c:v>6</c:v>
                </c:pt>
                <c:pt idx="14">
                  <c:v>6</c:v>
                </c:pt>
                <c:pt idx="15">
                  <c:v>2</c:v>
                </c:pt>
                <c:pt idx="16">
                  <c:v>0.02</c:v>
                </c:pt>
                <c:pt idx="17">
                  <c:v>0.02</c:v>
                </c:pt>
                <c:pt idx="18">
                  <c:v>0.02</c:v>
                </c:pt>
                <c:pt idx="19">
                  <c:v>0.02</c:v>
                </c:pt>
                <c:pt idx="20">
                  <c:v>7.0000000000000007E-2</c:v>
                </c:pt>
                <c:pt idx="21">
                  <c:v>8.0000000000000002E-3</c:v>
                </c:pt>
                <c:pt idx="22">
                  <c:v>8</c:v>
                </c:pt>
                <c:pt idx="23">
                  <c:v>8</c:v>
                </c:pt>
                <c:pt idx="24">
                  <c:v>8</c:v>
                </c:pt>
                <c:pt idx="25">
                  <c:v>8</c:v>
                </c:pt>
                <c:pt idx="26">
                  <c:v>4</c:v>
                </c:pt>
                <c:pt idx="27">
                  <c:v>2</c:v>
                </c:pt>
                <c:pt idx="28">
                  <c:v>1.4</c:v>
                </c:pt>
                <c:pt idx="29">
                  <c:v>0.16</c:v>
                </c:pt>
                <c:pt idx="30">
                  <c:v>0.02</c:v>
                </c:pt>
                <c:pt idx="31">
                  <c:v>7.0000000000000007E-2</c:v>
                </c:pt>
                <c:pt idx="32">
                  <c:v>8.0000000000000002E-3</c:v>
                </c:pt>
                <c:pt idx="33">
                  <c:v>10</c:v>
                </c:pt>
                <c:pt idx="34">
                  <c:v>10</c:v>
                </c:pt>
                <c:pt idx="35">
                  <c:v>6</c:v>
                </c:pt>
                <c:pt idx="36">
                  <c:v>8</c:v>
                </c:pt>
                <c:pt idx="37">
                  <c:v>4</c:v>
                </c:pt>
                <c:pt idx="38">
                  <c:v>4</c:v>
                </c:pt>
                <c:pt idx="39">
                  <c:v>2</c:v>
                </c:pt>
                <c:pt idx="40">
                  <c:v>2</c:v>
                </c:pt>
                <c:pt idx="41">
                  <c:v>0.4</c:v>
                </c:pt>
                <c:pt idx="42">
                  <c:v>0.16</c:v>
                </c:pt>
                <c:pt idx="43">
                  <c:v>0.16</c:v>
                </c:pt>
                <c:pt idx="44">
                  <c:v>0.16</c:v>
                </c:pt>
                <c:pt idx="45">
                  <c:v>8</c:v>
                </c:pt>
                <c:pt idx="46">
                  <c:v>4</c:v>
                </c:pt>
                <c:pt idx="47">
                  <c:v>8</c:v>
                </c:pt>
                <c:pt idx="48">
                  <c:v>6</c:v>
                </c:pt>
                <c:pt idx="49">
                  <c:v>4</c:v>
                </c:pt>
                <c:pt idx="50">
                  <c:v>2</c:v>
                </c:pt>
                <c:pt idx="51">
                  <c:v>1.4</c:v>
                </c:pt>
                <c:pt idx="52">
                  <c:v>1</c:v>
                </c:pt>
                <c:pt idx="53">
                  <c:v>0.4</c:v>
                </c:pt>
                <c:pt idx="54">
                  <c:v>0.4</c:v>
                </c:pt>
                <c:pt idx="55">
                  <c:v>0.4</c:v>
                </c:pt>
                <c:pt idx="56">
                  <c:v>0.16</c:v>
                </c:pt>
                <c:pt idx="57">
                  <c:v>6</c:v>
                </c:pt>
                <c:pt idx="58">
                  <c:v>10</c:v>
                </c:pt>
                <c:pt idx="59">
                  <c:v>8</c:v>
                </c:pt>
                <c:pt idx="60">
                  <c:v>8</c:v>
                </c:pt>
                <c:pt idx="61">
                  <c:v>2</c:v>
                </c:pt>
                <c:pt idx="62">
                  <c:v>2</c:v>
                </c:pt>
                <c:pt idx="63">
                  <c:v>1</c:v>
                </c:pt>
                <c:pt idx="64">
                  <c:v>1</c:v>
                </c:pt>
                <c:pt idx="65">
                  <c:v>0.16</c:v>
                </c:pt>
                <c:pt idx="66">
                  <c:v>0.4</c:v>
                </c:pt>
                <c:pt idx="67">
                  <c:v>0.4</c:v>
                </c:pt>
                <c:pt idx="68">
                  <c:v>0.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27F-49D4-B18A-DA6E804CC489}"/>
            </c:ext>
          </c:extLst>
        </c:ser>
        <c:ser>
          <c:idx val="0"/>
          <c:order val="1"/>
          <c:spPr>
            <a:ln w="31750">
              <a:solidFill>
                <a:srgbClr val="00B050"/>
              </a:solidFill>
            </a:ln>
          </c:spPr>
          <c:marker>
            <c:symbol val="none"/>
          </c:marker>
          <c:xVal>
            <c:numRef>
              <c:f>'Transit model n=6'!$C$91:$C$101</c:f>
              <c:numCache>
                <c:formatCode>General</c:formatCode>
                <c:ptCount val="11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</c:numCache>
            </c:numRef>
          </c:xVal>
          <c:yVal>
            <c:numRef>
              <c:f>'Transit model n=6'!$E$91:$E$101</c:f>
              <c:numCache>
                <c:formatCode>General</c:formatCode>
                <c:ptCount val="11"/>
                <c:pt idx="0">
                  <c:v>8</c:v>
                </c:pt>
                <c:pt idx="1">
                  <c:v>7.9498300000000004</c:v>
                </c:pt>
                <c:pt idx="2">
                  <c:v>7.5260899999999999</c:v>
                </c:pt>
                <c:pt idx="3">
                  <c:v>5.7667200000000003</c:v>
                </c:pt>
                <c:pt idx="4">
                  <c:v>4.3264199999999997</c:v>
                </c:pt>
                <c:pt idx="5">
                  <c:v>2.9368400000000001</c:v>
                </c:pt>
                <c:pt idx="6">
                  <c:v>0.94391700000000001</c:v>
                </c:pt>
                <c:pt idx="7">
                  <c:v>8.0000000000000002E-3</c:v>
                </c:pt>
                <c:pt idx="8">
                  <c:v>8.0000000000000002E-3</c:v>
                </c:pt>
                <c:pt idx="9">
                  <c:v>8.0000000000000002E-3</c:v>
                </c:pt>
                <c:pt idx="10">
                  <c:v>8.0000000000000002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27F-49D4-B18A-DA6E804CC4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2"/>
          <c:order val="0"/>
          <c:spPr>
            <a:ln w="19050">
              <a:noFill/>
            </a:ln>
          </c:spPr>
          <c:marker>
            <c:symbol val="circle"/>
            <c:size val="8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'Transit model n=6'!$C$160:$C$226</c:f>
              <c:numCache>
                <c:formatCode>General</c:formatCode>
                <c:ptCount val="67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0</c:v>
                </c:pt>
                <c:pt idx="11">
                  <c:v>3</c:v>
                </c:pt>
                <c:pt idx="12">
                  <c:v>5</c:v>
                </c:pt>
                <c:pt idx="13">
                  <c:v>8</c:v>
                </c:pt>
                <c:pt idx="14">
                  <c:v>10</c:v>
                </c:pt>
                <c:pt idx="15">
                  <c:v>12</c:v>
                </c:pt>
                <c:pt idx="16">
                  <c:v>15</c:v>
                </c:pt>
                <c:pt idx="17">
                  <c:v>17</c:v>
                </c:pt>
                <c:pt idx="18">
                  <c:v>19</c:v>
                </c:pt>
                <c:pt idx="19">
                  <c:v>22</c:v>
                </c:pt>
                <c:pt idx="20">
                  <c:v>0</c:v>
                </c:pt>
                <c:pt idx="21">
                  <c:v>3</c:v>
                </c:pt>
                <c:pt idx="22">
                  <c:v>5</c:v>
                </c:pt>
                <c:pt idx="23">
                  <c:v>8</c:v>
                </c:pt>
                <c:pt idx="24">
                  <c:v>10</c:v>
                </c:pt>
                <c:pt idx="25">
                  <c:v>12</c:v>
                </c:pt>
                <c:pt idx="26">
                  <c:v>15</c:v>
                </c:pt>
                <c:pt idx="27">
                  <c:v>17</c:v>
                </c:pt>
                <c:pt idx="28">
                  <c:v>0</c:v>
                </c:pt>
                <c:pt idx="29">
                  <c:v>3</c:v>
                </c:pt>
                <c:pt idx="30">
                  <c:v>5</c:v>
                </c:pt>
                <c:pt idx="31">
                  <c:v>8</c:v>
                </c:pt>
                <c:pt idx="32">
                  <c:v>10</c:v>
                </c:pt>
                <c:pt idx="33">
                  <c:v>12</c:v>
                </c:pt>
                <c:pt idx="34">
                  <c:v>15</c:v>
                </c:pt>
                <c:pt idx="35">
                  <c:v>17</c:v>
                </c:pt>
                <c:pt idx="36">
                  <c:v>0</c:v>
                </c:pt>
                <c:pt idx="37">
                  <c:v>3</c:v>
                </c:pt>
                <c:pt idx="38">
                  <c:v>5</c:v>
                </c:pt>
                <c:pt idx="39">
                  <c:v>8</c:v>
                </c:pt>
                <c:pt idx="40">
                  <c:v>10</c:v>
                </c:pt>
                <c:pt idx="41">
                  <c:v>12</c:v>
                </c:pt>
                <c:pt idx="42">
                  <c:v>15</c:v>
                </c:pt>
                <c:pt idx="43">
                  <c:v>17</c:v>
                </c:pt>
                <c:pt idx="44">
                  <c:v>19</c:v>
                </c:pt>
                <c:pt idx="45">
                  <c:v>22</c:v>
                </c:pt>
                <c:pt idx="46">
                  <c:v>0</c:v>
                </c:pt>
                <c:pt idx="47">
                  <c:v>3</c:v>
                </c:pt>
                <c:pt idx="48">
                  <c:v>5</c:v>
                </c:pt>
                <c:pt idx="49">
                  <c:v>8</c:v>
                </c:pt>
                <c:pt idx="50">
                  <c:v>10</c:v>
                </c:pt>
                <c:pt idx="51">
                  <c:v>12</c:v>
                </c:pt>
                <c:pt idx="52">
                  <c:v>15</c:v>
                </c:pt>
                <c:pt idx="53">
                  <c:v>17</c:v>
                </c:pt>
                <c:pt idx="54">
                  <c:v>19</c:v>
                </c:pt>
                <c:pt idx="55">
                  <c:v>22</c:v>
                </c:pt>
                <c:pt idx="56">
                  <c:v>0</c:v>
                </c:pt>
                <c:pt idx="57">
                  <c:v>3</c:v>
                </c:pt>
                <c:pt idx="58">
                  <c:v>5</c:v>
                </c:pt>
                <c:pt idx="59">
                  <c:v>8</c:v>
                </c:pt>
                <c:pt idx="60">
                  <c:v>10</c:v>
                </c:pt>
                <c:pt idx="61">
                  <c:v>12</c:v>
                </c:pt>
                <c:pt idx="62">
                  <c:v>15</c:v>
                </c:pt>
                <c:pt idx="63">
                  <c:v>17</c:v>
                </c:pt>
                <c:pt idx="64">
                  <c:v>19</c:v>
                </c:pt>
                <c:pt idx="65">
                  <c:v>22</c:v>
                </c:pt>
                <c:pt idx="66">
                  <c:v>22</c:v>
                </c:pt>
              </c:numCache>
            </c:numRef>
          </c:xVal>
          <c:yVal>
            <c:numRef>
              <c:f>'Transit model n=6'!$G$160:$G$226</c:f>
              <c:numCache>
                <c:formatCode>General</c:formatCode>
                <c:ptCount val="67"/>
                <c:pt idx="0">
                  <c:v>8</c:v>
                </c:pt>
                <c:pt idx="1">
                  <c:v>8</c:v>
                </c:pt>
                <c:pt idx="2">
                  <c:v>6</c:v>
                </c:pt>
                <c:pt idx="3">
                  <c:v>4</c:v>
                </c:pt>
                <c:pt idx="4">
                  <c:v>2</c:v>
                </c:pt>
                <c:pt idx="5">
                  <c:v>2</c:v>
                </c:pt>
                <c:pt idx="6">
                  <c:v>1.4</c:v>
                </c:pt>
                <c:pt idx="7">
                  <c:v>1</c:v>
                </c:pt>
                <c:pt idx="8">
                  <c:v>0.02</c:v>
                </c:pt>
                <c:pt idx="9">
                  <c:v>0.02</c:v>
                </c:pt>
                <c:pt idx="10">
                  <c:v>8</c:v>
                </c:pt>
                <c:pt idx="11">
                  <c:v>8</c:v>
                </c:pt>
                <c:pt idx="12">
                  <c:v>4</c:v>
                </c:pt>
                <c:pt idx="13">
                  <c:v>4</c:v>
                </c:pt>
                <c:pt idx="14">
                  <c:v>2</c:v>
                </c:pt>
                <c:pt idx="15">
                  <c:v>1.4</c:v>
                </c:pt>
                <c:pt idx="16">
                  <c:v>0.16</c:v>
                </c:pt>
                <c:pt idx="17">
                  <c:v>0.16</c:v>
                </c:pt>
                <c:pt idx="18">
                  <c:v>0.02</c:v>
                </c:pt>
                <c:pt idx="19">
                  <c:v>0.02</c:v>
                </c:pt>
                <c:pt idx="20">
                  <c:v>6</c:v>
                </c:pt>
                <c:pt idx="21">
                  <c:v>8</c:v>
                </c:pt>
                <c:pt idx="22">
                  <c:v>6</c:v>
                </c:pt>
                <c:pt idx="23">
                  <c:v>6</c:v>
                </c:pt>
                <c:pt idx="24">
                  <c:v>1.4</c:v>
                </c:pt>
                <c:pt idx="25">
                  <c:v>2</c:v>
                </c:pt>
                <c:pt idx="26">
                  <c:v>1.4</c:v>
                </c:pt>
                <c:pt idx="27">
                  <c:v>1.4</c:v>
                </c:pt>
                <c:pt idx="28">
                  <c:v>8</c:v>
                </c:pt>
                <c:pt idx="29">
                  <c:v>8</c:v>
                </c:pt>
                <c:pt idx="30">
                  <c:v>6</c:v>
                </c:pt>
                <c:pt idx="31">
                  <c:v>6</c:v>
                </c:pt>
                <c:pt idx="32">
                  <c:v>4</c:v>
                </c:pt>
                <c:pt idx="33">
                  <c:v>1.4</c:v>
                </c:pt>
                <c:pt idx="34">
                  <c:v>1.4</c:v>
                </c:pt>
                <c:pt idx="35">
                  <c:v>1.4</c:v>
                </c:pt>
                <c:pt idx="36">
                  <c:v>10</c:v>
                </c:pt>
                <c:pt idx="37">
                  <c:v>6</c:v>
                </c:pt>
                <c:pt idx="38">
                  <c:v>10</c:v>
                </c:pt>
                <c:pt idx="39">
                  <c:v>10</c:v>
                </c:pt>
                <c:pt idx="40">
                  <c:v>1.4</c:v>
                </c:pt>
                <c:pt idx="41">
                  <c:v>1</c:v>
                </c:pt>
                <c:pt idx="42">
                  <c:v>2</c:v>
                </c:pt>
                <c:pt idx="43">
                  <c:v>0.4</c:v>
                </c:pt>
                <c:pt idx="44">
                  <c:v>0.4</c:v>
                </c:pt>
                <c:pt idx="45">
                  <c:v>0.16</c:v>
                </c:pt>
                <c:pt idx="46">
                  <c:v>8</c:v>
                </c:pt>
                <c:pt idx="47">
                  <c:v>6</c:v>
                </c:pt>
                <c:pt idx="48">
                  <c:v>6</c:v>
                </c:pt>
                <c:pt idx="49">
                  <c:v>6</c:v>
                </c:pt>
                <c:pt idx="50">
                  <c:v>4</c:v>
                </c:pt>
                <c:pt idx="51">
                  <c:v>1</c:v>
                </c:pt>
                <c:pt idx="52">
                  <c:v>1.4</c:v>
                </c:pt>
                <c:pt idx="53">
                  <c:v>0.4</c:v>
                </c:pt>
                <c:pt idx="54">
                  <c:v>0.16</c:v>
                </c:pt>
                <c:pt idx="55">
                  <c:v>7.0000000000000007E-2</c:v>
                </c:pt>
                <c:pt idx="56">
                  <c:v>8</c:v>
                </c:pt>
                <c:pt idx="57">
                  <c:v>10</c:v>
                </c:pt>
                <c:pt idx="58">
                  <c:v>4</c:v>
                </c:pt>
                <c:pt idx="59">
                  <c:v>6</c:v>
                </c:pt>
                <c:pt idx="60">
                  <c:v>1.4</c:v>
                </c:pt>
                <c:pt idx="61">
                  <c:v>1</c:v>
                </c:pt>
                <c:pt idx="62">
                  <c:v>1</c:v>
                </c:pt>
                <c:pt idx="63">
                  <c:v>0.4</c:v>
                </c:pt>
                <c:pt idx="64">
                  <c:v>0.4</c:v>
                </c:pt>
                <c:pt idx="65">
                  <c:v>0.16</c:v>
                </c:pt>
                <c:pt idx="66">
                  <c:v>2.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61D-4A4F-804A-FEC0D55C56D5}"/>
            </c:ext>
          </c:extLst>
        </c:ser>
        <c:ser>
          <c:idx val="0"/>
          <c:order val="1"/>
          <c:spPr>
            <a:ln w="31750">
              <a:solidFill>
                <a:srgbClr val="FF0000"/>
              </a:solidFill>
            </a:ln>
          </c:spPr>
          <c:marker>
            <c:symbol val="none"/>
          </c:marker>
          <c:xVal>
            <c:numRef>
              <c:f>'Transit model n=6'!$C$160:$C$169</c:f>
              <c:numCache>
                <c:formatCode>General</c:formatCode>
                <c:ptCount val="10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</c:numCache>
            </c:numRef>
          </c:xVal>
          <c:yVal>
            <c:numRef>
              <c:f>'Transit model n=6'!$E$160:$E$169</c:f>
              <c:numCache>
                <c:formatCode>General</c:formatCode>
                <c:ptCount val="10"/>
                <c:pt idx="0">
                  <c:v>8</c:v>
                </c:pt>
                <c:pt idx="1">
                  <c:v>7.9016400000000004</c:v>
                </c:pt>
                <c:pt idx="2">
                  <c:v>7.0575099999999997</c:v>
                </c:pt>
                <c:pt idx="3">
                  <c:v>3.5224600000000001</c:v>
                </c:pt>
                <c:pt idx="4">
                  <c:v>0.61717699999999998</c:v>
                </c:pt>
                <c:pt idx="5">
                  <c:v>8.0000000000000002E-3</c:v>
                </c:pt>
                <c:pt idx="6">
                  <c:v>8.0000000000000002E-3</c:v>
                </c:pt>
                <c:pt idx="7">
                  <c:v>8.0000000000000002E-3</c:v>
                </c:pt>
                <c:pt idx="8">
                  <c:v>8.0000000000000002E-3</c:v>
                </c:pt>
                <c:pt idx="9">
                  <c:v>8.0000000000000002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61D-4A4F-804A-FEC0D55C56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966070764759556"/>
          <c:y val="5.0925881861406376E-2"/>
          <c:w val="0.79447377017786946"/>
          <c:h val="0.74203667249927097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5"/>
            <c:spPr>
              <a:noFill/>
              <a:ln w="15875">
                <a:solidFill>
                  <a:schemeClr val="tx1"/>
                </a:solidFill>
              </a:ln>
            </c:spPr>
          </c:marker>
          <c:trendline>
            <c:spPr>
              <a:ln>
                <a:noFill/>
              </a:ln>
            </c:spPr>
            <c:trendlineType val="linear"/>
            <c:dispRSqr val="0"/>
            <c:dispEq val="0"/>
          </c:trendline>
          <c:xVal>
            <c:numRef>
              <c:f>'PD analysis (Aceton)'!$J$104:$J$327</c:f>
              <c:numCache>
                <c:formatCode>General</c:formatCode>
                <c:ptCount val="224"/>
                <c:pt idx="0">
                  <c:v>3.32884</c:v>
                </c:pt>
                <c:pt idx="1">
                  <c:v>2.8766400000000001</c:v>
                </c:pt>
                <c:pt idx="2">
                  <c:v>2.6321599999999998</c:v>
                </c:pt>
                <c:pt idx="3">
                  <c:v>2.3338999999999999</c:v>
                </c:pt>
                <c:pt idx="4">
                  <c:v>2.17265</c:v>
                </c:pt>
                <c:pt idx="5">
                  <c:v>2.0361199999999999</c:v>
                </c:pt>
                <c:pt idx="6">
                  <c:v>1.8695600000000001</c:v>
                </c:pt>
                <c:pt idx="7">
                  <c:v>1.7795099999999999</c:v>
                </c:pt>
                <c:pt idx="8">
                  <c:v>1.70326</c:v>
                </c:pt>
                <c:pt idx="9">
                  <c:v>1.61025</c:v>
                </c:pt>
                <c:pt idx="10">
                  <c:v>1.55996</c:v>
                </c:pt>
                <c:pt idx="11">
                  <c:v>3.32884</c:v>
                </c:pt>
                <c:pt idx="12">
                  <c:v>2.8766400000000001</c:v>
                </c:pt>
                <c:pt idx="13">
                  <c:v>2.6321599999999998</c:v>
                </c:pt>
                <c:pt idx="14">
                  <c:v>2.3338999999999999</c:v>
                </c:pt>
                <c:pt idx="15">
                  <c:v>2.17265</c:v>
                </c:pt>
                <c:pt idx="16">
                  <c:v>2.0361199999999999</c:v>
                </c:pt>
                <c:pt idx="17">
                  <c:v>1.8695600000000001</c:v>
                </c:pt>
                <c:pt idx="18">
                  <c:v>1.7795099999999999</c:v>
                </c:pt>
                <c:pt idx="19">
                  <c:v>1.70326</c:v>
                </c:pt>
                <c:pt idx="20">
                  <c:v>1.61025</c:v>
                </c:pt>
                <c:pt idx="21">
                  <c:v>1.55996</c:v>
                </c:pt>
                <c:pt idx="22">
                  <c:v>3.32884</c:v>
                </c:pt>
                <c:pt idx="23">
                  <c:v>2.8766400000000001</c:v>
                </c:pt>
                <c:pt idx="24">
                  <c:v>2.6321599999999998</c:v>
                </c:pt>
                <c:pt idx="25">
                  <c:v>2.3338999999999999</c:v>
                </c:pt>
                <c:pt idx="26">
                  <c:v>2.17265</c:v>
                </c:pt>
                <c:pt idx="27">
                  <c:v>2.0361199999999999</c:v>
                </c:pt>
                <c:pt idx="28">
                  <c:v>1.8695600000000001</c:v>
                </c:pt>
                <c:pt idx="29">
                  <c:v>1.7795099999999999</c:v>
                </c:pt>
                <c:pt idx="30">
                  <c:v>1.70326</c:v>
                </c:pt>
                <c:pt idx="31">
                  <c:v>1.61025</c:v>
                </c:pt>
                <c:pt idx="32">
                  <c:v>1.55996</c:v>
                </c:pt>
                <c:pt idx="33">
                  <c:v>3.32884</c:v>
                </c:pt>
                <c:pt idx="34">
                  <c:v>2.8766400000000001</c:v>
                </c:pt>
                <c:pt idx="35">
                  <c:v>2.6321599999999998</c:v>
                </c:pt>
                <c:pt idx="36">
                  <c:v>2.3338999999999999</c:v>
                </c:pt>
                <c:pt idx="37">
                  <c:v>2.17265</c:v>
                </c:pt>
                <c:pt idx="38">
                  <c:v>2.0361199999999999</c:v>
                </c:pt>
                <c:pt idx="39">
                  <c:v>1.8695600000000001</c:v>
                </c:pt>
                <c:pt idx="40">
                  <c:v>1.7795099999999999</c:v>
                </c:pt>
                <c:pt idx="41">
                  <c:v>1.70326</c:v>
                </c:pt>
                <c:pt idx="42">
                  <c:v>1.61025</c:v>
                </c:pt>
                <c:pt idx="43">
                  <c:v>1.55996</c:v>
                </c:pt>
                <c:pt idx="44">
                  <c:v>3.32884</c:v>
                </c:pt>
                <c:pt idx="45">
                  <c:v>3.1310199999999999</c:v>
                </c:pt>
                <c:pt idx="46">
                  <c:v>2.8576000000000001</c:v>
                </c:pt>
                <c:pt idx="47">
                  <c:v>2.8090099999999998</c:v>
                </c:pt>
                <c:pt idx="48">
                  <c:v>2.5937000000000001</c:v>
                </c:pt>
                <c:pt idx="49">
                  <c:v>2.4092600000000002</c:v>
                </c:pt>
                <c:pt idx="50">
                  <c:v>2.4679000000000002</c:v>
                </c:pt>
                <c:pt idx="51">
                  <c:v>2.3097699999999999</c:v>
                </c:pt>
                <c:pt idx="52">
                  <c:v>2.17319</c:v>
                </c:pt>
                <c:pt idx="53">
                  <c:v>2.2893400000000002</c:v>
                </c:pt>
                <c:pt idx="54">
                  <c:v>2.1617799999999998</c:v>
                </c:pt>
                <c:pt idx="55">
                  <c:v>3.32884</c:v>
                </c:pt>
                <c:pt idx="56">
                  <c:v>3.1310199999999999</c:v>
                </c:pt>
                <c:pt idx="57">
                  <c:v>2.8576000000000001</c:v>
                </c:pt>
                <c:pt idx="58">
                  <c:v>2.8090099999999998</c:v>
                </c:pt>
                <c:pt idx="59">
                  <c:v>2.5937000000000001</c:v>
                </c:pt>
                <c:pt idx="60">
                  <c:v>2.4092600000000002</c:v>
                </c:pt>
                <c:pt idx="61">
                  <c:v>2.4679000000000002</c:v>
                </c:pt>
                <c:pt idx="62">
                  <c:v>2.3097699999999999</c:v>
                </c:pt>
                <c:pt idx="63">
                  <c:v>2.17319</c:v>
                </c:pt>
                <c:pt idx="64">
                  <c:v>2.2893400000000002</c:v>
                </c:pt>
                <c:pt idx="65">
                  <c:v>2.1617799999999998</c:v>
                </c:pt>
                <c:pt idx="66">
                  <c:v>3.32884</c:v>
                </c:pt>
                <c:pt idx="67">
                  <c:v>3.1310199999999999</c:v>
                </c:pt>
                <c:pt idx="68">
                  <c:v>2.8576000000000001</c:v>
                </c:pt>
                <c:pt idx="69">
                  <c:v>2.8090099999999998</c:v>
                </c:pt>
                <c:pt idx="70">
                  <c:v>2.5937000000000001</c:v>
                </c:pt>
                <c:pt idx="71">
                  <c:v>2.4092600000000002</c:v>
                </c:pt>
                <c:pt idx="72">
                  <c:v>2.4679000000000002</c:v>
                </c:pt>
                <c:pt idx="73">
                  <c:v>2.3097699999999999</c:v>
                </c:pt>
                <c:pt idx="74">
                  <c:v>2.17319</c:v>
                </c:pt>
                <c:pt idx="75">
                  <c:v>2.2893400000000002</c:v>
                </c:pt>
                <c:pt idx="76">
                  <c:v>2.1617799999999998</c:v>
                </c:pt>
                <c:pt idx="77">
                  <c:v>3.32884</c:v>
                </c:pt>
                <c:pt idx="78">
                  <c:v>3.1310199999999999</c:v>
                </c:pt>
                <c:pt idx="79">
                  <c:v>2.8576000000000001</c:v>
                </c:pt>
                <c:pt idx="80">
                  <c:v>2.8090099999999998</c:v>
                </c:pt>
                <c:pt idx="81">
                  <c:v>2.5937000000000001</c:v>
                </c:pt>
                <c:pt idx="82">
                  <c:v>2.4092600000000002</c:v>
                </c:pt>
                <c:pt idx="83">
                  <c:v>2.4679000000000002</c:v>
                </c:pt>
                <c:pt idx="84">
                  <c:v>2.3097699999999999</c:v>
                </c:pt>
                <c:pt idx="85">
                  <c:v>2.17319</c:v>
                </c:pt>
                <c:pt idx="86">
                  <c:v>2.2893400000000002</c:v>
                </c:pt>
                <c:pt idx="87">
                  <c:v>2.1617799999999998</c:v>
                </c:pt>
                <c:pt idx="88">
                  <c:v>3.32884</c:v>
                </c:pt>
                <c:pt idx="89">
                  <c:v>3.6736200000000001</c:v>
                </c:pt>
                <c:pt idx="90">
                  <c:v>3.33846</c:v>
                </c:pt>
                <c:pt idx="91">
                  <c:v>3.8224499999999999</c:v>
                </c:pt>
                <c:pt idx="92">
                  <c:v>3.4918200000000001</c:v>
                </c:pt>
                <c:pt idx="93">
                  <c:v>3.07647</c:v>
                </c:pt>
                <c:pt idx="94">
                  <c:v>3.7441900000000001</c:v>
                </c:pt>
                <c:pt idx="95">
                  <c:v>3.4408300000000001</c:v>
                </c:pt>
                <c:pt idx="96">
                  <c:v>3.0556399999999999</c:v>
                </c:pt>
                <c:pt idx="97">
                  <c:v>3.7378499999999999</c:v>
                </c:pt>
                <c:pt idx="98">
                  <c:v>3.4454699999999998</c:v>
                </c:pt>
                <c:pt idx="99">
                  <c:v>3.1883499999999998</c:v>
                </c:pt>
                <c:pt idx="100">
                  <c:v>3.32884</c:v>
                </c:pt>
                <c:pt idx="101">
                  <c:v>3.6736200000000001</c:v>
                </c:pt>
                <c:pt idx="102">
                  <c:v>3.33846</c:v>
                </c:pt>
                <c:pt idx="103">
                  <c:v>3.8224499999999999</c:v>
                </c:pt>
                <c:pt idx="104">
                  <c:v>3.4918200000000001</c:v>
                </c:pt>
                <c:pt idx="105">
                  <c:v>3.07647</c:v>
                </c:pt>
                <c:pt idx="106">
                  <c:v>3.7441900000000001</c:v>
                </c:pt>
                <c:pt idx="107">
                  <c:v>3.4408300000000001</c:v>
                </c:pt>
                <c:pt idx="108">
                  <c:v>3.0556399999999999</c:v>
                </c:pt>
                <c:pt idx="109">
                  <c:v>3.7378499999999999</c:v>
                </c:pt>
                <c:pt idx="110">
                  <c:v>3.4454699999999998</c:v>
                </c:pt>
                <c:pt idx="111">
                  <c:v>3.1883499999999998</c:v>
                </c:pt>
                <c:pt idx="112">
                  <c:v>3.32884</c:v>
                </c:pt>
                <c:pt idx="113">
                  <c:v>3.6736200000000001</c:v>
                </c:pt>
                <c:pt idx="114">
                  <c:v>3.33846</c:v>
                </c:pt>
                <c:pt idx="115">
                  <c:v>3.8224499999999999</c:v>
                </c:pt>
                <c:pt idx="116">
                  <c:v>3.4918200000000001</c:v>
                </c:pt>
                <c:pt idx="117">
                  <c:v>3.07647</c:v>
                </c:pt>
                <c:pt idx="118">
                  <c:v>3.7441900000000001</c:v>
                </c:pt>
                <c:pt idx="119">
                  <c:v>3.4408300000000001</c:v>
                </c:pt>
                <c:pt idx="120">
                  <c:v>3.0556399999999999</c:v>
                </c:pt>
                <c:pt idx="121">
                  <c:v>3.7378499999999999</c:v>
                </c:pt>
                <c:pt idx="122">
                  <c:v>3.4454699999999998</c:v>
                </c:pt>
                <c:pt idx="123">
                  <c:v>3.1883499999999998</c:v>
                </c:pt>
                <c:pt idx="124">
                  <c:v>3.32884</c:v>
                </c:pt>
                <c:pt idx="125">
                  <c:v>3.6736200000000001</c:v>
                </c:pt>
                <c:pt idx="126">
                  <c:v>3.33846</c:v>
                </c:pt>
                <c:pt idx="127">
                  <c:v>3.8224499999999999</c:v>
                </c:pt>
                <c:pt idx="128">
                  <c:v>3.4918200000000001</c:v>
                </c:pt>
                <c:pt idx="129">
                  <c:v>3.07647</c:v>
                </c:pt>
                <c:pt idx="130">
                  <c:v>3.7441900000000001</c:v>
                </c:pt>
                <c:pt idx="131">
                  <c:v>3.4408300000000001</c:v>
                </c:pt>
                <c:pt idx="132">
                  <c:v>3.0556399999999999</c:v>
                </c:pt>
                <c:pt idx="133">
                  <c:v>3.7378499999999999</c:v>
                </c:pt>
                <c:pt idx="134">
                  <c:v>3.4454699999999998</c:v>
                </c:pt>
                <c:pt idx="135">
                  <c:v>3.1883499999999998</c:v>
                </c:pt>
                <c:pt idx="136">
                  <c:v>3.32884</c:v>
                </c:pt>
                <c:pt idx="137">
                  <c:v>3.6736200000000001</c:v>
                </c:pt>
                <c:pt idx="138">
                  <c:v>3.33846</c:v>
                </c:pt>
                <c:pt idx="139">
                  <c:v>3.8224499999999999</c:v>
                </c:pt>
                <c:pt idx="140">
                  <c:v>3.4918200000000001</c:v>
                </c:pt>
                <c:pt idx="141">
                  <c:v>3.07647</c:v>
                </c:pt>
                <c:pt idx="142">
                  <c:v>3.7441900000000001</c:v>
                </c:pt>
                <c:pt idx="143">
                  <c:v>3.4408300000000001</c:v>
                </c:pt>
                <c:pt idx="144">
                  <c:v>3.0556399999999999</c:v>
                </c:pt>
                <c:pt idx="145">
                  <c:v>3.7378499999999999</c:v>
                </c:pt>
                <c:pt idx="146">
                  <c:v>3.4454699999999998</c:v>
                </c:pt>
                <c:pt idx="147">
                  <c:v>3.1883499999999998</c:v>
                </c:pt>
                <c:pt idx="148">
                  <c:v>3.32884</c:v>
                </c:pt>
                <c:pt idx="149">
                  <c:v>3.6736200000000001</c:v>
                </c:pt>
                <c:pt idx="150">
                  <c:v>3.33846</c:v>
                </c:pt>
                <c:pt idx="151">
                  <c:v>3.8224499999999999</c:v>
                </c:pt>
                <c:pt idx="152">
                  <c:v>3.4918200000000001</c:v>
                </c:pt>
                <c:pt idx="153">
                  <c:v>3.07647</c:v>
                </c:pt>
                <c:pt idx="154">
                  <c:v>3.7441900000000001</c:v>
                </c:pt>
                <c:pt idx="155">
                  <c:v>3.4408300000000001</c:v>
                </c:pt>
                <c:pt idx="156">
                  <c:v>3.0556399999999999</c:v>
                </c:pt>
                <c:pt idx="157">
                  <c:v>3.7378499999999999</c:v>
                </c:pt>
                <c:pt idx="158">
                  <c:v>3.4454699999999998</c:v>
                </c:pt>
                <c:pt idx="159">
                  <c:v>3.1883499999999998</c:v>
                </c:pt>
                <c:pt idx="160">
                  <c:v>3.32884</c:v>
                </c:pt>
                <c:pt idx="161">
                  <c:v>4.1826499999999998</c:v>
                </c:pt>
                <c:pt idx="162">
                  <c:v>3.7895699999999999</c:v>
                </c:pt>
                <c:pt idx="163">
                  <c:v>4.7731899999999996</c:v>
                </c:pt>
                <c:pt idx="164">
                  <c:v>4.3343800000000003</c:v>
                </c:pt>
                <c:pt idx="165">
                  <c:v>3.7793899999999998</c:v>
                </c:pt>
                <c:pt idx="166">
                  <c:v>4.9415199999999997</c:v>
                </c:pt>
                <c:pt idx="167">
                  <c:v>3.94089</c:v>
                </c:pt>
                <c:pt idx="168">
                  <c:v>5.0967500000000001</c:v>
                </c:pt>
                <c:pt idx="169">
                  <c:v>3.32884</c:v>
                </c:pt>
                <c:pt idx="170">
                  <c:v>4.1826499999999998</c:v>
                </c:pt>
                <c:pt idx="171">
                  <c:v>3.7895699999999999</c:v>
                </c:pt>
                <c:pt idx="172">
                  <c:v>4.7731899999999996</c:v>
                </c:pt>
                <c:pt idx="173">
                  <c:v>4.3343800000000003</c:v>
                </c:pt>
                <c:pt idx="174">
                  <c:v>3.7793899999999998</c:v>
                </c:pt>
                <c:pt idx="175">
                  <c:v>4.9415199999999997</c:v>
                </c:pt>
                <c:pt idx="176">
                  <c:v>3.94089</c:v>
                </c:pt>
                <c:pt idx="177">
                  <c:v>5.0967500000000001</c:v>
                </c:pt>
                <c:pt idx="178">
                  <c:v>3.32884</c:v>
                </c:pt>
                <c:pt idx="179">
                  <c:v>4.1826499999999998</c:v>
                </c:pt>
                <c:pt idx="180">
                  <c:v>3.7895699999999999</c:v>
                </c:pt>
                <c:pt idx="181">
                  <c:v>4.7731899999999996</c:v>
                </c:pt>
                <c:pt idx="182">
                  <c:v>4.3343800000000003</c:v>
                </c:pt>
                <c:pt idx="183">
                  <c:v>3.7793899999999998</c:v>
                </c:pt>
                <c:pt idx="184">
                  <c:v>4.9415199999999997</c:v>
                </c:pt>
                <c:pt idx="185">
                  <c:v>3.94089</c:v>
                </c:pt>
                <c:pt idx="186">
                  <c:v>3.32884</c:v>
                </c:pt>
                <c:pt idx="187">
                  <c:v>4.1826499999999998</c:v>
                </c:pt>
                <c:pt idx="188">
                  <c:v>3.7895699999999999</c:v>
                </c:pt>
                <c:pt idx="189">
                  <c:v>4.7731899999999996</c:v>
                </c:pt>
                <c:pt idx="190">
                  <c:v>4.3343800000000003</c:v>
                </c:pt>
                <c:pt idx="191">
                  <c:v>3.7793899999999998</c:v>
                </c:pt>
                <c:pt idx="192">
                  <c:v>4.9415199999999997</c:v>
                </c:pt>
                <c:pt idx="193">
                  <c:v>3.94089</c:v>
                </c:pt>
                <c:pt idx="194">
                  <c:v>3.32884</c:v>
                </c:pt>
                <c:pt idx="195">
                  <c:v>4.1826499999999998</c:v>
                </c:pt>
                <c:pt idx="196">
                  <c:v>3.7895699999999999</c:v>
                </c:pt>
                <c:pt idx="197">
                  <c:v>4.7731899999999996</c:v>
                </c:pt>
                <c:pt idx="198">
                  <c:v>4.3343800000000003</c:v>
                </c:pt>
                <c:pt idx="199">
                  <c:v>3.7793899999999998</c:v>
                </c:pt>
                <c:pt idx="200">
                  <c:v>4.9415199999999997</c:v>
                </c:pt>
                <c:pt idx="201">
                  <c:v>4.5019200000000001</c:v>
                </c:pt>
                <c:pt idx="202">
                  <c:v>3.94089</c:v>
                </c:pt>
                <c:pt idx="203">
                  <c:v>5.0967500000000001</c:v>
                </c:pt>
                <c:pt idx="204">
                  <c:v>3.32884</c:v>
                </c:pt>
                <c:pt idx="205">
                  <c:v>4.1826499999999998</c:v>
                </c:pt>
                <c:pt idx="206">
                  <c:v>3.7895699999999999</c:v>
                </c:pt>
                <c:pt idx="207">
                  <c:v>4.7731899999999996</c:v>
                </c:pt>
                <c:pt idx="208">
                  <c:v>4.3343800000000003</c:v>
                </c:pt>
                <c:pt idx="209">
                  <c:v>3.7793899999999998</c:v>
                </c:pt>
                <c:pt idx="210">
                  <c:v>4.9415199999999997</c:v>
                </c:pt>
                <c:pt idx="211">
                  <c:v>4.5019200000000001</c:v>
                </c:pt>
                <c:pt idx="212">
                  <c:v>3.94089</c:v>
                </c:pt>
                <c:pt idx="213">
                  <c:v>5.0967500000000001</c:v>
                </c:pt>
                <c:pt idx="214">
                  <c:v>3.32884</c:v>
                </c:pt>
                <c:pt idx="215">
                  <c:v>4.1826499999999998</c:v>
                </c:pt>
                <c:pt idx="216">
                  <c:v>3.7895699999999999</c:v>
                </c:pt>
                <c:pt idx="217">
                  <c:v>4.7731899999999996</c:v>
                </c:pt>
                <c:pt idx="218">
                  <c:v>4.3343800000000003</c:v>
                </c:pt>
                <c:pt idx="219">
                  <c:v>3.7793899999999998</c:v>
                </c:pt>
                <c:pt idx="220">
                  <c:v>4.9415199999999997</c:v>
                </c:pt>
                <c:pt idx="221">
                  <c:v>4.5019200000000001</c:v>
                </c:pt>
                <c:pt idx="222">
                  <c:v>3.94089</c:v>
                </c:pt>
                <c:pt idx="223">
                  <c:v>5.0967500000000001</c:v>
                </c:pt>
              </c:numCache>
            </c:numRef>
          </c:xVal>
          <c:yVal>
            <c:numRef>
              <c:f>'PD analysis (Aceton)'!$L$104:$L$327</c:f>
              <c:numCache>
                <c:formatCode>General</c:formatCode>
                <c:ptCount val="224"/>
                <c:pt idx="0">
                  <c:v>3</c:v>
                </c:pt>
                <c:pt idx="1">
                  <c:v>3.66</c:v>
                </c:pt>
                <c:pt idx="2">
                  <c:v>2</c:v>
                </c:pt>
                <c:pt idx="3">
                  <c:v>3.5</c:v>
                </c:pt>
                <c:pt idx="4">
                  <c:v>1.67</c:v>
                </c:pt>
                <c:pt idx="5">
                  <c:v>1.5</c:v>
                </c:pt>
                <c:pt idx="6">
                  <c:v>1.5</c:v>
                </c:pt>
                <c:pt idx="7">
                  <c:v>2</c:v>
                </c:pt>
                <c:pt idx="8">
                  <c:v>0.66</c:v>
                </c:pt>
                <c:pt idx="9">
                  <c:v>1</c:v>
                </c:pt>
                <c:pt idx="10">
                  <c:v>2</c:v>
                </c:pt>
                <c:pt idx="11">
                  <c:v>3.5</c:v>
                </c:pt>
                <c:pt idx="12">
                  <c:v>2</c:v>
                </c:pt>
                <c:pt idx="13">
                  <c:v>2.83</c:v>
                </c:pt>
                <c:pt idx="14">
                  <c:v>2</c:v>
                </c:pt>
                <c:pt idx="15">
                  <c:v>1.67</c:v>
                </c:pt>
                <c:pt idx="16">
                  <c:v>2</c:v>
                </c:pt>
                <c:pt idx="17">
                  <c:v>2</c:v>
                </c:pt>
                <c:pt idx="18">
                  <c:v>2</c:v>
                </c:pt>
                <c:pt idx="19">
                  <c:v>3</c:v>
                </c:pt>
                <c:pt idx="20">
                  <c:v>3</c:v>
                </c:pt>
                <c:pt idx="21">
                  <c:v>2</c:v>
                </c:pt>
                <c:pt idx="22">
                  <c:v>3</c:v>
                </c:pt>
                <c:pt idx="23">
                  <c:v>3.66</c:v>
                </c:pt>
                <c:pt idx="24">
                  <c:v>2</c:v>
                </c:pt>
                <c:pt idx="25">
                  <c:v>1.67</c:v>
                </c:pt>
                <c:pt idx="26">
                  <c:v>3</c:v>
                </c:pt>
                <c:pt idx="27">
                  <c:v>1.17</c:v>
                </c:pt>
                <c:pt idx="28">
                  <c:v>2</c:v>
                </c:pt>
                <c:pt idx="29">
                  <c:v>1.33</c:v>
                </c:pt>
                <c:pt idx="30">
                  <c:v>1.17</c:v>
                </c:pt>
                <c:pt idx="31">
                  <c:v>1.33</c:v>
                </c:pt>
                <c:pt idx="32">
                  <c:v>1.17</c:v>
                </c:pt>
                <c:pt idx="33">
                  <c:v>3</c:v>
                </c:pt>
                <c:pt idx="34">
                  <c:v>3.66</c:v>
                </c:pt>
                <c:pt idx="35">
                  <c:v>2</c:v>
                </c:pt>
                <c:pt idx="36">
                  <c:v>2</c:v>
                </c:pt>
                <c:pt idx="37">
                  <c:v>2</c:v>
                </c:pt>
                <c:pt idx="38">
                  <c:v>3.66</c:v>
                </c:pt>
                <c:pt idx="39">
                  <c:v>2</c:v>
                </c:pt>
                <c:pt idx="40">
                  <c:v>0.83</c:v>
                </c:pt>
                <c:pt idx="41">
                  <c:v>1</c:v>
                </c:pt>
                <c:pt idx="42">
                  <c:v>1.17</c:v>
                </c:pt>
                <c:pt idx="43">
                  <c:v>1.17</c:v>
                </c:pt>
                <c:pt idx="44">
                  <c:v>3</c:v>
                </c:pt>
                <c:pt idx="45">
                  <c:v>3.66</c:v>
                </c:pt>
                <c:pt idx="46">
                  <c:v>3.16</c:v>
                </c:pt>
                <c:pt idx="47">
                  <c:v>3.5</c:v>
                </c:pt>
                <c:pt idx="48">
                  <c:v>1.67</c:v>
                </c:pt>
                <c:pt idx="49">
                  <c:v>2</c:v>
                </c:pt>
                <c:pt idx="50">
                  <c:v>1.5</c:v>
                </c:pt>
                <c:pt idx="51">
                  <c:v>1.67</c:v>
                </c:pt>
                <c:pt idx="52">
                  <c:v>0.66</c:v>
                </c:pt>
                <c:pt idx="53">
                  <c:v>1.1599999999999999</c:v>
                </c:pt>
                <c:pt idx="54">
                  <c:v>1</c:v>
                </c:pt>
                <c:pt idx="55">
                  <c:v>2</c:v>
                </c:pt>
                <c:pt idx="56">
                  <c:v>3.5</c:v>
                </c:pt>
                <c:pt idx="57">
                  <c:v>2.83</c:v>
                </c:pt>
                <c:pt idx="58">
                  <c:v>2</c:v>
                </c:pt>
                <c:pt idx="59">
                  <c:v>2</c:v>
                </c:pt>
                <c:pt idx="60">
                  <c:v>1.83</c:v>
                </c:pt>
                <c:pt idx="61">
                  <c:v>1.67</c:v>
                </c:pt>
                <c:pt idx="62">
                  <c:v>1.67</c:v>
                </c:pt>
                <c:pt idx="63">
                  <c:v>2</c:v>
                </c:pt>
                <c:pt idx="64">
                  <c:v>2</c:v>
                </c:pt>
                <c:pt idx="65">
                  <c:v>3.5</c:v>
                </c:pt>
                <c:pt idx="66">
                  <c:v>2</c:v>
                </c:pt>
                <c:pt idx="67">
                  <c:v>1.17</c:v>
                </c:pt>
                <c:pt idx="68">
                  <c:v>3.5</c:v>
                </c:pt>
                <c:pt idx="69">
                  <c:v>1.33</c:v>
                </c:pt>
                <c:pt idx="70">
                  <c:v>2</c:v>
                </c:pt>
                <c:pt idx="71">
                  <c:v>1.17</c:v>
                </c:pt>
                <c:pt idx="72">
                  <c:v>2</c:v>
                </c:pt>
                <c:pt idx="73">
                  <c:v>1.33</c:v>
                </c:pt>
                <c:pt idx="74">
                  <c:v>2</c:v>
                </c:pt>
                <c:pt idx="75">
                  <c:v>1.17</c:v>
                </c:pt>
                <c:pt idx="76">
                  <c:v>1.83</c:v>
                </c:pt>
                <c:pt idx="77">
                  <c:v>3</c:v>
                </c:pt>
                <c:pt idx="78">
                  <c:v>3.5</c:v>
                </c:pt>
                <c:pt idx="79">
                  <c:v>0.83</c:v>
                </c:pt>
                <c:pt idx="80">
                  <c:v>2</c:v>
                </c:pt>
                <c:pt idx="81">
                  <c:v>1.67</c:v>
                </c:pt>
                <c:pt idx="82">
                  <c:v>3.5</c:v>
                </c:pt>
                <c:pt idx="83">
                  <c:v>1.17</c:v>
                </c:pt>
                <c:pt idx="84">
                  <c:v>0.83</c:v>
                </c:pt>
                <c:pt idx="85">
                  <c:v>2</c:v>
                </c:pt>
                <c:pt idx="86">
                  <c:v>1.17</c:v>
                </c:pt>
                <c:pt idx="87">
                  <c:v>1.17</c:v>
                </c:pt>
                <c:pt idx="88">
                  <c:v>3.33</c:v>
                </c:pt>
                <c:pt idx="89">
                  <c:v>6.5</c:v>
                </c:pt>
                <c:pt idx="90">
                  <c:v>5.5</c:v>
                </c:pt>
                <c:pt idx="91">
                  <c:v>4</c:v>
                </c:pt>
                <c:pt idx="92">
                  <c:v>4.33</c:v>
                </c:pt>
                <c:pt idx="93">
                  <c:v>4.66</c:v>
                </c:pt>
                <c:pt idx="94">
                  <c:v>4.5</c:v>
                </c:pt>
                <c:pt idx="95">
                  <c:v>3.1659999999999999</c:v>
                </c:pt>
                <c:pt idx="96">
                  <c:v>5.8330000000000002</c:v>
                </c:pt>
                <c:pt idx="97">
                  <c:v>4.25</c:v>
                </c:pt>
                <c:pt idx="98">
                  <c:v>5.1660000000000004</c:v>
                </c:pt>
                <c:pt idx="99">
                  <c:v>5.66</c:v>
                </c:pt>
                <c:pt idx="100">
                  <c:v>4.1660000000000004</c:v>
                </c:pt>
                <c:pt idx="101">
                  <c:v>5.66</c:v>
                </c:pt>
                <c:pt idx="102">
                  <c:v>7.5</c:v>
                </c:pt>
                <c:pt idx="103">
                  <c:v>8.33</c:v>
                </c:pt>
                <c:pt idx="104">
                  <c:v>6</c:v>
                </c:pt>
                <c:pt idx="105">
                  <c:v>4</c:v>
                </c:pt>
                <c:pt idx="106">
                  <c:v>5.8330000000000002</c:v>
                </c:pt>
                <c:pt idx="107">
                  <c:v>5.1660000000000004</c:v>
                </c:pt>
                <c:pt idx="108">
                  <c:v>4.66</c:v>
                </c:pt>
                <c:pt idx="109">
                  <c:v>6.5</c:v>
                </c:pt>
                <c:pt idx="110">
                  <c:v>4.33</c:v>
                </c:pt>
                <c:pt idx="111">
                  <c:v>4.8330000000000002</c:v>
                </c:pt>
                <c:pt idx="112">
                  <c:v>2</c:v>
                </c:pt>
                <c:pt idx="113">
                  <c:v>6.66</c:v>
                </c:pt>
                <c:pt idx="114">
                  <c:v>5.83</c:v>
                </c:pt>
                <c:pt idx="115">
                  <c:v>3.83</c:v>
                </c:pt>
                <c:pt idx="116">
                  <c:v>4.33</c:v>
                </c:pt>
                <c:pt idx="117">
                  <c:v>4.66</c:v>
                </c:pt>
                <c:pt idx="118">
                  <c:v>3.66</c:v>
                </c:pt>
                <c:pt idx="119">
                  <c:v>4.1660000000000004</c:v>
                </c:pt>
                <c:pt idx="120">
                  <c:v>4.33</c:v>
                </c:pt>
                <c:pt idx="121">
                  <c:v>3.75</c:v>
                </c:pt>
                <c:pt idx="122">
                  <c:v>6.33</c:v>
                </c:pt>
                <c:pt idx="123">
                  <c:v>4.83</c:v>
                </c:pt>
                <c:pt idx="124">
                  <c:v>4.5</c:v>
                </c:pt>
                <c:pt idx="125">
                  <c:v>3.5</c:v>
                </c:pt>
                <c:pt idx="126">
                  <c:v>3.5</c:v>
                </c:pt>
                <c:pt idx="127">
                  <c:v>3</c:v>
                </c:pt>
                <c:pt idx="128">
                  <c:v>4.16</c:v>
                </c:pt>
                <c:pt idx="129">
                  <c:v>2.33</c:v>
                </c:pt>
                <c:pt idx="130">
                  <c:v>4</c:v>
                </c:pt>
                <c:pt idx="131">
                  <c:v>2.16</c:v>
                </c:pt>
                <c:pt idx="132">
                  <c:v>4.66</c:v>
                </c:pt>
                <c:pt idx="133">
                  <c:v>1.5</c:v>
                </c:pt>
                <c:pt idx="134">
                  <c:v>3.83</c:v>
                </c:pt>
                <c:pt idx="135">
                  <c:v>2.66</c:v>
                </c:pt>
                <c:pt idx="136">
                  <c:v>4.83</c:v>
                </c:pt>
                <c:pt idx="137">
                  <c:v>4</c:v>
                </c:pt>
                <c:pt idx="138">
                  <c:v>3.5</c:v>
                </c:pt>
                <c:pt idx="139">
                  <c:v>2.5</c:v>
                </c:pt>
                <c:pt idx="140">
                  <c:v>2</c:v>
                </c:pt>
                <c:pt idx="141">
                  <c:v>3.66</c:v>
                </c:pt>
                <c:pt idx="142">
                  <c:v>4.66</c:v>
                </c:pt>
                <c:pt idx="143">
                  <c:v>2.66</c:v>
                </c:pt>
                <c:pt idx="144">
                  <c:v>5</c:v>
                </c:pt>
                <c:pt idx="145">
                  <c:v>1.66</c:v>
                </c:pt>
                <c:pt idx="146">
                  <c:v>2.16</c:v>
                </c:pt>
                <c:pt idx="147">
                  <c:v>2.83</c:v>
                </c:pt>
                <c:pt idx="148">
                  <c:v>3.66</c:v>
                </c:pt>
                <c:pt idx="149">
                  <c:v>5</c:v>
                </c:pt>
                <c:pt idx="150">
                  <c:v>3.66</c:v>
                </c:pt>
                <c:pt idx="151">
                  <c:v>3</c:v>
                </c:pt>
                <c:pt idx="152">
                  <c:v>3</c:v>
                </c:pt>
                <c:pt idx="153">
                  <c:v>3.33</c:v>
                </c:pt>
                <c:pt idx="154">
                  <c:v>3</c:v>
                </c:pt>
                <c:pt idx="155">
                  <c:v>2.33</c:v>
                </c:pt>
                <c:pt idx="156">
                  <c:v>2.16</c:v>
                </c:pt>
                <c:pt idx="157">
                  <c:v>1.5</c:v>
                </c:pt>
                <c:pt idx="158">
                  <c:v>2.16</c:v>
                </c:pt>
                <c:pt idx="159">
                  <c:v>2.83</c:v>
                </c:pt>
                <c:pt idx="160">
                  <c:v>3.6</c:v>
                </c:pt>
                <c:pt idx="161">
                  <c:v>4.66</c:v>
                </c:pt>
                <c:pt idx="162">
                  <c:v>4.66</c:v>
                </c:pt>
                <c:pt idx="163">
                  <c:v>4.66</c:v>
                </c:pt>
                <c:pt idx="164">
                  <c:v>4.8330000000000002</c:v>
                </c:pt>
                <c:pt idx="165">
                  <c:v>4.83</c:v>
                </c:pt>
                <c:pt idx="166">
                  <c:v>3.66</c:v>
                </c:pt>
                <c:pt idx="167">
                  <c:v>4.16</c:v>
                </c:pt>
                <c:pt idx="168">
                  <c:v>4.8330000000000002</c:v>
                </c:pt>
                <c:pt idx="169">
                  <c:v>4.2</c:v>
                </c:pt>
                <c:pt idx="170">
                  <c:v>6.1660000000000004</c:v>
                </c:pt>
                <c:pt idx="171">
                  <c:v>6.83</c:v>
                </c:pt>
                <c:pt idx="172">
                  <c:v>6</c:v>
                </c:pt>
                <c:pt idx="173">
                  <c:v>4.5</c:v>
                </c:pt>
                <c:pt idx="174">
                  <c:v>6.16</c:v>
                </c:pt>
                <c:pt idx="175">
                  <c:v>5.33</c:v>
                </c:pt>
                <c:pt idx="176">
                  <c:v>6.33</c:v>
                </c:pt>
                <c:pt idx="177">
                  <c:v>5.66</c:v>
                </c:pt>
                <c:pt idx="178">
                  <c:v>1.83</c:v>
                </c:pt>
                <c:pt idx="179">
                  <c:v>3.33</c:v>
                </c:pt>
                <c:pt idx="180">
                  <c:v>5.17</c:v>
                </c:pt>
                <c:pt idx="181">
                  <c:v>2.67</c:v>
                </c:pt>
                <c:pt idx="182">
                  <c:v>5</c:v>
                </c:pt>
                <c:pt idx="183">
                  <c:v>4.5</c:v>
                </c:pt>
                <c:pt idx="184">
                  <c:v>4.8</c:v>
                </c:pt>
                <c:pt idx="185">
                  <c:v>5.5</c:v>
                </c:pt>
                <c:pt idx="186">
                  <c:v>1.67</c:v>
                </c:pt>
                <c:pt idx="187">
                  <c:v>3</c:v>
                </c:pt>
                <c:pt idx="188">
                  <c:v>5</c:v>
                </c:pt>
                <c:pt idx="189">
                  <c:v>6</c:v>
                </c:pt>
                <c:pt idx="190">
                  <c:v>4.5</c:v>
                </c:pt>
                <c:pt idx="191">
                  <c:v>5.33</c:v>
                </c:pt>
                <c:pt idx="192">
                  <c:v>5.0999999999999996</c:v>
                </c:pt>
                <c:pt idx="193">
                  <c:v>5.83</c:v>
                </c:pt>
                <c:pt idx="194">
                  <c:v>4</c:v>
                </c:pt>
                <c:pt idx="195">
                  <c:v>7.33</c:v>
                </c:pt>
                <c:pt idx="196">
                  <c:v>4.83</c:v>
                </c:pt>
                <c:pt idx="197">
                  <c:v>3.5</c:v>
                </c:pt>
                <c:pt idx="198">
                  <c:v>5.33</c:v>
                </c:pt>
                <c:pt idx="199">
                  <c:v>4.5</c:v>
                </c:pt>
                <c:pt idx="200">
                  <c:v>6</c:v>
                </c:pt>
                <c:pt idx="201">
                  <c:v>4.66</c:v>
                </c:pt>
                <c:pt idx="202">
                  <c:v>4</c:v>
                </c:pt>
                <c:pt idx="203">
                  <c:v>3.16</c:v>
                </c:pt>
                <c:pt idx="204">
                  <c:v>4</c:v>
                </c:pt>
                <c:pt idx="205">
                  <c:v>6.16</c:v>
                </c:pt>
                <c:pt idx="206">
                  <c:v>4.83</c:v>
                </c:pt>
                <c:pt idx="207">
                  <c:v>4</c:v>
                </c:pt>
                <c:pt idx="208">
                  <c:v>4.33</c:v>
                </c:pt>
                <c:pt idx="209">
                  <c:v>3.66</c:v>
                </c:pt>
                <c:pt idx="210">
                  <c:v>6</c:v>
                </c:pt>
                <c:pt idx="211">
                  <c:v>4.5</c:v>
                </c:pt>
                <c:pt idx="212">
                  <c:v>4.33</c:v>
                </c:pt>
                <c:pt idx="213">
                  <c:v>3.5</c:v>
                </c:pt>
                <c:pt idx="214">
                  <c:v>3</c:v>
                </c:pt>
                <c:pt idx="215">
                  <c:v>6.5</c:v>
                </c:pt>
                <c:pt idx="216">
                  <c:v>5.18</c:v>
                </c:pt>
                <c:pt idx="217">
                  <c:v>2.5</c:v>
                </c:pt>
                <c:pt idx="218">
                  <c:v>3.33</c:v>
                </c:pt>
                <c:pt idx="219">
                  <c:v>5</c:v>
                </c:pt>
                <c:pt idx="220">
                  <c:v>5</c:v>
                </c:pt>
                <c:pt idx="221">
                  <c:v>4.5</c:v>
                </c:pt>
                <c:pt idx="222">
                  <c:v>4.5</c:v>
                </c:pt>
                <c:pt idx="223">
                  <c:v>2.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0A9-4EB0-9165-E4EF9FE9AAAD}"/>
            </c:ext>
          </c:extLst>
        </c:ser>
        <c:ser>
          <c:idx val="1"/>
          <c:order val="1"/>
          <c:spPr>
            <a:ln w="19050">
              <a:noFill/>
            </a:ln>
          </c:spPr>
          <c:marker>
            <c:symbol val="none"/>
          </c:marker>
          <c:trendline>
            <c:spPr>
              <a:ln w="9525"/>
            </c:spPr>
            <c:trendlineType val="linear"/>
            <c:dispRSqr val="0"/>
            <c:dispEq val="0"/>
          </c:trendline>
          <c:xVal>
            <c:numRef>
              <c:f>'　PK  (Pt conc.)'!$AI$39:$AJ$39</c:f>
              <c:numCache>
                <c:formatCode>General</c:formatCode>
                <c:ptCount val="2"/>
                <c:pt idx="0">
                  <c:v>0.01</c:v>
                </c:pt>
                <c:pt idx="1">
                  <c:v>100</c:v>
                </c:pt>
              </c:numCache>
            </c:numRef>
          </c:xVal>
          <c:yVal>
            <c:numRef>
              <c:f>'　PK  (Pt conc.)'!$AI$40:$AJ$40</c:f>
              <c:numCache>
                <c:formatCode>General</c:formatCode>
                <c:ptCount val="2"/>
                <c:pt idx="0">
                  <c:v>0.01</c:v>
                </c:pt>
                <c:pt idx="1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0A9-4EB0-9165-E4EF9FE9AA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582608"/>
        <c:axId val="1675446624"/>
      </c:scatterChart>
      <c:valAx>
        <c:axId val="1980582608"/>
        <c:scaling>
          <c:logBase val="10"/>
          <c:orientation val="minMax"/>
          <c:max val="10"/>
          <c:min val="1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lang="ja-JP" sz="1000" b="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675446624"/>
        <c:crossesAt val="1.0000000000000002E-2"/>
        <c:crossBetween val="midCat"/>
      </c:valAx>
      <c:valAx>
        <c:axId val="1675446624"/>
        <c:scaling>
          <c:logBase val="10"/>
          <c:orientation val="minMax"/>
          <c:max val="10"/>
          <c:min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lang="ja-JP" sz="1000" b="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980582608"/>
        <c:crossesAt val="1.0000000000000002E-2"/>
        <c:crossBetween val="midCat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913650793650794"/>
          <c:y val="5.0926041666666665E-2"/>
          <c:w val="0.79447377017786946"/>
          <c:h val="0.74203667249927097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5"/>
            <c:spPr>
              <a:noFill/>
              <a:ln w="15875">
                <a:solidFill>
                  <a:schemeClr val="tx1"/>
                </a:solidFill>
              </a:ln>
            </c:spPr>
          </c:marker>
          <c:xVal>
            <c:numRef>
              <c:f>'PD analysis (Aceton)'!$H$104:$H$327</c:f>
              <c:numCache>
                <c:formatCode>General</c:formatCode>
                <c:ptCount val="224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  <c:pt idx="11">
                  <c:v>0</c:v>
                </c:pt>
                <c:pt idx="12">
                  <c:v>3</c:v>
                </c:pt>
                <c:pt idx="13">
                  <c:v>5</c:v>
                </c:pt>
                <c:pt idx="14">
                  <c:v>8</c:v>
                </c:pt>
                <c:pt idx="15">
                  <c:v>10</c:v>
                </c:pt>
                <c:pt idx="16">
                  <c:v>12</c:v>
                </c:pt>
                <c:pt idx="17">
                  <c:v>15</c:v>
                </c:pt>
                <c:pt idx="18">
                  <c:v>17</c:v>
                </c:pt>
                <c:pt idx="19">
                  <c:v>19</c:v>
                </c:pt>
                <c:pt idx="20">
                  <c:v>22</c:v>
                </c:pt>
                <c:pt idx="21">
                  <c:v>24</c:v>
                </c:pt>
                <c:pt idx="22">
                  <c:v>0</c:v>
                </c:pt>
                <c:pt idx="23">
                  <c:v>3</c:v>
                </c:pt>
                <c:pt idx="24">
                  <c:v>5</c:v>
                </c:pt>
                <c:pt idx="25">
                  <c:v>8</c:v>
                </c:pt>
                <c:pt idx="26">
                  <c:v>10</c:v>
                </c:pt>
                <c:pt idx="27">
                  <c:v>12</c:v>
                </c:pt>
                <c:pt idx="28">
                  <c:v>15</c:v>
                </c:pt>
                <c:pt idx="29">
                  <c:v>17</c:v>
                </c:pt>
                <c:pt idx="30">
                  <c:v>19</c:v>
                </c:pt>
                <c:pt idx="31">
                  <c:v>22</c:v>
                </c:pt>
                <c:pt idx="32">
                  <c:v>24</c:v>
                </c:pt>
                <c:pt idx="33">
                  <c:v>0</c:v>
                </c:pt>
                <c:pt idx="34">
                  <c:v>3</c:v>
                </c:pt>
                <c:pt idx="35">
                  <c:v>5</c:v>
                </c:pt>
                <c:pt idx="36">
                  <c:v>8</c:v>
                </c:pt>
                <c:pt idx="37">
                  <c:v>10</c:v>
                </c:pt>
                <c:pt idx="38">
                  <c:v>12</c:v>
                </c:pt>
                <c:pt idx="39">
                  <c:v>15</c:v>
                </c:pt>
                <c:pt idx="40">
                  <c:v>17</c:v>
                </c:pt>
                <c:pt idx="41">
                  <c:v>19</c:v>
                </c:pt>
                <c:pt idx="42">
                  <c:v>22</c:v>
                </c:pt>
                <c:pt idx="43">
                  <c:v>24</c:v>
                </c:pt>
                <c:pt idx="44">
                  <c:v>0</c:v>
                </c:pt>
                <c:pt idx="45">
                  <c:v>3</c:v>
                </c:pt>
                <c:pt idx="46">
                  <c:v>5</c:v>
                </c:pt>
                <c:pt idx="47">
                  <c:v>8</c:v>
                </c:pt>
                <c:pt idx="48">
                  <c:v>10</c:v>
                </c:pt>
                <c:pt idx="49">
                  <c:v>12</c:v>
                </c:pt>
                <c:pt idx="50">
                  <c:v>15</c:v>
                </c:pt>
                <c:pt idx="51">
                  <c:v>17</c:v>
                </c:pt>
                <c:pt idx="52">
                  <c:v>19</c:v>
                </c:pt>
                <c:pt idx="53">
                  <c:v>22</c:v>
                </c:pt>
                <c:pt idx="54">
                  <c:v>24</c:v>
                </c:pt>
                <c:pt idx="55">
                  <c:v>0</c:v>
                </c:pt>
                <c:pt idx="56">
                  <c:v>3</c:v>
                </c:pt>
                <c:pt idx="57">
                  <c:v>5</c:v>
                </c:pt>
                <c:pt idx="58">
                  <c:v>8</c:v>
                </c:pt>
                <c:pt idx="59">
                  <c:v>10</c:v>
                </c:pt>
                <c:pt idx="60">
                  <c:v>12</c:v>
                </c:pt>
                <c:pt idx="61">
                  <c:v>15</c:v>
                </c:pt>
                <c:pt idx="62">
                  <c:v>17</c:v>
                </c:pt>
                <c:pt idx="63">
                  <c:v>19</c:v>
                </c:pt>
                <c:pt idx="64">
                  <c:v>22</c:v>
                </c:pt>
                <c:pt idx="65">
                  <c:v>24</c:v>
                </c:pt>
                <c:pt idx="66">
                  <c:v>0</c:v>
                </c:pt>
                <c:pt idx="67">
                  <c:v>3</c:v>
                </c:pt>
                <c:pt idx="68">
                  <c:v>5</c:v>
                </c:pt>
                <c:pt idx="69">
                  <c:v>8</c:v>
                </c:pt>
                <c:pt idx="70">
                  <c:v>10</c:v>
                </c:pt>
                <c:pt idx="71">
                  <c:v>12</c:v>
                </c:pt>
                <c:pt idx="72">
                  <c:v>15</c:v>
                </c:pt>
                <c:pt idx="73">
                  <c:v>17</c:v>
                </c:pt>
                <c:pt idx="74">
                  <c:v>19</c:v>
                </c:pt>
                <c:pt idx="75">
                  <c:v>22</c:v>
                </c:pt>
                <c:pt idx="76">
                  <c:v>24</c:v>
                </c:pt>
                <c:pt idx="77">
                  <c:v>0</c:v>
                </c:pt>
                <c:pt idx="78">
                  <c:v>3</c:v>
                </c:pt>
                <c:pt idx="79">
                  <c:v>5</c:v>
                </c:pt>
                <c:pt idx="80">
                  <c:v>8</c:v>
                </c:pt>
                <c:pt idx="81">
                  <c:v>10</c:v>
                </c:pt>
                <c:pt idx="82">
                  <c:v>12</c:v>
                </c:pt>
                <c:pt idx="83">
                  <c:v>15</c:v>
                </c:pt>
                <c:pt idx="84">
                  <c:v>17</c:v>
                </c:pt>
                <c:pt idx="85">
                  <c:v>19</c:v>
                </c:pt>
                <c:pt idx="86">
                  <c:v>22</c:v>
                </c:pt>
                <c:pt idx="87">
                  <c:v>24</c:v>
                </c:pt>
                <c:pt idx="88">
                  <c:v>0</c:v>
                </c:pt>
                <c:pt idx="89">
                  <c:v>3</c:v>
                </c:pt>
                <c:pt idx="90">
                  <c:v>5</c:v>
                </c:pt>
                <c:pt idx="91">
                  <c:v>8</c:v>
                </c:pt>
                <c:pt idx="92">
                  <c:v>10</c:v>
                </c:pt>
                <c:pt idx="93">
                  <c:v>13</c:v>
                </c:pt>
                <c:pt idx="94">
                  <c:v>15</c:v>
                </c:pt>
                <c:pt idx="95">
                  <c:v>17</c:v>
                </c:pt>
                <c:pt idx="96">
                  <c:v>20</c:v>
                </c:pt>
                <c:pt idx="97">
                  <c:v>22</c:v>
                </c:pt>
                <c:pt idx="98">
                  <c:v>24</c:v>
                </c:pt>
                <c:pt idx="99">
                  <c:v>26</c:v>
                </c:pt>
                <c:pt idx="100">
                  <c:v>0</c:v>
                </c:pt>
                <c:pt idx="101">
                  <c:v>3</c:v>
                </c:pt>
                <c:pt idx="102">
                  <c:v>5</c:v>
                </c:pt>
                <c:pt idx="103">
                  <c:v>8</c:v>
                </c:pt>
                <c:pt idx="104">
                  <c:v>10</c:v>
                </c:pt>
                <c:pt idx="105">
                  <c:v>13</c:v>
                </c:pt>
                <c:pt idx="106">
                  <c:v>15</c:v>
                </c:pt>
                <c:pt idx="107">
                  <c:v>17</c:v>
                </c:pt>
                <c:pt idx="108">
                  <c:v>20</c:v>
                </c:pt>
                <c:pt idx="109">
                  <c:v>22</c:v>
                </c:pt>
                <c:pt idx="110">
                  <c:v>24</c:v>
                </c:pt>
                <c:pt idx="111">
                  <c:v>26</c:v>
                </c:pt>
                <c:pt idx="112">
                  <c:v>0</c:v>
                </c:pt>
                <c:pt idx="113">
                  <c:v>3</c:v>
                </c:pt>
                <c:pt idx="114">
                  <c:v>5</c:v>
                </c:pt>
                <c:pt idx="115">
                  <c:v>8</c:v>
                </c:pt>
                <c:pt idx="116">
                  <c:v>10</c:v>
                </c:pt>
                <c:pt idx="117">
                  <c:v>13</c:v>
                </c:pt>
                <c:pt idx="118">
                  <c:v>15</c:v>
                </c:pt>
                <c:pt idx="119">
                  <c:v>17</c:v>
                </c:pt>
                <c:pt idx="120">
                  <c:v>20</c:v>
                </c:pt>
                <c:pt idx="121">
                  <c:v>22</c:v>
                </c:pt>
                <c:pt idx="122">
                  <c:v>24</c:v>
                </c:pt>
                <c:pt idx="123">
                  <c:v>26</c:v>
                </c:pt>
                <c:pt idx="124">
                  <c:v>0</c:v>
                </c:pt>
                <c:pt idx="125">
                  <c:v>3</c:v>
                </c:pt>
                <c:pt idx="126">
                  <c:v>5</c:v>
                </c:pt>
                <c:pt idx="127">
                  <c:v>8</c:v>
                </c:pt>
                <c:pt idx="128">
                  <c:v>10</c:v>
                </c:pt>
                <c:pt idx="129">
                  <c:v>13</c:v>
                </c:pt>
                <c:pt idx="130">
                  <c:v>15</c:v>
                </c:pt>
                <c:pt idx="131">
                  <c:v>17</c:v>
                </c:pt>
                <c:pt idx="132">
                  <c:v>20</c:v>
                </c:pt>
                <c:pt idx="133">
                  <c:v>22</c:v>
                </c:pt>
                <c:pt idx="134">
                  <c:v>24</c:v>
                </c:pt>
                <c:pt idx="135">
                  <c:v>26</c:v>
                </c:pt>
                <c:pt idx="136">
                  <c:v>0</c:v>
                </c:pt>
                <c:pt idx="137">
                  <c:v>3</c:v>
                </c:pt>
                <c:pt idx="138">
                  <c:v>5</c:v>
                </c:pt>
                <c:pt idx="139">
                  <c:v>8</c:v>
                </c:pt>
                <c:pt idx="140">
                  <c:v>10</c:v>
                </c:pt>
                <c:pt idx="141">
                  <c:v>13</c:v>
                </c:pt>
                <c:pt idx="142">
                  <c:v>15</c:v>
                </c:pt>
                <c:pt idx="143">
                  <c:v>17</c:v>
                </c:pt>
                <c:pt idx="144">
                  <c:v>20</c:v>
                </c:pt>
                <c:pt idx="145">
                  <c:v>22</c:v>
                </c:pt>
                <c:pt idx="146">
                  <c:v>24</c:v>
                </c:pt>
                <c:pt idx="147">
                  <c:v>26</c:v>
                </c:pt>
                <c:pt idx="148">
                  <c:v>0</c:v>
                </c:pt>
                <c:pt idx="149">
                  <c:v>3</c:v>
                </c:pt>
                <c:pt idx="150">
                  <c:v>5</c:v>
                </c:pt>
                <c:pt idx="151">
                  <c:v>8</c:v>
                </c:pt>
                <c:pt idx="152">
                  <c:v>10</c:v>
                </c:pt>
                <c:pt idx="153">
                  <c:v>13</c:v>
                </c:pt>
                <c:pt idx="154">
                  <c:v>15</c:v>
                </c:pt>
                <c:pt idx="155">
                  <c:v>17</c:v>
                </c:pt>
                <c:pt idx="156">
                  <c:v>20</c:v>
                </c:pt>
                <c:pt idx="157">
                  <c:v>22</c:v>
                </c:pt>
                <c:pt idx="158">
                  <c:v>24</c:v>
                </c:pt>
                <c:pt idx="159">
                  <c:v>26</c:v>
                </c:pt>
                <c:pt idx="160">
                  <c:v>0</c:v>
                </c:pt>
                <c:pt idx="161">
                  <c:v>3</c:v>
                </c:pt>
                <c:pt idx="162">
                  <c:v>5</c:v>
                </c:pt>
                <c:pt idx="163">
                  <c:v>8</c:v>
                </c:pt>
                <c:pt idx="164">
                  <c:v>10</c:v>
                </c:pt>
                <c:pt idx="165">
                  <c:v>13</c:v>
                </c:pt>
                <c:pt idx="166">
                  <c:v>15</c:v>
                </c:pt>
                <c:pt idx="167">
                  <c:v>20</c:v>
                </c:pt>
                <c:pt idx="168">
                  <c:v>22</c:v>
                </c:pt>
                <c:pt idx="169">
                  <c:v>0</c:v>
                </c:pt>
                <c:pt idx="170">
                  <c:v>3</c:v>
                </c:pt>
                <c:pt idx="171">
                  <c:v>5</c:v>
                </c:pt>
                <c:pt idx="172">
                  <c:v>8</c:v>
                </c:pt>
                <c:pt idx="173">
                  <c:v>10</c:v>
                </c:pt>
                <c:pt idx="174">
                  <c:v>13</c:v>
                </c:pt>
                <c:pt idx="175">
                  <c:v>15</c:v>
                </c:pt>
                <c:pt idx="176">
                  <c:v>20</c:v>
                </c:pt>
                <c:pt idx="177">
                  <c:v>22</c:v>
                </c:pt>
                <c:pt idx="178">
                  <c:v>0</c:v>
                </c:pt>
                <c:pt idx="179">
                  <c:v>3</c:v>
                </c:pt>
                <c:pt idx="180">
                  <c:v>5</c:v>
                </c:pt>
                <c:pt idx="181">
                  <c:v>8</c:v>
                </c:pt>
                <c:pt idx="182">
                  <c:v>10</c:v>
                </c:pt>
                <c:pt idx="183">
                  <c:v>13</c:v>
                </c:pt>
                <c:pt idx="184">
                  <c:v>15</c:v>
                </c:pt>
                <c:pt idx="185">
                  <c:v>20</c:v>
                </c:pt>
                <c:pt idx="186">
                  <c:v>0</c:v>
                </c:pt>
                <c:pt idx="187">
                  <c:v>3</c:v>
                </c:pt>
                <c:pt idx="188">
                  <c:v>5</c:v>
                </c:pt>
                <c:pt idx="189">
                  <c:v>8</c:v>
                </c:pt>
                <c:pt idx="190">
                  <c:v>10</c:v>
                </c:pt>
                <c:pt idx="191">
                  <c:v>13</c:v>
                </c:pt>
                <c:pt idx="192">
                  <c:v>15</c:v>
                </c:pt>
                <c:pt idx="193">
                  <c:v>20</c:v>
                </c:pt>
                <c:pt idx="194">
                  <c:v>0</c:v>
                </c:pt>
                <c:pt idx="195">
                  <c:v>3</c:v>
                </c:pt>
                <c:pt idx="196">
                  <c:v>5</c:v>
                </c:pt>
                <c:pt idx="197">
                  <c:v>8</c:v>
                </c:pt>
                <c:pt idx="198">
                  <c:v>10</c:v>
                </c:pt>
                <c:pt idx="199">
                  <c:v>13</c:v>
                </c:pt>
                <c:pt idx="200">
                  <c:v>15</c:v>
                </c:pt>
                <c:pt idx="201">
                  <c:v>17</c:v>
                </c:pt>
                <c:pt idx="202">
                  <c:v>20</c:v>
                </c:pt>
                <c:pt idx="203">
                  <c:v>22</c:v>
                </c:pt>
                <c:pt idx="204">
                  <c:v>0</c:v>
                </c:pt>
                <c:pt idx="205">
                  <c:v>3</c:v>
                </c:pt>
                <c:pt idx="206">
                  <c:v>5</c:v>
                </c:pt>
                <c:pt idx="207">
                  <c:v>8</c:v>
                </c:pt>
                <c:pt idx="208">
                  <c:v>10</c:v>
                </c:pt>
                <c:pt idx="209">
                  <c:v>13</c:v>
                </c:pt>
                <c:pt idx="210">
                  <c:v>15</c:v>
                </c:pt>
                <c:pt idx="211">
                  <c:v>17</c:v>
                </c:pt>
                <c:pt idx="212">
                  <c:v>20</c:v>
                </c:pt>
                <c:pt idx="213">
                  <c:v>22</c:v>
                </c:pt>
                <c:pt idx="214">
                  <c:v>0</c:v>
                </c:pt>
                <c:pt idx="215">
                  <c:v>3</c:v>
                </c:pt>
                <c:pt idx="216">
                  <c:v>5</c:v>
                </c:pt>
                <c:pt idx="217">
                  <c:v>8</c:v>
                </c:pt>
                <c:pt idx="218">
                  <c:v>10</c:v>
                </c:pt>
                <c:pt idx="219">
                  <c:v>13</c:v>
                </c:pt>
                <c:pt idx="220">
                  <c:v>15</c:v>
                </c:pt>
                <c:pt idx="221">
                  <c:v>17</c:v>
                </c:pt>
                <c:pt idx="222">
                  <c:v>20</c:v>
                </c:pt>
                <c:pt idx="223">
                  <c:v>22</c:v>
                </c:pt>
              </c:numCache>
            </c:numRef>
          </c:xVal>
          <c:yVal>
            <c:numRef>
              <c:f>'PD analysis (Aceton)'!$R$104:$R$327</c:f>
              <c:numCache>
                <c:formatCode>General</c:formatCode>
                <c:ptCount val="224"/>
                <c:pt idx="0">
                  <c:v>-0.307813</c:v>
                </c:pt>
                <c:pt idx="1">
                  <c:v>0.84853699999999999</c:v>
                </c:pt>
                <c:pt idx="2">
                  <c:v>-0.74836100000000005</c:v>
                </c:pt>
                <c:pt idx="3">
                  <c:v>1.5568599999999999</c:v>
                </c:pt>
                <c:pt idx="4">
                  <c:v>-0.720889</c:v>
                </c:pt>
                <c:pt idx="5">
                  <c:v>-0.82045199999999996</c:v>
                </c:pt>
                <c:pt idx="6">
                  <c:v>-0.61594099999999996</c:v>
                </c:pt>
                <c:pt idx="7">
                  <c:v>0.38609300000000002</c:v>
                </c:pt>
                <c:pt idx="8">
                  <c:v>-1.9085700000000001</c:v>
                </c:pt>
                <c:pt idx="9">
                  <c:v>-1.18089</c:v>
                </c:pt>
                <c:pt idx="10">
                  <c:v>0.87896300000000005</c:v>
                </c:pt>
                <c:pt idx="11">
                  <c:v>0.160217</c:v>
                </c:pt>
                <c:pt idx="12">
                  <c:v>-0.94958200000000004</c:v>
                </c:pt>
                <c:pt idx="13">
                  <c:v>0.234205</c:v>
                </c:pt>
                <c:pt idx="14">
                  <c:v>-0.44579000000000002</c:v>
                </c:pt>
                <c:pt idx="15">
                  <c:v>-0.720889</c:v>
                </c:pt>
                <c:pt idx="16">
                  <c:v>-5.5273200000000001E-2</c:v>
                </c:pt>
                <c:pt idx="17">
                  <c:v>0.21740799999999999</c:v>
                </c:pt>
                <c:pt idx="18">
                  <c:v>0.38609300000000002</c:v>
                </c:pt>
                <c:pt idx="19">
                  <c:v>2.3722799999999999</c:v>
                </c:pt>
                <c:pt idx="20">
                  <c:v>2.6892999999999998</c:v>
                </c:pt>
                <c:pt idx="21">
                  <c:v>0.87896300000000005</c:v>
                </c:pt>
                <c:pt idx="22">
                  <c:v>-0.307813</c:v>
                </c:pt>
                <c:pt idx="23">
                  <c:v>0.84853699999999999</c:v>
                </c:pt>
                <c:pt idx="24">
                  <c:v>-0.74836100000000005</c:v>
                </c:pt>
                <c:pt idx="25">
                  <c:v>-0.88637299999999997</c:v>
                </c:pt>
                <c:pt idx="26">
                  <c:v>1.18659</c:v>
                </c:pt>
                <c:pt idx="27">
                  <c:v>-1.3254699999999999</c:v>
                </c:pt>
                <c:pt idx="28">
                  <c:v>0.21740799999999999</c:v>
                </c:pt>
                <c:pt idx="29">
                  <c:v>-0.78710500000000005</c:v>
                </c:pt>
                <c:pt idx="30">
                  <c:v>-0.97556600000000004</c:v>
                </c:pt>
                <c:pt idx="31">
                  <c:v>-0.54231300000000005</c:v>
                </c:pt>
                <c:pt idx="32">
                  <c:v>-0.77894200000000002</c:v>
                </c:pt>
                <c:pt idx="33">
                  <c:v>-0.307813</c:v>
                </c:pt>
                <c:pt idx="34">
                  <c:v>0.84853699999999999</c:v>
                </c:pt>
                <c:pt idx="35">
                  <c:v>-0.74836100000000005</c:v>
                </c:pt>
                <c:pt idx="36">
                  <c:v>-0.44579000000000002</c:v>
                </c:pt>
                <c:pt idx="37">
                  <c:v>-0.24760599999999999</c:v>
                </c:pt>
                <c:pt idx="38">
                  <c:v>2.4851200000000002</c:v>
                </c:pt>
                <c:pt idx="39">
                  <c:v>0.21740799999999999</c:v>
                </c:pt>
                <c:pt idx="40">
                  <c:v>-1.6626300000000001</c:v>
                </c:pt>
                <c:pt idx="41">
                  <c:v>-1.28657</c:v>
                </c:pt>
                <c:pt idx="42">
                  <c:v>-0.85192800000000002</c:v>
                </c:pt>
                <c:pt idx="43">
                  <c:v>-0.77894200000000002</c:v>
                </c:pt>
                <c:pt idx="44">
                  <c:v>-0.307813</c:v>
                </c:pt>
                <c:pt idx="45">
                  <c:v>0.80189100000000002</c:v>
                </c:pt>
                <c:pt idx="46">
                  <c:v>0.57864599999999999</c:v>
                </c:pt>
                <c:pt idx="47">
                  <c:v>1.43083</c:v>
                </c:pt>
                <c:pt idx="48">
                  <c:v>-0.83134799999999998</c:v>
                </c:pt>
                <c:pt idx="49">
                  <c:v>-0.15817500000000001</c:v>
                </c:pt>
                <c:pt idx="50">
                  <c:v>-0.77626399999999995</c:v>
                </c:pt>
                <c:pt idx="51">
                  <c:v>-0.32992500000000002</c:v>
                </c:pt>
                <c:pt idx="52">
                  <c:v>-1.9968900000000001</c:v>
                </c:pt>
                <c:pt idx="53">
                  <c:v>-0.96342499999999998</c:v>
                </c:pt>
                <c:pt idx="54">
                  <c:v>-1.1568000000000001</c:v>
                </c:pt>
                <c:pt idx="55">
                  <c:v>-1.24387</c:v>
                </c:pt>
                <c:pt idx="56">
                  <c:v>0.309722</c:v>
                </c:pt>
                <c:pt idx="57">
                  <c:v>-0.13056899999999999</c:v>
                </c:pt>
                <c:pt idx="58">
                  <c:v>-0.76444299999999998</c:v>
                </c:pt>
                <c:pt idx="59">
                  <c:v>-0.281551</c:v>
                </c:pt>
                <c:pt idx="60">
                  <c:v>-0.25541799999999998</c:v>
                </c:pt>
                <c:pt idx="61">
                  <c:v>-0.14485999999999999</c:v>
                </c:pt>
                <c:pt idx="62">
                  <c:v>-9.9896299999999993E-3</c:v>
                </c:pt>
                <c:pt idx="63">
                  <c:v>0.53529800000000005</c:v>
                </c:pt>
                <c:pt idx="64">
                  <c:v>0.53523399999999999</c:v>
                </c:pt>
                <c:pt idx="65">
                  <c:v>2.6280399999999999</c:v>
                </c:pt>
                <c:pt idx="66">
                  <c:v>-1.24387</c:v>
                </c:pt>
                <c:pt idx="67">
                  <c:v>-1.8877999999999999</c:v>
                </c:pt>
                <c:pt idx="68">
                  <c:v>0.98231999999999997</c:v>
                </c:pt>
                <c:pt idx="69">
                  <c:v>-1.42208</c:v>
                </c:pt>
                <c:pt idx="70">
                  <c:v>-0.31949699999999998</c:v>
                </c:pt>
                <c:pt idx="71">
                  <c:v>-1.3756200000000001</c:v>
                </c:pt>
                <c:pt idx="72">
                  <c:v>0.126138</c:v>
                </c:pt>
                <c:pt idx="73">
                  <c:v>-0.85047399999999995</c:v>
                </c:pt>
                <c:pt idx="74">
                  <c:v>0.47753699999999999</c:v>
                </c:pt>
                <c:pt idx="75">
                  <c:v>-0.91351099999999996</c:v>
                </c:pt>
                <c:pt idx="76">
                  <c:v>0.47746300000000003</c:v>
                </c:pt>
                <c:pt idx="77">
                  <c:v>-0.307813</c:v>
                </c:pt>
                <c:pt idx="78">
                  <c:v>0.62393799999999999</c:v>
                </c:pt>
                <c:pt idx="79">
                  <c:v>-2.17238</c:v>
                </c:pt>
                <c:pt idx="80">
                  <c:v>-0.53781999999999996</c:v>
                </c:pt>
                <c:pt idx="81">
                  <c:v>-0.79650399999999999</c:v>
                </c:pt>
                <c:pt idx="82">
                  <c:v>2.1412900000000001</c:v>
                </c:pt>
                <c:pt idx="83">
                  <c:v>-1.2990900000000001</c:v>
                </c:pt>
                <c:pt idx="84">
                  <c:v>-1.73027</c:v>
                </c:pt>
                <c:pt idx="85">
                  <c:v>0.47819</c:v>
                </c:pt>
                <c:pt idx="86">
                  <c:v>-0.91202899999999998</c:v>
                </c:pt>
                <c:pt idx="87">
                  <c:v>-0.79144999999999999</c:v>
                </c:pt>
                <c:pt idx="88">
                  <c:v>1.0866300000000001E-3</c:v>
                </c:pt>
                <c:pt idx="89">
                  <c:v>1.84012</c:v>
                </c:pt>
                <c:pt idx="90">
                  <c:v>1.1444399999999999</c:v>
                </c:pt>
                <c:pt idx="91">
                  <c:v>-0.86216300000000001</c:v>
                </c:pt>
                <c:pt idx="92">
                  <c:v>-0.17857000000000001</c:v>
                </c:pt>
                <c:pt idx="93">
                  <c:v>0.503081</c:v>
                </c:pt>
                <c:pt idx="94">
                  <c:v>-0.51429800000000003</c:v>
                </c:pt>
                <c:pt idx="95">
                  <c:v>-0.96262800000000004</c:v>
                </c:pt>
                <c:pt idx="96">
                  <c:v>1.34812</c:v>
                </c:pt>
                <c:pt idx="97">
                  <c:v>-0.65771999999999997</c:v>
                </c:pt>
                <c:pt idx="98">
                  <c:v>0.211668</c:v>
                </c:pt>
                <c:pt idx="99">
                  <c:v>0.80504299999999995</c:v>
                </c:pt>
                <c:pt idx="100">
                  <c:v>0.783632</c:v>
                </c:pt>
                <c:pt idx="101">
                  <c:v>1.28033</c:v>
                </c:pt>
                <c:pt idx="102">
                  <c:v>2.48522</c:v>
                </c:pt>
                <c:pt idx="103">
                  <c:v>0.85064300000000004</c:v>
                </c:pt>
                <c:pt idx="104">
                  <c:v>-0.21254000000000001</c:v>
                </c:pt>
                <c:pt idx="105">
                  <c:v>-0.90247100000000002</c:v>
                </c:pt>
                <c:pt idx="106">
                  <c:v>-0.65333600000000003</c:v>
                </c:pt>
                <c:pt idx="107">
                  <c:v>-0.57203000000000004</c:v>
                </c:pt>
                <c:pt idx="108">
                  <c:v>-0.359539</c:v>
                </c:pt>
                <c:pt idx="109">
                  <c:v>-0.21542800000000001</c:v>
                </c:pt>
                <c:pt idx="110">
                  <c:v>-0.974414</c:v>
                </c:pt>
                <c:pt idx="111">
                  <c:v>-0.34690500000000002</c:v>
                </c:pt>
                <c:pt idx="112">
                  <c:v>-1.24387</c:v>
                </c:pt>
                <c:pt idx="113">
                  <c:v>1.9691700000000001</c:v>
                </c:pt>
                <c:pt idx="114">
                  <c:v>1.39191</c:v>
                </c:pt>
                <c:pt idx="115">
                  <c:v>-1.0588</c:v>
                </c:pt>
                <c:pt idx="116">
                  <c:v>-0.20986099999999999</c:v>
                </c:pt>
                <c:pt idx="117">
                  <c:v>0.49668299999999999</c:v>
                </c:pt>
                <c:pt idx="118">
                  <c:v>-1.0092000000000001</c:v>
                </c:pt>
                <c:pt idx="119">
                  <c:v>-0.27809899999999999</c:v>
                </c:pt>
                <c:pt idx="120">
                  <c:v>0.26440999999999998</c:v>
                </c:pt>
                <c:pt idx="121">
                  <c:v>-0.80981700000000001</c:v>
                </c:pt>
                <c:pt idx="122">
                  <c:v>1.1064700000000001</c:v>
                </c:pt>
                <c:pt idx="123">
                  <c:v>0.31241799999999997</c:v>
                </c:pt>
                <c:pt idx="124">
                  <c:v>1.0962799999999999</c:v>
                </c:pt>
                <c:pt idx="125">
                  <c:v>-0.13197500000000001</c:v>
                </c:pt>
                <c:pt idx="126">
                  <c:v>0.17418800000000001</c:v>
                </c:pt>
                <c:pt idx="127">
                  <c:v>-0.52371100000000004</c:v>
                </c:pt>
                <c:pt idx="128">
                  <c:v>0.79766800000000004</c:v>
                </c:pt>
                <c:pt idx="129">
                  <c:v>-0.68592299999999995</c:v>
                </c:pt>
                <c:pt idx="130">
                  <c:v>0.42426599999999998</c:v>
                </c:pt>
                <c:pt idx="131">
                  <c:v>-1.00512</c:v>
                </c:pt>
                <c:pt idx="132">
                  <c:v>1.9297200000000001</c:v>
                </c:pt>
                <c:pt idx="133">
                  <c:v>-1.8190200000000001</c:v>
                </c:pt>
                <c:pt idx="134">
                  <c:v>0.72937200000000002</c:v>
                </c:pt>
                <c:pt idx="135">
                  <c:v>-0.27023999999999998</c:v>
                </c:pt>
                <c:pt idx="136">
                  <c:v>1.40517</c:v>
                </c:pt>
                <c:pt idx="137">
                  <c:v>0.22176100000000001</c:v>
                </c:pt>
                <c:pt idx="138">
                  <c:v>4.4194400000000002E-2</c:v>
                </c:pt>
                <c:pt idx="139">
                  <c:v>-0.991031</c:v>
                </c:pt>
                <c:pt idx="140">
                  <c:v>-0.83175699999999997</c:v>
                </c:pt>
                <c:pt idx="141">
                  <c:v>1.1511499999999999</c:v>
                </c:pt>
                <c:pt idx="142">
                  <c:v>1.15795</c:v>
                </c:pt>
                <c:pt idx="143">
                  <c:v>-0.54964000000000002</c:v>
                </c:pt>
                <c:pt idx="144">
                  <c:v>2.1786400000000001</c:v>
                </c:pt>
                <c:pt idx="145">
                  <c:v>-1.8238300000000001</c:v>
                </c:pt>
                <c:pt idx="146">
                  <c:v>-0.92377100000000001</c:v>
                </c:pt>
                <c:pt idx="147">
                  <c:v>1.7077700000000001E-2</c:v>
                </c:pt>
                <c:pt idx="148">
                  <c:v>0.30998599999999998</c:v>
                </c:pt>
                <c:pt idx="149">
                  <c:v>0.83620700000000003</c:v>
                </c:pt>
                <c:pt idx="150">
                  <c:v>-0.28589900000000001</c:v>
                </c:pt>
                <c:pt idx="151">
                  <c:v>-1.3208800000000001</c:v>
                </c:pt>
                <c:pt idx="152">
                  <c:v>-0.43526399999999998</c:v>
                </c:pt>
                <c:pt idx="153">
                  <c:v>0.45608599999999999</c:v>
                </c:pt>
                <c:pt idx="154">
                  <c:v>-0.60179800000000006</c:v>
                </c:pt>
                <c:pt idx="155">
                  <c:v>-0.88730799999999999</c:v>
                </c:pt>
                <c:pt idx="156">
                  <c:v>-0.60322699999999996</c:v>
                </c:pt>
                <c:pt idx="157">
                  <c:v>-1.5876999999999999</c:v>
                </c:pt>
                <c:pt idx="158">
                  <c:v>-0.33986</c:v>
                </c:pt>
                <c:pt idx="159">
                  <c:v>0.749305</c:v>
                </c:pt>
                <c:pt idx="160">
                  <c:v>0.25382300000000002</c:v>
                </c:pt>
                <c:pt idx="161">
                  <c:v>0.32592300000000002</c:v>
                </c:pt>
                <c:pt idx="162">
                  <c:v>0.60355099999999995</c:v>
                </c:pt>
                <c:pt idx="163">
                  <c:v>-0.31281100000000001</c:v>
                </c:pt>
                <c:pt idx="164">
                  <c:v>0.169657</c:v>
                </c:pt>
                <c:pt idx="165">
                  <c:v>0.61955300000000002</c:v>
                </c:pt>
                <c:pt idx="166">
                  <c:v>-1.12073</c:v>
                </c:pt>
                <c:pt idx="167">
                  <c:v>4.7502299999999997E-2</c:v>
                </c:pt>
                <c:pt idx="168">
                  <c:v>-0.29888799999999999</c:v>
                </c:pt>
                <c:pt idx="169">
                  <c:v>0.81545800000000002</c:v>
                </c:pt>
                <c:pt idx="170">
                  <c:v>1.12581</c:v>
                </c:pt>
                <c:pt idx="171">
                  <c:v>1.5871500000000001</c:v>
                </c:pt>
                <c:pt idx="172">
                  <c:v>-0.44944000000000001</c:v>
                </c:pt>
                <c:pt idx="173">
                  <c:v>-0.75952699999999995</c:v>
                </c:pt>
                <c:pt idx="174">
                  <c:v>0.76978500000000005</c:v>
                </c:pt>
                <c:pt idx="175">
                  <c:v>-0.79834899999999998</c:v>
                </c:pt>
                <c:pt idx="176">
                  <c:v>0.56907300000000005</c:v>
                </c:pt>
                <c:pt idx="177">
                  <c:v>-0.74143899999999996</c:v>
                </c:pt>
                <c:pt idx="178">
                  <c:v>-1.403</c:v>
                </c:pt>
                <c:pt idx="179">
                  <c:v>-0.54603599999999997</c:v>
                </c:pt>
                <c:pt idx="180">
                  <c:v>1.13913</c:v>
                </c:pt>
                <c:pt idx="181">
                  <c:v>-1.2076899999999999</c:v>
                </c:pt>
                <c:pt idx="182">
                  <c:v>0.70287900000000003</c:v>
                </c:pt>
                <c:pt idx="183">
                  <c:v>0.65114099999999997</c:v>
                </c:pt>
                <c:pt idx="184">
                  <c:v>-6.3992300000000002E-2</c:v>
                </c:pt>
                <c:pt idx="185">
                  <c:v>1.11642</c:v>
                </c:pt>
                <c:pt idx="186">
                  <c:v>-1.55277</c:v>
                </c:pt>
                <c:pt idx="187">
                  <c:v>-0.68357699999999999</c:v>
                </c:pt>
                <c:pt idx="188">
                  <c:v>1.03796</c:v>
                </c:pt>
                <c:pt idx="189">
                  <c:v>0.57226299999999997</c:v>
                </c:pt>
                <c:pt idx="190">
                  <c:v>-0.123608</c:v>
                </c:pt>
                <c:pt idx="191">
                  <c:v>0.85468299999999997</c:v>
                </c:pt>
                <c:pt idx="192">
                  <c:v>-0.34831899999999999</c:v>
                </c:pt>
                <c:pt idx="193">
                  <c:v>0.86964200000000003</c:v>
                </c:pt>
                <c:pt idx="194">
                  <c:v>0.62824599999999997</c:v>
                </c:pt>
                <c:pt idx="195">
                  <c:v>2.0032399999999999</c:v>
                </c:pt>
                <c:pt idx="196">
                  <c:v>0.27704499999999999</c:v>
                </c:pt>
                <c:pt idx="197">
                  <c:v>-1.44095</c:v>
                </c:pt>
                <c:pt idx="198">
                  <c:v>0.28143299999999999</c:v>
                </c:pt>
                <c:pt idx="199">
                  <c:v>0.13321</c:v>
                </c:pt>
                <c:pt idx="200">
                  <c:v>4.6944800000000002E-2</c:v>
                </c:pt>
                <c:pt idx="201">
                  <c:v>-0.43112400000000001</c:v>
                </c:pt>
                <c:pt idx="202">
                  <c:v>-0.39650200000000002</c:v>
                </c:pt>
                <c:pt idx="203">
                  <c:v>-1.47349</c:v>
                </c:pt>
                <c:pt idx="204">
                  <c:v>0.62824599999999997</c:v>
                </c:pt>
                <c:pt idx="205">
                  <c:v>1.33341</c:v>
                </c:pt>
                <c:pt idx="206">
                  <c:v>0.51700900000000005</c:v>
                </c:pt>
                <c:pt idx="207">
                  <c:v>-0.97939299999999996</c:v>
                </c:pt>
                <c:pt idx="208">
                  <c:v>-0.24917800000000001</c:v>
                </c:pt>
                <c:pt idx="209">
                  <c:v>-0.27790599999999999</c:v>
                </c:pt>
                <c:pt idx="210">
                  <c:v>0.42954500000000001</c:v>
                </c:pt>
                <c:pt idx="211">
                  <c:v>-0.27656500000000001</c:v>
                </c:pt>
                <c:pt idx="212">
                  <c:v>7.4106500000000006E-2</c:v>
                </c:pt>
                <c:pt idx="213">
                  <c:v>-1.19353</c:v>
                </c:pt>
                <c:pt idx="214">
                  <c:v>-0.307813</c:v>
                </c:pt>
                <c:pt idx="215">
                  <c:v>1.56071</c:v>
                </c:pt>
                <c:pt idx="216">
                  <c:v>0.73466600000000004</c:v>
                </c:pt>
                <c:pt idx="217">
                  <c:v>-1.93445</c:v>
                </c:pt>
                <c:pt idx="218">
                  <c:v>-0.70859799999999995</c:v>
                </c:pt>
                <c:pt idx="219">
                  <c:v>1.03878</c:v>
                </c:pt>
                <c:pt idx="220">
                  <c:v>-6.7025199999999993E-2</c:v>
                </c:pt>
                <c:pt idx="221">
                  <c:v>-8.6351200000000003E-2</c:v>
                </c:pt>
                <c:pt idx="222">
                  <c:v>0.35382799999999998</c:v>
                </c:pt>
                <c:pt idx="223">
                  <c:v>-1.54441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BE6-4162-95BD-1C4262AE5CE5}"/>
            </c:ext>
          </c:extLst>
        </c:ser>
        <c:ser>
          <c:idx val="1"/>
          <c:order val="1"/>
          <c:spPr>
            <a:ln w="9525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'PD analysis (Aceton)'!$AO$144:$AO$145</c:f>
              <c:numCache>
                <c:formatCode>General</c:formatCode>
                <c:ptCount val="2"/>
                <c:pt idx="0">
                  <c:v>0</c:v>
                </c:pt>
                <c:pt idx="1">
                  <c:v>30</c:v>
                </c:pt>
              </c:numCache>
            </c:numRef>
          </c:xVal>
          <c:yVal>
            <c:numRef>
              <c:f>'PD analysis (Aceton)'!$AP$144:$AP$145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BE6-4162-95BD-1C4262AE5CE5}"/>
            </c:ext>
          </c:extLst>
        </c:ser>
        <c:ser>
          <c:idx val="2"/>
          <c:order val="2"/>
          <c:spPr>
            <a:ln w="9525">
              <a:solidFill>
                <a:schemeClr val="tx1"/>
              </a:solidFill>
              <a:prstDash val="sysDash"/>
            </a:ln>
          </c:spPr>
          <c:marker>
            <c:symbol val="none"/>
          </c:marker>
          <c:xVal>
            <c:numRef>
              <c:f>'PD analysis (Aceton)'!$AO$138:$AO$139</c:f>
              <c:numCache>
                <c:formatCode>General</c:formatCode>
                <c:ptCount val="2"/>
                <c:pt idx="0">
                  <c:v>0</c:v>
                </c:pt>
                <c:pt idx="1">
                  <c:v>30</c:v>
                </c:pt>
              </c:numCache>
            </c:numRef>
          </c:xVal>
          <c:yVal>
            <c:numRef>
              <c:f>'PD analysis (Aceton)'!$AP$138:$AP$139</c:f>
              <c:numCache>
                <c:formatCode>General</c:formatCode>
                <c:ptCount val="2"/>
                <c:pt idx="0">
                  <c:v>2</c:v>
                </c:pt>
                <c:pt idx="1">
                  <c:v>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BE6-4162-95BD-1C4262AE5CE5}"/>
            </c:ext>
          </c:extLst>
        </c:ser>
        <c:ser>
          <c:idx val="3"/>
          <c:order val="3"/>
          <c:spPr>
            <a:ln w="9525">
              <a:solidFill>
                <a:schemeClr val="tx1"/>
              </a:solidFill>
              <a:prstDash val="sysDash"/>
            </a:ln>
          </c:spPr>
          <c:marker>
            <c:symbol val="none"/>
          </c:marker>
          <c:xVal>
            <c:numRef>
              <c:f>'PD analysis (Aceton)'!$AO$141:$AO$142</c:f>
              <c:numCache>
                <c:formatCode>General</c:formatCode>
                <c:ptCount val="2"/>
                <c:pt idx="0">
                  <c:v>0</c:v>
                </c:pt>
                <c:pt idx="1">
                  <c:v>30</c:v>
                </c:pt>
              </c:numCache>
            </c:numRef>
          </c:xVal>
          <c:yVal>
            <c:numRef>
              <c:f>'PD analysis (Aceton)'!$AP$141:$AP$142</c:f>
              <c:numCache>
                <c:formatCode>General</c:formatCode>
                <c:ptCount val="2"/>
                <c:pt idx="0">
                  <c:v>-2</c:v>
                </c:pt>
                <c:pt idx="1">
                  <c:v>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BE6-4162-95BD-1C4262AE5C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448192"/>
        <c:axId val="30453088"/>
      </c:scatterChart>
      <c:valAx>
        <c:axId val="30448192"/>
        <c:scaling>
          <c:orientation val="minMax"/>
          <c:max val="3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30453088"/>
        <c:crossesAt val="-4"/>
        <c:crossBetween val="midCat"/>
        <c:majorUnit val="10"/>
      </c:valAx>
      <c:valAx>
        <c:axId val="30453088"/>
        <c:scaling>
          <c:orientation val="minMax"/>
          <c:min val="-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30448192"/>
        <c:crosses val="autoZero"/>
        <c:crossBetween val="midCat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966070764759556"/>
          <c:y val="5.0925881861406376E-2"/>
          <c:w val="0.79447377017786946"/>
          <c:h val="0.74203667249927097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5"/>
            <c:spPr>
              <a:noFill/>
              <a:ln w="15875">
                <a:solidFill>
                  <a:schemeClr val="tx1"/>
                </a:solidFill>
              </a:ln>
            </c:spPr>
          </c:marker>
          <c:trendline>
            <c:spPr>
              <a:ln>
                <a:noFill/>
              </a:ln>
            </c:spPr>
            <c:trendlineType val="linear"/>
            <c:dispRSqr val="0"/>
            <c:dispEq val="0"/>
          </c:trendline>
          <c:xVal>
            <c:numRef>
              <c:f>'PD analysis (Aceton)'!$K$104:$K$327</c:f>
              <c:numCache>
                <c:formatCode>General</c:formatCode>
                <c:ptCount val="224"/>
                <c:pt idx="0">
                  <c:v>3.32884</c:v>
                </c:pt>
                <c:pt idx="1">
                  <c:v>2.8766400000000001</c:v>
                </c:pt>
                <c:pt idx="2">
                  <c:v>2.6321599999999998</c:v>
                </c:pt>
                <c:pt idx="3">
                  <c:v>2.3338999999999999</c:v>
                </c:pt>
                <c:pt idx="4">
                  <c:v>2.17265</c:v>
                </c:pt>
                <c:pt idx="5">
                  <c:v>2.0361199999999999</c:v>
                </c:pt>
                <c:pt idx="6">
                  <c:v>1.8695600000000001</c:v>
                </c:pt>
                <c:pt idx="7">
                  <c:v>1.7795099999999999</c:v>
                </c:pt>
                <c:pt idx="8">
                  <c:v>1.70326</c:v>
                </c:pt>
                <c:pt idx="9">
                  <c:v>1.61025</c:v>
                </c:pt>
                <c:pt idx="10">
                  <c:v>1.55996</c:v>
                </c:pt>
                <c:pt idx="11">
                  <c:v>3.32884</c:v>
                </c:pt>
                <c:pt idx="12">
                  <c:v>2.8766400000000001</c:v>
                </c:pt>
                <c:pt idx="13">
                  <c:v>2.6321599999999998</c:v>
                </c:pt>
                <c:pt idx="14">
                  <c:v>2.3338999999999999</c:v>
                </c:pt>
                <c:pt idx="15">
                  <c:v>2.17265</c:v>
                </c:pt>
                <c:pt idx="16">
                  <c:v>2.0361199999999999</c:v>
                </c:pt>
                <c:pt idx="17">
                  <c:v>1.8695600000000001</c:v>
                </c:pt>
                <c:pt idx="18">
                  <c:v>1.7795099999999999</c:v>
                </c:pt>
                <c:pt idx="19">
                  <c:v>1.70326</c:v>
                </c:pt>
                <c:pt idx="20">
                  <c:v>1.61025</c:v>
                </c:pt>
                <c:pt idx="21">
                  <c:v>1.55996</c:v>
                </c:pt>
                <c:pt idx="22">
                  <c:v>3.32884</c:v>
                </c:pt>
                <c:pt idx="23">
                  <c:v>2.8766400000000001</c:v>
                </c:pt>
                <c:pt idx="24">
                  <c:v>2.6321599999999998</c:v>
                </c:pt>
                <c:pt idx="25">
                  <c:v>2.3338999999999999</c:v>
                </c:pt>
                <c:pt idx="26">
                  <c:v>2.17265</c:v>
                </c:pt>
                <c:pt idx="27">
                  <c:v>2.0361199999999999</c:v>
                </c:pt>
                <c:pt idx="28">
                  <c:v>1.8695600000000001</c:v>
                </c:pt>
                <c:pt idx="29">
                  <c:v>1.7795099999999999</c:v>
                </c:pt>
                <c:pt idx="30">
                  <c:v>1.70326</c:v>
                </c:pt>
                <c:pt idx="31">
                  <c:v>1.61025</c:v>
                </c:pt>
                <c:pt idx="32">
                  <c:v>1.55996</c:v>
                </c:pt>
                <c:pt idx="33">
                  <c:v>3.32884</c:v>
                </c:pt>
                <c:pt idx="34">
                  <c:v>2.8766400000000001</c:v>
                </c:pt>
                <c:pt idx="35">
                  <c:v>2.6321599999999998</c:v>
                </c:pt>
                <c:pt idx="36">
                  <c:v>2.3338999999999999</c:v>
                </c:pt>
                <c:pt idx="37">
                  <c:v>2.17265</c:v>
                </c:pt>
                <c:pt idx="38">
                  <c:v>2.0361199999999999</c:v>
                </c:pt>
                <c:pt idx="39">
                  <c:v>1.8695600000000001</c:v>
                </c:pt>
                <c:pt idx="40">
                  <c:v>1.7795099999999999</c:v>
                </c:pt>
                <c:pt idx="41">
                  <c:v>1.70326</c:v>
                </c:pt>
                <c:pt idx="42">
                  <c:v>1.61025</c:v>
                </c:pt>
                <c:pt idx="43">
                  <c:v>1.55996</c:v>
                </c:pt>
                <c:pt idx="44">
                  <c:v>3.32884</c:v>
                </c:pt>
                <c:pt idx="45">
                  <c:v>2.8844500000000002</c:v>
                </c:pt>
                <c:pt idx="46">
                  <c:v>2.6390799999999999</c:v>
                </c:pt>
                <c:pt idx="47">
                  <c:v>2.3484799999999999</c:v>
                </c:pt>
                <c:pt idx="48">
                  <c:v>2.1855699999999998</c:v>
                </c:pt>
                <c:pt idx="49">
                  <c:v>2.0475699999999999</c:v>
                </c:pt>
                <c:pt idx="50">
                  <c:v>1.8879300000000001</c:v>
                </c:pt>
                <c:pt idx="51">
                  <c:v>1.7957799999999999</c:v>
                </c:pt>
                <c:pt idx="52">
                  <c:v>1.7176899999999999</c:v>
                </c:pt>
                <c:pt idx="53">
                  <c:v>1.6311</c:v>
                </c:pt>
                <c:pt idx="54">
                  <c:v>1.5784400000000001</c:v>
                </c:pt>
                <c:pt idx="55">
                  <c:v>3.32884</c:v>
                </c:pt>
                <c:pt idx="56">
                  <c:v>3.0632199999999998</c:v>
                </c:pt>
                <c:pt idx="57">
                  <c:v>2.7975099999999999</c:v>
                </c:pt>
                <c:pt idx="58">
                  <c:v>2.6823800000000002</c:v>
                </c:pt>
                <c:pt idx="59">
                  <c:v>2.4814799999999999</c:v>
                </c:pt>
                <c:pt idx="60">
                  <c:v>2.3098100000000001</c:v>
                </c:pt>
                <c:pt idx="61">
                  <c:v>2.3084199999999999</c:v>
                </c:pt>
                <c:pt idx="62">
                  <c:v>2.1684399999999999</c:v>
                </c:pt>
                <c:pt idx="63">
                  <c:v>2.0479400000000001</c:v>
                </c:pt>
                <c:pt idx="64">
                  <c:v>2.1083400000000001</c:v>
                </c:pt>
                <c:pt idx="65">
                  <c:v>2.0013800000000002</c:v>
                </c:pt>
                <c:pt idx="66">
                  <c:v>3.32884</c:v>
                </c:pt>
                <c:pt idx="67">
                  <c:v>2.8854799999999998</c:v>
                </c:pt>
                <c:pt idx="68">
                  <c:v>2.64</c:v>
                </c:pt>
                <c:pt idx="69">
                  <c:v>2.3504100000000001</c:v>
                </c:pt>
                <c:pt idx="70">
                  <c:v>2.1872799999999999</c:v>
                </c:pt>
                <c:pt idx="71">
                  <c:v>2.0490900000000001</c:v>
                </c:pt>
                <c:pt idx="72">
                  <c:v>1.89035</c:v>
                </c:pt>
                <c:pt idx="73">
                  <c:v>1.7979400000000001</c:v>
                </c:pt>
                <c:pt idx="74">
                  <c:v>1.7196</c:v>
                </c:pt>
                <c:pt idx="75">
                  <c:v>1.63385</c:v>
                </c:pt>
                <c:pt idx="76">
                  <c:v>1.5808800000000001</c:v>
                </c:pt>
                <c:pt idx="77">
                  <c:v>3.32884</c:v>
                </c:pt>
                <c:pt idx="78">
                  <c:v>2.88558</c:v>
                </c:pt>
                <c:pt idx="79">
                  <c:v>2.6400800000000002</c:v>
                </c:pt>
                <c:pt idx="80">
                  <c:v>2.3506</c:v>
                </c:pt>
                <c:pt idx="81">
                  <c:v>2.1874400000000001</c:v>
                </c:pt>
                <c:pt idx="82">
                  <c:v>2.0492300000000001</c:v>
                </c:pt>
                <c:pt idx="83">
                  <c:v>1.89059</c:v>
                </c:pt>
                <c:pt idx="84">
                  <c:v>1.7981400000000001</c:v>
                </c:pt>
                <c:pt idx="85">
                  <c:v>1.7197800000000001</c:v>
                </c:pt>
                <c:pt idx="86">
                  <c:v>1.63412</c:v>
                </c:pt>
                <c:pt idx="87">
                  <c:v>1.58111</c:v>
                </c:pt>
                <c:pt idx="88">
                  <c:v>3.32884</c:v>
                </c:pt>
                <c:pt idx="89">
                  <c:v>4.2720599999999997</c:v>
                </c:pt>
                <c:pt idx="90">
                  <c:v>3.8687999999999998</c:v>
                </c:pt>
                <c:pt idx="91">
                  <c:v>4.9401799999999998</c:v>
                </c:pt>
                <c:pt idx="92">
                  <c:v>4.4823599999999999</c:v>
                </c:pt>
                <c:pt idx="93">
                  <c:v>3.9028499999999999</c:v>
                </c:pt>
                <c:pt idx="94">
                  <c:v>5.1518199999999998</c:v>
                </c:pt>
                <c:pt idx="95">
                  <c:v>4.6882900000000003</c:v>
                </c:pt>
                <c:pt idx="96">
                  <c:v>4.0963700000000003</c:v>
                </c:pt>
                <c:pt idx="97">
                  <c:v>5.3354299999999997</c:v>
                </c:pt>
                <c:pt idx="98">
                  <c:v>4.8612700000000002</c:v>
                </c:pt>
                <c:pt idx="99">
                  <c:v>4.4430500000000004</c:v>
                </c:pt>
                <c:pt idx="100">
                  <c:v>3.32884</c:v>
                </c:pt>
                <c:pt idx="101">
                  <c:v>4.6310700000000002</c:v>
                </c:pt>
                <c:pt idx="102">
                  <c:v>4.18696</c:v>
                </c:pt>
                <c:pt idx="103">
                  <c:v>5.6107199999999997</c:v>
                </c:pt>
                <c:pt idx="104">
                  <c:v>5.0766099999999996</c:v>
                </c:pt>
                <c:pt idx="105">
                  <c:v>4.3986200000000002</c:v>
                </c:pt>
                <c:pt idx="106">
                  <c:v>5.9962799999999996</c:v>
                </c:pt>
                <c:pt idx="107">
                  <c:v>5.4366700000000003</c:v>
                </c:pt>
                <c:pt idx="108">
                  <c:v>4.72072</c:v>
                </c:pt>
                <c:pt idx="109">
                  <c:v>6.2938400000000003</c:v>
                </c:pt>
                <c:pt idx="110">
                  <c:v>5.7106300000000001</c:v>
                </c:pt>
                <c:pt idx="111">
                  <c:v>5.1957700000000004</c:v>
                </c:pt>
                <c:pt idx="112">
                  <c:v>3.32884</c:v>
                </c:pt>
                <c:pt idx="113">
                  <c:v>4.2002800000000002</c:v>
                </c:pt>
                <c:pt idx="114">
                  <c:v>3.8051900000000001</c:v>
                </c:pt>
                <c:pt idx="115">
                  <c:v>4.8061100000000003</c:v>
                </c:pt>
                <c:pt idx="116">
                  <c:v>4.36355</c:v>
                </c:pt>
                <c:pt idx="117">
                  <c:v>3.8037299999999998</c:v>
                </c:pt>
                <c:pt idx="118">
                  <c:v>4.9829800000000004</c:v>
                </c:pt>
                <c:pt idx="119">
                  <c:v>4.5386600000000001</c:v>
                </c:pt>
                <c:pt idx="120">
                  <c:v>3.9715400000000001</c:v>
                </c:pt>
                <c:pt idx="121">
                  <c:v>5.1437999999999997</c:v>
                </c:pt>
                <c:pt idx="122">
                  <c:v>4.6914499999999997</c:v>
                </c:pt>
                <c:pt idx="123">
                  <c:v>4.2925500000000003</c:v>
                </c:pt>
                <c:pt idx="124">
                  <c:v>3.32884</c:v>
                </c:pt>
                <c:pt idx="125">
                  <c:v>3.5471200000000001</c:v>
                </c:pt>
                <c:pt idx="126">
                  <c:v>3.2263500000000001</c:v>
                </c:pt>
                <c:pt idx="127">
                  <c:v>3.5861700000000001</c:v>
                </c:pt>
                <c:pt idx="128">
                  <c:v>3.2824300000000002</c:v>
                </c:pt>
                <c:pt idx="129">
                  <c:v>2.90178</c:v>
                </c:pt>
                <c:pt idx="130">
                  <c:v>3.4466299999999999</c:v>
                </c:pt>
                <c:pt idx="131">
                  <c:v>3.17713</c:v>
                </c:pt>
                <c:pt idx="132">
                  <c:v>2.8356499999999998</c:v>
                </c:pt>
                <c:pt idx="133">
                  <c:v>3.4001399999999999</c:v>
                </c:pt>
                <c:pt idx="134">
                  <c:v>3.1461899999999998</c:v>
                </c:pt>
                <c:pt idx="135">
                  <c:v>2.9231199999999999</c:v>
                </c:pt>
                <c:pt idx="136">
                  <c:v>3.32884</c:v>
                </c:pt>
                <c:pt idx="137">
                  <c:v>3.5582199999999999</c:v>
                </c:pt>
                <c:pt idx="138">
                  <c:v>3.2361800000000001</c:v>
                </c:pt>
                <c:pt idx="139">
                  <c:v>3.6069100000000001</c:v>
                </c:pt>
                <c:pt idx="140">
                  <c:v>3.3008000000000002</c:v>
                </c:pt>
                <c:pt idx="141">
                  <c:v>2.9171100000000001</c:v>
                </c:pt>
                <c:pt idx="142">
                  <c:v>3.4727399999999999</c:v>
                </c:pt>
                <c:pt idx="143">
                  <c:v>3.2002700000000002</c:v>
                </c:pt>
                <c:pt idx="144">
                  <c:v>2.8549500000000001</c:v>
                </c:pt>
                <c:pt idx="145">
                  <c:v>3.42977</c:v>
                </c:pt>
                <c:pt idx="146">
                  <c:v>3.17245</c:v>
                </c:pt>
                <c:pt idx="147">
                  <c:v>2.9463900000000001</c:v>
                </c:pt>
                <c:pt idx="148">
                  <c:v>3.32884</c:v>
                </c:pt>
                <c:pt idx="149">
                  <c:v>3.2120099999999998</c:v>
                </c:pt>
                <c:pt idx="150">
                  <c:v>2.92936</c:v>
                </c:pt>
                <c:pt idx="151">
                  <c:v>2.96027</c:v>
                </c:pt>
                <c:pt idx="152">
                  <c:v>2.7277399999999998</c:v>
                </c:pt>
                <c:pt idx="153">
                  <c:v>2.4390200000000002</c:v>
                </c:pt>
                <c:pt idx="154">
                  <c:v>2.6583899999999998</c:v>
                </c:pt>
                <c:pt idx="155">
                  <c:v>2.47858</c:v>
                </c:pt>
                <c:pt idx="156">
                  <c:v>2.2528700000000002</c:v>
                </c:pt>
                <c:pt idx="157">
                  <c:v>2.5055299999999998</c:v>
                </c:pt>
                <c:pt idx="158">
                  <c:v>2.35337</c:v>
                </c:pt>
                <c:pt idx="159">
                  <c:v>2.22052</c:v>
                </c:pt>
                <c:pt idx="160">
                  <c:v>3.32884</c:v>
                </c:pt>
                <c:pt idx="161">
                  <c:v>4.0959300000000001</c:v>
                </c:pt>
                <c:pt idx="162">
                  <c:v>3.71271</c:v>
                </c:pt>
                <c:pt idx="163">
                  <c:v>4.6112099999999998</c:v>
                </c:pt>
                <c:pt idx="164">
                  <c:v>4.1908300000000001</c:v>
                </c:pt>
                <c:pt idx="165">
                  <c:v>3.6596299999999999</c:v>
                </c:pt>
                <c:pt idx="166">
                  <c:v>4.7375299999999996</c:v>
                </c:pt>
                <c:pt idx="167">
                  <c:v>3.79006</c:v>
                </c:pt>
                <c:pt idx="168">
                  <c:v>4.8652300000000004</c:v>
                </c:pt>
                <c:pt idx="169">
                  <c:v>3.32884</c:v>
                </c:pt>
                <c:pt idx="170">
                  <c:v>4.8443500000000004</c:v>
                </c:pt>
                <c:pt idx="171">
                  <c:v>4.3759699999999997</c:v>
                </c:pt>
                <c:pt idx="172">
                  <c:v>6.0090700000000004</c:v>
                </c:pt>
                <c:pt idx="173">
                  <c:v>5.4296300000000004</c:v>
                </c:pt>
                <c:pt idx="174">
                  <c:v>4.69313</c:v>
                </c:pt>
                <c:pt idx="175">
                  <c:v>6.4979399999999998</c:v>
                </c:pt>
                <c:pt idx="176">
                  <c:v>5.0916199999999998</c:v>
                </c:pt>
                <c:pt idx="177">
                  <c:v>6.8632</c:v>
                </c:pt>
                <c:pt idx="178">
                  <c:v>3.32884</c:v>
                </c:pt>
                <c:pt idx="179">
                  <c:v>4.2539899999999999</c:v>
                </c:pt>
                <c:pt idx="180">
                  <c:v>3.8527800000000001</c:v>
                </c:pt>
                <c:pt idx="181">
                  <c:v>4.9064199999999998</c:v>
                </c:pt>
                <c:pt idx="182">
                  <c:v>4.4524499999999998</c:v>
                </c:pt>
                <c:pt idx="183">
                  <c:v>3.8778999999999999</c:v>
                </c:pt>
                <c:pt idx="184">
                  <c:v>5.1093099999999998</c:v>
                </c:pt>
                <c:pt idx="185">
                  <c:v>4.06494</c:v>
                </c:pt>
                <c:pt idx="186">
                  <c:v>3.32884</c:v>
                </c:pt>
                <c:pt idx="187">
                  <c:v>4.4786999999999999</c:v>
                </c:pt>
                <c:pt idx="188">
                  <c:v>4.0519299999999996</c:v>
                </c:pt>
                <c:pt idx="189">
                  <c:v>5.32613</c:v>
                </c:pt>
                <c:pt idx="190">
                  <c:v>4.8243999999999998</c:v>
                </c:pt>
                <c:pt idx="191">
                  <c:v>4.1882000000000001</c:v>
                </c:pt>
                <c:pt idx="192">
                  <c:v>5.6378700000000004</c:v>
                </c:pt>
                <c:pt idx="193">
                  <c:v>4.45573</c:v>
                </c:pt>
                <c:pt idx="194">
                  <c:v>3.32884</c:v>
                </c:pt>
                <c:pt idx="195">
                  <c:v>4.28125</c:v>
                </c:pt>
                <c:pt idx="196">
                  <c:v>3.8769499999999999</c:v>
                </c:pt>
                <c:pt idx="197">
                  <c:v>4.9573499999999999</c:v>
                </c:pt>
                <c:pt idx="198">
                  <c:v>4.4975800000000001</c:v>
                </c:pt>
                <c:pt idx="199">
                  <c:v>3.9155500000000001</c:v>
                </c:pt>
                <c:pt idx="200">
                  <c:v>5.1734499999999999</c:v>
                </c:pt>
                <c:pt idx="201">
                  <c:v>4.7074600000000002</c:v>
                </c:pt>
                <c:pt idx="202">
                  <c:v>4.1123599999999998</c:v>
                </c:pt>
                <c:pt idx="203">
                  <c:v>5.3599699999999997</c:v>
                </c:pt>
                <c:pt idx="204">
                  <c:v>3.32884</c:v>
                </c:pt>
                <c:pt idx="205">
                  <c:v>4.1166</c:v>
                </c:pt>
                <c:pt idx="206">
                  <c:v>3.7310300000000001</c:v>
                </c:pt>
                <c:pt idx="207">
                  <c:v>4.6498299999999997</c:v>
                </c:pt>
                <c:pt idx="208">
                  <c:v>4.2250500000000004</c:v>
                </c:pt>
                <c:pt idx="209">
                  <c:v>3.68818</c:v>
                </c:pt>
                <c:pt idx="210">
                  <c:v>4.7861599999999997</c:v>
                </c:pt>
                <c:pt idx="211">
                  <c:v>4.3642399999999997</c:v>
                </c:pt>
                <c:pt idx="212">
                  <c:v>3.8260200000000002</c:v>
                </c:pt>
                <c:pt idx="213">
                  <c:v>4.9204299999999996</c:v>
                </c:pt>
                <c:pt idx="214">
                  <c:v>3.32884</c:v>
                </c:pt>
                <c:pt idx="215">
                  <c:v>4.11965</c:v>
                </c:pt>
                <c:pt idx="216">
                  <c:v>3.73373</c:v>
                </c:pt>
                <c:pt idx="217">
                  <c:v>4.6555099999999996</c:v>
                </c:pt>
                <c:pt idx="218">
                  <c:v>4.2300899999999997</c:v>
                </c:pt>
                <c:pt idx="219">
                  <c:v>3.6923900000000001</c:v>
                </c:pt>
                <c:pt idx="220">
                  <c:v>4.7933199999999996</c:v>
                </c:pt>
                <c:pt idx="221">
                  <c:v>4.37059</c:v>
                </c:pt>
                <c:pt idx="222">
                  <c:v>3.8313100000000002</c:v>
                </c:pt>
                <c:pt idx="223">
                  <c:v>4.9285500000000004</c:v>
                </c:pt>
              </c:numCache>
            </c:numRef>
          </c:xVal>
          <c:yVal>
            <c:numRef>
              <c:f>'PD analysis (Aceton)'!$L$104:$L$327</c:f>
              <c:numCache>
                <c:formatCode>General</c:formatCode>
                <c:ptCount val="224"/>
                <c:pt idx="0">
                  <c:v>3</c:v>
                </c:pt>
                <c:pt idx="1">
                  <c:v>3.66</c:v>
                </c:pt>
                <c:pt idx="2">
                  <c:v>2</c:v>
                </c:pt>
                <c:pt idx="3">
                  <c:v>3.5</c:v>
                </c:pt>
                <c:pt idx="4">
                  <c:v>1.67</c:v>
                </c:pt>
                <c:pt idx="5">
                  <c:v>1.5</c:v>
                </c:pt>
                <c:pt idx="6">
                  <c:v>1.5</c:v>
                </c:pt>
                <c:pt idx="7">
                  <c:v>2</c:v>
                </c:pt>
                <c:pt idx="8">
                  <c:v>0.66</c:v>
                </c:pt>
                <c:pt idx="9">
                  <c:v>1</c:v>
                </c:pt>
                <c:pt idx="10">
                  <c:v>2</c:v>
                </c:pt>
                <c:pt idx="11">
                  <c:v>3.5</c:v>
                </c:pt>
                <c:pt idx="12">
                  <c:v>2</c:v>
                </c:pt>
                <c:pt idx="13">
                  <c:v>2.83</c:v>
                </c:pt>
                <c:pt idx="14">
                  <c:v>2</c:v>
                </c:pt>
                <c:pt idx="15">
                  <c:v>1.67</c:v>
                </c:pt>
                <c:pt idx="16">
                  <c:v>2</c:v>
                </c:pt>
                <c:pt idx="17">
                  <c:v>2</c:v>
                </c:pt>
                <c:pt idx="18">
                  <c:v>2</c:v>
                </c:pt>
                <c:pt idx="19">
                  <c:v>3</c:v>
                </c:pt>
                <c:pt idx="20">
                  <c:v>3</c:v>
                </c:pt>
                <c:pt idx="21">
                  <c:v>2</c:v>
                </c:pt>
                <c:pt idx="22">
                  <c:v>3</c:v>
                </c:pt>
                <c:pt idx="23">
                  <c:v>3.66</c:v>
                </c:pt>
                <c:pt idx="24">
                  <c:v>2</c:v>
                </c:pt>
                <c:pt idx="25">
                  <c:v>1.67</c:v>
                </c:pt>
                <c:pt idx="26">
                  <c:v>3</c:v>
                </c:pt>
                <c:pt idx="27">
                  <c:v>1.17</c:v>
                </c:pt>
                <c:pt idx="28">
                  <c:v>2</c:v>
                </c:pt>
                <c:pt idx="29">
                  <c:v>1.33</c:v>
                </c:pt>
                <c:pt idx="30">
                  <c:v>1.17</c:v>
                </c:pt>
                <c:pt idx="31">
                  <c:v>1.33</c:v>
                </c:pt>
                <c:pt idx="32">
                  <c:v>1.17</c:v>
                </c:pt>
                <c:pt idx="33">
                  <c:v>3</c:v>
                </c:pt>
                <c:pt idx="34">
                  <c:v>3.66</c:v>
                </c:pt>
                <c:pt idx="35">
                  <c:v>2</c:v>
                </c:pt>
                <c:pt idx="36">
                  <c:v>2</c:v>
                </c:pt>
                <c:pt idx="37">
                  <c:v>2</c:v>
                </c:pt>
                <c:pt idx="38">
                  <c:v>3.66</c:v>
                </c:pt>
                <c:pt idx="39">
                  <c:v>2</c:v>
                </c:pt>
                <c:pt idx="40">
                  <c:v>0.83</c:v>
                </c:pt>
                <c:pt idx="41">
                  <c:v>1</c:v>
                </c:pt>
                <c:pt idx="42">
                  <c:v>1.17</c:v>
                </c:pt>
                <c:pt idx="43">
                  <c:v>1.17</c:v>
                </c:pt>
                <c:pt idx="44">
                  <c:v>3</c:v>
                </c:pt>
                <c:pt idx="45">
                  <c:v>3.66</c:v>
                </c:pt>
                <c:pt idx="46">
                  <c:v>3.16</c:v>
                </c:pt>
                <c:pt idx="47">
                  <c:v>3.5</c:v>
                </c:pt>
                <c:pt idx="48">
                  <c:v>1.67</c:v>
                </c:pt>
                <c:pt idx="49">
                  <c:v>2</c:v>
                </c:pt>
                <c:pt idx="50">
                  <c:v>1.5</c:v>
                </c:pt>
                <c:pt idx="51">
                  <c:v>1.67</c:v>
                </c:pt>
                <c:pt idx="52">
                  <c:v>0.66</c:v>
                </c:pt>
                <c:pt idx="53">
                  <c:v>1.1599999999999999</c:v>
                </c:pt>
                <c:pt idx="54">
                  <c:v>1</c:v>
                </c:pt>
                <c:pt idx="55">
                  <c:v>2</c:v>
                </c:pt>
                <c:pt idx="56">
                  <c:v>3.5</c:v>
                </c:pt>
                <c:pt idx="57">
                  <c:v>2.83</c:v>
                </c:pt>
                <c:pt idx="58">
                  <c:v>2</c:v>
                </c:pt>
                <c:pt idx="59">
                  <c:v>2</c:v>
                </c:pt>
                <c:pt idx="60">
                  <c:v>1.83</c:v>
                </c:pt>
                <c:pt idx="61">
                  <c:v>1.67</c:v>
                </c:pt>
                <c:pt idx="62">
                  <c:v>1.67</c:v>
                </c:pt>
                <c:pt idx="63">
                  <c:v>2</c:v>
                </c:pt>
                <c:pt idx="64">
                  <c:v>2</c:v>
                </c:pt>
                <c:pt idx="65">
                  <c:v>3.5</c:v>
                </c:pt>
                <c:pt idx="66">
                  <c:v>2</c:v>
                </c:pt>
                <c:pt idx="67">
                  <c:v>1.17</c:v>
                </c:pt>
                <c:pt idx="68">
                  <c:v>3.5</c:v>
                </c:pt>
                <c:pt idx="69">
                  <c:v>1.33</c:v>
                </c:pt>
                <c:pt idx="70">
                  <c:v>2</c:v>
                </c:pt>
                <c:pt idx="71">
                  <c:v>1.17</c:v>
                </c:pt>
                <c:pt idx="72">
                  <c:v>2</c:v>
                </c:pt>
                <c:pt idx="73">
                  <c:v>1.33</c:v>
                </c:pt>
                <c:pt idx="74">
                  <c:v>2</c:v>
                </c:pt>
                <c:pt idx="75">
                  <c:v>1.17</c:v>
                </c:pt>
                <c:pt idx="76">
                  <c:v>1.83</c:v>
                </c:pt>
                <c:pt idx="77">
                  <c:v>3</c:v>
                </c:pt>
                <c:pt idx="78">
                  <c:v>3.5</c:v>
                </c:pt>
                <c:pt idx="79">
                  <c:v>0.83</c:v>
                </c:pt>
                <c:pt idx="80">
                  <c:v>2</c:v>
                </c:pt>
                <c:pt idx="81">
                  <c:v>1.67</c:v>
                </c:pt>
                <c:pt idx="82">
                  <c:v>3.5</c:v>
                </c:pt>
                <c:pt idx="83">
                  <c:v>1.17</c:v>
                </c:pt>
                <c:pt idx="84">
                  <c:v>0.83</c:v>
                </c:pt>
                <c:pt idx="85">
                  <c:v>2</c:v>
                </c:pt>
                <c:pt idx="86">
                  <c:v>1.17</c:v>
                </c:pt>
                <c:pt idx="87">
                  <c:v>1.17</c:v>
                </c:pt>
                <c:pt idx="88">
                  <c:v>3.33</c:v>
                </c:pt>
                <c:pt idx="89">
                  <c:v>6.5</c:v>
                </c:pt>
                <c:pt idx="90">
                  <c:v>5.5</c:v>
                </c:pt>
                <c:pt idx="91">
                  <c:v>4</c:v>
                </c:pt>
                <c:pt idx="92">
                  <c:v>4.33</c:v>
                </c:pt>
                <c:pt idx="93">
                  <c:v>4.66</c:v>
                </c:pt>
                <c:pt idx="94">
                  <c:v>4.5</c:v>
                </c:pt>
                <c:pt idx="95">
                  <c:v>3.1659999999999999</c:v>
                </c:pt>
                <c:pt idx="96">
                  <c:v>5.8330000000000002</c:v>
                </c:pt>
                <c:pt idx="97">
                  <c:v>4.25</c:v>
                </c:pt>
                <c:pt idx="98">
                  <c:v>5.1660000000000004</c:v>
                </c:pt>
                <c:pt idx="99">
                  <c:v>5.66</c:v>
                </c:pt>
                <c:pt idx="100">
                  <c:v>4.1660000000000004</c:v>
                </c:pt>
                <c:pt idx="101">
                  <c:v>5.66</c:v>
                </c:pt>
                <c:pt idx="102">
                  <c:v>7.5</c:v>
                </c:pt>
                <c:pt idx="103">
                  <c:v>8.33</c:v>
                </c:pt>
                <c:pt idx="104">
                  <c:v>6</c:v>
                </c:pt>
                <c:pt idx="105">
                  <c:v>4</c:v>
                </c:pt>
                <c:pt idx="106">
                  <c:v>5.8330000000000002</c:v>
                </c:pt>
                <c:pt idx="107">
                  <c:v>5.1660000000000004</c:v>
                </c:pt>
                <c:pt idx="108">
                  <c:v>4.66</c:v>
                </c:pt>
                <c:pt idx="109">
                  <c:v>6.5</c:v>
                </c:pt>
                <c:pt idx="110">
                  <c:v>4.33</c:v>
                </c:pt>
                <c:pt idx="111">
                  <c:v>4.8330000000000002</c:v>
                </c:pt>
                <c:pt idx="112">
                  <c:v>2</c:v>
                </c:pt>
                <c:pt idx="113">
                  <c:v>6.66</c:v>
                </c:pt>
                <c:pt idx="114">
                  <c:v>5.83</c:v>
                </c:pt>
                <c:pt idx="115">
                  <c:v>3.83</c:v>
                </c:pt>
                <c:pt idx="116">
                  <c:v>4.33</c:v>
                </c:pt>
                <c:pt idx="117">
                  <c:v>4.66</c:v>
                </c:pt>
                <c:pt idx="118">
                  <c:v>3.66</c:v>
                </c:pt>
                <c:pt idx="119">
                  <c:v>4.1660000000000004</c:v>
                </c:pt>
                <c:pt idx="120">
                  <c:v>4.33</c:v>
                </c:pt>
                <c:pt idx="121">
                  <c:v>3.75</c:v>
                </c:pt>
                <c:pt idx="122">
                  <c:v>6.33</c:v>
                </c:pt>
                <c:pt idx="123">
                  <c:v>4.83</c:v>
                </c:pt>
                <c:pt idx="124">
                  <c:v>4.5</c:v>
                </c:pt>
                <c:pt idx="125">
                  <c:v>3.5</c:v>
                </c:pt>
                <c:pt idx="126">
                  <c:v>3.5</c:v>
                </c:pt>
                <c:pt idx="127">
                  <c:v>3</c:v>
                </c:pt>
                <c:pt idx="128">
                  <c:v>4.16</c:v>
                </c:pt>
                <c:pt idx="129">
                  <c:v>2.33</c:v>
                </c:pt>
                <c:pt idx="130">
                  <c:v>4</c:v>
                </c:pt>
                <c:pt idx="131">
                  <c:v>2.16</c:v>
                </c:pt>
                <c:pt idx="132">
                  <c:v>4.66</c:v>
                </c:pt>
                <c:pt idx="133">
                  <c:v>1.5</c:v>
                </c:pt>
                <c:pt idx="134">
                  <c:v>3.83</c:v>
                </c:pt>
                <c:pt idx="135">
                  <c:v>2.66</c:v>
                </c:pt>
                <c:pt idx="136">
                  <c:v>4.83</c:v>
                </c:pt>
                <c:pt idx="137">
                  <c:v>4</c:v>
                </c:pt>
                <c:pt idx="138">
                  <c:v>3.5</c:v>
                </c:pt>
                <c:pt idx="139">
                  <c:v>2.5</c:v>
                </c:pt>
                <c:pt idx="140">
                  <c:v>2</c:v>
                </c:pt>
                <c:pt idx="141">
                  <c:v>3.66</c:v>
                </c:pt>
                <c:pt idx="142">
                  <c:v>4.66</c:v>
                </c:pt>
                <c:pt idx="143">
                  <c:v>2.66</c:v>
                </c:pt>
                <c:pt idx="144">
                  <c:v>5</c:v>
                </c:pt>
                <c:pt idx="145">
                  <c:v>1.66</c:v>
                </c:pt>
                <c:pt idx="146">
                  <c:v>2.16</c:v>
                </c:pt>
                <c:pt idx="147">
                  <c:v>2.83</c:v>
                </c:pt>
                <c:pt idx="148">
                  <c:v>3.66</c:v>
                </c:pt>
                <c:pt idx="149">
                  <c:v>5</c:v>
                </c:pt>
                <c:pt idx="150">
                  <c:v>3.66</c:v>
                </c:pt>
                <c:pt idx="151">
                  <c:v>3</c:v>
                </c:pt>
                <c:pt idx="152">
                  <c:v>3</c:v>
                </c:pt>
                <c:pt idx="153">
                  <c:v>3.33</c:v>
                </c:pt>
                <c:pt idx="154">
                  <c:v>3</c:v>
                </c:pt>
                <c:pt idx="155">
                  <c:v>2.33</c:v>
                </c:pt>
                <c:pt idx="156">
                  <c:v>2.16</c:v>
                </c:pt>
                <c:pt idx="157">
                  <c:v>1.5</c:v>
                </c:pt>
                <c:pt idx="158">
                  <c:v>2.16</c:v>
                </c:pt>
                <c:pt idx="159">
                  <c:v>2.83</c:v>
                </c:pt>
                <c:pt idx="160">
                  <c:v>3.6</c:v>
                </c:pt>
                <c:pt idx="161">
                  <c:v>4.66</c:v>
                </c:pt>
                <c:pt idx="162">
                  <c:v>4.66</c:v>
                </c:pt>
                <c:pt idx="163">
                  <c:v>4.66</c:v>
                </c:pt>
                <c:pt idx="164">
                  <c:v>4.8330000000000002</c:v>
                </c:pt>
                <c:pt idx="165">
                  <c:v>4.83</c:v>
                </c:pt>
                <c:pt idx="166">
                  <c:v>3.66</c:v>
                </c:pt>
                <c:pt idx="167">
                  <c:v>4.16</c:v>
                </c:pt>
                <c:pt idx="168">
                  <c:v>4.8330000000000002</c:v>
                </c:pt>
                <c:pt idx="169">
                  <c:v>4.2</c:v>
                </c:pt>
                <c:pt idx="170">
                  <c:v>6.1660000000000004</c:v>
                </c:pt>
                <c:pt idx="171">
                  <c:v>6.83</c:v>
                </c:pt>
                <c:pt idx="172">
                  <c:v>6</c:v>
                </c:pt>
                <c:pt idx="173">
                  <c:v>4.5</c:v>
                </c:pt>
                <c:pt idx="174">
                  <c:v>6.16</c:v>
                </c:pt>
                <c:pt idx="175">
                  <c:v>5.33</c:v>
                </c:pt>
                <c:pt idx="176">
                  <c:v>6.33</c:v>
                </c:pt>
                <c:pt idx="177">
                  <c:v>5.66</c:v>
                </c:pt>
                <c:pt idx="178">
                  <c:v>1.83</c:v>
                </c:pt>
                <c:pt idx="179">
                  <c:v>3.33</c:v>
                </c:pt>
                <c:pt idx="180">
                  <c:v>5.17</c:v>
                </c:pt>
                <c:pt idx="181">
                  <c:v>2.67</c:v>
                </c:pt>
                <c:pt idx="182">
                  <c:v>5</c:v>
                </c:pt>
                <c:pt idx="183">
                  <c:v>4.5</c:v>
                </c:pt>
                <c:pt idx="184">
                  <c:v>4.8</c:v>
                </c:pt>
                <c:pt idx="185">
                  <c:v>5.5</c:v>
                </c:pt>
                <c:pt idx="186">
                  <c:v>1.67</c:v>
                </c:pt>
                <c:pt idx="187">
                  <c:v>3</c:v>
                </c:pt>
                <c:pt idx="188">
                  <c:v>5</c:v>
                </c:pt>
                <c:pt idx="189">
                  <c:v>6</c:v>
                </c:pt>
                <c:pt idx="190">
                  <c:v>4.5</c:v>
                </c:pt>
                <c:pt idx="191">
                  <c:v>5.33</c:v>
                </c:pt>
                <c:pt idx="192">
                  <c:v>5.0999999999999996</c:v>
                </c:pt>
                <c:pt idx="193">
                  <c:v>5.83</c:v>
                </c:pt>
                <c:pt idx="194">
                  <c:v>4</c:v>
                </c:pt>
                <c:pt idx="195">
                  <c:v>7.33</c:v>
                </c:pt>
                <c:pt idx="196">
                  <c:v>4.83</c:v>
                </c:pt>
                <c:pt idx="197">
                  <c:v>3.5</c:v>
                </c:pt>
                <c:pt idx="198">
                  <c:v>5.33</c:v>
                </c:pt>
                <c:pt idx="199">
                  <c:v>4.5</c:v>
                </c:pt>
                <c:pt idx="200">
                  <c:v>6</c:v>
                </c:pt>
                <c:pt idx="201">
                  <c:v>4.66</c:v>
                </c:pt>
                <c:pt idx="202">
                  <c:v>4</c:v>
                </c:pt>
                <c:pt idx="203">
                  <c:v>3.16</c:v>
                </c:pt>
                <c:pt idx="204">
                  <c:v>4</c:v>
                </c:pt>
                <c:pt idx="205">
                  <c:v>6.16</c:v>
                </c:pt>
                <c:pt idx="206">
                  <c:v>4.83</c:v>
                </c:pt>
                <c:pt idx="207">
                  <c:v>4</c:v>
                </c:pt>
                <c:pt idx="208">
                  <c:v>4.33</c:v>
                </c:pt>
                <c:pt idx="209">
                  <c:v>3.66</c:v>
                </c:pt>
                <c:pt idx="210">
                  <c:v>6</c:v>
                </c:pt>
                <c:pt idx="211">
                  <c:v>4.5</c:v>
                </c:pt>
                <c:pt idx="212">
                  <c:v>4.33</c:v>
                </c:pt>
                <c:pt idx="213">
                  <c:v>3.5</c:v>
                </c:pt>
                <c:pt idx="214">
                  <c:v>3</c:v>
                </c:pt>
                <c:pt idx="215">
                  <c:v>6.5</c:v>
                </c:pt>
                <c:pt idx="216">
                  <c:v>5.18</c:v>
                </c:pt>
                <c:pt idx="217">
                  <c:v>2.5</c:v>
                </c:pt>
                <c:pt idx="218">
                  <c:v>3.33</c:v>
                </c:pt>
                <c:pt idx="219">
                  <c:v>5</c:v>
                </c:pt>
                <c:pt idx="220">
                  <c:v>5</c:v>
                </c:pt>
                <c:pt idx="221">
                  <c:v>4.5</c:v>
                </c:pt>
                <c:pt idx="222">
                  <c:v>4.5</c:v>
                </c:pt>
                <c:pt idx="223">
                  <c:v>2.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108-44E0-A46D-EC2925ACD8E9}"/>
            </c:ext>
          </c:extLst>
        </c:ser>
        <c:ser>
          <c:idx val="1"/>
          <c:order val="1"/>
          <c:spPr>
            <a:ln w="19050">
              <a:noFill/>
            </a:ln>
          </c:spPr>
          <c:marker>
            <c:symbol val="none"/>
          </c:marker>
          <c:trendline>
            <c:spPr>
              <a:ln w="9525"/>
            </c:spPr>
            <c:trendlineType val="linear"/>
            <c:dispRSqr val="0"/>
            <c:dispEq val="0"/>
          </c:trendline>
          <c:xVal>
            <c:numRef>
              <c:f>'　PK  (Pt conc.)'!$AI$39:$AJ$39</c:f>
              <c:numCache>
                <c:formatCode>General</c:formatCode>
                <c:ptCount val="2"/>
                <c:pt idx="0">
                  <c:v>0.01</c:v>
                </c:pt>
                <c:pt idx="1">
                  <c:v>100</c:v>
                </c:pt>
              </c:numCache>
            </c:numRef>
          </c:xVal>
          <c:yVal>
            <c:numRef>
              <c:f>'　PK  (Pt conc.)'!$AI$40:$AJ$40</c:f>
              <c:numCache>
                <c:formatCode>General</c:formatCode>
                <c:ptCount val="2"/>
                <c:pt idx="0">
                  <c:v>0.01</c:v>
                </c:pt>
                <c:pt idx="1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108-44E0-A46D-EC2925ACD8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41018048"/>
        <c:axId val="2041016416"/>
      </c:scatterChart>
      <c:valAx>
        <c:axId val="2041018048"/>
        <c:scaling>
          <c:logBase val="10"/>
          <c:orientation val="minMax"/>
          <c:max val="10"/>
          <c:min val="1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2041016416"/>
        <c:crosses val="autoZero"/>
        <c:crossBetween val="midCat"/>
      </c:valAx>
      <c:valAx>
        <c:axId val="2041016416"/>
        <c:scaling>
          <c:logBase val="10"/>
          <c:orientation val="minMax"/>
          <c:max val="10"/>
          <c:min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2041018048"/>
        <c:crossesAt val="1"/>
        <c:crossBetween val="midCat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913650793650794"/>
          <c:y val="5.0926041666666665E-2"/>
          <c:w val="0.79447377017786946"/>
          <c:h val="0.74203667249927097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5"/>
            <c:spPr>
              <a:noFill/>
              <a:ln w="15875">
                <a:solidFill>
                  <a:schemeClr val="tx1"/>
                </a:solidFill>
              </a:ln>
            </c:spPr>
          </c:marker>
          <c:xVal>
            <c:numRef>
              <c:f>'PD analysis (Aceton)'!$J$104:$J$327</c:f>
              <c:numCache>
                <c:formatCode>General</c:formatCode>
                <c:ptCount val="224"/>
                <c:pt idx="0">
                  <c:v>3.32884</c:v>
                </c:pt>
                <c:pt idx="1">
                  <c:v>2.8766400000000001</c:v>
                </c:pt>
                <c:pt idx="2">
                  <c:v>2.6321599999999998</c:v>
                </c:pt>
                <c:pt idx="3">
                  <c:v>2.3338999999999999</c:v>
                </c:pt>
                <c:pt idx="4">
                  <c:v>2.17265</c:v>
                </c:pt>
                <c:pt idx="5">
                  <c:v>2.0361199999999999</c:v>
                </c:pt>
                <c:pt idx="6">
                  <c:v>1.8695600000000001</c:v>
                </c:pt>
                <c:pt idx="7">
                  <c:v>1.7795099999999999</c:v>
                </c:pt>
                <c:pt idx="8">
                  <c:v>1.70326</c:v>
                </c:pt>
                <c:pt idx="9">
                  <c:v>1.61025</c:v>
                </c:pt>
                <c:pt idx="10">
                  <c:v>1.55996</c:v>
                </c:pt>
                <c:pt idx="11">
                  <c:v>3.32884</c:v>
                </c:pt>
                <c:pt idx="12">
                  <c:v>2.8766400000000001</c:v>
                </c:pt>
                <c:pt idx="13">
                  <c:v>2.6321599999999998</c:v>
                </c:pt>
                <c:pt idx="14">
                  <c:v>2.3338999999999999</c:v>
                </c:pt>
                <c:pt idx="15">
                  <c:v>2.17265</c:v>
                </c:pt>
                <c:pt idx="16">
                  <c:v>2.0361199999999999</c:v>
                </c:pt>
                <c:pt idx="17">
                  <c:v>1.8695600000000001</c:v>
                </c:pt>
                <c:pt idx="18">
                  <c:v>1.7795099999999999</c:v>
                </c:pt>
                <c:pt idx="19">
                  <c:v>1.70326</c:v>
                </c:pt>
                <c:pt idx="20">
                  <c:v>1.61025</c:v>
                </c:pt>
                <c:pt idx="21">
                  <c:v>1.55996</c:v>
                </c:pt>
                <c:pt idx="22">
                  <c:v>3.32884</c:v>
                </c:pt>
                <c:pt idx="23">
                  <c:v>2.8766400000000001</c:v>
                </c:pt>
                <c:pt idx="24">
                  <c:v>2.6321599999999998</c:v>
                </c:pt>
                <c:pt idx="25">
                  <c:v>2.3338999999999999</c:v>
                </c:pt>
                <c:pt idx="26">
                  <c:v>2.17265</c:v>
                </c:pt>
                <c:pt idx="27">
                  <c:v>2.0361199999999999</c:v>
                </c:pt>
                <c:pt idx="28">
                  <c:v>1.8695600000000001</c:v>
                </c:pt>
                <c:pt idx="29">
                  <c:v>1.7795099999999999</c:v>
                </c:pt>
                <c:pt idx="30">
                  <c:v>1.70326</c:v>
                </c:pt>
                <c:pt idx="31">
                  <c:v>1.61025</c:v>
                </c:pt>
                <c:pt idx="32">
                  <c:v>1.55996</c:v>
                </c:pt>
                <c:pt idx="33">
                  <c:v>3.32884</c:v>
                </c:pt>
                <c:pt idx="34">
                  <c:v>2.8766400000000001</c:v>
                </c:pt>
                <c:pt idx="35">
                  <c:v>2.6321599999999998</c:v>
                </c:pt>
                <c:pt idx="36">
                  <c:v>2.3338999999999999</c:v>
                </c:pt>
                <c:pt idx="37">
                  <c:v>2.17265</c:v>
                </c:pt>
                <c:pt idx="38">
                  <c:v>2.0361199999999999</c:v>
                </c:pt>
                <c:pt idx="39">
                  <c:v>1.8695600000000001</c:v>
                </c:pt>
                <c:pt idx="40">
                  <c:v>1.7795099999999999</c:v>
                </c:pt>
                <c:pt idx="41">
                  <c:v>1.70326</c:v>
                </c:pt>
                <c:pt idx="42">
                  <c:v>1.61025</c:v>
                </c:pt>
                <c:pt idx="43">
                  <c:v>1.55996</c:v>
                </c:pt>
                <c:pt idx="44">
                  <c:v>3.32884</c:v>
                </c:pt>
                <c:pt idx="45">
                  <c:v>3.1310199999999999</c:v>
                </c:pt>
                <c:pt idx="46">
                  <c:v>2.8576000000000001</c:v>
                </c:pt>
                <c:pt idx="47">
                  <c:v>2.8090099999999998</c:v>
                </c:pt>
                <c:pt idx="48">
                  <c:v>2.5937000000000001</c:v>
                </c:pt>
                <c:pt idx="49">
                  <c:v>2.4092600000000002</c:v>
                </c:pt>
                <c:pt idx="50">
                  <c:v>2.4679000000000002</c:v>
                </c:pt>
                <c:pt idx="51">
                  <c:v>2.3097699999999999</c:v>
                </c:pt>
                <c:pt idx="52">
                  <c:v>2.17319</c:v>
                </c:pt>
                <c:pt idx="53">
                  <c:v>2.2893400000000002</c:v>
                </c:pt>
                <c:pt idx="54">
                  <c:v>2.1617799999999998</c:v>
                </c:pt>
                <c:pt idx="55">
                  <c:v>3.32884</c:v>
                </c:pt>
                <c:pt idx="56">
                  <c:v>3.1310199999999999</c:v>
                </c:pt>
                <c:pt idx="57">
                  <c:v>2.8576000000000001</c:v>
                </c:pt>
                <c:pt idx="58">
                  <c:v>2.8090099999999998</c:v>
                </c:pt>
                <c:pt idx="59">
                  <c:v>2.5937000000000001</c:v>
                </c:pt>
                <c:pt idx="60">
                  <c:v>2.4092600000000002</c:v>
                </c:pt>
                <c:pt idx="61">
                  <c:v>2.4679000000000002</c:v>
                </c:pt>
                <c:pt idx="62">
                  <c:v>2.3097699999999999</c:v>
                </c:pt>
                <c:pt idx="63">
                  <c:v>2.17319</c:v>
                </c:pt>
                <c:pt idx="64">
                  <c:v>2.2893400000000002</c:v>
                </c:pt>
                <c:pt idx="65">
                  <c:v>2.1617799999999998</c:v>
                </c:pt>
                <c:pt idx="66">
                  <c:v>3.32884</c:v>
                </c:pt>
                <c:pt idx="67">
                  <c:v>3.1310199999999999</c:v>
                </c:pt>
                <c:pt idx="68">
                  <c:v>2.8576000000000001</c:v>
                </c:pt>
                <c:pt idx="69">
                  <c:v>2.8090099999999998</c:v>
                </c:pt>
                <c:pt idx="70">
                  <c:v>2.5937000000000001</c:v>
                </c:pt>
                <c:pt idx="71">
                  <c:v>2.4092600000000002</c:v>
                </c:pt>
                <c:pt idx="72">
                  <c:v>2.4679000000000002</c:v>
                </c:pt>
                <c:pt idx="73">
                  <c:v>2.3097699999999999</c:v>
                </c:pt>
                <c:pt idx="74">
                  <c:v>2.17319</c:v>
                </c:pt>
                <c:pt idx="75">
                  <c:v>2.2893400000000002</c:v>
                </c:pt>
                <c:pt idx="76">
                  <c:v>2.1617799999999998</c:v>
                </c:pt>
                <c:pt idx="77">
                  <c:v>3.32884</c:v>
                </c:pt>
                <c:pt idx="78">
                  <c:v>3.1310199999999999</c:v>
                </c:pt>
                <c:pt idx="79">
                  <c:v>2.8576000000000001</c:v>
                </c:pt>
                <c:pt idx="80">
                  <c:v>2.8090099999999998</c:v>
                </c:pt>
                <c:pt idx="81">
                  <c:v>2.5937000000000001</c:v>
                </c:pt>
                <c:pt idx="82">
                  <c:v>2.4092600000000002</c:v>
                </c:pt>
                <c:pt idx="83">
                  <c:v>2.4679000000000002</c:v>
                </c:pt>
                <c:pt idx="84">
                  <c:v>2.3097699999999999</c:v>
                </c:pt>
                <c:pt idx="85">
                  <c:v>2.17319</c:v>
                </c:pt>
                <c:pt idx="86">
                  <c:v>2.2893400000000002</c:v>
                </c:pt>
                <c:pt idx="87">
                  <c:v>2.1617799999999998</c:v>
                </c:pt>
                <c:pt idx="88">
                  <c:v>3.32884</c:v>
                </c:pt>
                <c:pt idx="89">
                  <c:v>3.6736200000000001</c:v>
                </c:pt>
                <c:pt idx="90">
                  <c:v>3.33846</c:v>
                </c:pt>
                <c:pt idx="91">
                  <c:v>3.8224499999999999</c:v>
                </c:pt>
                <c:pt idx="92">
                  <c:v>3.4918200000000001</c:v>
                </c:pt>
                <c:pt idx="93">
                  <c:v>3.07647</c:v>
                </c:pt>
                <c:pt idx="94">
                  <c:v>3.7441900000000001</c:v>
                </c:pt>
                <c:pt idx="95">
                  <c:v>3.4408300000000001</c:v>
                </c:pt>
                <c:pt idx="96">
                  <c:v>3.0556399999999999</c:v>
                </c:pt>
                <c:pt idx="97">
                  <c:v>3.7378499999999999</c:v>
                </c:pt>
                <c:pt idx="98">
                  <c:v>3.4454699999999998</c:v>
                </c:pt>
                <c:pt idx="99">
                  <c:v>3.1883499999999998</c:v>
                </c:pt>
                <c:pt idx="100">
                  <c:v>3.32884</c:v>
                </c:pt>
                <c:pt idx="101">
                  <c:v>3.6736200000000001</c:v>
                </c:pt>
                <c:pt idx="102">
                  <c:v>3.33846</c:v>
                </c:pt>
                <c:pt idx="103">
                  <c:v>3.8224499999999999</c:v>
                </c:pt>
                <c:pt idx="104">
                  <c:v>3.4918200000000001</c:v>
                </c:pt>
                <c:pt idx="105">
                  <c:v>3.07647</c:v>
                </c:pt>
                <c:pt idx="106">
                  <c:v>3.7441900000000001</c:v>
                </c:pt>
                <c:pt idx="107">
                  <c:v>3.4408300000000001</c:v>
                </c:pt>
                <c:pt idx="108">
                  <c:v>3.0556399999999999</c:v>
                </c:pt>
                <c:pt idx="109">
                  <c:v>3.7378499999999999</c:v>
                </c:pt>
                <c:pt idx="110">
                  <c:v>3.4454699999999998</c:v>
                </c:pt>
                <c:pt idx="111">
                  <c:v>3.1883499999999998</c:v>
                </c:pt>
                <c:pt idx="112">
                  <c:v>3.32884</c:v>
                </c:pt>
                <c:pt idx="113">
                  <c:v>3.6736200000000001</c:v>
                </c:pt>
                <c:pt idx="114">
                  <c:v>3.33846</c:v>
                </c:pt>
                <c:pt idx="115">
                  <c:v>3.8224499999999999</c:v>
                </c:pt>
                <c:pt idx="116">
                  <c:v>3.4918200000000001</c:v>
                </c:pt>
                <c:pt idx="117">
                  <c:v>3.07647</c:v>
                </c:pt>
                <c:pt idx="118">
                  <c:v>3.7441900000000001</c:v>
                </c:pt>
                <c:pt idx="119">
                  <c:v>3.4408300000000001</c:v>
                </c:pt>
                <c:pt idx="120">
                  <c:v>3.0556399999999999</c:v>
                </c:pt>
                <c:pt idx="121">
                  <c:v>3.7378499999999999</c:v>
                </c:pt>
                <c:pt idx="122">
                  <c:v>3.4454699999999998</c:v>
                </c:pt>
                <c:pt idx="123">
                  <c:v>3.1883499999999998</c:v>
                </c:pt>
                <c:pt idx="124">
                  <c:v>3.32884</c:v>
                </c:pt>
                <c:pt idx="125">
                  <c:v>3.6736200000000001</c:v>
                </c:pt>
                <c:pt idx="126">
                  <c:v>3.33846</c:v>
                </c:pt>
                <c:pt idx="127">
                  <c:v>3.8224499999999999</c:v>
                </c:pt>
                <c:pt idx="128">
                  <c:v>3.4918200000000001</c:v>
                </c:pt>
                <c:pt idx="129">
                  <c:v>3.07647</c:v>
                </c:pt>
                <c:pt idx="130">
                  <c:v>3.7441900000000001</c:v>
                </c:pt>
                <c:pt idx="131">
                  <c:v>3.4408300000000001</c:v>
                </c:pt>
                <c:pt idx="132">
                  <c:v>3.0556399999999999</c:v>
                </c:pt>
                <c:pt idx="133">
                  <c:v>3.7378499999999999</c:v>
                </c:pt>
                <c:pt idx="134">
                  <c:v>3.4454699999999998</c:v>
                </c:pt>
                <c:pt idx="135">
                  <c:v>3.1883499999999998</c:v>
                </c:pt>
                <c:pt idx="136">
                  <c:v>3.32884</c:v>
                </c:pt>
                <c:pt idx="137">
                  <c:v>3.6736200000000001</c:v>
                </c:pt>
                <c:pt idx="138">
                  <c:v>3.33846</c:v>
                </c:pt>
                <c:pt idx="139">
                  <c:v>3.8224499999999999</c:v>
                </c:pt>
                <c:pt idx="140">
                  <c:v>3.4918200000000001</c:v>
                </c:pt>
                <c:pt idx="141">
                  <c:v>3.07647</c:v>
                </c:pt>
                <c:pt idx="142">
                  <c:v>3.7441900000000001</c:v>
                </c:pt>
                <c:pt idx="143">
                  <c:v>3.4408300000000001</c:v>
                </c:pt>
                <c:pt idx="144">
                  <c:v>3.0556399999999999</c:v>
                </c:pt>
                <c:pt idx="145">
                  <c:v>3.7378499999999999</c:v>
                </c:pt>
                <c:pt idx="146">
                  <c:v>3.4454699999999998</c:v>
                </c:pt>
                <c:pt idx="147">
                  <c:v>3.1883499999999998</c:v>
                </c:pt>
                <c:pt idx="148">
                  <c:v>3.32884</c:v>
                </c:pt>
                <c:pt idx="149">
                  <c:v>3.6736200000000001</c:v>
                </c:pt>
                <c:pt idx="150">
                  <c:v>3.33846</c:v>
                </c:pt>
                <c:pt idx="151">
                  <c:v>3.8224499999999999</c:v>
                </c:pt>
                <c:pt idx="152">
                  <c:v>3.4918200000000001</c:v>
                </c:pt>
                <c:pt idx="153">
                  <c:v>3.07647</c:v>
                </c:pt>
                <c:pt idx="154">
                  <c:v>3.7441900000000001</c:v>
                </c:pt>
                <c:pt idx="155">
                  <c:v>3.4408300000000001</c:v>
                </c:pt>
                <c:pt idx="156">
                  <c:v>3.0556399999999999</c:v>
                </c:pt>
                <c:pt idx="157">
                  <c:v>3.7378499999999999</c:v>
                </c:pt>
                <c:pt idx="158">
                  <c:v>3.4454699999999998</c:v>
                </c:pt>
                <c:pt idx="159">
                  <c:v>3.1883499999999998</c:v>
                </c:pt>
                <c:pt idx="160">
                  <c:v>3.32884</c:v>
                </c:pt>
                <c:pt idx="161">
                  <c:v>4.1826499999999998</c:v>
                </c:pt>
                <c:pt idx="162">
                  <c:v>3.7895699999999999</c:v>
                </c:pt>
                <c:pt idx="163">
                  <c:v>4.7731899999999996</c:v>
                </c:pt>
                <c:pt idx="164">
                  <c:v>4.3343800000000003</c:v>
                </c:pt>
                <c:pt idx="165">
                  <c:v>3.7793899999999998</c:v>
                </c:pt>
                <c:pt idx="166">
                  <c:v>4.9415199999999997</c:v>
                </c:pt>
                <c:pt idx="167">
                  <c:v>3.94089</c:v>
                </c:pt>
                <c:pt idx="168">
                  <c:v>5.0967500000000001</c:v>
                </c:pt>
                <c:pt idx="169">
                  <c:v>3.32884</c:v>
                </c:pt>
                <c:pt idx="170">
                  <c:v>4.1826499999999998</c:v>
                </c:pt>
                <c:pt idx="171">
                  <c:v>3.7895699999999999</c:v>
                </c:pt>
                <c:pt idx="172">
                  <c:v>4.7731899999999996</c:v>
                </c:pt>
                <c:pt idx="173">
                  <c:v>4.3343800000000003</c:v>
                </c:pt>
                <c:pt idx="174">
                  <c:v>3.7793899999999998</c:v>
                </c:pt>
                <c:pt idx="175">
                  <c:v>4.9415199999999997</c:v>
                </c:pt>
                <c:pt idx="176">
                  <c:v>3.94089</c:v>
                </c:pt>
                <c:pt idx="177">
                  <c:v>5.0967500000000001</c:v>
                </c:pt>
                <c:pt idx="178">
                  <c:v>3.32884</c:v>
                </c:pt>
                <c:pt idx="179">
                  <c:v>4.1826499999999998</c:v>
                </c:pt>
                <c:pt idx="180">
                  <c:v>3.7895699999999999</c:v>
                </c:pt>
                <c:pt idx="181">
                  <c:v>4.7731899999999996</c:v>
                </c:pt>
                <c:pt idx="182">
                  <c:v>4.3343800000000003</c:v>
                </c:pt>
                <c:pt idx="183">
                  <c:v>3.7793899999999998</c:v>
                </c:pt>
                <c:pt idx="184">
                  <c:v>4.9415199999999997</c:v>
                </c:pt>
                <c:pt idx="185">
                  <c:v>3.94089</c:v>
                </c:pt>
                <c:pt idx="186">
                  <c:v>3.32884</c:v>
                </c:pt>
                <c:pt idx="187">
                  <c:v>4.1826499999999998</c:v>
                </c:pt>
                <c:pt idx="188">
                  <c:v>3.7895699999999999</c:v>
                </c:pt>
                <c:pt idx="189">
                  <c:v>4.7731899999999996</c:v>
                </c:pt>
                <c:pt idx="190">
                  <c:v>4.3343800000000003</c:v>
                </c:pt>
                <c:pt idx="191">
                  <c:v>3.7793899999999998</c:v>
                </c:pt>
                <c:pt idx="192">
                  <c:v>4.9415199999999997</c:v>
                </c:pt>
                <c:pt idx="193">
                  <c:v>3.94089</c:v>
                </c:pt>
                <c:pt idx="194">
                  <c:v>3.32884</c:v>
                </c:pt>
                <c:pt idx="195">
                  <c:v>4.1826499999999998</c:v>
                </c:pt>
                <c:pt idx="196">
                  <c:v>3.7895699999999999</c:v>
                </c:pt>
                <c:pt idx="197">
                  <c:v>4.7731899999999996</c:v>
                </c:pt>
                <c:pt idx="198">
                  <c:v>4.3343800000000003</c:v>
                </c:pt>
                <c:pt idx="199">
                  <c:v>3.7793899999999998</c:v>
                </c:pt>
                <c:pt idx="200">
                  <c:v>4.9415199999999997</c:v>
                </c:pt>
                <c:pt idx="201">
                  <c:v>4.5019200000000001</c:v>
                </c:pt>
                <c:pt idx="202">
                  <c:v>3.94089</c:v>
                </c:pt>
                <c:pt idx="203">
                  <c:v>5.0967500000000001</c:v>
                </c:pt>
                <c:pt idx="204">
                  <c:v>3.32884</c:v>
                </c:pt>
                <c:pt idx="205">
                  <c:v>4.1826499999999998</c:v>
                </c:pt>
                <c:pt idx="206">
                  <c:v>3.7895699999999999</c:v>
                </c:pt>
                <c:pt idx="207">
                  <c:v>4.7731899999999996</c:v>
                </c:pt>
                <c:pt idx="208">
                  <c:v>4.3343800000000003</c:v>
                </c:pt>
                <c:pt idx="209">
                  <c:v>3.7793899999999998</c:v>
                </c:pt>
                <c:pt idx="210">
                  <c:v>4.9415199999999997</c:v>
                </c:pt>
                <c:pt idx="211">
                  <c:v>4.5019200000000001</c:v>
                </c:pt>
                <c:pt idx="212">
                  <c:v>3.94089</c:v>
                </c:pt>
                <c:pt idx="213">
                  <c:v>5.0967500000000001</c:v>
                </c:pt>
                <c:pt idx="214">
                  <c:v>3.32884</c:v>
                </c:pt>
                <c:pt idx="215">
                  <c:v>4.1826499999999998</c:v>
                </c:pt>
                <c:pt idx="216">
                  <c:v>3.7895699999999999</c:v>
                </c:pt>
                <c:pt idx="217">
                  <c:v>4.7731899999999996</c:v>
                </c:pt>
                <c:pt idx="218">
                  <c:v>4.3343800000000003</c:v>
                </c:pt>
                <c:pt idx="219">
                  <c:v>3.7793899999999998</c:v>
                </c:pt>
                <c:pt idx="220">
                  <c:v>4.9415199999999997</c:v>
                </c:pt>
                <c:pt idx="221">
                  <c:v>4.5019200000000001</c:v>
                </c:pt>
                <c:pt idx="222">
                  <c:v>3.94089</c:v>
                </c:pt>
                <c:pt idx="223">
                  <c:v>5.0967500000000001</c:v>
                </c:pt>
              </c:numCache>
            </c:numRef>
          </c:xVal>
          <c:yVal>
            <c:numRef>
              <c:f>'PD analysis (Aceton)'!$R$104:$R$327</c:f>
              <c:numCache>
                <c:formatCode>General</c:formatCode>
                <c:ptCount val="224"/>
                <c:pt idx="0">
                  <c:v>-0.307813</c:v>
                </c:pt>
                <c:pt idx="1">
                  <c:v>0.84853699999999999</c:v>
                </c:pt>
                <c:pt idx="2">
                  <c:v>-0.74836100000000005</c:v>
                </c:pt>
                <c:pt idx="3">
                  <c:v>1.5568599999999999</c:v>
                </c:pt>
                <c:pt idx="4">
                  <c:v>-0.720889</c:v>
                </c:pt>
                <c:pt idx="5">
                  <c:v>-0.82045199999999996</c:v>
                </c:pt>
                <c:pt idx="6">
                  <c:v>-0.61594099999999996</c:v>
                </c:pt>
                <c:pt idx="7">
                  <c:v>0.38609300000000002</c:v>
                </c:pt>
                <c:pt idx="8">
                  <c:v>-1.9085700000000001</c:v>
                </c:pt>
                <c:pt idx="9">
                  <c:v>-1.18089</c:v>
                </c:pt>
                <c:pt idx="10">
                  <c:v>0.87896300000000005</c:v>
                </c:pt>
                <c:pt idx="11">
                  <c:v>0.160217</c:v>
                </c:pt>
                <c:pt idx="12">
                  <c:v>-0.94958200000000004</c:v>
                </c:pt>
                <c:pt idx="13">
                  <c:v>0.234205</c:v>
                </c:pt>
                <c:pt idx="14">
                  <c:v>-0.44579000000000002</c:v>
                </c:pt>
                <c:pt idx="15">
                  <c:v>-0.720889</c:v>
                </c:pt>
                <c:pt idx="16">
                  <c:v>-5.5273200000000001E-2</c:v>
                </c:pt>
                <c:pt idx="17">
                  <c:v>0.21740799999999999</c:v>
                </c:pt>
                <c:pt idx="18">
                  <c:v>0.38609300000000002</c:v>
                </c:pt>
                <c:pt idx="19">
                  <c:v>2.3722799999999999</c:v>
                </c:pt>
                <c:pt idx="20">
                  <c:v>2.6892999999999998</c:v>
                </c:pt>
                <c:pt idx="21">
                  <c:v>0.87896300000000005</c:v>
                </c:pt>
                <c:pt idx="22">
                  <c:v>-0.307813</c:v>
                </c:pt>
                <c:pt idx="23">
                  <c:v>0.84853699999999999</c:v>
                </c:pt>
                <c:pt idx="24">
                  <c:v>-0.74836100000000005</c:v>
                </c:pt>
                <c:pt idx="25">
                  <c:v>-0.88637299999999997</c:v>
                </c:pt>
                <c:pt idx="26">
                  <c:v>1.18659</c:v>
                </c:pt>
                <c:pt idx="27">
                  <c:v>-1.3254699999999999</c:v>
                </c:pt>
                <c:pt idx="28">
                  <c:v>0.21740799999999999</c:v>
                </c:pt>
                <c:pt idx="29">
                  <c:v>-0.78710500000000005</c:v>
                </c:pt>
                <c:pt idx="30">
                  <c:v>-0.97556600000000004</c:v>
                </c:pt>
                <c:pt idx="31">
                  <c:v>-0.54231300000000005</c:v>
                </c:pt>
                <c:pt idx="32">
                  <c:v>-0.77894200000000002</c:v>
                </c:pt>
                <c:pt idx="33">
                  <c:v>-0.307813</c:v>
                </c:pt>
                <c:pt idx="34">
                  <c:v>0.84853699999999999</c:v>
                </c:pt>
                <c:pt idx="35">
                  <c:v>-0.74836100000000005</c:v>
                </c:pt>
                <c:pt idx="36">
                  <c:v>-0.44579000000000002</c:v>
                </c:pt>
                <c:pt idx="37">
                  <c:v>-0.24760599999999999</c:v>
                </c:pt>
                <c:pt idx="38">
                  <c:v>2.4851200000000002</c:v>
                </c:pt>
                <c:pt idx="39">
                  <c:v>0.21740799999999999</c:v>
                </c:pt>
                <c:pt idx="40">
                  <c:v>-1.6626300000000001</c:v>
                </c:pt>
                <c:pt idx="41">
                  <c:v>-1.28657</c:v>
                </c:pt>
                <c:pt idx="42">
                  <c:v>-0.85192800000000002</c:v>
                </c:pt>
                <c:pt idx="43">
                  <c:v>-0.77894200000000002</c:v>
                </c:pt>
                <c:pt idx="44">
                  <c:v>-0.307813</c:v>
                </c:pt>
                <c:pt idx="45">
                  <c:v>0.80189100000000002</c:v>
                </c:pt>
                <c:pt idx="46">
                  <c:v>0.57864599999999999</c:v>
                </c:pt>
                <c:pt idx="47">
                  <c:v>1.43083</c:v>
                </c:pt>
                <c:pt idx="48">
                  <c:v>-0.83134799999999998</c:v>
                </c:pt>
                <c:pt idx="49">
                  <c:v>-0.15817500000000001</c:v>
                </c:pt>
                <c:pt idx="50">
                  <c:v>-0.77626399999999995</c:v>
                </c:pt>
                <c:pt idx="51">
                  <c:v>-0.32992500000000002</c:v>
                </c:pt>
                <c:pt idx="52">
                  <c:v>-1.9968900000000001</c:v>
                </c:pt>
                <c:pt idx="53">
                  <c:v>-0.96342499999999998</c:v>
                </c:pt>
                <c:pt idx="54">
                  <c:v>-1.1568000000000001</c:v>
                </c:pt>
                <c:pt idx="55">
                  <c:v>-1.24387</c:v>
                </c:pt>
                <c:pt idx="56">
                  <c:v>0.309722</c:v>
                </c:pt>
                <c:pt idx="57">
                  <c:v>-0.13056899999999999</c:v>
                </c:pt>
                <c:pt idx="58">
                  <c:v>-0.76444299999999998</c:v>
                </c:pt>
                <c:pt idx="59">
                  <c:v>-0.281551</c:v>
                </c:pt>
                <c:pt idx="60">
                  <c:v>-0.25541799999999998</c:v>
                </c:pt>
                <c:pt idx="61">
                  <c:v>-0.14485999999999999</c:v>
                </c:pt>
                <c:pt idx="62">
                  <c:v>-9.9896299999999993E-3</c:v>
                </c:pt>
                <c:pt idx="63">
                  <c:v>0.53529800000000005</c:v>
                </c:pt>
                <c:pt idx="64">
                  <c:v>0.53523399999999999</c:v>
                </c:pt>
                <c:pt idx="65">
                  <c:v>2.6280399999999999</c:v>
                </c:pt>
                <c:pt idx="66">
                  <c:v>-1.24387</c:v>
                </c:pt>
                <c:pt idx="67">
                  <c:v>-1.8877999999999999</c:v>
                </c:pt>
                <c:pt idx="68">
                  <c:v>0.98231999999999997</c:v>
                </c:pt>
                <c:pt idx="69">
                  <c:v>-1.42208</c:v>
                </c:pt>
                <c:pt idx="70">
                  <c:v>-0.31949699999999998</c:v>
                </c:pt>
                <c:pt idx="71">
                  <c:v>-1.3756200000000001</c:v>
                </c:pt>
                <c:pt idx="72">
                  <c:v>0.126138</c:v>
                </c:pt>
                <c:pt idx="73">
                  <c:v>-0.85047399999999995</c:v>
                </c:pt>
                <c:pt idx="74">
                  <c:v>0.47753699999999999</c:v>
                </c:pt>
                <c:pt idx="75">
                  <c:v>-0.91351099999999996</c:v>
                </c:pt>
                <c:pt idx="76">
                  <c:v>0.47746300000000003</c:v>
                </c:pt>
                <c:pt idx="77">
                  <c:v>-0.307813</c:v>
                </c:pt>
                <c:pt idx="78">
                  <c:v>0.62393799999999999</c:v>
                </c:pt>
                <c:pt idx="79">
                  <c:v>-2.17238</c:v>
                </c:pt>
                <c:pt idx="80">
                  <c:v>-0.53781999999999996</c:v>
                </c:pt>
                <c:pt idx="81">
                  <c:v>-0.79650399999999999</c:v>
                </c:pt>
                <c:pt idx="82">
                  <c:v>2.1412900000000001</c:v>
                </c:pt>
                <c:pt idx="83">
                  <c:v>-1.2990900000000001</c:v>
                </c:pt>
                <c:pt idx="84">
                  <c:v>-1.73027</c:v>
                </c:pt>
                <c:pt idx="85">
                  <c:v>0.47819</c:v>
                </c:pt>
                <c:pt idx="86">
                  <c:v>-0.91202899999999998</c:v>
                </c:pt>
                <c:pt idx="87">
                  <c:v>-0.79144999999999999</c:v>
                </c:pt>
                <c:pt idx="88">
                  <c:v>1.0866300000000001E-3</c:v>
                </c:pt>
                <c:pt idx="89">
                  <c:v>1.84012</c:v>
                </c:pt>
                <c:pt idx="90">
                  <c:v>1.1444399999999999</c:v>
                </c:pt>
                <c:pt idx="91">
                  <c:v>-0.86216300000000001</c:v>
                </c:pt>
                <c:pt idx="92">
                  <c:v>-0.17857000000000001</c:v>
                </c:pt>
                <c:pt idx="93">
                  <c:v>0.503081</c:v>
                </c:pt>
                <c:pt idx="94">
                  <c:v>-0.51429800000000003</c:v>
                </c:pt>
                <c:pt idx="95">
                  <c:v>-0.96262800000000004</c:v>
                </c:pt>
                <c:pt idx="96">
                  <c:v>1.34812</c:v>
                </c:pt>
                <c:pt idx="97">
                  <c:v>-0.65771999999999997</c:v>
                </c:pt>
                <c:pt idx="98">
                  <c:v>0.211668</c:v>
                </c:pt>
                <c:pt idx="99">
                  <c:v>0.80504299999999995</c:v>
                </c:pt>
                <c:pt idx="100">
                  <c:v>0.783632</c:v>
                </c:pt>
                <c:pt idx="101">
                  <c:v>1.28033</c:v>
                </c:pt>
                <c:pt idx="102">
                  <c:v>2.48522</c:v>
                </c:pt>
                <c:pt idx="103">
                  <c:v>0.85064300000000004</c:v>
                </c:pt>
                <c:pt idx="104">
                  <c:v>-0.21254000000000001</c:v>
                </c:pt>
                <c:pt idx="105">
                  <c:v>-0.90247100000000002</c:v>
                </c:pt>
                <c:pt idx="106">
                  <c:v>-0.65333600000000003</c:v>
                </c:pt>
                <c:pt idx="107">
                  <c:v>-0.57203000000000004</c:v>
                </c:pt>
                <c:pt idx="108">
                  <c:v>-0.359539</c:v>
                </c:pt>
                <c:pt idx="109">
                  <c:v>-0.21542800000000001</c:v>
                </c:pt>
                <c:pt idx="110">
                  <c:v>-0.974414</c:v>
                </c:pt>
                <c:pt idx="111">
                  <c:v>-0.34690500000000002</c:v>
                </c:pt>
                <c:pt idx="112">
                  <c:v>-1.24387</c:v>
                </c:pt>
                <c:pt idx="113">
                  <c:v>1.9691700000000001</c:v>
                </c:pt>
                <c:pt idx="114">
                  <c:v>1.39191</c:v>
                </c:pt>
                <c:pt idx="115">
                  <c:v>-1.0588</c:v>
                </c:pt>
                <c:pt idx="116">
                  <c:v>-0.20986099999999999</c:v>
                </c:pt>
                <c:pt idx="117">
                  <c:v>0.49668299999999999</c:v>
                </c:pt>
                <c:pt idx="118">
                  <c:v>-1.0092000000000001</c:v>
                </c:pt>
                <c:pt idx="119">
                  <c:v>-0.27809899999999999</c:v>
                </c:pt>
                <c:pt idx="120">
                  <c:v>0.26440999999999998</c:v>
                </c:pt>
                <c:pt idx="121">
                  <c:v>-0.80981700000000001</c:v>
                </c:pt>
                <c:pt idx="122">
                  <c:v>1.1064700000000001</c:v>
                </c:pt>
                <c:pt idx="123">
                  <c:v>0.31241799999999997</c:v>
                </c:pt>
                <c:pt idx="124">
                  <c:v>1.0962799999999999</c:v>
                </c:pt>
                <c:pt idx="125">
                  <c:v>-0.13197500000000001</c:v>
                </c:pt>
                <c:pt idx="126">
                  <c:v>0.17418800000000001</c:v>
                </c:pt>
                <c:pt idx="127">
                  <c:v>-0.52371100000000004</c:v>
                </c:pt>
                <c:pt idx="128">
                  <c:v>0.79766800000000004</c:v>
                </c:pt>
                <c:pt idx="129">
                  <c:v>-0.68592299999999995</c:v>
                </c:pt>
                <c:pt idx="130">
                  <c:v>0.42426599999999998</c:v>
                </c:pt>
                <c:pt idx="131">
                  <c:v>-1.00512</c:v>
                </c:pt>
                <c:pt idx="132">
                  <c:v>1.9297200000000001</c:v>
                </c:pt>
                <c:pt idx="133">
                  <c:v>-1.8190200000000001</c:v>
                </c:pt>
                <c:pt idx="134">
                  <c:v>0.72937200000000002</c:v>
                </c:pt>
                <c:pt idx="135">
                  <c:v>-0.27023999999999998</c:v>
                </c:pt>
                <c:pt idx="136">
                  <c:v>1.40517</c:v>
                </c:pt>
                <c:pt idx="137">
                  <c:v>0.22176100000000001</c:v>
                </c:pt>
                <c:pt idx="138">
                  <c:v>4.4194400000000002E-2</c:v>
                </c:pt>
                <c:pt idx="139">
                  <c:v>-0.991031</c:v>
                </c:pt>
                <c:pt idx="140">
                  <c:v>-0.83175699999999997</c:v>
                </c:pt>
                <c:pt idx="141">
                  <c:v>1.1511499999999999</c:v>
                </c:pt>
                <c:pt idx="142">
                  <c:v>1.15795</c:v>
                </c:pt>
                <c:pt idx="143">
                  <c:v>-0.54964000000000002</c:v>
                </c:pt>
                <c:pt idx="144">
                  <c:v>2.1786400000000001</c:v>
                </c:pt>
                <c:pt idx="145">
                  <c:v>-1.8238300000000001</c:v>
                </c:pt>
                <c:pt idx="146">
                  <c:v>-0.92377100000000001</c:v>
                </c:pt>
                <c:pt idx="147">
                  <c:v>1.7077700000000001E-2</c:v>
                </c:pt>
                <c:pt idx="148">
                  <c:v>0.30998599999999998</c:v>
                </c:pt>
                <c:pt idx="149">
                  <c:v>0.83620700000000003</c:v>
                </c:pt>
                <c:pt idx="150">
                  <c:v>-0.28589900000000001</c:v>
                </c:pt>
                <c:pt idx="151">
                  <c:v>-1.3208800000000001</c:v>
                </c:pt>
                <c:pt idx="152">
                  <c:v>-0.43526399999999998</c:v>
                </c:pt>
                <c:pt idx="153">
                  <c:v>0.45608599999999999</c:v>
                </c:pt>
                <c:pt idx="154">
                  <c:v>-0.60179800000000006</c:v>
                </c:pt>
                <c:pt idx="155">
                  <c:v>-0.88730799999999999</c:v>
                </c:pt>
                <c:pt idx="156">
                  <c:v>-0.60322699999999996</c:v>
                </c:pt>
                <c:pt idx="157">
                  <c:v>-1.5876999999999999</c:v>
                </c:pt>
                <c:pt idx="158">
                  <c:v>-0.33986</c:v>
                </c:pt>
                <c:pt idx="159">
                  <c:v>0.749305</c:v>
                </c:pt>
                <c:pt idx="160">
                  <c:v>0.25382300000000002</c:v>
                </c:pt>
                <c:pt idx="161">
                  <c:v>0.32592300000000002</c:v>
                </c:pt>
                <c:pt idx="162">
                  <c:v>0.60355099999999995</c:v>
                </c:pt>
                <c:pt idx="163">
                  <c:v>-0.31281100000000001</c:v>
                </c:pt>
                <c:pt idx="164">
                  <c:v>0.169657</c:v>
                </c:pt>
                <c:pt idx="165">
                  <c:v>0.61955300000000002</c:v>
                </c:pt>
                <c:pt idx="166">
                  <c:v>-1.12073</c:v>
                </c:pt>
                <c:pt idx="167">
                  <c:v>4.7502299999999997E-2</c:v>
                </c:pt>
                <c:pt idx="168">
                  <c:v>-0.29888799999999999</c:v>
                </c:pt>
                <c:pt idx="169">
                  <c:v>0.81545800000000002</c:v>
                </c:pt>
                <c:pt idx="170">
                  <c:v>1.12581</c:v>
                </c:pt>
                <c:pt idx="171">
                  <c:v>1.5871500000000001</c:v>
                </c:pt>
                <c:pt idx="172">
                  <c:v>-0.44944000000000001</c:v>
                </c:pt>
                <c:pt idx="173">
                  <c:v>-0.75952699999999995</c:v>
                </c:pt>
                <c:pt idx="174">
                  <c:v>0.76978500000000005</c:v>
                </c:pt>
                <c:pt idx="175">
                  <c:v>-0.79834899999999998</c:v>
                </c:pt>
                <c:pt idx="176">
                  <c:v>0.56907300000000005</c:v>
                </c:pt>
                <c:pt idx="177">
                  <c:v>-0.74143899999999996</c:v>
                </c:pt>
                <c:pt idx="178">
                  <c:v>-1.403</c:v>
                </c:pt>
                <c:pt idx="179">
                  <c:v>-0.54603599999999997</c:v>
                </c:pt>
                <c:pt idx="180">
                  <c:v>1.13913</c:v>
                </c:pt>
                <c:pt idx="181">
                  <c:v>-1.2076899999999999</c:v>
                </c:pt>
                <c:pt idx="182">
                  <c:v>0.70287900000000003</c:v>
                </c:pt>
                <c:pt idx="183">
                  <c:v>0.65114099999999997</c:v>
                </c:pt>
                <c:pt idx="184">
                  <c:v>-6.3992300000000002E-2</c:v>
                </c:pt>
                <c:pt idx="185">
                  <c:v>1.11642</c:v>
                </c:pt>
                <c:pt idx="186">
                  <c:v>-1.55277</c:v>
                </c:pt>
                <c:pt idx="187">
                  <c:v>-0.68357699999999999</c:v>
                </c:pt>
                <c:pt idx="188">
                  <c:v>1.03796</c:v>
                </c:pt>
                <c:pt idx="189">
                  <c:v>0.57226299999999997</c:v>
                </c:pt>
                <c:pt idx="190">
                  <c:v>-0.123608</c:v>
                </c:pt>
                <c:pt idx="191">
                  <c:v>0.85468299999999997</c:v>
                </c:pt>
                <c:pt idx="192">
                  <c:v>-0.34831899999999999</c:v>
                </c:pt>
                <c:pt idx="193">
                  <c:v>0.86964200000000003</c:v>
                </c:pt>
                <c:pt idx="194">
                  <c:v>0.62824599999999997</c:v>
                </c:pt>
                <c:pt idx="195">
                  <c:v>2.0032399999999999</c:v>
                </c:pt>
                <c:pt idx="196">
                  <c:v>0.27704499999999999</c:v>
                </c:pt>
                <c:pt idx="197">
                  <c:v>-1.44095</c:v>
                </c:pt>
                <c:pt idx="198">
                  <c:v>0.28143299999999999</c:v>
                </c:pt>
                <c:pt idx="199">
                  <c:v>0.13321</c:v>
                </c:pt>
                <c:pt idx="200">
                  <c:v>4.6944800000000002E-2</c:v>
                </c:pt>
                <c:pt idx="201">
                  <c:v>-0.43112400000000001</c:v>
                </c:pt>
                <c:pt idx="202">
                  <c:v>-0.39650200000000002</c:v>
                </c:pt>
                <c:pt idx="203">
                  <c:v>-1.47349</c:v>
                </c:pt>
                <c:pt idx="204">
                  <c:v>0.62824599999999997</c:v>
                </c:pt>
                <c:pt idx="205">
                  <c:v>1.33341</c:v>
                </c:pt>
                <c:pt idx="206">
                  <c:v>0.51700900000000005</c:v>
                </c:pt>
                <c:pt idx="207">
                  <c:v>-0.97939299999999996</c:v>
                </c:pt>
                <c:pt idx="208">
                  <c:v>-0.24917800000000001</c:v>
                </c:pt>
                <c:pt idx="209">
                  <c:v>-0.27790599999999999</c:v>
                </c:pt>
                <c:pt idx="210">
                  <c:v>0.42954500000000001</c:v>
                </c:pt>
                <c:pt idx="211">
                  <c:v>-0.27656500000000001</c:v>
                </c:pt>
                <c:pt idx="212">
                  <c:v>7.4106500000000006E-2</c:v>
                </c:pt>
                <c:pt idx="213">
                  <c:v>-1.19353</c:v>
                </c:pt>
                <c:pt idx="214">
                  <c:v>-0.307813</c:v>
                </c:pt>
                <c:pt idx="215">
                  <c:v>1.56071</c:v>
                </c:pt>
                <c:pt idx="216">
                  <c:v>0.73466600000000004</c:v>
                </c:pt>
                <c:pt idx="217">
                  <c:v>-1.93445</c:v>
                </c:pt>
                <c:pt idx="218">
                  <c:v>-0.70859799999999995</c:v>
                </c:pt>
                <c:pt idx="219">
                  <c:v>1.03878</c:v>
                </c:pt>
                <c:pt idx="220">
                  <c:v>-6.7025199999999993E-2</c:v>
                </c:pt>
                <c:pt idx="221">
                  <c:v>-8.6351200000000003E-2</c:v>
                </c:pt>
                <c:pt idx="222">
                  <c:v>0.35382799999999998</c:v>
                </c:pt>
                <c:pt idx="223">
                  <c:v>-1.54441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55A-470D-A0B9-353C995F0241}"/>
            </c:ext>
          </c:extLst>
        </c:ser>
        <c:ser>
          <c:idx val="1"/>
          <c:order val="1"/>
          <c:spPr>
            <a:ln w="9525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'PD analysis (Aceton)'!$AO$144:$AO$145</c:f>
              <c:numCache>
                <c:formatCode>General</c:formatCode>
                <c:ptCount val="2"/>
                <c:pt idx="0">
                  <c:v>0</c:v>
                </c:pt>
                <c:pt idx="1">
                  <c:v>30</c:v>
                </c:pt>
              </c:numCache>
            </c:numRef>
          </c:xVal>
          <c:yVal>
            <c:numRef>
              <c:f>'PD analysis (Aceton)'!$AP$144:$AP$145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55A-470D-A0B9-353C995F0241}"/>
            </c:ext>
          </c:extLst>
        </c:ser>
        <c:ser>
          <c:idx val="2"/>
          <c:order val="2"/>
          <c:spPr>
            <a:ln w="9525">
              <a:solidFill>
                <a:schemeClr val="tx1"/>
              </a:solidFill>
              <a:prstDash val="sysDash"/>
            </a:ln>
          </c:spPr>
          <c:marker>
            <c:symbol val="none"/>
          </c:marker>
          <c:xVal>
            <c:numRef>
              <c:f>'PD analysis (Aceton)'!$AO$138:$AO$139</c:f>
              <c:numCache>
                <c:formatCode>General</c:formatCode>
                <c:ptCount val="2"/>
                <c:pt idx="0">
                  <c:v>0</c:v>
                </c:pt>
                <c:pt idx="1">
                  <c:v>30</c:v>
                </c:pt>
              </c:numCache>
            </c:numRef>
          </c:xVal>
          <c:yVal>
            <c:numRef>
              <c:f>'PD analysis (Aceton)'!$AP$138:$AP$139</c:f>
              <c:numCache>
                <c:formatCode>General</c:formatCode>
                <c:ptCount val="2"/>
                <c:pt idx="0">
                  <c:v>2</c:v>
                </c:pt>
                <c:pt idx="1">
                  <c:v>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55A-470D-A0B9-353C995F0241}"/>
            </c:ext>
          </c:extLst>
        </c:ser>
        <c:ser>
          <c:idx val="3"/>
          <c:order val="3"/>
          <c:spPr>
            <a:ln w="9525">
              <a:solidFill>
                <a:schemeClr val="tx1"/>
              </a:solidFill>
              <a:prstDash val="sysDash"/>
            </a:ln>
          </c:spPr>
          <c:marker>
            <c:symbol val="none"/>
          </c:marker>
          <c:xVal>
            <c:numRef>
              <c:f>'PD analysis (Aceton)'!$AO$141:$AO$142</c:f>
              <c:numCache>
                <c:formatCode>General</c:formatCode>
                <c:ptCount val="2"/>
                <c:pt idx="0">
                  <c:v>0</c:v>
                </c:pt>
                <c:pt idx="1">
                  <c:v>30</c:v>
                </c:pt>
              </c:numCache>
            </c:numRef>
          </c:xVal>
          <c:yVal>
            <c:numRef>
              <c:f>'PD analysis (Aceton)'!$AP$141:$AP$142</c:f>
              <c:numCache>
                <c:formatCode>General</c:formatCode>
                <c:ptCount val="2"/>
                <c:pt idx="0">
                  <c:v>-2</c:v>
                </c:pt>
                <c:pt idx="1">
                  <c:v>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155A-470D-A0B9-353C995F02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4802720"/>
        <c:axId val="24798368"/>
      </c:scatterChart>
      <c:valAx>
        <c:axId val="24802720"/>
        <c:scaling>
          <c:orientation val="minMax"/>
          <c:max val="5"/>
          <c:min val="1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24798368"/>
        <c:crossesAt val="-4"/>
        <c:crossBetween val="midCat"/>
        <c:majorUnit val="2"/>
      </c:valAx>
      <c:valAx>
        <c:axId val="24798368"/>
        <c:scaling>
          <c:orientation val="minMax"/>
          <c:min val="-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24802720"/>
        <c:crosses val="autoZero"/>
        <c:crossBetween val="midCat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913650793650794"/>
          <c:y val="5.0926041666666665E-2"/>
          <c:w val="0.79447377017786946"/>
          <c:h val="0.74203667249927097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5"/>
            <c:spPr>
              <a:noFill/>
              <a:ln w="15875">
                <a:solidFill>
                  <a:schemeClr val="tx1"/>
                </a:solidFill>
              </a:ln>
            </c:spPr>
          </c:marker>
          <c:trendline>
            <c:spPr>
              <a:ln>
                <a:noFill/>
              </a:ln>
            </c:spPr>
            <c:trendlineType val="linear"/>
            <c:dispRSqr val="0"/>
            <c:dispEq val="0"/>
          </c:trendline>
          <c:xVal>
            <c:numRef>
              <c:f>'　PK  (Pt conc.)'!$L$78:$L$210</c:f>
              <c:numCache>
                <c:formatCode>General</c:formatCode>
                <c:ptCount val="133"/>
                <c:pt idx="0">
                  <c:v>0.05</c:v>
                </c:pt>
                <c:pt idx="1">
                  <c:v>8.3333299999999999E-2</c:v>
                </c:pt>
                <c:pt idx="2">
                  <c:v>0.16666700000000001</c:v>
                </c:pt>
                <c:pt idx="3">
                  <c:v>0.33333299999999999</c:v>
                </c:pt>
                <c:pt idx="4">
                  <c:v>0.5</c:v>
                </c:pt>
                <c:pt idx="5">
                  <c:v>0.75</c:v>
                </c:pt>
                <c:pt idx="6">
                  <c:v>1</c:v>
                </c:pt>
                <c:pt idx="7">
                  <c:v>0.05</c:v>
                </c:pt>
                <c:pt idx="8">
                  <c:v>8.3333299999999999E-2</c:v>
                </c:pt>
                <c:pt idx="9">
                  <c:v>0.16666700000000001</c:v>
                </c:pt>
                <c:pt idx="10">
                  <c:v>0.33333299999999999</c:v>
                </c:pt>
                <c:pt idx="11">
                  <c:v>0.5</c:v>
                </c:pt>
                <c:pt idx="12">
                  <c:v>0.75</c:v>
                </c:pt>
                <c:pt idx="13">
                  <c:v>1</c:v>
                </c:pt>
                <c:pt idx="14">
                  <c:v>1.5</c:v>
                </c:pt>
                <c:pt idx="15">
                  <c:v>2</c:v>
                </c:pt>
                <c:pt idx="16">
                  <c:v>0.05</c:v>
                </c:pt>
                <c:pt idx="17">
                  <c:v>8.3333299999999999E-2</c:v>
                </c:pt>
                <c:pt idx="18">
                  <c:v>0.16666700000000001</c:v>
                </c:pt>
                <c:pt idx="19">
                  <c:v>0.33333299999999999</c:v>
                </c:pt>
                <c:pt idx="20">
                  <c:v>0.5</c:v>
                </c:pt>
                <c:pt idx="21">
                  <c:v>0.75</c:v>
                </c:pt>
                <c:pt idx="22">
                  <c:v>1</c:v>
                </c:pt>
                <c:pt idx="23">
                  <c:v>1.5</c:v>
                </c:pt>
                <c:pt idx="24">
                  <c:v>2</c:v>
                </c:pt>
                <c:pt idx="25">
                  <c:v>0.05</c:v>
                </c:pt>
                <c:pt idx="26">
                  <c:v>8.3333299999999999E-2</c:v>
                </c:pt>
                <c:pt idx="27">
                  <c:v>0.16666700000000001</c:v>
                </c:pt>
                <c:pt idx="28">
                  <c:v>0.33333299999999999</c:v>
                </c:pt>
                <c:pt idx="29">
                  <c:v>0.5</c:v>
                </c:pt>
                <c:pt idx="30">
                  <c:v>0.75</c:v>
                </c:pt>
                <c:pt idx="31">
                  <c:v>1</c:v>
                </c:pt>
                <c:pt idx="32">
                  <c:v>1.5</c:v>
                </c:pt>
                <c:pt idx="33">
                  <c:v>2</c:v>
                </c:pt>
                <c:pt idx="34">
                  <c:v>0.05</c:v>
                </c:pt>
                <c:pt idx="35">
                  <c:v>8.3333299999999999E-2</c:v>
                </c:pt>
                <c:pt idx="36">
                  <c:v>0.16666700000000001</c:v>
                </c:pt>
                <c:pt idx="37">
                  <c:v>0.33333299999999999</c:v>
                </c:pt>
                <c:pt idx="38">
                  <c:v>0.5</c:v>
                </c:pt>
                <c:pt idx="39">
                  <c:v>0.75</c:v>
                </c:pt>
                <c:pt idx="40">
                  <c:v>1</c:v>
                </c:pt>
                <c:pt idx="41">
                  <c:v>1.5</c:v>
                </c:pt>
                <c:pt idx="42">
                  <c:v>2</c:v>
                </c:pt>
                <c:pt idx="43">
                  <c:v>0.05</c:v>
                </c:pt>
                <c:pt idx="44">
                  <c:v>8.3333299999999999E-2</c:v>
                </c:pt>
                <c:pt idx="45">
                  <c:v>0.16666700000000001</c:v>
                </c:pt>
                <c:pt idx="46">
                  <c:v>0.33333299999999999</c:v>
                </c:pt>
                <c:pt idx="47">
                  <c:v>0.5</c:v>
                </c:pt>
                <c:pt idx="48">
                  <c:v>0.75</c:v>
                </c:pt>
                <c:pt idx="49">
                  <c:v>1</c:v>
                </c:pt>
                <c:pt idx="50">
                  <c:v>1.5</c:v>
                </c:pt>
                <c:pt idx="51">
                  <c:v>2</c:v>
                </c:pt>
                <c:pt idx="52">
                  <c:v>0.05</c:v>
                </c:pt>
                <c:pt idx="53">
                  <c:v>8.3333299999999999E-2</c:v>
                </c:pt>
                <c:pt idx="54">
                  <c:v>0.16666700000000001</c:v>
                </c:pt>
                <c:pt idx="55">
                  <c:v>0.33333299999999999</c:v>
                </c:pt>
                <c:pt idx="56">
                  <c:v>0.5</c:v>
                </c:pt>
                <c:pt idx="57">
                  <c:v>0.75</c:v>
                </c:pt>
                <c:pt idx="58">
                  <c:v>1</c:v>
                </c:pt>
                <c:pt idx="59">
                  <c:v>1.5</c:v>
                </c:pt>
                <c:pt idx="60">
                  <c:v>2</c:v>
                </c:pt>
                <c:pt idx="61">
                  <c:v>0.05</c:v>
                </c:pt>
                <c:pt idx="62">
                  <c:v>8.3333299999999999E-2</c:v>
                </c:pt>
                <c:pt idx="63">
                  <c:v>0.16666700000000001</c:v>
                </c:pt>
                <c:pt idx="64">
                  <c:v>0.33333299999999999</c:v>
                </c:pt>
                <c:pt idx="65">
                  <c:v>0.5</c:v>
                </c:pt>
                <c:pt idx="66">
                  <c:v>0.75</c:v>
                </c:pt>
                <c:pt idx="67">
                  <c:v>1</c:v>
                </c:pt>
                <c:pt idx="68">
                  <c:v>1.5</c:v>
                </c:pt>
                <c:pt idx="69">
                  <c:v>2</c:v>
                </c:pt>
                <c:pt idx="70">
                  <c:v>0.05</c:v>
                </c:pt>
                <c:pt idx="71">
                  <c:v>8.3333299999999999E-2</c:v>
                </c:pt>
                <c:pt idx="72">
                  <c:v>0.16666700000000001</c:v>
                </c:pt>
                <c:pt idx="73">
                  <c:v>0.33333299999999999</c:v>
                </c:pt>
                <c:pt idx="74">
                  <c:v>0.5</c:v>
                </c:pt>
                <c:pt idx="75">
                  <c:v>0.75</c:v>
                </c:pt>
                <c:pt idx="76">
                  <c:v>1</c:v>
                </c:pt>
                <c:pt idx="77">
                  <c:v>1.5</c:v>
                </c:pt>
                <c:pt idx="78">
                  <c:v>2</c:v>
                </c:pt>
                <c:pt idx="79">
                  <c:v>0.05</c:v>
                </c:pt>
                <c:pt idx="80">
                  <c:v>8.3333299999999999E-2</c:v>
                </c:pt>
                <c:pt idx="81">
                  <c:v>0.16666700000000001</c:v>
                </c:pt>
                <c:pt idx="82">
                  <c:v>0.33333299999999999</c:v>
                </c:pt>
                <c:pt idx="83">
                  <c:v>0.5</c:v>
                </c:pt>
                <c:pt idx="84">
                  <c:v>0.75</c:v>
                </c:pt>
                <c:pt idx="85">
                  <c:v>1</c:v>
                </c:pt>
                <c:pt idx="86">
                  <c:v>1.5</c:v>
                </c:pt>
                <c:pt idx="87">
                  <c:v>2</c:v>
                </c:pt>
                <c:pt idx="88">
                  <c:v>0.05</c:v>
                </c:pt>
                <c:pt idx="89">
                  <c:v>8.3333299999999999E-2</c:v>
                </c:pt>
                <c:pt idx="90">
                  <c:v>0.16666700000000001</c:v>
                </c:pt>
                <c:pt idx="91">
                  <c:v>0.33333299999999999</c:v>
                </c:pt>
                <c:pt idx="92">
                  <c:v>0.5</c:v>
                </c:pt>
                <c:pt idx="93">
                  <c:v>0.75</c:v>
                </c:pt>
                <c:pt idx="94">
                  <c:v>1</c:v>
                </c:pt>
                <c:pt idx="95">
                  <c:v>1.5</c:v>
                </c:pt>
                <c:pt idx="96">
                  <c:v>2</c:v>
                </c:pt>
                <c:pt idx="97">
                  <c:v>0.05</c:v>
                </c:pt>
                <c:pt idx="98">
                  <c:v>8.3333299999999999E-2</c:v>
                </c:pt>
                <c:pt idx="99">
                  <c:v>0.16666700000000001</c:v>
                </c:pt>
                <c:pt idx="100">
                  <c:v>0.33333299999999999</c:v>
                </c:pt>
                <c:pt idx="101">
                  <c:v>0.5</c:v>
                </c:pt>
                <c:pt idx="102">
                  <c:v>0.75</c:v>
                </c:pt>
                <c:pt idx="103">
                  <c:v>1</c:v>
                </c:pt>
                <c:pt idx="104">
                  <c:v>1.5</c:v>
                </c:pt>
                <c:pt idx="105">
                  <c:v>2</c:v>
                </c:pt>
                <c:pt idx="106">
                  <c:v>0.05</c:v>
                </c:pt>
                <c:pt idx="107">
                  <c:v>8.3333299999999999E-2</c:v>
                </c:pt>
                <c:pt idx="108">
                  <c:v>0.16666700000000001</c:v>
                </c:pt>
                <c:pt idx="109">
                  <c:v>0.33333299999999999</c:v>
                </c:pt>
                <c:pt idx="110">
                  <c:v>0.5</c:v>
                </c:pt>
                <c:pt idx="111">
                  <c:v>0.75</c:v>
                </c:pt>
                <c:pt idx="112">
                  <c:v>1</c:v>
                </c:pt>
                <c:pt idx="113">
                  <c:v>1.5</c:v>
                </c:pt>
                <c:pt idx="114">
                  <c:v>2</c:v>
                </c:pt>
                <c:pt idx="115">
                  <c:v>0.05</c:v>
                </c:pt>
                <c:pt idx="116">
                  <c:v>8.3333299999999999E-2</c:v>
                </c:pt>
                <c:pt idx="117">
                  <c:v>0.16666700000000001</c:v>
                </c:pt>
                <c:pt idx="118">
                  <c:v>0.33333299999999999</c:v>
                </c:pt>
                <c:pt idx="119">
                  <c:v>0.5</c:v>
                </c:pt>
                <c:pt idx="120">
                  <c:v>0.75</c:v>
                </c:pt>
                <c:pt idx="121">
                  <c:v>1</c:v>
                </c:pt>
                <c:pt idx="122">
                  <c:v>1.5</c:v>
                </c:pt>
                <c:pt idx="123">
                  <c:v>2</c:v>
                </c:pt>
                <c:pt idx="124">
                  <c:v>0.05</c:v>
                </c:pt>
                <c:pt idx="125">
                  <c:v>8.3333299999999999E-2</c:v>
                </c:pt>
                <c:pt idx="126">
                  <c:v>0.16666700000000001</c:v>
                </c:pt>
                <c:pt idx="127">
                  <c:v>0.33333299999999999</c:v>
                </c:pt>
                <c:pt idx="128">
                  <c:v>0.5</c:v>
                </c:pt>
                <c:pt idx="129">
                  <c:v>0.75</c:v>
                </c:pt>
                <c:pt idx="130">
                  <c:v>1</c:v>
                </c:pt>
                <c:pt idx="131">
                  <c:v>1.5</c:v>
                </c:pt>
                <c:pt idx="132">
                  <c:v>2</c:v>
                </c:pt>
              </c:numCache>
            </c:numRef>
          </c:xVal>
          <c:yVal>
            <c:numRef>
              <c:f>'　PK  (Pt conc.)'!$U$78:$U$210</c:f>
              <c:numCache>
                <c:formatCode>General</c:formatCode>
                <c:ptCount val="133"/>
                <c:pt idx="0">
                  <c:v>-1.17197</c:v>
                </c:pt>
                <c:pt idx="1">
                  <c:v>-1.09205</c:v>
                </c:pt>
                <c:pt idx="2">
                  <c:v>0.43820999999999999</c:v>
                </c:pt>
                <c:pt idx="3">
                  <c:v>-1.7299899999999999</c:v>
                </c:pt>
                <c:pt idx="4">
                  <c:v>0.41665000000000002</c:v>
                </c:pt>
                <c:pt idx="5">
                  <c:v>-0.68001</c:v>
                </c:pt>
                <c:pt idx="6">
                  <c:v>-0.77365700000000004</c:v>
                </c:pt>
                <c:pt idx="7">
                  <c:v>-1.1691800000000001</c:v>
                </c:pt>
                <c:pt idx="8">
                  <c:v>3.7795700000000002E-2</c:v>
                </c:pt>
                <c:pt idx="9">
                  <c:v>-0.35883100000000001</c:v>
                </c:pt>
                <c:pt idx="10">
                  <c:v>1.98081</c:v>
                </c:pt>
                <c:pt idx="11">
                  <c:v>-1.3699600000000001</c:v>
                </c:pt>
                <c:pt idx="12">
                  <c:v>-0.27450400000000003</c:v>
                </c:pt>
                <c:pt idx="13">
                  <c:v>-1.9539500000000001</c:v>
                </c:pt>
                <c:pt idx="14">
                  <c:v>0.228908</c:v>
                </c:pt>
                <c:pt idx="15">
                  <c:v>0.27321499999999999</c:v>
                </c:pt>
                <c:pt idx="16">
                  <c:v>-0.53998699999999999</c:v>
                </c:pt>
                <c:pt idx="17">
                  <c:v>-4.6437199999999998E-2</c:v>
                </c:pt>
                <c:pt idx="18">
                  <c:v>0.84535099999999996</c:v>
                </c:pt>
                <c:pt idx="19">
                  <c:v>1.53264</c:v>
                </c:pt>
                <c:pt idx="20">
                  <c:v>1.1314</c:v>
                </c:pt>
                <c:pt idx="21">
                  <c:v>1.4361600000000001</c:v>
                </c:pt>
                <c:pt idx="22">
                  <c:v>0.33622600000000002</c:v>
                </c:pt>
                <c:pt idx="23">
                  <c:v>0.56996899999999995</c:v>
                </c:pt>
                <c:pt idx="24">
                  <c:v>0.83359300000000003</c:v>
                </c:pt>
                <c:pt idx="25">
                  <c:v>-1.7187399999999999</c:v>
                </c:pt>
                <c:pt idx="26">
                  <c:v>-1.22614</c:v>
                </c:pt>
                <c:pt idx="27">
                  <c:v>0.33722299999999999</c:v>
                </c:pt>
                <c:pt idx="28">
                  <c:v>1.4874099999999999</c:v>
                </c:pt>
                <c:pt idx="29">
                  <c:v>1.1610100000000001</c:v>
                </c:pt>
                <c:pt idx="30">
                  <c:v>1.2424599999999999</c:v>
                </c:pt>
                <c:pt idx="31">
                  <c:v>1.1902299999999999</c:v>
                </c:pt>
                <c:pt idx="32">
                  <c:v>-8.6956800000000001E-2</c:v>
                </c:pt>
                <c:pt idx="33">
                  <c:v>0.720495</c:v>
                </c:pt>
                <c:pt idx="34">
                  <c:v>-0.91272699999999996</c:v>
                </c:pt>
                <c:pt idx="35">
                  <c:v>0.20873900000000001</c:v>
                </c:pt>
                <c:pt idx="36">
                  <c:v>-4.5918599999999997E-2</c:v>
                </c:pt>
                <c:pt idx="37">
                  <c:v>0.48560700000000001</c:v>
                </c:pt>
                <c:pt idx="38">
                  <c:v>0.39600000000000002</c:v>
                </c:pt>
                <c:pt idx="39">
                  <c:v>0.95606199999999997</c:v>
                </c:pt>
                <c:pt idx="40">
                  <c:v>0.25462000000000001</c:v>
                </c:pt>
                <c:pt idx="41">
                  <c:v>0.10929899999999999</c:v>
                </c:pt>
                <c:pt idx="42">
                  <c:v>0.82402600000000004</c:v>
                </c:pt>
                <c:pt idx="43">
                  <c:v>-0.46586699999999998</c:v>
                </c:pt>
                <c:pt idx="44">
                  <c:v>-0.29277300000000001</c:v>
                </c:pt>
                <c:pt idx="45">
                  <c:v>-0.39554099999999998</c:v>
                </c:pt>
                <c:pt idx="46">
                  <c:v>1.5558799999999999</c:v>
                </c:pt>
                <c:pt idx="47">
                  <c:v>-0.72583799999999998</c:v>
                </c:pt>
                <c:pt idx="48">
                  <c:v>0.65665399999999996</c:v>
                </c:pt>
                <c:pt idx="49">
                  <c:v>0.71448</c:v>
                </c:pt>
                <c:pt idx="50">
                  <c:v>-1.21625E-2</c:v>
                </c:pt>
                <c:pt idx="51">
                  <c:v>0.29574699999999998</c:v>
                </c:pt>
                <c:pt idx="52">
                  <c:v>0.63209000000000004</c:v>
                </c:pt>
                <c:pt idx="53">
                  <c:v>-0.78598900000000005</c:v>
                </c:pt>
                <c:pt idx="54">
                  <c:v>-0.114984</c:v>
                </c:pt>
                <c:pt idx="55">
                  <c:v>-1.8800699999999999</c:v>
                </c:pt>
                <c:pt idx="56">
                  <c:v>0.59534699999999996</c:v>
                </c:pt>
                <c:pt idx="57">
                  <c:v>0.37277399999999999</c:v>
                </c:pt>
                <c:pt idx="58">
                  <c:v>-1.69407</c:v>
                </c:pt>
                <c:pt idx="59">
                  <c:v>-0.195553</c:v>
                </c:pt>
                <c:pt idx="60">
                  <c:v>0.29677599999999998</c:v>
                </c:pt>
                <c:pt idx="61">
                  <c:v>1.1175900000000001</c:v>
                </c:pt>
                <c:pt idx="62">
                  <c:v>-2.5504500000000001</c:v>
                </c:pt>
                <c:pt idx="63">
                  <c:v>-1.42187</c:v>
                </c:pt>
                <c:pt idx="64">
                  <c:v>1.6030500000000001</c:v>
                </c:pt>
                <c:pt idx="65">
                  <c:v>0.23131199999999999</c:v>
                </c:pt>
                <c:pt idx="66">
                  <c:v>-1.6717599999999999</c:v>
                </c:pt>
                <c:pt idx="67">
                  <c:v>8.2141699999999998E-3</c:v>
                </c:pt>
                <c:pt idx="68">
                  <c:v>2.98071E-2</c:v>
                </c:pt>
                <c:pt idx="69">
                  <c:v>-0.49606</c:v>
                </c:pt>
                <c:pt idx="70">
                  <c:v>7.6558899999999999E-2</c:v>
                </c:pt>
                <c:pt idx="71">
                  <c:v>1.2306299999999999</c:v>
                </c:pt>
                <c:pt idx="72">
                  <c:v>-0.28813800000000001</c:v>
                </c:pt>
                <c:pt idx="73">
                  <c:v>-0.62690100000000004</c:v>
                </c:pt>
                <c:pt idx="74">
                  <c:v>-0.64248700000000003</c:v>
                </c:pt>
                <c:pt idx="75">
                  <c:v>-0.492149</c:v>
                </c:pt>
                <c:pt idx="76">
                  <c:v>0.70618499999999995</c:v>
                </c:pt>
                <c:pt idx="77">
                  <c:v>1.0359799999999999</c:v>
                </c:pt>
                <c:pt idx="78">
                  <c:v>1.47732</c:v>
                </c:pt>
                <c:pt idx="79">
                  <c:v>1.27156</c:v>
                </c:pt>
                <c:pt idx="80">
                  <c:v>0.80246300000000004</c:v>
                </c:pt>
                <c:pt idx="81">
                  <c:v>-0.60479899999999998</c:v>
                </c:pt>
                <c:pt idx="82">
                  <c:v>-0.880602</c:v>
                </c:pt>
                <c:pt idx="83">
                  <c:v>3.6573000000000001E-2</c:v>
                </c:pt>
                <c:pt idx="84">
                  <c:v>-1.72461E-2</c:v>
                </c:pt>
                <c:pt idx="85">
                  <c:v>4.5516000000000001E-2</c:v>
                </c:pt>
                <c:pt idx="86">
                  <c:v>-1.3053399999999999</c:v>
                </c:pt>
                <c:pt idx="87">
                  <c:v>1.3370500000000001</c:v>
                </c:pt>
                <c:pt idx="88">
                  <c:v>0.70893200000000001</c:v>
                </c:pt>
                <c:pt idx="89">
                  <c:v>-0.11237</c:v>
                </c:pt>
                <c:pt idx="90">
                  <c:v>2.94595E-2</c:v>
                </c:pt>
                <c:pt idx="91">
                  <c:v>0.55576899999999996</c:v>
                </c:pt>
                <c:pt idx="92">
                  <c:v>-2.4721700000000002</c:v>
                </c:pt>
                <c:pt idx="93">
                  <c:v>-1.0778000000000001</c:v>
                </c:pt>
                <c:pt idx="94">
                  <c:v>-0.89063400000000004</c:v>
                </c:pt>
                <c:pt idx="95">
                  <c:v>0.87339699999999998</c:v>
                </c:pt>
                <c:pt idx="96">
                  <c:v>0.368423</c:v>
                </c:pt>
                <c:pt idx="97">
                  <c:v>1.4649099999999999</c:v>
                </c:pt>
                <c:pt idx="98">
                  <c:v>-0.355605</c:v>
                </c:pt>
                <c:pt idx="99">
                  <c:v>-1.0368299999999999</c:v>
                </c:pt>
                <c:pt idx="100">
                  <c:v>-0.327847</c:v>
                </c:pt>
                <c:pt idx="101">
                  <c:v>-0.85253599999999996</c:v>
                </c:pt>
                <c:pt idx="102">
                  <c:v>-0.66937899999999995</c:v>
                </c:pt>
                <c:pt idx="103">
                  <c:v>-0.69438900000000003</c:v>
                </c:pt>
                <c:pt idx="104">
                  <c:v>-0.327677</c:v>
                </c:pt>
                <c:pt idx="105">
                  <c:v>-1.7298899999999999E-2</c:v>
                </c:pt>
                <c:pt idx="106">
                  <c:v>1.6143099999999999</c:v>
                </c:pt>
                <c:pt idx="107">
                  <c:v>0.34731299999999998</c:v>
                </c:pt>
                <c:pt idx="108">
                  <c:v>-1.6764699999999999</c:v>
                </c:pt>
                <c:pt idx="109">
                  <c:v>-0.13217799999999999</c:v>
                </c:pt>
                <c:pt idx="110">
                  <c:v>-0.66162900000000002</c:v>
                </c:pt>
                <c:pt idx="111">
                  <c:v>-0.80740500000000004</c:v>
                </c:pt>
                <c:pt idx="112">
                  <c:v>-0.65477600000000002</c:v>
                </c:pt>
                <c:pt idx="113">
                  <c:v>-0.75818099999999999</c:v>
                </c:pt>
                <c:pt idx="114">
                  <c:v>-0.35864600000000002</c:v>
                </c:pt>
                <c:pt idx="115">
                  <c:v>-0.67012799999999995</c:v>
                </c:pt>
                <c:pt idx="116">
                  <c:v>4.4217800000000002E-2</c:v>
                </c:pt>
                <c:pt idx="117">
                  <c:v>-7.1347499999999994E-2</c:v>
                </c:pt>
                <c:pt idx="118">
                  <c:v>0.76955499999999999</c:v>
                </c:pt>
                <c:pt idx="119">
                  <c:v>0.62430300000000005</c:v>
                </c:pt>
                <c:pt idx="120">
                  <c:v>-0.62964900000000001</c:v>
                </c:pt>
                <c:pt idx="121">
                  <c:v>-0.115076</c:v>
                </c:pt>
                <c:pt idx="122">
                  <c:v>-2.0873499999999998</c:v>
                </c:pt>
                <c:pt idx="123">
                  <c:v>1.2842499999999999</c:v>
                </c:pt>
                <c:pt idx="124">
                  <c:v>-1.4056599999999999</c:v>
                </c:pt>
                <c:pt idx="125">
                  <c:v>3.0463800000000001</c:v>
                </c:pt>
                <c:pt idx="126">
                  <c:v>0.25158399999999997</c:v>
                </c:pt>
                <c:pt idx="127">
                  <c:v>0.57695799999999997</c:v>
                </c:pt>
                <c:pt idx="128">
                  <c:v>-1.38436</c:v>
                </c:pt>
                <c:pt idx="129">
                  <c:v>0.98610600000000004</c:v>
                </c:pt>
                <c:pt idx="130">
                  <c:v>-4.6820000000000001E-2</c:v>
                </c:pt>
                <c:pt idx="131">
                  <c:v>-7.1507899999999999E-2</c:v>
                </c:pt>
                <c:pt idx="132">
                  <c:v>-0.135672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301-4E7E-B75A-C504AFB8BC23}"/>
            </c:ext>
          </c:extLst>
        </c:ser>
        <c:ser>
          <c:idx val="1"/>
          <c:order val="1"/>
          <c:spPr>
            <a:ln w="9525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'　PK  (Pt conc.)'!$AK$74:$AK$75</c:f>
              <c:numCache>
                <c:formatCode>General</c:formatCode>
                <c:ptCount val="2"/>
                <c:pt idx="0">
                  <c:v>0</c:v>
                </c:pt>
                <c:pt idx="1">
                  <c:v>2</c:v>
                </c:pt>
              </c:numCache>
            </c:numRef>
          </c:xVal>
          <c:yVal>
            <c:numRef>
              <c:f>'　PK  (Pt conc.)'!$AL$74:$AL$75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8301-4E7E-B75A-C504AFB8BC23}"/>
            </c:ext>
          </c:extLst>
        </c:ser>
        <c:ser>
          <c:idx val="2"/>
          <c:order val="2"/>
          <c:spPr>
            <a:ln w="9525">
              <a:solidFill>
                <a:schemeClr val="tx1"/>
              </a:solidFill>
              <a:prstDash val="sysDash"/>
            </a:ln>
          </c:spPr>
          <c:marker>
            <c:symbol val="none"/>
          </c:marker>
          <c:xVal>
            <c:numRef>
              <c:f>'　PK  (Pt conc.)'!$AK$77:$AK$78</c:f>
              <c:numCache>
                <c:formatCode>General</c:formatCode>
                <c:ptCount val="2"/>
                <c:pt idx="0">
                  <c:v>0</c:v>
                </c:pt>
                <c:pt idx="1">
                  <c:v>2</c:v>
                </c:pt>
              </c:numCache>
            </c:numRef>
          </c:xVal>
          <c:yVal>
            <c:numRef>
              <c:f>'　PK  (Pt conc.)'!$AL$77:$AL$78</c:f>
              <c:numCache>
                <c:formatCode>General</c:formatCode>
                <c:ptCount val="2"/>
                <c:pt idx="0">
                  <c:v>2</c:v>
                </c:pt>
                <c:pt idx="1">
                  <c:v>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8301-4E7E-B75A-C504AFB8BC23}"/>
            </c:ext>
          </c:extLst>
        </c:ser>
        <c:ser>
          <c:idx val="3"/>
          <c:order val="3"/>
          <c:spPr>
            <a:ln w="9525">
              <a:solidFill>
                <a:schemeClr val="tx1"/>
              </a:solidFill>
              <a:prstDash val="sysDash"/>
            </a:ln>
          </c:spPr>
          <c:marker>
            <c:symbol val="none"/>
          </c:marker>
          <c:xVal>
            <c:numRef>
              <c:f>'　PK  (Pt conc.)'!$AK$80:$AK$81</c:f>
              <c:numCache>
                <c:formatCode>General</c:formatCode>
                <c:ptCount val="2"/>
                <c:pt idx="0">
                  <c:v>0</c:v>
                </c:pt>
                <c:pt idx="1">
                  <c:v>2</c:v>
                </c:pt>
              </c:numCache>
            </c:numRef>
          </c:xVal>
          <c:yVal>
            <c:numRef>
              <c:f>'　PK  (Pt conc.)'!$AL$80:$AL$81</c:f>
              <c:numCache>
                <c:formatCode>General</c:formatCode>
                <c:ptCount val="2"/>
                <c:pt idx="0">
                  <c:v>-2</c:v>
                </c:pt>
                <c:pt idx="1">
                  <c:v>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8301-4E7E-B75A-C504AFB8BC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94389968"/>
        <c:axId val="1794392144"/>
      </c:scatterChart>
      <c:valAx>
        <c:axId val="1794389968"/>
        <c:scaling>
          <c:orientation val="minMax"/>
          <c:max val="2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794392144"/>
        <c:crossesAt val="-4"/>
        <c:crossBetween val="midCat"/>
      </c:valAx>
      <c:valAx>
        <c:axId val="1794392144"/>
        <c:scaling>
          <c:orientation val="minMax"/>
          <c:min val="-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794389968"/>
        <c:crosses val="autoZero"/>
        <c:crossBetween val="midCat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966070764759556"/>
          <c:y val="5.0925881861406376E-2"/>
          <c:w val="0.79447377017786946"/>
          <c:h val="0.74203667249927097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5"/>
            <c:spPr>
              <a:noFill/>
              <a:ln w="15875">
                <a:solidFill>
                  <a:schemeClr val="tx1"/>
                </a:solidFill>
              </a:ln>
            </c:spPr>
          </c:marker>
          <c:trendline>
            <c:spPr>
              <a:ln>
                <a:noFill/>
              </a:ln>
            </c:spPr>
            <c:trendlineType val="linear"/>
            <c:dispRSqr val="0"/>
            <c:dispEq val="0"/>
          </c:trendline>
          <c:xVal>
            <c:numRef>
              <c:f>'PD analysis (von Frey)'!$I$104:$I$327</c:f>
              <c:numCache>
                <c:formatCode>General</c:formatCode>
                <c:ptCount val="224"/>
                <c:pt idx="0">
                  <c:v>8</c:v>
                </c:pt>
                <c:pt idx="1">
                  <c:v>8</c:v>
                </c:pt>
                <c:pt idx="2">
                  <c:v>8</c:v>
                </c:pt>
                <c:pt idx="3">
                  <c:v>8</c:v>
                </c:pt>
                <c:pt idx="4">
                  <c:v>8</c:v>
                </c:pt>
                <c:pt idx="5">
                  <c:v>8</c:v>
                </c:pt>
                <c:pt idx="6">
                  <c:v>8</c:v>
                </c:pt>
                <c:pt idx="7">
                  <c:v>8</c:v>
                </c:pt>
                <c:pt idx="8">
                  <c:v>8</c:v>
                </c:pt>
                <c:pt idx="9">
                  <c:v>8</c:v>
                </c:pt>
                <c:pt idx="10">
                  <c:v>8</c:v>
                </c:pt>
                <c:pt idx="11">
                  <c:v>8</c:v>
                </c:pt>
                <c:pt idx="12">
                  <c:v>8</c:v>
                </c:pt>
                <c:pt idx="13">
                  <c:v>8</c:v>
                </c:pt>
                <c:pt idx="14">
                  <c:v>8</c:v>
                </c:pt>
                <c:pt idx="15">
                  <c:v>8</c:v>
                </c:pt>
                <c:pt idx="16">
                  <c:v>8</c:v>
                </c:pt>
                <c:pt idx="17">
                  <c:v>8</c:v>
                </c:pt>
                <c:pt idx="18">
                  <c:v>8</c:v>
                </c:pt>
                <c:pt idx="19">
                  <c:v>8</c:v>
                </c:pt>
                <c:pt idx="20">
                  <c:v>8</c:v>
                </c:pt>
                <c:pt idx="21">
                  <c:v>8</c:v>
                </c:pt>
                <c:pt idx="22">
                  <c:v>8</c:v>
                </c:pt>
                <c:pt idx="23">
                  <c:v>8</c:v>
                </c:pt>
                <c:pt idx="24">
                  <c:v>8</c:v>
                </c:pt>
                <c:pt idx="25">
                  <c:v>8</c:v>
                </c:pt>
                <c:pt idx="26">
                  <c:v>8</c:v>
                </c:pt>
                <c:pt idx="27">
                  <c:v>8</c:v>
                </c:pt>
                <c:pt idx="28">
                  <c:v>8</c:v>
                </c:pt>
                <c:pt idx="29">
                  <c:v>8</c:v>
                </c:pt>
                <c:pt idx="30">
                  <c:v>8</c:v>
                </c:pt>
                <c:pt idx="31">
                  <c:v>8</c:v>
                </c:pt>
                <c:pt idx="32">
                  <c:v>8</c:v>
                </c:pt>
                <c:pt idx="33">
                  <c:v>8</c:v>
                </c:pt>
                <c:pt idx="34">
                  <c:v>8</c:v>
                </c:pt>
                <c:pt idx="35">
                  <c:v>8</c:v>
                </c:pt>
                <c:pt idx="36">
                  <c:v>8</c:v>
                </c:pt>
                <c:pt idx="37">
                  <c:v>8</c:v>
                </c:pt>
                <c:pt idx="38">
                  <c:v>8</c:v>
                </c:pt>
                <c:pt idx="39">
                  <c:v>8</c:v>
                </c:pt>
                <c:pt idx="40">
                  <c:v>8</c:v>
                </c:pt>
                <c:pt idx="41">
                  <c:v>8</c:v>
                </c:pt>
                <c:pt idx="42">
                  <c:v>8</c:v>
                </c:pt>
                <c:pt idx="43">
                  <c:v>8</c:v>
                </c:pt>
                <c:pt idx="44">
                  <c:v>8</c:v>
                </c:pt>
                <c:pt idx="45">
                  <c:v>7.9725799999999998</c:v>
                </c:pt>
                <c:pt idx="46">
                  <c:v>7.8124900000000004</c:v>
                </c:pt>
                <c:pt idx="47">
                  <c:v>7.2594200000000004</c:v>
                </c:pt>
                <c:pt idx="48">
                  <c:v>6.8013399999999997</c:v>
                </c:pt>
                <c:pt idx="49">
                  <c:v>6.3047399999999998</c:v>
                </c:pt>
                <c:pt idx="50">
                  <c:v>5.5506799999999998</c:v>
                </c:pt>
                <c:pt idx="51">
                  <c:v>5.1519399999999997</c:v>
                </c:pt>
                <c:pt idx="52">
                  <c:v>4.8203800000000001</c:v>
                </c:pt>
                <c:pt idx="53">
                  <c:v>4.4059699999999999</c:v>
                </c:pt>
                <c:pt idx="54">
                  <c:v>4.23977</c:v>
                </c:pt>
                <c:pt idx="55">
                  <c:v>8</c:v>
                </c:pt>
                <c:pt idx="56">
                  <c:v>7.9725799999999998</c:v>
                </c:pt>
                <c:pt idx="57">
                  <c:v>7.8124900000000004</c:v>
                </c:pt>
                <c:pt idx="58">
                  <c:v>7.2594200000000004</c:v>
                </c:pt>
                <c:pt idx="59">
                  <c:v>6.8013399999999997</c:v>
                </c:pt>
                <c:pt idx="60">
                  <c:v>6.3047399999999998</c:v>
                </c:pt>
                <c:pt idx="61">
                  <c:v>5.5506799999999998</c:v>
                </c:pt>
                <c:pt idx="62">
                  <c:v>5.1519399999999997</c:v>
                </c:pt>
                <c:pt idx="63">
                  <c:v>4.8203800000000001</c:v>
                </c:pt>
                <c:pt idx="64">
                  <c:v>4.4059699999999999</c:v>
                </c:pt>
                <c:pt idx="65">
                  <c:v>4.23977</c:v>
                </c:pt>
                <c:pt idx="66">
                  <c:v>8</c:v>
                </c:pt>
                <c:pt idx="67">
                  <c:v>7.9725799999999998</c:v>
                </c:pt>
                <c:pt idx="68">
                  <c:v>7.8124900000000004</c:v>
                </c:pt>
                <c:pt idx="69">
                  <c:v>7.2594200000000004</c:v>
                </c:pt>
                <c:pt idx="70">
                  <c:v>6.8013399999999997</c:v>
                </c:pt>
                <c:pt idx="71">
                  <c:v>6.3047399999999998</c:v>
                </c:pt>
                <c:pt idx="72">
                  <c:v>5.5506799999999998</c:v>
                </c:pt>
                <c:pt idx="73">
                  <c:v>5.1519399999999997</c:v>
                </c:pt>
                <c:pt idx="74">
                  <c:v>4.8203800000000001</c:v>
                </c:pt>
                <c:pt idx="75">
                  <c:v>4.4059699999999999</c:v>
                </c:pt>
                <c:pt idx="76">
                  <c:v>4.23977</c:v>
                </c:pt>
                <c:pt idx="77">
                  <c:v>8</c:v>
                </c:pt>
                <c:pt idx="78">
                  <c:v>7.9725799999999998</c:v>
                </c:pt>
                <c:pt idx="79">
                  <c:v>7.8124900000000004</c:v>
                </c:pt>
                <c:pt idx="80">
                  <c:v>7.2594200000000004</c:v>
                </c:pt>
                <c:pt idx="81">
                  <c:v>6.8013399999999997</c:v>
                </c:pt>
                <c:pt idx="82">
                  <c:v>6.3047399999999998</c:v>
                </c:pt>
                <c:pt idx="83">
                  <c:v>5.5506799999999998</c:v>
                </c:pt>
                <c:pt idx="84">
                  <c:v>5.1519399999999997</c:v>
                </c:pt>
                <c:pt idx="85">
                  <c:v>4.8203800000000001</c:v>
                </c:pt>
                <c:pt idx="86">
                  <c:v>4.4059699999999999</c:v>
                </c:pt>
                <c:pt idx="87">
                  <c:v>4.23977</c:v>
                </c:pt>
                <c:pt idx="88">
                  <c:v>8</c:v>
                </c:pt>
                <c:pt idx="89">
                  <c:v>7.9118599999999999</c:v>
                </c:pt>
                <c:pt idx="90">
                  <c:v>7.3923300000000003</c:v>
                </c:pt>
                <c:pt idx="91">
                  <c:v>5.5890300000000002</c:v>
                </c:pt>
                <c:pt idx="92">
                  <c:v>4.09293</c:v>
                </c:pt>
                <c:pt idx="93">
                  <c:v>2.4711500000000002</c:v>
                </c:pt>
                <c:pt idx="94">
                  <c:v>8.0000000000000002E-3</c:v>
                </c:pt>
                <c:pt idx="95">
                  <c:v>8.0000000000000002E-3</c:v>
                </c:pt>
                <c:pt idx="96">
                  <c:v>8.0000000000000002E-3</c:v>
                </c:pt>
                <c:pt idx="97">
                  <c:v>8.0000000000000002E-3</c:v>
                </c:pt>
                <c:pt idx="98">
                  <c:v>8.0000000000000002E-3</c:v>
                </c:pt>
                <c:pt idx="99">
                  <c:v>8</c:v>
                </c:pt>
                <c:pt idx="100">
                  <c:v>7.9118599999999999</c:v>
                </c:pt>
                <c:pt idx="101">
                  <c:v>7.3923300000000003</c:v>
                </c:pt>
                <c:pt idx="102">
                  <c:v>5.5890300000000002</c:v>
                </c:pt>
                <c:pt idx="103">
                  <c:v>4.09293</c:v>
                </c:pt>
                <c:pt idx="104">
                  <c:v>2.4711500000000002</c:v>
                </c:pt>
                <c:pt idx="105">
                  <c:v>8.0000000000000002E-3</c:v>
                </c:pt>
                <c:pt idx="106">
                  <c:v>8.0000000000000002E-3</c:v>
                </c:pt>
                <c:pt idx="107">
                  <c:v>8.0000000000000002E-3</c:v>
                </c:pt>
                <c:pt idx="108">
                  <c:v>8.0000000000000002E-3</c:v>
                </c:pt>
                <c:pt idx="109">
                  <c:v>8.0000000000000002E-3</c:v>
                </c:pt>
                <c:pt idx="110">
                  <c:v>8</c:v>
                </c:pt>
                <c:pt idx="111">
                  <c:v>7.9118599999999999</c:v>
                </c:pt>
                <c:pt idx="112">
                  <c:v>7.3923300000000003</c:v>
                </c:pt>
                <c:pt idx="113">
                  <c:v>5.5890300000000002</c:v>
                </c:pt>
                <c:pt idx="114">
                  <c:v>4.09293</c:v>
                </c:pt>
                <c:pt idx="115">
                  <c:v>2.4711500000000002</c:v>
                </c:pt>
                <c:pt idx="116">
                  <c:v>8.0000000000000002E-3</c:v>
                </c:pt>
                <c:pt idx="117">
                  <c:v>8.0000000000000002E-3</c:v>
                </c:pt>
                <c:pt idx="118">
                  <c:v>8.0000000000000002E-3</c:v>
                </c:pt>
                <c:pt idx="119">
                  <c:v>8.0000000000000002E-3</c:v>
                </c:pt>
                <c:pt idx="120">
                  <c:v>8.0000000000000002E-3</c:v>
                </c:pt>
                <c:pt idx="121">
                  <c:v>8</c:v>
                </c:pt>
                <c:pt idx="122">
                  <c:v>7.9118599999999999</c:v>
                </c:pt>
                <c:pt idx="123">
                  <c:v>7.3923300000000003</c:v>
                </c:pt>
                <c:pt idx="124">
                  <c:v>5.5890300000000002</c:v>
                </c:pt>
                <c:pt idx="125">
                  <c:v>4.09293</c:v>
                </c:pt>
                <c:pt idx="126">
                  <c:v>2.4711500000000002</c:v>
                </c:pt>
                <c:pt idx="127">
                  <c:v>8.0000000000000002E-3</c:v>
                </c:pt>
                <c:pt idx="128">
                  <c:v>8.0000000000000002E-3</c:v>
                </c:pt>
                <c:pt idx="129">
                  <c:v>8.0000000000000002E-3</c:v>
                </c:pt>
                <c:pt idx="130">
                  <c:v>8.0000000000000002E-3</c:v>
                </c:pt>
                <c:pt idx="131">
                  <c:v>8.0000000000000002E-3</c:v>
                </c:pt>
                <c:pt idx="132">
                  <c:v>8.0000000000000002E-3</c:v>
                </c:pt>
                <c:pt idx="133">
                  <c:v>8</c:v>
                </c:pt>
                <c:pt idx="134">
                  <c:v>7.9118599999999999</c:v>
                </c:pt>
                <c:pt idx="135">
                  <c:v>7.3923300000000003</c:v>
                </c:pt>
                <c:pt idx="136">
                  <c:v>5.5890300000000002</c:v>
                </c:pt>
                <c:pt idx="137">
                  <c:v>4.09293</c:v>
                </c:pt>
                <c:pt idx="138">
                  <c:v>2.4711500000000002</c:v>
                </c:pt>
                <c:pt idx="139">
                  <c:v>8.0000000000000002E-3</c:v>
                </c:pt>
                <c:pt idx="140">
                  <c:v>8.0000000000000002E-3</c:v>
                </c:pt>
                <c:pt idx="141">
                  <c:v>8.0000000000000002E-3</c:v>
                </c:pt>
                <c:pt idx="142">
                  <c:v>8.0000000000000002E-3</c:v>
                </c:pt>
                <c:pt idx="143">
                  <c:v>8.0000000000000002E-3</c:v>
                </c:pt>
                <c:pt idx="144">
                  <c:v>8.0000000000000002E-3</c:v>
                </c:pt>
                <c:pt idx="145">
                  <c:v>8</c:v>
                </c:pt>
                <c:pt idx="146">
                  <c:v>7.9118599999999999</c:v>
                </c:pt>
                <c:pt idx="147">
                  <c:v>7.3923300000000003</c:v>
                </c:pt>
                <c:pt idx="148">
                  <c:v>5.5890300000000002</c:v>
                </c:pt>
                <c:pt idx="149">
                  <c:v>4.09293</c:v>
                </c:pt>
                <c:pt idx="150">
                  <c:v>2.4711500000000002</c:v>
                </c:pt>
                <c:pt idx="151">
                  <c:v>8.0000000000000002E-3</c:v>
                </c:pt>
                <c:pt idx="152">
                  <c:v>8.0000000000000002E-3</c:v>
                </c:pt>
                <c:pt idx="153">
                  <c:v>8.0000000000000002E-3</c:v>
                </c:pt>
                <c:pt idx="154">
                  <c:v>8.0000000000000002E-3</c:v>
                </c:pt>
                <c:pt idx="155">
                  <c:v>8.0000000000000002E-3</c:v>
                </c:pt>
                <c:pt idx="156">
                  <c:v>8.0000000000000002E-3</c:v>
                </c:pt>
                <c:pt idx="157">
                  <c:v>8</c:v>
                </c:pt>
                <c:pt idx="158">
                  <c:v>7.8443199999999997</c:v>
                </c:pt>
                <c:pt idx="159">
                  <c:v>6.9122899999999996</c:v>
                </c:pt>
                <c:pt idx="160">
                  <c:v>3.6518600000000001</c:v>
                </c:pt>
                <c:pt idx="161">
                  <c:v>0.93939399999999995</c:v>
                </c:pt>
                <c:pt idx="162">
                  <c:v>8.0000000000000002E-3</c:v>
                </c:pt>
                <c:pt idx="163">
                  <c:v>8.0000000000000002E-3</c:v>
                </c:pt>
                <c:pt idx="164">
                  <c:v>8.0000000000000002E-3</c:v>
                </c:pt>
                <c:pt idx="165">
                  <c:v>8.0000000000000002E-3</c:v>
                </c:pt>
                <c:pt idx="166">
                  <c:v>8.0000000000000002E-3</c:v>
                </c:pt>
                <c:pt idx="167">
                  <c:v>8</c:v>
                </c:pt>
                <c:pt idx="168">
                  <c:v>7.8443199999999997</c:v>
                </c:pt>
                <c:pt idx="169">
                  <c:v>6.9122899999999996</c:v>
                </c:pt>
                <c:pt idx="170">
                  <c:v>3.6518600000000001</c:v>
                </c:pt>
                <c:pt idx="171">
                  <c:v>0.93939399999999995</c:v>
                </c:pt>
                <c:pt idx="172">
                  <c:v>8.0000000000000002E-3</c:v>
                </c:pt>
                <c:pt idx="173">
                  <c:v>8.0000000000000002E-3</c:v>
                </c:pt>
                <c:pt idx="174">
                  <c:v>8.0000000000000002E-3</c:v>
                </c:pt>
                <c:pt idx="175">
                  <c:v>8.0000000000000002E-3</c:v>
                </c:pt>
                <c:pt idx="176">
                  <c:v>8.0000000000000002E-3</c:v>
                </c:pt>
                <c:pt idx="177">
                  <c:v>8</c:v>
                </c:pt>
                <c:pt idx="178">
                  <c:v>7.8443199999999997</c:v>
                </c:pt>
                <c:pt idx="179">
                  <c:v>6.9122899999999996</c:v>
                </c:pt>
                <c:pt idx="180">
                  <c:v>3.6518600000000001</c:v>
                </c:pt>
                <c:pt idx="181">
                  <c:v>0.93939399999999995</c:v>
                </c:pt>
                <c:pt idx="182">
                  <c:v>8.0000000000000002E-3</c:v>
                </c:pt>
                <c:pt idx="183">
                  <c:v>8.0000000000000002E-3</c:v>
                </c:pt>
                <c:pt idx="184">
                  <c:v>8.0000000000000002E-3</c:v>
                </c:pt>
                <c:pt idx="185">
                  <c:v>8</c:v>
                </c:pt>
                <c:pt idx="186">
                  <c:v>7.8443199999999997</c:v>
                </c:pt>
                <c:pt idx="187">
                  <c:v>6.9122899999999996</c:v>
                </c:pt>
                <c:pt idx="188">
                  <c:v>3.6518600000000001</c:v>
                </c:pt>
                <c:pt idx="189">
                  <c:v>0.93939399999999995</c:v>
                </c:pt>
                <c:pt idx="190">
                  <c:v>8.0000000000000002E-3</c:v>
                </c:pt>
                <c:pt idx="191">
                  <c:v>8.0000000000000002E-3</c:v>
                </c:pt>
                <c:pt idx="192">
                  <c:v>8.0000000000000002E-3</c:v>
                </c:pt>
                <c:pt idx="193">
                  <c:v>8</c:v>
                </c:pt>
                <c:pt idx="194">
                  <c:v>7.8443199999999997</c:v>
                </c:pt>
                <c:pt idx="195">
                  <c:v>6.9122899999999996</c:v>
                </c:pt>
                <c:pt idx="196">
                  <c:v>3.6518600000000001</c:v>
                </c:pt>
                <c:pt idx="197">
                  <c:v>0.93939399999999995</c:v>
                </c:pt>
                <c:pt idx="198">
                  <c:v>8.0000000000000002E-3</c:v>
                </c:pt>
                <c:pt idx="199">
                  <c:v>8.0000000000000002E-3</c:v>
                </c:pt>
                <c:pt idx="200">
                  <c:v>8.0000000000000002E-3</c:v>
                </c:pt>
                <c:pt idx="201">
                  <c:v>8.0000000000000002E-3</c:v>
                </c:pt>
                <c:pt idx="202">
                  <c:v>8.0000000000000002E-3</c:v>
                </c:pt>
                <c:pt idx="203">
                  <c:v>8</c:v>
                </c:pt>
                <c:pt idx="204">
                  <c:v>7.8443199999999997</c:v>
                </c:pt>
                <c:pt idx="205">
                  <c:v>6.9122899999999996</c:v>
                </c:pt>
                <c:pt idx="206">
                  <c:v>3.6518600000000001</c:v>
                </c:pt>
                <c:pt idx="207">
                  <c:v>0.93939399999999995</c:v>
                </c:pt>
                <c:pt idx="208">
                  <c:v>8.0000000000000002E-3</c:v>
                </c:pt>
                <c:pt idx="209">
                  <c:v>8.0000000000000002E-3</c:v>
                </c:pt>
                <c:pt idx="210">
                  <c:v>8.0000000000000002E-3</c:v>
                </c:pt>
                <c:pt idx="211">
                  <c:v>8.0000000000000002E-3</c:v>
                </c:pt>
                <c:pt idx="212">
                  <c:v>8.0000000000000002E-3</c:v>
                </c:pt>
                <c:pt idx="213">
                  <c:v>8</c:v>
                </c:pt>
                <c:pt idx="214">
                  <c:v>7.8443199999999997</c:v>
                </c:pt>
                <c:pt idx="215">
                  <c:v>6.9122899999999996</c:v>
                </c:pt>
                <c:pt idx="216">
                  <c:v>3.6518600000000001</c:v>
                </c:pt>
                <c:pt idx="217">
                  <c:v>0.93939399999999995</c:v>
                </c:pt>
                <c:pt idx="218">
                  <c:v>8.0000000000000002E-3</c:v>
                </c:pt>
                <c:pt idx="219">
                  <c:v>8.0000000000000002E-3</c:v>
                </c:pt>
                <c:pt idx="220">
                  <c:v>8.0000000000000002E-3</c:v>
                </c:pt>
                <c:pt idx="221">
                  <c:v>8.0000000000000002E-3</c:v>
                </c:pt>
                <c:pt idx="222">
                  <c:v>8.0000000000000002E-3</c:v>
                </c:pt>
              </c:numCache>
            </c:numRef>
          </c:xVal>
          <c:yVal>
            <c:numRef>
              <c:f>'PD analysis (von Frey)'!$K$104:$K$327</c:f>
              <c:numCache>
                <c:formatCode>General</c:formatCode>
                <c:ptCount val="224"/>
                <c:pt idx="0">
                  <c:v>8</c:v>
                </c:pt>
                <c:pt idx="1">
                  <c:v>8</c:v>
                </c:pt>
                <c:pt idx="2">
                  <c:v>8</c:v>
                </c:pt>
                <c:pt idx="3">
                  <c:v>8</c:v>
                </c:pt>
                <c:pt idx="4">
                  <c:v>8</c:v>
                </c:pt>
                <c:pt idx="5">
                  <c:v>10</c:v>
                </c:pt>
                <c:pt idx="6">
                  <c:v>8</c:v>
                </c:pt>
                <c:pt idx="7">
                  <c:v>8</c:v>
                </c:pt>
                <c:pt idx="8">
                  <c:v>8</c:v>
                </c:pt>
                <c:pt idx="9">
                  <c:v>8</c:v>
                </c:pt>
                <c:pt idx="10">
                  <c:v>8</c:v>
                </c:pt>
                <c:pt idx="11">
                  <c:v>10</c:v>
                </c:pt>
                <c:pt idx="12">
                  <c:v>8</c:v>
                </c:pt>
                <c:pt idx="13">
                  <c:v>8</c:v>
                </c:pt>
                <c:pt idx="14">
                  <c:v>8</c:v>
                </c:pt>
                <c:pt idx="15">
                  <c:v>8</c:v>
                </c:pt>
                <c:pt idx="16">
                  <c:v>10</c:v>
                </c:pt>
                <c:pt idx="17">
                  <c:v>8</c:v>
                </c:pt>
                <c:pt idx="18">
                  <c:v>10</c:v>
                </c:pt>
                <c:pt idx="19">
                  <c:v>8</c:v>
                </c:pt>
                <c:pt idx="20">
                  <c:v>8</c:v>
                </c:pt>
                <c:pt idx="21">
                  <c:v>8</c:v>
                </c:pt>
                <c:pt idx="22">
                  <c:v>10</c:v>
                </c:pt>
                <c:pt idx="23">
                  <c:v>6</c:v>
                </c:pt>
                <c:pt idx="24">
                  <c:v>10</c:v>
                </c:pt>
                <c:pt idx="25">
                  <c:v>8</c:v>
                </c:pt>
                <c:pt idx="26">
                  <c:v>8</c:v>
                </c:pt>
                <c:pt idx="27">
                  <c:v>8</c:v>
                </c:pt>
                <c:pt idx="28">
                  <c:v>8</c:v>
                </c:pt>
                <c:pt idx="29">
                  <c:v>8</c:v>
                </c:pt>
                <c:pt idx="30">
                  <c:v>8</c:v>
                </c:pt>
                <c:pt idx="31">
                  <c:v>8</c:v>
                </c:pt>
                <c:pt idx="32">
                  <c:v>8</c:v>
                </c:pt>
                <c:pt idx="33">
                  <c:v>8</c:v>
                </c:pt>
                <c:pt idx="34">
                  <c:v>8</c:v>
                </c:pt>
                <c:pt idx="35">
                  <c:v>8</c:v>
                </c:pt>
                <c:pt idx="36">
                  <c:v>10</c:v>
                </c:pt>
                <c:pt idx="37">
                  <c:v>6</c:v>
                </c:pt>
                <c:pt idx="38">
                  <c:v>6</c:v>
                </c:pt>
                <c:pt idx="39">
                  <c:v>8</c:v>
                </c:pt>
                <c:pt idx="40">
                  <c:v>6</c:v>
                </c:pt>
                <c:pt idx="41">
                  <c:v>8</c:v>
                </c:pt>
                <c:pt idx="42">
                  <c:v>10</c:v>
                </c:pt>
                <c:pt idx="43">
                  <c:v>8</c:v>
                </c:pt>
                <c:pt idx="44">
                  <c:v>10</c:v>
                </c:pt>
                <c:pt idx="45">
                  <c:v>8</c:v>
                </c:pt>
                <c:pt idx="46">
                  <c:v>6</c:v>
                </c:pt>
                <c:pt idx="47">
                  <c:v>8</c:v>
                </c:pt>
                <c:pt idx="48">
                  <c:v>8</c:v>
                </c:pt>
                <c:pt idx="49">
                  <c:v>10</c:v>
                </c:pt>
                <c:pt idx="50">
                  <c:v>6</c:v>
                </c:pt>
                <c:pt idx="51">
                  <c:v>8</c:v>
                </c:pt>
                <c:pt idx="52">
                  <c:v>8</c:v>
                </c:pt>
                <c:pt idx="53">
                  <c:v>6</c:v>
                </c:pt>
                <c:pt idx="54">
                  <c:v>8</c:v>
                </c:pt>
                <c:pt idx="55">
                  <c:v>10</c:v>
                </c:pt>
                <c:pt idx="56">
                  <c:v>10</c:v>
                </c:pt>
                <c:pt idx="57">
                  <c:v>8</c:v>
                </c:pt>
                <c:pt idx="58">
                  <c:v>8</c:v>
                </c:pt>
                <c:pt idx="59">
                  <c:v>8</c:v>
                </c:pt>
                <c:pt idx="60">
                  <c:v>6</c:v>
                </c:pt>
                <c:pt idx="61">
                  <c:v>8</c:v>
                </c:pt>
                <c:pt idx="62">
                  <c:v>6</c:v>
                </c:pt>
                <c:pt idx="63">
                  <c:v>6</c:v>
                </c:pt>
                <c:pt idx="64">
                  <c:v>8</c:v>
                </c:pt>
                <c:pt idx="65">
                  <c:v>8</c:v>
                </c:pt>
                <c:pt idx="66">
                  <c:v>8</c:v>
                </c:pt>
                <c:pt idx="67">
                  <c:v>6</c:v>
                </c:pt>
                <c:pt idx="68">
                  <c:v>6</c:v>
                </c:pt>
                <c:pt idx="69">
                  <c:v>6</c:v>
                </c:pt>
                <c:pt idx="70">
                  <c:v>6</c:v>
                </c:pt>
                <c:pt idx="71">
                  <c:v>6</c:v>
                </c:pt>
                <c:pt idx="72">
                  <c:v>8</c:v>
                </c:pt>
                <c:pt idx="73">
                  <c:v>6</c:v>
                </c:pt>
                <c:pt idx="74">
                  <c:v>6</c:v>
                </c:pt>
                <c:pt idx="75">
                  <c:v>8</c:v>
                </c:pt>
                <c:pt idx="76">
                  <c:v>6</c:v>
                </c:pt>
                <c:pt idx="77">
                  <c:v>8</c:v>
                </c:pt>
                <c:pt idx="78">
                  <c:v>8</c:v>
                </c:pt>
                <c:pt idx="79">
                  <c:v>8</c:v>
                </c:pt>
                <c:pt idx="80">
                  <c:v>6</c:v>
                </c:pt>
                <c:pt idx="81">
                  <c:v>6</c:v>
                </c:pt>
                <c:pt idx="82">
                  <c:v>6</c:v>
                </c:pt>
                <c:pt idx="83">
                  <c:v>8</c:v>
                </c:pt>
                <c:pt idx="84">
                  <c:v>6</c:v>
                </c:pt>
                <c:pt idx="85">
                  <c:v>10</c:v>
                </c:pt>
                <c:pt idx="86">
                  <c:v>6</c:v>
                </c:pt>
                <c:pt idx="87">
                  <c:v>10</c:v>
                </c:pt>
                <c:pt idx="88">
                  <c:v>8</c:v>
                </c:pt>
                <c:pt idx="89">
                  <c:v>8</c:v>
                </c:pt>
                <c:pt idx="90">
                  <c:v>6</c:v>
                </c:pt>
                <c:pt idx="91">
                  <c:v>6</c:v>
                </c:pt>
                <c:pt idx="92">
                  <c:v>4</c:v>
                </c:pt>
                <c:pt idx="93">
                  <c:v>2</c:v>
                </c:pt>
                <c:pt idx="94">
                  <c:v>2</c:v>
                </c:pt>
                <c:pt idx="95">
                  <c:v>0.16</c:v>
                </c:pt>
                <c:pt idx="96">
                  <c:v>7.0000000000000007E-2</c:v>
                </c:pt>
                <c:pt idx="97">
                  <c:v>7.0000000000000007E-2</c:v>
                </c:pt>
                <c:pt idx="98">
                  <c:v>8.0000000000000002E-3</c:v>
                </c:pt>
                <c:pt idx="99">
                  <c:v>10</c:v>
                </c:pt>
                <c:pt idx="100">
                  <c:v>8</c:v>
                </c:pt>
                <c:pt idx="101">
                  <c:v>6</c:v>
                </c:pt>
                <c:pt idx="102">
                  <c:v>6</c:v>
                </c:pt>
                <c:pt idx="103">
                  <c:v>2</c:v>
                </c:pt>
                <c:pt idx="104">
                  <c:v>0.02</c:v>
                </c:pt>
                <c:pt idx="105">
                  <c:v>0.02</c:v>
                </c:pt>
                <c:pt idx="106">
                  <c:v>0.02</c:v>
                </c:pt>
                <c:pt idx="107">
                  <c:v>0.02</c:v>
                </c:pt>
                <c:pt idx="108">
                  <c:v>7.0000000000000007E-2</c:v>
                </c:pt>
                <c:pt idx="109">
                  <c:v>8.0000000000000002E-3</c:v>
                </c:pt>
                <c:pt idx="110">
                  <c:v>8</c:v>
                </c:pt>
                <c:pt idx="111">
                  <c:v>8</c:v>
                </c:pt>
                <c:pt idx="112">
                  <c:v>8</c:v>
                </c:pt>
                <c:pt idx="113">
                  <c:v>8</c:v>
                </c:pt>
                <c:pt idx="114">
                  <c:v>4</c:v>
                </c:pt>
                <c:pt idx="115">
                  <c:v>2</c:v>
                </c:pt>
                <c:pt idx="116">
                  <c:v>1.4</c:v>
                </c:pt>
                <c:pt idx="117">
                  <c:v>0.16</c:v>
                </c:pt>
                <c:pt idx="118">
                  <c:v>0.02</c:v>
                </c:pt>
                <c:pt idx="119">
                  <c:v>7.0000000000000007E-2</c:v>
                </c:pt>
                <c:pt idx="120">
                  <c:v>8.0000000000000002E-3</c:v>
                </c:pt>
                <c:pt idx="121">
                  <c:v>10</c:v>
                </c:pt>
                <c:pt idx="122">
                  <c:v>10</c:v>
                </c:pt>
                <c:pt idx="123">
                  <c:v>6</c:v>
                </c:pt>
                <c:pt idx="124">
                  <c:v>8</c:v>
                </c:pt>
                <c:pt idx="125">
                  <c:v>4</c:v>
                </c:pt>
                <c:pt idx="126">
                  <c:v>4</c:v>
                </c:pt>
                <c:pt idx="127">
                  <c:v>2</c:v>
                </c:pt>
                <c:pt idx="128">
                  <c:v>2</c:v>
                </c:pt>
                <c:pt idx="129">
                  <c:v>0.4</c:v>
                </c:pt>
                <c:pt idx="130">
                  <c:v>0.16</c:v>
                </c:pt>
                <c:pt idx="131">
                  <c:v>0.16</c:v>
                </c:pt>
                <c:pt idx="132">
                  <c:v>0.16</c:v>
                </c:pt>
                <c:pt idx="133">
                  <c:v>8</c:v>
                </c:pt>
                <c:pt idx="134">
                  <c:v>4</c:v>
                </c:pt>
                <c:pt idx="135">
                  <c:v>8</c:v>
                </c:pt>
                <c:pt idx="136">
                  <c:v>6</c:v>
                </c:pt>
                <c:pt idx="137">
                  <c:v>4</c:v>
                </c:pt>
                <c:pt idx="138">
                  <c:v>2</c:v>
                </c:pt>
                <c:pt idx="139">
                  <c:v>1.4</c:v>
                </c:pt>
                <c:pt idx="140">
                  <c:v>1</c:v>
                </c:pt>
                <c:pt idx="141">
                  <c:v>0.4</c:v>
                </c:pt>
                <c:pt idx="142">
                  <c:v>0.4</c:v>
                </c:pt>
                <c:pt idx="143">
                  <c:v>0.4</c:v>
                </c:pt>
                <c:pt idx="144">
                  <c:v>0.16</c:v>
                </c:pt>
                <c:pt idx="145">
                  <c:v>6</c:v>
                </c:pt>
                <c:pt idx="146">
                  <c:v>10</c:v>
                </c:pt>
                <c:pt idx="147">
                  <c:v>8</c:v>
                </c:pt>
                <c:pt idx="148">
                  <c:v>8</c:v>
                </c:pt>
                <c:pt idx="149">
                  <c:v>2</c:v>
                </c:pt>
                <c:pt idx="150">
                  <c:v>2</c:v>
                </c:pt>
                <c:pt idx="151">
                  <c:v>1</c:v>
                </c:pt>
                <c:pt idx="152">
                  <c:v>1</c:v>
                </c:pt>
                <c:pt idx="153">
                  <c:v>0.16</c:v>
                </c:pt>
                <c:pt idx="154">
                  <c:v>0.4</c:v>
                </c:pt>
                <c:pt idx="155">
                  <c:v>0.4</c:v>
                </c:pt>
                <c:pt idx="156">
                  <c:v>0.16</c:v>
                </c:pt>
                <c:pt idx="157">
                  <c:v>8</c:v>
                </c:pt>
                <c:pt idx="158">
                  <c:v>8</c:v>
                </c:pt>
                <c:pt idx="159">
                  <c:v>6</c:v>
                </c:pt>
                <c:pt idx="160">
                  <c:v>4</c:v>
                </c:pt>
                <c:pt idx="161">
                  <c:v>2</c:v>
                </c:pt>
                <c:pt idx="162">
                  <c:v>2</c:v>
                </c:pt>
                <c:pt idx="163">
                  <c:v>1.4</c:v>
                </c:pt>
                <c:pt idx="164">
                  <c:v>1</c:v>
                </c:pt>
                <c:pt idx="165">
                  <c:v>0.02</c:v>
                </c:pt>
                <c:pt idx="166">
                  <c:v>0.02</c:v>
                </c:pt>
                <c:pt idx="167">
                  <c:v>8</c:v>
                </c:pt>
                <c:pt idx="168">
                  <c:v>8</c:v>
                </c:pt>
                <c:pt idx="169">
                  <c:v>4</c:v>
                </c:pt>
                <c:pt idx="170">
                  <c:v>4</c:v>
                </c:pt>
                <c:pt idx="171">
                  <c:v>2</c:v>
                </c:pt>
                <c:pt idx="172">
                  <c:v>1.4</c:v>
                </c:pt>
                <c:pt idx="173">
                  <c:v>0.16</c:v>
                </c:pt>
                <c:pt idx="174">
                  <c:v>0.16</c:v>
                </c:pt>
                <c:pt idx="175">
                  <c:v>0.02</c:v>
                </c:pt>
                <c:pt idx="176">
                  <c:v>0.02</c:v>
                </c:pt>
                <c:pt idx="177">
                  <c:v>6</c:v>
                </c:pt>
                <c:pt idx="178">
                  <c:v>8</c:v>
                </c:pt>
                <c:pt idx="179">
                  <c:v>6</c:v>
                </c:pt>
                <c:pt idx="180">
                  <c:v>6</c:v>
                </c:pt>
                <c:pt idx="181">
                  <c:v>1.4</c:v>
                </c:pt>
                <c:pt idx="182">
                  <c:v>2</c:v>
                </c:pt>
                <c:pt idx="183">
                  <c:v>1.4</c:v>
                </c:pt>
                <c:pt idx="184">
                  <c:v>1.4</c:v>
                </c:pt>
                <c:pt idx="185">
                  <c:v>8</c:v>
                </c:pt>
                <c:pt idx="186">
                  <c:v>8</c:v>
                </c:pt>
                <c:pt idx="187">
                  <c:v>6</c:v>
                </c:pt>
                <c:pt idx="188">
                  <c:v>6</c:v>
                </c:pt>
                <c:pt idx="189">
                  <c:v>4</c:v>
                </c:pt>
                <c:pt idx="190">
                  <c:v>1.4</c:v>
                </c:pt>
                <c:pt idx="191">
                  <c:v>1.4</c:v>
                </c:pt>
                <c:pt idx="192">
                  <c:v>1.4</c:v>
                </c:pt>
                <c:pt idx="193">
                  <c:v>10</c:v>
                </c:pt>
                <c:pt idx="194">
                  <c:v>6</c:v>
                </c:pt>
                <c:pt idx="195">
                  <c:v>10</c:v>
                </c:pt>
                <c:pt idx="196">
                  <c:v>10</c:v>
                </c:pt>
                <c:pt idx="197">
                  <c:v>1.4</c:v>
                </c:pt>
                <c:pt idx="198">
                  <c:v>1</c:v>
                </c:pt>
                <c:pt idx="199">
                  <c:v>2</c:v>
                </c:pt>
                <c:pt idx="200">
                  <c:v>0.4</c:v>
                </c:pt>
                <c:pt idx="201">
                  <c:v>0.4</c:v>
                </c:pt>
                <c:pt idx="202">
                  <c:v>0.16</c:v>
                </c:pt>
                <c:pt idx="203">
                  <c:v>8</c:v>
                </c:pt>
                <c:pt idx="204">
                  <c:v>6</c:v>
                </c:pt>
                <c:pt idx="205">
                  <c:v>6</c:v>
                </c:pt>
                <c:pt idx="206">
                  <c:v>6</c:v>
                </c:pt>
                <c:pt idx="207">
                  <c:v>4</c:v>
                </c:pt>
                <c:pt idx="208">
                  <c:v>1</c:v>
                </c:pt>
                <c:pt idx="209">
                  <c:v>1.4</c:v>
                </c:pt>
                <c:pt idx="210">
                  <c:v>0.4</c:v>
                </c:pt>
                <c:pt idx="211">
                  <c:v>0.16</c:v>
                </c:pt>
                <c:pt idx="212">
                  <c:v>7.0000000000000007E-2</c:v>
                </c:pt>
                <c:pt idx="213">
                  <c:v>8</c:v>
                </c:pt>
                <c:pt idx="214">
                  <c:v>10</c:v>
                </c:pt>
                <c:pt idx="215">
                  <c:v>4</c:v>
                </c:pt>
                <c:pt idx="216">
                  <c:v>6</c:v>
                </c:pt>
                <c:pt idx="217">
                  <c:v>1.4</c:v>
                </c:pt>
                <c:pt idx="218">
                  <c:v>1</c:v>
                </c:pt>
                <c:pt idx="219">
                  <c:v>1</c:v>
                </c:pt>
                <c:pt idx="220">
                  <c:v>0.4</c:v>
                </c:pt>
                <c:pt idx="221">
                  <c:v>0.4</c:v>
                </c:pt>
                <c:pt idx="222">
                  <c:v>0.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1FF-4840-8604-F6BF6E51E3F7}"/>
            </c:ext>
          </c:extLst>
        </c:ser>
        <c:ser>
          <c:idx val="1"/>
          <c:order val="1"/>
          <c:spPr>
            <a:ln w="19050">
              <a:noFill/>
            </a:ln>
          </c:spPr>
          <c:marker>
            <c:symbol val="none"/>
          </c:marker>
          <c:trendline>
            <c:spPr>
              <a:ln w="9525"/>
            </c:spPr>
            <c:trendlineType val="linear"/>
            <c:dispRSqr val="0"/>
            <c:dispEq val="0"/>
          </c:trendline>
          <c:xVal>
            <c:numRef>
              <c:f>'　PK  (Pt conc.)'!$AI$39:$AJ$39</c:f>
              <c:numCache>
                <c:formatCode>General</c:formatCode>
                <c:ptCount val="2"/>
                <c:pt idx="0">
                  <c:v>0.01</c:v>
                </c:pt>
                <c:pt idx="1">
                  <c:v>100</c:v>
                </c:pt>
              </c:numCache>
            </c:numRef>
          </c:xVal>
          <c:yVal>
            <c:numRef>
              <c:f>'　PK  (Pt conc.)'!$AI$40:$AJ$40</c:f>
              <c:numCache>
                <c:formatCode>General</c:formatCode>
                <c:ptCount val="2"/>
                <c:pt idx="0">
                  <c:v>0.01</c:v>
                </c:pt>
                <c:pt idx="1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1FF-4840-8604-F6BF6E51E3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582608"/>
        <c:axId val="1675446624"/>
      </c:scatterChart>
      <c:valAx>
        <c:axId val="1980582608"/>
        <c:scaling>
          <c:orientation val="minMax"/>
          <c:max val="1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675446624"/>
        <c:crosses val="autoZero"/>
        <c:crossBetween val="midCat"/>
      </c:valAx>
      <c:valAx>
        <c:axId val="1675446624"/>
        <c:scaling>
          <c:orientation val="minMax"/>
          <c:max val="1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980582608"/>
        <c:crosses val="autoZero"/>
        <c:crossBetween val="midCat"/>
        <c:majorUnit val="5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913650793650794"/>
          <c:y val="5.0926041666666665E-2"/>
          <c:w val="0.79447377017786946"/>
          <c:h val="0.74203667249927097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5"/>
            <c:spPr>
              <a:noFill/>
              <a:ln w="15875">
                <a:solidFill>
                  <a:schemeClr val="tx1"/>
                </a:solidFill>
              </a:ln>
            </c:spPr>
          </c:marker>
          <c:xVal>
            <c:numRef>
              <c:f>'PD analysis (von Frey)'!$G$104:$G$327</c:f>
              <c:numCache>
                <c:formatCode>General</c:formatCode>
                <c:ptCount val="224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  <c:pt idx="11">
                  <c:v>0</c:v>
                </c:pt>
                <c:pt idx="12">
                  <c:v>3</c:v>
                </c:pt>
                <c:pt idx="13">
                  <c:v>5</c:v>
                </c:pt>
                <c:pt idx="14">
                  <c:v>8</c:v>
                </c:pt>
                <c:pt idx="15">
                  <c:v>10</c:v>
                </c:pt>
                <c:pt idx="16">
                  <c:v>12</c:v>
                </c:pt>
                <c:pt idx="17">
                  <c:v>15</c:v>
                </c:pt>
                <c:pt idx="18">
                  <c:v>17</c:v>
                </c:pt>
                <c:pt idx="19">
                  <c:v>19</c:v>
                </c:pt>
                <c:pt idx="20">
                  <c:v>22</c:v>
                </c:pt>
                <c:pt idx="21">
                  <c:v>24</c:v>
                </c:pt>
                <c:pt idx="22">
                  <c:v>0</c:v>
                </c:pt>
                <c:pt idx="23">
                  <c:v>3</c:v>
                </c:pt>
                <c:pt idx="24">
                  <c:v>5</c:v>
                </c:pt>
                <c:pt idx="25">
                  <c:v>8</c:v>
                </c:pt>
                <c:pt idx="26">
                  <c:v>10</c:v>
                </c:pt>
                <c:pt idx="27">
                  <c:v>12</c:v>
                </c:pt>
                <c:pt idx="28">
                  <c:v>15</c:v>
                </c:pt>
                <c:pt idx="29">
                  <c:v>17</c:v>
                </c:pt>
                <c:pt idx="30">
                  <c:v>19</c:v>
                </c:pt>
                <c:pt idx="31">
                  <c:v>22</c:v>
                </c:pt>
                <c:pt idx="32">
                  <c:v>24</c:v>
                </c:pt>
                <c:pt idx="33">
                  <c:v>0</c:v>
                </c:pt>
                <c:pt idx="34">
                  <c:v>3</c:v>
                </c:pt>
                <c:pt idx="35">
                  <c:v>5</c:v>
                </c:pt>
                <c:pt idx="36">
                  <c:v>8</c:v>
                </c:pt>
                <c:pt idx="37">
                  <c:v>10</c:v>
                </c:pt>
                <c:pt idx="38">
                  <c:v>12</c:v>
                </c:pt>
                <c:pt idx="39">
                  <c:v>15</c:v>
                </c:pt>
                <c:pt idx="40">
                  <c:v>17</c:v>
                </c:pt>
                <c:pt idx="41">
                  <c:v>19</c:v>
                </c:pt>
                <c:pt idx="42">
                  <c:v>22</c:v>
                </c:pt>
                <c:pt idx="43">
                  <c:v>24</c:v>
                </c:pt>
                <c:pt idx="44">
                  <c:v>0</c:v>
                </c:pt>
                <c:pt idx="45">
                  <c:v>3</c:v>
                </c:pt>
                <c:pt idx="46">
                  <c:v>5</c:v>
                </c:pt>
                <c:pt idx="47">
                  <c:v>8</c:v>
                </c:pt>
                <c:pt idx="48">
                  <c:v>10</c:v>
                </c:pt>
                <c:pt idx="49">
                  <c:v>12</c:v>
                </c:pt>
                <c:pt idx="50">
                  <c:v>15</c:v>
                </c:pt>
                <c:pt idx="51">
                  <c:v>17</c:v>
                </c:pt>
                <c:pt idx="52">
                  <c:v>19</c:v>
                </c:pt>
                <c:pt idx="53">
                  <c:v>22</c:v>
                </c:pt>
                <c:pt idx="54">
                  <c:v>24</c:v>
                </c:pt>
                <c:pt idx="55">
                  <c:v>0</c:v>
                </c:pt>
                <c:pt idx="56">
                  <c:v>3</c:v>
                </c:pt>
                <c:pt idx="57">
                  <c:v>5</c:v>
                </c:pt>
                <c:pt idx="58">
                  <c:v>8</c:v>
                </c:pt>
                <c:pt idx="59">
                  <c:v>10</c:v>
                </c:pt>
                <c:pt idx="60">
                  <c:v>12</c:v>
                </c:pt>
                <c:pt idx="61">
                  <c:v>15</c:v>
                </c:pt>
                <c:pt idx="62">
                  <c:v>17</c:v>
                </c:pt>
                <c:pt idx="63">
                  <c:v>19</c:v>
                </c:pt>
                <c:pt idx="64">
                  <c:v>22</c:v>
                </c:pt>
                <c:pt idx="65">
                  <c:v>24</c:v>
                </c:pt>
                <c:pt idx="66">
                  <c:v>0</c:v>
                </c:pt>
                <c:pt idx="67">
                  <c:v>3</c:v>
                </c:pt>
                <c:pt idx="68">
                  <c:v>5</c:v>
                </c:pt>
                <c:pt idx="69">
                  <c:v>8</c:v>
                </c:pt>
                <c:pt idx="70">
                  <c:v>10</c:v>
                </c:pt>
                <c:pt idx="71">
                  <c:v>12</c:v>
                </c:pt>
                <c:pt idx="72">
                  <c:v>15</c:v>
                </c:pt>
                <c:pt idx="73">
                  <c:v>17</c:v>
                </c:pt>
                <c:pt idx="74">
                  <c:v>19</c:v>
                </c:pt>
                <c:pt idx="75">
                  <c:v>22</c:v>
                </c:pt>
                <c:pt idx="76">
                  <c:v>24</c:v>
                </c:pt>
                <c:pt idx="77">
                  <c:v>0</c:v>
                </c:pt>
                <c:pt idx="78">
                  <c:v>3</c:v>
                </c:pt>
                <c:pt idx="79">
                  <c:v>5</c:v>
                </c:pt>
                <c:pt idx="80">
                  <c:v>8</c:v>
                </c:pt>
                <c:pt idx="81">
                  <c:v>10</c:v>
                </c:pt>
                <c:pt idx="82">
                  <c:v>12</c:v>
                </c:pt>
                <c:pt idx="83">
                  <c:v>15</c:v>
                </c:pt>
                <c:pt idx="84">
                  <c:v>17</c:v>
                </c:pt>
                <c:pt idx="85">
                  <c:v>19</c:v>
                </c:pt>
                <c:pt idx="86">
                  <c:v>22</c:v>
                </c:pt>
                <c:pt idx="87">
                  <c:v>24</c:v>
                </c:pt>
                <c:pt idx="88">
                  <c:v>0</c:v>
                </c:pt>
                <c:pt idx="89">
                  <c:v>3</c:v>
                </c:pt>
                <c:pt idx="90">
                  <c:v>5</c:v>
                </c:pt>
                <c:pt idx="91">
                  <c:v>8</c:v>
                </c:pt>
                <c:pt idx="92">
                  <c:v>10</c:v>
                </c:pt>
                <c:pt idx="93">
                  <c:v>12</c:v>
                </c:pt>
                <c:pt idx="94">
                  <c:v>15</c:v>
                </c:pt>
                <c:pt idx="95">
                  <c:v>17</c:v>
                </c:pt>
                <c:pt idx="96">
                  <c:v>19</c:v>
                </c:pt>
                <c:pt idx="97">
                  <c:v>22</c:v>
                </c:pt>
                <c:pt idx="98">
                  <c:v>24</c:v>
                </c:pt>
                <c:pt idx="99">
                  <c:v>0</c:v>
                </c:pt>
                <c:pt idx="100">
                  <c:v>3</c:v>
                </c:pt>
                <c:pt idx="101">
                  <c:v>5</c:v>
                </c:pt>
                <c:pt idx="102">
                  <c:v>8</c:v>
                </c:pt>
                <c:pt idx="103">
                  <c:v>10</c:v>
                </c:pt>
                <c:pt idx="104">
                  <c:v>12</c:v>
                </c:pt>
                <c:pt idx="105">
                  <c:v>15</c:v>
                </c:pt>
                <c:pt idx="106">
                  <c:v>17</c:v>
                </c:pt>
                <c:pt idx="107">
                  <c:v>19</c:v>
                </c:pt>
                <c:pt idx="108">
                  <c:v>22</c:v>
                </c:pt>
                <c:pt idx="109">
                  <c:v>24</c:v>
                </c:pt>
                <c:pt idx="110">
                  <c:v>0</c:v>
                </c:pt>
                <c:pt idx="111">
                  <c:v>3</c:v>
                </c:pt>
                <c:pt idx="112">
                  <c:v>5</c:v>
                </c:pt>
                <c:pt idx="113">
                  <c:v>8</c:v>
                </c:pt>
                <c:pt idx="114">
                  <c:v>10</c:v>
                </c:pt>
                <c:pt idx="115">
                  <c:v>12</c:v>
                </c:pt>
                <c:pt idx="116">
                  <c:v>15</c:v>
                </c:pt>
                <c:pt idx="117">
                  <c:v>17</c:v>
                </c:pt>
                <c:pt idx="118">
                  <c:v>19</c:v>
                </c:pt>
                <c:pt idx="119">
                  <c:v>22</c:v>
                </c:pt>
                <c:pt idx="120">
                  <c:v>24</c:v>
                </c:pt>
                <c:pt idx="121">
                  <c:v>0</c:v>
                </c:pt>
                <c:pt idx="122">
                  <c:v>3</c:v>
                </c:pt>
                <c:pt idx="123">
                  <c:v>5</c:v>
                </c:pt>
                <c:pt idx="124">
                  <c:v>8</c:v>
                </c:pt>
                <c:pt idx="125">
                  <c:v>10</c:v>
                </c:pt>
                <c:pt idx="126">
                  <c:v>12</c:v>
                </c:pt>
                <c:pt idx="127">
                  <c:v>15</c:v>
                </c:pt>
                <c:pt idx="128">
                  <c:v>17</c:v>
                </c:pt>
                <c:pt idx="129">
                  <c:v>19</c:v>
                </c:pt>
                <c:pt idx="130">
                  <c:v>22</c:v>
                </c:pt>
                <c:pt idx="131">
                  <c:v>24</c:v>
                </c:pt>
                <c:pt idx="132">
                  <c:v>26</c:v>
                </c:pt>
                <c:pt idx="133">
                  <c:v>0</c:v>
                </c:pt>
                <c:pt idx="134">
                  <c:v>3</c:v>
                </c:pt>
                <c:pt idx="135">
                  <c:v>5</c:v>
                </c:pt>
                <c:pt idx="136">
                  <c:v>8</c:v>
                </c:pt>
                <c:pt idx="137">
                  <c:v>10</c:v>
                </c:pt>
                <c:pt idx="138">
                  <c:v>12</c:v>
                </c:pt>
                <c:pt idx="139">
                  <c:v>15</c:v>
                </c:pt>
                <c:pt idx="140">
                  <c:v>17</c:v>
                </c:pt>
                <c:pt idx="141">
                  <c:v>19</c:v>
                </c:pt>
                <c:pt idx="142">
                  <c:v>22</c:v>
                </c:pt>
                <c:pt idx="143">
                  <c:v>24</c:v>
                </c:pt>
                <c:pt idx="144">
                  <c:v>26</c:v>
                </c:pt>
                <c:pt idx="145">
                  <c:v>0</c:v>
                </c:pt>
                <c:pt idx="146">
                  <c:v>3</c:v>
                </c:pt>
                <c:pt idx="147">
                  <c:v>5</c:v>
                </c:pt>
                <c:pt idx="148">
                  <c:v>8</c:v>
                </c:pt>
                <c:pt idx="149">
                  <c:v>10</c:v>
                </c:pt>
                <c:pt idx="150">
                  <c:v>12</c:v>
                </c:pt>
                <c:pt idx="151">
                  <c:v>15</c:v>
                </c:pt>
                <c:pt idx="152">
                  <c:v>17</c:v>
                </c:pt>
                <c:pt idx="153">
                  <c:v>19</c:v>
                </c:pt>
                <c:pt idx="154">
                  <c:v>22</c:v>
                </c:pt>
                <c:pt idx="155">
                  <c:v>24</c:v>
                </c:pt>
                <c:pt idx="156">
                  <c:v>26</c:v>
                </c:pt>
                <c:pt idx="157">
                  <c:v>0</c:v>
                </c:pt>
                <c:pt idx="158">
                  <c:v>3</c:v>
                </c:pt>
                <c:pt idx="159">
                  <c:v>5</c:v>
                </c:pt>
                <c:pt idx="160">
                  <c:v>8</c:v>
                </c:pt>
                <c:pt idx="161">
                  <c:v>10</c:v>
                </c:pt>
                <c:pt idx="162">
                  <c:v>12</c:v>
                </c:pt>
                <c:pt idx="163">
                  <c:v>15</c:v>
                </c:pt>
                <c:pt idx="164">
                  <c:v>17</c:v>
                </c:pt>
                <c:pt idx="165">
                  <c:v>19</c:v>
                </c:pt>
                <c:pt idx="166">
                  <c:v>22</c:v>
                </c:pt>
                <c:pt idx="167">
                  <c:v>0</c:v>
                </c:pt>
                <c:pt idx="168">
                  <c:v>3</c:v>
                </c:pt>
                <c:pt idx="169">
                  <c:v>5</c:v>
                </c:pt>
                <c:pt idx="170">
                  <c:v>8</c:v>
                </c:pt>
                <c:pt idx="171">
                  <c:v>10</c:v>
                </c:pt>
                <c:pt idx="172">
                  <c:v>12</c:v>
                </c:pt>
                <c:pt idx="173">
                  <c:v>15</c:v>
                </c:pt>
                <c:pt idx="174">
                  <c:v>17</c:v>
                </c:pt>
                <c:pt idx="175">
                  <c:v>19</c:v>
                </c:pt>
                <c:pt idx="176">
                  <c:v>22</c:v>
                </c:pt>
                <c:pt idx="177">
                  <c:v>0</c:v>
                </c:pt>
                <c:pt idx="178">
                  <c:v>3</c:v>
                </c:pt>
                <c:pt idx="179">
                  <c:v>5</c:v>
                </c:pt>
                <c:pt idx="180">
                  <c:v>8</c:v>
                </c:pt>
                <c:pt idx="181">
                  <c:v>10</c:v>
                </c:pt>
                <c:pt idx="182">
                  <c:v>12</c:v>
                </c:pt>
                <c:pt idx="183">
                  <c:v>15</c:v>
                </c:pt>
                <c:pt idx="184">
                  <c:v>17</c:v>
                </c:pt>
                <c:pt idx="185">
                  <c:v>0</c:v>
                </c:pt>
                <c:pt idx="186">
                  <c:v>3</c:v>
                </c:pt>
                <c:pt idx="187">
                  <c:v>5</c:v>
                </c:pt>
                <c:pt idx="188">
                  <c:v>8</c:v>
                </c:pt>
                <c:pt idx="189">
                  <c:v>10</c:v>
                </c:pt>
                <c:pt idx="190">
                  <c:v>12</c:v>
                </c:pt>
                <c:pt idx="191">
                  <c:v>15</c:v>
                </c:pt>
                <c:pt idx="192">
                  <c:v>17</c:v>
                </c:pt>
                <c:pt idx="193">
                  <c:v>0</c:v>
                </c:pt>
                <c:pt idx="194">
                  <c:v>3</c:v>
                </c:pt>
                <c:pt idx="195">
                  <c:v>5</c:v>
                </c:pt>
                <c:pt idx="196">
                  <c:v>8</c:v>
                </c:pt>
                <c:pt idx="197">
                  <c:v>10</c:v>
                </c:pt>
                <c:pt idx="198">
                  <c:v>12</c:v>
                </c:pt>
                <c:pt idx="199">
                  <c:v>15</c:v>
                </c:pt>
                <c:pt idx="200">
                  <c:v>17</c:v>
                </c:pt>
                <c:pt idx="201">
                  <c:v>19</c:v>
                </c:pt>
                <c:pt idx="202">
                  <c:v>22</c:v>
                </c:pt>
                <c:pt idx="203">
                  <c:v>0</c:v>
                </c:pt>
                <c:pt idx="204">
                  <c:v>3</c:v>
                </c:pt>
                <c:pt idx="205">
                  <c:v>5</c:v>
                </c:pt>
                <c:pt idx="206">
                  <c:v>8</c:v>
                </c:pt>
                <c:pt idx="207">
                  <c:v>10</c:v>
                </c:pt>
                <c:pt idx="208">
                  <c:v>12</c:v>
                </c:pt>
                <c:pt idx="209">
                  <c:v>15</c:v>
                </c:pt>
                <c:pt idx="210">
                  <c:v>17</c:v>
                </c:pt>
                <c:pt idx="211">
                  <c:v>19</c:v>
                </c:pt>
                <c:pt idx="212">
                  <c:v>22</c:v>
                </c:pt>
                <c:pt idx="213">
                  <c:v>0</c:v>
                </c:pt>
                <c:pt idx="214">
                  <c:v>3</c:v>
                </c:pt>
                <c:pt idx="215">
                  <c:v>5</c:v>
                </c:pt>
                <c:pt idx="216">
                  <c:v>8</c:v>
                </c:pt>
                <c:pt idx="217">
                  <c:v>10</c:v>
                </c:pt>
                <c:pt idx="218">
                  <c:v>12</c:v>
                </c:pt>
                <c:pt idx="219">
                  <c:v>15</c:v>
                </c:pt>
                <c:pt idx="220">
                  <c:v>17</c:v>
                </c:pt>
                <c:pt idx="221">
                  <c:v>19</c:v>
                </c:pt>
                <c:pt idx="222">
                  <c:v>22</c:v>
                </c:pt>
              </c:numCache>
            </c:numRef>
          </c:xVal>
          <c:yVal>
            <c:numRef>
              <c:f>'PD analysis (von Frey)'!$Q$104:$Q$327</c:f>
              <c:numCache>
                <c:formatCode>General</c:formatCode>
                <c:ptCount val="2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4841599999999999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.4841599999999999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1.4841599999999999</c:v>
                </c:pt>
                <c:pt idx="17">
                  <c:v>0</c:v>
                </c:pt>
                <c:pt idx="18">
                  <c:v>1.4841599999999999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1.4841599999999999</c:v>
                </c:pt>
                <c:pt idx="23">
                  <c:v>-1.4841599999999999</c:v>
                </c:pt>
                <c:pt idx="24">
                  <c:v>1.4841599999999999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1.4841599999999999</c:v>
                </c:pt>
                <c:pt idx="37">
                  <c:v>-1.4841599999999999</c:v>
                </c:pt>
                <c:pt idx="38">
                  <c:v>-1.4841599999999999</c:v>
                </c:pt>
                <c:pt idx="39">
                  <c:v>0</c:v>
                </c:pt>
                <c:pt idx="40">
                  <c:v>-1.4841599999999999</c:v>
                </c:pt>
                <c:pt idx="41">
                  <c:v>0</c:v>
                </c:pt>
                <c:pt idx="42">
                  <c:v>1.4841599999999999</c:v>
                </c:pt>
                <c:pt idx="43">
                  <c:v>0</c:v>
                </c:pt>
                <c:pt idx="44">
                  <c:v>1.4841599999999999</c:v>
                </c:pt>
                <c:pt idx="45">
                  <c:v>1.02042E-2</c:v>
                </c:pt>
                <c:pt idx="46">
                  <c:v>-1.4074500000000001</c:v>
                </c:pt>
                <c:pt idx="47">
                  <c:v>0.31163800000000003</c:v>
                </c:pt>
                <c:pt idx="48">
                  <c:v>0.418327</c:v>
                </c:pt>
                <c:pt idx="49">
                  <c:v>1.6486799999999999</c:v>
                </c:pt>
                <c:pt idx="50">
                  <c:v>-1.28532</c:v>
                </c:pt>
                <c:pt idx="51">
                  <c:v>0.46520499999999998</c:v>
                </c:pt>
                <c:pt idx="52">
                  <c:v>0.34680699999999998</c:v>
                </c:pt>
                <c:pt idx="53">
                  <c:v>-0.97441299999999997</c:v>
                </c:pt>
                <c:pt idx="54">
                  <c:v>0.60734900000000003</c:v>
                </c:pt>
                <c:pt idx="55">
                  <c:v>1.4841599999999999</c:v>
                </c:pt>
                <c:pt idx="56">
                  <c:v>1.4989399999999999</c:v>
                </c:pt>
                <c:pt idx="57">
                  <c:v>9.5385899999999996E-2</c:v>
                </c:pt>
                <c:pt idx="58">
                  <c:v>0.310477</c:v>
                </c:pt>
                <c:pt idx="59">
                  <c:v>0.32806200000000002</c:v>
                </c:pt>
                <c:pt idx="60">
                  <c:v>-0.84145800000000004</c:v>
                </c:pt>
                <c:pt idx="61">
                  <c:v>0.89260700000000004</c:v>
                </c:pt>
                <c:pt idx="62">
                  <c:v>-0.57085300000000005</c:v>
                </c:pt>
                <c:pt idx="63">
                  <c:v>-0.27167599999999997</c:v>
                </c:pt>
                <c:pt idx="64">
                  <c:v>1.19615</c:v>
                </c:pt>
                <c:pt idx="65">
                  <c:v>0.91156800000000004</c:v>
                </c:pt>
                <c:pt idx="66">
                  <c:v>0</c:v>
                </c:pt>
                <c:pt idx="67">
                  <c:v>-1.4573499999999999</c:v>
                </c:pt>
                <c:pt idx="68">
                  <c:v>-1.1671499999999999</c:v>
                </c:pt>
                <c:pt idx="69">
                  <c:v>-3.08492E-2</c:v>
                </c:pt>
                <c:pt idx="70">
                  <c:v>0.45069500000000001</c:v>
                </c:pt>
                <c:pt idx="71">
                  <c:v>0.63209899999999997</c:v>
                </c:pt>
                <c:pt idx="72">
                  <c:v>1.9036599999999999</c:v>
                </c:pt>
                <c:pt idx="73">
                  <c:v>4.35872E-2</c:v>
                </c:pt>
                <c:pt idx="74">
                  <c:v>0.126004</c:v>
                </c:pt>
                <c:pt idx="75">
                  <c:v>1.47302</c:v>
                </c:pt>
                <c:pt idx="76">
                  <c:v>-0.192888</c:v>
                </c:pt>
                <c:pt idx="77">
                  <c:v>0</c:v>
                </c:pt>
                <c:pt idx="78">
                  <c:v>1.2139E-2</c:v>
                </c:pt>
                <c:pt idx="79">
                  <c:v>8.0199900000000005E-2</c:v>
                </c:pt>
                <c:pt idx="80">
                  <c:v>-1.1000000000000001</c:v>
                </c:pt>
                <c:pt idx="81">
                  <c:v>-0.66581800000000002</c:v>
                </c:pt>
                <c:pt idx="82">
                  <c:v>-0.20236499999999999</c:v>
                </c:pt>
                <c:pt idx="83">
                  <c:v>1.4517199999999999</c:v>
                </c:pt>
                <c:pt idx="84">
                  <c:v>-0.14580399999999999</c:v>
                </c:pt>
                <c:pt idx="85">
                  <c:v>2.5304600000000002</c:v>
                </c:pt>
                <c:pt idx="86">
                  <c:v>-0.64390999999999998</c:v>
                </c:pt>
                <c:pt idx="87">
                  <c:v>2.16506</c:v>
                </c:pt>
                <c:pt idx="88">
                  <c:v>0</c:v>
                </c:pt>
                <c:pt idx="89">
                  <c:v>6.4873200000000006E-2</c:v>
                </c:pt>
                <c:pt idx="90">
                  <c:v>-0.82840199999999997</c:v>
                </c:pt>
                <c:pt idx="91">
                  <c:v>0.68132700000000002</c:v>
                </c:pt>
                <c:pt idx="92">
                  <c:v>-7.7072299999999996E-2</c:v>
                </c:pt>
                <c:pt idx="93">
                  <c:v>-0.22031000000000001</c:v>
                </c:pt>
                <c:pt idx="94">
                  <c:v>1.4782200000000001</c:v>
                </c:pt>
                <c:pt idx="95">
                  <c:v>0.11279599999999999</c:v>
                </c:pt>
                <c:pt idx="96">
                  <c:v>4.6008899999999998E-2</c:v>
                </c:pt>
                <c:pt idx="97">
                  <c:v>4.6008899999999998E-2</c:v>
                </c:pt>
                <c:pt idx="98">
                  <c:v>0</c:v>
                </c:pt>
                <c:pt idx="99">
                  <c:v>1.4841599999999999</c:v>
                </c:pt>
                <c:pt idx="100">
                  <c:v>6.5715599999999999E-2</c:v>
                </c:pt>
                <c:pt idx="101">
                  <c:v>-0.79118299999999997</c:v>
                </c:pt>
                <c:pt idx="102">
                  <c:v>0.72297100000000003</c:v>
                </c:pt>
                <c:pt idx="103">
                  <c:v>-0.92914099999999999</c:v>
                </c:pt>
                <c:pt idx="104">
                  <c:v>-0.26303199999999999</c:v>
                </c:pt>
                <c:pt idx="105">
                  <c:v>8.90495E-3</c:v>
                </c:pt>
                <c:pt idx="106">
                  <c:v>8.90495E-3</c:v>
                </c:pt>
                <c:pt idx="107">
                  <c:v>8.90495E-3</c:v>
                </c:pt>
                <c:pt idx="108">
                  <c:v>4.6008899999999998E-2</c:v>
                </c:pt>
                <c:pt idx="109">
                  <c:v>0</c:v>
                </c:pt>
                <c:pt idx="110">
                  <c:v>0</c:v>
                </c:pt>
                <c:pt idx="111">
                  <c:v>6.31462E-2</c:v>
                </c:pt>
                <c:pt idx="112">
                  <c:v>0.37578899999999998</c:v>
                </c:pt>
                <c:pt idx="113">
                  <c:v>0.60231699999999999</c:v>
                </c:pt>
                <c:pt idx="114">
                  <c:v>-1.3940600000000001</c:v>
                </c:pt>
                <c:pt idx="115">
                  <c:v>-0.78644700000000001</c:v>
                </c:pt>
                <c:pt idx="116">
                  <c:v>0.69009299999999996</c:v>
                </c:pt>
                <c:pt idx="117">
                  <c:v>0.11279599999999999</c:v>
                </c:pt>
                <c:pt idx="118">
                  <c:v>8.90495E-3</c:v>
                </c:pt>
                <c:pt idx="119">
                  <c:v>4.6008899999999998E-2</c:v>
                </c:pt>
                <c:pt idx="120">
                  <c:v>0</c:v>
                </c:pt>
                <c:pt idx="121">
                  <c:v>1.4841599999999999</c:v>
                </c:pt>
                <c:pt idx="122">
                  <c:v>1.54175</c:v>
                </c:pt>
                <c:pt idx="123">
                  <c:v>-0.93423100000000003</c:v>
                </c:pt>
                <c:pt idx="124">
                  <c:v>1.1736200000000001</c:v>
                </c:pt>
                <c:pt idx="125">
                  <c:v>-1.2011499999999999</c:v>
                </c:pt>
                <c:pt idx="126">
                  <c:v>0.21346200000000001</c:v>
                </c:pt>
                <c:pt idx="127">
                  <c:v>7.4930200000000002E-2</c:v>
                </c:pt>
                <c:pt idx="128">
                  <c:v>0.55753299999999995</c:v>
                </c:pt>
                <c:pt idx="129">
                  <c:v>-0.20383200000000001</c:v>
                </c:pt>
                <c:pt idx="130">
                  <c:v>0.11279599999999999</c:v>
                </c:pt>
                <c:pt idx="131">
                  <c:v>0.11279599999999999</c:v>
                </c:pt>
                <c:pt idx="132">
                  <c:v>0.11279599999999999</c:v>
                </c:pt>
                <c:pt idx="133">
                  <c:v>0</c:v>
                </c:pt>
                <c:pt idx="134">
                  <c:v>-2.8866499999999999</c:v>
                </c:pt>
                <c:pt idx="135">
                  <c:v>0.54532499999999995</c:v>
                </c:pt>
                <c:pt idx="136">
                  <c:v>0.131521</c:v>
                </c:pt>
                <c:pt idx="137">
                  <c:v>-0.26178600000000002</c:v>
                </c:pt>
                <c:pt idx="138">
                  <c:v>-0.28127200000000002</c:v>
                </c:pt>
                <c:pt idx="139">
                  <c:v>1.0329699999999999</c:v>
                </c:pt>
                <c:pt idx="140">
                  <c:v>0.73614299999999999</c:v>
                </c:pt>
                <c:pt idx="141">
                  <c:v>0.29089500000000001</c:v>
                </c:pt>
                <c:pt idx="142">
                  <c:v>0.29089500000000001</c:v>
                </c:pt>
                <c:pt idx="143">
                  <c:v>0.29089500000000001</c:v>
                </c:pt>
                <c:pt idx="144">
                  <c:v>0.11279599999999999</c:v>
                </c:pt>
                <c:pt idx="145">
                  <c:v>-1.4841599999999999</c:v>
                </c:pt>
                <c:pt idx="146">
                  <c:v>1.5458700000000001</c:v>
                </c:pt>
                <c:pt idx="147">
                  <c:v>0.335671</c:v>
                </c:pt>
                <c:pt idx="148">
                  <c:v>0.55842099999999995</c:v>
                </c:pt>
                <c:pt idx="149">
                  <c:v>-2.25543</c:v>
                </c:pt>
                <c:pt idx="150">
                  <c:v>0.111981</c:v>
                </c:pt>
                <c:pt idx="151">
                  <c:v>0.73614299999999999</c:v>
                </c:pt>
                <c:pt idx="152">
                  <c:v>0.73614299999999999</c:v>
                </c:pt>
                <c:pt idx="153">
                  <c:v>0.11279599999999999</c:v>
                </c:pt>
                <c:pt idx="154">
                  <c:v>0.29089500000000001</c:v>
                </c:pt>
                <c:pt idx="155">
                  <c:v>0.29089500000000001</c:v>
                </c:pt>
                <c:pt idx="156">
                  <c:v>0.11279599999999999</c:v>
                </c:pt>
                <c:pt idx="157">
                  <c:v>0</c:v>
                </c:pt>
                <c:pt idx="158">
                  <c:v>0.115438</c:v>
                </c:pt>
                <c:pt idx="159">
                  <c:v>-0.49421300000000001</c:v>
                </c:pt>
                <c:pt idx="160">
                  <c:v>0.519814</c:v>
                </c:pt>
                <c:pt idx="161">
                  <c:v>0.38037900000000002</c:v>
                </c:pt>
                <c:pt idx="162">
                  <c:v>1.4782200000000001</c:v>
                </c:pt>
                <c:pt idx="163">
                  <c:v>1.0329699999999999</c:v>
                </c:pt>
                <c:pt idx="164">
                  <c:v>0.73614299999999999</c:v>
                </c:pt>
                <c:pt idx="165">
                  <c:v>8.90495E-3</c:v>
                </c:pt>
                <c:pt idx="166">
                  <c:v>8.90495E-3</c:v>
                </c:pt>
                <c:pt idx="167">
                  <c:v>0</c:v>
                </c:pt>
                <c:pt idx="168">
                  <c:v>0.13789499999999999</c:v>
                </c:pt>
                <c:pt idx="169">
                  <c:v>-1.1516</c:v>
                </c:pt>
                <c:pt idx="170">
                  <c:v>1.7863</c:v>
                </c:pt>
                <c:pt idx="171">
                  <c:v>0.58505499999999999</c:v>
                </c:pt>
                <c:pt idx="172">
                  <c:v>1.0329699999999999</c:v>
                </c:pt>
                <c:pt idx="173">
                  <c:v>0.11279599999999999</c:v>
                </c:pt>
                <c:pt idx="174">
                  <c:v>0.11279599999999999</c:v>
                </c:pt>
                <c:pt idx="175">
                  <c:v>8.90495E-3</c:v>
                </c:pt>
                <c:pt idx="176">
                  <c:v>8.90495E-3</c:v>
                </c:pt>
                <c:pt idx="177">
                  <c:v>-1.4841599999999999</c:v>
                </c:pt>
                <c:pt idx="178">
                  <c:v>0.12834999999999999</c:v>
                </c:pt>
                <c:pt idx="179">
                  <c:v>-0.43011700000000003</c:v>
                </c:pt>
                <c:pt idx="180">
                  <c:v>1.1322300000000001</c:v>
                </c:pt>
                <c:pt idx="181">
                  <c:v>-0.95130300000000001</c:v>
                </c:pt>
                <c:pt idx="182">
                  <c:v>1.1430800000000001</c:v>
                </c:pt>
                <c:pt idx="183">
                  <c:v>1.0329699999999999</c:v>
                </c:pt>
                <c:pt idx="184">
                  <c:v>1.0329699999999999</c:v>
                </c:pt>
                <c:pt idx="185">
                  <c:v>0</c:v>
                </c:pt>
                <c:pt idx="186">
                  <c:v>0.10377599999999999</c:v>
                </c:pt>
                <c:pt idx="187">
                  <c:v>-0.62758800000000003</c:v>
                </c:pt>
                <c:pt idx="188">
                  <c:v>1.03383</c:v>
                </c:pt>
                <c:pt idx="189">
                  <c:v>0.16231899999999999</c:v>
                </c:pt>
                <c:pt idx="190">
                  <c:v>-0.269293</c:v>
                </c:pt>
                <c:pt idx="191">
                  <c:v>1.0329699999999999</c:v>
                </c:pt>
                <c:pt idx="192">
                  <c:v>1.0329699999999999</c:v>
                </c:pt>
                <c:pt idx="193">
                  <c:v>1.4841599999999999</c:v>
                </c:pt>
                <c:pt idx="194">
                  <c:v>-1.39208</c:v>
                </c:pt>
                <c:pt idx="195">
                  <c:v>1.9789099999999999</c:v>
                </c:pt>
                <c:pt idx="196">
                  <c:v>1.3892</c:v>
                </c:pt>
                <c:pt idx="197">
                  <c:v>-3.4203199999999998</c:v>
                </c:pt>
                <c:pt idx="198">
                  <c:v>-0.36411399999999999</c:v>
                </c:pt>
                <c:pt idx="199">
                  <c:v>1.4782200000000001</c:v>
                </c:pt>
                <c:pt idx="200">
                  <c:v>0.29089500000000001</c:v>
                </c:pt>
                <c:pt idx="201">
                  <c:v>0.29089500000000001</c:v>
                </c:pt>
                <c:pt idx="202">
                  <c:v>0.11279599999999999</c:v>
                </c:pt>
                <c:pt idx="203">
                  <c:v>0</c:v>
                </c:pt>
                <c:pt idx="204">
                  <c:v>-1.37449</c:v>
                </c:pt>
                <c:pt idx="205">
                  <c:v>-0.55874800000000002</c:v>
                </c:pt>
                <c:pt idx="206">
                  <c:v>1.1356299999999999</c:v>
                </c:pt>
                <c:pt idx="207">
                  <c:v>0.20960200000000001</c:v>
                </c:pt>
                <c:pt idx="208">
                  <c:v>-0.43279400000000001</c:v>
                </c:pt>
                <c:pt idx="209">
                  <c:v>1.0329699999999999</c:v>
                </c:pt>
                <c:pt idx="210">
                  <c:v>0.29089500000000001</c:v>
                </c:pt>
                <c:pt idx="211">
                  <c:v>0.11279599999999999</c:v>
                </c:pt>
                <c:pt idx="212">
                  <c:v>4.6008899999999998E-2</c:v>
                </c:pt>
                <c:pt idx="213">
                  <c:v>0</c:v>
                </c:pt>
                <c:pt idx="214">
                  <c:v>1.5836699999999999</c:v>
                </c:pt>
                <c:pt idx="215">
                  <c:v>-1.7902199999999999</c:v>
                </c:pt>
                <c:pt idx="216">
                  <c:v>1.8189900000000001</c:v>
                </c:pt>
                <c:pt idx="217">
                  <c:v>-0.70740000000000003</c:v>
                </c:pt>
                <c:pt idx="218">
                  <c:v>0.73614299999999999</c:v>
                </c:pt>
                <c:pt idx="219">
                  <c:v>0.73614299999999999</c:v>
                </c:pt>
                <c:pt idx="220">
                  <c:v>0.29089500000000001</c:v>
                </c:pt>
                <c:pt idx="221">
                  <c:v>0.29089500000000001</c:v>
                </c:pt>
                <c:pt idx="222">
                  <c:v>0.112795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B55-40F0-BA9A-64CF07E7BA8C}"/>
            </c:ext>
          </c:extLst>
        </c:ser>
        <c:ser>
          <c:idx val="1"/>
          <c:order val="1"/>
          <c:spPr>
            <a:ln w="9525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'PD analysis (von Frey)'!$AN$144:$AN$145</c:f>
              <c:numCache>
                <c:formatCode>General</c:formatCode>
                <c:ptCount val="2"/>
                <c:pt idx="0">
                  <c:v>0</c:v>
                </c:pt>
                <c:pt idx="1">
                  <c:v>30</c:v>
                </c:pt>
              </c:numCache>
            </c:numRef>
          </c:xVal>
          <c:yVal>
            <c:numRef>
              <c:f>'PD analysis (von Frey)'!$AO$144:$AO$145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B55-40F0-BA9A-64CF07E7BA8C}"/>
            </c:ext>
          </c:extLst>
        </c:ser>
        <c:ser>
          <c:idx val="2"/>
          <c:order val="2"/>
          <c:spPr>
            <a:ln w="9525">
              <a:solidFill>
                <a:schemeClr val="tx1"/>
              </a:solidFill>
              <a:prstDash val="sysDash"/>
            </a:ln>
          </c:spPr>
          <c:marker>
            <c:symbol val="none"/>
          </c:marker>
          <c:xVal>
            <c:numRef>
              <c:f>'PD analysis (von Frey)'!$AN$138:$AN$139</c:f>
              <c:numCache>
                <c:formatCode>General</c:formatCode>
                <c:ptCount val="2"/>
                <c:pt idx="0">
                  <c:v>0</c:v>
                </c:pt>
                <c:pt idx="1">
                  <c:v>30</c:v>
                </c:pt>
              </c:numCache>
            </c:numRef>
          </c:xVal>
          <c:yVal>
            <c:numRef>
              <c:f>'PD analysis (von Frey)'!$AO$138:$AO$139</c:f>
              <c:numCache>
                <c:formatCode>General</c:formatCode>
                <c:ptCount val="2"/>
                <c:pt idx="0">
                  <c:v>2</c:v>
                </c:pt>
                <c:pt idx="1">
                  <c:v>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B55-40F0-BA9A-64CF07E7BA8C}"/>
            </c:ext>
          </c:extLst>
        </c:ser>
        <c:ser>
          <c:idx val="3"/>
          <c:order val="3"/>
          <c:spPr>
            <a:ln w="9525">
              <a:solidFill>
                <a:schemeClr val="tx1"/>
              </a:solidFill>
              <a:prstDash val="sysDash"/>
            </a:ln>
          </c:spPr>
          <c:marker>
            <c:symbol val="none"/>
          </c:marker>
          <c:xVal>
            <c:numRef>
              <c:f>'PD analysis (von Frey)'!$AN$141:$AN$142</c:f>
              <c:numCache>
                <c:formatCode>General</c:formatCode>
                <c:ptCount val="2"/>
                <c:pt idx="0">
                  <c:v>0</c:v>
                </c:pt>
                <c:pt idx="1">
                  <c:v>30</c:v>
                </c:pt>
              </c:numCache>
            </c:numRef>
          </c:xVal>
          <c:yVal>
            <c:numRef>
              <c:f>'PD analysis (von Frey)'!$AO$141:$AO$142</c:f>
              <c:numCache>
                <c:formatCode>General</c:formatCode>
                <c:ptCount val="2"/>
                <c:pt idx="0">
                  <c:v>-2</c:v>
                </c:pt>
                <c:pt idx="1">
                  <c:v>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B55-40F0-BA9A-64CF07E7BA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448192"/>
        <c:axId val="30453088"/>
      </c:scatterChart>
      <c:valAx>
        <c:axId val="30448192"/>
        <c:scaling>
          <c:orientation val="minMax"/>
          <c:max val="3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30453088"/>
        <c:crossesAt val="-4"/>
        <c:crossBetween val="midCat"/>
        <c:majorUnit val="10"/>
      </c:valAx>
      <c:valAx>
        <c:axId val="30453088"/>
        <c:scaling>
          <c:orientation val="minMax"/>
          <c:max val="4"/>
          <c:min val="-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30448192"/>
        <c:crosses val="autoZero"/>
        <c:crossBetween val="midCat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966070764759556"/>
          <c:y val="5.0925881861406376E-2"/>
          <c:w val="0.79447377017786946"/>
          <c:h val="0.74203667249927097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5"/>
            <c:spPr>
              <a:noFill/>
              <a:ln w="15875">
                <a:solidFill>
                  <a:schemeClr val="tx1"/>
                </a:solidFill>
              </a:ln>
            </c:spPr>
          </c:marker>
          <c:trendline>
            <c:spPr>
              <a:ln>
                <a:noFill/>
              </a:ln>
            </c:spPr>
            <c:trendlineType val="linear"/>
            <c:dispRSqr val="0"/>
            <c:dispEq val="0"/>
          </c:trendline>
          <c:xVal>
            <c:numRef>
              <c:f>'PD analysis (von Frey)'!$J$104:$J$327</c:f>
              <c:numCache>
                <c:formatCode>General</c:formatCode>
                <c:ptCount val="224"/>
                <c:pt idx="0">
                  <c:v>8</c:v>
                </c:pt>
                <c:pt idx="1">
                  <c:v>8</c:v>
                </c:pt>
                <c:pt idx="2">
                  <c:v>8</c:v>
                </c:pt>
                <c:pt idx="3">
                  <c:v>8</c:v>
                </c:pt>
                <c:pt idx="4">
                  <c:v>8</c:v>
                </c:pt>
                <c:pt idx="5">
                  <c:v>8</c:v>
                </c:pt>
                <c:pt idx="6">
                  <c:v>8</c:v>
                </c:pt>
                <c:pt idx="7">
                  <c:v>8</c:v>
                </c:pt>
                <c:pt idx="8">
                  <c:v>8</c:v>
                </c:pt>
                <c:pt idx="9">
                  <c:v>8</c:v>
                </c:pt>
                <c:pt idx="10">
                  <c:v>8</c:v>
                </c:pt>
                <c:pt idx="11">
                  <c:v>8</c:v>
                </c:pt>
                <c:pt idx="12">
                  <c:v>8</c:v>
                </c:pt>
                <c:pt idx="13">
                  <c:v>8</c:v>
                </c:pt>
                <c:pt idx="14">
                  <c:v>8</c:v>
                </c:pt>
                <c:pt idx="15">
                  <c:v>8</c:v>
                </c:pt>
                <c:pt idx="16">
                  <c:v>8</c:v>
                </c:pt>
                <c:pt idx="17">
                  <c:v>8</c:v>
                </c:pt>
                <c:pt idx="18">
                  <c:v>8</c:v>
                </c:pt>
                <c:pt idx="19">
                  <c:v>8</c:v>
                </c:pt>
                <c:pt idx="20">
                  <c:v>8</c:v>
                </c:pt>
                <c:pt idx="21">
                  <c:v>8</c:v>
                </c:pt>
                <c:pt idx="22">
                  <c:v>8</c:v>
                </c:pt>
                <c:pt idx="23">
                  <c:v>8</c:v>
                </c:pt>
                <c:pt idx="24">
                  <c:v>8</c:v>
                </c:pt>
                <c:pt idx="25">
                  <c:v>8</c:v>
                </c:pt>
                <c:pt idx="26">
                  <c:v>8</c:v>
                </c:pt>
                <c:pt idx="27">
                  <c:v>8</c:v>
                </c:pt>
                <c:pt idx="28">
                  <c:v>8</c:v>
                </c:pt>
                <c:pt idx="29">
                  <c:v>8</c:v>
                </c:pt>
                <c:pt idx="30">
                  <c:v>8</c:v>
                </c:pt>
                <c:pt idx="31">
                  <c:v>8</c:v>
                </c:pt>
                <c:pt idx="32">
                  <c:v>8</c:v>
                </c:pt>
                <c:pt idx="33">
                  <c:v>8</c:v>
                </c:pt>
                <c:pt idx="34">
                  <c:v>8</c:v>
                </c:pt>
                <c:pt idx="35">
                  <c:v>8</c:v>
                </c:pt>
                <c:pt idx="36">
                  <c:v>8</c:v>
                </c:pt>
                <c:pt idx="37">
                  <c:v>8</c:v>
                </c:pt>
                <c:pt idx="38">
                  <c:v>8</c:v>
                </c:pt>
                <c:pt idx="39">
                  <c:v>8</c:v>
                </c:pt>
                <c:pt idx="40">
                  <c:v>8</c:v>
                </c:pt>
                <c:pt idx="41">
                  <c:v>8</c:v>
                </c:pt>
                <c:pt idx="42">
                  <c:v>8</c:v>
                </c:pt>
                <c:pt idx="43">
                  <c:v>8</c:v>
                </c:pt>
                <c:pt idx="44">
                  <c:v>8</c:v>
                </c:pt>
                <c:pt idx="45">
                  <c:v>7.9954200000000002</c:v>
                </c:pt>
                <c:pt idx="46">
                  <c:v>7.9679200000000003</c:v>
                </c:pt>
                <c:pt idx="47">
                  <c:v>7.8696599999999997</c:v>
                </c:pt>
                <c:pt idx="48">
                  <c:v>7.7856500000000004</c:v>
                </c:pt>
                <c:pt idx="49">
                  <c:v>7.6932600000000004</c:v>
                </c:pt>
                <c:pt idx="50">
                  <c:v>7.5505100000000001</c:v>
                </c:pt>
                <c:pt idx="51">
                  <c:v>7.4724700000000004</c:v>
                </c:pt>
                <c:pt idx="52">
                  <c:v>7.4067699999999999</c:v>
                </c:pt>
                <c:pt idx="53">
                  <c:v>7.3241199999999997</c:v>
                </c:pt>
                <c:pt idx="54">
                  <c:v>7.2891199999999996</c:v>
                </c:pt>
                <c:pt idx="55">
                  <c:v>8</c:v>
                </c:pt>
                <c:pt idx="56">
                  <c:v>7.9908999999999999</c:v>
                </c:pt>
                <c:pt idx="57">
                  <c:v>7.9390000000000001</c:v>
                </c:pt>
                <c:pt idx="58">
                  <c:v>7.7673100000000002</c:v>
                </c:pt>
                <c:pt idx="59">
                  <c:v>7.6316800000000002</c:v>
                </c:pt>
                <c:pt idx="60">
                  <c:v>7.4877599999999997</c:v>
                </c:pt>
                <c:pt idx="61">
                  <c:v>7.2745199999999999</c:v>
                </c:pt>
                <c:pt idx="62">
                  <c:v>7.1676799999999998</c:v>
                </c:pt>
                <c:pt idx="63">
                  <c:v>7.08047</c:v>
                </c:pt>
                <c:pt idx="64">
                  <c:v>6.9719800000000003</c:v>
                </c:pt>
                <c:pt idx="65">
                  <c:v>6.9325599999999996</c:v>
                </c:pt>
                <c:pt idx="66">
                  <c:v>8</c:v>
                </c:pt>
                <c:pt idx="67">
                  <c:v>7.9711499999999997</c:v>
                </c:pt>
                <c:pt idx="68">
                  <c:v>7.8260800000000001</c:v>
                </c:pt>
                <c:pt idx="69">
                  <c:v>7.4331399999999999</c:v>
                </c:pt>
                <c:pt idx="70">
                  <c:v>7.1829999999999998</c:v>
                </c:pt>
                <c:pt idx="71">
                  <c:v>6.9341699999999999</c:v>
                </c:pt>
                <c:pt idx="72">
                  <c:v>6.6001599999999998</c:v>
                </c:pt>
                <c:pt idx="73">
                  <c:v>6.4763099999999998</c:v>
                </c:pt>
                <c:pt idx="74">
                  <c:v>6.3752300000000002</c:v>
                </c:pt>
                <c:pt idx="75">
                  <c:v>6.2450200000000002</c:v>
                </c:pt>
                <c:pt idx="76">
                  <c:v>6.2276100000000003</c:v>
                </c:pt>
                <c:pt idx="77">
                  <c:v>8</c:v>
                </c:pt>
                <c:pt idx="78">
                  <c:v>7.9941300000000002</c:v>
                </c:pt>
                <c:pt idx="79">
                  <c:v>7.9615299999999998</c:v>
                </c:pt>
                <c:pt idx="80">
                  <c:v>7.8586999999999998</c:v>
                </c:pt>
                <c:pt idx="81">
                  <c:v>7.7815799999999999</c:v>
                </c:pt>
                <c:pt idx="82">
                  <c:v>7.7014199999999997</c:v>
                </c:pt>
                <c:pt idx="83">
                  <c:v>7.5856199999999996</c:v>
                </c:pt>
                <c:pt idx="84">
                  <c:v>7.5311399999999997</c:v>
                </c:pt>
                <c:pt idx="85">
                  <c:v>7.4873200000000004</c:v>
                </c:pt>
                <c:pt idx="86">
                  <c:v>7.4327699999999997</c:v>
                </c:pt>
                <c:pt idx="87">
                  <c:v>7.4154600000000004</c:v>
                </c:pt>
                <c:pt idx="88">
                  <c:v>8</c:v>
                </c:pt>
                <c:pt idx="89">
                  <c:v>7.90585</c:v>
                </c:pt>
                <c:pt idx="90">
                  <c:v>7.3532500000000001</c:v>
                </c:pt>
                <c:pt idx="91">
                  <c:v>5.4487699999999997</c:v>
                </c:pt>
                <c:pt idx="92">
                  <c:v>3.8804599999999998</c:v>
                </c:pt>
                <c:pt idx="93">
                  <c:v>2.1862400000000002</c:v>
                </c:pt>
                <c:pt idx="94">
                  <c:v>8.0000000000000002E-3</c:v>
                </c:pt>
                <c:pt idx="95">
                  <c:v>8.0000000000000002E-3</c:v>
                </c:pt>
                <c:pt idx="96">
                  <c:v>8.0000000000000002E-3</c:v>
                </c:pt>
                <c:pt idx="97">
                  <c:v>8.0000000000000002E-3</c:v>
                </c:pt>
                <c:pt idx="98">
                  <c:v>8.0000000000000002E-3</c:v>
                </c:pt>
                <c:pt idx="99">
                  <c:v>8</c:v>
                </c:pt>
                <c:pt idx="100">
                  <c:v>7.8767300000000002</c:v>
                </c:pt>
                <c:pt idx="101">
                  <c:v>7.14689</c:v>
                </c:pt>
                <c:pt idx="102">
                  <c:v>4.6126100000000001</c:v>
                </c:pt>
                <c:pt idx="103">
                  <c:v>2.5135299999999998</c:v>
                </c:pt>
                <c:pt idx="104">
                  <c:v>0.241089</c:v>
                </c:pt>
                <c:pt idx="105">
                  <c:v>8.0000000000000002E-3</c:v>
                </c:pt>
                <c:pt idx="106">
                  <c:v>8.0000000000000002E-3</c:v>
                </c:pt>
                <c:pt idx="107">
                  <c:v>8.0000000000000002E-3</c:v>
                </c:pt>
                <c:pt idx="108">
                  <c:v>8.0000000000000002E-3</c:v>
                </c:pt>
                <c:pt idx="109">
                  <c:v>8.0000000000000002E-3</c:v>
                </c:pt>
                <c:pt idx="110">
                  <c:v>8</c:v>
                </c:pt>
                <c:pt idx="111">
                  <c:v>7.9331899999999997</c:v>
                </c:pt>
                <c:pt idx="112">
                  <c:v>7.5239099999999999</c:v>
                </c:pt>
                <c:pt idx="113">
                  <c:v>6.0154100000000001</c:v>
                </c:pt>
                <c:pt idx="114">
                  <c:v>4.6841900000000001</c:v>
                </c:pt>
                <c:pt idx="115">
                  <c:v>3.1968700000000001</c:v>
                </c:pt>
                <c:pt idx="116">
                  <c:v>0.85765100000000005</c:v>
                </c:pt>
                <c:pt idx="117">
                  <c:v>8.0000000000000002E-3</c:v>
                </c:pt>
                <c:pt idx="118">
                  <c:v>8.0000000000000002E-3</c:v>
                </c:pt>
                <c:pt idx="119">
                  <c:v>8.0000000000000002E-3</c:v>
                </c:pt>
                <c:pt idx="120">
                  <c:v>8.0000000000000002E-3</c:v>
                </c:pt>
                <c:pt idx="121">
                  <c:v>8</c:v>
                </c:pt>
                <c:pt idx="122">
                  <c:v>7.9358199999999997</c:v>
                </c:pt>
                <c:pt idx="123">
                  <c:v>7.5592499999999996</c:v>
                </c:pt>
                <c:pt idx="124">
                  <c:v>6.2604899999999999</c:v>
                </c:pt>
                <c:pt idx="125">
                  <c:v>5.1898600000000004</c:v>
                </c:pt>
                <c:pt idx="126">
                  <c:v>4.0326500000000003</c:v>
                </c:pt>
                <c:pt idx="127">
                  <c:v>2.2797100000000001</c:v>
                </c:pt>
                <c:pt idx="128">
                  <c:v>1.35829</c:v>
                </c:pt>
                <c:pt idx="129">
                  <c:v>0.59463900000000003</c:v>
                </c:pt>
                <c:pt idx="130">
                  <c:v>8.0000000000000002E-3</c:v>
                </c:pt>
                <c:pt idx="131">
                  <c:v>8.0000000000000002E-3</c:v>
                </c:pt>
                <c:pt idx="132">
                  <c:v>8.0000000000000002E-3</c:v>
                </c:pt>
                <c:pt idx="133">
                  <c:v>8</c:v>
                </c:pt>
                <c:pt idx="134">
                  <c:v>7.91411</c:v>
                </c:pt>
                <c:pt idx="135">
                  <c:v>7.3978599999999997</c:v>
                </c:pt>
                <c:pt idx="136">
                  <c:v>5.5521900000000004</c:v>
                </c:pt>
                <c:pt idx="137">
                  <c:v>3.9739800000000001</c:v>
                </c:pt>
                <c:pt idx="138">
                  <c:v>2.23854</c:v>
                </c:pt>
                <c:pt idx="139">
                  <c:v>8.0000000000000002E-3</c:v>
                </c:pt>
                <c:pt idx="140">
                  <c:v>8.0000000000000002E-3</c:v>
                </c:pt>
                <c:pt idx="141">
                  <c:v>8.0000000000000002E-3</c:v>
                </c:pt>
                <c:pt idx="142">
                  <c:v>8.0000000000000002E-3</c:v>
                </c:pt>
                <c:pt idx="143">
                  <c:v>8.0000000000000002E-3</c:v>
                </c:pt>
                <c:pt idx="144">
                  <c:v>8.0000000000000002E-3</c:v>
                </c:pt>
                <c:pt idx="145">
                  <c:v>8</c:v>
                </c:pt>
                <c:pt idx="146">
                  <c:v>7.9214099999999998</c:v>
                </c:pt>
                <c:pt idx="147">
                  <c:v>7.42835</c:v>
                </c:pt>
                <c:pt idx="148">
                  <c:v>5.5517799999999999</c:v>
                </c:pt>
                <c:pt idx="149">
                  <c:v>3.84361</c:v>
                </c:pt>
                <c:pt idx="150">
                  <c:v>1.90442</c:v>
                </c:pt>
                <c:pt idx="151">
                  <c:v>8.0000000000000002E-3</c:v>
                </c:pt>
                <c:pt idx="152">
                  <c:v>8.0000000000000002E-3</c:v>
                </c:pt>
                <c:pt idx="153">
                  <c:v>8.0000000000000002E-3</c:v>
                </c:pt>
                <c:pt idx="154">
                  <c:v>8.0000000000000002E-3</c:v>
                </c:pt>
                <c:pt idx="155">
                  <c:v>8.0000000000000002E-3</c:v>
                </c:pt>
                <c:pt idx="156">
                  <c:v>8.0000000000000002E-3</c:v>
                </c:pt>
                <c:pt idx="157">
                  <c:v>8</c:v>
                </c:pt>
                <c:pt idx="158">
                  <c:v>7.8557800000000002</c:v>
                </c:pt>
                <c:pt idx="159">
                  <c:v>7.0057999999999998</c:v>
                </c:pt>
                <c:pt idx="160">
                  <c:v>4.0892299999999997</c:v>
                </c:pt>
                <c:pt idx="161">
                  <c:v>1.7069000000000001</c:v>
                </c:pt>
                <c:pt idx="162">
                  <c:v>8.0000000000000002E-3</c:v>
                </c:pt>
                <c:pt idx="163">
                  <c:v>8.0000000000000002E-3</c:v>
                </c:pt>
                <c:pt idx="164">
                  <c:v>8.0000000000000002E-3</c:v>
                </c:pt>
                <c:pt idx="165">
                  <c:v>8.0000000000000002E-3</c:v>
                </c:pt>
                <c:pt idx="166">
                  <c:v>8.0000000000000002E-3</c:v>
                </c:pt>
                <c:pt idx="167">
                  <c:v>8</c:v>
                </c:pt>
                <c:pt idx="168">
                  <c:v>7.8066700000000004</c:v>
                </c:pt>
                <c:pt idx="169">
                  <c:v>6.77</c:v>
                </c:pt>
                <c:pt idx="170">
                  <c:v>3.7044899999999998</c:v>
                </c:pt>
                <c:pt idx="171">
                  <c:v>1.56731</c:v>
                </c:pt>
                <c:pt idx="172">
                  <c:v>8.0000000000000002E-3</c:v>
                </c:pt>
                <c:pt idx="173">
                  <c:v>8.0000000000000002E-3</c:v>
                </c:pt>
                <c:pt idx="174">
                  <c:v>8.0000000000000002E-3</c:v>
                </c:pt>
                <c:pt idx="175">
                  <c:v>8.0000000000000002E-3</c:v>
                </c:pt>
                <c:pt idx="176">
                  <c:v>8.0000000000000002E-3</c:v>
                </c:pt>
                <c:pt idx="177">
                  <c:v>8</c:v>
                </c:pt>
                <c:pt idx="178">
                  <c:v>7.8845999999999998</c:v>
                </c:pt>
                <c:pt idx="179">
                  <c:v>7.20906</c:v>
                </c:pt>
                <c:pt idx="180">
                  <c:v>4.9133699999999996</c:v>
                </c:pt>
                <c:pt idx="181">
                  <c:v>3.05661</c:v>
                </c:pt>
                <c:pt idx="182">
                  <c:v>1.0686899999999999</c:v>
                </c:pt>
                <c:pt idx="183">
                  <c:v>8.0000000000000002E-3</c:v>
                </c:pt>
                <c:pt idx="184">
                  <c:v>8.0000000000000002E-3</c:v>
                </c:pt>
                <c:pt idx="185">
                  <c:v>8</c:v>
                </c:pt>
                <c:pt idx="186">
                  <c:v>7.9184099999999997</c:v>
                </c:pt>
                <c:pt idx="187">
                  <c:v>7.4041100000000002</c:v>
                </c:pt>
                <c:pt idx="188">
                  <c:v>5.4420500000000001</c:v>
                </c:pt>
                <c:pt idx="189">
                  <c:v>3.6545200000000002</c:v>
                </c:pt>
                <c:pt idx="190">
                  <c:v>1.6251199999999999</c:v>
                </c:pt>
                <c:pt idx="191">
                  <c:v>8.0000000000000002E-3</c:v>
                </c:pt>
                <c:pt idx="192">
                  <c:v>8.0000000000000002E-3</c:v>
                </c:pt>
                <c:pt idx="193">
                  <c:v>8</c:v>
                </c:pt>
                <c:pt idx="194">
                  <c:v>7.9382900000000003</c:v>
                </c:pt>
                <c:pt idx="195">
                  <c:v>7.5096800000000004</c:v>
                </c:pt>
                <c:pt idx="196">
                  <c:v>5.6365400000000001</c:v>
                </c:pt>
                <c:pt idx="197">
                  <c:v>3.6906300000000001</c:v>
                </c:pt>
                <c:pt idx="198">
                  <c:v>1.3073999999999999</c:v>
                </c:pt>
                <c:pt idx="199">
                  <c:v>8.0000000000000002E-3</c:v>
                </c:pt>
                <c:pt idx="200">
                  <c:v>8.0000000000000002E-3</c:v>
                </c:pt>
                <c:pt idx="201">
                  <c:v>8.0000000000000002E-3</c:v>
                </c:pt>
                <c:pt idx="202">
                  <c:v>8.0000000000000002E-3</c:v>
                </c:pt>
                <c:pt idx="203">
                  <c:v>8</c:v>
                </c:pt>
                <c:pt idx="204">
                  <c:v>7.91601</c:v>
                </c:pt>
                <c:pt idx="205">
                  <c:v>7.3848700000000003</c:v>
                </c:pt>
                <c:pt idx="206">
                  <c:v>5.3489599999999999</c:v>
                </c:pt>
                <c:pt idx="207">
                  <c:v>3.4853100000000001</c:v>
                </c:pt>
                <c:pt idx="208">
                  <c:v>1.36408</c:v>
                </c:pt>
                <c:pt idx="209">
                  <c:v>8.0000000000000002E-3</c:v>
                </c:pt>
                <c:pt idx="210">
                  <c:v>8.0000000000000002E-3</c:v>
                </c:pt>
                <c:pt idx="211">
                  <c:v>8.0000000000000002E-3</c:v>
                </c:pt>
                <c:pt idx="212">
                  <c:v>8.0000000000000002E-3</c:v>
                </c:pt>
                <c:pt idx="213">
                  <c:v>8</c:v>
                </c:pt>
                <c:pt idx="214">
                  <c:v>7.8737000000000004</c:v>
                </c:pt>
                <c:pt idx="215">
                  <c:v>7.1044600000000004</c:v>
                </c:pt>
                <c:pt idx="216">
                  <c:v>4.3307099999999998</c:v>
                </c:pt>
                <c:pt idx="217">
                  <c:v>1.9471000000000001</c:v>
                </c:pt>
                <c:pt idx="218">
                  <c:v>8.0000000000000002E-3</c:v>
                </c:pt>
                <c:pt idx="219">
                  <c:v>8.0000000000000002E-3</c:v>
                </c:pt>
                <c:pt idx="220">
                  <c:v>8.0000000000000002E-3</c:v>
                </c:pt>
                <c:pt idx="221">
                  <c:v>8.0000000000000002E-3</c:v>
                </c:pt>
                <c:pt idx="222">
                  <c:v>8.0000000000000002E-3</c:v>
                </c:pt>
              </c:numCache>
            </c:numRef>
          </c:xVal>
          <c:yVal>
            <c:numRef>
              <c:f>'PD analysis (von Frey)'!$K$104:$K$327</c:f>
              <c:numCache>
                <c:formatCode>General</c:formatCode>
                <c:ptCount val="224"/>
                <c:pt idx="0">
                  <c:v>8</c:v>
                </c:pt>
                <c:pt idx="1">
                  <c:v>8</c:v>
                </c:pt>
                <c:pt idx="2">
                  <c:v>8</c:v>
                </c:pt>
                <c:pt idx="3">
                  <c:v>8</c:v>
                </c:pt>
                <c:pt idx="4">
                  <c:v>8</c:v>
                </c:pt>
                <c:pt idx="5">
                  <c:v>10</c:v>
                </c:pt>
                <c:pt idx="6">
                  <c:v>8</c:v>
                </c:pt>
                <c:pt idx="7">
                  <c:v>8</c:v>
                </c:pt>
                <c:pt idx="8">
                  <c:v>8</c:v>
                </c:pt>
                <c:pt idx="9">
                  <c:v>8</c:v>
                </c:pt>
                <c:pt idx="10">
                  <c:v>8</c:v>
                </c:pt>
                <c:pt idx="11">
                  <c:v>10</c:v>
                </c:pt>
                <c:pt idx="12">
                  <c:v>8</c:v>
                </c:pt>
                <c:pt idx="13">
                  <c:v>8</c:v>
                </c:pt>
                <c:pt idx="14">
                  <c:v>8</c:v>
                </c:pt>
                <c:pt idx="15">
                  <c:v>8</c:v>
                </c:pt>
                <c:pt idx="16">
                  <c:v>10</c:v>
                </c:pt>
                <c:pt idx="17">
                  <c:v>8</c:v>
                </c:pt>
                <c:pt idx="18">
                  <c:v>10</c:v>
                </c:pt>
                <c:pt idx="19">
                  <c:v>8</c:v>
                </c:pt>
                <c:pt idx="20">
                  <c:v>8</c:v>
                </c:pt>
                <c:pt idx="21">
                  <c:v>8</c:v>
                </c:pt>
                <c:pt idx="22">
                  <c:v>10</c:v>
                </c:pt>
                <c:pt idx="23">
                  <c:v>6</c:v>
                </c:pt>
                <c:pt idx="24">
                  <c:v>10</c:v>
                </c:pt>
                <c:pt idx="25">
                  <c:v>8</c:v>
                </c:pt>
                <c:pt idx="26">
                  <c:v>8</c:v>
                </c:pt>
                <c:pt idx="27">
                  <c:v>8</c:v>
                </c:pt>
                <c:pt idx="28">
                  <c:v>8</c:v>
                </c:pt>
                <c:pt idx="29">
                  <c:v>8</c:v>
                </c:pt>
                <c:pt idx="30">
                  <c:v>8</c:v>
                </c:pt>
                <c:pt idx="31">
                  <c:v>8</c:v>
                </c:pt>
                <c:pt idx="32">
                  <c:v>8</c:v>
                </c:pt>
                <c:pt idx="33">
                  <c:v>8</c:v>
                </c:pt>
                <c:pt idx="34">
                  <c:v>8</c:v>
                </c:pt>
                <c:pt idx="35">
                  <c:v>8</c:v>
                </c:pt>
                <c:pt idx="36">
                  <c:v>10</c:v>
                </c:pt>
                <c:pt idx="37">
                  <c:v>6</c:v>
                </c:pt>
                <c:pt idx="38">
                  <c:v>6</c:v>
                </c:pt>
                <c:pt idx="39">
                  <c:v>8</c:v>
                </c:pt>
                <c:pt idx="40">
                  <c:v>6</c:v>
                </c:pt>
                <c:pt idx="41">
                  <c:v>8</c:v>
                </c:pt>
                <c:pt idx="42">
                  <c:v>10</c:v>
                </c:pt>
                <c:pt idx="43">
                  <c:v>8</c:v>
                </c:pt>
                <c:pt idx="44">
                  <c:v>10</c:v>
                </c:pt>
                <c:pt idx="45">
                  <c:v>8</c:v>
                </c:pt>
                <c:pt idx="46">
                  <c:v>6</c:v>
                </c:pt>
                <c:pt idx="47">
                  <c:v>8</c:v>
                </c:pt>
                <c:pt idx="48">
                  <c:v>8</c:v>
                </c:pt>
                <c:pt idx="49">
                  <c:v>10</c:v>
                </c:pt>
                <c:pt idx="50">
                  <c:v>6</c:v>
                </c:pt>
                <c:pt idx="51">
                  <c:v>8</c:v>
                </c:pt>
                <c:pt idx="52">
                  <c:v>8</c:v>
                </c:pt>
                <c:pt idx="53">
                  <c:v>6</c:v>
                </c:pt>
                <c:pt idx="54">
                  <c:v>8</c:v>
                </c:pt>
                <c:pt idx="55">
                  <c:v>10</c:v>
                </c:pt>
                <c:pt idx="56">
                  <c:v>10</c:v>
                </c:pt>
                <c:pt idx="57">
                  <c:v>8</c:v>
                </c:pt>
                <c:pt idx="58">
                  <c:v>8</c:v>
                </c:pt>
                <c:pt idx="59">
                  <c:v>8</c:v>
                </c:pt>
                <c:pt idx="60">
                  <c:v>6</c:v>
                </c:pt>
                <c:pt idx="61">
                  <c:v>8</c:v>
                </c:pt>
                <c:pt idx="62">
                  <c:v>6</c:v>
                </c:pt>
                <c:pt idx="63">
                  <c:v>6</c:v>
                </c:pt>
                <c:pt idx="64">
                  <c:v>8</c:v>
                </c:pt>
                <c:pt idx="65">
                  <c:v>8</c:v>
                </c:pt>
                <c:pt idx="66">
                  <c:v>8</c:v>
                </c:pt>
                <c:pt idx="67">
                  <c:v>6</c:v>
                </c:pt>
                <c:pt idx="68">
                  <c:v>6</c:v>
                </c:pt>
                <c:pt idx="69">
                  <c:v>6</c:v>
                </c:pt>
                <c:pt idx="70">
                  <c:v>6</c:v>
                </c:pt>
                <c:pt idx="71">
                  <c:v>6</c:v>
                </c:pt>
                <c:pt idx="72">
                  <c:v>8</c:v>
                </c:pt>
                <c:pt idx="73">
                  <c:v>6</c:v>
                </c:pt>
                <c:pt idx="74">
                  <c:v>6</c:v>
                </c:pt>
                <c:pt idx="75">
                  <c:v>8</c:v>
                </c:pt>
                <c:pt idx="76">
                  <c:v>6</c:v>
                </c:pt>
                <c:pt idx="77">
                  <c:v>8</c:v>
                </c:pt>
                <c:pt idx="78">
                  <c:v>8</c:v>
                </c:pt>
                <c:pt idx="79">
                  <c:v>8</c:v>
                </c:pt>
                <c:pt idx="80">
                  <c:v>6</c:v>
                </c:pt>
                <c:pt idx="81">
                  <c:v>6</c:v>
                </c:pt>
                <c:pt idx="82">
                  <c:v>6</c:v>
                </c:pt>
                <c:pt idx="83">
                  <c:v>8</c:v>
                </c:pt>
                <c:pt idx="84">
                  <c:v>6</c:v>
                </c:pt>
                <c:pt idx="85">
                  <c:v>10</c:v>
                </c:pt>
                <c:pt idx="86">
                  <c:v>6</c:v>
                </c:pt>
                <c:pt idx="87">
                  <c:v>10</c:v>
                </c:pt>
                <c:pt idx="88">
                  <c:v>8</c:v>
                </c:pt>
                <c:pt idx="89">
                  <c:v>8</c:v>
                </c:pt>
                <c:pt idx="90">
                  <c:v>6</c:v>
                </c:pt>
                <c:pt idx="91">
                  <c:v>6</c:v>
                </c:pt>
                <c:pt idx="92">
                  <c:v>4</c:v>
                </c:pt>
                <c:pt idx="93">
                  <c:v>2</c:v>
                </c:pt>
                <c:pt idx="94">
                  <c:v>2</c:v>
                </c:pt>
                <c:pt idx="95">
                  <c:v>0.16</c:v>
                </c:pt>
                <c:pt idx="96">
                  <c:v>7.0000000000000007E-2</c:v>
                </c:pt>
                <c:pt idx="97">
                  <c:v>7.0000000000000007E-2</c:v>
                </c:pt>
                <c:pt idx="98">
                  <c:v>8.0000000000000002E-3</c:v>
                </c:pt>
                <c:pt idx="99">
                  <c:v>10</c:v>
                </c:pt>
                <c:pt idx="100">
                  <c:v>8</c:v>
                </c:pt>
                <c:pt idx="101">
                  <c:v>6</c:v>
                </c:pt>
                <c:pt idx="102">
                  <c:v>6</c:v>
                </c:pt>
                <c:pt idx="103">
                  <c:v>2</c:v>
                </c:pt>
                <c:pt idx="104">
                  <c:v>0.02</c:v>
                </c:pt>
                <c:pt idx="105">
                  <c:v>0.02</c:v>
                </c:pt>
                <c:pt idx="106">
                  <c:v>0.02</c:v>
                </c:pt>
                <c:pt idx="107">
                  <c:v>0.02</c:v>
                </c:pt>
                <c:pt idx="108">
                  <c:v>7.0000000000000007E-2</c:v>
                </c:pt>
                <c:pt idx="109">
                  <c:v>8.0000000000000002E-3</c:v>
                </c:pt>
                <c:pt idx="110">
                  <c:v>8</c:v>
                </c:pt>
                <c:pt idx="111">
                  <c:v>8</c:v>
                </c:pt>
                <c:pt idx="112">
                  <c:v>8</c:v>
                </c:pt>
                <c:pt idx="113">
                  <c:v>8</c:v>
                </c:pt>
                <c:pt idx="114">
                  <c:v>4</c:v>
                </c:pt>
                <c:pt idx="115">
                  <c:v>2</c:v>
                </c:pt>
                <c:pt idx="116">
                  <c:v>1.4</c:v>
                </c:pt>
                <c:pt idx="117">
                  <c:v>0.16</c:v>
                </c:pt>
                <c:pt idx="118">
                  <c:v>0.02</c:v>
                </c:pt>
                <c:pt idx="119">
                  <c:v>7.0000000000000007E-2</c:v>
                </c:pt>
                <c:pt idx="120">
                  <c:v>8.0000000000000002E-3</c:v>
                </c:pt>
                <c:pt idx="121">
                  <c:v>10</c:v>
                </c:pt>
                <c:pt idx="122">
                  <c:v>10</c:v>
                </c:pt>
                <c:pt idx="123">
                  <c:v>6</c:v>
                </c:pt>
                <c:pt idx="124">
                  <c:v>8</c:v>
                </c:pt>
                <c:pt idx="125">
                  <c:v>4</c:v>
                </c:pt>
                <c:pt idx="126">
                  <c:v>4</c:v>
                </c:pt>
                <c:pt idx="127">
                  <c:v>2</c:v>
                </c:pt>
                <c:pt idx="128">
                  <c:v>2</c:v>
                </c:pt>
                <c:pt idx="129">
                  <c:v>0.4</c:v>
                </c:pt>
                <c:pt idx="130">
                  <c:v>0.16</c:v>
                </c:pt>
                <c:pt idx="131">
                  <c:v>0.16</c:v>
                </c:pt>
                <c:pt idx="132">
                  <c:v>0.16</c:v>
                </c:pt>
                <c:pt idx="133">
                  <c:v>8</c:v>
                </c:pt>
                <c:pt idx="134">
                  <c:v>4</c:v>
                </c:pt>
                <c:pt idx="135">
                  <c:v>8</c:v>
                </c:pt>
                <c:pt idx="136">
                  <c:v>6</c:v>
                </c:pt>
                <c:pt idx="137">
                  <c:v>4</c:v>
                </c:pt>
                <c:pt idx="138">
                  <c:v>2</c:v>
                </c:pt>
                <c:pt idx="139">
                  <c:v>1.4</c:v>
                </c:pt>
                <c:pt idx="140">
                  <c:v>1</c:v>
                </c:pt>
                <c:pt idx="141">
                  <c:v>0.4</c:v>
                </c:pt>
                <c:pt idx="142">
                  <c:v>0.4</c:v>
                </c:pt>
                <c:pt idx="143">
                  <c:v>0.4</c:v>
                </c:pt>
                <c:pt idx="144">
                  <c:v>0.16</c:v>
                </c:pt>
                <c:pt idx="145">
                  <c:v>6</c:v>
                </c:pt>
                <c:pt idx="146">
                  <c:v>10</c:v>
                </c:pt>
                <c:pt idx="147">
                  <c:v>8</c:v>
                </c:pt>
                <c:pt idx="148">
                  <c:v>8</c:v>
                </c:pt>
                <c:pt idx="149">
                  <c:v>2</c:v>
                </c:pt>
                <c:pt idx="150">
                  <c:v>2</c:v>
                </c:pt>
                <c:pt idx="151">
                  <c:v>1</c:v>
                </c:pt>
                <c:pt idx="152">
                  <c:v>1</c:v>
                </c:pt>
                <c:pt idx="153">
                  <c:v>0.16</c:v>
                </c:pt>
                <c:pt idx="154">
                  <c:v>0.4</c:v>
                </c:pt>
                <c:pt idx="155">
                  <c:v>0.4</c:v>
                </c:pt>
                <c:pt idx="156">
                  <c:v>0.16</c:v>
                </c:pt>
                <c:pt idx="157">
                  <c:v>8</c:v>
                </c:pt>
                <c:pt idx="158">
                  <c:v>8</c:v>
                </c:pt>
                <c:pt idx="159">
                  <c:v>6</c:v>
                </c:pt>
                <c:pt idx="160">
                  <c:v>4</c:v>
                </c:pt>
                <c:pt idx="161">
                  <c:v>2</c:v>
                </c:pt>
                <c:pt idx="162">
                  <c:v>2</c:v>
                </c:pt>
                <c:pt idx="163">
                  <c:v>1.4</c:v>
                </c:pt>
                <c:pt idx="164">
                  <c:v>1</c:v>
                </c:pt>
                <c:pt idx="165">
                  <c:v>0.02</c:v>
                </c:pt>
                <c:pt idx="166">
                  <c:v>0.02</c:v>
                </c:pt>
                <c:pt idx="167">
                  <c:v>8</c:v>
                </c:pt>
                <c:pt idx="168">
                  <c:v>8</c:v>
                </c:pt>
                <c:pt idx="169">
                  <c:v>4</c:v>
                </c:pt>
                <c:pt idx="170">
                  <c:v>4</c:v>
                </c:pt>
                <c:pt idx="171">
                  <c:v>2</c:v>
                </c:pt>
                <c:pt idx="172">
                  <c:v>1.4</c:v>
                </c:pt>
                <c:pt idx="173">
                  <c:v>0.16</c:v>
                </c:pt>
                <c:pt idx="174">
                  <c:v>0.16</c:v>
                </c:pt>
                <c:pt idx="175">
                  <c:v>0.02</c:v>
                </c:pt>
                <c:pt idx="176">
                  <c:v>0.02</c:v>
                </c:pt>
                <c:pt idx="177">
                  <c:v>6</c:v>
                </c:pt>
                <c:pt idx="178">
                  <c:v>8</c:v>
                </c:pt>
                <c:pt idx="179">
                  <c:v>6</c:v>
                </c:pt>
                <c:pt idx="180">
                  <c:v>6</c:v>
                </c:pt>
                <c:pt idx="181">
                  <c:v>1.4</c:v>
                </c:pt>
                <c:pt idx="182">
                  <c:v>2</c:v>
                </c:pt>
                <c:pt idx="183">
                  <c:v>1.4</c:v>
                </c:pt>
                <c:pt idx="184">
                  <c:v>1.4</c:v>
                </c:pt>
                <c:pt idx="185">
                  <c:v>8</c:v>
                </c:pt>
                <c:pt idx="186">
                  <c:v>8</c:v>
                </c:pt>
                <c:pt idx="187">
                  <c:v>6</c:v>
                </c:pt>
                <c:pt idx="188">
                  <c:v>6</c:v>
                </c:pt>
                <c:pt idx="189">
                  <c:v>4</c:v>
                </c:pt>
                <c:pt idx="190">
                  <c:v>1.4</c:v>
                </c:pt>
                <c:pt idx="191">
                  <c:v>1.4</c:v>
                </c:pt>
                <c:pt idx="192">
                  <c:v>1.4</c:v>
                </c:pt>
                <c:pt idx="193">
                  <c:v>10</c:v>
                </c:pt>
                <c:pt idx="194">
                  <c:v>6</c:v>
                </c:pt>
                <c:pt idx="195">
                  <c:v>10</c:v>
                </c:pt>
                <c:pt idx="196">
                  <c:v>10</c:v>
                </c:pt>
                <c:pt idx="197">
                  <c:v>1.4</c:v>
                </c:pt>
                <c:pt idx="198">
                  <c:v>1</c:v>
                </c:pt>
                <c:pt idx="199">
                  <c:v>2</c:v>
                </c:pt>
                <c:pt idx="200">
                  <c:v>0.4</c:v>
                </c:pt>
                <c:pt idx="201">
                  <c:v>0.4</c:v>
                </c:pt>
                <c:pt idx="202">
                  <c:v>0.16</c:v>
                </c:pt>
                <c:pt idx="203">
                  <c:v>8</c:v>
                </c:pt>
                <c:pt idx="204">
                  <c:v>6</c:v>
                </c:pt>
                <c:pt idx="205">
                  <c:v>6</c:v>
                </c:pt>
                <c:pt idx="206">
                  <c:v>6</c:v>
                </c:pt>
                <c:pt idx="207">
                  <c:v>4</c:v>
                </c:pt>
                <c:pt idx="208">
                  <c:v>1</c:v>
                </c:pt>
                <c:pt idx="209">
                  <c:v>1.4</c:v>
                </c:pt>
                <c:pt idx="210">
                  <c:v>0.4</c:v>
                </c:pt>
                <c:pt idx="211">
                  <c:v>0.16</c:v>
                </c:pt>
                <c:pt idx="212">
                  <c:v>7.0000000000000007E-2</c:v>
                </c:pt>
                <c:pt idx="213">
                  <c:v>8</c:v>
                </c:pt>
                <c:pt idx="214">
                  <c:v>10</c:v>
                </c:pt>
                <c:pt idx="215">
                  <c:v>4</c:v>
                </c:pt>
                <c:pt idx="216">
                  <c:v>6</c:v>
                </c:pt>
                <c:pt idx="217">
                  <c:v>1.4</c:v>
                </c:pt>
                <c:pt idx="218">
                  <c:v>1</c:v>
                </c:pt>
                <c:pt idx="219">
                  <c:v>1</c:v>
                </c:pt>
                <c:pt idx="220">
                  <c:v>0.4</c:v>
                </c:pt>
                <c:pt idx="221">
                  <c:v>0.4</c:v>
                </c:pt>
                <c:pt idx="222">
                  <c:v>0.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EDD-4483-A24A-00A5ABE79BAF}"/>
            </c:ext>
          </c:extLst>
        </c:ser>
        <c:ser>
          <c:idx val="1"/>
          <c:order val="1"/>
          <c:spPr>
            <a:ln w="19050">
              <a:noFill/>
            </a:ln>
          </c:spPr>
          <c:marker>
            <c:symbol val="none"/>
          </c:marker>
          <c:trendline>
            <c:spPr>
              <a:ln w="9525"/>
            </c:spPr>
            <c:trendlineType val="linear"/>
            <c:dispRSqr val="0"/>
            <c:dispEq val="0"/>
          </c:trendline>
          <c:xVal>
            <c:numRef>
              <c:f>'　PK  (Pt conc.)'!$AI$39:$AJ$39</c:f>
              <c:numCache>
                <c:formatCode>General</c:formatCode>
                <c:ptCount val="2"/>
                <c:pt idx="0">
                  <c:v>0.01</c:v>
                </c:pt>
                <c:pt idx="1">
                  <c:v>100</c:v>
                </c:pt>
              </c:numCache>
            </c:numRef>
          </c:xVal>
          <c:yVal>
            <c:numRef>
              <c:f>'　PK  (Pt conc.)'!$AI$40:$AJ$40</c:f>
              <c:numCache>
                <c:formatCode>General</c:formatCode>
                <c:ptCount val="2"/>
                <c:pt idx="0">
                  <c:v>0.01</c:v>
                </c:pt>
                <c:pt idx="1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EDD-4483-A24A-00A5ABE79B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41018048"/>
        <c:axId val="2041016416"/>
      </c:scatterChart>
      <c:valAx>
        <c:axId val="2041018048"/>
        <c:scaling>
          <c:orientation val="minMax"/>
          <c:max val="1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2041016416"/>
        <c:crosses val="autoZero"/>
        <c:crossBetween val="midCat"/>
      </c:valAx>
      <c:valAx>
        <c:axId val="2041016416"/>
        <c:scaling>
          <c:orientation val="minMax"/>
          <c:max val="1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2041018048"/>
        <c:crosses val="autoZero"/>
        <c:crossBetween val="midCat"/>
        <c:majorUnit val="5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913650793650794"/>
          <c:y val="5.0926041666666665E-2"/>
          <c:w val="0.79447377017786946"/>
          <c:h val="0.74203667249927097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5"/>
            <c:spPr>
              <a:noFill/>
              <a:ln w="15875">
                <a:solidFill>
                  <a:schemeClr val="tx1"/>
                </a:solidFill>
              </a:ln>
            </c:spPr>
          </c:marker>
          <c:xVal>
            <c:numRef>
              <c:f>'PD analysis (von Frey)'!$I$104:$I$327</c:f>
              <c:numCache>
                <c:formatCode>General</c:formatCode>
                <c:ptCount val="224"/>
                <c:pt idx="0">
                  <c:v>8</c:v>
                </c:pt>
                <c:pt idx="1">
                  <c:v>8</c:v>
                </c:pt>
                <c:pt idx="2">
                  <c:v>8</c:v>
                </c:pt>
                <c:pt idx="3">
                  <c:v>8</c:v>
                </c:pt>
                <c:pt idx="4">
                  <c:v>8</c:v>
                </c:pt>
                <c:pt idx="5">
                  <c:v>8</c:v>
                </c:pt>
                <c:pt idx="6">
                  <c:v>8</c:v>
                </c:pt>
                <c:pt idx="7">
                  <c:v>8</c:v>
                </c:pt>
                <c:pt idx="8">
                  <c:v>8</c:v>
                </c:pt>
                <c:pt idx="9">
                  <c:v>8</c:v>
                </c:pt>
                <c:pt idx="10">
                  <c:v>8</c:v>
                </c:pt>
                <c:pt idx="11">
                  <c:v>8</c:v>
                </c:pt>
                <c:pt idx="12">
                  <c:v>8</c:v>
                </c:pt>
                <c:pt idx="13">
                  <c:v>8</c:v>
                </c:pt>
                <c:pt idx="14">
                  <c:v>8</c:v>
                </c:pt>
                <c:pt idx="15">
                  <c:v>8</c:v>
                </c:pt>
                <c:pt idx="16">
                  <c:v>8</c:v>
                </c:pt>
                <c:pt idx="17">
                  <c:v>8</c:v>
                </c:pt>
                <c:pt idx="18">
                  <c:v>8</c:v>
                </c:pt>
                <c:pt idx="19">
                  <c:v>8</c:v>
                </c:pt>
                <c:pt idx="20">
                  <c:v>8</c:v>
                </c:pt>
                <c:pt idx="21">
                  <c:v>8</c:v>
                </c:pt>
                <c:pt idx="22">
                  <c:v>8</c:v>
                </c:pt>
                <c:pt idx="23">
                  <c:v>8</c:v>
                </c:pt>
                <c:pt idx="24">
                  <c:v>8</c:v>
                </c:pt>
                <c:pt idx="25">
                  <c:v>8</c:v>
                </c:pt>
                <c:pt idx="26">
                  <c:v>8</c:v>
                </c:pt>
                <c:pt idx="27">
                  <c:v>8</c:v>
                </c:pt>
                <c:pt idx="28">
                  <c:v>8</c:v>
                </c:pt>
                <c:pt idx="29">
                  <c:v>8</c:v>
                </c:pt>
                <c:pt idx="30">
                  <c:v>8</c:v>
                </c:pt>
                <c:pt idx="31">
                  <c:v>8</c:v>
                </c:pt>
                <c:pt idx="32">
                  <c:v>8</c:v>
                </c:pt>
                <c:pt idx="33">
                  <c:v>8</c:v>
                </c:pt>
                <c:pt idx="34">
                  <c:v>8</c:v>
                </c:pt>
                <c:pt idx="35">
                  <c:v>8</c:v>
                </c:pt>
                <c:pt idx="36">
                  <c:v>8</c:v>
                </c:pt>
                <c:pt idx="37">
                  <c:v>8</c:v>
                </c:pt>
                <c:pt idx="38">
                  <c:v>8</c:v>
                </c:pt>
                <c:pt idx="39">
                  <c:v>8</c:v>
                </c:pt>
                <c:pt idx="40">
                  <c:v>8</c:v>
                </c:pt>
                <c:pt idx="41">
                  <c:v>8</c:v>
                </c:pt>
                <c:pt idx="42">
                  <c:v>8</c:v>
                </c:pt>
                <c:pt idx="43">
                  <c:v>8</c:v>
                </c:pt>
                <c:pt idx="44">
                  <c:v>8</c:v>
                </c:pt>
                <c:pt idx="45">
                  <c:v>7.9725799999999998</c:v>
                </c:pt>
                <c:pt idx="46">
                  <c:v>7.8124900000000004</c:v>
                </c:pt>
                <c:pt idx="47">
                  <c:v>7.2594200000000004</c:v>
                </c:pt>
                <c:pt idx="48">
                  <c:v>6.8013399999999997</c:v>
                </c:pt>
                <c:pt idx="49">
                  <c:v>6.3047399999999998</c:v>
                </c:pt>
                <c:pt idx="50">
                  <c:v>5.5506799999999998</c:v>
                </c:pt>
                <c:pt idx="51">
                  <c:v>5.1519399999999997</c:v>
                </c:pt>
                <c:pt idx="52">
                  <c:v>4.8203800000000001</c:v>
                </c:pt>
                <c:pt idx="53">
                  <c:v>4.4059699999999999</c:v>
                </c:pt>
                <c:pt idx="54">
                  <c:v>4.23977</c:v>
                </c:pt>
                <c:pt idx="55">
                  <c:v>8</c:v>
                </c:pt>
                <c:pt idx="56">
                  <c:v>7.9725799999999998</c:v>
                </c:pt>
                <c:pt idx="57">
                  <c:v>7.8124900000000004</c:v>
                </c:pt>
                <c:pt idx="58">
                  <c:v>7.2594200000000004</c:v>
                </c:pt>
                <c:pt idx="59">
                  <c:v>6.8013399999999997</c:v>
                </c:pt>
                <c:pt idx="60">
                  <c:v>6.3047399999999998</c:v>
                </c:pt>
                <c:pt idx="61">
                  <c:v>5.5506799999999998</c:v>
                </c:pt>
                <c:pt idx="62">
                  <c:v>5.1519399999999997</c:v>
                </c:pt>
                <c:pt idx="63">
                  <c:v>4.8203800000000001</c:v>
                </c:pt>
                <c:pt idx="64">
                  <c:v>4.4059699999999999</c:v>
                </c:pt>
                <c:pt idx="65">
                  <c:v>4.23977</c:v>
                </c:pt>
                <c:pt idx="66">
                  <c:v>8</c:v>
                </c:pt>
                <c:pt idx="67">
                  <c:v>7.9725799999999998</c:v>
                </c:pt>
                <c:pt idx="68">
                  <c:v>7.8124900000000004</c:v>
                </c:pt>
                <c:pt idx="69">
                  <c:v>7.2594200000000004</c:v>
                </c:pt>
                <c:pt idx="70">
                  <c:v>6.8013399999999997</c:v>
                </c:pt>
                <c:pt idx="71">
                  <c:v>6.3047399999999998</c:v>
                </c:pt>
                <c:pt idx="72">
                  <c:v>5.5506799999999998</c:v>
                </c:pt>
                <c:pt idx="73">
                  <c:v>5.1519399999999997</c:v>
                </c:pt>
                <c:pt idx="74">
                  <c:v>4.8203800000000001</c:v>
                </c:pt>
                <c:pt idx="75">
                  <c:v>4.4059699999999999</c:v>
                </c:pt>
                <c:pt idx="76">
                  <c:v>4.23977</c:v>
                </c:pt>
                <c:pt idx="77">
                  <c:v>8</c:v>
                </c:pt>
                <c:pt idx="78">
                  <c:v>7.9725799999999998</c:v>
                </c:pt>
                <c:pt idx="79">
                  <c:v>7.8124900000000004</c:v>
                </c:pt>
                <c:pt idx="80">
                  <c:v>7.2594200000000004</c:v>
                </c:pt>
                <c:pt idx="81">
                  <c:v>6.8013399999999997</c:v>
                </c:pt>
                <c:pt idx="82">
                  <c:v>6.3047399999999998</c:v>
                </c:pt>
                <c:pt idx="83">
                  <c:v>5.5506799999999998</c:v>
                </c:pt>
                <c:pt idx="84">
                  <c:v>5.1519399999999997</c:v>
                </c:pt>
                <c:pt idx="85">
                  <c:v>4.8203800000000001</c:v>
                </c:pt>
                <c:pt idx="86">
                  <c:v>4.4059699999999999</c:v>
                </c:pt>
                <c:pt idx="87">
                  <c:v>4.23977</c:v>
                </c:pt>
                <c:pt idx="88">
                  <c:v>8</c:v>
                </c:pt>
                <c:pt idx="89">
                  <c:v>7.9118599999999999</c:v>
                </c:pt>
                <c:pt idx="90">
                  <c:v>7.3923300000000003</c:v>
                </c:pt>
                <c:pt idx="91">
                  <c:v>5.5890300000000002</c:v>
                </c:pt>
                <c:pt idx="92">
                  <c:v>4.09293</c:v>
                </c:pt>
                <c:pt idx="93">
                  <c:v>2.4711500000000002</c:v>
                </c:pt>
                <c:pt idx="94">
                  <c:v>8.0000000000000002E-3</c:v>
                </c:pt>
                <c:pt idx="95">
                  <c:v>8.0000000000000002E-3</c:v>
                </c:pt>
                <c:pt idx="96">
                  <c:v>8.0000000000000002E-3</c:v>
                </c:pt>
                <c:pt idx="97">
                  <c:v>8.0000000000000002E-3</c:v>
                </c:pt>
                <c:pt idx="98">
                  <c:v>8.0000000000000002E-3</c:v>
                </c:pt>
                <c:pt idx="99">
                  <c:v>8</c:v>
                </c:pt>
                <c:pt idx="100">
                  <c:v>7.9118599999999999</c:v>
                </c:pt>
                <c:pt idx="101">
                  <c:v>7.3923300000000003</c:v>
                </c:pt>
                <c:pt idx="102">
                  <c:v>5.5890300000000002</c:v>
                </c:pt>
                <c:pt idx="103">
                  <c:v>4.09293</c:v>
                </c:pt>
                <c:pt idx="104">
                  <c:v>2.4711500000000002</c:v>
                </c:pt>
                <c:pt idx="105">
                  <c:v>8.0000000000000002E-3</c:v>
                </c:pt>
                <c:pt idx="106">
                  <c:v>8.0000000000000002E-3</c:v>
                </c:pt>
                <c:pt idx="107">
                  <c:v>8.0000000000000002E-3</c:v>
                </c:pt>
                <c:pt idx="108">
                  <c:v>8.0000000000000002E-3</c:v>
                </c:pt>
                <c:pt idx="109">
                  <c:v>8.0000000000000002E-3</c:v>
                </c:pt>
                <c:pt idx="110">
                  <c:v>8</c:v>
                </c:pt>
                <c:pt idx="111">
                  <c:v>7.9118599999999999</c:v>
                </c:pt>
                <c:pt idx="112">
                  <c:v>7.3923300000000003</c:v>
                </c:pt>
                <c:pt idx="113">
                  <c:v>5.5890300000000002</c:v>
                </c:pt>
                <c:pt idx="114">
                  <c:v>4.09293</c:v>
                </c:pt>
                <c:pt idx="115">
                  <c:v>2.4711500000000002</c:v>
                </c:pt>
                <c:pt idx="116">
                  <c:v>8.0000000000000002E-3</c:v>
                </c:pt>
                <c:pt idx="117">
                  <c:v>8.0000000000000002E-3</c:v>
                </c:pt>
                <c:pt idx="118">
                  <c:v>8.0000000000000002E-3</c:v>
                </c:pt>
                <c:pt idx="119">
                  <c:v>8.0000000000000002E-3</c:v>
                </c:pt>
                <c:pt idx="120">
                  <c:v>8.0000000000000002E-3</c:v>
                </c:pt>
                <c:pt idx="121">
                  <c:v>8</c:v>
                </c:pt>
                <c:pt idx="122">
                  <c:v>7.9118599999999999</c:v>
                </c:pt>
                <c:pt idx="123">
                  <c:v>7.3923300000000003</c:v>
                </c:pt>
                <c:pt idx="124">
                  <c:v>5.5890300000000002</c:v>
                </c:pt>
                <c:pt idx="125">
                  <c:v>4.09293</c:v>
                </c:pt>
                <c:pt idx="126">
                  <c:v>2.4711500000000002</c:v>
                </c:pt>
                <c:pt idx="127">
                  <c:v>8.0000000000000002E-3</c:v>
                </c:pt>
                <c:pt idx="128">
                  <c:v>8.0000000000000002E-3</c:v>
                </c:pt>
                <c:pt idx="129">
                  <c:v>8.0000000000000002E-3</c:v>
                </c:pt>
                <c:pt idx="130">
                  <c:v>8.0000000000000002E-3</c:v>
                </c:pt>
                <c:pt idx="131">
                  <c:v>8.0000000000000002E-3</c:v>
                </c:pt>
                <c:pt idx="132">
                  <c:v>8.0000000000000002E-3</c:v>
                </c:pt>
                <c:pt idx="133">
                  <c:v>8</c:v>
                </c:pt>
                <c:pt idx="134">
                  <c:v>7.9118599999999999</c:v>
                </c:pt>
                <c:pt idx="135">
                  <c:v>7.3923300000000003</c:v>
                </c:pt>
                <c:pt idx="136">
                  <c:v>5.5890300000000002</c:v>
                </c:pt>
                <c:pt idx="137">
                  <c:v>4.09293</c:v>
                </c:pt>
                <c:pt idx="138">
                  <c:v>2.4711500000000002</c:v>
                </c:pt>
                <c:pt idx="139">
                  <c:v>8.0000000000000002E-3</c:v>
                </c:pt>
                <c:pt idx="140">
                  <c:v>8.0000000000000002E-3</c:v>
                </c:pt>
                <c:pt idx="141">
                  <c:v>8.0000000000000002E-3</c:v>
                </c:pt>
                <c:pt idx="142">
                  <c:v>8.0000000000000002E-3</c:v>
                </c:pt>
                <c:pt idx="143">
                  <c:v>8.0000000000000002E-3</c:v>
                </c:pt>
                <c:pt idx="144">
                  <c:v>8.0000000000000002E-3</c:v>
                </c:pt>
                <c:pt idx="145">
                  <c:v>8</c:v>
                </c:pt>
                <c:pt idx="146">
                  <c:v>7.9118599999999999</c:v>
                </c:pt>
                <c:pt idx="147">
                  <c:v>7.3923300000000003</c:v>
                </c:pt>
                <c:pt idx="148">
                  <c:v>5.5890300000000002</c:v>
                </c:pt>
                <c:pt idx="149">
                  <c:v>4.09293</c:v>
                </c:pt>
                <c:pt idx="150">
                  <c:v>2.4711500000000002</c:v>
                </c:pt>
                <c:pt idx="151">
                  <c:v>8.0000000000000002E-3</c:v>
                </c:pt>
                <c:pt idx="152">
                  <c:v>8.0000000000000002E-3</c:v>
                </c:pt>
                <c:pt idx="153">
                  <c:v>8.0000000000000002E-3</c:v>
                </c:pt>
                <c:pt idx="154">
                  <c:v>8.0000000000000002E-3</c:v>
                </c:pt>
                <c:pt idx="155">
                  <c:v>8.0000000000000002E-3</c:v>
                </c:pt>
                <c:pt idx="156">
                  <c:v>8.0000000000000002E-3</c:v>
                </c:pt>
                <c:pt idx="157">
                  <c:v>8</c:v>
                </c:pt>
                <c:pt idx="158">
                  <c:v>7.8443199999999997</c:v>
                </c:pt>
                <c:pt idx="159">
                  <c:v>6.9122899999999996</c:v>
                </c:pt>
                <c:pt idx="160">
                  <c:v>3.6518600000000001</c:v>
                </c:pt>
                <c:pt idx="161">
                  <c:v>0.93939399999999995</c:v>
                </c:pt>
                <c:pt idx="162">
                  <c:v>8.0000000000000002E-3</c:v>
                </c:pt>
                <c:pt idx="163">
                  <c:v>8.0000000000000002E-3</c:v>
                </c:pt>
                <c:pt idx="164">
                  <c:v>8.0000000000000002E-3</c:v>
                </c:pt>
                <c:pt idx="165">
                  <c:v>8.0000000000000002E-3</c:v>
                </c:pt>
                <c:pt idx="166">
                  <c:v>8.0000000000000002E-3</c:v>
                </c:pt>
                <c:pt idx="167">
                  <c:v>8</c:v>
                </c:pt>
                <c:pt idx="168">
                  <c:v>7.8443199999999997</c:v>
                </c:pt>
                <c:pt idx="169">
                  <c:v>6.9122899999999996</c:v>
                </c:pt>
                <c:pt idx="170">
                  <c:v>3.6518600000000001</c:v>
                </c:pt>
                <c:pt idx="171">
                  <c:v>0.93939399999999995</c:v>
                </c:pt>
                <c:pt idx="172">
                  <c:v>8.0000000000000002E-3</c:v>
                </c:pt>
                <c:pt idx="173">
                  <c:v>8.0000000000000002E-3</c:v>
                </c:pt>
                <c:pt idx="174">
                  <c:v>8.0000000000000002E-3</c:v>
                </c:pt>
                <c:pt idx="175">
                  <c:v>8.0000000000000002E-3</c:v>
                </c:pt>
                <c:pt idx="176">
                  <c:v>8.0000000000000002E-3</c:v>
                </c:pt>
                <c:pt idx="177">
                  <c:v>8</c:v>
                </c:pt>
                <c:pt idx="178">
                  <c:v>7.8443199999999997</c:v>
                </c:pt>
                <c:pt idx="179">
                  <c:v>6.9122899999999996</c:v>
                </c:pt>
                <c:pt idx="180">
                  <c:v>3.6518600000000001</c:v>
                </c:pt>
                <c:pt idx="181">
                  <c:v>0.93939399999999995</c:v>
                </c:pt>
                <c:pt idx="182">
                  <c:v>8.0000000000000002E-3</c:v>
                </c:pt>
                <c:pt idx="183">
                  <c:v>8.0000000000000002E-3</c:v>
                </c:pt>
                <c:pt idx="184">
                  <c:v>8.0000000000000002E-3</c:v>
                </c:pt>
                <c:pt idx="185">
                  <c:v>8</c:v>
                </c:pt>
                <c:pt idx="186">
                  <c:v>7.8443199999999997</c:v>
                </c:pt>
                <c:pt idx="187">
                  <c:v>6.9122899999999996</c:v>
                </c:pt>
                <c:pt idx="188">
                  <c:v>3.6518600000000001</c:v>
                </c:pt>
                <c:pt idx="189">
                  <c:v>0.93939399999999995</c:v>
                </c:pt>
                <c:pt idx="190">
                  <c:v>8.0000000000000002E-3</c:v>
                </c:pt>
                <c:pt idx="191">
                  <c:v>8.0000000000000002E-3</c:v>
                </c:pt>
                <c:pt idx="192">
                  <c:v>8.0000000000000002E-3</c:v>
                </c:pt>
                <c:pt idx="193">
                  <c:v>8</c:v>
                </c:pt>
                <c:pt idx="194">
                  <c:v>7.8443199999999997</c:v>
                </c:pt>
                <c:pt idx="195">
                  <c:v>6.9122899999999996</c:v>
                </c:pt>
                <c:pt idx="196">
                  <c:v>3.6518600000000001</c:v>
                </c:pt>
                <c:pt idx="197">
                  <c:v>0.93939399999999995</c:v>
                </c:pt>
                <c:pt idx="198">
                  <c:v>8.0000000000000002E-3</c:v>
                </c:pt>
                <c:pt idx="199">
                  <c:v>8.0000000000000002E-3</c:v>
                </c:pt>
                <c:pt idx="200">
                  <c:v>8.0000000000000002E-3</c:v>
                </c:pt>
                <c:pt idx="201">
                  <c:v>8.0000000000000002E-3</c:v>
                </c:pt>
                <c:pt idx="202">
                  <c:v>8.0000000000000002E-3</c:v>
                </c:pt>
                <c:pt idx="203">
                  <c:v>8</c:v>
                </c:pt>
                <c:pt idx="204">
                  <c:v>7.8443199999999997</c:v>
                </c:pt>
                <c:pt idx="205">
                  <c:v>6.9122899999999996</c:v>
                </c:pt>
                <c:pt idx="206">
                  <c:v>3.6518600000000001</c:v>
                </c:pt>
                <c:pt idx="207">
                  <c:v>0.93939399999999995</c:v>
                </c:pt>
                <c:pt idx="208">
                  <c:v>8.0000000000000002E-3</c:v>
                </c:pt>
                <c:pt idx="209">
                  <c:v>8.0000000000000002E-3</c:v>
                </c:pt>
                <c:pt idx="210">
                  <c:v>8.0000000000000002E-3</c:v>
                </c:pt>
                <c:pt idx="211">
                  <c:v>8.0000000000000002E-3</c:v>
                </c:pt>
                <c:pt idx="212">
                  <c:v>8.0000000000000002E-3</c:v>
                </c:pt>
                <c:pt idx="213">
                  <c:v>8</c:v>
                </c:pt>
                <c:pt idx="214">
                  <c:v>7.8443199999999997</c:v>
                </c:pt>
                <c:pt idx="215">
                  <c:v>6.9122899999999996</c:v>
                </c:pt>
                <c:pt idx="216">
                  <c:v>3.6518600000000001</c:v>
                </c:pt>
                <c:pt idx="217">
                  <c:v>0.93939399999999995</c:v>
                </c:pt>
                <c:pt idx="218">
                  <c:v>8.0000000000000002E-3</c:v>
                </c:pt>
                <c:pt idx="219">
                  <c:v>8.0000000000000002E-3</c:v>
                </c:pt>
                <c:pt idx="220">
                  <c:v>8.0000000000000002E-3</c:v>
                </c:pt>
                <c:pt idx="221">
                  <c:v>8.0000000000000002E-3</c:v>
                </c:pt>
                <c:pt idx="222">
                  <c:v>8.0000000000000002E-3</c:v>
                </c:pt>
              </c:numCache>
            </c:numRef>
          </c:xVal>
          <c:yVal>
            <c:numRef>
              <c:f>'PD analysis (von Frey)'!$Q$104:$Q$327</c:f>
              <c:numCache>
                <c:formatCode>General</c:formatCode>
                <c:ptCount val="2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4841599999999999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1.4841599999999999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1.4841599999999999</c:v>
                </c:pt>
                <c:pt idx="17">
                  <c:v>0</c:v>
                </c:pt>
                <c:pt idx="18">
                  <c:v>1.4841599999999999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1.4841599999999999</c:v>
                </c:pt>
                <c:pt idx="23">
                  <c:v>-1.4841599999999999</c:v>
                </c:pt>
                <c:pt idx="24">
                  <c:v>1.4841599999999999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1.4841599999999999</c:v>
                </c:pt>
                <c:pt idx="37">
                  <c:v>-1.4841599999999999</c:v>
                </c:pt>
                <c:pt idx="38">
                  <c:v>-1.4841599999999999</c:v>
                </c:pt>
                <c:pt idx="39">
                  <c:v>0</c:v>
                </c:pt>
                <c:pt idx="40">
                  <c:v>-1.4841599999999999</c:v>
                </c:pt>
                <c:pt idx="41">
                  <c:v>0</c:v>
                </c:pt>
                <c:pt idx="42">
                  <c:v>1.4841599999999999</c:v>
                </c:pt>
                <c:pt idx="43">
                  <c:v>0</c:v>
                </c:pt>
                <c:pt idx="44">
                  <c:v>1.4841599999999999</c:v>
                </c:pt>
                <c:pt idx="45">
                  <c:v>1.02042E-2</c:v>
                </c:pt>
                <c:pt idx="46">
                  <c:v>-1.4074500000000001</c:v>
                </c:pt>
                <c:pt idx="47">
                  <c:v>0.31163800000000003</c:v>
                </c:pt>
                <c:pt idx="48">
                  <c:v>0.418327</c:v>
                </c:pt>
                <c:pt idx="49">
                  <c:v>1.6486799999999999</c:v>
                </c:pt>
                <c:pt idx="50">
                  <c:v>-1.28532</c:v>
                </c:pt>
                <c:pt idx="51">
                  <c:v>0.46520499999999998</c:v>
                </c:pt>
                <c:pt idx="52">
                  <c:v>0.34680699999999998</c:v>
                </c:pt>
                <c:pt idx="53">
                  <c:v>-0.97441299999999997</c:v>
                </c:pt>
                <c:pt idx="54">
                  <c:v>0.60734900000000003</c:v>
                </c:pt>
                <c:pt idx="55">
                  <c:v>1.4841599999999999</c:v>
                </c:pt>
                <c:pt idx="56">
                  <c:v>1.4989399999999999</c:v>
                </c:pt>
                <c:pt idx="57">
                  <c:v>9.5385899999999996E-2</c:v>
                </c:pt>
                <c:pt idx="58">
                  <c:v>0.310477</c:v>
                </c:pt>
                <c:pt idx="59">
                  <c:v>0.32806200000000002</c:v>
                </c:pt>
                <c:pt idx="60">
                  <c:v>-0.84145800000000004</c:v>
                </c:pt>
                <c:pt idx="61">
                  <c:v>0.89260700000000004</c:v>
                </c:pt>
                <c:pt idx="62">
                  <c:v>-0.57085300000000005</c:v>
                </c:pt>
                <c:pt idx="63">
                  <c:v>-0.27167599999999997</c:v>
                </c:pt>
                <c:pt idx="64">
                  <c:v>1.19615</c:v>
                </c:pt>
                <c:pt idx="65">
                  <c:v>0.91156800000000004</c:v>
                </c:pt>
                <c:pt idx="66">
                  <c:v>0</c:v>
                </c:pt>
                <c:pt idx="67">
                  <c:v>-1.4573499999999999</c:v>
                </c:pt>
                <c:pt idx="68">
                  <c:v>-1.1671499999999999</c:v>
                </c:pt>
                <c:pt idx="69">
                  <c:v>-3.08492E-2</c:v>
                </c:pt>
                <c:pt idx="70">
                  <c:v>0.45069500000000001</c:v>
                </c:pt>
                <c:pt idx="71">
                  <c:v>0.63209899999999997</c:v>
                </c:pt>
                <c:pt idx="72">
                  <c:v>1.9036599999999999</c:v>
                </c:pt>
                <c:pt idx="73">
                  <c:v>4.35872E-2</c:v>
                </c:pt>
                <c:pt idx="74">
                  <c:v>0.126004</c:v>
                </c:pt>
                <c:pt idx="75">
                  <c:v>1.47302</c:v>
                </c:pt>
                <c:pt idx="76">
                  <c:v>-0.192888</c:v>
                </c:pt>
                <c:pt idx="77">
                  <c:v>0</c:v>
                </c:pt>
                <c:pt idx="78">
                  <c:v>1.2139E-2</c:v>
                </c:pt>
                <c:pt idx="79">
                  <c:v>8.0199900000000005E-2</c:v>
                </c:pt>
                <c:pt idx="80">
                  <c:v>-1.1000000000000001</c:v>
                </c:pt>
                <c:pt idx="81">
                  <c:v>-0.66581800000000002</c:v>
                </c:pt>
                <c:pt idx="82">
                  <c:v>-0.20236499999999999</c:v>
                </c:pt>
                <c:pt idx="83">
                  <c:v>1.4517199999999999</c:v>
                </c:pt>
                <c:pt idx="84">
                  <c:v>-0.14580399999999999</c:v>
                </c:pt>
                <c:pt idx="85">
                  <c:v>2.5304600000000002</c:v>
                </c:pt>
                <c:pt idx="86">
                  <c:v>-0.64390999999999998</c:v>
                </c:pt>
                <c:pt idx="87">
                  <c:v>2.16506</c:v>
                </c:pt>
                <c:pt idx="88">
                  <c:v>0</c:v>
                </c:pt>
                <c:pt idx="89">
                  <c:v>6.4873200000000006E-2</c:v>
                </c:pt>
                <c:pt idx="90">
                  <c:v>-0.82840199999999997</c:v>
                </c:pt>
                <c:pt idx="91">
                  <c:v>0.68132700000000002</c:v>
                </c:pt>
                <c:pt idx="92">
                  <c:v>-7.7072299999999996E-2</c:v>
                </c:pt>
                <c:pt idx="93">
                  <c:v>-0.22031000000000001</c:v>
                </c:pt>
                <c:pt idx="94">
                  <c:v>1.4782200000000001</c:v>
                </c:pt>
                <c:pt idx="95">
                  <c:v>0.11279599999999999</c:v>
                </c:pt>
                <c:pt idx="96">
                  <c:v>4.6008899999999998E-2</c:v>
                </c:pt>
                <c:pt idx="97">
                  <c:v>4.6008899999999998E-2</c:v>
                </c:pt>
                <c:pt idx="98">
                  <c:v>0</c:v>
                </c:pt>
                <c:pt idx="99">
                  <c:v>1.4841599999999999</c:v>
                </c:pt>
                <c:pt idx="100">
                  <c:v>6.5715599999999999E-2</c:v>
                </c:pt>
                <c:pt idx="101">
                  <c:v>-0.79118299999999997</c:v>
                </c:pt>
                <c:pt idx="102">
                  <c:v>0.72297100000000003</c:v>
                </c:pt>
                <c:pt idx="103">
                  <c:v>-0.92914099999999999</c:v>
                </c:pt>
                <c:pt idx="104">
                  <c:v>-0.26303199999999999</c:v>
                </c:pt>
                <c:pt idx="105">
                  <c:v>8.90495E-3</c:v>
                </c:pt>
                <c:pt idx="106">
                  <c:v>8.90495E-3</c:v>
                </c:pt>
                <c:pt idx="107">
                  <c:v>8.90495E-3</c:v>
                </c:pt>
                <c:pt idx="108">
                  <c:v>4.6008899999999998E-2</c:v>
                </c:pt>
                <c:pt idx="109">
                  <c:v>0</c:v>
                </c:pt>
                <c:pt idx="110">
                  <c:v>0</c:v>
                </c:pt>
                <c:pt idx="111">
                  <c:v>6.31462E-2</c:v>
                </c:pt>
                <c:pt idx="112">
                  <c:v>0.37578899999999998</c:v>
                </c:pt>
                <c:pt idx="113">
                  <c:v>0.60231699999999999</c:v>
                </c:pt>
                <c:pt idx="114">
                  <c:v>-1.3940600000000001</c:v>
                </c:pt>
                <c:pt idx="115">
                  <c:v>-0.78644700000000001</c:v>
                </c:pt>
                <c:pt idx="116">
                  <c:v>0.69009299999999996</c:v>
                </c:pt>
                <c:pt idx="117">
                  <c:v>0.11279599999999999</c:v>
                </c:pt>
                <c:pt idx="118">
                  <c:v>8.90495E-3</c:v>
                </c:pt>
                <c:pt idx="119">
                  <c:v>4.6008899999999998E-2</c:v>
                </c:pt>
                <c:pt idx="120">
                  <c:v>0</c:v>
                </c:pt>
                <c:pt idx="121">
                  <c:v>1.4841599999999999</c:v>
                </c:pt>
                <c:pt idx="122">
                  <c:v>1.54175</c:v>
                </c:pt>
                <c:pt idx="123">
                  <c:v>-0.93423100000000003</c:v>
                </c:pt>
                <c:pt idx="124">
                  <c:v>1.1736200000000001</c:v>
                </c:pt>
                <c:pt idx="125">
                  <c:v>-1.2011499999999999</c:v>
                </c:pt>
                <c:pt idx="126">
                  <c:v>0.21346200000000001</c:v>
                </c:pt>
                <c:pt idx="127">
                  <c:v>7.4930200000000002E-2</c:v>
                </c:pt>
                <c:pt idx="128">
                  <c:v>0.55753299999999995</c:v>
                </c:pt>
                <c:pt idx="129">
                  <c:v>-0.20383200000000001</c:v>
                </c:pt>
                <c:pt idx="130">
                  <c:v>0.11279599999999999</c:v>
                </c:pt>
                <c:pt idx="131">
                  <c:v>0.11279599999999999</c:v>
                </c:pt>
                <c:pt idx="132">
                  <c:v>0.11279599999999999</c:v>
                </c:pt>
                <c:pt idx="133">
                  <c:v>0</c:v>
                </c:pt>
                <c:pt idx="134">
                  <c:v>-2.8866499999999999</c:v>
                </c:pt>
                <c:pt idx="135">
                  <c:v>0.54532499999999995</c:v>
                </c:pt>
                <c:pt idx="136">
                  <c:v>0.131521</c:v>
                </c:pt>
                <c:pt idx="137">
                  <c:v>-0.26178600000000002</c:v>
                </c:pt>
                <c:pt idx="138">
                  <c:v>-0.28127200000000002</c:v>
                </c:pt>
                <c:pt idx="139">
                  <c:v>1.0329699999999999</c:v>
                </c:pt>
                <c:pt idx="140">
                  <c:v>0.73614299999999999</c:v>
                </c:pt>
                <c:pt idx="141">
                  <c:v>0.29089500000000001</c:v>
                </c:pt>
                <c:pt idx="142">
                  <c:v>0.29089500000000001</c:v>
                </c:pt>
                <c:pt idx="143">
                  <c:v>0.29089500000000001</c:v>
                </c:pt>
                <c:pt idx="144">
                  <c:v>0.11279599999999999</c:v>
                </c:pt>
                <c:pt idx="145">
                  <c:v>-1.4841599999999999</c:v>
                </c:pt>
                <c:pt idx="146">
                  <c:v>1.5458700000000001</c:v>
                </c:pt>
                <c:pt idx="147">
                  <c:v>0.335671</c:v>
                </c:pt>
                <c:pt idx="148">
                  <c:v>0.55842099999999995</c:v>
                </c:pt>
                <c:pt idx="149">
                  <c:v>-2.25543</c:v>
                </c:pt>
                <c:pt idx="150">
                  <c:v>0.111981</c:v>
                </c:pt>
                <c:pt idx="151">
                  <c:v>0.73614299999999999</c:v>
                </c:pt>
                <c:pt idx="152">
                  <c:v>0.73614299999999999</c:v>
                </c:pt>
                <c:pt idx="153">
                  <c:v>0.11279599999999999</c:v>
                </c:pt>
                <c:pt idx="154">
                  <c:v>0.29089500000000001</c:v>
                </c:pt>
                <c:pt idx="155">
                  <c:v>0.29089500000000001</c:v>
                </c:pt>
                <c:pt idx="156">
                  <c:v>0.11279599999999999</c:v>
                </c:pt>
                <c:pt idx="157">
                  <c:v>0</c:v>
                </c:pt>
                <c:pt idx="158">
                  <c:v>0.115438</c:v>
                </c:pt>
                <c:pt idx="159">
                  <c:v>-0.49421300000000001</c:v>
                </c:pt>
                <c:pt idx="160">
                  <c:v>0.519814</c:v>
                </c:pt>
                <c:pt idx="161">
                  <c:v>0.38037900000000002</c:v>
                </c:pt>
                <c:pt idx="162">
                  <c:v>1.4782200000000001</c:v>
                </c:pt>
                <c:pt idx="163">
                  <c:v>1.0329699999999999</c:v>
                </c:pt>
                <c:pt idx="164">
                  <c:v>0.73614299999999999</c:v>
                </c:pt>
                <c:pt idx="165">
                  <c:v>8.90495E-3</c:v>
                </c:pt>
                <c:pt idx="166">
                  <c:v>8.90495E-3</c:v>
                </c:pt>
                <c:pt idx="167">
                  <c:v>0</c:v>
                </c:pt>
                <c:pt idx="168">
                  <c:v>0.13789499999999999</c:v>
                </c:pt>
                <c:pt idx="169">
                  <c:v>-1.1516</c:v>
                </c:pt>
                <c:pt idx="170">
                  <c:v>1.7863</c:v>
                </c:pt>
                <c:pt idx="171">
                  <c:v>0.58505499999999999</c:v>
                </c:pt>
                <c:pt idx="172">
                  <c:v>1.0329699999999999</c:v>
                </c:pt>
                <c:pt idx="173">
                  <c:v>0.11279599999999999</c:v>
                </c:pt>
                <c:pt idx="174">
                  <c:v>0.11279599999999999</c:v>
                </c:pt>
                <c:pt idx="175">
                  <c:v>8.90495E-3</c:v>
                </c:pt>
                <c:pt idx="176">
                  <c:v>8.90495E-3</c:v>
                </c:pt>
                <c:pt idx="177">
                  <c:v>-1.4841599999999999</c:v>
                </c:pt>
                <c:pt idx="178">
                  <c:v>0.12834999999999999</c:v>
                </c:pt>
                <c:pt idx="179">
                  <c:v>-0.43011700000000003</c:v>
                </c:pt>
                <c:pt idx="180">
                  <c:v>1.1322300000000001</c:v>
                </c:pt>
                <c:pt idx="181">
                  <c:v>-0.95130300000000001</c:v>
                </c:pt>
                <c:pt idx="182">
                  <c:v>1.1430800000000001</c:v>
                </c:pt>
                <c:pt idx="183">
                  <c:v>1.0329699999999999</c:v>
                </c:pt>
                <c:pt idx="184">
                  <c:v>1.0329699999999999</c:v>
                </c:pt>
                <c:pt idx="185">
                  <c:v>0</c:v>
                </c:pt>
                <c:pt idx="186">
                  <c:v>0.10377599999999999</c:v>
                </c:pt>
                <c:pt idx="187">
                  <c:v>-0.62758800000000003</c:v>
                </c:pt>
                <c:pt idx="188">
                  <c:v>1.03383</c:v>
                </c:pt>
                <c:pt idx="189">
                  <c:v>0.16231899999999999</c:v>
                </c:pt>
                <c:pt idx="190">
                  <c:v>-0.269293</c:v>
                </c:pt>
                <c:pt idx="191">
                  <c:v>1.0329699999999999</c:v>
                </c:pt>
                <c:pt idx="192">
                  <c:v>1.0329699999999999</c:v>
                </c:pt>
                <c:pt idx="193">
                  <c:v>1.4841599999999999</c:v>
                </c:pt>
                <c:pt idx="194">
                  <c:v>-1.39208</c:v>
                </c:pt>
                <c:pt idx="195">
                  <c:v>1.9789099999999999</c:v>
                </c:pt>
                <c:pt idx="196">
                  <c:v>1.3892</c:v>
                </c:pt>
                <c:pt idx="197">
                  <c:v>-3.4203199999999998</c:v>
                </c:pt>
                <c:pt idx="198">
                  <c:v>-0.36411399999999999</c:v>
                </c:pt>
                <c:pt idx="199">
                  <c:v>1.4782200000000001</c:v>
                </c:pt>
                <c:pt idx="200">
                  <c:v>0.29089500000000001</c:v>
                </c:pt>
                <c:pt idx="201">
                  <c:v>0.29089500000000001</c:v>
                </c:pt>
                <c:pt idx="202">
                  <c:v>0.11279599999999999</c:v>
                </c:pt>
                <c:pt idx="203">
                  <c:v>0</c:v>
                </c:pt>
                <c:pt idx="204">
                  <c:v>-1.37449</c:v>
                </c:pt>
                <c:pt idx="205">
                  <c:v>-0.55874800000000002</c:v>
                </c:pt>
                <c:pt idx="206">
                  <c:v>1.1356299999999999</c:v>
                </c:pt>
                <c:pt idx="207">
                  <c:v>0.20960200000000001</c:v>
                </c:pt>
                <c:pt idx="208">
                  <c:v>-0.43279400000000001</c:v>
                </c:pt>
                <c:pt idx="209">
                  <c:v>1.0329699999999999</c:v>
                </c:pt>
                <c:pt idx="210">
                  <c:v>0.29089500000000001</c:v>
                </c:pt>
                <c:pt idx="211">
                  <c:v>0.11279599999999999</c:v>
                </c:pt>
                <c:pt idx="212">
                  <c:v>4.6008899999999998E-2</c:v>
                </c:pt>
                <c:pt idx="213">
                  <c:v>0</c:v>
                </c:pt>
                <c:pt idx="214">
                  <c:v>1.5836699999999999</c:v>
                </c:pt>
                <c:pt idx="215">
                  <c:v>-1.7902199999999999</c:v>
                </c:pt>
                <c:pt idx="216">
                  <c:v>1.8189900000000001</c:v>
                </c:pt>
                <c:pt idx="217">
                  <c:v>-0.70740000000000003</c:v>
                </c:pt>
                <c:pt idx="218">
                  <c:v>0.73614299999999999</c:v>
                </c:pt>
                <c:pt idx="219">
                  <c:v>0.73614299999999999</c:v>
                </c:pt>
                <c:pt idx="220">
                  <c:v>0.29089500000000001</c:v>
                </c:pt>
                <c:pt idx="221">
                  <c:v>0.29089500000000001</c:v>
                </c:pt>
                <c:pt idx="222">
                  <c:v>0.112795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894-420F-BC64-EA8DDF03D99F}"/>
            </c:ext>
          </c:extLst>
        </c:ser>
        <c:ser>
          <c:idx val="1"/>
          <c:order val="1"/>
          <c:spPr>
            <a:ln w="9525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'PD analysis (von Frey)'!$AN$144:$AN$145</c:f>
              <c:numCache>
                <c:formatCode>General</c:formatCode>
                <c:ptCount val="2"/>
                <c:pt idx="0">
                  <c:v>0</c:v>
                </c:pt>
                <c:pt idx="1">
                  <c:v>30</c:v>
                </c:pt>
              </c:numCache>
            </c:numRef>
          </c:xVal>
          <c:yVal>
            <c:numRef>
              <c:f>'PD analysis (von Frey)'!$AO$144:$AO$145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894-420F-BC64-EA8DDF03D99F}"/>
            </c:ext>
          </c:extLst>
        </c:ser>
        <c:ser>
          <c:idx val="2"/>
          <c:order val="2"/>
          <c:spPr>
            <a:ln w="9525">
              <a:solidFill>
                <a:schemeClr val="tx1"/>
              </a:solidFill>
              <a:prstDash val="sysDash"/>
            </a:ln>
          </c:spPr>
          <c:marker>
            <c:symbol val="none"/>
          </c:marker>
          <c:xVal>
            <c:numRef>
              <c:f>'PD analysis (von Frey)'!$AN$138:$AN$139</c:f>
              <c:numCache>
                <c:formatCode>General</c:formatCode>
                <c:ptCount val="2"/>
                <c:pt idx="0">
                  <c:v>0</c:v>
                </c:pt>
                <c:pt idx="1">
                  <c:v>30</c:v>
                </c:pt>
              </c:numCache>
            </c:numRef>
          </c:xVal>
          <c:yVal>
            <c:numRef>
              <c:f>'PD analysis (von Frey)'!$AO$138:$AO$139</c:f>
              <c:numCache>
                <c:formatCode>General</c:formatCode>
                <c:ptCount val="2"/>
                <c:pt idx="0">
                  <c:v>2</c:v>
                </c:pt>
                <c:pt idx="1">
                  <c:v>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F894-420F-BC64-EA8DDF03D99F}"/>
            </c:ext>
          </c:extLst>
        </c:ser>
        <c:ser>
          <c:idx val="3"/>
          <c:order val="3"/>
          <c:spPr>
            <a:ln w="9525">
              <a:solidFill>
                <a:schemeClr val="tx1"/>
              </a:solidFill>
              <a:prstDash val="sysDash"/>
            </a:ln>
          </c:spPr>
          <c:marker>
            <c:symbol val="none"/>
          </c:marker>
          <c:xVal>
            <c:numRef>
              <c:f>'PD analysis (von Frey)'!$AN$141:$AN$142</c:f>
              <c:numCache>
                <c:formatCode>General</c:formatCode>
                <c:ptCount val="2"/>
                <c:pt idx="0">
                  <c:v>0</c:v>
                </c:pt>
                <c:pt idx="1">
                  <c:v>30</c:v>
                </c:pt>
              </c:numCache>
            </c:numRef>
          </c:xVal>
          <c:yVal>
            <c:numRef>
              <c:f>'PD analysis (von Frey)'!$AO$141:$AO$142</c:f>
              <c:numCache>
                <c:formatCode>General</c:formatCode>
                <c:ptCount val="2"/>
                <c:pt idx="0">
                  <c:v>-2</c:v>
                </c:pt>
                <c:pt idx="1">
                  <c:v>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F894-420F-BC64-EA8DDF03D9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4802720"/>
        <c:axId val="24798368"/>
      </c:scatterChart>
      <c:valAx>
        <c:axId val="24802720"/>
        <c:scaling>
          <c:orientation val="minMax"/>
          <c:max val="1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24798368"/>
        <c:crossesAt val="-4"/>
        <c:crossBetween val="midCat"/>
        <c:majorUnit val="5"/>
      </c:valAx>
      <c:valAx>
        <c:axId val="24798368"/>
        <c:scaling>
          <c:orientation val="minMax"/>
          <c:max val="4"/>
          <c:min val="-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24802720"/>
        <c:crosses val="autoZero"/>
        <c:crossBetween val="midCat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393824698951257"/>
          <c:y val="5.0925925925925923E-2"/>
          <c:w val="0.79447377017786946"/>
          <c:h val="0.74203667249927097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5"/>
            <c:spPr>
              <a:noFill/>
              <a:ln w="15875">
                <a:solidFill>
                  <a:schemeClr val="tx1"/>
                </a:solidFill>
              </a:ln>
            </c:spPr>
          </c:marker>
          <c:trendline>
            <c:spPr>
              <a:ln>
                <a:noFill/>
              </a:ln>
            </c:spPr>
            <c:trendlineType val="linear"/>
            <c:dispRSqr val="0"/>
            <c:dispEq val="0"/>
          </c:trendline>
          <c:xVal>
            <c:numRef>
              <c:f>'　PK  (Pt conc.)'!$M$78:$M$210</c:f>
              <c:numCache>
                <c:formatCode>General</c:formatCode>
                <c:ptCount val="133"/>
                <c:pt idx="0">
                  <c:v>3.0640700000000001</c:v>
                </c:pt>
                <c:pt idx="1">
                  <c:v>2.5288200000000001</c:v>
                </c:pt>
                <c:pt idx="2">
                  <c:v>1.5989599999999999</c:v>
                </c:pt>
                <c:pt idx="3">
                  <c:v>0.72833999999999999</c:v>
                </c:pt>
                <c:pt idx="4">
                  <c:v>0.41703200000000001</c:v>
                </c:pt>
                <c:pt idx="5">
                  <c:v>0.26480300000000001</c:v>
                </c:pt>
                <c:pt idx="6">
                  <c:v>0.211233</c:v>
                </c:pt>
                <c:pt idx="7">
                  <c:v>3.0640700000000001</c:v>
                </c:pt>
                <c:pt idx="8">
                  <c:v>2.5288200000000001</c:v>
                </c:pt>
                <c:pt idx="9">
                  <c:v>1.5989599999999999</c:v>
                </c:pt>
                <c:pt idx="10">
                  <c:v>0.72833999999999999</c:v>
                </c:pt>
                <c:pt idx="11">
                  <c:v>0.41703200000000001</c:v>
                </c:pt>
                <c:pt idx="12">
                  <c:v>0.26480300000000001</c:v>
                </c:pt>
                <c:pt idx="13">
                  <c:v>0.211233</c:v>
                </c:pt>
                <c:pt idx="14">
                  <c:v>0.15614900000000001</c:v>
                </c:pt>
                <c:pt idx="15">
                  <c:v>0.11829000000000001</c:v>
                </c:pt>
                <c:pt idx="16">
                  <c:v>3.0640700000000001</c:v>
                </c:pt>
                <c:pt idx="17">
                  <c:v>2.5288200000000001</c:v>
                </c:pt>
                <c:pt idx="18">
                  <c:v>1.5989599999999999</c:v>
                </c:pt>
                <c:pt idx="19">
                  <c:v>0.72833999999999999</c:v>
                </c:pt>
                <c:pt idx="20">
                  <c:v>0.41703200000000001</c:v>
                </c:pt>
                <c:pt idx="21">
                  <c:v>0.26480300000000001</c:v>
                </c:pt>
                <c:pt idx="22">
                  <c:v>0.211233</c:v>
                </c:pt>
                <c:pt idx="23">
                  <c:v>0.15614900000000001</c:v>
                </c:pt>
                <c:pt idx="24">
                  <c:v>0.11829000000000001</c:v>
                </c:pt>
                <c:pt idx="25">
                  <c:v>3.0640700000000001</c:v>
                </c:pt>
                <c:pt idx="26">
                  <c:v>2.5288200000000001</c:v>
                </c:pt>
                <c:pt idx="27">
                  <c:v>1.5989599999999999</c:v>
                </c:pt>
                <c:pt idx="28">
                  <c:v>0.72833999999999999</c:v>
                </c:pt>
                <c:pt idx="29">
                  <c:v>0.41703200000000001</c:v>
                </c:pt>
                <c:pt idx="30">
                  <c:v>0.26480300000000001</c:v>
                </c:pt>
                <c:pt idx="31">
                  <c:v>0.211233</c:v>
                </c:pt>
                <c:pt idx="32">
                  <c:v>0.15614900000000001</c:v>
                </c:pt>
                <c:pt idx="33">
                  <c:v>0.11829000000000001</c:v>
                </c:pt>
                <c:pt idx="34">
                  <c:v>3.0640700000000001</c:v>
                </c:pt>
                <c:pt idx="35">
                  <c:v>2.5288200000000001</c:v>
                </c:pt>
                <c:pt idx="36">
                  <c:v>1.5989599999999999</c:v>
                </c:pt>
                <c:pt idx="37">
                  <c:v>0.72833999999999999</c:v>
                </c:pt>
                <c:pt idx="38">
                  <c:v>0.41703200000000001</c:v>
                </c:pt>
                <c:pt idx="39">
                  <c:v>0.26480300000000001</c:v>
                </c:pt>
                <c:pt idx="40">
                  <c:v>0.211233</c:v>
                </c:pt>
                <c:pt idx="41">
                  <c:v>0.15614900000000001</c:v>
                </c:pt>
                <c:pt idx="42">
                  <c:v>0.11829000000000001</c:v>
                </c:pt>
                <c:pt idx="43">
                  <c:v>3.0640700000000001</c:v>
                </c:pt>
                <c:pt idx="44">
                  <c:v>2.5288200000000001</c:v>
                </c:pt>
                <c:pt idx="45">
                  <c:v>1.5989599999999999</c:v>
                </c:pt>
                <c:pt idx="46">
                  <c:v>0.72833999999999999</c:v>
                </c:pt>
                <c:pt idx="47">
                  <c:v>0.41703200000000001</c:v>
                </c:pt>
                <c:pt idx="48">
                  <c:v>0.26480300000000001</c:v>
                </c:pt>
                <c:pt idx="49">
                  <c:v>0.211233</c:v>
                </c:pt>
                <c:pt idx="50">
                  <c:v>0.15614900000000001</c:v>
                </c:pt>
                <c:pt idx="51">
                  <c:v>0.11829000000000001</c:v>
                </c:pt>
                <c:pt idx="52">
                  <c:v>5.1067799999999997</c:v>
                </c:pt>
                <c:pt idx="53">
                  <c:v>4.2147100000000002</c:v>
                </c:pt>
                <c:pt idx="54">
                  <c:v>2.6649400000000001</c:v>
                </c:pt>
                <c:pt idx="55">
                  <c:v>1.2139</c:v>
                </c:pt>
                <c:pt idx="56">
                  <c:v>0.69505300000000003</c:v>
                </c:pt>
                <c:pt idx="57">
                  <c:v>0.44133800000000001</c:v>
                </c:pt>
                <c:pt idx="58">
                  <c:v>0.35205500000000001</c:v>
                </c:pt>
                <c:pt idx="59">
                  <c:v>0.26024900000000001</c:v>
                </c:pt>
                <c:pt idx="60">
                  <c:v>0.19714999999999999</c:v>
                </c:pt>
                <c:pt idx="61">
                  <c:v>5.1067799999999997</c:v>
                </c:pt>
                <c:pt idx="62">
                  <c:v>4.2147100000000002</c:v>
                </c:pt>
                <c:pt idx="63">
                  <c:v>2.6649400000000001</c:v>
                </c:pt>
                <c:pt idx="64">
                  <c:v>1.2139</c:v>
                </c:pt>
                <c:pt idx="65">
                  <c:v>0.69505300000000003</c:v>
                </c:pt>
                <c:pt idx="66">
                  <c:v>0.44133800000000001</c:v>
                </c:pt>
                <c:pt idx="67">
                  <c:v>0.35205500000000001</c:v>
                </c:pt>
                <c:pt idx="68">
                  <c:v>0.26024900000000001</c:v>
                </c:pt>
                <c:pt idx="69">
                  <c:v>0.19714999999999999</c:v>
                </c:pt>
                <c:pt idx="70">
                  <c:v>5.1067799999999997</c:v>
                </c:pt>
                <c:pt idx="71">
                  <c:v>4.2147100000000002</c:v>
                </c:pt>
                <c:pt idx="72">
                  <c:v>2.6649400000000001</c:v>
                </c:pt>
                <c:pt idx="73">
                  <c:v>1.2139</c:v>
                </c:pt>
                <c:pt idx="74">
                  <c:v>0.69505300000000003</c:v>
                </c:pt>
                <c:pt idx="75">
                  <c:v>0.44133800000000001</c:v>
                </c:pt>
                <c:pt idx="76">
                  <c:v>0.35205500000000001</c:v>
                </c:pt>
                <c:pt idx="77">
                  <c:v>0.26024900000000001</c:v>
                </c:pt>
                <c:pt idx="78">
                  <c:v>0.19714999999999999</c:v>
                </c:pt>
                <c:pt idx="79">
                  <c:v>5.1067799999999997</c:v>
                </c:pt>
                <c:pt idx="80">
                  <c:v>4.2147100000000002</c:v>
                </c:pt>
                <c:pt idx="81">
                  <c:v>2.6649400000000001</c:v>
                </c:pt>
                <c:pt idx="82">
                  <c:v>1.2139</c:v>
                </c:pt>
                <c:pt idx="83">
                  <c:v>0.69505300000000003</c:v>
                </c:pt>
                <c:pt idx="84">
                  <c:v>0.44133800000000001</c:v>
                </c:pt>
                <c:pt idx="85">
                  <c:v>0.35205500000000001</c:v>
                </c:pt>
                <c:pt idx="86">
                  <c:v>0.26024900000000001</c:v>
                </c:pt>
                <c:pt idx="87">
                  <c:v>0.19714999999999999</c:v>
                </c:pt>
                <c:pt idx="88">
                  <c:v>8.1729199999999995</c:v>
                </c:pt>
                <c:pt idx="89">
                  <c:v>6.7452500000000004</c:v>
                </c:pt>
                <c:pt idx="90">
                  <c:v>4.2649800000000004</c:v>
                </c:pt>
                <c:pt idx="91">
                  <c:v>1.9427300000000001</c:v>
                </c:pt>
                <c:pt idx="92">
                  <c:v>1.1123700000000001</c:v>
                </c:pt>
                <c:pt idx="93">
                  <c:v>0.70631999999999995</c:v>
                </c:pt>
                <c:pt idx="94">
                  <c:v>0.56343100000000002</c:v>
                </c:pt>
                <c:pt idx="95">
                  <c:v>0.41650399999999999</c:v>
                </c:pt>
                <c:pt idx="96">
                  <c:v>0.315521</c:v>
                </c:pt>
                <c:pt idx="97">
                  <c:v>8.1729199999999995</c:v>
                </c:pt>
                <c:pt idx="98">
                  <c:v>6.7452500000000004</c:v>
                </c:pt>
                <c:pt idx="99">
                  <c:v>4.2649800000000004</c:v>
                </c:pt>
                <c:pt idx="100">
                  <c:v>1.9427300000000001</c:v>
                </c:pt>
                <c:pt idx="101">
                  <c:v>1.1123700000000001</c:v>
                </c:pt>
                <c:pt idx="102">
                  <c:v>0.70631999999999995</c:v>
                </c:pt>
                <c:pt idx="103">
                  <c:v>0.56343100000000002</c:v>
                </c:pt>
                <c:pt idx="104">
                  <c:v>0.41650399999999999</c:v>
                </c:pt>
                <c:pt idx="105">
                  <c:v>0.315521</c:v>
                </c:pt>
                <c:pt idx="106">
                  <c:v>8.1729199999999995</c:v>
                </c:pt>
                <c:pt idx="107">
                  <c:v>6.7452500000000004</c:v>
                </c:pt>
                <c:pt idx="108">
                  <c:v>4.2649800000000004</c:v>
                </c:pt>
                <c:pt idx="109">
                  <c:v>1.9427300000000001</c:v>
                </c:pt>
                <c:pt idx="110">
                  <c:v>1.1123700000000001</c:v>
                </c:pt>
                <c:pt idx="111">
                  <c:v>0.70631999999999995</c:v>
                </c:pt>
                <c:pt idx="112">
                  <c:v>0.56343100000000002</c:v>
                </c:pt>
                <c:pt idx="113">
                  <c:v>0.41650399999999999</c:v>
                </c:pt>
                <c:pt idx="114">
                  <c:v>0.315521</c:v>
                </c:pt>
                <c:pt idx="115">
                  <c:v>8.1729199999999995</c:v>
                </c:pt>
                <c:pt idx="116">
                  <c:v>6.7452500000000004</c:v>
                </c:pt>
                <c:pt idx="117">
                  <c:v>4.2649800000000004</c:v>
                </c:pt>
                <c:pt idx="118">
                  <c:v>1.9427300000000001</c:v>
                </c:pt>
                <c:pt idx="119">
                  <c:v>1.1123700000000001</c:v>
                </c:pt>
                <c:pt idx="120">
                  <c:v>0.70631999999999995</c:v>
                </c:pt>
                <c:pt idx="121">
                  <c:v>0.56343100000000002</c:v>
                </c:pt>
                <c:pt idx="122">
                  <c:v>0.41650399999999999</c:v>
                </c:pt>
                <c:pt idx="123">
                  <c:v>0.315521</c:v>
                </c:pt>
                <c:pt idx="124">
                  <c:v>8.1729199999999995</c:v>
                </c:pt>
                <c:pt idx="125">
                  <c:v>6.7452500000000004</c:v>
                </c:pt>
                <c:pt idx="126">
                  <c:v>4.2649800000000004</c:v>
                </c:pt>
                <c:pt idx="127">
                  <c:v>1.9427300000000001</c:v>
                </c:pt>
                <c:pt idx="128">
                  <c:v>1.1123700000000001</c:v>
                </c:pt>
                <c:pt idx="129">
                  <c:v>0.70631999999999995</c:v>
                </c:pt>
                <c:pt idx="130">
                  <c:v>0.56343100000000002</c:v>
                </c:pt>
                <c:pt idx="131">
                  <c:v>0.41650399999999999</c:v>
                </c:pt>
                <c:pt idx="132">
                  <c:v>0.315521</c:v>
                </c:pt>
              </c:numCache>
            </c:numRef>
          </c:xVal>
          <c:yVal>
            <c:numRef>
              <c:f>'　PK  (Pt conc.)'!$U$78:$U$210</c:f>
              <c:numCache>
                <c:formatCode>General</c:formatCode>
                <c:ptCount val="133"/>
                <c:pt idx="0">
                  <c:v>-1.17197</c:v>
                </c:pt>
                <c:pt idx="1">
                  <c:v>-1.09205</c:v>
                </c:pt>
                <c:pt idx="2">
                  <c:v>0.43820999999999999</c:v>
                </c:pt>
                <c:pt idx="3">
                  <c:v>-1.7299899999999999</c:v>
                </c:pt>
                <c:pt idx="4">
                  <c:v>0.41665000000000002</c:v>
                </c:pt>
                <c:pt idx="5">
                  <c:v>-0.68001</c:v>
                </c:pt>
                <c:pt idx="6">
                  <c:v>-0.77365700000000004</c:v>
                </c:pt>
                <c:pt idx="7">
                  <c:v>-1.1691800000000001</c:v>
                </c:pt>
                <c:pt idx="8">
                  <c:v>3.7795700000000002E-2</c:v>
                </c:pt>
                <c:pt idx="9">
                  <c:v>-0.35883100000000001</c:v>
                </c:pt>
                <c:pt idx="10">
                  <c:v>1.98081</c:v>
                </c:pt>
                <c:pt idx="11">
                  <c:v>-1.3699600000000001</c:v>
                </c:pt>
                <c:pt idx="12">
                  <c:v>-0.27450400000000003</c:v>
                </c:pt>
                <c:pt idx="13">
                  <c:v>-1.9539500000000001</c:v>
                </c:pt>
                <c:pt idx="14">
                  <c:v>0.228908</c:v>
                </c:pt>
                <c:pt idx="15">
                  <c:v>0.27321499999999999</c:v>
                </c:pt>
                <c:pt idx="16">
                  <c:v>-0.53998699999999999</c:v>
                </c:pt>
                <c:pt idx="17">
                  <c:v>-4.6437199999999998E-2</c:v>
                </c:pt>
                <c:pt idx="18">
                  <c:v>0.84535099999999996</c:v>
                </c:pt>
                <c:pt idx="19">
                  <c:v>1.53264</c:v>
                </c:pt>
                <c:pt idx="20">
                  <c:v>1.1314</c:v>
                </c:pt>
                <c:pt idx="21">
                  <c:v>1.4361600000000001</c:v>
                </c:pt>
                <c:pt idx="22">
                  <c:v>0.33622600000000002</c:v>
                </c:pt>
                <c:pt idx="23">
                  <c:v>0.56996899999999995</c:v>
                </c:pt>
                <c:pt idx="24">
                  <c:v>0.83359300000000003</c:v>
                </c:pt>
                <c:pt idx="25">
                  <c:v>-1.7187399999999999</c:v>
                </c:pt>
                <c:pt idx="26">
                  <c:v>-1.22614</c:v>
                </c:pt>
                <c:pt idx="27">
                  <c:v>0.33722299999999999</c:v>
                </c:pt>
                <c:pt idx="28">
                  <c:v>1.4874099999999999</c:v>
                </c:pt>
                <c:pt idx="29">
                  <c:v>1.1610100000000001</c:v>
                </c:pt>
                <c:pt idx="30">
                  <c:v>1.2424599999999999</c:v>
                </c:pt>
                <c:pt idx="31">
                  <c:v>1.1902299999999999</c:v>
                </c:pt>
                <c:pt idx="32">
                  <c:v>-8.6956800000000001E-2</c:v>
                </c:pt>
                <c:pt idx="33">
                  <c:v>0.720495</c:v>
                </c:pt>
                <c:pt idx="34">
                  <c:v>-0.91272699999999996</c:v>
                </c:pt>
                <c:pt idx="35">
                  <c:v>0.20873900000000001</c:v>
                </c:pt>
                <c:pt idx="36">
                  <c:v>-4.5918599999999997E-2</c:v>
                </c:pt>
                <c:pt idx="37">
                  <c:v>0.48560700000000001</c:v>
                </c:pt>
                <c:pt idx="38">
                  <c:v>0.39600000000000002</c:v>
                </c:pt>
                <c:pt idx="39">
                  <c:v>0.95606199999999997</c:v>
                </c:pt>
                <c:pt idx="40">
                  <c:v>0.25462000000000001</c:v>
                </c:pt>
                <c:pt idx="41">
                  <c:v>0.10929899999999999</c:v>
                </c:pt>
                <c:pt idx="42">
                  <c:v>0.82402600000000004</c:v>
                </c:pt>
                <c:pt idx="43">
                  <c:v>-0.46586699999999998</c:v>
                </c:pt>
                <c:pt idx="44">
                  <c:v>-0.29277300000000001</c:v>
                </c:pt>
                <c:pt idx="45">
                  <c:v>-0.39554099999999998</c:v>
                </c:pt>
                <c:pt idx="46">
                  <c:v>1.5558799999999999</c:v>
                </c:pt>
                <c:pt idx="47">
                  <c:v>-0.72583799999999998</c:v>
                </c:pt>
                <c:pt idx="48">
                  <c:v>0.65665399999999996</c:v>
                </c:pt>
                <c:pt idx="49">
                  <c:v>0.71448</c:v>
                </c:pt>
                <c:pt idx="50">
                  <c:v>-1.21625E-2</c:v>
                </c:pt>
                <c:pt idx="51">
                  <c:v>0.29574699999999998</c:v>
                </c:pt>
                <c:pt idx="52">
                  <c:v>0.63209000000000004</c:v>
                </c:pt>
                <c:pt idx="53">
                  <c:v>-0.78598900000000005</c:v>
                </c:pt>
                <c:pt idx="54">
                  <c:v>-0.114984</c:v>
                </c:pt>
                <c:pt idx="55">
                  <c:v>-1.8800699999999999</c:v>
                </c:pt>
                <c:pt idx="56">
                  <c:v>0.59534699999999996</c:v>
                </c:pt>
                <c:pt idx="57">
                  <c:v>0.37277399999999999</c:v>
                </c:pt>
                <c:pt idx="58">
                  <c:v>-1.69407</c:v>
                </c:pt>
                <c:pt idx="59">
                  <c:v>-0.195553</c:v>
                </c:pt>
                <c:pt idx="60">
                  <c:v>0.29677599999999998</c:v>
                </c:pt>
                <c:pt idx="61">
                  <c:v>1.1175900000000001</c:v>
                </c:pt>
                <c:pt idx="62">
                  <c:v>-2.5504500000000001</c:v>
                </c:pt>
                <c:pt idx="63">
                  <c:v>-1.42187</c:v>
                </c:pt>
                <c:pt idx="64">
                  <c:v>1.6030500000000001</c:v>
                </c:pt>
                <c:pt idx="65">
                  <c:v>0.23131199999999999</c:v>
                </c:pt>
                <c:pt idx="66">
                  <c:v>-1.6717599999999999</c:v>
                </c:pt>
                <c:pt idx="67">
                  <c:v>8.2141699999999998E-3</c:v>
                </c:pt>
                <c:pt idx="68">
                  <c:v>2.98071E-2</c:v>
                </c:pt>
                <c:pt idx="69">
                  <c:v>-0.49606</c:v>
                </c:pt>
                <c:pt idx="70">
                  <c:v>7.6558899999999999E-2</c:v>
                </c:pt>
                <c:pt idx="71">
                  <c:v>1.2306299999999999</c:v>
                </c:pt>
                <c:pt idx="72">
                  <c:v>-0.28813800000000001</c:v>
                </c:pt>
                <c:pt idx="73">
                  <c:v>-0.62690100000000004</c:v>
                </c:pt>
                <c:pt idx="74">
                  <c:v>-0.64248700000000003</c:v>
                </c:pt>
                <c:pt idx="75">
                  <c:v>-0.492149</c:v>
                </c:pt>
                <c:pt idx="76">
                  <c:v>0.70618499999999995</c:v>
                </c:pt>
                <c:pt idx="77">
                  <c:v>1.0359799999999999</c:v>
                </c:pt>
                <c:pt idx="78">
                  <c:v>1.47732</c:v>
                </c:pt>
                <c:pt idx="79">
                  <c:v>1.27156</c:v>
                </c:pt>
                <c:pt idx="80">
                  <c:v>0.80246300000000004</c:v>
                </c:pt>
                <c:pt idx="81">
                  <c:v>-0.60479899999999998</c:v>
                </c:pt>
                <c:pt idx="82">
                  <c:v>-0.880602</c:v>
                </c:pt>
                <c:pt idx="83">
                  <c:v>3.6573000000000001E-2</c:v>
                </c:pt>
                <c:pt idx="84">
                  <c:v>-1.72461E-2</c:v>
                </c:pt>
                <c:pt idx="85">
                  <c:v>4.5516000000000001E-2</c:v>
                </c:pt>
                <c:pt idx="86">
                  <c:v>-1.3053399999999999</c:v>
                </c:pt>
                <c:pt idx="87">
                  <c:v>1.3370500000000001</c:v>
                </c:pt>
                <c:pt idx="88">
                  <c:v>0.70893200000000001</c:v>
                </c:pt>
                <c:pt idx="89">
                  <c:v>-0.11237</c:v>
                </c:pt>
                <c:pt idx="90">
                  <c:v>2.94595E-2</c:v>
                </c:pt>
                <c:pt idx="91">
                  <c:v>0.55576899999999996</c:v>
                </c:pt>
                <c:pt idx="92">
                  <c:v>-2.4721700000000002</c:v>
                </c:pt>
                <c:pt idx="93">
                  <c:v>-1.0778000000000001</c:v>
                </c:pt>
                <c:pt idx="94">
                  <c:v>-0.89063400000000004</c:v>
                </c:pt>
                <c:pt idx="95">
                  <c:v>0.87339699999999998</c:v>
                </c:pt>
                <c:pt idx="96">
                  <c:v>0.368423</c:v>
                </c:pt>
                <c:pt idx="97">
                  <c:v>1.4649099999999999</c:v>
                </c:pt>
                <c:pt idx="98">
                  <c:v>-0.355605</c:v>
                </c:pt>
                <c:pt idx="99">
                  <c:v>-1.0368299999999999</c:v>
                </c:pt>
                <c:pt idx="100">
                  <c:v>-0.327847</c:v>
                </c:pt>
                <c:pt idx="101">
                  <c:v>-0.85253599999999996</c:v>
                </c:pt>
                <c:pt idx="102">
                  <c:v>-0.66937899999999995</c:v>
                </c:pt>
                <c:pt idx="103">
                  <c:v>-0.69438900000000003</c:v>
                </c:pt>
                <c:pt idx="104">
                  <c:v>-0.327677</c:v>
                </c:pt>
                <c:pt idx="105">
                  <c:v>-1.7298899999999999E-2</c:v>
                </c:pt>
                <c:pt idx="106">
                  <c:v>1.6143099999999999</c:v>
                </c:pt>
                <c:pt idx="107">
                  <c:v>0.34731299999999998</c:v>
                </c:pt>
                <c:pt idx="108">
                  <c:v>-1.6764699999999999</c:v>
                </c:pt>
                <c:pt idx="109">
                  <c:v>-0.13217799999999999</c:v>
                </c:pt>
                <c:pt idx="110">
                  <c:v>-0.66162900000000002</c:v>
                </c:pt>
                <c:pt idx="111">
                  <c:v>-0.80740500000000004</c:v>
                </c:pt>
                <c:pt idx="112">
                  <c:v>-0.65477600000000002</c:v>
                </c:pt>
                <c:pt idx="113">
                  <c:v>-0.75818099999999999</c:v>
                </c:pt>
                <c:pt idx="114">
                  <c:v>-0.35864600000000002</c:v>
                </c:pt>
                <c:pt idx="115">
                  <c:v>-0.67012799999999995</c:v>
                </c:pt>
                <c:pt idx="116">
                  <c:v>4.4217800000000002E-2</c:v>
                </c:pt>
                <c:pt idx="117">
                  <c:v>-7.1347499999999994E-2</c:v>
                </c:pt>
                <c:pt idx="118">
                  <c:v>0.76955499999999999</c:v>
                </c:pt>
                <c:pt idx="119">
                  <c:v>0.62430300000000005</c:v>
                </c:pt>
                <c:pt idx="120">
                  <c:v>-0.62964900000000001</c:v>
                </c:pt>
                <c:pt idx="121">
                  <c:v>-0.115076</c:v>
                </c:pt>
                <c:pt idx="122">
                  <c:v>-2.0873499999999998</c:v>
                </c:pt>
                <c:pt idx="123">
                  <c:v>1.2842499999999999</c:v>
                </c:pt>
                <c:pt idx="124">
                  <c:v>-1.4056599999999999</c:v>
                </c:pt>
                <c:pt idx="125">
                  <c:v>3.0463800000000001</c:v>
                </c:pt>
                <c:pt idx="126">
                  <c:v>0.25158399999999997</c:v>
                </c:pt>
                <c:pt idx="127">
                  <c:v>0.57695799999999997</c:v>
                </c:pt>
                <c:pt idx="128">
                  <c:v>-1.38436</c:v>
                </c:pt>
                <c:pt idx="129">
                  <c:v>0.98610600000000004</c:v>
                </c:pt>
                <c:pt idx="130">
                  <c:v>-4.6820000000000001E-2</c:v>
                </c:pt>
                <c:pt idx="131">
                  <c:v>-7.1507899999999999E-2</c:v>
                </c:pt>
                <c:pt idx="132">
                  <c:v>-0.135672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9BF-401B-9A24-23C74A314949}"/>
            </c:ext>
          </c:extLst>
        </c:ser>
        <c:ser>
          <c:idx val="1"/>
          <c:order val="1"/>
          <c:spPr>
            <a:ln w="9525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'　PK  (Pt conc.)'!$AK$94:$AK$95</c:f>
              <c:numCache>
                <c:formatCode>General</c:formatCode>
                <c:ptCount val="2"/>
                <c:pt idx="0">
                  <c:v>0.01</c:v>
                </c:pt>
                <c:pt idx="1">
                  <c:v>100</c:v>
                </c:pt>
              </c:numCache>
            </c:numRef>
          </c:xVal>
          <c:yVal>
            <c:numRef>
              <c:f>'　PK  (Pt conc.)'!$AL$94:$AL$95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9BF-401B-9A24-23C74A314949}"/>
            </c:ext>
          </c:extLst>
        </c:ser>
        <c:ser>
          <c:idx val="2"/>
          <c:order val="2"/>
          <c:spPr>
            <a:ln w="9525">
              <a:solidFill>
                <a:schemeClr val="tx1"/>
              </a:solidFill>
              <a:prstDash val="sysDash"/>
            </a:ln>
          </c:spPr>
          <c:marker>
            <c:symbol val="none"/>
          </c:marker>
          <c:xVal>
            <c:numRef>
              <c:f>'　PK  (Pt conc.)'!$AK$94:$AK$95</c:f>
              <c:numCache>
                <c:formatCode>General</c:formatCode>
                <c:ptCount val="2"/>
                <c:pt idx="0">
                  <c:v>0.01</c:v>
                </c:pt>
                <c:pt idx="1">
                  <c:v>100</c:v>
                </c:pt>
              </c:numCache>
            </c:numRef>
          </c:xVal>
          <c:yVal>
            <c:numRef>
              <c:f>'　PK  (Pt conc.)'!$AL$97:$AL$98</c:f>
              <c:numCache>
                <c:formatCode>General</c:formatCode>
                <c:ptCount val="2"/>
                <c:pt idx="0">
                  <c:v>2</c:v>
                </c:pt>
                <c:pt idx="1">
                  <c:v>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C9BF-401B-9A24-23C74A314949}"/>
            </c:ext>
          </c:extLst>
        </c:ser>
        <c:ser>
          <c:idx val="3"/>
          <c:order val="3"/>
          <c:spPr>
            <a:ln w="9525">
              <a:solidFill>
                <a:schemeClr val="tx1"/>
              </a:solidFill>
              <a:prstDash val="sysDash"/>
            </a:ln>
          </c:spPr>
          <c:marker>
            <c:symbol val="none"/>
          </c:marker>
          <c:xVal>
            <c:numRef>
              <c:f>'　PK  (Pt conc.)'!$AK$94:$AK$95</c:f>
              <c:numCache>
                <c:formatCode>General</c:formatCode>
                <c:ptCount val="2"/>
                <c:pt idx="0">
                  <c:v>0.01</c:v>
                </c:pt>
                <c:pt idx="1">
                  <c:v>100</c:v>
                </c:pt>
              </c:numCache>
            </c:numRef>
          </c:xVal>
          <c:yVal>
            <c:numRef>
              <c:f>'　PK  (Pt conc.)'!$AL$100:$AL$101</c:f>
              <c:numCache>
                <c:formatCode>General</c:formatCode>
                <c:ptCount val="2"/>
                <c:pt idx="0">
                  <c:v>-2</c:v>
                </c:pt>
                <c:pt idx="1">
                  <c:v>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C9BF-401B-9A24-23C74A3149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73603376"/>
        <c:axId val="1773599568"/>
      </c:scatterChart>
      <c:valAx>
        <c:axId val="1773603376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773599568"/>
        <c:crossesAt val="-4"/>
        <c:crossBetween val="midCat"/>
        <c:majorUnit val="10"/>
      </c:valAx>
      <c:valAx>
        <c:axId val="1773599568"/>
        <c:scaling>
          <c:orientation val="minMax"/>
          <c:max val="4"/>
          <c:min val="-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773603376"/>
        <c:crossesAt val="1.0000000000000002E-2"/>
        <c:crossBetween val="midCat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118564814814816"/>
          <c:y val="4.5978703703703702E-2"/>
          <c:w val="0.72747847400838417"/>
          <c:h val="0.82046729005492813"/>
        </c:manualLayout>
      </c:layout>
      <c:scatterChart>
        <c:scatterStyle val="lineMarker"/>
        <c:varyColors val="0"/>
        <c:ser>
          <c:idx val="4"/>
          <c:order val="0"/>
          <c:tx>
            <c:v>DV</c:v>
          </c:tx>
          <c:spPr>
            <a:ln w="19050">
              <a:noFill/>
            </a:ln>
          </c:spPr>
          <c:marker>
            <c:symbol val="circle"/>
            <c:size val="7"/>
            <c:spPr>
              <a:solidFill>
                <a:schemeClr val="bg1">
                  <a:lumMod val="65000"/>
                </a:schemeClr>
              </a:solidFill>
              <a:ln w="19050">
                <a:noFill/>
              </a:ln>
            </c:spPr>
          </c:marker>
          <c:xVal>
            <c:numRef>
              <c:f>'Pre PD model (Aceton) '!$C$4:$C$47</c:f>
              <c:numCache>
                <c:formatCode>General</c:formatCode>
                <c:ptCount val="44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  <c:pt idx="11">
                  <c:v>0</c:v>
                </c:pt>
                <c:pt idx="12">
                  <c:v>3</c:v>
                </c:pt>
                <c:pt idx="13">
                  <c:v>5</c:v>
                </c:pt>
                <c:pt idx="14">
                  <c:v>8</c:v>
                </c:pt>
                <c:pt idx="15">
                  <c:v>10</c:v>
                </c:pt>
                <c:pt idx="16">
                  <c:v>12</c:v>
                </c:pt>
                <c:pt idx="17">
                  <c:v>15</c:v>
                </c:pt>
                <c:pt idx="18">
                  <c:v>17</c:v>
                </c:pt>
                <c:pt idx="19">
                  <c:v>19</c:v>
                </c:pt>
                <c:pt idx="20">
                  <c:v>22</c:v>
                </c:pt>
                <c:pt idx="21">
                  <c:v>24</c:v>
                </c:pt>
                <c:pt idx="22">
                  <c:v>0</c:v>
                </c:pt>
                <c:pt idx="23">
                  <c:v>3</c:v>
                </c:pt>
                <c:pt idx="24">
                  <c:v>5</c:v>
                </c:pt>
                <c:pt idx="25">
                  <c:v>8</c:v>
                </c:pt>
                <c:pt idx="26">
                  <c:v>10</c:v>
                </c:pt>
                <c:pt idx="27">
                  <c:v>12</c:v>
                </c:pt>
                <c:pt idx="28">
                  <c:v>15</c:v>
                </c:pt>
                <c:pt idx="29">
                  <c:v>17</c:v>
                </c:pt>
                <c:pt idx="30">
                  <c:v>19</c:v>
                </c:pt>
                <c:pt idx="31">
                  <c:v>22</c:v>
                </c:pt>
                <c:pt idx="32">
                  <c:v>24</c:v>
                </c:pt>
                <c:pt idx="33">
                  <c:v>0</c:v>
                </c:pt>
                <c:pt idx="34">
                  <c:v>3</c:v>
                </c:pt>
                <c:pt idx="35">
                  <c:v>5</c:v>
                </c:pt>
                <c:pt idx="36">
                  <c:v>8</c:v>
                </c:pt>
                <c:pt idx="37">
                  <c:v>10</c:v>
                </c:pt>
                <c:pt idx="38">
                  <c:v>12</c:v>
                </c:pt>
                <c:pt idx="39">
                  <c:v>15</c:v>
                </c:pt>
                <c:pt idx="40">
                  <c:v>17</c:v>
                </c:pt>
                <c:pt idx="41">
                  <c:v>19</c:v>
                </c:pt>
                <c:pt idx="42">
                  <c:v>22</c:v>
                </c:pt>
                <c:pt idx="43">
                  <c:v>24</c:v>
                </c:pt>
              </c:numCache>
            </c:numRef>
          </c:xVal>
          <c:yVal>
            <c:numRef>
              <c:f>'Pre PD model (Aceton) '!$G$4:$G$47</c:f>
              <c:numCache>
                <c:formatCode>General</c:formatCode>
                <c:ptCount val="44"/>
                <c:pt idx="0">
                  <c:v>3</c:v>
                </c:pt>
                <c:pt idx="1">
                  <c:v>3.66</c:v>
                </c:pt>
                <c:pt idx="2">
                  <c:v>2</c:v>
                </c:pt>
                <c:pt idx="3">
                  <c:v>3.5</c:v>
                </c:pt>
                <c:pt idx="4">
                  <c:v>1.67</c:v>
                </c:pt>
                <c:pt idx="5">
                  <c:v>1.5</c:v>
                </c:pt>
                <c:pt idx="6">
                  <c:v>1.5</c:v>
                </c:pt>
                <c:pt idx="7">
                  <c:v>2</c:v>
                </c:pt>
                <c:pt idx="8">
                  <c:v>0.66</c:v>
                </c:pt>
                <c:pt idx="9">
                  <c:v>1</c:v>
                </c:pt>
                <c:pt idx="10">
                  <c:v>2</c:v>
                </c:pt>
                <c:pt idx="11">
                  <c:v>3.5</c:v>
                </c:pt>
                <c:pt idx="12">
                  <c:v>2</c:v>
                </c:pt>
                <c:pt idx="13">
                  <c:v>2.83</c:v>
                </c:pt>
                <c:pt idx="14">
                  <c:v>2</c:v>
                </c:pt>
                <c:pt idx="15">
                  <c:v>1.67</c:v>
                </c:pt>
                <c:pt idx="16">
                  <c:v>2</c:v>
                </c:pt>
                <c:pt idx="17">
                  <c:v>2</c:v>
                </c:pt>
                <c:pt idx="18">
                  <c:v>2</c:v>
                </c:pt>
                <c:pt idx="19">
                  <c:v>3</c:v>
                </c:pt>
                <c:pt idx="20">
                  <c:v>3</c:v>
                </c:pt>
                <c:pt idx="21">
                  <c:v>2</c:v>
                </c:pt>
                <c:pt idx="22">
                  <c:v>3</c:v>
                </c:pt>
                <c:pt idx="23">
                  <c:v>3.66</c:v>
                </c:pt>
                <c:pt idx="24">
                  <c:v>2</c:v>
                </c:pt>
                <c:pt idx="25">
                  <c:v>1.67</c:v>
                </c:pt>
                <c:pt idx="26">
                  <c:v>3</c:v>
                </c:pt>
                <c:pt idx="27">
                  <c:v>1.17</c:v>
                </c:pt>
                <c:pt idx="28">
                  <c:v>2</c:v>
                </c:pt>
                <c:pt idx="29">
                  <c:v>1.33</c:v>
                </c:pt>
                <c:pt idx="30">
                  <c:v>1.17</c:v>
                </c:pt>
                <c:pt idx="31">
                  <c:v>1.33</c:v>
                </c:pt>
                <c:pt idx="32">
                  <c:v>1.17</c:v>
                </c:pt>
                <c:pt idx="33">
                  <c:v>3</c:v>
                </c:pt>
                <c:pt idx="34">
                  <c:v>3.66</c:v>
                </c:pt>
                <c:pt idx="35">
                  <c:v>2</c:v>
                </c:pt>
                <c:pt idx="36">
                  <c:v>2</c:v>
                </c:pt>
                <c:pt idx="37">
                  <c:v>2</c:v>
                </c:pt>
                <c:pt idx="38">
                  <c:v>3.66</c:v>
                </c:pt>
                <c:pt idx="39">
                  <c:v>2</c:v>
                </c:pt>
                <c:pt idx="40">
                  <c:v>0.83</c:v>
                </c:pt>
                <c:pt idx="41">
                  <c:v>1</c:v>
                </c:pt>
                <c:pt idx="42">
                  <c:v>1.17</c:v>
                </c:pt>
                <c:pt idx="43">
                  <c:v>1.1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B2B-4893-8466-AD6CE4522284}"/>
            </c:ext>
          </c:extLst>
        </c:ser>
        <c:ser>
          <c:idx val="5"/>
          <c:order val="1"/>
          <c:tx>
            <c:v>PRED</c:v>
          </c:tx>
          <c:spPr>
            <a:ln w="31750">
              <a:solidFill>
                <a:schemeClr val="bg1">
                  <a:lumMod val="65000"/>
                </a:schemeClr>
              </a:solidFill>
            </a:ln>
          </c:spPr>
          <c:marker>
            <c:symbol val="none"/>
          </c:marker>
          <c:xVal>
            <c:numRef>
              <c:f>'Pre PD model (Aceton) '!$C$4:$C$14</c:f>
              <c:numCache>
                <c:formatCode>General</c:formatCode>
                <c:ptCount val="11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</c:numCache>
            </c:numRef>
          </c:xVal>
          <c:yVal>
            <c:numRef>
              <c:f>'Pre PD model (Aceton) '!$E$4:$E$14</c:f>
              <c:numCache>
                <c:formatCode>General</c:formatCode>
                <c:ptCount val="11"/>
                <c:pt idx="0">
                  <c:v>3.25766</c:v>
                </c:pt>
                <c:pt idx="1">
                  <c:v>2.8054700000000001</c:v>
                </c:pt>
                <c:pt idx="2">
                  <c:v>2.5609999999999999</c:v>
                </c:pt>
                <c:pt idx="3">
                  <c:v>2.26274</c:v>
                </c:pt>
                <c:pt idx="4">
                  <c:v>2.10148</c:v>
                </c:pt>
                <c:pt idx="5">
                  <c:v>1.96495</c:v>
                </c:pt>
                <c:pt idx="6">
                  <c:v>1.7983899999999999</c:v>
                </c:pt>
                <c:pt idx="7">
                  <c:v>1.70834</c:v>
                </c:pt>
                <c:pt idx="8">
                  <c:v>1.63209</c:v>
                </c:pt>
                <c:pt idx="9">
                  <c:v>1.5390699999999999</c:v>
                </c:pt>
                <c:pt idx="10">
                  <c:v>1.488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B2B-4893-8466-AD6CE45222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 b="0"/>
            </a:pPr>
            <a:r>
              <a:rPr lang="en-US" altLang="ja-JP" sz="1400" b="0" dirty="0"/>
              <a:t>Placebo</a:t>
            </a:r>
            <a:endParaRPr lang="ja-JP" altLang="en-US" sz="1400" b="0" dirty="0"/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4"/>
          <c:order val="0"/>
          <c:spPr>
            <a:ln w="19050">
              <a:noFill/>
            </a:ln>
          </c:spPr>
          <c:marker>
            <c:symbol val="circle"/>
            <c:size val="7"/>
            <c:spPr>
              <a:solidFill>
                <a:schemeClr val="bg1">
                  <a:lumMod val="65000"/>
                </a:schemeClr>
              </a:solidFill>
              <a:ln w="19050">
                <a:noFill/>
              </a:ln>
            </c:spPr>
          </c:marker>
          <c:xVal>
            <c:numRef>
              <c:f>'Pre PD model (Aceton) '!$C$50:$C$93</c:f>
              <c:numCache>
                <c:formatCode>General</c:formatCode>
                <c:ptCount val="44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  <c:pt idx="11">
                  <c:v>0</c:v>
                </c:pt>
                <c:pt idx="12">
                  <c:v>3</c:v>
                </c:pt>
                <c:pt idx="13">
                  <c:v>5</c:v>
                </c:pt>
                <c:pt idx="14">
                  <c:v>8</c:v>
                </c:pt>
                <c:pt idx="15">
                  <c:v>10</c:v>
                </c:pt>
                <c:pt idx="16">
                  <c:v>12</c:v>
                </c:pt>
                <c:pt idx="17">
                  <c:v>15</c:v>
                </c:pt>
                <c:pt idx="18">
                  <c:v>17</c:v>
                </c:pt>
                <c:pt idx="19">
                  <c:v>19</c:v>
                </c:pt>
                <c:pt idx="20">
                  <c:v>22</c:v>
                </c:pt>
                <c:pt idx="21">
                  <c:v>24</c:v>
                </c:pt>
                <c:pt idx="22">
                  <c:v>0</c:v>
                </c:pt>
                <c:pt idx="23">
                  <c:v>3</c:v>
                </c:pt>
                <c:pt idx="24">
                  <c:v>5</c:v>
                </c:pt>
                <c:pt idx="25">
                  <c:v>8</c:v>
                </c:pt>
                <c:pt idx="26">
                  <c:v>10</c:v>
                </c:pt>
                <c:pt idx="27">
                  <c:v>12</c:v>
                </c:pt>
                <c:pt idx="28">
                  <c:v>15</c:v>
                </c:pt>
                <c:pt idx="29">
                  <c:v>17</c:v>
                </c:pt>
                <c:pt idx="30">
                  <c:v>19</c:v>
                </c:pt>
                <c:pt idx="31">
                  <c:v>22</c:v>
                </c:pt>
                <c:pt idx="32">
                  <c:v>24</c:v>
                </c:pt>
                <c:pt idx="33">
                  <c:v>0</c:v>
                </c:pt>
                <c:pt idx="34">
                  <c:v>3</c:v>
                </c:pt>
                <c:pt idx="35">
                  <c:v>5</c:v>
                </c:pt>
                <c:pt idx="36">
                  <c:v>8</c:v>
                </c:pt>
                <c:pt idx="37">
                  <c:v>10</c:v>
                </c:pt>
                <c:pt idx="38">
                  <c:v>12</c:v>
                </c:pt>
                <c:pt idx="39">
                  <c:v>15</c:v>
                </c:pt>
                <c:pt idx="40">
                  <c:v>17</c:v>
                </c:pt>
                <c:pt idx="41">
                  <c:v>19</c:v>
                </c:pt>
                <c:pt idx="42">
                  <c:v>22</c:v>
                </c:pt>
                <c:pt idx="43">
                  <c:v>24</c:v>
                </c:pt>
              </c:numCache>
            </c:numRef>
          </c:xVal>
          <c:yVal>
            <c:numRef>
              <c:f>'Pre PD model (Aceton) '!$G$50:$G$93</c:f>
              <c:numCache>
                <c:formatCode>General</c:formatCode>
                <c:ptCount val="44"/>
                <c:pt idx="0">
                  <c:v>3</c:v>
                </c:pt>
                <c:pt idx="1">
                  <c:v>3.66</c:v>
                </c:pt>
                <c:pt idx="2">
                  <c:v>2</c:v>
                </c:pt>
                <c:pt idx="3">
                  <c:v>3.5</c:v>
                </c:pt>
                <c:pt idx="4">
                  <c:v>1.67</c:v>
                </c:pt>
                <c:pt idx="5">
                  <c:v>1.5</c:v>
                </c:pt>
                <c:pt idx="6">
                  <c:v>1.5</c:v>
                </c:pt>
                <c:pt idx="7">
                  <c:v>2</c:v>
                </c:pt>
                <c:pt idx="8">
                  <c:v>0.66</c:v>
                </c:pt>
                <c:pt idx="9">
                  <c:v>1</c:v>
                </c:pt>
                <c:pt idx="10">
                  <c:v>2</c:v>
                </c:pt>
                <c:pt idx="11">
                  <c:v>3.5</c:v>
                </c:pt>
                <c:pt idx="12">
                  <c:v>2</c:v>
                </c:pt>
                <c:pt idx="13">
                  <c:v>2.83</c:v>
                </c:pt>
                <c:pt idx="14">
                  <c:v>2</c:v>
                </c:pt>
                <c:pt idx="15">
                  <c:v>1.67</c:v>
                </c:pt>
                <c:pt idx="16">
                  <c:v>2</c:v>
                </c:pt>
                <c:pt idx="17">
                  <c:v>2</c:v>
                </c:pt>
                <c:pt idx="18">
                  <c:v>2</c:v>
                </c:pt>
                <c:pt idx="19">
                  <c:v>3</c:v>
                </c:pt>
                <c:pt idx="20">
                  <c:v>3</c:v>
                </c:pt>
                <c:pt idx="21">
                  <c:v>2</c:v>
                </c:pt>
                <c:pt idx="22">
                  <c:v>3</c:v>
                </c:pt>
                <c:pt idx="23">
                  <c:v>3.66</c:v>
                </c:pt>
                <c:pt idx="24">
                  <c:v>2</c:v>
                </c:pt>
                <c:pt idx="25">
                  <c:v>1.67</c:v>
                </c:pt>
                <c:pt idx="26">
                  <c:v>3</c:v>
                </c:pt>
                <c:pt idx="27">
                  <c:v>1.17</c:v>
                </c:pt>
                <c:pt idx="28">
                  <c:v>2</c:v>
                </c:pt>
                <c:pt idx="29">
                  <c:v>1.33</c:v>
                </c:pt>
                <c:pt idx="30">
                  <c:v>1.17</c:v>
                </c:pt>
                <c:pt idx="31">
                  <c:v>1.33</c:v>
                </c:pt>
                <c:pt idx="32">
                  <c:v>1.17</c:v>
                </c:pt>
                <c:pt idx="33">
                  <c:v>3</c:v>
                </c:pt>
                <c:pt idx="34">
                  <c:v>3.66</c:v>
                </c:pt>
                <c:pt idx="35">
                  <c:v>2</c:v>
                </c:pt>
                <c:pt idx="36">
                  <c:v>2</c:v>
                </c:pt>
                <c:pt idx="37">
                  <c:v>2</c:v>
                </c:pt>
                <c:pt idx="38">
                  <c:v>3.66</c:v>
                </c:pt>
                <c:pt idx="39">
                  <c:v>2</c:v>
                </c:pt>
                <c:pt idx="40">
                  <c:v>0.83</c:v>
                </c:pt>
                <c:pt idx="41">
                  <c:v>1</c:v>
                </c:pt>
                <c:pt idx="42">
                  <c:v>1.17</c:v>
                </c:pt>
                <c:pt idx="43">
                  <c:v>1.1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E55-4E42-B10B-9BF074D03CAA}"/>
            </c:ext>
          </c:extLst>
        </c:ser>
        <c:ser>
          <c:idx val="5"/>
          <c:order val="1"/>
          <c:spPr>
            <a:ln w="31750">
              <a:solidFill>
                <a:schemeClr val="bg1">
                  <a:lumMod val="65000"/>
                </a:schemeClr>
              </a:solidFill>
            </a:ln>
          </c:spPr>
          <c:marker>
            <c:symbol val="none"/>
          </c:marker>
          <c:xVal>
            <c:numRef>
              <c:f>'Pre PD model (Aceton) '!$C$50:$C$60</c:f>
              <c:numCache>
                <c:formatCode>General</c:formatCode>
                <c:ptCount val="11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</c:numCache>
            </c:numRef>
          </c:xVal>
          <c:yVal>
            <c:numRef>
              <c:f>'Pre PD model (Aceton) '!$E$50:$E$60</c:f>
              <c:numCache>
                <c:formatCode>General</c:formatCode>
                <c:ptCount val="11"/>
                <c:pt idx="0">
                  <c:v>3.2883</c:v>
                </c:pt>
                <c:pt idx="1">
                  <c:v>2.8361000000000001</c:v>
                </c:pt>
                <c:pt idx="2">
                  <c:v>2.5916199999999998</c:v>
                </c:pt>
                <c:pt idx="3">
                  <c:v>2.2933599999999998</c:v>
                </c:pt>
                <c:pt idx="4">
                  <c:v>2.1320999999999999</c:v>
                </c:pt>
                <c:pt idx="5">
                  <c:v>1.9955700000000001</c:v>
                </c:pt>
                <c:pt idx="6">
                  <c:v>1.82901</c:v>
                </c:pt>
                <c:pt idx="7">
                  <c:v>1.7389600000000001</c:v>
                </c:pt>
                <c:pt idx="8">
                  <c:v>1.66272</c:v>
                </c:pt>
                <c:pt idx="9">
                  <c:v>1.5697099999999999</c:v>
                </c:pt>
                <c:pt idx="10">
                  <c:v>1.5194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E55-4E42-B10B-9BF074D03C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 b="0"/>
            </a:pPr>
            <a:r>
              <a:rPr lang="en-US" altLang="ja-JP" sz="1400" b="0" dirty="0"/>
              <a:t>3 mg/kg</a:t>
            </a:r>
            <a:endParaRPr lang="ja-JP" altLang="en-US" sz="1400" b="0" dirty="0"/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circle"/>
            <c:size val="7"/>
            <c:spPr>
              <a:solidFill>
                <a:srgbClr val="0070C0"/>
              </a:solidFill>
              <a:ln>
                <a:noFill/>
              </a:ln>
            </c:spPr>
          </c:marker>
          <c:xVal>
            <c:numRef>
              <c:f>'Pre PD model (Aceton) '!$C$94:$C$137</c:f>
              <c:numCache>
                <c:formatCode>General</c:formatCode>
                <c:ptCount val="44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  <c:pt idx="11">
                  <c:v>0</c:v>
                </c:pt>
                <c:pt idx="12">
                  <c:v>3</c:v>
                </c:pt>
                <c:pt idx="13">
                  <c:v>5</c:v>
                </c:pt>
                <c:pt idx="14">
                  <c:v>8</c:v>
                </c:pt>
                <c:pt idx="15">
                  <c:v>10</c:v>
                </c:pt>
                <c:pt idx="16">
                  <c:v>12</c:v>
                </c:pt>
                <c:pt idx="17">
                  <c:v>15</c:v>
                </c:pt>
                <c:pt idx="18">
                  <c:v>17</c:v>
                </c:pt>
                <c:pt idx="19">
                  <c:v>19</c:v>
                </c:pt>
                <c:pt idx="20">
                  <c:v>22</c:v>
                </c:pt>
                <c:pt idx="21">
                  <c:v>24</c:v>
                </c:pt>
                <c:pt idx="22">
                  <c:v>0</c:v>
                </c:pt>
                <c:pt idx="23">
                  <c:v>3</c:v>
                </c:pt>
                <c:pt idx="24">
                  <c:v>5</c:v>
                </c:pt>
                <c:pt idx="25">
                  <c:v>8</c:v>
                </c:pt>
                <c:pt idx="26">
                  <c:v>10</c:v>
                </c:pt>
                <c:pt idx="27">
                  <c:v>12</c:v>
                </c:pt>
                <c:pt idx="28">
                  <c:v>15</c:v>
                </c:pt>
                <c:pt idx="29">
                  <c:v>17</c:v>
                </c:pt>
                <c:pt idx="30">
                  <c:v>19</c:v>
                </c:pt>
                <c:pt idx="31">
                  <c:v>22</c:v>
                </c:pt>
                <c:pt idx="32">
                  <c:v>24</c:v>
                </c:pt>
                <c:pt idx="33">
                  <c:v>0</c:v>
                </c:pt>
                <c:pt idx="34">
                  <c:v>3</c:v>
                </c:pt>
                <c:pt idx="35">
                  <c:v>5</c:v>
                </c:pt>
                <c:pt idx="36">
                  <c:v>8</c:v>
                </c:pt>
                <c:pt idx="37">
                  <c:v>10</c:v>
                </c:pt>
                <c:pt idx="38">
                  <c:v>12</c:v>
                </c:pt>
                <c:pt idx="39">
                  <c:v>15</c:v>
                </c:pt>
                <c:pt idx="40">
                  <c:v>17</c:v>
                </c:pt>
                <c:pt idx="41">
                  <c:v>19</c:v>
                </c:pt>
                <c:pt idx="42">
                  <c:v>22</c:v>
                </c:pt>
                <c:pt idx="43">
                  <c:v>24</c:v>
                </c:pt>
              </c:numCache>
            </c:numRef>
          </c:xVal>
          <c:yVal>
            <c:numRef>
              <c:f>'Pre PD model (Aceton) '!$G$94:$G$137</c:f>
              <c:numCache>
                <c:formatCode>General</c:formatCode>
                <c:ptCount val="44"/>
                <c:pt idx="0">
                  <c:v>3</c:v>
                </c:pt>
                <c:pt idx="1">
                  <c:v>3.66</c:v>
                </c:pt>
                <c:pt idx="2">
                  <c:v>3.16</c:v>
                </c:pt>
                <c:pt idx="3">
                  <c:v>3.5</c:v>
                </c:pt>
                <c:pt idx="4">
                  <c:v>1.67</c:v>
                </c:pt>
                <c:pt idx="5">
                  <c:v>2</c:v>
                </c:pt>
                <c:pt idx="6">
                  <c:v>1.5</c:v>
                </c:pt>
                <c:pt idx="7">
                  <c:v>1.67</c:v>
                </c:pt>
                <c:pt idx="8">
                  <c:v>0.66</c:v>
                </c:pt>
                <c:pt idx="9">
                  <c:v>1.1599999999999999</c:v>
                </c:pt>
                <c:pt idx="10">
                  <c:v>1</c:v>
                </c:pt>
                <c:pt idx="11">
                  <c:v>2</c:v>
                </c:pt>
                <c:pt idx="12">
                  <c:v>3.5</c:v>
                </c:pt>
                <c:pt idx="13">
                  <c:v>2.83</c:v>
                </c:pt>
                <c:pt idx="14">
                  <c:v>2</c:v>
                </c:pt>
                <c:pt idx="15">
                  <c:v>2</c:v>
                </c:pt>
                <c:pt idx="16">
                  <c:v>1.83</c:v>
                </c:pt>
                <c:pt idx="17">
                  <c:v>1.67</c:v>
                </c:pt>
                <c:pt idx="18">
                  <c:v>1.67</c:v>
                </c:pt>
                <c:pt idx="19">
                  <c:v>2</c:v>
                </c:pt>
                <c:pt idx="20">
                  <c:v>2</c:v>
                </c:pt>
                <c:pt idx="21">
                  <c:v>3.5</c:v>
                </c:pt>
                <c:pt idx="22">
                  <c:v>2</c:v>
                </c:pt>
                <c:pt idx="23">
                  <c:v>1.17</c:v>
                </c:pt>
                <c:pt idx="24">
                  <c:v>3.5</c:v>
                </c:pt>
                <c:pt idx="25">
                  <c:v>1.33</c:v>
                </c:pt>
                <c:pt idx="26">
                  <c:v>2</c:v>
                </c:pt>
                <c:pt idx="27">
                  <c:v>1.17</c:v>
                </c:pt>
                <c:pt idx="28">
                  <c:v>2</c:v>
                </c:pt>
                <c:pt idx="29">
                  <c:v>1.33</c:v>
                </c:pt>
                <c:pt idx="30">
                  <c:v>2</c:v>
                </c:pt>
                <c:pt idx="31">
                  <c:v>1.17</c:v>
                </c:pt>
                <c:pt idx="32">
                  <c:v>1.83</c:v>
                </c:pt>
                <c:pt idx="33">
                  <c:v>3</c:v>
                </c:pt>
                <c:pt idx="34">
                  <c:v>3.5</c:v>
                </c:pt>
                <c:pt idx="35">
                  <c:v>0.83</c:v>
                </c:pt>
                <c:pt idx="36">
                  <c:v>2</c:v>
                </c:pt>
                <c:pt idx="37">
                  <c:v>1.67</c:v>
                </c:pt>
                <c:pt idx="38">
                  <c:v>3.5</c:v>
                </c:pt>
                <c:pt idx="39">
                  <c:v>1.17</c:v>
                </c:pt>
                <c:pt idx="40">
                  <c:v>0.83</c:v>
                </c:pt>
                <c:pt idx="41">
                  <c:v>2</c:v>
                </c:pt>
                <c:pt idx="42">
                  <c:v>1.17</c:v>
                </c:pt>
                <c:pt idx="43">
                  <c:v>1.1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398-44DD-ACF8-30D98E02F711}"/>
            </c:ext>
          </c:extLst>
        </c:ser>
        <c:ser>
          <c:idx val="1"/>
          <c:order val="1"/>
          <c:spPr>
            <a:ln w="31750">
              <a:solidFill>
                <a:srgbClr val="0070C0"/>
              </a:solidFill>
            </a:ln>
          </c:spPr>
          <c:marker>
            <c:symbol val="none"/>
          </c:marker>
          <c:xVal>
            <c:numRef>
              <c:f>'Pre PD model (Aceton) '!$C$94:$C$104</c:f>
              <c:numCache>
                <c:formatCode>General</c:formatCode>
                <c:ptCount val="11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2</c:v>
                </c:pt>
                <c:pt idx="10">
                  <c:v>24</c:v>
                </c:pt>
              </c:numCache>
            </c:numRef>
          </c:xVal>
          <c:yVal>
            <c:numRef>
              <c:f>'Pre PD model (Aceton) '!$E$94:$E$104</c:f>
              <c:numCache>
                <c:formatCode>General</c:formatCode>
                <c:ptCount val="11"/>
                <c:pt idx="0">
                  <c:v>3.2883</c:v>
                </c:pt>
                <c:pt idx="1">
                  <c:v>3.2325900000000001</c:v>
                </c:pt>
                <c:pt idx="2">
                  <c:v>2.9438900000000001</c:v>
                </c:pt>
                <c:pt idx="3">
                  <c:v>3.0344899999999999</c:v>
                </c:pt>
                <c:pt idx="4">
                  <c:v>2.7907199999999999</c:v>
                </c:pt>
                <c:pt idx="5">
                  <c:v>2.58074</c:v>
                </c:pt>
                <c:pt idx="6">
                  <c:v>2.7652000000000001</c:v>
                </c:pt>
                <c:pt idx="7">
                  <c:v>2.5708700000000002</c:v>
                </c:pt>
                <c:pt idx="8">
                  <c:v>2.4018600000000001</c:v>
                </c:pt>
                <c:pt idx="9">
                  <c:v>2.6348400000000001</c:v>
                </c:pt>
                <c:pt idx="10">
                  <c:v>2.465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398-44DD-ACF8-30D98E02F7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 b="0"/>
            </a:pPr>
            <a:r>
              <a:rPr lang="en-US" altLang="ja-JP" sz="1400" b="0" dirty="0"/>
              <a:t>5 mg/kg</a:t>
            </a:r>
            <a:endParaRPr lang="ja-JP" altLang="en-US" sz="1400" b="0" dirty="0"/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1"/>
          <c:order val="0"/>
          <c:spPr>
            <a:ln w="19050">
              <a:noFill/>
            </a:ln>
          </c:spPr>
          <c:marker>
            <c:symbol val="circle"/>
            <c:size val="7"/>
            <c:spPr>
              <a:solidFill>
                <a:srgbClr val="00B050"/>
              </a:solidFill>
              <a:ln>
                <a:noFill/>
              </a:ln>
            </c:spPr>
          </c:marker>
          <c:xVal>
            <c:numRef>
              <c:f>'Pre PD model (Aceton) '!$C$138:$C$209</c:f>
              <c:numCache>
                <c:formatCode>General</c:formatCode>
                <c:ptCount val="72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3</c:v>
                </c:pt>
                <c:pt idx="6">
                  <c:v>15</c:v>
                </c:pt>
                <c:pt idx="7">
                  <c:v>17</c:v>
                </c:pt>
                <c:pt idx="8">
                  <c:v>20</c:v>
                </c:pt>
                <c:pt idx="9">
                  <c:v>22</c:v>
                </c:pt>
                <c:pt idx="10">
                  <c:v>24</c:v>
                </c:pt>
                <c:pt idx="11">
                  <c:v>26</c:v>
                </c:pt>
                <c:pt idx="12">
                  <c:v>0</c:v>
                </c:pt>
                <c:pt idx="13">
                  <c:v>3</c:v>
                </c:pt>
                <c:pt idx="14">
                  <c:v>5</c:v>
                </c:pt>
                <c:pt idx="15">
                  <c:v>8</c:v>
                </c:pt>
                <c:pt idx="16">
                  <c:v>10</c:v>
                </c:pt>
                <c:pt idx="17">
                  <c:v>13</c:v>
                </c:pt>
                <c:pt idx="18">
                  <c:v>15</c:v>
                </c:pt>
                <c:pt idx="19">
                  <c:v>17</c:v>
                </c:pt>
                <c:pt idx="20">
                  <c:v>20</c:v>
                </c:pt>
                <c:pt idx="21">
                  <c:v>22</c:v>
                </c:pt>
                <c:pt idx="22">
                  <c:v>24</c:v>
                </c:pt>
                <c:pt idx="23">
                  <c:v>26</c:v>
                </c:pt>
                <c:pt idx="24">
                  <c:v>0</c:v>
                </c:pt>
                <c:pt idx="25">
                  <c:v>3</c:v>
                </c:pt>
                <c:pt idx="26">
                  <c:v>5</c:v>
                </c:pt>
                <c:pt idx="27">
                  <c:v>8</c:v>
                </c:pt>
                <c:pt idx="28">
                  <c:v>10</c:v>
                </c:pt>
                <c:pt idx="29">
                  <c:v>13</c:v>
                </c:pt>
                <c:pt idx="30">
                  <c:v>15</c:v>
                </c:pt>
                <c:pt idx="31">
                  <c:v>17</c:v>
                </c:pt>
                <c:pt idx="32">
                  <c:v>20</c:v>
                </c:pt>
                <c:pt idx="33">
                  <c:v>22</c:v>
                </c:pt>
                <c:pt idx="34">
                  <c:v>24</c:v>
                </c:pt>
                <c:pt idx="35">
                  <c:v>26</c:v>
                </c:pt>
                <c:pt idx="36">
                  <c:v>0</c:v>
                </c:pt>
                <c:pt idx="37">
                  <c:v>3</c:v>
                </c:pt>
                <c:pt idx="38">
                  <c:v>5</c:v>
                </c:pt>
                <c:pt idx="39">
                  <c:v>8</c:v>
                </c:pt>
                <c:pt idx="40">
                  <c:v>10</c:v>
                </c:pt>
                <c:pt idx="41">
                  <c:v>13</c:v>
                </c:pt>
                <c:pt idx="42">
                  <c:v>15</c:v>
                </c:pt>
                <c:pt idx="43">
                  <c:v>17</c:v>
                </c:pt>
                <c:pt idx="44">
                  <c:v>20</c:v>
                </c:pt>
                <c:pt idx="45">
                  <c:v>22</c:v>
                </c:pt>
                <c:pt idx="46">
                  <c:v>24</c:v>
                </c:pt>
                <c:pt idx="47">
                  <c:v>26</c:v>
                </c:pt>
                <c:pt idx="48">
                  <c:v>0</c:v>
                </c:pt>
                <c:pt idx="49">
                  <c:v>3</c:v>
                </c:pt>
                <c:pt idx="50">
                  <c:v>5</c:v>
                </c:pt>
                <c:pt idx="51">
                  <c:v>8</c:v>
                </c:pt>
                <c:pt idx="52">
                  <c:v>10</c:v>
                </c:pt>
                <c:pt idx="53">
                  <c:v>13</c:v>
                </c:pt>
                <c:pt idx="54">
                  <c:v>15</c:v>
                </c:pt>
                <c:pt idx="55">
                  <c:v>17</c:v>
                </c:pt>
                <c:pt idx="56">
                  <c:v>20</c:v>
                </c:pt>
                <c:pt idx="57">
                  <c:v>22</c:v>
                </c:pt>
                <c:pt idx="58">
                  <c:v>24</c:v>
                </c:pt>
                <c:pt idx="59">
                  <c:v>26</c:v>
                </c:pt>
                <c:pt idx="60">
                  <c:v>0</c:v>
                </c:pt>
                <c:pt idx="61">
                  <c:v>3</c:v>
                </c:pt>
                <c:pt idx="62">
                  <c:v>5</c:v>
                </c:pt>
                <c:pt idx="63">
                  <c:v>8</c:v>
                </c:pt>
                <c:pt idx="64">
                  <c:v>10</c:v>
                </c:pt>
                <c:pt idx="65">
                  <c:v>13</c:v>
                </c:pt>
                <c:pt idx="66">
                  <c:v>15</c:v>
                </c:pt>
                <c:pt idx="67">
                  <c:v>17</c:v>
                </c:pt>
                <c:pt idx="68">
                  <c:v>20</c:v>
                </c:pt>
                <c:pt idx="69">
                  <c:v>22</c:v>
                </c:pt>
                <c:pt idx="70">
                  <c:v>24</c:v>
                </c:pt>
                <c:pt idx="71">
                  <c:v>26</c:v>
                </c:pt>
              </c:numCache>
            </c:numRef>
          </c:xVal>
          <c:yVal>
            <c:numRef>
              <c:f>'Pre PD model (Aceton) '!$G$138:$G$209</c:f>
              <c:numCache>
                <c:formatCode>General</c:formatCode>
                <c:ptCount val="72"/>
                <c:pt idx="0">
                  <c:v>3.33</c:v>
                </c:pt>
                <c:pt idx="1">
                  <c:v>6.5</c:v>
                </c:pt>
                <c:pt idx="2">
                  <c:v>5.5</c:v>
                </c:pt>
                <c:pt idx="3">
                  <c:v>4</c:v>
                </c:pt>
                <c:pt idx="4">
                  <c:v>4.33</c:v>
                </c:pt>
                <c:pt idx="5">
                  <c:v>4.66</c:v>
                </c:pt>
                <c:pt idx="6">
                  <c:v>4.5</c:v>
                </c:pt>
                <c:pt idx="7">
                  <c:v>3.1659999999999999</c:v>
                </c:pt>
                <c:pt idx="8">
                  <c:v>5.8330000000000002</c:v>
                </c:pt>
                <c:pt idx="9">
                  <c:v>4.25</c:v>
                </c:pt>
                <c:pt idx="10">
                  <c:v>5.1660000000000004</c:v>
                </c:pt>
                <c:pt idx="11">
                  <c:v>5.66</c:v>
                </c:pt>
                <c:pt idx="12">
                  <c:v>4.1660000000000004</c:v>
                </c:pt>
                <c:pt idx="13">
                  <c:v>5.66</c:v>
                </c:pt>
                <c:pt idx="14">
                  <c:v>7.5</c:v>
                </c:pt>
                <c:pt idx="15">
                  <c:v>8.33</c:v>
                </c:pt>
                <c:pt idx="16">
                  <c:v>6</c:v>
                </c:pt>
                <c:pt idx="17">
                  <c:v>4</c:v>
                </c:pt>
                <c:pt idx="18">
                  <c:v>5.8330000000000002</c:v>
                </c:pt>
                <c:pt idx="19">
                  <c:v>5.1660000000000004</c:v>
                </c:pt>
                <c:pt idx="20">
                  <c:v>4.66</c:v>
                </c:pt>
                <c:pt idx="21">
                  <c:v>6.5</c:v>
                </c:pt>
                <c:pt idx="22">
                  <c:v>4.33</c:v>
                </c:pt>
                <c:pt idx="23">
                  <c:v>4.8330000000000002</c:v>
                </c:pt>
                <c:pt idx="24">
                  <c:v>2</c:v>
                </c:pt>
                <c:pt idx="25">
                  <c:v>6.66</c:v>
                </c:pt>
                <c:pt idx="26">
                  <c:v>5.83</c:v>
                </c:pt>
                <c:pt idx="27">
                  <c:v>3.83</c:v>
                </c:pt>
                <c:pt idx="28">
                  <c:v>4.33</c:v>
                </c:pt>
                <c:pt idx="29">
                  <c:v>4.66</c:v>
                </c:pt>
                <c:pt idx="30">
                  <c:v>3.66</c:v>
                </c:pt>
                <c:pt idx="31">
                  <c:v>4.1660000000000004</c:v>
                </c:pt>
                <c:pt idx="32">
                  <c:v>4.33</c:v>
                </c:pt>
                <c:pt idx="33">
                  <c:v>3.75</c:v>
                </c:pt>
                <c:pt idx="34">
                  <c:v>6.33</c:v>
                </c:pt>
                <c:pt idx="35">
                  <c:v>4.83</c:v>
                </c:pt>
                <c:pt idx="36">
                  <c:v>4.5</c:v>
                </c:pt>
                <c:pt idx="37">
                  <c:v>3.5</c:v>
                </c:pt>
                <c:pt idx="38">
                  <c:v>3.5</c:v>
                </c:pt>
                <c:pt idx="39">
                  <c:v>3</c:v>
                </c:pt>
                <c:pt idx="40">
                  <c:v>4.16</c:v>
                </c:pt>
                <c:pt idx="41">
                  <c:v>2.33</c:v>
                </c:pt>
                <c:pt idx="42">
                  <c:v>4</c:v>
                </c:pt>
                <c:pt idx="43">
                  <c:v>2.16</c:v>
                </c:pt>
                <c:pt idx="44">
                  <c:v>4.66</c:v>
                </c:pt>
                <c:pt idx="45">
                  <c:v>1.5</c:v>
                </c:pt>
                <c:pt idx="46">
                  <c:v>3.83</c:v>
                </c:pt>
                <c:pt idx="47">
                  <c:v>2.66</c:v>
                </c:pt>
                <c:pt idx="48">
                  <c:v>4.83</c:v>
                </c:pt>
                <c:pt idx="49">
                  <c:v>4</c:v>
                </c:pt>
                <c:pt idx="50">
                  <c:v>3.5</c:v>
                </c:pt>
                <c:pt idx="51">
                  <c:v>2.5</c:v>
                </c:pt>
                <c:pt idx="52">
                  <c:v>2</c:v>
                </c:pt>
                <c:pt idx="53">
                  <c:v>3.66</c:v>
                </c:pt>
                <c:pt idx="54">
                  <c:v>4.66</c:v>
                </c:pt>
                <c:pt idx="55">
                  <c:v>2.66</c:v>
                </c:pt>
                <c:pt idx="56">
                  <c:v>5</c:v>
                </c:pt>
                <c:pt idx="57">
                  <c:v>1.66</c:v>
                </c:pt>
                <c:pt idx="58">
                  <c:v>2.16</c:v>
                </c:pt>
                <c:pt idx="59">
                  <c:v>2.83</c:v>
                </c:pt>
                <c:pt idx="60">
                  <c:v>3.66</c:v>
                </c:pt>
                <c:pt idx="61">
                  <c:v>5</c:v>
                </c:pt>
                <c:pt idx="62">
                  <c:v>3.66</c:v>
                </c:pt>
                <c:pt idx="63">
                  <c:v>3</c:v>
                </c:pt>
                <c:pt idx="64">
                  <c:v>3</c:v>
                </c:pt>
                <c:pt idx="65">
                  <c:v>3.33</c:v>
                </c:pt>
                <c:pt idx="66">
                  <c:v>3</c:v>
                </c:pt>
                <c:pt idx="67">
                  <c:v>2.33</c:v>
                </c:pt>
                <c:pt idx="68">
                  <c:v>2.16</c:v>
                </c:pt>
                <c:pt idx="69">
                  <c:v>1.5</c:v>
                </c:pt>
                <c:pt idx="70">
                  <c:v>2.16</c:v>
                </c:pt>
                <c:pt idx="71">
                  <c:v>2.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C9A-438D-A2AF-CD51DE69A495}"/>
            </c:ext>
          </c:extLst>
        </c:ser>
        <c:ser>
          <c:idx val="0"/>
          <c:order val="1"/>
          <c:spPr>
            <a:ln w="31750">
              <a:solidFill>
                <a:srgbClr val="00B050"/>
              </a:solidFill>
            </a:ln>
          </c:spPr>
          <c:marker>
            <c:symbol val="none"/>
          </c:marker>
          <c:xVal>
            <c:numRef>
              <c:f>'Pre PD model (Aceton) '!$C$138:$C$149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3</c:v>
                </c:pt>
                <c:pt idx="6">
                  <c:v>15</c:v>
                </c:pt>
                <c:pt idx="7">
                  <c:v>17</c:v>
                </c:pt>
                <c:pt idx="8">
                  <c:v>20</c:v>
                </c:pt>
                <c:pt idx="9">
                  <c:v>22</c:v>
                </c:pt>
                <c:pt idx="10">
                  <c:v>24</c:v>
                </c:pt>
                <c:pt idx="11">
                  <c:v>26</c:v>
                </c:pt>
              </c:numCache>
            </c:numRef>
          </c:xVal>
          <c:yVal>
            <c:numRef>
              <c:f>'Pre PD model (Aceton) '!$E$138:$E$149</c:f>
              <c:numCache>
                <c:formatCode>General</c:formatCode>
                <c:ptCount val="12"/>
                <c:pt idx="0">
                  <c:v>3.2883</c:v>
                </c:pt>
                <c:pt idx="1">
                  <c:v>3.49661</c:v>
                </c:pt>
                <c:pt idx="2">
                  <c:v>3.17848</c:v>
                </c:pt>
                <c:pt idx="3">
                  <c:v>3.5280300000000002</c:v>
                </c:pt>
                <c:pt idx="4">
                  <c:v>3.2292900000000002</c:v>
                </c:pt>
                <c:pt idx="5">
                  <c:v>2.85426</c:v>
                </c:pt>
                <c:pt idx="6">
                  <c:v>3.3886099999999999</c:v>
                </c:pt>
                <c:pt idx="7">
                  <c:v>3.1248499999999999</c:v>
                </c:pt>
                <c:pt idx="8">
                  <c:v>2.7897599999999998</c:v>
                </c:pt>
                <c:pt idx="9">
                  <c:v>3.3441200000000002</c:v>
                </c:pt>
                <c:pt idx="10">
                  <c:v>3.0961699999999999</c:v>
                </c:pt>
                <c:pt idx="11">
                  <c:v>2.87776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C9A-438D-A2AF-CD51DE69A4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 b="0"/>
            </a:pPr>
            <a:r>
              <a:rPr lang="en-US" altLang="ja-JP" sz="1400" b="0" dirty="0"/>
              <a:t>8 mg/kg</a:t>
            </a:r>
            <a:endParaRPr lang="ja-JP" altLang="en-US" sz="1400" b="0" dirty="0"/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5014280529563062"/>
          <c:y val="4.082454423808702E-2"/>
          <c:w val="0.72747847400838417"/>
          <c:h val="0.82046729005492813"/>
        </c:manualLayout>
      </c:layout>
      <c:scatterChart>
        <c:scatterStyle val="lineMarker"/>
        <c:varyColors val="0"/>
        <c:ser>
          <c:idx val="2"/>
          <c:order val="0"/>
          <c:spPr>
            <a:ln w="19050">
              <a:noFill/>
            </a:ln>
          </c:spPr>
          <c:marker>
            <c:symbol val="circle"/>
            <c:size val="7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'Pre PD model (Aceton) '!$C$210:$C$273</c:f>
              <c:numCache>
                <c:formatCode>General</c:formatCode>
                <c:ptCount val="64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3</c:v>
                </c:pt>
                <c:pt idx="6">
                  <c:v>15</c:v>
                </c:pt>
                <c:pt idx="7">
                  <c:v>20</c:v>
                </c:pt>
                <c:pt idx="8">
                  <c:v>22</c:v>
                </c:pt>
                <c:pt idx="9">
                  <c:v>0</c:v>
                </c:pt>
                <c:pt idx="10">
                  <c:v>3</c:v>
                </c:pt>
                <c:pt idx="11">
                  <c:v>5</c:v>
                </c:pt>
                <c:pt idx="12">
                  <c:v>8</c:v>
                </c:pt>
                <c:pt idx="13">
                  <c:v>10</c:v>
                </c:pt>
                <c:pt idx="14">
                  <c:v>13</c:v>
                </c:pt>
                <c:pt idx="15">
                  <c:v>15</c:v>
                </c:pt>
                <c:pt idx="16">
                  <c:v>20</c:v>
                </c:pt>
                <c:pt idx="17">
                  <c:v>22</c:v>
                </c:pt>
                <c:pt idx="18">
                  <c:v>0</c:v>
                </c:pt>
                <c:pt idx="19">
                  <c:v>3</c:v>
                </c:pt>
                <c:pt idx="20">
                  <c:v>5</c:v>
                </c:pt>
                <c:pt idx="21">
                  <c:v>8</c:v>
                </c:pt>
                <c:pt idx="22">
                  <c:v>10</c:v>
                </c:pt>
                <c:pt idx="23">
                  <c:v>13</c:v>
                </c:pt>
                <c:pt idx="24">
                  <c:v>15</c:v>
                </c:pt>
                <c:pt idx="25">
                  <c:v>20</c:v>
                </c:pt>
                <c:pt idx="26">
                  <c:v>0</c:v>
                </c:pt>
                <c:pt idx="27">
                  <c:v>3</c:v>
                </c:pt>
                <c:pt idx="28">
                  <c:v>5</c:v>
                </c:pt>
                <c:pt idx="29">
                  <c:v>8</c:v>
                </c:pt>
                <c:pt idx="30">
                  <c:v>10</c:v>
                </c:pt>
                <c:pt idx="31">
                  <c:v>13</c:v>
                </c:pt>
                <c:pt idx="32">
                  <c:v>15</c:v>
                </c:pt>
                <c:pt idx="33">
                  <c:v>20</c:v>
                </c:pt>
                <c:pt idx="34">
                  <c:v>0</c:v>
                </c:pt>
                <c:pt idx="35">
                  <c:v>3</c:v>
                </c:pt>
                <c:pt idx="36">
                  <c:v>5</c:v>
                </c:pt>
                <c:pt idx="37">
                  <c:v>8</c:v>
                </c:pt>
                <c:pt idx="38">
                  <c:v>10</c:v>
                </c:pt>
                <c:pt idx="39">
                  <c:v>13</c:v>
                </c:pt>
                <c:pt idx="40">
                  <c:v>15</c:v>
                </c:pt>
                <c:pt idx="41">
                  <c:v>17</c:v>
                </c:pt>
                <c:pt idx="42">
                  <c:v>20</c:v>
                </c:pt>
                <c:pt idx="43">
                  <c:v>22</c:v>
                </c:pt>
                <c:pt idx="44">
                  <c:v>0</c:v>
                </c:pt>
                <c:pt idx="45">
                  <c:v>3</c:v>
                </c:pt>
                <c:pt idx="46">
                  <c:v>5</c:v>
                </c:pt>
                <c:pt idx="47">
                  <c:v>8</c:v>
                </c:pt>
                <c:pt idx="48">
                  <c:v>10</c:v>
                </c:pt>
                <c:pt idx="49">
                  <c:v>13</c:v>
                </c:pt>
                <c:pt idx="50">
                  <c:v>15</c:v>
                </c:pt>
                <c:pt idx="51">
                  <c:v>17</c:v>
                </c:pt>
                <c:pt idx="52">
                  <c:v>20</c:v>
                </c:pt>
                <c:pt idx="53">
                  <c:v>22</c:v>
                </c:pt>
                <c:pt idx="54">
                  <c:v>0</c:v>
                </c:pt>
                <c:pt idx="55">
                  <c:v>3</c:v>
                </c:pt>
                <c:pt idx="56">
                  <c:v>5</c:v>
                </c:pt>
                <c:pt idx="57">
                  <c:v>8</c:v>
                </c:pt>
                <c:pt idx="58">
                  <c:v>10</c:v>
                </c:pt>
                <c:pt idx="59">
                  <c:v>13</c:v>
                </c:pt>
                <c:pt idx="60">
                  <c:v>15</c:v>
                </c:pt>
                <c:pt idx="61">
                  <c:v>17</c:v>
                </c:pt>
                <c:pt idx="62">
                  <c:v>20</c:v>
                </c:pt>
                <c:pt idx="63">
                  <c:v>22</c:v>
                </c:pt>
              </c:numCache>
            </c:numRef>
          </c:xVal>
          <c:yVal>
            <c:numRef>
              <c:f>'Pre PD model (Aceton) '!$G$210:$G$273</c:f>
              <c:numCache>
                <c:formatCode>General</c:formatCode>
                <c:ptCount val="64"/>
                <c:pt idx="0">
                  <c:v>3.6</c:v>
                </c:pt>
                <c:pt idx="1">
                  <c:v>4.66</c:v>
                </c:pt>
                <c:pt idx="2">
                  <c:v>4.66</c:v>
                </c:pt>
                <c:pt idx="3">
                  <c:v>4.66</c:v>
                </c:pt>
                <c:pt idx="4">
                  <c:v>4.8330000000000002</c:v>
                </c:pt>
                <c:pt idx="5">
                  <c:v>4.83</c:v>
                </c:pt>
                <c:pt idx="6">
                  <c:v>3.66</c:v>
                </c:pt>
                <c:pt idx="7">
                  <c:v>4.16</c:v>
                </c:pt>
                <c:pt idx="8">
                  <c:v>4.8330000000000002</c:v>
                </c:pt>
                <c:pt idx="9">
                  <c:v>4.2</c:v>
                </c:pt>
                <c:pt idx="10">
                  <c:v>6.1660000000000004</c:v>
                </c:pt>
                <c:pt idx="11">
                  <c:v>6.83</c:v>
                </c:pt>
                <c:pt idx="12">
                  <c:v>6</c:v>
                </c:pt>
                <c:pt idx="13">
                  <c:v>4.5</c:v>
                </c:pt>
                <c:pt idx="14">
                  <c:v>6.16</c:v>
                </c:pt>
                <c:pt idx="15">
                  <c:v>5.33</c:v>
                </c:pt>
                <c:pt idx="16">
                  <c:v>6.33</c:v>
                </c:pt>
                <c:pt idx="17">
                  <c:v>5.66</c:v>
                </c:pt>
                <c:pt idx="18">
                  <c:v>1.83</c:v>
                </c:pt>
                <c:pt idx="19">
                  <c:v>3.33</c:v>
                </c:pt>
                <c:pt idx="20">
                  <c:v>5.17</c:v>
                </c:pt>
                <c:pt idx="21">
                  <c:v>2.67</c:v>
                </c:pt>
                <c:pt idx="22">
                  <c:v>5</c:v>
                </c:pt>
                <c:pt idx="23">
                  <c:v>4.5</c:v>
                </c:pt>
                <c:pt idx="24">
                  <c:v>4.8</c:v>
                </c:pt>
                <c:pt idx="25">
                  <c:v>5.5</c:v>
                </c:pt>
                <c:pt idx="26">
                  <c:v>1.67</c:v>
                </c:pt>
                <c:pt idx="27">
                  <c:v>3</c:v>
                </c:pt>
                <c:pt idx="28">
                  <c:v>5</c:v>
                </c:pt>
                <c:pt idx="29">
                  <c:v>6</c:v>
                </c:pt>
                <c:pt idx="30">
                  <c:v>4.5</c:v>
                </c:pt>
                <c:pt idx="31">
                  <c:v>5.33</c:v>
                </c:pt>
                <c:pt idx="32">
                  <c:v>5.0999999999999996</c:v>
                </c:pt>
                <c:pt idx="33">
                  <c:v>5.83</c:v>
                </c:pt>
                <c:pt idx="34">
                  <c:v>4</c:v>
                </c:pt>
                <c:pt idx="35">
                  <c:v>7.33</c:v>
                </c:pt>
                <c:pt idx="36">
                  <c:v>4.83</c:v>
                </c:pt>
                <c:pt idx="37">
                  <c:v>3.5</c:v>
                </c:pt>
                <c:pt idx="38">
                  <c:v>5.33</c:v>
                </c:pt>
                <c:pt idx="39">
                  <c:v>4.5</c:v>
                </c:pt>
                <c:pt idx="40">
                  <c:v>6</c:v>
                </c:pt>
                <c:pt idx="41">
                  <c:v>4.66</c:v>
                </c:pt>
                <c:pt idx="42">
                  <c:v>4</c:v>
                </c:pt>
                <c:pt idx="43">
                  <c:v>3.16</c:v>
                </c:pt>
                <c:pt idx="44">
                  <c:v>4</c:v>
                </c:pt>
                <c:pt idx="45">
                  <c:v>6.16</c:v>
                </c:pt>
                <c:pt idx="46">
                  <c:v>4.83</c:v>
                </c:pt>
                <c:pt idx="47">
                  <c:v>4</c:v>
                </c:pt>
                <c:pt idx="48">
                  <c:v>4.33</c:v>
                </c:pt>
                <c:pt idx="49">
                  <c:v>3.66</c:v>
                </c:pt>
                <c:pt idx="50">
                  <c:v>6</c:v>
                </c:pt>
                <c:pt idx="51">
                  <c:v>4.5</c:v>
                </c:pt>
                <c:pt idx="52">
                  <c:v>4.33</c:v>
                </c:pt>
                <c:pt idx="53">
                  <c:v>3.5</c:v>
                </c:pt>
                <c:pt idx="54">
                  <c:v>3</c:v>
                </c:pt>
                <c:pt idx="55">
                  <c:v>6.5</c:v>
                </c:pt>
                <c:pt idx="56">
                  <c:v>5.18</c:v>
                </c:pt>
                <c:pt idx="57">
                  <c:v>2.5</c:v>
                </c:pt>
                <c:pt idx="58">
                  <c:v>3.33</c:v>
                </c:pt>
                <c:pt idx="59">
                  <c:v>5</c:v>
                </c:pt>
                <c:pt idx="60">
                  <c:v>5</c:v>
                </c:pt>
                <c:pt idx="61">
                  <c:v>4.5</c:v>
                </c:pt>
                <c:pt idx="62">
                  <c:v>4.5</c:v>
                </c:pt>
                <c:pt idx="63">
                  <c:v>2.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625-4CE5-A28E-5295FD0B3DDC}"/>
            </c:ext>
          </c:extLst>
        </c:ser>
        <c:ser>
          <c:idx val="0"/>
          <c:order val="1"/>
          <c:spPr>
            <a:ln w="31750">
              <a:solidFill>
                <a:srgbClr val="FF0000"/>
              </a:solidFill>
            </a:ln>
          </c:spPr>
          <c:marker>
            <c:symbol val="none"/>
          </c:marker>
          <c:xVal>
            <c:numRef>
              <c:f>'Pre PD model (Aceton) '!$C$210:$C$218</c:f>
              <c:numCache>
                <c:formatCode>General</c:formatCode>
                <c:ptCount val="9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8</c:v>
                </c:pt>
                <c:pt idx="4">
                  <c:v>10</c:v>
                </c:pt>
                <c:pt idx="5">
                  <c:v>13</c:v>
                </c:pt>
                <c:pt idx="6">
                  <c:v>15</c:v>
                </c:pt>
                <c:pt idx="7">
                  <c:v>20</c:v>
                </c:pt>
                <c:pt idx="8">
                  <c:v>22</c:v>
                </c:pt>
              </c:numCache>
            </c:numRef>
          </c:xVal>
          <c:yVal>
            <c:numRef>
              <c:f>'Pre PD model (Aceton) '!$E$210:$E$218</c:f>
              <c:numCache>
                <c:formatCode>General</c:formatCode>
                <c:ptCount val="9"/>
                <c:pt idx="0">
                  <c:v>3.2883</c:v>
                </c:pt>
                <c:pt idx="1">
                  <c:v>3.8924699999999999</c:v>
                </c:pt>
                <c:pt idx="2">
                  <c:v>3.5301900000000002</c:v>
                </c:pt>
                <c:pt idx="3">
                  <c:v>4.2679900000000002</c:v>
                </c:pt>
                <c:pt idx="4">
                  <c:v>3.88686</c:v>
                </c:pt>
                <c:pt idx="5">
                  <c:v>3.40496</c:v>
                </c:pt>
                <c:pt idx="6">
                  <c:v>4.3233100000000002</c:v>
                </c:pt>
                <c:pt idx="7">
                  <c:v>3.4853700000000001</c:v>
                </c:pt>
                <c:pt idx="8">
                  <c:v>4.40756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625-4CE5-A28E-5295FD0B3D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0272240"/>
        <c:axId val="1980276592"/>
      </c:scatterChart>
      <c:valAx>
        <c:axId val="1980272240"/>
        <c:scaling>
          <c:orientation val="minMax"/>
          <c:max val="28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6592"/>
        <c:crosses val="autoZero"/>
        <c:crossBetween val="midCat"/>
        <c:majorUnit val="7"/>
      </c:valAx>
      <c:valAx>
        <c:axId val="1980276592"/>
        <c:scaling>
          <c:orientation val="minMax"/>
          <c:max val="1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ja-JP"/>
          </a:p>
        </c:txPr>
        <c:crossAx val="1980272240"/>
        <c:crosses val="autoZero"/>
        <c:crossBetween val="midCat"/>
        <c:majorUnit val="4"/>
      </c:valAx>
      <c:spPr>
        <a:noFill/>
      </c:spPr>
    </c:plotArea>
    <c:plotVisOnly val="1"/>
    <c:dispBlanksAs val="gap"/>
    <c:showDLblsOverMax val="0"/>
  </c:chart>
  <c:spPr>
    <a:solidFill>
      <a:sysClr val="window" lastClr="FFFFFF"/>
    </a:solidFill>
    <a:ln>
      <a:noFill/>
    </a:ln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PK!$C$2:$C$1001</cx:f>
        <cx:lvl ptCount="1000" formatCode="G/標準">
          <cx:pt idx="0">350.81</cx:pt>
          <cx:pt idx="1">397.779</cx:pt>
          <cx:pt idx="2">267.755</cx:pt>
          <cx:pt idx="3">339.89999999999998</cx:pt>
          <cx:pt idx="4">386.209</cx:pt>
          <cx:pt idx="5">321.108</cx:pt>
          <cx:pt idx="6">364.803</cx:pt>
          <cx:pt idx="7">352.94600000000003</cx:pt>
          <cx:pt idx="8">382.05799999999999</cx:pt>
          <cx:pt idx="9">404.57799999999997</cx:pt>
          <cx:pt idx="10">314.892</cx:pt>
          <cx:pt idx="11">296.92000000000002</cx:pt>
          <cx:pt idx="12">353.50700000000001</cx:pt>
          <cx:pt idx="13">398.34300000000002</cx:pt>
          <cx:pt idx="14">320.31200000000001</cx:pt>
          <cx:pt idx="15">329.59199999999998</cx:pt>
          <cx:pt idx="16">357.846</cx:pt>
          <cx:pt idx="17">390.03300000000002</cx:pt>
          <cx:pt idx="18">290.61599999999999</cx:pt>
          <cx:pt idx="19">360.12799999999999</cx:pt>
          <cx:pt idx="20">277.709</cx:pt>
          <cx:pt idx="21">427.59899999999999</cx:pt>
          <cx:pt idx="22">338.101</cx:pt>
          <cx:pt idx="23">363.85300000000001</cx:pt>
          <cx:pt idx="24">368.87200000000001</cx:pt>
          <cx:pt idx="25">406.87700000000001</cx:pt>
          <cx:pt idx="26">357.846</cx:pt>
          <cx:pt idx="27">333.44799999999998</cx:pt>
          <cx:pt idx="28">282.173</cx:pt>
          <cx:pt idx="29">322.82900000000001</cx:pt>
          <cx:pt idx="30">350.017</cx:pt>
          <cx:pt idx="31">367.84899999999999</cx:pt>
          <cx:pt idx="32">351.613</cx:pt>
          <cx:pt idx="33">446.69900000000001</cx:pt>
          <cx:pt idx="34">357.846</cx:pt>
          <cx:pt idx="35">357.846</cx:pt>
          <cx:pt idx="36">410.99900000000002</cx:pt>
          <cx:pt idx="37">267.09699999999998</cx:pt>
          <cx:pt idx="38">258.84399999999999</cx:pt>
          <cx:pt idx="39">314.13</cx:pt>
          <cx:pt idx="40">358.66800000000001</cx:pt>
          <cx:pt idx="41">420.22199999999998</cx:pt>
          <cx:pt idx="42">368.88200000000001</cx:pt>
          <cx:pt idx="43">347.53199999999998</cx:pt>
          <cx:pt idx="44">350.81099999999998</cx:pt>
          <cx:pt idx="45">268.65499999999997</cx:pt>
          <cx:pt idx="46">352.40699999999998</cx:pt>
          <cx:pt idx="47">425.24799999999999</cx:pt>
          <cx:pt idx="48">390.74200000000002</cx:pt>
          <cx:pt idx="49">388.27800000000002</cx:pt>
          <cx:pt idx="50">329.202</cx:pt>
          <cx:pt idx="51">344.02999999999997</cx:pt>
          <cx:pt idx="52">352.71499999999997</cx:pt>
          <cx:pt idx="53">391.25400000000002</cx:pt>
          <cx:pt idx="54">332.62</cx:pt>
          <cx:pt idx="55">416.738</cx:pt>
          <cx:pt idx="56">342.572</cx:pt>
          <cx:pt idx="57">320.57400000000001</cx:pt>
          <cx:pt idx="58">304.89800000000002</cx:pt>
          <cx:pt idx="59">403.37</cx:pt>
          <cx:pt idx="60">386.67399999999998</cx:pt>
          <cx:pt idx="61">379.95600000000002</cx:pt>
          <cx:pt idx="62">409.66899999999998</cx:pt>
          <cx:pt idx="63">415.178</cx:pt>
          <cx:pt idx="64">347.245</cx:pt>
          <cx:pt idx="65">390.59300000000002</cx:pt>
          <cx:pt idx="66">317.26900000000001</cx:pt>
          <cx:pt idx="67">398.46199999999999</cx:pt>
          <cx:pt idx="68">306.74099999999999</cx:pt>
          <cx:pt idx="69">367.642</cx:pt>
          <cx:pt idx="70">276.959</cx:pt>
          <cx:pt idx="71">280.49400000000003</cx:pt>
          <cx:pt idx="72">307.37799999999999</cx:pt>
          <cx:pt idx="73">343.44999999999999</cx:pt>
          <cx:pt idx="74">350.017</cx:pt>
          <cx:pt idx="75">318.053</cx:pt>
          <cx:pt idx="76">379.77699999999999</cx:pt>
          <cx:pt idx="77">330.209</cx:pt>
          <cx:pt idx="78">437.41199999999998</cx:pt>
          <cx:pt idx="79">336.40199999999999</cx:pt>
          <cx:pt idx="80">345.55399999999997</cx:pt>
          <cx:pt idx="81">271.89600000000002</cx:pt>
          <cx:pt idx="82">357.846</cx:pt>
          <cx:pt idx="83">285.99299999999999</cx:pt>
          <cx:pt idx="84">361.62400000000002</cx:pt>
          <cx:pt idx="85">350.08699999999999</cx:pt>
          <cx:pt idx="86">293.33800000000002</cx:pt>
          <cx:pt idx="87">247.02699999999999</cx:pt>
          <cx:pt idx="88">358.673</cx:pt>
          <cx:pt idx="89">384.89299999999997</cx:pt>
          <cx:pt idx="90">347.84699999999998</cx:pt>
          <cx:pt idx="91">318.67099999999999</cx:pt>
          <cx:pt idx="92">371.02600000000001</cx:pt>
          <cx:pt idx="93">375.44600000000003</cx:pt>
          <cx:pt idx="94">390.74099999999999</cx:pt>
          <cx:pt idx="95">251.90899999999999</cx:pt>
          <cx:pt idx="96">356.267</cx:pt>
          <cx:pt idx="97">315.46699999999998</cx:pt>
          <cx:pt idx="98">366.42899999999997</cx:pt>
          <cx:pt idx="99">357.846</cx:pt>
          <cx:pt idx="100">333.86500000000001</cx:pt>
          <cx:pt idx="101">357.846</cx:pt>
          <cx:pt idx="102">357.846</cx:pt>
          <cx:pt idx="103">367.298</cx:pt>
          <cx:pt idx="104">321.53699999999998</cx:pt>
          <cx:pt idx="105">369.48500000000001</cx:pt>
          <cx:pt idx="106">318.82999999999998</cx:pt>
          <cx:pt idx="107">383.988</cx:pt>
          <cx:pt idx="108">436.99799999999999</cx:pt>
          <cx:pt idx="109">329.399</cx:pt>
          <cx:pt idx="110">365.61399999999998</cx:pt>
          <cx:pt idx="111">361.26299999999998</cx:pt>
          <cx:pt idx="112">328.87599999999998</cx:pt>
          <cx:pt idx="113">258.79500000000002</cx:pt>
          <cx:pt idx="114">309.61399999999998</cx:pt>
          <cx:pt idx="115">304.95400000000001</cx:pt>
          <cx:pt idx="116">406.07799999999997</cx:pt>
          <cx:pt idx="117">421.51999999999998</cx:pt>
          <cx:pt idx="118">357.846</cx:pt>
          <cx:pt idx="119">348.10899999999998</cx:pt>
          <cx:pt idx="120">343.44499999999999</cx:pt>
          <cx:pt idx="121">406.06900000000002</cx:pt>
          <cx:pt idx="122">292.40199999999999</cx:pt>
          <cx:pt idx="123">283.59899999999999</cx:pt>
          <cx:pt idx="124">381.63999999999999</cx:pt>
          <cx:pt idx="125">388.80200000000002</cx:pt>
          <cx:pt idx="126">373.238</cx:pt>
          <cx:pt idx="127">342.99799999999999</cx:pt>
          <cx:pt idx="128">423.178</cx:pt>
          <cx:pt idx="129">368.315</cx:pt>
          <cx:pt idx="130">418.47399999999999</cx:pt>
          <cx:pt idx="131">430.12200000000001</cx:pt>
          <cx:pt idx="132">332.45499999999998</cx:pt>
          <cx:pt idx="133">327.50599999999997</cx:pt>
          <cx:pt idx="134">338.58800000000002</cx:pt>
          <cx:pt idx="135">370.11200000000002</cx:pt>
          <cx:pt idx="136">357.846</cx:pt>
          <cx:pt idx="137">312.54300000000001</cx:pt>
          <cx:pt idx="138">322.60199999999998</cx:pt>
          <cx:pt idx="139">329.613</cx:pt>
          <cx:pt idx="140">372.149</cx:pt>
          <cx:pt idx="141">373.77600000000001</cx:pt>
          <cx:pt idx="142">391.18599999999998</cx:pt>
          <cx:pt idx="143">342.71899999999999</cx:pt>
          <cx:pt idx="144">360.59100000000001</cx:pt>
          <cx:pt idx="145">357.846</cx:pt>
          <cx:pt idx="146">428.28699999999998</cx:pt>
          <cx:pt idx="147">321.91800000000001</cx:pt>
          <cx:pt idx="148">341.94999999999999</cx:pt>
          <cx:pt idx="149">387.07799999999997</cx:pt>
          <cx:pt idx="150">331.15100000000001</cx:pt>
          <cx:pt idx="151">301.37099999999998</cx:pt>
          <cx:pt idx="152">318.77100000000002</cx:pt>
          <cx:pt idx="153">333.29300000000001</cx:pt>
          <cx:pt idx="154">363.291</cx:pt>
          <cx:pt idx="155">391.28399999999999</cx:pt>
          <cx:pt idx="156">339.17899999999997</cx:pt>
          <cx:pt idx="157">310.45699999999999</cx:pt>
          <cx:pt idx="158">318.745</cx:pt>
          <cx:pt idx="159">304.52699999999999</cx:pt>
          <cx:pt idx="160">357.01299999999998</cx:pt>
          <cx:pt idx="161">316.72500000000002</cx:pt>
          <cx:pt idx="162">350.35300000000001</cx:pt>
          <cx:pt idx="163">355.26299999999998</cx:pt>
          <cx:pt idx="164">454.10500000000002</cx:pt>
          <cx:pt idx="165">361.19099999999997</cx:pt>
          <cx:pt idx="166">400.44600000000003</cx:pt>
          <cx:pt idx="167">402.24000000000001</cx:pt>
          <cx:pt idx="168">323.50700000000001</cx:pt>
          <cx:pt idx="169">305.74099999999999</cx:pt>
          <cx:pt idx="170">425.69200000000001</cx:pt>
          <cx:pt idx="171">288.334</cx:pt>
          <cx:pt idx="172">381.04700000000003</cx:pt>
          <cx:pt idx="173">367.75799999999998</cx:pt>
          <cx:pt idx="174">356.79000000000002</cx:pt>
          <cx:pt idx="175">372.23000000000002</cx:pt>
          <cx:pt idx="176">411.06400000000002</cx:pt>
          <cx:pt idx="177">374.82499999999999</cx:pt>
          <cx:pt idx="178">295.51400000000001</cx:pt>
          <cx:pt idx="179">415.78800000000001</cx:pt>
          <cx:pt idx="180">369.74700000000001</cx:pt>
          <cx:pt idx="181">323.327</cx:pt>
          <cx:pt idx="182">254.977</cx:pt>
          <cx:pt idx="183">375.17000000000002</cx:pt>
          <cx:pt idx="184">391.64299999999997</cx:pt>
          <cx:pt idx="185">354.10899999999998</cx:pt>
          <cx:pt idx="186">336.74200000000002</cx:pt>
          <cx:pt idx="187">358.24599999999998</cx:pt>
          <cx:pt idx="188">320.221</cx:pt>
          <cx:pt idx="189">351.48000000000002</cx:pt>
          <cx:pt idx="190">357.846</cx:pt>
          <cx:pt idx="191">223.15700000000001</cx:pt>
          <cx:pt idx="192">337.69900000000001</cx:pt>
          <cx:pt idx="193">241.28</cx:pt>
          <cx:pt idx="194">333.48200000000003</cx:pt>
          <cx:pt idx="195">344.238</cx:pt>
          <cx:pt idx="196">396.22500000000002</cx:pt>
          <cx:pt idx="197">353.13499999999999</cx:pt>
          <cx:pt idx="198">314.36399999999998</cx:pt>
          <cx:pt idx="199">310.733</cx:pt>
          <cx:pt idx="200">356.86500000000001</cx:pt>
          <cx:pt idx="201">359.16399999999999</cx:pt>
          <cx:pt idx="202">396.55599999999998</cx:pt>
          <cx:pt idx="203">379.17899999999997</cx:pt>
          <cx:pt idx="204">289.42099999999999</cx:pt>
          <cx:pt idx="205">348.09800000000001</cx:pt>
          <cx:pt idx="206">383.78399999999999</cx:pt>
          <cx:pt idx="207">307.03500000000003</cx:pt>
          <cx:pt idx="208">401.67599999999999</cx:pt>
          <cx:pt idx="209">304.52600000000001</cx:pt>
          <cx:pt idx="210">333.59399999999999</cx:pt>
          <cx:pt idx="211">315.54500000000002</cx:pt>
          <cx:pt idx="212">351.49599999999998</cx:pt>
          <cx:pt idx="213">301.93900000000002</cx:pt>
          <cx:pt idx="214">381.96100000000001</cx:pt>
          <cx:pt idx="215">425.32400000000001</cx:pt>
          <cx:pt idx="216">361.22500000000002</cx:pt>
          <cx:pt idx="217">355.291</cx:pt>
          <cx:pt idx="218">360.20999999999998</cx:pt>
          <cx:pt idx="219">362.72300000000001</cx:pt>
          <cx:pt idx="220">361.40899999999999</cx:pt>
          <cx:pt idx="221">369.50400000000002</cx:pt>
          <cx:pt idx="222">450.98899999999998</cx:pt>
          <cx:pt idx="223">278.51499999999999</cx:pt>
          <cx:pt idx="224">362.36399999999998</cx:pt>
          <cx:pt idx="225">364.05599999999998</cx:pt>
          <cx:pt idx="226">408.64100000000002</cx:pt>
          <cx:pt idx="227">395.29700000000003</cx:pt>
          <cx:pt idx="228">357.846</cx:pt>
          <cx:pt idx="229">379.89100000000002</cx:pt>
          <cx:pt idx="230">284.17899999999997</cx:pt>
          <cx:pt idx="231">339.899</cx:pt>
          <cx:pt idx="232">315.28699999999998</cx:pt>
          <cx:pt idx="233">338.149</cx:pt>
          <cx:pt idx="234">379.63900000000001</cx:pt>
          <cx:pt idx="235">392.404</cx:pt>
          <cx:pt idx="236">379.77800000000002</cx:pt>
          <cx:pt idx="237">346.99900000000002</cx:pt>
          <cx:pt idx="238">363.99400000000003</cx:pt>
          <cx:pt idx="239">343.48399999999998</cx:pt>
          <cx:pt idx="240">355.46300000000002</cx:pt>
          <cx:pt idx="241">353.05700000000002</cx:pt>
          <cx:pt idx="242">381.99099999999999</cx:pt>
          <cx:pt idx="243">297.15800000000002</cx:pt>
          <cx:pt idx="244">344.14400000000001</cx:pt>
          <cx:pt idx="245">305.06099999999998</cx:pt>
          <cx:pt idx="246">357.54599999999999</cx:pt>
          <cx:pt idx="247">357.846</cx:pt>
          <cx:pt idx="248">326.19499999999999</cx:pt>
          <cx:pt idx="249">255.15899999999999</cx:pt>
          <cx:pt idx="250">407.11500000000001</cx:pt>
          <cx:pt idx="251">346.19400000000002</cx:pt>
          <cx:pt idx="252">385.79700000000003</cx:pt>
          <cx:pt idx="253">353.70600000000002</cx:pt>
          <cx:pt idx="254">312.10599999999999</cx:pt>
          <cx:pt idx="255">320.67399999999998</cx:pt>
          <cx:pt idx="256">327.23200000000003</cx:pt>
          <cx:pt idx="257">392.233</cx:pt>
          <cx:pt idx="258">329.87299999999999</cx:pt>
          <cx:pt idx="259">373.36399999999998</cx:pt>
          <cx:pt idx="260">318.315</cx:pt>
          <cx:pt idx="261">417.80000000000001</cx:pt>
          <cx:pt idx="262">271.53899999999999</cx:pt>
          <cx:pt idx="263">373.37099999999998</cx:pt>
          <cx:pt idx="264">342.95600000000002</cx:pt>
          <cx:pt idx="265">372.22199999999998</cx:pt>
          <cx:pt idx="266">377.74099999999999</cx:pt>
          <cx:pt idx="267">341.58800000000002</cx:pt>
          <cx:pt idx="268">385.75799999999998</cx:pt>
          <cx:pt idx="269">357.846</cx:pt>
          <cx:pt idx="270">382.42899999999997</cx:pt>
          <cx:pt idx="271">362.99400000000003</cx:pt>
          <cx:pt idx="272">352.09399999999999</cx:pt>
          <cx:pt idx="273">295.642</cx:pt>
          <cx:pt idx="274">342.12700000000001</cx:pt>
          <cx:pt idx="275">354.17500000000001</cx:pt>
          <cx:pt idx="276">409.14699999999999</cx:pt>
          <cx:pt idx="277">347.815</cx:pt>
          <cx:pt idx="278">415.77499999999998</cx:pt>
          <cx:pt idx="279">306.40699999999998</cx:pt>
          <cx:pt idx="280">332.47399999999999</cx:pt>
          <cx:pt idx="281">334.18200000000002</cx:pt>
          <cx:pt idx="282">333.959</cx:pt>
          <cx:pt idx="283">283.00099999999998</cx:pt>
          <cx:pt idx="284">334.41899999999998</cx:pt>
          <cx:pt idx="285">357.846</cx:pt>
          <cx:pt idx="286">360.69</cx:pt>
          <cx:pt idx="287">328.26900000000001</cx:pt>
          <cx:pt idx="288">371.255</cx:pt>
          <cx:pt idx="289">358.22399999999999</cx:pt>
          <cx:pt idx="290">350.178</cx:pt>
          <cx:pt idx="291">357.846</cx:pt>
          <cx:pt idx="292">297.04500000000002</cx:pt>
          <cx:pt idx="293">335.14999999999998</cx:pt>
          <cx:pt idx="294">279.00700000000001</cx:pt>
          <cx:pt idx="295">346.36599999999999</cx:pt>
          <cx:pt idx="296">407.47800000000001</cx:pt>
          <cx:pt idx="297">408.923</cx:pt>
          <cx:pt idx="298">385.84800000000001</cx:pt>
          <cx:pt idx="299">374.53899999999999</cx:pt>
          <cx:pt idx="300">363.399</cx:pt>
          <cx:pt idx="301">384.98599999999999</cx:pt>
          <cx:pt idx="302">411.137</cx:pt>
          <cx:pt idx="303">369.70699999999999</cx:pt>
          <cx:pt idx="304">357.846</cx:pt>
          <cx:pt idx="305">417.27499999999998</cx:pt>
          <cx:pt idx="306">355.20999999999998</cx:pt>
          <cx:pt idx="307">352.50900000000001</cx:pt>
          <cx:pt idx="308">338.81099999999998</cx:pt>
          <cx:pt idx="309">357.846</cx:pt>
          <cx:pt idx="310">353.68900000000002</cx:pt>
          <cx:pt idx="311">340.42599999999999</cx:pt>
          <cx:pt idx="312">364.21600000000001</cx:pt>
          <cx:pt idx="313">392.78699999999998</cx:pt>
          <cx:pt idx="314">248.50899999999999</cx:pt>
          <cx:pt idx="315">352.83300000000003</cx:pt>
          <cx:pt idx="316">358.67899999999997</cx:pt>
          <cx:pt idx="317">305.46600000000001</cx:pt>
          <cx:pt idx="318">408.47300000000001</cx:pt>
          <cx:pt idx="319">349.83199999999999</cx:pt>
          <cx:pt idx="320">363.88099999999997</cx:pt>
          <cx:pt idx="321">336.54700000000003</cx:pt>
          <cx:pt idx="322">335.32299999999998</cx:pt>
          <cx:pt idx="323">385.51100000000002</cx:pt>
          <cx:pt idx="324">350.38900000000001</cx:pt>
          <cx:pt idx="325">365.41000000000003</cx:pt>
          <cx:pt idx="326">308.64699999999999</cx:pt>
          <cx:pt idx="327">389.22899999999998</cx:pt>
          <cx:pt idx="328">349.43299999999999</cx:pt>
          <cx:pt idx="329">346.779</cx:pt>
          <cx:pt idx="330">321.06700000000001</cx:pt>
          <cx:pt idx="331">372.82499999999999</cx:pt>
          <cx:pt idx="332">357.83300000000003</cx:pt>
          <cx:pt idx="333">305.18799999999999</cx:pt>
          <cx:pt idx="334">391.96499999999997</cx:pt>
          <cx:pt idx="335">297.755</cx:pt>
          <cx:pt idx="336">358.68200000000002</cx:pt>
          <cx:pt idx="337">305.94400000000002</cx:pt>
          <cx:pt idx="338">392.49599999999998</cx:pt>
          <cx:pt idx="339">352.88799999999998</cx:pt>
          <cx:pt idx="340">325.30900000000003</cx:pt>
          <cx:pt idx="341">371.09800000000001</cx:pt>
          <cx:pt idx="342">361.36799999999999</cx:pt>
          <cx:pt idx="343">388.17500000000001</cx:pt>
          <cx:pt idx="344">347.99099999999999</cx:pt>
          <cx:pt idx="345">322.06700000000001</cx:pt>
          <cx:pt idx="346">291.87700000000001</cx:pt>
          <cx:pt idx="347">343.19400000000002</cx:pt>
          <cx:pt idx="348">396.017</cx:pt>
          <cx:pt idx="349">435.05500000000001</cx:pt>
          <cx:pt idx="350">365.79300000000001</cx:pt>
          <cx:pt idx="351">337.57499999999999</cx:pt>
          <cx:pt idx="352">370.41699999999997</cx:pt>
          <cx:pt idx="353">332.84199999999998</cx:pt>
          <cx:pt idx="354">322.029</cx:pt>
          <cx:pt idx="355">406.45499999999998</cx:pt>
          <cx:pt idx="356">422.75900000000001</cx:pt>
          <cx:pt idx="357">342.35599999999999</cx:pt>
          <cx:pt idx="358">327.57900000000001</cx:pt>
          <cx:pt idx="359">334.94</cx:pt>
          <cx:pt idx="360">310.84699999999998</cx:pt>
          <cx:pt idx="361">318.66899999999998</cx:pt>
          <cx:pt idx="362">338.93900000000002</cx:pt>
          <cx:pt idx="363">357.846</cx:pt>
          <cx:pt idx="364">381.56</cx:pt>
          <cx:pt idx="365">356.94299999999998</cx:pt>
          <cx:pt idx="366">343.25700000000001</cx:pt>
          <cx:pt idx="367">369.80399999999997</cx:pt>
          <cx:pt idx="368">282.70299999999997</cx:pt>
          <cx:pt idx="369">357.846</cx:pt>
          <cx:pt idx="370">393.88799999999998</cx:pt>
          <cx:pt idx="371">354.89100000000002</cx:pt>
          <cx:pt idx="372">318.01499999999999</cx:pt>
          <cx:pt idx="373">325.63200000000001</cx:pt>
          <cx:pt idx="374">246.69900000000001</cx:pt>
          <cx:pt idx="375">312.23599999999999</cx:pt>
          <cx:pt idx="376">357.846</cx:pt>
          <cx:pt idx="377">438.35199999999998</cx:pt>
          <cx:pt idx="378">325.49700000000001</cx:pt>
          <cx:pt idx="379">357.846</cx:pt>
          <cx:pt idx="380">371.39299999999997</cx:pt>
          <cx:pt idx="381">403.04899999999998</cx:pt>
          <cx:pt idx="382">345.78500000000003</cx:pt>
          <cx:pt idx="383">345.96899999999999</cx:pt>
          <cx:pt idx="384">277.54500000000002</cx:pt>
          <cx:pt idx="385">305.37900000000002</cx:pt>
          <cx:pt idx="386">357.82999999999998</cx:pt>
          <cx:pt idx="387">325.495</cx:pt>
          <cx:pt idx="388">347.83999999999997</cx:pt>
          <cx:pt idx="389">308.72300000000001</cx:pt>
          <cx:pt idx="390">321.62200000000001</cx:pt>
          <cx:pt idx="391">366.80599999999998</cx:pt>
          <cx:pt idx="392">347.15800000000002</cx:pt>
          <cx:pt idx="393">341.75200000000001</cx:pt>
          <cx:pt idx="394">357.846</cx:pt>
          <cx:pt idx="395">405.97199999999998</cx:pt>
          <cx:pt idx="396">363.17000000000002</cx:pt>
          <cx:pt idx="397">351.30900000000003</cx:pt>
          <cx:pt idx="398">348.58100000000002</cx:pt>
          <cx:pt idx="399">337.45499999999998</cx:pt>
          <cx:pt idx="400">332.21100000000001</cx:pt>
          <cx:pt idx="401">357.846</cx:pt>
          <cx:pt idx="402">321.471</cx:pt>
          <cx:pt idx="403">306.66199999999998</cx:pt>
          <cx:pt idx="404">382.33100000000002</cx:pt>
          <cx:pt idx="405">337.65600000000001</cx:pt>
          <cx:pt idx="406">340.74599999999998</cx:pt>
          <cx:pt idx="407">365.05099999999999</cx:pt>
          <cx:pt idx="408">337.51799999999997</cx:pt>
          <cx:pt idx="409">346.42500000000001</cx:pt>
          <cx:pt idx="410">382.88200000000001</cx:pt>
          <cx:pt idx="411">342.81400000000002</cx:pt>
          <cx:pt idx="412">364.83999999999997</cx:pt>
          <cx:pt idx="413">324.50599999999997</cx:pt>
          <cx:pt idx="414">420.87200000000001</cx:pt>
          <cx:pt idx="415">350.255</cx:pt>
          <cx:pt idx="416">375.08199999999999</cx:pt>
          <cx:pt idx="417">297.59699999999998</cx:pt>
          <cx:pt idx="418">379.322</cx:pt>
          <cx:pt idx="419">390.71699999999998</cx:pt>
          <cx:pt idx="420">369.43299999999999</cx:pt>
          <cx:pt idx="421">351.43900000000002</cx:pt>
          <cx:pt idx="422">383.50400000000002</cx:pt>
          <cx:pt idx="423">330.03899999999999</cx:pt>
          <cx:pt idx="424">286.096</cx:pt>
          <cx:pt idx="425">295.63099999999997</cx:pt>
          <cx:pt idx="426">355.43900000000002</cx:pt>
          <cx:pt idx="427">346.971</cx:pt>
          <cx:pt idx="428">306.80599999999998</cx:pt>
          <cx:pt idx="429">387.55000000000001</cx:pt>
          <cx:pt idx="430">346.40100000000001</cx:pt>
          <cx:pt idx="431">232.44800000000001</cx:pt>
          <cx:pt idx="432">329.67899999999997</cx:pt>
          <cx:pt idx="433">336.04700000000003</cx:pt>
          <cx:pt idx="434">349.33999999999997</cx:pt>
          <cx:pt idx="435">346.21899999999999</cx:pt>
          <cx:pt idx="436">389.47500000000002</cx:pt>
          <cx:pt idx="437">353.923</cx:pt>
          <cx:pt idx="438">337.65899999999999</cx:pt>
          <cx:pt idx="439">364.30099999999999</cx:pt>
          <cx:pt idx="440">323.61000000000001</cx:pt>
          <cx:pt idx="441">380.17099999999999</cx:pt>
          <cx:pt idx="442">274.79199999999997</cx:pt>
          <cx:pt idx="443">357.846</cx:pt>
          <cx:pt idx="444">393.25599999999997</cx:pt>
          <cx:pt idx="445">371.50299999999999</cx:pt>
          <cx:pt idx="446">355.71600000000001</cx:pt>
          <cx:pt idx="447">310.08999999999997</cx:pt>
          <cx:pt idx="448">374.608</cx:pt>
          <cx:pt idx="449">353.38799999999998</cx:pt>
          <cx:pt idx="450">367.505</cx:pt>
          <cx:pt idx="451">377.10000000000002</cx:pt>
          <cx:pt idx="452">325.23700000000002</cx:pt>
          <cx:pt idx="453">259.91199999999998</cx:pt>
          <cx:pt idx="454">321.21499999999997</cx:pt>
          <cx:pt idx="455">295.19600000000003</cx:pt>
          <cx:pt idx="456">324.50299999999999</cx:pt>
          <cx:pt idx="457">340.17700000000002</cx:pt>
          <cx:pt idx="458">333.14499999999998</cx:pt>
          <cx:pt idx="459">351.11500000000001</cx:pt>
          <cx:pt idx="460">346.548</cx:pt>
          <cx:pt idx="461">363.39800000000002</cx:pt>
          <cx:pt idx="462">242.363</cx:pt>
          <cx:pt idx="463">367.63</cx:pt>
          <cx:pt idx="464">341.14999999999998</cx:pt>
          <cx:pt idx="465">340.88400000000001</cx:pt>
          <cx:pt idx="466">341.50900000000001</cx:pt>
          <cx:pt idx="467">395.94999999999999</cx:pt>
          <cx:pt idx="468">409.43900000000002</cx:pt>
          <cx:pt idx="469">297.14499999999998</cx:pt>
          <cx:pt idx="470">362.99200000000002</cx:pt>
          <cx:pt idx="471">335.75999999999999</cx:pt>
          <cx:pt idx="472">336.19200000000001</cx:pt>
          <cx:pt idx="473">436.53300000000002</cx:pt>
          <cx:pt idx="474">331.01499999999999</cx:pt>
          <cx:pt idx="475">419.00900000000001</cx:pt>
          <cx:pt idx="476">241.69900000000001</cx:pt>
          <cx:pt idx="477">274.976</cx:pt>
          <cx:pt idx="478">389.56400000000002</cx:pt>
          <cx:pt idx="479">405.61700000000002</cx:pt>
          <cx:pt idx="480">346.709</cx:pt>
          <cx:pt idx="481">359.69499999999999</cx:pt>
          <cx:pt idx="482">349.12299999999999</cx:pt>
          <cx:pt idx="483">332.63999999999999</cx:pt>
          <cx:pt idx="484">357.846</cx:pt>
          <cx:pt idx="485">339.60300000000001</cx:pt>
          <cx:pt idx="486">374.13200000000001</cx:pt>
          <cx:pt idx="487">358.77600000000001</cx:pt>
          <cx:pt idx="488">405.66000000000003</cx:pt>
          <cx:pt idx="489">396.22199999999998</cx:pt>
          <cx:pt idx="490">357.846</cx:pt>
          <cx:pt idx="491">338.13200000000001</cx:pt>
          <cx:pt idx="492">334.84300000000002</cx:pt>
          <cx:pt idx="493">312.23000000000002</cx:pt>
          <cx:pt idx="494">401.35000000000002</cx:pt>
          <cx:pt idx="495">356.44799999999998</cx:pt>
          <cx:pt idx="496">346.98599999999999</cx:pt>
          <cx:pt idx="497">408.59300000000002</cx:pt>
          <cx:pt idx="498">332.505</cx:pt>
          <cx:pt idx="499">402.23000000000002</cx:pt>
          <cx:pt idx="500">366.38499999999999</cx:pt>
          <cx:pt idx="501">374.33600000000001</cx:pt>
          <cx:pt idx="502">418.58499999999998</cx:pt>
          <cx:pt idx="503">333.98700000000002</cx:pt>
          <cx:pt idx="504">318.56400000000002</cx:pt>
          <cx:pt idx="505">368.678</cx:pt>
          <cx:pt idx="506">365.89600000000002</cx:pt>
          <cx:pt idx="507">337.18900000000002</cx:pt>
          <cx:pt idx="508">357.846</cx:pt>
          <cx:pt idx="509">404.42399999999998</cx:pt>
          <cx:pt idx="510">357.846</cx:pt>
          <cx:pt idx="511">360.52699999999999</cx:pt>
          <cx:pt idx="512">360.00900000000001</cx:pt>
          <cx:pt idx="513">358.19099999999997</cx:pt>
          <cx:pt idx="514">323.31299999999999</cx:pt>
          <cx:pt idx="515">358.01100000000002</cx:pt>
          <cx:pt idx="516">317.77300000000002</cx:pt>
          <cx:pt idx="517">320.88600000000002</cx:pt>
          <cx:pt idx="518">379.13099999999997</cx:pt>
          <cx:pt idx="519">341.39699999999999</cx:pt>
          <cx:pt idx="520">336.45600000000002</cx:pt>
          <cx:pt idx="521">354.84300000000002</cx:pt>
          <cx:pt idx="522">334.70699999999999</cx:pt>
          <cx:pt idx="523">357.846</cx:pt>
          <cx:pt idx="524">333.178</cx:pt>
          <cx:pt idx="525">418.065</cx:pt>
          <cx:pt idx="526">425.88900000000001</cx:pt>
          <cx:pt idx="527">354.56</cx:pt>
          <cx:pt idx="528">389.73000000000002</cx:pt>
          <cx:pt idx="529">383.81</cx:pt>
          <cx:pt idx="530">301.23899999999998</cx:pt>
          <cx:pt idx="531">348.29199999999997</cx:pt>
          <cx:pt idx="532">294.95699999999999</cx:pt>
          <cx:pt idx="533">411.553</cx:pt>
          <cx:pt idx="534">328.50599999999997</cx:pt>
          <cx:pt idx="535">334.54899999999998</cx:pt>
          <cx:pt idx="536">343.18099999999998</cx:pt>
          <cx:pt idx="537">328.34100000000001</cx:pt>
          <cx:pt idx="538">358.39699999999999</cx:pt>
          <cx:pt idx="539">346.96899999999999</cx:pt>
          <cx:pt idx="540">355.26600000000002</cx:pt>
          <cx:pt idx="541">375.39999999999998</cx:pt>
          <cx:pt idx="542">370.32999999999998</cx:pt>
          <cx:pt idx="543">324.29399999999998</cx:pt>
          <cx:pt idx="544">345.80200000000002</cx:pt>
          <cx:pt idx="545">399.15499999999997</cx:pt>
          <cx:pt idx="546">350.88</cx:pt>
          <cx:pt idx="547">381.67000000000002</cx:pt>
          <cx:pt idx="548">356.17899999999997</cx:pt>
          <cx:pt idx="549">407.06099999999998</cx:pt>
          <cx:pt idx="550">396.24299999999999</cx:pt>
          <cx:pt idx="551">316.71800000000002</cx:pt>
          <cx:pt idx="552">393.11099999999999</cx:pt>
          <cx:pt idx="553">344.19299999999998</cx:pt>
          <cx:pt idx="554">427.74000000000001</cx:pt>
          <cx:pt idx="555">331.60000000000002</cx:pt>
          <cx:pt idx="556">375.04899999999998</cx:pt>
          <cx:pt idx="557">351.95299999999997</cx:pt>
          <cx:pt idx="558">459.92500000000001</cx:pt>
          <cx:pt idx="559">293.25799999999998</cx:pt>
          <cx:pt idx="560">362.452</cx:pt>
          <cx:pt idx="561">320.33199999999999</cx:pt>
          <cx:pt idx="562">336.40699999999998</cx:pt>
          <cx:pt idx="563">330.17899999999997</cx:pt>
          <cx:pt idx="564">379.35500000000002</cx:pt>
          <cx:pt idx="565">355.964</cx:pt>
          <cx:pt idx="566">370.41199999999998</cx:pt>
          <cx:pt idx="567">374.89499999999998</cx:pt>
          <cx:pt idx="568">341.928</cx:pt>
          <cx:pt idx="569">343.45600000000002</cx:pt>
          <cx:pt idx="570">398.363</cx:pt>
          <cx:pt idx="571">296.35899999999998</cx:pt>
          <cx:pt idx="572">380.53899999999999</cx:pt>
          <cx:pt idx="573">334.49700000000001</cx:pt>
          <cx:pt idx="574">381.55799999999999</cx:pt>
          <cx:pt idx="575">354.23899999999998</cx:pt>
          <cx:pt idx="576">346.26999999999998</cx:pt>
          <cx:pt idx="577">366.44</cx:pt>
          <cx:pt idx="578">353.92599999999999</cx:pt>
          <cx:pt idx="579">352.11700000000002</cx:pt>
          <cx:pt idx="580">305.59500000000003</cx:pt>
          <cx:pt idx="581">404.47199999999998</cx:pt>
          <cx:pt idx="582">360.41800000000001</cx:pt>
          <cx:pt idx="583">367.31999999999999</cx:pt>
          <cx:pt idx="584">257.464</cx:pt>
          <cx:pt idx="585">369.08699999999999</cx:pt>
          <cx:pt idx="586">355.411</cx:pt>
          <cx:pt idx="587">350.464</cx:pt>
          <cx:pt idx="588">341.54000000000002</cx:pt>
          <cx:pt idx="589">368.834</cx:pt>
          <cx:pt idx="590">364.79000000000002</cx:pt>
          <cx:pt idx="591">325.06</cx:pt>
          <cx:pt idx="592">352.79599999999999</cx:pt>
          <cx:pt idx="593">319.97800000000001</cx:pt>
          <cx:pt idx="594">375.60399999999998</cx:pt>
          <cx:pt idx="595">369.952</cx:pt>
          <cx:pt idx="596">372.88499999999999</cx:pt>
          <cx:pt idx="597">388.56900000000002</cx:pt>
          <cx:pt idx="598">331.34500000000003</cx:pt>
          <cx:pt idx="599">298.411</cx:pt>
          <cx:pt idx="600">417.42700000000002</cx:pt>
          <cx:pt idx="601">300.14800000000002</cx:pt>
          <cx:pt idx="602">309.75799999999998</cx:pt>
          <cx:pt idx="603">244.18600000000001</cx:pt>
          <cx:pt idx="604">392.44400000000002</cx:pt>
          <cx:pt idx="605">305.98200000000003</cx:pt>
          <cx:pt idx="606">385.02600000000001</cx:pt>
          <cx:pt idx="607">341.40699999999998</cx:pt>
          <cx:pt idx="608">316.447</cx:pt>
          <cx:pt idx="609">336.09500000000003</cx:pt>
          <cx:pt idx="610">354.178</cx:pt>
          <cx:pt idx="611">373.14999999999998</cx:pt>
          <cx:pt idx="612">366.06599999999997</cx:pt>
          <cx:pt idx="613">303.92500000000001</cx:pt>
          <cx:pt idx="614">345.04500000000002</cx:pt>
          <cx:pt idx="615">331.03300000000002</cx:pt>
          <cx:pt idx="616">418.70299999999997</cx:pt>
          <cx:pt idx="617">379.036</cx:pt>
          <cx:pt idx="618">350.57600000000002</cx:pt>
          <cx:pt idx="619">435.71600000000001</cx:pt>
          <cx:pt idx="620">342.08600000000001</cx:pt>
          <cx:pt idx="621">334.435</cx:pt>
          <cx:pt idx="622">408.78500000000003</cx:pt>
          <cx:pt idx="623">374.89800000000002</cx:pt>
          <cx:pt idx="624">336.22399999999999</cx:pt>
          <cx:pt idx="625">367.82999999999998</cx:pt>
          <cx:pt idx="626">373.54199999999997</cx:pt>
          <cx:pt idx="627">352.351</cx:pt>
          <cx:pt idx="628">361.69999999999999</cx:pt>
          <cx:pt idx="629">361.02999999999997</cx:pt>
          <cx:pt idx="630">345.50700000000001</cx:pt>
          <cx:pt idx="631">409.16500000000002</cx:pt>
          <cx:pt idx="632">322.20299999999997</cx:pt>
          <cx:pt idx="633">316.83800000000002</cx:pt>
          <cx:pt idx="634">335.97399999999999</cx:pt>
          <cx:pt idx="635">259.69499999999999</cx:pt>
          <cx:pt idx="636">388.22500000000002</cx:pt>
          <cx:pt idx="637">372.54199999999997</cx:pt>
          <cx:pt idx="638">354.15699999999998</cx:pt>
          <cx:pt idx="639">338.15499999999997</cx:pt>
          <cx:pt idx="640">407.471</cx:pt>
          <cx:pt idx="641">354.721</cx:pt>
          <cx:pt idx="642">362.89499999999998</cx:pt>
          <cx:pt idx="643">358.27699999999999</cx:pt>
          <cx:pt idx="644">358.36799999999999</cx:pt>
          <cx:pt idx="645">396.96300000000002</cx:pt>
          <cx:pt idx="646">350.988</cx:pt>
          <cx:pt idx="647">340.30900000000003</cx:pt>
          <cx:pt idx="648">344.54399999999998</cx:pt>
          <cx:pt idx="649">361.59800000000001</cx:pt>
          <cx:pt idx="650">298.72699999999998</cx:pt>
          <cx:pt idx="651">340.666</cx:pt>
          <cx:pt idx="652">257.94900000000001</cx:pt>
          <cx:pt idx="653">373.12799999999999</cx:pt>
          <cx:pt idx="654">397.48700000000002</cx:pt>
          <cx:pt idx="655">341.363</cx:pt>
          <cx:pt idx="656">343.33999999999997</cx:pt>
          <cx:pt idx="657">311.19900000000001</cx:pt>
          <cx:pt idx="658">346.18400000000003</cx:pt>
          <cx:pt idx="659">378.529</cx:pt>
          <cx:pt idx="660">299.68799999999999</cx:pt>
          <cx:pt idx="661">353.43599999999998</cx:pt>
          <cx:pt idx="662">356.21699999999998</cx:pt>
          <cx:pt idx="663">350.685</cx:pt>
          <cx:pt idx="664">407.67899999999997</cx:pt>
          <cx:pt idx="665">379.63400000000001</cx:pt>
          <cx:pt idx="666">360.77499999999998</cx:pt>
          <cx:pt idx="667">354.12599999999998</cx:pt>
          <cx:pt idx="668">365.22000000000003</cx:pt>
          <cx:pt idx="669">407.14999999999998</cx:pt>
          <cx:pt idx="670">399.89600000000002</cx:pt>
          <cx:pt idx="671">423.79500000000002</cx:pt>
          <cx:pt idx="672">338.10899999999998</cx:pt>
          <cx:pt idx="673">357.846</cx:pt>
          <cx:pt idx="674">352.61399999999998</cx:pt>
          <cx:pt idx="675">346.92700000000002</cx:pt>
          <cx:pt idx="676">348.512</cx:pt>
          <cx:pt idx="677">422.33100000000002</cx:pt>
          <cx:pt idx="678">357.846</cx:pt>
          <cx:pt idx="679">283.29599999999999</cx:pt>
          <cx:pt idx="680">402.334</cx:pt>
          <cx:pt idx="681">380.27300000000002</cx:pt>
          <cx:pt idx="682">350.98099999999999</cx:pt>
          <cx:pt idx="683">340.68599999999998</cx:pt>
          <cx:pt idx="684">326.59500000000003</cx:pt>
          <cx:pt idx="685">294.06900000000002</cx:pt>
          <cx:pt idx="686">372.57999999999998</cx:pt>
          <cx:pt idx="687">357.846</cx:pt>
          <cx:pt idx="688">334.137</cx:pt>
          <cx:pt idx="689">363.89299999999997</cx:pt>
          <cx:pt idx="690">336.733</cx:pt>
          <cx:pt idx="691">253.25299999999999</cx:pt>
          <cx:pt idx="692">384.66500000000002</cx:pt>
          <cx:pt idx="693">334.05099999999999</cx:pt>
          <cx:pt idx="694">349.75900000000001</cx:pt>
          <cx:pt idx="695">338.26900000000001</cx:pt>
          <cx:pt idx="696">392.173</cx:pt>
          <cx:pt idx="697">310.74799999999999</cx:pt>
          <cx:pt idx="698">365.98399999999998</cx:pt>
          <cx:pt idx="699">366.03800000000001</cx:pt>
          <cx:pt idx="700">374.11900000000003</cx:pt>
          <cx:pt idx="701">333.47699999999998</cx:pt>
          <cx:pt idx="702">252.404</cx:pt>
          <cx:pt idx="703">350.69900000000001</cx:pt>
          <cx:pt idx="704">339.59100000000001</cx:pt>
          <cx:pt idx="705">383.161</cx:pt>
          <cx:pt idx="706">357.846</cx:pt>
          <cx:pt idx="707">357.846</cx:pt>
          <cx:pt idx="708">359.05900000000003</cx:pt>
          <cx:pt idx="709">359.29899999999998</cx:pt>
          <cx:pt idx="710">357.846</cx:pt>
          <cx:pt idx="711">357.846</cx:pt>
          <cx:pt idx="712">320.94299999999998</cx:pt>
          <cx:pt idx="713">364.09899999999999</cx:pt>
          <cx:pt idx="714">385.19299999999998</cx:pt>
          <cx:pt idx="715">355.46300000000002</cx:pt>
          <cx:pt idx="716">368.83199999999999</cx:pt>
          <cx:pt idx="717">369.279</cx:pt>
          <cx:pt idx="718">399.75</cx:pt>
          <cx:pt idx="719">353.69200000000001</cx:pt>
          <cx:pt idx="720">241.989</cx:pt>
          <cx:pt idx="721">347.79300000000001</cx:pt>
          <cx:pt idx="722">352.22000000000003</cx:pt>
          <cx:pt idx="723">325.07999999999998</cx:pt>
          <cx:pt idx="724">333.94200000000001</cx:pt>
          <cx:pt idx="725">322.46499999999997</cx:pt>
          <cx:pt idx="726">399.30099999999999</cx:pt>
          <cx:pt idx="727">369.20400000000001</cx:pt>
          <cx:pt idx="728">322.15499999999997</cx:pt>
          <cx:pt idx="729">343.67500000000001</cx:pt>
          <cx:pt idx="730">388.35700000000003</cx:pt>
          <cx:pt idx="731">316.447</cx:pt>
          <cx:pt idx="732">315.66800000000001</cx:pt>
          <cx:pt idx="733">358.87400000000002</cx:pt>
          <cx:pt idx="734">352.084</cx:pt>
          <cx:pt idx="735">387.40600000000001</cx:pt>
          <cx:pt idx="736">423.142</cx:pt>
          <cx:pt idx="737">335.79300000000001</cx:pt>
          <cx:pt idx="738">357.846</cx:pt>
          <cx:pt idx="739">387.61900000000003</cx:pt>
          <cx:pt idx="740">392.733</cx:pt>
          <cx:pt idx="741">349.87599999999998</cx:pt>
          <cx:pt idx="742">284.88900000000001</cx:pt>
          <cx:pt idx="743">371.17500000000001</cx:pt>
          <cx:pt idx="744">366.93400000000003</cx:pt>
          <cx:pt idx="745">344.21699999999998</cx:pt>
          <cx:pt idx="746">330.92000000000002</cx:pt>
          <cx:pt idx="747">379.99799999999999</cx:pt>
          <cx:pt idx="748">319.73599999999999</cx:pt>
          <cx:pt idx="749">424.27800000000002</cx:pt>
          <cx:pt idx="750">365.14699999999999</cx:pt>
          <cx:pt idx="751">317.55099999999999</cx:pt>
          <cx:pt idx="752">409.64299999999997</cx:pt>
          <cx:pt idx="753">390.916</cx:pt>
          <cx:pt idx="754">367.79399999999998</cx:pt>
          <cx:pt idx="755">408.16699999999997</cx:pt>
          <cx:pt idx="756">341.565</cx:pt>
          <cx:pt idx="757">374.28899999999999</cx:pt>
          <cx:pt idx="758">349.73200000000003</cx:pt>
          <cx:pt idx="759">281.45999999999998</cx:pt>
          <cx:pt idx="760">334.07100000000003</cx:pt>
          <cx:pt idx="761">302.31799999999998</cx:pt>
          <cx:pt idx="762">358.40100000000001</cx:pt>
          <cx:pt idx="763">371.41800000000001</cx:pt>
          <cx:pt idx="764">376.85399999999998</cx:pt>
          <cx:pt idx="765">335.79700000000003</cx:pt>
          <cx:pt idx="766">357.846</cx:pt>
          <cx:pt idx="767">422.69400000000002</cx:pt>
          <cx:pt idx="768">341.19299999999998</cx:pt>
          <cx:pt idx="769">413.88400000000001</cx:pt>
          <cx:pt idx="770">322.44200000000001</cx:pt>
          <cx:pt idx="771">329.81</cx:pt>
          <cx:pt idx="772">357.846</cx:pt>
          <cx:pt idx="773">329.36099999999999</cx:pt>
          <cx:pt idx="774">330.05500000000001</cx:pt>
          <cx:pt idx="775">357.92000000000002</cx:pt>
          <cx:pt idx="776">319.375</cx:pt>
          <cx:pt idx="777">329.61900000000003</cx:pt>
          <cx:pt idx="778">371.28500000000003</cx:pt>
          <cx:pt idx="779">324.60399999999998</cx:pt>
          <cx:pt idx="780">314.97500000000002</cx:pt>
          <cx:pt idx="781">320.93099999999998</cx:pt>
          <cx:pt idx="782">383.81400000000002</cx:pt>
          <cx:pt idx="783">346.46300000000002</cx:pt>
          <cx:pt idx="784">386.23599999999999</cx:pt>
          <cx:pt idx="785">331.99400000000003</cx:pt>
          <cx:pt idx="786">377.10300000000001</cx:pt>
          <cx:pt idx="787">318.096</cx:pt>
          <cx:pt idx="788">293.16500000000002</cx:pt>
          <cx:pt idx="789">330.18000000000001</cx:pt>
          <cx:pt idx="790">402.55099999999999</cx:pt>
          <cx:pt idx="791">370.85899999999998</cx:pt>
          <cx:pt idx="792">367.50900000000001</cx:pt>
          <cx:pt idx="793">337.87</cx:pt>
          <cx:pt idx="794">355.67099999999999</cx:pt>
          <cx:pt idx="795">357.846</cx:pt>
          <cx:pt idx="796">295.33999999999997</cx:pt>
          <cx:pt idx="797">360.79199999999997</cx:pt>
          <cx:pt idx="798">391.61399999999998</cx:pt>
          <cx:pt idx="799">360.63799999999998</cx:pt>
          <cx:pt idx="800">372.05900000000003</cx:pt>
          <cx:pt idx="801">386.71100000000001</cx:pt>
          <cx:pt idx="802">287.42500000000001</cx:pt>
          <cx:pt idx="803">353.44299999999998</cx:pt>
          <cx:pt idx="804">320.32100000000003</cx:pt>
          <cx:pt idx="805">318.274</cx:pt>
          <cx:pt idx="806">389.88</cx:pt>
          <cx:pt idx="807">377.99000000000001</cx:pt>
          <cx:pt idx="808">332.50799999999998</cx:pt>
          <cx:pt idx="809">349.24700000000001</cx:pt>
          <cx:pt idx="810">387.07299999999998</cx:pt>
          <cx:pt idx="811">262.96800000000002</cx:pt>
          <cx:pt idx="812">362.71100000000001</cx:pt>
          <cx:pt idx="813">332.60700000000003</cx:pt>
          <cx:pt idx="814">355.762</cx:pt>
          <cx:pt idx="815">401.97199999999998</cx:pt>
          <cx:pt idx="816">364.572</cx:pt>
          <cx:pt idx="817">432.08199999999999</cx:pt>
          <cx:pt idx="818">395.49799999999999</cx:pt>
          <cx:pt idx="819">377.11900000000003</cx:pt>
          <cx:pt idx="820">359.97199999999998</cx:pt>
          <cx:pt idx="821">297.298</cx:pt>
          <cx:pt idx="822">338.209</cx:pt>
          <cx:pt idx="823">370.35700000000003</cx:pt>
          <cx:pt idx="824">344.601</cx:pt>
          <cx:pt idx="825">373.81200000000001</cx:pt>
          <cx:pt idx="826">333.63</cx:pt>
          <cx:pt idx="827">338.11799999999999</cx:pt>
          <cx:pt idx="828">371.185</cx:pt>
          <cx:pt idx="829">357.846</cx:pt>
          <cx:pt idx="830">396.30700000000002</cx:pt>
          <cx:pt idx="831">387.96499999999997</cx:pt>
          <cx:pt idx="832">362.66500000000002</cx:pt>
          <cx:pt idx="833">318.892</cx:pt>
          <cx:pt idx="834">429.245</cx:pt>
          <cx:pt idx="835">238.917</cx:pt>
          <cx:pt idx="836">381.35700000000003</cx:pt>
          <cx:pt idx="837">324.09100000000001</cx:pt>
          <cx:pt idx="838">336.75400000000002</cx:pt>
          <cx:pt idx="839">338.72699999999998</cx:pt>
          <cx:pt idx="840">352.42599999999999</cx:pt>
          <cx:pt idx="841">400.90800000000002</cx:pt>
          <cx:pt idx="842">357.846</cx:pt>
          <cx:pt idx="843">325.161</cx:pt>
          <cx:pt idx="844">309.14100000000002</cx:pt>
          <cx:pt idx="845">354.70100000000002</cx:pt>
          <cx:pt idx="846">331.74200000000002</cx:pt>
          <cx:pt idx="847">362.19799999999998</cx:pt>
          <cx:pt idx="848">360.94099999999997</cx:pt>
          <cx:pt idx="849">361.30099999999999</cx:pt>
          <cx:pt idx="850">343.23599999999999</cx:pt>
          <cx:pt idx="851">357.73200000000003</cx:pt>
          <cx:pt idx="852">365.46300000000002</cx:pt>
          <cx:pt idx="853">386.39699999999999</cx:pt>
          <cx:pt idx="854">370.029</cx:pt>
          <cx:pt idx="855">343.73000000000002</cx:pt>
          <cx:pt idx="856">374.76999999999998</cx:pt>
          <cx:pt idx="857">377.99000000000001</cx:pt>
          <cx:pt idx="858">359.42599999999999</cx:pt>
          <cx:pt idx="859">379.61900000000003</cx:pt>
          <cx:pt idx="860">357.846</cx:pt>
          <cx:pt idx="861">353.17700000000002</cx:pt>
          <cx:pt idx="862">329.13900000000001</cx:pt>
          <cx:pt idx="863">374.00099999999998</cx:pt>
          <cx:pt idx="864">367.09500000000003</cx:pt>
          <cx:pt idx="865">289.52999999999997</cx:pt>
          <cx:pt idx="866">334.88200000000001</cx:pt>
          <cx:pt idx="867">363.56099999999998</cx:pt>
          <cx:pt idx="868">376.57900000000001</cx:pt>
          <cx:pt idx="869">403.11500000000001</cx:pt>
          <cx:pt idx="870">388.82400000000001</cx:pt>
          <cx:pt idx="871">372.214</cx:pt>
          <cx:pt idx="872">270.08999999999997</cx:pt>
          <cx:pt idx="873">359.01499999999999</cx:pt>
          <cx:pt idx="874">366.96300000000002</cx:pt>
          <cx:pt idx="875">357.05099999999999</cx:pt>
          <cx:pt idx="876">439.13200000000001</cx:pt>
          <cx:pt idx="877">388.27100000000002</cx:pt>
          <cx:pt idx="878">382.05599999999998</cx:pt>
          <cx:pt idx="879">397.98000000000002</cx:pt>
          <cx:pt idx="880">293.63299999999998</cx:pt>
          <cx:pt idx="881">358.22300000000001</cx:pt>
          <cx:pt idx="882">341.68799999999999</cx:pt>
          <cx:pt idx="883">352.77600000000001</cx:pt>
          <cx:pt idx="884">251.78800000000001</cx:pt>
          <cx:pt idx="885">378.32900000000001</cx:pt>
          <cx:pt idx="886">349.30500000000001</cx:pt>
          <cx:pt idx="887">300.28699999999998</cx:pt>
          <cx:pt idx="888">380.42500000000001</cx:pt>
          <cx:pt idx="889">374.24299999999999</cx:pt>
          <cx:pt idx="890">405.74200000000002</cx:pt>
          <cx:pt idx="891">342.45699999999999</cx:pt>
          <cx:pt idx="892">335.66000000000003</cx:pt>
          <cx:pt idx="893">357.846</cx:pt>
          <cx:pt idx="894">390.80799999999999</cx:pt>
          <cx:pt idx="895">390.83800000000002</cx:pt>
          <cx:pt idx="896">357.846</cx:pt>
          <cx:pt idx="897">292.27100000000002</cx:pt>
          <cx:pt idx="898">357.29300000000001</cx:pt>
          <cx:pt idx="899">371.935</cx:pt>
          <cx:pt idx="900">396.40300000000002</cx:pt>
          <cx:pt idx="901">348.56599999999997</cx:pt>
          <cx:pt idx="902">358.666</cx:pt>
          <cx:pt idx="903">399.96300000000002</cx:pt>
          <cx:pt idx="904">308.36799999999999</cx:pt>
          <cx:pt idx="905">345.50999999999999</cx:pt>
          <cx:pt idx="906">337.04399999999998</cx:pt>
          <cx:pt idx="907">345.226</cx:pt>
          <cx:pt idx="908">269.70499999999998</cx:pt>
          <cx:pt idx="909">322.01900000000001</cx:pt>
          <cx:pt idx="910">402.245</cx:pt>
          <cx:pt idx="911">378.87799999999999</cx:pt>
          <cx:pt idx="912">362.09699999999998</cx:pt>
          <cx:pt idx="913">356.16899999999998</cx:pt>
          <cx:pt idx="914">394.11900000000003</cx:pt>
          <cx:pt idx="915">317.31400000000002</cx:pt>
          <cx:pt idx="916">376.57900000000001</cx:pt>
          <cx:pt idx="917">345.54199999999997</cx:pt>
          <cx:pt idx="918">401.01600000000002</cx:pt>
          <cx:pt idx="919">333.36900000000003</cx:pt>
          <cx:pt idx="920">399.37599999999998</cx:pt>
          <cx:pt idx="921">347.39600000000002</cx:pt>
          <cx:pt idx="922">382.03100000000001</cx:pt>
          <cx:pt idx="923">326.24299999999999</cx:pt>
          <cx:pt idx="924">344.23899999999998</cx:pt>
          <cx:pt idx="925">387.87099999999998</cx:pt>
          <cx:pt idx="926">338.38400000000001</cx:pt>
          <cx:pt idx="927">396.38400000000001</cx:pt>
          <cx:pt idx="928">306.23899999999998</cx:pt>
          <cx:pt idx="929">410.87900000000002</cx:pt>
          <cx:pt idx="930">271.416</cx:pt>
          <cx:pt idx="931">358.44799999999998</cx:pt>
          <cx:pt idx="932">338.05799999999999</cx:pt>
          <cx:pt idx="933">244.107</cx:pt>
          <cx:pt idx="934">355.88099999999997</cx:pt>
          <cx:pt idx="935">270.505</cx:pt>
          <cx:pt idx="936">329.03500000000003</cx:pt>
          <cx:pt idx="937">335.72500000000002</cx:pt>
          <cx:pt idx="938">375.96600000000001</cx:pt>
          <cx:pt idx="939">332.00099999999998</cx:pt>
          <cx:pt idx="940">341.66000000000003</cx:pt>
          <cx:pt idx="941">368.36599999999999</cx:pt>
          <cx:pt idx="942">353.83999999999997</cx:pt>
          <cx:pt idx="943">326.25700000000001</cx:pt>
          <cx:pt idx="944">351.49900000000002</cx:pt>
          <cx:pt idx="945">349.89299999999997</cx:pt>
          <cx:pt idx="946">341.57900000000001</cx:pt>
          <cx:pt idx="947">398.34199999999998</cx:pt>
          <cx:pt idx="948">357.35199999999998</cx:pt>
          <cx:pt idx="949">359.93799999999999</cx:pt>
          <cx:pt idx="950">358.69799999999998</cx:pt>
          <cx:pt idx="951">405.68599999999998</cx:pt>
          <cx:pt idx="952">383.62</cx:pt>
          <cx:pt idx="953">371.15300000000002</cx:pt>
          <cx:pt idx="954">349.95100000000002</cx:pt>
          <cx:pt idx="955">370.108</cx:pt>
          <cx:pt idx="956">339.15699999999998</cx:pt>
          <cx:pt idx="957">387.82400000000001</cx:pt>
          <cx:pt idx="958">372.60599999999999</cx:pt>
          <cx:pt idx="959">389.97000000000003</cx:pt>
          <cx:pt idx="960">381.40699999999998</cx:pt>
          <cx:pt idx="961">336.72500000000002</cx:pt>
          <cx:pt idx="962">361.48200000000003</cx:pt>
          <cx:pt idx="963">307.88299999999998</cx:pt>
          <cx:pt idx="964">339.65699999999998</cx:pt>
          <cx:pt idx="965">357.846</cx:pt>
          <cx:pt idx="966">360.65600000000001</cx:pt>
          <cx:pt idx="967">360.11599999999999</cx:pt>
          <cx:pt idx="968">385.42200000000003</cx:pt>
          <cx:pt idx="969">345.29500000000002</cx:pt>
          <cx:pt idx="970">342.40300000000002</cx:pt>
          <cx:pt idx="971">339.31599999999997</cx:pt>
          <cx:pt idx="972">328.69200000000001</cx:pt>
          <cx:pt idx="973">347.80599999999998</cx:pt>
          <cx:pt idx="974">372.87099999999998</cx:pt>
          <cx:pt idx="975">342.76400000000001</cx:pt>
          <cx:pt idx="976">343.91399999999999</cx:pt>
          <cx:pt idx="977">395.91500000000002</cx:pt>
          <cx:pt idx="978">358.63</cx:pt>
          <cx:pt idx="979">350.30900000000003</cx:pt>
          <cx:pt idx="980">357.846</cx:pt>
          <cx:pt idx="981">295.822</cx:pt>
          <cx:pt idx="982">349.97899999999998</cx:pt>
          <cx:pt idx="983">365.51600000000002</cx:pt>
          <cx:pt idx="984">332.83999999999997</cx:pt>
          <cx:pt idx="985">307.35000000000002</cx:pt>
          <cx:pt idx="986">429.54500000000002</cx:pt>
          <cx:pt idx="987">345.50599999999997</cx:pt>
          <cx:pt idx="988">355.93400000000003</cx:pt>
          <cx:pt idx="989">324.35199999999998</cx:pt>
          <cx:pt idx="990">402.19600000000003</cx:pt>
          <cx:pt idx="991">400.77499999999998</cx:pt>
          <cx:pt idx="992">349.77800000000002</cx:pt>
          <cx:pt idx="993">357.846</cx:pt>
          <cx:pt idx="994">404.541</cx:pt>
          <cx:pt idx="995">352.471</cx:pt>
          <cx:pt idx="996">238.452</cx:pt>
          <cx:pt idx="997">346.59399999999999</cx:pt>
          <cx:pt idx="998">364.01799999999997</cx:pt>
          <cx:pt idx="999">341.91800000000001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sz="12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200" b="0" i="0" u="none" strike="noStrike" baseline="0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V</a:t>
            </a:r>
            <a:endParaRPr lang="ja-JP" altLang="en-US" sz="1200" b="0" i="0" u="none" strike="noStrike" baseline="0">
              <a:solidFill>
                <a:sysClr val="windowText" lastClr="000000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cx:rich>
      </cx:tx>
    </cx:title>
    <cx:plotArea>
      <cx:plotAreaRegion>
        <cx:series layoutId="clusteredColumn" uniqueId="{F84E1B7A-F6C5-4191-BA21-67C089033C31}">
          <cx:tx>
            <cx:txData>
              <cx:f>PK!$C$1</cx:f>
              <cx:v>tvV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Count val="15"/>
            </cx:binning>
          </cx:layoutPr>
        </cx:series>
      </cx:plotAreaRegion>
      <cx:axis id="0">
        <cx:catScaling gapWidth="0"/>
        <cx:tickLabels/>
        <cx:numFmt formatCode="#,##0.0_);[赤](#,##0.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10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PD acute'!$J$2:$J$1001</cx:f>
        <cx:lvl ptCount="1000" formatCode="G/標準">
          <cx:pt idx="0">0.0136276</cx:pt>
          <cx:pt idx="1">0.000100127</cx:pt>
          <cx:pt idx="2">0.00042726100000000001</cx:pt>
          <cx:pt idx="3">0.000101066</cx:pt>
          <cx:pt idx="4">0.00010000099999999999</cx:pt>
          <cx:pt idx="5">0.00399724</cx:pt>
          <cx:pt idx="6">0.00010000099999999999</cx:pt>
          <cx:pt idx="7">0.00010003199999999999</cx:pt>
          <cx:pt idx="8">0.00010006299999999999</cx:pt>
          <cx:pt idx="9">0.0035605799999999998</cx:pt>
          <cx:pt idx="10">0.00010000099999999999</cx:pt>
          <cx:pt idx="11">0.0081964299999999993</cx:pt>
          <cx:pt idx="12">0.000198891</cx:pt>
          <cx:pt idx="13">0.000100009</cx:pt>
          <cx:pt idx="14">0.0001</cx:pt>
          <cx:pt idx="15">0.0072479600000000003</cx:pt>
          <cx:pt idx="16">0.00010289900000000001</cx:pt>
          <cx:pt idx="17">0.000100208</cx:pt>
          <cx:pt idx="18">0.012138400000000001</cx:pt>
          <cx:pt idx="19">0.0118242</cx:pt>
          <cx:pt idx="20">0.00012416200000000001</cx:pt>
          <cx:pt idx="21">0.0064821699999999998</cx:pt>
          <cx:pt idx="22">0.0043587699999999997</cx:pt>
          <cx:pt idx="23">0.000100115</cx:pt>
          <cx:pt idx="24">0.00096549500000000003</cx:pt>
          <cx:pt idx="25">0.0116989</cx:pt>
          <cx:pt idx="26">0.013832499999999999</cx:pt>
          <cx:pt idx="27">0.0085932100000000004</cx:pt>
          <cx:pt idx="28">0.0075470900000000002</cx:pt>
          <cx:pt idx="29">0.0058710500000000001</cx:pt>
          <cx:pt idx="30">0.0049918999999999996</cx:pt>
          <cx:pt idx="31">0.0045733400000000004</cx:pt>
          <cx:pt idx="32">0.000100015</cx:pt>
          <cx:pt idx="33">0.00308575</cx:pt>
          <cx:pt idx="34">0.0032076299999999999</cx:pt>
          <cx:pt idx="35">0.0001</cx:pt>
          <cx:pt idx="36">0.00606837</cx:pt>
          <cx:pt idx="37">0.0028877500000000001</cx:pt>
          <cx:pt idx="38">0.00374077</cx:pt>
          <cx:pt idx="39">0.0032884400000000001</cx:pt>
          <cx:pt idx="40">0.000101513</cx:pt>
          <cx:pt idx="41">0.0001</cx:pt>
          <cx:pt idx="42">0.0034076499999999999</cx:pt>
          <cx:pt idx="43">0.0089136700000000003</cx:pt>
          <cx:pt idx="44">0.000100072</cx:pt>
          <cx:pt idx="45">0.0046369200000000001</cx:pt>
          <cx:pt idx="46">0.0028620099999999999</cx:pt>
          <cx:pt idx="47">0.000100177</cx:pt>
          <cx:pt idx="48">0.0070087500000000002</cx:pt>
          <cx:pt idx="49">0.000100004</cx:pt>
          <cx:pt idx="50">0.00251929</cx:pt>
          <cx:pt idx="51">0.00060915700000000004</cx:pt>
          <cx:pt idx="52">0.0027375199999999998</cx:pt>
          <cx:pt idx="53">0.0078730399999999996</cx:pt>
          <cx:pt idx="54">0.000100009</cx:pt>
          <cx:pt idx="55">0.0001</cx:pt>
          <cx:pt idx="56">0.0129563</cx:pt>
          <cx:pt idx="57">0.0046007899999999996</cx:pt>
          <cx:pt idx="58">0.0088301300000000003</cx:pt>
          <cx:pt idx="59">0.0055548699999999999</cx:pt>
          <cx:pt idx="60">0.0042403500000000004</cx:pt>
          <cx:pt idx="61">0.0078326100000000003</cx:pt>
          <cx:pt idx="62">0.0013450700000000001</cx:pt>
          <cx:pt idx="63">0.000100002</cx:pt>
          <cx:pt idx="64">0.00039725999999999997</cx:pt>
          <cx:pt idx="65">0.000100253</cx:pt>
          <cx:pt idx="66">0.00168487</cx:pt>
          <cx:pt idx="67">0.00147846</cx:pt>
          <cx:pt idx="68">0.0063916199999999998</cx:pt>
          <cx:pt idx="69">0.000100053</cx:pt>
          <cx:pt idx="70">0.0088946900000000002</cx:pt>
          <cx:pt idx="71">0.0011266799999999999</cx:pt>
          <cx:pt idx="72">0.0095544700000000007</cx:pt>
          <cx:pt idx="73">0.0022738300000000001</cx:pt>
          <cx:pt idx="74">0.00010003799999999999</cx:pt>
          <cx:pt idx="75">0.0057443399999999997</cx:pt>
          <cx:pt idx="76">0.000101544</cx:pt>
          <cx:pt idx="77">0.0040223300000000002</cx:pt>
          <cx:pt idx="78">0.0033817999999999999</cx:pt>
          <cx:pt idx="79">0.000100079</cx:pt>
          <cx:pt idx="80">0.00010000099999999999</cx:pt>
          <cx:pt idx="81">0.000114759</cx:pt>
          <cx:pt idx="82">0.00307771</cx:pt>
          <cx:pt idx="83">0.021691499999999999</cx:pt>
          <cx:pt idx="84">0.0089687800000000008</cx:pt>
          <cx:pt idx="85">0.0081934899999999995</cx:pt>
          <cx:pt idx="86">0.0046381599999999997</cx:pt>
          <cx:pt idx="87">0.00048333399999999998</cx:pt>
          <cx:pt idx="88">0.00010001</cx:pt>
          <cx:pt idx="89">0.00010052000000000001</cx:pt>
          <cx:pt idx="90">0.0029866699999999999</cx:pt>
          <cx:pt idx="91">0.010489500000000001</cx:pt>
          <cx:pt idx="92">0.0127101</cx:pt>
          <cx:pt idx="93">0.010865400000000001</cx:pt>
          <cx:pt idx="94">0.00262261</cx:pt>
          <cx:pt idx="95">0.000100004</cx:pt>
          <cx:pt idx="96">0.000100022</cx:pt>
          <cx:pt idx="97">0.0043100400000000002</cx:pt>
          <cx:pt idx="98">0.00010190499999999999</cx:pt>
          <cx:pt idx="99">0.00719822</cx:pt>
          <cx:pt idx="100">0.0035518400000000001</cx:pt>
          <cx:pt idx="101">0.000100004</cx:pt>
          <cx:pt idx="102">0.0027189800000000002</cx:pt>
          <cx:pt idx="103">0.000100035</cx:pt>
          <cx:pt idx="104">0.000100054</cx:pt>
          <cx:pt idx="105">0.000100002</cx:pt>
          <cx:pt idx="106">0.0053995800000000002</cx:pt>
          <cx:pt idx="107">0.0059899100000000002</cx:pt>
          <cx:pt idx="108">0.0025331199999999998</cx:pt>
          <cx:pt idx="109">0.00010004400000000001</cx:pt>
          <cx:pt idx="110">0.0125483</cx:pt>
          <cx:pt idx="111">0.000100657</cx:pt>
          <cx:pt idx="112">0.0098840300000000002</cx:pt>
          <cx:pt idx="113">0.011956700000000001</cx:pt>
          <cx:pt idx="114">0.0060926499999999998</cx:pt>
          <cx:pt idx="115">0.0042211699999999998</cx:pt>
          <cx:pt idx="116">0.000101743</cx:pt>
          <cx:pt idx="117">0.00166628</cx:pt>
          <cx:pt idx="118">0.000100078</cx:pt>
          <cx:pt idx="119">0.011578400000000001</cx:pt>
          <cx:pt idx="120">0.017556700000000001</cx:pt>
          <cx:pt idx="121">0.000100024</cx:pt>
          <cx:pt idx="122">0.00010019</cx:pt>
          <cx:pt idx="123">0.0027109999999999999</cx:pt>
          <cx:pt idx="124">0.0091029000000000006</cx:pt>
          <cx:pt idx="125">0.000100945</cx:pt>
          <cx:pt idx="126">0.0049917299999999998</cx:pt>
          <cx:pt idx="127">0.000100145</cx:pt>
          <cx:pt idx="128">0.0081922499999999999</cx:pt>
          <cx:pt idx="129">0.00853662</cx:pt>
          <cx:pt idx="130">0.0062642899999999996</cx:pt>
          <cx:pt idx="131">0.000100048</cx:pt>
          <cx:pt idx="132">0.0043300500000000002</cx:pt>
          <cx:pt idx="133">0.00010040299999999999</cx:pt>
          <cx:pt idx="134">0.0156496</cx:pt>
          <cx:pt idx="135">0.0116039</cx:pt>
          <cx:pt idx="136">0.0016188000000000001</cx:pt>
          <cx:pt idx="137">0.0015552000000000001</cx:pt>
          <cx:pt idx="138">0.00010166399999999999</cx:pt>
          <cx:pt idx="139">0.0065907800000000001</cx:pt>
          <cx:pt idx="140">0.000100083</cx:pt>
          <cx:pt idx="141">0.0023267600000000002</cx:pt>
          <cx:pt idx="142">0.025160100000000001</cx:pt>
          <cx:pt idx="143">0.0025830800000000002</cx:pt>
          <cx:pt idx="144">0.000100349</cx:pt>
          <cx:pt idx="145">0.0070569200000000004</cx:pt>
          <cx:pt idx="146">0.0019542600000000002</cx:pt>
          <cx:pt idx="147">0.0070721999999999998</cx:pt>
          <cx:pt idx="148">0.018195900000000001</cx:pt>
          <cx:pt idx="149">0.0080251400000000001</cx:pt>
          <cx:pt idx="150">0.000100015</cx:pt>
          <cx:pt idx="151">0.0029792299999999998</cx:pt>
          <cx:pt idx="152">0.0104434</cx:pt>
          <cx:pt idx="153">0.0119177</cx:pt>
          <cx:pt idx="154">0.00134337</cx:pt>
          <cx:pt idx="155">0.0099917700000000005</cx:pt>
          <cx:pt idx="156">0.0097960300000000007</cx:pt>
          <cx:pt idx="157">0.0001</cx:pt>
          <cx:pt idx="158">0.0026964799999999998</cx:pt>
          <cx:pt idx="159">0.000100092</cx:pt>
          <cx:pt idx="160">0.00010007</cx:pt>
          <cx:pt idx="161">0.0118596</cx:pt>
          <cx:pt idx="162">0.00514184</cx:pt>
          <cx:pt idx="163">0.00400629</cx:pt>
          <cx:pt idx="164">0.0021235400000000001</cx:pt>
          <cx:pt idx="165">0.000101086</cx:pt>
          <cx:pt idx="166">0.000100002</cx:pt>
          <cx:pt idx="167">0.00010000700000000001</cx:pt>
          <cx:pt idx="168">0.0058481200000000001</cx:pt>
          <cx:pt idx="169">0.00010001</cx:pt>
          <cx:pt idx="170">0.0023986900000000002</cx:pt>
          <cx:pt idx="171">0.013950499999999999</cx:pt>
          <cx:pt idx="172">0.0001025</cx:pt>
          <cx:pt idx="173">0.0062071599999999998</cx:pt>
          <cx:pt idx="174">0.0073797899999999998</cx:pt>
          <cx:pt idx="175">0.0103099</cx:pt>
          <cx:pt idx="176">0.000100645</cx:pt>
          <cx:pt idx="177">0.022781300000000001</cx:pt>
          <cx:pt idx="178">0.000100022</cx:pt>
          <cx:pt idx="179">0.000102037</cx:pt>
          <cx:pt idx="180">0.00010006200000000001</cx:pt>
          <cx:pt idx="181">0.0048668299999999999</cx:pt>
          <cx:pt idx="182">0.021141400000000001</cx:pt>
          <cx:pt idx="183">0.000100122</cx:pt>
          <cx:pt idx="184">0.00266702</cx:pt>
          <cx:pt idx="185">0.00010060600000000001</cx:pt>
          <cx:pt idx="186">0.012907200000000001</cx:pt>
          <cx:pt idx="187">0.0056398300000000002</cx:pt>
          <cx:pt idx="188">0.0023548699999999998</cx:pt>
          <cx:pt idx="189">0.0127136</cx:pt>
          <cx:pt idx="190">0.00175263</cx:pt>
          <cx:pt idx="191">0.0151266</cx:pt>
          <cx:pt idx="192">0.0041870199999999996</cx:pt>
          <cx:pt idx="193">0.00723648</cx:pt>
          <cx:pt idx="194">0.000100444</cx:pt>
          <cx:pt idx="195">0.0054623700000000002</cx:pt>
          <cx:pt idx="196">0.00010014999999999999</cx:pt>
          <cx:pt idx="197">0.0065169800000000003</cx:pt>
          <cx:pt idx="198">0.000100197</cx:pt>
          <cx:pt idx="199">0.0085171599999999993</cx:pt>
          <cx:pt idx="200">0.00010024199999999999</cx:pt>
          <cx:pt idx="201">0.0106306</cx:pt>
          <cx:pt idx="202">0.000100028</cx:pt>
          <cx:pt idx="203">0.0028647</cx:pt>
          <cx:pt idx="204">0.00962644</cx:pt>
          <cx:pt idx="205">0.0146797</cx:pt>
          <cx:pt idx="206">0.000100016</cx:pt>
          <cx:pt idx="207">0.0104878</cx:pt>
          <cx:pt idx="208">0.0072564099999999996</cx:pt>
          <cx:pt idx="209">0.000100064</cx:pt>
          <cx:pt idx="210">0.0086490400000000002</cx:pt>
          <cx:pt idx="211">0.0087729599999999998</cx:pt>
          <cx:pt idx="212">0.0036350499999999999</cx:pt>
          <cx:pt idx="213">0.0029018</cx:pt>
          <cx:pt idx="214">0.0066956300000000002</cx:pt>
          <cx:pt idx="215">0.0109595</cx:pt>
          <cx:pt idx="216">0.000223921</cx:pt>
          <cx:pt idx="217">0.00025618800000000002</cx:pt>
          <cx:pt idx="218">0.00153012</cx:pt>
          <cx:pt idx="219">0.0057397200000000002</cx:pt>
          <cx:pt idx="220">0.0177036</cx:pt>
          <cx:pt idx="221">0.000100003</cx:pt>
          <cx:pt idx="222">0.0044580799999999997</cx:pt>
          <cx:pt idx="223">0.020218199999999999</cx:pt>
          <cx:pt idx="224">0.0040844399999999999</cx:pt>
          <cx:pt idx="225">0.00010001999999999999</cx:pt>
          <cx:pt idx="226">0.0093050300000000006</cx:pt>
          <cx:pt idx="227">0.0053344899999999999</cx:pt>
          <cx:pt idx="228">0.0073562999999999996</cx:pt>
          <cx:pt idx="229">0.0066568</cx:pt>
          <cx:pt idx="230">0.0001</cx:pt>
          <cx:pt idx="231">0.0063800100000000002</cx:pt>
          <cx:pt idx="232">0.00551266</cx:pt>
          <cx:pt idx="233">0.000100003</cx:pt>
          <cx:pt idx="234">0.0040797899999999998</cx:pt>
          <cx:pt idx="235">0.0142767</cx:pt>
          <cx:pt idx="236">0.0029747200000000001</cx:pt>
          <cx:pt idx="237">0.0094823600000000004</cx:pt>
          <cx:pt idx="238">0.000100132</cx:pt>
          <cx:pt idx="239">0.00097182799999999999</cx:pt>
          <cx:pt idx="240">0.000100144</cx:pt>
          <cx:pt idx="241">0.00357858</cx:pt>
          <cx:pt idx="242">0.0115411</cx:pt>
          <cx:pt idx="243">0.000180142</cx:pt>
          <cx:pt idx="244">0.0089418499999999995</cx:pt>
          <cx:pt idx="245">0.000100017</cx:pt>
          <cx:pt idx="246">0.0033232000000000001</cx:pt>
          <cx:pt idx="247">0.0165703</cx:pt>
          <cx:pt idx="248">0.0240264</cx:pt>
          <cx:pt idx="249">0.0029077600000000001</cx:pt>
          <cx:pt idx="250">0.011697900000000001</cx:pt>
          <cx:pt idx="251">0.0097166700000000002</cx:pt>
          <cx:pt idx="252">0.0027887799999999998</cx:pt>
          <cx:pt idx="253">0.0055534800000000004</cx:pt>
          <cx:pt idx="254">0.000100053</cx:pt>
          <cx:pt idx="255">0.0036575599999999998</cx:pt>
          <cx:pt idx="256">0.0119344</cx:pt>
          <cx:pt idx="257">0.000213425</cx:pt>
          <cx:pt idx="258">0.0056362699999999996</cx:pt>
          <cx:pt idx="259">0.0150454</cx:pt>
          <cx:pt idx="260">0.000100307</cx:pt>
          <cx:pt idx="261">0.00059765700000000003</cx:pt>
          <cx:pt idx="262">0.000100018</cx:pt>
          <cx:pt idx="263">0.0076394499999999999</cx:pt>
          <cx:pt idx="264">0.000100049</cx:pt>
          <cx:pt idx="265">0.0038861799999999999</cx:pt>
          <cx:pt idx="266">0.0095569399999999999</cx:pt>
          <cx:pt idx="267">0.017196199999999998</cx:pt>
          <cx:pt idx="268">0.0058049499999999997</cx:pt>
          <cx:pt idx="269">0.00010004400000000001</cx:pt>
          <cx:pt idx="270">0.0024423600000000002</cx:pt>
          <cx:pt idx="271">0.00268125</cx:pt>
          <cx:pt idx="272">0.0038410800000000002</cx:pt>
          <cx:pt idx="273">0.00010004</cx:pt>
          <cx:pt idx="274">0.0078407200000000007</cx:pt>
          <cx:pt idx="275">0.0072192200000000002</cx:pt>
          <cx:pt idx="276">0.0070123</cx:pt>
          <cx:pt idx="277">0.0044849199999999999</cx:pt>
          <cx:pt idx="278">0.017624500000000001</cx:pt>
          <cx:pt idx="279">0.0079017099999999993</cx:pt>
          <cx:pt idx="280">0.00044034500000000003</cx:pt>
          <cx:pt idx="281">0.000100017</cx:pt>
          <cx:pt idx="282">0.000100048</cx:pt>
          <cx:pt idx="283">0.00594409</cx:pt>
          <cx:pt idx="284">0.00319549</cx:pt>
          <cx:pt idx="285">0.0139414</cx:pt>
          <cx:pt idx="286">0.012014800000000001</cx:pt>
          <cx:pt idx="287">0.0079288499999999994</cx:pt>
          <cx:pt idx="288">0.00759971</cx:pt>
          <cx:pt idx="289">0.010176299999999999</cx:pt>
          <cx:pt idx="290">0.000100077</cx:pt>
          <cx:pt idx="291">0.000100012</cx:pt>
          <cx:pt idx="292">0.0103444</cx:pt>
          <cx:pt idx="293">0.0023341600000000001</cx:pt>
          <cx:pt idx="294">0.0021251099999999999</cx:pt>
          <cx:pt idx="295">0.0068569599999999996</cx:pt>
          <cx:pt idx="296">0.0039431600000000002</cx:pt>
          <cx:pt idx="297">0.033745499999999998</cx:pt>
          <cx:pt idx="298">0.0011711600000000001</cx:pt>
          <cx:pt idx="299">0.00726993</cx:pt>
          <cx:pt idx="300">0.0066345299999999996</cx:pt>
          <cx:pt idx="301">0.0105162</cx:pt>
          <cx:pt idx="302">0.0020135700000000001</cx:pt>
          <cx:pt idx="303">0.00010001</cx:pt>
          <cx:pt idx="304">0.00113166</cx:pt>
          <cx:pt idx="305">0.000100151</cx:pt>
          <cx:pt idx="306">0.000101067</cx:pt>
          <cx:pt idx="307">0.00010009999999999999</cx:pt>
          <cx:pt idx="308">0.00010001999999999999</cx:pt>
          <cx:pt idx="309">0.00687383</cx:pt>
          <cx:pt idx="310">0.0035582000000000001</cx:pt>
          <cx:pt idx="311">0.000102717</cx:pt>
          <cx:pt idx="312">0.000103531</cx:pt>
          <cx:pt idx="313">0.000109048</cx:pt>
          <cx:pt idx="314">0.0052550299999999999</cx:pt>
          <cx:pt idx="315">0.011398699999999999</cx:pt>
          <cx:pt idx="316">0.0001</cx:pt>
          <cx:pt idx="317">0.0090490699999999993</cx:pt>
          <cx:pt idx="318">0.00040631499999999997</cx:pt>
          <cx:pt idx="319">0.00277941</cx:pt>
          <cx:pt idx="320">0.000100023</cx:pt>
          <cx:pt idx="321">0.0011214700000000001</cx:pt>
          <cx:pt idx="322">0.00027187000000000001</cx:pt>
          <cx:pt idx="323">0.0041237599999999998</cx:pt>
          <cx:pt idx="324">0.000206159</cx:pt>
          <cx:pt idx="325">0.000100034</cx:pt>
          <cx:pt idx="326">0.00013756200000000001</cx:pt>
          <cx:pt idx="327">0.0114895</cx:pt>
          <cx:pt idx="328">0.0148691</cx:pt>
          <cx:pt idx="329">0.015072199999999999</cx:pt>
          <cx:pt idx="330">0.00306515</cx:pt>
          <cx:pt idx="331">0.011748700000000001</cx:pt>
          <cx:pt idx="332">0.015177</cx:pt>
          <cx:pt idx="333">0.000100016</cx:pt>
          <cx:pt idx="334">0.00010002500000000001</cx:pt>
          <cx:pt idx="335">0.000100129</cx:pt>
          <cx:pt idx="336">0.024084299999999999</cx:pt>
          <cx:pt idx="337">0.0085783700000000001</cx:pt>
          <cx:pt idx="338">0.0050106200000000004</cx:pt>
          <cx:pt idx="339">0.0010969300000000001</cx:pt>
          <cx:pt idx="340">0.00114134</cx:pt>
          <cx:pt idx="341">0.011524</cx:pt>
          <cx:pt idx="342">0.00491311</cx:pt>
          <cx:pt idx="343">0.00535667</cx:pt>
          <cx:pt idx="344">0.0032361600000000001</cx:pt>
          <cx:pt idx="345">0.019921700000000001</cx:pt>
          <cx:pt idx="346">0.0001</cx:pt>
          <cx:pt idx="347">0.0116431</cx:pt>
          <cx:pt idx="348">0.000100017</cx:pt>
          <cx:pt idx="349">0.00433125</cx:pt>
          <cx:pt idx="350">0.010347200000000001</cx:pt>
          <cx:pt idx="351">0.0054318600000000002</cx:pt>
          <cx:pt idx="352">0.000100006</cx:pt>
          <cx:pt idx="353">0.000100441</cx:pt>
          <cx:pt idx="354">0.0039209600000000002</cx:pt>
          <cx:pt idx="355">0.010536800000000001</cx:pt>
          <cx:pt idx="356">0.0090027500000000003</cx:pt>
          <cx:pt idx="357">0.0001</cx:pt>
          <cx:pt idx="358">0.011044399999999999</cx:pt>
          <cx:pt idx="359">0.0050123800000000003</cx:pt>
          <cx:pt idx="360">0.000100158</cx:pt>
          <cx:pt idx="361">0.0053784000000000002</cx:pt>
          <cx:pt idx="362">0.0035464099999999998</cx:pt>
          <cx:pt idx="363">0.0068069899999999997</cx:pt>
          <cx:pt idx="364">0.0040576199999999996</cx:pt>
          <cx:pt idx="365">0.0049347499999999999</cx:pt>
          <cx:pt idx="366">0.0036113199999999999</cx:pt>
          <cx:pt idx="367">0.0097016099999999994</cx:pt>
          <cx:pt idx="368">0.013405500000000001</cx:pt>
          <cx:pt idx="369">0.00010006299999999999</cx:pt>
          <cx:pt idx="370">0.00040236599999999998</cx:pt>
          <cx:pt idx="371">0.00191683</cx:pt>
          <cx:pt idx="372">0.0077516399999999997</cx:pt>
          <cx:pt idx="373">0.0054106500000000004</cx:pt>
          <cx:pt idx="374">0.0098322199999999992</cx:pt>
          <cx:pt idx="375">0.0031161299999999999</cx:pt>
          <cx:pt idx="376">0.00082043199999999995</cx:pt>
          <cx:pt idx="377">0.0001</cx:pt>
          <cx:pt idx="378">0.00016442900000000001</cx:pt>
          <cx:pt idx="379">0.000214544</cx:pt>
          <cx:pt idx="380">0.0016168599999999999</cx:pt>
          <cx:pt idx="381">0.000100006</cx:pt>
          <cx:pt idx="382">0.0063441399999999998</cx:pt>
          <cx:pt idx="383">0.0031373400000000002</cx:pt>
          <cx:pt idx="384">0.000100005</cx:pt>
          <cx:pt idx="385">0.014324399999999999</cx:pt>
          <cx:pt idx="386">0.00070881000000000004</cx:pt>
          <cx:pt idx="387">0.00328166</cx:pt>
          <cx:pt idx="388">0.000100757</cx:pt>
          <cx:pt idx="389">0.00089530700000000003</cx:pt>
          <cx:pt idx="390">0.0047400300000000001</cx:pt>
          <cx:pt idx="391">0.0049047700000000001</cx:pt>
          <cx:pt idx="392">0.0026952299999999998</cx:pt>
          <cx:pt idx="393">0.020419099999999999</cx:pt>
          <cx:pt idx="394">0.0016459599999999999</cx:pt>
          <cx:pt idx="395">0.0020908699999999999</cx:pt>
          <cx:pt idx="396">0.00019855900000000001</cx:pt>
          <cx:pt idx="397">0.0056432599999999998</cx:pt>
          <cx:pt idx="398">0.0021811700000000001</cx:pt>
          <cx:pt idx="399">0.000100047</cx:pt>
          <cx:pt idx="400">0.022834400000000001</cx:pt>
          <cx:pt idx="401">0.00081539399999999999</cx:pt>
          <cx:pt idx="402">0.0026543000000000001</cx:pt>
          <cx:pt idx="403">0.000100921</cx:pt>
          <cx:pt idx="404">0.018190100000000001</cx:pt>
          <cx:pt idx="405">0.017566100000000001</cx:pt>
          <cx:pt idx="406">0.0028926500000000001</cx:pt>
          <cx:pt idx="407">0.0001</cx:pt>
          <cx:pt idx="408">0.0125688</cx:pt>
          <cx:pt idx="409">0.00010001300000000001</cx:pt>
          <cx:pt idx="410">0.0055255699999999996</cx:pt>
          <cx:pt idx="411">0.00146367</cx:pt>
          <cx:pt idx="412">0.0053138700000000001</cx:pt>
          <cx:pt idx="413">0.0122208</cx:pt>
          <cx:pt idx="414">0.00347358</cx:pt>
          <cx:pt idx="415">0.0061637000000000003</cx:pt>
          <cx:pt idx="416">0.0062754600000000001</cx:pt>
          <cx:pt idx="417">0.0039780500000000003</cx:pt>
          <cx:pt idx="418">0.0038786799999999998</cx:pt>
          <cx:pt idx="419">0.00010001</cx:pt>
          <cx:pt idx="420">0.000100029</cx:pt>
          <cx:pt idx="421">0.0039645399999999999</cx:pt>
          <cx:pt idx="422">0.00377868</cx:pt>
          <cx:pt idx="423">0.0023141699999999999</cx:pt>
          <cx:pt idx="424">0.027785000000000001</cx:pt>
          <cx:pt idx="425">0.0107937</cx:pt>
          <cx:pt idx="426">0.0001273</cx:pt>
          <cx:pt idx="427">0.015957900000000001</cx:pt>
          <cx:pt idx="428">0.0036703600000000001</cx:pt>
          <cx:pt idx="429">0.0080811000000000008</cx:pt>
          <cx:pt idx="430">0.0080019500000000007</cx:pt>
          <cx:pt idx="431">0.000100004</cx:pt>
          <cx:pt idx="432">0.0081047900000000006</cx:pt>
          <cx:pt idx="433">0.0142156</cx:pt>
          <cx:pt idx="434">0.0252964</cx:pt>
          <cx:pt idx="435">0.00407961</cx:pt>
          <cx:pt idx="436">0.00150731</cx:pt>
          <cx:pt idx="437">0.00395999</cx:pt>
          <cx:pt idx="438">0.00010057599999999999</cx:pt>
          <cx:pt idx="439">0.0001</cx:pt>
          <cx:pt idx="440">0.000100034</cx:pt>
          <cx:pt idx="441">0.0076023999999999996</cx:pt>
          <cx:pt idx="442">0.0037872499999999998</cx:pt>
          <cx:pt idx="443">0.0021162899999999998</cx:pt>
          <cx:pt idx="444">0.0133598</cx:pt>
          <cx:pt idx="445">0.000100002</cx:pt>
          <cx:pt idx="446">0.00010019</cx:pt>
          <cx:pt idx="447">0.00010007500000000001</cx:pt>
          <cx:pt idx="448">0.0045167699999999998</cx:pt>
          <cx:pt idx="449">0.0089225199999999998</cx:pt>
          <cx:pt idx="450">0.0057734500000000003</cx:pt>
          <cx:pt idx="451">0.0080599899999999995</cx:pt>
          <cx:pt idx="452">0.0072751999999999999</cx:pt>
          <cx:pt idx="453">0.000143659</cx:pt>
          <cx:pt idx="454">0.000100053</cx:pt>
          <cx:pt idx="455">0.0129564</cx:pt>
          <cx:pt idx="456">0.0074116399999999997</cx:pt>
          <cx:pt idx="457">0.0083595200000000005</cx:pt>
          <cx:pt idx="458">0.0039955900000000003</cx:pt>
          <cx:pt idx="459">0.0094218400000000008</cx:pt>
          <cx:pt idx="460">0.000102557</cx:pt>
          <cx:pt idx="461">0.0034851700000000001</cx:pt>
          <cx:pt idx="462">0.0097458200000000005</cx:pt>
          <cx:pt idx="463">0.0098610599999999996</cx:pt>
          <cx:pt idx="464">0.0066885699999999996</cx:pt>
          <cx:pt idx="465">0.0067480300000000003</cx:pt>
          <cx:pt idx="466">0.0013746100000000001</cx:pt>
          <cx:pt idx="467">0.0001</cx:pt>
          <cx:pt idx="468">0.00344502</cx:pt>
          <cx:pt idx="469">0.0028375599999999998</cx:pt>
          <cx:pt idx="470">0.0022591</cx:pt>
          <cx:pt idx="471">0.00280547</cx:pt>
          <cx:pt idx="472">0.0071926500000000001</cx:pt>
          <cx:pt idx="473">0.0022290299999999999</cx:pt>
          <cx:pt idx="474">0.0159393</cx:pt>
          <cx:pt idx="475">0.0012557200000000001</cx:pt>
          <cx:pt idx="476">0.000100002</cx:pt>
          <cx:pt idx="477">0.000100083</cx:pt>
          <cx:pt idx="478">0.0059469099999999997</cx:pt>
          <cx:pt idx="479">0.00010660199999999999</cx:pt>
          <cx:pt idx="480">0.0090952199999999993</cx:pt>
          <cx:pt idx="481">0.011412500000000001</cx:pt>
          <cx:pt idx="482">0.0080547399999999995</cx:pt>
          <cx:pt idx="483">0.0018816499999999999</cx:pt>
          <cx:pt idx="484">0.0067245899999999999</cx:pt>
          <cx:pt idx="485">0.00468513</cx:pt>
          <cx:pt idx="486">0.0133653</cx:pt>
          <cx:pt idx="487">0.0078798199999999992</cx:pt>
          <cx:pt idx="488">0.000100004</cx:pt>
          <cx:pt idx="489">0.0070611399999999996</cx:pt>
          <cx:pt idx="490">0.00010001399999999999</cx:pt>
          <cx:pt idx="491">0.0069431199999999997</cx:pt>
          <cx:pt idx="492">0.000100159</cx:pt>
          <cx:pt idx="493">0.00071233799999999997</cx:pt>
          <cx:pt idx="494">0.00598498</cx:pt>
          <cx:pt idx="495">0.0087813800000000001</cx:pt>
          <cx:pt idx="496">0.00323719</cx:pt>
          <cx:pt idx="497">0.0128729</cx:pt>
          <cx:pt idx="498">0.01711</cx:pt>
          <cx:pt idx="499">0.000103044</cx:pt>
          <cx:pt idx="500">0.00457356</cx:pt>
          <cx:pt idx="501">0.0016215299999999999</cx:pt>
          <cx:pt idx="502">0.0083869099999999992</cx:pt>
          <cx:pt idx="503">0.00010409</cx:pt>
          <cx:pt idx="504">0.0018644099999999999</cx:pt>
          <cx:pt idx="505">0.000102606</cx:pt>
          <cx:pt idx="506">0.0001</cx:pt>
          <cx:pt idx="507">0.0086111699999999996</cx:pt>
          <cx:pt idx="508">0.0044604700000000002</cx:pt>
          <cx:pt idx="509">0.0061964400000000001</cx:pt>
          <cx:pt idx="510">0.00067838700000000002</cx:pt>
          <cx:pt idx="511">0.0023784000000000001</cx:pt>
          <cx:pt idx="512">0.00010006</cx:pt>
          <cx:pt idx="513">0.0053789199999999997</cx:pt>
          <cx:pt idx="514">0.0031966199999999998</cx:pt>
          <cx:pt idx="515">0.015027499999999999</cx:pt>
          <cx:pt idx="516">0.000100002</cx:pt>
          <cx:pt idx="517">0.019217999999999999</cx:pt>
          <cx:pt idx="518">0.0187038</cx:pt>
          <cx:pt idx="519">0.017121999999999998</cx:pt>
          <cx:pt idx="520">0.0078614400000000008</cx:pt>
          <cx:pt idx="521">0.0054331300000000004</cx:pt>
          <cx:pt idx="522">0.0112835</cx:pt>
          <cx:pt idx="523">0.0041792000000000001</cx:pt>
          <cx:pt idx="524">0.0038418300000000001</cx:pt>
          <cx:pt idx="525">0.0047632400000000002</cx:pt>
          <cx:pt idx="526">0.0112602</cx:pt>
          <cx:pt idx="527">0.019897999999999999</cx:pt>
          <cx:pt idx="528">0.0208606</cx:pt>
          <cx:pt idx="529">0.000100024</cx:pt>
          <cx:pt idx="530">0.000100003</cx:pt>
          <cx:pt idx="531">0.0132537</cx:pt>
          <cx:pt idx="532">0.0070270799999999998</cx:pt>
          <cx:pt idx="533">0.0042992200000000003</cx:pt>
          <cx:pt idx="534">0.000100554</cx:pt>
          <cx:pt idx="535">0.0029025800000000001</cx:pt>
          <cx:pt idx="536">0.000100092</cx:pt>
          <cx:pt idx="537">0.0037791299999999999</cx:pt>
          <cx:pt idx="538">0.0049944899999999999</cx:pt>
          <cx:pt idx="539">0.011275500000000001</cx:pt>
          <cx:pt idx="540">0.000100919</cx:pt>
          <cx:pt idx="541">0.015914299999999999</cx:pt>
          <cx:pt idx="542">0.0076344500000000001</cx:pt>
          <cx:pt idx="543">0.0070103300000000004</cx:pt>
          <cx:pt idx="544">0.0094991799999999994</cx:pt>
          <cx:pt idx="545">0.00316526</cx:pt>
          <cx:pt idx="546">0.000110061</cx:pt>
          <cx:pt idx="547">0.0024071000000000001</cx:pt>
          <cx:pt idx="548">0.0026443399999999998</cx:pt>
          <cx:pt idx="549">0.0095997300000000008</cx:pt>
          <cx:pt idx="550">0.0016305</cx:pt>
          <cx:pt idx="551">0.013110699999999999</cx:pt>
          <cx:pt idx="552">0.000100029</cx:pt>
          <cx:pt idx="553">0.000100109</cx:pt>
          <cx:pt idx="554">0.000100142</cx:pt>
          <cx:pt idx="555">0.0079461800000000006</cx:pt>
          <cx:pt idx="556">0.0082852099999999995</cx:pt>
          <cx:pt idx="557">0.0082270199999999998</cx:pt>
          <cx:pt idx="558">0.00010419700000000001</cx:pt>
          <cx:pt idx="559">0.0144741</cx:pt>
          <cx:pt idx="560">0.021235</cx:pt>
          <cx:pt idx="561">0.0001</cx:pt>
          <cx:pt idx="562">0.0036621900000000001</cx:pt>
          <cx:pt idx="563">0.00076511999999999999</cx:pt>
          <cx:pt idx="564">0.000100048</cx:pt>
          <cx:pt idx="565">0.000101401</cx:pt>
          <cx:pt idx="566">0.00168954</cx:pt>
          <cx:pt idx="567">0.00010060099999999999</cx:pt>
          <cx:pt idx="568">0.00270638</cx:pt>
          <cx:pt idx="569">0.0033216600000000002</cx:pt>
          <cx:pt idx="570">0.00646578</cx:pt>
          <cx:pt idx="571">0.0065467700000000004</cx:pt>
          <cx:pt idx="572">0.00148138</cx:pt>
          <cx:pt idx="573">0.0074953399999999996</cx:pt>
          <cx:pt idx="574">0.00020472000000000001</cx:pt>
          <cx:pt idx="575">0.00089859200000000003</cx:pt>
          <cx:pt idx="576">0.0054306500000000004</cx:pt>
          <cx:pt idx="577">0.0001</cx:pt>
          <cx:pt idx="578">0.0097049000000000007</cx:pt>
          <cx:pt idx="579">0.0096915600000000001</cx:pt>
          <cx:pt idx="580">0.00010329</cx:pt>
          <cx:pt idx="581">0.0019861599999999998</cx:pt>
          <cx:pt idx="582">0.019559300000000002</cx:pt>
          <cx:pt idx="583">0.00130831</cx:pt>
          <cx:pt idx="584">0.014735699999999999</cx:pt>
          <cx:pt idx="585">0.0108875</cx:pt>
          <cx:pt idx="586">0.00169827</cx:pt>
          <cx:pt idx="587">0.0087182200000000005</cx:pt>
          <cx:pt idx="588">0.000100364</cx:pt>
          <cx:pt idx="589">0.000100002</cx:pt>
          <cx:pt idx="590">0.0060543000000000003</cx:pt>
          <cx:pt idx="591">0.0055306299999999999</cx:pt>
          <cx:pt idx="592">0.0085115299999999998</cx:pt>
          <cx:pt idx="593">0.0079270399999999998</cx:pt>
          <cx:pt idx="594">0.0065810599999999997</cx:pt>
          <cx:pt idx="595">0.000100033</cx:pt>
          <cx:pt idx="596">0.00010016</cx:pt>
          <cx:pt idx="597">0.0030972999999999999</cx:pt>
          <cx:pt idx="598">0.00382183</cx:pt>
          <cx:pt idx="599">0.0044332699999999996</cx:pt>
          <cx:pt idx="600">0.011962</cx:pt>
          <cx:pt idx="601">0.0010301500000000001</cx:pt>
          <cx:pt idx="602">0.000102175</cx:pt>
          <cx:pt idx="603">0.0040226400000000001</cx:pt>
          <cx:pt idx="604">0.000100023</cx:pt>
          <cx:pt idx="605">0.00010000099999999999</cx:pt>
          <cx:pt idx="606">0.0076052200000000002</cx:pt>
          <cx:pt idx="607">0.0001</cx:pt>
          <cx:pt idx="608">0.0034825099999999999</cx:pt>
          <cx:pt idx="609">0.00010000099999999999</cx:pt>
          <cx:pt idx="610">0.00729285</cx:pt>
          <cx:pt idx="611">0.0065697100000000003</cx:pt>
          <cx:pt idx="612">0.015656099999999999</cx:pt>
          <cx:pt idx="613">0.000102738</cx:pt>
          <cx:pt idx="614">0.0015360899999999999</cx:pt>
          <cx:pt idx="615">0.0095223500000000006</cx:pt>
          <cx:pt idx="616">0.00242552</cx:pt>
          <cx:pt idx="617">0.00079205599999999997</cx:pt>
          <cx:pt idx="618">0.014562200000000001</cx:pt>
          <cx:pt idx="619">0.0064629800000000001</cx:pt>
          <cx:pt idx="620">0.0046562799999999996</cx:pt>
          <cx:pt idx="621">0.0060990599999999999</cx:pt>
          <cx:pt idx="622">0.0037136199999999999</cx:pt>
          <cx:pt idx="623">0.0050365399999999999</cx:pt>
          <cx:pt idx="624">0.0218116</cx:pt>
          <cx:pt idx="625">0.000100018</cx:pt>
          <cx:pt idx="626">0.0032324599999999999</cx:pt>
          <cx:pt idx="627">0.011251499999999999</cx:pt>
          <cx:pt idx="628">0.0052156599999999996</cx:pt>
          <cx:pt idx="629">0.0032987400000000001</cx:pt>
          <cx:pt idx="630">0.014235899999999999</cx:pt>
          <cx:pt idx="631">0.0068231200000000002</cx:pt>
          <cx:pt idx="632">0.00010003</cx:pt>
          <cx:pt idx="633">0.0042016800000000002</cx:pt>
          <cx:pt idx="634">0.00011701099999999999</cx:pt>
          <cx:pt idx="635">0.0036446899999999999</cx:pt>
          <cx:pt idx="636">0.010361</cx:pt>
          <cx:pt idx="637">0.000100046</cx:pt>
          <cx:pt idx="638">0.0055568700000000002</cx:pt>
          <cx:pt idx="639">0.000100147</cx:pt>
          <cx:pt idx="640">0.00010056</cx:pt>
          <cx:pt idx="641">0.0081301099999999994</cx:pt>
          <cx:pt idx="642">0.000100039</cx:pt>
          <cx:pt idx="643">0.00023812400000000001</cx:pt>
          <cx:pt idx="644">0.000100101</cx:pt>
          <cx:pt idx="645">0.0093175299999999992</cx:pt>
          <cx:pt idx="646">0.00075944700000000001</cx:pt>
          <cx:pt idx="647">0.0074515700000000002</cx:pt>
          <cx:pt idx="648">0.010696499999999999</cx:pt>
          <cx:pt idx="649">0.0035104799999999999</cx:pt>
          <cx:pt idx="650">0.0046347200000000002</cx:pt>
          <cx:pt idx="651">0.0107791</cx:pt>
          <cx:pt idx="652">0.000100011</cx:pt>
          <cx:pt idx="653">0.0057876400000000001</cx:pt>
          <cx:pt idx="654">0.0041768899999999999</cx:pt>
          <cx:pt idx="655">0.000100815</cx:pt>
          <cx:pt idx="656">0.0177304</cx:pt>
          <cx:pt idx="657">0.000107971</cx:pt>
          <cx:pt idx="658">0.0055431600000000001</cx:pt>
          <cx:pt idx="659">0.00017272500000000001</cx:pt>
          <cx:pt idx="660">0.0286346</cx:pt>
          <cx:pt idx="661">0.0122261</cx:pt>
          <cx:pt idx="662">0.00010001300000000001</cx:pt>
          <cx:pt idx="663">0.0048514099999999996</cx:pt>
          <cx:pt idx="664">0.0081540799999999993</cx:pt>
          <cx:pt idx="665">0.0030097600000000002</cx:pt>
          <cx:pt idx="666">0.0085329599999999992</cx:pt>
          <cx:pt idx="667">0.01125</cx:pt>
          <cx:pt idx="668">0.000100008</cx:pt>
          <cx:pt idx="669">0.0109926</cx:pt>
          <cx:pt idx="670">0.0076230400000000002</cx:pt>
          <cx:pt idx="671">0.00352571</cx:pt>
          <cx:pt idx="672">0.014578000000000001</cx:pt>
          <cx:pt idx="673">0.000100017</cx:pt>
          <cx:pt idx="674">0.0053709500000000002</cx:pt>
          <cx:pt idx="675">0.00010048</cx:pt>
          <cx:pt idx="676">0.0026330199999999998</cx:pt>
          <cx:pt idx="677">0.00010009</cx:pt>
          <cx:pt idx="678">0.00223829</cx:pt>
          <cx:pt idx="679">0.0041035100000000003</cx:pt>
          <cx:pt idx="680">0.0019983000000000002</cx:pt>
          <cx:pt idx="681">0.0047054200000000001</cx:pt>
          <cx:pt idx="682">0.013822299999999999</cx:pt>
          <cx:pt idx="683">0.0138231</cx:pt>
          <cx:pt idx="684">0.0188124</cx:pt>
          <cx:pt idx="685">0.00010001399999999999</cx:pt>
          <cx:pt idx="686">0.000103409</cx:pt>
          <cx:pt idx="687">0.00010003799999999999</cx:pt>
          <cx:pt idx="688">0.0026701099999999998</cx:pt>
          <cx:pt idx="689">0.0137158</cx:pt>
          <cx:pt idx="690">0.00175066</cx:pt>
          <cx:pt idx="691">0.00249752</cx:pt>
          <cx:pt idx="692">0.0031713800000000001</cx:pt>
          <cx:pt idx="693">0.0081383700000000007</cx:pt>
          <cx:pt idx="694">0.0107464</cx:pt>
          <cx:pt idx="695">0.00010002500000000001</cx:pt>
          <cx:pt idx="696">0.0150364</cx:pt>
          <cx:pt idx="697">0.0022003000000000001</cx:pt>
          <cx:pt idx="698">0.000100048</cx:pt>
          <cx:pt idx="699">0.015656400000000001</cx:pt>
          <cx:pt idx="700">0.00010014900000000001</cx:pt>
          <cx:pt idx="701">0.000100802</cx:pt>
          <cx:pt idx="702">0.0060347200000000004</cx:pt>
          <cx:pt idx="703">0.000100929</cx:pt>
          <cx:pt idx="704">0.0121566</cx:pt>
          <cx:pt idx="705">0.000792499</cx:pt>
          <cx:pt idx="706">0.0070926000000000001</cx:pt>
          <cx:pt idx="707">0.015769700000000001</cx:pt>
          <cx:pt idx="708">0.0032976799999999999</cx:pt>
          <cx:pt idx="709">0.00010001</cx:pt>
          <cx:pt idx="710">0.00351791</cx:pt>
          <cx:pt idx="711">0.012153300000000001</cx:pt>
          <cx:pt idx="712">0.000118925</cx:pt>
          <cx:pt idx="713">0.0054086999999999998</cx:pt>
          <cx:pt idx="714">0.010704</cx:pt>
          <cx:pt idx="715">0.0053064799999999997</cx:pt>
          <cx:pt idx="716">0.0090738199999999998</cx:pt>
          <cx:pt idx="717">0.0020328400000000002</cx:pt>
          <cx:pt idx="718">0.00010001300000000001</cx:pt>
          <cx:pt idx="719">0.0055411799999999997</cx:pt>
          <cx:pt idx="720">0.00093398699999999995</cx:pt>
          <cx:pt idx="721">0.000100407</cx:pt>
          <cx:pt idx="722">0.0083206100000000009</cx:pt>
          <cx:pt idx="723">0.0022009999999999998</cx:pt>
          <cx:pt idx="724">0.000100188</cx:pt>
          <cx:pt idx="725">0.0071970599999999999</cx:pt>
          <cx:pt idx="726">0.00010508199999999999</cx:pt>
          <cx:pt idx="727">0.0092025200000000005</cx:pt>
          <cx:pt idx="728">0.0017488</cx:pt>
          <cx:pt idx="729">0.0102998</cx:pt>
          <cx:pt idx="730">0.0001</cx:pt>
          <cx:pt idx="731">0.011933600000000001</cx:pt>
          <cx:pt idx="732">0.00372267</cx:pt>
          <cx:pt idx="733">0.0070477100000000004</cx:pt>
          <cx:pt idx="734">0.012828900000000001</cx:pt>
          <cx:pt idx="735">0.0070997200000000003</cx:pt>
          <cx:pt idx="736">0.0050495100000000001</cx:pt>
          <cx:pt idx="737">0.0040379700000000001</cx:pt>
          <cx:pt idx="738">0.0088210900000000002</cx:pt>
          <cx:pt idx="739">0.000656702</cx:pt>
          <cx:pt idx="740">0.0163079</cx:pt>
          <cx:pt idx="741">0.0014526999999999999</cx:pt>
          <cx:pt idx="742">0.0042991499999999998</cx:pt>
          <cx:pt idx="743">0.0039465000000000004</cx:pt>
          <cx:pt idx="744">0.00061914800000000003</cx:pt>
          <cx:pt idx="745">0.000100312</cx:pt>
          <cx:pt idx="746">0.000100005</cx:pt>
          <cx:pt idx="747">0.029474400000000001</cx:pt>
          <cx:pt idx="748">0.0057769300000000004</cx:pt>
          <cx:pt idx="749">0.000100011</cx:pt>
          <cx:pt idx="750">0.000100345</cx:pt>
          <cx:pt idx="751">0.000100004</cx:pt>
          <cx:pt idx="752">0.010585000000000001</cx:pt>
          <cx:pt idx="753">0.000100003</cx:pt>
          <cx:pt idx="754">0.0028423599999999999</cx:pt>
          <cx:pt idx="755">0.0050072199999999997</cx:pt>
          <cx:pt idx="756">0.00373946</cx:pt>
          <cx:pt idx="757">0.0056324399999999998</cx:pt>
          <cx:pt idx="758">0.000583725</cx:pt>
          <cx:pt idx="759">0.0030728700000000001</cx:pt>
          <cx:pt idx="760">0.000100109</cx:pt>
          <cx:pt idx="761">0.0026047800000000001</cx:pt>
          <cx:pt idx="762">0.0112373</cx:pt>
          <cx:pt idx="763">0.0136854</cx:pt>
          <cx:pt idx="764">0.0001</cx:pt>
          <cx:pt idx="765">0.011637</cx:pt>
          <cx:pt idx="766">0.000453747</cx:pt>
          <cx:pt idx="767">0.0079629699999999998</cx:pt>
          <cx:pt idx="768">0.000100005</cx:pt>
          <cx:pt idx="769">0.0041350700000000002</cx:pt>
          <cx:pt idx="770">0.0016201</cx:pt>
          <cx:pt idx="771">0.000100016</cx:pt>
          <cx:pt idx="772">0.0039762499999999997</cx:pt>
          <cx:pt idx="773">0.00010241100000000001</cx:pt>
          <cx:pt idx="774">0.0016100999999999999</cx:pt>
          <cx:pt idx="775">0.00010000099999999999</cx:pt>
          <cx:pt idx="776">0.0063633400000000003</cx:pt>
          <cx:pt idx="777">0.0057124300000000001</cx:pt>
          <cx:pt idx="778">0.0012361500000000001</cx:pt>
          <cx:pt idx="779">0.0060231399999999997</cx:pt>
          <cx:pt idx="780">0.00598279</cx:pt>
          <cx:pt idx="781">0.0063615199999999998</cx:pt>
          <cx:pt idx="782">0.00115784</cx:pt>
          <cx:pt idx="783">0.0026065900000000002</cx:pt>
          <cx:pt idx="784">0.0122884</cx:pt>
          <cx:pt idx="785">0.0020443800000000002</cx:pt>
          <cx:pt idx="786">0.000100006</cx:pt>
          <cx:pt idx="787">0.00611146</cx:pt>
          <cx:pt idx="788">0.00051076300000000002</cx:pt>
          <cx:pt idx="789">0.0042954200000000003</cx:pt>
          <cx:pt idx="790">0.0094411300000000007</cx:pt>
          <cx:pt idx="791">0.000100004</cx:pt>
          <cx:pt idx="792">0.0080326800000000004</cx:pt>
          <cx:pt idx="793">0.0010231400000000001</cx:pt>
          <cx:pt idx="794">0.00294706</cx:pt>
          <cx:pt idx="795">0.00264292</cx:pt>
          <cx:pt idx="796">0.0018076500000000001</cx:pt>
          <cx:pt idx="797">0.00965594</cx:pt>
          <cx:pt idx="798">0.0051234999999999996</cx:pt>
          <cx:pt idx="799">0.010011300000000001</cx:pt>
          <cx:pt idx="800">0.000100059</cx:pt>
          <cx:pt idx="801">0.0060656699999999996</cx:pt>
          <cx:pt idx="802">0.0018667899999999999</cx:pt>
          <cx:pt idx="803">0.0029331100000000001</cx:pt>
          <cx:pt idx="804">0.000100066</cx:pt>
          <cx:pt idx="805">0.0099987800000000005</cx:pt>
          <cx:pt idx="806">0.0110104</cx:pt>
          <cx:pt idx="807">0.0012147200000000001</cx:pt>
          <cx:pt idx="808">0.00010001</cx:pt>
          <cx:pt idx="809">0.00010000099999999999</cx:pt>
          <cx:pt idx="810">0.00068955000000000004</cx:pt>
          <cx:pt idx="811">0.0040250599999999996</cx:pt>
          <cx:pt idx="812">0.0022246100000000001</cx:pt>
          <cx:pt idx="813">0.000100018</cx:pt>
          <cx:pt idx="814">0.000100017</cx:pt>
          <cx:pt idx="815">0.0149807</cx:pt>
          <cx:pt idx="816">0.0082777500000000004</cx:pt>
          <cx:pt idx="817">0.0075925200000000002</cx:pt>
          <cx:pt idx="818">0.000100005</cx:pt>
          <cx:pt idx="819">0.0035600900000000001</cx:pt>
          <cx:pt idx="820">0.0086233000000000004</cx:pt>
          <cx:pt idx="821">0.000100692</cx:pt>
          <cx:pt idx="822">0.00650433</cx:pt>
          <cx:pt idx="823">0.000100004</cx:pt>
          <cx:pt idx="824">0.010668199999999999</cx:pt>
          <cx:pt idx="825">0.0074857099999999996</cx:pt>
          <cx:pt idx="826">0.0088286100000000006</cx:pt>
          <cx:pt idx="827">0.0076378399999999999</cx:pt>
          <cx:pt idx="828">0.0053094600000000002</cx:pt>
          <cx:pt idx="829">0.0032206700000000001</cx:pt>
          <cx:pt idx="830">0.0043689699999999998</cx:pt>
          <cx:pt idx="831">0.0092681299999999994</cx:pt>
          <cx:pt idx="832">0.0078833500000000008</cx:pt>
          <cx:pt idx="833">0.0063097400000000003</cx:pt>
          <cx:pt idx="834">0.00010022900000000001</cx:pt>
          <cx:pt idx="835">0.0076325100000000003</cx:pt>
          <cx:pt idx="836">0.0043283499999999999</cx:pt>
          <cx:pt idx="837">0.0071686199999999997</cx:pt>
          <cx:pt idx="838">0.000100008</cx:pt>
          <cx:pt idx="839">0.000100034</cx:pt>
          <cx:pt idx="840">0.000100599</cx:pt>
          <cx:pt idx="841">0.0035147500000000001</cx:pt>
          <cx:pt idx="842">0.0065681300000000001</cx:pt>
          <cx:pt idx="843">0.0081299000000000007</cx:pt>
          <cx:pt idx="844">0.012881099999999999</cx:pt>
          <cx:pt idx="845">0.000100115</cx:pt>
          <cx:pt idx="846">0.0099461399999999991</cx:pt>
          <cx:pt idx="847">0.0035671499999999998</cx:pt>
          <cx:pt idx="848">0.0092646199999999995</cx:pt>
          <cx:pt idx="849">0.0158195</cx:pt>
          <cx:pt idx="850">0.0033321499999999999</cx:pt>
          <cx:pt idx="851">0.0016967499999999999</cx:pt>
          <cx:pt idx="852">0.00312029</cx:pt>
          <cx:pt idx="853">0.0069789600000000002</cx:pt>
          <cx:pt idx="854">0.0059581199999999999</cx:pt>
          <cx:pt idx="855">0.000100238</cx:pt>
          <cx:pt idx="856">0.011126799999999999</cx:pt>
          <cx:pt idx="857">0.0075987800000000003</cx:pt>
          <cx:pt idx="858">0.0076533599999999997</cx:pt>
          <cx:pt idx="859">0.0061332599999999998</cx:pt>
          <cx:pt idx="860">0.0096950600000000001</cx:pt>
          <cx:pt idx="861">0.000100027</cx:pt>
          <cx:pt idx="862">0.0082625800000000003</cx:pt>
          <cx:pt idx="863">0.0053384399999999999</cx:pt>
          <cx:pt idx="864">0.00010031600000000001</cx:pt>
          <cx:pt idx="865">0.000100893</cx:pt>
          <cx:pt idx="866">0.00010025400000000001</cx:pt>
          <cx:pt idx="867">0.0083442299999999994</cx:pt>
          <cx:pt idx="868">0.0050032599999999998</cx:pt>
          <cx:pt idx="869">0.00097561900000000005</cx:pt>
          <cx:pt idx="870">0.00010008700000000001</cx:pt>
          <cx:pt idx="871">0.000100101</cx:pt>
          <cx:pt idx="872">0.0085473200000000006</cx:pt>
          <cx:pt idx="873">0.00010017399999999999</cx:pt>
          <cx:pt idx="874">0.0097486599999999993</cx:pt>
          <cx:pt idx="875">0.0075521499999999997</cx:pt>
          <cx:pt idx="876">0.00430774</cx:pt>
          <cx:pt idx="877">0.012246</cx:pt>
          <cx:pt idx="878">0.0067437900000000004</cx:pt>
          <cx:pt idx="879">0.000100222</cx:pt>
          <cx:pt idx="880">0.010662400000000001</cx:pt>
          <cx:pt idx="881">0.00010003</cx:pt>
          <cx:pt idx="882">0.0023048000000000001</cx:pt>
          <cx:pt idx="883">0.0214133</cx:pt>
          <cx:pt idx="884">0.000100043</cx:pt>
          <cx:pt idx="885">0.00010000099999999999</cx:pt>
          <cx:pt idx="886">0.0086753000000000004</cx:pt>
          <cx:pt idx="887">0.0057188600000000001</cx:pt>
          <cx:pt idx="888">0.000100008</cx:pt>
          <cx:pt idx="889">0.00278437</cx:pt>
          <cx:pt idx="890">0.0029556999999999999</cx:pt>
          <cx:pt idx="891">0.0081197100000000005</cx:pt>
          <cx:pt idx="892">0.000100142</cx:pt>
          <cx:pt idx="893">0.0105343</cx:pt>
          <cx:pt idx="894">0.0092380699999999993</cx:pt>
          <cx:pt idx="895">0.00010040299999999999</cx:pt>
          <cx:pt idx="896">0.0052915799999999997</cx:pt>
          <cx:pt idx="897">0.0094613500000000003</cx:pt>
          <cx:pt idx="898">0.00129006</cx:pt>
          <cx:pt idx="899">0.0143883</cx:pt>
          <cx:pt idx="900">0.00010053899999999999</cx:pt>
          <cx:pt idx="901">0.00010026600000000001</cx:pt>
          <cx:pt idx="902">0.00010006</cx:pt>
          <cx:pt idx="903">0.000100463</cx:pt>
          <cx:pt idx="904">0.000100247</cx:pt>
          <cx:pt idx="905">0.0070971599999999999</cx:pt>
          <cx:pt idx="906">0.011658699999999999</cx:pt>
          <cx:pt idx="907">0.016673500000000001</cx:pt>
          <cx:pt idx="908">0.0081223500000000004</cx:pt>
          <cx:pt idx="909">0.0099756399999999992</cx:pt>
          <cx:pt idx="910">0.0072453999999999999</cx:pt>
          <cx:pt idx="911">0.0017870399999999999</cx:pt>
          <cx:pt idx="912">0.0096078899999999991</cx:pt>
          <cx:pt idx="913">0.000100005</cx:pt>
          <cx:pt idx="914">0.0074888300000000001</cx:pt>
          <cx:pt idx="915">0.000100011</cx:pt>
          <cx:pt idx="916">0.016260799999999999</cx:pt>
          <cx:pt idx="917">0.0076820600000000001</cx:pt>
          <cx:pt idx="918">0.0047056099999999998</cx:pt>
          <cx:pt idx="919">0.0033028200000000001</cx:pt>
          <cx:pt idx="920">0.0056353699999999998</cx:pt>
          <cx:pt idx="921">0.00026331299999999999</cx:pt>
          <cx:pt idx="922">0.000100028</cx:pt>
          <cx:pt idx="923">0.0068650600000000001</cx:pt>
          <cx:pt idx="924">0.0045059399999999999</cx:pt>
          <cx:pt idx="925">0.000100016</cx:pt>
          <cx:pt idx="926">0.0021424600000000001</cx:pt>
          <cx:pt idx="927">0.0043283499999999999</cx:pt>
          <cx:pt idx="928">0.0060631299999999999</cx:pt>
          <cx:pt idx="929">0.0042782200000000001</cx:pt>
          <cx:pt idx="930">0.0070332299999999997</cx:pt>
          <cx:pt idx="931">0.00284659</cx:pt>
          <cx:pt idx="932">0.0067872799999999997</cx:pt>
          <cx:pt idx="933">0.00010001300000000001</cx:pt>
          <cx:pt idx="934">0.00192541</cx:pt>
          <cx:pt idx="935">0.00389325</cx:pt>
          <cx:pt idx="936">0.00010000700000000001</cx:pt>
          <cx:pt idx="937">0.0115505</cx:pt>
          <cx:pt idx="938">0.00024635999999999999</cx:pt>
          <cx:pt idx="939">0.0025272300000000001</cx:pt>
          <cx:pt idx="940">0.0078735000000000003</cx:pt>
          <cx:pt idx="941">0.00582842</cx:pt>
          <cx:pt idx="942">0.00050713899999999998</cx:pt>
          <cx:pt idx="943">0.0079143600000000005</cx:pt>
          <cx:pt idx="944">0.0132798</cx:pt>
          <cx:pt idx="945">0.0102983</cx:pt>
          <cx:pt idx="946">0.020000799999999999</cx:pt>
          <cx:pt idx="947">0.0001</cx:pt>
          <cx:pt idx="948">0.000100027</cx:pt>
          <cx:pt idx="949">0.0124025</cx:pt>
          <cx:pt idx="950">0.00010007500000000001</cx:pt>
          <cx:pt idx="951">0.0029687899999999998</cx:pt>
          <cx:pt idx="952">0.00935157</cx:pt>
          <cx:pt idx="953">0.00010000700000000001</cx:pt>
          <cx:pt idx="954">0.00276465</cx:pt>
          <cx:pt idx="955">0.020369200000000001</cx:pt>
          <cx:pt idx="956">0.0039904700000000003</cx:pt>
          <cx:pt idx="957">0.00010003100000000001</cx:pt>
          <cx:pt idx="958">0.000116966</cx:pt>
          <cx:pt idx="959">0.00010000099999999999</cx:pt>
          <cx:pt idx="960">0.0016227100000000001</cx:pt>
          <cx:pt idx="961">0.0019882300000000001</cx:pt>
          <cx:pt idx="962">0.0077409799999999997</cx:pt>
          <cx:pt idx="963">0.00624422</cx:pt>
          <cx:pt idx="964">0.0023093900000000001</cx:pt>
          <cx:pt idx="965">0.0088439799999999996</cx:pt>
          <cx:pt idx="966">0.0028628799999999999</cx:pt>
          <cx:pt idx="967">0.0038729699999999999</cx:pt>
          <cx:pt idx="968">0.0109569</cx:pt>
          <cx:pt idx="969">0.00717368</cx:pt>
          <cx:pt idx="970">0.0001</cx:pt>
          <cx:pt idx="971">0.0030699500000000001</cx:pt>
          <cx:pt idx="972">0.0091357000000000001</cx:pt>
          <cx:pt idx="973">0.00010078599999999999</cx:pt>
          <cx:pt idx="974">0.000105554</cx:pt>
          <cx:pt idx="975">0.010912</cx:pt>
          <cx:pt idx="976">0.0040039899999999998</cx:pt>
          <cx:pt idx="977">0.0121627</cx:pt>
          <cx:pt idx="978">0.0029752099999999998</cx:pt>
          <cx:pt idx="979">0.0029051200000000002</cx:pt>
          <cx:pt idx="980">0.0028619800000000001</cx:pt>
          <cx:pt idx="981">0.020576899999999999</cx:pt>
          <cx:pt idx="982">0.0061641200000000004</cx:pt>
          <cx:pt idx="983">0.0084883300000000005</cx:pt>
          <cx:pt idx="984">0.000100003</cx:pt>
          <cx:pt idx="985">0.0090433900000000001</cx:pt>
          <cx:pt idx="986">0.0096355299999999998</cx:pt>
          <cx:pt idx="987">0.0027243800000000002</cx:pt>
          <cx:pt idx="988">0.0042953899999999996</cx:pt>
          <cx:pt idx="989">0.0038398199999999999</cx:pt>
          <cx:pt idx="990">0.0020945</cx:pt>
          <cx:pt idx="991">0.00061107700000000002</cx:pt>
          <cx:pt idx="992">0.0043978400000000001</cx:pt>
          <cx:pt idx="993">0.0097879000000000004</cx:pt>
          <cx:pt idx="994">0.0001</cx:pt>
          <cx:pt idx="995">0.0013059899999999999</cx:pt>
          <cx:pt idx="996">0.00218491</cx:pt>
          <cx:pt idx="997">0.0001</cx:pt>
          <cx:pt idx="998">0.0150279</cx:pt>
          <cx:pt idx="999">0.0041116599999999996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sz="20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200" b="0" i="0" u="none" strike="noStrike" baseline="0" dirty="0" err="1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in,acute</a:t>
            </a:r>
            <a:endParaRPr lang="ja-JP" altLang="en-US" sz="1200" b="0" i="0" u="none" strike="noStrike" baseline="0" dirty="0">
              <a:solidFill>
                <a:sysClr val="windowText" lastClr="000000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cx:rich>
      </cx:tx>
    </cx:title>
    <cx:plotArea>
      <cx:plotAreaRegion>
        <cx:series layoutId="clusteredColumn" uniqueId="{A45DD942-B3F7-4327-A498-9735ED92D67D}">
          <cx:tx>
            <cx:txData>
              <cx:f>'PD acute'!$J$1</cx:f>
              <cx:v>tvKin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Count val="15"/>
            </cx:binning>
          </cx:layoutPr>
        </cx:series>
      </cx:plotAreaRegion>
      <cx:axis id="0">
        <cx:catScaling gapWidth="0"/>
        <cx:tickLabels/>
        <cx:numFmt formatCode="#,##0.000_);[赤](#,##0.00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1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PD acute'!$K$2:$K$1001</cx:f>
        <cx:lvl ptCount="1000" formatCode="G/標準">
          <cx:pt idx="0">0.060990599999999999</cx:pt>
          <cx:pt idx="1">0.077154899999999998</cx:pt>
          <cx:pt idx="2">0.0452935</cx:pt>
          <cx:pt idx="3">0.049067</cx:pt>
          <cx:pt idx="4">0.0551472</cx:pt>
          <cx:pt idx="5">0.046275499999999997</cx:pt>
          <cx:pt idx="6">0.054543000000000001</cx:pt>
          <cx:pt idx="7">0.085082099999999994</cx:pt>
          <cx:pt idx="8">0.063711699999999996</cx:pt>
          <cx:pt idx="9">0.035401700000000001</cx:pt>
          <cx:pt idx="10">0.079681399999999999</cx:pt>
          <cx:pt idx="11">0.083866800000000005</cx:pt>
          <cx:pt idx="12">0.082608399999999998</cx:pt>
          <cx:pt idx="13">0.066772799999999993</cx:pt>
          <cx:pt idx="14">0.054836900000000001</cx:pt>
          <cx:pt idx="15">0.057111299999999997</cx:pt>
          <cx:pt idx="16">0.056587899999999997</cx:pt>
          <cx:pt idx="17">0.066436700000000001</cx:pt>
          <cx:pt idx="18">0.065119899999999994</cx:pt>
          <cx:pt idx="19">0.056508700000000002</cx:pt>
          <cx:pt idx="20">0.067614800000000003</cx:pt>
          <cx:pt idx="21">0.074072399999999997</cx:pt>
          <cx:pt idx="22">0.057994400000000002</cx:pt>
          <cx:pt idx="23">0.065598100000000006</cx:pt>
          <cx:pt idx="24">0.0379537</cx:pt>
          <cx:pt idx="25">0.060076699999999997</cx:pt>
          <cx:pt idx="26">0.061735600000000002</cx:pt>
          <cx:pt idx="27">0.0397198</cx:pt>
          <cx:pt idx="28">0.035334200000000003</cx:pt>
          <cx:pt idx="29">0.053059099999999998</cx:pt>
          <cx:pt idx="30">0.077917700000000006</cx:pt>
          <cx:pt idx="31">0.037174499999999999</cx:pt>
          <cx:pt idx="32">0.0277828</cx:pt>
          <cx:pt idx="33">0.030632900000000001</cx:pt>
          <cx:pt idx="34">0.0406346</cx:pt>
          <cx:pt idx="35">0.067340300000000006</cx:pt>
          <cx:pt idx="36">0.0549271</cx:pt>
          <cx:pt idx="37">0.041180399999999999</cx:pt>
          <cx:pt idx="38">0.034790700000000001</cx:pt>
          <cx:pt idx="39">0.072056999999999996</cx:pt>
          <cx:pt idx="40">0.059159499999999997</cx:pt>
          <cx:pt idx="41">0.0574642</cx:pt>
          <cx:pt idx="42">0.065749199999999994</cx:pt>
          <cx:pt idx="43">0.057029099999999999</cx:pt>
          <cx:pt idx="44">0.077775999999999998</cx:pt>
          <cx:pt idx="45">0.0386868</cx:pt>
          <cx:pt idx="46">0.065248</cx:pt>
          <cx:pt idx="47">0.039000899999999998</cx:pt>
          <cx:pt idx="48">0.052571100000000003</cx:pt>
          <cx:pt idx="49">0.051528499999999998</cx:pt>
          <cx:pt idx="50">0.023813999999999998</cx:pt>
          <cx:pt idx="51">0.0572072</cx:pt>
          <cx:pt idx="52">0.040609899999999997</cx:pt>
          <cx:pt idx="53">0.060807</cx:pt>
          <cx:pt idx="54">0.061539000000000003</cx:pt>
          <cx:pt idx="55">0.030923900000000001</cx:pt>
          <cx:pt idx="56">0.056208399999999999</cx:pt>
          <cx:pt idx="57">0.0529542</cx:pt>
          <cx:pt idx="58">0.059257499999999998</cx:pt>
          <cx:pt idx="59">0.082751199999999997</cx:pt>
          <cx:pt idx="60">0.058994999999999999</cx:pt>
          <cx:pt idx="61">0.064737100000000006</cx:pt>
          <cx:pt idx="62">0.038473599999999997</cx:pt>
          <cx:pt idx="63">0.042852599999999998</cx:pt>
          <cx:pt idx="64">0.031046500000000001</cx:pt>
          <cx:pt idx="65">0.096496899999999997</cx:pt>
          <cx:pt idx="66">0.050859799999999997</cx:pt>
          <cx:pt idx="67">0.039985300000000001</cx:pt>
          <cx:pt idx="68">0.079602999999999993</cx:pt>
          <cx:pt idx="69">0.078108700000000003</cx:pt>
          <cx:pt idx="70">0.051296599999999998</cx:pt>
          <cx:pt idx="71">0.057222599999999998</cx:pt>
          <cx:pt idx="72">0.036149300000000002</cx:pt>
          <cx:pt idx="73">0.065939899999999996</cx:pt>
          <cx:pt idx="74">0.075210799999999994</cx:pt>
          <cx:pt idx="75">0.035470099999999997</cx:pt>
          <cx:pt idx="76">0.055710900000000001</cx:pt>
          <cx:pt idx="77">0.048378900000000002</cx:pt>
          <cx:pt idx="78">0.064923400000000006</cx:pt>
          <cx:pt idx="79">0.0669125</cx:pt>
          <cx:pt idx="80">0.0697681</cx:pt>
          <cx:pt idx="81">0.066221500000000003</cx:pt>
          <cx:pt idx="82">0.059148399999999997</cx:pt>
          <cx:pt idx="83">0.090253700000000006</cx:pt>
          <cx:pt idx="84">0.056101499999999999</cx:pt>
          <cx:pt idx="85">0.043985799999999999</cx:pt>
          <cx:pt idx="86">0.072342600000000007</cx:pt>
          <cx:pt idx="87">0.060579899999999999</cx:pt>
          <cx:pt idx="88">0.057357400000000003</cx:pt>
          <cx:pt idx="89">0.045503500000000002</cx:pt>
          <cx:pt idx="90">0.052436700000000003</cx:pt>
          <cx:pt idx="91">0.058284900000000001</cx:pt>
          <cx:pt idx="92">0.042797300000000003</cx:pt>
          <cx:pt idx="93">0.089289499999999994</cx:pt>
          <cx:pt idx="94">0.039116699999999997</cx:pt>
          <cx:pt idx="95">0.094553700000000004</cx:pt>
          <cx:pt idx="96">0.064266000000000004</cx:pt>
          <cx:pt idx="97">0.065824499999999994</cx:pt>
          <cx:pt idx="98">0.054898799999999998</cx:pt>
          <cx:pt idx="99">0.061983700000000003</cx:pt>
          <cx:pt idx="100">0.060569199999999997</cx:pt>
          <cx:pt idx="101">0.066077999999999998</cx:pt>
          <cx:pt idx="102">0.036876300000000001</cx:pt>
          <cx:pt idx="103">0.072347099999999998</cx:pt>
          <cx:pt idx="104">0.052537100000000003</cx:pt>
          <cx:pt idx="105">0.063169500000000003</cx:pt>
          <cx:pt idx="106">0.059368299999999999</cx:pt>
          <cx:pt idx="107">0.0606159</cx:pt>
          <cx:pt idx="108">0.052862899999999997</cx:pt>
          <cx:pt idx="109">0.0285096</cx:pt>
          <cx:pt idx="110">0.074759599999999996</cx:pt>
          <cx:pt idx="111">0.072033299999999995</cx:pt>
          <cx:pt idx="112">0.062815999999999997</cx:pt>
          <cx:pt idx="113">0.071454000000000004</cx:pt>
          <cx:pt idx="114">0.069694900000000004</cx:pt>
          <cx:pt idx="115">0.051528699999999997</cx:pt>
          <cx:pt idx="116">0.066906300000000002</cx:pt>
          <cx:pt idx="117">0.047995299999999998</cx:pt>
          <cx:pt idx="118">0.075666499999999998</cx:pt>
          <cx:pt idx="119">0.071929900000000005</cx:pt>
          <cx:pt idx="120">0.0653199</cx:pt>
          <cx:pt idx="121">0.080565399999999995</cx:pt>
          <cx:pt idx="122">0.060847100000000001</cx:pt>
          <cx:pt idx="123">0.056600699999999997</cx:pt>
          <cx:pt idx="124">0.061310999999999997</cx:pt>
          <cx:pt idx="125">0.057703299999999999</cx:pt>
          <cx:pt idx="126">0.038006600000000001</cx:pt>
          <cx:pt idx="127">0.050147799999999999</cx:pt>
          <cx:pt idx="128">0.037899200000000001</cx:pt>
          <cx:pt idx="129">0.048999399999999999</cx:pt>
          <cx:pt idx="130">0.070080799999999999</cx:pt>
          <cx:pt idx="131">0.074377399999999996</cx:pt>
          <cx:pt idx="132">0.079649700000000004</cx:pt>
          <cx:pt idx="133">0.0788359</cx:pt>
          <cx:pt idx="134">0.064519400000000005</cx:pt>
          <cx:pt idx="135">0.0761106</cx:pt>
          <cx:pt idx="136">0.088740700000000006</cx:pt>
          <cx:pt idx="137">0.043810500000000002</cx:pt>
          <cx:pt idx="138">0.0856576</cx:pt>
          <cx:pt idx="139">0.080732399999999996</cx:pt>
          <cx:pt idx="140">0.052254399999999999</cx:pt>
          <cx:pt idx="141">0.0385835</cx:pt>
          <cx:pt idx="142">0.093004900000000001</cx:pt>
          <cx:pt idx="143">0.028470200000000001</cx:pt>
          <cx:pt idx="144">0.076019600000000007</cx:pt>
          <cx:pt idx="145">0.051942099999999998</cx:pt>
          <cx:pt idx="146">0.066342600000000002</cx:pt>
          <cx:pt idx="147">0.065535499999999997</cx:pt>
          <cx:pt idx="148">0.066306199999999996</cx:pt>
          <cx:pt idx="149">0.069625400000000004</cx:pt>
          <cx:pt idx="150">0.061101500000000003</cx:pt>
          <cx:pt idx="151">0.044030800000000002</cx:pt>
          <cx:pt idx="152">0.081373899999999999</cx:pt>
          <cx:pt idx="153">0.048746400000000002</cx:pt>
          <cx:pt idx="154">0.041671699999999999</cx:pt>
          <cx:pt idx="155">0.063936400000000004</cx:pt>
          <cx:pt idx="156">0.041999599999999998</cx:pt>
          <cx:pt idx="157">0.069944500000000007</cx:pt>
          <cx:pt idx="158">0.032573100000000001</cx:pt>
          <cx:pt idx="159">0.061034900000000003</cx:pt>
          <cx:pt idx="160">0.070097300000000001</cx:pt>
          <cx:pt idx="161">0.076826599999999995</cx:pt>
          <cx:pt idx="162">0.038791899999999997</cx:pt>
          <cx:pt idx="163">0.078617800000000002</cx:pt>
          <cx:pt idx="164">0.042586300000000001</cx:pt>
          <cx:pt idx="165">0.053038200000000001</cx:pt>
          <cx:pt idx="166">0.0460507</cx:pt>
          <cx:pt idx="167">0.082250799999999999</cx:pt>
          <cx:pt idx="168">0.048823100000000001</cx:pt>
          <cx:pt idx="169">0.042744499999999998</cx:pt>
          <cx:pt idx="170">0.039676200000000002</cx:pt>
          <cx:pt idx="171">0.072914400000000004</cx:pt>
          <cx:pt idx="172">0.036953399999999997</cx:pt>
          <cx:pt idx="173">0.049954199999999997</cx:pt>
          <cx:pt idx="174">0.074545500000000001</cx:pt>
          <cx:pt idx="175">0.047012199999999997</cx:pt>
          <cx:pt idx="176">0.047164600000000001</cx:pt>
          <cx:pt idx="177">0.080229599999999998</cx:pt>
          <cx:pt idx="178">0.062647900000000006</cx:pt>
          <cx:pt idx="179">0.088406200000000004</cx:pt>
          <cx:pt idx="180">0.077286999999999995</cx:pt>
          <cx:pt idx="181">0.053075299999999999</cx:pt>
          <cx:pt idx="182">0.077754500000000004</cx:pt>
          <cx:pt idx="183">0.057197600000000001</cx:pt>
          <cx:pt idx="184">0.079051499999999997</cx:pt>
          <cx:pt idx="185">0.046846499999999999</cx:pt>
          <cx:pt idx="186">0.077651100000000001</cx:pt>
          <cx:pt idx="187">0.060363899999999998</cx:pt>
          <cx:pt idx="188">0.056642999999999999</cx:pt>
          <cx:pt idx="189">0.095106099999999999</cx:pt>
          <cx:pt idx="190">0.055780900000000001</cx:pt>
          <cx:pt idx="191">0.0679448</cx:pt>
          <cx:pt idx="192">0.060112199999999998</cx:pt>
          <cx:pt idx="193">0.063858799999999993</cx:pt>
          <cx:pt idx="194">0.068547800000000006</cx:pt>
          <cx:pt idx="195">0.068113000000000007</cx:pt>
          <cx:pt idx="196">0.0477671</cx:pt>
          <cx:pt idx="197">0.047849299999999997</cx:pt>
          <cx:pt idx="198">0.057304500000000001</cx:pt>
          <cx:pt idx="199">0.041905199999999997</cx:pt>
          <cx:pt idx="200">0.059218699999999999</cx:pt>
          <cx:pt idx="201">0.0700374</cx:pt>
          <cx:pt idx="202">0.076376399999999997</cx:pt>
          <cx:pt idx="203">0.052421200000000001</cx:pt>
          <cx:pt idx="204">0.060147800000000001</cx:pt>
          <cx:pt idx="205">0.077020699999999997</cx:pt>
          <cx:pt idx="206">0.066253599999999996</cx:pt>
          <cx:pt idx="207">0.060047999999999997</cx:pt>
          <cx:pt idx="208">0.0668015</cx:pt>
          <cx:pt idx="209">0.040619799999999998</cx:pt>
          <cx:pt idx="210">0.064616099999999996</cx:pt>
          <cx:pt idx="211">0.059851300000000003</cx:pt>
          <cx:pt idx="212">0.044587599999999998</cx:pt>
          <cx:pt idx="213">0.066174700000000003</cx:pt>
          <cx:pt idx="214">0.063740599999999994</cx:pt>
          <cx:pt idx="215">0.046771899999999998</cx:pt>
          <cx:pt idx="216">0.034805799999999998</cx:pt>
          <cx:pt idx="217">0.062080799999999998</cx:pt>
          <cx:pt idx="218">0.045050399999999997</cx:pt>
          <cx:pt idx="219">0.073159100000000005</cx:pt>
          <cx:pt idx="220">0.066618999999999998</cx:pt>
          <cx:pt idx="221">0.083866499999999997</cx:pt>
          <cx:pt idx="222">0.051375799999999999</cx:pt>
          <cx:pt idx="223">0.060811200000000003</cx:pt>
          <cx:pt idx="224">0.054302200000000002</cx:pt>
          <cx:pt idx="225">0.071002399999999993</cx:pt>
          <cx:pt idx="226">0.055319399999999998</cx:pt>
          <cx:pt idx="227">0.0963445</cx:pt>
          <cx:pt idx="228">0.053082900000000002</cx:pt>
          <cx:pt idx="229">0.092042899999999997</cx:pt>
          <cx:pt idx="230">0.086975899999999995</cx:pt>
          <cx:pt idx="231">0.053616999999999998</cx:pt>
          <cx:pt idx="232">0.073000700000000002</cx:pt>
          <cx:pt idx="233">0.036013099999999999</cx:pt>
          <cx:pt idx="234">0.060438100000000002</cx:pt>
          <cx:pt idx="235">0.053379099999999999</cx:pt>
          <cx:pt idx="236">0.055554800000000001</cx:pt>
          <cx:pt idx="237">0.066033400000000006</cx:pt>
          <cx:pt idx="238">0.053042899999999997</cx:pt>
          <cx:pt idx="239">0.041402899999999999</cx:pt>
          <cx:pt idx="240">0.070933300000000005</cx:pt>
          <cx:pt idx="241">0.049044200000000003</cx:pt>
          <cx:pt idx="242">0.072703299999999998</cx:pt>
          <cx:pt idx="243">0.044633300000000001</cx:pt>
          <cx:pt idx="244">0.067389299999999999</cx:pt>
          <cx:pt idx="245">0.050084400000000001</cx:pt>
          <cx:pt idx="246">0.057989600000000002</cx:pt>
          <cx:pt idx="247">0.072266700000000003</cx:pt>
          <cx:pt idx="248">0.072232599999999994</cx:pt>
          <cx:pt idx="249">0.041513899999999999</cx:pt>
          <cx:pt idx="250">0.040008299999999997</cx:pt>
          <cx:pt idx="251">0.055889099999999997</cx:pt>
          <cx:pt idx="252">0.076227299999999998</cx:pt>
          <cx:pt idx="253">0.073205500000000007</cx:pt>
          <cx:pt idx="254">0.045057800000000002</cx:pt>
          <cx:pt idx="255">0.054497799999999999</cx:pt>
          <cx:pt idx="256">0.055050599999999998</cx:pt>
          <cx:pt idx="257">0.047258700000000001</cx:pt>
          <cx:pt idx="258">0.031951199999999999</cx:pt>
          <cx:pt idx="259">0.068787299999999996</cx:pt>
          <cx:pt idx="260">0.067798700000000003</cx:pt>
          <cx:pt idx="261">0.038570399999999998</cx:pt>
          <cx:pt idx="262">0.081716899999999995</cx:pt>
          <cx:pt idx="263">0.043251600000000001</cx:pt>
          <cx:pt idx="264">0.035322199999999998</cx:pt>
          <cx:pt idx="265">0.0342492</cx:pt>
          <cx:pt idx="266">0.054956600000000001</cx:pt>
          <cx:pt idx="267">0.042393500000000001</cx:pt>
          <cx:pt idx="268">0.050262399999999999</cx:pt>
          <cx:pt idx="269">0.048927400000000003</cx:pt>
          <cx:pt idx="270">0.090250399999999995</cx:pt>
          <cx:pt idx="271">0.070668300000000003</cx:pt>
          <cx:pt idx="272">0.055262899999999997</cx:pt>
          <cx:pt idx="273">0.061234299999999998</cx:pt>
          <cx:pt idx="274">0.059037800000000001</cx:pt>
          <cx:pt idx="275">0.051331799999999997</cx:pt>
          <cx:pt idx="276">0.063181699999999993</cx:pt>
          <cx:pt idx="277">0.050977500000000002</cx:pt>
          <cx:pt idx="278">0.072594199999999998</cx:pt>
          <cx:pt idx="279">0.073979100000000006</cx:pt>
          <cx:pt idx="280">0.058802500000000001</cx:pt>
          <cx:pt idx="281">0.072808200000000003</cx:pt>
          <cx:pt idx="282">0.091786999999999994</cx:pt>
          <cx:pt idx="283">0.038507600000000003</cx:pt>
          <cx:pt idx="284">0.047760299999999999</cx:pt>
          <cx:pt idx="285">0.073168700000000003</cx:pt>
          <cx:pt idx="286">0.0537657</cx:pt>
          <cx:pt idx="287">0.073339100000000004</cx:pt>
          <cx:pt idx="288">0.0598015</cx:pt>
          <cx:pt idx="289">0.068220299999999998</cx:pt>
          <cx:pt idx="290">0.024096900000000001</cx:pt>
          <cx:pt idx="291">0.052358599999999998</cx:pt>
          <cx:pt idx="292">0.065593200000000004</cx:pt>
          <cx:pt idx="293">0.053719700000000002</cx:pt>
          <cx:pt idx="294">0.0181593</cx:pt>
          <cx:pt idx="295">0.057824199999999999</cx:pt>
          <cx:pt idx="296">0.056220899999999997</cx:pt>
          <cx:pt idx="297">0.074548299999999998</cx:pt>
          <cx:pt idx="298">0.056386600000000002</cx:pt>
          <cx:pt idx="299">0.038157099999999999</cx:pt>
          <cx:pt idx="300">0.056911200000000002</cx:pt>
          <cx:pt idx="301">0.070060999999999998</cx:pt>
          <cx:pt idx="302">0.044785199999999997</cx:pt>
          <cx:pt idx="303">0.072311100000000003</cx:pt>
          <cx:pt idx="304">0.058465299999999998</cx:pt>
          <cx:pt idx="305">0.062389</cx:pt>
          <cx:pt idx="306">0.059434899999999999</cx:pt>
          <cx:pt idx="307">0.030332499999999998</cx:pt>
          <cx:pt idx="308">0.050714200000000001</cx:pt>
          <cx:pt idx="309">0.068345299999999998</cx:pt>
          <cx:pt idx="310">0.053954099999999998</cx:pt>
          <cx:pt idx="311">0.0632548</cx:pt>
          <cx:pt idx="312">0.070753099999999999</cx:pt>
          <cx:pt idx="313">0.060595499999999997</cx:pt>
          <cx:pt idx="314">0.054406900000000001</cx:pt>
          <cx:pt idx="315">0.080864699999999998</cx:pt>
          <cx:pt idx="316">0.0546209</cx:pt>
          <cx:pt idx="317">0.080387200000000006</cx:pt>
          <cx:pt idx="318">0.033061800000000002</cx:pt>
          <cx:pt idx="319">0.0417236</cx:pt>
          <cx:pt idx="320">0.053926799999999997</cx:pt>
          <cx:pt idx="321">0.0588418</cx:pt>
          <cx:pt idx="322">0.052653199999999997</cx:pt>
          <cx:pt idx="323">0.0795183</cx:pt>
          <cx:pt idx="324">0.0412217</cx:pt>
          <cx:pt idx="325">0.085814500000000002</cx:pt>
          <cx:pt idx="326">0.062048199999999998</cx:pt>
          <cx:pt idx="327">0.077873600000000001</cx:pt>
          <cx:pt idx="328">0.065738500000000005</cx:pt>
          <cx:pt idx="329">0.073649999999999993</cx:pt>
          <cx:pt idx="330">0.059466100000000001</cx:pt>
          <cx:pt idx="331">0.058797599999999998</cx:pt>
          <cx:pt idx="332">0.086207300000000001</cx:pt>
          <cx:pt idx="333">0.068390500000000007</cx:pt>
          <cx:pt idx="334">0.083571599999999996</cx:pt>
          <cx:pt idx="335">0.079617199999999999</cx:pt>
          <cx:pt idx="336">0.078436900000000004</cx:pt>
          <cx:pt idx="337">0.044708600000000001</cx:pt>
          <cx:pt idx="338">0.051645200000000002</cx:pt>
          <cx:pt idx="339">0.045613099999999997</cx:pt>
          <cx:pt idx="340">0.017869199999999998</cx:pt>
          <cx:pt idx="341">0.071460399999999993</cx:pt>
          <cx:pt idx="342">0.048706100000000002</cx:pt>
          <cx:pt idx="343">0.066899299999999995</cx:pt>
          <cx:pt idx="344">0.063032099999999994</cx:pt>
          <cx:pt idx="345">0.083545400000000006</cx:pt>
          <cx:pt idx="346">0.0384496</cx:pt>
          <cx:pt idx="347">0.043112499999999998</cx:pt>
          <cx:pt idx="348">0.084541500000000006</cx:pt>
          <cx:pt idx="349">0.0638735</cx:pt>
          <cx:pt idx="350">0.055652500000000001</cx:pt>
          <cx:pt idx="351">0.056220600000000003</cx:pt>
          <cx:pt idx="352">0.079201800000000003</cx:pt>
          <cx:pt idx="353">0.080497600000000002</cx:pt>
          <cx:pt idx="354">0.089014899999999994</cx:pt>
          <cx:pt idx="355">0.068017499999999995</cx:pt>
          <cx:pt idx="356">0.054965199999999999</cx:pt>
          <cx:pt idx="357">0.050580600000000003</cx:pt>
          <cx:pt idx="358">0.061639699999999999</cx:pt>
          <cx:pt idx="359">0.052405399999999998</cx:pt>
          <cx:pt idx="360">0.070496600000000006</cx:pt>
          <cx:pt idx="361">0.044795300000000003</cx:pt>
          <cx:pt idx="362">0.052912500000000001</cx:pt>
          <cx:pt idx="363">0.061364500000000002</cx:pt>
          <cx:pt idx="364">0.060171200000000001</cx:pt>
          <cx:pt idx="365">0.035758499999999999</cx:pt>
          <cx:pt idx="366">0.049132700000000001</cx:pt>
          <cx:pt idx="367">0.067984900000000001</cx:pt>
          <cx:pt idx="368">0.058410700000000003</cx:pt>
          <cx:pt idx="369">0.040723500000000003</cx:pt>
          <cx:pt idx="370">0.047549800000000003</cx:pt>
          <cx:pt idx="371">0.037526400000000001</cx:pt>
          <cx:pt idx="372">0.078389200000000006</cx:pt>
          <cx:pt idx="373">0.057556000000000003</cx:pt>
          <cx:pt idx="374">0.068456900000000001</cx:pt>
          <cx:pt idx="375">0.055662900000000001</cx:pt>
          <cx:pt idx="376">0.037816500000000003</cx:pt>
          <cx:pt idx="377">0.062916700000000006</cx:pt>
          <cx:pt idx="378">0.0509451</cx:pt>
          <cx:pt idx="379">0.065178799999999995</cx:pt>
          <cx:pt idx="380">0.066698199999999999</cx:pt>
          <cx:pt idx="381">0.0575354</cx:pt>
          <cx:pt idx="382">0.049797399999999999</cx:pt>
          <cx:pt idx="383">0.059070999999999999</cx:pt>
          <cx:pt idx="384">0.040115999999999999</cx:pt>
          <cx:pt idx="385">0.052608200000000001</cx:pt>
          <cx:pt idx="386">0.055622100000000001</cx:pt>
          <cx:pt idx="387">0.060921900000000001</cx:pt>
          <cx:pt idx="388">0.068246000000000001</cx:pt>
          <cx:pt idx="389">0.056339899999999998</cx:pt>
          <cx:pt idx="390">0.073043499999999997</cx:pt>
          <cx:pt idx="391">0.0647234</cx:pt>
          <cx:pt idx="392">0.049408500000000001</cx:pt>
          <cx:pt idx="393">0.052219399999999999</cx:pt>
          <cx:pt idx="394">0.054819300000000001</cx:pt>
          <cx:pt idx="395">0.049044299999999999</cx:pt>
          <cx:pt idx="396">0.0581413</cx:pt>
          <cx:pt idx="397">0.055563399999999999</cx:pt>
          <cx:pt idx="398">0.045024599999999998</cx:pt>
          <cx:pt idx="399">0.0424555</cx:pt>
          <cx:pt idx="400">0.078682600000000005</cx:pt>
          <cx:pt idx="401">0.047083899999999998</cx:pt>
          <cx:pt idx="402">0.065480200000000002</cx:pt>
          <cx:pt idx="403">0.069115200000000002</cx:pt>
          <cx:pt idx="404">0.090020000000000003</cx:pt>
          <cx:pt idx="405">0.0590568</cx:pt>
          <cx:pt idx="406">0.052205000000000001</cx:pt>
          <cx:pt idx="407">0.058492000000000002</cx:pt>
          <cx:pt idx="408">0.057253199999999997</cx:pt>
          <cx:pt idx="409">0.053481899999999999</cx:pt>
          <cx:pt idx="410">0.048677400000000003</cx:pt>
          <cx:pt idx="411">0.0546431</cx:pt>
          <cx:pt idx="412">0.054882</cx:pt>
          <cx:pt idx="413">0.062782900000000003</cx:pt>
          <cx:pt idx="414">0.027591899999999999</cx:pt>
          <cx:pt idx="415">0.045064399999999998</cx:pt>
          <cx:pt idx="416">0.042164500000000001</cx:pt>
          <cx:pt idx="417">0.085110599999999995</cx:pt>
          <cx:pt idx="418">0.067631999999999998</cx:pt>
          <cx:pt idx="419">0.0610915</cx:pt>
          <cx:pt idx="420">0.077681299999999995</cx:pt>
          <cx:pt idx="421">0.054097100000000002</cx:pt>
          <cx:pt idx="422">0.041420499999999999</cx:pt>
          <cx:pt idx="423">0.033343600000000001</cx:pt>
          <cx:pt idx="424">0.070142700000000002</cx:pt>
          <cx:pt idx="425">0.068951799999999994</cx:pt>
          <cx:pt idx="426">0.072449700000000006</cx:pt>
          <cx:pt idx="427">0.047542399999999999</cx:pt>
          <cx:pt idx="428">0.066326800000000005</cx:pt>
          <cx:pt idx="429">0.055370700000000002</cx:pt>
          <cx:pt idx="430">0.0733129</cx:pt>
          <cx:pt idx="431">0.026671400000000001</cx:pt>
          <cx:pt idx="432">0.054295799999999998</cx:pt>
          <cx:pt idx="433">0.053006200000000003</cx:pt>
          <cx:pt idx="434">0.070651800000000001</cx:pt>
          <cx:pt idx="435">0.044309500000000002</cx:pt>
          <cx:pt idx="436">0.067814700000000006</cx:pt>
          <cx:pt idx="437">0.068227399999999994</cx:pt>
          <cx:pt idx="438">0.052358200000000001</cx:pt>
          <cx:pt idx="439">0.072879700000000006</cx:pt>
          <cx:pt idx="440">0.038619599999999997</cx:pt>
          <cx:pt idx="441">0.051719800000000003</cx:pt>
          <cx:pt idx="442">0.069967199999999993</cx:pt>
          <cx:pt idx="443">0.062675999999999996</cx:pt>
          <cx:pt idx="444">0.077297299999999999</cx:pt>
          <cx:pt idx="445">0.068938899999999997</cx:pt>
          <cx:pt idx="446">0.066214599999999998</cx:pt>
          <cx:pt idx="447">0.078132599999999996</cx:pt>
          <cx:pt idx="448">0.0458994</cx:pt>
          <cx:pt idx="449">0.056871699999999997</cx:pt>
          <cx:pt idx="450">0.067556900000000003</cx:pt>
          <cx:pt idx="451">0.047996999999999998</cx:pt>
          <cx:pt idx="452">0.0507844</cx:pt>
          <cx:pt idx="453">0.049992000000000002</cx:pt>
          <cx:pt idx="454">0.071837799999999993</cx:pt>
          <cx:pt idx="455">0.060793399999999997</cx:pt>
          <cx:pt idx="456">0.073030999999999999</cx:pt>
          <cx:pt idx="457">0.071721900000000005</cx:pt>
          <cx:pt idx="458">0.055848200000000001</cx:pt>
          <cx:pt idx="459">0.069339600000000001</cx:pt>
          <cx:pt idx="460">0.066241599999999998</cx:pt>
          <cx:pt idx="461">0.051530100000000002</cx:pt>
          <cx:pt idx="462">0.081828899999999996</cx:pt>
          <cx:pt idx="463">0.087307499999999996</cx:pt>
          <cx:pt idx="464">0.038522800000000003</cx:pt>
          <cx:pt idx="465">0.040640500000000003</cx:pt>
          <cx:pt idx="466">0.075989500000000001</cx:pt>
          <cx:pt idx="467">0.076018100000000005</cx:pt>
          <cx:pt idx="468">0.058286200000000003</cx:pt>
          <cx:pt idx="469">0.072775400000000004</cx:pt>
          <cx:pt idx="470">0.077981200000000001</cx:pt>
          <cx:pt idx="471">0.0567912</cx:pt>
          <cx:pt idx="472">0.0583218</cx:pt>
          <cx:pt idx="473">0.094450599999999996</cx:pt>
          <cx:pt idx="474">0.063279199999999994</cx:pt>
          <cx:pt idx="475">0.036455300000000003</cx:pt>
          <cx:pt idx="476">0.055761699999999997</cx:pt>
          <cx:pt idx="477">0.074620800000000001</cx:pt>
          <cx:pt idx="478">0.054393200000000003</cx:pt>
          <cx:pt idx="479">0.041738499999999998</cx:pt>
          <cx:pt idx="480">0.0762293</cx:pt>
          <cx:pt idx="481">0.0429504</cx:pt>
          <cx:pt idx="482">0.082814700000000005</cx:pt>
          <cx:pt idx="483">0.085231500000000002</cx:pt>
          <cx:pt idx="484">0.077119499999999994</cx:pt>
          <cx:pt idx="485">0.059836800000000002</cx:pt>
          <cx:pt idx="486">0.0488245</cx:pt>
          <cx:pt idx="487">0.050011</cx:pt>
          <cx:pt idx="488">0.069919400000000007</cx:pt>
          <cx:pt idx="489">0.067260100000000003</cx:pt>
          <cx:pt idx="490">0.052868699999999998</cx:pt>
          <cx:pt idx="491">0.060929400000000002</cx:pt>
          <cx:pt idx="492">0.068389800000000001</cx:pt>
          <cx:pt idx="493">0.043401700000000001</cx:pt>
          <cx:pt idx="494">0.069365099999999999</cx:pt>
          <cx:pt idx="495">0.060024599999999997</cx:pt>
          <cx:pt idx="496">0.024802600000000001</cx:pt>
          <cx:pt idx="497">0.052859900000000001</cx:pt>
          <cx:pt idx="498">0.056184499999999998</cx:pt>
          <cx:pt idx="499">0.052788099999999998</cx:pt>
          <cx:pt idx="500">0.048146000000000001</cx:pt>
          <cx:pt idx="501">0.047932200000000001</cx:pt>
          <cx:pt idx="502">0.072068300000000002</cx:pt>
          <cx:pt idx="503">0.072571999999999998</cx:pt>
          <cx:pt idx="504">0.065178399999999997</cx:pt>
          <cx:pt idx="505">0.058314999999999999</cx:pt>
          <cx:pt idx="506">0.051189699999999998</cx:pt>
          <cx:pt idx="507">0.058987199999999997</cx:pt>
          <cx:pt idx="508">0.0470555</cx:pt>
          <cx:pt idx="509">0.058326900000000001</cx:pt>
          <cx:pt idx="510">0.081009800000000007</cx:pt>
          <cx:pt idx="511">0.054317999999999998</cx:pt>
          <cx:pt idx="512">0.062875799999999996</cx:pt>
          <cx:pt idx="513">0.049265999999999997</cx:pt>
          <cx:pt idx="514">0.042350800000000001</cx:pt>
          <cx:pt idx="515">0.080410300000000004</cx:pt>
          <cx:pt idx="516">0.051003699999999999</cx:pt>
          <cx:pt idx="517">0.075896699999999997</cx:pt>
          <cx:pt idx="518">0.089746699999999999</cx:pt>
          <cx:pt idx="519">0.061724399999999999</cx:pt>
          <cx:pt idx="520">0.043781</cx:pt>
          <cx:pt idx="521">0.072519399999999998</cx:pt>
          <cx:pt idx="522">0.058994199999999997</cx:pt>
          <cx:pt idx="523">0.092250899999999997</cx:pt>
          <cx:pt idx="524">0.0606463</cx:pt>
          <cx:pt idx="525">0.0342866</cx:pt>
          <cx:pt idx="526">0.059799900000000003</cx:pt>
          <cx:pt idx="527">0.071895000000000001</cx:pt>
          <cx:pt idx="528">0.085033399999999995</cx:pt>
          <cx:pt idx="529">0.051901099999999999</cx:pt>
          <cx:pt idx="530">0.048976800000000001</cx:pt>
          <cx:pt idx="531">0.048030299999999998</cx:pt>
          <cx:pt idx="532">0.047060400000000002</cx:pt>
          <cx:pt idx="533">0.0226523</cx:pt>
          <cx:pt idx="534">0.057303300000000001</cx:pt>
          <cx:pt idx="535">0.049682799999999999</cx:pt>
          <cx:pt idx="536">0.048513500000000001</cx:pt>
          <cx:pt idx="537">0.0682363</cx:pt>
          <cx:pt idx="538">0.084986900000000004</cx:pt>
          <cx:pt idx="539">0.073580699999999999</cx:pt>
          <cx:pt idx="540">0.061975799999999998</cx:pt>
          <cx:pt idx="541">0.065603599999999998</cx:pt>
          <cx:pt idx="542">0.058670899999999998</cx:pt>
          <cx:pt idx="543">0.060451199999999997</cx:pt>
          <cx:pt idx="544">0.051416900000000001</cx:pt>
          <cx:pt idx="545">0.047534199999999999</cx:pt>
          <cx:pt idx="546">0.081672599999999998</cx:pt>
          <cx:pt idx="547">0.0498462</cx:pt>
          <cx:pt idx="548">0.064206399999999997</cx:pt>
          <cx:pt idx="549">0.070429800000000001</cx:pt>
          <cx:pt idx="550">0.0574659</cx:pt>
          <cx:pt idx="551">0.054310700000000003</cx:pt>
          <cx:pt idx="552">0.072286699999999995</cx:pt>
          <cx:pt idx="553">0.062873999999999999</cx:pt>
          <cx:pt idx="554">0.042250799999999998</cx:pt>
          <cx:pt idx="555">0.061296799999999999</cx:pt>
          <cx:pt idx="556">0.061146699999999998</cx:pt>
          <cx:pt idx="557">0.084175899999999998</cx:pt>
          <cx:pt idx="558">0.0576838</cx:pt>
          <cx:pt idx="559">0.073659299999999997</cx:pt>
          <cx:pt idx="560">0.090253899999999998</cx:pt>
          <cx:pt idx="561">0.063295599999999994</cx:pt>
          <cx:pt idx="562">0.061707999999999999</cx:pt>
          <cx:pt idx="563">0.055471699999999999</cx:pt>
          <cx:pt idx="564">0.036242299999999998</cx:pt>
          <cx:pt idx="565">0.0788383</cx:pt>
          <cx:pt idx="566">0.029813300000000001</cx:pt>
          <cx:pt idx="567">0.054615299999999999</cx:pt>
          <cx:pt idx="568">0.052507499999999999</cx:pt>
          <cx:pt idx="569">0.0670544</cx:pt>
          <cx:pt idx="570">0.042296300000000002</cx:pt>
          <cx:pt idx="571">0.056717900000000002</cx:pt>
          <cx:pt idx="572">0.051160799999999999</cx:pt>
          <cx:pt idx="573">0.087269200000000005</cx:pt>
          <cx:pt idx="574">0.069172700000000004</cx:pt>
          <cx:pt idx="575">0.033099900000000002</cx:pt>
          <cx:pt idx="576">0.0479481</cx:pt>
          <cx:pt idx="577">0.067133700000000004</cx:pt>
          <cx:pt idx="578">0.077740199999999995</cx:pt>
          <cx:pt idx="579">0.075237700000000005</cx:pt>
          <cx:pt idx="580">0.077725000000000002</cx:pt>
          <cx:pt idx="581">0.024886800000000001</cx:pt>
          <cx:pt idx="582">0.085743399999999997</cx:pt>
          <cx:pt idx="583">0.025285800000000001</cx:pt>
          <cx:pt idx="584">0.069386100000000006</cx:pt>
          <cx:pt idx="585">0.050921599999999997</cx:pt>
          <cx:pt idx="586">0.074627799999999994</cx:pt>
          <cx:pt idx="587">0.056577299999999997</cx:pt>
          <cx:pt idx="588">0.073272799999999999</cx:pt>
          <cx:pt idx="589">0.045845499999999997</cx:pt>
          <cx:pt idx="590">0.0432945</cx:pt>
          <cx:pt idx="591">0.057353099999999997</cx:pt>
          <cx:pt idx="592">0.053643999999999997</cx:pt>
          <cx:pt idx="593">0.042264799999999998</cx:pt>
          <cx:pt idx="594">0.0712203</cx:pt>
          <cx:pt idx="595">0.045550599999999997</cx:pt>
          <cx:pt idx="596">0.066320599999999993</cx:pt>
          <cx:pt idx="597">0.060603200000000003</cx:pt>
          <cx:pt idx="598">0.054794299999999997</cx:pt>
          <cx:pt idx="599">0.089786199999999997</cx:pt>
          <cx:pt idx="600">0.064243099999999997</cx:pt>
          <cx:pt idx="601">0.075690199999999999</cx:pt>
          <cx:pt idx="602">0.0774252</cx:pt>
          <cx:pt idx="603">0.065373200000000006</cx:pt>
          <cx:pt idx="604">0.053941200000000002</cx:pt>
          <cx:pt idx="605">0.080020599999999997</cx:pt>
          <cx:pt idx="606">0.054287799999999997</cx:pt>
          <cx:pt idx="607">0.065786999999999998</cx:pt>
          <cx:pt idx="608">0.047354199999999999</cx:pt>
          <cx:pt idx="609">0.067139400000000002</cx:pt>
          <cx:pt idx="610">0.052196100000000002</cx:pt>
          <cx:pt idx="611">0.0583136</cx:pt>
          <cx:pt idx="612">0.073936299999999996</cx:pt>
          <cx:pt idx="613">0.077788800000000005</cx:pt>
          <cx:pt idx="614">0.060614599999999998</cx:pt>
          <cx:pt idx="615">0.060790900000000002</cx:pt>
          <cx:pt idx="616">0.043908799999999998</cx:pt>
          <cx:pt idx="617">0.055219499999999998</cx:pt>
          <cx:pt idx="618">0.072267200000000004</cx:pt>
          <cx:pt idx="619">0.048555000000000001</cx:pt>
          <cx:pt idx="620">0.049745499999999998</cx:pt>
          <cx:pt idx="621">0.046554900000000003</cx:pt>
          <cx:pt idx="622">0.054938399999999998</cx:pt>
          <cx:pt idx="623">0.072619600000000006</cx:pt>
          <cx:pt idx="624">0.059002100000000002</cx:pt>
          <cx:pt idx="625">0.071368200000000007</cx:pt>
          <cx:pt idx="626">0.060493600000000002</cx:pt>
          <cx:pt idx="627">0.056276899999999998</cx:pt>
          <cx:pt idx="628">0.041594800000000001</cx:pt>
          <cx:pt idx="629">0.050740100000000003</cx:pt>
          <cx:pt idx="630">0.068261199999999994</cx:pt>
          <cx:pt idx="631">0.045317099999999999</cx:pt>
          <cx:pt idx="632">0.093150499999999997</cx:pt>
          <cx:pt idx="633">0.037849500000000001</cx:pt>
          <cx:pt idx="634">0.046609900000000003</cx:pt>
          <cx:pt idx="635">0.054461299999999997</cx:pt>
          <cx:pt idx="636">0.061984900000000002</cx:pt>
          <cx:pt idx="637">0.075662800000000002</cx:pt>
          <cx:pt idx="638">0.064125000000000001</cx:pt>
          <cx:pt idx="639">0.035780100000000002</cx:pt>
          <cx:pt idx="640">0.035213099999999997</cx:pt>
          <cx:pt idx="641">0.063276600000000002</cx:pt>
          <cx:pt idx="642">0.045741700000000003</cx:pt>
          <cx:pt idx="643">0.068861400000000003</cx:pt>
          <cx:pt idx="644">0.053749499999999999</cx:pt>
          <cx:pt idx="645">0.083688399999999996</cx:pt>
          <cx:pt idx="646">0.066630099999999998</cx:pt>
          <cx:pt idx="647">0.071099999999999997</cx:pt>
          <cx:pt idx="648">0.096213499999999993</cx:pt>
          <cx:pt idx="649">0.071947399999999995</cx:pt>
          <cx:pt idx="650">0.0277238</cx:pt>
          <cx:pt idx="651">0.069641400000000006</cx:pt>
          <cx:pt idx="652">0.057083099999999998</cx:pt>
          <cx:pt idx="653">0.039163999999999997</cx:pt>
          <cx:pt idx="654">0.085800100000000004</cx:pt>
          <cx:pt idx="655">0.075224200000000005</cx:pt>
          <cx:pt idx="656">0.083754200000000001</cx:pt>
          <cx:pt idx="657">0.042519300000000003</cx:pt>
          <cx:pt idx="658">0.065690299999999993</cx:pt>
          <cx:pt idx="659">0.052307800000000002</cx:pt>
          <cx:pt idx="660">0.067351499999999995</cx:pt>
          <cx:pt idx="661">0.052069299999999999</cx:pt>
          <cx:pt idx="662">0.049626999999999998</cx:pt>
          <cx:pt idx="663">0.072659000000000001</cx:pt>
          <cx:pt idx="664">0.076878500000000002</cx:pt>
          <cx:pt idx="665">0.0474609</cx:pt>
          <cx:pt idx="666">0.062552099999999999</cx:pt>
          <cx:pt idx="667">0.0613041</cx:pt>
          <cx:pt idx="668">0.045830999999999997</cx:pt>
          <cx:pt idx="669">0.065906699999999999</cx:pt>
          <cx:pt idx="670">0.033314799999999999</cx:pt>
          <cx:pt idx="671">0.069936499999999999</cx:pt>
          <cx:pt idx="672">0.060188699999999998</cx:pt>
          <cx:pt idx="673">0.080655400000000002</cx:pt>
          <cx:pt idx="674">0.041853599999999998</cx:pt>
          <cx:pt idx="675">0.065727900000000006</cx:pt>
          <cx:pt idx="676">0.047852800000000001</cx:pt>
          <cx:pt idx="677">0.082747000000000001</cx:pt>
          <cx:pt idx="678">0.0427692</cx:pt>
          <cx:pt idx="679">0.071117</cx:pt>
          <cx:pt idx="680">0.066765199999999997</cx:pt>
          <cx:pt idx="681">0.042138700000000001</cx:pt>
          <cx:pt idx="682">0.057110000000000001</cx:pt>
          <cx:pt idx="683">0.076321100000000003</cx:pt>
          <cx:pt idx="684">0.046296799999999999</cx:pt>
          <cx:pt idx="685">0.023731200000000001</cx:pt>
          <cx:pt idx="686">0.067024399999999998</cx:pt>
          <cx:pt idx="687">0.058428399999999998</cx:pt>
          <cx:pt idx="688">0.035432199999999997</cx:pt>
          <cx:pt idx="689">0.084364999999999996</cx:pt>
          <cx:pt idx="690">0.061114599999999998</cx:pt>
          <cx:pt idx="691">0.049091900000000001</cx:pt>
          <cx:pt idx="692">0.0432028</cx:pt>
          <cx:pt idx="693">0.049461600000000001</cx:pt>
          <cx:pt idx="694">0.075643699999999994</cx:pt>
          <cx:pt idx="695">0.0492989</cx:pt>
          <cx:pt idx="696">0.087792700000000001</cx:pt>
          <cx:pt idx="697">0.044480699999999998</cx:pt>
          <cx:pt idx="698">0.068199399999999993</cx:pt>
          <cx:pt idx="699">0.078968399999999994</cx:pt>
          <cx:pt idx="700">0.084360400000000002</cx:pt>
          <cx:pt idx="701">0.068817400000000001</cx:pt>
          <cx:pt idx="702">0.051311799999999998</cx:pt>
          <cx:pt idx="703">0.055516599999999999</cx:pt>
          <cx:pt idx="704">0.0623067</cx:pt>
          <cx:pt idx="705">0.077093599999999998</cx:pt>
          <cx:pt idx="706">0.063785400000000006</cx:pt>
          <cx:pt idx="707">0.070784</cx:pt>
          <cx:pt idx="708">0.055432700000000001</cx:pt>
          <cx:pt idx="709">0.059074700000000001</cx:pt>
          <cx:pt idx="710">0.054095400000000002</cx:pt>
          <cx:pt idx="711">0.075865199999999994</cx:pt>
          <cx:pt idx="712">0.054560999999999998</cx:pt>
          <cx:pt idx="713">0.063677600000000001</cx:pt>
          <cx:pt idx="714">0.056022200000000001</cx:pt>
          <cx:pt idx="715">0.046505499999999998</cx:pt>
          <cx:pt idx="716">0.091748499999999997</cx:pt>
          <cx:pt idx="717">0.0408175</cx:pt>
          <cx:pt idx="718">0.045690000000000001</cx:pt>
          <cx:pt idx="719">0.065476000000000006</cx:pt>
          <cx:pt idx="720">0.078730999999999995</cx:pt>
          <cx:pt idx="721">0.051669399999999997</cx:pt>
          <cx:pt idx="722">0.041137399999999998</cx:pt>
          <cx:pt idx="723">0.0452761</cx:pt>
          <cx:pt idx="724">0.068554400000000001</cx:pt>
          <cx:pt idx="725">0.037833600000000002</cx:pt>
          <cx:pt idx="726">0.056651300000000002</cx:pt>
          <cx:pt idx="727">0.074231800000000001</cx:pt>
          <cx:pt idx="728">0.044349699999999999</cx:pt>
          <cx:pt idx="729">0.065778600000000007</cx:pt>
          <cx:pt idx="730">0.063747799999999993</cx:pt>
          <cx:pt idx="731">0.058603099999999998</cx:pt>
          <cx:pt idx="732">0.084856200000000007</cx:pt>
          <cx:pt idx="733">0.060381900000000002</cx:pt>
          <cx:pt idx="734">0.049481799999999999</cx:pt>
          <cx:pt idx="735">0.048264399999999999</cx:pt>
          <cx:pt idx="736">0.0570822</cx:pt>
          <cx:pt idx="737">0.067289699999999994</cx:pt>
          <cx:pt idx="738">0.057296399999999997</cx:pt>
          <cx:pt idx="739">0.056914300000000001</cx:pt>
          <cx:pt idx="740">0.049975199999999997</cx:pt>
          <cx:pt idx="741">0.041473799999999998</cx:pt>
          <cx:pt idx="742">0.075255500000000003</cx:pt>
          <cx:pt idx="743">0.0600913</cx:pt>
          <cx:pt idx="744">0.0594113</cx:pt>
          <cx:pt idx="745">0.071445900000000007</cx:pt>
          <cx:pt idx="746">0.105902</cx:pt>
          <cx:pt idx="747">0.073097200000000001</cx:pt>
          <cx:pt idx="748">0.051159900000000001</cx:pt>
          <cx:pt idx="749">0.058610000000000002</cx:pt>
          <cx:pt idx="750">0.075942800000000005</cx:pt>
          <cx:pt idx="751">0.060213999999999997</cx:pt>
          <cx:pt idx="752">0.077887700000000004</cx:pt>
          <cx:pt idx="753">0.091193099999999999</cx:pt>
          <cx:pt idx="754">0.041304100000000003</cx:pt>
          <cx:pt idx="755">0.056732499999999998</cx:pt>
          <cx:pt idx="756">0.041577700000000002</cx:pt>
          <cx:pt idx="757">0.092441400000000007</cx:pt>
          <cx:pt idx="758">0.045217</cx:pt>
          <cx:pt idx="759">0.046463699999999997</cx:pt>
          <cx:pt idx="760">0.051729600000000001</cx:pt>
          <cx:pt idx="761">0.041968999999999999</cx:pt>
          <cx:pt idx="762">0.083527900000000002</cx:pt>
          <cx:pt idx="763">0.054878299999999998</cx:pt>
          <cx:pt idx="764">0.0293327</cx:pt>
          <cx:pt idx="765">0.081030900000000003</cx:pt>
          <cx:pt idx="766">0.054232299999999997</cx:pt>
          <cx:pt idx="767">0.027981800000000001</cx:pt>
          <cx:pt idx="768">0.0566778</cx:pt>
          <cx:pt idx="769">0.050983000000000001</cx:pt>
          <cx:pt idx="770">0.054967599999999998</cx:pt>
          <cx:pt idx="771">0.071135000000000004</cx:pt>
          <cx:pt idx="772">0.050081500000000001</cx:pt>
          <cx:pt idx="773">0.063766100000000006</cx:pt>
          <cx:pt idx="774">0.050012000000000001</cx:pt>
          <cx:pt idx="775">0.060522800000000002</cx:pt>
          <cx:pt idx="776">0.030180499999999999</cx:pt>
          <cx:pt idx="777">0.068981899999999999</cx:pt>
          <cx:pt idx="778">0.0486452</cx:pt>
          <cx:pt idx="779">0.038318400000000002</cx:pt>
          <cx:pt idx="780">0.043883600000000002</cx:pt>
          <cx:pt idx="781">0.059189899999999997</cx:pt>
          <cx:pt idx="782">0.077930700000000006</cx:pt>
          <cx:pt idx="783">0.063788399999999995</cx:pt>
          <cx:pt idx="784">0.046953599999999998</cx:pt>
          <cx:pt idx="785">0.039076800000000002</cx:pt>
          <cx:pt idx="786">0.082808000000000007</cx:pt>
          <cx:pt idx="787">0.051191899999999999</cx:pt>
          <cx:pt idx="788">0.0320229</cx:pt>
          <cx:pt idx="789">0.071702399999999999</cx:pt>
          <cx:pt idx="790">0.056719100000000001</cx:pt>
          <cx:pt idx="791">0.065294199999999997</cx:pt>
          <cx:pt idx="792">0.065320600000000006</cx:pt>
          <cx:pt idx="793">0.0448724</cx:pt>
          <cx:pt idx="794">0.049024600000000002</cx:pt>
          <cx:pt idx="795">0.052966199999999998</cx:pt>
          <cx:pt idx="796">0.037665499999999998</cx:pt>
          <cx:pt idx="797">0.077487899999999998</cx:pt>
          <cx:pt idx="798">0.041059900000000003</cx:pt>
          <cx:pt idx="799">0.049459700000000002</cx:pt>
          <cx:pt idx="800">0.049499899999999999</cx:pt>
          <cx:pt idx="801">0.049070099999999998</cx:pt>
          <cx:pt idx="802">0.078220399999999995</cx:pt>
          <cx:pt idx="803">0.033080400000000003</cx:pt>
          <cx:pt idx="804">0.0683362</cx:pt>
          <cx:pt idx="805">0.045087099999999998</cx:pt>
          <cx:pt idx="806">0.067067000000000002</cx:pt>
          <cx:pt idx="807">0.053983099999999999</cx:pt>
          <cx:pt idx="808">0.057649699999999998</cx:pt>
          <cx:pt idx="809">0.061892500000000003</cx:pt>
          <cx:pt idx="810">0.047386900000000003</cx:pt>
          <cx:pt idx="811">0.064268800000000001</cx:pt>
          <cx:pt idx="812">0.049626200000000002</cx:pt>
          <cx:pt idx="813">0.044774700000000001</cx:pt>
          <cx:pt idx="814">0.074458700000000003</cx:pt>
          <cx:pt idx="815">0.074498499999999995</cx:pt>
          <cx:pt idx="816">0.031276600000000002</cx:pt>
          <cx:pt idx="817">0.059950499999999997</cx:pt>
          <cx:pt idx="818">0.065104499999999996</cx:pt>
          <cx:pt idx="819">0.056465000000000001</cx:pt>
          <cx:pt idx="820">0.073688799999999999</cx:pt>
          <cx:pt idx="821">0.049198499999999999</cx:pt>
          <cx:pt idx="822">0.076259800000000003</cx:pt>
          <cx:pt idx="823">0.043263099999999999</cx:pt>
          <cx:pt idx="824">0.062914700000000004</cx:pt>
          <cx:pt idx="825">0.076736200000000004</cx:pt>
          <cx:pt idx="826">0.067770499999999997</cx:pt>
          <cx:pt idx="827">0.0303637</cx:pt>
          <cx:pt idx="828">0.068120100000000003</cx:pt>
          <cx:pt idx="829">0.055116800000000001</cx:pt>
          <cx:pt idx="830">0.0434721</cx:pt>
          <cx:pt idx="831">0.065230800000000005</cx:pt>
          <cx:pt idx="832">0.061322399999999999</cx:pt>
          <cx:pt idx="833">0.0623347</cx:pt>
          <cx:pt idx="834">0.0768263</cx:pt>
          <cx:pt idx="835">0.053131400000000002</cx:pt>
          <cx:pt idx="836">0.093984799999999993</cx:pt>
          <cx:pt idx="837">0.053109200000000002</cx:pt>
          <cx:pt idx="838">0.067200200000000002</cx:pt>
          <cx:pt idx="839">0.044182699999999998</cx:pt>
          <cx:pt idx="840">0.036692099999999998</cx:pt>
          <cx:pt idx="841">0.051791400000000001</cx:pt>
          <cx:pt idx="842">0.049383799999999999</cx:pt>
          <cx:pt idx="843">0.069992200000000004</cx:pt>
          <cx:pt idx="844">0.072322399999999995</cx:pt>
          <cx:pt idx="845">0.037914499999999997</cx:pt>
          <cx:pt idx="846">0.064290299999999995</cx:pt>
          <cx:pt idx="847">0.040494599999999999</cx:pt>
          <cx:pt idx="848">0.058035799999999998</cx:pt>
          <cx:pt idx="849">0.050705699999999999</cx:pt>
          <cx:pt idx="850">0.039404099999999997</cx:pt>
          <cx:pt idx="851">0.038727999999999999</cx:pt>
          <cx:pt idx="852">0.0758268</cx:pt>
          <cx:pt idx="853">0.037456099999999999</cx:pt>
          <cx:pt idx="854">0.038577</cx:pt>
          <cx:pt idx="855">0.053492600000000001</cx:pt>
          <cx:pt idx="856">0.089195300000000005</cx:pt>
          <cx:pt idx="857">0.080036300000000005</cx:pt>
          <cx:pt idx="858">0.037654699999999999</cx:pt>
          <cx:pt idx="859">0.070502999999999996</cx:pt>
          <cx:pt idx="860">0.050519700000000001</cx:pt>
          <cx:pt idx="861">0.050502199999999997</cx:pt>
          <cx:pt idx="862">0.057280600000000001</cx:pt>
          <cx:pt idx="863">0.069752400000000006</cx:pt>
          <cx:pt idx="864">0.058253899999999997</cx:pt>
          <cx:pt idx="865">0.057844399999999997</cx:pt>
          <cx:pt idx="866">0.020256099999999999</cx:pt>
          <cx:pt idx="867">0.050746600000000003</cx:pt>
          <cx:pt idx="868">0.085511799999999999</cx:pt>
          <cx:pt idx="869">0.073706499999999994</cx:pt>
          <cx:pt idx="870">0.054815999999999997</cx:pt>
          <cx:pt idx="871">0.090131799999999998</cx:pt>
          <cx:pt idx="872">0.041906899999999997</cx:pt>
          <cx:pt idx="873">0.051585300000000001</cx:pt>
          <cx:pt idx="874">0.078411599999999998</cx:pt>
          <cx:pt idx="875">0.0601405</cx:pt>
          <cx:pt idx="876">0.051150800000000003</cx:pt>
          <cx:pt idx="877">0.058237799999999999</cx:pt>
          <cx:pt idx="878">0.055446500000000003</cx:pt>
          <cx:pt idx="879">0.067141199999999998</cx:pt>
          <cx:pt idx="880">0.059625200000000003</cx:pt>
          <cx:pt idx="881">0.0440387</cx:pt>
          <cx:pt idx="882">0.052026099999999999</cx:pt>
          <cx:pt idx="883">0.060630000000000003</cx:pt>
          <cx:pt idx="884">0.084111500000000006</cx:pt>
          <cx:pt idx="885">0.068221400000000001</cx:pt>
          <cx:pt idx="886">0.078910800000000003</cx:pt>
          <cx:pt idx="887">0.065516900000000003</cx:pt>
          <cx:pt idx="888">0.027946499999999999</cx:pt>
          <cx:pt idx="889">0.046286099999999997</cx:pt>
          <cx:pt idx="890">0.057835200000000003</cx:pt>
          <cx:pt idx="891">0.056148000000000003</cx:pt>
          <cx:pt idx="892">0.03049</cx:pt>
          <cx:pt idx="893">0.068670599999999998</cx:pt>
          <cx:pt idx="894">0.053933799999999997</cx:pt>
          <cx:pt idx="895">0.073151800000000003</cx:pt>
          <cx:pt idx="896">0.0580105</cx:pt>
          <cx:pt idx="897">0.054151400000000002</cx:pt>
          <cx:pt idx="898">0.060356199999999999</cx:pt>
          <cx:pt idx="899">0.069519800000000007</cx:pt>
          <cx:pt idx="900">0.060250100000000001</cx:pt>
          <cx:pt idx="901">0.065281900000000004</cx:pt>
          <cx:pt idx="902">0.052910100000000002</cx:pt>
          <cx:pt idx="903">0.056668799999999998</cx:pt>
          <cx:pt idx="904">0.0741087</cx:pt>
          <cx:pt idx="905">0.053981599999999998</cx:pt>
          <cx:pt idx="906">0.060006299999999999</cx:pt>
          <cx:pt idx="907">0.068545999999999996</cx:pt>
          <cx:pt idx="908">0.047026600000000002</cx:pt>
          <cx:pt idx="909">0.080067299999999994</cx:pt>
          <cx:pt idx="910">0.062573799999999999</cx:pt>
          <cx:pt idx="911">0.046815700000000002</cx:pt>
          <cx:pt idx="912">0.070227399999999995</cx:pt>
          <cx:pt idx="913">0.080200800000000003</cx:pt>
          <cx:pt idx="914">0.049850800000000001</cx:pt>
          <cx:pt idx="915">0.053486100000000002</cx:pt>
          <cx:pt idx="916">0.062604499999999993</cx:pt>
          <cx:pt idx="917">0.076498099999999999</cx:pt>
          <cx:pt idx="918">0.048311100000000003</cx:pt>
          <cx:pt idx="919">0.034446699999999997</cx:pt>
          <cx:pt idx="920">0.0409355</cx:pt>
          <cx:pt idx="921">0.075918200000000005</cx:pt>
          <cx:pt idx="922">0.055226600000000001</cx:pt>
          <cx:pt idx="923">0.061577600000000003</cx:pt>
          <cx:pt idx="924">0.080050099999999999</cx:pt>
          <cx:pt idx="925">0.062534099999999995</cx:pt>
          <cx:pt idx="926">0.044031500000000001</cx:pt>
          <cx:pt idx="927">0.063343800000000006</cx:pt>
          <cx:pt idx="928">0.063980599999999999</cx:pt>
          <cx:pt idx="929">0.059860400000000001</cx:pt>
          <cx:pt idx="930">0.036194299999999999</cx:pt>
          <cx:pt idx="931">0.055160500000000001</cx:pt>
          <cx:pt idx="932">0.0540857</cx:pt>
          <cx:pt idx="933">0.040353</cx:pt>
          <cx:pt idx="934">0.0612522</cx:pt>
          <cx:pt idx="935">0.080405400000000002</cx:pt>
          <cx:pt idx="936">0.045670799999999998</cx:pt>
          <cx:pt idx="937">0.062727900000000003</cx:pt>
          <cx:pt idx="938">0.0611183</cx:pt>
          <cx:pt idx="939">0.027068999999999999</cx:pt>
          <cx:pt idx="940">0.0675288</cx:pt>
          <cx:pt idx="941">0.076857700000000001</cx:pt>
          <cx:pt idx="942">0.091124200000000002</cx:pt>
          <cx:pt idx="943">0.084415100000000007</cx:pt>
          <cx:pt idx="944">0.07621</cx:pt>
          <cx:pt idx="945">0.047342099999999998</cx:pt>
          <cx:pt idx="946">0.087833300000000003</cx:pt>
          <cx:pt idx="947">0.043263599999999999</cx:pt>
          <cx:pt idx="948">0.081445600000000007</cx:pt>
          <cx:pt idx="949">0.070414299999999999</cx:pt>
          <cx:pt idx="950">0.082230600000000001</cx:pt>
          <cx:pt idx="951">0.068976099999999999</cx:pt>
          <cx:pt idx="952">0.045447899999999999</cx:pt>
          <cx:pt idx="953">0.0480002</cx:pt>
          <cx:pt idx="954">0.047035599999999997</cx:pt>
          <cx:pt idx="955">0.0717946</cx:pt>
          <cx:pt idx="956">0.064643900000000004</cx:pt>
          <cx:pt idx="957">0.053255799999999999</cx:pt>
          <cx:pt idx="958">0.057394399999999998</cx:pt>
          <cx:pt idx="959">0.0858569</cx:pt>
          <cx:pt idx="960">0.055773999999999997</cx:pt>
          <cx:pt idx="961">0.057440900000000003</cx:pt>
          <cx:pt idx="962">0.050609000000000001</cx:pt>
          <cx:pt idx="963">0.034376999999999998</cx:pt>
          <cx:pt idx="964">0.056780799999999999</cx:pt>
          <cx:pt idx="965">0.086196300000000003</cx:pt>
          <cx:pt idx="966">0.048528300000000003</cx:pt>
          <cx:pt idx="967">0.045522199999999999</cx:pt>
          <cx:pt idx="968">0.103478</cx:pt>
          <cx:pt idx="969">0.037920799999999998</cx:pt>
          <cx:pt idx="970">0.066445100000000007</cx:pt>
          <cx:pt idx="971">0.044207700000000003</cx:pt>
          <cx:pt idx="972">0.0460068</cx:pt>
          <cx:pt idx="973">0.033084000000000002</cx:pt>
          <cx:pt idx="974">0.076178700000000002</cx:pt>
          <cx:pt idx="975">0.074142700000000006</cx:pt>
          <cx:pt idx="976">0.074103699999999995</cx:pt>
          <cx:pt idx="977">0.072595900000000005</cx:pt>
          <cx:pt idx="978">0.051937700000000003</cx:pt>
          <cx:pt idx="979">0.037263499999999998</cx:pt>
          <cx:pt idx="980">0.046144699999999997</cx:pt>
          <cx:pt idx="981">0.071813500000000002</cx:pt>
          <cx:pt idx="982">0.077810799999999999</cx:pt>
          <cx:pt idx="983">0.055503299999999998</cx:pt>
          <cx:pt idx="984">0.049709200000000002</cx:pt>
          <cx:pt idx="985">0.058156800000000002</cx:pt>
          <cx:pt idx="986">0.054929600000000002</cx:pt>
          <cx:pt idx="987">0.023424</cx:pt>
          <cx:pt idx="988">0.065465999999999996</cx:pt>
          <cx:pt idx="989">0.0250171</cx:pt>
          <cx:pt idx="990">0.035556499999999998</cx:pt>
          <cx:pt idx="991">0.052229200000000003</cx:pt>
          <cx:pt idx="992">0.064564099999999999</cx:pt>
          <cx:pt idx="993">0.038334600000000003</cx:pt>
          <cx:pt idx="994">0.0742839</cx:pt>
          <cx:pt idx="995">0.035621600000000003</cx:pt>
          <cx:pt idx="996">0.052126800000000001</cx:pt>
          <cx:pt idx="997">0.046832699999999998</cx:pt>
          <cx:pt idx="998">0.066153600000000007</cx:pt>
          <cx:pt idx="999">0.065334600000000007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sz="20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200" b="0" i="0" u="none" strike="noStrike" baseline="0" dirty="0" err="1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out,acute</a:t>
            </a:r>
            <a:endParaRPr lang="ja-JP" altLang="en-US" sz="1200" b="0" i="0" u="none" strike="noStrike" baseline="0" dirty="0">
              <a:solidFill>
                <a:sysClr val="windowText" lastClr="000000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cx:rich>
      </cx:tx>
    </cx:title>
    <cx:plotArea>
      <cx:plotAreaRegion>
        <cx:series layoutId="clusteredColumn" uniqueId="{F3AF1F0E-555E-4B98-9B50-8A88EB8E7134}">
          <cx:tx>
            <cx:txData>
              <cx:f>'PD acute'!$K$1</cx:f>
              <cx:v>tvKout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Count val="15"/>
            </cx:binning>
          </cx:layoutPr>
        </cx:series>
      </cx:plotAreaRegion>
      <cx:axis id="0">
        <cx:catScaling gapWidth="0"/>
        <cx:tickLabels/>
        <cx:numFmt formatCode="#,##0.000_);[赤](#,##0.00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1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PD acute'!$L$2:$L$1001</cx:f>
        <cx:lvl ptCount="1000" formatCode="G/標準">
          <cx:pt idx="0">10.8962</cx:pt>
          <cx:pt idx="1">12.6005</cx:pt>
          <cx:pt idx="2">10.1038</cx:pt>
          <cx:pt idx="3">7.16587</cx:pt>
          <cx:pt idx="4">11.7624</cx:pt>
          <cx:pt idx="5">5.8777499999999998</cx:pt>
          <cx:pt idx="6">11.758699999999999</cx:pt>
          <cx:pt idx="7">12.906599999999999</cx:pt>
          <cx:pt idx="8">12.297000000000001</cx:pt>
          <cx:pt idx="9">7.0907200000000001</cx:pt>
          <cx:pt idx="10">13.659800000000001</cx:pt>
          <cx:pt idx="11">10.5654</cx:pt>
          <cx:pt idx="12">14.421200000000001</cx:pt>
          <cx:pt idx="13">11.460800000000001</cx:pt>
          <cx:pt idx="14">10.9773</cx:pt>
          <cx:pt idx="15">11.010999999999999</cx:pt>
          <cx:pt idx="16">11.6114</cx:pt>
          <cx:pt idx="17">9.6901200000000003</cx:pt>
          <cx:pt idx="18">10.875500000000001</cx:pt>
          <cx:pt idx="19">8.2869399999999995</cx:pt>
          <cx:pt idx="20">11.2966</cx:pt>
          <cx:pt idx="21">13.1365</cx:pt>
          <cx:pt idx="22">9.3883899999999993</cx:pt>
          <cx:pt idx="23">9.5266300000000008</cx:pt>
          <cx:pt idx="24">7.3338000000000001</cx:pt>
          <cx:pt idx="25">9.5854099999999995</cx:pt>
          <cx:pt idx="26">8.2979500000000002</cx:pt>
          <cx:pt idx="27">7.7657800000000003</cx:pt>
          <cx:pt idx="28">4.7930700000000002</cx:pt>
          <cx:pt idx="29">10.3125</cx:pt>
          <cx:pt idx="30">11.3276</cx:pt>
          <cx:pt idx="31">6.3246599999999997</cx:pt>
          <cx:pt idx="32">5.0632700000000002</cx:pt>
          <cx:pt idx="33">6.0415000000000001</cx:pt>
          <cx:pt idx="34">9.7604699999999998</cx:pt>
          <cx:pt idx="35">12.498900000000001</cx:pt>
          <cx:pt idx="36">10.227600000000001</cx:pt>
          <cx:pt idx="37">8.3591599999999993</cx:pt>
          <cx:pt idx="38">4.9917199999999999</cx:pt>
          <cx:pt idx="39">11.6783</cx:pt>
          <cx:pt idx="40">8.6220800000000004</cx:pt>
          <cx:pt idx="41">11.1431</cx:pt>
          <cx:pt idx="42">13.284599999999999</cx:pt>
          <cx:pt idx="43">10.8531</cx:pt>
          <cx:pt idx="44">12.9612</cx:pt>
          <cx:pt idx="45">8.6024499999999993</cx:pt>
          <cx:pt idx="46">11.6495</cx:pt>
          <cx:pt idx="47">6.11015</cx:pt>
          <cx:pt idx="48">8.0389999999999997</cx:pt>
          <cx:pt idx="49">10.386699999999999</cx:pt>
          <cx:pt idx="50">5.8925700000000001</cx:pt>
          <cx:pt idx="51">9.8222000000000005</cx:pt>
          <cx:pt idx="52">10.43</cx:pt>
          <cx:pt idx="53">6.3785800000000004</cx:pt>
          <cx:pt idx="54">12.0124</cx:pt>
          <cx:pt idx="55">8.5574200000000005</cx:pt>
          <cx:pt idx="56">10.199299999999999</cx:pt>
          <cx:pt idx="57">9.7331500000000002</cx:pt>
          <cx:pt idx="58">9.8214000000000006</cx:pt>
          <cx:pt idx="59">13.884</cx:pt>
          <cx:pt idx="60">7.7834000000000003</cx:pt>
          <cx:pt idx="61">10.9628</cx:pt>
          <cx:pt idx="62">9.3115299999999994</cx:pt>
          <cx:pt idx="63">8.9793199999999995</cx:pt>
          <cx:pt idx="64">5.43771</cx:pt>
          <cx:pt idx="65">13.901</cx:pt>
          <cx:pt idx="66">7.9936100000000003</cx:pt>
          <cx:pt idx="67">7.6779400000000004</cx:pt>
          <cx:pt idx="68">11.3139</cx:pt>
          <cx:pt idx="69">12.9842</cx:pt>
          <cx:pt idx="70">9.7260600000000004</cx:pt>
          <cx:pt idx="71">8.8775300000000001</cx:pt>
          <cx:pt idx="72">4.7075500000000003</cx:pt>
          <cx:pt idx="73">12.089600000000001</cx:pt>
          <cx:pt idx="74">12.803599999999999</cx:pt>
          <cx:pt idx="75">7.0807900000000004</cx:pt>
          <cx:pt idx="76">10.805199999999999</cx:pt>
          <cx:pt idx="77">9.2594999999999992</cx:pt>
          <cx:pt idx="78">10.0753</cx:pt>
          <cx:pt idx="79">10.7319</cx:pt>
          <cx:pt idx="80">10.0472</cx:pt>
          <cx:pt idx="81">13.058400000000001</cx:pt>
          <cx:pt idx="82">11.5754</cx:pt>
          <cx:pt idx="83">11.548999999999999</cx:pt>
          <cx:pt idx="84">10.250400000000001</cx:pt>
          <cx:pt idx="85">6.2805</cx:pt>
          <cx:pt idx="86">12.2005</cx:pt>
          <cx:pt idx="87">9.0483200000000004</cx:pt>
          <cx:pt idx="88">10.923999999999999</cx:pt>
          <cx:pt idx="89">8.0506200000000003</cx:pt>
          <cx:pt idx="90">9.1117299999999997</cx:pt>
          <cx:pt idx="91">5.9380699999999997</cx:pt>
          <cx:pt idx="92">8.3454800000000002</cx:pt>
          <cx:pt idx="93">13.673500000000001</cx:pt>
          <cx:pt idx="94">5.64229</cx:pt>
          <cx:pt idx="95">14.183299999999999</cx:pt>
          <cx:pt idx="96">8.8609899999999993</cx:pt>
          <cx:pt idx="97">10.1256</cx:pt>
          <cx:pt idx="98">7.2747099999999998</cx:pt>
          <cx:pt idx="99">11.5281</cx:pt>
          <cx:pt idx="100">10.4724</cx:pt>
          <cx:pt idx="101">12.8843</cx:pt>
          <cx:pt idx="102">7.1957500000000003</cx:pt>
          <cx:pt idx="103">10.7821</cx:pt>
          <cx:pt idx="104">10.180899999999999</cx:pt>
          <cx:pt idx="105">7.1866700000000003</cx:pt>
          <cx:pt idx="106">7.6269499999999999</cx:pt>
          <cx:pt idx="107">8.3146799999999992</cx:pt>
          <cx:pt idx="108">9.7619500000000006</cx:pt>
          <cx:pt idx="109">6.2418300000000002</cx:pt>
          <cx:pt idx="110">10.435</cx:pt>
          <cx:pt idx="111">11.6287</cx:pt>
          <cx:pt idx="112">9.8595000000000006</cx:pt>
          <cx:pt idx="113">11.621499999999999</cx:pt>
          <cx:pt idx="114">10.2554</cx:pt>
          <cx:pt idx="115">8.5403400000000005</cx:pt>
          <cx:pt idx="116">11.8216</cx:pt>
          <cx:pt idx="117">8.07911</cx:pt>
          <cx:pt idx="118">11.6869</cx:pt>
          <cx:pt idx="119">9.6857900000000008</cx:pt>
          <cx:pt idx="120">9.2656100000000006</cx:pt>
          <cx:pt idx="121">11.3851</cx:pt>
          <cx:pt idx="122">10.359400000000001</cx:pt>
          <cx:pt idx="123">10.6463</cx:pt>
          <cx:pt idx="124">12.4566</cx:pt>
          <cx:pt idx="125">8.5220900000000004</cx:pt>
          <cx:pt idx="126">7.4643800000000002</cx:pt>
          <cx:pt idx="127">7.5681900000000004</cx:pt>
          <cx:pt idx="128">8.7992799999999995</cx:pt>
          <cx:pt idx="129">8.9771300000000007</cx:pt>
          <cx:pt idx="130">12.6883</cx:pt>
          <cx:pt idx="131">12.600099999999999</cx:pt>
          <cx:pt idx="132">10.6157</cx:pt>
          <cx:pt idx="133">13.4476</cx:pt>
          <cx:pt idx="134">9.9918499999999995</cx:pt>
          <cx:pt idx="135">12.258800000000001</cx:pt>
          <cx:pt idx="136">14.109299999999999</cx:pt>
          <cx:pt idx="137">7.5341300000000002</cx:pt>
          <cx:pt idx="138">13.7486</cx:pt>
          <cx:pt idx="139">13.6404</cx:pt>
          <cx:pt idx="140">8.1589399999999994</cx:pt>
          <cx:pt idx="141">6.1181200000000002</cx:pt>
          <cx:pt idx="142">13.9899</cx:pt>
          <cx:pt idx="143">5.1002999999999998</cx:pt>
          <cx:pt idx="144">10.976100000000001</cx:pt>
          <cx:pt idx="145">8.5670999999999999</cx:pt>
          <cx:pt idx="146">12.280900000000001</cx:pt>
          <cx:pt idx="147">7.0262599999999997</cx:pt>
          <cx:pt idx="148">9.8858599999999992</cx:pt>
          <cx:pt idx="149">10.3139</cx:pt>
          <cx:pt idx="150">7.9793200000000004</cx:pt>
          <cx:pt idx="151">7.8576600000000001</cx:pt>
          <cx:pt idx="152">12.4808</cx:pt>
          <cx:pt idx="153">7.4147499999999997</cx:pt>
          <cx:pt idx="154">6.3481899999999998</cx:pt>
          <cx:pt idx="155">7.5174599999999998</cx:pt>
          <cx:pt idx="156">9.3955599999999997</cx:pt>
          <cx:pt idx="157">12.4368</cx:pt>
          <cx:pt idx="158">9.0059199999999997</cx:pt>
          <cx:pt idx="159">10.575799999999999</cx:pt>
          <cx:pt idx="160">13.894600000000001</cx:pt>
          <cx:pt idx="161">11.967700000000001</cx:pt>
          <cx:pt idx="162">7.7811199999999996</cx:pt>
          <cx:pt idx="163">10.725899999999999</cx:pt>
          <cx:pt idx="164">9.3761500000000009</cx:pt>
          <cx:pt idx="165">8.8805599999999991</cx:pt>
          <cx:pt idx="166">8.1567100000000003</cx:pt>
          <cx:pt idx="167">13.0519</cx:pt>
          <cx:pt idx="168">8.9099900000000005</cx:pt>
          <cx:pt idx="169">8.8189600000000006</cx:pt>
          <cx:pt idx="170">5.80992</cx:pt>
          <cx:pt idx="171">11.169</cx:pt>
          <cx:pt idx="172">5.9524699999999999</cx:pt>
          <cx:pt idx="173">9.5455100000000002</cx:pt>
          <cx:pt idx="174">10.715999999999999</cx:pt>
          <cx:pt idx="175">9.2065400000000004</cx:pt>
          <cx:pt idx="176">7.9953700000000003</cx:pt>
          <cx:pt idx="177">9.9529999999999994</cx:pt>
          <cx:pt idx="178">11.5092</cx:pt>
          <cx:pt idx="179">13.1112</cx:pt>
          <cx:pt idx="180">13.1203</cx:pt>
          <cx:pt idx="181">9.7699300000000004</cx:pt>
          <cx:pt idx="182">12.384600000000001</cx:pt>
          <cx:pt idx="183">9.1244700000000005</cx:pt>
          <cx:pt idx="184">13.2897</cx:pt>
          <cx:pt idx="185">8.3510000000000009</cx:pt>
          <cx:pt idx="186">11.183199999999999</cx:pt>
          <cx:pt idx="187">7.0688700000000004</cx:pt>
          <cx:pt idx="188">11.3049</cx:pt>
          <cx:pt idx="189">14.8466</cx:pt>
          <cx:pt idx="190">10.6638</cx:pt>
          <cx:pt idx="191">9.3628</cx:pt>
          <cx:pt idx="192">12.1372</cx:pt>
          <cx:pt idx="193">11.268700000000001</cx:pt>
          <cx:pt idx="194">11.147500000000001</cx:pt>
          <cx:pt idx="195">12.791600000000001</cx:pt>
          <cx:pt idx="196">6.1232899999999999</cx:pt>
          <cx:pt idx="197">8.8275199999999998</cx:pt>
          <cx:pt idx="198">11.1266</cx:pt>
          <cx:pt idx="199">8.5295900000000007</cx:pt>
          <cx:pt idx="200">10.2273</cx:pt>
          <cx:pt idx="201">11.1591</cx:pt>
          <cx:pt idx="202">12.8653</cx:pt>
          <cx:pt idx="203">9.36815</cx:pt>
          <cx:pt idx="204">7.7662300000000002</cx:pt>
          <cx:pt idx="205">12.4129</cx:pt>
          <cx:pt idx="206">13.1646</cx:pt>
          <cx:pt idx="207">9.2526799999999998</cx:pt>
          <cx:pt idx="208">11.5405</cx:pt>
          <cx:pt idx="209">9.1303099999999997</cx:pt>
          <cx:pt idx="210">9.1094500000000007</cx:pt>
          <cx:pt idx="211">6.5130499999999998</cx:pt>
          <cx:pt idx="212">10.441700000000001</cx:pt>
          <cx:pt idx="213">11.516500000000001</cx:pt>
          <cx:pt idx="214">11.0777</cx:pt>
          <cx:pt idx="215">9.4571699999999996</cx:pt>
          <cx:pt idx="216">5.6261299999999999</cx:pt>
          <cx:pt idx="217">12.060600000000001</cx:pt>
          <cx:pt idx="218">9.1702600000000007</cx:pt>
          <cx:pt idx="219">11.112</cx:pt>
          <cx:pt idx="220">11.1839</cx:pt>
          <cx:pt idx="221">15.1288</cx:pt>
          <cx:pt idx="222">6.0199800000000003</cx:pt>
          <cx:pt idx="223">10.229900000000001</cx:pt>
          <cx:pt idx="224">6.8253399999999997</cx:pt>
          <cx:pt idx="225">13.303699999999999</cx:pt>
          <cx:pt idx="226">10.573399999999999</cx:pt>
          <cx:pt idx="227">13.357699999999999</cx:pt>
          <cx:pt idx="228">9.2030600000000007</cx:pt>
          <cx:pt idx="229">14.417400000000001</cx:pt>
          <cx:pt idx="230">11.8058</cx:pt>
          <cx:pt idx="231">6.3505700000000003</cx:pt>
          <cx:pt idx="232">12.7614</cx:pt>
          <cx:pt idx="233">5.6216799999999996</cx:pt>
          <cx:pt idx="234">8.9462600000000005</cx:pt>
          <cx:pt idx="235">9.8683999999999994</cx:pt>
          <cx:pt idx="236">8.6422399999999993</cx:pt>
          <cx:pt idx="237">9.5733999999999995</cx:pt>
          <cx:pt idx="238">9.9212600000000002</cx:pt>
          <cx:pt idx="239">7.9199900000000003</cx:pt>
          <cx:pt idx="240">9.0725200000000008</cx:pt>
          <cx:pt idx="241">9.4804099999999991</cx:pt>
          <cx:pt idx="242">10.7399</cx:pt>
          <cx:pt idx="243">9.7067599999999992</cx:pt>
          <cx:pt idx="244">9.6847700000000003</cx:pt>
          <cx:pt idx="245">10.858599999999999</cx:pt>
          <cx:pt idx="246">8.6484100000000002</cx:pt>
          <cx:pt idx="247">11.3794</cx:pt>
          <cx:pt idx="248">7.8643700000000001</cx:pt>
          <cx:pt idx="249">5.5964499999999999</cx:pt>
          <cx:pt idx="250">7.2154199999999999</cx:pt>
          <cx:pt idx="251">9.1404300000000003</cx:pt>
          <cx:pt idx="252">11.259399999999999</cx:pt>
          <cx:pt idx="253">7.2554600000000002</cx:pt>
          <cx:pt idx="254">7.94285</cx:pt>
          <cx:pt idx="255">8.9646399999999993</cx:pt>
          <cx:pt idx="256">7.9913699999999999</cx:pt>
          <cx:pt idx="257">6.8352899999999996</cx:pt>
          <cx:pt idx="258">4.6921499999999998</cx:pt>
          <cx:pt idx="259">10.201499999999999</cx:pt>
          <cx:pt idx="260">11.3095</cx:pt>
          <cx:pt idx="261">8.4352599999999995</cx:pt>
          <cx:pt idx="262">12.217599999999999</cx:pt>
          <cx:pt idx="263">8.3871900000000004</cx:pt>
          <cx:pt idx="264">9.0577799999999993</cx:pt>
          <cx:pt idx="265">7.1092599999999999</cx:pt>
          <cx:pt idx="266">9.8142700000000005</cx:pt>
          <cx:pt idx="267">6.4707600000000003</cx:pt>
          <cx:pt idx="268">9.5967199999999995</cx:pt>
          <cx:pt idx="269">6.74247</cx:pt>
          <cx:pt idx="270">13.007300000000001</cx:pt>
          <cx:pt idx="271">13.1183</cx:pt>
          <cx:pt idx="272">9.0426000000000002</cx:pt>
          <cx:pt idx="273">10.928599999999999</cx:pt>
          <cx:pt idx="274">10.1485</cx:pt>
          <cx:pt idx="275">7.4411300000000002</cx:pt>
          <cx:pt idx="276">11.495100000000001</cx:pt>
          <cx:pt idx="277">9.9687599999999996</cx:pt>
          <cx:pt idx="278">13.138999999999999</cx:pt>
          <cx:pt idx="279">14.442600000000001</cx:pt>
          <cx:pt idx="280">9.7945399999999996</cx:pt>
          <cx:pt idx="281">11.5687</cx:pt>
          <cx:pt idx="282">14.995699999999999</cx:pt>
          <cx:pt idx="283">9.5253200000000007</cx:pt>
          <cx:pt idx="284">7.14839</cx:pt>
          <cx:pt idx="285">10.91</cx:pt>
          <cx:pt idx="286">9.5926200000000001</cx:pt>
          <cx:pt idx="287">12.566700000000001</cx:pt>
          <cx:pt idx="288">7.0095400000000003</cx:pt>
          <cx:pt idx="289">12.0289</cx:pt>
          <cx:pt idx="290">5.0453000000000001</cx:pt>
          <cx:pt idx="291">7.5293900000000002</cx:pt>
          <cx:pt idx="292">11.527900000000001</cx:pt>
          <cx:pt idx="293">9.0965799999999994</cx:pt>
          <cx:pt idx="294">4.2195600000000004</cx:pt>
          <cx:pt idx="295">9.41127</cx:pt>
          <cx:pt idx="296">10.2195</cx:pt>
          <cx:pt idx="297">10.6165</cx:pt>
          <cx:pt idx="298">8.9414999999999996</cx:pt>
          <cx:pt idx="299">5.82315</cx:pt>
          <cx:pt idx="300">10.2677</cx:pt>
          <cx:pt idx="301">10.677300000000001</cx:pt>
          <cx:pt idx="302">7.6500300000000001</cx:pt>
          <cx:pt idx="303">9.8369800000000005</cx:pt>
          <cx:pt idx="304">10.0413</cx:pt>
          <cx:pt idx="305">10.546900000000001</cx:pt>
          <cx:pt idx="306">11.1936</cx:pt>
          <cx:pt idx="307">6.2161499999999998</cx:pt>
          <cx:pt idx="308">8.1206800000000001</cx:pt>
          <cx:pt idx="309">10.8795</cx:pt>
          <cx:pt idx="310">11.273400000000001</cx:pt>
          <cx:pt idx="311">8.7109000000000005</cx:pt>
          <cx:pt idx="312">12.6983</cx:pt>
          <cx:pt idx="313">11.4991</cx:pt>
          <cx:pt idx="314">10.0679</cx:pt>
          <cx:pt idx="315">11.582700000000001</cx:pt>
          <cx:pt idx="316">8.4816099999999999</cx:pt>
          <cx:pt idx="317">13.048500000000001</cx:pt>
          <cx:pt idx="318">8.3418899999999994</cx:pt>
          <cx:pt idx="319">7.44313</cx:pt>
          <cx:pt idx="320">11.4795</cx:pt>
          <cx:pt idx="321">8.1096299999999992</cx:pt>
          <cx:pt idx="322">9.0521999999999991</cx:pt>
          <cx:pt idx="323">14.1716</cx:pt>
          <cx:pt idx="324">6.8794500000000003</cx:pt>
          <cx:pt idx="325">13.8748</cx:pt>
          <cx:pt idx="326">10.688700000000001</cx:pt>
          <cx:pt idx="327">13.256</cx:pt>
          <cx:pt idx="328">10.6358</cx:pt>
          <cx:pt idx="329">10.4282</cx:pt>
          <cx:pt idx="330">12.0785</cx:pt>
          <cx:pt idx="331">9.8801600000000001</cx:pt>
          <cx:pt idx="332">13.4352</cx:pt>
          <cx:pt idx="333">12.837300000000001</cx:pt>
          <cx:pt idx="334">15.470599999999999</cx:pt>
          <cx:pt idx="335">13.689399999999999</cx:pt>
          <cx:pt idx="336">11.6942</cx:pt>
          <cx:pt idx="337">9.4454100000000007</cx:pt>
          <cx:pt idx="338">8.6382499999999993</cx:pt>
          <cx:pt idx="339">10.238300000000001</cx:pt>
          <cx:pt idx="340">6.4282500000000002</cx:pt>
          <cx:pt idx="341">10.6541</cx:pt>
          <cx:pt idx="342">6.4127999999999998</cx:pt>
          <cx:pt idx="343">9.6349499999999999</cx:pt>
          <cx:pt idx="344">9.3183900000000008</cx:pt>
          <cx:pt idx="345">11.930199999999999</cx:pt>
          <cx:pt idx="346">8.2153299999999998</cx:pt>
          <cx:pt idx="347">8.6097999999999999</cx:pt>
          <cx:pt idx="348">11.998699999999999</cx:pt>
          <cx:pt idx="349">12.8796</cx:pt>
          <cx:pt idx="350">9.3339499999999997</cx:pt>
          <cx:pt idx="351">7.11409</cx:pt>
          <cx:pt idx="352">13.4841</cx:pt>
          <cx:pt idx="353">14.0068</cx:pt>
          <cx:pt idx="354">14.505699999999999</cx:pt>
          <cx:pt idx="355">11.4663</cx:pt>
          <cx:pt idx="356">9.2211400000000001</cx:pt>
          <cx:pt idx="357">8.7270400000000006</cx:pt>
          <cx:pt idx="358">10.7242</cx:pt>
          <cx:pt idx="359">9.1624400000000001</cx:pt>
          <cx:pt idx="360">12.31</cx:pt>
          <cx:pt idx="361">6.4211600000000004</cx:pt>
          <cx:pt idx="362">12.4739</cx:pt>
          <cx:pt idx="363">10.386699999999999</cx:pt>
          <cx:pt idx="364">9.9376300000000004</cx:pt>
          <cx:pt idx="365">6.2443400000000002</cx:pt>
          <cx:pt idx="366">10.1273</cx:pt>
          <cx:pt idx="367">11.2416</cx:pt>
          <cx:pt idx="368">10.774800000000001</cx:pt>
          <cx:pt idx="369">7.1909299999999998</cx:pt>
          <cx:pt idx="370">9.6755200000000006</cx:pt>
          <cx:pt idx="371">7.6221800000000002</cx:pt>
          <cx:pt idx="372">11.951599999999999</cx:pt>
          <cx:pt idx="373">7.2401499999999999</cx:pt>
          <cx:pt idx="374">11.561</cx:pt>
          <cx:pt idx="375">7.7417299999999996</cx:pt>
          <cx:pt idx="376">6.7895000000000003</cx:pt>
          <cx:pt idx="377">11.8179</cx:pt>
          <cx:pt idx="378">7.5929099999999998</cx:pt>
          <cx:pt idx="379">12.160299999999999</cx:pt>
          <cx:pt idx="380">11.584</cx:pt>
          <cx:pt idx="381">10.3056</cx:pt>
          <cx:pt idx="382">8.7560699999999994</cx:pt>
          <cx:pt idx="383">12.234500000000001</cx:pt>
          <cx:pt idx="384">6.6178499999999998</cx:pt>
          <cx:pt idx="385">5.9430500000000004</cx:pt>
          <cx:pt idx="386">11.188800000000001</cx:pt>
          <cx:pt idx="387">11.857100000000001</cx:pt>
          <cx:pt idx="388">12.9663</cx:pt>
          <cx:pt idx="389">6.5191800000000004</cx:pt>
          <cx:pt idx="390">13.2973</cx:pt>
          <cx:pt idx="391">12.674899999999999</cx:pt>
          <cx:pt idx="392">7.9715800000000003</cx:pt>
          <cx:pt idx="393">8.5184200000000008</cx:pt>
          <cx:pt idx="394">8.1375499999999992</cx:pt>
          <cx:pt idx="395">8.1302299999999992</cx:pt>
          <cx:pt idx="396">6.8073800000000002</cx:pt>
          <cx:pt idx="397">9.4177300000000006</cx:pt>
          <cx:pt idx="398">6.0137799999999997</cx:pt>
          <cx:pt idx="399">7.9633200000000004</cx:pt>
          <cx:pt idx="400">11.5846</cx:pt>
          <cx:pt idx="401">7.1959</cx:pt>
          <cx:pt idx="402">11.001899999999999</cx:pt>
          <cx:pt idx="403">10.295</cx:pt>
          <cx:pt idx="404">13.6166</cx:pt>
          <cx:pt idx="405">10.4918</cx:pt>
          <cx:pt idx="406">9.4202300000000001</cx:pt>
          <cx:pt idx="407">9.4832900000000002</cx:pt>
          <cx:pt idx="408">10.929</cx:pt>
          <cx:pt idx="409">10.6701</cx:pt>
          <cx:pt idx="410">8.1556899999999999</cx:pt>
          <cx:pt idx="411">7.4770899999999996</cx:pt>
          <cx:pt idx="412">8.9612999999999996</cx:pt>
          <cx:pt idx="413">10.2578</cx:pt>
          <cx:pt idx="414">4.7268499999999998</cx:pt>
          <cx:pt idx="415">6.2203999999999997</cx:pt>
          <cx:pt idx="416">5.7736700000000001</cx:pt>
          <cx:pt idx="417">13.805400000000001</cx:pt>
          <cx:pt idx="418">9.5850200000000001</cx:pt>
          <cx:pt idx="419">8.6914999999999996</cx:pt>
          <cx:pt idx="420">12.290900000000001</cx:pt>
          <cx:pt idx="421">8.1601199999999992</cx:pt>
          <cx:pt idx="422">5.6556899999999999</cx:pt>
          <cx:pt idx="423">5.8765599999999996</cx:pt>
          <cx:pt idx="424">10.172700000000001</cx:pt>
          <cx:pt idx="425">9.9067600000000002</cx:pt>
          <cx:pt idx="426">11.214600000000001</cx:pt>
          <cx:pt idx="427">9.3030500000000007</cx:pt>
          <cx:pt idx="428">9.5714900000000007</cx:pt>
          <cx:pt idx="429">7.7204800000000002</cx:pt>
          <cx:pt idx="430">11.064</cx:pt>
          <cx:pt idx="431">7.7333800000000004</cx:pt>
          <cx:pt idx="432">6.0349199999999996</cx:pt>
          <cx:pt idx="433">8.4669000000000008</cx:pt>
          <cx:pt idx="434">10.1341</cx:pt>
          <cx:pt idx="435">7.0809600000000001</cx:pt>
          <cx:pt idx="436">10.9025</cx:pt>
          <cx:pt idx="437">12.8498</cx:pt>
          <cx:pt idx="438">9.2981800000000003</cx:pt>
          <cx:pt idx="439">11.4976</cx:pt>
          <cx:pt idx="440">6.3742599999999996</cx:pt>
          <cx:pt idx="441">9.5514200000000002</cx:pt>
          <cx:pt idx="442">10.004899999999999</cx:pt>
          <cx:pt idx="443">11.1173</cx:pt>
          <cx:pt idx="444">9.4383599999999994</cx:pt>
          <cx:pt idx="445">12.6633</cx:pt>
          <cx:pt idx="446">12.901</cx:pt>
          <cx:pt idx="447">13.0502</cx:pt>
          <cx:pt idx="448">9.03294</cx:pt>
          <cx:pt idx="449">10.214</cx:pt>
          <cx:pt idx="450">7.4834800000000001</cx:pt>
          <cx:pt idx="451">9.7393599999999996</cx:pt>
          <cx:pt idx="452">7.7746599999999999</cx:pt>
          <cx:pt idx="453">7.6573700000000002</cx:pt>
          <cx:pt idx="454">11.8248</cx:pt>
          <cx:pt idx="455">9.3181200000000004</cx:pt>
          <cx:pt idx="456">13.867800000000001</cx:pt>
          <cx:pt idx="457">11.305099999999999</cx:pt>
          <cx:pt idx="458">10.599</cx:pt>
          <cx:pt idx="459">10.8401</cx:pt>
          <cx:pt idx="460">12.6661</cx:pt>
          <cx:pt idx="461">10.2737</cx:pt>
          <cx:pt idx="462">12.642300000000001</cx:pt>
          <cx:pt idx="463">12.864599999999999</cx:pt>
          <cx:pt idx="464">9.0260400000000001</cx:pt>
          <cx:pt idx="465">8.0235299999999992</cx:pt>
          <cx:pt idx="466">11.550599999999999</cx:pt>
          <cx:pt idx="467">12.9277</cx:pt>
          <cx:pt idx="468">8.58887</cx:pt>
          <cx:pt idx="469">10.9796</cx:pt>
          <cx:pt idx="470">12.856400000000001</cx:pt>
          <cx:pt idx="471">8.7164199999999994</cx:pt>
          <cx:pt idx="472">9.1814300000000006</cx:pt>
          <cx:pt idx="473">16.853200000000001</cx:pt>
          <cx:pt idx="474">11.245900000000001</cx:pt>
          <cx:pt idx="475">8.9919899999999995</cx:pt>
          <cx:pt idx="476">7.6116999999999999</cx:pt>
          <cx:pt idx="477">11.476800000000001</cx:pt>
          <cx:pt idx="478">7.3401199999999998</cx:pt>
          <cx:pt idx="479">6.6878399999999996</cx:pt>
          <cx:pt idx="480">8.4137400000000007</cx:pt>
          <cx:pt idx="481">6.32111</cx:pt>
          <cx:pt idx="482">12.8841</cx:pt>
          <cx:pt idx="483">12.9954</cx:pt>
          <cx:pt idx="484">13.212999999999999</cx:pt>
          <cx:pt idx="485">9.9750700000000005</cx:pt>
          <cx:pt idx="486">5.1997400000000003</cx:pt>
          <cx:pt idx="487">9.6422399999999993</cx:pt>
          <cx:pt idx="488">11.6128</cx:pt>
          <cx:pt idx="489">12.2737</cx:pt>
          <cx:pt idx="490">9.3691999999999993</cx:pt>
          <cx:pt idx="491">9.5753900000000005</cx:pt>
          <cx:pt idx="492">12.4504</cx:pt>
          <cx:pt idx="493">6.3001500000000004</cx:pt>
          <cx:pt idx="494">8.6209199999999999</cx:pt>
          <cx:pt idx="495">10.4734</cx:pt>
          <cx:pt idx="496">4.5751999999999997</cx:pt>
          <cx:pt idx="497">9.77928</cx:pt>
          <cx:pt idx="498">8.2520500000000006</cx:pt>
          <cx:pt idx="499">9.1422399999999993</cx:pt>
          <cx:pt idx="500">8.6150699999999993</cx:pt>
          <cx:pt idx="501">7.6269600000000004</cx:pt>
          <cx:pt idx="502">12.114000000000001</cx:pt>
          <cx:pt idx="503">12.545299999999999</cx:pt>
          <cx:pt idx="504">12.568</cx:pt>
          <cx:pt idx="505">10.309900000000001</cx:pt>
          <cx:pt idx="506">11.1159</cx:pt>
          <cx:pt idx="507">8.3232099999999996</cx:pt>
          <cx:pt idx="508">6.8223200000000004</cx:pt>
          <cx:pt idx="509">11.1889</cx:pt>
          <cx:pt idx="510">13.343500000000001</cx:pt>
          <cx:pt idx="511">9.6092999999999993</cx:pt>
          <cx:pt idx="512">12.4351</cx:pt>
          <cx:pt idx="513">7.0297799999999997</cx:pt>
          <cx:pt idx="514">6.5971599999999997</cx:pt>
          <cx:pt idx="515">12.0328</cx:pt>
          <cx:pt idx="516">10.3895</cx:pt>
          <cx:pt idx="517">11.933</cx:pt>
          <cx:pt idx="518">11.891400000000001</cx:pt>
          <cx:pt idx="519">7.0312900000000003</cx:pt>
          <cx:pt idx="520">6.6140800000000004</cx:pt>
          <cx:pt idx="521">11.2342</cx:pt>
          <cx:pt idx="522">11.3713</cx:pt>
          <cx:pt idx="523">13.8249</cx:pt>
          <cx:pt idx="524">11.4068</cx:pt>
          <cx:pt idx="525">6.8876900000000001</cx:pt>
          <cx:pt idx="526">5.9749699999999999</cx:pt>
          <cx:pt idx="527">8.9068400000000008</cx:pt>
          <cx:pt idx="528">11.1229</cx:pt>
          <cx:pt idx="529">6.5113300000000001</cx:pt>
          <cx:pt idx="530">7.3622100000000001</cx:pt>
          <cx:pt idx="531">6.4805299999999999</cx:pt>
          <cx:pt idx="532">7.2362399999999996</cx:pt>
          <cx:pt idx="533">5.2384199999999996</cx:pt>
          <cx:pt idx="534">9.7280899999999999</cx:pt>
          <cx:pt idx="535">9.1477000000000004</cx:pt>
          <cx:pt idx="536">9.3955000000000002</cx:pt>
          <cx:pt idx="537">10.7554</cx:pt>
          <cx:pt idx="538">10.19</cx:pt>
          <cx:pt idx="539">12.247400000000001</cx:pt>
          <cx:pt idx="540">9.5704499999999992</cx:pt>
          <cx:pt idx="541">10.7257</cx:pt>
          <cx:pt idx="542">8.9762500000000003</cx:pt>
          <cx:pt idx="543">11.348000000000001</cx:pt>
          <cx:pt idx="544">7.2421699999999998</cx:pt>
          <cx:pt idx="545">7.9453100000000001</cx:pt>
          <cx:pt idx="546">14.279199999999999</cx:pt>
          <cx:pt idx="547">8.7549299999999999</cx:pt>
          <cx:pt idx="548">11.4688</cx:pt>
          <cx:pt idx="549">12.1439</cx:pt>
          <cx:pt idx="550">10.233499999999999</cx:pt>
          <cx:pt idx="551">9.6748700000000003</cx:pt>
          <cx:pt idx="552">11.1769</cx:pt>
          <cx:pt idx="553">10.3438</cx:pt>
          <cx:pt idx="554">8.5190599999999996</cx:pt>
          <cx:pt idx="555">10.624700000000001</cx:pt>
          <cx:pt idx="556">9.2846899999999994</cx:pt>
          <cx:pt idx="557">10.375</cx:pt>
          <cx:pt idx="558">8.6072900000000008</cx:pt>
          <cx:pt idx="559">9.9466999999999999</cx:pt>
          <cx:pt idx="560">12.2056</cx:pt>
          <cx:pt idx="561">12.2095</cx:pt>
          <cx:pt idx="562">10.906499999999999</cx:pt>
          <cx:pt idx="563">8.9098199999999999</cx:pt>
          <cx:pt idx="564">6.1363599999999998</cx:pt>
          <cx:pt idx="565">12.5085</cx:pt>
          <cx:pt idx="566">5.3632900000000001</cx:pt>
          <cx:pt idx="567">10.4077</cx:pt>
          <cx:pt idx="568">6.2150499999999997</cx:pt>
          <cx:pt idx="569">12.435700000000001</cx:pt>
          <cx:pt idx="570">8.0530399999999993</cx:pt>
          <cx:pt idx="571">7.2820999999999998</cx:pt>
          <cx:pt idx="572">10.145</cx:pt>
          <cx:pt idx="573">13.5753</cx:pt>
          <cx:pt idx="574">11.3889</cx:pt>
          <cx:pt idx="575">8.1912500000000001</cx:pt>
          <cx:pt idx="576">7.86693</cx:pt>
          <cx:pt idx="577">12.56</cx:pt>
          <cx:pt idx="578">11.1294</cx:pt>
          <cx:pt idx="579">12.283799999999999</cx:pt>
          <cx:pt idx="580">10.200900000000001</cx:pt>
          <cx:pt idx="581">4.6548400000000001</cx:pt>
          <cx:pt idx="582">13.305199999999999</cx:pt>
          <cx:pt idx="583">5.6344799999999999</cx:pt>
          <cx:pt idx="584">10.4039</cx:pt>
          <cx:pt idx="585">9.1717399999999998</cx:pt>
          <cx:pt idx="586">8.1275899999999996</cx:pt>
          <cx:pt idx="587">10.6327</cx:pt>
          <cx:pt idx="588">10.591100000000001</cx:pt>
          <cx:pt idx="589">9.8481799999999993</cx:pt>
          <cx:pt idx="590">5.5841500000000002</cx:pt>
          <cx:pt idx="591">11.6332</cx:pt>
          <cx:pt idx="592">8.7310400000000001</cx:pt>
          <cx:pt idx="593">5.1122100000000001</cx:pt>
          <cx:pt idx="594">12.2463</cx:pt>
          <cx:pt idx="595">9.4797700000000003</cx:pt>
          <cx:pt idx="596">9.4294499999999992</cx:pt>
          <cx:pt idx="597">11.0319</cx:pt>
          <cx:pt idx="598">9.8990899999999993</cx:pt>
          <cx:pt idx="599">14.303000000000001</cx:pt>
          <cx:pt idx="600">10.539999999999999</cx:pt>
          <cx:pt idx="601">11.983000000000001</cx:pt>
          <cx:pt idx="602">13.748900000000001</cx:pt>
          <cx:pt idx="603">9.9936699999999998</cx:pt>
          <cx:pt idx="604">11.567600000000001</cx:pt>
          <cx:pt idx="605">12.191000000000001</cx:pt>
          <cx:pt idx="606">8.1777099999999994</cx:pt>
          <cx:pt idx="607">10.738899999999999</cx:pt>
          <cx:pt idx="608">6.7219600000000002</cx:pt>
          <cx:pt idx="609">12.499700000000001</cx:pt>
          <cx:pt idx="610">9.2235700000000005</cx:pt>
          <cx:pt idx="611">11.389099999999999</cx:pt>
          <cx:pt idx="612">11.2338</cx:pt>
          <cx:pt idx="613">11.0916</cx:pt>
          <cx:pt idx="614">8.7832699999999999</cx:pt>
          <cx:pt idx="615">11.1754</cx:pt>
          <cx:pt idx="616">5.8117200000000002</cx:pt>
          <cx:pt idx="617">9.80213</cx:pt>
          <cx:pt idx="618">10.5708</cx:pt>
          <cx:pt idx="619">8.6560699999999997</cx:pt>
          <cx:pt idx="620">7.29779</cx:pt>
          <cx:pt idx="621">5.4061700000000004</cx:pt>
          <cx:pt idx="622">8.0834299999999999</cx:pt>
          <cx:pt idx="623">7.2127600000000003</cx:pt>
          <cx:pt idx="624">6.6758600000000001</cx:pt>
          <cx:pt idx="625">13.09</cx:pt>
          <cx:pt idx="626">10.6988</cx:pt>
          <cx:pt idx="627">9.5857100000000006</cx:pt>
          <cx:pt idx="628">8.57742</cx:pt>
          <cx:pt idx="629">10.2767</cx:pt>
          <cx:pt idx="630">8.05776</cx:pt>
          <cx:pt idx="631">8.3577899999999996</cx:pt>
          <cx:pt idx="632">15.819000000000001</cx:pt>
          <cx:pt idx="633">5.3836899999999996</cx:pt>
          <cx:pt idx="634">7.1715999999999998</cx:pt>
          <cx:pt idx="635">10.3202</cx:pt>
          <cx:pt idx="636">10.089499999999999</cx:pt>
          <cx:pt idx="637">12.2415</cx:pt>
          <cx:pt idx="638">13.5068</cx:pt>
          <cx:pt idx="639">6.1363500000000002</cx:pt>
          <cx:pt idx="640">5.6378300000000001</cx:pt>
          <cx:pt idx="641">9.8277900000000002</cx:pt>
          <cx:pt idx="642">10.255699999999999</cx:pt>
          <cx:pt idx="643">12.1698</cx:pt>
          <cx:pt idx="644">10.257999999999999</cx:pt>
          <cx:pt idx="645">13.473100000000001</cx:pt>
          <cx:pt idx="646">11.8592</cx:pt>
          <cx:pt idx="647">11.042199999999999</cx:pt>
          <cx:pt idx="648">12.936199999999999</cx:pt>
          <cx:pt idx="649">12.0351</cx:pt>
          <cx:pt idx="650">6.0172800000000004</cx:pt>
          <cx:pt idx="651">9.9072200000000006</cx:pt>
          <cx:pt idx="652">8.7207000000000008</cx:pt>
          <cx:pt idx="653">7.2033699999999996</cx:pt>
          <cx:pt idx="654">11.345000000000001</cx:pt>
          <cx:pt idx="655">13.8171</cx:pt>
          <cx:pt idx="656">12.0016</cx:pt>
          <cx:pt idx="657">5.81006</cx:pt>
          <cx:pt idx="658">11.471</cx:pt>
          <cx:pt idx="659">9.5828699999999998</cx:pt>
          <cx:pt idx="660">8.0087100000000007</cx:pt>
          <cx:pt idx="661">5.3450800000000003</cx:pt>
          <cx:pt idx="662">10.595700000000001</cx:pt>
          <cx:pt idx="663">11.1013</cx:pt>
          <cx:pt idx="664">7.5472700000000001</cx:pt>
          <cx:pt idx="665">6.8055099999999999</cx:pt>
          <cx:pt idx="666">11.3979</cx:pt>
          <cx:pt idx="667">10.511799999999999</cx:pt>
          <cx:pt idx="668">9.7911800000000007</cx:pt>
          <cx:pt idx="669">6.32789</cx:pt>
          <cx:pt idx="670">7.5547800000000001</cx:pt>
          <cx:pt idx="671">11.6967</cx:pt>
          <cx:pt idx="672">7.9421299999999997</cx:pt>
          <cx:pt idx="673">14.011200000000001</cx:pt>
          <cx:pt idx="674">6.4821499999999999</cx:pt>
          <cx:pt idx="675">10.9062</cx:pt>
          <cx:pt idx="676">9.3373600000000003</cx:pt>
          <cx:pt idx="677">14.4688</cx:pt>
          <cx:pt idx="678">7.9152399999999998</cx:pt>
          <cx:pt idx="679">12.7774</cx:pt>
          <cx:pt idx="680">12.7354</cx:pt>
          <cx:pt idx="681">8.8830200000000001</cx:pt>
          <cx:pt idx="682">11.0646</cx:pt>
          <cx:pt idx="683">7.6453199999999999</cx:pt>
          <cx:pt idx="684">8.8724699999999999</cx:pt>
          <cx:pt idx="685">5.4251800000000001</cx:pt>
          <cx:pt idx="686">8.6525599999999994</cx:pt>
          <cx:pt idx="687">8.7990499999999994</cx:pt>
          <cx:pt idx="688">6.6445100000000004</cx:pt>
          <cx:pt idx="689">13.081200000000001</cx:pt>
          <cx:pt idx="690">10.954700000000001</cx:pt>
          <cx:pt idx="691">10.719799999999999</cx:pt>
          <cx:pt idx="692">6.3649899999999997</cx:pt>
          <cx:pt idx="693">7.9131600000000004</cx:pt>
          <cx:pt idx="694">12.449</cx:pt>
          <cx:pt idx="695">6.343</cx:pt>
          <cx:pt idx="696">14.015599999999999</cx:pt>
          <cx:pt idx="697">6.2857000000000003</cx:pt>
          <cx:pt idx="698">10.017300000000001</cx:pt>
          <cx:pt idx="699">12.497400000000001</cx:pt>
          <cx:pt idx="700">12.7395</cx:pt>
          <cx:pt idx="701">11.7037</cx:pt>
          <cx:pt idx="702">7.4614099999999999</cx:pt>
          <cx:pt idx="703">9.3840299999999992</cx:pt>
          <cx:pt idx="704">10.894</cx:pt>
          <cx:pt idx="705">11.631399999999999</cx:pt>
          <cx:pt idx="706">11.0032</cx:pt>
          <cx:pt idx="707">11.771699999999999</cx:pt>
          <cx:pt idx="708">10.353999999999999</cx:pt>
          <cx:pt idx="709">10.2219</cx:pt>
          <cx:pt idx="710">7.7797999999999998</cx:pt>
          <cx:pt idx="711">12.242800000000001</cx:pt>
          <cx:pt idx="712">6.3424399999999999</cx:pt>
          <cx:pt idx="713">9.3067100000000007</cx:pt>
          <cx:pt idx="714">7.5080499999999999</cx:pt>
          <cx:pt idx="715">6.8603500000000004</cx:pt>
          <cx:pt idx="716">13.741199999999999</cx:pt>
          <cx:pt idx="717">8.9296100000000003</cx:pt>
          <cx:pt idx="718">6.4793799999999999</cx:pt>
          <cx:pt idx="719">7.5709999999999997</cx:pt>
          <cx:pt idx="720">14.6813</cx:pt>
          <cx:pt idx="721">9.5609800000000007</cx:pt>
          <cx:pt idx="722">6.8557300000000003</cx:pt>
          <cx:pt idx="723">7.5829500000000003</cx:pt>
          <cx:pt idx="724">10.905200000000001</cx:pt>
          <cx:pt idx="725">8.8198600000000003</cx:pt>
          <cx:pt idx="726">8.2308299999999992</cx:pt>
          <cx:pt idx="727">13.0365</cx:pt>
          <cx:pt idx="728">7.1127200000000004</cx:pt>
          <cx:pt idx="729">9.8730700000000002</cx:pt>
          <cx:pt idx="730">11.470599999999999</cx:pt>
          <cx:pt idx="731">10.402200000000001</cx:pt>
          <cx:pt idx="732">14.4175</cx:pt>
          <cx:pt idx="733">6.4282199999999996</cx:pt>
          <cx:pt idx="734">8.1409199999999995</cx:pt>
          <cx:pt idx="735">10.4193</cx:pt>
          <cx:pt idx="736">8.0798900000000007</cx:pt>
          <cx:pt idx="737">10.171799999999999</cx:pt>
          <cx:pt idx="738">11.427</cx:pt>
          <cx:pt idx="739">9.9171099999999992</cx:pt>
          <cx:pt idx="740">9.2497299999999996</cx:pt>
          <cx:pt idx="741">9.5644299999999998</cx:pt>
          <cx:pt idx="742">12.520200000000001</cx:pt>
          <cx:pt idx="743">10.207100000000001</cx:pt>
          <cx:pt idx="744">10.5528</cx:pt>
          <cx:pt idx="745">12.6691</cx:pt>
          <cx:pt idx="746">16.827000000000002</cx:pt>
          <cx:pt idx="747">10.7562</cx:pt>
          <cx:pt idx="748">8.5365000000000002</cx:pt>
          <cx:pt idx="749">7.1090799999999996</cx:pt>
          <cx:pt idx="750">10.952199999999999</cx:pt>
          <cx:pt idx="751">11.3597</cx:pt>
          <cx:pt idx="752">12.1447</cx:pt>
          <cx:pt idx="753">13.520799999999999</cx:pt>
          <cx:pt idx="754">9.1249900000000004</cx:pt>
          <cx:pt idx="755">10.005800000000001</cx:pt>
          <cx:pt idx="756">7.6062500000000002</cx:pt>
          <cx:pt idx="757">15.2385</cx:pt>
          <cx:pt idx="758">7.17415</cx:pt>
          <cx:pt idx="759">7.8041200000000002</cx:pt>
          <cx:pt idx="760">10.9254</cx:pt>
          <cx:pt idx="761">6.6070700000000002</cx:pt>
          <cx:pt idx="762">13.780900000000001</cx:pt>
          <cx:pt idx="763">9.4322800000000004</cx:pt>
          <cx:pt idx="764">7.3373600000000003</cx:pt>
          <cx:pt idx="765">13.087</cx:pt>
          <cx:pt idx="766">11.686400000000001</cx:pt>
          <cx:pt idx="767">4.1799400000000002</cx:pt>
          <cx:pt idx="768">11.468400000000001</cx:pt>
          <cx:pt idx="769">8.0868099999999998</cx:pt>
          <cx:pt idx="770">10.806699999999999</cx:pt>
          <cx:pt idx="771">11.810499999999999</cx:pt>
          <cx:pt idx="772">9.2941599999999998</cx:pt>
          <cx:pt idx="773">9.2423599999999997</cx:pt>
          <cx:pt idx="774">11.4796</cx:pt>
          <cx:pt idx="775">9.6781199999999998</cx:pt>
          <cx:pt idx="776">8.1333900000000003</cx:pt>
          <cx:pt idx="777">10.1706</cx:pt>
          <cx:pt idx="778">10.8674</cx:pt>
          <cx:pt idx="779">8.4971899999999998</cx:pt>
          <cx:pt idx="780">9.6684999999999999</cx:pt>
          <cx:pt idx="781">10.0083</cx:pt>
          <cx:pt idx="782">13.3622</cx:pt>
          <cx:pt idx="783">11.5283</cx:pt>
          <cx:pt idx="784">5.3181000000000003</cx:pt>
          <cx:pt idx="785">8.1124899999999993</cx:pt>
          <cx:pt idx="786">14.8742</cx:pt>
          <cx:pt idx="787">8.3601799999999997</cx:pt>
          <cx:pt idx="788">7.9469700000000003</cx:pt>
          <cx:pt idx="789">12.233000000000001</cx:pt>
          <cx:pt idx="790">8.5824599999999993</cx:pt>
          <cx:pt idx="791">12.497</cx:pt>
          <cx:pt idx="792">10.952500000000001</cx:pt>
          <cx:pt idx="793">6.9640399999999998</cx:pt>
          <cx:pt idx="794">10.1798</cx:pt>
          <cx:pt idx="795">6.6201999999999996</cx:pt>
          <cx:pt idx="796">8.1621799999999993</cx:pt>
          <cx:pt idx="797">7.1618399999999998</cx:pt>
          <cx:pt idx="798">6.3703500000000002</cx:pt>
          <cx:pt idx="799">9.2361400000000007</cx:pt>
          <cx:pt idx="800">9.8830600000000004</cx:pt>
          <cx:pt idx="801">7.0915100000000004</cx:pt>
          <cx:pt idx="802">11.9703</cx:pt>
          <cx:pt idx="803">7.1505000000000001</cx:pt>
          <cx:pt idx="804">13.0876</cx:pt>
          <cx:pt idx="805">5.9852600000000002</cx:pt>
          <cx:pt idx="806">7.9535200000000001</cx:pt>
          <cx:pt idx="807">7.7603299999999997</cx:pt>
          <cx:pt idx="808">11.289</cx:pt>
          <cx:pt idx="809">11.7525</cx:pt>
          <cx:pt idx="810">9.1232399999999991</cx:pt>
          <cx:pt idx="811">12.2766</cx:pt>
          <cx:pt idx="812">10.151899999999999</cx:pt>
          <cx:pt idx="813">9.6332500000000003</cx:pt>
          <cx:pt idx="814">12.455299999999999</cx:pt>
          <cx:pt idx="815">8.9904600000000006</cx:pt>
          <cx:pt idx="816">4.3485199999999997</cx:pt>
          <cx:pt idx="817">10.5848</cx:pt>
          <cx:pt idx="818">11.276899999999999</cx:pt>
          <cx:pt idx="819">9.5596700000000006</cx:pt>
          <cx:pt idx="820">12.298299999999999</cx:pt>
          <cx:pt idx="821">7.3476600000000003</cx:pt>
          <cx:pt idx="822">12.449299999999999</cx:pt>
          <cx:pt idx="823">9.0947700000000005</cx:pt>
          <cx:pt idx="824">10.2866</cx:pt>
          <cx:pt idx="825">10.4945</cx:pt>
          <cx:pt idx="826">10.4407</cx:pt>
          <cx:pt idx="827">7.05647</cx:pt>
          <cx:pt idx="828">6.9322999999999997</cx:pt>
          <cx:pt idx="829">8.4989500000000007</cx:pt>
          <cx:pt idx="830">9.5657099999999993</cx:pt>
          <cx:pt idx="831">12.412599999999999</cx:pt>
          <cx:pt idx="832">11.1896</cx:pt>
          <cx:pt idx="833">11.9809</cx:pt>
          <cx:pt idx="834">13.1944</cx:pt>
          <cx:pt idx="835">5.7506000000000004</cx:pt>
          <cx:pt idx="836">16.212499999999999</cx:pt>
          <cx:pt idx="837">10.509499999999999</cx:pt>
          <cx:pt idx="838">11.9648</cx:pt>
          <cx:pt idx="839">9.7270099999999999</cx:pt>
          <cx:pt idx="840">8.7196499999999997</cx:pt>
          <cx:pt idx="841">9.7777999999999992</cx:pt>
          <cx:pt idx="842">5.6837999999999997</cx:pt>
          <cx:pt idx="843">12.770200000000001</cx:pt>
          <cx:pt idx="844">11.700799999999999</cx:pt>
          <cx:pt idx="845">6.4363700000000001</cx:pt>
          <cx:pt idx="846">10.3643</cx:pt>
          <cx:pt idx="847">5.3830299999999998</cx:pt>
          <cx:pt idx="848">9.0295400000000008</cx:pt>
          <cx:pt idx="849">9.4362100000000009</cx:pt>
          <cx:pt idx="850">7.6551499999999999</cx:pt>
          <cx:pt idx="851">6.7409999999999997</cx:pt>
          <cx:pt idx="852">13.787800000000001</cx:pt>
          <cx:pt idx="853">6.4379799999999996</cx:pt>
          <cx:pt idx="854">9.2580500000000008</cx:pt>
          <cx:pt idx="855">8.3238299999999992</cx:pt>
          <cx:pt idx="856">11.3187</cx:pt>
          <cx:pt idx="857">13.294499999999999</cx:pt>
          <cx:pt idx="858">4.8449900000000001</cx:pt>
          <cx:pt idx="859">13.079800000000001</cx:pt>
          <cx:pt idx="860">6.26288</cx:pt>
          <cx:pt idx="861">7.01044</cx:pt>
          <cx:pt idx="862">8.8026999999999997</cx:pt>
          <cx:pt idx="863">11.9809</cx:pt>
          <cx:pt idx="864">6.90341</cx:pt>
          <cx:pt idx="865">10.7768</cx:pt>
          <cx:pt idx="866">5.0850400000000002</cx:pt>
          <cx:pt idx="867">10.0747</cx:pt>
          <cx:pt idx="868">13.9091</cx:pt>
          <cx:pt idx="869">11.9299</cx:pt>
          <cx:pt idx="870">11.414899999999999</cx:pt>
          <cx:pt idx="871">13.5242</cx:pt>
          <cx:pt idx="872">7.1187699999999996</cx:pt>
          <cx:pt idx="873">9.6940600000000003</cx:pt>
          <cx:pt idx="874">9.6223899999999993</cx:pt>
          <cx:pt idx="875">10.3009</cx:pt>
          <cx:pt idx="876">10.8691</cx:pt>
          <cx:pt idx="877">9.4567300000000003</cx:pt>
          <cx:pt idx="878">8.9111499999999992</cx:pt>
          <cx:pt idx="879">10.4147</cx:pt>
          <cx:pt idx="880">10.116199999999999</cx:pt>
          <cx:pt idx="881">8.3102800000000006</cx:pt>
          <cx:pt idx="882">10.246</cx:pt>
          <cx:pt idx="883">10.4117</cx:pt>
          <cx:pt idx="884">12.8409</cx:pt>
          <cx:pt idx="885">13.024800000000001</cx:pt>
          <cx:pt idx="886">10.7202</cx:pt>
          <cx:pt idx="887">8.56921</cx:pt>
          <cx:pt idx="888">5.4041399999999999</cx:pt>
          <cx:pt idx="889">6.83535</cx:pt>
          <cx:pt idx="890">10.178000000000001</cx:pt>
          <cx:pt idx="891">6.86937</cx:pt>
          <cx:pt idx="892">5.6931200000000004</cx:pt>
          <cx:pt idx="893">11.9846</cx:pt>
          <cx:pt idx="894">9.8603799999999993</cx:pt>
          <cx:pt idx="895">11.928100000000001</cx:pt>
          <cx:pt idx="896">6.6470399999999996</cx:pt>
          <cx:pt idx="897">9.7417999999999996</cx:pt>
          <cx:pt idx="898">11.0334</cx:pt>
          <cx:pt idx="899">11.112299999999999</cx:pt>
          <cx:pt idx="900">10.9499</cx:pt>
          <cx:pt idx="901">7.3320699999999999</cx:pt>
          <cx:pt idx="902">9.4670000000000005</cx:pt>
          <cx:pt idx="903">9.5478100000000001</cx:pt>
          <cx:pt idx="904">12.259399999999999</cx:pt>
          <cx:pt idx="905">10.497299999999999</cx:pt>
          <cx:pt idx="906">7.6062500000000002</cx:pt>
          <cx:pt idx="907">11.4635</cx:pt>
          <cx:pt idx="908">8.0287500000000005</cx:pt>
          <cx:pt idx="909">12.169700000000001</cx:pt>
          <cx:pt idx="910">10.8826</cx:pt>
          <cx:pt idx="911">8.6699300000000008</cx:pt>
          <cx:pt idx="912">12.795400000000001</cx:pt>
          <cx:pt idx="913">11.551399999999999</cx:pt>
          <cx:pt idx="914">7.3822599999999996</cx:pt>
          <cx:pt idx="915">7.5056200000000004</cx:pt>
          <cx:pt idx="916">7.91561</cx:pt>
          <cx:pt idx="917">12.0623</cx:pt>
          <cx:pt idx="918">9.9704899999999999</cx:pt>
          <cx:pt idx="919">6.2154800000000003</cx:pt>
          <cx:pt idx="920">8.4302899999999994</cx:pt>
          <cx:pt idx="921">11.2294</cx:pt>
          <cx:pt idx="922">8.0415399999999995</cx:pt>
          <cx:pt idx="923">11.6175</cx:pt>
          <cx:pt idx="924">12.424899999999999</cx:pt>
          <cx:pt idx="925">11.045199999999999</cx:pt>
          <cx:pt idx="926">7.8959700000000002</cx:pt>
          <cx:pt idx="927">10.259600000000001</cx:pt>
          <cx:pt idx="928">8.9311699999999998</cx:pt>
          <cx:pt idx="929">9.2325900000000001</cx:pt>
          <cx:pt idx="930">5.0929599999999997</cx:pt>
          <cx:pt idx="931">11.202500000000001</cx:pt>
          <cx:pt idx="932">10.553100000000001</cx:pt>
          <cx:pt idx="933">7.3518800000000004</cx:pt>
          <cx:pt idx="934">9.6240000000000006</cx:pt>
          <cx:pt idx="935">12.564500000000001</cx:pt>
          <cx:pt idx="936">9.1051300000000008</cx:pt>
          <cx:pt idx="937">11.632999999999999</cx:pt>
          <cx:pt idx="938">10.9351</cx:pt>
          <cx:pt idx="939">6.2394699999999998</cx:pt>
          <cx:pt idx="940">12.4094</cx:pt>
          <cx:pt idx="941">11.477</cx:pt>
          <cx:pt idx="942">16.508800000000001</cx:pt>
          <cx:pt idx="943">13.132</cx:pt>
          <cx:pt idx="944">10.0403</cx:pt>
          <cx:pt idx="945">10.156700000000001</cx:pt>
          <cx:pt idx="946">13.2355</cx:pt>
          <cx:pt idx="947">9.4654299999999996</cx:pt>
          <cx:pt idx="948">15.1325</cx:pt>
          <cx:pt idx="949">11.5412</cx:pt>
          <cx:pt idx="950">11.174200000000001</cx:pt>
          <cx:pt idx="951">11.058</cx:pt>
          <cx:pt idx="952">8.3635900000000003</cx:pt>
          <cx:pt idx="953">10.495699999999999</cx:pt>
          <cx:pt idx="954">7.8284099999999999</cx:pt>
          <cx:pt idx="955">11.1386</cx:pt>
          <cx:pt idx="956">11.7539</cx:pt>
          <cx:pt idx="957">8.6161799999999999</cx:pt>
          <cx:pt idx="958">10.8613</cx:pt>
          <cx:pt idx="959">12.747299999999999</cx:pt>
          <cx:pt idx="960">10.5197</cx:pt>
          <cx:pt idx="961">10.6341</cx:pt>
          <cx:pt idx="962">9.0410400000000006</cx:pt>
          <cx:pt idx="963">8.0247700000000002</cx:pt>
          <cx:pt idx="964">10.829599999999999</cx:pt>
          <cx:pt idx="965">13.1945</cx:pt>
          <cx:pt idx="966">10.684699999999999</cx:pt>
          <cx:pt idx="967">6.4841300000000004</cx:pt>
          <cx:pt idx="968">14.100300000000001</cx:pt>
          <cx:pt idx="969">5.0201900000000004</cx:pt>
          <cx:pt idx="970">9.3944600000000005</cx:pt>
          <cx:pt idx="971">9.5247399999999995</cx:pt>
          <cx:pt idx="972">9.0603200000000008</cx:pt>
          <cx:pt idx="973">5.6022100000000004</cx:pt>
          <cx:pt idx="974">10.905900000000001</cx:pt>
          <cx:pt idx="975">11.1549</cx:pt>
          <cx:pt idx="976">12.035500000000001</cx:pt>
          <cx:pt idx="977">11.064299999999999</cx:pt>
          <cx:pt idx="978">8.2046799999999998</cx:pt>
          <cx:pt idx="979">5.3460299999999998</cx:pt>
          <cx:pt idx="980">9.7922799999999999</cx:pt>
          <cx:pt idx="981">11.165100000000001</cx:pt>
          <cx:pt idx="982">9.4114500000000003</cx:pt>
          <cx:pt idx="983">9.6177799999999998</cx:pt>
          <cx:pt idx="984">8.5487199999999994</cx:pt>
          <cx:pt idx="985">11.0365</cx:pt>
          <cx:pt idx="986">9.9919200000000004</cx:pt>
          <cx:pt idx="987">4.5890199999999997</cx:pt>
          <cx:pt idx="988">12.161</cx:pt>
          <cx:pt idx="989">5.1645200000000004</cx:pt>
          <cx:pt idx="990">5.9942399999999996</cx:pt>
          <cx:pt idx="991">9.4318100000000005</cx:pt>
          <cx:pt idx="992">9.0067699999999995</cx:pt>
          <cx:pt idx="993">5.2366200000000003</cx:pt>
          <cx:pt idx="994">13.1591</cx:pt>
          <cx:pt idx="995">8.9304000000000006</cx:pt>
          <cx:pt idx="996">8.9950700000000001</cx:pt>
          <cx:pt idx="997">10.2798</cx:pt>
          <cx:pt idx="998">9.8553800000000003</cx:pt>
          <cx:pt idx="999">12.2418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sz="20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200" b="0" i="0" u="none" strike="noStrike" baseline="0" dirty="0" err="1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max,acute</a:t>
            </a:r>
            <a:endParaRPr lang="ja-JP" altLang="en-US" sz="1200" b="0" i="0" u="none" strike="noStrike" baseline="0" dirty="0">
              <a:solidFill>
                <a:sysClr val="windowText" lastClr="000000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cx:rich>
      </cx:tx>
    </cx:title>
    <cx:plotArea>
      <cx:plotAreaRegion>
        <cx:series layoutId="clusteredColumn" uniqueId="{47C08B74-032A-4CD1-BFA2-96128D94215E}">
          <cx:tx>
            <cx:txData>
              <cx:f>'PD acute'!$L$1</cx:f>
              <cx:v>tvEmaxp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Count val="15"/>
            </cx:binning>
          </cx:layoutPr>
        </cx:series>
      </cx:plotAreaRegion>
      <cx:axis id="0">
        <cx:catScaling gapWidth="0"/>
        <cx:tickLabels/>
        <cx:numFmt formatCode="#,##0.0_);[赤](#,##0.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13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PD acute'!$M$2:$M$1001</cx:f>
        <cx:lvl ptCount="1000" formatCode="G/標準">
          <cx:pt idx="0">0.33437600000000001</cx:pt>
          <cx:pt idx="1">0.34376099999999998</cx:pt>
          <cx:pt idx="2">0.34782200000000002</cx:pt>
          <cx:pt idx="3">0.298261</cx:pt>
          <cx:pt idx="4">0.35204400000000002</cx:pt>
          <cx:pt idx="5">0.251917</cx:pt>
          <cx:pt idx="6">0.372859</cx:pt>
          <cx:pt idx="7">0.33404200000000001</cx:pt>
          <cx:pt idx="8">0.34170699999999998</cx:pt>
          <cx:pt idx="9">0.32355</cx:pt>
          <cx:pt idx="10">0.35623500000000002</cx:pt>
          <cx:pt idx="11">0.32822200000000001</cx:pt>
          <cx:pt idx="12">0.33853499999999997</cx:pt>
          <cx:pt idx="13">0.39139200000000002</cx:pt>
          <cx:pt idx="14">0.34120299999999998</cx:pt>
          <cx:pt idx="15">0.33602799999999999</cx:pt>
          <cx:pt idx="16">0.36003200000000002</cx:pt>
          <cx:pt idx="17">0.34839999999999999</cx:pt>
          <cx:pt idx="18">0.32741399999999998</cx:pt>
          <cx:pt idx="19">0.35930099999999998</cx:pt>
          <cx:pt idx="20">0.319604</cx:pt>
          <cx:pt idx="21">0.33660299999999999</cx:pt>
          <cx:pt idx="22">0.35452699999999998</cx:pt>
          <cx:pt idx="23">0.403914</cx:pt>
          <cx:pt idx="24">0.34259699999999998</cx:pt>
          <cx:pt idx="25">0.372581</cx:pt>
          <cx:pt idx="26">0.38427899999999998</cx:pt>
          <cx:pt idx="27">0.38533499999999998</cx:pt>
          <cx:pt idx="28">0.21261099999999999</cx:pt>
          <cx:pt idx="29">0.32224999999999998</cx:pt>
          <cx:pt idx="30">0.36685400000000001</cx:pt>
          <cx:pt idx="31">0.32635900000000001</cx:pt>
          <cx:pt idx="32">0.26911099999999999</cx:pt>
          <cx:pt idx="33">0.30975999999999998</cx:pt>
          <cx:pt idx="34">0.37976799999999999</cx:pt>
          <cx:pt idx="35">0.35121999999999998</cx:pt>
          <cx:pt idx="36">0.331874</cx:pt>
          <cx:pt idx="37">0.35722100000000001</cx:pt>
          <cx:pt idx="38">0.23252999999999999</cx:pt>
          <cx:pt idx="39">0.36051</cx:pt>
          <cx:pt idx="40">0.329924</cx:pt>
          <cx:pt idx="41">0.33785199999999999</cx:pt>
          <cx:pt idx="42">0.36271399999999998</cx:pt>
          <cx:pt idx="43">0.34887400000000002</cx:pt>
          <cx:pt idx="44">0.34532400000000002</cx:pt>
          <cx:pt idx="45">0.35512199999999999</cx:pt>
          <cx:pt idx="46">0.35616100000000001</cx:pt>
          <cx:pt idx="47">0.26062999999999997</cx:pt>
          <cx:pt idx="48">0.32084200000000002</cx:pt>
          <cx:pt idx="49">0.35142699999999999</cx:pt>
          <cx:pt idx="50">0.34605000000000002</cx:pt>
          <cx:pt idx="51">0.36982100000000001</cx:pt>
          <cx:pt idx="52">0.339445</cx:pt>
          <cx:pt idx="53">0.25814700000000002</cx:pt>
          <cx:pt idx="54">0.35853699999999999</cx:pt>
          <cx:pt idx="55">0.364927</cx:pt>
          <cx:pt idx="56">0.33258199999999999</cx:pt>
          <cx:pt idx="57">0.36181999999999997</cx:pt>
          <cx:pt idx="58">0.34366200000000002</cx:pt>
          <cx:pt idx="59">0.33395399999999997</cx:pt>
          <cx:pt idx="60">0.31501699999999999</cx:pt>
          <cx:pt idx="61">0.35382799999999998</cx:pt>
          <cx:pt idx="62">0.34794599999999998</cx:pt>
          <cx:pt idx="63">0.35700100000000001</cx:pt>
          <cx:pt idx="64">0.27604899999999999</cx:pt>
          <cx:pt idx="65">0.32100000000000001</cx:pt>
          <cx:pt idx="66">0.32633400000000001</cx:pt>
          <cx:pt idx="67">0.36226799999999998</cx:pt>
          <cx:pt idx="68">0.35406700000000002</cx:pt>
          <cx:pt idx="69">0.37913999999999998</cx:pt>
          <cx:pt idx="70">0.34399299999999999</cx:pt>
          <cx:pt idx="71">0.32631300000000002</cx:pt>
          <cx:pt idx="72">0.272341</cx:pt>
          <cx:pt idx="73">0.343864</cx:pt>
          <cx:pt idx="74">0.36512499999999998</cx:pt>
          <cx:pt idx="75">0.34148200000000001</cx:pt>
          <cx:pt idx="76">0.355319</cx:pt>
          <cx:pt idx="77">0.34245300000000001</cx:pt>
          <cx:pt idx="78">0.35188399999999997</cx:pt>
          <cx:pt idx="79">0.34370899999999999</cx:pt>
          <cx:pt idx="80">0.31340800000000002</cx:pt>
          <cx:pt idx="81">0.33963199999999999</cx:pt>
          <cx:pt idx="82">0.346163</cx:pt>
          <cx:pt idx="83">0.36216100000000001</cx:pt>
          <cx:pt idx="84">0.34265200000000001</cx:pt>
          <cx:pt idx="85">0.33706799999999998</cx:pt>
          <cx:pt idx="86">0.34679399999999999</cx:pt>
          <cx:pt idx="87">0.32613900000000001</cx:pt>
          <cx:pt idx="88">0.385328</cx:pt>
          <cx:pt idx="89">0.36299100000000001</cx:pt>
          <cx:pt idx="90">0.34193200000000001</cx:pt>
          <cx:pt idx="91">0.23871700000000001</cx:pt>
          <cx:pt idx="92">0.40437600000000001</cx:pt>
          <cx:pt idx="93">0.335673</cx:pt>
          <cx:pt idx="94">0.28627200000000003</cx:pt>
          <cx:pt idx="95">0.35827999999999999</cx:pt>
          <cx:pt idx="96">0.35131600000000002</cx:pt>
          <cx:pt idx="97">0.371415</cx:pt>
          <cx:pt idx="98">0.32350099999999998</cx:pt>
          <cx:pt idx="99">0.32561400000000001</cx:pt>
          <cx:pt idx="100">0.37865500000000002</cx:pt>
          <cx:pt idx="101">0.33179199999999998</cx:pt>
          <cx:pt idx="102">0.31579000000000002</cx:pt>
          <cx:pt idx="103">0.38543300000000003</cx:pt>
          <cx:pt idx="104">0.36966500000000002</cx:pt>
          <cx:pt idx="105">0.22406699999999999</cx:pt>
          <cx:pt idx="106">0.345055</cx:pt>
          <cx:pt idx="107">0.32395800000000002</cx:pt>
          <cx:pt idx="108">0.35469800000000001</cx:pt>
          <cx:pt idx="109">0.33351999999999998</cx:pt>
          <cx:pt idx="110">0.34768500000000002</cx:pt>
          <cx:pt idx="111">0.37021100000000001</cx:pt>
          <cx:pt idx="112">0.34938900000000001</cx:pt>
          <cx:pt idx="113">0.35895100000000002</cx:pt>
          <cx:pt idx="114">0.35322900000000002</cx:pt>
          <cx:pt idx="115">0.35244500000000001</cx:pt>
          <cx:pt idx="116">0.37321700000000002</cx:pt>
          <cx:pt idx="117">0.34071200000000001</cx:pt>
          <cx:pt idx="118">0.38474799999999998</cx:pt>
          <cx:pt idx="119">0.35593999999999998</cx:pt>
          <cx:pt idx="120">0.34933199999999998</cx:pt>
          <cx:pt idx="121">0.36299100000000001</cx:pt>
          <cx:pt idx="122">0.38777200000000001</cx:pt>
          <cx:pt idx="123">0.37157299999999999</cx:pt>
          <cx:pt idx="124">0.32838400000000001</cx:pt>
          <cx:pt idx="125">0.35727700000000001</cx:pt>
          <cx:pt idx="126">0.34464899999999998</cx:pt>
          <cx:pt idx="127">0.34715299999999999</cx:pt>
          <cx:pt idx="128">0.34648400000000001</cx:pt>
          <cx:pt idx="129">0.36160700000000001</cx:pt>
          <cx:pt idx="130">0.35453800000000002</cx:pt>
          <cx:pt idx="131">0.37639699999999998</cx:pt>
          <cx:pt idx="132">0.359404</cx:pt>
          <cx:pt idx="133">0.35037299999999999</cx:pt>
          <cx:pt idx="134">0.37713099999999999</cx:pt>
          <cx:pt idx="135">0.39516800000000002</cx:pt>
          <cx:pt idx="136">0.36744199999999999</cx:pt>
          <cx:pt idx="137">0.35557899999999998</cx:pt>
          <cx:pt idx="138">0.34843200000000002</cx:pt>
          <cx:pt idx="139">0.345999</cx:pt>
          <cx:pt idx="140">0.31903700000000002</cx:pt>
          <cx:pt idx="141">0.29617700000000002</cx:pt>
          <cx:pt idx="142">0.344582</cx:pt>
          <cx:pt idx="143">0.25699300000000003</cx:pt>
          <cx:pt idx="144">0.32250299999999998</cx:pt>
          <cx:pt idx="145">0.34612300000000001</cx:pt>
          <cx:pt idx="146">0.34296599999999999</cx:pt>
          <cx:pt idx="147">0.27968799999999999</cx:pt>
          <cx:pt idx="148">0.34714200000000001</cx:pt>
          <cx:pt idx="149">0.36773400000000001</cx:pt>
          <cx:pt idx="150">0.31730799999999998</cx:pt>
          <cx:pt idx="151">0.33548499999999998</cx:pt>
          <cx:pt idx="152">0.34089000000000003</cx:pt>
          <cx:pt idx="153">0.33832000000000001</cx:pt>
          <cx:pt idx="154">0.28881800000000002</cx:pt>
          <cx:pt idx="155">0.33429999999999999</cx:pt>
          <cx:pt idx="156">0.36887999999999999</cx:pt>
          <cx:pt idx="157">0.34756799999999999</cx:pt>
          <cx:pt idx="158">0.37906600000000001</cx:pt>
          <cx:pt idx="159">0.34300399999999998</cx:pt>
          <cx:pt idx="160">0.32999299999999998</cx:pt>
          <cx:pt idx="161">0.33191500000000002</cx:pt>
          <cx:pt idx="162">0.34311599999999998</cx:pt>
          <cx:pt idx="163">0.36691400000000002</cx:pt>
          <cx:pt idx="164">0.36391400000000002</cx:pt>
          <cx:pt idx="165">0.34684999999999999</cx:pt>
          <cx:pt idx="166">0.36487799999999998</cx:pt>
          <cx:pt idx="167">0.37168600000000002</cx:pt>
          <cx:pt idx="168">0.35894500000000001</cx:pt>
          <cx:pt idx="169">0.35846</cx:pt>
          <cx:pt idx="170">0.336339</cx:pt>
          <cx:pt idx="171">0.34235199999999999</cx:pt>
          <cx:pt idx="172">0.29157699999999998</cx:pt>
          <cx:pt idx="173">0.37068099999999998</cx:pt>
          <cx:pt idx="174">0.35292699999999999</cx:pt>
          <cx:pt idx="175">0.34574899999999997</cx:pt>
          <cx:pt idx="176">0.33532499999999998</cx:pt>
          <cx:pt idx="177">0.35449199999999997</cx:pt>
          <cx:pt idx="178">0.37703399999999998</cx:pt>
          <cx:pt idx="179">0.35572500000000001</cx:pt>
          <cx:pt idx="180">0.38048399999999999</cx:pt>
          <cx:pt idx="181">0.382162</cx:pt>
          <cx:pt idx="182">0.334866</cx:pt>
          <cx:pt idx="183">0.34716599999999997</cx:pt>
          <cx:pt idx="184">0.35755599999999998</cx:pt>
          <cx:pt idx="185">0.36904199999999998</cx:pt>
          <cx:pt idx="186">0.38400899999999999</cx:pt>
          <cx:pt idx="187">0.32433899999999999</cx:pt>
          <cx:pt idx="188">0.35554599999999997</cx:pt>
          <cx:pt idx="189">0.33534599999999998</cx:pt>
          <cx:pt idx="190">0.35865000000000002</cx:pt>
          <cx:pt idx="191">0.37379200000000001</cx:pt>
          <cx:pt idx="192">0.32905400000000001</cx:pt>
          <cx:pt idx="193">0.34016000000000002</cx:pt>
          <cx:pt idx="194">0.35651300000000002</cx:pt>
          <cx:pt idx="195">0.33048</cx:pt>
          <cx:pt idx="196">0.26236700000000002</cx:pt>
          <cx:pt idx="197">0.367921</cx:pt>
          <cx:pt idx="198">0.340088</cx:pt>
          <cx:pt idx="199">0.35638700000000001</cx:pt>
          <cx:pt idx="200">0.375998</cx:pt>
          <cx:pt idx="201">0.33697899999999997</cx:pt>
          <cx:pt idx="202">0.361203</cx:pt>
          <cx:pt idx="203">0.36805199999999999</cx:pt>
          <cx:pt idx="204">0.360819</cx:pt>
          <cx:pt idx="205">0.32530500000000001</cx:pt>
          <cx:pt idx="206">0.33976499999999998</cx:pt>
          <cx:pt idx="207">0.37803100000000001</cx:pt>
          <cx:pt idx="208">0.34551599999999999</cx:pt>
          <cx:pt idx="209">0.342561</cx:pt>
          <cx:pt idx="210">0.35456700000000002</cx:pt>
          <cx:pt idx="211">0.20735500000000001</cx:pt>
          <cx:pt idx="212">0.403781</cx:pt>
          <cx:pt idx="213">0.36804799999999999</cx:pt>
          <cx:pt idx="214">0.45788899999999999</cx:pt>
          <cx:pt idx="215">0.33232200000000001</cx:pt>
          <cx:pt idx="216">0.29716500000000001</cx:pt>
          <cx:pt idx="217">0.35017199999999998</cx:pt>
          <cx:pt idx="218">0.342503</cx:pt>
          <cx:pt idx="219">0.40400599999999998</cx:pt>
          <cx:pt idx="220">0.33710499999999999</cx:pt>
          <cx:pt idx="221">0.33202900000000002</cx:pt>
          <cx:pt idx="222">0.27518100000000001</cx:pt>
          <cx:pt idx="223">0.36220400000000003</cx:pt>
          <cx:pt idx="224">0.30815199999999998</cx:pt>
          <cx:pt idx="225">0.33701799999999998</cx:pt>
          <cx:pt idx="226">0.340167</cx:pt>
          <cx:pt idx="227">0.36831000000000003</cx:pt>
          <cx:pt idx="228">0.360792</cx:pt>
          <cx:pt idx="229">0.34309699999999999</cx:pt>
          <cx:pt idx="230">0.347279</cx:pt>
          <cx:pt idx="231">0.28109699999999999</cx:pt>
          <cx:pt idx="232">0.34242099999999998</cx:pt>
          <cx:pt idx="233">0.30774200000000002</cx:pt>
          <cx:pt idx="234">0.328648</cx:pt>
          <cx:pt idx="235">0.33936899999999998</cx:pt>
          <cx:pt idx="236">0.36192999999999997</cx:pt>
          <cx:pt idx="237">0.360601</cx:pt>
          <cx:pt idx="238">0.35447099999999998</cx:pt>
          <cx:pt idx="239">0.333841</cx:pt>
          <cx:pt idx="240">0.32839099999999999</cx:pt>
          <cx:pt idx="241">0.40594999999999998</cx:pt>
          <cx:pt idx="242">0.36616300000000002</cx:pt>
          <cx:pt idx="243">0.35972599999999999</cx:pt>
          <cx:pt idx="244">0.38442300000000001</cx:pt>
          <cx:pt idx="245">0.35078999999999999</cx:pt>
          <cx:pt idx="246">0.36068800000000001</cx:pt>
          <cx:pt idx="247">0.35795100000000002</cx:pt>
          <cx:pt idx="248">0.36374699999999999</cx:pt>
          <cx:pt idx="249">0.22071099999999999</cx:pt>
          <cx:pt idx="250">0.36762800000000001</cx:pt>
          <cx:pt idx="251">0.35928500000000002</cx:pt>
          <cx:pt idx="252">0.33907799999999999</cx:pt>
          <cx:pt idx="253">0.239978</cx:pt>
          <cx:pt idx="254">0.34437099999999998</cx:pt>
          <cx:pt idx="255">0.339642</cx:pt>
          <cx:pt idx="256">0.35217900000000002</cx:pt>
          <cx:pt idx="257">0.31101600000000001</cx:pt>
          <cx:pt idx="258">0.22789599999999999</cx:pt>
          <cx:pt idx="259">0.344582</cx:pt>
          <cx:pt idx="260">0.35022399999999998</cx:pt>
          <cx:pt idx="261">0.373303</cx:pt>
          <cx:pt idx="262">0.356771</cx:pt>
          <cx:pt idx="263">0.33860099999999999</cx:pt>
          <cx:pt idx="264">0.36276900000000001</cx:pt>
          <cx:pt idx="265">0.35924800000000001</cx:pt>
          <cx:pt idx="266">0.35015499999999999</cx:pt>
          <cx:pt idx="267">0.35986200000000002</cx:pt>
          <cx:pt idx="268">0.33625500000000003</cx:pt>
          <cx:pt idx="269">0.28067500000000001</cx:pt>
          <cx:pt idx="270">0.38842599999999999</cx:pt>
          <cx:pt idx="271">0.409717</cx:pt>
          <cx:pt idx="272">0.37228699999999998</cx:pt>
          <cx:pt idx="273">0.35248699999999999</cx:pt>
          <cx:pt idx="274">0.36305399999999999</cx:pt>
          <cx:pt idx="275">0.342555</cx:pt>
          <cx:pt idx="276">0.37782100000000002</cx:pt>
          <cx:pt idx="277">0.34544900000000001</cx:pt>
          <cx:pt idx="278">0.329264</cx:pt>
          <cx:pt idx="279">0.33432600000000001</cx:pt>
          <cx:pt idx="280">0.32675599999999999</cx:pt>
          <cx:pt idx="281">0.37096899999999999</cx:pt>
          <cx:pt idx="282">0.33570100000000003</cx:pt>
          <cx:pt idx="283">0.33983600000000003</cx:pt>
          <cx:pt idx="284">0.353244</cx:pt>
          <cx:pt idx="285">0.355238</cx:pt>
          <cx:pt idx="286">0.40672599999999998</cx:pt>
          <cx:pt idx="287">0.33174199999999998</cx:pt>
          <cx:pt idx="288">0.32273000000000002</cx:pt>
          <cx:pt idx="289">0.34896300000000002</cx:pt>
          <cx:pt idx="290">0.233067</cx:pt>
          <cx:pt idx="291">0.31263999999999997</cx:pt>
          <cx:pt idx="292">0.34804800000000002</cx:pt>
          <cx:pt idx="293">0.36347200000000002</cx:pt>
          <cx:pt idx="294">0.26219900000000002</cx:pt>
          <cx:pt idx="295">0.38917600000000002</cx:pt>
          <cx:pt idx="296">0.35165999999999997</cx:pt>
          <cx:pt idx="297">0.349964</cx:pt>
          <cx:pt idx="298">0.34494799999999998</cx:pt>
          <cx:pt idx="299">0.33464300000000002</cx:pt>
          <cx:pt idx="300">0.37193999999999999</cx:pt>
          <cx:pt idx="301">0.39286599999999999</cx:pt>
          <cx:pt idx="302">0.33923799999999998</cx:pt>
          <cx:pt idx="303">0.33325900000000003</cx:pt>
          <cx:pt idx="304">0.35110599999999997</cx:pt>
          <cx:pt idx="305">0.34453299999999998</cx:pt>
          <cx:pt idx="306">0.40287800000000001</cx:pt>
          <cx:pt idx="307">0.317496</cx:pt>
          <cx:pt idx="308">0.32153300000000001</cx:pt>
          <cx:pt idx="309">0.34242800000000001</cx:pt>
          <cx:pt idx="310">0.36303299999999999</cx:pt>
          <cx:pt idx="311">0.346831</cx:pt>
          <cx:pt idx="312">0.37998100000000001</cx:pt>
          <cx:pt idx="313">0.36632700000000001</cx:pt>
          <cx:pt idx="314">0.37229200000000001</cx:pt>
          <cx:pt idx="315">0.36402699999999999</cx:pt>
          <cx:pt idx="316">0.34058100000000002</cx:pt>
          <cx:pt idx="317">0.34027000000000002</cx:pt>
          <cx:pt idx="318">0.37889299999999998</cx:pt>
          <cx:pt idx="319">0.36326000000000003</cx:pt>
          <cx:pt idx="320">0.353155</cx:pt>
          <cx:pt idx="321">0.34988799999999998</cx:pt>
          <cx:pt idx="322">0.371313</cx:pt>
          <cx:pt idx="323">0.330036</cx:pt>
          <cx:pt idx="324">0.30973899999999999</cx:pt>
          <cx:pt idx="325">0.368087</cx:pt>
          <cx:pt idx="326">0.35326000000000002</cx:pt>
          <cx:pt idx="327">0.32997399999999999</cx:pt>
          <cx:pt idx="328">0.343109</cx:pt>
          <cx:pt idx="329">0.39595399999999997</cx:pt>
          <cx:pt idx="330">0.353385</cx:pt>
          <cx:pt idx="331">0.36348599999999998</cx:pt>
          <cx:pt idx="332">0.34461900000000001</cx:pt>
          <cx:pt idx="333">0.34982200000000002</cx:pt>
          <cx:pt idx="334">0.32936500000000002</cx:pt>
          <cx:pt idx="335">0.34434300000000001</cx:pt>
          <cx:pt idx="336">0.34692099999999998</cx:pt>
          <cx:pt idx="337">0.35042899999999999</cx:pt>
          <cx:pt idx="338">0.35403800000000002</cx:pt>
          <cx:pt idx="339">0.34561900000000001</cx:pt>
          <cx:pt idx="340">0.34292899999999998</cx:pt>
          <cx:pt idx="341">0.35821599999999998</cx:pt>
          <cx:pt idx="342">0.31970100000000001</cx:pt>
          <cx:pt idx="343">0.33561000000000002</cx:pt>
          <cx:pt idx="344">0.34458699999999998</cx:pt>
          <cx:pt idx="345">0.338507</cx:pt>
          <cx:pt idx="346">0.34137800000000001</cx:pt>
          <cx:pt idx="347">0.35666599999999998</cx:pt>
          <cx:pt idx="348">0.38753300000000002</cx:pt>
          <cx:pt idx="349">0.33096199999999998</cx:pt>
          <cx:pt idx="350">0.36064299999999999</cx:pt>
          <cx:pt idx="351">0.34609000000000001</cx:pt>
          <cx:pt idx="352">0.34220099999999998</cx:pt>
          <cx:pt idx="353">0.39110400000000001</cx:pt>
          <cx:pt idx="354">0.33971099999999999</cx:pt>
          <cx:pt idx="355">0.373809</cx:pt>
          <cx:pt idx="356">0.34538099999999999</cx:pt>
          <cx:pt idx="357">0.32156299999999999</cx:pt>
          <cx:pt idx="358">0.34336299999999997</cx:pt>
          <cx:pt idx="359">0.35774699999999998</cx:pt>
          <cx:pt idx="360">0.338339</cx:pt>
          <cx:pt idx="361">0.303622</cx:pt>
          <cx:pt idx="362">0.38053700000000001</cx:pt>
          <cx:pt idx="363">0.35056599999999999</cx:pt>
          <cx:pt idx="364">0.34364299999999998</cx:pt>
          <cx:pt idx="365">0.30727700000000002</cx:pt>
          <cx:pt idx="366">0.35234599999999999</cx:pt>
          <cx:pt idx="367">0.36187200000000003</cx:pt>
          <cx:pt idx="368">0.33932200000000001</cx:pt>
          <cx:pt idx="369">0.34293400000000002</cx:pt>
          <cx:pt idx="370">0.34456700000000001</cx:pt>
          <cx:pt idx="371">0.36970700000000001</cx:pt>
          <cx:pt idx="372">0.34844399999999998</cx:pt>
          <cx:pt idx="373">0.29947200000000002</cx:pt>
          <cx:pt idx="374">0.37108099999999999</cx:pt>
          <cx:pt idx="375">0.32686399999999999</cx:pt>
          <cx:pt idx="376">0.33726</cx:pt>
          <cx:pt idx="377">0.34373999999999999</cx:pt>
          <cx:pt idx="378">0.307174</cx:pt>
          <cx:pt idx="379">0.344308</cx:pt>
          <cx:pt idx="380">0.346582</cx:pt>
          <cx:pt idx="381">0.34693000000000002</cx:pt>
          <cx:pt idx="382">0.34329199999999999</cx:pt>
          <cx:pt idx="383">0.338084</cx:pt>
          <cx:pt idx="384">0.28834900000000002</cx:pt>
          <cx:pt idx="385">0.30991999999999997</cx:pt>
          <cx:pt idx="386">0.35728199999999999</cx:pt>
          <cx:pt idx="387">0.33507399999999998</cx:pt>
          <cx:pt idx="388">0.32077099999999997</cx:pt>
          <cx:pt idx="389">0.23693700000000001</cx:pt>
          <cx:pt idx="390">0.33830100000000002</cx:pt>
          <cx:pt idx="391">0.32904299999999997</cx:pt>
          <cx:pt idx="392">0.34060000000000001</cx:pt>
          <cx:pt idx="393">0.34878199999999998</cx:pt>
          <cx:pt idx="394">0.35422399999999998</cx:pt>
          <cx:pt idx="395">0.36085699999999998</cx:pt>
          <cx:pt idx="396">0.22300900000000001</cx:pt>
          <cx:pt idx="397">0.355242</cx:pt>
          <cx:pt idx="398">0.26799299999999998</cx:pt>
          <cx:pt idx="399">0.383044</cx:pt>
          <cx:pt idx="400">0.33208300000000002</cx:pt>
          <cx:pt idx="401">0.34018799999999999</cx:pt>
          <cx:pt idx="402">0.39982000000000001</cx:pt>
          <cx:pt idx="403">0.34797600000000001</cx:pt>
          <cx:pt idx="404">0.35871500000000001</cx:pt>
          <cx:pt idx="405">0.35824499999999998</cx:pt>
          <cx:pt idx="406">0.37042799999999998</cx:pt>
          <cx:pt idx="407">0.349634</cx:pt>
          <cx:pt idx="408">0.33709299999999998</cx:pt>
          <cx:pt idx="409">0.37134899999999998</cx:pt>
          <cx:pt idx="410">0.34293099999999999</cx:pt>
          <cx:pt idx="411">0.31737100000000001</cx:pt>
          <cx:pt idx="412">0.34418599999999999</cx:pt>
          <cx:pt idx="413">0.35058699999999998</cx:pt>
          <cx:pt idx="414">0.24607899999999999</cx:pt>
          <cx:pt idx="415">0.27420699999999998</cx:pt>
          <cx:pt idx="416">0.30050399999999999</cx:pt>
          <cx:pt idx="417">0.347831</cx:pt>
          <cx:pt idx="418">0.32943800000000001</cx:pt>
          <cx:pt idx="419">0.31592500000000001</cx:pt>
          <cx:pt idx="420">0.34196300000000002</cx:pt>
          <cx:pt idx="421">0.33765800000000001</cx:pt>
          <cx:pt idx="422">0.277117</cx:pt>
          <cx:pt idx="423">0.36045300000000002</cx:pt>
          <cx:pt idx="424">0.41197099999999998</cx:pt>
          <cx:pt idx="425">0.35833999999999999</cx:pt>
          <cx:pt idx="426">0.36590299999999998</cx:pt>
          <cx:pt idx="427">0.36361500000000002</cx:pt>
          <cx:pt idx="428">0.37587500000000001</cx:pt>
          <cx:pt idx="429">0.34093699999999999</cx:pt>
          <cx:pt idx="430">0.36082599999999998</cx:pt>
          <cx:pt idx="431">0.36074899999999999</cx:pt>
          <cx:pt idx="432">0.26377200000000001</cx:pt>
          <cx:pt idx="433">0.36614999999999998</cx:pt>
          <cx:pt idx="434">0.35122100000000001</cx:pt>
          <cx:pt idx="435">0.35873899999999997</cx:pt>
          <cx:pt idx="436">0.38778800000000002</cx:pt>
          <cx:pt idx="437">0.33373399999999998</cx:pt>
          <cx:pt idx="438">0.35104099999999999</cx:pt>
          <cx:pt idx="439">0.33970600000000001</cx:pt>
          <cx:pt idx="440">0.29662899999999998</cx:pt>
          <cx:pt idx="441">0.35230600000000001</cx:pt>
          <cx:pt idx="442">0.36722199999999999</cx:pt>
          <cx:pt idx="443">0.372888</cx:pt>
          <cx:pt idx="444">0.34721200000000002</cx:pt>
          <cx:pt idx="445">0.337455</cx:pt>
          <cx:pt idx="446">0.35364499999999999</cx:pt>
          <cx:pt idx="447">0.33638299999999999</cx:pt>
          <cx:pt idx="448">0.33303199999999999</cx:pt>
          <cx:pt idx="449">0.36524099999999998</cx:pt>
          <cx:pt idx="450">0.31650899999999998</cx:pt>
          <cx:pt idx="451">0.358404</cx:pt>
          <cx:pt idx="452">0.32750699999999999</cx:pt>
          <cx:pt idx="453">0.33575700000000003</cx:pt>
          <cx:pt idx="454">0.35363800000000001</cx:pt>
          <cx:pt idx="455">0.372751</cx:pt>
          <cx:pt idx="456">0.324766</cx:pt>
          <cx:pt idx="457">0.365591</cx:pt>
          <cx:pt idx="458">0.33988699999999999</cx:pt>
          <cx:pt idx="459">0.34945199999999998</cx:pt>
          <cx:pt idx="460">0.336511</cx:pt>
          <cx:pt idx="461">0.35116000000000003</cx:pt>
          <cx:pt idx="462">0.34187600000000001</cx:pt>
          <cx:pt idx="463">0.33147300000000002</cx:pt>
          <cx:pt idx="464">0.372444</cx:pt>
          <cx:pt idx="465">0.382718</cx:pt>
          <cx:pt idx="466">0.35257699999999997</cx:pt>
          <cx:pt idx="467">0.34512500000000002</cx:pt>
          <cx:pt idx="468">0.32529400000000003</cx:pt>
          <cx:pt idx="469">0.34473500000000001</cx:pt>
          <cx:pt idx="470">0.37764700000000001</cx:pt>
          <cx:pt idx="471">0.33111099999999999</cx:pt>
          <cx:pt idx="472">0.36728</cx:pt>
          <cx:pt idx="473">0.32814700000000002</cx:pt>
          <cx:pt idx="474">0.34314</cx:pt>
          <cx:pt idx="475">0.381714</cx:pt>
          <cx:pt idx="476">0.29347400000000001</cx:pt>
          <cx:pt idx="477">0.354101</cx:pt>
          <cx:pt idx="478">0.31485000000000002</cx:pt>
          <cx:pt idx="479">0.291238</cx:pt>
          <cx:pt idx="480">0.30455399999999999</cx:pt>
          <cx:pt idx="481">0.33869500000000002</cx:pt>
          <cx:pt idx="482">0.34484799999999999</cx:pt>
          <cx:pt idx="483">0.34218999999999999</cx:pt>
          <cx:pt idx="484">0.33420699999999998</cx:pt>
          <cx:pt idx="485">0.38978000000000002</cx:pt>
          <cx:pt idx="486">0.21154700000000001</cx:pt>
          <cx:pt idx="487">0.33897100000000002</cx:pt>
          <cx:pt idx="488">0.37139299999999997</cx:pt>
          <cx:pt idx="489">0.37957200000000002</cx:pt>
          <cx:pt idx="490">0.37346600000000002</cx:pt>
          <cx:pt idx="491">0.35673500000000002</cx:pt>
          <cx:pt idx="492">0.33991300000000002</cx:pt>
          <cx:pt idx="493">0.30786599999999997</cx:pt>
          <cx:pt idx="494">0.331646</cx:pt>
          <cx:pt idx="495">0.37421599999999999</cx:pt>
          <cx:pt idx="496">0.22151899999999999</cx:pt>
          <cx:pt idx="497">0.377444</cx:pt>
          <cx:pt idx="498">0.39729700000000001</cx:pt>
          <cx:pt idx="499">0.36459399999999997</cx:pt>
          <cx:pt idx="500">0.32951399999999997</cx:pt>
          <cx:pt idx="501">0.31875999999999999</cx:pt>
          <cx:pt idx="502">0.34561999999999998</cx:pt>
          <cx:pt idx="503">0.35032999999999997</cx:pt>
          <cx:pt idx="504">0.33559099999999997</cx:pt>
          <cx:pt idx="505">0.36472399999999999</cx:pt>
          <cx:pt idx="506">0.35506900000000002</cx:pt>
          <cx:pt idx="507">0.32292700000000002</cx:pt>
          <cx:pt idx="508">0.336038</cx:pt>
          <cx:pt idx="509">0.38323600000000002</cx:pt>
          <cx:pt idx="510">0.33929799999999999</cx:pt>
          <cx:pt idx="511">0.36901600000000001</cx:pt>
          <cx:pt idx="512">0.33062200000000003</cx:pt>
          <cx:pt idx="513">0.33714899999999998</cx:pt>
          <cx:pt idx="514">0.327565</cx:pt>
          <cx:pt idx="515">0.35591</cx:pt>
          <cx:pt idx="516">0.36486299999999999</cx:pt>
          <cx:pt idx="517">0.336642</cx:pt>
          <cx:pt idx="518">0.36042099999999999</cx:pt>
          <cx:pt idx="519">0.32864900000000002</cx:pt>
          <cx:pt idx="520">0.32037900000000002</cx:pt>
          <cx:pt idx="521">0.36387700000000001</cx:pt>
          <cx:pt idx="522">0.33391500000000002</cx:pt>
          <cx:pt idx="523">0.41209499999999999</cx:pt>
          <cx:pt idx="524">0.33658500000000002</cx:pt>
          <cx:pt idx="525">0.363454</cx:pt>
          <cx:pt idx="526">0.23462</cx:pt>
          <cx:pt idx="527">0.36674400000000001</cx:pt>
          <cx:pt idx="528">0.35080099999999997</cx:pt>
          <cx:pt idx="529">0.274696</cx:pt>
          <cx:pt idx="530">0.32737100000000002</cx:pt>
          <cx:pt idx="531">0.31004900000000002</cx:pt>
          <cx:pt idx="532">0.35803099999999999</cx:pt>
          <cx:pt idx="533">0.31538500000000003</cx:pt>
          <cx:pt idx="534">0.39061800000000002</cx:pt>
          <cx:pt idx="535">0.37510199999999999</cx:pt>
          <cx:pt idx="536">0.37379600000000002</cx:pt>
          <cx:pt idx="537">0.37288500000000002</cx:pt>
          <cx:pt idx="538">0.33186199999999999</cx:pt>
          <cx:pt idx="539">0.337866</cx:pt>
          <cx:pt idx="540">0.36746699999999999</cx:pt>
          <cx:pt idx="541">0.35786200000000001</cx:pt>
          <cx:pt idx="542">0.33940300000000001</cx:pt>
          <cx:pt idx="543">0.34179300000000001</cx:pt>
          <cx:pt idx="544">0.31040800000000002</cx:pt>
          <cx:pt idx="545">0.325826</cx:pt>
          <cx:pt idx="546">0.33082099999999998</cx:pt>
          <cx:pt idx="547">0.339615</cx:pt>
          <cx:pt idx="548">0.39152399999999998</cx:pt>
          <cx:pt idx="549">0.33491399999999999</cx:pt>
          <cx:pt idx="550">0.35762500000000003</cx:pt>
          <cx:pt idx="551">0.35156100000000001</cx:pt>
          <cx:pt idx="552">0.34184199999999998</cx:pt>
          <cx:pt idx="553">0.371805</cx:pt>
          <cx:pt idx="554">0.33828399999999997</cx:pt>
          <cx:pt idx="555">0.36177799999999999</cx:pt>
          <cx:pt idx="556">0.38528499999999999</cx:pt>
          <cx:pt idx="557">0.34228900000000001</cx:pt>
          <cx:pt idx="558">0.31903199999999998</cx:pt>
          <cx:pt idx="559">0.35104800000000003</cx:pt>
          <cx:pt idx="560">0.34448200000000001</cx:pt>
          <cx:pt idx="561">0.33293400000000001</cx:pt>
          <cx:pt idx="562">0.38530300000000001</cx:pt>
          <cx:pt idx="563">0.36468499999999998</cx:pt>
          <cx:pt idx="564">0.337094</cx:pt>
          <cx:pt idx="565">0.35319499999999998</cx:pt>
          <cx:pt idx="566">0.20463999999999999</cx:pt>
          <cx:pt idx="567">0.411771</cx:pt>
          <cx:pt idx="568">0.22642699999999999</cx:pt>
          <cx:pt idx="569">0.33502700000000002</cx:pt>
          <cx:pt idx="570">0.34873199999999999</cx:pt>
          <cx:pt idx="571">0.33278799999999997</cx:pt>
          <cx:pt idx="572">0.35582399999999997</cx:pt>
          <cx:pt idx="573">0.35622300000000001</cx:pt>
          <cx:pt idx="574">0.35928500000000002</cx:pt>
          <cx:pt idx="575">0.37626399999999999</cx:pt>
          <cx:pt idx="576">0.33796999999999999</cx:pt>
          <cx:pt idx="577">0.34481600000000001</cx:pt>
          <cx:pt idx="578">0.35003499999999999</cx:pt>
          <cx:pt idx="579">0.36115999999999998</cx:pt>
          <cx:pt idx="580">0.358763</cx:pt>
          <cx:pt idx="581">0.22319</cx:pt>
          <cx:pt idx="582">0.34044000000000002</cx:pt>
          <cx:pt idx="583">0.32163599999999998</cx:pt>
          <cx:pt idx="584">0.36815599999999998</cx:pt>
          <cx:pt idx="585">0.34709800000000002</cx:pt>
          <cx:pt idx="586">0.26140400000000003</cx:pt>
          <cx:pt idx="587">0.32491399999999998</cx:pt>
          <cx:pt idx="588">0.33557399999999998</cx:pt>
          <cx:pt idx="589">0.37126100000000001</cx:pt>
          <cx:pt idx="590">0.21268400000000001</cx:pt>
          <cx:pt idx="591">0.38600299999999999</cx:pt>
          <cx:pt idx="592">0.33241999999999999</cx:pt>
          <cx:pt idx="593">0.24332400000000001</cx:pt>
          <cx:pt idx="594">0.33534199999999997</cx:pt>
          <cx:pt idx="595">0.359014</cx:pt>
          <cx:pt idx="596">0.36048599999999997</cx:pt>
          <cx:pt idx="597">0.35162900000000002</cx:pt>
          <cx:pt idx="598">0.39272899999999999</cx:pt>
          <cx:pt idx="599">0.356049</cx:pt>
          <cx:pt idx="600">0.34789199999999998</cx:pt>
          <cx:pt idx="601">0.36942199999999997</cx:pt>
          <cx:pt idx="602">0.33954299999999998</cx:pt>
          <cx:pt idx="603">0.36363899999999999</cx:pt>
          <cx:pt idx="604">0.34367900000000001</cx:pt>
          <cx:pt idx="605">0.36684499999999998</cx:pt>
          <cx:pt idx="606">0.33335900000000002</cx:pt>
          <cx:pt idx="607">0.35181200000000001</cx:pt>
          <cx:pt idx="608">0.32011899999999999</cx:pt>
          <cx:pt idx="609">0.39370100000000002</cx:pt>
          <cx:pt idx="610">0.34504600000000002</cx:pt>
          <cx:pt idx="611">0.35117599999999999</cx:pt>
          <cx:pt idx="612">0.37264900000000001</cx:pt>
          <cx:pt idx="613">0.40359800000000001</cx:pt>
          <cx:pt idx="614">0.35652299999999998</cx:pt>
          <cx:pt idx="615">0.33621800000000002</cx:pt>
          <cx:pt idx="616">0.24554200000000001</cx:pt>
          <cx:pt idx="617">0.353018</cx:pt>
          <cx:pt idx="618">0.37299700000000002</cx:pt>
          <cx:pt idx="619">0.37428600000000001</cx:pt>
          <cx:pt idx="620">0.32811000000000001</cx:pt>
          <cx:pt idx="621">0.217033</cx:pt>
          <cx:pt idx="622">0.31931500000000002</cx:pt>
          <cx:pt idx="623">0.250585</cx:pt>
          <cx:pt idx="624">0.36228300000000002</cx:pt>
          <cx:pt idx="625">0.35494900000000001</cx:pt>
          <cx:pt idx="626">0.34946500000000003</cx:pt>
          <cx:pt idx="627">0.35423300000000002</cx:pt>
          <cx:pt idx="628">0.35432799999999998</cx:pt>
          <cx:pt idx="629">0.34480300000000003</cx:pt>
          <cx:pt idx="630">0.35665599999999997</cx:pt>
          <cx:pt idx="631">0.37248300000000001</cx:pt>
          <cx:pt idx="632">0.34112300000000001</cx:pt>
          <cx:pt idx="633">0.26868399999999998</cx:pt>
          <cx:pt idx="634">0.33525300000000002</cx:pt>
          <cx:pt idx="635">0.36000599999999999</cx:pt>
          <cx:pt idx="636">0.37966800000000001</cx:pt>
          <cx:pt idx="637">0.37019099999999999</cx:pt>
          <cx:pt idx="638">0.325627</cx:pt>
          <cx:pt idx="639">0.31010700000000002</cx:pt>
          <cx:pt idx="640">0.25833299999999998</cx:pt>
          <cx:pt idx="641">0.36622199999999999</cx:pt>
          <cx:pt idx="642">0.37180600000000003</cx:pt>
          <cx:pt idx="643">0.33399800000000002</cx:pt>
          <cx:pt idx="644">0.39207199999999998</cx:pt>
          <cx:pt idx="645">0.34549299999999999</cx:pt>
          <cx:pt idx="646">0.32197100000000001</cx:pt>
          <cx:pt idx="647">0.38718599999999997</cx:pt>
          <cx:pt idx="648">0.36348000000000003</cx:pt>
          <cx:pt idx="649">0.350659</cx:pt>
          <cx:pt idx="650">0.31953999999999999</cx:pt>
          <cx:pt idx="651">0.38238100000000003</cx:pt>
          <cx:pt idx="652">0.33792899999999998</cx:pt>
          <cx:pt idx="653">0.33064199999999999</cx:pt>
          <cx:pt idx="654">0.34423300000000001</cx:pt>
          <cx:pt idx="655">0.32886900000000002</cx:pt>
          <cx:pt idx="656">0.34364499999999998</cx:pt>
          <cx:pt idx="657">0.248393</cx:pt>
          <cx:pt idx="658">0.36086600000000002</cx:pt>
          <cx:pt idx="659">0.35688300000000001</cx:pt>
          <cx:pt idx="660">0.44417499999999999</cx:pt>
          <cx:pt idx="661">0.23410600000000001</cx:pt>
          <cx:pt idx="662">0.35852099999999998</cx:pt>
          <cx:pt idx="663">0.35211900000000002</cx:pt>
          <cx:pt idx="664">0.26118799999999998</cx:pt>
          <cx:pt idx="665">0.30615999999999999</cx:pt>
          <cx:pt idx="666">0.36932900000000002</cx:pt>
          <cx:pt idx="667">0.33827800000000002</cx:pt>
          <cx:pt idx="668">0.34587699999999999</cx:pt>
          <cx:pt idx="669">0.22716500000000001</cx:pt>
          <cx:pt idx="670">0.36971799999999999</cx:pt>
          <cx:pt idx="671">0.36254999999999998</cx:pt>
          <cx:pt idx="672">0.33798699999999998</cx:pt>
          <cx:pt idx="673">0.34179300000000001</cx:pt>
          <cx:pt idx="674">0.30342000000000002</cx:pt>
          <cx:pt idx="675">0.345947</cx:pt>
          <cx:pt idx="676">0.37728099999999998</cx:pt>
          <cx:pt idx="677">0.33141700000000002</cx:pt>
          <cx:pt idx="678">0.380023</cx:pt>
          <cx:pt idx="679">0.34073599999999998</cx:pt>
          <cx:pt idx="680">0.38412499999999999</cx:pt>
          <cx:pt idx="681">0.381079</cx:pt>
          <cx:pt idx="682">0.41044399999999998</cx:pt>
          <cx:pt idx="683">0.28356399999999998</cx:pt>
          <cx:pt idx="684">0.36855700000000002</cx:pt>
          <cx:pt idx="685">0.309201</cx:pt>
          <cx:pt idx="686">0.29687799999999998</cx:pt>
          <cx:pt idx="687">0.377639</cx:pt>
          <cx:pt idx="688">0.33399400000000001</cx:pt>
          <cx:pt idx="689">0.33741599999999999</cx:pt>
          <cx:pt idx="690">0.36175299999999999</cx:pt>
          <cx:pt idx="691">0.364981</cx:pt>
          <cx:pt idx="692">0.29698000000000002</cx:pt>
          <cx:pt idx="693">0.408831</cx:pt>
          <cx:pt idx="694">0.34769299999999997</cx:pt>
          <cx:pt idx="695">0.238396</cx:pt>
          <cx:pt idx="696">0.33812599999999998</cx:pt>
          <cx:pt idx="697">0.20622499999999999</cx:pt>
          <cx:pt idx="698">0.36225600000000002</cx:pt>
          <cx:pt idx="699">0.34528999999999999</cx:pt>
          <cx:pt idx="700">0.35183599999999998</cx:pt>
          <cx:pt idx="701">0.35581200000000002</cx:pt>
          <cx:pt idx="702">0.30527700000000002</cx:pt>
          <cx:pt idx="703">0.35520200000000002</cx:pt>
          <cx:pt idx="704">0.344995</cx:pt>
          <cx:pt idx="705">0.327704</cx:pt>
          <cx:pt idx="706">0.36385800000000001</cx:pt>
          <cx:pt idx="707">0.33776499999999998</cx:pt>
          <cx:pt idx="708">0.36673600000000001</cx:pt>
          <cx:pt idx="709">0.36055100000000001</cx:pt>
          <cx:pt idx="710">0.33141300000000001</cx:pt>
          <cx:pt idx="711">0.36326999999999998</cx:pt>
          <cx:pt idx="712">0.26660899999999998</cx:pt>
          <cx:pt idx="713">0.336059</cx:pt>
          <cx:pt idx="714">0.33770299999999998</cx:pt>
          <cx:pt idx="715">0.36189900000000003</cx:pt>
          <cx:pt idx="716">0.366927</cx:pt>
          <cx:pt idx="717">0.397762</cx:pt>
          <cx:pt idx="718">0.28310999999999997</cx:pt>
          <cx:pt idx="719">0.30702800000000002</cx:pt>
          <cx:pt idx="720">0.33118700000000001</cx:pt>
          <cx:pt idx="721">0.34254800000000002</cx:pt>
          <cx:pt idx="722">0.35988100000000001</cx:pt>
          <cx:pt idx="723">0.34177999999999997</cx:pt>
          <cx:pt idx="724">0.35422300000000001</cx:pt>
          <cx:pt idx="725">0.40702300000000002</cx:pt>
          <cx:pt idx="726">0.326546</cx:pt>
          <cx:pt idx="727">0.33710299999999999</cx:pt>
          <cx:pt idx="728">0.30962699999999999</cx:pt>
          <cx:pt idx="729">0.34405999999999998</cx:pt>
          <cx:pt idx="730">0.361122</cx:pt>
          <cx:pt idx="731">0.348194</cx:pt>
          <cx:pt idx="732">0.34106799999999998</cx:pt>
          <cx:pt idx="733">0.22178999999999999</cx:pt>
          <cx:pt idx="734">0.35336600000000001</cx:pt>
          <cx:pt idx="735">0.35453899999999999</cx:pt>
          <cx:pt idx="736">0.31637799999999999</cx:pt>
          <cx:pt idx="737">0.35260000000000002</cx:pt>
          <cx:pt idx="738">0.35914000000000001</cx:pt>
          <cx:pt idx="739">0.34077099999999999</cx:pt>
          <cx:pt idx="740">0.33295200000000003</cx:pt>
          <cx:pt idx="741">0.37160500000000002</cx:pt>
          <cx:pt idx="742">0.35571000000000003</cx:pt>
          <cx:pt idx="743">0.35936600000000002</cx:pt>
          <cx:pt idx="744">0.35722100000000001</cx:pt>
          <cx:pt idx="745">0.35894100000000001</cx:pt>
          <cx:pt idx="746">0.33363900000000002</cx:pt>
          <cx:pt idx="747">0.36786099999999999</cx:pt>
          <cx:pt idx="748">0.389376</cx:pt>
          <cx:pt idx="749">0.21155099999999999</cx:pt>
          <cx:pt idx="750">0.36416700000000002</cx:pt>
          <cx:pt idx="751">0.33861400000000003</cx:pt>
          <cx:pt idx="752">0.344995</cx:pt>
          <cx:pt idx="753">0.353209</cx:pt>
          <cx:pt idx="754">0.340055</cx:pt>
          <cx:pt idx="755">0.344387</cx:pt>
          <cx:pt idx="756">0.36852699999999999</cx:pt>
          <cx:pt idx="757">0.33577200000000001</cx:pt>
          <cx:pt idx="758">0.31849499999999997</cx:pt>
          <cx:pt idx="759">0.32381300000000002</cx:pt>
          <cx:pt idx="760">0.385519</cx:pt>
          <cx:pt idx="761">0.312253</cx:pt>
          <cx:pt idx="762">0.359267</cx:pt>
          <cx:pt idx="763">0.35255599999999998</cx:pt>
          <cx:pt idx="764">0.352854</cx:pt>
          <cx:pt idx="765">0.334565</cx:pt>
          <cx:pt idx="766">0.33029900000000001</cx:pt>
          <cx:pt idx="767">0.21859000000000001</cx:pt>
          <cx:pt idx="768">0.35256399999999999</cx:pt>
          <cx:pt idx="769">0.330376</cx:pt>
          <cx:pt idx="770">0.37876399999999999</cx:pt>
          <cx:pt idx="771">0.33089099999999999</cx:pt>
          <cx:pt idx="772">0.36745</cx:pt>
          <cx:pt idx="773">0.36042800000000003</cx:pt>
          <cx:pt idx="774">0.33444499999999999</cx:pt>
          <cx:pt idx="775">0.33278000000000002</cx:pt>
          <cx:pt idx="776">0.370058</cx:pt>
          <cx:pt idx="777">0.35284700000000002</cx:pt>
          <cx:pt idx="778">0.38911699999999999</cx:pt>
          <cx:pt idx="779">0.36393799999999998</cx:pt>
          <cx:pt idx="780">0.365699</cx:pt>
          <cx:pt idx="781">0.36874000000000001</cx:pt>
          <cx:pt idx="782">0.35097</cx:pt>
          <cx:pt idx="783">0.33957399999999999</cx:pt>
          <cx:pt idx="784">0.20727599999999999</cx:pt>
          <cx:pt idx="785">0.34123300000000001</cx:pt>
          <cx:pt idx="786">0.33373799999999998</cx:pt>
          <cx:pt idx="787">0.36740699999999998</cx:pt>
          <cx:pt idx="788">0.36090100000000003</cx:pt>
          <cx:pt idx="789">0.34308899999999998</cx:pt>
          <cx:pt idx="790">0.35452699999999998</cx:pt>
          <cx:pt idx="791">0.335345</cx:pt>
          <cx:pt idx="792">0.331204</cx:pt>
          <cx:pt idx="793">0.34120600000000001</cx:pt>
          <cx:pt idx="794">0.349638</cx:pt>
          <cx:pt idx="795">0.29432199999999997</cx:pt>
          <cx:pt idx="796">0.37465199999999999</cx:pt>
          <cx:pt idx="797">0.242454</cx:pt>
          <cx:pt idx="798">0.30802600000000002</cx:pt>
          <cx:pt idx="799">0.365948</cx:pt>
          <cx:pt idx="800">0.33322600000000002</cx:pt>
          <cx:pt idx="801">0.31026399999999998</cx:pt>
          <cx:pt idx="802">0.34932200000000002</cx:pt>
          <cx:pt idx="803">0.33912599999999998</cx:pt>
          <cx:pt idx="804">0.33504099999999998</cx:pt>
          <cx:pt idx="805">0.311114</cx:pt>
          <cx:pt idx="806">0.33270699999999997</cx:pt>
          <cx:pt idx="807">0.34690300000000002</cx:pt>
          <cx:pt idx="808">0.359454</cx:pt>
          <cx:pt idx="809">0.36688399999999999</cx:pt>
          <cx:pt idx="810">0.37182500000000002</cx:pt>
          <cx:pt idx="811">0.34517900000000001</cx:pt>
          <cx:pt idx="812">0.36461199999999999</cx:pt>
          <cx:pt idx="813">0.38414300000000001</cx:pt>
          <cx:pt idx="814">0.352601</cx:pt>
          <cx:pt idx="815">0.34551999999999999</cx:pt>
          <cx:pt idx="816">0.21752099999999999</cx:pt>
          <cx:pt idx="817">0.34221400000000002</cx:pt>
          <cx:pt idx="818">0.34015200000000001</cx:pt>
          <cx:pt idx="819">0.35426400000000002</cx:pt>
          <cx:pt idx="820">0.33715299999999998</cx:pt>
          <cx:pt idx="821">0.313448</cx:pt>
          <cx:pt idx="822">0.36237000000000003</cx:pt>
          <cx:pt idx="823">0.36097699999999999</cx:pt>
          <cx:pt idx="824">0.37046699999999999</cx:pt>
          <cx:pt idx="825">0.35000999999999999</cx:pt>
          <cx:pt idx="826">0.39427499999999999</cx:pt>
          <cx:pt idx="827">0.365504</cx:pt>
          <cx:pt idx="828">0.232492</cx:pt>
          <cx:pt idx="829">0.35758499999999999</cx:pt>
          <cx:pt idx="830">0.36629800000000001</cx:pt>
          <cx:pt idx="831">0.32902700000000001</cx:pt>
          <cx:pt idx="832">0.35864400000000002</cx:pt>
          <cx:pt idx="833">0.33659600000000001</cx:pt>
          <cx:pt idx="834">0.36294700000000002</cx:pt>
          <cx:pt idx="835">0.23862</cx:pt>
          <cx:pt idx="836">0.32943</cx:pt>
          <cx:pt idx="837">0.38323000000000002</cx:pt>
          <cx:pt idx="838">0.34556799999999999</cx:pt>
          <cx:pt idx="839">0.35339300000000001</cx:pt>
          <cx:pt idx="840">0.330731</cx:pt>
          <cx:pt idx="841">0.34302500000000002</cx:pt>
          <cx:pt idx="842">0.220418</cx:pt>
          <cx:pt idx="843">0.33901199999999998</cx:pt>
          <cx:pt idx="844">0.34545399999999998</cx:pt>
          <cx:pt idx="845">0.36158499999999999</cx:pt>
          <cx:pt idx="846">0.35902400000000001</cx:pt>
          <cx:pt idx="847">0.21562400000000001</cx:pt>
          <cx:pt idx="848">0.36004000000000003</cx:pt>
          <cx:pt idx="849">0.34091900000000003</cx:pt>
          <cx:pt idx="850">0.35229199999999999</cx:pt>
          <cx:pt idx="851">0.32955400000000001</cx:pt>
          <cx:pt idx="852">0.33429900000000001</cx:pt>
          <cx:pt idx="853">0.34289799999999998</cx:pt>
          <cx:pt idx="854">0.37564199999999998</cx:pt>
          <cx:pt idx="855">0.32058999999999999</cx:pt>
          <cx:pt idx="856">0.35124899999999998</cx:pt>
          <cx:pt idx="857">0.405198</cx:pt>
          <cx:pt idx="858">0.22299099999999999</cx:pt>
          <cx:pt idx="859">0.33122299999999999</cx:pt>
          <cx:pt idx="860">0.29848799999999998</cx:pt>
          <cx:pt idx="861">0.31615399999999999</cx:pt>
          <cx:pt idx="862">0.36825600000000003</cx:pt>
          <cx:pt idx="863">0.41244999999999998</cx:pt>
          <cx:pt idx="864">0.234489</cx:pt>
          <cx:pt idx="865">0.402945</cx:pt>
          <cx:pt idx="866">0.29888500000000001</cx:pt>
          <cx:pt idx="867">0.35190199999999999</cx:pt>
          <cx:pt idx="868">0.34933700000000001</cx:pt>
          <cx:pt idx="869">0.35311999999999999</cx:pt>
          <cx:pt idx="870">0.36937999999999999</cx:pt>
          <cx:pt idx="871">0.35090399999999999</cx:pt>
          <cx:pt idx="872">0.36864799999999998</cx:pt>
          <cx:pt idx="873">0.37112099999999998</cx:pt>
          <cx:pt idx="874">0.34852699999999998</cx:pt>
          <cx:pt idx="875">0.36543799999999999</cx:pt>
          <cx:pt idx="876">0.37098399999999998</cx:pt>
          <cx:pt idx="877">0.37899100000000002</cx:pt>
          <cx:pt idx="878">0.36655700000000002</cx:pt>
          <cx:pt idx="879">0.33812599999999998</cx:pt>
          <cx:pt idx="880">0.36009400000000003</cx:pt>
          <cx:pt idx="881">0.389071</cx:pt>
          <cx:pt idx="882">0.345474</cx:pt>
          <cx:pt idx="883">0.358927</cx:pt>
          <cx:pt idx="884">0.36580400000000002</cx:pt>
          <cx:pt idx="885">0.34596500000000002</cx:pt>
          <cx:pt idx="886">0.34200199999999997</cx:pt>
          <cx:pt idx="887">0.32945799999999997</cx:pt>
          <cx:pt idx="888">0.273285</cx:pt>
          <cx:pt idx="889">0.319826</cx:pt>
          <cx:pt idx="890">0.34437600000000002</cx:pt>
          <cx:pt idx="891">0.292352</cx:pt>
          <cx:pt idx="892">0.30981799999999998</cx:pt>
          <cx:pt idx="893">0.33696399999999999</cx:pt>
          <cx:pt idx="894">0.389351</cx:pt>
          <cx:pt idx="895">0.36509000000000003</cx:pt>
          <cx:pt idx="896">0.274088</cx:pt>
          <cx:pt idx="897">0.35711100000000001</cx:pt>
          <cx:pt idx="898">0.318795</cx:pt>
          <cx:pt idx="899">0.32858100000000001</cx:pt>
          <cx:pt idx="900">0.34514499999999998</cx:pt>
          <cx:pt idx="901">0.27947499999999997</cx:pt>
          <cx:pt idx="902">0.36897999999999997</cx:pt>
          <cx:pt idx="903">0.35186200000000001</cx:pt>
          <cx:pt idx="904">0.35835800000000001</cx:pt>
          <cx:pt idx="905">0.37701200000000001</cx:pt>
          <cx:pt idx="906">0.30596099999999998</cx:pt>
          <cx:pt idx="907">0.33071800000000001</cx:pt>
          <cx:pt idx="908">0.37423299999999998</cx:pt>
          <cx:pt idx="909">0.37250299999999997</cx:pt>
          <cx:pt idx="910">0.35197200000000001</cx:pt>
          <cx:pt idx="911">0.35559499999999999</cx:pt>
          <cx:pt idx="912">0.32993499999999998</cx:pt>
          <cx:pt idx="913">0.40203</cx:pt>
          <cx:pt idx="914">0.37611800000000001</cx:pt>
          <cx:pt idx="915">0.31935599999999997</cx:pt>
          <cx:pt idx="916">0.332789</cx:pt>
          <cx:pt idx="917">0.349601</cx:pt>
          <cx:pt idx="918">0.35378999999999999</cx:pt>
          <cx:pt idx="919">0.35949199999999998</cx:pt>
          <cx:pt idx="920">0.38221300000000002</cx:pt>
          <cx:pt idx="921">0.38260499999999997</cx:pt>
          <cx:pt idx="922">0.37082999999999999</cx:pt>
          <cx:pt idx="923">0.39679199999999998</cx:pt>
          <cx:pt idx="924">0.35616900000000001</cx:pt>
          <cx:pt idx="925">0.343864</cx:pt>
          <cx:pt idx="926">0.34400599999999998</cx:pt>
          <cx:pt idx="927">0.33176699999999998</cx:pt>
          <cx:pt idx="928">0.36299700000000001</cx:pt>
          <cx:pt idx="929">0.353161</cx:pt>
          <cx:pt idx="930">0.294929</cx:pt>
          <cx:pt idx="931">0.36378199999999999</cx:pt>
          <cx:pt idx="932">0.334621</cx:pt>
          <cx:pt idx="933">0.33285300000000001</cx:pt>
          <cx:pt idx="934">0.38272200000000001</cx:pt>
          <cx:pt idx="935">0.36321500000000001</cx:pt>
          <cx:pt idx="936">0.34393299999999999</cx:pt>
          <cx:pt idx="937">0.33995399999999998</cx:pt>
          <cx:pt idx="938">0.35585800000000001</cx:pt>
          <cx:pt idx="939">0.32305699999999998</cx:pt>
          <cx:pt idx="940">0.34212999999999999</cx:pt>
          <cx:pt idx="941">0.385438</cx:pt>
          <cx:pt idx="942">0.32926</cx:pt>
          <cx:pt idx="943">0.36591099999999999</cx:pt>
          <cx:pt idx="944">0.336648</cx:pt>
          <cx:pt idx="945">0.39055099999999998</cx:pt>
          <cx:pt idx="946">0.34537699999999999</cx:pt>
          <cx:pt idx="947">0.334256</cx:pt>
          <cx:pt idx="948">0.33218700000000001</cx:pt>
          <cx:pt idx="949">0.33700000000000002</cx:pt>
          <cx:pt idx="950">0.33100499999999999</cx:pt>
          <cx:pt idx="951">0.36910300000000001</cx:pt>
          <cx:pt idx="952">0.35814800000000002</cx:pt>
          <cx:pt idx="953">0.38189499999999998</cx:pt>
          <cx:pt idx="954">0.36446600000000001</cx:pt>
          <cx:pt idx="955">0.35408200000000001</cx:pt>
          <cx:pt idx="956">0.35323199999999999</cx:pt>
          <cx:pt idx="957">0.34385500000000002</cx:pt>
          <cx:pt idx="958">0.33780500000000002</cx:pt>
          <cx:pt idx="959">0.38673200000000002</cx:pt>
          <cx:pt idx="960">0.354767</cx:pt>
          <cx:pt idx="961">0.37126500000000001</cx:pt>
          <cx:pt idx="962">0.35966199999999998</cx:pt>
          <cx:pt idx="963">0.346779</cx:pt>
          <cx:pt idx="964">0.36105799999999999</cx:pt>
          <cx:pt idx="965">0.396065</cx:pt>
          <cx:pt idx="966">0.32960699999999998</cx:pt>
          <cx:pt idx="967">0.293068</cx:pt>
          <cx:pt idx="968">0.33471000000000001</cx:pt>
          <cx:pt idx="969">0.220384</cx:pt>
          <cx:pt idx="970">0.336009</cx:pt>
          <cx:pt idx="971">0.37216700000000003</cx:pt>
          <cx:pt idx="972">0.35372999999999999</cx:pt>
          <cx:pt idx="973">0.27765499999999999</cx:pt>
          <cx:pt idx="974">0.35436800000000002</cx:pt>
          <cx:pt idx="975">0.36812899999999998</cx:pt>
          <cx:pt idx="976">0.34905399999999998</cx:pt>
          <cx:pt idx="977">0.35171400000000003</cx:pt>
          <cx:pt idx="978">0.31962699999999999</cx:pt>
          <cx:pt idx="979">0.29491499999999998</cx:pt>
          <cx:pt idx="980">0.38321</cx:pt>
          <cx:pt idx="981">0.36127999999999999</cx:pt>
          <cx:pt idx="982">0.37193900000000002</cx:pt>
          <cx:pt idx="983">0.38682699999999998</cx:pt>
          <cx:pt idx="984">0.36433700000000002</cx:pt>
          <cx:pt idx="985">0.33102300000000001</cx:pt>
          <cx:pt idx="986">0.36960100000000001</cx:pt>
          <cx:pt idx="987">0.21299399999999999</cx:pt>
          <cx:pt idx="988">0.38162699999999999</cx:pt>
          <cx:pt idx="989">0.30218099999999998</cx:pt>
          <cx:pt idx="990">0.30498399999999998</cx:pt>
          <cx:pt idx="991">0.34701100000000001</cx:pt>
          <cx:pt idx="992">0.35732900000000001</cx:pt>
          <cx:pt idx="993">0.31572699999999998</cx:pt>
          <cx:pt idx="994">0.35644599999999999</cx:pt>
          <cx:pt idx="995">0.38936100000000001</cx:pt>
          <cx:pt idx="996">0.40618799999999999</cx:pt>
          <cx:pt idx="997">0.36423299999999997</cx:pt>
          <cx:pt idx="998">0.378523</cx:pt>
          <cx:pt idx="999">0.350993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sz="20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200" b="0" i="0" u="none" strike="noStrike" baseline="0" dirty="0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C50,acute</a:t>
            </a:r>
            <a:endParaRPr lang="ja-JP" altLang="en-US" sz="1200" b="0" i="0" u="none" strike="noStrike" baseline="0" dirty="0">
              <a:solidFill>
                <a:sysClr val="windowText" lastClr="000000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cx:rich>
      </cx:tx>
    </cx:title>
    <cx:plotArea>
      <cx:plotAreaRegion>
        <cx:series layoutId="clusteredColumn" uniqueId="{C60C5AF1-41ED-4581-8DBF-999FA859A212}">
          <cx:tx>
            <cx:txData>
              <cx:f>'PD acute'!$M$1</cx:f>
              <cx:v>tvIC50p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Count val="15"/>
            </cx:binning>
          </cx:layoutPr>
        </cx:series>
      </cx:plotAreaRegion>
      <cx:axis id="0">
        <cx:catScaling gapWidth="0"/>
        <cx:tickLabels/>
        <cx:numFmt formatCode="#,##0.00_);[赤](#,##0.0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14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PD acute'!$O$2:$O$1001</cx:f>
        <cx:lvl ptCount="1000" formatCode="G/標準">
          <cx:pt idx="0">0.31894699999999998</cx:pt>
          <cx:pt idx="1">0.33228600000000003</cx:pt>
          <cx:pt idx="2">0.32629000000000002</cx:pt>
          <cx:pt idx="3">0.30321100000000001</cx:pt>
          <cx:pt idx="4">0.31879400000000002</cx:pt>
          <cx:pt idx="5">0.30242799999999997</cx:pt>
          <cx:pt idx="6">0.30732999999999999</cx:pt>
          <cx:pt idx="7">0.31558599999999998</cx:pt>
          <cx:pt idx="8">0.33480799999999999</cx:pt>
          <cx:pt idx="9">0.32419700000000001</cx:pt>
          <cx:pt idx="10">0.329843</cx:pt>
          <cx:pt idx="11">0.32436700000000002</cx:pt>
          <cx:pt idx="12">0.31196299999999999</cx:pt>
          <cx:pt idx="13">0.312502</cx:pt>
          <cx:pt idx="14">0.29651899999999998</cx:pt>
          <cx:pt idx="15">0.325239</cx:pt>
          <cx:pt idx="16">0.30905899999999997</cx:pt>
          <cx:pt idx="17">0.29832700000000001</cx:pt>
          <cx:pt idx="18">0.32156400000000002</cx:pt>
          <cx:pt idx="19">0.31226500000000001</cx:pt>
          <cx:pt idx="20">0.31300899999999998</cx:pt>
          <cx:pt idx="21">0.32840000000000003</cx:pt>
          <cx:pt idx="22">0.31128400000000001</cx:pt>
          <cx:pt idx="23">0.31647500000000001</cx:pt>
          <cx:pt idx="24">0.34028000000000003</cx:pt>
          <cx:pt idx="25">0.310027</cx:pt>
          <cx:pt idx="26">0.32244600000000001</cx:pt>
          <cx:pt idx="27">0.30214999999999997</cx:pt>
          <cx:pt idx="28">0.32602100000000001</cx:pt>
          <cx:pt idx="29">0.30507299999999998</cx:pt>
          <cx:pt idx="30">0.31679000000000002</cx:pt>
          <cx:pt idx="31">0.313639</cx:pt>
          <cx:pt idx="32">0.32136500000000001</cx:pt>
          <cx:pt idx="33">0.322521</cx:pt>
          <cx:pt idx="34">0.31208399999999997</cx:pt>
          <cx:pt idx="35">0.31423200000000001</cx:pt>
          <cx:pt idx="36">0.319965</cx:pt>
          <cx:pt idx="37">0.32722099999999998</cx:pt>
          <cx:pt idx="38">0.32822000000000001</cx:pt>
          <cx:pt idx="39">0.32844499999999999</cx:pt>
          <cx:pt idx="40">0.320301</cx:pt>
          <cx:pt idx="41">0.32947900000000002</cx:pt>
          <cx:pt idx="42">0.326428</cx:pt>
          <cx:pt idx="43">0.30283599999999999</cx:pt>
          <cx:pt idx="44">0.30980999999999997</cx:pt>
          <cx:pt idx="45">0.327656</cx:pt>
          <cx:pt idx="46">0.33513199999999999</cx:pt>
          <cx:pt idx="47">0.32229999999999998</cx:pt>
          <cx:pt idx="48">0.32412400000000002</cx:pt>
          <cx:pt idx="49">0.30121599999999998</cx:pt>
          <cx:pt idx="50">0.32278000000000001</cx:pt>
          <cx:pt idx="51">0.32190200000000002</cx:pt>
          <cx:pt idx="52">0.31877699999999998</cx:pt>
          <cx:pt idx="53">0.31151400000000001</cx:pt>
          <cx:pt idx="54">0.319467</cx:pt>
          <cx:pt idx="55">0.31590099999999999</cx:pt>
          <cx:pt idx="56">0.32053399999999999</cx:pt>
          <cx:pt idx="57">0.30892399999999998</cx:pt>
          <cx:pt idx="58">0.31900699999999999</cx:pt>
          <cx:pt idx="59">0.31877299999999997</cx:pt>
          <cx:pt idx="60">0.33654000000000001</cx:pt>
          <cx:pt idx="61">0.33331300000000003</cx:pt>
          <cx:pt idx="62">0.31478800000000001</cx:pt>
          <cx:pt idx="63">0.32627</cx:pt>
          <cx:pt idx="64">0.33456200000000003</cx:pt>
          <cx:pt idx="65">0.31142900000000001</cx:pt>
          <cx:pt idx="66">0.31611800000000001</cx:pt>
          <cx:pt idx="67">0.33115099999999997</cx:pt>
          <cx:pt idx="68">0.31560899999999997</cx:pt>
          <cx:pt idx="69">0.31803700000000001</cx:pt>
          <cx:pt idx="70">0.31626700000000002</cx:pt>
          <cx:pt idx="71">0.33283400000000002</cx:pt>
          <cx:pt idx="72">0.301674</cx:pt>
          <cx:pt idx="73">0.32000600000000001</cx:pt>
          <cx:pt idx="74">0.32390600000000003</cx:pt>
          <cx:pt idx="75">0.31866299999999997</cx:pt>
          <cx:pt idx="76">0.334596</cx:pt>
          <cx:pt idx="77">0.32212600000000002</cx:pt>
          <cx:pt idx="78">0.29280699999999998</cx:pt>
          <cx:pt idx="79">0.329036</cx:pt>
          <cx:pt idx="80">0.31690200000000002</cx:pt>
          <cx:pt idx="81">0.312558</cx:pt>
          <cx:pt idx="82">0.317492</cx:pt>
          <cx:pt idx="83">0.308614</cx:pt>
          <cx:pt idx="84">0.31477300000000003</cx:pt>
          <cx:pt idx="85">0.331513</cx:pt>
          <cx:pt idx="86">0.32572200000000001</cx:pt>
          <cx:pt idx="87">0.31939299999999998</cx:pt>
          <cx:pt idx="88">0.31212099999999998</cx:pt>
          <cx:pt idx="89">0.32322899999999999</cx:pt>
          <cx:pt idx="90">0.32482899999999998</cx:pt>
          <cx:pt idx="91">0.32538699999999998</cx:pt>
          <cx:pt idx="92">0.30857299999999999</cx:pt>
          <cx:pt idx="93">0.31446400000000002</cx:pt>
          <cx:pt idx="94">0.31503399999999998</cx:pt>
          <cx:pt idx="95">0.30015399999999998</cx:pt>
          <cx:pt idx="96">0.30666300000000002</cx:pt>
          <cx:pt idx="97">0.31801200000000002</cx:pt>
          <cx:pt idx="98">0.34330899999999998</cx:pt>
          <cx:pt idx="99">0.32456099999999999</cx:pt>
          <cx:pt idx="100">0.31340499999999999</cx:pt>
          <cx:pt idx="101">0.292404</cx:pt>
          <cx:pt idx="102">0.329845</cx:pt>
          <cx:pt idx="103">0.33137899999999998</cx:pt>
          <cx:pt idx="104">0.31579499999999999</cx:pt>
          <cx:pt idx="105">0.31398500000000001</cx:pt>
          <cx:pt idx="106">0.31170199999999998</cx:pt>
          <cx:pt idx="107">0.31790099999999999</cx:pt>
          <cx:pt idx="108">0.30497400000000002</cx:pt>
          <cx:pt idx="109">0.32266</cx:pt>
          <cx:pt idx="110">0.33091900000000002</cx:pt>
          <cx:pt idx="111">0.31801400000000002</cx:pt>
          <cx:pt idx="112">0.31291600000000003</cx:pt>
          <cx:pt idx="113">0.30646400000000001</cx:pt>
          <cx:pt idx="114">0.323575</cx:pt>
          <cx:pt idx="115">0.33560800000000002</cx:pt>
          <cx:pt idx="116">0.31659599999999999</cx:pt>
          <cx:pt idx="117">0.32885199999999998</cx:pt>
          <cx:pt idx="118">0.30172199999999999</cx:pt>
          <cx:pt idx="119">0.32461400000000001</cx:pt>
          <cx:pt idx="120">0.31661600000000001</cx:pt>
          <cx:pt idx="121">0.30586000000000002</cx:pt>
          <cx:pt idx="122">0.30719800000000003</cx:pt>
          <cx:pt idx="123">0.321322</cx:pt>
          <cx:pt idx="124">0.32063199999999997</cx:pt>
          <cx:pt idx="125">0.32623600000000003</cx:pt>
          <cx:pt idx="126">0.32299</cx:pt>
          <cx:pt idx="127">0.32541500000000001</cx:pt>
          <cx:pt idx="128">0.303867</cx:pt>
          <cx:pt idx="129">0.31729299999999999</cx:pt>
          <cx:pt idx="130">0.30940600000000001</cx:pt>
          <cx:pt idx="131">0.31339899999999998</cx:pt>
          <cx:pt idx="132">0.31186999999999998</cx:pt>
          <cx:pt idx="133">0.31441000000000002</cx:pt>
          <cx:pt idx="134">0.31712000000000001</cx:pt>
          <cx:pt idx="135">0.30882100000000001</cx:pt>
          <cx:pt idx="136">0.31088500000000002</cx:pt>
          <cx:pt idx="137">0.318465</cx:pt>
          <cx:pt idx="138">0.32323800000000003</cx:pt>
          <cx:pt idx="139">0.31769500000000001</cx:pt>
          <cx:pt idx="140">0.31043700000000002</cx:pt>
          <cx:pt idx="141">0.330237</cx:pt>
          <cx:pt idx="142">0.30018400000000001</cx:pt>
          <cx:pt idx="143">0.33692100000000003</cx:pt>
          <cx:pt idx="144">0.30874299999999999</cx:pt>
          <cx:pt idx="145">0.33427699999999999</cx:pt>
          <cx:pt idx="146">0.30495299999999997</cx:pt>
          <cx:pt idx="147">0.33115</cx:pt>
          <cx:pt idx="148">0.29496899999999998</cx:pt>
          <cx:pt idx="149">0.31291200000000002</cx:pt>
          <cx:pt idx="150">0.341775</cx:pt>
          <cx:pt idx="151">0.318469</cx:pt>
          <cx:pt idx="152">0.30963499999999999</cx:pt>
          <cx:pt idx="153">0.29846499999999998</cx:pt>
          <cx:pt idx="154">0.31122100000000003</cx:pt>
          <cx:pt idx="155">0.31762600000000002</cx:pt>
          <cx:pt idx="156">0.326179</cx:pt>
          <cx:pt idx="157">0.30220999999999998</cx:pt>
          <cx:pt idx="158">0.32506000000000002</cx:pt>
          <cx:pt idx="159">0.32277800000000001</cx:pt>
          <cx:pt idx="160">0.30324800000000002</cx:pt>
          <cx:pt idx="161">0.32055600000000001</cx:pt>
          <cx:pt idx="162">0.30659999999999998</cx:pt>
          <cx:pt idx="163">0.33908500000000003</cx:pt>
          <cx:pt idx="164">0.32691900000000002</cx:pt>
          <cx:pt idx="165">0.34250999999999998</cx:pt>
          <cx:pt idx="166">0.32646799999999998</cx:pt>
          <cx:pt idx="167">0.33332099999999998</cx:pt>
          <cx:pt idx="168">0.31125999999999998</cx:pt>
          <cx:pt idx="169">0.31237300000000001</cx:pt>
          <cx:pt idx="170">0.33963100000000002</cx:pt>
          <cx:pt idx="171">0.31861299999999998</cx:pt>
          <cx:pt idx="172">0.33907700000000002</cx:pt>
          <cx:pt idx="173">0.337453</cx:pt>
          <cx:pt idx="174">0.31700299999999998</cx:pt>
          <cx:pt idx="175">0.31459399999999998</cx:pt>
          <cx:pt idx="176">0.31356499999999998</cx:pt>
          <cx:pt idx="177">0.315079</cx:pt>
          <cx:pt idx="178">0.33580700000000002</cx:pt>
          <cx:pt idx="179">0.31797500000000001</cx:pt>
          <cx:pt idx="180">0.32029999999999997</cx:pt>
          <cx:pt idx="181">0.32548199999999999</cx:pt>
          <cx:pt idx="182">0.30240899999999998</cx:pt>
          <cx:pt idx="183">0.31034</cx:pt>
          <cx:pt idx="184">0.32357799999999998</cx:pt>
          <cx:pt idx="185">0.312332</cx:pt>
          <cx:pt idx="186">0.30830099999999999</cx:pt>
          <cx:pt idx="187">0.32834999999999998</cx:pt>
          <cx:pt idx="188">0.33608199999999999</cx:pt>
          <cx:pt idx="189">0.32608999999999999</cx:pt>
          <cx:pt idx="190">0.329955</cx:pt>
          <cx:pt idx="191">0.31039899999999998</cx:pt>
          <cx:pt idx="192">0.31429499999999999</cx:pt>
          <cx:pt idx="193">0.32839200000000002</cx:pt>
          <cx:pt idx="194">0.31765599999999999</cx:pt>
          <cx:pt idx="195">0.30857099999999998</cx:pt>
          <cx:pt idx="196">0.341418</cx:pt>
          <cx:pt idx="197">0.30986200000000003</cx:pt>
          <cx:pt idx="198">0.305232</cx:pt>
          <cx:pt idx="199">0.30655100000000002</cx:pt>
          <cx:pt idx="200">0.32484099999999999</cx:pt>
          <cx:pt idx="201">0.31765700000000002</cx:pt>
          <cx:pt idx="202">0.31593599999999999</cx:pt>
          <cx:pt idx="203">0.32160300000000003</cx:pt>
          <cx:pt idx="204">0.31057299999999999</cx:pt>
          <cx:pt idx="205">0.311614</cx:pt>
          <cx:pt idx="206">0.31295299999999998</cx:pt>
          <cx:pt idx="207">0.32253700000000002</cx:pt>
          <cx:pt idx="208">0.309396</cx:pt>
          <cx:pt idx="209">0.31922200000000001</cx:pt>
          <cx:pt idx="210">0.31062099999999998</cx:pt>
          <cx:pt idx="211">0.33286700000000002</cx:pt>
          <cx:pt idx="212">0.33594099999999999</cx:pt>
          <cx:pt idx="213">0.304641</cx:pt>
          <cx:pt idx="214">0.32249299999999997</cx:pt>
          <cx:pt idx="215">0.299427</cx:pt>
          <cx:pt idx="216">0.33206400000000003</cx:pt>
          <cx:pt idx="217">0.32480100000000001</cx:pt>
          <cx:pt idx="218">0.32889200000000002</cx:pt>
          <cx:pt idx="219">0.30738700000000002</cx:pt>
          <cx:pt idx="220">0.29515000000000002</cx:pt>
          <cx:pt idx="221">0.30341200000000002</cx:pt>
          <cx:pt idx="222">0.32205400000000001</cx:pt>
          <cx:pt idx="223">0.30961499999999997</cx:pt>
          <cx:pt idx="224">0.312859</cx:pt>
          <cx:pt idx="225">0.307448</cx:pt>
          <cx:pt idx="226">0.32118200000000002</cx:pt>
          <cx:pt idx="227">0.32353700000000002</cx:pt>
          <cx:pt idx="228">0.31948300000000002</cx:pt>
          <cx:pt idx="229">0.31109399999999998</cx:pt>
          <cx:pt idx="230">0.32447799999999999</cx:pt>
          <cx:pt idx="231">0.33030199999999998</cx:pt>
          <cx:pt idx="232">0.30792700000000001</cx:pt>
          <cx:pt idx="233">0.34048499999999998</cx:pt>
          <cx:pt idx="234">0.31209700000000001</cx:pt>
          <cx:pt idx="235">0.30979400000000001</cx:pt>
          <cx:pt idx="236">0.342644</cx:pt>
          <cx:pt idx="237">0.316826</cx:pt>
          <cx:pt idx="238">0.33411400000000002</cx:pt>
          <cx:pt idx="239">0.32863599999999998</cx:pt>
          <cx:pt idx="240">0.33040799999999998</cx:pt>
          <cx:pt idx="241">0.31974200000000003</cx:pt>
          <cx:pt idx="242">0.306672</cx:pt>
          <cx:pt idx="243">0.331814</cx:pt>
          <cx:pt idx="244">0.30938500000000002</cx:pt>
          <cx:pt idx="245">0.31411899999999998</cx:pt>
          <cx:pt idx="246">0.33357999999999999</cx:pt>
          <cx:pt idx="247">0.29408200000000001</cx:pt>
          <cx:pt idx="248">0.30785000000000001</cx:pt>
          <cx:pt idx="249">0.328013</cx:pt>
          <cx:pt idx="250">0.31161699999999998</cx:pt>
          <cx:pt idx="251">0.316965</cx:pt>
          <cx:pt idx="252">0.30290800000000001</cx:pt>
          <cx:pt idx="253">0.31625900000000001</cx:pt>
          <cx:pt idx="254">0.32877299999999998</cx:pt>
          <cx:pt idx="255">0.316639</cx:pt>
          <cx:pt idx="256">0.31562600000000002</cx:pt>
          <cx:pt idx="257">0.32061099999999998</cx:pt>
          <cx:pt idx="258">0.31280799999999997</cx:pt>
          <cx:pt idx="259">0.31430900000000001</cx:pt>
          <cx:pt idx="260">0.31170900000000001</cx:pt>
          <cx:pt idx="261">0.32461200000000001</cx:pt>
          <cx:pt idx="262">0.31182399999999999</cx:pt>
          <cx:pt idx="263">0.32369999999999999</cx:pt>
          <cx:pt idx="264">0.31946200000000002</cx:pt>
          <cx:pt idx="265">0.31856299999999999</cx:pt>
          <cx:pt idx="266">0.30991800000000003</cx:pt>
          <cx:pt idx="267">0.29671799999999998</cx:pt>
          <cx:pt idx="268">0.32114399999999999</cx:pt>
          <cx:pt idx="269">0.32936399999999999</cx:pt>
          <cx:pt idx="270">0.32356800000000002</cx:pt>
          <cx:pt idx="271">0.31468699999999999</cx:pt>
          <cx:pt idx="272">0.32740599999999997</cx:pt>
          <cx:pt idx="273">0.32700600000000002</cx:pt>
          <cx:pt idx="274">0.32134099999999999</cx:pt>
          <cx:pt idx="275">0.333482</cx:pt>
          <cx:pt idx="276">0.31238700000000003</cx:pt>
          <cx:pt idx="277">0.32666200000000001</cx:pt>
          <cx:pt idx="278">0.31410900000000003</cx:pt>
          <cx:pt idx="279">0.31219400000000003</cx:pt>
          <cx:pt idx="280">0.31806400000000001</cx:pt>
          <cx:pt idx="281">0.32695800000000003</cx:pt>
          <cx:pt idx="282">0.32534200000000002</cx:pt>
          <cx:pt idx="283">0.30269099999999999</cx:pt>
          <cx:pt idx="284">0.32884799999999997</cx:pt>
          <cx:pt idx="285">0.31608999999999998</cx:pt>
          <cx:pt idx="286">0.31540800000000002</cx:pt>
          <cx:pt idx="287">0.30874400000000002</cx:pt>
          <cx:pt idx="288">0.31752000000000002</cx:pt>
          <cx:pt idx="289">0.31957999999999998</cx:pt>
          <cx:pt idx="290">0.31495099999999998</cx:pt>
          <cx:pt idx="291">0.33857199999999998</cx:pt>
          <cx:pt idx="292">0.31109799999999999</cx:pt>
          <cx:pt idx="293">0.30631700000000001</cx:pt>
          <cx:pt idx="294">0.356236</cx:pt>
          <cx:pt idx="295">0.32701200000000002</cx:pt>
          <cx:pt idx="296">0.32059700000000002</cx:pt>
          <cx:pt idx="297">0.30401299999999998</cx:pt>
          <cx:pt idx="298">0.31765599999999999</cx:pt>
          <cx:pt idx="299">0.32741199999999998</cx:pt>
          <cx:pt idx="300">0.32348199999999999</cx:pt>
          <cx:pt idx="301">0.33207900000000001</cx:pt>
          <cx:pt idx="302">0.33326499999999998</cx:pt>
          <cx:pt idx="303">0.30684499999999998</cx:pt>
          <cx:pt idx="304">0.31762699999999999</cx:pt>
          <cx:pt idx="305">0.31781700000000002</cx:pt>
          <cx:pt idx="306">0.31428099999999998</cx:pt>
          <cx:pt idx="307">0.32170300000000002</cx:pt>
          <cx:pt idx="308">0.30171900000000001</cx:pt>
          <cx:pt idx="309">0.32278600000000002</cx:pt>
          <cx:pt idx="310">0.31709199999999998</cx:pt>
          <cx:pt idx="311">0.32118999999999998</cx:pt>
          <cx:pt idx="312">0.32451999999999998</cx:pt>
          <cx:pt idx="313">0.31283699999999998</cx:pt>
          <cx:pt idx="314">0.32222699999999999</cx:pt>
          <cx:pt idx="315">0.306118</cx:pt>
          <cx:pt idx="316">0.32134400000000002</cx:pt>
          <cx:pt idx="317">0.31615100000000002</cx:pt>
          <cx:pt idx="318">0.311805</cx:pt>
          <cx:pt idx="319">0.32105499999999998</cx:pt>
          <cx:pt idx="320">0.32095200000000002</cx:pt>
          <cx:pt idx="321">0.31650200000000001</cx:pt>
          <cx:pt idx="322">0.31706400000000001</cx:pt>
          <cx:pt idx="323">0.31746200000000002</cx:pt>
          <cx:pt idx="324">0.32569799999999999</cx:pt>
          <cx:pt idx="325">0.30816399999999999</cx:pt>
          <cx:pt idx="326">0.319992</cx:pt>
          <cx:pt idx="327">0.31385200000000002</cx:pt>
          <cx:pt idx="328">0.31317699999999998</cx:pt>
          <cx:pt idx="329">0.32717499999999999</cx:pt>
          <cx:pt idx="330">0.31240400000000002</cx:pt>
          <cx:pt idx="331">0.32397700000000001</cx:pt>
          <cx:pt idx="332">0.30436000000000002</cx:pt>
          <cx:pt idx="333">0.30595800000000001</cx:pt>
          <cx:pt idx="334">0.28913299999999997</cx:pt>
          <cx:pt idx="335">0.33444400000000002</cx:pt>
          <cx:pt idx="336">0.30843500000000001</cx:pt>
          <cx:pt idx="337">0.29800199999999999</cx:pt>
          <cx:pt idx="338">0.32845600000000003</cx:pt>
          <cx:pt idx="339">0.31779600000000002</cx:pt>
          <cx:pt idx="340">0.33124900000000002</cx:pt>
          <cx:pt idx="341">0.31232799999999999</cx:pt>
          <cx:pt idx="342">0.32511000000000001</cx:pt>
          <cx:pt idx="343">0.338644</cx:pt>
          <cx:pt idx="344">0.32949800000000001</cx:pt>
          <cx:pt idx="345">0.299014</cx:pt>
          <cx:pt idx="346">0.33489999999999998</cx:pt>
          <cx:pt idx="347">0.300819</cx:pt>
          <cx:pt idx="348">0.32117600000000002</cx:pt>
          <cx:pt idx="349">0.31977899999999998</cx:pt>
          <cx:pt idx="350">0.32198300000000002</cx:pt>
          <cx:pt idx="351">0.317411</cx:pt>
          <cx:pt idx="352">0.33021699999999998</cx:pt>
          <cx:pt idx="353">0.30177900000000002</cx:pt>
          <cx:pt idx="354">0.31429800000000002</cx:pt>
          <cx:pt idx="355">0.32242900000000002</cx:pt>
          <cx:pt idx="356">0.32025700000000001</cx:pt>
          <cx:pt idx="357">0.317855</cx:pt>
          <cx:pt idx="358">0.30998500000000001</cx:pt>
          <cx:pt idx="359">0.332758</cx:pt>
          <cx:pt idx="360">0.316388</cx:pt>
          <cx:pt idx="361">0.33707399999999998</cx:pt>
          <cx:pt idx="362">0.32372899999999999</cx:pt>
          <cx:pt idx="363">0.31843399999999999</cx:pt>
          <cx:pt idx="364">0.331899</cx:pt>
          <cx:pt idx="365">0.30604500000000001</cx:pt>
          <cx:pt idx="366">0.32566400000000001</cx:pt>
          <cx:pt idx="367">0.30604500000000001</cx:pt>
          <cx:pt idx="368">0.31742999999999999</cx:pt>
          <cx:pt idx="369">0.32019599999999998</cx:pt>
          <cx:pt idx="370">0.32866099999999998</cx:pt>
          <cx:pt idx="371">0.32861099999999999</cx:pt>
          <cx:pt idx="372">0.30631599999999998</cx:pt>
          <cx:pt idx="373">0.33082800000000001</cx:pt>
          <cx:pt idx="374">0.32477200000000001</cx:pt>
          <cx:pt idx="375">0.31742999999999999</cx:pt>
          <cx:pt idx="376">0.32511600000000002</cx:pt>
          <cx:pt idx="377">0.32665699999999998</cx:pt>
          <cx:pt idx="378">0.32975599999999999</cx:pt>
          <cx:pt idx="379">0.32551400000000003</cx:pt>
          <cx:pt idx="380">0.31798500000000002</cx:pt>
          <cx:pt idx="381">0.31541799999999998</cx:pt>
          <cx:pt idx="382">0.30438700000000002</cx:pt>
          <cx:pt idx="383">0.326936</cx:pt>
          <cx:pt idx="384">0.30060399999999998</cx:pt>
          <cx:pt idx="385">0.31745099999999998</cx:pt>
          <cx:pt idx="386">0.31556000000000001</cx:pt>
          <cx:pt idx="387">0.31132700000000002</cx:pt>
          <cx:pt idx="388">0.303093</cx:pt>
          <cx:pt idx="389">0.33738699999999999</cx:pt>
          <cx:pt idx="390">0.31761099999999998</cx:pt>
          <cx:pt idx="391">0.31591599999999997</cx:pt>
          <cx:pt idx="392">0.339229</cx:pt>
          <cx:pt idx="393">0.30235099999999998</cx:pt>
          <cx:pt idx="394">0.320212</cx:pt>
          <cx:pt idx="395">0.32309300000000002</cx:pt>
          <cx:pt idx="396">0.322378</cx:pt>
          <cx:pt idx="397">0.323795</cx:pt>
          <cx:pt idx="398">0.32846900000000001</cx:pt>
          <cx:pt idx="399">0.328181</cx:pt>
          <cx:pt idx="400">0.309863</cx:pt>
          <cx:pt idx="401">0.32716099999999998</cx:pt>
          <cx:pt idx="402">0.33530300000000002</cx:pt>
          <cx:pt idx="403">0.330814</cx:pt>
          <cx:pt idx="404">0.30700899999999998</cx:pt>
          <cx:pt idx="405">0.29813200000000001</cx:pt>
          <cx:pt idx="406">0.31311800000000001</cx:pt>
          <cx:pt idx="407">0.30876399999999998</cx:pt>
          <cx:pt idx="408">0.300423</cx:pt>
          <cx:pt idx="409">0.31344499999999997</cx:pt>
          <cx:pt idx="410">0.34054800000000002</cx:pt>
          <cx:pt idx="411">0.33977200000000002</cx:pt>
          <cx:pt idx="412">0.31339600000000001</cx:pt>
          <cx:pt idx="413">0.329378</cx:pt>
          <cx:pt idx="414">0.32431399999999999</cx:pt>
          <cx:pt idx="415">0.33030599999999999</cx:pt>
          <cx:pt idx="416">0.30936200000000003</cx:pt>
          <cx:pt idx="417">0.32993699999999998</cx:pt>
          <cx:pt idx="418">0.31437399999999999</cx:pt>
          <cx:pt idx="419">0.32317499999999999</cx:pt>
          <cx:pt idx="420">0.32841799999999999</cx:pt>
          <cx:pt idx="421">0.32650000000000001</cx:pt>
          <cx:pt idx="422">0.34173300000000001</cx:pt>
          <cx:pt idx="423">0.33471800000000002</cx:pt>
          <cx:pt idx="424">0.29912899999999998</cx:pt>
          <cx:pt idx="425">0.309587</cx:pt>
          <cx:pt idx="426">0.326129</cx:pt>
          <cx:pt idx="427">0.29854000000000003</cx:pt>
          <cx:pt idx="428">0.31297199999999997</cx:pt>
          <cx:pt idx="429">0.33415899999999998</cx:pt>
          <cx:pt idx="430">0.32026399999999999</cx:pt>
          <cx:pt idx="431">0.30552800000000002</cx:pt>
          <cx:pt idx="432">0.33191900000000002</cx:pt>
          <cx:pt idx="433">0.329878</cx:pt>
          <cx:pt idx="434">0.30593100000000001</cx:pt>
          <cx:pt idx="435">0.317166</cx:pt>
          <cx:pt idx="436">0.32268200000000002</cx:pt>
          <cx:pt idx="437">0.30707400000000001</cx:pt>
          <cx:pt idx="438">0.32368200000000003</cx:pt>
          <cx:pt idx="439">0.31184699999999999</cx:pt>
          <cx:pt idx="440">0.30458800000000003</cx:pt>
          <cx:pt idx="441">0.31251600000000002</cx:pt>
          <cx:pt idx="442">0.319855</cx:pt>
          <cx:pt idx="443">0.32249699999999998</cx:pt>
          <cx:pt idx="444">0.32489800000000002</cx:pt>
          <cx:pt idx="445">0.31996799999999997</cx:pt>
          <cx:pt idx="446">0.30799900000000002</cx:pt>
          <cx:pt idx="447">0.32816899999999999</cx:pt>
          <cx:pt idx="448">0.31530599999999998</cx:pt>
          <cx:pt idx="449">0.32120300000000002</cx:pt>
          <cx:pt idx="450">0.32375700000000002</cx:pt>
          <cx:pt idx="451">0.31529400000000002</cx:pt>
          <cx:pt idx="452">0.32682600000000001</cx:pt>
          <cx:pt idx="453">0.31559399999999999</cx:pt>
          <cx:pt idx="454">0.32577400000000001</cx:pt>
          <cx:pt idx="455">0.31157699999999999</cx:pt>
          <cx:pt idx="456">0.30682700000000002</cx:pt>
          <cx:pt idx="457">0.31139099999999997</cx:pt>
          <cx:pt idx="458">0.31955</cx:pt>
          <cx:pt idx="459">0.32740999999999998</cx:pt>
          <cx:pt idx="460">0.31679299999999999</cx:pt>
          <cx:pt idx="461">0.32895799999999997</cx:pt>
          <cx:pt idx="462">0.29988500000000001</cx:pt>
          <cx:pt idx="463">0.30214099999999999</cx:pt>
          <cx:pt idx="464">0.31525500000000001</cx:pt>
          <cx:pt idx="465">0.32369199999999998</cx:pt>
          <cx:pt idx="466">0.32528499999999999</cx:pt>
          <cx:pt idx="467">0.31853500000000001</cx:pt>
          <cx:pt idx="468">0.32978600000000002</cx:pt>
          <cx:pt idx="469">0.32562400000000002</cx:pt>
          <cx:pt idx="470">0.30737700000000001</cx:pt>
          <cx:pt idx="471">0.33896900000000002</cx:pt>
          <cx:pt idx="472">0.34182800000000002</cx:pt>
          <cx:pt idx="473">0.31535299999999999</cx:pt>
          <cx:pt idx="474">0.30837700000000001</cx:pt>
          <cx:pt idx="475">0.32985300000000001</cx:pt>
          <cx:pt idx="476">0.32926800000000001</cx:pt>
          <cx:pt idx="477">0.32163599999999998</cx:pt>
          <cx:pt idx="478">0.31153500000000001</cx:pt>
          <cx:pt idx="479">0.32177299999999998</cx:pt>
          <cx:pt idx="480">0.32016699999999998</cx:pt>
          <cx:pt idx="481">0.30800300000000003</cx:pt>
          <cx:pt idx="482">0.31341799999999997</cx:pt>
          <cx:pt idx="483">0.32836500000000002</cx:pt>
          <cx:pt idx="484">0.31438100000000002</cx:pt>
          <cx:pt idx="485">0.31629800000000002</cx:pt>
          <cx:pt idx="486">0.32815100000000003</cx:pt>
          <cx:pt idx="487">0.33108199999999999</cx:pt>
          <cx:pt idx="488">0.32853900000000003</cx:pt>
          <cx:pt idx="489">0.32268799999999997</cx:pt>
          <cx:pt idx="490">0.31209300000000001</cx:pt>
          <cx:pt idx="491">0.333507</cx:pt>
          <cx:pt idx="492">0.30933100000000002</cx:pt>
          <cx:pt idx="493">0.30697400000000002</cx:pt>
          <cx:pt idx="494">0.34018700000000002</cx:pt>
          <cx:pt idx="495">0.31408399999999997</cx:pt>
          <cx:pt idx="496">0.32236599999999999</cx:pt>
          <cx:pt idx="497">0.305809</cx:pt>
          <cx:pt idx="498">0.30466399999999999</cx:pt>
          <cx:pt idx="499">0.32597500000000001</cx:pt>
          <cx:pt idx="500">0.32463599999999998</cx:pt>
          <cx:pt idx="501">0.31560199999999999</cx:pt>
          <cx:pt idx="502">0.308784</cx:pt>
          <cx:pt idx="503">0.33660499999999999</cx:pt>
          <cx:pt idx="504">0.319631</cx:pt>
          <cx:pt idx="505">0.31609399999999999</cx:pt>
          <cx:pt idx="506">0.324959</cx:pt>
          <cx:pt idx="507">0.317023</cx:pt>
          <cx:pt idx="508">0.32868599999999998</cx:pt>
          <cx:pt idx="509">0.32108799999999998</cx:pt>
          <cx:pt idx="510">0.32478699999999999</cx:pt>
          <cx:pt idx="511">0.32382499999999997</cx:pt>
          <cx:pt idx="512">0.29979800000000001</cx:pt>
          <cx:pt idx="513">0.332208</cx:pt>
          <cx:pt idx="514">0.329237</cx:pt>
          <cx:pt idx="515">0.315886</cx:pt>
          <cx:pt idx="516">0.31919599999999998</cx:pt>
          <cx:pt idx="517">0.312913</cx:pt>
          <cx:pt idx="518">0.31826900000000002</cx:pt>
          <cx:pt idx="519">0.30462699999999998</cx:pt>
          <cx:pt idx="520">0.32677299999999998</cx:pt>
          <cx:pt idx="521">0.33092899999999997</cx:pt>
          <cx:pt idx="522">0.31196800000000002</cx:pt>
          <cx:pt idx="523">0.31393199999999999</cx:pt>
          <cx:pt idx="524">0.31389499999999998</cx:pt>
          <cx:pt idx="525">0.318718</cx:pt>
          <cx:pt idx="526">0.31374999999999997</cx:pt>
          <cx:pt idx="527">0.31938800000000001</cx:pt>
          <cx:pt idx="528">0.30500699999999997</cx:pt>
          <cx:pt idx="529">0.31902200000000003</cx:pt>
          <cx:pt idx="530">0.32971800000000001</cx:pt>
          <cx:pt idx="531">0.31978600000000001</cx:pt>
          <cx:pt idx="532">0.33529599999999998</cx:pt>
          <cx:pt idx="533">0.32784999999999997</cx:pt>
          <cx:pt idx="534">0.33665600000000001</cx:pt>
          <cx:pt idx="535">0.32397500000000001</cx:pt>
          <cx:pt idx="536">0.31106499999999998</cx:pt>
          <cx:pt idx="537">0.31060300000000002</cx:pt>
          <cx:pt idx="538">0.31038199999999999</cx:pt>
          <cx:pt idx="539">0.32092599999999999</cx:pt>
          <cx:pt idx="540">0.32730799999999999</cx:pt>
          <cx:pt idx="541">0.31632500000000002</cx:pt>
          <cx:pt idx="542">0.31753399999999998</cx:pt>
          <cx:pt idx="543">0.32774599999999998</cx:pt>
          <cx:pt idx="544">0.32936100000000001</cx:pt>
          <cx:pt idx="545">0.32406800000000002</cx:pt>
          <cx:pt idx="546">0.32563900000000001</cx:pt>
          <cx:pt idx="547">0.33623700000000001</cx:pt>
          <cx:pt idx="548">0.32800800000000002</cx:pt>
          <cx:pt idx="549">0.30235600000000001</cx:pt>
          <cx:pt idx="550">0.32847599999999999</cx:pt>
          <cx:pt idx="551">0.30227900000000002</cx:pt>
          <cx:pt idx="552">0.32596700000000001</cx:pt>
          <cx:pt idx="553">0.31990200000000002</cx:pt>
          <cx:pt idx="554">0.33512199999999998</cx:pt>
          <cx:pt idx="555">0.32209199999999999</cx:pt>
          <cx:pt idx="556">0.322853</cx:pt>
          <cx:pt idx="557">0.33204800000000001</cx:pt>
          <cx:pt idx="558">0.34019300000000002</cx:pt>
          <cx:pt idx="559">0.32559100000000002</cx:pt>
          <cx:pt idx="560">0.312973</cx:pt>
          <cx:pt idx="561">0.309091</cx:pt>
          <cx:pt idx="562">0.32353900000000002</cx:pt>
          <cx:pt idx="563">0.34037000000000001</cx:pt>
          <cx:pt idx="564">0.330702</cx:pt>
          <cx:pt idx="565">0.323208</cx:pt>
          <cx:pt idx="566">0.321517</cx:pt>
          <cx:pt idx="567">0.32107999999999998</cx:pt>
          <cx:pt idx="568">0.32625799999999999</cx:pt>
          <cx:pt idx="569">0.30794899999999997</cx:pt>
          <cx:pt idx="570">0.32897500000000002</cx:pt>
          <cx:pt idx="571">0.329434</cx:pt>
          <cx:pt idx="572">0.32109799999999999</cx:pt>
          <cx:pt idx="573">0.30551499999999998</cx:pt>
          <cx:pt idx="574">0.31967699999999999</cx:pt>
          <cx:pt idx="575">0.31195200000000001</cx:pt>
          <cx:pt idx="576">0.32917800000000003</cx:pt>
          <cx:pt idx="577">0.30757099999999998</cx:pt>
          <cx:pt idx="578">0.32324799999999998</cx:pt>
          <cx:pt idx="579">0.32044299999999998</cx:pt>
          <cx:pt idx="580">0.31091999999999997</cx:pt>
          <cx:pt idx="581">0.32596399999999998</cx:pt>
          <cx:pt idx="582">0.30803599999999998</cx:pt>
          <cx:pt idx="583">0.322438</cx:pt>
          <cx:pt idx="584">0.29511199999999999</cx:pt>
          <cx:pt idx="585">0.30267500000000003</cx:pt>
          <cx:pt idx="586">0.29695500000000002</cx:pt>
          <cx:pt idx="587">0.31647500000000001</cx:pt>
          <cx:pt idx="588">0.32519500000000001</cx:pt>
          <cx:pt idx="589">0.31154799999999999</cx:pt>
          <cx:pt idx="590">0.31401200000000001</cx:pt>
          <cx:pt idx="591">0.30582799999999999</cx:pt>
          <cx:pt idx="592">0.31856400000000001</cx:pt>
          <cx:pt idx="593">0.32941100000000001</cx:pt>
          <cx:pt idx="594">0.30583500000000002</cx:pt>
          <cx:pt idx="595">0.31903300000000001</cx:pt>
          <cx:pt idx="596">0.32718799999999998</cx:pt>
          <cx:pt idx="597">0.32830300000000001</cx:pt>
          <cx:pt idx="598">0.33013599999999999</cx:pt>
          <cx:pt idx="599">0.31715399999999999</cx:pt>
          <cx:pt idx="600">0.313135</cx:pt>
          <cx:pt idx="601">0.32788299999999998</cx:pt>
          <cx:pt idx="602">0.30684099999999997</cx:pt>
          <cx:pt idx="603">0.315023</cx:pt>
          <cx:pt idx="604">0.30556100000000003</cx:pt>
          <cx:pt idx="605">0.31998599999999999</cx:pt>
          <cx:pt idx="606">0.32988299999999998</cx:pt>
          <cx:pt idx="607">0.29833700000000002</cx:pt>
          <cx:pt idx="608">0.31916800000000001</cx:pt>
          <cx:pt idx="609">0.30207699999999998</cx:pt>
          <cx:pt idx="610">0.306589</cx:pt>
          <cx:pt idx="611">0.31884699999999999</cx:pt>
          <cx:pt idx="612">0.30829400000000001</cx:pt>
          <cx:pt idx="613">0.31705800000000001</cx:pt>
          <cx:pt idx="614">0.330764</cx:pt>
          <cx:pt idx="615">0.32006200000000001</cx:pt>
          <cx:pt idx="616">0.324264</cx:pt>
          <cx:pt idx="617">0.31066899999999997</cx:pt>
          <cx:pt idx="618">0.32534200000000002</cx:pt>
          <cx:pt idx="619">0.32929700000000001</cx:pt>
          <cx:pt idx="620">0.31317099999999998</cx:pt>
          <cx:pt idx="621">0.32285399999999997</cx:pt>
          <cx:pt idx="622">0.33391300000000002</cx:pt>
          <cx:pt idx="623">0.32446700000000001</cx:pt>
          <cx:pt idx="624">0.31091600000000003</cx:pt>
          <cx:pt idx="625">0.30683199999999999</cx:pt>
          <cx:pt idx="626">0.33305400000000002</cx:pt>
          <cx:pt idx="627">0.317079</cx:pt>
          <cx:pt idx="628">0.31674799999999997</cx:pt>
          <cx:pt idx="629">0.33388000000000001</cx:pt>
          <cx:pt idx="630">0.314525</cx:pt>
          <cx:pt idx="631">0.322187</cx:pt>
          <cx:pt idx="632">0.30459700000000001</cx:pt>
          <cx:pt idx="633">0.32784600000000003</cx:pt>
          <cx:pt idx="634">0.32791900000000002</cx:pt>
          <cx:pt idx="635">0.31158799999999998</cx:pt>
          <cx:pt idx="636">0.30946099999999999</cx:pt>
          <cx:pt idx="637">0.30816300000000002</cx:pt>
          <cx:pt idx="638">0.30130899999999999</cx:pt>
          <cx:pt idx="639">0.32415899999999997</cx:pt>
          <cx:pt idx="640">0.33466099999999999</cx:pt>
          <cx:pt idx="641">0.32457999999999998</cx:pt>
          <cx:pt idx="642">0.31474299999999999</cx:pt>
          <cx:pt idx="643">0.31645899999999999</cx:pt>
          <cx:pt idx="644">0.32703199999999999</cx:pt>
          <cx:pt idx="645">0.29898999999999998</cx:pt>
          <cx:pt idx="646">0.30788900000000002</cx:pt>
          <cx:pt idx="647">0.30914799999999998</cx:pt>
          <cx:pt idx="648">0.315662</cx:pt>
          <cx:pt idx="649">0.327795</cx:pt>
          <cx:pt idx="650">0.31888899999999998</cx:pt>
          <cx:pt idx="651">0.30546400000000001</cx:pt>
          <cx:pt idx="652">0.33159499999999997</cx:pt>
          <cx:pt idx="653">0.32410899999999998</cx:pt>
          <cx:pt idx="654">0.31494899999999998</cx:pt>
          <cx:pt idx="655">0.296875</cx:pt>
          <cx:pt idx="656">0.30794899999999997</cx:pt>
          <cx:pt idx="657">0.33656199999999997</cx:pt>
          <cx:pt idx="658">0.32181300000000002</cx:pt>
          <cx:pt idx="659">0.32702399999999998</cx:pt>
          <cx:pt idx="660">0.31210199999999999</cx:pt>
          <cx:pt idx="661">0.33045999999999998</cx:pt>
          <cx:pt idx="662">0.32234800000000002</cx:pt>
          <cx:pt idx="663">0.32508599999999999</cx:pt>
          <cx:pt idx="664">0.32180900000000001</cx:pt>
          <cx:pt idx="665">0.32078899999999999</cx:pt>
          <cx:pt idx="666">0.30891400000000002</cx:pt>
          <cx:pt idx="667">0.30505500000000002</cx:pt>
          <cx:pt idx="668">0.29821999999999999</cx:pt>
          <cx:pt idx="669">0.33218500000000001</cx:pt>
          <cx:pt idx="670">0.32140999999999997</cx:pt>
          <cx:pt idx="671">0.32746700000000001</cx:pt>
          <cx:pt idx="672">0.312413</cx:pt>
          <cx:pt idx="673">0.31860100000000002</cx:pt>
          <cx:pt idx="674">0.315359</cx:pt>
          <cx:pt idx="675">0.32781199999999999</cx:pt>
          <cx:pt idx="676">0.32896700000000001</cx:pt>
          <cx:pt idx="677">0.30599900000000002</cx:pt>
          <cx:pt idx="678">0.32265100000000002</cx:pt>
          <cx:pt idx="679">0.31384499999999999</cx:pt>
          <cx:pt idx="680">0.31778699999999999</cx:pt>
          <cx:pt idx="681">0.323739</cx:pt>
          <cx:pt idx="682">0.31347000000000003</cx:pt>
          <cx:pt idx="683">0.32557199999999997</cx:pt>
          <cx:pt idx="684">0.31106099999999998</cx:pt>
          <cx:pt idx="685">0.33848800000000001</cx:pt>
          <cx:pt idx="686">0.31772</cx:pt>
          <cx:pt idx="687">0.32626300000000003</cx:pt>
          <cx:pt idx="688">0.33039299999999999</cx:pt>
          <cx:pt idx="689">0.31102099999999999</cx:pt>
          <cx:pt idx="690">0.33141100000000001</cx:pt>
          <cx:pt idx="691">0.34235500000000002</cx:pt>
          <cx:pt idx="692">0.30481599999999998</cx:pt>
          <cx:pt idx="693">0.32680799999999999</cx:pt>
          <cx:pt idx="694">0.29824800000000001</cx:pt>
          <cx:pt idx="695">0.32058999999999999</cx:pt>
          <cx:pt idx="696">0.30800699999999998</cx:pt>
          <cx:pt idx="697">0.31749100000000002</cx:pt>
          <cx:pt idx="698">0.31951200000000002</cx:pt>
          <cx:pt idx="699">0.32097999999999999</cx:pt>
          <cx:pt idx="700">0.30629400000000001</cx:pt>
          <cx:pt idx="701">0.31818999999999997</cx:pt>
          <cx:pt idx="702">0.309948</cx:pt>
          <cx:pt idx="703">0.32771699999999998</cx:pt>
          <cx:pt idx="704">0.309892</cx:pt>
          <cx:pt idx="705">0.30825200000000003</cx:pt>
          <cx:pt idx="706">0.31771500000000003</cx:pt>
          <cx:pt idx="707">0.31437999999999999</cx:pt>
          <cx:pt idx="708">0.31820500000000002</cx:pt>
          <cx:pt idx="709">0.33871800000000002</cx:pt>
          <cx:pt idx="710">0.32795999999999997</cx:pt>
          <cx:pt idx="711">0.29658200000000001</cx:pt>
          <cx:pt idx="712">0.32913799999999999</cx:pt>
          <cx:pt idx="713">0.33396300000000001</cx:pt>
          <cx:pt idx="714">0.31816299999999997</cx:pt>
          <cx:pt idx="715">0.33307100000000001</cx:pt>
          <cx:pt idx="716">0.331237</cx:pt>
          <cx:pt idx="717">0.32103900000000002</cx:pt>
          <cx:pt idx="718">0.323604</cx:pt>
          <cx:pt idx="719">0.32172699999999999</cx:pt>
          <cx:pt idx="720">0.308166</cx:pt>
          <cx:pt idx="721">0.318631</cx:pt>
          <cx:pt idx="722">0.30526700000000001</cx:pt>
          <cx:pt idx="723">0.311558</cx:pt>
          <cx:pt idx="724">0.31673299999999999</cx:pt>
          <cx:pt idx="725">0.31601600000000002</cx:pt>
          <cx:pt idx="726">0.32409300000000002</cx:pt>
          <cx:pt idx="727">0.30086200000000002</cx:pt>
          <cx:pt idx="728">0.32420199999999999</cx:pt>
          <cx:pt idx="729">0.32021100000000002</cx:pt>
          <cx:pt idx="730">0.31165599999999999</cx:pt>
          <cx:pt idx="731">0.31148399999999998</cx:pt>
          <cx:pt idx="732">0.31402999999999998</cx:pt>
          <cx:pt idx="733">0.326652</cx:pt>
          <cx:pt idx="734">0.32381500000000002</cx:pt>
          <cx:pt idx="735">0.32437199999999999</cx:pt>
          <cx:pt idx="736">0.324214</cx:pt>
          <cx:pt idx="737">0.315467</cx:pt>
          <cx:pt idx="738">0.30914399999999997</cx:pt>
          <cx:pt idx="739">0.309307</cx:pt>
          <cx:pt idx="740">0.30296699999999999</cx:pt>
          <cx:pt idx="741">0.33717999999999998</cx:pt>
          <cx:pt idx="742">0.32592700000000002</cx:pt>
          <cx:pt idx="743">0.31804399999999999</cx:pt>
          <cx:pt idx="744">0.307093</cx:pt>
          <cx:pt idx="745">0.31993300000000002</cx:pt>
          <cx:pt idx="746">0.30928600000000001</cx:pt>
          <cx:pt idx="747">0.29692800000000003</cx:pt>
          <cx:pt idx="748">0.31662400000000002</cx:pt>
          <cx:pt idx="749">0.317799</cx:pt>
          <cx:pt idx="750">0.32385799999999998</cx:pt>
          <cx:pt idx="751">0.32930199999999998</cx:pt>
          <cx:pt idx="752">0.32073400000000002</cx:pt>
          <cx:pt idx="753">0.30041499999999999</cx:pt>
          <cx:pt idx="754">0.30684099999999997</cx:pt>
          <cx:pt idx="755">0.33229300000000001</cx:pt>
          <cx:pt idx="756">0.321463</cx:pt>
          <cx:pt idx="757">0.30275099999999999</cx:pt>
          <cx:pt idx="758">0.33003500000000002</cx:pt>
          <cx:pt idx="759">0.31154500000000002</cx:pt>
          <cx:pt idx="760">0.32488099999999998</cx:pt>
          <cx:pt idx="761">0.32491799999999998</cx:pt>
          <cx:pt idx="762">0.32666400000000001</cx:pt>
          <cx:pt idx="763">0.31583600000000001</cx:pt>
          <cx:pt idx="764">0.32522499999999999</cx:pt>
          <cx:pt idx="765">0.32501999999999998</cx:pt>
          <cx:pt idx="766">0.310948</cx:pt>
          <cx:pt idx="767">0.313222</cx:pt>
          <cx:pt idx="768">0.31791199999999997</cx:pt>
          <cx:pt idx="769">0.351219</cx:pt>
          <cx:pt idx="770">0.32996500000000001</cx:pt>
          <cx:pt idx="771">0.29938799999999999</cx:pt>
          <cx:pt idx="772">0.30397999999999997</cx:pt>
          <cx:pt idx="773">0.32300699999999999</cx:pt>
          <cx:pt idx="774">0.31064599999999998</cx:pt>
          <cx:pt idx="775">0.30885200000000002</cx:pt>
          <cx:pt idx="776">0.31853900000000002</cx:pt>
          <cx:pt idx="777">0.32405600000000001</cx:pt>
          <cx:pt idx="778">0.31154700000000002</cx:pt>
          <cx:pt idx="779">0.31489499999999998</cx:pt>
          <cx:pt idx="780">0.31696999999999997</cx:pt>
          <cx:pt idx="781">0.33838299999999999</cx:pt>
          <cx:pt idx="782">0.29864400000000002</cx:pt>
          <cx:pt idx="783">0.31161</cx:pt>
          <cx:pt idx="784">0.32571600000000001</cx:pt>
          <cx:pt idx="785">0.32179600000000003</cx:pt>
          <cx:pt idx="786">0.31753300000000001</cx:pt>
          <cx:pt idx="787">0.33189400000000002</cx:pt>
          <cx:pt idx="788">0.334621</cx:pt>
          <cx:pt idx="789">0.31964900000000002</cx:pt>
          <cx:pt idx="790">0.32200899999999999</cx:pt>
          <cx:pt idx="791">0.30531000000000003</cx:pt>
          <cx:pt idx="792">0.31688100000000002</cx:pt>
          <cx:pt idx="793">0.35076299999999999</cx:pt>
          <cx:pt idx="794">0.314299</cx:pt>
          <cx:pt idx="795">0.328988</cx:pt>
          <cx:pt idx="796">0.31098100000000001</cx:pt>
          <cx:pt idx="797">0.331316</cx:pt>
          <cx:pt idx="798">0.32173600000000002</cx:pt>
          <cx:pt idx="799">0.32442900000000002</cx:pt>
          <cx:pt idx="800">0.321463</cx:pt>
          <cx:pt idx="801">0.313164</cx:pt>
          <cx:pt idx="802">0.31254700000000002</cx:pt>
          <cx:pt idx="803">0.32742199999999999</cx:pt>
          <cx:pt idx="804">0.31095499999999998</cx:pt>
          <cx:pt idx="805">0.32175999999999999</cx:pt>
          <cx:pt idx="806">0.325382</cx:pt>
          <cx:pt idx="807">0.33316299999999999</cx:pt>
          <cx:pt idx="808">0.32428200000000001</cx:pt>
          <cx:pt idx="809">0.31997399999999998</cx:pt>
          <cx:pt idx="810">0.32902700000000001</cx:pt>
          <cx:pt idx="811">0.305255</cx:pt>
          <cx:pt idx="812">0.323994</cx:pt>
          <cx:pt idx="813">0.30960500000000002</cx:pt>
          <cx:pt idx="814">0.32889299999999999</cx:pt>
          <cx:pt idx="815">0.31931300000000001</cx:pt>
          <cx:pt idx="816">0.31885000000000002</cx:pt>
          <cx:pt idx="817">0.31520799999999999</cx:pt>
          <cx:pt idx="818">0.33601399999999998</cx:pt>
          <cx:pt idx="819">0.32196399999999997</cx:pt>
          <cx:pt idx="820">0.31495800000000002</cx:pt>
          <cx:pt idx="821">0.34145500000000001</cx:pt>
          <cx:pt idx="822">0.30863099999999999</cx:pt>
          <cx:pt idx="823">0.32670900000000003</cx:pt>
          <cx:pt idx="824">0.326353</cx:pt>
          <cx:pt idx="825">0.305089</cx:pt>
          <cx:pt idx="826">0.31875399999999998</cx:pt>
          <cx:pt idx="827">0.30844899999999997</cx:pt>
          <cx:pt idx="828">0.333758</cx:pt>
          <cx:pt idx="829">0.328065</cx:pt>
          <cx:pt idx="830">0.322606</cx:pt>
          <cx:pt idx="831">0.31115700000000002</cx:pt>
          <cx:pt idx="832">0.31363600000000003</cx:pt>
          <cx:pt idx="833">0.30492900000000001</cx:pt>
          <cx:pt idx="834">0.310058</cx:pt>
          <cx:pt idx="835">0.32811699999999999</cx:pt>
          <cx:pt idx="836">0.32648899999999997</cx:pt>
          <cx:pt idx="837">0.32554100000000002</cx:pt>
          <cx:pt idx="838">0.31998599999999999</cx:pt>
          <cx:pt idx="839">0.32369599999999998</cx:pt>
          <cx:pt idx="840">0.31435400000000002</cx:pt>
          <cx:pt idx="841">0.32368400000000003</cx:pt>
          <cx:pt idx="842">0.32304300000000002</cx:pt>
          <cx:pt idx="843">0.31580999999999998</cx:pt>
          <cx:pt idx="844">0.31816699999999998</cx:pt>
          <cx:pt idx="845">0.32295099999999999</cx:pt>
          <cx:pt idx="846">0.32352700000000001</cx:pt>
          <cx:pt idx="847">0.33508700000000002</cx:pt>
          <cx:pt idx="848">0.30911300000000003</cx:pt>
          <cx:pt idx="849">0.310033</cx:pt>
          <cx:pt idx="850">0.31669000000000003</cx:pt>
          <cx:pt idx="851">0.31912800000000002</cx:pt>
          <cx:pt idx="852">0.306255</cx:pt>
          <cx:pt idx="853">0.33528400000000003</cx:pt>
          <cx:pt idx="854">0.32220399999999999</cx:pt>
          <cx:pt idx="855">0.32676500000000003</cx:pt>
          <cx:pt idx="856">0.32904</cx:pt>
          <cx:pt idx="857">0.31445899999999999</cx:pt>
          <cx:pt idx="858">0.316195</cx:pt>
          <cx:pt idx="859">0.31312800000000002</cx:pt>
          <cx:pt idx="860">0.315363</cx:pt>
          <cx:pt idx="861">0.303479</cx:pt>
          <cx:pt idx="862">0.332125</cx:pt>
          <cx:pt idx="863">0.2989</cx:pt>
          <cx:pt idx="864">0.31884499999999999</cx:pt>
          <cx:pt idx="865">0.320218</cx:pt>
          <cx:pt idx="866">0.33511400000000002</cx:pt>
          <cx:pt idx="867">0.30486999999999997</cx:pt>
          <cx:pt idx="868">0.30713099999999999</cx:pt>
          <cx:pt idx="869">0.32028299999999998</cx:pt>
          <cx:pt idx="870">0.31113099999999999</cx:pt>
          <cx:pt idx="871">0.32445499999999999</cx:pt>
          <cx:pt idx="872">0.30334899999999998</cx:pt>
          <cx:pt idx="873">0.33351500000000001</cx:pt>
          <cx:pt idx="874">0.32578000000000001</cx:pt>
          <cx:pt idx="875">0.333345</cx:pt>
          <cx:pt idx="876">0.31781100000000001</cx:pt>
          <cx:pt idx="877">0.31014900000000001</cx:pt>
          <cx:pt idx="878">0.33054600000000001</cx:pt>
          <cx:pt idx="879">0.32162499999999999</cx:pt>
          <cx:pt idx="880">0.31270900000000001</cx:pt>
          <cx:pt idx="881">0.31564199999999998</cx:pt>
          <cx:pt idx="882">0.32822499999999999</cx:pt>
          <cx:pt idx="883">0.30911100000000002</cx:pt>
          <cx:pt idx="884">0.31641799999999998</cx:pt>
          <cx:pt idx="885">0.31906699999999999</cx:pt>
          <cx:pt idx="886">0.31586500000000001</cx:pt>
          <cx:pt idx="887">0.330675</cx:pt>
          <cx:pt idx="888">0.32530199999999998</cx:pt>
          <cx:pt idx="889">0.31189600000000001</cx:pt>
          <cx:pt idx="890">0.32007000000000002</cx:pt>
          <cx:pt idx="891">0.31919599999999998</cx:pt>
          <cx:pt idx="892">0.33419300000000002</cx:pt>
          <cx:pt idx="893">0.30929000000000001</cx:pt>
          <cx:pt idx="894">0.32034000000000001</cx:pt>
          <cx:pt idx="895">0.31476100000000001</cx:pt>
          <cx:pt idx="896">0.32320300000000002</cx:pt>
          <cx:pt idx="897">0.31087999999999999</cx:pt>
          <cx:pt idx="898">0.30763200000000002</cx:pt>
          <cx:pt idx="899">0.32882800000000001</cx:pt>
          <cx:pt idx="900">0.34442800000000001</cx:pt>
          <cx:pt idx="901">0.32303500000000002</cx:pt>
          <cx:pt idx="902">0.32189800000000002</cx:pt>
          <cx:pt idx="903">0.31892999999999999</cx:pt>
          <cx:pt idx="904">0.316778</cx:pt>
          <cx:pt idx="905">0.326407</cx:pt>
          <cx:pt idx="906">0.32472600000000001</cx:pt>
          <cx:pt idx="907">0.31434099999999998</cx:pt>
          <cx:pt idx="908">0.33024999999999999</cx:pt>
          <cx:pt idx="909">0.32444499999999998</cx:pt>
          <cx:pt idx="910">0.32447799999999999</cx:pt>
          <cx:pt idx="911">0.32344699999999998</cx:pt>
          <cx:pt idx="912">0.325013</cx:pt>
          <cx:pt idx="913">0.31116899999999997</cx:pt>
          <cx:pt idx="914">0.330175</cx:pt>
          <cx:pt idx="915">0.32756099999999999</cx:pt>
          <cx:pt idx="916">0.31986500000000001</cx:pt>
          <cx:pt idx="917">0.32949499999999998</cx:pt>
          <cx:pt idx="918">0.320079</cx:pt>
          <cx:pt idx="919">0.32791100000000001</cx:pt>
          <cx:pt idx="920">0.31950699999999999</cx:pt>
          <cx:pt idx="921">0.32577800000000001</cx:pt>
          <cx:pt idx="922">0.299205</cx:pt>
          <cx:pt idx="923">0.308423</cx:pt>
          <cx:pt idx="924">0.31893199999999999</cx:pt>
          <cx:pt idx="925">0.31183</cx:pt>
          <cx:pt idx="926">0.33930700000000003</cx:pt>
          <cx:pt idx="927">0.32308599999999998</cx:pt>
          <cx:pt idx="928">0.321247</cx:pt>
          <cx:pt idx="929">0.31953900000000002</cx:pt>
          <cx:pt idx="930">0.32004100000000002</cx:pt>
          <cx:pt idx="931">0.320328</cx:pt>
          <cx:pt idx="932">0.31643100000000002</cx:pt>
          <cx:pt idx="933">0.33221800000000001</cx:pt>
          <cx:pt idx="934">0.30722699999999997</cx:pt>
          <cx:pt idx="935">0.334397</cx:pt>
          <cx:pt idx="936">0.31476599999999999</cx:pt>
          <cx:pt idx="937">0.30576100000000001</cx:pt>
          <cx:pt idx="938">0.32139499999999999</cx:pt>
          <cx:pt idx="939">0.32960899999999999</cx:pt>
          <cx:pt idx="940">0.31929400000000002</cx:pt>
          <cx:pt idx="941">0.31673400000000002</cx:pt>
          <cx:pt idx="942">0.31395400000000001</cx:pt>
          <cx:pt idx="943">0.30866900000000003</cx:pt>
          <cx:pt idx="944">0.31266500000000003</cx:pt>
          <cx:pt idx="945">0.320465</cx:pt>
          <cx:pt idx="946">0.297537</cx:pt>
          <cx:pt idx="947">0.31074800000000002</cx:pt>
          <cx:pt idx="948">0.32531500000000002</cx:pt>
          <cx:pt idx="949">0.3165</cx:pt>
          <cx:pt idx="950">0.301622</cx:pt>
          <cx:pt idx="951">0.32000499999999998</cx:pt>
          <cx:pt idx="952">0.30763699999999999</cx:pt>
          <cx:pt idx="953">0.319635</cx:pt>
          <cx:pt idx="954">0.31151899999999999</cx:pt>
          <cx:pt idx="955">0.31655899999999998</cx:pt>
          <cx:pt idx="956">0.31458900000000001</cx:pt>
          <cx:pt idx="957">0.314029</cx:pt>
          <cx:pt idx="958">0.32208100000000001</cx:pt>
          <cx:pt idx="959">0.31095200000000001</cx:pt>
          <cx:pt idx="960">0.313332</cx:pt>
          <cx:pt idx="961">0.31844499999999998</cx:pt>
          <cx:pt idx="962">0.30903199999999997</cx:pt>
          <cx:pt idx="963">0.321131</cx:pt>
          <cx:pt idx="964">0.31828299999999998</cx:pt>
          <cx:pt idx="965">0.31603900000000001</cx:pt>
          <cx:pt idx="966">0.30163800000000002</cx:pt>
          <cx:pt idx="967">0.31464199999999998</cx:pt>
          <cx:pt idx="968">0.308722</cx:pt>
          <cx:pt idx="969">0.31357499999999999</cx:pt>
          <cx:pt idx="970">0.31709500000000002</cx:pt>
          <cx:pt idx="971">0.30952400000000002</cx:pt>
          <cx:pt idx="972">0.31964900000000002</cx:pt>
          <cx:pt idx="973">0.31952900000000001</cx:pt>
          <cx:pt idx="974">0.333895</cx:pt>
          <cx:pt idx="975">0.321297</cx:pt>
          <cx:pt idx="976">0.31733</cx:pt>
          <cx:pt idx="977">0.32946599999999998</cx:pt>
          <cx:pt idx="978">0.307201</cx:pt>
          <cx:pt idx="979">0.34099600000000002</cx:pt>
          <cx:pt idx="980">0.31268200000000002</cx:pt>
          <cx:pt idx="981">0.30396699999999999</cx:pt>
          <cx:pt idx="982">0.315693</cx:pt>
          <cx:pt idx="983">0.30980000000000002</cx:pt>
          <cx:pt idx="984">0.31225999999999998</cx:pt>
          <cx:pt idx="985">0.31121399999999999</cx:pt>
          <cx:pt idx="986">0.32660400000000001</cx:pt>
          <cx:pt idx="987">0.322911</cx:pt>
          <cx:pt idx="988">0.32111299999999998</cx:pt>
          <cx:pt idx="989">0.32084099999999999</cx:pt>
          <cx:pt idx="990">0.326289</cx:pt>
          <cx:pt idx="991">0.32103199999999998</cx:pt>
          <cx:pt idx="992">0.32706299999999999</cx:pt>
          <cx:pt idx="993">0.327013</cx:pt>
          <cx:pt idx="994">0.31759700000000002</cx:pt>
          <cx:pt idx="995">0.32503900000000002</cx:pt>
          <cx:pt idx="996">0.30723400000000001</cx:pt>
          <cx:pt idx="997">0.32560600000000001</cx:pt>
          <cx:pt idx="998">0.31554399999999999</cx:pt>
          <cx:pt idx="999">0.31424999999999997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rtl="0"/>
            <a:r>
              <a:rPr lang="el-GR" altLang="ja-JP" sz="1200" b="0" i="0" baseline="0" dirty="0">
                <a:effectLst/>
              </a:rPr>
              <a:t>σ</a:t>
            </a:r>
            <a:r>
              <a:rPr lang="en-US" altLang="ja-JP" sz="1200" b="0" i="0" baseline="0" dirty="0">
                <a:effectLst/>
              </a:rPr>
              <a:t>,</a:t>
            </a:r>
            <a:r>
              <a:rPr lang="en-US" altLang="ja-JP" sz="1200" b="0" i="1" baseline="0" dirty="0" err="1">
                <a:effectLst/>
              </a:rPr>
              <a:t>x</a:t>
            </a:r>
            <a:r>
              <a:rPr lang="en-US" altLang="ja-JP" sz="1200" b="0" i="0" baseline="0" dirty="0" err="1">
                <a:effectLst/>
              </a:rPr>
              <a:t>acute</a:t>
            </a:r>
            <a:endParaRPr lang="ja-JP" altLang="ja-JP" sz="1400" dirty="0">
              <a:effectLst/>
            </a:endParaRPr>
          </a:p>
        </cx:rich>
      </cx:tx>
    </cx:title>
    <cx:plotArea>
      <cx:plotAreaRegion>
        <cx:series layoutId="clusteredColumn" uniqueId="{20AD7E4B-A118-433D-BBC3-F2DEEAE7EB84}">
          <cx:tx>
            <cx:txData>
              <cx:f>'PD acute'!$O$1</cx:f>
              <cx:v>E1Eps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Count val="15"/>
            </cx:binning>
          </cx:layoutPr>
        </cx:series>
      </cx:plotAreaRegion>
      <cx:axis id="0">
        <cx:catScaling gapWidth="0"/>
        <cx:tickLabels/>
        <cx:numFmt formatCode="#,##0.00_);[赤](#,##0.0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15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PD chronic'!$G$2:$G$1001</cx:f>
        <cx:lvl ptCount="1000" formatCode="G/標準">
          <cx:pt idx="0">2.66316</cx:pt>
          <cx:pt idx="1">2.5957400000000002</cx:pt>
          <cx:pt idx="2">2.59151</cx:pt>
          <cx:pt idx="3">2.9571100000000001</cx:pt>
          <cx:pt idx="4">2.65448</cx:pt>
          <cx:pt idx="5">3.6645400000000001</cx:pt>
          <cx:pt idx="6">3.4646400000000002</cx:pt>
          <cx:pt idx="7">2.9602200000000001</cx:pt>
          <cx:pt idx="8">2.5853299999999999</cx:pt>
          <cx:pt idx="9">3.8812500000000001</cx:pt>
          <cx:pt idx="10">3.0229300000000001</cx:pt>
          <cx:pt idx="11">3.5739299999999998</cx:pt>
          <cx:pt idx="12">3.5553400000000002</cx:pt>
          <cx:pt idx="13">2.4919199999999999</cx:pt>
          <cx:pt idx="14">2.6585999999999999</cx:pt>
          <cx:pt idx="15">2.5909</cx:pt>
          <cx:pt idx="16">3.5967099999999999</cx:pt>
          <cx:pt idx="17">3.13916</cx:pt>
          <cx:pt idx="18">3.4472</cx:pt>
          <cx:pt idx="19">2.62236</cx:pt>
          <cx:pt idx="20">3.52834</cx:pt>
          <cx:pt idx="21">3.5720700000000001</cx:pt>
          <cx:pt idx="22">3.6180300000000001</cx:pt>
          <cx:pt idx="23">2.5538400000000001</cx:pt>
          <cx:pt idx="24">3.9099499999999998</cx:pt>
          <cx:pt idx="25">2.6359499999999998</cx:pt>
          <cx:pt idx="26">2.3849399999999998</cx:pt>
          <cx:pt idx="27">2.3645700000000001</cx:pt>
          <cx:pt idx="28">2.5699399999999999</cx:pt>
          <cx:pt idx="29">3.2145299999999999</cx:pt>
          <cx:pt idx="30">3.3306800000000001</cx:pt>
          <cx:pt idx="31">2.6033300000000001</cx:pt>
          <cx:pt idx="32">3.5398200000000002</cx:pt>
          <cx:pt idx="33">2.5739299999999998</cx:pt>
          <cx:pt idx="34">2.6521699999999999</cx:pt>
          <cx:pt idx="35">2.6272700000000002</cx:pt>
          <cx:pt idx="36">3.6392000000000002</cx:pt>
          <cx:pt idx="37">2.5990199999999999</cx:pt>
          <cx:pt idx="38">2.65184</cx:pt>
          <cx:pt idx="39">2.4751400000000001</cx:pt>
          <cx:pt idx="40">3.7488700000000001</cx:pt>
          <cx:pt idx="41">3.3386399999999998</cx:pt>
          <cx:pt idx="42">3.6042299999999998</cx:pt>
          <cx:pt idx="43">2.3799399999999999</cx:pt>
          <cx:pt idx="44">2.4880200000000001</cx:pt>
          <cx:pt idx="45">3.5843099999999999</cx:pt>
          <cx:pt idx="46">3.4744600000000001</cx:pt>
          <cx:pt idx="47">2.6209199999999999</cx:pt>
          <cx:pt idx="48">2.5971099999999998</cx:pt>
          <cx:pt idx="49">2.6337899999999999</cx:pt>
          <cx:pt idx="50">2.6579299999999999</cx:pt>
          <cx:pt idx="51">3.3040699999999998</cx:pt>
          <cx:pt idx="52">3.47919</cx:pt>
          <cx:pt idx="53">2.6442700000000001</cx:pt>
          <cx:pt idx="54">2.39195</cx:pt>
          <cx:pt idx="55">3.6846000000000001</cx:pt>
          <cx:pt idx="56">2.6374599999999999</cx:pt>
          <cx:pt idx="57">2.6314700000000002</cx:pt>
          <cx:pt idx="58">3.55762</cx:pt>
          <cx:pt idx="59">2.6464099999999999</cx:pt>
          <cx:pt idx="60">2.5977000000000001</cx:pt>
          <cx:pt idx="61">2.54209</cx:pt>
          <cx:pt idx="62">2.61077</cx:pt>
          <cx:pt idx="63">3.4740799999999998</cx:pt>
          <cx:pt idx="64">2.5952600000000001</cx:pt>
          <cx:pt idx="65">2.4858799999999999</cx:pt>
          <cx:pt idx="66">2.50299</cx:pt>
          <cx:pt idx="67">3.4291399999999999</cx:pt>
          <cx:pt idx="68">3.5557599999999998</cx:pt>
          <cx:pt idx="69">2.5644499999999999</cx:pt>
          <cx:pt idx="70">2.3639399999999999</cx:pt>
          <cx:pt idx="71">3.48448</cx:pt>
          <cx:pt idx="72">3.5004499999999998</cx:pt>
          <cx:pt idx="73">3.5738300000000001</cx:pt>
          <cx:pt idx="74">3.50224</cx:pt>
          <cx:pt idx="75">2.67815</cx:pt>
          <cx:pt idx="76">3.7222599999999999</cx:pt>
          <cx:pt idx="77">3.4810099999999999</cx:pt>
          <cx:pt idx="78">2.6358700000000002</cx:pt>
          <cx:pt idx="79">2.36632</cx:pt>
          <cx:pt idx="80">2.95987</cx:pt>
          <cx:pt idx="81">3.9882499999999999</cx:pt>
          <cx:pt idx="82">3.6454599999999999</cx:pt>
          <cx:pt idx="83">2.5924700000000001</cx:pt>
          <cx:pt idx="84">3.5073799999999999</cx:pt>
          <cx:pt idx="85">2.4736699999999998</cx:pt>
          <cx:pt idx="86">2.4655800000000001</cx:pt>
          <cx:pt idx="87">3.1438000000000001</cx:pt>
          <cx:pt idx="88">2.58203</cx:pt>
          <cx:pt idx="89">3.38252</cx:pt>
          <cx:pt idx="90">2.6624699999999999</cx:pt>
          <cx:pt idx="91">3.4893200000000002</cx:pt>
          <cx:pt idx="92">2.3835500000000001</cx:pt>
          <cx:pt idx="93">3.3563399999999999</cx:pt>
          <cx:pt idx="94">2.6615700000000002</cx:pt>
          <cx:pt idx="95">2.5971299999999999</cx:pt>
          <cx:pt idx="96">2.6267299999999998</cx:pt>
          <cx:pt idx="97">2.51396</cx:pt>
          <cx:pt idx="98">2.5952600000000001</cx:pt>
          <cx:pt idx="99">2.66378</cx:pt>
          <cx:pt idx="100">2.37405</cx:pt>
          <cx:pt idx="101">2.6593599999999999</cx:pt>
          <cx:pt idx="102">2.3658999999999999</cx:pt>
          <cx:pt idx="103">2.4919199999999999</cx:pt>
          <cx:pt idx="104">2.59423</cx:pt>
          <cx:pt idx="105">2.6186600000000002</cx:pt>
          <cx:pt idx="106">2.5196900000000002</cx:pt>
          <cx:pt idx="107">3.1976900000000001</cx:pt>
          <cx:pt idx="108">3.5464699999999998</cx:pt>
          <cx:pt idx="109">3.6837300000000002</cx:pt>
          <cx:pt idx="110">2.5857700000000001</cx:pt>
          <cx:pt idx="111">2.6276000000000002</cx:pt>
          <cx:pt idx="112">3.5981100000000001</cx:pt>
          <cx:pt idx="113">2.5740099999999999</cx:pt>
          <cx:pt idx="114">3.6587700000000001</cx:pt>
          <cx:pt idx="115">2.6633300000000002</cx:pt>
          <cx:pt idx="116">3.60744</cx:pt>
          <cx:pt idx="117">3.64174</cx:pt>
          <cx:pt idx="118">2.5074100000000001</cx:pt>
          <cx:pt idx="119">2.45913</cx:pt>
          <cx:pt idx="120">2.59592</cx:pt>
          <cx:pt idx="121">2.6581899999999998</cx:pt>
          <cx:pt idx="122">3.18018</cx:pt>
          <cx:pt idx="123">2.5925400000000001</cx:pt>
          <cx:pt idx="124">2.9815999999999998</cx:pt>
          <cx:pt idx="125">2.4424899999999998</cx:pt>
          <cx:pt idx="126">3.5747599999999999</cx:pt>
          <cx:pt idx="127">2.3268800000000001</cx:pt>
          <cx:pt idx="128">2.6682700000000001</cx:pt>
          <cx:pt idx="129">2.42048</cx:pt>
          <cx:pt idx="130">3.5914000000000001</cx:pt>
          <cx:pt idx="131">2.5005099999999998</cx:pt>
          <cx:pt idx="132">3.4778600000000002</cx:pt>
          <cx:pt idx="133">2.4874900000000002</cx:pt>
          <cx:pt idx="134">3.4707499999999998</cx:pt>
          <cx:pt idx="135">2.6148600000000002</cx:pt>
          <cx:pt idx="136">3.36666</cx:pt>
          <cx:pt idx="137">2.7809699999999999</cx:pt>
          <cx:pt idx="138">2.3835700000000002</cx:pt>
          <cx:pt idx="139">2.6666099999999999</cx:pt>
          <cx:pt idx="140">3.36978</cx:pt>
          <cx:pt idx="141">3.0881500000000002</cx:pt>
          <cx:pt idx="142">2.5968499999999999</cx:pt>
          <cx:pt idx="143">2.5814900000000001</cx:pt>
          <cx:pt idx="144">2.6025700000000001</cx:pt>
          <cx:pt idx="145">2.6468699999999998</cx:pt>
          <cx:pt idx="146">2.66221</cx:pt>
          <cx:pt idx="147">2.50922</cx:pt>
          <cx:pt idx="148">3.73203</cx:pt>
          <cx:pt idx="149">2.56921</cx:pt>
          <cx:pt idx="150">3.54318</cx:pt>
          <cx:pt idx="151">2.6122200000000002</cx:pt>
          <cx:pt idx="152">2.34355</cx:pt>
          <cx:pt idx="153">3.5722299999999998</cx:pt>
          <cx:pt idx="154">3.4557600000000002</cx:pt>
          <cx:pt idx="155">3.4801099999999998</cx:pt>
          <cx:pt idx="156">2.57335</cx:pt>
          <cx:pt idx="157">2.6078999999999999</cx:pt>
          <cx:pt idx="158">3.1028799999999999</cx:pt>
          <cx:pt idx="159">2.5754899999999998</cx:pt>
          <cx:pt idx="160">3.6155900000000001</cx:pt>
          <cx:pt idx="161">2.6365500000000002</cx:pt>
          <cx:pt idx="162">2.3257300000000001</cx:pt>
          <cx:pt idx="163">2.6233900000000001</cx:pt>
          <cx:pt idx="164">3.2054399999999998</cx:pt>
          <cx:pt idx="165">3.6033599999999999</cx:pt>
          <cx:pt idx="166">2.6768200000000002</cx:pt>
          <cx:pt idx="167">3.4750899999999998</cx:pt>
          <cx:pt idx="168">2.6384699999999999</cx:pt>
          <cx:pt idx="169">3.3321999999999998</cx:pt>
          <cx:pt idx="170">3.4461400000000002</cx:pt>
          <cx:pt idx="171">3.6623999999999999</cx:pt>
          <cx:pt idx="172">3.4571900000000002</cx:pt>
          <cx:pt idx="173">2.5006200000000001</cx:pt>
          <cx:pt idx="174">3.2745899999999999</cx:pt>
          <cx:pt idx="175">2.5080399999999998</cx:pt>
          <cx:pt idx="176">2.6390500000000001</cx:pt>
          <cx:pt idx="177">3.4699800000000001</cx:pt>
          <cx:pt idx="178">2.6149499999999999</cx:pt>
          <cx:pt idx="179">2.63361</cx:pt>
          <cx:pt idx="180">3.5765099999999999</cx:pt>
          <cx:pt idx="181">3.33263</cx:pt>
          <cx:pt idx="182">3.5549200000000001</cx:pt>
          <cx:pt idx="183">3.19686</cx:pt>
          <cx:pt idx="184">2.38422</cx:pt>
          <cx:pt idx="185">2.51654</cx:pt>
          <cx:pt idx="186">3.4213</cx:pt>
          <cx:pt idx="187">3.7817500000000002</cx:pt>
          <cx:pt idx="188">3.3256700000000001</cx:pt>
          <cx:pt idx="189">3.3637199999999998</cx:pt>
          <cx:pt idx="190">2.6540499999999998</cx:pt>
          <cx:pt idx="191">2.6515300000000002</cx:pt>
          <cx:pt idx="192">3.6257899999999998</cx:pt>
          <cx:pt idx="193">3.7254399999999999</cx:pt>
          <cx:pt idx="194">2.5553400000000002</cx:pt>
          <cx:pt idx="195">3.4308100000000001</cx:pt>
          <cx:pt idx="196">3.5998199999999998</cx:pt>
          <cx:pt idx="197">2.3940399999999999</cx:pt>
          <cx:pt idx="198">3.6446200000000002</cx:pt>
          <cx:pt idx="199">2.6410800000000001</cx:pt>
          <cx:pt idx="200">2.6044299999999998</cx:pt>
          <cx:pt idx="201">2.3373200000000001</cx:pt>
          <cx:pt idx="202">2.65062</cx:pt>
          <cx:pt idx="203">2.4919799999999999</cx:pt>
          <cx:pt idx="204">2.99207</cx:pt>
          <cx:pt idx="205">3.5429599999999999</cx:pt>
          <cx:pt idx="206">3.6547299999999998</cx:pt>
          <cx:pt idx="207">2.7772399999999999</cx:pt>
          <cx:pt idx="208">2.4952700000000001</cx:pt>
          <cx:pt idx="209">2.4964</cx:pt>
          <cx:pt idx="210">2.6597300000000001</cx:pt>
          <cx:pt idx="211">2.59579</cx:pt>
          <cx:pt idx="212">2.8994900000000001</cx:pt>
          <cx:pt idx="213">2.5882000000000001</cx:pt>
          <cx:pt idx="214">2.6339100000000002</cx:pt>
          <cx:pt idx="215">3.7198600000000002</cx:pt>
          <cx:pt idx="216">3.4643299999999999</cx:pt>
          <cx:pt idx="217">2.6495000000000002</cx:pt>
          <cx:pt idx="218">2.3799199999999998</cx:pt>
          <cx:pt idx="219">2.5857700000000001</cx:pt>
          <cx:pt idx="220">2.7734700000000001</cx:pt>
          <cx:pt idx="221">2.52494</cx:pt>
          <cx:pt idx="222">3.3223500000000001</cx:pt>
          <cx:pt idx="223">2.3208000000000002</cx:pt>
          <cx:pt idx="224">3.5045199999999999</cx:pt>
          <cx:pt idx="225">2.6118700000000001</cx:pt>
          <cx:pt idx="226">3.6153900000000001</cx:pt>
          <cx:pt idx="227">3.4374099999999999</cx:pt>
          <cx:pt idx="228">3.5762299999999998</cx:pt>
          <cx:pt idx="229">2.5946699999999998</cx:pt>
          <cx:pt idx="230">2.6071900000000001</cx:pt>
          <cx:pt idx="231">2.6421100000000002</cx:pt>
          <cx:pt idx="232">2.9698600000000002</cx:pt>
          <cx:pt idx="233">2.5964900000000002</cx:pt>
          <cx:pt idx="234">3.7203599999999999</cx:pt>
          <cx:pt idx="235">2.52494</cx:pt>
          <cx:pt idx="236">3.6375000000000002</cx:pt>
          <cx:pt idx="237">3.4894400000000001</cx:pt>
          <cx:pt idx="238">2.6418900000000001</cx:pt>
          <cx:pt idx="239">2.3676699999999999</cx:pt>
          <cx:pt idx="240">2.8250600000000001</cx:pt>
          <cx:pt idx="241">2.6409099999999999</cx:pt>
          <cx:pt idx="242">2.59606</cx:pt>
          <cx:pt idx="243">3.0222899999999999</cx:pt>
          <cx:pt idx="244">3.3061099999999999</cx:pt>
          <cx:pt idx="245">2.6454599999999999</cx:pt>
          <cx:pt idx="246">2.3327300000000002</cx:pt>
          <cx:pt idx="247">3.5824799999999999</cx:pt>
          <cx:pt idx="248">3.58311</cx:pt>
          <cx:pt idx="249">3.3177500000000002</cx:pt>
          <cx:pt idx="250">2.5945299999999998</cx:pt>
          <cx:pt idx="251">2.5066099999999998</cx:pt>
          <cx:pt idx="252">3.0735899999999998</cx:pt>
          <cx:pt idx="253">3.51559</cx:pt>
          <cx:pt idx="254">2.61252</cx:pt>
          <cx:pt idx="255">2.4872299999999998</cx:pt>
          <cx:pt idx="256">3.5781499999999999</cx:pt>
          <cx:pt idx="257">3.4646499999999998</cx:pt>
          <cx:pt idx="258">3.4627400000000002</cx:pt>
          <cx:pt idx="259">3.5106700000000002</cx:pt>
          <cx:pt idx="260">2.6357400000000002</cx:pt>
          <cx:pt idx="261">3.0886300000000002</cx:pt>
          <cx:pt idx="262">3.4322699999999999</cx:pt>
          <cx:pt idx="263">2.5496400000000001</cx:pt>
          <cx:pt idx="264">2.5975799999999998</cx:pt>
          <cx:pt idx="265">2.6555300000000002</cx:pt>
          <cx:pt idx="266">2.5990199999999999</cx:pt>
          <cx:pt idx="267">2.5871</cx:pt>
          <cx:pt idx="268">2.42672</cx:pt>
          <cx:pt idx="269">3.4593400000000001</cx:pt>
          <cx:pt idx="270">3.2132999999999998</cx:pt>
          <cx:pt idx="271">2.6440100000000002</cx:pt>
          <cx:pt idx="272">3.1577500000000001</cx:pt>
          <cx:pt idx="273">2.6462699999999999</cx:pt>
          <cx:pt idx="274">3.3687800000000001</cx:pt>
          <cx:pt idx="275">2.5907900000000001</cx:pt>
          <cx:pt idx="276">2.6141800000000002</cx:pt>
          <cx:pt idx="277">3.56704</cx:pt>
          <cx:pt idx="278">2.6240999999999999</cx:pt>
          <cx:pt idx="279">2.5239099999999999</cx:pt>
          <cx:pt idx="280">3.5936499999999998</cx:pt>
          <cx:pt idx="281">2.5904199999999999</cx:pt>
          <cx:pt idx="282">3.4558</cx:pt>
          <cx:pt idx="283">3.3437199999999998</cx:pt>
          <cx:pt idx="284">3.5460199999999999</cx:pt>
          <cx:pt idx="285">3.1832500000000001</cx:pt>
          <cx:pt idx="286">3.6489400000000001</cx:pt>
          <cx:pt idx="287">2.23319</cx:pt>
          <cx:pt idx="288">3.4810500000000002</cx:pt>
          <cx:pt idx="289">2.4916499999999999</cx:pt>
          <cx:pt idx="290">3.4155799999999998</cx:pt>
          <cx:pt idx="291">2.6065100000000001</cx:pt>
          <cx:pt idx="292">2.4518499999999999</cx:pt>
          <cx:pt idx="293">3.6222599999999998</cx:pt>
          <cx:pt idx="294">2.4846200000000001</cx:pt>
          <cx:pt idx="295">2.5934900000000001</cx:pt>
          <cx:pt idx="296">3.5812499999999998</cx:pt>
          <cx:pt idx="297">3.4646300000000001</cx:pt>
          <cx:pt idx="298">3.4777499999999999</cx:pt>
          <cx:pt idx="299">3.5806300000000002</cx:pt>
          <cx:pt idx="300">2.6660200000000001</cx:pt>
          <cx:pt idx="301">2.5973799999999998</cx:pt>
          <cx:pt idx="302">2.6247199999999999</cx:pt>
          <cx:pt idx="303">2.5043199999999999</cx:pt>
          <cx:pt idx="304">3.6180599999999998</cx:pt>
          <cx:pt idx="305">2.6101200000000002</cx:pt>
          <cx:pt idx="306">3.60649</cx:pt>
          <cx:pt idx="307">2.5996199999999998</cx:pt>
          <cx:pt idx="308">2.5886499999999999</cx:pt>
          <cx:pt idx="309">2.5903</cx:pt>
          <cx:pt idx="310">2.36212</cx:pt>
          <cx:pt idx="311">2.3723200000000002</cx:pt>
          <cx:pt idx="312">3.5284</cx:pt>
          <cx:pt idx="313">2.5987100000000001</cx:pt>
          <cx:pt idx="314">3.4838900000000002</cx:pt>
          <cx:pt idx="315">3.4944000000000002</cx:pt>
          <cx:pt idx="316">2.6359699999999999</cx:pt>
          <cx:pt idx="317">2.3605900000000002</cx:pt>
          <cx:pt idx="318">3.50027</cx:pt>
          <cx:pt idx="319">3.0191599999999998</cx:pt>
          <cx:pt idx="320">2.9169900000000002</cx:pt>
          <cx:pt idx="321">2.5923600000000002</cx:pt>
          <cx:pt idx="322">3.3622200000000002</cx:pt>
          <cx:pt idx="323">3.4845700000000002</cx:pt>
          <cx:pt idx="324">2.64276</cx:pt>
          <cx:pt idx="325">2.5080100000000001</cx:pt>
          <cx:pt idx="326">2.5925199999999999</cx:pt>
          <cx:pt idx="327">2.6100400000000001</cx:pt>
          <cx:pt idx="328">3.6013799999999998</cx:pt>
          <cx:pt idx="329">3.6795800000000001</cx:pt>
          <cx:pt idx="330">2.5959699999999999</cx:pt>
          <cx:pt idx="331">2.5844499999999999</cx:pt>
          <cx:pt idx="332">3.46732</cx:pt>
          <cx:pt idx="333">2.7819099999999999</cx:pt>
          <cx:pt idx="334">3.6954600000000002</cx:pt>
          <cx:pt idx="335">2.66229</cx:pt>
          <cx:pt idx="336">3.3276400000000002</cx:pt>
          <cx:pt idx="337">3.3642400000000001</cx:pt>
          <cx:pt idx="338">3.7668900000000001</cx:pt>
          <cx:pt idx="339">2.6265800000000001</cx:pt>
          <cx:pt idx="340">2.61802</cx:pt>
          <cx:pt idx="341">2.5934300000000001</cx:pt>
          <cx:pt idx="342">3.3601899999999998</cx:pt>
          <cx:pt idx="343">2.3611499999999999</cx:pt>
          <cx:pt idx="344">3.48448</cx:pt>
          <cx:pt idx="345">2.5151300000000001</cx:pt>
          <cx:pt idx="346">2.6074799999999998</cx:pt>
          <cx:pt idx="347">3.3584299999999998</cx:pt>
          <cx:pt idx="348">3.3780399999999999</cx:pt>
          <cx:pt idx="349">3.5978500000000002</cx:pt>
          <cx:pt idx="350">3.5925500000000001</cx:pt>
          <cx:pt idx="351">2.63687</cx:pt>
          <cx:pt idx="352">3.3854899999999999</cx:pt>
          <cx:pt idx="353">2.65496</cx:pt>
          <cx:pt idx="354">2.61999</cx:pt>
          <cx:pt idx="355">3.5907800000000001</cx:pt>
          <cx:pt idx="356">3.21774</cx:pt>
          <cx:pt idx="357">3.6930900000000002</cx:pt>
          <cx:pt idx="358">2.5941100000000001</cx:pt>
          <cx:pt idx="359">3.5514800000000002</cx:pt>
          <cx:pt idx="360">3.5697999999999999</cx:pt>
          <cx:pt idx="361">2.6512899999999999</cx:pt>
          <cx:pt idx="362">2.57687</cx:pt>
          <cx:pt idx="363">2.6348400000000001</cx:pt>
          <cx:pt idx="364">3.5499399999999999</cx:pt>
          <cx:pt idx="365">3.3040400000000001</cx:pt>
          <cx:pt idx="366">3.4763299999999999</cx:pt>
          <cx:pt idx="367">3.5070399999999999</cx:pt>
          <cx:pt idx="368">3.2309100000000002</cx:pt>
          <cx:pt idx="369">2.5076399999999999</cx:pt>
          <cx:pt idx="370">2.6486900000000002</cx:pt>
          <cx:pt idx="371">3.4779599999999999</cx:pt>
          <cx:pt idx="372">3.2850700000000002</cx:pt>
          <cx:pt idx="373">2.6154500000000001</cx:pt>
          <cx:pt idx="374">2.5006900000000001</cx:pt>
          <cx:pt idx="375">2.61022</cx:pt>
          <cx:pt idx="376">3.53593</cx:pt>
          <cx:pt idx="377">3.5603199999999999</cx:pt>
          <cx:pt idx="378">3.6119400000000002</cx:pt>
          <cx:pt idx="379">3.2156199999999999</cx:pt>
          <cx:pt idx="380">2.6072099999999998</cx:pt>
          <cx:pt idx="381">2.6050800000000001</cx:pt>
          <cx:pt idx="382">2.8231999999999999</cx:pt>
          <cx:pt idx="383">3.3529399999999998</cx:pt>
          <cx:pt idx="384">2.3723000000000001</cx:pt>
          <cx:pt idx="385">2.6203500000000002</cx:pt>
          <cx:pt idx="386">2.6019999999999999</cx:pt>
          <cx:pt idx="387">2.4749099999999999</cx:pt>
          <cx:pt idx="388">3.38245</cx:pt>
          <cx:pt idx="389">2.4811899999999998</cx:pt>
          <cx:pt idx="390">3.5469400000000002</cx:pt>
          <cx:pt idx="391">2.6418300000000001</cx:pt>
          <cx:pt idx="392">2.62574</cx:pt>
          <cx:pt idx="393">2.4765299999999999</cx:pt>
          <cx:pt idx="394">2.6049600000000002</cx:pt>
          <cx:pt idx="395">2.5385800000000001</cx:pt>
          <cx:pt idx="396">2.6216200000000001</cx:pt>
          <cx:pt idx="397">3.3890400000000001</cx:pt>
          <cx:pt idx="398">2.9403199999999998</cx:pt>
          <cx:pt idx="399">3.6691400000000001</cx:pt>
          <cx:pt idx="400">2.6101200000000002</cx:pt>
          <cx:pt idx="401">2.6039400000000001</cx:pt>
          <cx:pt idx="402">2.3600099999999999</cx:pt>
          <cx:pt idx="403">2.5872700000000002</cx:pt>
          <cx:pt idx="404">3.5046900000000001</cx:pt>
          <cx:pt idx="405">3.677</cx:pt>
          <cx:pt idx="406">2.5903</cx:pt>
          <cx:pt idx="407">3.5867399999999998</cx:pt>
          <cx:pt idx="408">2.6539899999999998</cx:pt>
          <cx:pt idx="409">2.6393599999999999</cx:pt>
          <cx:pt idx="410">2.6077400000000002</cx:pt>
          <cx:pt idx="411">3.4025599999999998</cx:pt>
          <cx:pt idx="412">3.3929299999999998</cx:pt>
          <cx:pt idx="413">2.34294</cx:pt>
          <cx:pt idx="414">3.3528699999999998</cx:pt>
          <cx:pt idx="415">3.7631700000000001</cx:pt>
          <cx:pt idx="416">2.6006200000000002</cx:pt>
          <cx:pt idx="417">2.3892099999999998</cx:pt>
          <cx:pt idx="418">3.5992000000000002</cx:pt>
          <cx:pt idx="419">2.62845</cx:pt>
          <cx:pt idx="420">3.2498800000000001</cx:pt>
          <cx:pt idx="421">3.6589999999999998</cx:pt>
          <cx:pt idx="422">2.6390500000000001</cx:pt>
          <cx:pt idx="423">2.5888200000000001</cx:pt>
          <cx:pt idx="424">3.4047900000000002</cx:pt>
          <cx:pt idx="425">2.6238000000000001</cx:pt>
          <cx:pt idx="426">3.6371199999999999</cx:pt>
          <cx:pt idx="427">2.6369199999999999</cx:pt>
          <cx:pt idx="428">2.65794</cx:pt>
          <cx:pt idx="429">3.1982200000000001</cx:pt>
          <cx:pt idx="430">3.7117800000000001</cx:pt>
          <cx:pt idx="431">2.6661700000000002</cx:pt>
          <cx:pt idx="432">3.25135</cx:pt>
          <cx:pt idx="433">3.6139399999999999</cx:pt>
          <cx:pt idx="434">3.4348800000000002</cx:pt>
          <cx:pt idx="435">2.5146000000000002</cx:pt>
          <cx:pt idx="436">3.6147100000000001</cx:pt>
          <cx:pt idx="437">2.99105</cx:pt>
          <cx:pt idx="438">2.6354199999999999</cx:pt>
          <cx:pt idx="439">3.6867700000000001</cx:pt>
          <cx:pt idx="440">2.6061000000000001</cx:pt>
          <cx:pt idx="441">2.6032600000000001</cx:pt>
          <cx:pt idx="442">3.4496899999999999</cx:pt>
          <cx:pt idx="443">2.65137</cx:pt>
          <cx:pt idx="444">2.59267</cx:pt>
          <cx:pt idx="445">2.9894599999999998</cx:pt>
          <cx:pt idx="446">2.4931999999999999</cx:pt>
          <cx:pt idx="447">2.5956000000000001</cx:pt>
          <cx:pt idx="448">2.5811799999999998</cx:pt>
          <cx:pt idx="449">3.5561199999999999</cx:pt>
          <cx:pt idx="450">3.5691999999999999</cx:pt>
          <cx:pt idx="451">2.37914</cx:pt>
          <cx:pt idx="452">2.7943799999999999</cx:pt>
          <cx:pt idx="453">2.6569600000000002</cx:pt>
          <cx:pt idx="454">3.5928800000000001</cx:pt>
          <cx:pt idx="455">2.37982</cx:pt>
          <cx:pt idx="456">3.6796500000000001</cx:pt>
          <cx:pt idx="457">3.54799</cx:pt>
          <cx:pt idx="458">2.2919100000000001</cx:pt>
          <cx:pt idx="459">2.48482</cx:pt>
          <cx:pt idx="460">3.4594800000000001</cx:pt>
          <cx:pt idx="461">2.61815</cx:pt>
          <cx:pt idx="462">3.5799500000000002</cx:pt>
          <cx:pt idx="463">3.4265300000000001</cx:pt>
          <cx:pt idx="464">2.5874999999999999</cx:pt>
          <cx:pt idx="465">3.4508899999999998</cx:pt>
          <cx:pt idx="466">2.6537600000000001</cx:pt>
          <cx:pt idx="467">2.6104699999999998</cx:pt>
          <cx:pt idx="468">2.3471299999999999</cx:pt>
          <cx:pt idx="469">2.3578199999999998</cx:pt>
          <cx:pt idx="470">2.5116900000000002</cx:pt>
          <cx:pt idx="471">2.4914000000000001</cx:pt>
          <cx:pt idx="472">2.9948700000000001</cx:pt>
          <cx:pt idx="473">2.5927799999999999</cx:pt>
          <cx:pt idx="474">3.7155900000000002</cx:pt>
          <cx:pt idx="475">2.4482499999999998</cx:pt>
          <cx:pt idx="476">2.6873100000000001</cx:pt>
          <cx:pt idx="477">2.5748099999999998</cx:pt>
          <cx:pt idx="478">3.61239</cx:pt>
          <cx:pt idx="479">3.5215900000000002</cx:pt>
          <cx:pt idx="480">3.3915099999999998</cx:pt>
          <cx:pt idx="481">2.5436000000000001</cx:pt>
          <cx:pt idx="482">3.3250500000000001</cx:pt>
          <cx:pt idx="483">2.60527</cx:pt>
          <cx:pt idx="484">2.5339200000000002</cx:pt>
          <cx:pt idx="485">2.3788399999999998</cx:pt>
          <cx:pt idx="486">3.1139100000000002</cx:pt>
          <cx:pt idx="487">2.8277600000000001</cx:pt>
          <cx:pt idx="488">3.5848800000000001</cx:pt>
          <cx:pt idx="489">3.5937600000000001</cx:pt>
          <cx:pt idx="490">2.48766</cx:pt>
          <cx:pt idx="491">3.5242300000000002</cx:pt>
          <cx:pt idx="492">3.3991600000000002</cx:pt>
          <cx:pt idx="493">3.4982000000000002</cx:pt>
          <cx:pt idx="494">3.6080899999999998</cx:pt>
          <cx:pt idx="495">3.2062200000000001</cx:pt>
          <cx:pt idx="496">2.63043</cx:pt>
          <cx:pt idx="497">2.62005</cx:pt>
          <cx:pt idx="498">2.6044800000000001</cx:pt>
          <cx:pt idx="499">2.6558799999999998</cx:pt>
          <cx:pt idx="500">2.6015299999999999</cx:pt>
          <cx:pt idx="501">2.5990799999999998</cx:pt>
          <cx:pt idx="502">3.53077</cx:pt>
          <cx:pt idx="503">2.6341000000000001</cx:pt>
          <cx:pt idx="504">2.4813700000000001</cx:pt>
          <cx:pt idx="505">3.3691900000000001</cx:pt>
          <cx:pt idx="506">2.6070700000000002</cx:pt>
          <cx:pt idx="507">3.6599499999999998</cx:pt>
          <cx:pt idx="508">2.6037300000000001</cx:pt>
          <cx:pt idx="509">2.3583599999999998</cx:pt>
          <cx:pt idx="510">3.4586100000000002</cx:pt>
          <cx:pt idx="511">2.6053099999999998</cx:pt>
          <cx:pt idx="512">3.6106199999999999</cx:pt>
          <cx:pt idx="513">3.4776899999999999</cx:pt>
          <cx:pt idx="514">3.1870099999999999</cx:pt>
          <cx:pt idx="515">3.62677</cx:pt>
          <cx:pt idx="516">2.6025499999999999</cx:pt>
          <cx:pt idx="517">3.49498</cx:pt>
          <cx:pt idx="518">3.4920399999999998</cx:pt>
          <cx:pt idx="519">2.5068100000000002</cx:pt>
          <cx:pt idx="520">2.5893700000000002</cx:pt>
          <cx:pt idx="521">2.6593</cx:pt>
          <cx:pt idx="522">3.5720700000000001</cx:pt>
          <cx:pt idx="523">3.7512400000000001</cx:pt>
          <cx:pt idx="524">3.4346999999999999</cx:pt>
          <cx:pt idx="525">2.5739399999999999</cx:pt>
          <cx:pt idx="526">2.5867800000000001</cx:pt>
          <cx:pt idx="527">2.6284399999999999</cx:pt>
          <cx:pt idx="528">2.57138</cx:pt>
          <cx:pt idx="529">2.66099</cx:pt>
          <cx:pt idx="530">3.4271400000000001</cx:pt>
          <cx:pt idx="531">2.6131500000000001</cx:pt>
          <cx:pt idx="532">2.3925700000000001</cx:pt>
          <cx:pt idx="533">2.6580900000000001</cx:pt>
          <cx:pt idx="534">2.6437300000000001</cx:pt>
          <cx:pt idx="535">2.65036</cx:pt>
          <cx:pt idx="536">3.4278300000000002</cx:pt>
          <cx:pt idx="537">3.4458299999999999</cx:pt>
          <cx:pt idx="538">2.3742999999999999</cx:pt>
          <cx:pt idx="539">3.5655800000000002</cx:pt>
          <cx:pt idx="540">3.4060100000000002</cx:pt>
          <cx:pt idx="541">3.5248400000000002</cx:pt>
          <cx:pt idx="542">3.3591600000000001</cx:pt>
          <cx:pt idx="543">2.6434600000000001</cx:pt>
          <cx:pt idx="544">3.25745</cx:pt>
          <cx:pt idx="545">2.53233</cx:pt>
          <cx:pt idx="546">2.6560800000000002</cx:pt>
          <cx:pt idx="547">2.6008200000000001</cx:pt>
          <cx:pt idx="548">3.3136700000000001</cx:pt>
          <cx:pt idx="549">2.4944199999999999</cx:pt>
          <cx:pt idx="550">2.5015100000000001</cx:pt>
          <cx:pt idx="551">3.7211699999999999</cx:pt>
          <cx:pt idx="552">2.4904799999999998</cx:pt>
          <cx:pt idx="553">3.5640499999999999</cx:pt>
          <cx:pt idx="554">3.5743299999999998</cx:pt>
          <cx:pt idx="555">2.5697100000000002</cx:pt>
          <cx:pt idx="556">3.4557000000000002</cx:pt>
          <cx:pt idx="557">3.3612799999999998</cx:pt>
          <cx:pt idx="558">2.637</cx:pt>
          <cx:pt idx="559">2.3660800000000002</cx:pt>
          <cx:pt idx="560">2.5960299999999998</cx:pt>
          <cx:pt idx="561">3.3544</cx:pt>
          <cx:pt idx="562">3.6459800000000002</cx:pt>
          <cx:pt idx="563">2.6075900000000001</cx:pt>
          <cx:pt idx="564">3.13564</cx:pt>
          <cx:pt idx="565">2.6519200000000001</cx:pt>
          <cx:pt idx="566">3.2109399999999999</cx:pt>
          <cx:pt idx="567">2.6000200000000002</cx:pt>
          <cx:pt idx="568">2.6705899999999998</cx:pt>
          <cx:pt idx="569">2.7059199999999999</cx:pt>
          <cx:pt idx="570">2.6896800000000001</cx:pt>
          <cx:pt idx="571">2.6506099999999999</cx:pt>
          <cx:pt idx="572">2.4703599999999999</cx:pt>
          <cx:pt idx="573">3.45756</cx:pt>
          <cx:pt idx="574">2.5995200000000001</cx:pt>
          <cx:pt idx="575">3.4626399999999999</cx:pt>
          <cx:pt idx="576">3.55789</cx:pt>
          <cx:pt idx="577">2.3104499999999999</cx:pt>
          <cx:pt idx="578">2.6080999999999999</cx:pt>
          <cx:pt idx="579">3.51532</cx:pt>
          <cx:pt idx="580">3.3137500000000002</cx:pt>
          <cx:pt idx="581">3.4619399999999998</cx:pt>
          <cx:pt idx="582">2.49851</cx:pt>
          <cx:pt idx="583">3.5964</cx:pt>
          <cx:pt idx="584">2.54678</cx:pt>
          <cx:pt idx="585">2.6503000000000001</cx:pt>
          <cx:pt idx="586">2.57247</cx:pt>
          <cx:pt idx="587">2.6340400000000002</cx:pt>
          <cx:pt idx="588">3.4681299999999999</cx:pt>
          <cx:pt idx="589">3.46922</cx:pt>
          <cx:pt idx="590">2.5678100000000001</cx:pt>
          <cx:pt idx="591">2.6351100000000001</cx:pt>
          <cx:pt idx="592">2.5737399999999999</cx:pt>
          <cx:pt idx="593">3.6343999999999999</cx:pt>
          <cx:pt idx="594">3.4713599999999998</cx:pt>
          <cx:pt idx="595">2.5898400000000001</cx:pt>
          <cx:pt idx="596">3.6474700000000002</cx:pt>
          <cx:pt idx="597">3.4877099999999999</cx:pt>
          <cx:pt idx="598">2.5967600000000002</cx:pt>
          <cx:pt idx="599">2.6471200000000001</cx:pt>
          <cx:pt idx="600">3.4100799999999998</cx:pt>
          <cx:pt idx="601">3.0005500000000001</cx:pt>
          <cx:pt idx="602">2.58121</cx:pt>
          <cx:pt idx="603">3.6967500000000002</cx:pt>
          <cx:pt idx="604">3.05016</cx:pt>
          <cx:pt idx="605">2.6658400000000002</cx:pt>
          <cx:pt idx="606">2.6865000000000001</cx:pt>
          <cx:pt idx="607">2.6359599999999999</cx:pt>
          <cx:pt idx="608">3.4722400000000002</cx:pt>
          <cx:pt idx="609">3.5924900000000002</cx:pt>
          <cx:pt idx="610">2.6365099999999999</cx:pt>
          <cx:pt idx="611">2.6574800000000001</cx:pt>
          <cx:pt idx="612">3.60046</cx:pt>
          <cx:pt idx="613">2.6339399999999999</cx:pt>
          <cx:pt idx="614">3.3804599999999998</cx:pt>
          <cx:pt idx="615">3.2275800000000001</cx:pt>
          <cx:pt idx="616">2.4955500000000002</cx:pt>
          <cx:pt idx="617">2.52196</cx:pt>
          <cx:pt idx="618">2.6240700000000001</cx:pt>
          <cx:pt idx="619">2.27189</cx:pt>
          <cx:pt idx="620">3.6768700000000001</cx:pt>
          <cx:pt idx="621">2.6508799999999999</cx:pt>
          <cx:pt idx="622">2.5181499999999999</cx:pt>
          <cx:pt idx="623">2.6011700000000002</cx:pt>
          <cx:pt idx="624">2.6528399999999999</cx:pt>
          <cx:pt idx="625">2.3067299999999999</cx:pt>
          <cx:pt idx="626">2.6135600000000001</cx:pt>
          <cx:pt idx="627">3.2009500000000002</cx:pt>
          <cx:pt idx="628">3.42814</cx:pt>
          <cx:pt idx="629">3.5603600000000002</cx:pt>
          <cx:pt idx="630">2.5984400000000001</cx:pt>
          <cx:pt idx="631">2.98292</cx:pt>
          <cx:pt idx="632">2.5526499999999999</cx:pt>
          <cx:pt idx="633">2.6060500000000002</cx:pt>
          <cx:pt idx="634">2.6097999999999999</cx:pt>
          <cx:pt idx="635">2.6648900000000002</cx:pt>
          <cx:pt idx="636">3.8001999999999998</cx:pt>
          <cx:pt idx="637">2.6021800000000002</cx:pt>
          <cx:pt idx="638">2.73658</cx:pt>
          <cx:pt idx="639">3.5096799999999999</cx:pt>
          <cx:pt idx="640">2.6233</cx:pt>
          <cx:pt idx="641">3.7119399999999998</cx:pt>
          <cx:pt idx="642">2.5946699999999998</cx:pt>
          <cx:pt idx="643">3.5590099999999998</cx:pt>
          <cx:pt idx="644">2.6584500000000002</cx:pt>
          <cx:pt idx="645">3.1610100000000001</cx:pt>
          <cx:pt idx="646">2.33785</cx:pt>
          <cx:pt idx="647">2.6592199999999999</cx:pt>
          <cx:pt idx="648">3.4319600000000001</cx:pt>
          <cx:pt idx="649">3.3717299999999999</cx:pt>
          <cx:pt idx="650">3.8526400000000001</cx:pt>
          <cx:pt idx="651">3.3529</cx:pt>
          <cx:pt idx="652">2.60527</cx:pt>
          <cx:pt idx="653">3.4956999999999998</cx:pt>
          <cx:pt idx="654">2.5013000000000001</cx:pt>
          <cx:pt idx="655">2.37371</cx:pt>
          <cx:pt idx="656">3.7607699999999999</cx:pt>
          <cx:pt idx="657">3.4120599999999999</cx:pt>
          <cx:pt idx="658">2.6623000000000001</cx:pt>
          <cx:pt idx="659">3.5174400000000001</cx:pt>
          <cx:pt idx="660">2.6017600000000001</cx:pt>
          <cx:pt idx="661">2.6050900000000001</cx:pt>
          <cx:pt idx="662">3.6828699999999999</cx:pt>
          <cx:pt idx="663">3.4950800000000002</cx:pt>
          <cx:pt idx="664">2.3508</cx:pt>
          <cx:pt idx="665">2.57985</cx:pt>
          <cx:pt idx="666">2.6511</cx:pt>
          <cx:pt idx="667">2.60527</cx:pt>
          <cx:pt idx="668">3.3342399999999999</cx:pt>
          <cx:pt idx="669">2.5738400000000001</cx:pt>
          <cx:pt idx="670">2.38565</cx:pt>
          <cx:pt idx="671">2.6108199999999999</cx:pt>
          <cx:pt idx="672">3.66031</cx:pt>
          <cx:pt idx="673">3.4350999999999998</cx:pt>
          <cx:pt idx="674">3.5069499999999998</cx:pt>
          <cx:pt idx="675">2.3816099999999998</cx:pt>
          <cx:pt idx="676">3.6448900000000002</cx:pt>
          <cx:pt idx="677">3.3098399999999999</cx:pt>
          <cx:pt idx="678">3.6082900000000002</cx:pt>
          <cx:pt idx="679">2.6024699999999998</cx:pt>
          <cx:pt idx="680">2.64975</cx:pt>
          <cx:pt idx="681">2.3671899999999999</cx:pt>
          <cx:pt idx="682">2.58847</cx:pt>
          <cx:pt idx="683">2.3909699999999998</cx:pt>
          <cx:pt idx="684">3.54556</cx:pt>
          <cx:pt idx="685">2.5874799999999998</cx:pt>
          <cx:pt idx="686">3.65191</cx:pt>
          <cx:pt idx="687">2.60521</cx:pt>
          <cx:pt idx="688">2.6406999999999998</cx:pt>
          <cx:pt idx="689">2.65707</cx:pt>
          <cx:pt idx="690">2.6378200000000001</cx:pt>
          <cx:pt idx="691">3.5942699999999999</cx:pt>
          <cx:pt idx="692">2.6520899999999998</cx:pt>
          <cx:pt idx="693">2.6418300000000001</cx:pt>
          <cx:pt idx="694">2.6663800000000002</cx:pt>
          <cx:pt idx="695">2.6644199999999998</cx:pt>
          <cx:pt idx="696">3.6392500000000001</cx:pt>
          <cx:pt idx="697">3.4852099999999999</cx:pt>
          <cx:pt idx="698">2.6011299999999999</cx:pt>
          <cx:pt idx="699">2.6564700000000001</cx:pt>
          <cx:pt idx="700">3.13436</cx:pt>
          <cx:pt idx="701">2.4997799999999999</cx:pt>
          <cx:pt idx="702">2.61965</cx:pt>
          <cx:pt idx="703">2.6296200000000001</cx:pt>
          <cx:pt idx="704">3.6644999999999999</cx:pt>
          <cx:pt idx="705">3.5479599999999998</cx:pt>
          <cx:pt idx="706">3.5427</cx:pt>
          <cx:pt idx="707">3.5353599999999998</cx:pt>
          <cx:pt idx="708">3.54914</cx:pt>
          <cx:pt idx="709">2.6585800000000002</cx:pt>
          <cx:pt idx="710">3.58961</cx:pt>
          <cx:pt idx="711">3.5883799999999999</cx:pt>
          <cx:pt idx="712">3.5964100000000001</cx:pt>
          <cx:pt idx="713">3.8178899999999998</cx:pt>
          <cx:pt idx="714">2.7405200000000001</cx:pt>
          <cx:pt idx="715">3.6308500000000001</cx:pt>
          <cx:pt idx="716">3.36944</cx:pt>
          <cx:pt idx="717">3.35649</cx:pt>
          <cx:pt idx="718">2.5947399999999998</cx:pt>
          <cx:pt idx="719">3.6501000000000001</cx:pt>
          <cx:pt idx="720">2.5844900000000002</cx:pt>
          <cx:pt idx="721">2.6452200000000001</cx:pt>
          <cx:pt idx="722">3.2693400000000001</cx:pt>
          <cx:pt idx="723">3.4374099999999999</cx:pt>
          <cx:pt idx="724">2.3784000000000001</cx:pt>
          <cx:pt idx="725">2.9428100000000001</cx:pt>
          <cx:pt idx="726">3.3587699999999998</cx:pt>
          <cx:pt idx="727">3.3119700000000001</cx:pt>
          <cx:pt idx="728">3.2934199999999998</cx:pt>
          <cx:pt idx="729">2.3675999999999999</cx:pt>
          <cx:pt idx="730">2.5777899999999998</cx:pt>
          <cx:pt idx="731">2.5912099999999998</cx:pt>
          <cx:pt idx="732">2.59802</cx:pt>
          <cx:pt idx="733">2.94015</cx:pt>
          <cx:pt idx="734">3.6921400000000002</cx:pt>
          <cx:pt idx="735">2.6578599999999999</cx:pt>
          <cx:pt idx="736">2.5790500000000001</cx:pt>
          <cx:pt idx="737">2.60338</cx:pt>
          <cx:pt idx="738">2.6393399999999998</cx:pt>
          <cx:pt idx="739">3.4071099999999999</cx:pt>
          <cx:pt idx="740">2.6535099999999998</cx:pt>
          <cx:pt idx="741">3.5004400000000002</cx:pt>
          <cx:pt idx="742">2.6323799999999999</cx:pt>
          <cx:pt idx="743">2.6184099999999999</cx:pt>
          <cx:pt idx="744">2.9904799999999998</cx:pt>
          <cx:pt idx="745">2.6445400000000001</cx:pt>
          <cx:pt idx="746">3.2460900000000001</cx:pt>
          <cx:pt idx="747">2.4847700000000001</cx:pt>
          <cx:pt idx="748">3.5628799999999998</cx:pt>
          <cx:pt idx="749">3.0259399999999999</cx:pt>
          <cx:pt idx="750">2.6511800000000001</cx:pt>
          <cx:pt idx="751">3.53878</cx:pt>
          <cx:pt idx="752">3.6138699999999999</cx:pt>
          <cx:pt idx="753">2.5937399999999999</cx:pt>
          <cx:pt idx="754">2.5895899999999998</cx:pt>
          <cx:pt idx="755">3.4242400000000002</cx:pt>
          <cx:pt idx="756">2.5954199999999998</cx:pt>
          <cx:pt idx="757">3.7017500000000001</cx:pt>
          <cx:pt idx="758">3.5134400000000001</cx:pt>
          <cx:pt idx="759">3.0278299999999998</cx:pt>
          <cx:pt idx="760">3.4167100000000001</cx:pt>
          <cx:pt idx="761">2.7773500000000002</cx:pt>
          <cx:pt idx="762">3.4798800000000001</cx:pt>
          <cx:pt idx="763">2.6220500000000002</cx:pt>
          <cx:pt idx="764">2.62846</cx:pt>
          <cx:pt idx="765">3.7510300000000001</cx:pt>
          <cx:pt idx="766">2.3846799999999999</cx:pt>
          <cx:pt idx="767">2.6410800000000001</cx:pt>
          <cx:pt idx="768">2.6422699999999999</cx:pt>
          <cx:pt idx="769">2.6477599999999999</cx:pt>
          <cx:pt idx="770">2.6368800000000001</cx:pt>
          <cx:pt idx="771">3.44876</cx:pt>
          <cx:pt idx="772">2.4597899999999999</cx:pt>
          <cx:pt idx="773">3.6317599999999999</cx:pt>
          <cx:pt idx="774">3.4510999999999998</cx:pt>
          <cx:pt idx="775">3.5865100000000001</cx:pt>
          <cx:pt idx="776">3.3496600000000001</cx:pt>
          <cx:pt idx="777">3.6448</cx:pt>
          <cx:pt idx="778">3.6031399999999998</cx:pt>
          <cx:pt idx="779">3.5740400000000001</cx:pt>
          <cx:pt idx="780">2.44401</cx:pt>
          <cx:pt idx="781">3.4504199999999998</cx:pt>
          <cx:pt idx="782">3.4695</cx:pt>
          <cx:pt idx="783">2.6183299999999998</cx:pt>
          <cx:pt idx="784">2.3887299999999998</cx:pt>
          <cx:pt idx="785">3.5693999999999999</cx:pt>
          <cx:pt idx="786">3.2739099999999999</cx:pt>
          <cx:pt idx="787">3.4576199999999999</cx:pt>
          <cx:pt idx="788">2.3538899999999998</cx:pt>
          <cx:pt idx="789">2.6149</cx:pt>
          <cx:pt idx="790">2.60629</cx:pt>
          <cx:pt idx="791">2.6604399999999999</cx:pt>
          <cx:pt idx="792">2.5813299999999999</cx:pt>
          <cx:pt idx="793">2.3762099999999999</cx:pt>
          <cx:pt idx="794">3.4847800000000002</cx:pt>
          <cx:pt idx="795">3.5380799999999999</cx:pt>
          <cx:pt idx="796">3.61117</cx:pt>
          <cx:pt idx="797">2.34131</cx:pt>
          <cx:pt idx="798">2.3685</cx:pt>
          <cx:pt idx="799">2.6406999999999998</cx:pt>
          <cx:pt idx="800">3.5064600000000001</cx:pt>
          <cx:pt idx="801">3.6137700000000001</cx:pt>
          <cx:pt idx="802">2.6392699999999998</cx:pt>
          <cx:pt idx="803">3.2388499999999998</cx:pt>
          <cx:pt idx="804">2.37771</cx:pt>
          <cx:pt idx="805">3.5457399999999999</cx:pt>
          <cx:pt idx="806">2.4883000000000002</cx:pt>
          <cx:pt idx="807">3.71462</cx:pt>
          <cx:pt idx="808">2.5133399999999999</cx:pt>
          <cx:pt idx="809">3.3662100000000001</cx:pt>
          <cx:pt idx="810">3.2795399999999999</cx:pt>
          <cx:pt idx="811">2.4653499999999999</cx:pt>
          <cx:pt idx="812">3.62826</cx:pt>
          <cx:pt idx="813">2.6572100000000001</cx:pt>
          <cx:pt idx="814">2.59741</cx:pt>
          <cx:pt idx="815">3.6093899999999999</cx:pt>
          <cx:pt idx="816">3.01858</cx:pt>
          <cx:pt idx="817">3.4786899999999998</cx:pt>
          <cx:pt idx="818">2.3595899999999999</cx:pt>
          <cx:pt idx="819">3.5311400000000002</cx:pt>
          <cx:pt idx="820">3.30653</cx:pt>
          <cx:pt idx="821">2.6610499999999999</cx:pt>
          <cx:pt idx="822">2.4153600000000002</cx:pt>
          <cx:pt idx="823">2.6508500000000002</cx:pt>
          <cx:pt idx="824">2.3689200000000001</cx:pt>
          <cx:pt idx="825">3.4655200000000002</cx:pt>
          <cx:pt idx="826">2.5733799999999998</cx:pt>
          <cx:pt idx="827">2.3628100000000001</cx:pt>
          <cx:pt idx="828">2.6005099999999999</cx:pt>
          <cx:pt idx="829">2.6130200000000001</cx:pt>
          <cx:pt idx="830">2.6233399999999998</cx:pt>
          <cx:pt idx="831">3.5487199999999999</cx:pt>
          <cx:pt idx="832">2.63992</cx:pt>
          <cx:pt idx="833">2.64899</cx:pt>
          <cx:pt idx="834">3.69157</cx:pt>
          <cx:pt idx="835">2.6440999999999999</cx:pt>
          <cx:pt idx="836">2.5854300000000001</cx:pt>
          <cx:pt idx="837">3.51878</cx:pt>
          <cx:pt idx="838">3.05409</cx:pt>
          <cx:pt idx="839">2.60161</cx:pt>
          <cx:pt idx="840">3.6053799999999998</cx:pt>
          <cx:pt idx="841">3.3732000000000002</cx:pt>
          <cx:pt idx="842">3.4982500000000001</cx:pt>
          <cx:pt idx="843">2.58074</cx:pt>
          <cx:pt idx="844">3.5114200000000002</cx:pt>
          <cx:pt idx="845">3.6050300000000002</cx:pt>
          <cx:pt idx="846">3.55985</cx:pt>
          <cx:pt idx="847">3.4663400000000002</cx:pt>
          <cx:pt idx="848">2.6052</cx:pt>
          <cx:pt idx="849">2.6530900000000002</cx:pt>
          <cx:pt idx="850">3.48759</cx:pt>
          <cx:pt idx="851">3.4165000000000001</cx:pt>
          <cx:pt idx="852">2.5863499999999999</cx:pt>
          <cx:pt idx="853">2.3587400000000001</cx:pt>
          <cx:pt idx="854">3.6922600000000001</cx:pt>
          <cx:pt idx="855">2.5042499999999999</cx:pt>
          <cx:pt idx="856">2.3157199999999998</cx:pt>
          <cx:pt idx="857">2.59361</cx:pt>
          <cx:pt idx="858">3.4701200000000001</cx:pt>
          <cx:pt idx="859">2.3769800000000001</cx:pt>
          <cx:pt idx="860">2.59538</cx:pt>
          <cx:pt idx="861">2.4506299999999999</cx:pt>
          <cx:pt idx="862">2.6404299999999998</cx:pt>
          <cx:pt idx="863">3.4553799999999999</cx:pt>
          <cx:pt idx="864">2.4972099999999999</cx:pt>
          <cx:pt idx="865">2.32315</cx:pt>
          <cx:pt idx="866">2.3462700000000001</cx:pt>
          <cx:pt idx="867">2.6422300000000001</cx:pt>
          <cx:pt idx="868">2.65273</cx:pt>
          <cx:pt idx="869">2.5771000000000002</cx:pt>
          <cx:pt idx="870">2.48637</cx:pt>
          <cx:pt idx="871">2.6072099999999998</cx:pt>
          <cx:pt idx="872">2.6030500000000001</cx:pt>
          <cx:pt idx="873">2.5928499999999999</cx:pt>
          <cx:pt idx="874">3.4759000000000002</cx:pt>
          <cx:pt idx="875">2.6547999999999998</cx:pt>
          <cx:pt idx="876">3.5691899999999999</cx:pt>
          <cx:pt idx="877">2.5888800000000001</cx:pt>
          <cx:pt idx="878">2.42611</cx:pt>
          <cx:pt idx="879">2.5821900000000002</cx:pt>
          <cx:pt idx="880">2.3577400000000002</cx:pt>
          <cx:pt idx="881">3.7216399999999998</cx:pt>
          <cx:pt idx="882">3.41411</cx:pt>
          <cx:pt idx="883">3.7142300000000001</cx:pt>
          <cx:pt idx="884">2.4983200000000001</cx:pt>
          <cx:pt idx="885">2.6498300000000001</cx:pt>
          <cx:pt idx="886">2.6626400000000001</cx:pt>
          <cx:pt idx="887">3.2764099999999998</cx:pt>
          <cx:pt idx="888">2.2846600000000001</cx:pt>
          <cx:pt idx="889">3.5518200000000002</cx:pt>
          <cx:pt idx="890">3.54813</cx:pt>
          <cx:pt idx="891">2.4883899999999999</cx:pt>
          <cx:pt idx="892">3.4334600000000002</cx:pt>
          <cx:pt idx="893">3.43615</cx:pt>
          <cx:pt idx="894">3.5160399999999998</cx:pt>
          <cx:pt idx="895">2.5966900000000002</cx:pt>
          <cx:pt idx="896">3.4331999999999998</cx:pt>
          <cx:pt idx="897">3.5891700000000002</cx:pt>
          <cx:pt idx="898">2.59388</cx:pt>
          <cx:pt idx="899">3.0173199999999998</cx:pt>
          <cx:pt idx="900">2.62127</cx:pt>
          <cx:pt idx="901">2.6440000000000001</cx:pt>
          <cx:pt idx="902">2.4835600000000002</cx:pt>
          <cx:pt idx="903">3.2195200000000002</cx:pt>
          <cx:pt idx="904">2.6510899999999999</cx:pt>
          <cx:pt idx="905">2.6496300000000002</cx:pt>
          <cx:pt idx="906">2.6107300000000002</cx:pt>
          <cx:pt idx="907">2.6374900000000001</cx:pt>
          <cx:pt idx="908">3.6579100000000002</cx:pt>
          <cx:pt idx="909">2.65768</cx:pt>
          <cx:pt idx="910">2.60236</cx:pt>
          <cx:pt idx="911">3.50563</cx:pt>
          <cx:pt idx="912">2.6101399999999999</cx:pt>
          <cx:pt idx="913">2.5704099999999999</cx:pt>
          <cx:pt idx="914">3.4461599999999999</cx:pt>
          <cx:pt idx="915">3.7028300000000001</cx:pt>
          <cx:pt idx="916">3.4796100000000001</cx:pt>
          <cx:pt idx="917">3.6634000000000002</cx:pt>
          <cx:pt idx="918">3.6091600000000001</cx:pt>
          <cx:pt idx="919">3.5536500000000002</cx:pt>
          <cx:pt idx="920">2.6694599999999999</cx:pt>
          <cx:pt idx="921">2.6247500000000001</cx:pt>
          <cx:pt idx="922">2.6012900000000001</cx:pt>
          <cx:pt idx="923">3.43425</cx:pt>
          <cx:pt idx="924">3.5748099999999998</cx:pt>
          <cx:pt idx="925">2.92075</cx:pt>
          <cx:pt idx="926">2.5915300000000001</cx:pt>
          <cx:pt idx="927">3.2488700000000001</cx:pt>
          <cx:pt idx="928">2.6089799999999999</cx:pt>
          <cx:pt idx="929">3.66134</cx:pt>
          <cx:pt idx="930">3.4333800000000001</cx:pt>
          <cx:pt idx="931">3.3285999999999998</cx:pt>
          <cx:pt idx="932">2.6406499999999999</cx:pt>
          <cx:pt idx="933">3.6724800000000002</cx:pt>
          <cx:pt idx="934">2.63537</cx:pt>
          <cx:pt idx="935">3.5249799999999998</cx:pt>
          <cx:pt idx="936">2.6040100000000002</cx:pt>
          <cx:pt idx="937">2.6549499999999999</cx:pt>
          <cx:pt idx="938">2.6065299999999998</cx:pt>
          <cx:pt idx="939">3.3280799999999999</cx:pt>
          <cx:pt idx="940">3.4114</cx:pt>
          <cx:pt idx="941">2.7448000000000001</cx:pt>
          <cx:pt idx="942">2.3386100000000001</cx:pt>
          <cx:pt idx="943">2.63585</cx:pt>
          <cx:pt idx="944">3.4949499999999998</cx:pt>
          <cx:pt idx="945">2.5846300000000002</cx:pt>
          <cx:pt idx="946">2.59789</cx:pt>
          <cx:pt idx="947">3.8290999999999999</cx:pt>
          <cx:pt idx="948">2.6589299999999998</cx:pt>
          <cx:pt idx="949">3.3703699999999999</cx:pt>
          <cx:pt idx="950">2.8636499999999998</cx:pt>
          <cx:pt idx="951">2.9167000000000001</cx:pt>
          <cx:pt idx="952">2.5969000000000002</cx:pt>
          <cx:pt idx="953">3.42604</cx:pt>
          <cx:pt idx="954">3.12378</cx:pt>
          <cx:pt idx="955">3.3063400000000001</cx:pt>
          <cx:pt idx="956">2.4329299999999998</cx:pt>
          <cx:pt idx="957">2.5904699999999998</cx:pt>
          <cx:pt idx="958">3.62696</cx:pt>
          <cx:pt idx="959">2.6664699999999999</cx:pt>
          <cx:pt idx="960">3.56541</cx:pt>
          <cx:pt idx="961">2.6291899999999999</cx:pt>
          <cx:pt idx="962">2.5240300000000002</cx:pt>
          <cx:pt idx="963">3.5766800000000001</cx:pt>
          <cx:pt idx="964">3.6083699999999999</cx:pt>
          <cx:pt idx="965">3.5209800000000002</cx:pt>
          <cx:pt idx="966">3.6469299999999998</cx:pt>
          <cx:pt idx="967">2.37974</cx:pt>
          <cx:pt idx="968">2.5958000000000001</cx:pt>
          <cx:pt idx="969">2.3629600000000002</cx:pt>
          <cx:pt idx="970">2.3619599999999998</cx:pt>
          <cx:pt idx="971">3.4724200000000001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sz="20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200" b="0" i="0" u="none" strike="noStrike" baseline="0" dirty="0" err="1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in,chronic</a:t>
            </a:r>
            <a:endParaRPr lang="ja-JP" altLang="en-US" sz="1200" b="0" i="0" u="none" strike="noStrike" baseline="0" dirty="0">
              <a:solidFill>
                <a:sysClr val="windowText" lastClr="000000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cx:rich>
      </cx:tx>
    </cx:title>
    <cx:plotArea>
      <cx:plotAreaRegion>
        <cx:series layoutId="clusteredColumn" uniqueId="{D2F9A502-9B59-4239-A9E8-61EEE2C9C76E}">
          <cx:tx>
            <cx:txData>
              <cx:f>'PD chronic'!$G$1</cx:f>
              <cx:v>tvKin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Count val="10"/>
            </cx:binning>
          </cx:layoutPr>
        </cx:series>
      </cx:plotAreaRegion>
      <cx:axis id="0">
        <cx:catScaling gapWidth="0"/>
        <cx:tickLabels/>
        <cx:numFmt formatCode="#,##0.0_);[赤](#,##0.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16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PD chronic'!$H$2:$H$1001</cx:f>
        <cx:lvl ptCount="1000" formatCode="G/標準">
          <cx:pt idx="0">167.43799999999999</cx:pt>
          <cx:pt idx="1">166.93899999999999</cx:pt>
          <cx:pt idx="2">167.63800000000001</cx:pt>
          <cx:pt idx="3">129.17400000000001</cx:pt>
          <cx:pt idx="4">167.94499999999999</cx:pt>
          <cx:pt idx="5">32.187600000000003</cx:pt>
          <cx:pt idx="6">32.768900000000002</cx:pt>
          <cx:pt idx="7">122.05</cx:pt>
          <cx:pt idx="8">167.74299999999999</cx:pt>
          <cx:pt idx="9">73.238500000000002</cx:pt>
          <cx:pt idx="10">82.954499999999996</cx:pt>
          <cx:pt idx="11">33.5501</cx:pt>
          <cx:pt idx="12">30.1936</cx:pt>
          <cx:pt idx="13">163.56700000000001</cx:pt>
          <cx:pt idx="14">167.98500000000001</cx:pt>
          <cx:pt idx="15">167.33600000000001</cx:pt>
          <cx:pt idx="16">36.656199999999998</cx:pt>
          <cx:pt idx="17">113.53100000000001</cx:pt>
          <cx:pt idx="18">33.564500000000002</cx:pt>
          <cx:pt idx="19">166.27600000000001</cx:pt>
          <cx:pt idx="20">32.698799999999999</cx:pt>
          <cx:pt idx="21">32.259</cx:pt>
          <cx:pt idx="22">31.238800000000001</cx:pt>
          <cx:pt idx="23">169.273</cx:pt>
          <cx:pt idx="24">129.44200000000001</cx:pt>
          <cx:pt idx="25">168.75299999999999</cx:pt>
          <cx:pt idx="26">159.49000000000001</cx:pt>
          <cx:pt idx="27">160.85499999999999</cx:pt>
          <cx:pt idx="28">169.66</cx:pt>
          <cx:pt idx="29">115.746</cx:pt>
          <cx:pt idx="30">31.9847</cx:pt>
          <cx:pt idx="31">166.27199999999999</cx:pt>
          <cx:pt idx="32">30.3523</cx:pt>
          <cx:pt idx="33">168.77799999999999</cx:pt>
          <cx:pt idx="34">167.56999999999999</cx:pt>
          <cx:pt idx="35">166.578</cx:pt>
          <cx:pt idx="36">65.805800000000005</cx:pt>
          <cx:pt idx="37">114.14100000000001</cx:pt>
          <cx:pt idx="38">169.16</cx:pt>
          <cx:pt idx="39">164.578</cx:pt>
          <cx:pt idx="40">30.744399999999999</cx:pt>
          <cx:pt idx="41">117.07299999999999</cx:pt>
          <cx:pt idx="42">31.1633</cx:pt>
          <cx:pt idx="43">134.21799999999999</cx:pt>
          <cx:pt idx="44">165.422</cx:pt>
          <cx:pt idx="45">35.8018</cx:pt>
          <cx:pt idx="46">31.3507</cx:pt>
          <cx:pt idx="47">166.87200000000001</cx:pt>
          <cx:pt idx="48">166.74700000000001</cx:pt>
          <cx:pt idx="49">166.273</cx:pt>
          <cx:pt idx="50">168.09700000000001</cx:pt>
          <cx:pt idx="51">112.485</cx:pt>
          <cx:pt idx="52">30.897300000000001</cx:pt>
          <cx:pt idx="53">168.16900000000001</cx:pt>
          <cx:pt idx="54">159.59299999999999</cx:pt>
          <cx:pt idx="55">31.810500000000001</cx:pt>
          <cx:pt idx="56">169.303</cx:pt>
          <cx:pt idx="57">169.46600000000001</cx:pt>
          <cx:pt idx="58">31.936199999999999</cx:pt>
          <cx:pt idx="59">168.59700000000001</cx:pt>
          <cx:pt idx="60">165.499</cx:pt>
          <cx:pt idx="61">162.91499999999999</cx:pt>
          <cx:pt idx="62">165.131</cx:pt>
          <cx:pt idx="63">30.485499999999998</cx:pt>
          <cx:pt idx="64">166.93700000000001</cx:pt>
          <cx:pt idx="65">164.596</cx:pt>
          <cx:pt idx="66">164.06800000000001</cx:pt>
          <cx:pt idx="67">32.500700000000002</cx:pt>
          <cx:pt idx="68">31.4177</cx:pt>
          <cx:pt idx="69">169.06399999999999</cx:pt>
          <cx:pt idx="70">160.661</cx:pt>
          <cx:pt idx="71">33.101700000000001</cx:pt>
          <cx:pt idx="72">31.2911</cx:pt>
          <cx:pt idx="73">30.5411</cx:pt>
          <cx:pt idx="74">32.475299999999997</cx:pt>
          <cx:pt idx="75">168.30699999999999</cx:pt>
          <cx:pt idx="76">29.764399999999998</cx:pt>
          <cx:pt idx="77">33.177700000000002</cx:pt>
          <cx:pt idx="78">169.399</cx:pt>
          <cx:pt idx="79">159.86600000000001</cx:pt>
          <cx:pt idx="80">105.84</cx:pt>
          <cx:pt idx="81">41.868299999999998</cx:pt>
          <cx:pt idx="82">32.358699999999999</cx:pt>
          <cx:pt idx="83">167.25299999999999</cx:pt>
          <cx:pt idx="84">32.6158</cx:pt>
          <cx:pt idx="85">165.24600000000001</cx:pt>
          <cx:pt idx="86">161.55099999999999</cx:pt>
          <cx:pt idx="87">101.73999999999999</cx:pt>
          <cx:pt idx="88">167.249</cx:pt>
          <cx:pt idx="89">120.18899999999999</cx:pt>
          <cx:pt idx="90">168.15299999999999</cx:pt>
          <cx:pt idx="91">32.7806</cx:pt>
          <cx:pt idx="92">159.673</cx:pt>
          <cx:pt idx="93">114.85899999999999</cx:pt>
          <cx:pt idx="94">168.19999999999999</cx:pt>
          <cx:pt idx="95">166.607</cx:pt>
          <cx:pt idx="96">165.488</cx:pt>
          <cx:pt idx="97">164.42599999999999</cx:pt>
          <cx:pt idx="98">166.47</cx:pt>
          <cx:pt idx="99">167.53100000000001</cx:pt>
          <cx:pt idx="100">160.18100000000001</cx:pt>
          <cx:pt idx="101">167.75899999999999</cx:pt>
          <cx:pt idx="102">159.54599999999999</cx:pt>
          <cx:pt idx="103">164.81</cx:pt>
          <cx:pt idx="104">167.23699999999999</cx:pt>
          <cx:pt idx="105">169.37700000000001</cx:pt>
          <cx:pt idx="106">164.05000000000001</cx:pt>
          <cx:pt idx="107">111.523</cx:pt>
          <cx:pt idx="108">32.3337</cx:pt>
          <cx:pt idx="109">29.6602</cx:pt>
          <cx:pt idx="110">166.751</cx:pt>
          <cx:pt idx="111">166.625</cx:pt>
          <cx:pt idx="112">31.2821</cx:pt>
          <cx:pt idx="113">168.76300000000001</cx:pt>
          <cx:pt idx="114">32.411499999999997</cx:pt>
          <cx:pt idx="115">167.66399999999999</cx:pt>
          <cx:pt idx="116">31.197199999999999</cx:pt>
          <cx:pt idx="117">27.645600000000002</cx:pt>
          <cx:pt idx="118">164.31700000000001</cx:pt>
          <cx:pt idx="119">165.37700000000001</cx:pt>
          <cx:pt idx="120">166.69800000000001</cx:pt>
          <cx:pt idx="121">167.99799999999999</cx:pt>
          <cx:pt idx="122">108.68899999999999</cx:pt>
          <cx:pt idx="123">167.70099999999999</cx:pt>
          <cx:pt idx="124">106.93899999999999</cx:pt>
          <cx:pt idx="125">156.62799999999999</cx:pt>
          <cx:pt idx="126">31.183</cx:pt>
          <cx:pt idx="127">157.46899999999999</cx:pt>
          <cx:pt idx="128">167.232</cx:pt>
          <cx:pt idx="129">158.47499999999999</cx:pt>
          <cx:pt idx="130">30.151499999999999</cx:pt>
          <cx:pt idx="131">163.30099999999999</cx:pt>
          <cx:pt idx="132">35.892600000000002</cx:pt>
          <cx:pt idx="133">164.72300000000001</cx:pt>
          <cx:pt idx="134">32.584000000000003</cx:pt>
          <cx:pt idx="135">164.51900000000001</cx:pt>
          <cx:pt idx="136">117.254</cx:pt>
          <cx:pt idx="137">177.83099999999999</cx:pt>
          <cx:pt idx="138">160.50299999999999</cx:pt>
          <cx:pt idx="139">168.65100000000001</cx:pt>
          <cx:pt idx="140">115.95099999999999</cx:pt>
          <cx:pt idx="141">120.11199999999999</cx:pt>
          <cx:pt idx="142">166.15199999999999</cx:pt>
          <cx:pt idx="143">167.66800000000001</cx:pt>
          <cx:pt idx="144">166.41900000000001</cx:pt>
          <cx:pt idx="145">168.46799999999999</cx:pt>
          <cx:pt idx="146">167.64599999999999</cx:pt>
          <cx:pt idx="147">163.86500000000001</cx:pt>
          <cx:pt idx="148">35.1584</cx:pt>
          <cx:pt idx="149">169.69800000000001</cx:pt>
          <cx:pt idx="150">30.828399999999998</cx:pt>
          <cx:pt idx="151">165.66300000000001</cx:pt>
          <cx:pt idx="152">161.577</cx:pt>
          <cx:pt idx="153">31.215399999999999</cx:pt>
          <cx:pt idx="154">32.864600000000003</cx:pt>
          <cx:pt idx="155">32.833199999999998</cx:pt>
          <cx:pt idx="156">168.01900000000001</cx:pt>
          <cx:pt idx="157">165.53</cx:pt>
          <cx:pt idx="158">46.695300000000003</cx:pt>
          <cx:pt idx="159">168.80500000000001</cx:pt>
          <cx:pt idx="160">32.648099999999999</cx:pt>
          <cx:pt idx="161">168.50399999999999</cx:pt>
          <cx:pt idx="162">161.339</cx:pt>
          <cx:pt idx="163">170.30699999999999</cx:pt>
          <cx:pt idx="164">103.914</cx:pt>
          <cx:pt idx="165">33.525500000000001</cx:pt>
          <cx:pt idx="166">166.69399999999999</cx:pt>
          <cx:pt idx="167">31.743500000000001</cx:pt>
          <cx:pt idx="168">168.465</cx:pt>
          <cx:pt idx="169">37.793700000000001</cx:pt>
          <cx:pt idx="170">32.312399999999997</cx:pt>
          <cx:pt idx="171">30.6555</cx:pt>
          <cx:pt idx="172">32.022599999999997</cx:pt>
          <cx:pt idx="173">159.02699999999999</cx:pt>
          <cx:pt idx="174">84.685400000000001</cx:pt>
          <cx:pt idx="175">163.68100000000001</cx:pt>
          <cx:pt idx="176">167.84700000000001</cx:pt>
          <cx:pt idx="177">32.594200000000001</cx:pt>
          <cx:pt idx="178">166.71000000000001</cx:pt>
          <cx:pt idx="179">161.268</cx:pt>
          <cx:pt idx="180">116.56</cx:pt>
          <cx:pt idx="181">122.292</cx:pt>
          <cx:pt idx="182">108.193</cx:pt>
          <cx:pt idx="183">71.654799999999994</cx:pt>
          <cx:pt idx="184">159.70500000000001</cx:pt>
          <cx:pt idx="185">162.22</cx:pt>
          <cx:pt idx="186">31.8735</cx:pt>
          <cx:pt idx="187">29.545300000000001</cx:pt>
          <cx:pt idx="188">115.075</cx:pt>
          <cx:pt idx="189">132.542</cx:pt>
          <cx:pt idx="190">167.59200000000001</cx:pt>
          <cx:pt idx="191">168.19800000000001</cx:pt>
          <cx:pt idx="192">30.487200000000001</cx:pt>
          <cx:pt idx="193">30.207999999999998</cx:pt>
          <cx:pt idx="194">148.24199999999999</cx:pt>
          <cx:pt idx="195">33.816499999999998</cx:pt>
          <cx:pt idx="196">31.0456</cx:pt>
          <cx:pt idx="197">159.08799999999999</cx:pt>
          <cx:pt idx="198">30.467700000000001</cx:pt>
          <cx:pt idx="199">168.577</cx:pt>
          <cx:pt idx="200">166.114</cx:pt>
          <cx:pt idx="201">162.34999999999999</cx:pt>
          <cx:pt idx="202">168.321</cx:pt>
          <cx:pt idx="203">164.38399999999999</cx:pt>
          <cx:pt idx="204">110.992</cx:pt>
          <cx:pt idx="205">30.427199999999999</cx:pt>
          <cx:pt idx="206">32.102600000000002</cx:pt>
          <cx:pt idx="207">177.50899999999999</cx:pt>
          <cx:pt idx="208">164.44800000000001</cx:pt>
          <cx:pt idx="209">164.27500000000001</cx:pt>
          <cx:pt idx="210">168.102</cx:pt>
          <cx:pt idx="211">167.679</cx:pt>
          <cx:pt idx="212">128.953</cx:pt>
          <cx:pt idx="213">167.45400000000001</cx:pt>
          <cx:pt idx="214">168.90700000000001</cx:pt>
          <cx:pt idx="215">31.963100000000001</cx:pt>
          <cx:pt idx="216">32.663800000000002</cx:pt>
          <cx:pt idx="217">168.21299999999999</cx:pt>
          <cx:pt idx="218">159.62700000000001</cx:pt>
          <cx:pt idx="219">167.89099999999999</cx:pt>
          <cx:pt idx="220">59.629100000000001</cx:pt>
          <cx:pt idx="221">162.56999999999999</cx:pt>
          <cx:pt idx="222">121.389</cx:pt>
          <cx:pt idx="223">161.41499999999999</cx:pt>
          <cx:pt idx="224">32.654499999999999</cx:pt>
          <cx:pt idx="225">166.99600000000001</cx:pt>
          <cx:pt idx="226">31.8064</cx:pt>
          <cx:pt idx="227">38.086599999999997</cx:pt>
          <cx:pt idx="228">30.073499999999999</cx:pt>
          <cx:pt idx="229">166.80699999999999</cx:pt>
          <cx:pt idx="230">165.721</cx:pt>
          <cx:pt idx="231">168.86699999999999</cx:pt>
          <cx:pt idx="232">116.47</cx:pt>
          <cx:pt idx="233">166.55000000000001</cx:pt>
          <cx:pt idx="234">70.726699999999994</cx:pt>
          <cx:pt idx="235">163.33099999999999</cx:pt>
          <cx:pt idx="236">30.972200000000001</cx:pt>
          <cx:pt idx="237">123.42400000000001</cx:pt>
          <cx:pt idx="238">168.65199999999999</cx:pt>
          <cx:pt idx="239">160.179</cx:pt>
          <cx:pt idx="240">120.319</cx:pt>
          <cx:pt idx="241">167.74000000000001</cx:pt>
          <cx:pt idx="242">166.755</cx:pt>
          <cx:pt idx="243">115.25700000000001</cx:pt>
          <cx:pt idx="244">102.22799999999999</cx:pt>
          <cx:pt idx="245">168.55600000000001</cx:pt>
          <cx:pt idx="246">162.667</cx:pt>
          <cx:pt idx="247">31.349299999999999</cx:pt>
          <cx:pt idx="248">31.246500000000001</cx:pt>
          <cx:pt idx="249">119.295</cx:pt>
          <cx:pt idx="250">167.06100000000001</cx:pt>
          <cx:pt idx="251">164.07400000000001</cx:pt>
          <cx:pt idx="252">133.05199999999999</cx:pt>
          <cx:pt idx="253">32.902700000000003</cx:pt>
          <cx:pt idx="254">167.142</cx:pt>
          <cx:pt idx="255">164.79400000000001</cx:pt>
          <cx:pt idx="256">29.7683</cx:pt>
          <cx:pt idx="257">33.015000000000001</cx:pt>
          <cx:pt idx="258">33.699800000000003</cx:pt>
          <cx:pt idx="259">31.415400000000002</cx:pt>
          <cx:pt idx="260">168.994</cx:pt>
          <cx:pt idx="261">124.61799999999999</cx:pt>
          <cx:pt idx="262">34.1845</cx:pt>
          <cx:pt idx="263">168.875</cx:pt>
          <cx:pt idx="264">166.21000000000001</cx:pt>
          <cx:pt idx="265">167.74799999999999</cx:pt>
          <cx:pt idx="266">166.24799999999999</cx:pt>
          <cx:pt idx="267">167.583</cx:pt>
          <cx:pt idx="268">163.251</cx:pt>
          <cx:pt idx="269">30.4757</cx:pt>
          <cx:pt idx="270">92.731999999999999</cx:pt>
          <cx:pt idx="271">168.55000000000001</cx:pt>
          <cx:pt idx="272">122.473</cx:pt>
          <cx:pt idx="273">168.21799999999999</cx:pt>
          <cx:pt idx="274">32.571599999999997</cx:pt>
          <cx:pt idx="275">166.018</cx:pt>
          <cx:pt idx="276">166.93899999999999</cx:pt>
          <cx:pt idx="277">31.382200000000001</cx:pt>
          <cx:pt idx="278">166.80699999999999</cx:pt>
          <cx:pt idx="279">161.268</cx:pt>
          <cx:pt idx="280">30.830300000000001</cx:pt>
          <cx:pt idx="281">167.786</cx:pt>
          <cx:pt idx="282">30.849599999999999</cx:pt>
          <cx:pt idx="283">117.586</cx:pt>
          <cx:pt idx="284">31.665500000000002</cx:pt>
          <cx:pt idx="285">121.538</cx:pt>
          <cx:pt idx="286">31.6829</cx:pt>
          <cx:pt idx="287">153.40100000000001</cx:pt>
          <cx:pt idx="288">30.956399999999999</cx:pt>
          <cx:pt idx="289">165.01400000000001</cx:pt>
          <cx:pt idx="290">113.991</cx:pt>
          <cx:pt idx="291">164.94499999999999</cx:pt>
          <cx:pt idx="292">166.03700000000001</cx:pt>
          <cx:pt idx="293">32.856900000000003</cx:pt>
          <cx:pt idx="294">164.07400000000001</cx:pt>
          <cx:pt idx="295">166.41</cx:pt>
          <cx:pt idx="296">32.179099999999998</cx:pt>
          <cx:pt idx="297">32.933799999999998</cx:pt>
          <cx:pt idx="298">30.078900000000001</cx:pt>
          <cx:pt idx="299">30.917200000000001</cx:pt>
          <cx:pt idx="300">167.577</cx:pt>
          <cx:pt idx="301">166.79499999999999</cx:pt>
          <cx:pt idx="302">166.55500000000001</cx:pt>
          <cx:pt idx="303">162.179</cx:pt>
          <cx:pt idx="304">32.773800000000001</cx:pt>
          <cx:pt idx="305">165.50399999999999</cx:pt>
          <cx:pt idx="306">30.607600000000001</cx:pt>
          <cx:pt idx="307">166.63499999999999</cx:pt>
          <cx:pt idx="308">167.566</cx:pt>
          <cx:pt idx="309">167.53100000000001</cx:pt>
          <cx:pt idx="310">159.82400000000001</cx:pt>
          <cx:pt idx="311">159.386</cx:pt>
          <cx:pt idx="312">33.442900000000002</cx:pt>
          <cx:pt idx="313">166.773</cx:pt>
          <cx:pt idx="314">29.3995</cx:pt>
          <cx:pt idx="315">32.882800000000003</cx:pt>
          <cx:pt idx="316">168.733</cx:pt>
          <cx:pt idx="317">160.934</cx:pt>
          <cx:pt idx="318">33.874299999999998</cx:pt>
          <cx:pt idx="319">84.476799999999997</cx:pt>
          <cx:pt idx="320">123.295</cx:pt>
          <cx:pt idx="321">167.208</cx:pt>
          <cx:pt idx="322">110.604</cx:pt>
          <cx:pt idx="323">30.705400000000001</cx:pt>
          <cx:pt idx="324">168.458</cx:pt>
          <cx:pt idx="325">164.47</cx:pt>
          <cx:pt idx="326">167.43299999999999</cx:pt>
          <cx:pt idx="327">164.89400000000001</cx:pt>
          <cx:pt idx="328">32.370199999999997</cx:pt>
          <cx:pt idx="329">33.384900000000002</cx:pt>
          <cx:pt idx="330">166.88</cx:pt>
          <cx:pt idx="331">165.67599999999999</cx:pt>
          <cx:pt idx="332">33.442900000000002</cx:pt>
          <cx:pt idx="333">121.771</cx:pt>
          <cx:pt idx="334">28.709199999999999</cx:pt>
          <cx:pt idx="335">167.417</cx:pt>
          <cx:pt idx="336">212.22499999999999</cx:pt>
          <cx:pt idx="337">119.65900000000001</cx:pt>
          <cx:pt idx="338">30.958300000000001</cx:pt>
          <cx:pt idx="339">169.34999999999999</cx:pt>
          <cx:pt idx="340">166.58799999999999</cx:pt>
          <cx:pt idx="341">167.15299999999999</cx:pt>
          <cx:pt idx="342">115.235</cx:pt>
          <cx:pt idx="343">160.74000000000001</cx:pt>
          <cx:pt idx="344">62.291800000000002</cx:pt>
          <cx:pt idx="345">163.727</cx:pt>
          <cx:pt idx="346">165.47800000000001</cx:pt>
          <cx:pt idx="347">120.617</cx:pt>
          <cx:pt idx="348">118.93300000000001</cx:pt>
          <cx:pt idx="349">31.3278</cx:pt>
          <cx:pt idx="350">32.4771</cx:pt>
          <cx:pt idx="351">98.769400000000005</cx:pt>
          <cx:pt idx="352">116.367</cx:pt>
          <cx:pt idx="353">168.059</cx:pt>
          <cx:pt idx="354">169.96799999999999</cx:pt>
          <cx:pt idx="355">29.782399999999999</cx:pt>
          <cx:pt idx="356">100.31999999999999</cx:pt>
          <cx:pt idx="357">30.230399999999999</cx:pt>
          <cx:pt idx="358">166.45500000000001</cx:pt>
          <cx:pt idx="359">32.666499999999999</cx:pt>
          <cx:pt idx="360">29.7318</cx:pt>
          <cx:pt idx="361">168.315</cx:pt>
          <cx:pt idx="362">167.63499999999999</cx:pt>
          <cx:pt idx="363">168.887</cx:pt>
          <cx:pt idx="364">32.930100000000003</cx:pt>
          <cx:pt idx="365">31.338799999999999</cx:pt>
          <cx:pt idx="366">33.780299999999997</cx:pt>
          <cx:pt idx="367">166.64099999999999</cx:pt>
          <cx:pt idx="368">119.27800000000001</cx:pt>
          <cx:pt idx="369">164.261</cx:pt>
          <cx:pt idx="370">168.19300000000001</cx:pt>
          <cx:pt idx="371">32.968400000000003</cx:pt>
          <cx:pt idx="372">120.06100000000001</cx:pt>
          <cx:pt idx="373">164.202</cx:pt>
          <cx:pt idx="374">163.541</cx:pt>
          <cx:pt idx="375">167.06700000000001</cx:pt>
          <cx:pt idx="376">31.296600000000002</cx:pt>
          <cx:pt idx="377">33.3675</cx:pt>
          <cx:pt idx="378">33.725299999999997</cx:pt>
          <cx:pt idx="379">120.884</cx:pt>
          <cx:pt idx="380">165.93299999999999</cx:pt>
          <cx:pt idx="381">167.51599999999999</cx:pt>
          <cx:pt idx="382">132.54400000000001</cx:pt>
          <cx:pt idx="383">108.72799999999999</cx:pt>
          <cx:pt idx="384">159.55099999999999</cx:pt>
          <cx:pt idx="385">167.08699999999999</cx:pt>
          <cx:pt idx="386">166.196</cx:pt>
          <cx:pt idx="387">164.666</cx:pt>
          <cx:pt idx="388">109.491</cx:pt>
          <cx:pt idx="389">164.584</cx:pt>
          <cx:pt idx="390">32.829599999999999</cx:pt>
          <cx:pt idx="391">167.03899999999999</cx:pt>
          <cx:pt idx="392">166.541</cx:pt>
          <cx:pt idx="393">165.721</cx:pt>
          <cx:pt idx="394">165.78399999999999</cx:pt>
          <cx:pt idx="395">162.38800000000001</cx:pt>
          <cx:pt idx="396">166.84800000000001</cx:pt>
          <cx:pt idx="397">33.612000000000002</cx:pt>
          <cx:pt idx="398">127.13</cx:pt>
          <cx:pt idx="399">32.5747</cx:pt>
          <cx:pt idx="400">164.625</cx:pt>
          <cx:pt idx="401">166.93000000000001</cx:pt>
          <cx:pt idx="402">161.20500000000001</cx:pt>
          <cx:pt idx="403">167.71899999999999</cx:pt>
          <cx:pt idx="404">31.470300000000002</cx:pt>
          <cx:pt idx="405">31.218</cx:pt>
          <cx:pt idx="406">166.959</cx:pt>
          <cx:pt idx="407">32.720599999999997</cx:pt>
          <cx:pt idx="408">168.328</cx:pt>
          <cx:pt idx="409">168.44900000000001</cx:pt>
          <cx:pt idx="410">165.596</cx:pt>
          <cx:pt idx="411">32.764899999999997</cx:pt>
          <cx:pt idx="412">115.173</cx:pt>
          <cx:pt idx="413">161.755</cx:pt>
          <cx:pt idx="414">82.055000000000007</cx:pt>
          <cx:pt idx="415">31.606300000000001</cx:pt>
          <cx:pt idx="416">165.619</cx:pt>
          <cx:pt idx="417">157.989</cx:pt>
          <cx:pt idx="418">31.282499999999999</cx:pt>
          <cx:pt idx="419">169.43600000000001</cx:pt>
          <cx:pt idx="420">84.673299999999998</cx:pt>
          <cx:pt idx="421">29.903400000000001</cx:pt>
          <cx:pt idx="422">168.738</cx:pt>
          <cx:pt idx="423">167.42400000000001</cx:pt>
          <cx:pt idx="424">43.075400000000002</cx:pt>
          <cx:pt idx="425">166.55099999999999</cx:pt>
          <cx:pt idx="426">31.919699999999999</cx:pt>
          <cx:pt idx="427">168.67599999999999</cx:pt>
          <cx:pt idx="428">167.77500000000001</cx:pt>
          <cx:pt idx="429">121.093</cx:pt>
          <cx:pt idx="430">165.34800000000001</cx:pt>
          <cx:pt idx="431">167.184</cx:pt>
          <cx:pt idx="432">114.77800000000001</cx:pt>
          <cx:pt idx="433">30.814299999999999</cx:pt>
          <cx:pt idx="434">32.5246</cx:pt>
          <cx:pt idx="435">164.047</cx:pt>
          <cx:pt idx="436">32.631900000000002</cx:pt>
          <cx:pt idx="437">122.953</cx:pt>
          <cx:pt idx="438">167.03299999999999</cx:pt>
          <cx:pt idx="439">31.3843</cx:pt>
          <cx:pt idx="440">165.898</cx:pt>
          <cx:pt idx="441">165.94200000000001</cx:pt>
          <cx:pt idx="442">31.877400000000002</cx:pt>
          <cx:pt idx="443">167.90000000000001</cx:pt>
          <cx:pt idx="444">167.32900000000001</cx:pt>
          <cx:pt idx="445">129.65299999999999</cx:pt>
          <cx:pt idx="446">163.886</cx:pt>
          <cx:pt idx="447">166.95400000000001</cx:pt>
          <cx:pt idx="448">167.971</cx:pt>
          <cx:pt idx="449">31.400300000000001</cx:pt>
          <cx:pt idx="450">35.970799999999997</cx:pt>
          <cx:pt idx="451">159.601</cx:pt>
          <cx:pt idx="452">119.32299999999999</cx:pt>
          <cx:pt idx="453">167.63200000000001</cx:pt>
          <cx:pt idx="454">31.5123</cx:pt>
          <cx:pt idx="455">159.61099999999999</cx:pt>
          <cx:pt idx="456">30.791399999999999</cx:pt>
          <cx:pt idx="457">91.3613</cx:pt>
          <cx:pt idx="458">127.521</cx:pt>
          <cx:pt idx="459">164.65000000000001</cx:pt>
          <cx:pt idx="460">32.152299999999997</cx:pt>
          <cx:pt idx="461">166.66499999999999</cx:pt>
          <cx:pt idx="462">30.898399999999999</cx:pt>
          <cx:pt idx="463">115.536</cx:pt>
          <cx:pt idx="464">167.816</cx:pt>
          <cx:pt idx="465">32.465699999999998</cx:pt>
          <cx:pt idx="466">168.488</cx:pt>
          <cx:pt idx="467">165.12799999999999</cx:pt>
          <cx:pt idx="468">161.62299999999999</cx:pt>
          <cx:pt idx="469">160.36799999999999</cx:pt>
          <cx:pt idx="470">149.12200000000001</cx:pt>
          <cx:pt idx="471">163.90600000000001</cx:pt>
          <cx:pt idx="472">109.01000000000001</cx:pt>
          <cx:pt idx="473">167.04400000000001</cx:pt>
          <cx:pt idx="474">31.9755</cx:pt>
          <cx:pt idx="475">189.15299999999999</cx:pt>
          <cx:pt idx="476">168.06999999999999</cx:pt>
          <cx:pt idx="477">168.84700000000001</cx:pt>
          <cx:pt idx="478">31.603400000000001</cx:pt>
          <cx:pt idx="479">33.124600000000001</cx:pt>
          <cx:pt idx="480">118.798</cx:pt>
          <cx:pt idx="481">168.41499999999999</cx:pt>
          <cx:pt idx="482">33.0105</cx:pt>
          <cx:pt idx="483">167.39599999999999</cx:pt>
          <cx:pt idx="484">251.55199999999999</cx:pt>
          <cx:pt idx="485">159.99600000000001</cx:pt>
          <cx:pt idx="486">121.291</cx:pt>
          <cx:pt idx="487">131.29400000000001</cx:pt>
          <cx:pt idx="488">33.370600000000003</cx:pt>
          <cx:pt idx="489">32.808300000000003</cx:pt>
          <cx:pt idx="490">164.23699999999999</cx:pt>
          <cx:pt idx="491">32.394399999999997</cx:pt>
          <cx:pt idx="492">33.242699999999999</cx:pt>
          <cx:pt idx="493">32.8078</cx:pt>
          <cx:pt idx="494">31.099</cx:pt>
          <cx:pt idx="495">104.67700000000001</cx:pt>
          <cx:pt idx="496">166.53399999999999</cx:pt>
          <cx:pt idx="497">166.25299999999999</cx:pt>
          <cx:pt idx="498">163.83000000000001</cx:pt>
          <cx:pt idx="499">167.02000000000001</cx:pt>
          <cx:pt idx="500">166.11799999999999</cx:pt>
          <cx:pt idx="501">166.63900000000001</cx:pt>
          <cx:pt idx="502">33.008499999999998</cx:pt>
          <cx:pt idx="503">168.89699999999999</cx:pt>
          <cx:pt idx="504">160.52600000000001</cx:pt>
          <cx:pt idx="505">32.371299999999998</cx:pt>
          <cx:pt idx="506">166.16399999999999</cx:pt>
          <cx:pt idx="507">30.5365</cx:pt>
          <cx:pt idx="508">166.059</cx:pt>
          <cx:pt idx="509">159.589</cx:pt>
          <cx:pt idx="510">67.259900000000002</cx:pt>
          <cx:pt idx="511">165.83000000000001</cx:pt>
          <cx:pt idx="512">105.012</cx:pt>
          <cx:pt idx="513">31.508900000000001</cx:pt>
          <cx:pt idx="514">107.929</cx:pt>
          <cx:pt idx="515">33.667700000000004</cx:pt>
          <cx:pt idx="516">165.971</cx:pt>
          <cx:pt idx="517">116.19799999999999</cx:pt>
          <cx:pt idx="518">31.875599999999999</cx:pt>
          <cx:pt idx="519">163.279</cx:pt>
          <cx:pt idx="520">167.67599999999999</cx:pt>
          <cx:pt idx="521">167.83000000000001</cx:pt>
          <cx:pt idx="522">37.051000000000002</cx:pt>
          <cx:pt idx="523">128.334</cx:pt>
          <cx:pt idx="524">31.5381</cx:pt>
          <cx:pt idx="525">169.191</cx:pt>
          <cx:pt idx="526">167.423</cx:pt>
          <cx:pt idx="527">169.13499999999999</cx:pt>
          <cx:pt idx="528">169.24799999999999</cx:pt>
          <cx:pt idx="529">168.67699999999999</cx:pt>
          <cx:pt idx="530">33.3324</cx:pt>
          <cx:pt idx="531">166.858</cx:pt>
          <cx:pt idx="532">159.113</cx:pt>
          <cx:pt idx="533">167.59</cx:pt>
          <cx:pt idx="534">169.16</cx:pt>
          <cx:pt idx="535">168.435</cx:pt>
          <cx:pt idx="536">31.593499999999999</cx:pt>
          <cx:pt idx="537">115.331</cx:pt>
          <cx:pt idx="538">160.79499999999999</cx:pt>
          <cx:pt idx="539">31.0701</cx:pt>
          <cx:pt idx="540">33.365600000000001</cx:pt>
          <cx:pt idx="541">33.3977</cx:pt>
          <cx:pt idx="542">118.869</cx:pt>
          <cx:pt idx="543">169.54499999999999</cx:pt>
          <cx:pt idx="544">101.14</cx:pt>
          <cx:pt idx="545">158.006</cx:pt>
          <cx:pt idx="546">167.90600000000001</cx:pt>
          <cx:pt idx="547">166.43199999999999</cx:pt>
          <cx:pt idx="548">120.334</cx:pt>
          <cx:pt idx="549">164.75999999999999</cx:pt>
          <cx:pt idx="550">164.458</cx:pt>
          <cx:pt idx="551">30.913499999999999</cx:pt>
          <cx:pt idx="552">164.761</cx:pt>
          <cx:pt idx="553">31.947099999999999</cx:pt>
          <cx:pt idx="554">33.5961</cx:pt>
          <cx:pt idx="555">169.61500000000001</cx:pt>
          <cx:pt idx="556">37.3538</cx:pt>
          <cx:pt idx="557">32.540799999999997</cx:pt>
          <cx:pt idx="558">169.46899999999999</cx:pt>
          <cx:pt idx="559">160.035</cx:pt>
          <cx:pt idx="560">167.01300000000001</cx:pt>
          <cx:pt idx="561">119.402</cx:pt>
          <cx:pt idx="562">31.3184</cx:pt>
          <cx:pt idx="563">167.25800000000001</cx:pt>
          <cx:pt idx="564">106.497</cx:pt>
          <cx:pt idx="565">168.06800000000001</cx:pt>
          <cx:pt idx="566">105.729</cx:pt>
          <cx:pt idx="567">166.346</cx:pt>
          <cx:pt idx="568">167.34700000000001</cx:pt>
          <cx:pt idx="569">138.17500000000001</cx:pt>
          <cx:pt idx="570">167.285</cx:pt>
          <cx:pt idx="571">168.33500000000001</cx:pt>
          <cx:pt idx="572">166.02199999999999</cx:pt>
          <cx:pt idx="573">33.265799999999999</cx:pt>
          <cx:pt idx="574">166.49199999999999</cx:pt>
          <cx:pt idx="575">31.587199999999999</cx:pt>
          <cx:pt idx="576">32.128399999999999</cx:pt>
          <cx:pt idx="577">161.10400000000001</cx:pt>
          <cx:pt idx="578">165.10900000000001</cx:pt>
          <cx:pt idx="579">31.262499999999999</cx:pt>
          <cx:pt idx="580">33.232999999999997</cx:pt>
          <cx:pt idx="581">33.174500000000002</cx:pt>
          <cx:pt idx="582">161.124</cx:pt>
          <cx:pt idx="583">103.688</cx:pt>
          <cx:pt idx="584">169.00399999999999</cx:pt>
          <cx:pt idx="585">168.358</cx:pt>
          <cx:pt idx="586">168.26300000000001</cx:pt>
          <cx:pt idx="587">169.03899999999999</cx:pt>
          <cx:pt idx="588">33.9587</cx:pt>
          <cx:pt idx="589">32.652799999999999</cx:pt>
          <cx:pt idx="590">169.80600000000001</cx:pt>
          <cx:pt idx="591">169.63399999999999</cx:pt>
          <cx:pt idx="592">168.81200000000001</cx:pt>
          <cx:pt idx="593">32.722900000000003</cx:pt>
          <cx:pt idx="594">29.7334</cx:pt>
          <cx:pt idx="595">167.72499999999999</cx:pt>
          <cx:pt idx="596">30.943100000000001</cx:pt>
          <cx:pt idx="597">30.027899999999999</cx:pt>
          <cx:pt idx="598">167.76300000000001</cx:pt>
          <cx:pt idx="599">168.291</cx:pt>
          <cx:pt idx="600">32.823399999999999</cx:pt>
          <cx:pt idx="601">119.371</cx:pt>
          <cx:pt idx="602">168.142</cx:pt>
          <cx:pt idx="603">28.599499999999999</cx:pt>
          <cx:pt idx="604">103.703</cx:pt>
          <cx:pt idx="605">167.55500000000001</cx:pt>
          <cx:pt idx="606">167.67400000000001</cx:pt>
          <cx:pt idx="607">166.33500000000001</cx:pt>
          <cx:pt idx="608">32.712400000000002</cx:pt>
          <cx:pt idx="609">33.293399999999998</cx:pt>
          <cx:pt idx="610">165.94399999999999</cx:pt>
          <cx:pt idx="611">168.59700000000001</cx:pt>
          <cx:pt idx="612">108.06999999999999</cx:pt>
          <cx:pt idx="613">168.51900000000001</cx:pt>
          <cx:pt idx="614">31.369800000000001</cx:pt>
          <cx:pt idx="615">74.8977</cx:pt>
          <cx:pt idx="616">164.767</cx:pt>
          <cx:pt idx="617">163.137</cx:pt>
          <cx:pt idx="618">169.672</cx:pt>
          <cx:pt idx="619">143.64500000000001</cx:pt>
          <cx:pt idx="620">137.06</cx:pt>
          <cx:pt idx="621">167.845</cx:pt>
          <cx:pt idx="622">161.91900000000001</cx:pt>
          <cx:pt idx="623">166.57300000000001</cx:pt>
          <cx:pt idx="624">168.33799999999999</cx:pt>
          <cx:pt idx="625">116.624</cx:pt>
          <cx:pt idx="626">163.96899999999999</cx:pt>
          <cx:pt idx="627">120.577</cx:pt>
          <cx:pt idx="628">31.581499999999998</cx:pt>
          <cx:pt idx="629">33.125700000000002</cx:pt>
          <cx:pt idx="630">166.79599999999999</cx:pt>
          <cx:pt idx="631">109.261</cx:pt>
          <cx:pt idx="632">111.40600000000001</cx:pt>
          <cx:pt idx="633">166.07300000000001</cx:pt>
          <cx:pt idx="634">165.13499999999999</cx:pt>
          <cx:pt idx="635">166.61600000000001</cx:pt>
          <cx:pt idx="636">27.812799999999999</cx:pt>
          <cx:pt idx="637">165.70500000000001</cx:pt>
          <cx:pt idx="638">110.83199999999999</cx:pt>
          <cx:pt idx="639">32.186799999999998</cx:pt>
          <cx:pt idx="640">166.833</cx:pt>
          <cx:pt idx="641">30.756599999999999</cx:pt>
          <cx:pt idx="642">167.06899999999999</cx:pt>
          <cx:pt idx="643">35.722999999999999</cx:pt>
          <cx:pt idx="644">167.96700000000001</cx:pt>
          <cx:pt idx="645">111.971</cx:pt>
          <cx:pt idx="646">161.017</cx:pt>
          <cx:pt idx="647">167.78800000000001</cx:pt>
          <cx:pt idx="648">32.243400000000001</cx:pt>
          <cx:pt idx="649">120.17700000000001</cx:pt>
          <cx:pt idx="650">31.292300000000001</cx:pt>
          <cx:pt idx="651">32.427599999999998</cx:pt>
          <cx:pt idx="652">165.81999999999999</cx:pt>
          <cx:pt idx="653">31.799099999999999</cx:pt>
          <cx:pt idx="654">163.40100000000001</cx:pt>
          <cx:pt idx="655">160.20500000000001</cx:pt>
          <cx:pt idx="656">30.369299999999999</cx:pt>
          <cx:pt idx="657">32.670000000000002</cx:pt>
          <cx:pt idx="658">167.67699999999999</cx:pt>
          <cx:pt idx="659">31.349799999999998</cx:pt>
          <cx:pt idx="660">166.06299999999999</cx:pt>
          <cx:pt idx="661">165.434</cx:pt>
          <cx:pt idx="662">30.9467</cx:pt>
          <cx:pt idx="663">30.249199999999998</cx:pt>
          <cx:pt idx="664">160.52099999999999</cx:pt>
          <cx:pt idx="665">167.773</cx:pt>
          <cx:pt idx="666">168.334</cx:pt>
          <cx:pt idx="667">166.06100000000001</cx:pt>
          <cx:pt idx="668">76.561999999999998</cx:pt>
          <cx:pt idx="669">168.279</cx:pt>
          <cx:pt idx="670">158.40199999999999</cx:pt>
          <cx:pt idx="671">166.59899999999999</cx:pt>
          <cx:pt idx="672">32.164700000000003</cx:pt>
          <cx:pt idx="673">33.282899999999998</cx:pt>
          <cx:pt idx="674">31.404900000000001</cx:pt>
          <cx:pt idx="675">159.999</cx:pt>
          <cx:pt idx="676">32.371600000000001</cx:pt>
          <cx:pt idx="677">117.011</cx:pt>
          <cx:pt idx="678">30.4785</cx:pt>
          <cx:pt idx="679">165.97499999999999</cx:pt>
          <cx:pt idx="680">168.44999999999999</cx:pt>
          <cx:pt idx="681">157.90899999999999</cx:pt>
          <cx:pt idx="682">167.67099999999999</cx:pt>
          <cx:pt idx="683">158.52799999999999</cx:pt>
          <cx:pt idx="684">31.2211</cx:pt>
          <cx:pt idx="685">166.53899999999999</cx:pt>
          <cx:pt idx="686">30.710999999999999</cx:pt>
          <cx:pt idx="687">165.64400000000001</cx:pt>
          <cx:pt idx="688">165.822</cx:pt>
          <cx:pt idx="689">168.29900000000001</cx:pt>
          <cx:pt idx="690">169.011</cx:pt>
          <cx:pt idx="691">31.779699999999998</cx:pt>
          <cx:pt idx="692">168.429</cx:pt>
          <cx:pt idx="693">168.63200000000001</cx:pt>
          <cx:pt idx="694">167.381</cx:pt>
          <cx:pt idx="695">167.69800000000001</cx:pt>
          <cx:pt idx="696">30.727399999999999</cx:pt>
          <cx:pt idx="697">32.599400000000003</cx:pt>
          <cx:pt idx="698">166.28100000000001</cx:pt>
          <cx:pt idx="699">167.63800000000001</cx:pt>
          <cx:pt idx="700">113.71299999999999</cx:pt>
          <cx:pt idx="701">164.321</cx:pt>
          <cx:pt idx="702">166.732</cx:pt>
          <cx:pt idx="703">166.21199999999999</cx:pt>
          <cx:pt idx="704">31.244199999999999</cx:pt>
          <cx:pt idx="705">31.884</cx:pt>
          <cx:pt idx="706">34.302500000000002</cx:pt>
          <cx:pt idx="707">31.1098</cx:pt>
          <cx:pt idx="708">32.9129</cx:pt>
          <cx:pt idx="709">165.65299999999999</cx:pt>
          <cx:pt idx="710">33.798699999999997</cx:pt>
          <cx:pt idx="711">31.631</cx:pt>
          <cx:pt idx="712">31.766400000000001</cx:pt>
          <cx:pt idx="713">31.350300000000001</cx:pt>
          <cx:pt idx="714">105.29300000000001</cx:pt>
          <cx:pt idx="715">30.538499999999999</cx:pt>
          <cx:pt idx="716">38.381399999999999</cx:pt>
          <cx:pt idx="717">116.97</cx:pt>
          <cx:pt idx="718">166.39500000000001</cx:pt>
          <cx:pt idx="719">31.951499999999999</cx:pt>
          <cx:pt idx="720">166.59999999999999</cx:pt>
          <cx:pt idx="721">167.59999999999999</cx:pt>
          <cx:pt idx="722">122.926</cx:pt>
          <cx:pt idx="723">30.7395</cx:pt>
          <cx:pt idx="724">159.56399999999999</cx:pt>
          <cx:pt idx="725">123.937</cx:pt>
          <cx:pt idx="726">32.2119</cx:pt>
          <cx:pt idx="727">111.178</cx:pt>
          <cx:pt idx="728">97.578500000000005</cx:pt>
          <cx:pt idx="729">159.38999999999999</cx:pt>
          <cx:pt idx="730">167.34999999999999</cx:pt>
          <cx:pt idx="731">166.745</cx:pt>
          <cx:pt idx="732">166.74199999999999</cx:pt>
          <cx:pt idx="733">115.608</cx:pt>
          <cx:pt idx="734">31.611899999999999</cx:pt>
          <cx:pt idx="735">167.697</cx:pt>
          <cx:pt idx="736">168.17400000000001</cx:pt>
          <cx:pt idx="737">165.91800000000001</cx:pt>
          <cx:pt idx="738">168.78200000000001</cx:pt>
          <cx:pt idx="739">35.389699999999998</cx:pt>
          <cx:pt idx="740">167.893</cx:pt>
          <cx:pt idx="741">113.20399999999999</cx:pt>
          <cx:pt idx="742">169.08600000000001</cx:pt>
          <cx:pt idx="743">164.99799999999999</cx:pt>
          <cx:pt idx="744">125.765</cx:pt>
          <cx:pt idx="745">168.29400000000001</cx:pt>
          <cx:pt idx="746">119.53700000000001</cx:pt>
          <cx:pt idx="747">163.941</cx:pt>
          <cx:pt idx="748">31.145399999999999</cx:pt>
          <cx:pt idx="749">110.459</cx:pt>
          <cx:pt idx="750">167.68199999999999</cx:pt>
          <cx:pt idx="751">30.608599999999999</cx:pt>
          <cx:pt idx="752">32.298999999999999</cx:pt>
          <cx:pt idx="753">167.798</cx:pt>
          <cx:pt idx="754">167.42400000000001</cx:pt>
          <cx:pt idx="755">33.696199999999997</cx:pt>
          <cx:pt idx="756">166.46899999999999</cx:pt>
          <cx:pt idx="757">29.494700000000002</cx:pt>
          <cx:pt idx="758">32.432899999999997</cx:pt>
          <cx:pt idx="759">116.249</cx:pt>
          <cx:pt idx="760">33.052199999999999</cx:pt>
          <cx:pt idx="761">108.55500000000001</cx:pt>
          <cx:pt idx="762">108.45999999999999</cx:pt>
          <cx:pt idx="763">166.863</cx:pt>
          <cx:pt idx="764">165.95699999999999</cx:pt>
          <cx:pt idx="765">31.354700000000001</cx:pt>
          <cx:pt idx="766">159.24000000000001</cx:pt>
          <cx:pt idx="767">168.922</cx:pt>
          <cx:pt idx="768">168.732</cx:pt>
          <cx:pt idx="769">168.715</cx:pt>
          <cx:pt idx="770">169.18000000000001</cx:pt>
          <cx:pt idx="771">32.766800000000003</cx:pt>
          <cx:pt idx="772">165.86199999999999</cx:pt>
          <cx:pt idx="773">101.551</cx:pt>
          <cx:pt idx="774">32.809800000000003</cx:pt>
          <cx:pt idx="775">31.450399999999998</cx:pt>
          <cx:pt idx="776">32.767699999999998</cx:pt>
          <cx:pt idx="777">32.5321</cx:pt>
          <cx:pt idx="778">34.0107</cx:pt>
          <cx:pt idx="779">30.636399999999998</cx:pt>
          <cx:pt idx="780">165.68299999999999</cx:pt>
          <cx:pt idx="781">31.6797</cx:pt>
          <cx:pt idx="782">113.15000000000001</cx:pt>
          <cx:pt idx="783">165.673</cx:pt>
          <cx:pt idx="784">159.60499999999999</cx:pt>
          <cx:pt idx="785">30.637</cx:pt>
          <cx:pt idx="786">106</cx:pt>
          <cx:pt idx="787">32.240099999999998</cx:pt>
          <cx:pt idx="788">161.40299999999999</cx:pt>
          <cx:pt idx="789">166.505</cx:pt>
          <cx:pt idx="790">165.81399999999999</cx:pt>
          <cx:pt idx="791">167.78200000000001</cx:pt>
          <cx:pt idx="792">168.34100000000001</cx:pt>
          <cx:pt idx="793">160.06700000000001</cx:pt>
          <cx:pt idx="794">108.48699999999999</cx:pt>
          <cx:pt idx="795">30.483499999999999</cx:pt>
          <cx:pt idx="796">31.953099999999999</cx:pt>
          <cx:pt idx="797">161.774</cx:pt>
          <cx:pt idx="798">159.84</cx:pt>
          <cx:pt idx="799">168.89400000000001</cx:pt>
          <cx:pt idx="800">32.453800000000001</cx:pt>
          <cx:pt idx="801">30.9496</cx:pt>
          <cx:pt idx="802">168.904</cx:pt>
          <cx:pt idx="803">99.170400000000001</cx:pt>
          <cx:pt idx="804">159.48699999999999</cx:pt>
          <cx:pt idx="805">30.886700000000001</cx:pt>
          <cx:pt idx="806">163.82400000000001</cx:pt>
          <cx:pt idx="807">30.131599999999999</cx:pt>
          <cx:pt idx="808">163.52699999999999</cx:pt>
          <cx:pt idx="809">115.294</cx:pt>
          <cx:pt idx="810">28.110299999999999</cx:pt>
          <cx:pt idx="811">165.654</cx:pt>
          <cx:pt idx="812">34.911499999999997</cx:pt>
          <cx:pt idx="813">167.83099999999999</cx:pt>
          <cx:pt idx="814">166.762</cx:pt>
          <cx:pt idx="815">32.3934</cx:pt>
          <cx:pt idx="816">117.18899999999999</cx:pt>
          <cx:pt idx="817">31.979199999999999</cx:pt>
          <cx:pt idx="818">161.50399999999999</cx:pt>
          <cx:pt idx="819">31.6663</cx:pt>
          <cx:pt idx="820">112.955</cx:pt>
          <cx:pt idx="821">167.81399999999999</cx:pt>
          <cx:pt idx="822">139.71899999999999</cx:pt>
          <cx:pt idx="823">168.26300000000001</cx:pt>
          <cx:pt idx="824">158.172</cx:pt>
          <cx:pt idx="825">85.840900000000005</cx:pt>
          <cx:pt idx="826">168.67500000000001</cx:pt>
          <cx:pt idx="827">159.76400000000001</cx:pt>
          <cx:pt idx="828">166.571</cx:pt>
          <cx:pt idx="829">165.13200000000001</cx:pt>
          <cx:pt idx="830">170.32499999999999</cx:pt>
          <cx:pt idx="831">32.567300000000003</cx:pt>
          <cx:pt idx="832">168.68899999999999</cx:pt>
          <cx:pt idx="833">168.22399999999999</cx:pt>
          <cx:pt idx="834">31.554500000000001</cx:pt>
          <cx:pt idx="835">168.31700000000001</cx:pt>
          <cx:pt idx="836">168.13900000000001</cx:pt>
          <cx:pt idx="837">32.191200000000002</cx:pt>
          <cx:pt idx="838">111.90900000000001</cx:pt>
          <cx:pt idx="839">166.11699999999999</cx:pt>
          <cx:pt idx="840">31.162199999999999</cx:pt>
          <cx:pt idx="841">114.93899999999999</cx:pt>
          <cx:pt idx="842">31.399899999999999</cx:pt>
          <cx:pt idx="843">167.45599999999999</cx:pt>
          <cx:pt idx="844">30.939299999999999</cx:pt>
          <cx:pt idx="845">30.4405</cx:pt>
          <cx:pt idx="846">30.6252</cx:pt>
          <cx:pt idx="847">31.282</cx:pt>
          <cx:pt idx="848">165.96299999999999</cx:pt>
          <cx:pt idx="849">168.506</cx:pt>
          <cx:pt idx="850">115.575</cx:pt>
          <cx:pt idx="851">33.902299999999997</cx:pt>
          <cx:pt idx="852">167.56399999999999</cx:pt>
          <cx:pt idx="853">159.59399999999999</cx:pt>
          <cx:pt idx="854">29.5992</cx:pt>
          <cx:pt idx="855">162.756</cx:pt>
          <cx:pt idx="856">157.941</cx:pt>
          <cx:pt idx="857">168.041</cx:pt>
          <cx:pt idx="858">33.272300000000001</cx:pt>
          <cx:pt idx="859">160.66300000000001</cx:pt>
          <cx:pt idx="860">166.928</cx:pt>
          <cx:pt idx="861">166.36600000000001</cx:pt>
          <cx:pt idx="862">168.429</cx:pt>
          <cx:pt idx="863">32.037399999999998</cx:pt>
          <cx:pt idx="864">164.37899999999999</cx:pt>
          <cx:pt idx="865">161.965</cx:pt>
          <cx:pt idx="866">161.124</cx:pt>
          <cx:pt idx="867">168.72</cx:pt>
          <cx:pt idx="868">168.12299999999999</cx:pt>
          <cx:pt idx="869">168.79599999999999</cx:pt>
          <cx:pt idx="870">164.80699999999999</cx:pt>
          <cx:pt idx="871">165.464</cx:pt>
          <cx:pt idx="872">166.30199999999999</cx:pt>
          <cx:pt idx="873">99.9756</cx:pt>
          <cx:pt idx="874">35.684399999999997</cx:pt>
          <cx:pt idx="875">167.93000000000001</cx:pt>
          <cx:pt idx="876">31.5288</cx:pt>
          <cx:pt idx="877">167.624</cx:pt>
          <cx:pt idx="878">164.441</cx:pt>
          <cx:pt idx="879">167.77600000000001</cx:pt>
          <cx:pt idx="880">160.24299999999999</cx:pt>
          <cx:pt idx="881">33.514899999999997</cx:pt>
          <cx:pt idx="882">113.191</cx:pt>
          <cx:pt idx="883">31.5687</cx:pt>
          <cx:pt idx="884">163.429</cx:pt>
          <cx:pt idx="885">168.553</cx:pt>
          <cx:pt idx="886">167.55600000000001</cx:pt>
          <cx:pt idx="887">124.416</cx:pt>
          <cx:pt idx="888">101.274</cx:pt>
          <cx:pt idx="889">32.9938</cx:pt>
          <cx:pt idx="890">30.446000000000002</cx:pt>
          <cx:pt idx="891">164.667</cx:pt>
          <cx:pt idx="892">111.776</cx:pt>
          <cx:pt idx="893">30.7133</cx:pt>
          <cx:pt idx="894">39.029000000000003</cx:pt>
          <cx:pt idx="895">166.655</cx:pt>
          <cx:pt idx="896">31.770600000000002</cx:pt>
          <cx:pt idx="897">29.9649</cx:pt>
          <cx:pt idx="898">167.24700000000001</cx:pt>
          <cx:pt idx="899">112.54000000000001</cx:pt>
          <cx:pt idx="900">169.535</cx:pt>
          <cx:pt idx="901">168.499</cx:pt>
          <cx:pt idx="902">164.08199999999999</cx:pt>
          <cx:pt idx="903">112.679</cx:pt>
          <cx:pt idx="904">168.53200000000001</cx:pt>
          <cx:pt idx="905">168.15799999999999</cx:pt>
          <cx:pt idx="906">167.167</cx:pt>
          <cx:pt idx="907">168.38</cx:pt>
          <cx:pt idx="908">29.593299999999999</cx:pt>
          <cx:pt idx="909">168.90799999999999</cx:pt>
          <cx:pt idx="910">166.27000000000001</cx:pt>
          <cx:pt idx="911">32.964399999999998</cx:pt>
          <cx:pt idx="912">165.38300000000001</cx:pt>
          <cx:pt idx="913">169.392</cx:pt>
          <cx:pt idx="914">32.460099999999997</cx:pt>
          <cx:pt idx="915">129.74000000000001</cx:pt>
          <cx:pt idx="916">35.242400000000004</cx:pt>
          <cx:pt idx="917">30.554300000000001</cx:pt>
          <cx:pt idx="918">29.659400000000002</cx:pt>
          <cx:pt idx="919">31.587299999999999</cx:pt>
          <cx:pt idx="920">167.17400000000001</cx:pt>
          <cx:pt idx="921">169.92400000000001</cx:pt>
          <cx:pt idx="922">167.108</cx:pt>
          <cx:pt idx="923">33.105699999999999</cx:pt>
          <cx:pt idx="924">30.829599999999999</cx:pt>
          <cx:pt idx="925">124.28400000000001</cx:pt>
          <cx:pt idx="926">167.352</cx:pt>
          <cx:pt idx="927">51.748199999999997</cx:pt>
          <cx:pt idx="928">164.946</cx:pt>
          <cx:pt idx="929">32.648200000000003</cx:pt>
          <cx:pt idx="930">33.687100000000001</cx:pt>
          <cx:pt idx="931">114.27200000000001</cx:pt>
          <cx:pt idx="932">168.571</cx:pt>
          <cx:pt idx="933">28.737200000000001</cx:pt>
          <cx:pt idx="934">168.66499999999999</cx:pt>
          <cx:pt idx="935">30.947800000000001</cx:pt>
          <cx:pt idx="936">165.881</cx:pt>
          <cx:pt idx="937">167.01300000000001</cx:pt>
          <cx:pt idx="938">125.521</cx:pt>
          <cx:pt idx="939">89.382800000000003</cx:pt>
          <cx:pt idx="940">32.939</cx:pt>
          <cx:pt idx="941">123.038</cx:pt>
          <cx:pt idx="942">162.16300000000001</cx:pt>
          <cx:pt idx="943">168.77000000000001</cx:pt>
          <cx:pt idx="944">31.182300000000001</cx:pt>
          <cx:pt idx="945">167.899</cx:pt>
          <cx:pt idx="946">166.55500000000001</cx:pt>
          <cx:pt idx="947">33.0017</cx:pt>
          <cx:pt idx="948">168.03700000000001</cx:pt>
          <cx:pt idx="949">32.941200000000002</cx:pt>
          <cx:pt idx="950">124.256</cx:pt>
          <cx:pt idx="951">120.245</cx:pt>
          <cx:pt idx="952">166.65700000000001</cx:pt>
          <cx:pt idx="953">35.722299999999997</cx:pt>
          <cx:pt idx="954">112.93600000000001</cx:pt>
          <cx:pt idx="955">120.77500000000001</cx:pt>
          <cx:pt idx="956">142.755</cx:pt>
          <cx:pt idx="957">167.381</cx:pt>
          <cx:pt idx="958">123.227</cx:pt>
          <cx:pt idx="959">168.215</cx:pt>
          <cx:pt idx="960">30.4329</cx:pt>
          <cx:pt idx="961">169.708</cx:pt>
          <cx:pt idx="962">163.69399999999999</cx:pt>
          <cx:pt idx="963">33.136899999999997</cx:pt>
          <cx:pt idx="964">31.3598</cx:pt>
          <cx:pt idx="965">28.938099999999999</cx:pt>
          <cx:pt idx="966">31.0275</cx:pt>
          <cx:pt idx="967">160.315</cx:pt>
          <cx:pt idx="968">167.48699999999999</cx:pt>
          <cx:pt idx="969">161.13</cx:pt>
          <cx:pt idx="970">161.34299999999999</cx:pt>
          <cx:pt idx="971">32.533200000000001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sz="20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200" b="0" i="0" u="none" strike="noStrike" baseline="0" dirty="0" err="1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max,chronic</a:t>
            </a:r>
            <a:endParaRPr lang="ja-JP" altLang="en-US" sz="1200" b="0" i="0" u="none" strike="noStrike" baseline="0" dirty="0">
              <a:solidFill>
                <a:sysClr val="windowText" lastClr="000000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cx:rich>
      </cx:tx>
    </cx:title>
    <cx:plotArea>
      <cx:plotAreaRegion>
        <cx:series layoutId="clusteredColumn" uniqueId="{F1CA36AD-CA83-4631-AAA4-466E3FD86301}">
          <cx:tx>
            <cx:txData>
              <cx:f>'PD chronic'!$H$1</cx:f>
              <cx:v>tvEmaxp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Count val="10"/>
            </cx:binning>
          </cx:layoutPr>
        </cx:series>
      </cx:plotAreaRegion>
      <cx:axis id="0">
        <cx:catScaling gapWidth="0"/>
        <cx:tickLabels/>
        <cx:numFmt formatCode="#,##0.0_);[赤](#,##0.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17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PD chronic'!$I$2:$I$1001</cx:f>
        <cx:lvl ptCount="1000" formatCode="G/標準">
          <cx:pt idx="0">0.434672</cx:pt>
          <cx:pt idx="1">0.34803200000000001</cx:pt>
          <cx:pt idx="2">0.34708899999999998</cx:pt>
          <cx:pt idx="3">0.65573700000000001</cx:pt>
          <cx:pt idx="4">0.43399599999999999</cx:pt>
          <cx:pt idx="5">0.23960999999999999</cx:pt>
          <cx:pt idx="6">0.24007400000000001</cx:pt>
          <cx:pt idx="7">0.36171900000000001</cx:pt>
          <cx:pt idx="8">0.34510299999999999</cx:pt>
          <cx:pt idx="9">0.52929199999999998</cx:pt>
          <cx:pt idx="10">0.34608899999999998</cx:pt>
          <cx:pt idx="11">0.24906400000000001</cx:pt>
          <cx:pt idx="12">0.21560599999999999</cx:pt>
          <cx:pt idx="13">0.44203599999999998</cx:pt>
          <cx:pt idx="14">0.43473000000000001</cx:pt>
          <cx:pt idx="15">0.34669299999999997</cx:pt>
          <cx:pt idx="16">0.23783499999999999</cx:pt>
          <cx:pt idx="17">0.39002599999999998</cx:pt>
          <cx:pt idx="18">0.247062</cx:pt>
          <cx:pt idx="19">0.49474200000000002</cx:pt>
          <cx:pt idx="20">0.24565899999999999</cx:pt>
          <cx:pt idx="21">0.24126800000000001</cx:pt>
          <cx:pt idx="22">0.22891300000000001</cx:pt>
          <cx:pt idx="23">0.49149100000000001</cx:pt>
          <cx:pt idx="24">0.623367</cx:pt>
          <cx:pt idx="25">0.43205399999999999</cx:pt>
          <cx:pt idx="26">0.36540400000000001</cx:pt>
          <cx:pt idx="27">0.362786</cx:pt>
          <cx:pt idx="28">0.342615</cx:pt>
          <cx:pt idx="29">0.44595499999999999</cx:pt>
          <cx:pt idx="30">0.23345299999999999</cx:pt>
          <cx:pt idx="31">0.34992499999999999</cx:pt>
          <cx:pt idx="32">0.222688</cx:pt>
          <cx:pt idx="33">0.34222200000000003</cx:pt>
          <cx:pt idx="34">0.43297799999999997</cx:pt>
          <cx:pt idx="35">0.49560300000000002</cx:pt>
          <cx:pt idx="36">0.46030700000000002</cx:pt>
          <cx:pt idx="37">0.31905</cx:pt>
          <cx:pt idx="38">0.53257600000000005</cx:pt>
          <cx:pt idx="39">0.44085000000000002</cx:pt>
          <cx:pt idx="40">0.222526</cx:pt>
          <cx:pt idx="41">0.67708800000000002</cx:pt>
          <cx:pt idx="42">0.22592699999999999</cx:pt>
          <cx:pt idx="43">0.31425700000000001</cx:pt>
          <cx:pt idx="44">0.44431799999999999</cx:pt>
          <cx:pt idx="45">0.132385</cx:pt>
          <cx:pt idx="46">0.227018</cx:pt>
          <cx:pt idx="47">0.49536400000000003</cx:pt>
          <cx:pt idx="48">0.348242</cx:pt>
          <cx:pt idx="49">0.49598100000000001</cx:pt>
          <cx:pt idx="50">0.43483500000000003</cx:pt>
          <cx:pt idx="51">0.65565499999999999</cx:pt>
          <cx:pt idx="52">0.225326</cx:pt>
          <cx:pt idx="53">0.43259199999999998</cx:pt>
          <cx:pt idx="54">0.36723600000000001</cx:pt>
          <cx:pt idx="55">0.23674799999999999</cx:pt>
          <cx:pt idx="56">0.53171999999999997</cx:pt>
          <cx:pt idx="57">0.53004899999999999</cx:pt>
          <cx:pt idx="58">0.206763</cx:pt>
          <cx:pt idx="59">0.43361499999999997</cx:pt>
          <cx:pt idx="60">0.345136</cx:pt>
          <cx:pt idx="61">0.44908500000000001</cx:pt>
          <cx:pt idx="62">0.35041600000000001</cx:pt>
          <cx:pt idx="63">0.224518</cx:pt>
          <cx:pt idx="64">0.34782099999999999</cx:pt>
          <cx:pt idx="65">0.44274999999999998</cx:pt>
          <cx:pt idx="66">0.44465300000000002</cx:pt>
          <cx:pt idx="67">0.236871</cx:pt>
          <cx:pt idx="68">0.23333400000000001</cx:pt>
          <cx:pt idx="69">0.33832800000000002</cx:pt>
          <cx:pt idx="70">0.36232799999999998</cx:pt>
          <cx:pt idx="71">0.24720600000000001</cx:pt>
          <cx:pt idx="72">0.23509099999999999</cx:pt>
          <cx:pt idx="73">0.223028</cx:pt>
          <cx:pt idx="74">0.23874999999999999</cx:pt>
          <cx:pt idx="75">0.53311600000000003</cx:pt>
          <cx:pt idx="76">0.215361</cx:pt>
          <cx:pt idx="77">0.24631400000000001</cx:pt>
          <cx:pt idx="78">0.53156099999999995</cx:pt>
          <cx:pt idx="79">0.36154999999999998</cx:pt>
          <cx:pt idx="80">0.38629000000000002</cx:pt>
          <cx:pt idx="81">0.25823800000000002</cx:pt>
          <cx:pt idx="82">0.23907999999999999</cx:pt>
          <cx:pt idx="83">0.34731200000000001</cx:pt>
          <cx:pt idx="84">0.24512</cx:pt>
          <cx:pt idx="85">0.44166</cx:pt>
          <cx:pt idx="86">0.43433699999999997</cx:pt>
          <cx:pt idx="87">0.342754</cx:pt>
          <cx:pt idx="88">0.49174400000000001</cx:pt>
          <cx:pt idx="89">0.69396999999999998</cx:pt>
          <cx:pt idx="90">0.43530799999999997</cx:pt>
          <cx:pt idx="91">0.24376900000000001</cx:pt>
          <cx:pt idx="92">0.36531599999999997</cx:pt>
          <cx:pt idx="93">0.67147599999999996</cx:pt>
          <cx:pt idx="94">0.53180799999999995</cx:pt>
          <cx:pt idx="95">0.34783500000000001</cx:pt>
          <cx:pt idx="96">0.49402499999999999</cx:pt>
          <cx:pt idx="97">0.44704700000000003</cx:pt>
          <cx:pt idx="98">0.34655399999999997</cx:pt>
          <cx:pt idx="99">0.434896</cx:pt>
          <cx:pt idx="100">0.36392099999999999</cx:pt>
          <cx:pt idx="101">0.43450800000000001</cx:pt>
          <cx:pt idx="102">0.36081200000000002</cx:pt>
          <cx:pt idx="103">0.44406800000000002</cx:pt>
          <cx:pt idx="104">0.34803299999999998</cx:pt>
          <cx:pt idx="105">0.42991499999999999</cx:pt>
          <cx:pt idx="106">0.44734499999999999</cx:pt>
          <cx:pt idx="107">0.39744699999999999</cx:pt>
          <cx:pt idx="108">0.24290100000000001</cx:pt>
          <cx:pt idx="109">0.21410199999999999</cx:pt>
          <cx:pt idx="110">0.34269899999999998</cx:pt>
          <cx:pt idx="111">0.49585200000000001</cx:pt>
          <cx:pt idx="112">0.22350700000000001</cx:pt>
          <cx:pt idx="113">0.34222900000000001</cx:pt>
          <cx:pt idx="114">0.23911399999999999</cx:pt>
          <cx:pt idx="115">0.435</cx:pt>
          <cx:pt idx="116">0.22228300000000001</cx:pt>
          <cx:pt idx="117">0.194915</cx:pt>
          <cx:pt idx="118">0.44580599999999998</cx:pt>
          <cx:pt idx="119">0.43937300000000001</cx:pt>
          <cx:pt idx="120">0.347441</cx:pt>
          <cx:pt idx="121">0.43473099999999998</cx:pt>
          <cx:pt idx="122">0.38320599999999999</cx:pt>
          <cx:pt idx="123">0.49362099999999998</cx:pt>
          <cx:pt idx="124">0.36179699999999998</cx:pt>
          <cx:pt idx="125">0.37368600000000002</cx:pt>
          <cx:pt idx="126">0.228598</cx:pt>
          <cx:pt idx="127">0.34742400000000001</cx:pt>
          <cx:pt idx="128">0.43520799999999998</cx:pt>
          <cx:pt idx="129">0.37170500000000001</cx:pt>
          <cx:pt idx="130">0.221746</cx:pt>
          <cx:pt idx="131">0.44300600000000001</cx:pt>
          <cx:pt idx="132">0.22458800000000001</cx:pt>
          <cx:pt idx="133">0.443129</cx:pt>
          <cx:pt idx="134">0.23597199999999999</cx:pt>
          <cx:pt idx="135">0.35061199999999998</cx:pt>
          <cx:pt idx="136">0.681585</cx:pt>
          <cx:pt idx="137">0.46087</cx:pt>
          <cx:pt idx="138">0.36676500000000001</cx:pt>
          <cx:pt idx="139">0.53286500000000003</cx:pt>
          <cx:pt idx="140">0.67723</cx:pt>
          <cx:pt idx="141">0.43090000000000001</cx:pt>
          <cx:pt idx="142">0.34635199999999999</cx:pt>
          <cx:pt idx="143">0.492336</cx:pt>
          <cx:pt idx="144">0.34996300000000002</cx:pt>
          <cx:pt idx="145">0.43351000000000001</cx:pt>
          <cx:pt idx="146">0.43460799999999999</cx:pt>
          <cx:pt idx="147">0.44533600000000001</cx:pt>
          <cx:pt idx="148">0.211618</cx:pt>
          <cx:pt idx="149">0.34207500000000002</cx:pt>
          <cx:pt idx="150">0.224851</cx:pt>
          <cx:pt idx="151">0.35254600000000003</cx:pt>
          <cx:pt idx="152">0.35884700000000003</cx:pt>
          <cx:pt idx="153">0.230022</cx:pt>
          <cx:pt idx="154">0.24303</cx:pt>
          <cx:pt idx="155">0.24271899999999999</cx:pt>
          <cx:pt idx="156">0.33998</cx:pt>
          <cx:pt idx="157">0.35016999999999998</cx:pt>
          <cx:pt idx="158">0.191805</cx:pt>
          <cx:pt idx="159">0.34309800000000001</cx:pt>
          <cx:pt idx="160">0.19476099999999999</cx:pt>
          <cx:pt idx="161">0.52963800000000005</cx:pt>
          <cx:pt idx="162">0.35389300000000001</cx:pt>
          <cx:pt idx="163">0.529196</cx:pt>
          <cx:pt idx="164">0.37072300000000002</cx:pt>
          <cx:pt idx="165">0.24949299999999999</cx:pt>
          <cx:pt idx="166">0.43587999999999999</cx:pt>
          <cx:pt idx="167">0.22506699999999999</cx:pt>
          <cx:pt idx="168">0.43201600000000001</cx:pt>
          <cx:pt idx="169">0.23705100000000001</cx:pt>
          <cx:pt idx="170">0.23141300000000001</cx:pt>
          <cx:pt idx="171">0.173984</cx:pt>
          <cx:pt idx="172">0.237454</cx:pt>
          <cx:pt idx="173">0.44636999999999999</cx:pt>
          <cx:pt idx="174">0.30057</cx:pt>
          <cx:pt idx="175">0.44485999999999998</cx:pt>
          <cx:pt idx="176">0.43112499999999998</cx:pt>
          <cx:pt idx="177">0.23665</cx:pt>
          <cx:pt idx="178">0.49459999999999998</cx:pt>
          <cx:pt idx="179">0.35074899999999998</cx:pt>
          <cx:pt idx="180">0.70295200000000002</cx:pt>
          <cx:pt idx="181">0.69468399999999997</cx:pt>
          <cx:pt idx="182">0.66931099999999999</cx:pt>
          <cx:pt idx="183">0.31567699999999999</cx:pt>
          <cx:pt idx="184">0.36552899999999999</cx:pt>
          <cx:pt idx="185">0.44388899999999998</cx:pt>
          <cx:pt idx="186">0.235455</cx:pt>
          <cx:pt idx="187">0.21362100000000001</cx:pt>
          <cx:pt idx="188">0.66822700000000002</cx:pt>
          <cx:pt idx="189">0.62991799999999998</cx:pt>
          <cx:pt idx="190">0.43338700000000002</cx:pt>
          <cx:pt idx="191">0.43387999999999999</cx:pt>
          <cx:pt idx="192">0.22737299999999999</cx:pt>
          <cx:pt idx="193">0.21729499999999999</cx:pt>
          <cx:pt idx="194">0.42645300000000003</cx:pt>
          <cx:pt idx="195">0.24970000000000001</cx:pt>
          <cx:pt idx="196">0.233156</cx:pt>
          <cx:pt idx="197">0.36688199999999999</cx:pt>
          <cx:pt idx="198">0.22292200000000001</cx:pt>
          <cx:pt idx="199">0.43245499999999998</cx:pt>
          <cx:pt idx="200">0.34998499999999999</cx:pt>
          <cx:pt idx="201">0.358547</cx:pt>
          <cx:pt idx="202">0.43382700000000002</cx:pt>
          <cx:pt idx="203">0.443411</cx:pt>
          <cx:pt idx="204">0.33108100000000001</cx:pt>
          <cx:pt idx="205">0.219108</cx:pt>
          <cx:pt idx="206">0.23286399999999999</cx:pt>
          <cx:pt idx="207">0.45851599999999998</cx:pt>
          <cx:pt idx="208">0.44405</cx:pt>
          <cx:pt idx="209">0.44390299999999999</cx:pt>
          <cx:pt idx="210">0.435139</cx:pt>
          <cx:pt idx="211">0.49393300000000001</cx:pt>
          <cx:pt idx="212">0.45519700000000002</cx:pt>
          <cx:pt idx="213">0.34566200000000002</cx:pt>
          <cx:pt idx="214">0.43190600000000001</cx:pt>
          <cx:pt idx="215">0.233628</cx:pt>
          <cx:pt idx="216">0.238182</cx:pt>
          <cx:pt idx="217">0.43353599999999998</cx:pt>
          <cx:pt idx="218">0.36438799999999999</cx:pt>
          <cx:pt idx="219">0.34566599999999997</cx:pt>
          <cx:pt idx="220">0.23363300000000001</cx:pt>
          <cx:pt idx="221">0.44585599999999997</cx:pt>
          <cx:pt idx="222">0.69029399999999996</cx:pt>
          <cx:pt idx="223">0.35282000000000002</cx:pt>
          <cx:pt idx="224">0.23646</cx:pt>
          <cx:pt idx="225">0.494751</cx:pt>
          <cx:pt idx="226">0.23610900000000001</cx:pt>
          <cx:pt idx="227">0.24587400000000001</cx:pt>
          <cx:pt idx="228">0.220247</cx:pt>
          <cx:pt idx="229">0.34720400000000001</cx:pt>
          <cx:pt idx="230">0.35025200000000001</cx:pt>
          <cx:pt idx="231">0.43325999999999998</cx:pt>
          <cx:pt idx="232">0.38353500000000001</cx:pt>
          <cx:pt idx="233">0.34731800000000002</cx:pt>
          <cx:pt idx="234">0.31942500000000001</cx:pt>
          <cx:pt idx="235">0.446994</cx:pt>
          <cx:pt idx="236">0.224354</cx:pt>
          <cx:pt idx="237">0.44830900000000001</cx:pt>
          <cx:pt idx="238">0.43295099999999997</cx:pt>
          <cx:pt idx="239">0.36235600000000001</cx:pt>
          <cx:pt idx="240">0.37234800000000001</cx:pt>
          <cx:pt idx="241">0.43133500000000002</cx:pt>
          <cx:pt idx="242">0.34773599999999999</cx:pt>
          <cx:pt idx="243">0.41465999999999997</cx:pt>
          <cx:pt idx="244">0.39198699999999997</cx:pt>
          <cx:pt idx="245">0.43340600000000001</cx:pt>
          <cx:pt idx="246">0.35798799999999997</cx:pt>
          <cx:pt idx="247">0.228496</cx:pt>
          <cx:pt idx="248">0.22800200000000001</cx:pt>
          <cx:pt idx="249">0.68232400000000004</cx:pt>
          <cx:pt idx="250">0.34779500000000002</cx:pt>
          <cx:pt idx="251">0.44525100000000001</cx:pt>
          <cx:pt idx="252">0.440359</cx:pt>
          <cx:pt idx="253">0.24224699999999999</cx:pt>
          <cx:pt idx="254">0.49497999999999998</cx:pt>
          <cx:pt idx="255">0.443193</cx:pt>
          <cx:pt idx="256">0.21823200000000001</cx:pt>
          <cx:pt idx="257">0.248722</cx:pt>
          <cx:pt idx="258">0.22420699999999999</cx:pt>
          <cx:pt idx="259">0.23280100000000001</cx:pt>
          <cx:pt idx="260">0.43238199999999999</cx:pt>
          <cx:pt idx="261">0.66523200000000005</cx:pt>
          <cx:pt idx="262">0.20408799999999999</cx:pt>
          <cx:pt idx="263">0.49039199999999999</cx:pt>
          <cx:pt idx="264">0.34683999999999998</cx:pt>
          <cx:pt idx="265">0.43343599999999999</cx:pt>
          <cx:pt idx="266">0.34781499999999999</cx:pt>
          <cx:pt idx="267">0.34551199999999999</cx:pt>
          <cx:pt idx="268">0.42397099999999999</cx:pt>
          <cx:pt idx="269">0.217749</cx:pt>
          <cx:pt idx="270">0.55831299999999995</cx:pt>
          <cx:pt idx="271">0.43311699999999997</cx:pt>
          <cx:pt idx="272">0.44098700000000002</cx:pt>
          <cx:pt idx="273">0.43296800000000002</cx:pt>
          <cx:pt idx="274">0.237788</cx:pt>
          <cx:pt idx="275">0.34314099999999997</cx:pt>
          <cx:pt idx="276">0.49487900000000001</cx:pt>
          <cx:pt idx="277">0.23128399999999999</cx:pt>
          <cx:pt idx="278">0.495643</cx:pt>
          <cx:pt idx="279">0.44352599999999998</cx:pt>
          <cx:pt idx="280">0.221391</cx:pt>
          <cx:pt idx="281">0.493504</cx:pt>
          <cx:pt idx="282">0.22208</cx:pt>
          <cx:pt idx="283">0.465138</cx:pt>
          <cx:pt idx="284">0.228103</cx:pt>
          <cx:pt idx="285">0.45707300000000001</cx:pt>
          <cx:pt idx="286">0.23297000000000001</cx:pt>
          <cx:pt idx="287">0.29659099999999999</cx:pt>
          <cx:pt idx="288">0.22545499999999999</cx:pt>
          <cx:pt idx="289">0.44428800000000002</cx:pt>
          <cx:pt idx="290">0.67571199999999998</cx:pt>
          <cx:pt idx="291">0.34789500000000001</cx:pt>
          <cx:pt idx="292">0.43915799999999999</cx:pt>
          <cx:pt idx="293">0.23982999999999999</cx:pt>
          <cx:pt idx="294">0.44166299999999997</cx:pt>
          <cx:pt idx="295">0.345553</cx:pt>
          <cx:pt idx="296">0.23933699999999999</cx:pt>
          <cx:pt idx="297">0.24360399999999999</cx:pt>
          <cx:pt idx="298">0.21716299999999999</cx:pt>
          <cx:pt idx="299">0.225352</cx:pt>
          <cx:pt idx="300">0.53120500000000004</cx:pt>
          <cx:pt idx="301">0.34842000000000001</cx:pt>
          <cx:pt idx="302">0.49542999999999998</cx:pt>
          <cx:pt idx="303">0.44187599999999999</cx:pt>
          <cx:pt idx="304">0.243369</cx:pt>
          <cx:pt idx="305">0.35111900000000001</cx:pt>
          <cx:pt idx="306">0.225576</cx:pt>
          <cx:pt idx="307">0.34841100000000003</cx:pt>
          <cx:pt idx="308">0.49304599999999998</cx:pt>
          <cx:pt idx="309">0.34687400000000002</cx:pt>
          <cx:pt idx="310">0.36046</cx:pt>
          <cx:pt idx="311">0.36218400000000001</cx:pt>
          <cx:pt idx="312">0.251722</cx:pt>
          <cx:pt idx="313">0.348999</cx:pt>
          <cx:pt idx="314">0.21551200000000001</cx:pt>
          <cx:pt idx="315">0.2397</cx:pt>
          <cx:pt idx="316">0.43198399999999998</cx:pt>
          <cx:pt idx="317">0.36194900000000002</cx:pt>
          <cx:pt idx="318">0.20378099999999999</cx:pt>
          <cx:pt idx="319">0.301124</cx:pt>
          <cx:pt idx="320">0.62740899999999999</cx:pt>
          <cx:pt idx="321">0.34712199999999999</cx:pt>
          <cx:pt idx="322">0.65626600000000002</cx:pt>
          <cx:pt idx="323">0.22112000000000001</cx:pt>
          <cx:pt idx="324">0.432645</cx:pt>
          <cx:pt idx="325">0.44608900000000001</cx:pt>
          <cx:pt idx="326">0.34780699999999998</cx:pt>
          <cx:pt idx="327">0.34938200000000003</cx:pt>
          <cx:pt idx="328">0.24115300000000001</cx:pt>
          <cx:pt idx="329">0.24503</cx:pt>
          <cx:pt idx="330">0.34796500000000002</cx:pt>
          <cx:pt idx="331">0.339202</cx:pt>
          <cx:pt idx="332">0.24771000000000001</cx:pt>
          <cx:pt idx="333">0.36902299999999999</cx:pt>
          <cx:pt idx="334">0.213613</cx:pt>
          <cx:pt idx="335">0.43446400000000002</cx:pt>
          <cx:pt idx="336">0.71820099999999998</cx:pt>
          <cx:pt idx="337">0.68967699999999998</cx:pt>
          <cx:pt idx="338">0.225991</cx:pt>
          <cx:pt idx="339">0.43107800000000002</cx:pt>
          <cx:pt idx="340">0.49474600000000002</cx:pt>
          <cx:pt idx="341">0.34744000000000003</cx:pt>
          <cx:pt idx="342">0.673373</cx:pt>
          <cx:pt idx="343">0.36172199999999999</cx:pt>
          <cx:pt idx="344">0.27526099999999998</cx:pt>
          <cx:pt idx="345">0.44605600000000001</cx:pt>
          <cx:pt idx="346">0.34975400000000001</cx:pt>
          <cx:pt idx="347">0.69211</cx:pt>
          <cx:pt idx="348">0.68877500000000003</cx:pt>
          <cx:pt idx="349">0.227413</cx:pt>
          <cx:pt idx="350">0.24066699999999999</cx:pt>
          <cx:pt idx="351">0.35975800000000002</cx:pt>
          <cx:pt idx="352">0.68074599999999996</cx:pt>
          <cx:pt idx="353">0.43426399999999998</cx:pt>
          <cx:pt idx="354">0.52690999999999999</cx:pt>
          <cx:pt idx="355">0.213587</cx:pt>
          <cx:pt idx="356">0.428041</cx:pt>
          <cx:pt idx="357">0.219641</cx:pt>
          <cx:pt idx="358">0.34589599999999998</cx:pt>
          <cx:pt idx="359">0.23827000000000001</cx:pt>
          <cx:pt idx="360">0.213449</cx:pt>
          <cx:pt idx="361">0.43402200000000002</cx:pt>
          <cx:pt idx="362">0.49181200000000003</cx:pt>
          <cx:pt idx="363">0.43201699999999998</cx:pt>
          <cx:pt idx="364">0.21799499999999999</cx:pt>
          <cx:pt idx="365">0.22170300000000001</cx:pt>
          <cx:pt idx="366">0.20169799999999999</cx:pt>
          <cx:pt idx="367">0.75160899999999997</cx:pt>
          <cx:pt idx="368">0.66992200000000002</cx:pt>
          <cx:pt idx="369">0.44569399999999998</cx:pt>
          <cx:pt idx="370">0.43334899999999998</cx:pt>
          <cx:pt idx="371">0.24485100000000001</cx:pt>
          <cx:pt idx="372">0.68045199999999995</cx:pt>
          <cx:pt idx="373">0.350134</cx:pt>
          <cx:pt idx="374">0.44348700000000002</cx:pt>
          <cx:pt idx="375">0.49466599999999999</cx:pt>
          <cx:pt idx="376">0.085146899999999998</cx:pt>
          <cx:pt idx="377">0.24917600000000001</cx:pt>
          <cx:pt idx="378">0.25320999999999999</cx:pt>
          <cx:pt idx="379">0.67320500000000005</cx:pt>
          <cx:pt idx="380">0.35093000000000002</cx:pt>
          <cx:pt idx="381">0.49479499999999998</cx:pt>
          <cx:pt idx="382">0.39817900000000001</cx:pt>
          <cx:pt idx="383">0.64773999999999998</cx:pt>
          <cx:pt idx="384">0.36244900000000002</cx:pt>
          <cx:pt idx="385">0.49578100000000003</cx:pt>
          <cx:pt idx="386">0.34904299999999999</cx:pt>
          <cx:pt idx="387">0.44096099999999999</cx:pt>
          <cx:pt idx="388">0.65454199999999996</cx:pt>
          <cx:pt idx="389">0.44187199999999999</cx:pt>
          <cx:pt idx="390">0.24159700000000001</cx:pt>
          <cx:pt idx="391">0.52754400000000001</cx:pt>
          <cx:pt idx="392">0.49537500000000001</cx:pt>
          <cx:pt idx="393">0.44290099999999999</cx:pt>
          <cx:pt idx="394">0.34938599999999997</cx:pt>
          <cx:pt idx="395">0.44770199999999999</cx:pt>
          <cx:pt idx="396">0.495529</cx:pt>
          <cx:pt idx="397">0.24851599999999999</cx:pt>
          <cx:pt idx="398">0.37288900000000003</cx:pt>
          <cx:pt idx="399">0.24260699999999999</cx:pt>
          <cx:pt idx="400">0.34876600000000002</cx:pt>
          <cx:pt idx="401">0.49374499999999999</cx:pt>
          <cx:pt idx="402">0.36224800000000001</cx:pt>
          <cx:pt idx="403">0.34595300000000001</cx:pt>
          <cx:pt idx="404">0.228296</cx:pt>
          <cx:pt idx="405">0.22583300000000001</cx:pt>
          <cx:pt idx="406">0.34541699999999997</cx:pt>
          <cx:pt idx="407">0.24023900000000001</cx:pt>
          <cx:pt idx="408">0.43451299999999998</cx:pt>
          <cx:pt idx="409">0.43220700000000001</cx:pt>
          <cx:pt idx="410">0.350192</cx:pt>
          <cx:pt idx="411">0.237904</cx:pt>
          <cx:pt idx="412">0.67731300000000005</cx:pt>
          <cx:pt idx="413">0.358962</cx:pt>
          <cx:pt idx="414">0.34564499999999998</cx:pt>
          <cx:pt idx="415">0.233958</cx:pt>
          <cx:pt idx="416">0.34684599999999999</cx:pt>
          <cx:pt idx="417">0.36378500000000003</cx:pt>
          <cx:pt idx="418">0.232706</cx:pt>
          <cx:pt idx="419">0.528748</cx:pt>
          <cx:pt idx="420">0.348107</cx:pt>
          <cx:pt idx="421">0.216916</cx:pt>
          <cx:pt idx="422">0.43230499999999999</cx:pt>
          <cx:pt idx="423">0.34598499999999999</cx:pt>
          <cx:pt idx="424">0.24973799999999999</cx:pt>
          <cx:pt idx="425">0.49531700000000001</cx:pt>
          <cx:pt idx="426">0.23952599999999999</cx:pt>
          <cx:pt idx="427">0.43208099999999999</cx:pt>
          <cx:pt idx="428">0.43428099999999997</cx:pt>
          <cx:pt idx="429">0.44081700000000001</cx:pt>
          <cx:pt idx="430">0.69499999999999995</cx:pt>
          <cx:pt idx="431">0.43480799999999997</cx:pt>
          <cx:pt idx="432">0.44546400000000003</cx:pt>
          <cx:pt idx="433">0.23444799999999999</cx:pt>
          <cx:pt idx="434">0.23847099999999999</cx:pt>
          <cx:pt idx="435">0.44648500000000002</cx:pt>
          <cx:pt idx="436">0.24226300000000001</cx:pt>
          <cx:pt idx="437">0.37618200000000002</cx:pt>
          <cx:pt idx="438">0.42930000000000001</cx:pt>
          <cx:pt idx="439">0.225798</cx:pt>
          <cx:pt idx="440">0.35023199999999999</cx:pt>
          <cx:pt idx="441">0.34900700000000001</cx:pt>
          <cx:pt idx="442">0.22811999999999999</cx:pt>
          <cx:pt idx="443">0.43340099999999998</cx:pt>
          <cx:pt idx="444">0.34753699999999998</cx:pt>
          <cx:pt idx="445">0.442691</cx:pt>
          <cx:pt idx="446">0.44275599999999998</cx:pt>
          <cx:pt idx="447">0.34804000000000002</cx:pt>
          <cx:pt idx="448">0.49279400000000001</cx:pt>
          <cx:pt idx="449">0.23105300000000001</cx:pt>
          <cx:pt idx="450">0.21290000000000001</cx:pt>
          <cx:pt idx="451">0.36420999999999998</cx:pt>
          <cx:pt idx="452">0.36544900000000002</cx:pt>
          <cx:pt idx="453">0.43394500000000003</cx:pt>
          <cx:pt idx="454">0.226688</cx:pt>
          <cx:pt idx="455">0.36439899999999997</cx:pt>
          <cx:pt idx="456">0.224968</cx:pt>
          <cx:pt idx="457">0.59621000000000002</cx:pt>
          <cx:pt idx="458">0.37872299999999998</cx:pt>
          <cx:pt idx="459">0.44259399999999999</cx:pt>
          <cx:pt idx="460">0.230548</cx:pt>
          <cx:pt idx="461">0.49492799999999998</cx:pt>
          <cx:pt idx="462">0.22920399999999999</cx:pt>
          <cx:pt idx="463">0.46876899999999999</cx:pt>
          <cx:pt idx="464">0.34632400000000002</cx:pt>
          <cx:pt idx="465">0.24069499999999999</cx:pt>
          <cx:pt idx="466">0.53165499999999999</cx:pt>
          <cx:pt idx="467">0.34983599999999998</cx:pt>
          <cx:pt idx="468">0.35968099999999997</cx:pt>
          <cx:pt idx="469">0.360315</cx:pt>
          <cx:pt idx="470">0.42108699999999999</cx:pt>
          <cx:pt idx="471">0.44254900000000003</cx:pt>
          <cx:pt idx="472">0.36874899999999999</cx:pt>
          <cx:pt idx="473">0.34693600000000002</cx:pt>
          <cx:pt idx="474">0.23775399999999999</cx:pt>
          <cx:pt idx="475">0.50585199999999997</cx:pt>
          <cx:pt idx="476">0.533447</cx:pt>
          <cx:pt idx="477">0.34232200000000002</cx:pt>
          <cx:pt idx="478">0.23061000000000001</cx:pt>
          <cx:pt idx="479">0.219443</cx:pt>
          <cx:pt idx="480">0.69015000000000004</cx:pt>
          <cx:pt idx="481">0.48892799999999997</cx:pt>
          <cx:pt idx="482">0.24033399999999999</cx:pt>
          <cx:pt idx="483">0.49460799999999999</cx:pt>
          <cx:pt idx="484">0.50163999999999997</cx:pt>
          <cx:pt idx="485">0.36476799999999998</cx:pt>
          <cx:pt idx="486">0.45299800000000001</cx:pt>
          <cx:pt idx="487">0.39633800000000002</cx:pt>
          <cx:pt idx="488">0.224019</cx:pt>
          <cx:pt idx="489">0.21778700000000001</cx:pt>
          <cx:pt idx="490">0.44238699999999997</cx:pt>
          <cx:pt idx="491">0.235764</cx:pt>
          <cx:pt idx="492">0.24476300000000001</cx:pt>
          <cx:pt idx="493">0.24430199999999999</cx:pt>
          <cx:pt idx="494">0.22604299999999999</cx:pt>
          <cx:pt idx="495">0.61013300000000004</cx:pt>
          <cx:pt idx="496">0.49599599999999999</cx:pt>
          <cx:pt idx="497">0.494477</cx:pt>
          <cx:pt idx="498">0.34386899999999998</cx:pt>
          <cx:pt idx="499">0.432778</cx:pt>
          <cx:pt idx="500">0.34867399999999998</cx:pt>
          <cx:pt idx="501">0.34882800000000003</cx:pt>
          <cx:pt idx="502">0.24559400000000001</cx:pt>
          <cx:pt idx="503">0.431925</cx:pt>
          <cx:pt idx="504">0.43539499999999998</cx:pt>
          <cx:pt idx="505">0.237238</cx:pt>
          <cx:pt idx="506">0.35112700000000002</cx:pt>
          <cx:pt idx="507">0.21789500000000001</cx:pt>
          <cx:pt idx="508">0.349495</cx:pt>
          <cx:pt idx="509">0.35907899999999998</cx:pt>
          <cx:pt idx="510">0.28102100000000002</cx:pt>
          <cx:pt idx="511">0.34969</cx:pt>
          <cx:pt idx="512">0.66248499999999999</cx:pt>
          <cx:pt idx="513">0.230542</cx:pt>
          <cx:pt idx="514">0.38209799999999999</cx:pt>
          <cx:pt idx="515">0.24637500000000001</cx:pt>
          <cx:pt idx="516">0.34870099999999998</cx:pt>
          <cx:pt idx="517">0.69312399999999996</cx:pt>
          <cx:pt idx="518">0.23632</cx:pt>
          <cx:pt idx="519">0.44403500000000001</cx:pt>
          <cx:pt idx="520">0.34690199999999999</cx:pt>
          <cx:pt idx="521">0.43464999999999998</cx:pt>
          <cx:pt idx="522">0.26485399999999998</cx:pt>
          <cx:pt idx="523">0.59359899999999999</cx:pt>
          <cx:pt idx="524">0.23441100000000001</cx:pt>
          <cx:pt idx="525">0.34331200000000001</cx:pt>
          <cx:pt idx="526">0.34464</cx:pt>
          <cx:pt idx="527">0.52796500000000002</cx:pt>
          <cx:pt idx="528">0.34228700000000001</cx:pt>
          <cx:pt idx="529">0.53242299999999998</cx:pt>
          <cx:pt idx="530">0.24593300000000001</cx:pt>
          <cx:pt idx="531">0.49463000000000001</cx:pt>
          <cx:pt idx="532">0.366512</cx:pt>
          <cx:pt idx="533">0.43404100000000001</cx:pt>
          <cx:pt idx="534">0.53195000000000003</cx:pt>
          <cx:pt idx="535">0.43407400000000002</cx:pt>
          <cx:pt idx="536">0.227549</cx:pt>
          <cx:pt idx="537">0.68431900000000001</cx:pt>
          <cx:pt idx="538">0.365033</cx:pt>
          <cx:pt idx="539">0.218776</cx:pt>
          <cx:pt idx="540">0.244642</cx:pt>
          <cx:pt idx="541">0.25165700000000002</cx:pt>
          <cx:pt idx="542">0.68625499999999995</cx:pt>
          <cx:pt idx="543">0.53240399999999999</cx:pt>
          <cx:pt idx="544">0.37368400000000002</cx:pt>
          <cx:pt idx="545">0.45727299999999999</cx:pt>
          <cx:pt idx="546">0.43418699999999999</cx:pt>
          <cx:pt idx="547">0.34919099999999997</cx:pt>
          <cx:pt idx="548">0.68527700000000003</cx:pt>
          <cx:pt idx="549">0.44433699999999998</cx:pt>
          <cx:pt idx="550">0.44507999999999998</cx:pt>
          <cx:pt idx="551">0.22595100000000001</cx:pt>
          <cx:pt idx="552">0.44370399999999999</cx:pt>
          <cx:pt idx="553">0.23894799999999999</cx:pt>
          <cx:pt idx="554">0.24767800000000001</cx:pt>
          <cx:pt idx="555">0.34239599999999998</cx:pt>
          <cx:pt idx="556">0.200486</cx:pt>
          <cx:pt idx="557">0.23783099999999999</cx:pt>
          <cx:pt idx="558">0.53192700000000004</cx:pt>
          <cx:pt idx="559">0.36171999999999999</cx:pt>
          <cx:pt idx="560">0.348408</cx:pt>
          <cx:pt idx="561">0.68728599999999995</cx:pt>
          <cx:pt idx="562">0.22613800000000001</cx:pt>
          <cx:pt idx="563">0.49460700000000002</cx:pt>
          <cx:pt idx="564">0.3604</cx:pt>
          <cx:pt idx="565">0.43375000000000002</cx:pt>
          <cx:pt idx="566">0.38002000000000002</cx:pt>
          <cx:pt idx="567">0.34847800000000001</cx:pt>
          <cx:pt idx="568">0.43569200000000002</cx:pt>
          <cx:pt idx="569">0.42916100000000001</cx:pt>
          <cx:pt idx="570">0.53240799999999999</cx:pt>
          <cx:pt idx="571">0.43395899999999998</cx:pt>
          <cx:pt idx="572">0.44237700000000002</cx:pt>
          <cx:pt idx="573">0.122026</cx:pt>
          <cx:pt idx="574">0.34838200000000002</cx:pt>
          <cx:pt idx="575">0.23000399999999999</cx:pt>
          <cx:pt idx="576">0.237846</cx:pt>
          <cx:pt idx="577">0.35946400000000001</cx:pt>
          <cx:pt idx="578">0.34909800000000002</cx:pt>
          <cx:pt idx="579">0.22406499999999999</cx:pt>
          <cx:pt idx="580">0.24506600000000001</cx:pt>
          <cx:pt idx="581">0.24512400000000001</cx:pt>
          <cx:pt idx="582">0.43919900000000001</cx:pt>
          <cx:pt idx="583">0.65554100000000004</cx:pt>
          <cx:pt idx="584">0.490226</cx:pt>
          <cx:pt idx="585">0.43362099999999998</cx:pt>
          <cx:pt idx="586">0.49214999999999998</cx:pt>
          <cx:pt idx="587">0.43215199999999998</cx:pt>
          <cx:pt idx="588">0.251606</cx:pt>
          <cx:pt idx="589">0.24357899999999999</cx:pt>
          <cx:pt idx="590">0.34191500000000002</cx:pt>
          <cx:pt idx="591">0.53195400000000004</cx:pt>
          <cx:pt idx="592">0.34227600000000002</cx:pt>
          <cx:pt idx="593">0.19622300000000001</cx:pt>
          <cx:pt idx="594">0.216752</cx:pt>
          <cx:pt idx="595">0.34723700000000002</cx:pt>
          <cx:pt idx="596">0.22822300000000001</cx:pt>
          <cx:pt idx="597">0.21357699999999999</cx:pt>
          <cx:pt idx="598">0.49420500000000001</cx:pt>
          <cx:pt idx="599">0.43323</cx:pt>
          <cx:pt idx="600">0.23935999999999999</cx:pt>
          <cx:pt idx="601">0.366421</cx:pt>
          <cx:pt idx="602">0.34415800000000002</cx:pt>
          <cx:pt idx="603">0.206066</cx:pt>
          <cx:pt idx="604">0.34818300000000002</cx:pt>
          <cx:pt idx="605">0.43529699999999999</cx:pt>
          <cx:pt idx="606">0.53281500000000004</cx:pt>
          <cx:pt idx="607">0.496143</cx:pt>
          <cx:pt idx="608">0.23921799999999999</cx:pt>
          <cx:pt idx="609">0.24951100000000001</cx:pt>
          <cx:pt idx="610">0.49560700000000002</cx:pt>
          <cx:pt idx="611">0.53212499999999996</cx:pt>
          <cx:pt idx="612">0.730827</cx:pt>
          <cx:pt idx="613">0.431284</cx:pt>
          <cx:pt idx="614">0.22747500000000001</cx:pt>
          <cx:pt idx="615">0.29074800000000001</cx:pt>
          <cx:pt idx="616">0.44457099999999999</cx:pt>
          <cx:pt idx="617">0.446102</cx:pt>
          <cx:pt idx="618">0.43132999999999999</cx:pt>
          <cx:pt idx="619">0.289354</cx:pt>
          <cx:pt idx="620">0.60859399999999997</cx:pt>
          <cx:pt idx="621">0.433224</cx:pt>
          <cx:pt idx="622">0.44367800000000002</cx:pt>
          <cx:pt idx="623">0.34971799999999997</cx:pt>
          <cx:pt idx="624">0.434365</cx:pt>
          <cx:pt idx="625">0.25812600000000002</cx:pt>
          <cx:pt idx="626">0.348659</cx:pt>
          <cx:pt idx="627">0.66984999999999995</cx:pt>
          <cx:pt idx="628">0.23272100000000001</cx:pt>
          <cx:pt idx="629">0.24418799999999999</cx:pt>
          <cx:pt idx="630">0.34899000000000002</cx:pt>
          <cx:pt idx="631">0.36783199999999999</cx:pt>
          <cx:pt idx="632">0.30298599999999998</cx:pt>
          <cx:pt idx="633">0.35068199999999999</cx:pt>
          <cx:pt idx="634">0.349802</cx:pt>
          <cx:pt idx="635">0.43370900000000001</cx:pt>
          <cx:pt idx="636">0.197987</cx:pt>
          <cx:pt idx="637">0.34773500000000002</cx:pt>
          <cx:pt idx="638">0.33573199999999997</cx:pt>
          <cx:pt idx="639">0.241559</cx:pt>
          <cx:pt idx="640">0.49562499999999998</cx:pt>
          <cx:pt idx="641">0.22689500000000001</cx:pt>
          <cx:pt idx="642">0.34790199999999999</cx:pt>
          <cx:pt idx="643">0.22628799999999999</cx:pt>
          <cx:pt idx="644">0.43470199999999998</cx:pt>
          <cx:pt idx="645">0.39063199999999998</cx:pt>
          <cx:pt idx="646">0.35644700000000001</cx:pt>
          <cx:pt idx="647">0.43454799999999999</cx:pt>
          <cx:pt idx="648">0.22995199999999999</cx:pt>
          <cx:pt idx="649">0.692438</cx:pt>
          <cx:pt idx="650">0.23311999999999999</cx:pt>
          <cx:pt idx="651">0.23180600000000001</cx:pt>
          <cx:pt idx="652">0.34966999999999998</cx:pt>
          <cx:pt idx="653">0.23449800000000001</cx:pt>
          <cx:pt idx="654">0.44333600000000001</cx:pt>
          <cx:pt idx="655">0.363867</cx:pt>
          <cx:pt idx="656">0.21887000000000001</cx:pt>
          <cx:pt idx="657">0.239927</cx:pt>
          <cx:pt idx="658">0.43493399999999999</cx:pt>
          <cx:pt idx="659">0.229905</cx:pt>
          <cx:pt idx="660">0.34861199999999998</cx:pt>
          <cx:pt idx="661">0.348549</cx:pt>
          <cx:pt idx="662">0.17791499999999999</cx:pt>
          <cx:pt idx="663">0.21985099999999999</cx:pt>
          <cx:pt idx="664">0.35880600000000001</cx:pt>
          <cx:pt idx="665">0.34248600000000001</cx:pt>
          <cx:pt idx="666">0.43373800000000001</cx:pt>
          <cx:pt idx="667">0.35032600000000003</cx:pt>
          <cx:pt idx="668">0.49137500000000001</cx:pt>
          <cx:pt idx="669">0.49236600000000003</cx:pt>
          <cx:pt idx="670">0.36355100000000001</cx:pt>
          <cx:pt idx="671">0.49405199999999999</cx:pt>
          <cx:pt idx="672">0.24199499999999999</cx:pt>
          <cx:pt idx="673">0.24768000000000001</cx:pt>
          <cx:pt idx="674">0.227911</cx:pt>
          <cx:pt idx="675">0.36531000000000002</cx:pt>
          <cx:pt idx="676">0.24240800000000001</cx:pt>
          <cx:pt idx="677">0.67304799999999998</cx:pt>
          <cx:pt idx="678">0.22357099999999999</cx:pt>
          <cx:pt idx="679">0.34868199999999999</cx:pt>
          <cx:pt idx="680">0.43398199999999998</cx:pt>
          <cx:pt idx="681">0.35833500000000001</cx:pt>
          <cx:pt idx="682">0.34642400000000001</cx:pt>
          <cx:pt idx="683">0.36516100000000001</cx:pt>
          <cx:pt idx="684">0.23067599999999999</cx:pt>
          <cx:pt idx="685">0.34293099999999999</cx:pt>
          <cx:pt idx="686">0.22013199999999999</cx:pt>
          <cx:pt idx="687">0.349132</cx:pt>
          <cx:pt idx="688">0.496085</cx:pt>
          <cx:pt idx="689">0.531694</cx:pt>
          <cx:pt idx="690">0.43272699999999997</cx:pt>
          <cx:pt idx="691">0.23908399999999999</cx:pt>
          <cx:pt idx="692">0.53146000000000004</cx:pt>
          <cx:pt idx="693">0.43289299999999997</cx:pt>
          <cx:pt idx="694">0.43517099999999997</cx:pt>
          <cx:pt idx="695">0.43526799999999999</cx:pt>
          <cx:pt idx="696">0.19467400000000001</cx:pt>
          <cx:pt idx="697">0.23919599999999999</cx:pt>
          <cx:pt idx="698">0.34889500000000001</cx:pt>
          <cx:pt idx="699">0.43371599999999999</cx:pt>
          <cx:pt idx="700">0.41989100000000001</cx:pt>
          <cx:pt idx="701">0.444579</cx:pt>
          <cx:pt idx="702">0.49520900000000001</cx:pt>
          <cx:pt idx="703">0.49543300000000001</cx:pt>
          <cx:pt idx="704">0.22317300000000001</cx:pt>
          <cx:pt idx="705">0.23491699999999999</cx:pt>
          <cx:pt idx="706">0.210232</cx:pt>
          <cx:pt idx="707">0.22902400000000001</cx:pt>
          <cx:pt idx="708">0.24315700000000001</cx:pt>
          <cx:pt idx="709">0.49745299999999998</cx:pt>
          <cx:pt idx="710">0.25095400000000001</cx:pt>
          <cx:pt idx="711">0.23486399999999999</cx:pt>
          <cx:pt idx="712">0.22848299999999999</cx:pt>
          <cx:pt idx="713">0.22689000000000001</cx:pt>
          <cx:pt idx="714">0.322098</cx:pt>
          <cx:pt idx="715">0.171734</cx:pt>
          <cx:pt idx="716">0.24532300000000001</cx:pt>
          <cx:pt idx="717">0.466138</cx:pt>
          <cx:pt idx="718">0.346051</cx:pt>
          <cx:pt idx="719">0.23386399999999999</cx:pt>
          <cx:pt idx="720">0.34160200000000002</cx:pt>
          <cx:pt idx="721">0.43173099999999998</cx:pt>
          <cx:pt idx="722">0.68815499999999996</cx:pt>
          <cx:pt idx="723">0.21981800000000001</cx:pt>
          <cx:pt idx="724">0.36397000000000002</cx:pt>
          <cx:pt idx="725">0.362344</cx:pt>
          <cx:pt idx="726">0.22808400000000001</cx:pt>
          <cx:pt idx="727">0.65176999999999996</cx:pt>
          <cx:pt idx="728">0.38954100000000003</cx:pt>
          <cx:pt idx="729">0.36105900000000002</cx:pt>
          <cx:pt idx="730">0.34037499999999998</cx:pt>
          <cx:pt idx="731">0.34532400000000002</cx:pt>
          <cx:pt idx="732">0.348605</cx:pt>
          <cx:pt idx="733">0.377666</cx:pt>
          <cx:pt idx="734">0.23624400000000001</cx:pt>
          <cx:pt idx="735">0.43419099999999999</cx:pt>
          <cx:pt idx="736">0.342922</cx:pt>
          <cx:pt idx="737">0.34901599999999999</cx:pt>
          <cx:pt idx="738">0.43267800000000001</cx:pt>
          <cx:pt idx="739">0.215809</cx:pt>
          <cx:pt idx="740">0.43376700000000001</cx:pt>
          <cx:pt idx="741">0.48699799999999999</cx:pt>
          <cx:pt idx="742">0.43194100000000002</cx:pt>
          <cx:pt idx="743">0.353713</cx:pt>
          <cx:pt idx="744">0.38621</cx:pt>
          <cx:pt idx="745">0.53071299999999999</cx:pt>
          <cx:pt idx="746">0.67303599999999997</cx:pt>
          <cx:pt idx="747">0.44145000000000001</cx:pt>
          <cx:pt idx="748">0.23020199999999999</cx:pt>
          <cx:pt idx="749">0.37617299999999998</cx:pt>
          <cx:pt idx="750">0.43304500000000001</cx:pt>
          <cx:pt idx="751">0.22243099999999999</cx:pt>
          <cx:pt idx="752">0.233877</cx:pt>
          <cx:pt idx="753">0.49392000000000003</cx:pt>
          <cx:pt idx="754">0.34632200000000002</cx:pt>
          <cx:pt idx="755">0.25290200000000002</cx:pt>
          <cx:pt idx="756">0.34666400000000003</cx:pt>
          <cx:pt idx="757">0.21316399999999999</cx:pt>
          <cx:pt idx="758">0.24220900000000001</cx:pt>
          <cx:pt idx="759">0.36413600000000002</cx:pt>
          <cx:pt idx="760">0.24578900000000001</cx:pt>
          <cx:pt idx="761">0.373664</cx:pt>
          <cx:pt idx="762">0.413887</cx:pt>
          <cx:pt idx="763">0.49561300000000003</cx:pt>
          <cx:pt idx="764">0.49476700000000001</cx:pt>
          <cx:pt idx="765">0.22811699999999999</cx:pt>
          <cx:pt idx="766">0.364846</cx:pt>
          <cx:pt idx="767">0.43315399999999998</cx:pt>
          <cx:pt idx="768">0.43307099999999998</cx:pt>
          <cx:pt idx="769">0.53159000000000001</cx:pt>
          <cx:pt idx="770">0.53147299999999997</cx:pt>
          <cx:pt idx="771">0.239095</cx:pt>
          <cx:pt idx="772">0.44027300000000003</cx:pt>
          <cx:pt idx="773">0.65037999999999996</cx:pt>
          <cx:pt idx="774">0.213646</cx:pt>
          <cx:pt idx="775">0.22731499999999999</cx:pt>
          <cx:pt idx="776">0.238928</cx:pt>
          <cx:pt idx="777">0.24412300000000001</cx:pt>
          <cx:pt idx="778">0.23180000000000001</cx:pt>
          <cx:pt idx="779">0.218393</cx:pt>
          <cx:pt idx="780">0.43724400000000002</cx:pt>
          <cx:pt idx="781">0.231097</cx:pt>
          <cx:pt idx="782">0.67900000000000005</cx:pt>
          <cx:pt idx="783">0.35547899999999999</cx:pt>
          <cx:pt idx="784">0.36644199999999999</cx:pt>
          <cx:pt idx="785">0.22033900000000001</cx:pt>
          <cx:pt idx="786">0.62587999999999999</cx:pt>
          <cx:pt idx="787">0.23535900000000001</cx:pt>
          <cx:pt idx="788">0.361097</cx:pt>
          <cx:pt idx="789">0.49432599999999999</cx:pt>
          <cx:pt idx="790">0.34997699999999998</cx:pt>
          <cx:pt idx="791">0.43474400000000002</cx:pt>
          <cx:pt idx="792">0.34467399999999998</cx:pt>
          <cx:pt idx="793">0.36424099999999998</cx:pt>
          <cx:pt idx="794">0.66289399999999998</cx:pt>
          <cx:pt idx="795">0.221828</cx:pt>
          <cx:pt idx="796">0.23035600000000001</cx:pt>
          <cx:pt idx="797">0.35858200000000001</cx:pt>
          <cx:pt idx="798">0.36197499999999999</cx:pt>
          <cx:pt idx="799">0.43306600000000001</cx:pt>
          <cx:pt idx="800">0.237458</cx:pt>
          <cx:pt idx="801">0.226661</cx:pt>
          <cx:pt idx="802">0.432809</cx:pt>
          <cx:pt idx="803">0.39060400000000001</cx:pt>
          <cx:pt idx="804">0.36359900000000001</cx:pt>
          <cx:pt idx="805">0.224385</cx:pt>
          <cx:pt idx="806">0.44189299999999998</cx:pt>
          <cx:pt idx="807">0.21613399999999999</cx:pt>
          <cx:pt idx="808">0.445461</cx:pt>
          <cx:pt idx="809">0.67437599999999998</cx:pt>
          <cx:pt idx="810">0.081878500000000007</cx:pt>
          <cx:pt idx="811">0.44088100000000002</cx:pt>
          <cx:pt idx="812">0.19103600000000001</cx:pt>
          <cx:pt idx="813">0.43420700000000001</cx:pt>
          <cx:pt idx="814">0.348362</cx:pt>
          <cx:pt idx="815">0.24215</cx:pt>
          <cx:pt idx="816">0.36448999999999998</cx:pt>
          <cx:pt idx="817">0.22936400000000001</cx:pt>
          <cx:pt idx="818">0.36270999999999998</cx:pt>
          <cx:pt idx="819">0.22714599999999999</cx:pt>
          <cx:pt idx="820">0.65766999999999998</cx:pt>
          <cx:pt idx="821">0.43490499999999999</cx:pt>
          <cx:pt idx="822">0.38687500000000002</cx:pt>
          <cx:pt idx="823">0.43390099999999998</cx:pt>
          <cx:pt idx="824">0.35922300000000001</cx:pt>
          <cx:pt idx="825">0.55952999999999997</cx:pt>
          <cx:pt idx="826">0.341729</cx:pt>
          <cx:pt idx="827">0.36048400000000003</cx:pt>
          <cx:pt idx="828">0.34928799999999999</cx:pt>
          <cx:pt idx="829">0.35154200000000002</cx:pt>
          <cx:pt idx="830">0.52922100000000005</cx:pt>
          <cx:pt idx="831">0.24751400000000001</cx:pt>
          <cx:pt idx="832">0.43267099999999997</cx:pt>
          <cx:pt idx="833">0.43321700000000002</cx:pt>
          <cx:pt idx="834">0.23166100000000001</cx:pt>
          <cx:pt idx="835">0.43282599999999999</cx:pt>
          <cx:pt idx="836">0.34619699999999998</cx:pt>
          <cx:pt idx="837">0.23858699999999999</cx:pt>
          <cx:pt idx="838">0.42858600000000002</cx:pt>
          <cx:pt idx="839">0.34870499999999999</cx:pt>
          <cx:pt idx="840">0.22931399999999999</cx:pt>
          <cx:pt idx="841">0.67394799999999999</cx:pt>
          <cx:pt idx="842">0.227968</cx:pt>
          <cx:pt idx="843">0.34215299999999998</cx:pt>
          <cx:pt idx="844">0.19388</cx:pt>
          <cx:pt idx="845">0.22539200000000001</cx:pt>
          <cx:pt idx="846">0.22512299999999999</cx:pt>
          <cx:pt idx="847">0.22845699999999999</cx:pt>
          <cx:pt idx="848">0.35001900000000002</cx:pt>
          <cx:pt idx="849">0.43460199999999999</cx:pt>
          <cx:pt idx="850">0.68996599999999997</cx:pt>
          <cx:pt idx="851">0.24967600000000001</cx:pt>
          <cx:pt idx="852">0.34501799999999999</cx:pt>
          <cx:pt idx="853">0.35918099999999997</cx:pt>
          <cx:pt idx="854">0.21459500000000001</cx:pt>
          <cx:pt idx="855">0.44276300000000002</cx:pt>
          <cx:pt idx="856">0.34547699999999998</cx:pt>
          <cx:pt idx="857">0.34990700000000002</cx:pt>
          <cx:pt idx="858">0.24776200000000001</cx:pt>
          <cx:pt idx="859">0.36543700000000001</cx:pt>
          <cx:pt idx="860">0.34786499999999998</cx:pt>
          <cx:pt idx="861">0.43949199999999999</cx:pt>
          <cx:pt idx="862">0.43236200000000002</cx:pt>
          <cx:pt idx="863">0.23626800000000001</cx:pt>
          <cx:pt idx="864">0.44426199999999999</cx:pt>
          <cx:pt idx="865">0.35432200000000003</cx:pt>
          <cx:pt idx="866">0.358761</cx:pt>
          <cx:pt idx="867">0.43312600000000001</cx:pt>
          <cx:pt idx="868">0.43397799999999997</cx:pt>
          <cx:pt idx="869">0.34381499999999998</cx:pt>
          <cx:pt idx="870">0.44308599999999998</cx:pt>
          <cx:pt idx="871">0.34959000000000001</cx:pt>
          <cx:pt idx="872">0.34988799999999998</cx:pt>
          <cx:pt idx="873">0.35781299999999999</cx:pt>
          <cx:pt idx="874">0.22231000000000001</cx:pt>
          <cx:pt idx="875">0.43401400000000001</cx:pt>
          <cx:pt idx="876">0.227186</cx:pt>
          <cx:pt idx="877">0.34653299999999998</cx:pt>
          <cx:pt idx="878">0.38326300000000002</cx:pt>
          <cx:pt idx="879">0.49257600000000001</cx:pt>
          <cx:pt idx="880">0.36005999999999999</cx:pt>
          <cx:pt idx="881">0.22901199999999999</cx:pt>
          <cx:pt idx="882">0.67258399999999996</cx:pt>
          <cx:pt idx="883">0.23038600000000001</cx:pt>
          <cx:pt idx="884">0.44288499999999997</cx:pt>
          <cx:pt idx="885">0.43409199999999998</cx:pt>
          <cx:pt idx="886">0.434751</cx:pt>
          <cx:pt idx="887">0.694218</cx:pt>
          <cx:pt idx="888">0.313442</cx:pt>
          <cx:pt idx="889">0.19623099999999999</cx:pt>
          <cx:pt idx="890">0.222414</cx:pt>
          <cx:pt idx="891">0.443214</cx:pt>
          <cx:pt idx="892">0.66958799999999996</cx:pt>
          <cx:pt idx="893">0.22170500000000001</cx:pt>
          <cx:pt idx="894">0.24141899999999999</cx:pt>
          <cx:pt idx="895">0.462982</cx:pt>
          <cx:pt idx="896">0.233038</cx:pt>
          <cx:pt idx="897">0.21938299999999999</cx:pt>
          <cx:pt idx="898">0.34778700000000001</cx:pt>
          <cx:pt idx="899">0.34614099999999998</cx:pt>
          <cx:pt idx="900">0.43064799999999998</cx:pt>
          <cx:pt idx="901">0.43302499999999999</cx:pt>
          <cx:pt idx="902">0.44138100000000002</cx:pt>
          <cx:pt idx="903">0.423294</cx:pt>
          <cx:pt idx="904">0.43428699999999998</cx:pt>
          <cx:pt idx="905">0.433471</cx:pt>
          <cx:pt idx="906">0.49464799999999998</cx:pt>
          <cx:pt idx="907">0.43170500000000001</cx:pt>
          <cx:pt idx="908">0.21474799999999999</cx:pt>
          <cx:pt idx="909">0.53254999999999997</cx:pt>
          <cx:pt idx="910">0.34939900000000002</cx:pt>
          <cx:pt idx="911">0.24773100000000001</cx:pt>
          <cx:pt idx="912">0.350771</cx:pt>
          <cx:pt idx="913">0.34209499999999998</cx:pt>
          <cx:pt idx="914">0.233735</cx:pt>
          <cx:pt idx="915">0.58967599999999998</cx:pt>
          <cx:pt idx="916">0.242063</cx:pt>
          <cx:pt idx="917">0.232262</cx:pt>
          <cx:pt idx="918">0.21345900000000001</cx:pt>
          <cx:pt idx="919">0.23003100000000001</cx:pt>
          <cx:pt idx="920">0.435114</cx:pt>
          <cx:pt idx="921">0.52863199999999999</cx:pt>
          <cx:pt idx="922">0.49372100000000002</cx:pt>
          <cx:pt idx="923">0.24343799999999999</cx:pt>
          <cx:pt idx="924">0.22134200000000001</cx:pt>
          <cx:pt idx="925">0.44722299999999998</cx:pt>
          <cx:pt idx="926">0.34703699999999998</cx:pt>
          <cx:pt idx="927">0.21115999999999999</cx:pt>
          <cx:pt idx="928">0.34895799999999999</cx:pt>
          <cx:pt idx="929">0.246307</cx:pt>
          <cx:pt idx="930">0.25135200000000002</cx:pt>
          <cx:pt idx="931">0.43338100000000002</cx:pt>
          <cx:pt idx="932">0.43259500000000001</cx:pt>
          <cx:pt idx="933">0.20932400000000001</cx:pt>
          <cx:pt idx="934">0.43180099999999999</cx:pt>
          <cx:pt idx="935">0.22322800000000001</cx:pt>
          <cx:pt idx="936">0.34909899999999999</cx:pt>
          <cx:pt idx="937">0.43258400000000002</cx:pt>
          <cx:pt idx="938">0.34689399999999998</cx:pt>
          <cx:pt idx="939">0.33821000000000001</cx:pt>
          <cx:pt idx="940">0.239285</cx:pt>
          <cx:pt idx="941">0.36594700000000002</cx:pt>
          <cx:pt idx="942">0.35861399999999999</cx:pt>
          <cx:pt idx="943">0.53002400000000005</cx:pt>
          <cx:pt idx="944">0.23002400000000001</cx:pt>
          <cx:pt idx="945">0.34517599999999998</cx:pt>
          <cx:pt idx="946">0.34805399999999997</cx:pt>
          <cx:pt idx="947">0.24459800000000001</cx:pt>
          <cx:pt idx="948">0.53140600000000004</cx:pt>
          <cx:pt idx="949">0.24001400000000001</cx:pt>
          <cx:pt idx="950">0.33377899999999999</cx:pt>
          <cx:pt idx="951">0.41621399999999997</cx:pt>
          <cx:pt idx="952">0.34778999999999999</cx:pt>
          <cx:pt idx="953">0.24546899999999999</cx:pt>
          <cx:pt idx="954">0.38284299999999999</cx:pt>
          <cx:pt idx="955">0.68596599999999996</cx:pt>
          <cx:pt idx="956">0.430344</cx:pt>
          <cx:pt idx="957">0.34661900000000001</cx:pt>
          <cx:pt idx="958">0.64442900000000003</cx:pt>
          <cx:pt idx="959">0.53219399999999994</cx:pt>
          <cx:pt idx="960">0.220918</cx:pt>
          <cx:pt idx="961">0.52990999999999999</cx:pt>
          <cx:pt idx="962">0.44748599999999999</cx:pt>
          <cx:pt idx="963">0.221079</cx:pt>
          <cx:pt idx="964">0.23074500000000001</cx:pt>
          <cx:pt idx="965">0.209036</cx:pt>
          <cx:pt idx="966">0.226661</cx:pt>
          <cx:pt idx="967">0.36550300000000002</cx:pt>
          <cx:pt idx="968">0.49368400000000001</cx:pt>
          <cx:pt idx="969">0.36282999999999999</cx:pt>
          <cx:pt idx="970">0.36294999999999999</cx:pt>
          <cx:pt idx="971">0.24001800000000001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sz="20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200" b="0" i="0" u="none" strike="noStrike" baseline="0" dirty="0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C50,chronic</a:t>
            </a:r>
            <a:endParaRPr lang="ja-JP" altLang="en-US" sz="1200" b="0" i="0" u="none" strike="noStrike" baseline="0" dirty="0">
              <a:solidFill>
                <a:sysClr val="windowText" lastClr="000000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cx:rich>
      </cx:tx>
    </cx:title>
    <cx:plotArea>
      <cx:plotAreaRegion>
        <cx:series layoutId="clusteredColumn" uniqueId="{05B16539-C9F2-4BB1-914E-FF634A608EBF}">
          <cx:tx>
            <cx:txData>
              <cx:f>'PD chronic'!$I$1</cx:f>
              <cx:v>tvIC50p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Count val="10"/>
            </cx:binning>
          </cx:layoutPr>
        </cx:series>
      </cx:plotAreaRegion>
      <cx:axis id="0">
        <cx:catScaling gapWidth="0"/>
        <cx:tickLabels/>
        <cx:numFmt formatCode="#,##0.0_);[赤](#,##0.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18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PD chronic'!$AI$2:$AI$1001</cx:f>
        <cx:lvl ptCount="1000" formatCode="G/標準">
          <cx:pt idx="0">25.172604156105898</cx:pt>
          <cx:pt idx="1">25.157980841077048</cx:pt>
          <cx:pt idx="2">25.15126239376465</cx:pt>
          <cx:pt idx="3">25.184499200897363</cx:pt>
          <cx:pt idx="4">25.178880038635555</cx:pt>
          <cx:pt idx="5">4.9364663475000006</cx:pt>
          <cx:pt idx="6">11.81435567434805</cx:pt>
          <cx:pt idx="7">25.248861360465348</cx:pt>
          <cx:pt idx="8">25.200337299329945</cx:pt>
          <cx:pt idx="9">40.446755123248138</cx:pt>
          <cx:pt idx="10">24.9854157459907</cx:pt>
          <cx:pt idx="11">9.4376797996117681</cx:pt>
          <cx:pt idx="12">13.850884448294268</cx:pt>
          <cx:pt idx="13">25.137700769959054</cx:pt>
          <cx:pt idx="14">25.180865751597974</cx:pt>
          <cx:pt idx="15">25.168730599694534</cx:pt>
          <cx:pt idx="16">0.00033109515248641141</cx:pt>
          <cx:pt idx="17">25.361427404623736</cx:pt>
          <cx:pt idx="18">0.003964177089888896</cx:pt>
          <cx:pt idx="19">25.16173682399528</cx:pt>
          <cx:pt idx="20">9.7321888596553645</cx:pt>
          <cx:pt idx="21">12.799296855687034</cx:pt>
          <cx:pt idx="22">11.845547686789327</cx:pt>
          <cx:pt idx="23">25.13045960582496</cx:pt>
          <cx:pt idx="24">25.834453739144553</cx:pt>
          <cx:pt idx="25">25.174471196035082</cx:pt>
          <cx:pt idx="26">25.078237577628936</cx:pt>
          <cx:pt idx="27">25.087008590104958</cx:pt>
          <cx:pt idx="28">25.161677209597933</cx:pt>
          <cx:pt idx="29">25.254524347134318</cx:pt>
          <cx:pt idx="30">0.00072995479312077955</cx:pt>
          <cx:pt idx="31">25.162889341250143</cx:pt>
          <cx:pt idx="32">8.5007529078311652</cx:pt>
          <cx:pt idx="33">25.163644410140595</cx:pt>
          <cx:pt idx="34">25.192637813456535</cx:pt>
          <cx:pt idx="35">25.155098886706845</cx:pt>
          <cx:pt idx="36">23.012387968222679</cx:pt>
          <cx:pt idx="37">25.038510339075685</cx:pt>
          <cx:pt idx="38">25.170915756086426</cx:pt>
          <cx:pt idx="39">25.130539190395417</cx:pt>
          <cx:pt idx="40">9.8327208848822725</cx:pt>
          <cx:pt idx="41">25.309405366385047</cx:pt>
          <cx:pt idx="42">22.83606796276452</cx:pt>
          <cx:pt idx="43">25.099103569649657</cx:pt>
          <cx:pt idx="44">25.116548329736709</cx:pt>
          <cx:pt idx="45">14.339386318807371</cx:pt>
          <cx:pt idx="46">11.086839044560898</cx:pt>
          <cx:pt idx="47">25.155874065513999</cx:pt>
          <cx:pt idx="48">25.159232897685889</cx:pt>
          <cx:pt idx="49">25.169406031926933</cx:pt>
          <cx:pt idx="50">25.174272581347807</cx:pt>
          <cx:pt idx="51">25.543746788597794</cx:pt>
          <cx:pt idx="52">10.848133480004751</cx:pt>
          <cx:pt idx="53">25.180389194768217</cx:pt>
          <cx:pt idx="54">25.06533462772839</cx:pt>
          <cx:pt idx="55">0.00056576585262809907</cx:pt>
          <cx:pt idx="56">25.170995212744369</cx:pt>
          <cx:pt idx="57">25.185491855431373</cx:pt>
          <cx:pt idx="58">10.02177628966043</cx:pt>
          <cx:pt idx="59">25.172385663659298</cx:pt>
          <cx:pt idx="60">25.100418323207286</cx:pt>
          <cx:pt idx="61">25.1090222828369</cx:pt>
          <cx:pt idx="62">25.170657520215876</cx:pt>
          <cx:pt idx="63">14.774403541260133</cx:pt>
          <cx:pt idx="64">25.164876316008389</cx:pt>
          <cx:pt idx="65">25.138317366124568</cx:pt>
          <cx:pt idx="66">25.142155834375064</cx:pt>
          <cx:pt idx="67">11.899789914111929</cx:pt>
          <cx:pt idx="68">13.098396848469662</cx:pt>
          <cx:pt idx="69">25.130917213663334</cx:pt>
          <cx:pt idx="70">25.07959329813783</cx:pt>
          <cx:pt idx="71">11.28007092176286</cx:pt>
          <cx:pt idx="72">10.435276709316337</cx:pt>
          <cx:pt idx="73">0.0014134850547494304</cx:pt>
          <cx:pt idx="74">11.880698632656246</cx:pt>
          <cx:pt idx="75">25.185769791689911</cx:pt>
          <cx:pt idx="76">14.571822123536919</cx:pt>
          <cx:pt idx="77">9.4146747155703672</cx:pt>
          <cx:pt idx="78">25.171630856978656</cx:pt>
          <cx:pt idx="79">25.094899880254552</cx:pt>
          <cx:pt idx="80">25.070360986631208</cx:pt>
          <cx:pt idx="81">39.317171820974103</cx:pt>
          <cx:pt idx="82">12.500239997696044</cx:pt>
          <cx:pt idx="83">25.156927475349605</cx:pt>
          <cx:pt idx="84">16.545875619017568</cx:pt>
          <cx:pt idx="85">25.112486933794507</cx:pt>
          <cx:pt idx="86">25.1101772196056</cx:pt>
          <cx:pt idx="87">25.335271855656099</cx:pt>
          <cx:pt idx="88">25.144601806351996</cx:pt>
          <cx:pt idx="89">25.227802123847411</cx:pt>
          <cx:pt idx="90">25.173140447707354</cx:pt>
          <cx:pt idx="91">7.2339753939310567</cx:pt>
          <cx:pt idx="92">25.082523796460354</cx:pt>
          <cx:pt idx="93">25.306659202668374</cx:pt>
          <cx:pt idx="94">25.188410033187886</cx:pt>
          <cx:pt idx="95">25.156251708074478</cx:pt>
          <cx:pt idx="96">25.169048452414728</cx:pt>
          <cx:pt idx="97">25.12287801984478</cx:pt>
          <cx:pt idx="98">25.204662267128281</cx:pt>
          <cx:pt idx="99">25.172564430347578</cx:pt>
          <cx:pt idx="100">25.078197702386827</cx:pt>
          <cx:pt idx="101">25.171074669151494</cx:pt>
          <cx:pt idx="102">25.119554136170493</cx:pt>
          <cx:pt idx="103">25.126619350800063</cx:pt>
          <cx:pt idx="104">25.157185852157625</cx:pt>
          <cx:pt idx="105">25.177470087361836</cx:pt>
          <cx:pt idx="106">25.123216354599187</cx:pt>
          <cx:pt idx="107">25.5038428476965</cx:pt>
          <cx:pt idx="108">8.3345665754135041</cx:pt>
          <cx:pt idx="109">4.0525177359266422</cx:pt>
          <cx:pt idx="110">25.167399547827742</cx:pt>
          <cx:pt idx="111">25.147564494399848</cx:pt>
          <cx:pt idx="112">10.645045796049917</cx:pt>
          <cx:pt idx="113">25.166902868648737</cx:pt>
          <cx:pt idx="114">0.0061247857105371454</cx:pt>
          <cx:pt idx="115">25.187854215871585</cx:pt>
          <cx:pt idx="116">17.09037740952493</cx:pt>
          <cx:pt idx="117">16.498302943030232</cx:pt>
          <cx:pt idx="118">25.13384172783779</cx:pt>
          <cx:pt idx="119">25.131175857886156</cx:pt>
          <cx:pt idx="120">25.173259622067224</cx:pt>
          <cx:pt idx="121">25.175305360610821</cx:pt>
          <cx:pt idx="122">25.662073182032664</cx:pt>
          <cx:pt idx="123">25.15088467628922</cx:pt>
          <cx:pt idx="124">25.237848561238334</cx:pt>
          <cx:pt idx="125">25.076562762866843</cx:pt>
          <cx:pt idx="126">8.3460409776132778</cx:pt>
          <cx:pt idx="127">25.038510339075685</cx:pt>
          <cx:pt idx="128">25.15835845201352</cx:pt>
          <cx:pt idx="129">25.073930685076085</cx:pt>
          <cx:pt idx="130">8.23889555705132</cx:pt>
          <cx:pt idx="131">25.114199170986918</cx:pt>
          <cx:pt idx="132">13.179415768538453</cx:pt>
          <cx:pt idx="133">25.127335712327319</cx:pt>
          <cx:pt idx="134">17.081890996022658</cx:pt>
          <cx:pt idx="135">25.176060057125699</cx:pt>
          <cx:pt idx="136">25.228911986052825</cx:pt>
          <cx:pt idx="137">25.150268388229975</cx:pt>
          <cx:pt idx="138">25.076363372706179</cx:pt>
          <cx:pt idx="139">25.178045992491153</cx:pt>
          <cx:pt idx="140">25.073850920829855</cx:pt>
          <cx:pt idx="141">25.370967659906075</cx:pt>
          <cx:pt idx="142">25.175444385352964</cx:pt>
          <cx:pt idx="143">25.152355754481526</cx:pt>
          <cx:pt idx="144">25.169684145813193</cx:pt>
          <cx:pt idx="145">25.176159357614498</cx:pt>
          <cx:pt idx="146">25.176814731017906</cx:pt>
          <cx:pt idx="147">25.12098724174669</cx:pt>
          <cx:pt idx="148">8.1528829256895374</cx:pt>
          <cx:pt idx="149">25.161240033034936</cx:pt>
          <cx:pt idx="150">7.843933961986167</cx:pt>
          <cx:pt idx="151">25.204186160239335</cx:pt>
          <cx:pt idx="152">25.086669767029662</cx:pt>
          <cx:pt idx="153">11.354602591020084</cx:pt>
          <cx:pt idx="154">1.1940644873707618</cx:pt>
          <cx:pt idx="155">8.4233900538916036</cx:pt>
          <cx:pt idx="156">25.142633115885062</cx:pt>
          <cx:pt idx="157">25.160782976688147</cx:pt>
          <cx:pt idx="158">8.4174045881138451</cx:pt>
          <cx:pt idx="159">25.159073909824265</cx:pt>
          <cx:pt idx="160">5.823349551589704</cx:pt>
          <cx:pt idx="161">25.187298386289864</cx:pt>
          <cx:pt idx="162">25.089061361477839</cx:pt>
          <cx:pt idx="163">25.169465628018408</cx:pt>
          <cx:pt idx="164">25.612575036493308</cx:pt>
          <cx:pt idx="165">0.0048074213462104606</cx:pt>
          <cx:pt idx="166">25.211049164999061</cx:pt>
          <cx:pt idx="167">9.8988585200516948</cx:pt>
          <cx:pt idx="168">25.169167646149919</cx:pt>
          <cx:pt idx="169">12.197335774668172</cx:pt>
          <cx:pt idx="170">8.4286831711721142</cx:pt>
          <cx:pt idx="171">8.3263497404324784</cx:pt>
          <cx:pt idx="172">17.154212310683345</cx:pt>
          <cx:pt idx="173">25.117205258547376</cx:pt>
          <cx:pt idx="174">25.709920264364882</cx:pt>
          <cx:pt idx="175">25.122042114446032</cx:pt>
          <cx:pt idx="176">25.160643870934624</cx:pt>
          <cx:pt idx="177">4.9097250432177972</cx:pt>
          <cx:pt idx="178">25.164856447037405</cx:pt>
          <cx:pt idx="179">25.227366093193321</cx:pt>
          <cx:pt idx="180">25.268399236991645</cx:pt>
          <cx:pt idx="181">25.105437658005485</cx:pt>
          <cx:pt idx="182">25.232162015966846</cx:pt>
          <cx:pt idx="183">24.95317615054244</cx:pt>
          <cx:pt idx="184">25.082942411128723</cx:pt>
          <cx:pt idx="185">25.145814761108852</cx:pt>
          <cx:pt idx="186">5.0418647344013507</cx:pt>
          <cx:pt idx="187">21.009854830531314</cx:pt>
          <cx:pt idx="188">25.248564315620008</cx:pt>
          <cx:pt idx="189">25.436312625850473</cx:pt>
          <cx:pt idx="190">25.181004745641104</cx:pt>
          <cx:pt idx="191">25.169664280637516</cx:pt>
          <cx:pt idx="192">10.822661410207751</cx:pt>
          <cx:pt idx="193">10.074671210516003</cx:pt>
          <cx:pt idx="194">24.927956193799762</cx:pt>
          <cx:pt idx="195">12.283240614756352</cx:pt>
          <cx:pt idx="196">13.03472285858046</cx:pt>
          <cx:pt idx="197">25.076941599804393</cx:pt>
          <cx:pt idx="198">0.0044017723703072154</cx:pt>
          <cx:pt idx="199">25.174928003869248</cx:pt>
          <cx:pt idx="200">25.169723876117512</cx:pt>
          <cx:pt idx="201">25.089738938458488</cx:pt>
          <cx:pt idx="202">25.178423302502484</cx:pt>
          <cx:pt idx="203">25.115552950313475</cx:pt>
          <cx:pt idx="204">25.500549013697725</cx:pt>
          <cx:pt idx="205">9.3111599707018247</cx:pt>
          <cx:pt idx="206">11.994540424709902</cx:pt>
          <cx:pt idx="207">25.131772719010492</cx:pt>
          <cx:pt idx="208">25.133980981929621</cx:pt>
          <cx:pt idx="209">25.127534698016042</cx:pt>
          <cx:pt idx="210">25.184757294840065</cx:pt>
          <cx:pt idx="211">25.149075529728719</cx:pt>
          <cx:pt idx="212">25.049451091790413</cx:pt>
          <cx:pt idx="213">25.162213734089455</cx:pt>
          <cx:pt idx="214">25.175722432534087</cx:pt>
          <cx:pt idx="215">16.269572827828025</cx:pt>
          <cx:pt idx="216">12.623747462619805</cx:pt>
          <cx:pt idx="217">25.170677384607671</cx:pt>
          <cx:pt idx="218">25.094879955879446</cx:pt>
          <cx:pt idx="219">25.157702597812857</cx:pt>
          <cx:pt idx="220">0.0036855257426858384</cx:pt>
          <cx:pt idx="221">25.120688684827098</cx:pt>
          <cx:pt idx="222">24.908452380667892</cx:pt>
          <cx:pt idx="223">25.116986284186243</cx:pt>
          <cx:pt idx="224">7.2071076029153334</cx:pt>
          <cx:pt idx="225">25.147922379393489</cx:pt>
          <cx:pt idx="226">13.494369196075823</cx:pt>
          <cx:pt idx="227">11.259840140961149</cx:pt>
          <cx:pt idx="228">12.326840633349649</cx:pt>
          <cx:pt idx="229">25.186782247837851</cx:pt>
          <cx:pt idx="230">25.165929349022658</cx:pt>
          <cx:pt idx="231">25.167637950352034</cx:pt>
          <cx:pt idx="232">25.066591311943469</cx:pt>
          <cx:pt idx="233">25.158020589863582</cx:pt>
          <cx:pt idx="234">26.840547684427008</cx:pt>
          <cx:pt idx="235">25.148777306262826</cx:pt>
          <cx:pt idx="236">11.284635572316901</cx:pt>
          <cx:pt idx="237">25.921612604157175</cx:pt>
          <cx:pt idx="238">25.166664459161055</cx:pt>
          <cx:pt idx="239">25.086749490517903</cx:pt>
          <cx:pt idx="240">25.129444880458461</cx:pt>
          <cx:pt idx="241">25.190196505783753</cx:pt>
          <cx:pt idx="242">25.162690635144724</cx:pt>
          <cx:pt idx="243">25.064117778210349</cx:pt>
          <cx:pt idx="244">25.736608168132801</cx:pt>
          <cx:pt idx="245">25.170240364366801</cx:pt>
          <cx:pt idx="246">25.088124680812633</cx:pt>
          <cx:pt idx="247">15.373125902040874</cx:pt>
          <cx:pt idx="248">14.141994201667599</cx:pt>
          <cx:pt idx="249">25.19787689469095</cx:pt>
          <cx:pt idx="250">25.162253476189289</cx:pt>
          <cx:pt idx="251">25.13364279208249</cx:pt>
          <cx:pt idx="252">25.220646304169129</cx:pt>
          <cx:pt idx="253">9.7204320891614682</cx:pt>
          <cx:pt idx="254">25.14728613588353</cx:pt>
          <cx:pt idx="255">25.127713783788607</cx:pt>
          <cx:pt idx="256">6.8829499489681023</cx:pt>
          <cx:pt idx="257">8.963185817553935</cx:pt>
          <cx:pt idx="258">6.2851332523662542</cx:pt>
          <cx:pt idx="259">0.011734734764791236</cx:pt>
          <cx:pt idx="260">25.164379587027376</cx:pt>
          <cx:pt idx="261">25.162730376491343</cx:pt>
          <cx:pt idx="262">10.010594387947201</cx:pt>
          <cx:pt idx="263">25.149691847018723</cx:pt>
          <cx:pt idx="264">25.205693801202933</cx:pt>
          <cx:pt idx="265">25.173656865858803</cx:pt>
          <cx:pt idx="266">25.167618083561266</cx:pt>
          <cx:pt idx="267">25.160524636819481</cx:pt>
          <cx:pt idx="268">24.892910637368221</cx:pt>
          <cx:pt idx="269">15.53634448639705</cx:pt>
          <cx:pt idx="270">24.864935149724403</cx:pt>
          <cx:pt idx="271">25.181878404916503</cx:pt>
          <cx:pt idx="272">25.23844289967192</cx:pt>
          <cx:pt idx="273">25.176000476644418</cx:pt>
          <cx:pt idx="274">5.3579940276189193</cx:pt>
          <cx:pt idx="275">25.19446367756218</cx:pt>
          <cx:pt idx="276">25.149890655825917</cx:pt>
          <cx:pt idx="277">9.5254606187837449</cx:pt>
          <cx:pt idx="278">25.156370962442097</cx:pt>
          <cx:pt idx="279">25.13839692581848</cx:pt>
          <cx:pt idx="280">13.728255533752275</cx:pt>
          <cx:pt idx="281">25.15088467628922</cx:pt>
          <cx:pt idx="282">12.277581195007427</cx:pt>
          <cx:pt idx="283">25.348550254403111</cx:pt>
          <cx:pt idx="284">17.814292015120895</cx:pt>
          <cx:pt idx="285">25.169525223968769</cx:pt>
          <cx:pt idx="286">12.539776712525624</cx:pt>
          <cx:pt idx="287">24.424434486800305</cx:pt>
          <cx:pt idx="288">9.1793082528042387</cx:pt>
          <cx:pt idx="289">25.123853207659053</cx:pt>
          <cx:pt idx="290">25.648274795783049</cx:pt>
          <cx:pt idx="291">25.204404377013155</cx:pt>
          <cx:pt idx="292">25.115891383743481</cx:pt>
          <cx:pt idx="293">8.851802076413593</cx:pt>
          <cx:pt idx="294">25.149572560980037</cx:pt>
          <cx:pt idx="295">25.164498802877038</cx:pt>
          <cx:pt idx="296">14.474529353315777</cx:pt>
          <cx:pt idx="297">15.381839941957528</cx:pt>
          <cx:pt idx="298">10.902430921588085</cx:pt>
          <cx:pt idx="299">12.181789687890692</cx:pt>
          <cx:pt idx="300">25.200952362956446</cx:pt>
          <cx:pt idx="301">25.162650893735339</cx:pt>
          <cx:pt idx="302">25.159272644494319</cx:pt>
          <cx:pt idx="303">25.10268909897902</cx:pt>
          <cx:pt idx="304">13.725742238582219</cx:pt>
          <cx:pt idx="305">25.1899781659294</cx:pt>
          <cx:pt idx="306">8.8927442333623876</cx:pt>
          <cx:pt idx="307">25.160564381587307</cx:pt>
          <cx:pt idx="308">25.147763320025103</cx:pt>
          <cx:pt idx="309">25.161220161192499</cx:pt>
          <cx:pt idx="310">25.093644613726401</cx:pt>
          <cx:pt idx="311">25.124947761139723</cx:pt>
          <cx:pt idx="312">10.528580151188478</cx:pt>
          <cx:pt idx="313">25.187377791266798</cx:pt>
          <cx:pt idx="314">13.409026810324454</cx:pt>
          <cx:pt idx="315">11.785245012302461</cx:pt>
          <cx:pt idx="316">25.175384803414623</cx:pt>
          <cx:pt idx="317">25.0814473266596</cx:pt>
          <cx:pt idx="318">10.315522284402279</cx:pt>
          <cx:pt idx="319">24.391412423227976</cx:pt>
          <cx:pt idx="320">25.002199903208517</cx:pt>
          <cx:pt idx="321">25.162889341250143</cx:pt>
          <cx:pt idx="322">25.111391837172224</cx:pt>
          <cx:pt idx="323">17.91957030734833</cx:pt>
          <cx:pt idx="324">25.177489946378689</cx:pt>
          <cx:pt idx="325">25.111471482173243</cx:pt>
          <cx:pt idx="326">25.151978053425537</cx:pt>
          <cx:pt idx="327">25.170299958482818</cx:pt>
          <cx:pt idx="328">12.633012309025904</cx:pt>
          <cx:pt idx="329">0.0011635634920364251</cx:pt>
          <cx:pt idx="330">25.151182874767542</cx:pt>
          <cx:pt idx="331">25.154025522766727</cx:pt>
          <cx:pt idx="332">5.3944230460726752</cx:pt>
          <cx:pt idx="333">25.06774820361813</cx:pt>
          <cx:pt idx="334">10.077747764257646</cx:pt>
          <cx:pt idx="335">25.181143738917022</cx:pt>
          <cx:pt idx="336">18.660894941025738</cx:pt>
          <cx:pt idx="337">25.161359263759977</cx:pt>
          <cx:pt idx="338">16.179400483330646</cx:pt>
          <cx:pt idx="339">25.17196853644943</cx:pt>
          <cx:pt idx="340">25.159769474301623</cx:pt>
          <cx:pt idx="341">25.152733449865845</cx:pt>
          <cx:pt idx="342">25.270219627062996</cx:pt>
          <cx:pt idx="343">25.076762151442118</cx:pt>
          <cx:pt idx="344">2.5699766535904565</cx:pt>
          <cx:pt idx="345">25.139291955025307</cx:pt>
          <cx:pt idx="346">25.180845895243475</cx:pt>
          <cx:pt idx="347">25.481189140226562</cx:pt>
          <cx:pt idx="348">25.35227800415576</cx:pt>
          <cx:pt idx="349">10.544429809145679</cx:pt>
          <cx:pt idx="350">17.52578100970111</cx:pt>
          <cx:pt idx="351">25.008298622657239</cx:pt>
          <cx:pt idx="352">25.325244322612168</cx:pt>
          <cx:pt idx="353">25.180845895243475</cx:pt>
          <cx:pt idx="354">25.195575008322397</cx:pt>
          <cx:pt idx="355">11.207854388775756</cx:pt>
          <cx:pt idx="356">24.338467494893756</cx:pt>
          <cx:pt idx="357">8.685033102988152</cx:pt>
          <cx:pt idx="358">25.165988953347334</cx:pt>
          <cx:pt idx="359">9.8264337376283173</cx:pt>
          <cx:pt idx="360">16.275533785409312</cx:pt>
          <cx:pt idx="361">25.170419146291543</cx:pt>
          <cx:pt idx="362">25.156013197643222</cx:pt>
          <cx:pt idx="363">25.172703470227432</cx:pt>
          <cx:pt idx="364">10.584233557513741</cx:pt>
          <cx:pt idx="365">9.8213644673232654</cx:pt>
          <cx:pt idx="366">13.621380253116788</cx:pt>
          <cx:pt idx="367">26.085072359493271</cx:pt>
          <cx:pt idx="368">25.258642085432857</cx:pt>
          <cx:pt idx="369">25.130837630290003</cx:pt>
          <cx:pt idx="370">25.177847406003558</cx:pt>
          <cx:pt idx="371">16.276854733025051</cx:pt>
          <cx:pt idx="372">25.153131017827583</cx:pt>
          <cx:pt idx="373">25.21245723843672</cx:pt>
          <cx:pt idx="374">25.142672888935259</cx:pt>
          <cx:pt idx="375">25.147047540417145</cx:pt>
          <cx:pt idx="376">16.017178278336043</cx:pt>
          <cx:pt idx="377">13.618406661573887</cx:pt>
          <cx:pt idx="378">5.2208619977930848</cx:pt>
          <cx:pt idx="379">25.240265450268151</cx:pt>
          <cx:pt idx="380">25.162690635144724</cx:pt>
          <cx:pt idx="381">25.149592442025774</cx:pt>
          <cx:pt idx="382">25.073990508094241</cx:pt>
          <cx:pt idx="383">25.231547713130876</cx:pt>
          <cx:pt idx="384">25.084995515247755</cx:pt>
          <cx:pt idx="385">25.154482701896296</cx:pt>
          <cx:pt idx="386">25.188151976673478</cx:pt>
          <cx:pt idx="387">25.136666445652651</cx:pt>
          <cx:pt idx="388">25.403267506366184</cx:pt>
          <cx:pt idx="389">25.138814610080562</cx:pt>
          <cx:pt idx="390">8.7355022751986056</cx:pt>
          <cx:pt idx="391">25.149910536620208</cx:pt>
          <cx:pt idx="392">25.161458622265918</cx:pt>
          <cx:pt idx="393">25.121265891670348</cx:pt>
          <cx:pt idx="394">25.187953469863327</cx:pt>
          <cx:pt idx="395">25.116886749754634</cx:pt>
          <cx:pt idx="396">25.146510692340602</cx:pt>
          <cx:pt idx="397">6.636761258324726</cx:pt>
          <cx:pt idx="398">25.17566285125379</cx:pt>
          <cx:pt idx="399">8.3102226203634277</cx:pt>
          <cx:pt idx="400">25.20781624814018</cx:pt>
          <cx:pt idx="401">25.146948124971345</cx:pt>
          <cx:pt idx="402">25.085912381254943</cx:pt>
          <cx:pt idx="403">25.158159710121879</cx:pt>
          <cx:pt idx="404">8.0575926926098713</cx:pt>
          <cx:pt idx="405">17.705874731286222</cx:pt>
          <cx:pt idx="406">25.160107312966691</cx:pt>
          <cx:pt idx="407">11.17286892431841</cx:pt>
          <cx:pt idx="408">25.177807688518079</cx:pt>
          <cx:pt idx="409">25.179793486047497</cx:pt>
          <cx:pt idx="410">25.180170769873662</cx:pt>
          <cx:pt idx="411">8.5961561177074959</cx:pt>
          <cx:pt idx="412">25.129385189454993</cx:pt>
          <cx:pt idx="413">25.107847378857471</cx:pt>
          <cx:pt idx="414">25.12934539537391</cx:pt>
          <cx:pt idx="415">7.4536299881332981</cx:pt>
          <cx:pt idx="416">25.167637950352034</cx:pt>
          <cx:pt idx="417">25.100597602447639</cx:pt>
          <cx:pt idx="418">13.868489463528464</cx:pt>
          <cx:pt idx="419">25.180746613236078</cx:pt>
          <cx:pt idx="420">25.283611292693138</cx:pt>
          <cx:pt idx="421">16.24776907763032</cx:pt>
          <cx:pt idx="422">25.169306704794238</cx:pt>
          <cx:pt idx="423">25.198849180071697</cx:pt>
          <cx:pt idx="424">1.0840064575453414</cx:pt>
          <cx:pt idx="425">25.149890655825917</cx:pt>
          <cx:pt idx="426">11.553787257864842</cx:pt>
          <cx:pt idx="427">25.163783499307097</cx:pt>
          <cx:pt idx="428">25.171690447802664</cx:pt>
          <cx:pt idx="429">25.20724102316634</cx:pt>
          <cx:pt idx="430">18.457166629794507</cx:pt>
          <cx:pt idx="431">25.181123882781719</cx:pt>
          <cx:pt idx="432">25.331798199101463</cx:pt>
          <cx:pt idx="433">6.5342099751997562</cx:pt>
          <cx:pt idx="434">8.2274236550696731</cx:pt>
          <cx:pt idx="435">25.126241262870973</cx:pt>
          <cx:pt idx="436">3.2277856186556133</cx:pt>
          <cx:pt idx="437">25.187735110565225</cx:pt>
          <cx:pt idx="438">25.133006187083947</cx:pt>
          <cx:pt idx="439">20.177363554240678</cx:pt>
          <cx:pt idx="440">25.16698233797608</cx:pt>
          <cx:pt idx="441">25.172028126474039</cx:pt>
          <cx:pt idx="442">13.40705038403302</cx:pt>
          <cx:pt idx="443">25.182930726982512</cx:pt>
          <cx:pt idx="444">25.149870775015927</cx:pt>
          <cx:pt idx="445">25.074130094581548</cx:pt>
          <cx:pt idx="446">25.136566989149493</cx:pt>
          <cx:pt idx="447">25.158060338587312</cx:pt>
          <cx:pt idx="448">25.149393630861162</cx:pt>
          <cx:pt idx="449">9.9851990465889067</cx:pt>
          <cx:pt idx="450">6.5155889987014994</cx:pt>
          <cx:pt idx="451">25.085194836795665</cx:pt>
          <cx:pt idx="452">25.175782013673377</cx:pt>
          <cx:pt idx="453">25.168651135887277</cx:pt>
          <cx:pt idx="454">12.044251740975859</cx:pt>
          <cx:pt idx="455">25.095457756335112</cx:pt>
          <cx:pt idx="456">14.351724635039512</cx:pt>
          <cx:pt idx="457">24.893051239251488</cx:pt>
          <cx:pt idx="458">24.17724136455605</cx:pt>
          <cx:pt idx="459">25.127256117610614</cx:pt>
          <cx:pt idx="460">9.9365738562142223</cx:pt>
          <cx:pt idx="461">25.156688971325302</cx:pt>
          <cx:pt idx="462">12.010786818522757</cx:pt>
          <cx:pt idx="463">25.550283755762869</cx:pt>
          <cx:pt idx="464">25.153926134899894</cx:pt>
          <cx:pt idx="465">6.441715609990867</cx:pt>
          <cx:pt idx="466">25.182076959615546</cx:pt>
          <cx:pt idx="467">25.160524636819481</cx:pt>
          <cx:pt idx="468">25.075844950868554</cx:pt>
          <cx:pt idx="469">25.087028520731586</cx:pt>
          <cx:pt idx="470">25.117901982450686</cx:pt>
          <cx:pt idx="471">25.130837630290003</cx:pt>
          <cx:pt idx="472">25.245098534170946</cx:pt>
          <cx:pt idx="473">25.150288268725667</cx:pt>
          <cx:pt idx="474">8.8393325539884522</cx:pt>
          <cx:pt idx="475">24.328296282312905</cx:pt>
          <cx:pt idx="476">25.203491821571074</cx:pt>
          <cx:pt idx="477">25.156847974259417</cx:pt>
          <cx:pt idx="478">15.111915828246264</cx:pt>
          <cx:pt idx="479">7.6689569042993071</cx:pt>
          <cx:pt idx="480">25.241711510909877</cx:pt>
          <cx:pt idx="481">25.129444880458461</cx:pt>
          <cx:pt idx="482">9.5708672543296718</cx:pt>
          <cx:pt idx="483">25.146451041846841</cx:pt>
          <cx:pt idx="484">24.553533350619823</cx:pt>
          <cx:pt idx="485">25.108464708141753</cx:pt>
          <cx:pt idx="486">25.162452185746918</cx:pt>
          <cx:pt idx="487">25.133662685728876</cx:pt>
          <cx:pt idx="488">23.033150023390199</cx:pt>
          <cx:pt idx="489">9.1227901433717093</cx:pt>
          <cx:pt idx="490">25.100258962807537</cx:pt>
          <cx:pt idx="491">10.01009490464501</cx:pt>
          <cx:pt idx="492">9.1894776783014169</cx:pt>
          <cx:pt idx="493">8.1189777681676158</cx:pt>
          <cx:pt idx="494">14.238574366838838</cx:pt>
          <cx:pt idx="495">25.573208637165575</cx:pt>
          <cx:pt idx="496">25.159570743556021</cx:pt>
          <cx:pt idx="497">25.157364726854841</cx:pt>
          <cx:pt idx="498">25.158139835846367</cx:pt>
          <cx:pt idx="499">25.187616004695641</cx:pt>
          <cx:pt idx="500">25.169843066654192</cx:pt>
          <cx:pt idx="501">25.161240033034936</cx:pt>
          <cx:pt idx="502">11.456526524213174</cx:pt>
          <cx:pt idx="503">25.169088183722511</cx:pt>
          <cx:pt idx="504">25.028044270377979</cx:pt>
          <cx:pt idx="505">4.8337045834432217</cx:pt>
          <cx:pt idx="506">25.165929349022658</cx:pt>
          <cx:pt idx="507">12.165114056185416</cx:pt>
          <cx:pt idx="508">25.170061581172181</cx:pt>
          <cx:pt idx="509">25.105437658005485</cx:pt>
          <cx:pt idx="510">31.071047616712249</cx:pt>
          <cx:pt idx="511">25.164538541368092</cx:pt>
          <cx:pt idx="512">25.897026856378709</cx:pt>
          <cx:pt idx="513">12.030004156275259</cx:pt>
          <cx:pt idx="514">25.424673055911651</cx:pt>
          <cx:pt idx="515">0.001840983432842349</cx:pt>
          <cx:pt idx="516">25.160286166894046</cx:pt>
          <cx:pt idx="517">25.054021633262792</cx:pt>
          <cx:pt idx="518">11.373389995951074</cx:pt>
          <cx:pt idx="519">25.14189730310742</cx:pt>
          <cx:pt idx="520">25.147743437533315</cx:pt>
          <cx:pt idx="521">25.183109418814826</cx:pt>
          <cx:pt idx="522">9.544123846639879</cx:pt>
          <cx:pt idx="523">25.801162764495711</cx:pt>
          <cx:pt idx="524">8.9826722082017447</cx:pt>
          <cx:pt idx="525">25.163207267755038</cx:pt>
          <cx:pt idx="526">25.165373035184675</cx:pt>
          <cx:pt idx="527">25.172246622024026</cx:pt>
          <cx:pt idx="528">25.167379680848779</cx:pt>
          <cx:pt idx="529">25.187973320614741</cx:pt>
          <cx:pt idx="530">5.3259271493327809</cx:pt>
          <cx:pt idx="531">25.149831013348777</cx:pt>
          <cx:pt idx="532">25.101215110030033</cx:pt>
          <cx:pt idx="533">25.166565121207938</cx:pt>
          <cx:pt idx="534">25.185233769016317</cx:pt>
          <cx:pt idx="535">25.172484978642849</cx:pt>
          <cx:pt idx="536">14.014849267830176</cx:pt>
          <cx:pt idx="537">25.089220793001921</cx:pt>
          <cx:pt idx="538">25.0731729144917</cx:pt>
          <cx:pt idx="539">16.836597043345783</cx:pt>
          <cx:pt idx="540">6.9744963975902952</cx:pt>
          <cx:pt idx="541">9.6473519682864275</cx:pt>
          <cx:pt idx="542">25.195455939514172</cx:pt>
          <cx:pt idx="543">25.197460189471478</cx:pt>
          <cx:pt idx="544">25.524262966832168</cx:pt>
          <cx:pt idx="545">25.096175007359189</cx:pt>
          <cx:pt idx="546">25.175444385352964</cx:pt>
          <cx:pt idx="547">25.161220161192499</cx:pt>
          <cx:pt idx="548">25.385940991028871</cx:pt>
          <cx:pt idx="549">25.119613850535206</cx:pt>
          <cx:pt idx="550">25.125763669986235</cx:pt>
          <cx:pt idx="551">10.608722826052155</cx:pt>
          <cx:pt idx="552">25.132389460614363</cx:pt>
          <cx:pt idx="553">7.96186535932378</cx:pt>
          <cx:pt idx="554">9.0515910203676349</cx:pt>
          <cx:pt idx="555">25.163247008285715</cx:pt>
          <cx:pt idx="556">12.64187486095318</cx:pt>
          <cx:pt idx="557">8.4576769860287282</cx:pt>
          <cx:pt idx="558">25.166366444125384</cx:pt>
          <cx:pt idx="559">25.099880477803076</cx:pt>
          <cx:pt idx="560">25.160822721047893</cx:pt>
          <cx:pt idx="561">25.378199305703308</cx:pt>
          <cx:pt idx="562">10.800046296197067</cx:pt>
          <cx:pt idx="563">25.155337405807142</cx:pt>
          <cx:pt idx="564">25.945269318316971</cx:pt>
          <cx:pt idx="565">25.172187032516664</cx:pt>
          <cx:pt idx="566">25.347169467220592</cx:pt>
          <cx:pt idx="567">25.176437396899509</cx:pt>
          <cx:pt idx="568">25.201666611555673</cx:pt>
          <cx:pt idx="569">25.000419996472061</cx:pt>
          <cx:pt idx="570">25.213587606685412</cx:pt>
          <cx:pt idx="571">25.169564954523942</cx:pt>
          <cx:pt idx="572">25.121166374195287</cx:pt>
          <cx:pt idx="573">12.647450335937279</cx:pt>
          <cx:pt idx="574">25.170498604517157</cx:pt>
          <cx:pt idx="575">7.0703323825687292</cx:pt>
          <cx:pt idx="576">11.178014134898918</cx:pt>
          <cx:pt idx="577">25.093525061258333</cx:pt>
          <cx:pt idx="578">25.172822646656059</cx:pt>
          <cx:pt idx="579">7.1208075384748328</cx:pt>
          <cx:pt idx="580">7.4614073739476261</cx:pt>
          <cx:pt idx="581">13.660161053223346</cx:pt>
          <cx:pt idx="582">25.079752789850225</cx:pt>
          <cx:pt idx="583">26.079129586702081</cx:pt>
          <cx:pt idx="584">25.146172671005022</cx:pt>
          <cx:pt idx="585">25.173001410241092</cx:pt>
          <cx:pt idx="586">25.14853872494384</cx:pt>
          <cx:pt idx="587">25.166644591601798</cx:pt>
          <cx:pt idx="588">7.292407010034478</cx:pt>
          <cx:pt idx="589">13.58259916216333</cx:pt>
          <cx:pt idx="590">25.139888623460529</cx:pt>
          <cx:pt idx="591">25.185829349060558</cx:pt>
          <cx:pt idx="592">25.167955816871579</cx:pt>
          <cx:pt idx="593">12.784600111071132</cx:pt>
          <cx:pt idx="594">13.124366651385508</cx:pt>
          <cx:pt idx="595">25.180865751597974</cx:pt>
          <cx:pt idx="596">5.2169914701866249</cx:pt>
          <cx:pt idx="597">13.313714733311663</cx:pt>
          <cx:pt idx="598">25.149294224689488</cx:pt>
          <cx:pt idx="599">25.177072903735255</cx:pt>
          <cx:pt idx="600">11.396578433898483</cx:pt>
          <cx:pt idx="601">25.321749544610856</cx:pt>
          <cx:pt idx="602">25.157762221628538</cx:pt>
          <cx:pt idx="603">13.041472309520884</cx:pt>
          <cx:pt idx="604">25.270555989134863</cx:pt>
          <cx:pt idx="605">25.18519406317926</cx:pt>
          <cx:pt idx="606">25.22320360303187</cx:pt>
          <cx:pt idx="607">25.157623099172149</cx:pt>
          <cx:pt idx="608">5.4793156506994549</cx:pt>
          <cx:pt idx="609">7.3813955320115445</cx:pt>
          <cx:pt idx="610">25.171471947424923</cx:pt>
          <cx:pt idx="611">25.200099206153929</cx:pt>
          <cx:pt idx="612">2.8958763785769586</cx:pt>
          <cx:pt idx="613">25.183149127938709</cx:pt>
          <cx:pt idx="614">9.9397686089767703</cx:pt>
          <cx:pt idx="615">25.410470282936519</cx:pt>
          <cx:pt idx="616">25.120688684827098</cx:pt>
          <cx:pt idx="617">25.116150182701169</cx:pt>
          <cx:pt idx="618">25.169763606359119</cx:pt>
          <cx:pt idx="619">24.924144920137177</cx:pt>
          <cx:pt idx="620">25.39230198308141</cx:pt>
          <cx:pt idx="621">25.184161689442831</cx:pt>
          <cx:pt idx="622">25.130300435927943</cx:pt>
          <cx:pt idx="623">25.156847974259417</cx:pt>
          <cx:pt idx="624">25.182851307983377</cx:pt>
          <cx:pt idx="625">16.467483110663878</cx:pt>
          <cx:pt idx="626">25.190950756174331</cx:pt>
          <cx:pt idx="627">25.31053140493103</cx:pt>
          <cx:pt idx="628">9.2515025806622351</cx:pt>
          <cx:pt idx="629">4.6873873319792985</cx:pt>
          <cx:pt idx="630">25.154641718776276</cx:pt>
          <cx:pt idx="631">25.548639885520323</cx:pt>
          <cx:pt idx="632">24.696497727410662</cx:pt>
          <cx:pt idx="633">25.165869744556812</cx:pt>
          <cx:pt idx="634">25.193153831944105</cx:pt>
          <cx:pt idx="635">25.156688971325302</cx:pt>
          <cx:pt idx="636">19.531768993104542</cx:pt>
          <cx:pt idx="637">25.170876027663404</cx:pt>
          <cx:pt idx="638">24.961790801142453</cx:pt>
          <cx:pt idx="639">13.174482912053891</cx:pt>
          <cx:pt idx="640">25.158298829610874</cx:pt>
          <cx:pt idx="641">0.010221937194093887</cx:pt>
          <cx:pt idx="642">25.160524636819481</cx:pt>
          <cx:pt idx="643">5.8186596394702441</cx:pt>
          <cx:pt idx="644">25.171531538625135</cx:pt>
          <cx:pt idx="645">25.155039256578394</cx:pt>
          <cx:pt idx="646">25.098167263766491</cx:pt>
          <cx:pt idx="647">25.180329624530334</cx:pt>
          <cx:pt idx="648">13.077079184588584</cx:pt>
          <cx:pt idx="649">25.138575934209161</cx:pt>
          <cx:pt idx="650">0.30791589760842164</cx:pt>
          <cx:pt idx="651">2.6834175970206354e-05</cx:pt>
          <cx:pt idx="652">25.166565121207938</cx:pt>
          <cx:pt idx="653">9.090258522176363</cx:pt>
          <cx:pt idx="654">25.14060460689042</cx:pt>
          <cx:pt idx="655">25.08836383664746</cx:pt>
          <cx:pt idx="656">14.775960205685449</cx:pt>
          <cx:pt idx="657">8.1529565189567883</cx:pt>
          <cx:pt idx="658">25.177966558084076</cx:pt>
          <cx:pt idx="659">0.017965160728476662</cx:pt>
          <cx:pt idx="660">25.177529664365405</cx:pt>
          <cx:pt idx="661">25.164061675333731</cx:pt>
          <cx:pt idx="662">4.7183047803209996</cx:pt>
          <cx:pt idx="663">9.426674917488139</cx:pt>
          <cx:pt idx="664">25.100557762727107</cx:pt>
          <cx:pt idx="665">25.138436705571017</cx:pt>
          <cx:pt idx="666">25.179197763233045</cx:pt>
          <cx:pt idx="667">25.177172200229318</cx:pt>
          <cx:pt idx="668">24.290780143914688</cx:pt>
          <cx:pt idx="669">25.149731608905888</cx:pt>
          <cx:pt idx="670">25.10115535189566</cx:pt>
          <cx:pt idx="671">25.15398576766712</cx:pt>
          <cx:pt idx="672">7.8060937734567348</cx:pt>
          <cx:pt idx="673">12.761151985616346</cx:pt>
          <cx:pt idx="674">5.732669535216556</cx:pt>
          <cx:pt idx="675">25.10952010692359</cx:pt>
          <cx:pt idx="676">3.7848381735551127</cx:pt>
          <cx:pt idx="677">25.4159398803192</cx:pt>
          <cx:pt idx="678">12.282711427042484</cx:pt>
          <cx:pt idx="679">25.162233605147222</cx:pt>
          <cx:pt idx="680">25.170578062491934</cx:pt>
          <cx:pt idx="681">25.160564381587307</cx:pt>
          <cx:pt idx="682">25.155893941579578</cx:pt>
          <cx:pt idx="683">25.094122817902999</cx:pt>
          <cx:pt idx="684">10.848225661369696</cx:pt>
          <cx:pt idx="685">25.198829337887901</cx:pt>
          <cx:pt idx="686">12.518945642505203</cx:pt>
          <cx:pt idx="687">25.196011589138468</cx:pt>
          <cx:pt idx="688">25.170160905325972</cx:pt>
          <cx:pt idx="689">25.184836707828779</cx:pt>
          <cx:pt idx="690">25.170895891882751</cx:pt>
          <cx:pt idx="691">4.0616499110583124</cx:pt>
          <cx:pt idx="692">25.179773628847425</cx:pt>
          <cx:pt idx="693">25.1782048605535</cx:pt>
          <cx:pt idx="694">25.188648236854633</cx:pt>
          <cx:pt idx="695">25.176258657711632</cx:pt>
          <cx:pt idx="696">2.0464383694604633</cx:pt>
          <cx:pt idx="697">8.4838670428054215</cx:pt>
          <cx:pt idx="698">25.169147780566586</cx:pt>
          <cx:pt idx="699">25.189660577308302</cx:pt>
          <cx:pt idx="700">25.247990019009436</cx:pt>
          <cx:pt idx="701">25.134080448665713</cx:pt>
          <cx:pt idx="702">25.14641127477239</cx:pt>
          <cx:pt idx="703">25.158656561907279</cx:pt>
          <cx:pt idx="704">18.999368410555125</cx:pt>
          <cx:pt idx="705">10.968318011436393</cx:pt>
          <cx:pt idx="706">12.596031120952347</cx:pt>
          <cx:pt idx="707">16.061008685633663</cx:pt>
          <cx:pt idx="708">0.0013666162592330005</cx:pt>
          <cx:pt idx="709">25.166445915146618</cx:pt>
          <cx:pt idx="710">5.975257316634992</cx:pt>
          <cx:pt idx="711">0.0015566277653954396</cx:pt>
          <cx:pt idx="712">7.0873831560033489</cx:pt>
          <cx:pt idx="713">10.229125084776312</cx:pt>
          <cx:pt idx="714">25.059010355558737</cx:pt>
          <cx:pt idx="715">20.984589583787432</cx:pt>
          <cx:pt idx="716">3.9459853015438364</cx:pt>
          <cx:pt idx="717">25.566227723307165</cx:pt>
          <cx:pt idx="718">25.176874309572266</cx:pt>
          <cx:pt idx="719">5.284590807243263</cx:pt>
          <cx:pt idx="720">25.144900079340143</cx:pt>
          <cx:pt idx="721">25.177708394530267</cx:pt>
          <cx:pt idx="722">25.109201500645135</cx:pt>
          <cx:pt idx="723">12.696219909878687</cx:pt>
          <cx:pt idx="724">25.087347408604199</cx:pt>
          <cx:pt idx="725">25.110675020795437</cx:pt>
          <cx:pt idx="726">7.95582805244055</cx:pt>
          <cx:pt idx="727">25.289523522597257</cx:pt>
          <cx:pt idx="728">25.273523695757188</cx:pt>
          <cx:pt idx="729">25.098466088587962</cx:pt>
          <cx:pt idx="730">25.111869703389271</cx:pt>
          <cx:pt idx="731">25.183288109379205</cx:pt>
          <cx:pt idx="732">25.159292517874981</cx:pt>
          <cx:pt idx="733">25.065873214392514</cx:pt>
          <cx:pt idx="734">9.6794834572925428</cx:pt>
          <cx:pt idx="735">25.167697550630251</cx:pt>
          <cx:pt idx="736">25.152773206944794</cx:pt>
          <cx:pt idx="737">25.169704010973192</cx:pt>
          <cx:pt idx="738">25.173319209035583</cx:pt>
          <cx:pt idx="739">5.6457683268090264</cx:pt>
          <cx:pt idx="740">25.181580569932461</cx:pt>
          <cx:pt idx="741">31.434073868972185</cx:pt>
          <cx:pt idx="742">25.171849355977006</cx:pt>
          <cx:pt idx="743">25.203253758195586</cx:pt>
          <cx:pt idx="744">25.346794669148998</cx:pt>
          <cx:pt idx="745">25.196904571792146</cx:pt>
          <cx:pt idx="746">25.243613053602292</cx:pt>
          <cx:pt idx="747">25.132110934022233</cx:pt>
          <cx:pt idx="748">12.673712952406646</cx:pt>
          <cx:pt idx="749">25.463954916705301</cx:pt>
          <cx:pt idx="750">25.175126613385679</cx:pt>
          <cx:pt idx="751">0.002307366464175121</cx:pt>
          <cx:pt idx="752">11.756572629810101</cx:pt>
          <cx:pt idx="753">25.14871766114527</cx:pt>
          <cx:pt idx="754">25.161061185888006</cx:pt>
          <cx:pt idx="755">7.9972557793283068</cx:pt>
          <cx:pt idx="756">25.161915666339873</cx:pt>
          <cx:pt idx="757">13.955285736952863</cx:pt>
          <cx:pt idx="758">11.740911378594083</cx:pt>
          <cx:pt idx="759">25.077519813570081</cx:pt>
          <cx:pt idx="760">3.7295844272519156</cx:pt>
          <cx:pt idx="761">25.0901175764483</cx:pt>
          <cx:pt idx="762">25.341290417024936</cx:pt>
          <cx:pt idx="763">25.146987891196833</cx:pt>
          <cx:pt idx="764">25.163942457413146</cx:pt>
          <cx:pt idx="765">12.434508434192322</cx:pt>
          <cx:pt idx="766">25.115015429021742</cx:pt>
          <cx:pt idx="767">25.171352764601274</cx:pt>
          <cx:pt idx="768">25.153548457424453</cx:pt>
          <cx:pt idx="769">25.189342984683027</cx:pt>
          <cx:pt idx="770">25.185551413459262</cx:pt>
          <cx:pt idx="771">15.937753919545877</cx:pt>
          <cx:pt idx="772">25.121405215473118</cx:pt>
          <cx:pt idx="773">25.181084170464146</cx:pt>
          <cx:pt idx="774">10.258752360789297</cx:pt>
          <cx:pt idx="775">18.296147135394381</cx:pt>
          <cx:pt idx="776">9.1681132191961936</cx:pt>
          <cx:pt idx="777">7.1808356059723302</cx:pt>
          <cx:pt idx="778">12.402661004800542</cx:pt>
          <cx:pt idx="779">15.816984541940982</cx:pt>
          <cx:pt idx="780">25.118738025625415</cx:pt>
          <cx:pt idx="781">4.0382298102014946</cx:pt>
          <cx:pt idx="782">25.295078572718449</cx:pt>
          <cx:pt idx="783">25.238819306774236</cx:pt>
          <cx:pt idx="784">25.080649911834424</cx:pt>
          <cx:pt idx="785">13.650897406397867</cx:pt>
          <cx:pt idx="786">25.037252245404247</cx:pt>
          <cx:pt idx="787">10.207203338819111</cx:pt>
          <cx:pt idx="788">25.08152706674775</cx:pt>
          <cx:pt idx="789">25.15877580487572</cx:pt>
          <cx:pt idx="790">25.164776970996584</cx:pt>
          <cx:pt idx="791">25.193669839862554</cx:pt>
          <cx:pt idx="792">25.148658015886255</cx:pt>
          <cx:pt idx="793">25.120031847113566</cx:pt>
          <cx:pt idx="794">25.863932415624657</cx:pt>
          <cx:pt idx="795">15.565988564816562</cx:pt>
          <cx:pt idx="796">12.804061855520693</cx:pt>
          <cx:pt idx="797">25.086749490517903</cx:pt>
          <cx:pt idx="798">25.090057791882426</cx:pt>
          <cx:pt idx="799">25.170995212744369</cx:pt>
          <cx:pt idx="800">5.0654812209700273</cx:pt>
          <cx:pt idx="801">13.160585093376358</cx:pt>
          <cx:pt idx="802">25.170677384607671</cx:pt>
          <cx:pt idx="803">25.199583329888615</cx:pt>
          <cx:pt idx="804">25.067389173984594</cx:pt>
          <cx:pt idx="805">12.548466041712031</cx:pt>
          <cx:pt idx="806">25.13348364234453</cx:pt>
          <cx:pt idx="807">12.683138412869269</cx:pt>
          <cx:pt idx="808">25.117941794661441</cx:pt>
          <cx:pt idx="809">25.085892449741547</cx:pt>
          <cx:pt idx="810">10.299660188569328</cx:pt>
          <cx:pt idx="811">25.126440257227049</cx:pt>
          <cx:pt idx="812">13.923038461485337</cx:pt>
          <cx:pt idx="813">25.179892771812991</cx:pt>
          <cx:pt idx="814">25.170796570629221</cx:pt>
          <cx:pt idx="815">8.1744479935956527</cx:pt>
          <cx:pt idx="816">25.3587263087088</cx:pt>
          <cx:pt idx="817">12.877305618800852</cx:pt>
          <cx:pt idx="818">25.075206878508499</cx:pt>
          <cx:pt idx="819">12.209586397581205</cx:pt>
          <cx:pt idx="820">25.322282677515474</cx:pt>
          <cx:pt idx="821">25.180508334821202</cx:pt>
          <cx:pt idx="822">24.856105889700423</cx:pt>
          <cx:pt idx="823">25.176973606849572</cx:pt>
          <cx:pt idx="824">25.111571038069286</cx:pt>
          <cx:pt idx="825">24.448701397006754</cx:pt>
          <cx:pt idx="826">25.182970436388157</cx:pt>
          <cx:pt idx="827">25.066990246138449</cx:pt>
          <cx:pt idx="828">25.168313411907441</cx:pt>
          <cx:pt idx="829">25.197222069109127</cx:pt>
          <cx:pt idx="830">25.165472377843418</cx:pt>
          <cx:pt idx="831">9.4759959898682951</cx:pt>
          <cx:pt idx="832">25.17566285125379</cx:pt>
          <cx:pt idx="833">25.172842509339304</cx:pt>
          <cx:pt idx="834">13.035490017640303</cx:pt>
          <cx:pt idx="835">25.178800606859731</cx:pt>
          <cx:pt idx="836">25.154979626308581</cx:pt>
          <cx:pt idx="837">10.727907531294255</cx:pt>
          <cx:pt idx="838">25.548933441535283</cx:pt>
          <cx:pt idx="839">25.156370962442097</cx:pt>
          <cx:pt idx="840">15.992717092476813</cx:pt>
          <cx:pt idx="841">25.222430493511126</cx:pt>
          <cx:pt idx="842">5.0005699675137034</cx:pt>
          <cx:pt idx="843">25.154085155298333</cx:pt>
          <cx:pt idx="844">4.8757871159434352</cx:pt>
          <cx:pt idx="845">14.694829022482706</cx:pt>
          <cx:pt idx="846">10.891694083107549</cx:pt>
          <cx:pt idx="847">5.6003303473991597</cx:pt>
          <cx:pt idx="848">25.164002066444041</cx:pt>
          <cx:pt idx="849">25.169088183722511</cx:pt>
          <cx:pt idx="850">25.004399612868134</cx:pt>
          <cx:pt idx="851">2.3580267174058904</cx:pt>
          <cx:pt idx="852">25.156211956492974</cx:pt>
          <cx:pt idx="853">25.050648694195527</cx:pt>
          <cx:pt idx="854">16.785648632090449</cx:pt>
          <cx:pt idx="855">25.15340931166191</cx:pt>
          <cx:pt idx="856">25.082284584941622</cx:pt>
          <cx:pt idx="857">25.177489946378689</cx:pt>
          <cx:pt idx="858">11.253044032616241</cx:pt>
          <cx:pt idx="859">25.102748853462241</cx:pt>
          <cx:pt idx="860">25.159709855242767</cx:pt>
          <cx:pt idx="861">25.123992517113997</cx:pt>
          <cx:pt idx="862">25.181362155371978</cx:pt>
          <cx:pt idx="863">5.436552216248824</cx:pt>
          <cx:pt idx="864">25.115413594046188</cx:pt>
          <cx:pt idx="865">25.103605318758497</cx:pt>
          <cx:pt idx="866">25.090476280852066</cx:pt>
          <cx:pt idx="867">25.175364942737176</cx:pt>
          <cx:pt idx="868">25.180091342169508</cx:pt>
          <cx:pt idx="869">25.157245477198014</cx:pt>
          <cx:pt idx="870">25.137999124830916</cx:pt>
          <cx:pt idx="871">25.185888906290366</cx:pt>
          <cx:pt idx="872">25.157225602200256</cx:pt>
          <cx:pt idx="873">24.697975625544696</cx:pt>
          <cx:pt idx="874">15.412397607121353</cx:pt>
          <cx:pt idx="875">25.175821734354571</cx:pt>
          <cx:pt idx="876">17.673030300432352</cx:pt>
          <cx:pt idx="877">25.160107312966691</cx:pt>
          <cx:pt idx="878">25.117384417968363</cx:pt>
          <cx:pt idx="879">25.15579456109467</cx:pt>
          <cx:pt idx="880">25.099900398208753</cx:pt>
          <cx:pt idx="881">11.623467640940891</cx:pt>
          <cx:pt idx="882">25.306916050755767</cx:pt>
          <cx:pt idx="883">9.6132772767667536</cx:pt>
          <cx:pt idx="884">25.147723555025809</cx:pt>
          <cx:pt idx="885">25.164220631682593</cx:pt>
          <cx:pt idx="886">25.175901175528949</cx:pt>
          <cx:pt idx="887">25.061264932161741</cx:pt>
          <cx:pt idx="888">24.147463634924478</cx:pt>
          <cx:pt idx="889">12.630201898623792</cx:pt>
          <cx:pt idx="890">15.351612293176245</cx:pt>
          <cx:pt idx="891">25.11348243474011</cx:pt>
          <cx:pt idx="892">25.574655422898662</cx:pt>
          <cx:pt idx="893">7.8764839871607695</cx:pt>
          <cx:pt idx="894">13.387867642010805</cx:pt>
          <cx:pt idx="895">25.138834499634228</cx:pt>
          <cx:pt idx="896">0.0022042912693199146</cx:pt>
          <cx:pt idx="897">8.165984325235998</cx:pt>
          <cx:pt idx="898">25.161399007209432</cx:pt>
          <cx:pt idx="899">25.1073694360839</cx:pt>
          <cx:pt idx="900">25.170995212744369</cx:pt>
          <cx:pt idx="901">25.17933676648374</cx:pt>
          <cx:pt idx="902">25.114736709748719</cx:pt>
          <cx:pt idx="903">25.546408749567913</cx:pt>
          <cx:pt idx="904">25.167181010196593</cx:pt>
          <cx:pt idx="905">25.185650676526105</cx:pt>
          <cx:pt idx="906">25.150685875339462</cx:pt>
          <cx:pt idx="907">25.166664459161055</cx:pt>
          <cx:pt idx="908">8.343128909467957</cx:pt>
          <cx:pt idx="909">25.196646602276264</cx:pt>
          <cx:pt idx="910">25.189779673510444</cx:pt>
          <cx:pt idx="911">9.9059426608475789</cx:pt>
          <cx:pt idx="912">25.161816309638695</cx:pt>
          <cx:pt idx="913">25.158159710121879</cx:pt>
          <cx:pt idx="914">11.848459815520327</cx:pt>
          <cx:pt idx="915">25.76049300770465</cx:pt>
          <cx:pt idx="916">13.359678139835554</cx:pt>
          <cx:pt idx="917">3.5693696922566036</cx:pt>
          <cx:pt idx="918">0.0039938577841480529</cx:pt>
          <cx:pt idx="919">14.749745760520755</cx:pt>
          <cx:pt idx="920">25.185035239205046</cx:pt>
          <cx:pt idx="921">25.183188836999971</cx:pt>
          <cx:pt idx="922">25.16076310448473</cx:pt>
          <cx:pt idx="923">10.352535921212734</cx:pt>
          <cx:pt idx="924">11.694400369407573</cx:pt>
          <cx:pt idx="925">25.078676201107587</cx:pt>
          <cx:pt idx="926">25.16886966075354</cx:pt>
          <cx:pt idx="927">14.971105503602598</cx:pt>
          <cx:pt idx="928">25.204543241249183</cx:pt>
          <cx:pt idx="929">7.3276462796726198</cx:pt>
          <cx:pt idx="930">12.496239434325833</cx:pt>
          <cx:pt idx="931">25.407065946307139</cx:pt>
          <cx:pt idx="932">25.178463019016867</cx:pt>
          <cx:pt idx="933">10.336053405434784</cx:pt>
          <cx:pt idx="934">25.179475768967073</cx:pt>
          <cx:pt idx="935">14.563138398023964</cx:pt>
          <cx:pt idx="936">25.170617791385258</cx:pt>
          <cx:pt idx="937">25.138337256071651</cx:pt>
          <cx:pt idx="938">25.163485450151775</cx:pt>
          <cx:pt idx="939">27.455454831417381</cx:pt>
          <cx:pt idx="940">9.3249450400525156</cx:pt>
          <cx:pt idx="941">25.011797216513653</cx:pt>
          <cx:pt idx="942">25.090934617905329</cx:pt>
          <cx:pt idx="943">25.185650676526105</cx:pt>
          <cx:pt idx="944">14.224415629473148</cx:pt>
          <cx:pt idx="945">25.163525190243121</cx:pt>
          <cx:pt idx="946">25.149691847018723</cx:pt>
          <cx:pt idx="947">0.0034881513728621349</cx:pt>
          <cx:pt idx="948">25.198134851611538</cx:pt>
          <cx:pt idx="949">7.0663286082661063</cx:pt>
          <cx:pt idx="950">25.450009823180814</cx:pt>
          <cx:pt idx="951">25.395097952163916</cx:pt>
          <cx:pt idx="952">25.173716451886879</cx:pt>
          <cx:pt idx="953">9.0871502683734686</cx:pt>
          <cx:pt idx="954">25.298992074784323</cx:pt>
          <cx:pt idx="955">25.498196014620326</cx:pt>
          <cx:pt idx="956">24.959947916612325</cx:pt>
          <cx:pt idx="957">25.159590616701216</cx:pt>
          <cx:pt idx="958">25.513565019416635</cx:pt>
          <cx:pt idx="959">25.183824173464998</cx:pt>
          <cx:pt idx="960">16.522923470136874</cx:pt>
          <cx:pt idx="961">25.170081446034299</cx:pt>
          <cx:pt idx="962">25.113562073111019</cx:pt>
          <cx:pt idx="963">20.278461480102479</cx:pt>
          <cx:pt idx="964">6.1375483704814906</cx:pt>
          <cx:pt idx="965">17.129098049809862</cx:pt>
          <cx:pt idx="966">0.018604596206314179</cx:pt>
          <cx:pt idx="967">25.080610040427647</cx:pt>
          <cx:pt idx="968">25.148916477653664</cx:pt>
          <cx:pt idx="969">25.080769525674445</cx:pt>
          <cx:pt idx="970">25.062082914235202</cx:pt>
          <cx:pt idx="971">7.1108157056697792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sz="20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l-GR" altLang="ja-JP" sz="1200" b="0" i="0" u="none" strike="noStrike" baseline="0" dirty="0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ω </a:t>
            </a:r>
            <a:r>
              <a:rPr lang="en-US" altLang="ja-JP" sz="1200" b="0" i="0" u="none" strike="noStrike" baseline="0" dirty="0" err="1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in,chronic</a:t>
            </a:r>
            <a:endParaRPr lang="ja-JP" altLang="en-US" sz="1200" b="0" i="0" u="none" strike="noStrike" baseline="0" dirty="0">
              <a:solidFill>
                <a:sysClr val="windowText" lastClr="000000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cx:rich>
      </cx:tx>
    </cx:title>
    <cx:plotArea>
      <cx:plotAreaRegion>
        <cx:series layoutId="clusteredColumn" uniqueId="{24604E1F-94D5-4263-AA9B-0E25749C1DB1}">
          <cx:tx>
            <cx:txData>
              <cx:f>'PD chronic'!$AI$1</cx:f>
              <cx:v>omega nKin %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Count val="10"/>
            </cx:binning>
          </cx:layoutPr>
        </cx:series>
      </cx:plotAreaRegion>
      <cx:axis id="0">
        <cx:catScaling gapWidth="0"/>
        <cx:tickLabels/>
        <cx:numFmt formatCode="#,##0.00_);[赤](#,##0.0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19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PD chronic'!$AJ$2:$AJ$1001</cx:f>
        <cx:lvl ptCount="1000" formatCode="G/標準">
          <cx:pt idx="0">28.163451493025494</cx:pt>
          <cx:pt idx="1">28.163149681809386</cx:pt>
          <cx:pt idx="2">28.165564080983714</cx:pt>
          <cx:pt idx="3">27.937591163162224</cx:pt>
          <cx:pt idx="4">28.164818479798516</cx:pt>
          <cx:pt idx="5">0.0041160053449916705</cx:pt>
          <cx:pt idx="6">0.024300205760445732</cx:pt>
          <cx:pt idx="7">27.887129647921817</cx:pt>
          <cx:pt idx="8">28.159243597795736</cx:pt>
          <cx:pt idx="9">20.481332964433737</cx:pt>
          <cx:pt idx="10">27.695053710003886</cx:pt>
          <cx:pt idx="11">0.00030398453908052624</cx:pt>
          <cx:pt idx="12">0.008288660929245446</cx:pt>
          <cx:pt idx="13">28.147841835565295</cx:pt>
          <cx:pt idx="14">28.165084768201925</cx:pt>
          <cx:pt idx="15">28.163327218210565</cx:pt>
          <cx:pt idx="16">0.012336814823932474</cx:pt>
          <cx:pt idx="17">27.844837941708334</cx:pt>
          <cx:pt idx="18">0.025342671524525587</cx:pt>
          <cx:pt idx="19">28.154964038336118</cx:pt>
          <cx:pt idx="20">0.0019392859510654948</cx:pt>
          <cx:pt idx="21">0.001344499907028632</cx:pt>
          <cx:pt idx="22">0.0021648048410884526</cx:pt>
          <cx:pt idx="23">28.172007383216414</cx:pt>
          <cx:pt idx="24">27.844891811605233</cx:pt>
          <cx:pt idx="25">28.169487038283108</cx:pt>
          <cx:pt idx="26">28.145710152703558</cx:pt>
          <cx:pt idx="27">28.151145625000773</cx:pt>
          <cx:pt idx="28">28.176745731187623</cx:pt>
          <cx:pt idx="29">27.859971284981611</cx:pt>
          <cx:pt idx="30">0.0026110017234770261</cx:pt>
          <cx:pt idx="31">28.159918323745188</cx:pt>
          <cx:pt idx="32">0.015079688325691617</cx:pt>
          <cx:pt idx="33">28.171954138823953</cx:pt>
          <cx:pt idx="34">28.161622822557653</cx:pt>
          <cx:pt idx="35">28.158515585875616</cx:pt>
          <cx:pt idx="36">24.910700512028964</cx:pt>
          <cx:pt idx="37">27.865893131209702</cx:pt>
          <cx:pt idx="38">28.172539821606428</cx:pt>
          <cx:pt idx="39">28.154750931237167</cx:pt>
          <cx:pt idx="40">0.052042194419528467</cx:pt>
          <cx:pt idx="41">27.853707114134735</cx:pt>
          <cx:pt idx="42">0.019904697937924102</cx:pt>
          <cx:pt idx="43">27.979331657493177</cx:pt>
          <cx:pt idx="44">28.160273436172456</cx:pt>
          <cx:pt idx="45">4.6968074263269513</cx:pt>
          <cx:pt idx="46">0.017942575066026617</cx:pt>
          <cx:pt idx="47">28.160113636134355</cx:pt>
          <cx:pt idx="48">28.159243597795736</cx:pt>
          <cx:pt idx="49">28.156242647057862</cx:pt>
          <cx:pt idx="50">28.166611439788063</cx:pt>
          <cx:pt idx="51">27.79672642596606</cx:pt>
          <cx:pt idx="52">0.02202864044828913</cx:pt>
          <cx:pt idx="53">28.166469427317299</cx:pt>
          <cx:pt idx="54">28.147042473410949</cx:pt>
          <cx:pt idx="55">0.033678034384447081</cx:pt>
          <cx:pt idx="56">28.169717783463859</cx:pt>
          <cx:pt idx="57">28.172593064891981</cx:pt>
          <cx:pt idx="58">0.0599472267915706</cx:pt>
          <cx:pt idx="59">28.171244203975089</cx:pt>
          <cx:pt idx="60">28.115689570060344</cx:pt>
          <cx:pt idx="61">28.150701589836086</cx:pt>
          <cx:pt idx="62">28.15343673514834</cx:pt>
          <cx:pt idx="63">0.032219093717856188</cx:pt>
          <cx:pt idx="64">28.161303236888735</cx:pt>
          <cx:pt idx="65">28.15164293607036</cx:pt>
          <cx:pt idx="66">28.153276896304629</cx:pt>
          <cx:pt idx="67">0.0013875157656761958</cx:pt>
          <cx:pt idx="68">0.0035080193842109827</cx:pt>
          <cx:pt idx="69">28.16877704125616</cx:pt>
          <cx:pt idx="70">28.150115452693974</cx:pt>
          <cx:pt idx="71">0.0034539542556322315</cx:pt>
          <cx:pt idx="72">0.0020307806380798492</cx:pt>
          <cx:pt idx="73">0.0046768258466613876</cx:pt>
          <cx:pt idx="74">0.0091062396190743841</cx:pt>
          <cx:pt idx="75">28.164800727148769</cx:pt>
          <cx:pt idx="76">0.001447991712683467</cx:pt>
          <cx:pt idx="77">0.0045831102976035829</cx:pt>
          <cx:pt idx="78">28.169771032083307</cx:pt>
          <cx:pt idx="79">28.145781211400049</cx:pt>
          <cx:pt idx="80">27.821646248919201</cx:pt>
          <cx:pt idx="81">0.0066491127227623383</cx:pt>
          <cx:pt idx="82">0.0029381439719659759</cx:pt>
          <cx:pt idx="83">28.161818123125503</cx:pt>
          <cx:pt idx="84">0.0093789231791288272</cx:pt>
          <cx:pt idx="85">28.162546049673846</cx:pt>
          <cx:pt idx="86">28.139864960585719</cx:pt>
          <cx:pt idx="87">27.789818279362677</cx:pt>
          <cx:pt idx="88">28.160806096417058</cx:pt>
          <cx:pt idx="89">27.888761177219756</cx:pt>
          <cx:pt idx="90">28.167996023856578</cx:pt>
          <cx:pt idx="91">0.011165213835838524</cx:pt>
          <cx:pt idx="92">28.14345394581127</cx:pt>
          <cx:pt idx="93">27.857853470789884</cx:pt>
          <cx:pt idx="94">28.161906895663158</cx:pt>
          <cx:pt idx="95">28.162048931141353</cx:pt>
          <cx:pt idx="96">28.155763175591602</cx:pt>
          <cx:pt idx="97">28.154750931237167</cx:pt>
          <cx:pt idx="98">28.155265937298481</cx:pt>
          <cx:pt idx="99">28.162705835910018</cx:pt>
          <cx:pt idx="100">28.147078001099867</cx:pt>
          <cx:pt idx="101">28.16432140137589</cx:pt>
          <cx:pt idx="102">28.141926017954066</cx:pt>
          <cx:pt idx="103">28.157823069264428</cx:pt>
          <cx:pt idx="104">28.165049263226933</cx:pt>
          <cx:pt idx="105">28.173817632688685</cx:pt>
          <cx:pt idx="106">28.153809688921321</cx:pt>
          <cx:pt idx="107">27.807229275855587</cx:pt>
          <cx:pt idx="108">0.0040694717101854884</cx:pt>
          <cx:pt idx="109">0.0070394175895453171</cx:pt>
          <cx:pt idx="110">28.168794791399932</cx:pt>
          <cx:pt idx="111">28.161676086483205</cx:pt>
          <cx:pt idx="112">0.0034005293705539432</cx:pt>
          <cx:pt idx="113">28.17188314614414</cx:pt>
          <cx:pt idx="114">0.0077648116525772864</cx:pt>
          <cx:pt idx="115">28.163451493025494</cx:pt>
          <cx:pt idx="116">0.015494644235993288</cx:pt>
          <cx:pt idx="117">0.0019282738394740516</cx:pt>
          <cx:pt idx="118">28.153507774343144</cx:pt>
          <cx:pt idx="119">28.157237080367103</cx:pt>
          <cx:pt idx="120">28.159971590894763</cx:pt>
          <cx:pt idx="121">28.165493072197407</cx:pt>
          <cx:pt idx="122">27.739826964132273</cx:pt>
          <cx:pt idx="123">28.166380669159462</cx:pt>
          <cx:pt idx="124">27.81364772912751</cx:pt>
          <cx:pt idx="125">28.121308646647297</cx:pt>
          <cx:pt idx="126">0.025653381843335973</cx:pt>
          <cx:pt idx="127">28.13975835006406</cx:pt>
          <cx:pt idx="128">28.160593033528254</cx:pt>
          <cx:pt idx="129">28.133147708708318</cx:pt>
          <cx:pt idx="130">0.0017759926801650958</cx:pt>
          <cx:pt idx="131">28.150239785834863</cx:pt>
          <cx:pt idx="132">0.046638074574321786</cx:pt>
          <cx:pt idx="133">28.158870715992855</cx:pt>
          <cx:pt idx="134">0.0014229089921706166</cx:pt>
          <cx:pt idx="135">28.153738650488318</cx:pt>
          <cx:pt idx="136">27.877015622193134</cx:pt>
          <cx:pt idx="137">28.149031954935854</cx:pt>
          <cx:pt idx="138">28.148605649303484</cx:pt>
          <cx:pt idx="139">28.165848114338754</cx:pt>
          <cx:pt idx="140">27.894909929949584</cx:pt>
          <cx:pt idx="141">27.863363041815319</cx:pt>
          <cx:pt idx="142">28.155265937298481</cx:pt>
          <cx:pt idx="143">28.16590137027395</cx:pt>
          <cx:pt idx="144">28.159403402771161</cx:pt>
          <cx:pt idx="145">28.16772976297522</cx:pt>
          <cx:pt idx="146">28.163646780912448</cx:pt>
          <cx:pt idx="147">28.155141626353082</cx:pt>
          <cx:pt idx="148">13.974405175176511</cx:pt>
          <cx:pt idx="149">28.17761522911405</cx:pt>
          <cx:pt idx="150">0.0043285794436512303</cx:pt>
          <cx:pt idx="151">28.150062166894052</cx:pt>
          <cx:pt idx="152">28.157237080367103</cx:pt>
          <cx:pt idx="153">0.01506456106230779</cx:pt>
          <cx:pt idx="154">0.021811258560660823</cx:pt>
          <cx:pt idx="155">0.006060957020141291</cx:pt>
          <cx:pt idx="156">28.168155779177305</cx:pt>
          <cx:pt idx="157">28.157982882301781</cx:pt>
          <cx:pt idx="158">0.21226539991246804</cx:pt>
          <cx:pt idx="159">28.173338460324505</cx:pt>
          <cx:pt idx="160">24.490835020472453</cx:pt>
          <cx:pt idx="161">28.166948716536549</cx:pt>
          <cx:pt idx="162">28.153347935902755</cx:pt>
          <cx:pt idx="163">28.17742003803755</cx:pt>
          <cx:pt idx="164">27.700631761748685</cx:pt>
          <cx:pt idx="165">0.0030683008327085531</cx:pt>
          <cx:pt idx="166">28.153418975321632</cx:pt>
          <cx:pt idx="167">0.0011958386178745023</cx:pt>
          <cx:pt idx="168">28.170055023020456</cx:pt>
          <cx:pt idx="169">0.5884496579997307</cx:pt>
          <cx:pt idx="170">0.18101961219713184</cx:pt>
          <cx:pt idx="171">0.31951212809531976</cx:pt>
          <cx:pt idx="172">0.0034618492168203979</cx:pt>
          <cx:pt idx="173">28.132187970365901</cx:pt>
          <cx:pt idx="174">27.479919941659219</cx:pt>
          <cx:pt idx="175">28.152744093604802</cx:pt>
          <cx:pt idx="176">28.163256203784393</cx:pt>
          <cx:pt idx="177">0.011572251293503784</cx:pt>
          <cx:pt idx="178">28.161747104893902</cx:pt>
          <cx:pt idx="179">28.125699991289103</cx:pt>
          <cx:pt idx="180">27.879598275441488</cx:pt>
          <cx:pt idx="181">27.911216383382509</cx:pt>
          <cx:pt idx="182">27.788252913776351</cx:pt>
          <cx:pt idx="183">27.602065140130367</cx:pt>
          <cx:pt idx="184">28.14542591612356</cx:pt>
          <cx:pt idx="185">28.142494558940577</cx:pt>
          <cx:pt idx="186">0.0034738595250815773</cx:pt>
          <cx:pt idx="187">0.0084114564731680094</cx:pt>
          <cx:pt idx="188">27.842539395680127</cx:pt>
          <cx:pt idx="189">27.952423866276789</cx:pt>
          <cx:pt idx="190">28.164836232437068</cx:pt>
          <cx:pt idx="191">28.16772976297522</cx:pt>
          <cx:pt idx="192">0.024584527654604227</cx:pt>
          <cx:pt idx="193">0.068992970656437169</cx:pt>
          <cx:pt idx="194">28.104803859838622</cx:pt>
          <cx:pt idx="195">0.0024411083548257335</cx:pt>
          <cx:pt idx="196">0.0039846957223858386</cx:pt>
          <cx:pt idx="197">28.144146815990002</cx:pt>
          <cx:pt idx="198">0.011688541397454174</cx:pt>
          <cx:pt idx="199">28.167925021200979</cx:pt>
          <cx:pt idx="200">28.158923985124147</cx:pt>
          <cx:pt idx="201">28.158515585875616</cx:pt>
          <cx:pt idx="202">28.167410246595264</cx:pt>
          <cx:pt idx="203">28.153312416126099</cx:pt>
          <cx:pt idx="204">27.757485476894335</cx:pt>
          <cx:pt idx="205">0.0044787274978502541</cx:pt>
          <cx:pt idx="206">0.0057967490889290702</cx:pt>
          <cx:pt idx="207">28.14112648775809</cx:pt>
          <cx:pt idx="208">28.152815134547382</cx:pt>
          <cx:pt idx="209">28.157982882301781</cx:pt>
          <cx:pt idx="210">28.166061137475367</cx:pt>
          <cx:pt idx="211">28.167232735929172</cx:pt>
          <cx:pt idx="212">27.960615157753594</cx:pt>
          <cx:pt idx="213">28.161693841102668</cx:pt>
          <cx:pt idx="214">28.17161692200148</cx:pt>
          <cx:pt idx="215">0.042957420779185525</cx:pt>
          <cx:pt idx="216">0.0085566757563904465</cx:pt>
          <cx:pt idx="217">28.168244531741767</cx:pt>
          <cx:pt idx="218">28.144093518889534</cx:pt>
          <cx:pt idx="219">28.167871769091818</cx:pt>
          <cx:pt idx="220">0.075621888365737078</cx:pt>
          <cx:pt idx="221">28.141499604676362</cx:pt>
          <cx:pt idx="222">27.939720828956037</cx:pt>
          <cx:pt idx="223">28.147841835565295</cx:pt>
          <cx:pt idx="224">0.047188240060421834</cx:pt>
          <cx:pt idx="225">28.159527694902842</cx:pt>
          <cx:pt idx="226">0.027568496513230459</cx:pt>
          <cx:pt idx="227">0.00076442723656342849</cx:pt>
          <cx:pt idx="228">0.070748639562891943</cx:pt>
          <cx:pt idx="229">28.159527694902842</cx:pt>
          <cx:pt idx="230">28.156651079274326</cx:pt>
          <cx:pt idx="231">28.170977973794237</cx:pt>
          <cx:pt idx="232">27.889639653462716</cx:pt>
          <cx:pt idx="233">28.162315245732195</cx:pt>
          <cx:pt idx="234">27.061744215774414</cx:pt>
          <cx:pt idx="235">28.144466596473279</cx:pt>
          <cx:pt idx="236">0.010159724405711014</cx:pt>
          <cx:pt idx="237">27.739087944631493</cx:pt>
          <cx:pt idx="238">28.170693992161429</cx:pt>
          <cx:pt idx="239">28.146047679914137</cx:pt>
          <cx:pt idx="240">27.908332089180821</cx:pt>
          <cx:pt idx="241">28.163735547686141</cx:pt>
          <cx:pt idx="242">28.159847300722351</cx:pt>
          <cx:pt idx="243">27.810285866923412</cx:pt>
          <cx:pt idx="244">27.685194599279956</cx:pt>
          <cx:pt idx="245">28.168067026333205</cx:pt>
          <cx:pt idx="246">28.159279110090868</cx:pt>
          <cx:pt idx="247">0.026112295954205174</cx:pt>
          <cx:pt idx="248">0.0064841961722329157</cx:pt>
          <cx:pt idx="249">27.900465945930009</cx:pt>
          <cx:pt idx="250">28.163575767292055</cx:pt>
          <cx:pt idx="251">28.150523973809083</cx:pt>
          <cx:pt idx="252">27.95353287153522</cx:pt>
          <cx:pt idx="253">0.0010042161121989628</cx:pt>
          <cx:pt idx="254">28.159066035648273</cx:pt>
          <cx:pt idx="255">28.153312416126099</cx:pt>
          <cx:pt idx="256">0.029845183866077957</cx:pt>
          <cx:pt idx="257">0.034086067534991479</cx:pt>
          <cx:pt idx="258">0.17584282754778485</cx:pt>
          <cx:pt idx="259">0.0072122257313536713</cx:pt>
          <cx:pt idx="260">28.171386192376119</cx:pt>
          <cx:pt idx="261">27.916124372842297</cx:pt>
          <cx:pt idx="262">3.1770269120673182</cx:pt>
          <cx:pt idx="263">28.171332946809596</cx:pt>
          <cx:pt idx="264">28.152655292174483</cx:pt>
          <cx:pt idx="265">28.166380669159462</cx:pt>
          <cx:pt idx="266">28.158409045967069</cx:pt>
          <cx:pt idx="267">28.165812610326014</cx:pt>
          <cx:pt idx="268">28.114462470408359</cx:pt>
          <cx:pt idx="269">0.025321433608703914</cx:pt>
          <cx:pt idx="270">27.715663441454907</cx:pt>
          <cx:pt idx="271">28.168244531741767</cx:pt>
          <cx:pt idx="272">27.912864417683831</cx:pt>
          <cx:pt idx="273">28.165723850098367</cx:pt>
          <cx:pt idx="274">0.014449359847411926</cx:pt>
          <cx:pt idx="275">28.155070591280712</cx:pt>
          <cx:pt idx="276">28.158923985124147</cx:pt>
          <cx:pt idx="277">8.7336647519812663e-05</cx:pt>
          <cx:pt idx="278">28.158480072617554</cx:pt>
          <cx:pt idx="279">28.131832503411502</cx:pt>
          <cx:pt idx="280">0.002664828324676845</cx:pt>
          <cx:pt idx="281">28.168138028630857</cx:pt>
          <cx:pt idx="282">0.037893798965002182</cx:pt>
          <cx:pt idx="283">27.852935213366653</cx:pt>
          <cx:pt idx="284">0.0045996630311360854</cx:pt>
          <cx:pt idx="285">27.908206678323133</cx:pt>
          <cx:pt idx="286">0.0029404744515128846</cx:pt>
          <cx:pt idx="287">27.753179997975007</cx:pt>
          <cx:pt idx="288">0.0034996142644582989</cx:pt>
          <cx:pt idx="289">28.155692142087364</cx:pt>
          <cx:pt idx="290">27.788234920555858</cx:pt>
          <cx:pt idx="291">28.144288941097802</cx:pt>
          <cx:pt idx="292">28.165954626108451</cx:pt>
          <cx:pt idx="293">0.0046531387256345579</cx:pt>
          <cx:pt idx="294">28.149618114638784</cx:pt>
          <cx:pt idx="295">28.156615563664605</cx:pt>
          <cx:pt idx="296">0.017413471796284625</cx:pt>
          <cx:pt idx="297">0.0091164137685824688</cx:pt>
          <cx:pt idx="298">0.0030581252426936344</cx:pt>
          <cx:pt idx="299">0.01696994401876447</cx:pt>
          <cx:pt idx="300">28.159580962791331</cx:pt>
          <cx:pt idx="301">28.162741343839382</cx:pt>
          <cx:pt idx="302">28.154449026752417</cx:pt>
          <cx:pt idx="303">28.135760163891078</cx:pt>
          <cx:pt idx="304">0.0056633117519698673</cx:pt>
          <cx:pt idx="305">28.151589653161686</cx:pt>
          <cx:pt idx="306">0.0034097507240266117</cx:pt>
          <cx:pt idx="307">28.162119948611824</cx:pt>
          <cx:pt idx="308">28.165617337455966</cx:pt>
          <cx:pt idx="309">28.164978253142674</cx:pt>
          <cx:pt idx="310">28.144111284600903</cx:pt>
          <cx:pt idx="311">28.141748346540236</cx:pt>
          <cx:pt idx="312">0.0080696654205735206</cx:pt>
          <cx:pt idx="313">28.156207130932959</cx:pt>
          <cx:pt idx="314">0.055616094792784579</cx:pt>
          <cx:pt idx="315">0.0020869547192021204</cx:pt>
          <cx:pt idx="316">28.170090521686298</cx:pt>
          <cx:pt idx="317">28.147770782070825</cx:pt>
          <cx:pt idx="318">0.14837856988123319</cx:pt>
          <cx:pt idx="319">27.725475649661991</cx:pt>
          <cx:pt idx="320">27.902455089113577</cx:pt>
          <cx:pt idx="321">28.163504753492596</cx:pt>
          <cx:pt idx="322">27.869032993629329</cx:pt>
          <cx:pt idx="323">0.018294152071085448</cx:pt>
          <cx:pt idx="324">28.169078792179196</cx:pt>
          <cx:pt idx="325">28.154040562590655</cx:pt>
          <cx:pt idx="326">28.163504753492596</cx:pt>
          <cx:pt idx="327">28.154679895179058</cx:pt>
          <cx:pt idx="328">0.012180517230397073</cx:pt>
          <cx:pt idx="329">0.002286525748816313</cx:pt>
          <cx:pt idx="330">28.163913080394209</cx:pt>
          <cx:pt idx="331">28.152069195709224</cx:pt>
          <cx:pt idx="332">0.0083194711370374978</cx:pt>
          <cx:pt idx="333">27.940526122462334</cx:pt>
          <cx:pt idx="334">0.0046763981866389439</cx:pt>
          <cx:pt idx="335">28.163025405662651</cx:pt>
          <cx:pt idx="336">4.1740268326880701</cx:pt>
          <cx:pt idx="337">27.888044033241201</cx:pt>
          <cx:pt idx="338">0.030348953853469151</cx:pt>
          <cx:pt idx="339">28.173533679678876</cx:pt>
          <cx:pt idx="340">28.157432411354556</cx:pt>
          <cx:pt idx="341">28.165191282858348</cx:pt>
          <cx:pt idx="342">27.852773650033491</cx:pt>
          <cx:pt idx="343">28.147024709549679</cx:pt>
          <cx:pt idx="344">14.630823626850267</cx:pt>
          <cx:pt idx="345">28.150168738393027</cx:pt>
          <cx:pt idx="346">28.155212661246232</cx:pt>
          <cx:pt idx="347">27.852432568808062</cx:pt>
          <cx:pt idx="348">27.864978019011605</cx:pt>
          <cx:pt idx="349">0.001054068308981918</cx:pt>
          <cx:pt idx="350">5.4634055313513012e-05</cx:pt>
          <cx:pt idx="351">27.800000000000004</cx:pt>
          <cx:pt idx="352">27.853401946620455</cx:pt>
          <cx:pt idx="353">28.165155778017631</cx:pt>
          <cx:pt idx="354">28.170356760254204</cx:pt>
          <cx:pt idx="355">0.0040716090185576514</cx:pt>
          <cx:pt idx="356">27.846023055366452</cx:pt>
          <cx:pt idx="357">0.0024335919953846</cx:pt>
          <cx:pt idx="358">28.155940758568164</cx:pt>
          <cx:pt idx="359">0.019461962902030207</cx:pt>
          <cx:pt idx="360">0.010584658709660884</cx:pt>
          <cx:pt idx="361">28.167516752457967</cx:pt>
          <cx:pt idx="362">28.167161731349506</cx:pt>
          <cx:pt idx="363">28.171013471297051</cx:pt>
          <cx:pt idx="364">0.31730427037781889</cx:pt>
          <cx:pt idx="365">0.028575898935991495</cx:pt>
          <cx:pt idx="366">0.024766146248457792</cx:pt>
          <cx:pt idx="367">27.050508313153749</cx:pt>
          <cx:pt idx="368">27.873195008825235</cx:pt>
          <cx:pt idx="369">28.151625175112006</cx:pt>
          <cx:pt idx="370">28.166433924087723</cx:pt>
          <cx:pt idx="371">0.039937200703103866</cx:pt>
          <cx:pt idx="372">27.904892044227658</cx:pt>
          <cx:pt idx="373">28.146296381584555</cx:pt>
          <cx:pt idx="374">28.148232626578885</cx:pt>
          <cx:pt idx="375">28.162404016702837</cx:pt>
          <cx:pt idx="376">25.575808882614055</cx:pt>
          <cx:pt idx="377">0.025807111423016716</cx:pt>
          <cx:pt idx="378">0.040103491119851398</cx:pt>
          <cx:pt idx="379">27.890482247533832</cx:pt>
          <cx:pt idx="380">28.158995010475785</cx:pt>
          <cx:pt idx="381">28.160557522890063</cx:pt>
          <cx:pt idx="382">27.99682124813458</cx:pt>
          <cx:pt idx="383">27.837402896103651</cx:pt>
          <cx:pt idx="384">28.144715312114993</cx:pt>
          <cx:pt idx="385">28.158622125381061</cx:pt>
          <cx:pt idx="386">28.157290352588969</cx:pt>
          <cx:pt idx="387">28.153241376438341</cx:pt>
          <cx:pt idx="388">27.829570603945726</cx:pt>
          <cx:pt idx="389">28.1544135083649</cx:pt>
          <cx:pt idx="390">0.0070587321807814747</cx:pt>
          <cx:pt idx="391">28.161320991743267</cx:pt>
          <cx:pt idx="392">28.155851967219885</cx:pt>
          <cx:pt idx="393">28.164055105754926</cx:pt>
          <cx:pt idx="394">28.156349195163777</cx:pt>
          <cx:pt idx="395">28.145017321010833</cx:pt>
          <cx:pt idx="396">28.159651986485912</cx:pt>
          <cx:pt idx="397">0.042266653522605738</cx:pt>
          <cx:pt idx="398">27.901344053647311</cx:pt>
          <cx:pt idx="399">0.0050957335095155832</cx:pt>
          <cx:pt idx="400">28.142405725168558</cx:pt>
          <cx:pt idx="401">28.158977254154667</cx:pt>
          <cx:pt idx="402">28.151554131166545</cx:pt>
          <cx:pt idx="403">28.166966467832495</cx:pt>
          <cx:pt idx="404">0.049269666124300053</cx:pt>
          <cx:pt idx="405">0.013591394336123134</cx:pt>
          <cx:pt idx="406">28.162315245732195</cx:pt>
          <cx:pt idx="407">0.0013891256242687341</cx:pt>
          <cx:pt idx="408">28.16900779225282</cx:pt>
          <cx:pt idx="409">28.167427997600349</cx:pt>
          <cx:pt idx="410">28.156082824142992</cx:pt>
          <cx:pt idx="411">0.0079090897074189266</cx:pt>
          <cx:pt idx="412">27.888366750313654</cx:pt>
          <cx:pt idx="413">28.155301454610637</cx:pt>
          <cx:pt idx="414">27.679757946918539</cx:pt>
          <cx:pt idx="415">0.011466080411369877</cx:pt>
          <cx:pt idx="416">28.153561053621619</cx:pt>
          <cx:pt idx="417">28.139705044651762</cx:pt>
          <cx:pt idx="418">0.00067995808694359971</cx:pt>
          <cx:pt idx="419">28.173870873559419</cx:pt>
          <cx:pt idx="420">27.630544692423275</cx:pt>
          <cx:pt idx="421">0.005849504252498668</cx:pt>
          <cx:pt idx="422">28.17080048560921</cx:pt>
          <cx:pt idx="423">28.158089423822773</cx:pt>
          <cx:pt idx="424">2.1375897641970503</cx:pt>
          <cx:pt idx="425">28.157734283851749</cx:pt>
          <cx:pt idx="426">0.0019245025331238199</cx:pt>
          <cx:pt idx="427">28.163806560903659</cx:pt>
          <cx:pt idx="428">28.166717948671266</cx:pt>
          <cx:pt idx="429">27.904014048161603</cx:pt>
          <cx:pt idx="430">25.018573100798534</cx:pt>
          <cx:pt idx="431">28.162066685525762</cx:pt>
          <cx:pt idx="432">27.850368040656125</cx:pt>
          <cx:pt idx="433">23.456086630126517</cx:pt>
          <cx:pt idx="434">7.2591115158812658e-05</cx:pt>
          <cx:pt idx="435">28.154537822525167</cx:pt>
          <cx:pt idx="436">0.0029657005917657973</cx:pt>
          <cx:pt idx="437">27.903351053233731</cx:pt>
          <cx:pt idx="438">28.154360230699616</cx:pt>
          <cx:pt idx="439">0.34140884581393027</cx:pt>
          <cx:pt idx="440">28.158551099088886</cx:pt>
          <cx:pt idx="441">28.15791185439716</cx:pt>
          <cx:pt idx="442">0.041466371917494783</cx:pt>
          <cx:pt idx="443">28.16334497178913</cx:pt>
          <cx:pt idx="444">28.165457567737118</cx:pt>
          <cx:pt idx="445">27.956859623355406</cx:pt>
          <cx:pt idx="446">28.15148308704179</cx:pt>
          <cx:pt idx="447">28.162812359563805</cx:pt>
          <cx:pt idx="448">28.166007881842255</cx:pt>
          <cx:pt idx="449">0.083657396564798744</cx:pt>
          <cx:pt idx="450">8.752896663390926</cx:pt>
          <cx:pt idx="451">28.144377768925715</cx:pt>
          <cx:pt idx="452">27.89403161968524</cx:pt>
          <cx:pt idx="453">28.164676458287254</cx:pt>
          <cx:pt idx="454">0.056536536858919829</cx:pt>
          <cx:pt idx="455">28.143898095324321</cx:pt>
          <cx:pt idx="456">0.015174320413119001</cx:pt>
          <cx:pt idx="457">27.776716868629382</cx:pt>
          <cx:pt idx="458">27.784348111841673</cx:pt>
          <cx:pt idx="459">28.156810898963684</cx:pt>
          <cx:pt idx="460">0.025917098603045828</cx:pt>
          <cx:pt idx="461">28.160912627256952</cx:pt>
          <cx:pt idx="462">0.00075781792008370989</cx:pt>
          <cx:pt idx="463">27.809243067728399</cx:pt>
          <cx:pt idx="464">28.166575936737502</cx:pt>
          <cx:pt idx="465">0.0015045331501831389</cx:pt>
          <cx:pt idx="466">28.166522682077744</cx:pt>
          <cx:pt idx="467">28.154964038336118</cx:pt>
          <cx:pt idx="468">28.152957215894741</cx:pt>
          <cx:pt idx="469">28.145603564322442</cx:pt>
          <cx:pt idx="470">28.112523899500736</cx:pt>
          <cx:pt idx="471">28.152637531854808</cx:pt>
          <cx:pt idx="472">27.837187357921056</cx:pt>
          <cx:pt idx="473">28.165084768201925</cx:pt>
          <cx:pt idx="474">0.0039617925235933297</cx:pt>
          <cx:pt idx="475">27.839288784018891</cx:pt>
          <cx:pt idx="476">28.159350134546784</cx:pt>
          <cx:pt idx="477">28.174066089224681</cx:pt>
          <cx:pt idx="478">0.061926730900314766</cx:pt>
          <cx:pt idx="479">0.0065218325645480957</cx:pt>
          <cx:pt idx="480">27.870163257505325</cx:pt>
          <cx:pt idx="481">28.169096542132831</cx:pt>
          <cx:pt idx="482">0.03455430508634199</cx:pt>
          <cx:pt idx="483">28.160184658485459</cx:pt>
          <cx:pt idx="484">27.628716944512643</cx:pt>
          <cx:pt idx="485">28.143898095324321</cx:pt>
          <cx:pt idx="486">27.903924455172969</cx:pt>
          <cx:pt idx="487">27.961455613039892</cx:pt>
          <cx:pt idx="488">25.881112804514416</cx:pt>
          <cx:pt idx="489">0.060214616165844649</cx:pt>
          <cx:pt idx="490">28.153756410113374</cx:pt>
          <cx:pt idx="491">0.043554104284211838</cx:pt>
          <cx:pt idx="492">0.0037397727203668405</cx:pt>
          <cx:pt idx="493">0.00059980830271012418</cx:pt>
          <cx:pt idx="494">0.0040500493824149851</cx:pt>
          <cx:pt idx="495">27.721688260277368</cx:pt>
          <cx:pt idx="496">28.157503440468577</cx:pt>
          <cx:pt idx="497">28.155141626353082</cx:pt>
          <cx:pt idx="498">28.137430586320423</cx:pt>
          <cx:pt idx="499">28.160273436172456</cx:pt>
          <cx:pt idx="500">28.158231478557028</cx:pt>
          <cx:pt idx="501">28.162208720198066</cx:pt>
          <cx:pt idx="502">3.6596584540090626</cx:pt>
          <cx:pt idx="503">28.171528180061518</cx:pt>
          <cx:pt idx="504">28.113946716887689</cx:pt>
          <cx:pt idx="505">0.023620076206481638</cx:pt>
          <cx:pt idx="506">28.159137060641616</cx:pt>
          <cx:pt idx="507">0.009820575339561325</cx:pt>
          <cx:pt idx="508">28.157965125342422</cx:pt>
          <cx:pt idx="509">28.142920957143026</cx:pt>
          <cx:pt idx="510">15.335970787661276</cx:pt>
          <cx:pt idx="511">28.158462315971729</cx:pt>
          <cx:pt idx="512">27.686097594280056</cx:pt>
          <cx:pt idx="513">0.66981639275252136</cx:pt>
          <cx:pt idx="514">27.807732737495876</cx:pt>
          <cx:pt idx="515">0.0030418103162426153</cx:pt>
          <cx:pt idx="516">28.156526774444323</cx:pt>
          <cx:pt idx="517">27.895286340168656</cx:pt>
          <cx:pt idx="518">0.042404245070511513</cx:pt>
          <cx:pt idx="519">28.14652731688227</cx:pt>
          <cx:pt idx="520">28.165457567737118</cx:pt>
          <cx:pt idx="521">28.163984093164089</cx:pt>
          <cx:pt idx="522">1.1576830308853974</cx:pt>
          <cx:pt idx="523">27.849147204178443</cx:pt>
          <cx:pt idx="524">20.321146621192419</cx:pt>
          <cx:pt idx="525">28.175539036547288</cx:pt>
          <cx:pt idx="526">28.16334497178913</cx:pt>
          <cx:pt idx="527">28.164924995461998</cx:pt>
          <cx:pt idx="528">28.174687220979045</cx:pt>
          <cx:pt idx="529">28.164072858874654</cx:pt>
          <cx:pt idx="530">0.0084250637979780309</cx:pt>
          <cx:pt idx="531">28.160255680657446</cx:pt>
          <cx:pt idx="532">28.143755968242761</cx:pt>
          <cx:pt idx="533">28.165386558682272</cx:pt>
          <cx:pt idx="534">28.17080048560921</cx:pt>
          <cx:pt idx="535">28.167321491402053</cx:pt>
          <cx:pt idx="536">0.01880436119627572</cx:pt>
          <cx:pt idx="537">27.887470304780244</cx:pt>
          <cx:pt idx="538">28.149493778752046</cx:pt>
          <cx:pt idx="539">0.0027566301891983991</cx:pt>
          <cx:pt idx="540">0.0067307874725027533</cx:pt>
          <cx:pt idx="541">0.0023961197799776206</cx:pt>
          <cx:pt idx="542">27.894856156646515</cx:pt>
          <cx:pt idx="543">28.169593536293704</cx:pt>
          <cx:pt idx="544">27.668827224875287</cx:pt>
          <cx:pt idx="545">28.117503445362996</cx:pt>
          <cx:pt idx="546">28.165599585309735</cx:pt>
          <cx:pt idx="547">28.161942404599866</cx:pt>
          <cx:pt idx="548">27.856076536368146</cx:pt>
          <cx:pt idx="549">28.158213721754439</cx:pt>
          <cx:pt idx="550">28.154093840860874</cx:pt>
          <cx:pt idx="551">0.0025530354482458718</cx:pt>
          <cx:pt idx="552">28.155425764850371</cx:pt>
          <cx:pt idx="553">0.00025046317094535079</cx:pt>
          <cx:pt idx="554">0.0090561360413810039</cx:pt>
          <cx:pt idx="555">28.176674750580489</cx:pt>
          <cx:pt idx="556">0.037106603185956002</cx:pt>
          <cx:pt idx="557">0.019682200080275578</cx:pt>
          <cx:pt idx="558">28.173675656541512</cx:pt>
          <cx:pt idx="559">28.145870034518381</cx:pt>
          <cx:pt idx="560">28.163007651882637</cx:pt>
          <cx:pt idx="561">27.860545579726182</cx:pt>
          <cx:pt idx="562">0.092886059233880727</cx:pt>
          <cx:pt idx="563">28.161658331852546</cx:pt>
          <cx:pt idx="564">27.669080216010073</cx:pt>
          <cx:pt idx="565">28.16513802558049</cx:pt>
          <cx:pt idx="566">27.802985451206496</cx:pt>
          <cx:pt idx="567">28.157450168649863</cx:pt>
          <cx:pt idx="568">28.160770586047533</cx:pt>
          <cx:pt idx="569">28.020510345102569</cx:pt>
          <cx:pt idx="570">28.15228232310837</cx:pt>
          <cx:pt idx="571">28.167445748594243</cx:pt>
          <cx:pt idx="572">28.162475033277879</cx:pt>
          <cx:pt idx="573">0.087380089265232497</cx:pt>
          <cx:pt idx="574">28.159669742381567</cx:pt>
          <cx:pt idx="575">0.07694225107182659</cx:pt>
          <cx:pt idx="576">0.042751725111391699</cx:pt>
          <cx:pt idx="577">28.149014192330075</cx:pt>
          <cx:pt idx="578">28.152388886202889</cx:pt>
          <cx:pt idx="579">0.014283767010141266</cx:pt>
          <cx:pt idx="580">0.0072032631494344289</cx:pt>
          <cx:pt idx="581">0.004657842848358025</cx:pt>
          <cx:pt idx="582">28.117983569239097</cx:pt>
          <cx:pt idx="583">27.622780453821083</cx:pt>
          <cx:pt idx="584">28.173231976470149</cx:pt>
          <cx:pt idx="585">28.166948716536549</cx:pt>
          <cx:pt idx="586">28.171102214858401</cx:pt>
          <cx:pt idx="587">28.17277054178378</cx:pt>
          <cx:pt idx="588">0.018844123752512345</cx:pt>
          <cx:pt idx="589">0.001750577047718837</cx:pt>
          <cx:pt idx="590">28.173409449337157</cx:pt>
          <cx:pt idx="591">28.169309540704045</cx:pt>
          <cx:pt idx="592">28.172593064891981</cx:pt>
          <cx:pt idx="593">0.012459975922930189</cx:pt>
          <cx:pt idx="594">0.0037204300826651749</cx:pt>
          <cx:pt idx="595">28.164232636448659</cx:pt>
          <cx:pt idx="596">0.00076916058141327035</cx:pt>
          <cx:pt idx="597">0.0094712301207393341</cx:pt>
          <cx:pt idx="598">28.166735700112643</cx:pt>
          <cx:pt idx="599">28.166682445754947</cx:pt>
          <cx:pt idx="600">0.0027482630878429381</cx:pt>
          <cx:pt idx="601">27.872118685166363</cx:pt>
          <cx:pt idx="602">28.169487038283108</cx:pt>
          <cx:pt idx="603">0.034036744850235015</cx:pt>
          <cx:pt idx="604">27.790124145098737</cx:pt>
          <cx:pt idx="605">28.163451493025494</cx:pt>
          <cx:pt idx="606">28.155638866841574</cx:pt>
          <cx:pt idx="607">28.157112778124109</cx:pt>
          <cx:pt idx="608">0.01562376395110986</cx:pt>
          <cx:pt idx="609">0.003147406869154352</cx:pt>
          <cx:pt idx="610">28.152442167598885</cx:pt>
          <cx:pt idx="611">28.163895327173762</cx:pt>
          <cx:pt idx="612">21.939074729805721</cx:pt>
          <cx:pt idx="613">28.167587756142698</cx:pt>
          <cx:pt idx="614">0.0051904238747909597</cx:pt>
          <cx:pt idx="615">27.652594814953623</cx:pt>
          <cx:pt idx="616">28.157645498159113</cx:pt>
          <cx:pt idx="617">28.143489478030258</cx:pt>
          <cx:pt idx="618">28.175095385819017</cx:pt>
          <cx:pt idx="619">28.065762059847938</cx:pt>
          <cx:pt idx="620">27.976847570803969</cx:pt>
          <cx:pt idx="621">28.163966339988406</cx:pt>
          <cx:pt idx="622">28.142139222170016</cx:pt>
          <cx:pt idx="623">28.162475033277879</cx:pt>
          <cx:pt idx="624">28.166522682077744</cx:pt>
          <cx:pt idx="625">25.471552759892752</cx:pt>
          <cx:pt idx="626">28.14652731688227</cx:pt>
          <cx:pt idx="627">27.856058586957346</cx:pt>
          <cx:pt idx="628">0.0021761985203560814</cx:pt>
          <cx:pt idx="629">0.054579666543503172</cx:pt>
          <cx:pt idx="630">28.162563803744856</cx:pt>
          <cx:pt idx="631">27.766562624855101</cx:pt>
          <cx:pt idx="632">27.824449680092506</cx:pt>
          <cx:pt idx="633">28.160113636134355</cx:pt>
          <cx:pt idx="634">28.15412935965167</cx:pt>
          <cx:pt idx="635">28.150346356661405</cx:pt>
          <cx:pt idx="636">0.0043478615433336877</cx:pt>
          <cx:pt idx="637">28.158338019137425</cx:pt>
          <cx:pt idx="638">27.873356453789345</cx:pt>
          <cx:pt idx="639">0.00026108351154372042</cx:pt>
          <cx:pt idx="640">28.159367890632776</cx:pt>
          <cx:pt idx="641">0.033107098936632912</cx:pt>
          <cx:pt idx="642">28.163309464620813</cx:pt>
          <cx:pt idx="643">5.1144892218089577</cx:pt>
          <cx:pt idx="644">28.167143980176618</cx:pt>
          <cx:pt idx="645">27.847495399048011</cx:pt>
          <cx:pt idx="646">28.146616137646102</cx:pt>
          <cx:pt idx="647">28.167747513778945</cx:pt>
          <cx:pt idx="648">0.029064892912240358</cx:pt>
          <cx:pt idx="649">27.899587810575266</cx:pt>
          <cx:pt idx="650">0.0066172577401821062</cx:pt>
          <cx:pt idx="651">0.00048793647127469376</cx:pt>
          <cx:pt idx="652">28.157965125342422</cx:pt>
          <cx:pt idx="653">0.029724165253207698</cx:pt>
          <cx:pt idx="654">28.146260852909045</cx:pt>
          <cx:pt idx="655">28.146474024289436</cx:pt>
          <cx:pt idx="656">0.011981110132203944</cx:pt>
          <cx:pt idx="657">0.0013352565296601249</cx:pt>
          <cx:pt idx="658">28.164214883429644</cx:pt>
          <cx:pt idx="659">0.012958279206746552</cx:pt>
          <cx:pt idx="660">28.158355775861626</cx:pt>
          <cx:pt idx="661">28.154679895179058</cx:pt>
          <cx:pt idx="662">0.096033223417731836</cx:pt>
          <cx:pt idx="663">0.0020054550605785211</cx:pt>
          <cx:pt idx="664">28.146633901765234</cx:pt>
          <cx:pt idx="665">28.1664871789153</cx:pt>
          <cx:pt idx="666">28.165972378030908</cx:pt>
          <cx:pt idx="667">28.157645498159113</cx:pt>
          <cx:pt idx="668">26.868810915260095</cx:pt>
          <cx:pt idx="669">28.171155460861026</cx:pt>
          <cx:pt idx="670">28.138923220336633</cx:pt>
          <cx:pt idx="671">28.154928520598304</cx:pt>
          <cx:pt idx="672">0.0063368998729662757</cx:pt>
          <cx:pt idx="673">0.0085566114788507251</cx:pt>
          <cx:pt idx="674">0.001659879513699714</cx:pt>
          <cx:pt idx="675">28.146385203077145</cx:pt>
          <cx:pt idx="676">0.024659724248255497</cx:pt>
          <cx:pt idx="677">27.809063270811553</cx:pt>
          <cx:pt idx="678">0.025956078286212658</cx:pt>
          <cx:pt idx="679">28.156580048010092</cx:pt>
          <cx:pt idx="680">28.165830362337978</cx:pt>
          <cx:pt idx="681">28.135102629988751</cx:pt>
          <cx:pt idx="682">28.165067015720023</cx:pt>
          <cx:pt idx="683">28.141659510412669</cx:pt>
          <cx:pt idx="684">24.278303070849084</cx:pt>
          <cx:pt idx="685">28.1633627253565</cx:pt>
          <cx:pt idx="686">0.025082543730650605</cx:pt>
          <cx:pt idx="687">28.150008880993273</cx:pt>
          <cx:pt idx="688">28.151660697017505</cx:pt>
          <cx:pt idx="689">28.167108477797292</cx:pt>
          <cx:pt idx="690">28.170374509402603</cx:pt>
          <cx:pt idx="691">0.0038298563941745905</cx:pt>
          <cx:pt idx="692">28.166895462581603</cx:pt>
          <cx:pt idx="693">28.169398289633378</cx:pt>
          <cx:pt idx="694">28.162759097787276</cx:pt>
          <cx:pt idx="695">28.164978253142674</cx:pt>
          <cx:pt idx="696">21.741619074944719</cx:pt>
          <cx:pt idx="697">0.018781320507355172</cx:pt>
          <cx:pt idx="698">28.157538954958405</cx:pt>
          <cx:pt idx="699">28.162528295591642</cx:pt>
          <cx:pt idx="700">27.879060242411331</cx:pt>
          <cx:pt idx="701">28.150968011775369</cx:pt>
          <cx:pt idx="702">28.159137060641616</cx:pt>
          <cx:pt idx="703">28.156384711109482</cx:pt>
          <cx:pt idx="704">0.0080583621164601431</cx:pt>
          <cx:pt idx="705">0.078530439958018824</cx:pt>
          <cx:pt idx="706">0.1569050668397933</cx:pt>
          <cx:pt idx="707">0.00092936806486988786</cx:pt>
          <cx:pt idx="708">0.00031935246985110357</cx:pt>
          <cx:pt idx="709">28.155354730494874</cx:pt>
          <cx:pt idx="710">0.0035629622507121791</cx:pt>
          <cx:pt idx="711">0.0085578385121477963</cx:pt>
          <cx:pt idx="712">0.033223335172736644</cx:pt>
          <cx:pt idx="713">0.022657118086817661</cx:pt>
          <cx:pt idx="714">27.848285405029877</cx:pt>
          <cx:pt idx="715">25.367183525176774</cx:pt>
          <cx:pt idx="716">23.466316285263012</cx:pt>
          <cx:pt idx="717">27.817404623724336</cx:pt>
          <cx:pt idx="718">28.157716526735616</cx:pt>
          <cx:pt idx="719">0.0027743936274436617</cx:pt>
          <cx:pt idx="720">28.159847300722351</cx:pt>
          <cx:pt idx="721">28.162812359563805</cx:pt>
          <cx:pt idx="722">27.916231837409576</cx:pt>
          <cx:pt idx="723">0.0013075358503689296</cx:pt>
          <cx:pt idx="724">28.14423564426648</cx:pt>
          <cx:pt idx="725">27.905841682343141</cx:pt>
          <cx:pt idx="726">0.0011769494466628548</cx:pt>
          <cx:pt idx="727">27.826677846987053</cx:pt>
          <cx:pt idx="728">27.774682716459608</cx:pt>
          <cx:pt idx="729">28.14181941524037</cx:pt>
          <cx:pt idx="730">28.160735075633237</cx:pt>
          <cx:pt idx="731">28.158142694432104</cx:pt>
          <cx:pt idx="732">28.161711595710937</cx:pt>
          <cx:pt idx="733">27.890482247533832</cx:pt>
          <cx:pt idx="734">0.021847951849086448</cx:pt>
          <cx:pt idx="735">28.162670327935878</cx:pt>
          <cx:pt idx="736">28.166629191296572</cx:pt>
          <cx:pt idx="737">28.158338019137425</cx:pt>
          <cx:pt idx="738">28.169114292075282</cx:pt>
          <cx:pt idx="739">5.0971756885553789</cx:pt>
          <cx:pt idx="740">28.165865866328343</cx:pt>
          <cx:pt idx="741">26.109193783033589</cx:pt>
          <cx:pt idx="742">28.172202611794482</cx:pt>
          <cx:pt idx="743">28.151305475945517</cx:pt>
          <cx:pt idx="744">27.897956914440886</cx:pt>
          <cx:pt idx="745">28.163238450149869</cx:pt>
          <cx:pt idx="746">27.885390440157011</cx:pt>
          <cx:pt idx="747">28.150879204742434</cx:pt>
          <cx:pt idx="748">0.0012450582315699133</cx:pt>
          <cx:pt idx="749">27.809440842994309</cx:pt>
          <cx:pt idx="750">28.165297797111961</cx:pt>
          <cx:pt idx="751">0.0011433940703012239</cx:pt>
          <cx:pt idx="752">0.00032913978793211858</cx:pt>
          <cx:pt idx="753">28.168049275730827</cx:pt>
          <cx:pt idx="754">28.164782974487839</cx:pt>
          <cx:pt idx="755">0.056633294094551832</cx:pt>
          <cx:pt idx="756">28.161409765848017</cx:pt>
          <cx:pt idx="757">0.011189995531723861</cx:pt>
          <cx:pt idx="758">0.005561474624593732</cx:pt>
          <cx:pt idx="759">27.88757787976575</cx:pt>
          <cx:pt idx="760">0.022897838325920638</cx:pt>
          <cx:pt idx="761">27.851840154646872</cx:pt>
          <cx:pt idx="762">27.811238735446501</cx:pt>
          <cx:pt idx="763">28.159865056494855</cx:pt>
          <cx:pt idx="764">28.159456670894773</cx:pt>
          <cx:pt idx="765">0.020384307689985452</cx:pt>
          <cx:pt idx="766">28.143880329478378</cx:pt>
          <cx:pt idx="767">28.170764987838016</cx:pt>
          <cx:pt idx="768">28.167836267629788</cx:pt>
          <cx:pt idx="769">28.166469427317299</cx:pt>
          <cx:pt idx="770">28.169788781600758</cx:pt>
          <cx:pt idx="771">0.0020192127178680309</cx:pt>
          <cx:pt idx="772">28.158373532574636</cx:pt>
          <cx:pt idx="773">27.799082718679763</cx:pt>
          <cx:pt idx="774">0.0015885339152816346</cx:pt>
          <cx:pt idx="775">0.0072993218863124532</cx:pt>
          <cx:pt idx="776">0.015079754639913741</cx:pt>
          <cx:pt idx="777">0.0031242567116035774</cx:pt>
          <cx:pt idx="778">0.099408701832384871</cx:pt>
          <cx:pt idx="779">0.030742413698341905</cx:pt>
          <cx:pt idx="780">28.162261983015497</cx:pt>
          <cx:pt idx="781">0.025852659437667146</cx:pt>
          <cx:pt idx="782">27.830468914482914</cx:pt>
          <cx:pt idx="783">28.145550269980511</cx:pt>
          <cx:pt idx="784">28.145248266803403</cx:pt>
          <cx:pt idx="785">0.012584832140318756</cx:pt>
          <cx:pt idx="786">27.838965498020933</cx:pt>
          <cx:pt idx="787">0.0045507581785895852</cx:pt>
          <cx:pt idx="788">28.152193520221473</cx:pt>
          <cx:pt idx="789">28.160433235303749</cx:pt>
          <cx:pt idx="790">28.158249235348421</cx:pt>
          <cx:pt idx="791">28.164427918919284</cx:pt>
          <cx:pt idx="792">28.167605507035915</cx:pt>
          <cx:pt idx="793">28.142156989115101</cx:pt>
          <cx:pt idx="794">27.67643401885438</cx:pt>
          <cx:pt idx="795">0.014817287201103986</cx:pt>
          <cx:pt idx="796">0.051132866143019991</cx:pt>
          <cx:pt idx="797">28.154395749154343</cx:pt>
          <cx:pt idx="798">28.144875199581186</cx:pt>
          <cx:pt idx="799">28.17049875312825</cx:pt>
          <cx:pt idx="800">0.0084819396366633028</cx:pt>
          <cx:pt idx="801">0.0097463736846070091</cx:pt>
          <cx:pt idx="802">28.171723411960443</cx:pt>
          <cx:pt idx="803">27.75826003192563</cx:pt>
          <cx:pt idx="804">28.14420011298953</cx:pt>
          <cx:pt idx="805">0.011622435200937883</cx:pt>
          <cx:pt idx="806">28.154573340755849</cx:pt>
          <cx:pt idx="807">0.00019130342391081241</cx:pt>
          <cx:pt idx="808">28.151145625000773</cx:pt>
          <cx:pt idx="809">27.893189132833125</cx:pt>
          <cx:pt idx="810">0.057658650695277286</cx:pt>
          <cx:pt idx="811">28.1633627253565</cx:pt>
          <cx:pt idx="812">0.0014489720494198638</cx:pt>
          <cx:pt idx="813">28.16513802558049</cx:pt>
          <cx:pt idx="814">28.161161197649502</cx:pt>
          <cx:pt idx="815">0.0007398432266365625</cx:pt>
          <cx:pt idx="816">27.855663696993471</cx:pt>
          <cx:pt idx="817">0.0023323871891261965</cx:pt>
          <cx:pt idx="818">28.153614332799258</cx:pt>
          <cx:pt idx="819">0.036718660106272942</cx:pt>
          <cx:pt idx="820">27.838139305636073</cx:pt>
          <cx:pt idx="821">28.164445671804017</cx:pt>
          <cx:pt idx="822">28.04466081092799</cx:pt>
          <cx:pt idx="823">28.167374744551545</cx:pt>
          <cx:pt idx="824">28.13773267340494</cx:pt>
          <cx:pt idx="825">27.658434518244157</cx:pt>
          <cx:pt idx="826">28.166575936737502</cx:pt>
          <cx:pt idx="827">28.13654207609741</cx:pt>
          <cx:pt idx="828">28.161303236888735</cx:pt>
          <cx:pt idx="829">28.14920958037721</cx:pt>
          <cx:pt idx="830">28.176142390327318</cx:pt>
          <cx:pt idx="831">0.013273093083377362</cx:pt>
          <cx:pt idx="832">28.168830291653929</cx:pt>
          <cx:pt idx="833">28.168173529712568</cx:pt>
          <cx:pt idx="834">0.0061872045384001985</cx:pt>
          <cx:pt idx="835">28.166203152004709</cx:pt>
          <cx:pt idx="836">28.168794791399932</cx:pt>
          <cx:pt idx="837">0.0039787058197358598</cx:pt>
          <cx:pt idx="838">27.765140014053596</cx:pt>
          <cx:pt idx="839">28.160433235303749</cx:pt>
          <cx:pt idx="840">0.041430182234694551</cx:pt>
          <cx:pt idx="841">27.843527075426344</cx:pt>
          <cx:pt idx="842">0.043650429551151039</cx:pt>
          <cx:pt idx="843">28.161143442694225</cx:pt>
          <cx:pt idx="844">5.5639554275712886</cx:pt>
          <cx:pt idx="845">0.01045896744425567</cx:pt>
          <cx:pt idx="846">0.0040266238960200889</cx:pt>
          <cx:pt idx="847">0.02051048512346795</cx:pt>
          <cx:pt idx="848">28.159421158823562</cx:pt>
          <cx:pt idx="849">28.168333284026588</cx:pt>
          <cx:pt idx="850">27.891934318006701</cx:pt>
          <cx:pt idx="851">3.7048886622947256e-05</cx:pt>
          <cx:pt idx="852">28.165741602166271</cx:pt>
          <cx:pt idx="853">28.131885823741005</cx:pt>
          <cx:pt idx="854">0.0019818173477896494</cx:pt>
          <cx:pt idx="855">28.144910730005879</cx:pt>
          <cx:pt idx="856">28.134533939626582</cx:pt>
          <cx:pt idx="857">28.180330019359246</cx:pt>
          <cx:pt idx="858">0.01611353468361303</cx:pt>
          <cx:pt idx="859">28.14711352874394</cx:pt>
          <cx:pt idx="860">28.160806096417058</cx:pt>
          <cx:pt idx="861">28.166132144829543</cx:pt>
          <cx:pt idx="862">28.16772976297522</cx:pt>
          <cx:pt idx="863">0.0047697589037602314</cx:pt>
          <cx:pt idx="864">28.157450168649863</cx:pt>
          <cx:pt idx="865">28.155123867601787</cx:pt>
          <cx:pt idx="866">28.153330176020031</cx:pt>
          <cx:pt idx="867">28.16920304161976</cx:pt>
          <cx:pt idx="868">28.164978253142674</cx:pt>
          <cx:pt idx="869">28.172823784633305</cx:pt>
          <cx:pt idx="870">28.154697654210388</cx:pt>
          <cx:pt idx="871">28.153614332799258</cx:pt>
          <cx:pt idx="872">28.160237925131241</cx:pt>
          <cx:pt idx="873">27.804657883167707</cx:pt>
          <cx:pt idx="874">0.0090301771854155773</cx:pt>
          <cx:pt idx="875">28.165386558682272</cx:pt>
          <cx:pt idx="876">0.052557872864110476</cx:pt>
          <cx:pt idx="877">28.164339154327767</cx:pt>
          <cx:pt idx="878">28.157858583351114</cx:pt>
          <cx:pt idx="879">28.166771202961833</cx:pt>
          <cx:pt idx="880">28.147575384036188</cx:pt>
          <cx:pt idx="881">0.012386242368046897</cx:pt>
          <cx:pt idx="882">27.845358679679457</cx:pt>
          <cx:pt idx="883">0.0026490941848111025</cx:pt>
          <cx:pt idx="884">28.148339205004618</cx:pt>
          <cx:pt idx="885">28.170143769601175</cx:pt>
          <cx:pt idx="886">28.164197130399437</cx:pt>
          <cx:pt idx="887">27.924326312375019</cx:pt>
          <cx:pt idx="888">27.782098552845142</cx:pt>
          <cx:pt idx="889">0.076843802612832746</cx:pt>
          <cx:pt idx="890">0.0075569570595577689</cx:pt>
          <cx:pt idx="891">28.159492182921198</cx:pt>
          <cx:pt idx="892">27.804046468095251</cx:pt>
          <cx:pt idx="893">0.018570460414324683</cx:pt>
          <cx:pt idx="894">0.0019248376554920159</cx:pt>
          <cx:pt idx="895">28.161818123125503</cx:pt>
          <cx:pt idx="896">0.11933817494833747</cx:pt>
          <cx:pt idx="897">0.0080354215819706688</cx:pt>
          <cx:pt idx="898">28.162421770863389</cx:pt>
          <cx:pt idx="899">27.872226319402614</cx:pt>
          <cx:pt idx="900">28.172965765073439</cx:pt>
          <cx:pt idx="901">28.168830291653929</cx:pt>
          <cx:pt idx="902">28.15228232310837</cx:pt>
          <cx:pt idx="903">27.816757539296344</cx:pt>
          <cx:pt idx="904">28.168865791863183</cx:pt>
          <cx:pt idx="905">28.165777106268525</cx:pt>
          <cx:pt idx="906">28.16105466774993</cx:pt>
          <cx:pt idx="907">28.169043292238378</cx:pt>
          <cx:pt idx="908">0.00026960118694100733</cx:pt>
          <cx:pt idx="909">28.16249278739366</cx:pt>
          <cx:pt idx="910">28.156509016566666</cx:pt>
          <cx:pt idx="911">0.002452557848451286</cx:pt>
          <cx:pt idx="912">28.156437984944048</cx:pt>
          <cx:pt idx="913">28.174864684679502</cx:pt>
          <cx:pt idx="914">0.056202935866376237</cx:pt>
          <cx:pt idx="915">27.842359813780153</cx:pt>
          <cx:pt idx="916">2.0490778413715769</cx:pt>
          <cx:pt idx="917">22.481547989406778</cx:pt>
          <cx:pt idx="918">0.011794702200564455</cx:pt>
          <cx:pt idx="919">0.005616199782771265</cx:pt>
          <cx:pt idx="920">28.160930382357751</cx:pt>
          <cx:pt idx="921">28.174332290224729</cx:pt>
          <cx:pt idx="922">28.160291191676269</cx:pt>
          <cx:pt idx="923">0.0027907060038635384</cx:pt>
          <cx:pt idx="924">0.0032291175265078227</cx:pt>
          <cx:pt idx="925">27.933277645131444</cx:pt>
          <cx:pt idx="926">28.161960159051429</cx:pt>
          <cx:pt idx="927">0.10607450211997227</cx:pt>
          <cx:pt idx="928">28.152832894755015</cx:pt>
          <cx:pt idx="929">0.0098486344231065864</cx:pt>
          <cx:pt idx="930">0.017805336278767667</cx:pt>
          <cx:pt idx="931">27.814258933144341</cx:pt>
          <cx:pt idx="932">28.167871769091818</cx:pt>
          <cx:pt idx="933">0.00054534117761269416</cx:pt>
          <cx:pt idx="934">28.16856403865841</cx:pt>
          <cx:pt idx="935">0.0096369030295007114</cx:pt>
          <cx:pt idx="936">28.156793141265219</cx:pt>
          <cx:pt idx="937">28.155336971877997</cx:pt>
          <cx:pt idx="938">27.942798714516769</cx:pt>
          <cx:pt idx="939">27.276271739370834</cx:pt>
          <cx:pt idx="940">0.0040339186903059904</cx:pt>
          <cx:pt idx="941">27.939702933281161</cx:pt>
          <cx:pt idx="942">28.154662136136533</cx:pt>
          <cx:pt idx="943">28.16893679214748</cx:pt>
          <cx:pt idx="944">0.00078089756050329668</cx:pt>
          <cx:pt idx="945">28.166895462581603</cx:pt>
          <cx:pt idx="946">28.163469246525718</cx:pt>
          <cx:pt idx="947">0.0032392283031611093</cx:pt>
          <cx:pt idx="948">28.16045099070681</cx:pt>
          <cx:pt idx="949">0.0026802947599098128</cx:pt>
          <cx:pt idx="950">27.770487932335648</cx:pt>
          <cx:pt idx="951">27.825258309672524</cx:pt>
          <cx:pt idx="952">28.159438914864765</cx:pt>
          <cx:pt idx="953">0.041916941682331739</cx:pt>
          <cx:pt idx="954">27.831528883624053</cx:pt>
          <cx:pt idx="955">27.849129250301523</cx:pt>
          <cx:pt idx="956">28.044161602729361</cx:pt>
          <cx:pt idx="957">28.165049263226933</cx:pt>
          <cx:pt idx="958">27.848123814720445</cx:pt>
          <cx:pt idx="959">28.166025633731145</cx:pt>
          <cx:pt idx="960">0.0030093022447072342</cx:pt>
          <cx:pt idx="961">28.173764391717341</cx:pt>
          <cx:pt idx="962">28.15343673514834</cx:pt>
          <cx:pt idx="963">25.940836532386534</cx:pt>
          <cx:pt idx="964">0.012823104148372186</cx:pt>
          <cx:pt idx="965">0.00092484322995846173</cx:pt>
          <cx:pt idx="966">0.001674801480773169</cx:pt>
          <cx:pt idx="967">28.149369442316107</cx:pt>
          <cx:pt idx="968">28.1661854002277</cx:pt>
          <cx:pt idx="969">28.151305475945517</cx:pt>
          <cx:pt idx="970">28.150541735462216</cx:pt>
          <cx:pt idx="971">0.00046584868788051773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sz="20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l-GR" altLang="ja-JP" sz="1200" b="0" i="0" u="none" strike="noStrike" baseline="0" dirty="0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ω</a:t>
            </a:r>
            <a:r>
              <a:rPr lang="en-US" altLang="ja-JP" sz="1200" b="0" i="0" u="none" strike="noStrike" baseline="0" dirty="0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C50,chronic</a:t>
            </a:r>
            <a:endParaRPr lang="ja-JP" altLang="en-US" sz="1200" b="0" i="0" u="none" strike="noStrike" baseline="0" dirty="0">
              <a:solidFill>
                <a:sysClr val="windowText" lastClr="000000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cx:rich>
      </cx:tx>
    </cx:title>
    <cx:plotArea>
      <cx:plotAreaRegion>
        <cx:series layoutId="clusteredColumn" uniqueId="{EE5DDF92-881F-41BC-AED0-CADC38AED78C}">
          <cx:tx>
            <cx:txData>
              <cx:f>'PD chronic'!$AJ$1</cx:f>
              <cx:v>omega nIC50p %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Count val="8"/>
            </cx:binning>
          </cx:layoutPr>
        </cx:series>
      </cx:plotAreaRegion>
      <cx:axis id="0">
        <cx:catScaling gapWidth="0"/>
        <cx:tickLabels/>
        <cx:numFmt formatCode="#,##0.00_);[赤](#,##0.0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PK!$D$2:$D$1001</cx:f>
        <cx:lvl ptCount="1000" formatCode="G/標準">
          <cx:pt idx="0">2.79467</cx:pt>
          <cx:pt idx="1">3.0039400000000001</cx:pt>
          <cx:pt idx="2">4.5811799999999998</cx:pt>
          <cx:pt idx="3">3.5613000000000001</cx:pt>
          <cx:pt idx="4">2.82741</cx:pt>
          <cx:pt idx="5">4.0731799999999998</cx:pt>
          <cx:pt idx="6">3.8989799999999999</cx:pt>
          <cx:pt idx="7">3.5953900000000001</cx:pt>
          <cx:pt idx="8">3.01667</cx:pt>
          <cx:pt idx="9">3.2209099999999999</cx:pt>
          <cx:pt idx="10">4.0035999999999996</cx:pt>
          <cx:pt idx="11">4.7587400000000004</cx:pt>
          <cx:pt idx="12">3.4293300000000002</cx:pt>
          <cx:pt idx="13">3.1260599999999998</cx:pt>
          <cx:pt idx="14">3.7719900000000002</cx:pt>
          <cx:pt idx="15">3.4764900000000001</cx:pt>
          <cx:pt idx="16">3.3600699999999999</cx:pt>
          <cx:pt idx="17">3.1640000000000001</cx:pt>
          <cx:pt idx="18">3.8119299999999998</cx:pt>
          <cx:pt idx="19">2.7020300000000002</cx:pt>
          <cx:pt idx="20">4.7061799999999998</cx:pt>
          <cx:pt idx="21">2.2565499999999998</cx:pt>
          <cx:pt idx="22">2.3041999999999998</cx:pt>
          <cx:pt idx="23">3.8757799999999998</cx:pt>
          <cx:pt idx="24">1.59795</cx:pt>
          <cx:pt idx="25">2.6593</cx:pt>
          <cx:pt idx="26">3.3600699999999999</cx:pt>
          <cx:pt idx="27">3.4898099999999999</cx:pt>
          <cx:pt idx="28">4.3936200000000003</cx:pt>
          <cx:pt idx="29">4.15449</cx:pt>
          <cx:pt idx="30">3.3094000000000001</cx:pt>
          <cx:pt idx="31">4.0891599999999997</cx:pt>
          <cx:pt idx="32">2.4062700000000001</cx:pt>
          <cx:pt idx="33">3.4759899999999999</cx:pt>
          <cx:pt idx="34">3.3600699999999999</cx:pt>
          <cx:pt idx="35">3.3600699999999999</cx:pt>
          <cx:pt idx="36">4.2209199999999996</cx:pt>
          <cx:pt idx="37">4.37927</cx:pt>
          <cx:pt idx="38">3.99736</cx:pt>
          <cx:pt idx="39">3.28043</cx:pt>
          <cx:pt idx="40">3.2924500000000001</cx:pt>
          <cx:pt idx="41">2.9672000000000001</cx:pt>
          <cx:pt idx="42">3.5202300000000002</cx:pt>
          <cx:pt idx="43">3.6770700000000001</cx:pt>
          <cx:pt idx="44">3.1874899999999999</cx:pt>
          <cx:pt idx="45">4.4929100000000002</cx:pt>
          <cx:pt idx="46">3.4758800000000001</cx:pt>
          <cx:pt idx="47">4.2577499999999997</cx:pt>
          <cx:pt idx="48">2.8636900000000001</cx:pt>
          <cx:pt idx="49">3.09226</cx:pt>
          <cx:pt idx="50">3.1750699999999998</cx:pt>
          <cx:pt idx="51">3.0267900000000001</cx:pt>
          <cx:pt idx="52">2.6588500000000002</cx:pt>
          <cx:pt idx="53">2.2071200000000002</cx:pt>
          <cx:pt idx="54">3.8075199999999998</cx:pt>
          <cx:pt idx="55">3.7175600000000002</cx:pt>
          <cx:pt idx="56">3.0645500000000001</cx:pt>
          <cx:pt idx="57">3.3023099999999999</cx:pt>
          <cx:pt idx="58">4.0090199999999996</cx:pt>
          <cx:pt idx="59">2.3593099999999998</cx:pt>
          <cx:pt idx="60">3.0160100000000001</cx:pt>
          <cx:pt idx="61">3.3158400000000001</cx:pt>
          <cx:pt idx="62">3.3144399999999998</cx:pt>
          <cx:pt idx="63">3.0441400000000001</cx:pt>
          <cx:pt idx="64">3.33331</cx:pt>
          <cx:pt idx="65">3.9973700000000001</cx:pt>
          <cx:pt idx="66">3.8997299999999999</cx:pt>
          <cx:pt idx="67">3.2768199999999998</cx:pt>
          <cx:pt idx="68">3.1398299999999999</cx:pt>
          <cx:pt idx="69">3.41276</cx:pt>
          <cx:pt idx="70">4.0869200000000001</cx:pt>
          <cx:pt idx="71">4.5043899999999999</cx:pt>
          <cx:pt idx="72">3.3711500000000001</cx:pt>
          <cx:pt idx="73">3.0591599999999999</cx:pt>
          <cx:pt idx="74">3.36368</cx:pt>
          <cx:pt idx="75">4.0276800000000001</cx:pt>
          <cx:pt idx="76">3.2986200000000001</cx:pt>
          <cx:pt idx="77">3.0998899999999998</cx:pt>
          <cx:pt idx="78">3.6334900000000001</cx:pt>
          <cx:pt idx="79">3.5358200000000002</cx:pt>
          <cx:pt idx="80">3.88565</cx:pt>
          <cx:pt idx="81">4.3022600000000004</cx:pt>
          <cx:pt idx="82">3.3600699999999999</cx:pt>
          <cx:pt idx="83">3.7579799999999999</cx:pt>
          <cx:pt idx="84">3.2282799999999998</cx:pt>
          <cx:pt idx="85">3.7486700000000002</cx:pt>
          <cx:pt idx="86">3.8072900000000001</cx:pt>
          <cx:pt idx="87">4.72661</cx:pt>
          <cx:pt idx="88">3.3257699999999999</cx:pt>
          <cx:pt idx="89">3.6008</cx:pt>
          <cx:pt idx="90">3.02088</cx:pt>
          <cx:pt idx="91">3.8692799999999998</cx:pt>
          <cx:pt idx="92">3.0926900000000002</cx:pt>
          <cx:pt idx="93">3.1599300000000001</cx:pt>
          <cx:pt idx="94">3.32348</cx:pt>
          <cx:pt idx="95">4.3606199999999999</cx:pt>
          <cx:pt idx="96">2.9430200000000002</cx:pt>
          <cx:pt idx="97">4.0449099999999998</cx:pt>
          <cx:pt idx="98">2.9769700000000001</cx:pt>
          <cx:pt idx="99">3.3600699999999999</cx:pt>
          <cx:pt idx="100">3.78573</cx:pt>
          <cx:pt idx="101">3.3600699999999999</cx:pt>
          <cx:pt idx="102">3.3600699999999999</cx:pt>
          <cx:pt idx="103">2.3604099999999999</cx:pt>
          <cx:pt idx="104">2.8060299999999998</cx:pt>
          <cx:pt idx="105">3.6886899999999998</cx:pt>
          <cx:pt idx="106">4.55952</cx:pt>
          <cx:pt idx="107">2.8402099999999999</cx:pt>
          <cx:pt idx="108">3.16981</cx:pt>
          <cx:pt idx="109">3.1849799999999999</cx:pt>
          <cx:pt idx="110">2.9264700000000001</cx:pt>
          <cx:pt idx="111">2.9906700000000002</cx:pt>
          <cx:pt idx="112">3.6873900000000002</cx:pt>
          <cx:pt idx="113">3.99797</cx:pt>
          <cx:pt idx="114">3.5701399999999999</cx:pt>
          <cx:pt idx="115">3.9575100000000001</cx:pt>
          <cx:pt idx="116">3.3086600000000002</cx:pt>
          <cx:pt idx="117">2.9432800000000001</cx:pt>
          <cx:pt idx="118">3.3600699999999999</cx:pt>
          <cx:pt idx="119">3.6550199999999999</cx:pt>
          <cx:pt idx="120">3.44313</cx:pt>
          <cx:pt idx="121">3.57904</cx:pt>
          <cx:pt idx="122">3.5361699999999998</cx:pt>
          <cx:pt idx="123">4.5684699999999996</cx:pt>
          <cx:pt idx="124">3.33047</cx:pt>
          <cx:pt idx="125">3.6734399999999998</cx:pt>
          <cx:pt idx="126">3.7456800000000001</cx:pt>
          <cx:pt idx="127">3.4406699999999999</cx:pt>
          <cx:pt idx="128">3.4026100000000001</cx:pt>
          <cx:pt idx="129">3.8224200000000002</cx:pt>
          <cx:pt idx="130">3.36198</cx:pt>
          <cx:pt idx="131">2.7069000000000001</cx:pt>
          <cx:pt idx="132">3.8165</cx:pt>
          <cx:pt idx="133">3.4941800000000001</cx:pt>
          <cx:pt idx="134">3.6800199999999998</cx:pt>
          <cx:pt idx="135">3.5880700000000001</cx:pt>
          <cx:pt idx="136">3.3600699999999999</cx:pt>
          <cx:pt idx="137">3.2783099999999998</cx:pt>
          <cx:pt idx="138">3.8385799999999999</cx:pt>
          <cx:pt idx="139">3.5101800000000001</cx:pt>
          <cx:pt idx="140">2.86626</cx:pt>
          <cx:pt idx="141">2.9949300000000001</cx:pt>
          <cx:pt idx="142">3.2926899999999999</cx:pt>
          <cx:pt idx="143">3.8714499999999998</cx:pt>
          <cx:pt idx="144">3.2876699999999999</cx:pt>
          <cx:pt idx="145">3.3600699999999999</cx:pt>
          <cx:pt idx="146">3.3807700000000001</cx:pt>
          <cx:pt idx="147">3.5106600000000001</cx:pt>
          <cx:pt idx="148">4.2563899999999997</cx:pt>
          <cx:pt idx="149">2.8504100000000001</cx:pt>
          <cx:pt idx="150">3.4727700000000001</cx:pt>
          <cx:pt idx="151">3.15611</cx:pt>
          <cx:pt idx="152">2.6005400000000001</cx:pt>
          <cx:pt idx="153">3.5648</cx:pt>
          <cx:pt idx="154">2.5238900000000002</cx:pt>
          <cx:pt idx="155">3.4534099999999999</cx:pt>
          <cx:pt idx="156">3.3246600000000002</cx:pt>
          <cx:pt idx="157">3.2028799999999999</cx:pt>
          <cx:pt idx="158">3.8553000000000002</cx:pt>
          <cx:pt idx="159">4.0779699999999997</cx:pt>
          <cx:pt idx="160">3.7989600000000001</cx:pt>
          <cx:pt idx="161">2.5157600000000002</cx:pt>
          <cx:pt idx="162">3.9975499999999999</cx:pt>
          <cx:pt idx="163">4.0170199999999996</cx:pt>
          <cx:pt idx="164">3.5694499999999998</cx:pt>
          <cx:pt idx="165">3.10406</cx:pt>
          <cx:pt idx="166">1.48929</cx:pt>
          <cx:pt idx="167">3.0364800000000001</cx:pt>
          <cx:pt idx="168">3.6323400000000001</cx:pt>
          <cx:pt idx="169">3.3918599999999999</cx:pt>
          <cx:pt idx="170">2.9649100000000002</cx:pt>
          <cx:pt idx="171">3.1764000000000001</cx:pt>
          <cx:pt idx="172">3.2501799999999998</cx:pt>
          <cx:pt idx="173">3.2737500000000002</cx:pt>
          <cx:pt idx="174">3.4279000000000002</cx:pt>
          <cx:pt idx="175">3.3384999999999998</cx:pt>
          <cx:pt idx="176">3.3415400000000002</cx:pt>
          <cx:pt idx="177">3.1193399999999998</cx:pt>
          <cx:pt idx="178">3.49878</cx:pt>
          <cx:pt idx="179">2.89818</cx:pt>
          <cx:pt idx="180">2.7460200000000001</cx:pt>
          <cx:pt idx="181">3.6341899999999998</cx:pt>
          <cx:pt idx="182">4.3014700000000001</cx:pt>
          <cx:pt idx="183">3.6174300000000001</cx:pt>
          <cx:pt idx="184">4.11693</cx:pt>
          <cx:pt idx="185">3.1151800000000001</cx:pt>
          <cx:pt idx="186">2.7161200000000001</cx:pt>
          <cx:pt idx="187">3.1739999999999999</cx:pt>
          <cx:pt idx="188">3.8840599999999998</cx:pt>
          <cx:pt idx="189">3.2741400000000001</cx:pt>
          <cx:pt idx="190">3.3600699999999999</cx:pt>
          <cx:pt idx="191">4.3714599999999999</cx:pt>
          <cx:pt idx="192">3.7033</cx:pt>
          <cx:pt idx="193">4.8138500000000004</cx:pt>
          <cx:pt idx="194">3.73123</cx:pt>
          <cx:pt idx="195">2.1347999999999998</cx:pt>
          <cx:pt idx="196">2.75739</cx:pt>
          <cx:pt idx="197">2.5177499999999999</cx:pt>
          <cx:pt idx="198">3.3377599999999998</cx:pt>
          <cx:pt idx="199">3.90232</cx:pt>
          <cx:pt idx="200">3.4949599999999998</cx:pt>
          <cx:pt idx="201">3.2845900000000001</cx:pt>
          <cx:pt idx="202">3.11422</cx:pt>
          <cx:pt idx="203">3.0029599999999999</cx:pt>
          <cx:pt idx="204">4.0500299999999996</cx:pt>
          <cx:pt idx="205">2.9367200000000002</cx:pt>
          <cx:pt idx="206">3.2166000000000001</cx:pt>
          <cx:pt idx="207">3.6139299999999999</cx:pt>
          <cx:pt idx="208">2.9338899999999999</cx:pt>
          <cx:pt idx="209">4.02651</cx:pt>
          <cx:pt idx="210">1.6958599999999999</cx:pt>
          <cx:pt idx="211">3.6315200000000001</cx:pt>
          <cx:pt idx="212">3.1393200000000001</cx:pt>
          <cx:pt idx="213">3.8311700000000002</cx:pt>
          <cx:pt idx="214">3.4923299999999999</cx:pt>
          <cx:pt idx="215">3.0727899999999999</cx:pt>
          <cx:pt idx="216">3.6750400000000001</cx:pt>
          <cx:pt idx="217">3.11829</cx:pt>
          <cx:pt idx="218">2.0927799999999999</cx:pt>
          <cx:pt idx="219">3.6157599999999999</cx:pt>
          <cx:pt idx="220">3.3769</cx:pt>
          <cx:pt idx="221">3.0017999999999998</cx:pt>
          <cx:pt idx="222">3.0011800000000002</cx:pt>
          <cx:pt idx="223">4.5704000000000002</cx:pt>
          <cx:pt idx="224">3.4357700000000002</cx:pt>
          <cx:pt idx="225">3.2151000000000001</cx:pt>
          <cx:pt idx="226">3.1535099999999998</cx:pt>
          <cx:pt idx="227">3.3106599999999999</cx:pt>
          <cx:pt idx="228">3.3600699999999999</cx:pt>
          <cx:pt idx="229">3.1062699999999999</cx:pt>
          <cx:pt idx="230">3.7260900000000001</cx:pt>
          <cx:pt idx="231">3.3659300000000001</cx:pt>
          <cx:pt idx="232">3.88659</cx:pt>
          <cx:pt idx="233">3.3864800000000002</cx:pt>
          <cx:pt idx="234">2.7420300000000002</cx:pt>
          <cx:pt idx="235">3.0897899999999998</cx:pt>
          <cx:pt idx="236">3.3657300000000001</cx:pt>
          <cx:pt idx="237">3.6777000000000002</cx:pt>
          <cx:pt idx="238">3.19753</cx:pt>
          <cx:pt idx="239">3.6689400000000001</cx:pt>
          <cx:pt idx="240">3.3250999999999999</cx:pt>
          <cx:pt idx="241">3.3676699999999999</cx:pt>
          <cx:pt idx="242">2.6541899999999998</cx:pt>
          <cx:pt idx="243">3.7054499999999999</cx:pt>
          <cx:pt idx="244">3.7429800000000002</cx:pt>
          <cx:pt idx="245">4.2247300000000001</cx:pt>
          <cx:pt idx="246">3.1820499999999998</cx:pt>
          <cx:pt idx="247">3.3600699999999999</cx:pt>
          <cx:pt idx="248">4.0288500000000003</cx:pt>
          <cx:pt idx="249">4.3312799999999996</cx:pt>
          <cx:pt idx="250">3.7340200000000001</cx:pt>
          <cx:pt idx="251">3.9885199999999998</cx:pt>
          <cx:pt idx="252">3.7723800000000001</cx:pt>
          <cx:pt idx="253">3.3604500000000002</cx:pt>
          <cx:pt idx="254">4.3769600000000004</cx:pt>
          <cx:pt idx="255">3.8345500000000001</cx:pt>
          <cx:pt idx="256">3.6107100000000001</cx:pt>
          <cx:pt idx="257">3.6991000000000001</cx:pt>
          <cx:pt idx="258">3.4888300000000001</cx:pt>
          <cx:pt idx="259">3.1530499999999999</cx:pt>
          <cx:pt idx="260">3.8047900000000001</cx:pt>
          <cx:pt idx="261">3.7776900000000002</cx:pt>
          <cx:pt idx="262">4.0546199999999999</cx:pt>
          <cx:pt idx="263">3.5956600000000001</cx:pt>
          <cx:pt idx="264">3.5873200000000001</cx:pt>
          <cx:pt idx="265">2.9716999999999998</cx:pt>
          <cx:pt idx="266">3.7437399999999998</cx:pt>
          <cx:pt idx="267">4.02996</cx:pt>
          <cx:pt idx="268">3.10806</cx:pt>
          <cx:pt idx="269">3.3600699999999999</cx:pt>
          <cx:pt idx="270">3.7639</cx:pt>
          <cx:pt idx="271">3.41777</cx:pt>
          <cx:pt idx="272">2.81616</cx:pt>
          <cx:pt idx="273">3.9650099999999999</cx:pt>
          <cx:pt idx="274">2.577</cx:pt>
          <cx:pt idx="275">3.1451500000000001</cx:pt>
          <cx:pt idx="276">3.1739000000000002</cx:pt>
          <cx:pt idx="277">3.6212300000000002</cx:pt>
          <cx:pt idx="278">3.6113400000000002</cx:pt>
          <cx:pt idx="279">3.5733799999999998</cx:pt>
          <cx:pt idx="280">3.1766800000000002</cx:pt>
          <cx:pt idx="281">3.70648</cx:pt>
          <cx:pt idx="282">2.52013</cx:pt>
          <cx:pt idx="283">3.33752</cx:pt>
          <cx:pt idx="284">3.5989499999999999</cx:pt>
          <cx:pt idx="285">3.3600699999999999</cx:pt>
          <cx:pt idx="286">3.1834799999999999</cx:pt>
          <cx:pt idx="287">3.3195700000000001</cx:pt>
          <cx:pt idx="288">3.4040699999999999</cx:pt>
          <cx:pt idx="289">3.5898500000000002</cx:pt>
          <cx:pt idx="290">1.7566600000000001</cx:pt>
          <cx:pt idx="291">3.3600699999999999</cx:pt>
          <cx:pt idx="292">3.6701899999999998</cx:pt>
          <cx:pt idx="293">2.9047000000000001</cx:pt>
          <cx:pt idx="294">4.8159299999999998</cx:pt>
          <cx:pt idx="295">3.8916200000000001</cx:pt>
          <cx:pt idx="296">3.26573</cx:pt>
          <cx:pt idx="297">3.1637200000000001</cx:pt>
          <cx:pt idx="298">2.8774700000000002</cx:pt>
          <cx:pt idx="299">3.7321499999999999</cx:pt>
          <cx:pt idx="300">3.1626799999999999</cx:pt>
          <cx:pt idx="301">3.2431199999999998</cx:pt>
          <cx:pt idx="302">2.9347400000000001</cx:pt>
          <cx:pt idx="303">3.2631800000000002</cx:pt>
          <cx:pt idx="304">3.3600699999999999</cx:pt>
          <cx:pt idx="305">3.3506900000000002</cx:pt>
          <cx:pt idx="306">3.0840800000000002</cx:pt>
          <cx:pt idx="307">1.6373</cx:pt>
          <cx:pt idx="308">1.55582</cx:pt>
          <cx:pt idx="309">3.3600699999999999</cx:pt>
          <cx:pt idx="310">3.5736500000000002</cx:pt>
          <cx:pt idx="311">3.0116399999999999</cx:pt>
          <cx:pt idx="312">3.49478</cx:pt>
          <cx:pt idx="313">3.06271</cx:pt>
          <cx:pt idx="314">4.1665299999999998</cx:pt>
          <cx:pt idx="315">2.4178899999999999</cx:pt>
          <cx:pt idx="316">3.04067</cx:pt>
          <cx:pt idx="317">4.1711400000000003</cx:pt>
          <cx:pt idx="318">3.0087100000000002</cx:pt>
          <cx:pt idx="319">3.2054900000000002</cx:pt>
          <cx:pt idx="320">2.6742599999999999</cx:pt>
          <cx:pt idx="321">3.68377</cx:pt>
          <cx:pt idx="322">3.3773200000000001</cx:pt>
          <cx:pt idx="323">3.22641</cx:pt>
          <cx:pt idx="324">2.78647</cx:pt>
          <cx:pt idx="325">2.6105200000000002</cx:pt>
          <cx:pt idx="326">2.7639900000000002</cx:pt>
          <cx:pt idx="327">3.3071600000000001</cx:pt>
          <cx:pt idx="328">3.1005799999999999</cx:pt>
          <cx:pt idx="329">3.21536</cx:pt>
          <cx:pt idx="330">3.3266</cx:pt>
          <cx:pt idx="331">2.7178900000000001</cx:pt>
          <cx:pt idx="332">3.2686999999999999</cx:pt>
          <cx:pt idx="333">3.5146199999999999</cx:pt>
          <cx:pt idx="334">3.3743099999999999</cx:pt>
          <cx:pt idx="335">3.9532500000000002</cx:pt>
          <cx:pt idx="336">2.8955799999999998</cx:pt>
          <cx:pt idx="337">2.22079</cx:pt>
          <cx:pt idx="338">2.5698500000000002</cx:pt>
          <cx:pt idx="339">2.83188</cx:pt>
          <cx:pt idx="340">3.1678999999999999</cx:pt>
          <cx:pt idx="341">3.5196399999999999</cx:pt>
          <cx:pt idx="342">3.19503</cx:pt>
          <cx:pt idx="343">2.70716</cx:pt>
          <cx:pt idx="344">3.1145399999999999</cx:pt>
          <cx:pt idx="345">3.37249</cx:pt>
          <cx:pt idx="346">3.6049000000000002</cx:pt>
          <cx:pt idx="347">3.2999000000000001</cx:pt>
          <cx:pt idx="348">2.8368799999999998</cx:pt>
          <cx:pt idx="349">3.4106399999999999</cx:pt>
          <cx:pt idx="350">3.4714200000000002</cx:pt>
          <cx:pt idx="351">3.6446399999999999</cx:pt>
          <cx:pt idx="352">3.3290299999999999</cx:pt>
          <cx:pt idx="353">3.7476799999999999</cx:pt>
          <cx:pt idx="354">3.6243599999999998</cx:pt>
          <cx:pt idx="355">3.0595500000000002</cx:pt>
          <cx:pt idx="356">2.86246</cx:pt>
          <cx:pt idx="357">3.8866700000000001</cx:pt>
          <cx:pt idx="358">3.7273299999999998</cx:pt>
          <cx:pt idx="359">3.4188000000000001</cx:pt>
          <cx:pt idx="360">3.58745</cx:pt>
          <cx:pt idx="361">3.0862400000000001</cx:pt>
          <cx:pt idx="362">3.4986199999999998</cx:pt>
          <cx:pt idx="363">3.3600699999999999</cx:pt>
          <cx:pt idx="364">3.2552400000000001</cx:pt>
          <cx:pt idx="365">1.8518600000000001</cx:pt>
          <cx:pt idx="366">3.1913399999999998</cx:pt>
          <cx:pt idx="367">3.6830799999999999</cx:pt>
          <cx:pt idx="368">3.7720600000000002</cx:pt>
          <cx:pt idx="369">3.3600699999999999</cx:pt>
          <cx:pt idx="370">2.8248000000000002</cx:pt>
          <cx:pt idx="371">2.8569800000000001</cx:pt>
          <cx:pt idx="372">3.3753600000000001</cx:pt>
          <cx:pt idx="373">3.0658599999999998</cx:pt>
          <cx:pt idx="374">4.0301200000000001</cx:pt>
          <cx:pt idx="375">2.6619000000000002</cx:pt>
          <cx:pt idx="376">3.3600699999999999</cx:pt>
          <cx:pt idx="377">3.0718800000000002</cx:pt>
          <cx:pt idx="378">3.7102900000000001</cx:pt>
          <cx:pt idx="379">3.3600699999999999</cx:pt>
          <cx:pt idx="380">3.1330399999999998</cx:pt>
          <cx:pt idx="381">2.5784500000000001</cx:pt>
          <cx:pt idx="382">4.0625299999999998</cx:pt>
          <cx:pt idx="383">3.9788899999999998</cx:pt>
          <cx:pt idx="384">3.8889800000000001</cx:pt>
          <cx:pt idx="385">3.0563799999999999</cx:pt>
          <cx:pt idx="386">3.8545099999999999</cx:pt>
          <cx:pt idx="387">3.4902299999999999</cx:pt>
          <cx:pt idx="388">3.3788999999999998</cx:pt>
          <cx:pt idx="389">3.6327199999999999</cx:pt>
          <cx:pt idx="390">4.7513399999999999</cx:pt>
          <cx:pt idx="391">2.9765199999999998</cx:pt>
          <cx:pt idx="392">3.6175299999999999</cx:pt>
          <cx:pt idx="393">3.14832</cx:pt>
          <cx:pt idx="394">3.3600699999999999</cx:pt>
          <cx:pt idx="395">2.6207099999999999</cx:pt>
          <cx:pt idx="396">3.0841500000000002</cx:pt>
          <cx:pt idx="397">3.0894400000000002</cx:pt>
          <cx:pt idx="398">3.7325300000000001</cx:pt>
          <cx:pt idx="399">3.44136</cx:pt>
          <cx:pt idx="400">3.2410100000000002</cx:pt>
          <cx:pt idx="401">3.3600699999999999</cx:pt>
          <cx:pt idx="402">3.4499900000000001</cx:pt>
          <cx:pt idx="403">3.4273199999999999</cx:pt>
          <cx:pt idx="404">3.3616999999999999</cx:pt>
          <cx:pt idx="405">3.73306</cx:pt>
          <cx:pt idx="406">3.3924500000000002</cx:pt>
          <cx:pt idx="407">3.4821499999999999</cx:pt>
          <cx:pt idx="408">3.8294299999999999</cx:pt>
          <cx:pt idx="409">3.5539000000000001</cx:pt>
          <cx:pt idx="410">3.7303099999999998</cx:pt>
          <cx:pt idx="411">2.9744199999999998</cx:pt>
          <cx:pt idx="412">3.2275200000000002</cx:pt>
          <cx:pt idx="413">4.0896400000000002</cx:pt>
          <cx:pt idx="414">3.0637699999999999</cx:pt>
          <cx:pt idx="415">3.42272</cx:pt>
          <cx:pt idx="416">2.59205</cx:pt>
          <cx:pt idx="417">3.9401000000000002</cx:pt>
          <cx:pt idx="418">2.9870299999999999</cx:pt>
          <cx:pt idx="419">3.01058</cx:pt>
          <cx:pt idx="420">4.3111199999999998</cx:pt>
          <cx:pt idx="421">3.7419799999999999</cx:pt>
          <cx:pt idx="422">3.6727400000000001</cx:pt>
          <cx:pt idx="423">4.3784900000000002</cx:pt>
          <cx:pt idx="424">4.1154999999999999</cx:pt>
          <cx:pt idx="425">3.3496199999999998</cx:pt>
          <cx:pt idx="426">2.8071100000000002</cx:pt>
          <cx:pt idx="427">3.0904799999999999</cx:pt>
          <cx:pt idx="428">4.2245900000000001</cx:pt>
          <cx:pt idx="429">3.5761699999999998</cx:pt>
          <cx:pt idx="430">4.3204799999999999</cx:pt>
          <cx:pt idx="431">4.2430700000000003</cx:pt>
          <cx:pt idx="432">4.1415100000000002</cx:pt>
          <cx:pt idx="433">3.39791</cx:pt>
          <cx:pt idx="434">3.7021299999999999</cx:pt>
          <cx:pt idx="435">2.9152399999999998</cx:pt>
          <cx:pt idx="436">3.64575</cx:pt>
          <cx:pt idx="437">2.7945000000000002</cx:pt>
          <cx:pt idx="438">3.0807799999999999</cx:pt>
          <cx:pt idx="439">3.38409</cx:pt>
          <cx:pt idx="440">2.9607999999999999</cx:pt>
          <cx:pt idx="441">3.65509</cx:pt>
          <cx:pt idx="442">4.1166700000000001</cx:pt>
          <cx:pt idx="443">3.3600699999999999</cx:pt>
          <cx:pt idx="444">3.3125800000000001</cx:pt>
          <cx:pt idx="445">1.6184400000000001</cx:pt>
          <cx:pt idx="446">3.8441399999999999</cx:pt>
          <cx:pt idx="447">3.4818199999999999</cx:pt>
          <cx:pt idx="448">2.92082</cx:pt>
          <cx:pt idx="449">3.18554</cx:pt>
          <cx:pt idx="450">2.62995</cx:pt>
          <cx:pt idx="451">3.4988600000000001</cx:pt>
          <cx:pt idx="452">3.66919</cx:pt>
          <cx:pt idx="453">4.4737200000000001</cx:pt>
          <cx:pt idx="454">2.9584600000000001</cx:pt>
          <cx:pt idx="455">3.9982199999999999</cx:pt>
          <cx:pt idx="456">3.0807799999999999</cx:pt>
          <cx:pt idx="457">3.2334299999999998</cx:pt>
          <cx:pt idx="458">3.33067</cx:pt>
          <cx:pt idx="459">3.1365599999999998</cx:pt>
          <cx:pt idx="460">3.2725200000000001</cx:pt>
          <cx:pt idx="461">2.9290400000000001</cx:pt>
          <cx:pt idx="462">4.4539400000000002</cx:pt>
          <cx:pt idx="463">3.4796800000000001</cx:pt>
          <cx:pt idx="464">3.1538400000000002</cx:pt>
          <cx:pt idx="465">3.01397</cx:pt>
          <cx:pt idx="466">3.2984499999999999</cx:pt>
          <cx:pt idx="467">2.5097999999999998</cx:pt>
          <cx:pt idx="468">3.6102799999999999</cx:pt>
          <cx:pt idx="469">3.6719300000000001</cx:pt>
          <cx:pt idx="470">3.2037399999999998</cx:pt>
          <cx:pt idx="471">2.9327299999999998</cx:pt>
          <cx:pt idx="472">3.4955400000000001</cx:pt>
          <cx:pt idx="473">2.7150799999999999</cx:pt>
          <cx:pt idx="474">3.61998</cx:pt>
          <cx:pt idx="475">3.0711300000000001</cx:pt>
          <cx:pt idx="476">4.90801</cx:pt>
          <cx:pt idx="477">4.2170100000000001</cx:pt>
          <cx:pt idx="478">3.8168000000000002</cx:pt>
          <cx:pt idx="479">3.35656</cx:pt>
          <cx:pt idx="480">2.4889999999999999</cx:pt>
          <cx:pt idx="481">3.3306</cx:pt>
          <cx:pt idx="482">2.8506499999999999</cx:pt>
          <cx:pt idx="483">3.6507800000000001</cx:pt>
          <cx:pt idx="484">3.3600699999999999</cx:pt>
          <cx:pt idx="485">3.3486899999999999</cx:pt>
          <cx:pt idx="486">3.2969200000000001</cx:pt>
          <cx:pt idx="487">2.59396</cx:pt>
          <cx:pt idx="488">3.0702799999999999</cx:pt>
          <cx:pt idx="489">3.0676800000000002</cx:pt>
          <cx:pt idx="490">3.3600699999999999</cx:pt>
          <cx:pt idx="491">3.32551</cx:pt>
          <cx:pt idx="492">3.9415200000000001</cx:pt>
          <cx:pt idx="493">3.5278700000000001</cx:pt>
          <cx:pt idx="494">3.0364599999999999</cx:pt>
          <cx:pt idx="495">3.0969799999999998</cx:pt>
          <cx:pt idx="496">3.3173300000000001</cx:pt>
          <cx:pt idx="497">3.1253799999999998</cx:pt>
          <cx:pt idx="498">3.3544299999999998</cx:pt>
          <cx:pt idx="499">3.35975</cx:pt>
          <cx:pt idx="500">2.7981500000000001</cx:pt>
          <cx:pt idx="501">2.7225100000000002</cx:pt>
          <cx:pt idx="502">3.6085799999999999</cx:pt>
          <cx:pt idx="503">4.0566899999999997</cx:pt>
          <cx:pt idx="504">3.2700499999999999</cx:pt>
          <cx:pt idx="505">3.6257700000000002</cx:pt>
          <cx:pt idx="506">3.4022000000000001</cx:pt>
          <cx:pt idx="507">3.7649400000000002</cx:pt>
          <cx:pt idx="508">3.3600699999999999</cx:pt>
          <cx:pt idx="509">3.3426999999999998</cx:pt>
          <cx:pt idx="510">3.3600699999999999</cx:pt>
          <cx:pt idx="511">3.44665</cx:pt>
          <cx:pt idx="512">2.99743</cx:pt>
          <cx:pt idx="513">3.3449599999999999</cx:pt>
          <cx:pt idx="514">3.3929900000000002</cx:pt>
          <cx:pt idx="515">2.8269600000000001</cx:pt>
          <cx:pt idx="516">3.6775600000000002</cx:pt>
          <cx:pt idx="517">3.2692700000000001</cx:pt>
          <cx:pt idx="518">2.9673099999999999</cx:pt>
          <cx:pt idx="519">2.6844899999999998</cx:pt>
          <cx:pt idx="520">1.7576000000000001</cx:pt>
          <cx:pt idx="521">3.6944400000000002</cx:pt>
          <cx:pt idx="522">3.6473100000000001</cx:pt>
          <cx:pt idx="523">3.3600699999999999</cx:pt>
          <cx:pt idx="524">2.9463900000000001</cx:pt>
          <cx:pt idx="525">3.5256799999999999</cx:pt>
          <cx:pt idx="526">3.2425799999999998</cx:pt>
          <cx:pt idx="527">2.93587</cx:pt>
          <cx:pt idx="528">2.68872</cx:pt>
          <cx:pt idx="529">3.4590399999999999</cx:pt>
          <cx:pt idx="530">3.9981599999999999</cx:pt>
          <cx:pt idx="531">2.57721</cx:pt>
          <cx:pt idx="532">4.0025599999999999</cx:pt>
          <cx:pt idx="533">2.6346799999999999</cx:pt>
          <cx:pt idx="534">3.1366900000000002</cx:pt>
          <cx:pt idx="535">4.0047100000000002</cx:pt>
          <cx:pt idx="536">3.8536899999999998</cx:pt>
          <cx:pt idx="537">3.3424399999999999</cx:pt>
          <cx:pt idx="538">3.6028600000000002</cx:pt>
          <cx:pt idx="539">3.5750299999999999</cx:pt>
          <cx:pt idx="540">3.48671</cx:pt>
          <cx:pt idx="541">2.04339</cx:pt>
          <cx:pt idx="542">2.9709500000000002</cx:pt>
          <cx:pt idx="543">3.1845599999999998</cx:pt>
          <cx:pt idx="544">3.2102900000000001</cx:pt>
          <cx:pt idx="545">3.83541</cx:pt>
          <cx:pt idx="546">3.1086900000000002</cx:pt>
          <cx:pt idx="547">3.5226500000000001</cx:pt>
          <cx:pt idx="548">4.2436499999999997</cx:pt>
          <cx:pt idx="549">3.50414</cx:pt>
          <cx:pt idx="550">2.8877700000000002</cx:pt>
          <cx:pt idx="551">3.3090199999999999</cx:pt>
          <cx:pt idx="552">3.4328500000000002</cx:pt>
          <cx:pt idx="553">3.7971200000000001</cx:pt>
          <cx:pt idx="554">2.1372900000000001</cx:pt>
          <cx:pt idx="555">3.08548</cx:pt>
          <cx:pt idx="556">3.71516</cx:pt>
          <cx:pt idx="557">2.8137099999999999</cx:pt>
          <cx:pt idx="558">2.39472</cx:pt>
          <cx:pt idx="559">4.60853</cx:pt>
          <cx:pt idx="560">3.4501200000000001</cx:pt>
          <cx:pt idx="561">3.2093099999999999</cx:pt>
          <cx:pt idx="562">2.8312900000000001</cx:pt>
          <cx:pt idx="563">3.0609299999999999</cx:pt>
          <cx:pt idx="564">2.6597499999999998</cx:pt>
          <cx:pt idx="565">4.5442600000000004</cx:pt>
          <cx:pt idx="566">2.5992600000000001</cx:pt>
          <cx:pt idx="567">3.2720600000000002</cx:pt>
          <cx:pt idx="568">2.9874700000000001</cx:pt>
          <cx:pt idx="569">3.2206800000000002</cx:pt>
          <cx:pt idx="570">3.3313700000000002</cx:pt>
          <cx:pt idx="571">3.6173899999999999</cx:pt>
          <cx:pt idx="572">3.30206</cx:pt>
          <cx:pt idx="573">2.9592100000000001</cx:pt>
          <cx:pt idx="574">3.5842200000000002</cx:pt>
          <cx:pt idx="575">3.4399899999999999</cx:pt>
          <cx:pt idx="576">2.2162899999999999</cx:pt>
          <cx:pt idx="577">3.1598000000000002</cx:pt>
          <cx:pt idx="578">2.9317899999999999</cx:pt>
          <cx:pt idx="579">3.72479</cx:pt>
          <cx:pt idx="580">3.9023599999999998</cx:pt>
          <cx:pt idx="581">3.5093100000000002</cx:pt>
          <cx:pt idx="582">2.90272</cx:pt>
          <cx:pt idx="583">4.1133600000000001</cx:pt>
          <cx:pt idx="584">3.6797</cx:pt>
          <cx:pt idx="585">3.3283299999999998</cx:pt>
          <cx:pt idx="586">2.8372199999999999</cx:pt>
          <cx:pt idx="587">1.45519</cx:pt>
          <cx:pt idx="588">3.0047299999999999</cx:pt>
          <cx:pt idx="589">3.8388399999999998</cx:pt>
          <cx:pt idx="590">3.4592200000000002</cx:pt>
          <cx:pt idx="591">3.3540700000000001</cx:pt>
          <cx:pt idx="592">3.6414499999999999</cx:pt>
          <cx:pt idx="593">3.1525799999999999</cx:pt>
          <cx:pt idx="594">3.5449199999999998</cx:pt>
          <cx:pt idx="595">2.7685</cx:pt>
          <cx:pt idx="596">3.02318</cx:pt>
          <cx:pt idx="597">3.42563</cx:pt>
          <cx:pt idx="598">3.6276700000000002</cx:pt>
          <cx:pt idx="599">3.91161</cx:pt>
          <cx:pt idx="600">3.1293500000000001</cx:pt>
          <cx:pt idx="601">3.5009899999999998</cx:pt>
          <cx:pt idx="602">4.0688000000000004</cx:pt>
          <cx:pt idx="603">4.0765000000000002</cx:pt>
          <cx:pt idx="604">3.7886199999999999</cx:pt>
          <cx:pt idx="605">3.8605200000000002</cx:pt>
          <cx:pt idx="606">3.4270100000000001</cx:pt>
          <cx:pt idx="607">3.35324</cx:pt>
          <cx:pt idx="608">2.9050799999999999</cx:pt>
          <cx:pt idx="609">3.3038500000000002</cx:pt>
          <cx:pt idx="610">3.9745699999999999</cx:pt>
          <cx:pt idx="611">3.1018699999999999</cx:pt>
          <cx:pt idx="612">2.4233899999999999</cx:pt>
          <cx:pt idx="613">3.3541699999999999</cx:pt>
          <cx:pt idx="614">2.8797600000000001</cx:pt>
          <cx:pt idx="615">3.3545199999999999</cx:pt>
          <cx:pt idx="616">2.89886</cx:pt>
          <cx:pt idx="617">3.12473</cx:pt>
          <cx:pt idx="618">3.3259300000000001</cx:pt>
          <cx:pt idx="619">3.3763700000000001</cx:pt>
          <cx:pt idx="620">3.9007200000000002</cx:pt>
          <cx:pt idx="621">3.0910099999999998</cx:pt>
          <cx:pt idx="622">3.4457200000000001</cx:pt>
          <cx:pt idx="623">2.68154</cx:pt>
          <cx:pt idx="624">3.93933</cx:pt>
          <cx:pt idx="625">1.73515</cx:pt>
          <cx:pt idx="626">3.6371699999999998</cx:pt>
          <cx:pt idx="627">3.17517</cx:pt>
          <cx:pt idx="628">3.5830799999999998</cx:pt>
          <cx:pt idx="629">2.9144700000000001</cx:pt>
          <cx:pt idx="630">1.5703400000000001</cx:pt>
          <cx:pt idx="631">3.2246999999999999</cx:pt>
          <cx:pt idx="632">3.6145</cx:pt>
          <cx:pt idx="633">3.145</cx:pt>
          <cx:pt idx="634">3.2409300000000001</cx:pt>
          <cx:pt idx="635">4.6198199999999998</cx:pt>
          <cx:pt idx="636">3.9336199999999999</cx:pt>
          <cx:pt idx="637">2.86863</cx:pt>
          <cx:pt idx="638">3.3473099999999998</cx:pt>
          <cx:pt idx="639">3.1951200000000002</cx:pt>
          <cx:pt idx="640">3.0204900000000001</cx:pt>
          <cx:pt idx="641">2.2742499999999999</cx:pt>
          <cx:pt idx="642">3.2883300000000002</cx:pt>
          <cx:pt idx="643">2.99614</cx:pt>
          <cx:pt idx="644">3.64012</cx:pt>
          <cx:pt idx="645">3.2001499999999998</cx:pt>
          <cx:pt idx="646">3.51444</cx:pt>
          <cx:pt idx="647">3.7248999999999999</cx:pt>
          <cx:pt idx="648">3.9956999999999998</cx:pt>
          <cx:pt idx="649">3.3780399999999999</cx:pt>
          <cx:pt idx="650">4.5158300000000002</cx:pt>
          <cx:pt idx="651">3.5871200000000001</cx:pt>
          <cx:pt idx="652">4.3757999999999999</cx:pt>
          <cx:pt idx="653">3.7903500000000001</cx:pt>
          <cx:pt idx="654">3.0316299999999998</cx:pt>
          <cx:pt idx="655">3.3891100000000001</cx:pt>
          <cx:pt idx="656">3.3350599999999999</cx:pt>
          <cx:pt idx="657">4.0763299999999996</cx:pt>
          <cx:pt idx="658">3.6841400000000002</cx:pt>
          <cx:pt idx="659">2.4891999999999999</cx:pt>
          <cx:pt idx="660">4.0885699999999998</cx:pt>
          <cx:pt idx="661">2.9151099999999999</cx:pt>
          <cx:pt idx="662">2.9503200000000001</cx:pt>
          <cx:pt idx="663">3.7961399999999998</cx:pt>
          <cx:pt idx="664">3.40822</cx:pt>
          <cx:pt idx="665">3.14907</cx:pt>
          <cx:pt idx="666">2.9255300000000002</cx:pt>
          <cx:pt idx="667">2.7385700000000002</cx:pt>
          <cx:pt idx="668">3.25482</cx:pt>
          <cx:pt idx="669">2.58046</cx:pt>
          <cx:pt idx="670">2.4289200000000002</cx:pt>
          <cx:pt idx="671">3.2006899999999998</cx:pt>
          <cx:pt idx="672">3.81182</cx:pt>
          <cx:pt idx="673">3.3600699999999999</cx:pt>
          <cx:pt idx="674">3.4327899999999998</cx:pt>
          <cx:pt idx="675">3.4787499999999998</cx:pt>
          <cx:pt idx="676">3.16587</cx:pt>
          <cx:pt idx="677">3.2115900000000002</cx:pt>
          <cx:pt idx="678">3.3600699999999999</cx:pt>
          <cx:pt idx="679">3.99058</cx:pt>
          <cx:pt idx="680">3.2495400000000001</cx:pt>
          <cx:pt idx="681">3.6144599999999998</cx:pt>
          <cx:pt idx="682">3.76349</cx:pt>
          <cx:pt idx="683">3.5735700000000001</cx:pt>
          <cx:pt idx="684">2.70269</cx:pt>
          <cx:pt idx="685">3.97133</cx:pt>
          <cx:pt idx="686">3.5699999999999998</cx:pt>
          <cx:pt idx="687">3.3600699999999999</cx:pt>
          <cx:pt idx="688">3.7339199999999999</cx:pt>
          <cx:pt idx="689">3.4465400000000002</cx:pt>
          <cx:pt idx="690">3.7835999999999999</cx:pt>
          <cx:pt idx="691">4.7768899999999999</cx:pt>
          <cx:pt idx="692">3.6076299999999999</cx:pt>
          <cx:pt idx="693">3.9705400000000002</cx:pt>
          <cx:pt idx="694">2.5504899999999999</cx:pt>
          <cx:pt idx="695">3.5494400000000002</cx:pt>
          <cx:pt idx="696">2.88944</cx:pt>
          <cx:pt idx="697">3.71313</cx:pt>
          <cx:pt idx="698">2.57525</cx:pt>
          <cx:pt idx="699">2.20221</cx:pt>
          <cx:pt idx="700">3.4707699999999999</cx:pt>
          <cx:pt idx="701">3.7298300000000002</cx:pt>
          <cx:pt idx="702">4.6722299999999999</cx:pt>
          <cx:pt idx="703">3.58012</cx:pt>
          <cx:pt idx="704">3.2035999999999998</cx:pt>
          <cx:pt idx="705">3.0216799999999999</cx:pt>
          <cx:pt idx="706">3.3600699999999999</cx:pt>
          <cx:pt idx="707">3.3600699999999999</cx:pt>
          <cx:pt idx="708">3.6153200000000001</cx:pt>
          <cx:pt idx="709">3.8681899999999998</cx:pt>
          <cx:pt idx="710">3.3600699999999999</cx:pt>
          <cx:pt idx="711">3.3600699999999999</cx:pt>
          <cx:pt idx="712">2.8355700000000001</cx:pt>
          <cx:pt idx="713">2.9601299999999999</cx:pt>
          <cx:pt idx="714">1.71793</cx:pt>
          <cx:pt idx="715">3.5103200000000001</cx:pt>
          <cx:pt idx="716">3.2285400000000002</cx:pt>
          <cx:pt idx="717">3.0576300000000001</cx:pt>
          <cx:pt idx="718">3.6527599999999998</cx:pt>
          <cx:pt idx="719">3.6450399999999998</cx:pt>
          <cx:pt idx="720">4.5603199999999999</cx:pt>
          <cx:pt idx="721">3.2580200000000001</cx:pt>
          <cx:pt idx="722">3.4955400000000001</cx:pt>
          <cx:pt idx="723">2.9730099999999999</cx:pt>
          <cx:pt idx="724">3.86252</cx:pt>
          <cx:pt idx="725">3.7794500000000002</cx:pt>
          <cx:pt idx="726">2.9069400000000001</cx:pt>
          <cx:pt idx="727">3.0782600000000002</cx:pt>
          <cx:pt idx="728">3.5156200000000002</cx:pt>
          <cx:pt idx="729">3.9123899999999998</cx:pt>
          <cx:pt idx="730">3.3353299999999999</cx:pt>
          <cx:pt idx="731">3.75624</cx:pt>
          <cx:pt idx="732">3.1939799999999998</cx:pt>
          <cx:pt idx="733">2.9327399999999999</cx:pt>
          <cx:pt idx="734">3.6886399999999999</cx:pt>
          <cx:pt idx="735">3.8223099999999999</cx:pt>
          <cx:pt idx="736">2.8613900000000001</cx:pt>
          <cx:pt idx="737">4.0381099999999996</cx:pt>
          <cx:pt idx="738">3.3600699999999999</cx:pt>
          <cx:pt idx="739">3.0025499999999998</cx:pt>
          <cx:pt idx="740">3.3076599999999998</cx:pt>
          <cx:pt idx="741">2.61286</cx:pt>
          <cx:pt idx="742">3.38625</cx:pt>
          <cx:pt idx="743">3.1550199999999999</cx:pt>
          <cx:pt idx="744">2.0567000000000002</cx:pt>
          <cx:pt idx="745">4.1396699999999997</cx:pt>
          <cx:pt idx="746">3.6521400000000002</cx:pt>
          <cx:pt idx="747">1.74309</cx:pt>
          <cx:pt idx="748">3.5209199999999998</cx:pt>
          <cx:pt idx="749">2.42883</cx:pt>
          <cx:pt idx="750">3.26972</cx:pt>
          <cx:pt idx="751">4.4312300000000002</cx:pt>
          <cx:pt idx="752">3.5005500000000001</cx:pt>
          <cx:pt idx="753">3.5247299999999999</cx:pt>
          <cx:pt idx="754">3.3514900000000001</cx:pt>
          <cx:pt idx="755">3.4794700000000001</cx:pt>
          <cx:pt idx="756">2.37337</cx:pt>
          <cx:pt idx="757">2.86971</cx:pt>
          <cx:pt idx="758">2.10134</cx:pt>
          <cx:pt idx="759">3.95505</cx:pt>
          <cx:pt idx="760">3.15672</cx:pt>
          <cx:pt idx="761">3.2850000000000001</cx:pt>
          <cx:pt idx="762">3.24254</cx:pt>
          <cx:pt idx="763">2.7263999999999999</cx:pt>
          <cx:pt idx="764">3.4021300000000001</cx:pt>
          <cx:pt idx="765">3.3511299999999999</cx:pt>
          <cx:pt idx="766">3.3600699999999999</cx:pt>
          <cx:pt idx="767">3.2635399999999999</cx:pt>
          <cx:pt idx="768">3.78538</cx:pt>
          <cx:pt idx="769">3.7444899999999999</cx:pt>
          <cx:pt idx="770">3.7815400000000001</cx:pt>
          <cx:pt idx="771">3.7166299999999999</cx:pt>
          <cx:pt idx="772">3.3600699999999999</cx:pt>
          <cx:pt idx="773">4.1122699999999996</cx:pt>
          <cx:pt idx="774">3.9159700000000002</cx:pt>
          <cx:pt idx="775">3.1645699999999999</cx:pt>
          <cx:pt idx="776">2.9426100000000002</cx:pt>
          <cx:pt idx="777">3.4588299999999998</cx:pt>
          <cx:pt idx="778">3.6161599999999998</cx:pt>
          <cx:pt idx="779">3.50901</cx:pt>
          <cx:pt idx="780">3.4684400000000002</cx:pt>
          <cx:pt idx="781">3.5979800000000002</cx:pt>
          <cx:pt idx="782">4.0798300000000003</cx:pt>
          <cx:pt idx="783">3.6054200000000001</cx:pt>
          <cx:pt idx="784">2.4864899999999999</cx:pt>
          <cx:pt idx="785">4.0122400000000003</cx:pt>
          <cx:pt idx="786">1.8968100000000001</cx:pt>
          <cx:pt idx="787">3.8296700000000001</cx:pt>
          <cx:pt idx="788">3.33243</cx:pt>
          <cx:pt idx="789">3.0561099999999999</cx:pt>
          <cx:pt idx="790">3.8334600000000001</cx:pt>
          <cx:pt idx="791">3.3281499999999999</cx:pt>
          <cx:pt idx="792">3.0314100000000002</cx:pt>
          <cx:pt idx="793">3.1835100000000001</cx:pt>
          <cx:pt idx="794">2.47078</cx:pt>
          <cx:pt idx="795">3.3600699999999999</cx:pt>
          <cx:pt idx="796">2.9377</cx:pt>
          <cx:pt idx="797">3.0143900000000001</cx:pt>
          <cx:pt idx="798">2.9752700000000001</cx:pt>
          <cx:pt idx="799">3.802</cx:pt>
          <cx:pt idx="800">2.9617599999999999</cx:pt>
          <cx:pt idx="801">3.0251600000000001</cx:pt>
          <cx:pt idx="802">4.0766600000000004</cx:pt>
          <cx:pt idx="803">2.9079999999999999</cx:pt>
          <cx:pt idx="804">3.1315</cx:pt>
          <cx:pt idx="805">2.5063399999999998</cx:pt>
          <cx:pt idx="806">3.1264400000000001</cx:pt>
          <cx:pt idx="807">3.0826199999999999</cx:pt>
          <cx:pt idx="808">4.4062299999999999</cx:pt>
          <cx:pt idx="809">2.83799</cx:pt>
          <cx:pt idx="810">2.4844200000000001</cx:pt>
          <cx:pt idx="811">4.3151000000000002</cx:pt>
          <cx:pt idx="812">3.8865699999999999</cx:pt>
          <cx:pt idx="813">3.7728100000000002</cx:pt>
          <cx:pt idx="814">3.46075</cx:pt>
          <cx:pt idx="815">3.6063100000000001</cx:pt>
          <cx:pt idx="816">3.3305500000000001</cx:pt>
          <cx:pt idx="817">2.4515600000000002</cx:pt>
          <cx:pt idx="818">2.2404199999999999</cx:pt>
          <cx:pt idx="819">3.0640900000000002</cx:pt>
          <cx:pt idx="820">3.4684499999999998</cx:pt>
          <cx:pt idx="821">3.4963299999999999</cx:pt>
          <cx:pt idx="822">3.0167000000000002</cx:pt>
          <cx:pt idx="823">3.5515599999999998</cx:pt>
          <cx:pt idx="824">3.4528699999999999</cx:pt>
          <cx:pt idx="825">2.8307899999999999</cx:pt>
          <cx:pt idx="826">2.4922499999999999</cx:pt>
          <cx:pt idx="827">3.29962</cx:pt>
          <cx:pt idx="828">3.83813</cx:pt>
          <cx:pt idx="829">3.3600699999999999</cx:pt>
          <cx:pt idx="830">2.7195</cx:pt>
          <cx:pt idx="831">3.4852699999999999</cx:pt>
          <cx:pt idx="832">3.8172700000000002</cx:pt>
          <cx:pt idx="833">2.9152499999999999</cx:pt>
          <cx:pt idx="834">3.36694</cx:pt>
          <cx:pt idx="835">4.8844200000000004</cx:pt>
          <cx:pt idx="836">2.4666000000000001</cx:pt>
          <cx:pt idx="837">3.8180299999999998</cx:pt>
          <cx:pt idx="838">3.6549999999999998</cx:pt>
          <cx:pt idx="839">3.6480000000000001</cx:pt>
          <cx:pt idx="840">3.4756999999999998</cx:pt>
          <cx:pt idx="841">3.3621099999999999</cx:pt>
          <cx:pt idx="842">3.3600699999999999</cx:pt>
          <cx:pt idx="843">2.7968299999999999</cx:pt>
          <cx:pt idx="844">3.5930399999999998</cx:pt>
          <cx:pt idx="845">3.2242999999999999</cx:pt>
          <cx:pt idx="846">3.78132</cx:pt>
          <cx:pt idx="847">3.1298300000000001</cx:pt>
          <cx:pt idx="848">3.347</cx:pt>
          <cx:pt idx="849">2.2335600000000002</cx:pt>
          <cx:pt idx="850">2.9981599999999999</cx:pt>
          <cx:pt idx="851">2.8477700000000001</cx:pt>
          <cx:pt idx="852">4.0403900000000004</cx:pt>
          <cx:pt idx="853">4.19346</cx:pt>
          <cx:pt idx="854">3.3732899999999999</cx:pt>
          <cx:pt idx="855">3.6051899999999999</cx:pt>
          <cx:pt idx="856">3.51823</cx:pt>
          <cx:pt idx="857">3.22458</cx:pt>
          <cx:pt idx="858">3.1561499999999998</cx:pt>
          <cx:pt idx="859">2.9652799999999999</cx:pt>
          <cx:pt idx="860">3.3600699999999999</cx:pt>
          <cx:pt idx="861">3.1831200000000002</cx:pt>
          <cx:pt idx="862">3.3233299999999999</cx:pt>
          <cx:pt idx="863">3.4404499999999998</cx:pt>
          <cx:pt idx="864">3.4145500000000002</cx:pt>
          <cx:pt idx="865">3.8582700000000001</cx:pt>
          <cx:pt idx="866">3.4820500000000001</cx:pt>
          <cx:pt idx="867">3.7260599999999999</cx:pt>
          <cx:pt idx="868">2.1847699999999999</cx:pt>
          <cx:pt idx="869">3.5759500000000002</cx:pt>
          <cx:pt idx="870">3.1899299999999999</cx:pt>
          <cx:pt idx="871">3.0650900000000001</cx:pt>
          <cx:pt idx="872">3.8741099999999999</cx:pt>
          <cx:pt idx="873">3.9487700000000001</cx:pt>
          <cx:pt idx="874">2.45248</cx:pt>
          <cx:pt idx="875">3.32639</cx:pt>
          <cx:pt idx="876">3.22871</cx:pt>
          <cx:pt idx="877">3.5911599999999999</cx:pt>
          <cx:pt idx="878">2.9171100000000001</cx:pt>
          <cx:pt idx="879">2.9603100000000002</cx:pt>
          <cx:pt idx="880">3.7947500000000001</cx:pt>
          <cx:pt idx="881">3.2515900000000002</cx:pt>
          <cx:pt idx="882">4.17448</cx:pt>
          <cx:pt idx="883">2.9530500000000002</cx:pt>
          <cx:pt idx="884">4.5035100000000003</cx:pt>
          <cx:pt idx="885">3.45784</cx:pt>
          <cx:pt idx="886">4.0357000000000003</cx:pt>
          <cx:pt idx="887">3.1701899999999998</cx:pt>
          <cx:pt idx="888">2.6947100000000002</cx:pt>
          <cx:pt idx="889">3.2214999999999998</cx:pt>
          <cx:pt idx="890">3.7567599999999999</cx:pt>
          <cx:pt idx="891">3.9121299999999999</cx:pt>
          <cx:pt idx="892">3.58954</cx:pt>
          <cx:pt idx="893">3.3600699999999999</cx:pt>
          <cx:pt idx="894">3.5081099999999998</cx:pt>
          <cx:pt idx="895">3.0004</cx:pt>
          <cx:pt idx="896">3.3600699999999999</cx:pt>
          <cx:pt idx="897">3.3016299999999998</cx:pt>
          <cx:pt idx="898">4.1370199999999997</cx:pt>
          <cx:pt idx="899">2.5471699999999999</cx:pt>
          <cx:pt idx="900">3.1732499999999999</cx:pt>
          <cx:pt idx="901">2.01553</cx:pt>
          <cx:pt idx="902">3.53613</cx:pt>
          <cx:pt idx="903">2.97906</cx:pt>
          <cx:pt idx="904">4.5782100000000003</cx:pt>
          <cx:pt idx="905">3.30924</cx:pt>
          <cx:pt idx="906">3.1427399999999999</cx:pt>
          <cx:pt idx="907">2.95438</cx:pt>
          <cx:pt idx="908">3.5072800000000002</cx:pt>
          <cx:pt idx="909">4.2139699999999998</cx:pt>
          <cx:pt idx="910">3.4798200000000001</cx:pt>
          <cx:pt idx="911">3.6429399999999998</cx:pt>
          <cx:pt idx="912">2.7869100000000002</cx:pt>
          <cx:pt idx="913">3.0926399999999998</cx:pt>
          <cx:pt idx="914">3.5629200000000001</cx:pt>
          <cx:pt idx="915">3.5719500000000002</cx:pt>
          <cx:pt idx="916">3.4459900000000001</cx:pt>
          <cx:pt idx="917">2.89418</cx:pt>
          <cx:pt idx="918">3.29779</cx:pt>
          <cx:pt idx="919">3.5913499999999998</cx:pt>
          <cx:pt idx="920">3.0556199999999998</cx:pt>
          <cx:pt idx="921">3.17882</cx:pt>
          <cx:pt idx="922">3.1232000000000002</cx:pt>
          <cx:pt idx="923">3.1249199999999999</cx:pt>
          <cx:pt idx="924">3.09693</cx:pt>
          <cx:pt idx="925">2.9051900000000002</cx:pt>
          <cx:pt idx="926">3.6312000000000002</cx:pt>
          <cx:pt idx="927">2.93737</cx:pt>
          <cx:pt idx="928">3.7468499999999998</cx:pt>
          <cx:pt idx="929">3.2350599999999998</cx:pt>
          <cx:pt idx="930">3.9902700000000002</cx:pt>
          <cx:pt idx="931">3.83134</cx:pt>
          <cx:pt idx="932">4.0114999999999998</cx:pt>
          <cx:pt idx="933">4.3553300000000004</cx:pt>
          <cx:pt idx="934">3.38388</cx:pt>
          <cx:pt idx="935">4.6087800000000003</cx:pt>
          <cx:pt idx="936">3.3385500000000001</cx:pt>
          <cx:pt idx="937">3.5806</cx:pt>
          <cx:pt idx="938">3.4926400000000002</cx:pt>
          <cx:pt idx="939">2.8666</cx:pt>
          <cx:pt idx="940">3.5239600000000002</cx:pt>
          <cx:pt idx="941">3.77149</cx:pt>
          <cx:pt idx="942">3.1573099999999998</cx:pt>
          <cx:pt idx="943">4.0636099999999997</cx:pt>
          <cx:pt idx="944">3.3894000000000002</cx:pt>
          <cx:pt idx="945">3.3265099999999999</cx:pt>
          <cx:pt idx="946">3.2986800000000001</cx:pt>
          <cx:pt idx="947">3.3566400000000001</cx:pt>
          <cx:pt idx="948">3.8909500000000001</cx:pt>
          <cx:pt idx="949">1.3807100000000001</cx:pt>
          <cx:pt idx="950">2.9921099999999998</cx:pt>
          <cx:pt idx="951">2.1321099999999999</cx:pt>
          <cx:pt idx="952">3.1222099999999999</cx:pt>
          <cx:pt idx="953">3.24004</cx:pt>
          <cx:pt idx="954">3.70356</cx:pt>
          <cx:pt idx="955">3.4965899999999999</cx:pt>
          <cx:pt idx="956">2.95553</cx:pt>
          <cx:pt idx="957">3.67571</cx:pt>
          <cx:pt idx="958">3.5499100000000001</cx:pt>
          <cx:pt idx="959">2.96225</cx:pt>
          <cx:pt idx="960">3.1038999999999999</cx:pt>
          <cx:pt idx="961">4.3722700000000003</cx:pt>
          <cx:pt idx="962">2.6709499999999999</cx:pt>
          <cx:pt idx="963">3.6802800000000002</cx:pt>
          <cx:pt idx="964">4.1768799999999997</cx:pt>
          <cx:pt idx="965">3.3600699999999999</cx:pt>
          <cx:pt idx="966">2.8487</cx:pt>
          <cx:pt idx="967">3.17672</cx:pt>
          <cx:pt idx="968">3.7322799999999998</cx:pt>
          <cx:pt idx="969">3.1769500000000002</cx:pt>
          <cx:pt idx="970">2.7798600000000002</cx:pt>
          <cx:pt idx="971">3.72797</cx:pt>
          <cx:pt idx="972">3.3382900000000002</cx:pt>
          <cx:pt idx="973">2.6813500000000001</cx:pt>
          <cx:pt idx="974">3.1997599999999999</cx:pt>
          <cx:pt idx="975">3.37113</cx:pt>
          <cx:pt idx="976">3.1739899999999999</cx:pt>
          <cx:pt idx="977">3.1570999999999998</cx:pt>
          <cx:pt idx="978">2.0867399999999998</cx:pt>
          <cx:pt idx="979">4.0664300000000004</cx:pt>
          <cx:pt idx="980">3.3600699999999999</cx:pt>
          <cx:pt idx="981">3.8724400000000001</cx:pt>
          <cx:pt idx="982">4.6232800000000003</cx:pt>
          <cx:pt idx="983">3.9155500000000001</cx:pt>
          <cx:pt idx="984">3.8157299999999998</cx:pt>
          <cx:pt idx="985">3.8877600000000001</cx:pt>
          <cx:pt idx="986">3.1066500000000001</cx:pt>
          <cx:pt idx="987">3.2348699999999999</cx:pt>
          <cx:pt idx="988">3.7444000000000002</cx:pt>
          <cx:pt idx="989">3.3322099999999999</cx:pt>
          <cx:pt idx="990">3.55898</cx:pt>
          <cx:pt idx="991">3.3980800000000002</cx:pt>
          <cx:pt idx="992">3.1086999999999998</cx:pt>
          <cx:pt idx="993">3.3600699999999999</cx:pt>
          <cx:pt idx="994">2.81697</cx:pt>
          <cx:pt idx="995">2.7815699999999999</cx:pt>
          <cx:pt idx="996">4.73468</cx:pt>
          <cx:pt idx="997">3.2071700000000001</cx:pt>
          <cx:pt idx="998">3.6544400000000001</cx:pt>
          <cx:pt idx="999">2.5911400000000002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sz="12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200" b="0" i="0" u="none" strike="noStrike" baseline="0" dirty="0" err="1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e</a:t>
            </a:r>
            <a:endParaRPr lang="ja-JP" altLang="en-US" sz="1200" b="0" i="0" u="none" strike="noStrike" baseline="0" dirty="0">
              <a:solidFill>
                <a:sysClr val="windowText" lastClr="000000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cx:rich>
      </cx:tx>
    </cx:title>
    <cx:plotArea>
      <cx:plotAreaRegion>
        <cx:series layoutId="clusteredColumn" uniqueId="{BB8B5EDD-7AAE-4A7E-96F0-C3122CE8BB89}">
          <cx:tx>
            <cx:txData>
              <cx:f>PK!$D$1</cx:f>
              <cx:v>tvKe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Count val="15"/>
            </cx:binning>
          </cx:layoutPr>
        </cx:series>
      </cx:plotAreaRegion>
      <cx:axis id="0">
        <cx:catScaling gapWidth="0"/>
        <cx:tickLabels/>
        <cx:numFmt formatCode="#,##0.0_);[赤](#,##0.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20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PD chronic'!$K$2:$K$1001</cx:f>
        <cx:lvl ptCount="1000" formatCode="G/標準">
          <cx:pt idx="0">1.3423</cx:pt>
          <cx:pt idx="1">1.3433600000000001</cx:pt>
          <cx:pt idx="2">1.3507100000000001</cx:pt>
          <cx:pt idx="3">1.24838</cx:pt>
          <cx:pt idx="4">1.3525199999999999</cx:pt>
          <cx:pt idx="5">1.1699900000000001</cx:pt>
          <cx:pt idx="6">1.1735199999999999</cx:pt>
          <cx:pt idx="7">1.3092299999999999</cx:pt>
          <cx:pt idx="8">1.3633999999999999</cx:pt>
          <cx:pt idx="9">1.13985</cx:pt>
          <cx:pt idx="10">1.13852</cx:pt>
          <cx:pt idx="11">1.1474899999999999</cx:pt>
          <cx:pt idx="12">1.2639100000000001</cx:pt>
          <cx:pt idx="13">1.32209</cx:pt>
          <cx:pt idx="14">1.3528899999999999</cx:pt>
          <cx:pt idx="15">1.3559099999999999</cx:pt>
          <cx:pt idx="16">1.2251700000000001</cx:pt>
          <cx:pt idx="17">1.23115</cx:pt>
          <cx:pt idx="18">1.16351</cx:pt>
          <cx:pt idx="19">1.36236</cx:pt>
          <cx:pt idx="20">1.2007300000000001</cx:pt>
          <cx:pt idx="21">1.1468400000000001</cx:pt>
          <cx:pt idx="22">1.1437900000000001</cx:pt>
          <cx:pt idx="23">1.3541399999999999</cx:pt>
          <cx:pt idx="24">1.37385</cx:pt>
          <cx:pt idx="25">1.3546</cx:pt>
          <cx:pt idx="26">1.32182</cx:pt>
          <cx:pt idx="27">1.3219099999999999</cx:pt>
          <cx:pt idx="28">1.34995</cx:pt>
          <cx:pt idx="29">1.1369400000000001</cx:pt>
          <cx:pt idx="30">1.1698299999999999</cx:pt>
          <cx:pt idx="31">1.3458699999999999</cx:pt>
          <cx:pt idx="32">1.21658</cx:pt>
          <cx:pt idx="33">1.3465100000000001</cx:pt>
          <cx:pt idx="34">1.3523400000000001</cx:pt>
          <cx:pt idx="35">1.3459399999999999</cx:pt>
          <cx:pt idx="36">1.1733899999999999</cx:pt>
          <cx:pt idx="37">1.2262500000000001</cx:pt>
          <cx:pt idx="38">1.3530199999999999</cx:pt>
          <cx:pt idx="39">1.32491</cx:pt>
          <cx:pt idx="40">1.10419</cx:pt>
          <cx:pt idx="41">1.1823900000000001</cx:pt>
          <cx:pt idx="42">1.0803199999999999</cx:pt>
          <cx:pt idx="43">1.2947</cx:pt>
          <cx:pt idx="44">1.3289200000000001</cx:pt>
          <cx:pt idx="45">1.21139</cx:pt>
          <cx:pt idx="46">1.24685</cx:pt>
          <cx:pt idx="47">1.3521000000000001</cx:pt>
          <cx:pt idx="48">1.3542700000000001</cx:pt>
          <cx:pt idx="49">1.3475299999999999</cx:pt>
          <cx:pt idx="50">1.3408899999999999</cx:pt>
          <cx:pt idx="51">1.27058</cx:pt>
          <cx:pt idx="52">1.1727799999999999</cx:pt>
          <cx:pt idx="53">1.34887</cx:pt>
          <cx:pt idx="54">1.32887</cx:pt>
          <cx:pt idx="55">1.18554</cx:pt>
          <cx:pt idx="56">1.35903</cx:pt>
          <cx:pt idx="57">1.3530500000000001</cx:pt>
          <cx:pt idx="58">1.1412199999999999</cx:pt>
          <cx:pt idx="59">1.34256</cx:pt>
          <cx:pt idx="60">1.35277</cx:pt>
          <cx:pt idx="61">1.31199</cx:pt>
          <cx:pt idx="62">1.3607</cx:pt>
          <cx:pt idx="63">1.1364000000000001</cx:pt>
          <cx:pt idx="64">1.35998</cx:pt>
          <cx:pt idx="65">1.31698</cx:pt>
          <cx:pt idx="66">1.3372599999999999</cx:pt>
          <cx:pt idx="67">1.13696</cx:pt>
          <cx:pt idx="68">1.1222700000000001</cx:pt>
          <cx:pt idx="69">1.35948</cx:pt>
          <cx:pt idx="70">1.3536900000000001</cx:pt>
          <cx:pt idx="71">1.1251</cx:pt>
          <cx:pt idx="72">1.16123</cx:pt>
          <cx:pt idx="73">1.15778</cx:pt>
          <cx:pt idx="74">1.16465</cx:pt>
          <cx:pt idx="75">1.3587100000000001</cx:pt>
          <cx:pt idx="76">1.1792400000000001</cx:pt>
          <cx:pt idx="77">1.14768</cx:pt>
          <cx:pt idx="78">1.36328</cx:pt>
          <cx:pt idx="79">1.3402499999999999</cx:pt>
          <cx:pt idx="80">1.2790600000000001</cx:pt>
          <cx:pt idx="81">1.2250000000000001</cx:pt>
          <cx:pt idx="82">1.0596000000000001</cx:pt>
          <cx:pt idx="83">1.35791</cx:pt>
          <cx:pt idx="84">1.14653</cx:pt>
          <cx:pt idx="85">1.33613</cx:pt>
          <cx:pt idx="86">1.3546400000000001</cx:pt>
          <cx:pt idx="87">1.2939000000000001</cx:pt>
          <cx:pt idx="88">1.35439</cx:pt>
          <cx:pt idx="89">1.1644699999999999</cx:pt>
          <cx:pt idx="90">1.3444700000000001</cx:pt>
          <cx:pt idx="91">1.2124200000000001</cx:pt>
          <cx:pt idx="92">1.31945</cx:pt>
          <cx:pt idx="93">1.1572899999999999</cx:pt>
          <cx:pt idx="94">1.3650599999999999</cx:pt>
          <cx:pt idx="95">1.3564000000000001</cx:pt>
          <cx:pt idx="96">1.34619</cx:pt>
          <cx:pt idx="97">1.3261700000000001</cx:pt>
          <cx:pt idx="98">1.3754200000000001</cx:pt>
          <cx:pt idx="99">1.3544400000000001</cx:pt>
          <cx:pt idx="100">1.3246500000000001</cx:pt>
          <cx:pt idx="101">1.3501000000000001</cx:pt>
          <cx:pt idx="102">1.3234300000000001</cx:pt>
          <cx:pt idx="103">1.33087</cx:pt>
          <cx:pt idx="104">1.34382</cx:pt>
          <cx:pt idx="105">1.3493599999999999</cx:pt>
          <cx:pt idx="106">1.3284899999999999</cx:pt>
          <cx:pt idx="107">1.1993499999999999</cx:pt>
          <cx:pt idx="108">1.14232</cx:pt>
          <cx:pt idx="109">1.1421600000000001</cx:pt>
          <cx:pt idx="110">1.3549599999999999</cx:pt>
          <cx:pt idx="111">1.33762</cx:pt>
          <cx:pt idx="112">1.0466599999999999</cx:pt>
          <cx:pt idx="113">1.34751</cx:pt>
          <cx:pt idx="114">1.1415299999999999</cx:pt>
          <cx:pt idx="115">1.33972</cx:pt>
          <cx:pt idx="116">1.1099600000000001</cx:pt>
          <cx:pt idx="117">1.0243800000000001</cx:pt>
          <cx:pt idx="118">1.3327599999999999</cx:pt>
          <cx:pt idx="119">1.3272299999999999</cx:pt>
          <cx:pt idx="120">1.3481099999999999</cx:pt>
          <cx:pt idx="121">1.35083</cx:pt>
          <cx:pt idx="122">1.2350000000000001</cx:pt>
          <cx:pt idx="123">1.34789</cx:pt>
          <cx:pt idx="124">1.1992400000000001</cx:pt>
          <cx:pt idx="125">1.3249</cx:pt>
          <cx:pt idx="126">1.26945</cx:pt>
          <cx:pt idx="127">1.3293600000000001</cx:pt>
          <cx:pt idx="128">1.3533299999999999</cx:pt>
          <cx:pt idx="129">1.33284</cx:pt>
          <cx:pt idx="130">1.2097500000000001</cx:pt>
          <cx:pt idx="131">1.31968</cx:pt>
          <cx:pt idx="132">1.15473</cx:pt>
          <cx:pt idx="133">1.3257399999999999</cx:pt>
          <cx:pt idx="134">1.10765</cx:pt>
          <cx:pt idx="135">1.34806</cx:pt>
          <cx:pt idx="136">1.2680499999999999</cx:pt>
          <cx:pt idx="137">1.3502000000000001</cx:pt>
          <cx:pt idx="138">1.32836</cx:pt>
          <cx:pt idx="139">1.3635900000000001</cx:pt>
          <cx:pt idx="140">1.1653500000000001</cx:pt>
          <cx:pt idx="141">1.21939</cx:pt>
          <cx:pt idx="142">1.35585</cx:pt>
          <cx:pt idx="143">1.35998</cx:pt>
          <cx:pt idx="144">1.3483099999999999</cx:pt>
          <cx:pt idx="145">1.3508</cx:pt>
          <cx:pt idx="146">1.3499000000000001</cx:pt>
          <cx:pt idx="147">1.3400799999999999</cx:pt>
          <cx:pt idx="148">1.1907300000000001</cx:pt>
          <cx:pt idx="149">1.3577699999999999</cx:pt>
          <cx:pt idx="150">1.1826099999999999</cx:pt>
          <cx:pt idx="151">1.34639</cx:pt>
          <cx:pt idx="152">1.3372200000000001</cx:pt>
          <cx:pt idx="153">1.1359600000000001</cx:pt>
          <cx:pt idx="154">1.0347299999999999</cx:pt>
          <cx:pt idx="155">1.2352799999999999</cx:pt>
          <cx:pt idx="156">1.3609199999999999</cx:pt>
          <cx:pt idx="157">1.34578</cx:pt>
          <cx:pt idx="158">1.17658</cx:pt>
          <cx:pt idx="159">1.3478000000000001</cx:pt>
          <cx:pt idx="160">1.06091</cx:pt>
          <cx:pt idx="161">1.3544099999999999</cx:pt>
          <cx:pt idx="162">1.3329599999999999</cx:pt>
          <cx:pt idx="163">1.35198</cx:pt>
          <cx:pt idx="164">1.1702900000000001</cx:pt>
          <cx:pt idx="165">1.17876</cx:pt>
          <cx:pt idx="166">1.3468599999999999</cx:pt>
          <cx:pt idx="167">1.0834600000000001</cx:pt>
          <cx:pt idx="168">1.34823</cx:pt>
          <cx:pt idx="169">1.25644</cx:pt>
          <cx:pt idx="170">1.0997600000000001</cx:pt>
          <cx:pt idx="171">1.1696800000000001</cx:pt>
          <cx:pt idx="172">1.1675599999999999</cx:pt>
          <cx:pt idx="173">1.3117399999999999</cx:pt>
          <cx:pt idx="174">1.2034</cx:pt>
          <cx:pt idx="175">1.3335300000000001</cx:pt>
          <cx:pt idx="176">1.3428500000000001</cx:pt>
          <cx:pt idx="177">1.07758</cx:pt>
          <cx:pt idx="178">1.33772</cx:pt>
          <cx:pt idx="179">1.3563700000000001</cx:pt>
          <cx:pt idx="180">1.1041399999999999</cx:pt>
          <cx:pt idx="181">1.1569199999999999</cx:pt>
          <cx:pt idx="182">1.20706</cx:pt>
          <cx:pt idx="183">1.1869400000000001</cx:pt>
          <cx:pt idx="184">1.3367</cx:pt>
          <cx:pt idx="185">1.3295300000000001</cx:pt>
          <cx:pt idx="186">1.2026300000000001</cx:pt>
          <cx:pt idx="187">1.0407</cx:pt>
          <cx:pt idx="188">1.25153</cx:pt>
          <cx:pt idx="189">1.2293400000000001</cx:pt>
          <cx:pt idx="190">1.34246</cx:pt>
          <cx:pt idx="191">1.3479399999999999</cx:pt>
          <cx:pt idx="192">1.17709</cx:pt>
          <cx:pt idx="193">1.1604699999999999</cx:pt>
          <cx:pt idx="194">1.25258</cx:pt>
          <cx:pt idx="195">1.14978</cx:pt>
          <cx:pt idx="196">1.1463300000000001</cx:pt>
          <cx:pt idx="197">1.32941</cx:pt>
          <cx:pt idx="198">1.1414200000000001</cx:pt>
          <cx:pt idx="199">1.3411299999999999</cx:pt>
          <cx:pt idx="200">1.3419700000000001</cx:pt>
          <cx:pt idx="201">1.33535</cx:pt>
          <cx:pt idx="202">1.3489100000000001</cx:pt>
          <cx:pt idx="203">1.3374200000000001</cx:pt>
          <cx:pt idx="204">1.3950199999999999</cx:pt>
          <cx:pt idx="205">1.1538600000000001</cx:pt>
          <cx:pt idx="206">1.1199300000000001</cx:pt>
          <cx:pt idx="207">1.36477</cx:pt>
          <cx:pt idx="208">1.34796</cx:pt>
          <cx:pt idx="209">1.32308</cx:pt>
          <cx:pt idx="210">1.3514900000000001</cx:pt>
          <cx:pt idx="211">1.3494900000000001</cx:pt>
          <cx:pt idx="212">1.23807</cx:pt>
          <cx:pt idx="213">1.3553299999999999</cx:pt>
          <cx:pt idx="214">1.33755</cx:pt>
          <cx:pt idx="215">1.0432399999999999</cx:pt>
          <cx:pt idx="216">0.99677400000000005</cx:pt>
          <cx:pt idx="217">1.3432999999999999</cx:pt>
          <cx:pt idx="218">1.32941</cx:pt>
          <cx:pt idx="219">1.3604499999999999</cx:pt>
          <cx:pt idx="220">1.19902</cx:pt>
          <cx:pt idx="221">1.32829</cx:pt>
          <cx:pt idx="222">1.1511400000000001</cx:pt>
          <cx:pt idx="223">1.3264400000000001</cx:pt>
          <cx:pt idx="224">1.2406299999999999</cx:pt>
          <cx:pt idx="225">1.3459300000000001</cx:pt>
          <cx:pt idx="226">1.1325000000000001</cx:pt>
          <cx:pt idx="227">1.14367</cx:pt>
          <cx:pt idx="228">1.16767</cx:pt>
          <cx:pt idx="229">1.36497</cx:pt>
          <cx:pt idx="230">1.3425</cx:pt>
          <cx:pt idx="231">1.34121</cx:pt>
          <cx:pt idx="232">1.1932100000000001</cx:pt>
          <cx:pt idx="233">1.35094</cx:pt>
          <cx:pt idx="234">1.2320599999999999</cx:pt>
          <cx:pt idx="235">1.3288599999999999</cx:pt>
          <cx:pt idx="236">1.07941</cx:pt>
          <cx:pt idx="237">1.2014400000000001</cx:pt>
          <cx:pt idx="238">1.3495299999999999</cx:pt>
          <cx:pt idx="239">1.32169</cx:pt>
          <cx:pt idx="240">1.15143</cx:pt>
          <cx:pt idx="241">1.3547100000000001</cx:pt>
          <cx:pt idx="242">1.3585799999999999</cx:pt>
          <cx:pt idx="243">1.2210399999999999</cx:pt>
          <cx:pt idx="244">1.2513799999999999</cx:pt>
          <cx:pt idx="245">1.35063</cx:pt>
          <cx:pt idx="246">1.34592</cx:pt>
          <cx:pt idx="247">1.0657000000000001</cx:pt>
          <cx:pt idx="248">1.15849</cx:pt>
          <cx:pt idx="249">1.1460399999999999</cx:pt>
          <cx:pt idx="250">1.3593599999999999</cx:pt>
          <cx:pt idx="251">1.3232999999999999</cx:pt>
          <cx:pt idx="252">1.2880199999999999</cx:pt>
          <cx:pt idx="253">1.14821</cx:pt>
          <cx:pt idx="254">1.3456999999999999</cx:pt>
          <cx:pt idx="255">1.33362</cx:pt>
          <cx:pt idx="256">1.1454599999999999</cx:pt>
          <cx:pt idx="257">1.1148100000000001</cx:pt>
          <cx:pt idx="258">1.1852100000000001</cx:pt>
          <cx:pt idx="259">1.1861600000000001</cx:pt>
          <cx:pt idx="260">1.3469599999999999</cx:pt>
          <cx:pt idx="261">1.2458800000000001</cx:pt>
          <cx:pt idx="262">1.1770400000000001</cx:pt>
          <cx:pt idx="263">1.34694</cx:pt>
          <cx:pt idx="264">1.37296</cx:pt>
          <cx:pt idx="265">1.3424499999999999</cx:pt>
          <cx:pt idx="266">1.33477</cx:pt>
          <cx:pt idx="267">1.36215</cx:pt>
          <cx:pt idx="268">1.3480300000000001</cx:pt>
          <cx:pt idx="269">1.1201099999999999</cx:pt>
          <cx:pt idx="270">1.11561</cx:pt>
          <cx:pt idx="271">1.34859</cx:pt>
          <cx:pt idx="272">1.14331</cx:pt>
          <cx:pt idx="273">1.3539699999999999</cx:pt>
          <cx:pt idx="274">1.1907099999999999</cx:pt>
          <cx:pt idx="275">1.34433</cx:pt>
          <cx:pt idx="276">1.3511</cx:pt>
          <cx:pt idx="277">1.1533800000000001</cx:pt>
          <cx:pt idx="278">1.35246</cx:pt>
          <cx:pt idx="279">1.34433</cx:pt>
          <cx:pt idx="280">1.0984100000000001</cx:pt>
          <cx:pt idx="281">1.3395300000000001</cx:pt>
          <cx:pt idx="282">1.1118399999999999</cx:pt>
          <cx:pt idx="283">1.2362500000000001</cx:pt>
          <cx:pt idx="284">1.0801799999999999</cx:pt>
          <cx:pt idx="285">1.1412500000000001</cx:pt>
          <cx:pt idx="286">1.12486</cx:pt>
          <cx:pt idx="287">1.3633200000000001</cx:pt>
          <cx:pt idx="288">1.13809</cx:pt>
          <cx:pt idx="289">1.3394900000000001</cx:pt>
          <cx:pt idx="290">1.21926</cx:pt>
          <cx:pt idx="291">1.3571200000000001</cx:pt>
          <cx:pt idx="292">1.32376</cx:pt>
          <cx:pt idx="293">1.1784399999999999</cx:pt>
          <cx:pt idx="294">1.3344199999999999</cx:pt>
          <cx:pt idx="295">1.35785</cx:pt>
          <cx:pt idx="296">1.1670199999999999</cx:pt>
          <cx:pt idx="297">1.14194</cx:pt>
          <cx:pt idx="298">1.1937500000000001</cx:pt>
          <cx:pt idx="299">1.0697300000000001</cx:pt>
          <cx:pt idx="300">1.36311</cx:pt>
          <cx:pt idx="301">1.3452200000000001</cx:pt>
          <cx:pt idx="302">1.3441799999999999</cx:pt>
          <cx:pt idx="303">1.3371900000000001</cx:pt>
          <cx:pt idx="304">1.25658</cx:pt>
          <cx:pt idx="305">1.35605</cx:pt>
          <cx:pt idx="306">1.1339999999999999</cx:pt>
          <cx:pt idx="307">1.3419399999999999</cx:pt>
          <cx:pt idx="308">1.34409</cx:pt>
          <cx:pt idx="309">1.34867</cx:pt>
          <cx:pt idx="310">1.3236300000000001</cx:pt>
          <cx:pt idx="311">1.3325899999999999</cx:pt>
          <cx:pt idx="312">1.0396799999999999</cx:pt>
          <cx:pt idx="313">1.3587800000000001</cx:pt>
          <cx:pt idx="314">1.1637999999999999</cx:pt>
          <cx:pt idx="315">1.1558999999999999</cx:pt>
          <cx:pt idx="316">1.34382</cx:pt>
          <cx:pt idx="317">1.3293200000000001</cx:pt>
          <cx:pt idx="318">1.1334</cx:pt>
          <cx:pt idx="319">1.22096</cx:pt>
          <cx:pt idx="320">1.26376</cx:pt>
          <cx:pt idx="321">1.3519399999999999</cx:pt>
          <cx:pt idx="322">1.05752</cx:pt>
          <cx:pt idx="323">1.1443399999999999</cx:pt>
          <cx:pt idx="324">1.3407500000000001</cx:pt>
          <cx:pt idx="325">1.34755</cx:pt>
          <cx:pt idx="326">1.35287</cx:pt>
          <cx:pt idx="327">1.3520300000000001</cx:pt>
          <cx:pt idx="328">1.1638900000000001</cx:pt>
          <cx:pt idx="329">1.21549</cx:pt>
          <cx:pt idx="330">1.3509100000000001</cx:pt>
          <cx:pt idx="331">1.3659699999999999</cx:pt>
          <cx:pt idx="332">1.2072000000000001</cx:pt>
          <cx:pt idx="333">1.12761</cx:pt>
          <cx:pt idx="334">1.2072099999999999</cx:pt>
          <cx:pt idx="335">1.3536999999999999</cx:pt>
          <cx:pt idx="336">1.1428199999999999</cx:pt>
          <cx:pt idx="337">1.19204</cx:pt>
          <cx:pt idx="338">1.1287</cx:pt>
          <cx:pt idx="339">1.34921</cx:pt>
          <cx:pt idx="340">1.3475699999999999</cx:pt>
          <cx:pt idx="341">1.353</cx:pt>
          <cx:pt idx="342">1.2378199999999999</cx:pt>
          <cx:pt idx="343">1.31036</cx:pt>
          <cx:pt idx="344">1.18068</cx:pt>
          <cx:pt idx="345">1.3248899999999999</cx:pt>
          <cx:pt idx="346">1.3548500000000001</cx:pt>
          <cx:pt idx="347">1.2665900000000001</cx:pt>
          <cx:pt idx="348">1.3107899999999999</cx:pt>
          <cx:pt idx="349">1.0817600000000001</cx:pt>
          <cx:pt idx="350">1.14202</cx:pt>
          <cx:pt idx="351">1.22525</cx:pt>
          <cx:pt idx="352">1.2091700000000001</cx:pt>
          <cx:pt idx="353">1.3490899999999999</cx:pt>
          <cx:pt idx="354">1.3705400000000001</cx:pt>
          <cx:pt idx="355">1.11483</cx:pt>
          <cx:pt idx="356">1.2251799999999999</cx:pt>
          <cx:pt idx="357">1.1477900000000001</cx:pt>
          <cx:pt idx="358">1.3627499999999999</cx:pt>
          <cx:pt idx="359">1.2463599999999999</cx:pt>
          <cx:pt idx="360">1.1360699999999999</cx:pt>
          <cx:pt idx="361">1.3490500000000001</cx:pt>
          <cx:pt idx="362">1.34596</cx:pt>
          <cx:pt idx="363">1.3493599999999999</cx:pt>
          <cx:pt idx="364">1.1061000000000001</cx:pt>
          <cx:pt idx="365">1.1688700000000001</cx:pt>
          <cx:pt idx="366">1.08752</cx:pt>
          <cx:pt idx="367">1.2161200000000001</cx:pt>
          <cx:pt idx="368">1.17771</cx:pt>
          <cx:pt idx="369">1.3353600000000001</cx:pt>
          <cx:pt idx="370">1.3455900000000001</cx:pt>
          <cx:pt idx="371">1.05657</cx:pt>
          <cx:pt idx="372">1.0619700000000001</cx:pt>
          <cx:pt idx="373">1.3449899999999999</cx:pt>
          <cx:pt idx="374">1.3340700000000001</cx:pt>
          <cx:pt idx="375">1.34182</cx:pt>
          <cx:pt idx="376">1.0978600000000001</cx:pt>
          <cx:pt idx="377">1.18008</cx:pt>
          <cx:pt idx="378">1.18113</cx:pt>
          <cx:pt idx="379">1.0979699999999999</cx:pt>
          <cx:pt idx="380">1.3521399999999999</cx:pt>
          <cx:pt idx="381">1.3480799999999999</cx:pt>
          <cx:pt idx="382">1.2081</cx:pt>
          <cx:pt idx="383">1.15832</cx:pt>
          <cx:pt idx="384">1.30999</cx:pt>
          <cx:pt idx="385">1.3457300000000001</cx:pt>
          <cx:pt idx="386">1.3556999999999999</cx:pt>
          <cx:pt idx="387">1.31203</cx:pt>
          <cx:pt idx="388">1.1399600000000001</cx:pt>
          <cx:pt idx="389">1.3460300000000001</cx:pt>
          <cx:pt idx="390">1.1696</cx:pt>
          <cx:pt idx="391">1.36677</cx:pt>
          <cx:pt idx="392">1.35554</cx:pt>
          <cx:pt idx="393">1.3416999999999999</cx:pt>
          <cx:pt idx="394">1.34328</cx:pt>
          <cx:pt idx="395">1.32877</cx:pt>
          <cx:pt idx="396">1.34354</cx:pt>
          <cx:pt idx="397">1.1557599999999999</cx:pt>
          <cx:pt idx="398">1.3022899999999999</cx:pt>
          <cx:pt idx="399">1.06901</cx:pt>
          <cx:pt idx="400">1.3609100000000001</cx:pt>
          <cx:pt idx="401">1.3547400000000001</cx:pt>
          <cx:pt idx="402">1.3367899999999999</cx:pt>
          <cx:pt idx="403">1.35412</cx:pt>
          <cx:pt idx="404">1.0924400000000001</cx:pt>
          <cx:pt idx="405">1.1037999999999999</cx:pt>
          <cx:pt idx="406">1.3569800000000001</cx:pt>
          <cx:pt idx="407">1.05735</cx:pt>
          <cx:pt idx="408">1.34077</cx:pt>
          <cx:pt idx="409">1.3501000000000001</cx:pt>
          <cx:pt idx="410">1.3536699999999999</cx:pt>
          <cx:pt idx="411">1.1490100000000001</cx:pt>
          <cx:pt idx="412">1.22793</cx:pt>
          <cx:pt idx="413">1.3454200000000001</cx:pt>
          <cx:pt idx="414">1.1811499999999999</cx:pt>
          <cx:pt idx="415">1.0880799999999999</cx:pt>
          <cx:pt idx="416">1.3678699999999999</cx:pt>
          <cx:pt idx="417">1.3526899999999999</cx:pt>
          <cx:pt idx="418">1.12557</cx:pt>
          <cx:pt idx="419">1.34738</cx:pt>
          <cx:pt idx="420">1.23566</cx:pt>
          <cx:pt idx="421">1.1203399999999999</cx:pt>
          <cx:pt idx="422">1.3470599999999999</cx:pt>
          <cx:pt idx="423">1.3615299999999999</cx:pt>
          <cx:pt idx="424">1.18943</cx:pt>
          <cx:pt idx="425">1.3544</cx:pt>
          <cx:pt idx="426">1.16432</cx:pt>
          <cx:pt idx="427">1.36324</cx:pt>
          <cx:pt idx="428">1.34609</cx:pt>
          <cx:pt idx="429">1.12887</cx:pt>
          <cx:pt idx="430">1.28685</cx:pt>
          <cx:pt idx="431">1.3475600000000001</cx:pt>
          <cx:pt idx="432">1.14455</cx:pt>
          <cx:pt idx="433">1.1698</cx:pt>
          <cx:pt idx="434">1.1385000000000001</cx:pt>
          <cx:pt idx="435">1.3278099999999999</cx:pt>
          <cx:pt idx="436">1.19099</cx:pt>
          <cx:pt idx="437">1.30036</cx:pt>
          <cx:pt idx="438">1.3403799999999999</cx:pt>
          <cx:pt idx="439">1.15008</cx:pt>
          <cx:pt idx="440">1.3611500000000001</cx:pt>
          <cx:pt idx="441">1.3515900000000001</cx:pt>
          <cx:pt idx="442">1.1322300000000001</cx:pt>
          <cx:pt idx="443">1.3390299999999999</cx:pt>
          <cx:pt idx="444">1.3571899999999999</cx:pt>
          <cx:pt idx="445">1.16296</cx:pt>
          <cx:pt idx="446">1.33992</cx:pt>
          <cx:pt idx="447">1.35633</cx:pt>
          <cx:pt idx="448">1.35117</cx:pt>
          <cx:pt idx="449">1.1639200000000001</cx:pt>
          <cx:pt idx="450">1.24491</cx:pt>
          <cx:pt idx="451">1.3076000000000001</cx:pt>
          <cx:pt idx="452">1.23258</cx:pt>
          <cx:pt idx="453">1.3389</cx:pt>
          <cx:pt idx="454">1.2390300000000001</cx:pt>
          <cx:pt idx="455">1.3167500000000001</cx:pt>
          <cx:pt idx="456">1.03949</cx:pt>
          <cx:pt idx="457">1.0467599999999999</cx:pt>
          <cx:pt idx="458">1.33602</cx:pt>
          <cx:pt idx="459">1.3347899999999999</cx:pt>
          <cx:pt idx="460">1.2608299999999999</cx:pt>
          <cx:pt idx="461">1.3448800000000001</cx:pt>
          <cx:pt idx="462">1.16845</cx:pt>
          <cx:pt idx="463">1.2103999999999999</cx:pt>
          <cx:pt idx="464">1.3565100000000001</cx:pt>
          <cx:pt idx="465">1.1391100000000001</cx:pt>
          <cx:pt idx="466">1.3574299999999999</cx:pt>
          <cx:pt idx="467">1.34588</cx:pt>
          <cx:pt idx="468">1.3375600000000001</cx:pt>
          <cx:pt idx="469">1.32907</cx:pt>
          <cx:pt idx="470">1.3551299999999999</cx:pt>
          <cx:pt idx="471">1.3212699999999999</cx:pt>
          <cx:pt idx="472">1.18893</cx:pt>
          <cx:pt idx="473">1.3534200000000001</cx:pt>
          <cx:pt idx="474">1.10551</cx:pt>
          <cx:pt idx="475">1.0866499999999999</cx:pt>
          <cx:pt idx="476">1.3628199999999999</cx:pt>
          <cx:pt idx="477">1.3583499999999999</cx:pt>
          <cx:pt idx="478">1.06047</cx:pt>
          <cx:pt idx="479">1.2077899999999999</cx:pt>
          <cx:pt idx="480">1.21722</cx:pt>
          <cx:pt idx="481">1.36056</cx:pt>
          <cx:pt idx="482">1.2203200000000001</cx:pt>
          <cx:pt idx="483">1.3521099999999999</cx:pt>
          <cx:pt idx="484">1.2817799999999999</cx:pt>
          <cx:pt idx="485">1.3331200000000001</cx:pt>
          <cx:pt idx="486">1.2097199999999999</cx:pt>
          <cx:pt idx="487">1.15463</cx:pt>
          <cx:pt idx="488">1.0352699999999999</cx:pt>
          <cx:pt idx="489">1.23898</cx:pt>
          <cx:pt idx="490">1.3310999999999999</cx:pt>
          <cx:pt idx="491">1.1166400000000001</cx:pt>
          <cx:pt idx="492">1.1217200000000001</cx:pt>
          <cx:pt idx="493">1.2004999999999999</cx:pt>
          <cx:pt idx="494">1.1874400000000001</cx:pt>
          <cx:pt idx="495">1.2468699999999999</cx:pt>
          <cx:pt idx="496">1.34436</cx:pt>
          <cx:pt idx="497">1.34029</cx:pt>
          <cx:pt idx="498">1.3651899999999999</cx:pt>
          <cx:pt idx="499">1.3475200000000001</cx:pt>
          <cx:pt idx="500">1.35286</cx:pt>
          <cx:pt idx="501">1.35324</cx:pt>
          <cx:pt idx="502">1.1847300000000001</cx:pt>
          <cx:pt idx="503">1.33439</cx:pt>
          <cx:pt idx="504">1.3375699999999999</cx:pt>
          <cx:pt idx="505">1.1619900000000001</cx:pt>
          <cx:pt idx="506">1.3478300000000001</cx:pt>
          <cx:pt idx="507">1.1158600000000001</cx:pt>
          <cx:pt idx="508">1.3442499999999999</cx:pt>
          <cx:pt idx="509">1.34666</cx:pt>
          <cx:pt idx="510">1.1100000000000001</cx:pt>
          <cx:pt idx="511">1.3573</cx:pt>
          <cx:pt idx="512">1.23245</cx:pt>
          <cx:pt idx="513">1.1858299999999999</cx:pt>
          <cx:pt idx="514">1.18615</cx:pt>
          <cx:pt idx="515">1.1792400000000001</cx:pt>
          <cx:pt idx="516">1.3625799999999999</cx:pt>
          <cx:pt idx="517">1.2161500000000001</cx:pt>
          <cx:pt idx="518">1.2385299999999999</cx:pt>
          <cx:pt idx="519">1.3226800000000001</cx:pt>
          <cx:pt idx="520">1.34453</cx:pt>
          <cx:pt idx="521">1.3383499999999999</cx:pt>
          <cx:pt idx="522">1.22566</cx:pt>
          <cx:pt idx="523">1.28505</cx:pt>
          <cx:pt idx="524">1.10978</cx:pt>
          <cx:pt idx="525">1.35216</cx:pt>
          <cx:pt idx="526">1.3585100000000001</cx:pt>
          <cx:pt idx="527">1.36819</cx:pt>
          <cx:pt idx="528">1.35795</cx:pt>
          <cx:pt idx="529">1.36269</cx:pt>
          <cx:pt idx="530">1.16835</cx:pt>
          <cx:pt idx="531">1.35039</cx:pt>
          <cx:pt idx="532">1.34565</cx:pt>
          <cx:pt idx="533">1.33728</cx:pt>
          <cx:pt idx="534">1.3541300000000001</cx:pt>
          <cx:pt idx="535">1.35571</cx:pt>
          <cx:pt idx="536">1.1326700000000001</cx:pt>
          <cx:pt idx="537">1.20208</cx:pt>
          <cx:pt idx="538">1.32619</cx:pt>
          <cx:pt idx="539">1.1864300000000001</cx:pt>
          <cx:pt idx="540">1.0338400000000001</cx:pt>
          <cx:pt idx="541">1.2411700000000001</cx:pt>
          <cx:pt idx="542">1.2040200000000001</cx:pt>
          <cx:pt idx="543">1.36233</cx:pt>
          <cx:pt idx="544">1.22879</cx:pt>
          <cx:pt idx="545">1.32328</cx:pt>
          <cx:pt idx="546">1.33846</cx:pt>
          <cx:pt idx="547">1.3471599999999999</cx:pt>
          <cx:pt idx="548">1.2036100000000001</cx:pt>
          <cx:pt idx="549">1.3392999999999999</cx:pt>
          <cx:pt idx="550">1.31999</cx:pt>
          <cx:pt idx="551">1.1261399999999999</cx:pt>
          <cx:pt idx="552">1.3368599999999999</cx:pt>
          <cx:pt idx="553">1.1339600000000001</cx:pt>
          <cx:pt idx="554">1.08124</cx:pt>
          <cx:pt idx="555">1.35605</cx:pt>
          <cx:pt idx="556">1.2113799999999999</cx:pt>
          <cx:pt idx="557">1.2917799999999999</cx:pt>
          <cx:pt idx="558">1.3429500000000001</cx:pt>
          <cx:pt idx="559">1.3191299999999999</cx:pt>
          <cx:pt idx="560">1.3274300000000001</cx:pt>
          <cx:pt idx="561">1.29026</cx:pt>
          <cx:pt idx="562">1.0857699999999999</cx:pt>
          <cx:pt idx="563">1.34751</cx:pt>
          <cx:pt idx="564">1.25312</cx:pt>
          <cx:pt idx="565">1.3517999999999999</cx:pt>
          <cx:pt idx="566">1.2430000000000001</cx:pt>
          <cx:pt idx="567">1.34789</cx:pt>
          <cx:pt idx="568">1.3506800000000001</cx:pt>
          <cx:pt idx="569">1.16933</cx:pt>
          <cx:pt idx="570">1.3555600000000001</cx:pt>
          <cx:pt idx="571">1.3484499999999999</cx:pt>
          <cx:pt idx="572">1.3423400000000001</cx:pt>
          <cx:pt idx="573">1.1596900000000001</cx:pt>
          <cx:pt idx="574">1.35907</cx:pt>
          <cx:pt idx="575">1.1868799999999999</cx:pt>
          <cx:pt idx="576">1.0717699999999999</cx:pt>
          <cx:pt idx="577">1.3265199999999999</cx:pt>
          <cx:pt idx="578">1.33754</cx:pt>
          <cx:pt idx="579">1.34222</cx:pt>
          <cx:pt idx="580">1.17964</cx:pt>
          <cx:pt idx="581">1.1801999999999999</cx:pt>
          <cx:pt idx="582">1.3241000000000001</cx:pt>
          <cx:pt idx="583">1.2291399999999999</cx:pt>
          <cx:pt idx="584">1.3445100000000001</cx:pt>
          <cx:pt idx="585">1.3371200000000001</cx:pt>
          <cx:pt idx="586">1.3359300000000001</cx:pt>
          <cx:pt idx="587">1.3492999999999999</cx:pt>
          <cx:pt idx="588">1.15245</cx:pt>
          <cx:pt idx="589">1.14005</cx:pt>
          <cx:pt idx="590">1.35758</cx:pt>
          <cx:pt idx="591">1.3653500000000001</cx:pt>
          <cx:pt idx="592">1.3556299999999999</cx:pt>
          <cx:pt idx="593">1.1557999999999999</cx:pt>
          <cx:pt idx="594">1.23664</cx:pt>
          <cx:pt idx="595">1.36555</cx:pt>
          <cx:pt idx="596">1.16198</cx:pt>
          <cx:pt idx="597">1.04044</cx:pt>
          <cx:pt idx="598">1.3391299999999999</cx:pt>
          <cx:pt idx="599">1.34968</cx:pt>
          <cx:pt idx="600">1.17608</cx:pt>
          <cx:pt idx="601">1.29769</cx:pt>
          <cx:pt idx="602">1.34975</cx:pt>
          <cx:pt idx="603">1.08714</cx:pt>
          <cx:pt idx="604">1.2011700000000001</cx:pt>
          <cx:pt idx="605">1.34524</cx:pt>
          <cx:pt idx="606">1.3605400000000001</cx:pt>
          <cx:pt idx="607">1.3494699999999999</cx:pt>
          <cx:pt idx="608">1.1014900000000001</cx:pt>
          <cx:pt idx="609">1.1769499999999999</cx:pt>
          <cx:pt idx="610">1.3461099999999999</cx:pt>
          <cx:pt idx="611">1.3681700000000001</cx:pt>
          <cx:pt idx="612">1.2252400000000001</cx:pt>
          <cx:pt idx="613">1.3540099999999999</cx:pt>
          <cx:pt idx="614">1.2118899999999999</cx:pt>
          <cx:pt idx="615">1.1797599999999999</cx:pt>
          <cx:pt idx="616">1.3330200000000001</cx:pt>
          <cx:pt idx="617">1.33751</cx:pt>
          <cx:pt idx="618">1.3551</cx:pt>
          <cx:pt idx="619">1.27372</cx:pt>
          <cx:pt idx="620">1.1867099999999999</cx:pt>
          <cx:pt idx="621">1.34097</cx:pt>
          <cx:pt idx="622">1.3070600000000001</cx:pt>
          <cx:pt idx="623">1.3507899999999999</cx:pt>
          <cx:pt idx="624">1.3584499999999999</cx:pt>
          <cx:pt idx="625">1.21943</cx:pt>
          <cx:pt idx="626">1.34751</cx:pt>
          <cx:pt idx="627">1.2523599999999999</cx:pt>
          <cx:pt idx="628">1.21817</cx:pt>
          <cx:pt idx="629">1.1983699999999999</cx:pt>
          <cx:pt idx="630">1.35703</cx:pt>
          <cx:pt idx="631">1.2882199999999999</cx:pt>
          <cx:pt idx="632">1.2344599999999999</cx:pt>
          <cx:pt idx="633">1.34317</cx:pt>
          <cx:pt idx="634">1.35141</cx:pt>
          <cx:pt idx="635">1.3277000000000001</cx:pt>
          <cx:pt idx="636">1.03694</cx:pt>
          <cx:pt idx="637">1.3463099999999999</cx:pt>
          <cx:pt idx="638">1.2434099999999999</cx:pt>
          <cx:pt idx="639">1.1587499999999999</cx:pt>
          <cx:pt idx="640">1.3507899999999999</cx:pt>
          <cx:pt idx="641">1.1123499999999999</cx:pt>
          <cx:pt idx="642">1.35057</cx:pt>
          <cx:pt idx="643">1.03267</cx:pt>
          <cx:pt idx="644">1.34049</cx:pt>
          <cx:pt idx="645">1.1435999999999999</cx:pt>
          <cx:pt idx="646">1.3251900000000001</cx:pt>
          <cx:pt idx="647">1.34267</cx:pt>
          <cx:pt idx="648">1.0981399999999999</cx:pt>
          <cx:pt idx="649">1.1925600000000001</cx:pt>
          <cx:pt idx="650">1.1050199999999999</cx:pt>
          <cx:pt idx="651">1.1140699999999999</cx:pt>
          <cx:pt idx="652">1.36408</cx:pt>
          <cx:pt idx="653">1.1530400000000001</cx:pt>
          <cx:pt idx="654">1.3312299999999999</cx:pt>
          <cx:pt idx="655">1.3311200000000001</cx:pt>
          <cx:pt idx="656">1.1497999999999999</cx:pt>
          <cx:pt idx="657">1.17702</cx:pt>
          <cx:pt idx="658">1.349</cx:pt>
          <cx:pt idx="659">1.12039</cx:pt>
          <cx:pt idx="660">1.3372200000000001</cx:pt>
          <cx:pt idx="661">1.35107</cx:pt>
          <cx:pt idx="662">1.1945300000000001</cx:pt>
          <cx:pt idx="663">1.0161500000000001</cx:pt>
          <cx:pt idx="664">1.32341</cx:pt>
          <cx:pt idx="665">1.35809</cx:pt>
          <cx:pt idx="666">1.35128</cx:pt>
          <cx:pt idx="667">1.3431500000000001</cx:pt>
          <cx:pt idx="668">1.2214100000000001</cx:pt>
          <cx:pt idx="669">1.33971</cx:pt>
          <cx:pt idx="670">1.33344</cx:pt>
          <cx:pt idx="671">1.3567899999999999</cx:pt>
          <cx:pt idx="672">1.1682999999999999</cx:pt>
          <cx:pt idx="673">1.1597900000000001</cx:pt>
          <cx:pt idx="674">1.1354900000000001</cx:pt>
          <cx:pt idx="675">1.34124</cx:pt>
          <cx:pt idx="676">1.1793100000000001</cx:pt>
          <cx:pt idx="677">1.2771699999999999</cx:pt>
          <cx:pt idx="678">1.2335400000000001</cx:pt>
          <cx:pt idx="679">1.33612</cx:pt>
          <cx:pt idx="680">1.341</cx:pt>
          <cx:pt idx="681">1.3324499999999999</cx:pt>
          <cx:pt idx="682">1.35849</cx:pt>
          <cx:pt idx="683">1.3323499999999999</cx:pt>
          <cx:pt idx="684">1.1378600000000001</cx:pt>
          <cx:pt idx="685">1.35981</cx:pt>
          <cx:pt idx="686">1.1950099999999999</cx:pt>
          <cx:pt idx="687">1.3557600000000001</cx:pt>
          <cx:pt idx="688">1.3498399999999999</cx:pt>
          <cx:pt idx="689">1.3548899999999999</cx:pt>
          <cx:pt idx="690">1.34907</cx:pt>
          <cx:pt idx="691">1.1750799999999999</cx:pt>
          <cx:pt idx="692">1.3545199999999999</cx:pt>
          <cx:pt idx="693">1.3432599999999999</cx:pt>
          <cx:pt idx="694">1.3428800000000001</cx:pt>
          <cx:pt idx="695">1.3426800000000001</cx:pt>
          <cx:pt idx="696">1.23227</cx:pt>
          <cx:pt idx="697">1.175</cx:pt>
          <cx:pt idx="698">1.3645499999999999</cx:pt>
          <cx:pt idx="699">1.3482400000000001</cx:pt>
          <cx:pt idx="700">1.08962</cx:pt>
          <cx:pt idx="701">1.33701</cx:pt>
          <cx:pt idx="702">1.35103</cx:pt>
          <cx:pt idx="703">1.3389200000000001</cx:pt>
          <cx:pt idx="704">1.0980300000000001</cx:pt>
          <cx:pt idx="705">1.1008199999999999</cx:pt>
          <cx:pt idx="706">1.1425399999999999</cx:pt>
          <cx:pt idx="707">1.0636399999999999</cx:pt>
          <cx:pt idx="708">1.1715500000000001</cx:pt>
          <cx:pt idx="709">1.34466</cx:pt>
          <cx:pt idx="710">1.2490000000000001</cx:pt>
          <cx:pt idx="711">1.1126100000000001</cx:pt>
          <cx:pt idx="712">1.2616099999999999</cx:pt>
          <cx:pt idx="713">1.1113599999999999</cx:pt>
          <cx:pt idx="714">1.1875100000000001</cx:pt>
          <cx:pt idx="715">1.13409</cx:pt>
          <cx:pt idx="716">1.0228200000000001</cx:pt>
          <cx:pt idx="717">1.23203</cx:pt>
          <cx:pt idx="718">1.3592299999999999</cx:pt>
          <cx:pt idx="719">1.2749999999999999</cx:pt>
          <cx:pt idx="720">1.36459</cx:pt>
          <cx:pt idx="721">1.3380700000000001</cx:pt>
          <cx:pt idx="722">1.23129</cx:pt>
          <cx:pt idx="723">1.06003</cx:pt>
          <cx:pt idx="724">1.3362499999999999</cx:pt>
          <cx:pt idx="725">1.2837799999999999</cx:pt>
          <cx:pt idx="726">1.1766799999999999</cx:pt>
          <cx:pt idx="727">1.2028099999999999</cx:pt>
          <cx:pt idx="728">1.14828</cx:pt>
          <cx:pt idx="729">1.31873</cx:pt>
          <cx:pt idx="730">1.36052</cx:pt>
          <cx:pt idx="731">1.3400399999999999</cx:pt>
          <cx:pt idx="732">1.3529599999999999</cx:pt>
          <cx:pt idx="733">1.20231</cx:pt>
          <cx:pt idx="734">1.13947</cx:pt>
          <cx:pt idx="735">1.3491899999999999</cx:pt>
          <cx:pt idx="736">1.3551800000000001</cx:pt>
          <cx:pt idx="737">1.3552599999999999</cx:pt>
          <cx:pt idx="738">1.35415</cx:pt>
          <cx:pt idx="739">1.1146499999999999</cx:pt>
          <cx:pt idx="740">1.3584000000000001</cx:pt>
          <cx:pt idx="741">1.1674800000000001</cx:pt>
          <cx:pt idx="742">1.3480099999999999</cx:pt>
          <cx:pt idx="743">1.3506800000000001</cx:pt>
          <cx:pt idx="744">1.2989599999999999</cx:pt>
          <cx:pt idx="745">1.36633</cx:pt>
          <cx:pt idx="746">1.10076</cx:pt>
          <cx:pt idx="747">1.3175399999999999</cx:pt>
          <cx:pt idx="748">1.21767</cx:pt>
          <cx:pt idx="749">1.2570300000000001</cx:pt>
          <cx:pt idx="750">1.34592</cx:pt>
          <cx:pt idx="751">1.1311500000000001</cx:pt>
          <cx:pt idx="752">1.07474</cx:pt>
          <cx:pt idx="753">1.3491200000000001</cx:pt>
          <cx:pt idx="754">1.3592599999999999</cx:pt>
          <cx:pt idx="755">1.21116</cx:pt>
          <cx:pt idx="756">1.34276</cx:pt>
          <cx:pt idx="757">1.10507</cx:pt>
          <cx:pt idx="758">1.2599899999999999</cx:pt>
          <cx:pt idx="759">1.2361899999999999</cx:pt>
          <cx:pt idx="760">1.22953</cx:pt>
          <cx:pt idx="761">1.19198</cx:pt>
          <cx:pt idx="762">1.2692699999999999</cx:pt>
          <cx:pt idx="763">1.3460099999999999</cx:pt>
          <cx:pt idx="764">1.3379099999999999</cx:pt>
          <cx:pt idx="765">1.2230300000000001</cx:pt>
          <cx:pt idx="766">1.34148</cx:pt>
          <cx:pt idx="767">1.3507499999999999</cx:pt>
          <cx:pt idx="768">1.34636</cx:pt>
          <cx:pt idx="769">1.3591200000000001</cx:pt>
          <cx:pt idx="770">1.3501700000000001</cx:pt>
          <cx:pt idx="771">1.0631999999999999</cx:pt>
          <cx:pt idx="772">1.32769</cx:pt>
          <cx:pt idx="773">1.21858</cx:pt>
          <cx:pt idx="774">1.1048100000000001</cx:pt>
          <cx:pt idx="775">1.08761</cx:pt>
          <cx:pt idx="776">1.19848</cx:pt>
          <cx:pt idx="777">1.2415099999999999</cx:pt>
          <cx:pt idx="778">1.1175999999999999</cx:pt>
          <cx:pt idx="779">1.0826199999999999</cx:pt>
          <cx:pt idx="780">1.3309599999999999</cx:pt>
          <cx:pt idx="781">1.24309</cx:pt>
          <cx:pt idx="782">1.2620400000000001</cx:pt>
          <cx:pt idx="783">1.36592</cx:pt>
          <cx:pt idx="784">1.33029</cx:pt>
          <cx:pt idx="785">1.1212200000000001</cx:pt>
          <cx:pt idx="786">1.1126199999999999</cx:pt>
          <cx:pt idx="787">1.0078499999999999</cx:pt>
          <cx:pt idx="788">1.3640000000000001</cx:pt>
          <cx:pt idx="789">1.34362</cx:pt>
          <cx:pt idx="790">1.36328</cx:pt>
          <cx:pt idx="791">1.34762</cx:pt>
          <cx:pt idx="792">1.3499099999999999</cx:pt>
          <cx:pt idx="793">1.3388599999999999</cx:pt>
          <cx:pt idx="794">1.2709299999999999</cx:pt>
          <cx:pt idx="795">1.21194</cx:pt>
          <cx:pt idx="796">1.06227</cx:pt>
          <cx:pt idx="797">1.32962</cx:pt>
          <cx:pt idx="798">1.3362400000000001</cx:pt>
          <cx:pt idx="799">1.3575299999999999</cx:pt>
          <cx:pt idx="800">1.1584700000000001</cx:pt>
          <cx:pt idx="801">1.2446699999999999</cx:pt>
          <cx:pt idx="802">1.34585</cx:pt>
          <cx:pt idx="803">1.10344</cx:pt>
          <cx:pt idx="804">1.31264</cx:pt>
          <cx:pt idx="805">1.09998</cx:pt>
          <cx:pt idx="806">1.33867</cx:pt>
          <cx:pt idx="807">1.03871</cx:pt>
          <cx:pt idx="808">1.3259799999999999</cx:pt>
          <cx:pt idx="809">1.1710400000000001</cx:pt>
          <cx:pt idx="810">1.14005</cx:pt>
          <cx:pt idx="811">1.3245199999999999</cx:pt>
          <cx:pt idx="812">1.17398</cx:pt>
          <cx:pt idx="813">1.3478000000000001</cx:pt>
          <cx:pt idx="814">1.3562799999999999</cx:pt>
          <cx:pt idx="815">1.1536900000000001</cx:pt>
          <cx:pt idx="816">1.2740100000000001</cx:pt>
          <cx:pt idx="817">1.22529</cx:pt>
          <cx:pt idx="818">1.34043</cx:pt>
          <cx:pt idx="819">1.2260200000000001</cx:pt>
          <cx:pt idx="820">1.26661</cx:pt>
          <cx:pt idx="821">1.35327</cx:pt>
          <cx:pt idx="822">1.3065800000000001</cx:pt>
          <cx:pt idx="823">1.3429599999999999</cx:pt>
          <cx:pt idx="824">1.34053</cx:pt>
          <cx:pt idx="825">1.19164</cx:pt>
          <cx:pt idx="826">1.3547800000000001</cx:pt>
          <cx:pt idx="827">1.3307</cx:pt>
          <cx:pt idx="828">1.34998</cx:pt>
          <cx:pt idx="829">1.35856</cx:pt>
          <cx:pt idx="830">1.3545199999999999</cx:pt>
          <cx:pt idx="831">1.19181</cx:pt>
          <cx:pt idx="832">1.3540099999999999</cx:pt>
          <cx:pt idx="833">1.3444700000000001</cx:pt>
          <cx:pt idx="834">1.1169500000000001</cx:pt>
          <cx:pt idx="835">1.3570500000000001</cx:pt>
          <cx:pt idx="836">1.3508500000000001</cx:pt>
          <cx:pt idx="837">1.16429</cx:pt>
          <cx:pt idx="838">1.29803</cx:pt>
          <cx:pt idx="839">1.3437300000000001</cx:pt>
          <cx:pt idx="840">1.26047</cx:pt>
          <cx:pt idx="841">1.2405999999999999</cx:pt>
          <cx:pt idx="842">1.1326000000000001</cx:pt>
          <cx:pt idx="843">1.3606</cx:pt>
          <cx:pt idx="844">1.1520300000000001</cx:pt>
          <cx:pt idx="845">1.08673</cx:pt>
          <cx:pt idx="846">1.16472</cx:pt>
          <cx:pt idx="847">1.2106600000000001</cx:pt>
          <cx:pt idx="848">1.3407</cx:pt>
          <cx:pt idx="849">1.35059</cx:pt>
          <cx:pt idx="850">1.21027</cx:pt>
          <cx:pt idx="851">1.1650100000000001</cx:pt>
          <cx:pt idx="852">1.3548100000000001</cx:pt>
          <cx:pt idx="853">1.3270900000000001</cx:pt>
          <cx:pt idx="854">1.0160800000000001</cx:pt>
          <cx:pt idx="855">1.3121700000000001</cx:pt>
          <cx:pt idx="856">1.30881</cx:pt>
          <cx:pt idx="857">1.35968</cx:pt>
          <cx:pt idx="858">1.09118</cx:pt>
          <cx:pt idx="859">1.33274</cx:pt>
          <cx:pt idx="860">1.3503799999999999</cx:pt>
          <cx:pt idx="861">1.3264</cx:pt>
          <cx:pt idx="862">1.3508899999999999</cx:pt>
          <cx:pt idx="863">1.2176499999999999</cx:pt>
          <cx:pt idx="864">1.32508</cx:pt>
          <cx:pt idx="865">1.3299000000000001</cx:pt>
          <cx:pt idx="866">1.31958</cx:pt>
          <cx:pt idx="867">1.34294</cx:pt>
          <cx:pt idx="868">1.34596</cx:pt>
          <cx:pt idx="869">1.36253</cx:pt>
          <cx:pt idx="870">1.31599</cx:pt>
          <cx:pt idx="871">1.3469</cx:pt>
          <cx:pt idx="872">1.35185</cx:pt>
          <cx:pt idx="873">1.2087699999999999</cx:pt>
          <cx:pt idx="874">1.1933800000000001</cx:pt>
          <cx:pt idx="875">1.3425400000000001</cx:pt>
          <cx:pt idx="876">1.14693</cx:pt>
          <cx:pt idx="877">1.36191</cx:pt>
          <cx:pt idx="878">1.3397600000000001</cx:pt>
          <cx:pt idx="879">1.35117</cx:pt>
          <cx:pt idx="880">1.3443400000000001</cx:pt>
          <cx:pt idx="881">1.1795</cx:pt>
          <cx:pt idx="882">1.1064499999999999</cx:pt>
          <cx:pt idx="883">1.10667</cx:pt>
          <cx:pt idx="884">1.33596</cx:pt>
          <cx:pt idx="885">1.3514200000000001</cx:pt>
          <cx:pt idx="886">1.3420700000000001</cx:pt>
          <cx:pt idx="887">1.2622500000000001</cx:pt>
          <cx:pt idx="888">1.3102199999999999</cx:pt>
          <cx:pt idx="889">1.18441</cx:pt>
          <cx:pt idx="890">1.1334200000000001</cx:pt>
          <cx:pt idx="891">1.3186500000000001</cx:pt>
          <cx:pt idx="892">1.2317</cx:pt>
          <cx:pt idx="893">1.20522</cx:pt>
          <cx:pt idx="894">1.0490600000000001</cx:pt>
          <cx:pt idx="895">1.3401000000000001</cx:pt>
          <cx:pt idx="896">1.181</cx:pt>
          <cx:pt idx="897">1.1682399999999999</cx:pt>
          <cx:pt idx="898">1.3508100000000001</cx:pt>
          <cx:pt idx="899">1.21357</cx:pt>
          <cx:pt idx="900">1.35083</cx:pt>
          <cx:pt idx="901">1.3505499999999999</cx:pt>
          <cx:pt idx="902">1.3403499999999999</cx:pt>
          <cx:pt idx="903">1.2466900000000001</cx:pt>
          <cx:pt idx="904">1.35425</cx:pt>
          <cx:pt idx="905">1.3445100000000001</cx:pt>
          <cx:pt idx="906">1.3434699999999999</cx:pt>
          <cx:pt idx="907">1.34795</cx:pt>
          <cx:pt idx="908">1.1795</cx:pt>
          <cx:pt idx="909">1.3642300000000001</cx:pt>
          <cx:pt idx="910">1.34711</cx:pt>
          <cx:pt idx="911">1.15151</cx:pt>
          <cx:pt idx="912">1.34745</cx:pt>
          <cx:pt idx="913">1.34822</cx:pt>
          <cx:pt idx="914">1.14554</cx:pt>
          <cx:pt idx="915">1.38337</cx:pt>
          <cx:pt idx="916">1.09165</cx:pt>
          <cx:pt idx="917">1.1194</cx:pt>
          <cx:pt idx="918">1.0560799999999999</cx:pt>
          <cx:pt idx="919">1.1019399999999999</cx:pt>
          <cx:pt idx="920">1.3484799999999999</cx:pt>
          <cx:pt idx="921">1.3491899999999999</cx:pt>
          <cx:pt idx="922">1.35128</cx:pt>
          <cx:pt idx="923">1.1236900000000001</cx:pt>
          <cx:pt idx="924">1.1965699999999999</cx:pt>
          <cx:pt idx="925">1.22255</cx:pt>
          <cx:pt idx="926">1.3548899999999999</cx:pt>
          <cx:pt idx="927">1.12815</cx:pt>
          <cx:pt idx="928">1.3475299999999999</cx:pt>
          <cx:pt idx="929">1.1629400000000001</cx:pt>
          <cx:pt idx="930">1.1719299999999999</cx:pt>
          <cx:pt idx="931">1.2172000000000001</cx:pt>
          <cx:pt idx="932">1.3486</cx:pt>
          <cx:pt idx="933">1.16306</cx:pt>
          <cx:pt idx="934">1.35449</cx:pt>
          <cx:pt idx="935">1.12124</cx:pt>
          <cx:pt idx="936">1.3456399999999999</cx:pt>
          <cx:pt idx="937">1.3458699999999999</cx:pt>
          <cx:pt idx="938">1.2048300000000001</cx:pt>
          <cx:pt idx="939">1.1383700000000001</cx:pt>
          <cx:pt idx="940">1.12307</cx:pt>
          <cx:pt idx="941">1.15584</cx:pt>
          <cx:pt idx="942">1.3275699999999999</cx:pt>
          <cx:pt idx="943">1.3506899999999999</cx:pt>
          <cx:pt idx="944">1.0753200000000001</cx:pt>
          <cx:pt idx="945">1.3608800000000001</cx:pt>
          <cx:pt idx="946">1.3466199999999999</cx:pt>
          <cx:pt idx="947">1.1342099999999999</cx:pt>
          <cx:pt idx="948">1.3600399999999999</cx:pt>
          <cx:pt idx="949">1.13432</cx:pt>
          <cx:pt idx="950">1.3103800000000001</cx:pt>
          <cx:pt idx="951">1.2601800000000001</cx:pt>
          <cx:pt idx="952">1.3576999999999999</cx:pt>
          <cx:pt idx="953">1.1684399999999999</cx:pt>
          <cx:pt idx="954">1.2237</cx:pt>
          <cx:pt idx="955">1.2266600000000001</cx:pt>
          <cx:pt idx="956">1.25905</cx:pt>
          <cx:pt idx="957">1.36053</cx:pt>
          <cx:pt idx="958">1.1378699999999999</cx:pt>
          <cx:pt idx="959">1.3552999999999999</cx:pt>
          <cx:pt idx="960">1.0956999999999999</cx:pt>
          <cx:pt idx="961">1.34903</cx:pt>
          <cx:pt idx="962">1.3355600000000001</cx:pt>
          <cx:pt idx="963">1.1612100000000001</cx:pt>
          <cx:pt idx="964">1.1040700000000001</cx:pt>
          <cx:pt idx="965">1.04454</cx:pt>
          <cx:pt idx="966">1.06227</cx:pt>
          <cx:pt idx="967">1.33057</cx:pt>
          <cx:pt idx="968">1.3463700000000001</cx:pt>
          <cx:pt idx="969">1.3303400000000001</cx:pt>
          <cx:pt idx="970">1.34626</cx:pt>
          <cx:pt idx="971">1.11822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rtl="0"/>
            <a:r>
              <a:rPr lang="el-GR" altLang="ja-JP" sz="1200" b="0" i="0" baseline="0" dirty="0">
                <a:effectLst/>
              </a:rPr>
              <a:t>σ</a:t>
            </a:r>
            <a:r>
              <a:rPr lang="en-US" altLang="ja-JP" sz="1200" b="0" i="0" baseline="0" dirty="0">
                <a:effectLst/>
              </a:rPr>
              <a:t>,</a:t>
            </a:r>
            <a:r>
              <a:rPr lang="en-US" altLang="ja-JP" sz="1200" b="0" i="1" baseline="0" dirty="0" err="1">
                <a:effectLst/>
              </a:rPr>
              <a:t>x</a:t>
            </a:r>
            <a:r>
              <a:rPr lang="en-US" altLang="ja-JP" sz="1200" b="0" i="0" baseline="0" dirty="0" err="1">
                <a:effectLst/>
              </a:rPr>
              <a:t>chronic</a:t>
            </a:r>
            <a:endParaRPr lang="ja-JP" altLang="ja-JP" sz="1400" dirty="0">
              <a:effectLst/>
            </a:endParaRPr>
          </a:p>
        </cx:rich>
      </cx:tx>
    </cx:title>
    <cx:plotArea>
      <cx:plotAreaRegion>
        <cx:series layoutId="clusteredColumn" uniqueId="{D50D3ECB-8A5E-4D8E-8B68-2FDA1EF377A0}">
          <cx:tx>
            <cx:txData>
              <cx:f>'PD chronic'!$K$1</cx:f>
              <cx:v>E1Eps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Count val="8"/>
            </cx:binning>
          </cx:layoutPr>
        </cx:series>
      </cx:plotAreaRegion>
      <cx:axis id="0">
        <cx:catScaling gapWidth="0"/>
        <cx:tickLabels/>
        <cx:numFmt formatCode="#,##0.00_);[赤](#,##0.0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3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PK!$E$2:$E$1001</cx:f>
        <cx:lvl ptCount="1000" formatCode="G/標準">
          <cx:pt idx="0">1.7167600000000001</cx:pt>
          <cx:pt idx="1">2.5904799999999999</cx:pt>
          <cx:pt idx="2">3.6026899999999999</cx:pt>
          <cx:pt idx="3">2.4062399999999999</cx:pt>
          <cx:pt idx="4">2.0414099999999999</cx:pt>
          <cx:pt idx="5">3.9154100000000001</cx:pt>
          <cx:pt idx="6">2.1027200000000001</cx:pt>
          <cx:pt idx="7">1.81348</cx:pt>
          <cx:pt idx="8">1.68048</cx:pt>
          <cx:pt idx="9">2.25535</cx:pt>
          <cx:pt idx="10">1.99055</cx:pt>
          <cx:pt idx="11">2.58907</cx:pt>
          <cx:pt idx="12">3.10697</cx:pt>
          <cx:pt idx="13">3.5987200000000001</cx:pt>
          <cx:pt idx="14">2.3782999999999999</cx:pt>
          <cx:pt idx="15">2.3228900000000001</cx:pt>
          <cx:pt idx="16">2.6201300000000001</cx:pt>
          <cx:pt idx="17">2.0743</cx:pt>
          <cx:pt idx="18">5.0409100000000002</cx:pt>
          <cx:pt idx="19">2.08121</cx:pt>
          <cx:pt idx="20">3.5696099999999999</cx:pt>
          <cx:pt idx="21">3.1103900000000002</cx:pt>
          <cx:pt idx="22">3.8102900000000002</cx:pt>
          <cx:pt idx="23">3.10765</cx:pt>
          <cx:pt idx="24">4.2234299999999996</cx:pt>
          <cx:pt idx="25">2.9033199999999999</cx:pt>
          <cx:pt idx="26">2.6201300000000001</cx:pt>
          <cx:pt idx="27">2.4157299999999999</cx:pt>
          <cx:pt idx="28">3.1965300000000001</cx:pt>
          <cx:pt idx="29">2.5532599999999999</cx:pt>
          <cx:pt idx="30">2.5366399999999998</cx:pt>
          <cx:pt idx="31">2.6730700000000001</cx:pt>
          <cx:pt idx="32">3.7230400000000001</cx:pt>
          <cx:pt idx="33">2.0072199999999998</cx:pt>
          <cx:pt idx="34">2.6201300000000001</cx:pt>
          <cx:pt idx="35">2.6201300000000001</cx:pt>
          <cx:pt idx="36">2.51166</cx:pt>
          <cx:pt idx="37">3.0819800000000002</cx:pt>
          <cx:pt idx="38">4.5076799999999997</cx:pt>
          <cx:pt idx="39">3.5754299999999999</cx:pt>
          <cx:pt idx="40">3.9908600000000001</cx:pt>
          <cx:pt idx="41">2.0102500000000001</cx:pt>
          <cx:pt idx="42">3.3334800000000002</cx:pt>
          <cx:pt idx="43">2.4538799999999998</cx:pt>
          <cx:pt idx="44">2.8778899999999998</cx:pt>
          <cx:pt idx="45">3.6539700000000002</cx:pt>
          <cx:pt idx="46">2.3591000000000002</cx:pt>
          <cx:pt idx="47">1.71905</cx:pt>
          <cx:pt idx="48">1.9321200000000001</cx:pt>
          <cx:pt idx="49">2.08867</cx:pt>
          <cx:pt idx="50">3.8130199999999999</cx:pt>
          <cx:pt idx="51">3.1551800000000001</cx:pt>
          <cx:pt idx="52">2.1767599999999998</cx:pt>
          <cx:pt idx="53">3.4972099999999999</cx:pt>
          <cx:pt idx="54">2.7722600000000002</cx:pt>
          <cx:pt idx="55">1.97496</cx:pt>
          <cx:pt idx="56">2.5397599999999998</cx:pt>
          <cx:pt idx="57">4.2397499999999999</cx:pt>
          <cx:pt idx="58">3.50692</cx:pt>
          <cx:pt idx="59">2.9298999999999999</cx:pt>
          <cx:pt idx="60">3.0474299999999999</cx:pt>
          <cx:pt idx="61">2.0554700000000001</cx:pt>
          <cx:pt idx="62">2.8872599999999999</cx:pt>
          <cx:pt idx="63">2.2103999999999999</cx:pt>
          <cx:pt idx="64">2.2010900000000002</cx:pt>
          <cx:pt idx="65">2.53382</cx:pt>
          <cx:pt idx="66">2.7791999999999999</cx:pt>
          <cx:pt idx="67">2.2623600000000001</cx:pt>
          <cx:pt idx="68">2.53409</cx:pt>
          <cx:pt idx="69">2.2894399999999999</cx:pt>
          <cx:pt idx="70">4.4626099999999997</cx:pt>
          <cx:pt idx="71">3.45458</cx:pt>
          <cx:pt idx="72">2.4439799999999998</cx:pt>
          <cx:pt idx="73">2.6225499999999999</cx:pt>
          <cx:pt idx="74">2.7239</cx:pt>
          <cx:pt idx="75">3.3596699999999999</cx:pt>
          <cx:pt idx="76">2.21482</cx:pt>
          <cx:pt idx="77">2.8539099999999999</cx:pt>
          <cx:pt idx="78">2.92049</cx:pt>
          <cx:pt idx="79">2.6961300000000001</cx:pt>
          <cx:pt idx="80">2.1478000000000002</cx:pt>
          <cx:pt idx="81">5.4646800000000004</cx:pt>
          <cx:pt idx="82">2.6201300000000001</cx:pt>
          <cx:pt idx="83">4.6057300000000003</cx:pt>
          <cx:pt idx="84">2.4802900000000001</cx:pt>
          <cx:pt idx="85">1.9861200000000001</cx:pt>
          <cx:pt idx="86">2.4402699999999999</cx:pt>
          <cx:pt idx="87">3.9849899999999998</cx:pt>
          <cx:pt idx="88">2.6918799999999998</cx:pt>
          <cx:pt idx="89">3.2839700000000001</cx:pt>
          <cx:pt idx="90">3.03105</cx:pt>
          <cx:pt idx="91">2.88916</cx:pt>
          <cx:pt idx="92">1.9996799999999999</cx:pt>
          <cx:pt idx="93">4.1892300000000002</cx:pt>
          <cx:pt idx="94">3.4467500000000002</cx:pt>
          <cx:pt idx="95">5.0104300000000004</cx:pt>
          <cx:pt idx="96">2.9732099999999999</cx:pt>
          <cx:pt idx="97">2.0731000000000002</cx:pt>
          <cx:pt idx="98">3.2341500000000001</cx:pt>
          <cx:pt idx="99">2.6201300000000001</cx:pt>
          <cx:pt idx="100">3.70675</cx:pt>
          <cx:pt idx="101">2.6201300000000001</cx:pt>
          <cx:pt idx="102">2.6201300000000001</cx:pt>
          <cx:pt idx="103">3.90035</cx:pt>
          <cx:pt idx="104">4.12974</cx:pt>
          <cx:pt idx="105">2.0591499999999998</cx:pt>
          <cx:pt idx="106">2.1907800000000002</cx:pt>
          <cx:pt idx="107">3.0066700000000002</cx:pt>
          <cx:pt idx="108">2.5593699999999999</cx:pt>
          <cx:pt idx="109">3.3691800000000001</cx:pt>
          <cx:pt idx="110">3.1566299999999998</cx:pt>
          <cx:pt idx="111">2.7311399999999999</cx:pt>
          <cx:pt idx="112">1.8628800000000001</cx:pt>
          <cx:pt idx="113">4.51004</cx:pt>
          <cx:pt idx="114">4.3737300000000001</cx:pt>
          <cx:pt idx="115">2.2948300000000001</cx:pt>
          <cx:pt idx="116">2.6697500000000001</cx:pt>
          <cx:pt idx="117">2.74898</cx:pt>
          <cx:pt idx="118">2.6201300000000001</cx:pt>
          <cx:pt idx="119">2.87262</cx:pt>
          <cx:pt idx="120">3.5886900000000002</cx:pt>
          <cx:pt idx="121">2.6866599999999998</cx:pt>
          <cx:pt idx="122">4.8934199999999999</cx:pt>
          <cx:pt idx="123">3.0204399999999998</cx:pt>
          <cx:pt idx="124">1.96112</cx:pt>
          <cx:pt idx="125">1.90036</cx:pt>
          <cx:pt idx="126">2.4902600000000001</cx:pt>
          <cx:pt idx="127">2.45235</cx:pt>
          <cx:pt idx="128">1.6849400000000001</cx:pt>
          <cx:pt idx="129">2.6341600000000001</cx:pt>
          <cx:pt idx="130">2.2378300000000002</cx:pt>
          <cx:pt idx="131">2.1619299999999999</cx:pt>
          <cx:pt idx="132">2.0564100000000001</cx:pt>
          <cx:pt idx="133">3.66025</cx:pt>
          <cx:pt idx="134">3.3373300000000001</cx:pt>
          <cx:pt idx="135">2.4579399999999998</cx:pt>
          <cx:pt idx="136">2.6201300000000001</cx:pt>
          <cx:pt idx="137">4.1145699999999996</cx:pt>
          <cx:pt idx="138">2.3481900000000002</cx:pt>
          <cx:pt idx="139">2.3664100000000001</cx:pt>
          <cx:pt idx="140">2.64019</cx:pt>
          <cx:pt idx="141">1.5891999999999999</cx:pt>
          <cx:pt idx="142">3.0801699999999999</cx:pt>
          <cx:pt idx="143">1.8619600000000001</cx:pt>
          <cx:pt idx="144">2.4762200000000001</cx:pt>
          <cx:pt idx="145">2.6201300000000001</cx:pt>
          <cx:pt idx="146">1.8795500000000001</cx:pt>
          <cx:pt idx="147">2.1518999999999999</cx:pt>
          <cx:pt idx="148">1.9976400000000001</cx:pt>
          <cx:pt idx="149">2.3113999999999999</cx:pt>
          <cx:pt idx="150">2.31325</cx:pt>
          <cx:pt idx="151">2.3685299999999998</cx:pt>
          <cx:pt idx="152">2.71515</cx:pt>
          <cx:pt idx="153">2.83169</cx:pt>
          <cx:pt idx="154">3.5087899999999999</cx:pt>
          <cx:pt idx="155">2.4737</cx:pt>
          <cx:pt idx="156">2.7384900000000001</cx:pt>
          <cx:pt idx="157">4.6085799999999999</cx:pt>
          <cx:pt idx="158">4.0663900000000002</cx:pt>
          <cx:pt idx="159">3.4434399999999998</cx:pt>
          <cx:pt idx="160">2.2288199999999998</cx:pt>
          <cx:pt idx="161">3.6608299999999998</cx:pt>
          <cx:pt idx="162">2.3434499999999998</cx:pt>
          <cx:pt idx="163">2.1513900000000001</cx:pt>
          <cx:pt idx="164">2.03017</cx:pt>
          <cx:pt idx="165">3.3603100000000001</cx:pt>
          <cx:pt idx="166">4.4887800000000002</cx:pt>
          <cx:pt idx="167">3.0883699999999998</cx:pt>
          <cx:pt idx="168">2.9576799999999999</cx:pt>
          <cx:pt idx="169">2.0435400000000001</cx:pt>
          <cx:pt idx="170">2.2865799999999998</cx:pt>
          <cx:pt idx="171">3.2250100000000002</cx:pt>
          <cx:pt idx="172">2.5058600000000002</cx:pt>
          <cx:pt idx="173">2.3825099999999999</cx:pt>
          <cx:pt idx="174">2.6614499999999999</cx:pt>
          <cx:pt idx="175">2.0331700000000001</cx:pt>
          <cx:pt idx="176">2.4916999999999998</cx:pt>
          <cx:pt idx="177">4.3179499999999997</cx:pt>
          <cx:pt idx="178">3.7836500000000002</cx:pt>
          <cx:pt idx="179">2.2058</cx:pt>
          <cx:pt idx="180">2.4782199999999999</cx:pt>
          <cx:pt idx="181">2.9733499999999999</cx:pt>
          <cx:pt idx="182">6.8235999999999999</cx:pt>
          <cx:pt idx="183">1.73081</cx:pt>
          <cx:pt idx="184">2.4541200000000001</cx:pt>
          <cx:pt idx="185">2.5491100000000002</cx:pt>
          <cx:pt idx="186">4.0834000000000001</cx:pt>
          <cx:pt idx="187">2.94754</cx:pt>
          <cx:pt idx="188">2.8986900000000002</cx:pt>
          <cx:pt idx="189">4.0505699999999996</cx:pt>
          <cx:pt idx="190">2.6201300000000001</cx:pt>
          <cx:pt idx="191">5.0657899999999998</cx:pt>
          <cx:pt idx="192">2.5523400000000001</cx:pt>
          <cx:pt idx="193">3.83439</cx:pt>
          <cx:pt idx="194">2.1349399999999998</cx:pt>
          <cx:pt idx="195">3.95322</cx:pt>
          <cx:pt idx="196">2.90238</cx:pt>
          <cx:pt idx="197">3.3756599999999999</cx:pt>
          <cx:pt idx="198">3.0041699999999998</cx:pt>
          <cx:pt idx="199">2.3936999999999999</cx:pt>
          <cx:pt idx="200">2.6865000000000001</cx:pt>
          <cx:pt idx="201">4.1490600000000004</cx:pt>
          <cx:pt idx="202">2.7506499999999998</cx:pt>
          <cx:pt idx="203">3.10819</cx:pt>
          <cx:pt idx="204">4.09537</cx:pt>
          <cx:pt idx="205">3.1724299999999999</cx:pt>
          <cx:pt idx="206">3.4242699999999999</cx:pt>
          <cx:pt idx="207">4.20336</cx:pt>
          <cx:pt idx="208">2.1072600000000001</cx:pt>
          <cx:pt idx="209">2.9417499999999999</cx:pt>
          <cx:pt idx="210">4.2431799999999997</cx:pt>
          <cx:pt idx="211">3.8815400000000002</cx:pt>
          <cx:pt idx="212">2.2791600000000001</cx:pt>
          <cx:pt idx="213">3.8951099999999999</cx:pt>
          <cx:pt idx="214">2.6656399999999998</cx:pt>
          <cx:pt idx="215">2.3295300000000001</cx:pt>
          <cx:pt idx="216">2.0640000000000001</cx:pt>
          <cx:pt idx="217">2.4369299999999998</cx:pt>
          <cx:pt idx="218">3.7333599999999998</cx:pt>
          <cx:pt idx="219">1.7082900000000001</cx:pt>
          <cx:pt idx="220">2.34789</cx:pt>
          <cx:pt idx="221">1.9791099999999999</cx:pt>
          <cx:pt idx="222">1.8289599999999999</cx:pt>
          <cx:pt idx="223">3.0343200000000001</cx:pt>
          <cx:pt idx="224">2.5379800000000001</cx:pt>
          <cx:pt idx="225">2.1559300000000001</cx:pt>
          <cx:pt idx="226">2.2789899999999998</cx:pt>
          <cx:pt idx="227">1.96671</cx:pt>
          <cx:pt idx="228">2.6201300000000001</cx:pt>
          <cx:pt idx="229">2.03451</cx:pt>
          <cx:pt idx="230">3.4828600000000001</cx:pt>
          <cx:pt idx="231">2.1732399999999998</cx:pt>
          <cx:pt idx="232">2.89371</cx:pt>
          <cx:pt idx="233">3.12541</cx:pt>
          <cx:pt idx="234">3.31738</cx:pt>
          <cx:pt idx="235">2.73021</cx:pt>
          <cx:pt idx="236">2.32959</cx:pt>
          <cx:pt idx="237">2.1981799999999998</cx:pt>
          <cx:pt idx="238">2.8360500000000002</cx:pt>
          <cx:pt idx="239">1.73064</cx:pt>
          <cx:pt idx="240">2.48264</cx:pt>
          <cx:pt idx="241">2.0656300000000001</cx:pt>
          <cx:pt idx="242">2.3011400000000002</cx:pt>
          <cx:pt idx="243">3.7204899999999999</cx:pt>
          <cx:pt idx="244">2.6296499999999998</cx:pt>
          <cx:pt idx="245">2.8017099999999999</cx:pt>
          <cx:pt idx="246">3.50949</cx:pt>
          <cx:pt idx="247">2.6201300000000001</cx:pt>
          <cx:pt idx="248">3.2744599999999999</cx:pt>
          <cx:pt idx="249">4.3806500000000002</cx:pt>
          <cx:pt idx="250">2.33073</cx:pt>
          <cx:pt idx="251">3.20838</cx:pt>
          <cx:pt idx="252">2.0265599999999999</cx:pt>
          <cx:pt idx="253">1.9267700000000001</cx:pt>
          <cx:pt idx="254">3.6167400000000001</cx:pt>
          <cx:pt idx="255">2.7074600000000002</cx:pt>
          <cx:pt idx="256">3.81758</cx:pt>
          <cx:pt idx="257">2.5150600000000001</cx:pt>
          <cx:pt idx="258">3.6239699999999999</cx:pt>
          <cx:pt idx="259">2.7460399999999998</cx:pt>
          <cx:pt idx="260">2.62975</cx:pt>
          <cx:pt idx="261">1.80809</cx:pt>
          <cx:pt idx="262">3.9285399999999999</cx:pt>
          <cx:pt idx="263">2.06046</cx:pt>
          <cx:pt idx="264">2.68397</cx:pt>
          <cx:pt idx="265">2.20133</cx:pt>
          <cx:pt idx="266">2.3177699999999999</cx:pt>
          <cx:pt idx="267">1.76983</cx:pt>
          <cx:pt idx="268">2.2398799999999999</cx:pt>
          <cx:pt idx="269">2.6201300000000001</cx:pt>
          <cx:pt idx="270">2.1445799999999999</cx:pt>
          <cx:pt idx="271">2.2061700000000002</cx:pt>
          <cx:pt idx="272">3.3341500000000002</cx:pt>
          <cx:pt idx="273">3.3264</cx:pt>
          <cx:pt idx="274">2.6619799999999998</cx:pt>
          <cx:pt idx="275">2.90706</cx:pt>
          <cx:pt idx="276">2.3531900000000001</cx:pt>
          <cx:pt idx="277">2.3205499999999999</cx:pt>
          <cx:pt idx="278">3.1333799999999998</cx:pt>
          <cx:pt idx="279">3.0834100000000002</cx:pt>
          <cx:pt idx="280">3.1500599999999999</cx:pt>
          <cx:pt idx="281">2.1550699999999998</cx:pt>
          <cx:pt idx="282">3.4646599999999999</cx:pt>
          <cx:pt idx="283">4.4814699999999998</cx:pt>
          <cx:pt idx="284">2.4896400000000001</cx:pt>
          <cx:pt idx="285">2.6201300000000001</cx:pt>
          <cx:pt idx="286">3.2088299999999998</cx:pt>
          <cx:pt idx="287">2.69055</cx:pt>
          <cx:pt idx="288">2.14398</cx:pt>
          <cx:pt idx="289">2.7937799999999999</cx:pt>
          <cx:pt idx="290">4.01769</cx:pt>
          <cx:pt idx="291">2.6201300000000001</cx:pt>
          <cx:pt idx="292">4.4997999999999996</cx:pt>
          <cx:pt idx="293">3.1773799999999999</cx:pt>
          <cx:pt idx="294">3.4034200000000001</cx:pt>
          <cx:pt idx="295">2.64194</cx:pt>
          <cx:pt idx="296">2.4075299999999999</cx:pt>
          <cx:pt idx="297">2.5325500000000001</cx:pt>
          <cx:pt idx="298">2.7247400000000002</cx:pt>
          <cx:pt idx="299">2.2181000000000002</cx:pt>
          <cx:pt idx="300">2.7120099999999998</cx:pt>
          <cx:pt idx="301">3.0489999999999999</cx:pt>
          <cx:pt idx="302">2.9620000000000002</cx:pt>
          <cx:pt idx="303">1.7475799999999999</cx:pt>
          <cx:pt idx="304">2.6201300000000001</cx:pt>
          <cx:pt idx="305">2.1606800000000002</cx:pt>
          <cx:pt idx="306">2.3587500000000001</cx:pt>
          <cx:pt idx="307">4.3362499999999997</cx:pt>
          <cx:pt idx="308">4.3932500000000001</cx:pt>
          <cx:pt idx="309">2.6201300000000001</cx:pt>
          <cx:pt idx="310">2.15306</cx:pt>
          <cx:pt idx="311">3.08148</cx:pt>
          <cx:pt idx="312">3.3509600000000002</cx:pt>
          <cx:pt idx="313">2.20411</cx:pt>
          <cx:pt idx="314">3.7854100000000002</cx:pt>
          <cx:pt idx="315">3.9411299999999998</cx:pt>
          <cx:pt idx="316">3.1338200000000001</cx:pt>
          <cx:pt idx="317">2.6094200000000001</cx:pt>
          <cx:pt idx="318">2.0379399999999999</cx:pt>
          <cx:pt idx="319">2.5815800000000002</cx:pt>
          <cx:pt idx="320">3.3356400000000002</cx:pt>
          <cx:pt idx="321">2.4168799999999999</cx:pt>
          <cx:pt idx="322">3.3710399999999998</cx:pt>
          <cx:pt idx="323">3.8409200000000001</cx:pt>
          <cx:pt idx="324">2.5605099999999998</cx:pt>
          <cx:pt idx="325">3.6777000000000002</cx:pt>
          <cx:pt idx="326">4.5285099999999998</cx:pt>
          <cx:pt idx="327">2.2866499999999998</cx:pt>
          <cx:pt idx="328">2.6478799999999998</cx:pt>
          <cx:pt idx="329">2.84137</cx:pt>
          <cx:pt idx="330">3.4628800000000002</cx:pt>
          <cx:pt idx="331">2.4327999999999999</cx:pt>
          <cx:pt idx="332">2.2539099999999999</cx:pt>
          <cx:pt idx="333">3.3930099999999999</cx:pt>
          <cx:pt idx="334">2.9145799999999999</cx:pt>
          <cx:pt idx="335">3.1021800000000002</cx:pt>
          <cx:pt idx="336">3.0196100000000001</cx:pt>
          <cx:pt idx="337">3.9552900000000002</cx:pt>
          <cx:pt idx="338">3.3211599999999999</cx:pt>
          <cx:pt idx="339">2.4516100000000001</cx:pt>
          <cx:pt idx="340">2.7939400000000001</cx:pt>
          <cx:pt idx="341">2.89194</cx:pt>
          <cx:pt idx="342">2.9127999999999998</cx:pt>
          <cx:pt idx="343">3.2412800000000002</cx:pt>
          <cx:pt idx="344">3.7808099999999998</cx:pt>
          <cx:pt idx="345">2.8632399999999998</cx:pt>
          <cx:pt idx="346">2.7483599999999999</cx:pt>
          <cx:pt idx="347">2.8110599999999999</cx:pt>
          <cx:pt idx="348">3.1287099999999999</cx:pt>
          <cx:pt idx="349">1.89211</cx:pt>
          <cx:pt idx="350">2.5403099999999998</cx:pt>
          <cx:pt idx="351">2.5258400000000001</cx:pt>
          <cx:pt idx="352">2.4376899999999999</cx:pt>
          <cx:pt idx="353">3.8786200000000002</cx:pt>
          <cx:pt idx="354">2.6663899999999998</cx:pt>
          <cx:pt idx="355">2.1312799999999998</cx:pt>
          <cx:pt idx="356">3.1317200000000001</cx:pt>
          <cx:pt idx="357">2.0478800000000001</cx:pt>
          <cx:pt idx="358">3.1589800000000001</cx:pt>
          <cx:pt idx="359">3.4114200000000001</cx:pt>
          <cx:pt idx="360">2.09836</cx:pt>
          <cx:pt idx="361">2.9228700000000001</cx:pt>
          <cx:pt idx="362">4.6714799999999999</cx:pt>
          <cx:pt idx="363">2.6201300000000001</cx:pt>
          <cx:pt idx="364">2.0152299999999999</cx:pt>
          <cx:pt idx="365">3.97126</cx:pt>
          <cx:pt idx="366">1.8885000000000001</cx:pt>
          <cx:pt idx="367">2.15821</cx:pt>
          <cx:pt idx="368">3.2132200000000002</cx:pt>
          <cx:pt idx="369">2.6201300000000001</cx:pt>
          <cx:pt idx="370">3.0071300000000001</cx:pt>
          <cx:pt idx="371">3.7503099999999998</cx:pt>
          <cx:pt idx="372">3.3086600000000002</cx:pt>
          <cx:pt idx="373">2.5627300000000002</cx:pt>
          <cx:pt idx="374">4.80077</cx:pt>
          <cx:pt idx="375">3.2753800000000002</cx:pt>
          <cx:pt idx="376">2.6201300000000001</cx:pt>
          <cx:pt idx="377">2.2907899999999999</cx:pt>
          <cx:pt idx="378">3.3090000000000002</cx:pt>
          <cx:pt idx="379">2.6201300000000001</cx:pt>
          <cx:pt idx="380">1.9079600000000001</cx:pt>
          <cx:pt idx="381">3.93614</cx:pt>
          <cx:pt idx="382">1.9716199999999999</cx:pt>
          <cx:pt idx="383">2.0066299999999999</cx:pt>
          <cx:pt idx="384">2.9517000000000002</cx:pt>
          <cx:pt idx="385">2.7496800000000001</cx:pt>
          <cx:pt idx="386">2.71346</cx:pt>
          <cx:pt idx="387">3.7219000000000002</cx:pt>
          <cx:pt idx="388">3.34076</cx:pt>
          <cx:pt idx="389">3.2556400000000001</cx:pt>
          <cx:pt idx="390">4.15937</cx:pt>
          <cx:pt idx="391">1.9127700000000001</cx:pt>
          <cx:pt idx="392">3.4938899999999999</cx:pt>
          <cx:pt idx="393">2.7488000000000001</cx:pt>
          <cx:pt idx="394">2.6201300000000001</cx:pt>
          <cx:pt idx="395">1.9131</cx:pt>
          <cx:pt idx="396">2.2479300000000002</cx:pt>
          <cx:pt idx="397">2.5866400000000001</cx:pt>
          <cx:pt idx="398">3.5840200000000002</cx:pt>
          <cx:pt idx="399">1.7963</cx:pt>
          <cx:pt idx="400">3.3212999999999999</cx:pt>
          <cx:pt idx="401">2.6201300000000001</cx:pt>
          <cx:pt idx="402">2.8873099999999998</cx:pt>
          <cx:pt idx="403">2.5513400000000002</cx:pt>
          <cx:pt idx="404">2.5778799999999999</cx:pt>
          <cx:pt idx="405">2.9387699999999999</cx:pt>
          <cx:pt idx="406">2.8429600000000002</cx:pt>
          <cx:pt idx="407">1.84602</cx:pt>
          <cx:pt idx="408">2.2616999999999998</cx:pt>
          <cx:pt idx="409">3.48062</cx:pt>
          <cx:pt idx="410">1.8863700000000001</cx:pt>
          <cx:pt idx="411">2.2086800000000002</cx:pt>
          <cx:pt idx="412">4.1603700000000003</cx:pt>
          <cx:pt idx="413">2.3976000000000002</cx:pt>
          <cx:pt idx="414">1.72888</cx:pt>
          <cx:pt idx="415">2.3584200000000002</cx:pt>
          <cx:pt idx="416">3.14941</cx:pt>
          <cx:pt idx="417">3.1478600000000001</cx:pt>
          <cx:pt idx="418">2.4579800000000001</cx:pt>
          <cx:pt idx="419">4.0313299999999996</cx:pt>
          <cx:pt idx="420">2.0039500000000001</cx:pt>
          <cx:pt idx="421">2.20886</cx:pt>
          <cx:pt idx="422">1.79925</cx:pt>
          <cx:pt idx="423">3.2180200000000001</cx:pt>
          <cx:pt idx="424">3.5422799999999999</cx:pt>
          <cx:pt idx="425">4.1733099999999999</cx:pt>
          <cx:pt idx="426">3.00258</cx:pt>
          <cx:pt idx="427">2.5609899999999999</cx:pt>
          <cx:pt idx="428">2.6147900000000002</cx:pt>
          <cx:pt idx="429">2.1280800000000002</cx:pt>
          <cx:pt idx="430">2.3216299999999999</cx:pt>
          <cx:pt idx="431">4.6539599999999997</cx:pt>
          <cx:pt idx="432">2.2156799999999999</cx:pt>
          <cx:pt idx="433">3.3028400000000002</cx:pt>
          <cx:pt idx="434">2.12174</cx:pt>
          <cx:pt idx="435">2.8889</cx:pt>
          <cx:pt idx="436">1.70817</cx:pt>
          <cx:pt idx="437">2.6426400000000001</cx:pt>
          <cx:pt idx="438">2.5028800000000002</cx:pt>
          <cx:pt idx="439">3.1997499999999999</cx:pt>
          <cx:pt idx="440">4.1381800000000002</cx:pt>
          <cx:pt idx="441">2.2337799999999999</cx:pt>
          <cx:pt idx="442">3.33162</cx:pt>
          <cx:pt idx="443">2.6201300000000001</cx:pt>
          <cx:pt idx="444">2.5735800000000002</cx:pt>
          <cx:pt idx="445">4.1223000000000001</cx:pt>
          <cx:pt idx="446">2.2786</cx:pt>
          <cx:pt idx="447">2.8947400000000001</cx:pt>
          <cx:pt idx="448">2.9189400000000001</cx:pt>
          <cx:pt idx="449">2.12886</cx:pt>
          <cx:pt idx="450">3.3580000000000001</cx:pt>
          <cx:pt idx="451">1.90672</cx:pt>
          <cx:pt idx="452">2.8828</cx:pt>
          <cx:pt idx="453">4.1602399999999999</cx:pt>
          <cx:pt idx="454">3.7028699999999999</cx:pt>
          <cx:pt idx="455">3.4765899999999998</cx:pt>
          <cx:pt idx="456">2.3006099999999998</cx:pt>
          <cx:pt idx="457">2.10704</cx:pt>
          <cx:pt idx="458">4.2652999999999999</cx:pt>
          <cx:pt idx="459">2.9379200000000001</cx:pt>
          <cx:pt idx="460">1.90208</cx:pt>
          <cx:pt idx="461">4.0588300000000004</cx:pt>
          <cx:pt idx="462">4.2366700000000002</cx:pt>
          <cx:pt idx="463">2.2353399999999999</cx:pt>
          <cx:pt idx="464">2.8725900000000002</cx:pt>
          <cx:pt idx="465">1.7678400000000001</cx:pt>
          <cx:pt idx="466">2.9279299999999999</cx:pt>
          <cx:pt idx="467">3.6610100000000001</cx:pt>
          <cx:pt idx="468">2.0708700000000002</cx:pt>
          <cx:pt idx="469">4.4570800000000004</cx:pt>
          <cx:pt idx="470">2.4987300000000001</cx:pt>
          <cx:pt idx="471">1.89923</cx:pt>
          <cx:pt idx="472">3.5116200000000002</cx:pt>
          <cx:pt idx="473">2.2874599999999998</cx:pt>
          <cx:pt idx="474">2.2279800000000001</cx:pt>
          <cx:pt idx="475">2.0119500000000001</cx:pt>
          <cx:pt idx="476">3.9422000000000001</cx:pt>
          <cx:pt idx="477">3.4333100000000001</cx:pt>
          <cx:pt idx="478">1.9542999999999999</cx:pt>
          <cx:pt idx="479">1.98759</cx:pt>
          <cx:pt idx="480">3.05565</cx:pt>
          <cx:pt idx="481">2.82239</cx:pt>
          <cx:pt idx="482">3.1231200000000001</cx:pt>
          <cx:pt idx="483">2.3603000000000001</cx:pt>
          <cx:pt idx="484">2.6201300000000001</cx:pt>
          <cx:pt idx="485">2.6306600000000002</cx:pt>
          <cx:pt idx="486">2.5942400000000001</cx:pt>
          <cx:pt idx="487">3.0722499999999999</cx:pt>
          <cx:pt idx="488">2.8727100000000001</cx:pt>
          <cx:pt idx="489">2.5005000000000002</cx:pt>
          <cx:pt idx="490">2.6201300000000001</cx:pt>
          <cx:pt idx="491">3.7818900000000002</cx:pt>
          <cx:pt idx="492">2.0377299999999998</cx:pt>
          <cx:pt idx="493">2.4138999999999999</cx:pt>
          <cx:pt idx="494">2.47336</cx:pt>
          <cx:pt idx="495">1.8804000000000001</cx:pt>
          <cx:pt idx="496">2.3295300000000001</cx:pt>
          <cx:pt idx="497">3.3625500000000001</cx:pt>
          <cx:pt idx="498">3.0209100000000002</cx:pt>
          <cx:pt idx="499">2.0948500000000001</cx:pt>
          <cx:pt idx="500">2.07707</cx:pt>
          <cx:pt idx="501">3.41858</cx:pt>
          <cx:pt idx="502">1.88148</cx:pt>
          <cx:pt idx="503">2.35093</cx:pt>
          <cx:pt idx="504">2.3645399999999999</cx:pt>
          <cx:pt idx="505">3.0291000000000001</cx:pt>
          <cx:pt idx="506">2.8819499999999998</cx:pt>
          <cx:pt idx="507">2.72729</cx:pt>
          <cx:pt idx="508">2.6201300000000001</cx:pt>
          <cx:pt idx="509">2.47729</cx:pt>
          <cx:pt idx="510">2.6201300000000001</cx:pt>
          <cx:pt idx="511">2.93425</cx:pt>
          <cx:pt idx="512">2.6582300000000001</cx:pt>
          <cx:pt idx="513">3.13469</cx:pt>
          <cx:pt idx="514">2.82213</cx:pt>
          <cx:pt idx="515">4.3865299999999996</cx:pt>
          <cx:pt idx="516">2.8104200000000001</cx:pt>
          <cx:pt idx="517">2.8059099999999999</cx:pt>
          <cx:pt idx="518">2.3075600000000001</cx:pt>
          <cx:pt idx="519">4.3364399999999996</cx:pt>
          <cx:pt idx="520">4.1595500000000003</cx:pt>
          <cx:pt idx="521">2.0374699999999999</cx:pt>
          <cx:pt idx="522">2.17848</cx:pt>
          <cx:pt idx="523">2.6201300000000001</cx:pt>
          <cx:pt idx="524">2.8329</cx:pt>
          <cx:pt idx="525">2.0675500000000002</cx:pt>
          <cx:pt idx="526">1.8255699999999999</cx:pt>
          <cx:pt idx="527">2.3978100000000002</cx:pt>
          <cx:pt idx="528">3.1904499999999998</cx:pt>
          <cx:pt idx="529">3.5978599999999998</cx:pt>
          <cx:pt idx="530">4.45608</cx:pt>
          <cx:pt idx="531">2.50684</cx:pt>
          <cx:pt idx="532">3.8656899999999998</cx:pt>
          <cx:pt idx="533">3.2216300000000002</cx:pt>
          <cx:pt idx="534">2.7860299999999998</cx:pt>
          <cx:pt idx="535">3.4920900000000001</cx:pt>
          <cx:pt idx="536">2.4894500000000002</cx:pt>
          <cx:pt idx="537">2.4971000000000001</cx:pt>
          <cx:pt idx="538">1.6722300000000001</cx:pt>
          <cx:pt idx="539">3.5821299999999998</cx:pt>
          <cx:pt idx="540">2.0328499999999998</cx:pt>
          <cx:pt idx="541">3.92475</cx:pt>
          <cx:pt idx="542">2.5043600000000001</cx:pt>
          <cx:pt idx="543">2.5496500000000002</cx:pt>
          <cx:pt idx="544">2.8140100000000001</cx:pt>
          <cx:pt idx="545">2.4120699999999999</cx:pt>
          <cx:pt idx="546">2.95282</cx:pt>
          <cx:pt idx="547">2.2193900000000002</cx:pt>
          <cx:pt idx="548">3.464</cx:pt>
          <cx:pt idx="549">2.8955700000000002</cx:pt>
          <cx:pt idx="550">2.02806</cx:pt>
          <cx:pt idx="551">2.7195399999999998</cx:pt>
          <cx:pt idx="552">2.5244300000000002</cx:pt>
          <cx:pt idx="553">3.6289899999999999</cx:pt>
          <cx:pt idx="554">2.5250499999999998</cx:pt>
          <cx:pt idx="555">3.4770099999999999</cx:pt>
          <cx:pt idx="556">3.0264700000000002</cx:pt>
          <cx:pt idx="557">3.2389199999999998</cx:pt>
          <cx:pt idx="558">2.2996500000000002</cx:pt>
          <cx:pt idx="559">3.56623</cx:pt>
          <cx:pt idx="560">2.2440699999999998</cx:pt>
          <cx:pt idx="561">2.83778</cx:pt>
          <cx:pt idx="562">2.8713600000000001</cx:pt>
          <cx:pt idx="563">3.4439299999999999</cx:pt>
          <cx:pt idx="564">2.5560999999999998</cx:pt>
          <cx:pt idx="565">2.2792500000000002</cx:pt>
          <cx:pt idx="566">2.7103299999999999</cx:pt>
          <cx:pt idx="567">1.84301</cx:pt>
          <cx:pt idx="568">2.2341799999999998</cx:pt>
          <cx:pt idx="569">2.7705000000000002</cx:pt>
          <cx:pt idx="570">2.07029</cx:pt>
          <cx:pt idx="571">3.87182</cx:pt>
          <cx:pt idx="572">3.2442899999999999</cx:pt>
          <cx:pt idx="573">2.8286199999999999</cx:pt>
          <cx:pt idx="574">2.1951299999999998</cx:pt>
          <cx:pt idx="575">3.0720100000000001</cx:pt>
          <cx:pt idx="576">3.63354</cx:pt>
          <cx:pt idx="577">2.8317100000000002</cx:pt>
          <cx:pt idx="578">2.8668</cx:pt>
          <cx:pt idx="579">2.5152199999999998</cx:pt>
          <cx:pt idx="580">2.71441</cx:pt>
          <cx:pt idx="581">2.46719</cx:pt>
          <cx:pt idx="582">2.7941099999999999</cx:pt>
          <cx:pt idx="583">2.0840100000000001</cx:pt>
          <cx:pt idx="584">4.61144</cx:pt>
          <cx:pt idx="585">2.3695499999999998</cx:pt>
          <cx:pt idx="586">3.5141300000000002</cx:pt>
          <cx:pt idx="587">4.5857099999999997</cx:pt>
          <cx:pt idx="588">1.66499</cx:pt>
          <cx:pt idx="589">2.6280800000000002</cx:pt>
          <cx:pt idx="590">2.0657899999999998</cx:pt>
          <cx:pt idx="591">2.5977800000000002</cx:pt>
          <cx:pt idx="592">2.8673299999999999</cx:pt>
          <cx:pt idx="593">3.7509399999999999</cx:pt>
          <cx:pt idx="594">3.12033</cx:pt>
          <cx:pt idx="595">3.1675499999999999</cx:pt>
          <cx:pt idx="596">2.34903</cx:pt>
          <cx:pt idx="597">2.3372600000000001</cx:pt>
          <cx:pt idx="598">2.8293699999999999</cx:pt>
          <cx:pt idx="599">3.4081600000000001</cx:pt>
          <cx:pt idx="600">1.9256599999999999</cx:pt>
          <cx:pt idx="601">4.0778999999999996</cx:pt>
          <cx:pt idx="602">3.9889000000000001</cx:pt>
          <cx:pt idx="603">4.7316599999999998</cx:pt>
          <cx:pt idx="604">2.1965599999999998</cx:pt>
          <cx:pt idx="605">4.0817600000000001</cx:pt>
          <cx:pt idx="606">2.1685099999999999</cx:pt>
          <cx:pt idx="607">2.61246</cx:pt>
          <cx:pt idx="608">2.77197</cx:pt>
          <cx:pt idx="609">2.7918500000000002</cx:pt>
          <cx:pt idx="610">1.7815399999999999</cx:pt>
          <cx:pt idx="611">2.5511300000000001</cx:pt>
          <cx:pt idx="612">3.7099799999999998</cx:pt>
          <cx:pt idx="613">3.7990499999999998</cx:pt>
          <cx:pt idx="614">3.0636899999999998</cx:pt>
          <cx:pt idx="615">3.9579599999999999</cx:pt>
          <cx:pt idx="616">1.9681</cx:pt>
          <cx:pt idx="617">2.16594</cx:pt>
          <cx:pt idx="618">3.5091199999999998</cx:pt>
          <cx:pt idx="619">2.1688999999999998</cx:pt>
          <cx:pt idx="620">3.2418300000000002</cx:pt>
          <cx:pt idx="621">3.5612300000000001</cx:pt>
          <cx:pt idx="622">1.8044199999999999</cx:pt>
          <cx:pt idx="623">4.2923299999999998</cx:pt>
          <cx:pt idx="624">2.7344499999999998</cx:pt>
          <cx:pt idx="625">4.1197100000000004</cx:pt>
          <cx:pt idx="626">2.2597900000000002</cx:pt>
          <cx:pt idx="627">2.5990899999999999</cx:pt>
          <cx:pt idx="628">2.0690400000000002</cx:pt>
          <cx:pt idx="629">3.1650700000000001</cx:pt>
          <cx:pt idx="630">4.3754400000000002</cx:pt>
          <cx:pt idx="631">3.0963500000000002</cx:pt>
          <cx:pt idx="632">2.0482300000000002</cx:pt>
          <cx:pt idx="633">2.1131899999999999</cx:pt>
          <cx:pt idx="634">2.4731700000000001</cx:pt>
          <cx:pt idx="635">5.3379200000000004</cx:pt>
          <cx:pt idx="636">2.02983</cx:pt>
          <cx:pt idx="637">2.5844399999999998</cx:pt>
          <cx:pt idx="638">3.3083900000000002</cx:pt>
          <cx:pt idx="639">3.77502</cx:pt>
          <cx:pt idx="640">1.9437800000000001</cx:pt>
          <cx:pt idx="641">3.8597800000000002</cx:pt>
          <cx:pt idx="642">2.39317</cx:pt>
          <cx:pt idx="643">1.81924</cx:pt>
          <cx:pt idx="644">2.8694700000000002</cx:pt>
          <cx:pt idx="645">2.7960799999999999</cx:pt>
          <cx:pt idx="646">2.0042300000000002</cx:pt>
          <cx:pt idx="647">2.6013799999999998</cx:pt>
          <cx:pt idx="648">2.7538800000000001</cx:pt>
          <cx:pt idx="649">3.6225399999999999</cx:pt>
          <cx:pt idx="650">2.4013599999999999</cx:pt>
          <cx:pt idx="651">2.6426500000000002</cx:pt>
          <cx:pt idx="652">4.3241699999999996</cx:pt>
          <cx:pt idx="653">1.6414899999999999</cx:pt>
          <cx:pt idx="654">2.4222000000000001</cx:pt>
          <cx:pt idx="655">2.4841899999999999</cx:pt>
          <cx:pt idx="656">2.45465</cx:pt>
          <cx:pt idx="657">2.5716199999999998</cx:pt>
          <cx:pt idx="658">3.0304500000000001</cx:pt>
          <cx:pt idx="659">4.1103800000000001</cx:pt>
          <cx:pt idx="660">2.79617</cx:pt>
          <cx:pt idx="661">2.8554300000000001</cx:pt>
          <cx:pt idx="662">2.1776900000000001</cx:pt>
          <cx:pt idx="663">1.95218</cx:pt>
          <cx:pt idx="664">2.3044099999999998</cx:pt>
          <cx:pt idx="665">2.5586700000000002</cx:pt>
          <cx:pt idx="666">3.4375100000000001</cx:pt>
          <cx:pt idx="667">3.5590000000000002</cx:pt>
          <cx:pt idx="668">3.2983799999999999</cx:pt>
          <cx:pt idx="669">3.9233799999999999</cx:pt>
          <cx:pt idx="670">3.6104400000000001</cx:pt>
          <cx:pt idx="671">2.08982</cx:pt>
          <cx:pt idx="672">1.9535100000000001</cx:pt>
          <cx:pt idx="673">2.6201300000000001</cx:pt>
          <cx:pt idx="674">3.0565899999999999</cx:pt>
          <cx:pt idx="675">2.74213</cx:pt>
          <cx:pt idx="676">2.7294399999999999</cx:pt>
          <cx:pt idx="677">1.8057700000000001</cx:pt>
          <cx:pt idx="678">2.6201300000000001</cx:pt>
          <cx:pt idx="679">4.1481700000000004</cx:pt>
          <cx:pt idx="680">2.0270000000000001</cx:pt>
          <cx:pt idx="681">1.89219</cx:pt>
          <cx:pt idx="682">2.05104</cx:pt>
          <cx:pt idx="683">1.6997500000000001</cx:pt>
          <cx:pt idx="684">4.3378399999999999</cx:pt>
          <cx:pt idx="685">3.19428</cx:pt>
          <cx:pt idx="686">3.0725699999999998</cx:pt>
          <cx:pt idx="687">2.6201300000000001</cx:pt>
          <cx:pt idx="688">2.6881300000000001</cx:pt>
          <cx:pt idx="689">1.9447099999999999</cx:pt>
          <cx:pt idx="690">2.42937</cx:pt>
          <cx:pt idx="691">3.4099699999999999</cx:pt>
          <cx:pt idx="692">1.96523</cx:pt>
          <cx:pt idx="693">3.3293200000000001</cx:pt>
          <cx:pt idx="694">3.6284000000000001</cx:pt>
          <cx:pt idx="695">2.4053900000000001</cx:pt>
          <cx:pt idx="696">2.5924800000000001</cx:pt>
          <cx:pt idx="697">3.5177800000000001</cx:pt>
          <cx:pt idx="698">1.8631599999999999</cx:pt>
          <cx:pt idx="699">3.8389099999999998</cx:pt>
          <cx:pt idx="700">2.8323800000000001</cx:pt>
          <cx:pt idx="701">2.26891</cx:pt>
          <cx:pt idx="702">4.7020600000000004</cx:pt>
          <cx:pt idx="703">2.04176</cx:pt>
          <cx:pt idx="704">2.1114999999999999</cx:pt>
          <cx:pt idx="705">1.61313</cx:pt>
          <cx:pt idx="706">2.6201300000000001</cx:pt>
          <cx:pt idx="707">2.6201300000000001</cx:pt>
          <cx:pt idx="708">2.0845600000000002</cx:pt>
          <cx:pt idx="709">3.6557400000000002</cx:pt>
          <cx:pt idx="710">2.6201300000000001</cx:pt>
          <cx:pt idx="711">2.6201300000000001</cx:pt>
          <cx:pt idx="712">3.0407999999999999</cx:pt>
          <cx:pt idx="713">2.5983800000000001</cx:pt>
          <cx:pt idx="714">4.38598</cx:pt>
          <cx:pt idx="715">2.9512100000000001</cx:pt>
          <cx:pt idx="716">2.7545899999999999</cx:pt>
          <cx:pt idx="717">3.6643500000000002</cx:pt>
          <cx:pt idx="718">1.86216</cx:pt>
          <cx:pt idx="719">2.8459300000000001</cx:pt>
          <cx:pt idx="720">4.4558499999999999</cx:pt>
          <cx:pt idx="721">1.89113</cx:pt>
          <cx:pt idx="722">2.5994600000000001</cx:pt>
          <cx:pt idx="723">4.0533900000000003</cx:pt>
          <cx:pt idx="724">2.5078100000000001</cx:pt>
          <cx:pt idx="725">4.0355699999999999</cx:pt>
          <cx:pt idx="726">2.4956800000000001</cx:pt>
          <cx:pt idx="727">3.33725</cx:pt>
          <cx:pt idx="728">3.4851000000000001</cx:pt>
          <cx:pt idx="729">2.28762</cx:pt>
          <cx:pt idx="730">2.9434900000000002</cx:pt>
          <cx:pt idx="731">2.2740399999999998</cx:pt>
          <cx:pt idx="732">2.7601100000000001</cx:pt>
          <cx:pt idx="733">3.1777899999999999</cx:pt>
          <cx:pt idx="734">2.6097600000000001</cx:pt>
          <cx:pt idx="735">1.97004</cx:pt>
          <cx:pt idx="736">2.7117100000000001</cx:pt>
          <cx:pt idx="737">2.09633</cx:pt>
          <cx:pt idx="738">2.6201300000000001</cx:pt>
          <cx:pt idx="739">1.7047000000000001</cx:pt>
          <cx:pt idx="740">2.17239</cx:pt>
          <cx:pt idx="741">2.4806599999999999</cx:pt>
          <cx:pt idx="742">4.8037400000000003</cx:pt>
          <cx:pt idx="743">2.6392600000000002</cx:pt>
          <cx:pt idx="744">3.85432</cx:pt>
          <cx:pt idx="745">2.9353199999999999</cx:pt>
          <cx:pt idx="746">2.14018</cx:pt>
          <cx:pt idx="747">4.0369099999999998</cx:pt>
          <cx:pt idx="748">2.4737200000000001</cx:pt>
          <cx:pt idx="749">2.18573</cx:pt>
          <cx:pt idx="750">2.4072</cx:pt>
          <cx:pt idx="751">2.9093300000000002</cx:pt>
          <cx:pt idx="752">1.9625300000000001</cx:pt>
          <cx:pt idx="753">3.0971799999999998</cx:pt>
          <cx:pt idx="754">4.0590200000000003</cx:pt>
          <cx:pt idx="755">2.8347099999999998</cx:pt>
          <cx:pt idx="756">3.5181</cx:pt>
          <cx:pt idx="757">2.7483</cx:pt>
          <cx:pt idx="758">4.0114799999999997</cx:pt>
          <cx:pt idx="759">3.3351099999999998</cx:pt>
          <cx:pt idx="760">2.6600799999999998</cx:pt>
          <cx:pt idx="761">4.8259699999999999</cx:pt>
          <cx:pt idx="762">3.4527999999999999</cx:pt>
          <cx:pt idx="763">2.5324300000000002</cx:pt>
          <cx:pt idx="764">1.9934700000000001</cx:pt>
          <cx:pt idx="765">2.6638299999999999</cx:pt>
          <cx:pt idx="766">2.6201300000000001</cx:pt>
          <cx:pt idx="767">1.74579</cx:pt>
          <cx:pt idx="768">2.78301</cx:pt>
          <cx:pt idx="769">1.8837299999999999</cx:pt>
          <cx:pt idx="770">2.45601</cx:pt>
          <cx:pt idx="771">2.1950400000000001</cx:pt>
          <cx:pt idx="772">2.6201300000000001</cx:pt>
          <cx:pt idx="773">2.4659200000000001</cx:pt>
          <cx:pt idx="774">2.2183799999999998</cx:pt>
          <cx:pt idx="775">2.2925599999999999</cx:pt>
          <cx:pt idx="776">2.8193000000000001</cx:pt>
          <cx:pt idx="777">2.9488400000000001</cx:pt>
          <cx:pt idx="778">1.9642500000000001</cx:pt>
          <cx:pt idx="779">3.01071</cx:pt>
          <cx:pt idx="780">2.5745100000000001</cx:pt>
          <cx:pt idx="781">2.5647199999999999</cx:pt>
          <cx:pt idx="782">1.70956</cx:pt>
          <cx:pt idx="783">3.08894</cx:pt>
          <cx:pt idx="784">3.92042</cx:pt>
          <cx:pt idx="785">2.69069</cx:pt>
          <cx:pt idx="786">3.9306100000000002</cx:pt>
          <cx:pt idx="787">3.6151300000000002</cx:pt>
          <cx:pt idx="788">4.3136400000000004</cx:pt>
          <cx:pt idx="789">3.21888</cx:pt>
          <cx:pt idx="790">2.4969399999999999</cx:pt>
          <cx:pt idx="791">2.88348</cx:pt>
          <cx:pt idx="792">2.76607</cx:pt>
          <cx:pt idx="793">2.6960099999999998</cx:pt>
          <cx:pt idx="794">3.4548700000000001</cx:pt>
          <cx:pt idx="795">2.6201300000000001</cx:pt>
          <cx:pt idx="796">3.4016799999999998</cx:pt>
          <cx:pt idx="797">2.6973199999999999</cx:pt>
          <cx:pt idx="798">2.0688</cx:pt>
          <cx:pt idx="799">2.18092</cx:pt>
          <cx:pt idx="800">2.5427900000000001</cx:pt>
          <cx:pt idx="801">2.6659299999999999</cx:pt>
          <cx:pt idx="802">3.6954099999999999</cx:pt>
          <cx:pt idx="803">3.1791800000000001</cx:pt>
          <cx:pt idx="804">4.1032799999999998</cx:pt>
          <cx:pt idx="805">3.5661800000000001</cx:pt>
          <cx:pt idx="806">3.2261299999999999</cx:pt>
          <cx:pt idx="807">2.00346</cx:pt>
          <cx:pt idx="808">2.5175399999999999</cx:pt>
          <cx:pt idx="809">2.0434100000000002</cx:pt>
          <cx:pt idx="810">3.58907</cx:pt>
          <cx:pt idx="811">4.0203699999999998</cx:pt>
          <cx:pt idx="812">2.5218600000000002</cx:pt>
          <cx:pt idx="813">2.0356200000000002</cx:pt>
          <cx:pt idx="814">2.96393</cx:pt>
          <cx:pt idx="815">2.0533100000000002</cx:pt>
          <cx:pt idx="816">2.0103200000000001</cx:pt>
          <cx:pt idx="817">2.5211600000000001</cx:pt>
          <cx:pt idx="818">3.5146700000000002</cx:pt>
          <cx:pt idx="819">2.9493299999999998</cx:pt>
          <cx:pt idx="820">3.1078399999999999</cx:pt>
          <cx:pt idx="821">4.1469100000000001</cx:pt>
          <cx:pt idx="822">2.77691</cx:pt>
          <cx:pt idx="823">3.5096500000000002</cx:pt>
          <cx:pt idx="824">2.2559</cx:pt>
          <cx:pt idx="825">2.8142399999999999</cx:pt>
          <cx:pt idx="826">3.35832</cx:pt>
          <cx:pt idx="827">2.7002799999999998</cx:pt>
          <cx:pt idx="828">2.7559300000000002</cx:pt>
          <cx:pt idx="829">2.6201300000000001</cx:pt>
          <cx:pt idx="830">1.9847600000000001</cx:pt>
          <cx:pt idx="831">2.54617</cx:pt>
          <cx:pt idx="832">2.33832</cx:pt>
          <cx:pt idx="833">2.8773</cx:pt>
          <cx:pt idx="834">2.1326999999999998</cx:pt>
          <cx:pt idx="835">3.5664400000000001</cx:pt>
          <cx:pt idx="836">4.0006199999999996</cx:pt>
          <cx:pt idx="837">2.0354000000000001</cx:pt>
          <cx:pt idx="838">2.3670300000000002</cx:pt>
          <cx:pt idx="839">2.9290400000000001</cx:pt>
          <cx:pt idx="840">2.3586800000000001</cx:pt>
          <cx:pt idx="841">2.7946499999999999</cx:pt>
          <cx:pt idx="842">2.6201300000000001</cx:pt>
          <cx:pt idx="843">3.0126300000000001</cx:pt>
          <cx:pt idx="844">3.5832700000000002</cx:pt>
          <cx:pt idx="845">3.9168400000000001</cx:pt>
          <cx:pt idx="846">1.9396599999999999</cx:pt>
          <cx:pt idx="847">2.2004199999999998</cx:pt>
          <cx:pt idx="848">2.9299900000000001</cx:pt>
          <cx:pt idx="849">3.60947</cx:pt>
          <cx:pt idx="850">3.06724</cx:pt>
          <cx:pt idx="851">4.2817400000000001</cx:pt>
          <cx:pt idx="852">2.5164200000000001</cx:pt>
          <cx:pt idx="853">1.8140499999999999</cx:pt>
          <cx:pt idx="854">2.6220599999999998</cx:pt>
          <cx:pt idx="855">2.59761</cx:pt>
          <cx:pt idx="856">3.3567900000000002</cx:pt>
          <cx:pt idx="857">2.96922</cx:pt>
          <cx:pt idx="858">3.3021199999999999</cx:pt>
          <cx:pt idx="859">2.8713199999999999</cx:pt>
          <cx:pt idx="860">2.6201300000000001</cx:pt>
          <cx:pt idx="861">2.6177600000000001</cx:pt>
          <cx:pt idx="862">3.4197500000000001</cx:pt>
          <cx:pt idx="863">3.5284200000000001</cx:pt>
          <cx:pt idx="864">2.63429</cx:pt>
          <cx:pt idx="865">4.6114800000000002</cx:pt>
          <cx:pt idx="866">3.4818899999999999</cx:pt>
          <cx:pt idx="867">2.6325400000000001</cx:pt>
          <cx:pt idx="868">3.4729700000000001</cx:pt>
          <cx:pt idx="869">2.4283000000000001</cx:pt>
          <cx:pt idx="870">1.8979999999999999</cx:pt>
          <cx:pt idx="871">2.1044399999999999</cx:pt>
          <cx:pt idx="872">4.0009600000000001</cx:pt>
          <cx:pt idx="873">2.84558</cx:pt>
          <cx:pt idx="874">3.3226300000000002</cx:pt>
          <cx:pt idx="875">3.2015600000000002</cx:pt>
          <cx:pt idx="876">2.1234199999999999</cx:pt>
          <cx:pt idx="877">2.35907</cx:pt>
          <cx:pt idx="878">1.7261</cx:pt>
          <cx:pt idx="879">2.7598099999999999</cx:pt>
          <cx:pt idx="880">3.9066399999999999</cx:pt>
          <cx:pt idx="881">1.7470000000000001</cx:pt>
          <cx:pt idx="882">2.0554800000000002</cx:pt>
          <cx:pt idx="883">1.8663099999999999</cx:pt>
          <cx:pt idx="884">4.0382600000000002</cx:pt>
          <cx:pt idx="885">1.98271</cx:pt>
          <cx:pt idx="886">2.65082</cx:pt>
          <cx:pt idx="887">2.9436800000000001</cx:pt>
          <cx:pt idx="888">3.0879699999999999</cx:pt>
          <cx:pt idx="889">2.0023599999999999</cx:pt>
          <cx:pt idx="890">2.7386200000000001</cx:pt>
          <cx:pt idx="891">2.6992400000000001</cx:pt>
          <cx:pt idx="892">2.1084999999999998</cx:pt>
          <cx:pt idx="893">2.6201300000000001</cx:pt>
          <cx:pt idx="894">1.8239700000000001</cx:pt>
          <cx:pt idx="895">2.5192299999999999</cx:pt>
          <cx:pt idx="896">2.6201300000000001</cx:pt>
          <cx:pt idx="897">4.4186699999999997</cx:pt>
          <cx:pt idx="898">2.47797</cx:pt>
          <cx:pt idx="899">3.7565200000000001</cx:pt>
          <cx:pt idx="900">2.1822400000000002</cx:pt>
          <cx:pt idx="901">3.8786100000000001</cx:pt>
          <cx:pt idx="902">2.2513700000000001</cx:pt>
          <cx:pt idx="903">2.6187299999999998</cx:pt>
          <cx:pt idx="904">4.4376100000000003</cx:pt>
          <cx:pt idx="905">3.90218</cx:pt>
          <cx:pt idx="906">3.0657100000000002</cx:pt>
          <cx:pt idx="907">3.5841599999999998</cx:pt>
          <cx:pt idx="908">4.5785299999999998</cx:pt>
          <cx:pt idx="909">3.2461099999999998</cx:pt>
          <cx:pt idx="910">2.2709100000000002</cx:pt>
          <cx:pt idx="911">3.69963</cx:pt>
          <cx:pt idx="912">2.61666</cx:pt>
          <cx:pt idx="913">3.0050500000000002</cx:pt>
          <cx:pt idx="914">2.0246400000000002</cx:pt>
          <cx:pt idx="915">2.9395199999999999</cx:pt>
          <cx:pt idx="916">2.48048</cx:pt>
          <cx:pt idx="917">2.2147299999999999</cx:pt>
          <cx:pt idx="918">1.9488000000000001</cx:pt>
          <cx:pt idx="919">2.4458500000000001</cx:pt>
          <cx:pt idx="920">1.6838599999999999</cx:pt>
          <cx:pt idx="921">2.5902099999999999</cx:pt>
          <cx:pt idx="922">2.7836099999999999</cx:pt>
          <cx:pt idx="923">2.71584</cx:pt>
          <cx:pt idx="924">2.61077</cx:pt>
          <cx:pt idx="925">2.2183700000000002</cx:pt>
          <cx:pt idx="926">1.85714</cx:pt>
          <cx:pt idx="927">2.6913900000000002</cx:pt>
          <cx:pt idx="928">3.4567800000000002</cx:pt>
          <cx:pt idx="929">1.7537100000000001</cx:pt>
          <cx:pt idx="930">3.5665300000000002</cx:pt>
          <cx:pt idx="931">1.6613800000000001</cx:pt>
          <cx:pt idx="932">2.4081000000000001</cx:pt>
          <cx:pt idx="933">4.4123799999999997</cx:pt>
          <cx:pt idx="934">1.77458</cx:pt>
          <cx:pt idx="935">4.2282200000000003</cx:pt>
          <cx:pt idx="936">1.8872500000000001</cx:pt>
          <cx:pt idx="937">3.8833799999999998</cx:pt>
          <cx:pt idx="938">3.17456</cx:pt>
          <cx:pt idx="939">3.0642100000000001</cx:pt>
          <cx:pt idx="940">3.5179</cx:pt>
          <cx:pt idx="941">1.8675200000000001</cx:pt>
          <cx:pt idx="942">3.0470999999999999</cx:pt>
          <cx:pt idx="943">4.0872099999999998</cx:pt>
          <cx:pt idx="944">2.0952799999999998</cx:pt>
          <cx:pt idx="945">2.9085100000000002</cx:pt>
          <cx:pt idx="946">3.2075399999999998</cx:pt>
          <cx:pt idx="947">2.5745300000000002</cx:pt>
          <cx:pt idx="948">2.0701100000000001</cx:pt>
          <cx:pt idx="949">4.8346400000000003</cx:pt>
          <cx:pt idx="950">2.7959100000000001</cx:pt>
          <cx:pt idx="951">3.4202900000000001</cx:pt>
          <cx:pt idx="952">2.9025500000000002</cx:pt>
          <cx:pt idx="953">1.9358299999999999</cx:pt>
          <cx:pt idx="954">2.1794099999999998</cx:pt>
          <cx:pt idx="955">3.1945100000000002</cx:pt>
          <cx:pt idx="956">2.8704900000000002</cx:pt>
          <cx:pt idx="957">2.5674700000000001</cx:pt>
          <cx:pt idx="958">2.84355</cx:pt>
          <cx:pt idx="959">2.35521</cx:pt>
          <cx:pt idx="960">2.2860999999999998</cx:pt>
          <cx:pt idx="961">1.8819600000000001</cx:pt>
          <cx:pt idx="962">3.47559</cx:pt>
          <cx:pt idx="963">3.3507400000000001</cx:pt>
          <cx:pt idx="964">2.9767399999999999</cx:pt>
          <cx:pt idx="965">2.6201300000000001</cx:pt>
          <cx:pt idx="966">3.17848</cx:pt>
          <cx:pt idx="967">1.7226300000000001</cx:pt>
          <cx:pt idx="968">2.6506799999999999</cx:pt>
          <cx:pt idx="969">2.02887</cx:pt>
          <cx:pt idx="970">4.32843</cx:pt>
          <cx:pt idx="971">2.05532</cx:pt>
          <cx:pt idx="972">3.8968799999999999</cx:pt>
          <cx:pt idx="973">3.5392399999999999</cx:pt>
          <cx:pt idx="974">3.9400900000000001</cx:pt>
          <cx:pt idx="975">2.7798799999999999</cx:pt>
          <cx:pt idx="976">2.0173299999999998</cx:pt>
          <cx:pt idx="977">2.0834600000000001</cx:pt>
          <cx:pt idx="978">3.6762899999999998</cx:pt>
          <cx:pt idx="979">2.31474</cx:pt>
          <cx:pt idx="980">2.6201300000000001</cx:pt>
          <cx:pt idx="981">2.64994</cx:pt>
          <cx:pt idx="982">2.44042</cx:pt>
          <cx:pt idx="983">2.6825399999999999</cx:pt>
          <cx:pt idx="984">2.2726299999999999</cx:pt>
          <cx:pt idx="985">2.2035300000000002</cx:pt>
          <cx:pt idx="986">2.9295100000000001</cx:pt>
          <cx:pt idx="987">3.8618800000000002</cx:pt>
          <cx:pt idx="988">2.0976300000000001</cx:pt>
          <cx:pt idx="989">2.2642500000000001</cx:pt>
          <cx:pt idx="990">2.18764</cx:pt>
          <cx:pt idx="991">2.0200499999999999</cx:pt>
          <cx:pt idx="992">2.2439900000000002</cx:pt>
          <cx:pt idx="993">2.6201300000000001</cx:pt>
          <cx:pt idx="994">1.8835500000000001</cx:pt>
          <cx:pt idx="995">3.2699699999999998</cx:pt>
          <cx:pt idx="996">3.9491200000000002</cx:pt>
          <cx:pt idx="997">2.1090399999999998</cx:pt>
          <cx:pt idx="998">2.7436699999999998</cx:pt>
          <cx:pt idx="999">3.6367400000000001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sz="12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200" b="0" i="0" u="none" strike="noStrike" baseline="0" dirty="0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12</a:t>
            </a:r>
            <a:endParaRPr lang="ja-JP" altLang="en-US" sz="1200" b="0" i="0" u="none" strike="noStrike" baseline="0" dirty="0">
              <a:solidFill>
                <a:sysClr val="windowText" lastClr="000000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cx:rich>
      </cx:tx>
    </cx:title>
    <cx:plotArea>
      <cx:plotAreaRegion>
        <cx:series layoutId="clusteredColumn" uniqueId="{53D7E983-9C3A-4840-92FB-52C905A18756}">
          <cx:tx>
            <cx:txData>
              <cx:f>PK!$E$1</cx:f>
              <cx:v>tvK12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Count val="15"/>
            </cx:binning>
          </cx:layoutPr>
        </cx:series>
      </cx:plotAreaRegion>
      <cx:axis id="0">
        <cx:catScaling gapWidth="0"/>
        <cx:tickLabels/>
        <cx:numFmt formatCode="#,##0.0_);[赤](#,##0.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4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PK!$F$2:$F$1001</cx:f>
        <cx:lvl ptCount="1000" formatCode="G/標準">
          <cx:pt idx="0">0.79609099999999999</cx:pt>
          <cx:pt idx="1">0.79585300000000003</cx:pt>
          <cx:pt idx="2">0.80516100000000002</cx:pt>
          <cx:pt idx="3">1.00911</cx:pt>
          <cx:pt idx="4">1.2702</cx:pt>
          <cx:pt idx="5">0.79760299999999995</cx:pt>
          <cx:pt idx="6">1.0422100000000001</cx:pt>
          <cx:pt idx="7">1.35714</cx:pt>
          <cx:pt idx="8">1.46363</cx:pt>
          <cx:pt idx="9">1.0491600000000001</cx:pt>
          <cx:pt idx="10">1.1743600000000001</cx:pt>
          <cx:pt idx="11">1.30559</cx:pt>
          <cx:pt idx="12">1.2579400000000001</cx:pt>
          <cx:pt idx="13">1.81535</cx:pt>
          <cx:pt idx="14">1.0761400000000001</cx:pt>
          <cx:pt idx="15">0.95799400000000001</cx:pt>
          <cx:pt idx="16">1.06846</cx:pt>
          <cx:pt idx="17">1.0653300000000001</cx:pt>
          <cx:pt idx="18">1.1223099999999999</cx:pt>
          <cx:pt idx="19">0.815469</cx:pt>
          <cx:pt idx="20">1.29894</cx:pt>
          <cx:pt idx="21">0.87864799999999998</cx:pt>
          <cx:pt idx="22">0.45056099999999999</cx:pt>
          <cx:pt idx="23">1.2382299999999999</cx:pt>
          <cx:pt idx="24">0.41397299999999998</cx:pt>
          <cx:pt idx="25">0.88164600000000004</cx:pt>
          <cx:pt idx="26">1.06846</cx:pt>
          <cx:pt idx="27">0.76977200000000001</cx:pt>
          <cx:pt idx="28">0.78137500000000004</cx:pt>
          <cx:pt idx="29">0.84431199999999995</cx:pt>
          <cx:pt idx="30">0.97012699999999996</cx:pt>
          <cx:pt idx="31">1.0411900000000001</cx:pt>
          <cx:pt idx="32">0.51700800000000002</cx:pt>
          <cx:pt idx="33">1.7237899999999999</cx:pt>
          <cx:pt idx="34">1.06846</cx:pt>
          <cx:pt idx="35">1.06846</cx:pt>
          <cx:pt idx="36">1.31515</cx:pt>
          <cx:pt idx="37">1.26298</cx:pt>
          <cx:pt idx="38">1.04565</cx:pt>
          <cx:pt idx="39">1.10429</cx:pt>
          <cx:pt idx="40">0.61387000000000003</cx:pt>
          <cx:pt idx="41">0.85729699999999998</cx:pt>
          <cx:pt idx="42">1.1061000000000001</cx:pt>
          <cx:pt idx="43">0.55409299999999995</cx:pt>
          <cx:pt idx="44">0.75362600000000002</cx:pt>
          <cx:pt idx="45">0.91323299999999996</cx:pt>
          <cx:pt idx="46">1.19815</cx:pt>
          <cx:pt idx="47">1.5090300000000001</cx:pt>
          <cx:pt idx="48">1.0436300000000001</cx:pt>
          <cx:pt idx="49">1.28674</cx:pt>
          <cx:pt idx="50">0.993479</cx:pt>
          <cx:pt idx="51">0.69720300000000002</cx:pt>
          <cx:pt idx="52">0.79995799999999995</cx:pt>
          <cx:pt idx="53">0.54333699999999996</cx:pt>
          <cx:pt idx="54">1.14846</cx:pt>
          <cx:pt idx="55">1.0104200000000001</cx:pt>
          <cx:pt idx="56">1.02843</cx:pt>
          <cx:pt idx="57">0.750753</cx:pt>
          <cx:pt idx="58">0.98476799999999998</cx:pt>
          <cx:pt idx="59">0.58893399999999996</cx:pt>
          <cx:pt idx="60">1.12636</cx:pt>
          <cx:pt idx="61">1.35301</cx:pt>
          <cx:pt idx="62">1.87768</cx:pt>
          <cx:pt idx="63">1.7902899999999999</cx:pt>
          <cx:pt idx="64">1.05507</cx:pt>
          <cx:pt idx="65">1.0395799999999999</cx:pt>
          <cx:pt idx="66">0.73738400000000004</cx:pt>
          <cx:pt idx="67">1.1200600000000001</cx:pt>
          <cx:pt idx="68">1.0176400000000001</cx:pt>
          <cx:pt idx="69">1.0452999999999999</cx:pt>
          <cx:pt idx="70">1.2002999999999999</cx:pt>
          <cx:pt idx="71">1.23184</cx:pt>
          <cx:pt idx="72">0.80709200000000003</cx:pt>
          <cx:pt idx="73">1.1205400000000001</cx:pt>
          <cx:pt idx="74">0.96112299999999995</cx:pt>
          <cx:pt idx="75">0.97274099999999997</cx:pt>
          <cx:pt idx="76">1.0103599999999999</cx:pt>
          <cx:pt idx="77">1.0329600000000001</cx:pt>
          <cx:pt idx="78">1.35141</cx:pt>
          <cx:pt idx="79">1.2884500000000001</cx:pt>
          <cx:pt idx="80">1.39133</cx:pt>
          <cx:pt idx="81">1.4866999999999999</cx:pt>
          <cx:pt idx="82">1.06846</cx:pt>
          <cx:pt idx="83">1.3117799999999999</cx:pt>
          <cx:pt idx="84">1.5250600000000001</cx:pt>
          <cx:pt idx="85">1.20932</cx:pt>
          <cx:pt idx="86">1.1059699999999999</cx:pt>
          <cx:pt idx="87">1.63215</cx:pt>
          <cx:pt idx="88">0.96889800000000004</cx:pt>
          <cx:pt idx="89">1.8774999999999999</cx:pt>
          <cx:pt idx="90">0.68334700000000004</cx:pt>
          <cx:pt idx="91">0.61058299999999999</cx:pt>
          <cx:pt idx="92">1.0154300000000001</cx:pt>
          <cx:pt idx="93">1.44276</cx:pt>
          <cx:pt idx="94">1.1534800000000001</cx:pt>
          <cx:pt idx="95">1.6869000000000001</cx:pt>
          <cx:pt idx="96">1.2994600000000001</cx:pt>
          <cx:pt idx="97">0.80494600000000005</cx:pt>
          <cx:pt idx="98">0.52732199999999996</cx:pt>
          <cx:pt idx="99">1.06846</cx:pt>
          <cx:pt idx="100">1.1313800000000001</cx:pt>
          <cx:pt idx="101">1.06846</cx:pt>
          <cx:pt idx="102">1.06846</cx:pt>
          <cx:pt idx="103">0.58248</cx:pt>
          <cx:pt idx="104">0.80636699999999994</cx:pt>
          <cx:pt idx="105">1.5467900000000001</cx:pt>
          <cx:pt idx="106">0.838426</cx:pt>
          <cx:pt idx="107">1.42621</cx:pt>
          <cx:pt idx="108">1.5868800000000001</cx:pt>
          <cx:pt idx="109">0.68619300000000005</cx:pt>
          <cx:pt idx="110">1.14669</cx:pt>
          <cx:pt idx="111">1.10121</cx:pt>
          <cx:pt idx="112">1.0733699999999999</cx:pt>
          <cx:pt idx="113">1.04545</cx:pt>
          <cx:pt idx="114">0.86881699999999995</cx:pt>
          <cx:pt idx="115">1.0924499999999999</cx:pt>
          <cx:pt idx="116">1.0700700000000001</cx:pt>
          <cx:pt idx="117">1.7091000000000001</cx:pt>
          <cx:pt idx="118">1.06846</cx:pt>
          <cx:pt idx="119">0.94415700000000002</cx:pt>
          <cx:pt idx="120">0.864761</cx:pt>
          <cx:pt idx="121">1.25183</cx:pt>
          <cx:pt idx="122">0.78305199999999997</cx:pt>
          <cx:pt idx="123">0.92861099999999996</cx:pt>
          <cx:pt idx="124">1.5005299999999999</cx:pt>
          <cx:pt idx="125">1.38774</cx:pt>
          <cx:pt idx="126">1.3330200000000001</cx:pt>
          <cx:pt idx="127">0.82154400000000005</cx:pt>
          <cx:pt idx="128">1.23889</cx:pt>
          <cx:pt idx="129">0.87956699999999999</cx:pt>
          <cx:pt idx="130">1.0329900000000001</cx:pt>
          <cx:pt idx="131">1.5924799999999999</cx:pt>
          <cx:pt idx="132">0.93111900000000003</cx:pt>
          <cx:pt idx="133">1.1242700000000001</cx:pt>
          <cx:pt idx="134">1.0476300000000001</cx:pt>
          <cx:pt idx="135">0.92285700000000004</cx:pt>
          <cx:pt idx="136">1.06846</cx:pt>
          <cx:pt idx="137">0.62868299999999999</cx:pt>
          <cx:pt idx="138">1.14398</cx:pt>
          <cx:pt idx="139">0.947295</cx:pt>
          <cx:pt idx="140">0.74328399999999994</cx:pt>
          <cx:pt idx="141">0.98287400000000003</cx:pt>
          <cx:pt idx="142">1.28485</cx:pt>
          <cx:pt idx="143">1.05671</cx:pt>
          <cx:pt idx="144">0.58400200000000002</cx:pt>
          <cx:pt idx="145">1.06846</cx:pt>
          <cx:pt idx="146">1.1753199999999999</cx:pt>
          <cx:pt idx="147">0.83950000000000002</cx:pt>
          <cx:pt idx="148">0.99544500000000002</cx:pt>
          <cx:pt idx="149">0.95006100000000004</cx:pt>
          <cx:pt idx="150">0.99887000000000004</cx:pt>
          <cx:pt idx="151">0.98923000000000005</cx:pt>
          <cx:pt idx="152">0.75427</cx:pt>
          <cx:pt idx="153">0.94413599999999998</cx:pt>
          <cx:pt idx="154">0.898258</cx:pt>
          <cx:pt idx="155">1.5075400000000001</cx:pt>
          <cx:pt idx="156">1.2867299999999999</cx:pt>
          <cx:pt idx="157">0.688724</cx:pt>
          <cx:pt idx="158">1.39463</cx:pt>
          <cx:pt idx="159">1.4489300000000001</cx:pt>
          <cx:pt idx="160">1.27366</cx:pt>
          <cx:pt idx="161">0.55313100000000004</cx:pt>
          <cx:pt idx="162">0.90011799999999997</cx:pt>
          <cx:pt idx="163">1.0825400000000001</cx:pt>
          <cx:pt idx="164">1.66835</cx:pt>
          <cx:pt idx="165">0.70161499999999999</cx:pt>
          <cx:pt idx="166">0.34739999999999999</cx:pt>
          <cx:pt idx="167">1.4885699999999999</cx:pt>
          <cx:pt idx="168">0.72431599999999996</cx:pt>
          <cx:pt idx="169">0.95144700000000004</cx:pt>
          <cx:pt idx="170">1.34284</cx:pt>
          <cx:pt idx="171">0.91441799999999995</cx:pt>
          <cx:pt idx="172">1.3225899999999999</cx:pt>
          <cx:pt idx="173">1.0161800000000001</cx:pt>
          <cx:pt idx="174">1.2148099999999999</cx:pt>
          <cx:pt idx="175">1.0577000000000001</cx:pt>
          <cx:pt idx="176">1.46224</cx:pt>
          <cx:pt idx="177">1.07734</cx:pt>
          <cx:pt idx="178">1.02658</cx:pt>
          <cx:pt idx="179">1.2938400000000001</cx:pt>
          <cx:pt idx="180">0.83459899999999998</cx:pt>
          <cx:pt idx="181">0.94812300000000005</cx:pt>
          <cx:pt idx="182">1.5186900000000001</cx:pt>
          <cx:pt idx="183">0.87654100000000001</cx:pt>
          <cx:pt idx="184">1.58975</cx:pt>
          <cx:pt idx="185">1.4502299999999999</cx:pt>
          <cx:pt idx="186">0.69534799999999997</cx:pt>
          <cx:pt idx="187">0.91634800000000005</cx:pt>
          <cx:pt idx="188">0.82499</cx:pt>
          <cx:pt idx="189">0.94164400000000004</cx:pt>
          <cx:pt idx="190">1.06846</cx:pt>
          <cx:pt idx="191">1.3413600000000001</cx:pt>
          <cx:pt idx="192">1.3970899999999999</cx:pt>
          <cx:pt idx="193">1.1780900000000001</cx:pt>
          <cx:pt idx="194">0.82806299999999999</cx:pt>
          <cx:pt idx="195">0.39933400000000002</cx:pt>
          <cx:pt idx="196">0.79381599999999997</cx:pt>
          <cx:pt idx="197">0.52189099999999999</cx:pt>
          <cx:pt idx="198">0.86675100000000005</cx:pt>
          <cx:pt idx="199">0.97484000000000004</cx:pt>
          <cx:pt idx="200">1.5611900000000001</cx:pt>
          <cx:pt idx="201">1.06687</cx:pt>
          <cx:pt idx="202">0.97452000000000005</cx:pt>
          <cx:pt idx="203">0.96349700000000005</cx:pt>
          <cx:pt idx="204">1.1097399999999999</cx:pt>
          <cx:pt idx="205">0.739317</cx:pt>
          <cx:pt idx="206">1.72319</cx:pt>
          <cx:pt idx="207">0.94063699999999995</cx:pt>
          <cx:pt idx="208">1.1352599999999999</cx:pt>
          <cx:pt idx="209">1.4967900000000001</cx:pt>
          <cx:pt idx="210">0.32303500000000002</cx:pt>
          <cx:pt idx="211">1.1966399999999999</cx:pt>
          <cx:pt idx="212">1.1840900000000001</cx:pt>
          <cx:pt idx="213">0.91379999999999995</cx:pt>
          <cx:pt idx="214">1.38452</cx:pt>
          <cx:pt idx="215">1.2054400000000001</cx:pt>
          <cx:pt idx="216">0.86572700000000002</cx:pt>
          <cx:pt idx="217">1.1628499999999999</cx:pt>
          <cx:pt idx="218">0.57331900000000002</cx:pt>
          <cx:pt idx="219">1.2857799999999999</cx:pt>
          <cx:pt idx="220">1.1974499999999999</cx:pt>
          <cx:pt idx="221">1.02545</cx:pt>
          <cx:pt idx="222">1.9129799999999999</cx:pt>
          <cx:pt idx="223">1.1266</cx:pt>
          <cx:pt idx="224">0.76241499999999995</cx:pt>
          <cx:pt idx="225">1.0749500000000001</cx:pt>
          <cx:pt idx="226">0.98801499999999998</cx:pt>
          <cx:pt idx="227">1.2863500000000001</cx:pt>
          <cx:pt idx="228">1.06846</cx:pt>
          <cx:pt idx="229">1.1089899999999999</cx:pt>
          <cx:pt idx="230">1.0209600000000001</cx:pt>
          <cx:pt idx="231">1.1161700000000001</cx:pt>
          <cx:pt idx="232">1.0285</cx:pt>
          <cx:pt idx="233">0.64863099999999996</cx:pt>
          <cx:pt idx="234">0.65526300000000004</cx:pt>
          <cx:pt idx="235">0.985738</cx:pt>
          <cx:pt idx="236">1.4297599999999999</cx:pt>
          <cx:pt idx="237">1.3188899999999999</cx:pt>
          <cx:pt idx="238">0.98460599999999998</cx:pt>
          <cx:pt idx="239">0.92431099999999999</cx:pt>
          <cx:pt idx="240">1.08748</cx:pt>
          <cx:pt idx="241">1.0638000000000001</cx:pt>
          <cx:pt idx="242">1.02111</cx:pt>
          <cx:pt idx="243">1.21513</cx:pt>
          <cx:pt idx="244">1.24108</cx:pt>
          <cx:pt idx="245">0.88605299999999998</cx:pt>
          <cx:pt idx="246">1.0454600000000001</cx:pt>
          <cx:pt idx="247">1.06846</cx:pt>
          <cx:pt idx="248">0.94198599999999999</cx:pt>
          <cx:pt idx="249">1.04935</cx:pt>
          <cx:pt idx="250">1.31626</cx:pt>
          <cx:pt idx="251">1.0953999999999999</cx:pt>
          <cx:pt idx="252">1.0472600000000001</cx:pt>
          <cx:pt idx="253">1.09348</cx:pt>
          <cx:pt idx="254">0.949739</cx:pt>
          <cx:pt idx="255">0.98542300000000005</cx:pt>
          <cx:pt idx="256">1.23244</cx:pt>
          <cx:pt idx="257">1.0054799999999999</cx:pt>
          <cx:pt idx="258">1.20248</cx:pt>
          <cx:pt idx="259">1.1025400000000001</cx:pt>
          <cx:pt idx="260">1.1842999999999999</cx:pt>
          <cx:pt idx="261">1.22332</cx:pt>
          <cx:pt idx="262">1.1652499999999999</cx:pt>
          <cx:pt idx="263">1.03772</cx:pt>
          <cx:pt idx="264">1.22363</cx:pt>
          <cx:pt idx="265">1.03698</cx:pt>
          <cx:pt idx="266">1.59402</cx:pt>
          <cx:pt idx="267">0.95379400000000003</cx:pt>
          <cx:pt idx="268">1.7779400000000001</cx:pt>
          <cx:pt idx="269">1.06846</cx:pt>
          <cx:pt idx="270">1.11107</cx:pt>
          <cx:pt idx="271">0.80571999999999999</cx:pt>
          <cx:pt idx="272">0.51798500000000003</cx:pt>
          <cx:pt idx="273">1.4670799999999999</cx:pt>
          <cx:pt idx="274">0.79143600000000003</cx:pt>
          <cx:pt idx="275">1.03989</cx:pt>
          <cx:pt idx="276">1.43618</cx:pt>
          <cx:pt idx="277">1.0480100000000001</cx:pt>
          <cx:pt idx="278">1.95041</cx:pt>
          <cx:pt idx="279">1.0670900000000001</cx:pt>
          <cx:pt idx="280">1.3877299999999999</cx:pt>
          <cx:pt idx="281">1.2890600000000001</cx:pt>
          <cx:pt idx="282">0.71543400000000001</cx:pt>
          <cx:pt idx="283">0.74593299999999996</cx:pt>
          <cx:pt idx="284">0.65222199999999997</cx:pt>
          <cx:pt idx="285">1.06846</cx:pt>
          <cx:pt idx="286">1.0582400000000001</cx:pt>
          <cx:pt idx="287">0.80995700000000004</cx:pt>
          <cx:pt idx="288">1.3836599999999999</cx:pt>
          <cx:pt idx="289">0.98880400000000002</cx:pt>
          <cx:pt idx="290">0.29799700000000001</cx:pt>
          <cx:pt idx="291">1.06846</cx:pt>
          <cx:pt idx="292">1.03416</cx:pt>
          <cx:pt idx="293">0.79552599999999996</cx:pt>
          <cx:pt idx="294">1.4111800000000001</cx:pt>
          <cx:pt idx="295">1.24613</cx:pt>
          <cx:pt idx="296">1.21241</cx:pt>
          <cx:pt idx="297">0.88234599999999996</cx:pt>
          <cx:pt idx="298">1.0778300000000001</cx:pt>
          <cx:pt idx="299">0.86580299999999999</cx:pt>
          <cx:pt idx="300">0.79975700000000005</cx:pt>
          <cx:pt idx="301">1.4320900000000001</cx:pt>
          <cx:pt idx="302">1.0102500000000001</cx:pt>
          <cx:pt idx="303">1.1234299999999999</cx:pt>
          <cx:pt idx="304">1.06846</cx:pt>
          <cx:pt idx="305">1.3496600000000001</cx:pt>
          <cx:pt idx="306">1.0545</cx:pt>
          <cx:pt idx="307">0.30965900000000002</cx:pt>
          <cx:pt idx="308">0.39276899999999998</cx:pt>
          <cx:pt idx="309">1.06846</cx:pt>
          <cx:pt idx="310">0.88821099999999997</cx:pt>
          <cx:pt idx="311">1.232</cx:pt>
          <cx:pt idx="312">0.99746699999999999</cx:pt>
          <cx:pt idx="313">0.90523500000000001</cx:pt>
          <cx:pt idx="314">1.1996599999999999</cx:pt>
          <cx:pt idx="315">0.96712399999999998</cx:pt>
          <cx:pt idx="316">0.675095</cx:pt>
          <cx:pt idx="317">0.94192299999999995</cx:pt>
          <cx:pt idx="318">1.29542</cx:pt>
          <cx:pt idx="319">1.11103</cx:pt>
          <cx:pt idx="320">1.1114900000000001</cx:pt>
          <cx:pt idx="321">1.17171</cx:pt>
          <cx:pt idx="322">0.56550500000000004</cx:pt>
          <cx:pt idx="323">1.0243100000000001</cx:pt>
          <cx:pt idx="324">1.1567700000000001</cx:pt>
          <cx:pt idx="325">1.15876</cx:pt>
          <cx:pt idx="326">0.76853000000000005</cx:pt>
          <cx:pt idx="327">1.1540999999999999</cx:pt>
          <cx:pt idx="328">0.953345</cx:pt>
          <cx:pt idx="329">0.78125599999999995</cx:pt>
          <cx:pt idx="330">1.27806</cx:pt>
          <cx:pt idx="331">0.72658900000000004</cx:pt>
          <cx:pt idx="332">1.2537199999999999</cx:pt>
          <cx:pt idx="333">1.1609499999999999</cx:pt>
          <cx:pt idx="334">0.89607700000000001</cx:pt>
          <cx:pt idx="335">0.92808500000000005</cx:pt>
          <cx:pt idx="336">0.745749</cx:pt>
          <cx:pt idx="337">0.35253800000000002</cx:pt>
          <cx:pt idx="338">0.72434200000000004</cx:pt>
          <cx:pt idx="339">1.05809</cx:pt>
          <cx:pt idx="340">0.99411499999999997</cx:pt>
          <cx:pt idx="341">0.71401700000000001</cx:pt>
          <cx:pt idx="342">0.97097800000000001</cx:pt>
          <cx:pt idx="343">0.76601200000000003</cx:pt>
          <cx:pt idx="344">0.81977</cx:pt>
          <cx:pt idx="345">0.74892800000000004</cx:pt>
          <cx:pt idx="346">1.09812</cx:pt>
          <cx:pt idx="347">1.05982</cx:pt>
          <cx:pt idx="348">0.48246499999999998</cx:pt>
          <cx:pt idx="349">1.5044599999999999</cx:pt>
          <cx:pt idx="350">1.5159899999999999</cx:pt>
          <cx:pt idx="351">0.92528100000000002</cx:pt>
          <cx:pt idx="352">0.92023200000000005</cx:pt>
          <cx:pt idx="353">1.4243600000000001</cx:pt>
          <cx:pt idx="354">0.78716299999999995</cx:pt>
          <cx:pt idx="355">1.3627100000000001</cx:pt>
          <cx:pt idx="356">1.5960700000000001</cx:pt>
          <cx:pt idx="357">0.89256899999999995</cx:pt>
          <cx:pt idx="358">1.0115099999999999</cx:pt>
          <cx:pt idx="359">1.36216</cx:pt>
          <cx:pt idx="360">0.90068199999999998</cx:pt>
          <cx:pt idx="361">0.97341</cx:pt>
          <cx:pt idx="362">1.15768</cx:pt>
          <cx:pt idx="363">1.06846</cx:pt>
          <cx:pt idx="364">1.10914</cx:pt>
          <cx:pt idx="365">0.69322499999999998</cx:pt>
          <cx:pt idx="366">1.2877700000000001</cx:pt>
          <cx:pt idx="367">1.2398899999999999</cx:pt>
          <cx:pt idx="368">1.0192699999999999</cx:pt>
          <cx:pt idx="369">1.06846</cx:pt>
          <cx:pt idx="370">0.72441299999999997</cx:pt>
          <cx:pt idx="371">0.65511299999999995</cx:pt>
          <cx:pt idx="372">0.84501400000000004</cx:pt>
          <cx:pt idx="373">0.63941999999999999</cx:pt>
          <cx:pt idx="374">1.37809</cx:pt>
          <cx:pt idx="375">0.64082600000000001</cx:pt>
          <cx:pt idx="376">1.06846</cx:pt>
          <cx:pt idx="377">1.2275799999999999</cx:pt>
          <cx:pt idx="378">1.0140100000000001</cx:pt>
          <cx:pt idx="379">1.06846</cx:pt>
          <cx:pt idx="380">1.2608299999999999</cx:pt>
          <cx:pt idx="381">0.97138800000000003</cx:pt>
          <cx:pt idx="382">1.01488</cx:pt>
          <cx:pt idx="383">0.88065199999999999</cx:pt>
          <cx:pt idx="384">1.0617700000000001</cx:pt>
          <cx:pt idx="385">0.94779199999999997</cx:pt>
          <cx:pt idx="386">1.26596</cx:pt>
          <cx:pt idx="387">0.98997000000000002</cx:pt>
          <cx:pt idx="388">0.88278500000000004</cx:pt>
          <cx:pt idx="389">1.1471899999999999</cx:pt>
          <cx:pt idx="390">1.64367</cx:pt>
          <cx:pt idx="391">0.91801500000000003</cx:pt>
          <cx:pt idx="392">1.2282200000000001</cx:pt>
          <cx:pt idx="393">1.0748800000000001</cx:pt>
          <cx:pt idx="394">1.06846</cx:pt>
          <cx:pt idx="395">1.40838</cx:pt>
          <cx:pt idx="396">1.09524</cx:pt>
          <cx:pt idx="397">0.74777199999999999</cx:pt>
          <cx:pt idx="398">1.1614800000000001</cx:pt>
          <cx:pt idx="399">1.24638</cx:pt>
          <cx:pt idx="400">1.4073100000000001</cx:pt>
          <cx:pt idx="401">1.06846</cx:pt>
          <cx:pt idx="402">0.74108700000000005</cx:pt>
          <cx:pt idx="403">1.1891</cx:pt>
          <cx:pt idx="404">1.13602</cx:pt>
          <cx:pt idx="405">1.6897899999999999</cx:pt>
          <cx:pt idx="406">0.81740000000000002</cx:pt>
          <cx:pt idx="407">0.94198599999999999</cx:pt>
          <cx:pt idx="408">1.3716900000000001</cx:pt>
          <cx:pt idx="409">0.76875700000000002</cx:pt>
          <cx:pt idx="410">1.0549299999999999</cx:pt>
          <cx:pt idx="411">0.84434699999999996</cx:pt>
          <cx:pt idx="412">1.4715400000000001</cx:pt>
          <cx:pt idx="413">1.40516</cx:pt>
          <cx:pt idx="414">1.5510999999999999</cx:pt>
          <cx:pt idx="415">1.53352</cx:pt>
          <cx:pt idx="416">0.75274600000000003</cx:pt>
          <cx:pt idx="417">1.07403</cx:pt>
          <cx:pt idx="418">1.1547499999999999</cx:pt>
          <cx:pt idx="419">1.7139</cx:pt>
          <cx:pt idx="420">0.92590600000000001</cx:pt>
          <cx:pt idx="421">1.22851</cx:pt>
          <cx:pt idx="422">1.07988</cx:pt>
          <cx:pt idx="423">1.2315400000000001</cx:pt>
          <cx:pt idx="424">1.0728899999999999</cx:pt>
          <cx:pt idx="425">0.93337599999999998</cx:pt>
          <cx:pt idx="426">1.1118399999999999</cx:pt>
          <cx:pt idx="427">1.04251</cx:pt>
          <cx:pt idx="428">1.3486800000000001</cx:pt>
          <cx:pt idx="429">1.2564599999999999</cx:pt>
          <cx:pt idx="430">0.89002099999999995</cx:pt>
          <cx:pt idx="431">1.49579</cx:pt>
          <cx:pt idx="432">1.06589</cx:pt>
          <cx:pt idx="433">1.1055200000000001</cx:pt>
          <cx:pt idx="434">1.0303500000000001</cx:pt>
          <cx:pt idx="435">0.81889800000000001</cx:pt>
          <cx:pt idx="436">1.21299</cx:pt>
          <cx:pt idx="437">0.78566999999999998</cx:pt>
          <cx:pt idx="438">1.0819099999999999</cx:pt>
          <cx:pt idx="439">1.1042400000000001</cx:pt>
          <cx:pt idx="440">1.0341800000000001</cx:pt>
          <cx:pt idx="441">1.0034700000000001</cx:pt>
          <cx:pt idx="442">0.968472</cx:pt>
          <cx:pt idx="443">1.06846</cx:pt>
          <cx:pt idx="444">1.5787599999999999</cx:pt>
          <cx:pt idx="445">0.47187800000000002</cx:pt>
          <cx:pt idx="446">1.01854</cx:pt>
          <cx:pt idx="447">1.3320000000000001</cx:pt>
          <cx:pt idx="448">1.8906099999999999</cx:pt>
          <cx:pt idx="449">1.1226</cx:pt>
          <cx:pt idx="450">1.0150300000000001</cx:pt>
          <cx:pt idx="451">1.1509</cx:pt>
          <cx:pt idx="452">0.97448900000000005</cx:pt>
          <cx:pt idx="453">1.52329</cx:pt>
          <cx:pt idx="454">1.1237600000000001</cx:pt>
          <cx:pt idx="455">0.93825199999999997</cx:pt>
          <cx:pt idx="456">0.86879300000000004</cx:pt>
          <cx:pt idx="457">1.3050299999999999</cx:pt>
          <cx:pt idx="458">1.3179000000000001</cx:pt>
          <cx:pt idx="459">0.64809399999999995</cx:pt>
          <cx:pt idx="460">0.77512000000000003</cx:pt>
          <cx:pt idx="461">0.91426200000000002</cx:pt>
          <cx:pt idx="462">1.33565</cx:pt>
          <cx:pt idx="463">1.42306</cx:pt>
          <cx:pt idx="464">0.95621699999999998</cx:pt>
          <cx:pt idx="465">1.0903</cx:pt>
          <cx:pt idx="466">1.0657300000000001</cx:pt>
          <cx:pt idx="467">0.70447199999999999</cx:pt>
          <cx:pt idx="468">1.0036400000000001</cx:pt>
          <cx:pt idx="469">1.0204299999999999</cx:pt>
          <cx:pt idx="470">0.90491200000000005</cx:pt>
          <cx:pt idx="471">1.05667</cx:pt>
          <cx:pt idx="472">0.91492300000000004</cx:pt>
          <cx:pt idx="473">1.4573799999999999</cx:pt>
          <cx:pt idx="474">0.87654200000000004</cx:pt>
          <cx:pt idx="475">1.0182800000000001</cx:pt>
          <cx:pt idx="476">1.1749799999999999</cx:pt>
          <cx:pt idx="477">0.92665900000000001</cx:pt>
          <cx:pt idx="478">1.3497600000000001</cx:pt>
          <cx:pt idx="479">1.1783399999999999</cx:pt>
          <cx:pt idx="480">1.0494300000000001</cx:pt>
          <cx:pt idx="481">1.03895</cx:pt>
          <cx:pt idx="482">0.89124599999999998</cx:pt>
          <cx:pt idx="483">0.93365299999999996</cx:pt>
          <cx:pt idx="484">1.06846</cx:pt>
          <cx:pt idx="485">0.94043699999999997</cx:pt>
          <cx:pt idx="486">1.5406500000000001</cx:pt>
          <cx:pt idx="487">0.85491300000000003</cx:pt>
          <cx:pt idx="488">1.23997</cx:pt>
          <cx:pt idx="489">1.28531</cx:pt>
          <cx:pt idx="490">1.06846</cx:pt>
          <cx:pt idx="491">1.46007</cx:pt>
          <cx:pt idx="492">1.0870299999999999</cx:pt>
          <cx:pt idx="493">0.88506499999999999</cx:pt>
          <cx:pt idx="494">1.0936300000000001</cx:pt>
          <cx:pt idx="495">1.4860599999999999</cx:pt>
          <cx:pt idx="496">1.0703499999999999</cx:pt>
          <cx:pt idx="497">1.50562</cx:pt>
          <cx:pt idx="498">0.78394900000000001</cx:pt>
          <cx:pt idx="499">0.98557300000000003</cx:pt>
          <cx:pt idx="500">0.82894900000000005</cx:pt>
          <cx:pt idx="501">1.1499999999999999</cx:pt>
          <cx:pt idx="502">1.6479999999999999</cx:pt>
          <cx:pt idx="503">1.1780999999999999</cx:pt>
          <cx:pt idx="504">0.75109700000000001</cx:pt>
          <cx:pt idx="505">0.74568000000000001</cx:pt>
          <cx:pt idx="506">0.89923600000000004</cx:pt>
          <cx:pt idx="507">0.88091799999999998</cx:pt>
          <cx:pt idx="508">1.06846</cx:pt>
          <cx:pt idx="509">1.95384</cx:pt>
          <cx:pt idx="510">1.06846</cx:pt>
          <cx:pt idx="511">1.87757</cx:pt>
          <cx:pt idx="512">1.4348799999999999</cx:pt>
          <cx:pt idx="513">0.80240299999999998</cx:pt>
          <cx:pt idx="514">0.83885500000000002</cx:pt>
          <cx:pt idx="515">1.1813899999999999</cx:pt>
          <cx:pt idx="516">0.88554900000000003</cx:pt>
          <cx:pt idx="517">0.73406700000000003</cx:pt>
          <cx:pt idx="518">1.5073099999999999</cx:pt>
          <cx:pt idx="519">0.73010799999999998</cx:pt>
          <cx:pt idx="520">0.36518</cx:pt>
          <cx:pt idx="521">1.0456399999999999</cx:pt>
          <cx:pt idx="522">1.0433600000000001</cx:pt>
          <cx:pt idx="523">1.06846</cx:pt>
          <cx:pt idx="524">0.71843900000000005</cx:pt>
          <cx:pt idx="525">1.51756</cx:pt>
          <cx:pt idx="526">1.28335</cx:pt>
          <cx:pt idx="527">1.0613999999999999</cx:pt>
          <cx:pt idx="528">1.2595400000000001</cx:pt>
          <cx:pt idx="529">1.0510299999999999</cx:pt>
          <cx:pt idx="530">1.3772599999999999</cx:pt>
          <cx:pt idx="531">0.76656999999999997</cx:pt>
          <cx:pt idx="532">1.1978200000000001</cx:pt>
          <cx:pt idx="533">0.86302400000000001</cx:pt>
          <cx:pt idx="534">1.14602</cx:pt>
          <cx:pt idx="535">1.60673</cx:pt>
          <cx:pt idx="536">1.18957</cx:pt>
          <cx:pt idx="537">1.20021</cx:pt>
          <cx:pt idx="538">1.1765399999999999</cx:pt>
          <cx:pt idx="539">0.84528099999999995</cx:pt>
          <cx:pt idx="540">1.0615300000000001</cx:pt>
          <cx:pt idx="541">0.36343799999999998</cx:pt>
          <cx:pt idx="542">1.17953</cx:pt>
          <cx:pt idx="543">0.85513600000000001</cx:pt>
          <cx:pt idx="544">1.2941400000000001</cx:pt>
          <cx:pt idx="545">1.1171899999999999</cx:pt>
          <cx:pt idx="546">0.85958100000000004</cx:pt>
          <cx:pt idx="547">1.1731</cx:pt>
          <cx:pt idx="548">1.46292</cx:pt>
          <cx:pt idx="549">1.08968</cx:pt>
          <cx:pt idx="550">0.86093799999999998</cx:pt>
          <cx:pt idx="551">1.17286</cx:pt>
          <cx:pt idx="552">1.5741099999999999</cx:pt>
          <cx:pt idx="553">1.35792</cx:pt>
          <cx:pt idx="554">0.77984399999999998</cx:pt>
          <cx:pt idx="555">0.846715</cx:pt>
          <cx:pt idx="556">1.0870200000000001</cx:pt>
          <cx:pt idx="557">0.52678999999999998</cx:pt>
          <cx:pt idx="558">1.28704</cx:pt>
          <cx:pt idx="559">1.2993600000000001</cx:pt>
          <cx:pt idx="560">1.0791900000000001</cx:pt>
          <cx:pt idx="561">1.0855399999999999</cx:pt>
          <cx:pt idx="562">0.64882700000000004</cx:pt>
          <cx:pt idx="563">0.80644499999999997</cx:pt>
          <cx:pt idx="564">0.929674</cx:pt>
          <cx:pt idx="565">1.2640899999999999</cx:pt>
          <cx:pt idx="566">0.86163699999999999</cx:pt>
          <cx:pt idx="567">0.81364499999999995</cx:pt>
          <cx:pt idx="568">1.19459</cx:pt>
          <cx:pt idx="569">1.23902</cx:pt>
          <cx:pt idx="570">1.5504100000000001</cx:pt>
          <cx:pt idx="571">1.1730799999999999</cx:pt>
          <cx:pt idx="572">1.0616099999999999</cx:pt>
          <cx:pt idx="573">0.59258699999999997</cx:pt>
          <cx:pt idx="574">1.4621999999999999</cx:pt>
          <cx:pt idx="575">0.87259399999999998</cx:pt>
          <cx:pt idx="576">0.56717499999999998</cx:pt>
          <cx:pt idx="577">1.3472200000000001</cx:pt>
          <cx:pt idx="578">0.75290900000000005</cx:pt>
          <cx:pt idx="579">1.4753499999999999</cx:pt>
          <cx:pt idx="580">0.83128199999999997</cx:pt>
          <cx:pt idx="581">1.3141799999999999</cx:pt>
          <cx:pt idx="582">1.1537299999999999</cx:pt>
          <cx:pt idx="583">1.1541300000000001</cx:pt>
          <cx:pt idx="584">0.78095999999999999</cx:pt>
          <cx:pt idx="585">0.81375900000000001</cx:pt>
          <cx:pt idx="586">1.5912900000000001</cx:pt>
          <cx:pt idx="587">0.33425100000000002</cx:pt>
          <cx:pt idx="588">1.0055700000000001</cx:pt>
          <cx:pt idx="589">1.67899</cx:pt>
          <cx:pt idx="590">1.0040100000000001</cx:pt>
          <cx:pt idx="591">0.93634200000000001</cx:pt>
          <cx:pt idx="592">0.91301100000000002</cx:pt>
          <cx:pt idx="593">0.93717399999999995</cx:pt>
          <cx:pt idx="594">0.94777100000000003</cx:pt>
          <cx:pt idx="595">0.571774</cx:pt>
          <cx:pt idx="596">0.91212099999999996</cx:pt>
          <cx:pt idx="597">1.47723</cx:pt>
          <cx:pt idx="598">0.95336500000000002</cx:pt>
          <cx:pt idx="599">1.1296900000000001</cx:pt>
          <cx:pt idx="600">1.0957399999999999</cx:pt>
          <cx:pt idx="601">0.72741100000000003</cx:pt>
          <cx:pt idx="602">1.06569</cx:pt>
          <cx:pt idx="603">1.3149900000000001</cx:pt>
          <cx:pt idx="604">0.979464</cx:pt>
          <cx:pt idx="605">1.0012000000000001</cx:pt>
          <cx:pt idx="606">0.79710999999999999</cx:pt>
          <cx:pt idx="607">1.18649</cx:pt>
          <cx:pt idx="608">0.81378399999999995</cx:pt>
          <cx:pt idx="609">0.85569200000000001</cx:pt>
          <cx:pt idx="610">0.76328399999999996</cx:pt>
          <cx:pt idx="611">1.5150999999999999</cx:pt>
          <cx:pt idx="612">1.04033</cx:pt>
          <cx:pt idx="613">1.3062800000000001</cx:pt>
          <cx:pt idx="614">0.93125899999999995</cx:pt>
          <cx:pt idx="615">0.65205599999999997</cx:pt>
          <cx:pt idx="616">1.2931299999999999</cx:pt>
          <cx:pt idx="617">1.06873</cx:pt>
          <cx:pt idx="618">0.79879999999999995</cx:pt>
          <cx:pt idx="619">0.96468600000000004</cx:pt>
          <cx:pt idx="620">1.2701499999999999</cx:pt>
          <cx:pt idx="621">1.4242999999999999</cx:pt>
          <cx:pt idx="622">1.1265499999999999</cx:pt>
          <cx:pt idx="623">0.91859400000000002</cx:pt>
          <cx:pt idx="624">0.96689599999999998</cx:pt>
          <cx:pt idx="625">0.46697</cx:pt>
          <cx:pt idx="626">0.750579</cx:pt>
          <cx:pt idx="627">0.76200000000000001</cx:pt>
          <cx:pt idx="628">1.15398</cx:pt>
          <cx:pt idx="629">0.9375</cx:pt>
          <cx:pt idx="630">0.38605</cx:pt>
          <cx:pt idx="631">1.75082</cx:pt>
          <cx:pt idx="632">1.1106199999999999</cx:pt>
          <cx:pt idx="633">1.0068600000000001</cx:pt>
          <cx:pt idx="634">1.0696300000000001</cx:pt>
          <cx:pt idx="635">1.86378</cx:pt>
          <cx:pt idx="636">1.1488799999999999</cx:pt>
          <cx:pt idx="637">1.0566599999999999</cx:pt>
          <cx:pt idx="638">0.901833</cx:pt>
          <cx:pt idx="639">0.73042499999999999</cx:pt>
          <cx:pt idx="640">1.21478</cx:pt>
          <cx:pt idx="641">0.67867299999999997</cx:pt>
          <cx:pt idx="642">1.2781100000000001</cx:pt>
          <cx:pt idx="643">0.83533400000000002</cx:pt>
          <cx:pt idx="644">0.86991399999999997</cx:pt>
          <cx:pt idx="645">1.4571000000000001</cx:pt>
          <cx:pt idx="646">1.1612</cx:pt>
          <cx:pt idx="647">0.93436399999999997</cx:pt>
          <cx:pt idx="648">0.73022100000000001</cx:pt>
          <cx:pt idx="649">1.0218700000000001</cx:pt>
          <cx:pt idx="650">0.93439000000000005</cx:pt>
          <cx:pt idx="651">1.00549</cx:pt>
          <cx:pt idx="652">1.05765</cx:pt>
          <cx:pt idx="653">1.06301</cx:pt>
          <cx:pt idx="654">1.153</cx:pt>
          <cx:pt idx="655">1.09212</cx:pt>
          <cx:pt idx="656">0.87372399999999995</cx:pt>
          <cx:pt idx="657">1.01475</cx:pt>
          <cx:pt idx="658">0.90361199999999997</cx:pt>
          <cx:pt idx="659">0.92927899999999997</cx:pt>
          <cx:pt idx="660">1.1979500000000001</cx:pt>
          <cx:pt idx="661">0.84415399999999996</cx:pt>
          <cx:pt idx="662">1.37687</cx:pt>
          <cx:pt idx="663">0.94026600000000005</cx:pt>
          <cx:pt idx="664">1.18899</cx:pt>
          <cx:pt idx="665">1.15995</cx:pt>
          <cx:pt idx="666">0.65365099999999998</cx:pt>
          <cx:pt idx="667">0.46566999999999997</cx:pt>
          <cx:pt idx="668">1.39882</cx:pt>
          <cx:pt idx="669">0.89823900000000001</cx:pt>
          <cx:pt idx="670">0.55971499999999996</cx:pt>
          <cx:pt idx="671">1.0062199999999999</cx:pt>
          <cx:pt idx="672">1.05711</cx:pt>
          <cx:pt idx="673">1.06846</cx:pt>
          <cx:pt idx="674">1.1070599999999999</cx:pt>
          <cx:pt idx="675">0.96297600000000005</cx:pt>
          <cx:pt idx="676">0.84929200000000005</cx:pt>
          <cx:pt idx="677">1.18743</cx:pt>
          <cx:pt idx="678">1.06846</cx:pt>
          <cx:pt idx="679">1.4633100000000001</cx:pt>
          <cx:pt idx="680">1.2302</cx:pt>
          <cx:pt idx="681">1.03003</cx:pt>
          <cx:pt idx="682">1.17675</cx:pt>
          <cx:pt idx="683">0.99228899999999998</cx:pt>
          <cx:pt idx="684">0.76320900000000003</cx:pt>
          <cx:pt idx="685">1.0446</cx:pt>
          <cx:pt idx="686">0.98613200000000001</cx:pt>
          <cx:pt idx="687">1.06846</cx:pt>
          <cx:pt idx="688">0.65985099999999997</cx:pt>
          <cx:pt idx="689">0.96132799999999996</cx:pt>
          <cx:pt idx="690">1.03379</cx:pt>
          <cx:pt idx="691">1.22367</cx:pt>
          <cx:pt idx="692">1.13226</cx:pt>
          <cx:pt idx="693">0.86217100000000002</cx:pt>
          <cx:pt idx="694">0.52976400000000001</cx:pt>
          <cx:pt idx="695">1.07473</cx:pt>
          <cx:pt idx="696">0.840387</cx:pt>
          <cx:pt idx="697">0.68482900000000002</cx:pt>
          <cx:pt idx="698">0.82408099999999995</cx:pt>
          <cx:pt idx="699">0.38736900000000002</cx:pt>
          <cx:pt idx="700">1.2897000000000001</cx:pt>
          <cx:pt idx="701">0.97704400000000002</cx:pt>
          <cx:pt idx="702">1.67154</cx:pt>
          <cx:pt idx="703">1.0407200000000001</cx:pt>
          <cx:pt idx="704">0.77607800000000005</cx:pt>
          <cx:pt idx="705">1.1296900000000001</cx:pt>
          <cx:pt idx="706">1.06846</cx:pt>
          <cx:pt idx="707">1.06846</cx:pt>
          <cx:pt idx="708">1.31345</cx:pt>
          <cx:pt idx="709">1.6264799999999999</cx:pt>
          <cx:pt idx="710">1.06846</cx:pt>
          <cx:pt idx="711">1.06846</cx:pt>
          <cx:pt idx="712">0.89754999999999996</cx:pt>
          <cx:pt idx="713">0.84074499999999996</cx:pt>
          <cx:pt idx="714">0.25207600000000002</cx:pt>
          <cx:pt idx="715">0.94282200000000005</cx:pt>
          <cx:pt idx="716">1.3658300000000001</cx:pt>
          <cx:pt idx="717">0.68623400000000001</cx:pt>
          <cx:pt idx="718">1.14818</cx:pt>
          <cx:pt idx="719">0.93037499999999995</cx:pt>
          <cx:pt idx="720">1.50793</cx:pt>
          <cx:pt idx="721">0.88558899999999996</cx:pt>
          <cx:pt idx="722">1.07168</cx:pt>
          <cx:pt idx="723">0.91692399999999996</cx:pt>
          <cx:pt idx="724">1.0648</cx:pt>
          <cx:pt idx="725">1.31341</cx:pt>
          <cx:pt idx="726">1.7319</cx:pt>
          <cx:pt idx="727">1.2533399999999999</cx:pt>
          <cx:pt idx="728">0.59993300000000005</cx:pt>
          <cx:pt idx="729">0.92198899999999995</cx:pt>
          <cx:pt idx="730">1.1712899999999999</cx:pt>
          <cx:pt idx="731">1.10446</cx:pt>
          <cx:pt idx="732">1.28426</cx:pt>
          <cx:pt idx="733">0.69095600000000001</cx:pt>
          <cx:pt idx="734">0.97163299999999997</cx:pt>
          <cx:pt idx="735">0.91281500000000004</cx:pt>
          <cx:pt idx="736">1.3138700000000001</cx:pt>
          <cx:pt idx="737">1.1959500000000001</cx:pt>
          <cx:pt idx="738">1.06846</cx:pt>
          <cx:pt idx="739">1.11582</cx:pt>
          <cx:pt idx="740">1.2817799999999999</cx:pt>
          <cx:pt idx="741">1.1569499999999999</cx:pt>
          <cx:pt idx="742">0.69934099999999999</cx:pt>
          <cx:pt idx="743">0.95299</cx:pt>
          <cx:pt idx="744">0.507382</cx:pt>
          <cx:pt idx="745">1.4032</cx:pt>
          <cx:pt idx="746">0.88014599999999998</cx:pt>
          <cx:pt idx="747">0.379747</cx:pt>
          <cx:pt idx="748">0.85662099999999997</cx:pt>
          <cx:pt idx="749">1.55379</cx:pt>
          <cx:pt idx="750">0.81884100000000004</cx:pt>
          <cx:pt idx="751">1.05644</cx:pt>
          <cx:pt idx="752">1.5014700000000001</cx:pt>
          <cx:pt idx="753">1.0528900000000001</cx:pt>
          <cx:pt idx="754">0.93054499999999996</cx:pt>
          <cx:pt idx="755">1.0157400000000001</cx:pt>
          <cx:pt idx="756">0.704434</cx:pt>
          <cx:pt idx="757">1.07125</cx:pt>
          <cx:pt idx="758">0.56672800000000001</cx:pt>
          <cx:pt idx="759">1.02905</cx:pt>
          <cx:pt idx="760">1.3742799999999999</cx:pt>
          <cx:pt idx="761">0.81074000000000002</cx:pt>
          <cx:pt idx="762">0.99565499999999996</cx:pt>
          <cx:pt idx="763">0.78992499999999999</cx:pt>
          <cx:pt idx="764">1.20625</cx:pt>
          <cx:pt idx="765">1.0641499999999999</cx:pt>
          <cx:pt idx="766">1.06846</cx:pt>
          <cx:pt idx="767">1.1684600000000001</cx:pt>
          <cx:pt idx="768">1.11429</cx:pt>
          <cx:pt idx="769">1.08511</cx:pt>
          <cx:pt idx="770">0.944739</cx:pt>
          <cx:pt idx="771">1.0167600000000001</cx:pt>
          <cx:pt idx="772">1.06846</cx:pt>
          <cx:pt idx="773">0.89701900000000001</cx:pt>
          <cx:pt idx="774">0.89549500000000004</cx:pt>
          <cx:pt idx="775">1.1583000000000001</cx:pt>
          <cx:pt idx="776">0.66681400000000002</cx:pt>
          <cx:pt idx="777">0.98480800000000002</cx:pt>
          <cx:pt idx="778">1.0965400000000001</cx:pt>
          <cx:pt idx="779">1.02379</cx:pt>
          <cx:pt idx="780">0.94704500000000003</cx:pt>
          <cx:pt idx="781">0.73511099999999996</cx:pt>
          <cx:pt idx="782">1.22651</cx:pt>
          <cx:pt idx="783">1.0186500000000001</cx:pt>
          <cx:pt idx="784">0.59171399999999996</cx:pt>
          <cx:pt idx="785">1.4326300000000001</cx:pt>
          <cx:pt idx="786">0.47689100000000001</cx:pt>
          <cx:pt idx="787">1.4609799999999999</cx:pt>
          <cx:pt idx="788">0.93894500000000003</cx:pt>
          <cx:pt idx="789">0.66047800000000001</cx:pt>
          <cx:pt idx="790">1.4402699999999999</cx:pt>
          <cx:pt idx="791">1.23421</cx:pt>
          <cx:pt idx="792">0.85354699999999994</cx:pt>
          <cx:pt idx="793">0.65947100000000003</cx:pt>
          <cx:pt idx="794">0.70267900000000005</cx:pt>
          <cx:pt idx="795">1.06846</cx:pt>
          <cx:pt idx="796">0.63597300000000001</cx:pt>
          <cx:pt idx="797">1.2948500000000001</cx:pt>
          <cx:pt idx="798">1.2137199999999999</cx:pt>
          <cx:pt idx="799">1.3204</cx:pt>
          <cx:pt idx="800">0.75419199999999997</cx:pt>
          <cx:pt idx="801">1.1046400000000001</cx:pt>
          <cx:pt idx="802">1.29243</cx:pt>
          <cx:pt idx="803">0.76963599999999999</cx:pt>
          <cx:pt idx="804">1.0193099999999999</cx:pt>
          <cx:pt idx="805">0.49446699999999999</cx:pt>
          <cx:pt idx="806">1.42967</cx:pt>
          <cx:pt idx="807">1.1265499999999999</cx:pt>
          <cx:pt idx="808">0.846414</cx:pt>
          <cx:pt idx="809">1.03633</cx:pt>
          <cx:pt idx="810">0.64901799999999998</cx:pt>
          <cx:pt idx="811">0.97374700000000003</cx:pt>
          <cx:pt idx="812">0.548813</cx:pt>
          <cx:pt idx="813">1.0991899999999999</cx:pt>
          <cx:pt idx="814">0.90850399999999998</cx:pt>
          <cx:pt idx="815">1.2914000000000001</cx:pt>
          <cx:pt idx="816">0.96755199999999997</cx:pt>
          <cx:pt idx="817">0.93137400000000004</cx:pt>
          <cx:pt idx="818">0.51085800000000003</cx:pt>
          <cx:pt idx="819">0.783049</cx:pt>
          <cx:pt idx="820">1.5066299999999999</cx:pt>
          <cx:pt idx="821">0.70328000000000002</cx:pt>
          <cx:pt idx="822">1.2490699999999999</cx:pt>
          <cx:pt idx="823">0.67640699999999998</cx:pt>
          <cx:pt idx="824">0.95302299999999995</cx:pt>
          <cx:pt idx="825">1.3061499999999999</cx:pt>
          <cx:pt idx="826">1.0359</cx:pt>
          <cx:pt idx="827">0.62689799999999996</cx:pt>
          <cx:pt idx="828">1.2033100000000001</cx:pt>
          <cx:pt idx="829">1.06846</cx:pt>
          <cx:pt idx="830">1.1042400000000001</cx:pt>
          <cx:pt idx="831">1.31978</cx:pt>
          <cx:pt idx="832">1.51519</cx:pt>
          <cx:pt idx="833">0.83793899999999999</cx:pt>
          <cx:pt idx="834">1.6051599999999999</cx:pt>
          <cx:pt idx="835">1.26898</cx:pt>
          <cx:pt idx="836">0.77142699999999997</cx:pt>
          <cx:pt idx="837">0.88031800000000004</cx:pt>
          <cx:pt idx="838">0.92816900000000002</cx:pt>
          <cx:pt idx="839">0.86458500000000005</cx:pt>
          <cx:pt idx="840">1.1981200000000001</cx:pt>
          <cx:pt idx="841">1.4094</cx:pt>
          <cx:pt idx="842">1.06846</cx:pt>
          <cx:pt idx="843">0.77195899999999995</cx:pt>
          <cx:pt idx="844">0.63577499999999998</cx:pt>
          <cx:pt idx="845">0.75702199999999997</cx:pt>
          <cx:pt idx="846">0.941415</cx:pt>
          <cx:pt idx="847">1.1577900000000001</cx:pt>
          <cx:pt idx="848">1.37087</cx:pt>
          <cx:pt idx="849">0.54693999999999998</cx:pt>
          <cx:pt idx="850">0.78928900000000002</cx:pt>
          <cx:pt idx="851">0.97003899999999998</cx:pt>
          <cx:pt idx="852">1.2780199999999999</cx:pt>
          <cx:pt idx="853">0.98586700000000005</cx:pt>
          <cx:pt idx="854">1.18222</cx:pt>
          <cx:pt idx="855">0.82569899999999996</cx:pt>
          <cx:pt idx="856">1.5435399999999999</cx:pt>
          <cx:pt idx="857">0.97215600000000002</cx:pt>
          <cx:pt idx="858">1.3823300000000001</cx:pt>
          <cx:pt idx="859">0.85278299999999996</cx:pt>
          <cx:pt idx="860">1.06846</cx:pt>
          <cx:pt idx="861">1.1059399999999999</cx:pt>
          <cx:pt idx="862">0.71047899999999997</cx:pt>
          <cx:pt idx="863">1.8923700000000001</cx:pt>
          <cx:pt idx="864">1.0744899999999999</cx:pt>
          <cx:pt idx="865">1.05698</cx:pt>
          <cx:pt idx="866">0.87985400000000002</cx:pt>
          <cx:pt idx="867">1.2028300000000001</cx:pt>
          <cx:pt idx="868">0.73642799999999997</cx:pt>
          <cx:pt idx="869">1.1528799999999999</cx:pt>
          <cx:pt idx="870">0.899478</cx:pt>
          <cx:pt idx="871">1.2199</cx:pt>
          <cx:pt idx="872">1.11893</cx:pt>
          <cx:pt idx="873">0.67264299999999999</cx:pt>
          <cx:pt idx="874">0.72329100000000002</cx:pt>
          <cx:pt idx="875">0.90638600000000002</cx:pt>
          <cx:pt idx="876">1.5572999999999999</cx:pt>
          <cx:pt idx="877">1.40734</cx:pt>
          <cx:pt idx="878">0.85300600000000004</cx:pt>
          <cx:pt idx="879">1.49678</cx:pt>
          <cx:pt idx="880">0.69791999999999998</cx:pt>
          <cx:pt idx="881">0.76967699999999994</cx:pt>
          <cx:pt idx="882">0.86589799999999995</cx:pt>
          <cx:pt idx="883">0.61263500000000004</cx:pt>
          <cx:pt idx="884">1.16292</cx:pt>
          <cx:pt idx="885">1.264</cx:pt>
          <cx:pt idx="886">0.75970499999999996</cx:pt>
          <cx:pt idx="887">1.15212</cx:pt>
          <cx:pt idx="888">0.70026699999999997</cx:pt>
          <cx:pt idx="889">1.12805</cx:pt>
          <cx:pt idx="890">1.63025</cx:pt>
          <cx:pt idx="891">0.90466400000000002</cx:pt>
          <cx:pt idx="892">1.3270299999999999</cx:pt>
          <cx:pt idx="893">1.06846</cx:pt>
          <cx:pt idx="894">1.45221</cx:pt>
          <cx:pt idx="895">1.5099800000000001</cx:pt>
          <cx:pt idx="896">1.06846</cx:pt>
          <cx:pt idx="897">1.0637799999999999</cx:pt>
          <cx:pt idx="898">0.89209700000000003</cx:pt>
          <cx:pt idx="899">0.981182</cx:pt>
          <cx:pt idx="900">1.4009499999999999</cx:pt>
          <cx:pt idx="901">0.56742700000000001</cx:pt>
          <cx:pt idx="902">1.2670399999999999</cx:pt>
          <cx:pt idx="903">0.79392099999999999</cx:pt>
          <cx:pt idx="904">1.5231300000000001</cx:pt>
          <cx:pt idx="905">0.74126400000000003</cx:pt>
          <cx:pt idx="906">0.67579199999999995</cx:pt>
          <cx:pt idx="907">0.76216200000000001</cx:pt>
          <cx:pt idx="908">1.05986</cx:pt>
          <cx:pt idx="909">1.2417899999999999</cx:pt>
          <cx:pt idx="910">1.12599</cx:pt>
          <cx:pt idx="911">1.6029199999999999</cx:pt>
          <cx:pt idx="912">1.06968</cx:pt>
          <cx:pt idx="913">1.05436</cx:pt>
          <cx:pt idx="914">1.08507</cx:pt>
          <cx:pt idx="915">0.93079699999999999</cx:pt>
          <cx:pt idx="916">1.23983</cx:pt>
          <cx:pt idx="917">1.00539</cx:pt>
          <cx:pt idx="918">1.2751399999999999</cx:pt>
          <cx:pt idx="919">1.1235599999999999</cx:pt>
          <cx:pt idx="920">1.18424</cx:pt>
          <cx:pt idx="921">1.5204</cx:pt>
          <cx:pt idx="922">1.00668</cx:pt>
          <cx:pt idx="923">0.69043600000000005</cx:pt>
          <cx:pt idx="924">1.2780800000000001</cx:pt>
          <cx:pt idx="925">1.2334099999999999</cx:pt>
          <cx:pt idx="926">1.0627</cx:pt>
          <cx:pt idx="927">1.75369</cx:pt>
          <cx:pt idx="928">1.1524099999999999</cx:pt>
          <cx:pt idx="929">1.3278399999999999</cx:pt>
          <cx:pt idx="930">1.30968</cx:pt>
          <cx:pt idx="931">1.16995</cx:pt>
          <cx:pt idx="932">1.07742</cx:pt>
          <cx:pt idx="933">1.12381</cx:pt>
          <cx:pt idx="934">1.04867</cx:pt>
          <cx:pt idx="935">1.5005200000000001</cx:pt>
          <cx:pt idx="936">0.89177700000000004</cx:pt>
          <cx:pt idx="937">1.02078</cx:pt>
          <cx:pt idx="938">1.3893500000000001</cx:pt>
          <cx:pt idx="939">0.70067400000000002</cx:pt>
          <cx:pt idx="940">1.4795100000000001</cx:pt>
          <cx:pt idx="941">0.93517499999999998</cx:pt>
          <cx:pt idx="942">0.94182200000000005</cx:pt>
          <cx:pt idx="943">1.8088599999999999</cx:pt>
          <cx:pt idx="944">1.1152599999999999</cx:pt>
          <cx:pt idx="945">1.5464</cx:pt>
          <cx:pt idx="946">1.2579800000000001</cx:pt>
          <cx:pt idx="947">1.37283</cx:pt>
          <cx:pt idx="948">1.29257</cx:pt>
          <cx:pt idx="949">0.37402800000000003</cx:pt>
          <cx:pt idx="950">1.3595299999999999</cx:pt>
          <cx:pt idx="951">1.05352</cx:pt>
          <cx:pt idx="952">1.2739499999999999</cx:pt>
          <cx:pt idx="953">1.09216</cx:pt>
          <cx:pt idx="954">1.2723899999999999</cx:pt>
          <cx:pt idx="955">1.4724299999999999</cx:pt>
          <cx:pt idx="956">1.1043000000000001</cx:pt>
          <cx:pt idx="957">0.98224900000000004</cx:pt>
          <cx:pt idx="958">0.678068</cx:pt>
          <cx:pt idx="959">1.24414</cx:pt>
          <cx:pt idx="960">1.3290299999999999</cx:pt>
          <cx:pt idx="961">1.23024</cx:pt>
          <cx:pt idx="962">1.1498699999999999</cx:pt>
          <cx:pt idx="963">0.92929499999999998</cx:pt>
          <cx:pt idx="964">0.75936400000000004</cx:pt>
          <cx:pt idx="965">1.06846</cx:pt>
          <cx:pt idx="966">0.80017099999999997</cx:pt>
          <cx:pt idx="967">0.83377100000000004</cx:pt>
          <cx:pt idx="968">1.2433000000000001</cx:pt>
          <cx:pt idx="969">1.0406299999999999</cx:pt>
          <cx:pt idx="970">0.996645</cx:pt>
          <cx:pt idx="971">0.90658899999999998</cx:pt>
          <cx:pt idx="972">0.84930300000000003</cx:pt>
          <cx:pt idx="973">0.95565599999999995</cx:pt>
          <cx:pt idx="974">1.0033700000000001</cx:pt>
          <cx:pt idx="975">1.2661100000000001</cx:pt>
          <cx:pt idx="976">1.1344099999999999</cx:pt>
          <cx:pt idx="977">1.1734800000000001</cx:pt>
          <cx:pt idx="978">0.66011799999999998</cx:pt>
          <cx:pt idx="979">1.0822400000000001</cx:pt>
          <cx:pt idx="980">1.06846</cx:pt>
          <cx:pt idx="981">1.0135099999999999</cx:pt>
          <cx:pt idx="982">0.68216500000000002</cx:pt>
          <cx:pt idx="983">0.98487899999999995</cx:pt>
          <cx:pt idx="984">1.12016</cx:pt>
          <cx:pt idx="985">1.10076</cx:pt>
          <cx:pt idx="986">1.8474999999999999</cx:pt>
          <cx:pt idx="987">0.84609100000000004</cx:pt>
          <cx:pt idx="988">1.2926599999999999</cx:pt>
          <cx:pt idx="989">1.0643499999999999</cx:pt>
          <cx:pt idx="990">1.2235400000000001</cx:pt>
          <cx:pt idx="991">0.97109800000000002</cx:pt>
          <cx:pt idx="992">0.85977499999999996</cx:pt>
          <cx:pt idx="993">1.06846</cx:pt>
          <cx:pt idx="994">1.27423</cx:pt>
          <cx:pt idx="995">0.75582300000000002</cx:pt>
          <cx:pt idx="996">1.25034</cx:pt>
          <cx:pt idx="997">0.81100099999999997</cx:pt>
          <cx:pt idx="998">1.20231</cx:pt>
          <cx:pt idx="999">0.56821900000000003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sz="12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200" b="0" i="0" u="none" strike="noStrike" baseline="0" dirty="0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21</a:t>
            </a:r>
            <a:endParaRPr lang="ja-JP" altLang="en-US" sz="1200" b="0" i="0" u="none" strike="noStrike" baseline="0" dirty="0">
              <a:solidFill>
                <a:sysClr val="windowText" lastClr="000000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cx:rich>
      </cx:tx>
    </cx:title>
    <cx:plotArea>
      <cx:plotAreaRegion>
        <cx:series layoutId="clusteredColumn" uniqueId="{A74FC657-ACA3-43C0-9988-8EFAC78A4293}">
          <cx:tx>
            <cx:txData>
              <cx:f>PK!$F$1</cx:f>
              <cx:v>tvK21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Count val="15"/>
            </cx:binning>
          </cx:layoutPr>
        </cx:series>
      </cx:plotAreaRegion>
      <cx:axis id="0">
        <cx:catScaling gapWidth="0"/>
        <cx:tickLabels/>
        <cx:numFmt formatCode="#,##0.00_);[赤](#,##0.0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5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PK!$T$2:$T$1001</cx:f>
        <cx:lvl ptCount="1000" formatCode="G/標準">
          <cx:pt idx="0">76.796223865500053</cx:pt>
          <cx:pt idx="1">45.087137855490447</cx:pt>
          <cx:pt idx="2">0.009264059585300603</cx:pt>
          <cx:pt idx="3">44.506291690052095</cx:pt>
          <cx:pt idx="4">59.713817496455547</cx:pt>
          <cx:pt idx="5">10.337020847420209</cx:pt>
          <cx:pt idx="6">28.555927580801853</cx:pt>
          <cx:pt idx="7">32.697553425294679</cx:pt>
          <cx:pt idx="8">55.116422235119721</cx:pt>
          <cx:pt idx="9">36.564873854561569</cx:pt>
          <cx:pt idx="10">38.54400083022</cx:pt>
          <cx:pt idx="11">44.37420421821669</cx:pt>
          <cx:pt idx="12">51.158186050719188</cx:pt>
          <cx:pt idx="13">37.659925650484233</cx:pt>
          <cx:pt idx="14">24.349722791029883</cx:pt>
          <cx:pt idx="15">35.882725648980454</cx:pt>
          <cx:pt idx="16">40.582754958233188</cx:pt>
          <cx:pt idx="17">64.807329832357695</cx:pt>
          <cx:pt idx="18">30.520222803904957</cx:pt>
          <cx:pt idx="19">58.818534493814113</cx:pt>
          <cx:pt idx="20">0.021825260594091424</cx:pt>
          <cx:pt idx="21">32.534904333653728</cx:pt>
          <cx:pt idx="22">26.784958465526877</cx:pt>
          <cx:pt idx="23">26.915014397172442</cx:pt>
          <cx:pt idx="24">0.0047109234763472859</cx:pt>
          <cx:pt idx="25">33.364352234083611</cx:pt>
          <cx:pt idx="26">40.582754958233188</cx:pt>
          <cx:pt idx="27">41.264027917788155</cx:pt>
          <cx:pt idx="28">10.242070103255493</cx:pt>
          <cx:pt idx="29">21.260997154413996</cx:pt>
          <cx:pt idx="30">40.984753262646343</cx:pt>
          <cx:pt idx="31">31.50987146911266</cx:pt>
          <cx:pt idx="32">29.999966666648149</cx:pt>
          <cx:pt idx="33">39.225629376722559</cx:pt>
          <cx:pt idx="34">40.582754958233188</cx:pt>
          <cx:pt idx="35">40.582754958233188</cx:pt>
          <cx:pt idx="36">33.51596634441561</cx:pt>
          <cx:pt idx="37">5.5306509562618391</cx:pt>
          <cx:pt idx="38">16.173651412096156</cx:pt>
          <cx:pt idx="39">40.939345378254401</cx:pt>
          <cx:pt idx="40">0.051365260634012165</cx:pt>
          <cx:pt idx="41">47.305707900844276</cx:pt>
          <cx:pt idx="42">0.004003023857036078</cx:pt>
          <cx:pt idx="43">43.116702100230256</cx:pt>
          <cx:pt idx="44">40.727386363477827</cx:pt>
          <cx:pt idx="45">5.5558527698275091</cx:pt>
          <cx:pt idx="46">40.007374320242512</cx:pt>
          <cx:pt idx="47">24.708965984030979</cx:pt>
          <cx:pt idx="48">53.531205852287691</cx:pt>
          <cx:pt idx="49">54.811677587900917</cx:pt>
          <cx:pt idx="50">38.417574103527151</cx:pt>
          <cx:pt idx="51">13.235671497887818</cx:pt>
          <cx:pt idx="52">52.32504180600337</cx:pt>
          <cx:pt idx="53">31.042293729684346</cx:pt>
          <cx:pt idx="54">29.984996248123828</cx:pt>
          <cx:pt idx="55">47.571525096427166</cx:pt>
          <cx:pt idx="56">51.020682080897352</cx:pt>
          <cx:pt idx="57">0.11848375416064433</cx:pt>
          <cx:pt idx="58">0.0033815676837821835</cx:pt>
          <cx:pt idx="59">35.60379193288265</cx:pt>
          <cx:pt idx="60">44.298758447613409</cx:pt>
          <cx:pt idx="61">42.681494819183641</cx:pt>
          <cx:pt idx="62">31.792609204027279</cx:pt>
          <cx:pt idx="63">42.474580633597789</cx:pt>
          <cx:pt idx="64">46.936020282934088</cx:pt>
          <cx:pt idx="65">23.634593290344558</cx:pt>
          <cx:pt idx="66">29.652993103563762</cx:pt>
          <cx:pt idx="67">43.37084274025581</cx:pt>
          <cx:pt idx="68">46.458798951328909</cx:pt>
          <cx:pt idx="69">37.009323149714589</cx:pt>
          <cx:pt idx="70">20.030302044652245</cx:pt>
          <cx:pt idx="71">5.3286677509486369</cx:pt>
          <cx:pt idx="72">32.092834091117602</cx:pt>
          <cx:pt idx="73">50.805806754740146</cx:pt>
          <cx:pt idx="74">40.486293977097972</cx:pt>
          <cx:pt idx="75">24.449314918827479</cx:pt>
          <cx:pt idx="76">34.77959171698253</cx:pt>
          <cx:pt idx="77">39.158651662180603</cx:pt>
          <cx:pt idx="78">0.013231893288566079</cx:pt>
          <cx:pt idx="79">50.850073746259206</cx:pt>
          <cx:pt idx="80">21.583141569289673</cx:pt>
          <cx:pt idx="81">7.9119529826712194</cx:pt>
          <cx:pt idx="82">40.582754958233188</cx:pt>
          <cx:pt idx="83">24.679363849175694</cx:pt>
          <cx:pt idx="84">33.383079546380976</cx:pt>
          <cx:pt idx="85">46.219584593546493</cx:pt>
          <cx:pt idx="86">41.162482918308022</cx:pt>
          <cx:pt idx="87">0.024882885684743242</cx:pt>
          <cx:pt idx="88">45.61841733335342</cx:pt>
          <cx:pt idx="89">35.623868403080536</cx:pt>
          <cx:pt idx="90">39.490125347990478</cx:pt>
          <cx:pt idx="91">18.433556357903377</cx:pt>
          <cx:pt idx="92">45.831866643199248</cx:pt>
          <cx:pt idx="93">22.876887900236781</cx:pt>
          <cx:pt idx="94">23.041831524425309</cx:pt>
          <cx:pt idx="95">12.885573328338944</cx:pt>
          <cx:pt idx="96">41.875768649661829</cx:pt>
          <cx:pt idx="97">42.914100246888545</cx:pt>
          <cx:pt idx="98">13.420134127496642</cx:pt>
          <cx:pt idx="99">40.582754958233188</cx:pt>
          <cx:pt idx="100">0.0085190257658960041</cx:pt>
          <cx:pt idx="101">40.582754958233188</cx:pt>
          <cx:pt idx="102">40.582754958233188</cx:pt>
          <cx:pt idx="103">22.991063481274633</cx:pt>
          <cx:pt idx="104">42.500352939710986</cx:pt>
          <cx:pt idx="105">44.951640681959546</cx:pt>
          <cx:pt idx="106">20.32203237867709</cx:pt>
          <cx:pt idx="107">45.162152295921416</cx:pt>
          <cx:pt idx="108">50.226885230919905</cx:pt>
          <cx:pt idx="109">11.535770455413891</cx:pt>
          <cx:pt idx="110">49.092463780095621</cx:pt>
          <cx:pt idx="111">39.807034554209132</cx:pt>
          <cx:pt idx="112">42.477641177447694</cx:pt>
          <cx:pt idx="113">16.15592770471569</cx:pt>
          <cx:pt idx="114">0.20807570737594525</cx:pt>
          <cx:pt idx="115">49.319266012381</cx:pt>
          <cx:pt idx="116">45.822920029173176</cx:pt>
          <cx:pt idx="117">48.470093872407546</cx:pt>
          <cx:pt idx="118">40.582754958233188</cx:pt>
          <cx:pt idx="119">19.392060230929566</cx:pt>
          <cx:pt idx="120">0.00011101035987690518</cx:pt>
          <cx:pt idx="121">0.010154358670049034</cx:pt>
          <cx:pt idx="122">0.010855321275761488</cx:pt>
          <cx:pt idx="123">0.00077427127029226653</cx:pt>
          <cx:pt idx="124">55.902772739820335</cx:pt>
          <cx:pt idx="125">50.071349093069188</cx:pt>
          <cx:pt idx="126">14.770003385239963</cx:pt>
          <cx:pt idx="127">49.417810554495432</cx:pt>
          <cx:pt idx="128">52.199233710850578</cx:pt>
          <cx:pt idx="129">23.785394678247407</cx:pt>
          <cx:pt idx="130">50.322758270985112</cx:pt>
          <cx:pt idx="131">52.511522545056721</cx:pt>
          <cx:pt idx="132">55.209147792734491</cx:pt>
          <cx:pt idx="133">0.058161241389777782</cx:pt>
          <cx:pt idx="134">15.230397237104487</cx:pt>
          <cx:pt idx="135">34.292127376411045</cx:pt>
          <cx:pt idx="136">40.582754958233188</cx:pt>
          <cx:pt idx="137">0.0074309353381657147</cx:pt>
          <cx:pt idx="138">31.022604661762365</cx:pt>
          <cx:pt idx="139">41.110582579185127</cx:pt>
          <cx:pt idx="140">43.55662980534651</cx:pt>
          <cx:pt idx="141">61.941746827160117</cx:pt>
          <cx:pt idx="142">26.568628116634102</cx:pt>
          <cx:pt idx="143">42.207108406049329</cx:pt>
          <cx:pt idx="144">41.620667942742102</cx:pt>
          <cx:pt idx="145">40.582754958233188</cx:pt>
          <cx:pt idx="146">57.418986406936853</cx:pt>
          <cx:pt idx="147">39.842816165527253</cx:pt>
          <cx:pt idx="148">32.603527416523512</cx:pt>
          <cx:pt idx="149">50.937412576612097</cx:pt>
          <cx:pt idx="150">42.123152778489889</cx:pt>
          <cx:pt idx="151">48.921774293253101</cx:pt>
          <cx:pt idx="152">62.785826426033452</cx:pt>
          <cx:pt idx="153">28.578715856385152</cx:pt>
          <cx:pt idx="154">31.131029536460886</cx:pt>
          <cx:pt idx="155">27.724826419655002</cx:pt>
          <cx:pt idx="156">43.934610502427354</cx:pt>
          <cx:pt idx="157">0.10126746762904659</cx:pt>
          <cx:pt idx="158">17.679960407195487</cx:pt>
          <cx:pt idx="159">13.408765789587049</cx:pt>
          <cx:pt idx="160">47.034455455548759</cx:pt>
          <cx:pt idx="161">23.1653404896194</cx:pt>
          <cx:pt idx="162">21.654029648081671</cx:pt>
          <cx:pt idx="163">31.183328879386817</cx:pt>
          <cx:pt idx="164">39.962607522532863</cx:pt>
          <cx:pt idx="165">12.707005941605598</cx:pt>
          <cx:pt idx="166">0.053757232071601303</cx:pt>
          <cx:pt idx="167">30.619781187983691</cx:pt>
          <cx:pt idx="168">0.026172944045330479</cx:pt>
          <cx:pt idx="169">53.670569216284633</cx:pt>
          <cx:pt idx="170">55.381404821474142</cx:pt>
          <cx:pt idx="171">39.302417228460641</cx:pt>
          <cx:pt idx="172">44.721359549995796</cx:pt>
          <cx:pt idx="173">45.408919828597547</cx:pt>
          <cx:pt idx="174">27.628336902535409</cx:pt>
          <cx:pt idx="175">49.114865366811301</cx:pt>
          <cx:pt idx="176">48.560168862968339</cx:pt>
          <cx:pt idx="177">8.6899482161863322</cx:pt>
          <cx:pt idx="178">0.0010001249921884764</cx:pt>
          <cx:pt idx="179">39.77184934095974</cx:pt>
          <cx:pt idx="180">44.335989895343488</cx:pt>
          <cx:pt idx="181">36.2342379525222</cx:pt>
          <cx:pt idx="182">24.330413066777144</cx:pt>
          <cx:pt idx="183">50.775190792354486</cx:pt>
          <cx:pt idx="184">33.202108366788998</cx:pt>
          <cx:pt idx="185">49.999099991899854</cx:pt>
          <cx:pt idx="186">0.0054259284919725955</cx:pt>
          <cx:pt idx="187">43.836400399667852</cx:pt>
          <cx:pt idx="188">26.841460466971611</cx:pt>
          <cx:pt idx="189">0.031355669343836372</cx:pt>
          <cx:pt idx="190">40.582754958233188</cx:pt>
          <cx:pt idx="191">12.909066581283094</cx:pt>
          <cx:pt idx="192">55.662105601567035</cx:pt>
          <cx:pt idx="193">0.0079956050427719347</cx:pt>
          <cx:pt idx="194">29.288274104153011</cx:pt>
          <cx:pt idx="195">12.687947036459443</cx:pt>
          <cx:pt idx="196">38.050098554405878</cx:pt>
          <cx:pt idx="197">13.077040949695004</cx:pt>
          <cx:pt idx="198">0.00024326939799325357</cx:pt>
          <cx:pt idx="199">28.51185718258283</cx:pt>
          <cx:pt idx="200">51.0646648867884</cx:pt>
          <cx:pt idx="201">0.018851684274886423</cx:pt>
          <cx:pt idx="202">17.114116979850291</cx:pt>
          <cx:pt idx="203">15.61700995709486</cx:pt>
          <cx:pt idx="204">14.280301117273403</cx:pt>
          <cx:pt idx="205">26.169772639440335</cx:pt>
          <cx:pt idx="206">25.981493413581909</cx:pt>
          <cx:pt idx="207">0.019260711305660545</cx:pt>
          <cx:pt idx="208">49.447750201601693</cx:pt>
          <cx:pt idx="209">26.282218323421635</cx:pt>
          <cx:pt idx="210">0.027225833320579922</cx:pt>
          <cx:pt idx="211">30.978202013674068</cx:pt>
          <cx:pt idx="212">47.306870536952658</cx:pt>
          <cx:pt idx="213">21.829475486140293</cx:pt>
          <cx:pt idx="214">46.724618778541149</cx:pt>
          <cx:pt idx="215">41.204368700418158</cx:pt>
          <cx:pt idx="216">40.929329337285751</cx:pt>
          <cx:pt idx="217">44.070852045314481</cx:pt>
          <cx:pt idx="218">26.117752583252638</cx:pt>
          <cx:pt idx="219">48.334976983546809</cx:pt>
          <cx:pt idx="220">53.390916830487193</cx:pt>
          <cx:pt idx="221">65.545709241719251</cx:pt>
          <cx:pt idx="222">49.109367741806651</cx:pt>
          <cx:pt idx="223">0.84573222712629326</cx:pt>
          <cx:pt idx="224">38.711497000245288</cx:pt>
          <cx:pt idx="225">49.202032478343817</cx:pt>
          <cx:pt idx="226">37.050371118249274</cx:pt>
          <cx:pt idx="227">55.642250134228036</cx:pt>
          <cx:pt idx="228">40.582754958233188</cx:pt>
          <cx:pt idx="229">59.127658502599267</cx:pt>
          <cx:pt idx="230">18.00052777004052</cx:pt>
          <cx:pt idx="231">53.588618194538284</cx:pt>
          <cx:pt idx="232">0.021284736315021618</cx:pt>
          <cx:pt idx="233">0.011725996759337774</cx:pt>
          <cx:pt idx="234">14.325571541826873</cx:pt>
          <cx:pt idx="235">34.223237719420993</cx:pt>
          <cx:pt idx="236">38.754483611577122</cx:pt>
          <cx:pt idx="237">37.87545379266102</cx:pt>
          <cx:pt idx="238">10.897522654254956</cx:pt>
          <cx:pt idx="239">52.459508194416003</cx:pt>
          <cx:pt idx="240">33.473870406632095</cx:pt>
          <cx:pt idx="241">52.54988106551717</cx:pt>
          <cx:pt idx="242">58.895585573114047</cx:pt>
          <cx:pt idx="243">15.255326938482833</cx:pt>
          <cx:pt idx="244">27.995124575539936</cx:pt>
          <cx:pt idx="245">11.909869856551749</cx:pt>
          <cx:pt idx="246">0.041166126852061273</cx:pt>
          <cx:pt idx="247">40.582754958233188</cx:pt>
          <cx:pt idx="248">6.1530805292958743e-05</cx:pt>
          <cx:pt idx="249">0.0015022583000269961</cx:pt>
          <cx:pt idx="250">42.979879013324364</cx:pt>
          <cx:pt idx="251">25.559753519938333</cx:pt>
          <cx:pt idx="252">35.305382025974453</cx:pt>
          <cx:pt idx="253">55.861346206478061</cx:pt>
          <cx:pt idx="254">0.00070873337723011186</cx:pt>
          <cx:pt idx="255">25.472652001705669</cx:pt>
          <cx:pt idx="256">22.798442929287958</cx:pt>
          <cx:pt idx="257">39.04420571608545</cx:pt>
          <cx:pt idx="258">0.0028021134880657494</cx:pt>
          <cx:pt idx="259">43.809587991671414</cx:pt>
          <cx:pt idx="260">28.87824440647319</cx:pt>
          <cx:pt idx="261">51.063391975073493</cx:pt>
          <cx:pt idx="262">14.205245510021994</cx:pt>
          <cx:pt idx="263">41.349969770242879</cx:pt>
          <cx:pt idx="264">34.319965034947224</cx:pt>
          <cx:pt idx="265">56.394680600212645</cx:pt>
          <cx:pt idx="266">19.796161244039208</cx:pt>
          <cx:pt idx="267">41.41026442803765</cx:pt>
          <cx:pt idx="268">60.987129789817132</cx:pt>
          <cx:pt idx="269">40.582754958233188</cx:pt>
          <cx:pt idx="270">31.917706684534842</cx:pt>
          <cx:pt idx="271">41.091483302504429</cx:pt>
          <cx:pt idx="272">9.3269662806295166</cx:pt>
          <cx:pt idx="273">17.118294307552958</cx:pt>
          <cx:pt idx="274">54.789688810943247</cx:pt>
          <cx:pt idx="275">40.467888504343783</cx:pt>
          <cx:pt idx="276">53.520463376170426</cx:pt>
          <cx:pt idx="277">43.575681291289065</cx:pt>
          <cx:pt idx="278">40.445766156669599</cx:pt>
          <cx:pt idx="279">47.189617502158249</cx:pt>
          <cx:pt idx="280">40.600492607848985</cx:pt>
          <cx:pt idx="281">47.256004909429237</cx:pt>
          <cx:pt idx="282">30.150754551088767</cx:pt>
          <cx:pt idx="283">0.029456035035286064</cx:pt>
          <cx:pt idx="284">29.788823407445953</cx:pt>
          <cx:pt idx="285">40.582754958233188</cx:pt>
          <cx:pt idx="286">9.4856259677472003</cx:pt>
          <cx:pt idx="287">37.257214066540186</cx:pt>
          <cx:pt idx="288">54.651075012299621</cx:pt>
          <cx:pt idx="289">0.032843720861071755</cx:pt>
          <cx:pt idx="290">21.290749164836825</cx:pt>
          <cx:pt idx="291">40.582754958233188</cx:pt>
          <cx:pt idx="292">0.015917097725402077</cx:pt>
          <cx:pt idx="293">28.21605925709683</cx:pt>
          <cx:pt idx="294">0.027028669963577563</cx:pt>
          <cx:pt idx="295">13.456522582004609</cx:pt>
          <cx:pt idx="296">59.115564786272657</cx:pt>
          <cx:pt idx="297">42.762600482197058</cx:pt>
          <cx:pt idx="298">27.250137614331422</cx:pt>
          <cx:pt idx="299">39.355304597982723</cx:pt>
          <cx:pt idx="300">45.950299237328153</cx:pt>
          <cx:pt idx="301">32.326614422175417</cx:pt>
          <cx:pt idx="302">17.944609218369735</cx:pt>
          <cx:pt idx="303">60.28930253369996</cx:pt>
          <cx:pt idx="304">40.582754958233188</cx:pt>
          <cx:pt idx="305">51.407100676852025</cx:pt>
          <cx:pt idx="306">45.45976242788781</cx:pt>
          <cx:pt idx="307">0.0029795100268332712</cx:pt>
          <cx:pt idx="308">0.032940856090878996</cx:pt>
          <cx:pt idx="309">40.582754958233188</cx:pt>
          <cx:pt idx="310">50.532069025520812</cx:pt>
          <cx:pt idx="311">40.753772831481506</cx:pt>
          <cx:pt idx="312">0.0098045550638466011</cx:pt>
          <cx:pt idx="313">53.25823879926935</cx:pt>
          <cx:pt idx="314">17.239779580957524</cx:pt>
          <cx:pt idx="315">30.408189686332861</cx:pt>
          <cx:pt idx="316">13.299022520471196</cx:pt>
          <cx:pt idx="317">34.619792027104957</cx:pt>
          <cx:pt idx="318">43.579582375236228</cx:pt>
          <cx:pt idx="319">52.516664022003532</cx:pt>
          <cx:pt idx="320">44.368795340869916</cx:pt>
          <cx:pt idx="321">43.55203783980722</cx:pt>
          <cx:pt idx="322">8.9097250238152697</cx:pt>
          <cx:pt idx="323">12.597460061456832</cx:pt>
          <cx:pt idx="324">49.383600516770748</cx:pt>
          <cx:pt idx="325">38.462969204157908</cx:pt>
          <cx:pt idx="326">21.262455173380143</cx:pt>
          <cx:pt idx="327">36.171259309014943</cx:pt>
          <cx:pt idx="328">39.811681702736443</cx:pt>
          <cx:pt idx="329">39.434249073616201</cx:pt>
          <cx:pt idx="330">37.525724509994475</cx:pt>
          <cx:pt idx="331">46.251054042043194</cx:pt>
          <cx:pt idx="332">50.745049019584165</cx:pt>
          <cx:pt idx="333">27.234848999030635</cx:pt>
          <cx:pt idx="334">27.552295730120203</cx:pt>
          <cx:pt idx="335">23.441437669221571</cx:pt>
          <cx:pt idx="336">17.595084540859698</cx:pt>
          <cx:pt idx="337">14.513924348707347</cx:pt>
          <cx:pt idx="338">25.319537910475383</cx:pt>
          <cx:pt idx="339">47.355464309834403</cx:pt>
          <cx:pt idx="340">45.635402923607451</cx:pt>
          <cx:pt idx="341">0.11962065039114275</cx:pt>
          <cx:pt idx="342">24.586419015383271</cx:pt>
          <cx:pt idx="343">24.600609748540787</cx:pt>
          <cx:pt idx="344">11.818967806031116</cx:pt>
          <cx:pt idx="345">41.292372176952973</cx:pt>
          <cx:pt idx="346">27.312158464683822</cx:pt>
          <cx:pt idx="347">40.370905365126504</cx:pt>
          <cx:pt idx="348">18.268825906445109</cx:pt>
          <cx:pt idx="349">60.245580750790353</cx:pt>
          <cx:pt idx="350">41.84041108784664</cx:pt>
          <cx:pt idx="351">39.254426501988284</cx:pt>
          <cx:pt idx="352">50.179079306021549</cx:pt>
          <cx:pt idx="353">0.039489492273261761</cx:pt>
          <cx:pt idx="354">22.384503568317079</cx:pt>
          <cx:pt idx="355">43.880633541461087</cx:pt>
          <cx:pt idx="356">25.568554906368878</cx:pt>
          <cx:pt idx="357">46.148239403036818</cx:pt>
          <cx:pt idx="358">16.686491542562205</cx:pt>
          <cx:pt idx="359">31.853728196241015</cx:pt>
          <cx:pt idx="360">54.868205729730214</cx:pt>
          <cx:pt idx="361">41.336182697486713</cx:pt>
          <cx:pt idx="362">0.078259823664508718</cx:pt>
          <cx:pt idx="363">40.582754958233188</cx:pt>
          <cx:pt idx="364">48.412188547926647</cx:pt>
          <cx:pt idx="365">29.060815542582418</cx:pt>
          <cx:pt idx="366">65.198312861607093</cx:pt>
          <cx:pt idx="367">44.780687801774548</cx:pt>
          <cx:pt idx="368">23.160073402301641</cx:pt>
          <cx:pt idx="369">40.582754958233188</cx:pt>
          <cx:pt idx="370">27.340117044372725</cx:pt>
          <cx:pt idx="371">14.952157035023408</cx:pt>
          <cx:pt idx="372">0.028198191431366655</cx:pt>
          <cx:pt idx="373">43.94314508543966</cx:pt>
          <cx:pt idx="374">16.387098583947068</cx:pt>
          <cx:pt idx="375">21.491021381032592</cx:pt>
          <cx:pt idx="376">40.582754958233188</cx:pt>
          <cx:pt idx="377">40.188679998228352</cx:pt>
          <cx:pt idx="378">26.765780392135031</cx:pt>
          <cx:pt idx="379">40.582754958233188</cx:pt>
          <cx:pt idx="380">57.293018771923684</cx:pt>
          <cx:pt idx="381">36.137791852851223</cx:pt>
          <cx:pt idx="382">43.614217865278746</cx:pt>
          <cx:pt idx="383">43.669898099262838</cx:pt>
          <cx:pt idx="384">41.578720519034732</cx:pt>
          <cx:pt idx="385">49.37985419176529</cx:pt>
          <cx:pt idx="386">34.303789878087812</cx:pt>
          <cx:pt idx="387">0.011813043638283912</cx:pt>
          <cx:pt idx="388">0.022129143679772159</cx:pt>
          <cx:pt idx="389">43.912640549163065</cx:pt>
          <cx:pt idx="390">0.048557491697986212</cx:pt>
          <cx:pt idx="391">73.132277415652794</cx:pt>
          <cx:pt idx="392">26.333248945012468</cx:pt>
          <cx:pt idx="393">38.528431060711519</cx:pt>
          <cx:pt idx="394">40.582754958233188</cx:pt>
          <cx:pt idx="395">55.984997990533138</cx:pt>
          <cx:pt idx="396">56.157813347743513</cx:pt>
          <cx:pt idx="397">47.834610900476655</cx:pt>
          <cx:pt idx="398">0.012142652099109157</cx:pt>
          <cx:pt idx="399">58.969907580053075</cx:pt>
          <cx:pt idx="400">35.534490287606488</cx:pt>
          <cx:pt idx="401">40.582754958233188</cx:pt>
          <cx:pt idx="402">42.42110323883621</cx:pt>
          <cx:pt idx="403">54.654825953432507</cx:pt>
          <cx:pt idx="404">53.777039710270401</cx:pt>
          <cx:pt idx="405">40.059580626861283</cx:pt>
          <cx:pt idx="406">44.063023046540962</cx:pt>
          <cx:pt idx="407">50.948797826837875</cx:pt>
          <cx:pt idx="408">23.823748655490807</cx:pt>
          <cx:pt idx="409">20.841928893458974</cx:pt>
          <cx:pt idx="410">57.229100988919967</cx:pt>
          <cx:pt idx="411">57.444581989949242</cx:pt>
          <cx:pt idx="412">28.031946061591938</cx:pt>
          <cx:pt idx="413">35.269817124561335</cx:pt>
          <cx:pt idx="414">51.200878898706414</cx:pt>
          <cx:pt idx="415">39.849215801568796</cx:pt>
          <cx:pt idx="416">44.150537935567669</cx:pt>
          <cx:pt idx="417">15.20726799921669</cx:pt>
          <cx:pt idx="418">38.158485294885594</cx:pt>
          <cx:pt idx="419">24.257225727605373</cx:pt>
          <cx:pt idx="420">26.042599716618152</cx:pt>
          <cx:pt idx="421">43.365539314068265</cx:pt>
          <cx:pt idx="422">55.311391231824935</cx:pt>
          <cx:pt idx="423">21.658508720592931</cx:pt>
          <cx:pt idx="424">0.01394044475617618</cx:pt>
          <cx:pt idx="425">0.0074905073259426153</cx:pt>
          <cx:pt idx="426">45.258148437601818</cx:pt>
          <cx:pt idx="427">51.451530589478104</cx:pt>
          <cx:pt idx="428">30.776598252568458</cx:pt>
          <cx:pt idx="429">35.883979712400908</cx:pt>
          <cx:pt idx="430">12.105535923700362</cx:pt>
          <cx:pt idx="431">9.3125614091934992</cx:pt>
          <cx:pt idx="432">22.04264049518569</cx:pt>
          <cx:pt idx="433">38.704521699667083</cx:pt>
          <cx:pt idx="434">39.642149285829596</cx:pt>
          <cx:pt idx="435">38.886501514021546</cx:pt>
          <cx:pt idx="436">49.227736084447358</cx:pt>
          <cx:pt idx="437">41.89952267031213</cx:pt>
          <cx:pt idx="438">44.637092199201327</cx:pt>
          <cx:pt idx="439">0.0051121717498534809</cx:pt>
          <cx:pt idx="440">30.990079057659724</cx:pt>
          <cx:pt idx="441">46.776276038179866</cx:pt>
          <cx:pt idx="442">26.630170859384283</cx:pt>
          <cx:pt idx="443">40.582754958233188</cx:pt>
          <cx:pt idx="444">35.738214840699584</cx:pt>
          <cx:pt idx="445">0.0095260012597101831</cx:pt>
          <cx:pt idx="446">35.386296782794325</cx:pt>
          <cx:pt idx="447">27.798435207759447</cx:pt>
          <cx:pt idx="448">47.34205318741467</cx:pt>
          <cx:pt idx="449">40.35219944439212</cx:pt>
          <cx:pt idx="450">30.830098929455286</cx:pt>
          <cx:pt idx="451">35.511265818047093</cx:pt>
          <cx:pt idx="452">18.985389119004122</cx:pt>
          <cx:pt idx="453">4.4555695483293718</cx:pt>
          <cx:pt idx="454">38.812369162420374</cx:pt>
          <cx:pt idx="455">13.164421749549046</cx:pt>
          <cx:pt idx="456">55.18632076882821</cx:pt>
          <cx:pt idx="457">51.462510626668809</cx:pt>
          <cx:pt idx="458">16.17501159195875</cx:pt>
          <cx:pt idx="459">42.105344078869614</cx:pt>
          <cx:pt idx="460">50.573708584599565</cx:pt>
          <cx:pt idx="461">10.424106676353615</cx:pt>
          <cx:pt idx="462">7.0278375052358744</cx:pt>
          <cx:pt idx="463">44.797432962168713</cx:pt>
          <cx:pt idx="464">42.502941074706818</cx:pt>
          <cx:pt idx="465">60.899343182008124</cx:pt>
          <cx:pt idx="466">40.082539839685808</cx:pt>
          <cx:pt idx="467">32.225455776451014</cx:pt>
          <cx:pt idx="468">45.428735399524385</cx:pt>
          <cx:pt idx="469">31.215348788696883</cx:pt>
          <cx:pt idx="470">56.352550962667159</cx:pt>
          <cx:pt idx="471">58.376279429233925</cx:pt>
          <cx:pt idx="472">0.028658576377761685</cx:pt>
          <cx:pt idx="473">44.02465218488387</cx:pt>
          <cx:pt idx="474">45.20995465602681</cx:pt>
          <cx:pt idx="475">58.255986816807081</cx:pt>
          <cx:pt idx="476">0.42430295780255878</cx:pt>
          <cx:pt idx="477">12.717940084777881</cx:pt>
          <cx:pt idx="478">26.460782301360631</cx:pt>
          <cx:pt idx="479">37.381947514809873</cx:pt>
          <cx:pt idx="480">42.58826129345973</cx:pt>
          <cx:pt idx="481">40.175863400803223</cx:pt>
          <cx:pt idx="482">24.441624332273829</cx:pt>
          <cx:pt idx="483">43.608026784068095</cx:pt>
          <cx:pt idx="484">40.582754958233188</cx:pt>
          <cx:pt idx="485">38.376555343073719</cx:pt>
          <cx:pt idx="486">36.213533381872587</cx:pt>
          <cx:pt idx="487">41.43235450707575</cx:pt>
          <cx:pt idx="488">15.017689569304594</cx:pt>
          <cx:pt idx="489">34.98814084800734</cx:pt>
          <cx:pt idx="490">40.582754958233188</cx:pt>
          <cx:pt idx="491">35.367640577228222</cx:pt>
          <cx:pt idx="492">37.98578681559723</cx:pt>
          <cx:pt idx="493">53.909553884260632</cx:pt>
          <cx:pt idx="494">34.193420419724028</cx:pt>
          <cx:pt idx="495">62.402964673162764</cx:pt>
          <cx:pt idx="496">40.530482355876302</cx:pt>
          <cx:pt idx="497">34.410754132974184</cx:pt>
          <cx:pt idx="498">8.9231888918704403</cx:pt>
          <cx:pt idx="499">45.079818100786525</cx:pt>
          <cx:pt idx="500">58.831369183455188</cx:pt>
          <cx:pt idx="501">25.677928265341031</cx:pt>
          <cx:pt idx="502">38.686431730000635</cx:pt>
          <cx:pt idx="503">27.823479293575058</cx:pt>
          <cx:pt idx="504">57.326084813111031</cx:pt>
          <cx:pt idx="505">25.125684070289513</cx:pt>
          <cx:pt idx="506">0.1133009267393696</cx:pt>
          <cx:pt idx="507">24.429285703843245</cx:pt>
          <cx:pt idx="508">40.582754958233188</cx:pt>
          <cx:pt idx="509">34.612425514546075</cx:pt>
          <cx:pt idx="510">40.582754958233188</cx:pt>
          <cx:pt idx="511">51.789284605987753</cx:pt>
          <cx:pt idx="512">50.859709004279608</cx:pt>
          <cx:pt idx="513">0.022388814171366917</cx:pt>
          <cx:pt idx="514">34.202046722381979</cx:pt>
          <cx:pt idx="515">34.356804275135957</cx:pt>
          <cx:pt idx="516">0.035875757831716946</cx:pt>
          <cx:pt idx="517">46.102060691470179</cx:pt>
          <cx:pt idx="518">56.225083370325024</cx:pt>
          <cx:pt idx="519">22.695858653067084</cx:pt>
          <cx:pt idx="520">0.055860719651647878</cx:pt>
          <cx:pt idx="521">42.328123038944213</cx:pt>
          <cx:pt idx="522">40.279895729755808</cx:pt>
          <cx:pt idx="523">40.582754958233188</cx:pt>
          <cx:pt idx="524">34.831451304819325</cx:pt>
          <cx:pt idx="525">47.731121922703643</cx:pt>
          <cx:pt idx="526">55.289420326134731</cx:pt>
          <cx:pt idx="527">44.685903817647016</cx:pt>
          <cx:pt idx="528">29.388535179555991</cx:pt>
          <cx:pt idx="529">0.011333049016041536</cx:pt>
          <cx:pt idx="530">27.423876458298157</cx:pt>
          <cx:pt idx="531">43.858066532851169</cx:pt>
          <cx:pt idx="532">21.296173365184647</cx:pt>
          <cx:pt idx="533">31.582922600671399</cx:pt>
          <cx:pt idx="534">60.263836585468077</cx:pt>
          <cx:pt idx="535">21.785844027716713</cx:pt>
          <cx:pt idx="536">27.609183254851999</cx:pt>
          <cx:pt idx="537">42.813198899404838</cx:pt>
          <cx:pt idx="538">36.48465430835271</cx:pt>
          <cx:pt idx="539">0.20118101302061286</cx:pt>
          <cx:pt idx="540">50.369534442954702</cx:pt>
          <cx:pt idx="541">11.558849423709956</cx:pt>
          <cx:pt idx="542">27.530728286770767</cx:pt>
          <cx:pt idx="543">45.086250675788072</cx:pt>
          <cx:pt idx="544">26.347333830959062</cx:pt>
          <cx:pt idx="545">37.065212801223737</cx:pt>
          <cx:pt idx="546">36.383650174219738</cx:pt>
          <cx:pt idx="547">39.714984577612519</cx:pt>
          <cx:pt idx="548">37.437547996630336</cx:pt>
          <cx:pt idx="549">0.0011704571756369388</cx:pt>
          <cx:pt idx="550">54.227207193437501</cx:pt>
          <cx:pt idx="551">47.212392440968294</cx:pt>
          <cx:pt idx="552">37.073710361926281</cx:pt>
          <cx:pt idx="553">15.003066353249258</cx:pt>
          <cx:pt idx="554">41.789592005665718</cx:pt>
          <cx:pt idx="555">30.720221353369187</cx:pt>
          <cx:pt idx="556">27.800953221067797</cx:pt>
          <cx:pt idx="557">10.217925425447183</cx:pt>
          <cx:pt idx="558">41.148876047833923</cx:pt>
          <cx:pt idx="559">19.685730872893696</cx:pt>
          <cx:pt idx="560">39.842439684336597</cx:pt>
          <cx:pt idx="561">43.279671902638079</cx:pt>
          <cx:pt idx="562">28.109500173428909</cx:pt>
          <cx:pt idx="563">0.018456922820448699</cx:pt>
          <cx:pt idx="564">50.498910879344713</cx:pt>
          <cx:pt idx="565">19.438467017746021</cx:pt>
          <cx:pt idx="566">42.826510481242806</cx:pt>
          <cx:pt idx="567">51.077000695029071</cx:pt>
          <cx:pt idx="568">47.167785616880515</cx:pt>
          <cx:pt idx="569">44.896102280710295</cx:pt>
          <cx:pt idx="570">50.749778324639017</cx:pt>
          <cx:pt idx="571">0.012951331977831469</cx:pt>
          <cx:pt idx="572">0.003775698610853361</cx:pt>
          <cx:pt idx="573">37.12142238654117</cx:pt>
          <cx:pt idx="574">42.618657885954129</cx:pt>
          <cx:pt idx="575">0.0062825711297206975</cx:pt>
          <cx:pt idx="576">24.611867056361248</cx:pt>
          <cx:pt idx="577">23.847284960766498</cx:pt>
          <cx:pt idx="578">38.099475062000529</cx:pt>
          <cx:pt idx="579">45.845937660822251</cx:pt>
          <cx:pt idx="580">28.492507787135899</cx:pt>
          <cx:pt idx="581">21.615688746833861</cx:pt>
          <cx:pt idx="582">40.809067619831744</cx:pt>
          <cx:pt idx="583">32.869895040903309</cx:pt>
          <cx:pt idx="584">0.013618186369704301</cx:pt>
          <cx:pt idx="585">49.173773497668449</cx:pt>
          <cx:pt idx="586">41.406038207005508</cx:pt>
          <cx:pt idx="587">0.036881160502348617</cx:pt>
          <cx:pt idx="588">65.939669395592219</cx:pt>
          <cx:pt idx="589">31.18528499148276</cx:pt>
          <cx:pt idx="590">35.935358631854506</cx:pt>
          <cx:pt idx="591">44.432533126077786</cx:pt>
          <cx:pt idx="592">29.301791754089034</cx:pt>
          <cx:pt idx="593">35.951495101038567</cx:pt>
          <cx:pt idx="594">0.022535194696296723</cx:pt>
          <cx:pt idx="595">23.533274315317875</cx:pt>
          <cx:pt idx="596">51.554146292999562</cx:pt>
          <cx:pt idx="597">50.699605521147795</cx:pt>
          <cx:pt idx="598">47.929427286375962</cx:pt>
          <cx:pt idx="599">25.55740597165526</cx:pt>
          <cx:pt idx="600">64.638301339066757</cx:pt>
          <cx:pt idx="601">0.009335689583528364</cx:pt>
          <cx:pt idx="602">6.8717901597764168</cx:pt>
          <cx:pt idx="603">25.295711098919515</cx:pt>
          <cx:pt idx="604">29.753789674594394</cx:pt>
          <cx:pt idx="605">0.019963867360809628</cx:pt>
          <cx:pt idx="606">42.73476336660822</cx:pt>
          <cx:pt idx="607">44.787386617216235</cx:pt>
          <cx:pt idx="608">43.53515820575366</cx:pt>
          <cx:pt idx="609">35.396751263357487</cx:pt>
          <cx:pt idx="610">37.827238863020391</cx:pt>
          <cx:pt idx="611">32.337439601799026</cx:pt>
          <cx:pt idx="612">45.275821361958748</cx:pt>
          <cx:pt idx="613">19.128826414602649</cx:pt>
          <cx:pt idx="614">26.756700095490103</cx:pt>
          <cx:pt idx="615">0.0046440930223241653</cx:pt>
          <cx:pt idx="616">50.183563046081133</cx:pt>
          <cx:pt idx="617">59.472598732525547</cx:pt>
          <cx:pt idx="618">8.9038081740342996</cx:pt>
          <cx:pt idx="619">51.128270066568845</cx:pt>
          <cx:pt idx="620">20.402083226964841</cx:pt>
          <cx:pt idx="621">36.988646906855081</cx:pt>
          <cx:pt idx="622">40.016746494436553</cx:pt>
          <cx:pt idx="623">25.904208152344673</cx:pt>
          <cx:pt idx="624">35.868649263667571</cx:pt>
          <cx:pt idx="625">0.087633384049687374</cx:pt>
          <cx:pt idx="626">35.62555262729267</cx:pt>
          <cx:pt idx="627">48.162329677871689</cx:pt>
          <cx:pt idx="628">45.129923554112075</cx:pt>
          <cx:pt idx="629">49.574892839016812</cx:pt>
          <cx:pt idx="630">0.039030885206461821</cx:pt>
          <cx:pt idx="631">30.228810760597248</cx:pt>
          <cx:pt idx="632">45.147425175750612</cx:pt>
          <cx:pt idx="633">51.274555093145366</cx:pt>
          <cx:pt idx="634">41.9260062491051</cx:pt>
          <cx:pt idx="635">0.088017327839465795</cx:pt>
          <cx:pt idx="636">53.665817798669565</cx:pt>
          <cx:pt idx="637">37.834508058120697</cx:pt>
          <cx:pt idx="638">0.049610079620980248</cx:pt>
          <cx:pt idx="639">11.066164647247936</cx:pt>
          <cx:pt idx="640">61.038430517174987</cx:pt>
          <cx:pt idx="641">29.015426931203336</cx:pt>
          <cx:pt idx="642">51.823160845320892</cx:pt>
          <cx:pt idx="643">61.21772619103065</cx:pt>
          <cx:pt idx="644">0.0047943925579785399</cx:pt>
          <cx:pt idx="645">30.993176668421711</cx:pt>
          <cx:pt idx="646">60.936360245751466</cx:pt>
          <cx:pt idx="647">32.031546949843055</cx:pt>
          <cx:pt idx="648">20.269558455970373</cx:pt>
          <cx:pt idx="649">0.018627103908015329</cx:pt>
          <cx:pt idx="650">21.268709410775259</cx:pt>
          <cx:pt idx="651">33.553390290699383</cx:pt>
          <cx:pt idx="652">4.5960200173628483</cx:pt>
          <cx:pt idx="653">49.043450123334509</cx:pt>
          <cx:pt idx="654">29.093109149762597</cx:pt>
          <cx:pt idx="655">39.850846916972792</cx:pt>
          <cx:pt idx="656">42.65219806762601</cx:pt>
          <cx:pt idx="657">26.414295372013996</cx:pt>
          <cx:pt idx="658">25.603163866991132</cx:pt>
          <cx:pt idx="659">35.508308886794367</cx:pt>
          <cx:pt idx="660">25.238304221955961</cx:pt>
          <cx:pt idx="661">44.721359549995796</cx:pt>
          <cx:pt idx="662">63.05021808051103</cx:pt>
          <cx:pt idx="663">41.648769489625984</cx:pt>
          <cx:pt idx="664">50.960278649159683</cx:pt>
          <cx:pt idx="665">26.544133061752085</cx:pt>
          <cx:pt idx="666">14.342942515397599</cx:pt>
          <cx:pt idx="667">13.640931053267588</cx:pt>
          <cx:pt idx="668">5.2386544073836365</cx:pt>
          <cx:pt idx="669">35.040405248798137</cx:pt>
          <cx:pt idx="670">32.307893772265629</cx:pt>
          <cx:pt idx="671">52.544552524500574</cx:pt>
          <cx:pt idx="672">46.210929443152295</cx:pt>
          <cx:pt idx="673">40.582754958233188</cx:pt>
          <cx:pt idx="674">0.046824139073772621</cx:pt>
          <cx:pt idx="675">39.309668022001915</cx:pt>
          <cx:pt idx="676">35.549824190845165</cx:pt>
          <cx:pt idx="677">53.544187359600478</cx:pt>
          <cx:pt idx="678">40.582754958233188</cx:pt>
          <cx:pt idx="679">18.481531321835863</cx:pt>
          <cx:pt idx="680">35.434728727619749</cx:pt>
          <cx:pt idx="681">47.377737387933585</cx:pt>
          <cx:pt idx="682">41.31137857782042</cx:pt>
          <cx:pt idx="683">52.330010510222522</cx:pt>
          <cx:pt idx="684">23.038424425294366</cx:pt>
          <cx:pt idx="685">22.372438400853849</cx:pt>
          <cx:pt idx="686">0.0001670254471629997</cx:pt>
          <cx:pt idx="687">40.582754958233188</cx:pt>
          <cx:pt idx="688">25.161021441904936</cx:pt>
          <cx:pt idx="689">43.674592156080863</cx:pt>
          <cx:pt idx="690">43.115658408517902</cx:pt>
          <cx:pt idx="691">0.0049086658065099521</cx:pt>
          <cx:pt idx="692">56.279214635600596</cx:pt>
          <cx:pt idx="693">0.23356690690249765</cx:pt>
          <cx:pt idx="694">30.485635961875552</cx:pt>
          <cx:pt idx="695">40.630161210608065</cx:pt>
          <cx:pt idx="696">42.38761611603087</cx:pt>
          <cx:pt idx="697">28.706062077547312</cx:pt>
          <cx:pt idx="698">76.563307138602639</cx:pt>
          <cx:pt idx="699">15.399058412773165</cx:pt>
          <cx:pt idx="700">0.0037651162000660755</cx:pt>
          <cx:pt idx="701">35.741712326076374</cx:pt>
          <cx:pt idx="702">0.015757474416923545</cx:pt>
          <cx:pt idx="703">48.404648537098169</cx:pt>
          <cx:pt idx="704">49.868326621213185</cx:pt>
          <cx:pt idx="705">62.443174166597274</cx:pt>
          <cx:pt idx="706">40.582754958233188</cx:pt>
          <cx:pt idx="707">40.582754958233188</cx:pt>
          <cx:pt idx="708">53.817748001937048</cx:pt>
          <cx:pt idx="709">27.224327356245187</cx:pt>
          <cx:pt idx="710">40.582754958233188</cx:pt>
          <cx:pt idx="711">40.582754958233188</cx:pt>
          <cx:pt idx="712">49.190141288676941</cx:pt>
          <cx:pt idx="713">39.665476172611363</cx:pt>
          <cx:pt idx="714">0.089861782755518482</cx:pt>
          <cx:pt idx="715">0.047041045906739784</cx:pt>
          <cx:pt idx="716">40.001374976367998</cx:pt>
          <cx:pt idx="717">8.3587917787201764</cx:pt>
          <cx:pt idx="718">50.233156381019896</cx:pt>
          <cx:pt idx="719">20.064645523905973</cx:pt>
          <cx:pt idx="720">10.393651908737372</cx:pt>
          <cx:pt idx="721">59.924118683548443</cx:pt>
          <cx:pt idx="722">44.49280840765168</cx:pt>
          <cx:pt idx="723">42.744590300995988</cx:pt>
          <cx:pt idx="724">24.652525225623439</cx:pt>
          <cx:pt idx="725">12.817683097970553</cx:pt>
          <cx:pt idx="726">51.043216983258411</cx:pt>
          <cx:pt idx="727">29.155496908816353</cx:pt>
          <cx:pt idx="728">0.10866140069040156</cx:pt>
          <cx:pt idx="729">35.079908779812982</cx:pt>
          <cx:pt idx="730">43.18367747193377</cx:pt>
          <cx:pt idx="731">26.363137142608807</cx:pt>
          <cx:pt idx="732">42.497294031502761</cx:pt>
          <cx:pt idx="733">26.336666455722902</cx:pt>
          <cx:pt idx="734">0.01337617284577319</cx:pt>
          <cx:pt idx="735">43.878240621064108</cx:pt>
          <cx:pt idx="736">26.653217441802408</cx:pt>
          <cx:pt idx="737">26.189845360368203</cx:pt>
          <cx:pt idx="738">40.582754958233188</cx:pt>
          <cx:pt idx="739">63.081930851869139</cx:pt>
          <cx:pt idx="740">50.998529390561842</cx:pt>
          <cx:pt idx="741">60.029909211991985</cx:pt>
          <cx:pt idx="742">0.18978013594683718</cx:pt>
          <cx:pt idx="743">52.936376906622542</cx:pt>
          <cx:pt idx="744">11.970463650168275</cx:pt>
          <cx:pt idx="745">21.635295237181303</cx:pt>
          <cx:pt idx="746">48.164198321990156</cx:pt>
          <cx:pt idx="747">0.023329852121263008</cx:pt>
          <cx:pt idx="748">42.868403282604312</cx:pt>
          <cx:pt idx="749">54.503486127035949</cx:pt>
          <cx:pt idx="750">34.71599055190562</cx:pt>
          <cx:pt idx="751">0.0021724433249224249</cx:pt>
          <cx:pt idx="752">42.620065696805305</cx:pt>
          <cx:pt idx="753">0.050208465421679636</cx:pt>
          <cx:pt idx="754">0.0030212149873850421</cx:pt>
          <cx:pt idx="755">9.0669123741216338e-05</cx:pt>
          <cx:pt idx="756">25.704007469653444</cx:pt>
          <cx:pt idx="757">32.87111193738356</cx:pt>
          <cx:pt idx="758">28.589770897997766</cx:pt>
          <cx:pt idx="759">11.00290870633761</cx:pt>
          <cx:pt idx="760">49.050993873722888</cx:pt>
          <cx:pt idx="761">0.0082790035632315084</cx:pt>
          <cx:pt idx="762">7.9024996045555103</cx:pt>
          <cx:pt idx="763">40.525794255017381</cx:pt>
          <cx:pt idx="764">55.673422743711384</cx:pt>
          <cx:pt idx="765">42.201540256251313</cx:pt>
          <cx:pt idx="766">40.582754958233188</cx:pt>
          <cx:pt idx="767">54.582781167690605</cx:pt>
          <cx:pt idx="768">0.0018014938245800346</cx:pt>
          <cx:pt idx="769">51.598837196200456</cx:pt>
          <cx:pt idx="770">27.605271235762203</cx:pt>
          <cx:pt idx="771">45.305297703469513</cx:pt>
          <cx:pt idx="772">40.582754958233188</cx:pt>
          <cx:pt idx="773">26.243570641206581</cx:pt>
          <cx:pt idx="774">41.727329174055697</cx:pt>
          <cx:pt idx="775">48.295651978206074</cx:pt>
          <cx:pt idx="776">40.492468435500442</cx:pt>
          <cx:pt idx="777">23.593240557413896</cx:pt>
          <cx:pt idx="778">42.509410722803487</cx:pt>
          <cx:pt idx="779">32.842198464780033</cx:pt>
          <cx:pt idx="780">42.620300327426129</cx:pt>
          <cx:pt idx="781">46.684794098292862</cx:pt>
          <cx:pt idx="782">36.179275835759903</cx:pt>
          <cx:pt idx="783">20.41825163915853</cx:pt>
          <cx:pt idx="784">27.544654653852536</cx:pt>
          <cx:pt idx="785">21.966565503054863</cx:pt>
          <cx:pt idx="786">13.275127118035442</cx:pt>
          <cx:pt idx="787">31.424385435518065</cx:pt>
          <cx:pt idx="788">0.0065055284181994013</cx:pt>
          <cx:pt idx="789">11.103422895666002</cx:pt>
          <cx:pt idx="790">29.968967282841096</cx:pt>
          <cx:pt idx="791">33.443235489408018</cx:pt>
          <cx:pt idx="792">29.648507550971264</cx:pt>
          <cx:pt idx="793">38.371864692766756</cx:pt>
          <cx:pt idx="794">30.559352087372531</cx:pt>
          <cx:pt idx="795">40.582754958233188</cx:pt>
          <cx:pt idx="796">36.119523806384827</cx:pt>
          <cx:pt idx="797">38.89768630651443</cx:pt>
          <cx:pt idx="798">44.489774105967314</cx:pt>
          <cx:pt idx="799">22.25412321346316</cx:pt>
          <cx:pt idx="800">32.545045705913516</cx:pt>
          <cx:pt idx="801">41.95521421706723</cx:pt>
          <cx:pt idx="802">11.345483682946266</cx:pt>
          <cx:pt idx="803">12.679234992695735</cx:pt>
          <cx:pt idx="804">16.994675636798721</cx:pt>
          <cx:pt idx="805">0.0081088285220492842</cx:pt>
          <cx:pt idx="806">27.389742605581379</cx:pt>
          <cx:pt idx="807">63.619415275527338</cx:pt>
          <cx:pt idx="808">24.502265201405361</cx:pt>
          <cx:pt idx="809">59.294434814744626</cx:pt>
          <cx:pt idx="810">39.218618027666402</cx:pt>
          <cx:pt idx="811">13.091218430688567</cx:pt>
          <cx:pt idx="812">0.01016065942741907</cx:pt>
          <cx:pt idx="813">33.525363532704603</cx:pt>
          <cx:pt idx="814">24.70064776478544</cx:pt>
          <cx:pt idx="815">45.98064810330537</cx:pt>
          <cx:pt idx="816">61.679494161349922</cx:pt>
          <cx:pt idx="817">35.782677373276584</cx:pt>
          <cx:pt idx="818">26.036820082337243</cx:pt>
          <cx:pt idx="819">15.73620030375821</cx:pt>
          <cx:pt idx="820">36.324647279774105</cx:pt>
          <cx:pt idx="821">0.0061078883421359304</cx:pt>
          <cx:pt idx="822">40.489134344907896</cx:pt>
          <cx:pt idx="823">0.055735715658812524</cx:pt>
          <cx:pt idx="824">43.268464266715085</cx:pt>
          <cx:pt idx="825">42.962774584516765</cx:pt>
          <cx:pt idx="826">43.416241200730397</cx:pt>
          <cx:pt idx="827">43.21724192958176</cx:pt>
          <cx:pt idx="828">30.064929735490821</cx:pt>
          <cx:pt idx="829">40.582754958233188</cx:pt>
          <cx:pt idx="830">49.935758730593051</cx:pt>
          <cx:pt idx="831">0.0045009443453568714</cx:pt>
          <cx:pt idx="832">21.456490859411286</cx:pt>
          <cx:pt idx="833">50.226188388130751</cx:pt>
          <cx:pt idx="834">45.924612137719798</cx:pt>
          <cx:pt idx="835">0.0055279652676188187</cx:pt>
          <cx:pt idx="836">42.283211798537728</cx:pt>
          <cx:pt idx="837">41.79365980624334</cx:pt>
          <cx:pt idx="838">41.136601706995684</cx:pt>
          <cx:pt idx="839">32.06228313766816</cx:pt>
          <cx:pt idx="840">40.012747968616203</cx:pt>
          <cx:pt idx="841">0.00084180401519593612</cx:pt>
          <cx:pt idx="842">40.582754958233188</cx:pt>
          <cx:pt idx="843">47.992499413970933</cx:pt>
          <cx:pt idx="844">0.014176600438751174</cx:pt>
          <cx:pt idx="845">0.087472910092210837</cx:pt>
          <cx:pt idx="846">46.04758408429263</cx:pt>
          <cx:pt idx="847">60.424084602085614</cx:pt>
          <cx:pt idx="848">46.841541392230042</cx:pt>
          <cx:pt idx="849">24.758836806279895</cx:pt>
          <cx:pt idx="850">27.698736433274352</cx:pt>
          <cx:pt idx="851">23.930503546728808</cx:pt>
          <cx:pt idx="852">36.738127333874822</cx:pt>
          <cx:pt idx="853">34.211255457816804</cx:pt>
          <cx:pt idx="854">30.89590587764016</cx:pt>
          <cx:pt idx="855">0.0010398846089831313</cx:pt>
          <cx:pt idx="856">21.726964813337364</cx:pt>
          <cx:pt idx="857">35.352651951444884</cx:pt>
          <cx:pt idx="858">43.192360435614077</cx:pt>
          <cx:pt idx="859">16.278114141386279</cx:pt>
          <cx:pt idx="860">40.582754958233188</cx:pt>
          <cx:pt idx="861">37.629908317719831</cx:pt>
          <cx:pt idx="862">0.0068857025785318375</cx:pt>
          <cx:pt idx="863">24.495101551126503</cx:pt>
          <cx:pt idx="864">35.132890572795169</cx:pt>
          <cx:pt idx="865">20.757239700885087</cx:pt>
          <cx:pt idx="866">0.029777609037664528</cx:pt>
          <cx:pt idx="867">23.637977916903129</cx:pt>
          <cx:pt idx="868">30.819360798043817</cx:pt>
          <cx:pt idx="869">27.822131478375269</cx:pt>
          <cx:pt idx="870">52.681211071880277</cx:pt>
          <cx:pt idx="871">46.030533344726734</cx:pt>
          <cx:pt idx="872">13.239410863025592</cx:pt>
          <cx:pt idx="873">15.83448767721899</cx:pt>
          <cx:pt idx="874">21.858499491044668</cx:pt>
          <cx:pt idx="875">0.010868486555174093</cx:pt>
          <cx:pt idx="876">39.800376882637686</cx:pt>
          <cx:pt idx="877">40.168893437584266</cx:pt>
          <cx:pt idx="878">66.556667584848327</cx:pt>
          <cx:pt idx="879">43.656843678855211</cx:pt>
          <cx:pt idx="880">0.048031031635808116</cx:pt>
          <cx:pt idx="881">64.51759449948517</cx:pt>
          <cx:pt idx="882">31.997031112276652</cx:pt>
          <cx:pt idx="883">82.15041083281325</cx:pt>
          <cx:pt idx="884">4.0924564750281709</cx:pt>
          <cx:pt idx="885">47.17806693793208</cx:pt>
          <cx:pt idx="886">14.191405850020638</cx:pt>
          <cx:pt idx="887">41.390941037864799</cx:pt>
          <cx:pt idx="888">33.396107557618151</cx:pt>
          <cx:pt idx="889">58.389639491950959</cx:pt>
          <cx:pt idx="890">26.391854804086812</cx:pt>
          <cx:pt idx="891">0.16918303697475112</cx:pt>
          <cx:pt idx="892">45.234279037031193</cx:pt>
          <cx:pt idx="893">40.582754958233188</cx:pt>
          <cx:pt idx="894">47.079825828055057</cx:pt>
          <cx:pt idx="895">51.82673055480155</cx:pt>
          <cx:pt idx="896">40.582754958233188</cx:pt>
          <cx:pt idx="897">13.544851420373721</cx:pt>
          <cx:pt idx="898">14.615334412869244</cx:pt>
          <cx:pt idx="899">31.182992159188316</cx:pt>
          <cx:pt idx="900">47.074727827147342</cx:pt>
          <cx:pt idx="901">27.262061550807193</cx:pt>
          <cx:pt idx="902">37.669350936802722</cx:pt>
          <cx:pt idx="903">35.543775826436899</cx:pt>
          <cx:pt idx="904">0.006486169902184185</cx:pt>
          <cx:pt idx="905">5.095684448629056</cx:pt>
          <cx:pt idx="906">45.483953214293059</cx:pt>
          <cx:pt idx="907">14.54073588234103</cx:pt>
          <cx:pt idx="908">0.0029742679771668189</cx:pt>
          <cx:pt idx="909">26.557786052304888</cx:pt>
          <cx:pt idx="910">32.080991256505776</cx:pt>
          <cx:pt idx="911">0.0019506486100781964</cx:pt>
          <cx:pt idx="912">47.38554631952659</cx:pt>
          <cx:pt idx="913">37.706232906510294</cx:pt>
          <cx:pt idx="914">52.971124209327478</cx:pt>
          <cx:pt idx="915">29.006533746726788</cx:pt>
          <cx:pt idx="916">30.948004782214962</cx:pt>
          <cx:pt idx="917">53.869100605077861</cx:pt>
          <cx:pt idx="918">48.3235967204429</cx:pt>
          <cx:pt idx="919">48.731201503759372</cx:pt>
          <cx:pt idx="920">54.138526023525976</cx:pt>
          <cx:pt idx="921">54.29060692237654</cx:pt>
          <cx:pt idx="922">47.231663108554628</cx:pt>
          <cx:pt idx="923">26.985662860118893</cx:pt>
          <cx:pt idx="924">51.046253535396701</cx:pt>
          <cx:pt idx="925">49.534634348100319</cx:pt>
          <cx:pt idx="926">43.304849612947507</cx:pt>
          <cx:pt idx="927">56.983067660490164</cx:pt>
          <cx:pt idx="928">32.017026720168758</cx:pt>
          <cx:pt idx="929">52.352363843478933</cx:pt>
          <cx:pt idx="930">12.890694317995443</cx:pt>
          <cx:pt idx="931">52.211301458592274</cx:pt>
          <cx:pt idx="932">27.198474221911788</cx:pt>
          <cx:pt idx="933">9.5159234969602409</cx:pt>
          <cx:pt idx="934">56.632058059018121</cx:pt>
          <cx:pt idx="935">0.035465335188039605</cx:pt>
          <cx:pt idx="936">53.025654168524881</cx:pt>
          <cx:pt idx="937">0.020657734628947093</cx:pt>
          <cx:pt idx="938">22.076571291756338</cx:pt>
          <cx:pt idx="939">11.065215768343608</cx:pt>
          <cx:pt idx="940">42.053061719689325</cx:pt>
          <cx:pt idx="941">38.220151752707629</cx:pt>
          <cx:pt idx="942">45.265549814400799</cx:pt>
          <cx:pt idx="943">19.063945027197281</cx:pt>
          <cx:pt idx="944">55.323322387578997</cx:pt>
          <cx:pt idx="945">48.030198833650481</cx:pt>
          <cx:pt idx="946">0.0059591610147738082</cx:pt>
          <cx:pt idx="947">44.687134613890834</cx:pt>
          <cx:pt idx="948">27.397737132836355</cx:pt>
          <cx:pt idx="949">6.0180893978072474e-06</cx:pt>
          <cx:pt idx="950">41.534925063132114</cx:pt>
          <cx:pt idx="951">33.839621747294991</cx:pt>
          <cx:pt idx="952">29.509676379113341</cx:pt>
          <cx:pt idx="953">59.848141157432785</cx:pt>
          <cx:pt idx="954">44.208257147279625</cx:pt>
          <cx:pt idx="955">34.486954055120613</cx:pt>
          <cx:pt idx="956">39.337895215682295</cx:pt>
          <cx:pt idx="957">26.233490046122341</cx:pt>
          <cx:pt idx="958">0.018012467904204577</cx:pt>
          <cx:pt idx="959">53.943674327950632</cx:pt>
          <cx:pt idx="960">44.997333254316302</cx:pt>
          <cx:pt idx="961">46.283582402402686</cx:pt>
          <cx:pt idx="962">38.05482886573003</cx:pt>
          <cx:pt idx="963">24.344424412994449</cx:pt>
          <cx:pt idx="964">28.350643731668601</cx:pt>
          <cx:pt idx="965">40.582754958233188</cx:pt>
          <cx:pt idx="966">26.153871606322461</cx:pt>
          <cx:pt idx="967">57.027624884787201</cx:pt>
          <cx:pt idx="968">33.012724819378356</cx:pt>
          <cx:pt idx="969">47.397679268082314</cx:pt>
          <cx:pt idx="970">41.982615449731092</cx:pt>
          <cx:pt idx="971">53.825737338191658</cx:pt>
          <cx:pt idx="972">0.0044008181057617005</cx:pt>
          <cx:pt idx="973">48.942619464021334</cx:pt>
          <cx:pt idx="974">8.077573893193426</cx:pt>
          <cx:pt idx="975">27.257732847762668</cx:pt>
          <cx:pt idx="976">60.569794452350592</cx:pt>
          <cx:pt idx="977">56.83678386397316</cx:pt>
          <cx:pt idx="978">28.31879234713232</cx:pt>
          <cx:pt idx="979">26.167690001220972</cx:pt>
          <cx:pt idx="980">40.582754958233188</cx:pt>
          <cx:pt idx="981">48.324320998851093</cx:pt>
          <cx:pt idx="982">0.38370301015238334</cx:pt>
          <cx:pt idx="983">34.195613753813511</cx:pt>
          <cx:pt idx="984">42.043073151233848</cx:pt>
          <cx:pt idx="985">48.991631938525991</cx:pt>
          <cx:pt idx="986">28.637038953076139</cx:pt>
          <cx:pt idx="987">0.041407728747179552</cx:pt>
          <cx:pt idx="988">22.029094398090905</cx:pt>
          <cx:pt idx="989">42.613964847218803</cx:pt>
          <cx:pt idx="990">52.052377467316511</cx:pt>
          <cx:pt idx="991">44.23324541563732</cx:pt>
          <cx:pt idx="992">45.949428723325816</cx:pt>
          <cx:pt idx="993">40.582754958233188</cx:pt>
          <cx:pt idx="994">56.081458611558958</cx:pt>
          <cx:pt idx="995">23.983890426701006</cx:pt>
          <cx:pt idx="996">0.0099683348659643251</cx:pt>
          <cx:pt idx="997">54.284159752178176</cx:pt>
          <cx:pt idx="998">0.0046102819870372357</cx:pt>
          <cx:pt idx="999">23.970982457963625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sz="140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l-GR" altLang="ja-JP" sz="1200" b="0" i="0" u="none" strike="noStrike" baseline="0" dirty="0">
                <a:solidFill>
                  <a:schemeClr val="tx1"/>
                </a:solidFill>
                <a:effectLst/>
                <a:latin typeface="Calibri"/>
                <a:ea typeface="ＭＳ Ｐゴシック" panose="020B0600070205080204" pitchFamily="50" charset="-128"/>
                <a:cs typeface="Calibri" panose="020F0502020204030204" pitchFamily="34" charset="0"/>
              </a:rPr>
              <a:t>ω</a:t>
            </a:r>
            <a:r>
              <a:rPr lang="en-US" altLang="ja-JP" sz="1200" b="0" i="0" u="none" strike="noStrike" baseline="0" dirty="0">
                <a:solidFill>
                  <a:schemeClr val="tx1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lang="en-US" altLang="ja-JP" sz="1200" b="0" i="0" u="none" strike="noStrike" baseline="0" dirty="0" err="1">
                <a:solidFill>
                  <a:schemeClr val="tx1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e</a:t>
            </a:r>
            <a:r>
              <a:rPr lang="en-US" altLang="ja-JP" sz="1200" b="0" i="0" u="none" strike="noStrike" baseline="0" dirty="0">
                <a:solidFill>
                  <a:schemeClr val="tx1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endParaRPr lang="ja-JP" altLang="en-US" sz="1200" b="0" i="0" u="none" strike="noStrike" baseline="0" dirty="0">
              <a:solidFill>
                <a:schemeClr val="tx1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cx:rich>
      </cx:tx>
    </cx:title>
    <cx:plotArea>
      <cx:plotAreaRegion>
        <cx:series layoutId="clusteredColumn" uniqueId="{C81E1BEB-3B5C-46A8-9B50-42E7A265D31A}">
          <cx:tx>
            <cx:txData>
              <cx:f>PK!$T$1</cx:f>
              <cx:v>omega nKe (%)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Count val="15"/>
            </cx:binning>
          </cx:layoutPr>
        </cx:series>
      </cx:plotAreaRegion>
      <cx:axis id="0">
        <cx:catScaling gapWidth="0"/>
        <cx:tickLabels/>
        <cx:numFmt formatCode="#,##0.0_);[赤](#,##0.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6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PK!$U$2:$U$1001</cx:f>
        <cx:lvl ptCount="1000" formatCode="G/標準">
          <cx:pt idx="0">19.904095056043118</cx:pt>
          <cx:pt idx="1">12.034949106664307</cx:pt>
          <cx:pt idx="2">104.98190320240911</cx:pt>
          <cx:pt idx="3">54.804653087123903</cx:pt>
          <cx:pt idx="4">32.853919096509628</cx:pt>
          <cx:pt idx="5">88.742943381431743</cx:pt>
          <cx:pt idx="6">26.544792332960526</cx:pt>
          <cx:pt idx="7">37.635887129174996</cx:pt>
          <cx:pt idx="8">15.074647591237417</cx:pt>
          <cx:pt idx="9">16.006436205476845</cx:pt>
          <cx:pt idx="10">30.263311120893562</cx:pt>
          <cx:pt idx="11">77.771202896702079</cx:pt>
          <cx:pt idx="12">65.272046084062666</cx:pt>
          <cx:pt idx="13">45.733248299240678</cx:pt>
          <cx:pt idx="14">103.13777193637644</cx:pt>
          <cx:pt idx="15">28.354770321764207</cx:pt>
          <cx:pt idx="16">54.258271258859693</cx:pt>
          <cx:pt idx="17">18.858685001876456</cx:pt>
          <cx:pt idx="18">96.777270058624822</cx:pt>
          <cx:pt idx="19">0.0086281863679454687</cx:pt>
          <cx:pt idx="20">99.080724664285739</cx:pt>
          <cx:pt idx="21">46.803845995815344</cx:pt>
          <cx:pt idx="22">0.074298990571877888</cx:pt>
          <cx:pt idx="23">72.223749556499754</cx:pt>
          <cx:pt idx="24">0.017471233499670252</cx:pt>
          <cx:pt idx="25">0.028254291709402305</cx:pt>
          <cx:pt idx="26">54.258271258859693</cx:pt>
          <cx:pt idx="27">29.094157489090485</cx:pt>
          <cx:pt idx="28">85.634630845236899</cx:pt>
          <cx:pt idx="29">65.107142465324031</cx:pt>
          <cx:pt idx="30">40.474806979156796</cx:pt>
          <cx:pt idx="31">60.154717188263795</cx:pt>
          <cx:pt idx="32">0.0015581046177968925</cx:pt>
          <cx:pt idx="33">0.034019700175045631</cx:pt>
          <cx:pt idx="34">54.258271258859693</cx:pt>
          <cx:pt idx="35">54.258271258859693</cx:pt>
          <cx:pt idx="36">49.598084640437477</cx:pt>
          <cx:pt idx="37">95.53507209396976</cx:pt>
          <cx:pt idx="38">100.93661377319927</cx:pt>
          <cx:pt idx="39">72.838176803102371</cx:pt>
          <cx:pt idx="40">60.882345552713389</cx:pt>
          <cx:pt idx="41">0.078071505685493217</cx:pt>
          <cx:pt idx="42">52.731679282950964</cx:pt>
          <cx:pt idx="43">14.612494653549065</cx:pt>
          <cx:pt idx="44">47.9578982024859</cx:pt>
          <cx:pt idx="45">102.49829266870741</cx:pt>
          <cx:pt idx="46">66.700374811540613</cx:pt>
          <cx:pt idx="47">24.300514397847632</cx:pt>
          <cx:pt idx="48">0.025098187185531945</cx:pt>
          <cx:pt idx="49">23.80348713949282</cx:pt>
          <cx:pt idx="50">68.270271714707562</cx:pt>
          <cx:pt idx="51">0.050447001893075868</cx:pt>
          <cx:pt idx="52">16.687630149305203</cx:pt>
          <cx:pt idx="53">0.076792773097473177</cx:pt>
          <cx:pt idx="54">56.314030223382161</cx:pt>
          <cx:pt idx="55">0.00087465250242596353</cx:pt>
          <cx:pt idx="56">32.516149833582695</cx:pt>
          <cx:pt idx="57">79.08849473848899</cx:pt>
          <cx:pt idx="58">80.377297789861032</cx:pt>
          <cx:pt idx="59">26.142073368422786</cx:pt>
          <cx:pt idx="60">38.470768123342694</cx:pt>
          <cx:pt idx="61">19.960460916521942</cx:pt>
          <cx:pt idx="62">58.166399235297348</cx:pt>
          <cx:pt idx="63">54.227576010734616</cx:pt>
          <cx:pt idx="64">26.076828794928264</cx:pt>
          <cx:pt idx="65">9.8132716257117831</cx:pt>
          <cx:pt idx="66">63.907120104101075</cx:pt>
          <cx:pt idx="67">0.015497193294271063</cx:pt>
          <cx:pt idx="68">55.259207377594556</cx:pt>
          <cx:pt idx="69">8.5755757824183441</cx:pt>
          <cx:pt idx="70">100.54551208283739</cx:pt>
          <cx:pt idx="71">104.33839178365747</cx:pt>
          <cx:pt idx="72">46.067233474564105</cx:pt>
          <cx:pt idx="73">58.700511071029013</cx:pt>
          <cx:pt idx="74">55.598920852836706</cx:pt>
          <cx:pt idx="75">76.889596175295395</cx:pt>
          <cx:pt idx="76">15.787970103848057</cx:pt>
          <cx:pt idx="77">62.969516434541561</cx:pt>
          <cx:pt idx="78">7.1740922770758955</cx:pt>
          <cx:pt idx="79">80.39900496896712</cx:pt>
          <cx:pt idx="80">70.68670313432365</cx:pt>
          <cx:pt idx="81">108.31758859945137</cx:pt>
          <cx:pt idx="82">54.258271258859693</cx:pt>
          <cx:pt idx="83">93.467962425635449</cx:pt>
          <cx:pt idx="84">63.900312988278863</cx:pt>
          <cx:pt idx="85">32.540897344726069</cx:pt>
          <cx:pt idx="86">88.140058997030408</cx:pt>
          <cx:pt idx="87">107.54115491289835</cx:pt>
          <cx:pt idx="88">34.419035430993702</cx:pt>
          <cx:pt idx="89">75.291500184283748</cx:pt>
          <cx:pt idx="90">15.624083973148634</cx:pt>
          <cx:pt idx="91">59.550734672210382</cx:pt>
          <cx:pt idx="92">0.093588941654449753</cx:pt>
          <cx:pt idx="93">67.255929106659437</cx:pt>
          <cx:pt idx="94">51.132866143019996</cx:pt>
          <cx:pt idx="95">109.7328574311268</cx:pt>
          <cx:pt idx="96">83.623680856561194</cx:pt>
          <cx:pt idx="97">31.439004437163721</cx:pt>
          <cx:pt idx="98">0.026917169241954104</cx:pt>
          <cx:pt idx="99">54.258271258859693</cx:pt>
          <cx:pt idx="100">87.694127511481639</cx:pt>
          <cx:pt idx="101">54.258271258859693</cx:pt>
          <cx:pt idx="102">54.258271258859693</cx:pt>
          <cx:pt idx="103">0.32701834810909308</cx:pt>
          <cx:pt idx="104">56.720014104370598</cx:pt>
          <cx:pt idx="105">63.659720388955535</cx:pt>
          <cx:pt idx="106">69.676825415628684</cx:pt>
          <cx:pt idx="107">18.908490156540793</cx:pt>
          <cx:pt idx="108">9.1900326441204765</cx:pt>
          <cx:pt idx="109">43.481950278247645</cx:pt>
          <cx:pt idx="110">54.742396732331699</cx:pt>
          <cx:pt idx="111">38.133449883271773</cx:pt>
          <cx:pt idx="112">20.988044215695751</cx:pt>
          <cx:pt idx="113">100.93314619093175</cx:pt>
          <cx:pt idx="114">81.982071210722651</cx:pt>
          <cx:pt idx="115">56.722394166678129</cx:pt>
          <cx:pt idx="116">13.039133406787432</cx:pt>
          <cx:pt idx="117">8.6903509710482929</cx:pt>
          <cx:pt idx="118">54.258271258859693</cx:pt>
          <cx:pt idx="119">61.100245498688466</cx:pt>
          <cx:pt idx="120">75.051049293131143</cx:pt>
          <cx:pt idx="121">60.73343395527705</cx:pt>
          <cx:pt idx="122">86.376212003074087</cx:pt>
          <cx:pt idx="123">98.093679714852172</cx:pt>
          <cx:pt idx="124">20.17728921337056</cx:pt>
          <cx:pt idx="125">17.915551903304568</cx:pt>
          <cx:pt idx="126">67.7293141852182</cx:pt>
          <cx:pt idx="127">51.03900469248984</cx:pt>
          <cx:pt idx="128">0.014686149937951745</cx:pt>
          <cx:pt idx="129">58.64571595606963</cx:pt>
          <cx:pt idx="130">14.760250675378112</cx:pt>
          <cx:pt idx="131">37.256140433490962</cx:pt>
          <cx:pt idx="132">26.740755411917593</cx:pt>
          <cx:pt idx="133">88.132967724909847</cx:pt>
          <cx:pt idx="134">75.371480017311583</cx:pt>
          <cx:pt idx="135">0.32738814883865297</cx:pt>
          <cx:pt idx="136">54.258271258859693</cx:pt>
          <cx:pt idx="137">63.610533718873953</cx:pt>
          <cx:pt idx="138">65.402064187608019</cx:pt>
          <cx:pt idx="139">57.24360226261097</cx:pt>
          <cx:pt idx="140">0.027852612085763159</cx:pt>
          <cx:pt idx="141">1.2865768535147832</cx:pt>
          <cx:pt idx="142">15.128846618298436</cx:pt>
          <cx:pt idx="143">35.048109792112896</cx:pt>
          <cx:pt idx="144">8.9197421487395019</cx:pt>
          <cx:pt idx="145">54.258271258859693</cx:pt>
          <cx:pt idx="146">0.17886279657883022</cx:pt>
          <cx:pt idx="147">35.870461385379478</cx:pt>
          <cx:pt idx="148">36.238929344007943</cx:pt>
          <cx:pt idx="149">0.0081881072293906853</cx:pt>
          <cx:pt idx="150">64.84088216549803</cx:pt>
          <cx:pt idx="151">57.429870276712272</cx:pt>
          <cx:pt idx="152">65.877689698410038</cx:pt>
          <cx:pt idx="153">54.291251597287761</cx:pt>
          <cx:pt idx="154">0.21614323954266995</cx:pt>
          <cx:pt idx="155">62.93298022499809</cx:pt>
          <cx:pt idx="156">55.520716854161748</cx:pt>
          <cx:pt idx="157">71.340381271759398</cx:pt>
          <cx:pt idx="158">91.19446255118784</cx:pt>
          <cx:pt idx="159">95.564271566312897</cx:pt>
          <cx:pt idx="160">28.358138161734104</cx:pt>
          <cx:pt idx="161">0.033218067373042635</cx:pt>
          <cx:pt idx="162">0.19142727078449404</cx:pt>
          <cx:pt idx="163">23.79399083802463</cx:pt>
          <cx:pt idx="164">0.40891197096685733</cx:pt>
          <cx:pt idx="165">47.964778744407859</cx:pt>
          <cx:pt idx="166">0.00011460890017795302</cx:pt>
          <cx:pt idx="167">48.888546715974286</cx:pt>
          <cx:pt idx="168">61.345252465044112</cx:pt>
          <cx:pt idx="169">34.562841318387008</cx:pt>
          <cx:pt idx="170">19.661027440090713</cx:pt>
          <cx:pt idx="171">81.242968926547732</cx:pt>
          <cx:pt idx="172">32.535211694408879</cx:pt>
          <cx:pt idx="173">35.183660980631338</cx:pt>
          <cx:pt idx="174">60.754752900493301</cx:pt>
          <cx:pt idx="175">22.170182678543721</cx:pt>
          <cx:pt idx="176">38.421998906876254</cx:pt>
          <cx:pt idx="177">59.840705209748322</cx:pt>
          <cx:pt idx="178">90.062811415145148</cx:pt>
          <cx:pt idx="179">11.258108189211898</cx:pt>
          <cx:pt idx="180">0.0021972801368965221</cx:pt>
          <cx:pt idx="181">60.41829193216239</cx:pt>
          <cx:pt idx="182">105.37741693550853</cx:pt>
          <cx:pt idx="183">0.18624124140479734</cx:pt>
          <cx:pt idx="184">56.702116362619122</cx:pt>
          <cx:pt idx="185">57.176656075709772</cx:pt>
          <cx:pt idx="186">53.856011734995747</cx:pt>
          <cx:pt idx="187">16.84532576117185</cx:pt>
          <cx:pt idx="188">87.467651163158592</cx:pt>
          <cx:pt idx="189">65.377060196983479</cx:pt>
          <cx:pt idx="190">54.258271258859693</cx:pt>
          <cx:pt idx="191">117.48361587898117</cx:pt>
          <cx:pt idx="192">70.521911488557947</cx:pt>
          <cx:pt idx="193">108.03980747854006</cx:pt>
          <cx:pt idx="194">82.325937589559231</cx:pt>
          <cx:pt idx="195">0.010303494552820418</cx:pt>
          <cx:pt idx="196">24.40651552352363</cx:pt>
          <cx:pt idx="197">0.00023672241127531632</cx:pt>
          <cx:pt idx="198">60.78067126973837</cx:pt>
          <cx:pt idx="199">62.930119974460567</cx:pt>
          <cx:pt idx="200">75.366902550124749</cx:pt>
          <cx:pt idx="201">81.999329265549477</cx:pt>
          <cx:pt idx="202">0.011638900291694228</cx:pt>
          <cx:pt idx="203">0.032082393925640898</cx:pt>
          <cx:pt idx="204">92.86339429506117</cx:pt>
          <cx:pt idx="205">0.061844563221030192</cx:pt>
          <cx:pt idx="206">77.005779003916317</cx:pt>
          <cx:pt idx="207">83.544179928945383</cx:pt>
          <cx:pt idx="208">0.038061923230441205</cx:pt>
          <cx:pt idx="209">87.148723455940541</cx:pt>
          <cx:pt idx="210">0.0012491957412671562</cx:pt>
          <cx:pt idx="211">73.388623096499089</cx:pt>
          <cx:pt idx="212">62.213342620373645</cx:pt>
          <cx:pt idx="213">87.980566035915004</cx:pt>
          <cx:pt idx="214">50.151370868601383</cx:pt>
          <cx:pt idx="215">19.17933784049908</cx:pt>
          <cx:pt idx="216">17.358196910969756</cx:pt>
          <cx:pt idx="217">25.510723235533721</cx:pt>
          <cx:pt idx="218">0.021625933505862813</cx:pt>
          <cx:pt idx="219">13.735428642747195</cx:pt>
          <cx:pt idx="220">42.601525794271737</cx:pt>
          <cx:pt idx="221">20.039860278954041</cx:pt>
          <cx:pt idx="222">14.283486969224288</cx:pt>
          <cx:pt idx="223">87.165474816580897</cx:pt>
          <cx:pt idx="224">16.366887303332909</cx:pt>
          <cx:pt idx="225">27.798525140733638</cx:pt>
          <cx:pt idx="226">0.021040223382844586</cx:pt>
          <cx:pt idx="227">29.813117918124565</cx:pt>
          <cx:pt idx="228">54.258271258859693</cx:pt>
          <cx:pt idx="229">32.276462011812882</cx:pt>
          <cx:pt idx="230">89.703846071392064</cx:pt>
          <cx:pt idx="231">31.420964339116008</cx:pt>
          <cx:pt idx="232">70.402059628962562</cx:pt>
          <cx:pt idx="233">61.75321853960326</cx:pt>
          <cx:pt idx="234">0.032617939849107574</cx:pt>
          <cx:pt idx="235">6.7912075509440877</cx:pt>
          <cx:pt idx="236">54.393381950380693</cx:pt>
          <cx:pt idx="237">68.771433022731173</cx:pt>
          <cx:pt idx="238">0.062020883579645976</cx:pt>
          <cx:pt idx="239">8.7619461308547191</cx:pt>
          <cx:pt idx="240">0.070144850131709596</cx:pt>
          <cx:pt idx="241">25.550635999912018</cx:pt>
          <cx:pt idx="242">0.0096288732466472942</cx:pt>
          <cx:pt idx="243">87.357999061333814</cx:pt>
          <cx:pt idx="244">59.193918606559571</cx:pt>
          <cx:pt idx="245">87.802847334240823</cx:pt>
          <cx:pt idx="246">79.033980033906943</cx:pt>
          <cx:pt idx="247">54.258271258859693</cx:pt>
          <cx:pt idx="248">83.6562609731035</cx:pt>
          <cx:pt idx="249">104.7888352831541</cx:pt>
          <cx:pt idx="250">0.25881228718899729</cx:pt>
          <cx:pt idx="251">78.999620252251844</cx:pt>
          <cx:pt idx="252">0.15079157801415832</cx:pt>
          <cx:pt idx="253">29.805888679923637</cx:pt>
          <cx:pt idx="254">98.933967877569742</cx:pt>
          <cx:pt idx="255">68.005514482282976</cx:pt>
          <cx:pt idx="256">79.87001940653326</cx:pt>
          <cx:pt idx="257">3.3861630202930275</cx:pt>
          <cx:pt idx="258">89.482065242147826</cx:pt>
          <cx:pt idx="259">49.130235090013564</cx:pt>
          <cx:pt idx="260">68.321299753444393</cx:pt>
          <cx:pt idx="261">0.025551223062702886</cx:pt>
          <cx:pt idx="262">93.260763453877004</cx:pt>
          <cx:pt idx="263">20.710504581009126</cx:pt>
          <cx:pt idx="264">61.318349619016978</cx:pt>
          <cx:pt idx="265">31.743975806442393</cx:pt>
          <cx:pt idx="266">74.050590814658591</cx:pt>
          <cx:pt idx="267">23.803802217292937</cx:pt>
          <cx:pt idx="268">31.379595281010236</cx:pt>
          <cx:pt idx="269">54.258271258859693</cx:pt>
          <cx:pt idx="270">0.3028682882046253</cx:pt>
          <cx:pt idx="271">0.051125140586603772</cx:pt>
          <cx:pt idx="272">0.0041534925063132109</cx:pt>
          <cx:pt idx="273">97.562082798595483</cx:pt>
          <cx:pt idx="274">67.907657889224836</cx:pt>
          <cx:pt idx="275">14.42272512391469</cx:pt>
          <cx:pt idx="276">24.739341139165369</cx:pt>
          <cx:pt idx="277">29.86019089021368</cx:pt>
          <cx:pt idx="278">67.890352775633744</cx:pt>
          <cx:pt idx="279">74.785626961335296</cx:pt>
          <cx:pt idx="280">79.910512449864825</cx:pt>
          <cx:pt idx="281">60.999672130266404</cx:pt>
          <cx:pt idx="282">0.072160792678573032</cx:pt>
          <cx:pt idx="283">76.671833159250852</cx:pt>
          <cx:pt idx="284">0.13767461639677811</cx:pt>
          <cx:pt idx="285">54.258271258859693</cx:pt>
          <cx:pt idx="286">50.203983905662305</cx:pt>
          <cx:pt idx="287">57.696447030991436</cx:pt>
          <cx:pt idx="288">34.787928940941569</cx:pt>
          <cx:pt idx="289">58.932334079009628</cx:pt>
          <cx:pt idx="290">30.361126461315628</cx:pt>
          <cx:pt idx="291">54.258271258859693</cx:pt>
          <cx:pt idx="292">81.891818883207122</cx:pt>
          <cx:pt idx="293">0.00259312745540978</cx:pt>
          <cx:pt idx="294">107.65825560541096</cx:pt>
          <cx:pt idx="295">68.655589721449488</cx:pt>
          <cx:pt idx="296">21.778934776522014</cx:pt>
          <cx:pt idx="297">10.045844912201263</cx:pt>
          <cx:pt idx="298">0.044904565469448647</cx:pt>
          <cx:pt idx="299">15.938820533527567</cx:pt>
          <cx:pt idx="300">17.161031437533119</cx:pt>
          <cx:pt idx="301">55.60341716117815</cx:pt>
          <cx:pt idx="302">0.17886950550610911</cx:pt>
          <cx:pt idx="303">16.159733908700353</cx:pt>
          <cx:pt idx="304">54.258271258859693</cx:pt>
          <cx:pt idx="305">1.106544169927256</cx:pt>
          <cx:pt idx="306">33.030137753270118</cx:pt>
          <cx:pt idx="307">0.0055991785111746519</cx:pt>
          <cx:pt idx="308">0.0025540360216723648</cx:pt>
          <cx:pt idx="309">54.258271258859693</cx:pt>
          <cx:pt idx="310">30.66049575593976</cx:pt>
          <cx:pt idx="311">58.463407358791528</cx:pt>
          <cx:pt idx="312">58.727761748597231</cx:pt>
          <cx:pt idx="313">13.655621553045471</cx:pt>
          <cx:pt idx="314">111.71347277745866</cx:pt>
          <cx:pt idx="315">0.0082596186352639784</cx:pt>
          <cx:pt idx="316">0.017491769493107323</cx:pt>
          <cx:pt idx="317">60.780095426052107</cx:pt>
          <cx:pt idx="318">0.019591120437586006</cx:pt>
          <cx:pt idx="319">49.989898979693884</cx:pt>
          <cx:pt idx="320">16.950988171785148</cx:pt>
          <cx:pt idx="321">55.945866692723598</cx:pt>
          <cx:pt idx="322">50.863739540069211</cx:pt>
          <cx:pt idx="323">43.064602633717634</cx:pt>
          <cx:pt idx="324">33.517756488166093</cx:pt>
          <cx:pt idx="325">22.145383266044416</cx:pt>
          <cx:pt idx="326">55.916366119410874</cx:pt>
          <cx:pt idx="327">22.390265742058535</cx:pt>
          <cx:pt idx="328">10.67679727259069</cx:pt>
          <cx:pt idx="329">9.021485465265684</cx:pt>
          <cx:pt idx="330">77.005064768494293</cx:pt>
          <cx:pt idx="331">0.0037149697172386212</cx:pt>
          <cx:pt idx="332">56.035881361855999</cx:pt>
          <cx:pt idx="333">75.927531238675201</cx:pt>
          <cx:pt idx="334">17.669833049579161</cx:pt>
          <cx:pt idx="335">83.530832630831597</cx:pt>
          <cx:pt idx="336">0.26375727478118971</cx:pt>
          <cx:pt idx="337">0.022587297315083982</cx:pt>
          <cx:pt idx="338">0.0075317328683378038</cx:pt>
          <cx:pt idx="339">0.059250485230080613</cx:pt>
          <cx:pt idx="340">64.100624021923537</cx:pt>
          <cx:pt idx="341">21.14901888977359</cx:pt>
          <cx:pt idx="342">55.440959587655044</cx:pt>
          <cx:pt idx="343">0.086825514683185154</cx:pt>
          <cx:pt idx="344">43.516433677405139</cx:pt>
          <cx:pt idx="345">49.202032478343817</cx:pt>
          <cx:pt idx="346">98.877651671143568</cx:pt>
          <cx:pt idx="347">52.647032205054067</cx:pt>
          <cx:pt idx="348">0.12667004381462887</cx:pt>
          <cx:pt idx="349">0.08012839696387293</cx:pt>
          <cx:pt idx="350">64.653538186243139</cx:pt>
          <cx:pt idx="351">29.31520083506166</cx:pt>
          <cx:pt idx="352">33.929485701967252</cx:pt>
          <cx:pt idx="353">87.672344556308062</cx:pt>
          <cx:pt idx="354">60.07278918112592</cx:pt>
          <cx:pt idx="355">20.365166338628317</cx:pt>
          <cx:pt idx="356">45.58629179918016</cx:pt>
          <cx:pt idx="357">23.507785944235582</cx:pt>
          <cx:pt idx="358">80.316374420164166</cx:pt>
          <cx:pt idx="359">79.1537743888439</cx:pt>
          <cx:pt idx="360">31.004531926800638</cx:pt>
          <cx:pt idx="361">54.629387695635032</cx:pt>
          <cx:pt idx="362">75.667760638200463</cx:pt>
          <cx:pt idx="363">54.258271258859693</cx:pt>
          <cx:pt idx="364">18.531001052290723</cx:pt>
          <cx:pt idx="365">0.081209851619123155</cx:pt>
          <cx:pt idx="366">26.867229109083802</cx:pt>
          <cx:pt idx="367">30.375401231917909</cx:pt>
          <cx:pt idx="368">80.36616203353249</cx:pt>
          <cx:pt idx="369">54.258271258859693</cx:pt>
          <cx:pt idx="370">0.007882804069618882</cx:pt>
          <cx:pt idx="371">0.01425015789386209</cx:pt>
          <cx:pt idx="372">56.753766394839388</cx:pt>
          <cx:pt idx="373">0.030813730705644846</cx:pt>
          <cx:pt idx="374">112.36058027618047</cx:pt>
          <cx:pt idx="375">0.11088687929597442</cx:pt>
          <cx:pt idx="376">54.258271258859693</cx:pt>
          <cx:pt idx="377">0.24846609426640084</cx:pt>
          <cx:pt idx="378">79.489810667783061</cx:pt>
          <cx:pt idx="379">54.258271258859693</cx:pt>
          <cx:pt idx="380">26.096149141204723</cx:pt>
          <cx:pt idx="381">0.075724434629781165</cx:pt>
          <cx:pt idx="382">24.067488443956922</cx:pt>
          <cx:pt idx="383">31.87114682593019</cx:pt>
          <cx:pt idx="384">78.113763191898528</cx:pt>
          <cx:pt idx="385">61.720337004912729</cx:pt>
          <cx:pt idx="386">60.209550737403781</cx:pt>
          <cx:pt idx="387">71.140775930544933</cx:pt>
          <cx:pt idx="388">75.778624954534507</cx:pt>
          <cx:pt idx="389">75.614813363520256</cx:pt>
          <cx:pt idx="390">86.930777058530879</cx:pt>
          <cx:pt idx="391">26.569907790581439</cx:pt>
          <cx:pt idx="392">67.874958563523265</cx:pt>
          <cx:pt idx="393">57.47251517029683</cx:pt>
          <cx:pt idx="394">54.258271258859693</cx:pt>
          <cx:pt idx="395">18.524929149662086</cx:pt>
          <cx:pt idx="396">26.081698564319005</cx:pt>
          <cx:pt idx="397">0.02626185446612634</cx:pt>
          <cx:pt idx="398">80.02680800831682</cx:pt>
          <cx:pt idx="399">27.113631258095989</cx:pt>
          <cx:pt idx="400">80.836996480571941</cx:pt>
          <cx:pt idx="401">54.258271258859693</cx:pt>
          <cx:pt idx="402">55.192300187616752</cx:pt>
          <cx:pt idx="403">83.561474376652782</cx:pt>
          <cx:pt idx="404">52.323417319590284</cx:pt>
          <cx:pt idx="405">78.335624079980377</cx:pt>
          <cx:pt idx="406">53.882000705244792</cx:pt>
          <cx:pt idx="407">0.058072196445459169</cx:pt>
          <cx:pt idx="408">74.943378626800651</cx:pt>
          <cx:pt idx="409">78.785087421414971</cx:pt>
          <cx:pt idx="410">0.057877024802593303</cx:pt>
          <cx:pt idx="411">31.903604811995773</cx:pt>
          <cx:pt idx="412">68.692576018082178</cx:pt>
          <cx:pt idx="413">65.560430138918406</cx:pt>
          <cx:pt idx="414">0.1645153488280045</cx:pt>
          <cx:pt idx="415">61.342562711383351</cx:pt>
          <cx:pt idx="416">19.915571796963299</cx:pt>
          <cx:pt idx="417">88.806306082394855</cx:pt>
          <cx:pt idx="418">0.92493837632568798</cx:pt>
          <cx:pt idx="419">64.907164473577183</cx:pt>
          <cx:pt idx="420">28.039721824583069</cx:pt>
          <cx:pt idx="421">65.969007874910474</cx:pt>
          <cx:pt idx="422">0.059604278369929119</cx:pt>
          <cx:pt idx="423">80.120596602871103</cx:pt>
          <cx:pt idx="424">99.003434283867136</cx:pt>
          <cx:pt idx="425">83.043663213998457</cx:pt>
          <cx:pt idx="426">53.48560554018249</cx:pt>
          <cx:pt idx="427">21.209290417173317</cx:pt>
          <cx:pt idx="428">89.405984139765508</cx:pt>
          <cx:pt idx="429">24.989517802470697</cx:pt>
          <cx:pt idx="430">64.015388774887555</cx:pt>
          <cx:pt idx="431">105.59403392237652</cx:pt>
          <cx:pt idx="432">66.927498085614999</cx:pt>
          <cx:pt idx="433">76.651549234180521</cx:pt>
          <cx:pt idx="434">28.895933970024224</cx:pt>
          <cx:pt idx="435">10.671504111417471</cx:pt>
          <cx:pt idx="436">0.0050166423033738416</cx:pt>
          <cx:pt idx="437">1.0896375544188994</cx:pt>
          <cx:pt idx="438">31.083146558866915</cx:pt>
          <cx:pt idx="439">53.60895447590822</cx:pt>
          <cx:pt idx="440">70.651256181330552</cx:pt>
          <cx:pt idx="441">26.537953952782416</cx:pt>
          <cx:pt idx="442">92.188773720014311</cx:pt>
          <cx:pt idx="443">54.258271258859693</cx:pt>
          <cx:pt idx="444">66.47164809149838</cx:pt>
          <cx:pt idx="445">0.00012828483932250141</cx:pt>
          <cx:pt idx="446">30.501344232672761</cx:pt>
          <cx:pt idx="447">63.941066616064511</cx:pt>
          <cx:pt idx="448">70.588667645734745</cx:pt>
          <cx:pt idx="449">32.687765295290525</cx:pt>
          <cx:pt idx="450">0.0046255053777938693</cx:pt>
          <cx:pt idx="451">0.20848357249433347</cx:pt>
          <cx:pt idx="452">68.096108552545047</cx:pt>
          <cx:pt idx="453">103.55191934483881</cx:pt>
          <cx:pt idx="454">69.4235550803904</cx:pt>
          <cx:pt idx="455">96.927962941557794</cx:pt>
          <cx:pt idx="456">67.677396522029426</cx:pt>
          <cx:pt idx="457">63.214001613566595</cx:pt>
          <cx:pt idx="458">84.398992884986484</cx:pt>
          <cx:pt idx="459">10.077648535248688</cx:pt>
          <cx:pt idx="460">12.85480454927262</cx:pt>
          <cx:pt idx="461">58.539900922362342</cx:pt>
          <cx:pt idx="462">113.80070298552643</cx:pt>
          <cx:pt idx="463">31.038121721521744</cx:pt>
          <cx:pt idx="464">45.865782452717404</cx:pt>
          <cx:pt idx="465">31.137774486947521</cx:pt>
          <cx:pt idx="466">54.678514976176885</cx:pt>
          <cx:pt idx="467">0.29301655243347602</cx:pt>
          <cx:pt idx="468">20.421900009548573</cx:pt>
          <cx:pt idx="469">90.135952871204509</cx:pt>
          <cx:pt idx="470">21.42633893132469</cx:pt>
          <cx:pt idx="471">38.243561549625575</cx:pt>
          <cx:pt idx="472">75.201728703534471</cx:pt>
          <cx:pt idx="473">18.129120221345545</cx:pt>
          <cx:pt idx="474">36.35698007260779</cx:pt>
          <cx:pt idx="475">25.338547708974957</cx:pt>
          <cx:pt idx="476">108.43707852944029</cx:pt>
          <cx:pt idx="477">98.909200785366778</cx:pt>
          <cx:pt idx="478">35.503520952153458</cx:pt>
          <cx:pt idx="479">0.022608759364458723</cx:pt>
          <cx:pt idx="480">33.550409833562391</cx:pt>
          <cx:pt idx="481">10.279348228365453</cx:pt>
          <cx:pt idx="482">0.2035541696944575</cx:pt>
          <cx:pt idx="483">29.913725946461433</cx:pt>
          <cx:pt idx="484">54.258271258859693</cx:pt>
          <cx:pt idx="485">57.570825945091322</cx:pt>
          <cx:pt idx="486">60.63744717581703</cx:pt>
          <cx:pt idx="487">27.561168335177666</cx:pt>
          <cx:pt idx="488">17.850938350686217</cx:pt>
          <cx:pt idx="489">18.776314867406757</cx:pt>
          <cx:pt idx="490">54.258271258859693</cx:pt>
          <cx:pt idx="491">72.320951321176636</cx:pt>
          <cx:pt idx="492">24.67561549384331</cx:pt>
          <cx:pt idx="493">55.491260573174941</cx:pt>
          <cx:pt idx="494">0.12208685432920287</cx:pt>
          <cx:pt idx="495">24.929580822789621</cx:pt>
          <cx:pt idx="496">33.160217128360301</cx:pt>
          <cx:pt idx="497">44.189704683330937</cx:pt>
          <cx:pt idx="498">57.827675035401512</cx:pt>
          <cx:pt idx="499">0.050594663750241485</cx:pt>
          <cx:pt idx="500">26.557032966805611</cx:pt>
          <cx:pt idx="501">0.0026091435376383565</cx:pt>
          <cx:pt idx="502">24.997039824747251</cx:pt>
          <cx:pt idx="503">67.722965085707827</cx:pt>
          <cx:pt idx="504">41.164061995872075</cx:pt>
          <cx:pt idx="505">51.284403087098518</cx:pt>
          <cx:pt idx="506">58.794557571258245</cx:pt>
          <cx:pt idx="507">55.795519533381885</cx:pt>
          <cx:pt idx="508">54.258271258859693</cx:pt>
          <cx:pt idx="509">62.586180583256557</cx:pt>
          <cx:pt idx="510">54.258271258859693</cx:pt>
          <cx:pt idx="511">71.67028673027616</cx:pt>
          <cx:pt idx="512">78.703621263573382</cx:pt>
          <cx:pt idx="513">57.559447530357687</cx:pt>
          <cx:pt idx="514">67.950349520808203</cx:pt>
          <cx:pt idx="515">57.822832860384835</cx:pt>
          <cx:pt idx="516">63.721660367570465</cx:pt>
          <cx:pt idx="517">52.565197612108335</cx:pt>
          <cx:pt idx="518">36.380351839969883</cx:pt>
          <cx:pt idx="519">54.418195486436339</cx:pt>
          <cx:pt idx="520">0.0090821418178753423</cx:pt>
          <cx:pt idx="521">0.0084736591859715469</cx:pt>
          <cx:pt idx="522">34.693947598968897</cx:pt>
          <cx:pt idx="523">54.258271258859693</cx:pt>
          <cx:pt idx="524">8.4912484358897427</cx:pt>
          <cx:pt idx="525">0.017202819536343453</cx:pt>
          <cx:pt idx="526">0.17933237298379787</cx:pt>
          <cx:pt idx="527">57.283243623244658</cx:pt>
          <cx:pt idx="528">47.001595717592402</cx:pt>
          <cx:pt idx="529">72.393784263567824</cx:pt>
          <cx:pt idx="530">84.699468711438797</cx:pt>
          <cx:pt idx="531">0.0082506302789544517</cx:pt>
          <cx:pt idx="532">92.023964270183441</cx:pt>
          <cx:pt idx="533">0.072811880898655534</cx:pt>
          <cx:pt idx="534">47.575308722067163</cx:pt>
          <cx:pt idx="535">87.207568478888348</cx:pt>
          <cx:pt idx="536">60.897701106035193</cx:pt>
          <cx:pt idx="537">65.982118789866092</cx:pt>
          <cx:pt idx="538">5.3874483756227303</cx:pt>
          <cx:pt idx="539">74.437893575785722</cx:pt>
          <cx:pt idx="540">17.652421930148847</cx:pt>
          <cx:pt idx="541">0.0052956869242809278</cx:pt>
          <cx:pt idx="542">0.029199109575464798</cx:pt>
          <cx:pt idx="543">57.01482263411858</cx:pt>
          <cx:pt idx="544">0.060423670858364767</cx:pt>
          <cx:pt idx="545">6.3307187585613063</cx:pt>
          <cx:pt idx="546">7.699305163454687</cx:pt>
          <cx:pt idx="547">55.02708424039929</cx:pt>
          <cx:pt idx="548">75.760345828144153</cx:pt>
          <cx:pt idx="549">24.55475514029818</cx:pt>
          <cx:pt idx="550">0.080032430926468806</cx:pt>
          <cx:pt idx="551">59.021436783595838</cx:pt>
          <cx:pt idx="552">63.163201312156438</cx:pt>
          <cx:pt idx="553">78.214832352949529</cx:pt>
          <cx:pt idx="554">23.164628207679051</cx:pt>
          <cx:pt idx="555">41.911454281616145</cx:pt>
          <cx:pt idx="556">52.463225215383012</cx:pt>
          <cx:pt idx="557">0.029667625452671469</cx:pt>
          <cx:pt idx="558">25.436175026917869</cx:pt>
          <cx:pt idx="559">100.83055092579829</cx:pt>
          <cx:pt idx="560">61.719040822099622</cx:pt>
          <cx:pt idx="561">53.109038778723907</cx:pt>
          <cx:pt idx="562">0.04626294413458789</cx:pt>
          <cx:pt idx="563">86.327284215362639</cx:pt>
          <cx:pt idx="564">11.373389995951074</cx:pt>
          <cx:pt idx="565">67.726877973224191</cx:pt>
          <cx:pt idx="566">0.19215488544400841</cx:pt>
          <cx:pt idx="567">0.054432159611758929</cx:pt>
          <cx:pt idx="568">35.744789830127687</cx:pt>
          <cx:pt idx="569">60.628376194649981</cx:pt>
          <cx:pt idx="570">24.856850162480363</cx:pt>
          <cx:pt idx="571">89.674188036469005</cx:pt>
          <cx:pt idx="572">56.654743843741805</cx:pt>
          <cx:pt idx="573">6.3830165282568405</cx:pt>
          <cx:pt idx="574">59.951146778022526</cx:pt>
          <cx:pt idx="575">60.262260163389158</cx:pt>
          <cx:pt idx="576">0.00062805573001127851</cx:pt>
          <cx:pt idx="577">6.0780918058219555</cx:pt>
          <cx:pt idx="578">57.103765199853505</cx:pt>
          <cx:pt idx="579">60.771539391396033</cx:pt>
          <cx:pt idx="580">70.472689745744773</cx:pt>
          <cx:pt idx="581">2.391706503733265</cx:pt>
          <cx:pt idx="582">0.025521128501694433</cx:pt>
          <cx:pt idx="583">27.337794351410281</cx:pt>
          <cx:pt idx="584">82.074295610745267</cx:pt>
          <cx:pt idx="585">0.28479922752704229</cx:pt>
          <cx:pt idx="586">66.124579393747368</cx:pt>
          <cx:pt idx="587">0.0090600000000000003</cx:pt>
          <cx:pt idx="588">0.010755603190895432</cx:pt>
          <cx:pt idx="589">70.745388542292986</cx:pt>
          <cx:pt idx="590">0.12839820871024643</cx:pt>
          <cx:pt idx="591">60.544198731174895</cx:pt>
          <cx:pt idx="592">55.099364787627096</cx:pt>
          <cx:pt idx="593">71.980414002699362</cx:pt>
          <cx:pt idx="594">59.932211706226887</cx:pt>
          <cx:pt idx="595">0.028563123078543074</cx:pt>
          <cx:pt idx="596">17.314387081268571</cx:pt>
          <cx:pt idx="597">22.123562100168229</cx:pt>
          <cx:pt idx="598">53.182045842558558</cx:pt>
          <cx:pt idx="599">95.249934383179507</cx:pt>
          <cx:pt idx="600">0.072251089957176426</cx:pt>
          <cx:pt idx="601">84.898704348181894</cx:pt>
          <cx:pt idx="602">85.018233338502156</cx:pt>
          <cx:pt idx="603">107.40204839759808</cx:pt>
          <cx:pt idx="604">0.012933058416322103</cx:pt>
          <cx:pt idx="605">85.626339405582442</cx:pt>
          <cx:pt idx="606">16.071092059969043</cx:pt>
          <cx:pt idx="607">59.439885598813191</cx:pt>
          <cx:pt idx="608">58.757893086801538</cx:pt>
          <cx:pt idx="609">60.285321596554496</cx:pt>
          <cx:pt idx="610">0.09960070280876536</cx:pt>
          <cx:pt idx="611">76.345923270335788</cx:pt>
          <cx:pt idx="612">33.206926988205339</cx:pt>
          <cx:pt idx="613">79.015694643532683</cx:pt>
          <cx:pt idx="614">0.2071494629488573</cx:pt>
          <cx:pt idx="615">67.371804191367772</cx:pt>
          <cx:pt idx="616">18.234116375629501</cx:pt>
          <cx:pt idx="617">19.43658920695707</cx:pt>
          <cx:pt idx="618">46.090779989060721</cx:pt>
          <cx:pt idx="619">0.021724064997140843</cx:pt>
          <cx:pt idx="620">78.904182398653617</cx:pt>
          <cx:pt idx="621">74.652662377171779</cx:pt>
          <cx:pt idx="622">0.039963983785403577</cx:pt>
          <cx:pt idx="623">54.229788861842344</cx:pt>
          <cx:pt idx="624">56.947870899621876</cx:pt>
          <cx:pt idx="625">0.0032916409281694135</cx:pt>
          <cx:pt idx="626">0.067954470051645607</cx:pt>
          <cx:pt idx="627">0.032742327345501872</cx:pt>
          <cx:pt idx="628">23.222080010197192</cx:pt>
          <cx:pt idx="629">39.48379414392695</cx:pt>
          <cx:pt idx="630">0.019236943624183132</cx:pt>
          <cx:pt idx="631">57.293891471953629</cx:pt>
          <cx:pt idx="632">71.438645003947272</cx:pt>
          <cx:pt idx="633">45.378188593199702</cx:pt>
          <cx:pt idx="634">38.702842272887402</cx:pt>
          <cx:pt idx="635">107.71907909001079</cx:pt>
          <cx:pt idx="636">15.681007620685605</cx:pt>
          <cx:pt idx="637">16.576489375015445</cx:pt>
          <cx:pt idx="638">57.283505479326244</cx:pt>
          <cx:pt idx="639">45.859895333504639</cx:pt>
          <cx:pt idx="640">11.96983709162326</cx:pt>
          <cx:pt idx="641">0.044897215949321403</cx:pt>
          <cx:pt idx="642">31.884635798453147</cx:pt>
          <cx:pt idx="643">0.028636899273489787</cx:pt>
          <cx:pt idx="644">57.050503941683104</cx:pt>
          <cx:pt idx="645">54.429128231122718</cx:pt>
          <cx:pt idx="646">14.097446577306119</cx:pt>
          <cx:pt idx="647">0.00053390354934201368</cx:pt>
          <cx:pt idx="648">59.868689646592401</cx:pt>
          <cx:pt idx="649">69.680341560586513</cx:pt>
          <cx:pt idx="650">76.263621734087607</cx:pt>
          <cx:pt idx="651">73.343711386866701</cx:pt>
          <cx:pt idx="652">106.45139736048559</cx:pt>
          <cx:pt idx="653">0.0021902351471931045</cx:pt>
          <cx:pt idx="654">2.3317439825160906</cx:pt>
          <cx:pt idx="655">55.481618577687506</cx:pt>
          <cx:pt idx="656">51.635840266233679</cx:pt>
          <cx:pt idx="657">67.118551831814727</cx:pt>
          <cx:pt idx="658">58.934879316072241</cx:pt>
          <cx:pt idx="659">0.013412307780542466</cx:pt>
          <cx:pt idx="660">84.201425166086111</cx:pt>
          <cx:pt idx="661">13.299360886899791</cx:pt>
          <cx:pt idx="662">34.120082063207292</cx:pt>
          <cx:pt idx="663">31.464329009212953</cx:pt>
          <cx:pt idx="664">36.509587781841631</cx:pt>
          <cx:pt idx="665">0.053387358054131133</cx:pt>
          <cx:pt idx="666">3.6602595536382392</cx:pt>
          <cx:pt idx="667">0.027991552297077057</cx:pt>
          <cx:pt idx="668">53.340884882048968</cx:pt>
          <cx:pt idx="669">0.014364574480297005</cx:pt>
          <cx:pt idx="670">0.0047835551632650795</cx:pt>
          <cx:pt idx="671">0.0059554344929652276</cx:pt>
          <cx:pt idx="672">25.499784312813311</cx:pt>
          <cx:pt idx="673">54.258271258859693</cx:pt>
          <cx:pt idx="674">63.412222796555554</cx:pt>
          <cx:pt idx="675">51.09628166510749</cx:pt>
          <cx:pt idx="676">0.024808687994329726</cx:pt>
          <cx:pt idx="677">0.15154108353842533</cx:pt>
          <cx:pt idx="678">54.258271258859693</cx:pt>
          <cx:pt idx="679">103.62094382893837</cx:pt>
          <cx:pt idx="680">0.0054160040620368811</cx:pt>
          <cx:pt idx="681">14.538466218965466</cx:pt>
          <cx:pt idx="682">31.727117738615966</cx:pt>
          <cx:pt idx="683">15.366619667317858</cx:pt>
          <cx:pt idx="684">55.215668066229171</cx:pt>
          <cx:pt idx="685">81.076013715525022</cx:pt>
          <cx:pt idx="686">63.469362687835464</cx:pt>
          <cx:pt idx="687">54.258271258859693</cx:pt>
          <cx:pt idx="688">53.114404825809721</cx:pt>
          <cx:pt idx="689">29.629816064228276</cx:pt>
          <cx:pt idx="690">54.937418941919724</cx:pt>
          <cx:pt idx="691">89.950097276211991</cx:pt>
          <cx:pt idx="692">0.011668376065245754</cx:pt>
          <cx:pt idx="693">79.279568616384381</cx:pt>
          <cx:pt idx="694">0.012359611644384301</cx:pt>
          <cx:pt idx="695">59.301517687155361</cx:pt>
          <cx:pt idx="696">0.44828450787418472</cx:pt>
          <cx:pt idx="697">79.556206546064018</cx:pt>
          <cx:pt idx="698">21.794999426473954</cx:pt>
          <cx:pt idx="699">0.0012138368918433811</cx:pt>
          <cx:pt idx="700">64.291834629290207</cx:pt>
          <cx:pt idx="701">33.190209399761251</cx:pt>
          <cx:pt idx="702">114.21120785632203</cx:pt>
          <cx:pt idx="703">20.965495462783608</cx:pt>
          <cx:pt idx="704">37.315144378656775</cx:pt>
          <cx:pt idx="705">9.8827678309267188</cx:pt>
          <cx:pt idx="706">54.258271258859693</cx:pt>
          <cx:pt idx="707">54.258271258859693</cx:pt>
          <cx:pt idx="708">21.390231415297968</cx:pt>
          <cx:pt idx="709">72.687619303427454</cx:pt>
          <cx:pt idx="710">54.258271258859693</cx:pt>
          <cx:pt idx="711">54.258271258859693</cx:pt>
          <cx:pt idx="712">80.590694251879981</cx:pt>
          <cx:pt idx="713">13.352041042477364</cx:pt>
          <cx:pt idx="714">0.0287958851227046</cx:pt>
          <cx:pt idx="715">61.062918371135844</cx:pt>
          <cx:pt idx="716">53.12061746629081</cx:pt>
          <cx:pt idx="717">45.437209421354211</cx:pt>
          <cx:pt idx="718">0.35358591600910805</cx:pt>
          <cx:pt idx="719">61.353565503563033</cx:pt>
          <cx:pt idx="720">111.70362572450368</cx:pt>
          <cx:pt idx="721">22.816923543720787</cx:pt>
          <cx:pt idx="722">60.228813702413234</cx:pt>
          <cx:pt idx="723">60.632746927712255</cx:pt>
          <cx:pt idx="724">65.933223794988223</cx:pt>
          <cx:pt idx="725">91.207620295674857</cx:pt>
          <cx:pt idx="726">36.500410956590613</cx:pt>
          <cx:pt idx="727">47.1820940612008</cx:pt>
          <cx:pt idx="728">55.674500446793417</cx:pt>
          <cx:pt idx="729">37.01918421575494</cx:pt>
          <cx:pt idx="730">42.730083079722654</cx:pt>
          <cx:pt idx="731">75.229183167172565</cx:pt>
          <cx:pt idx="732">58.509913689903868</cx:pt>
          <cx:pt idx="733">0.033085948679159857</cx:pt>
          <cx:pt idx="734">65.973934246791742</cx:pt>
          <cx:pt idx="735">0.071343324845426145</cx:pt>
          <cx:pt idx="736">0.0034674053700137226</cx:pt>
          <cx:pt idx="737">74.393682527483477</cx:pt>
          <cx:pt idx="738">54.258271258859693</cx:pt>
          <cx:pt idx="739">9.6411461974186459</cx:pt>
          <cx:pt idx="740">26.938708209563426</cx:pt>
          <cx:pt idx="741">54.827000647491197</cx:pt>
          <cx:pt idx="742">85.291910519110786</cx:pt>
          <cx:pt idx="743">49.654304949319354</cx:pt>
          <cx:pt idx="744">0.029324392576829277</cx:pt>
          <cx:pt idx="745">89.618134325592834</cx:pt>
          <cx:pt idx="746">29.204331870460585</cx:pt>
          <cx:pt idx="747">0.0038365870249480851</cx:pt>
          <cx:pt idx="748">61.395928203749797</cx:pt>
          <cx:pt idx="749">18.288520989954328</cx:pt>
          <cx:pt idx="750">0.029550025380699757</cx:pt>
          <cx:pt idx="751">78.270684167189955</cx:pt>
          <cx:pt idx="752">20.096840547707991</cx:pt>
          <cx:pt idx="753">63.401498405006173</cx:pt>
          <cx:pt idx="754">64.3073090713645</cx:pt>
          <cx:pt idx="755">26.104980367738261</cx:pt>
          <cx:pt idx="756">0.052447211556001717</cx:pt>
          <cx:pt idx="757">11.407716686524083</cx:pt>
          <cx:pt idx="758">0.10939149875561628</cx:pt>
          <cx:pt idx="759">72.925372813582527</cx:pt>
          <cx:pt idx="760">60.509916542662658</cx:pt>
          <cx:pt idx="761">81.911476607371696</cx:pt>
          <cx:pt idx="762">49.85689521019134</cx:pt>
          <cx:pt idx="763">0.15388339741505577</cx:pt>
          <cx:pt idx="764">15.754586633739395</cx:pt>
          <cx:pt idx="765">63.408674485436137</cx:pt>
          <cx:pt idx="766">54.258271258859693</cx:pt>
          <cx:pt idx="767">0.099925322116068249</cx:pt>
          <cx:pt idx="768">66.04846705261221</cx:pt>
          <cx:pt idx="769">0.082961497093531289</cx:pt>
          <cx:pt idx="770">96.421678060485959</cx:pt>
          <cx:pt idx="771">34.370481521212355</cx:pt>
          <cx:pt idx="772">54.258271258859693</cx:pt>
          <cx:pt idx="773">62.853003110432205</cx:pt>
          <cx:pt idx="774">65.960442691055377</cx:pt>
          <cx:pt idx="775">25.725182215098108</cx:pt>
          <cx:pt idx="776">0.53143390934339152</cx:pt>
          <cx:pt idx="777">67.20349693282337</cx:pt>
          <cx:pt idx="778">19.243310525998378</cx:pt>
          <cx:pt idx="779">59.28768843528983</cx:pt>
          <cx:pt idx="780">50.443731027750118</cx:pt>
          <cx:pt idx="781">53.43809502592697</cx:pt>
          <cx:pt idx="782">0.066330159053028068</cx:pt>
          <cx:pt idx="783">60.782398768064425</cx:pt>
          <cx:pt idx="784">0.11745382071265285</cx:pt>
          <cx:pt idx="785">86.826608824714555</cx:pt>
          <cx:pt idx="786">0.0035607302621793748</cx:pt>
          <cx:pt idx="787">86.707150800842257</cx:pt>
          <cx:pt idx="788">81.139632732715768</cx:pt>
          <cx:pt idx="789">42.184001706808232</cx:pt>
          <cx:pt idx="790">59.015506436867923</cx:pt>
          <cx:pt idx="791">12.326394444443192</cx:pt>
          <cx:pt idx="792">0.12661674454826266</cx:pt>
          <cx:pt idx="793">0.59229384599200419</cx:pt>
          <cx:pt idx="794">0.0036600546444008181</cx:pt>
          <cx:pt idx="795">54.258271258859693</cx:pt>
          <cx:pt idx="796">78.913687025762528</cx:pt>
          <cx:pt idx="797">5.1522131167101383e-05</cx:pt>
          <cx:pt idx="798">0.0040806004460128172</cx:pt>
          <cx:pt idx="799">70.983167018667189</cx:pt>
          <cx:pt idx="800">0.01352863629491162</cx:pt>
          <cx:pt idx="801">9.7532199811139293</cx:pt>
          <cx:pt idx="802">88.316532993545437</cx:pt>
          <cx:pt idx="803">0.083753925281147265</cx:pt>
          <cx:pt idx="804">72.841883556097045</cx:pt>
          <cx:pt idx="805">56.784328824069064</cx:pt>
          <cx:pt idx="806">53.416944877070605</cx:pt>
          <cx:pt idx="807">15.041343025142403</cx:pt>
          <cx:pt idx="808">66.571690680048079</cx:pt>
          <cx:pt idx="809">31.546679698503933</cx:pt>
          <cx:pt idx="810">11.884191179882626</cx:pt>
          <cx:pt idx="811">98.946197501470465</cx:pt>
          <cx:pt idx="812">12.421392836554199</cx:pt>
          <cx:pt idx="813">31.00869232973232</cx:pt>
          <cx:pt idx="814">57.039021730741489</cx:pt>
          <cx:pt idx="815">26.526458489591104</cx:pt>
          <cx:pt idx="816">0.036615433904297785</cx:pt>
          <cx:pt idx="817">21.823863086080799</cx:pt>
          <cx:pt idx="818">0.023716407822433817</cx:pt>
          <cx:pt idx="819">0.0040595443094022261</cx:pt>
          <cx:pt idx="820">81.229612826850286</cx:pt>
          <cx:pt idx="821">76.962653280665933</cx:pt>
          <cx:pt idx="822">42.746812746683233</cx:pt>
          <cx:pt idx="823">51.059866823171404</cx:pt>
          <cx:pt idx="824">29.277277878928565</cx:pt>
          <cx:pt idx="825">34.617192260493916</cx:pt>
          <cx:pt idx="826">48.78145139292188</cx:pt>
          <cx:pt idx="827">11.193212228846553</cx:pt>
          <cx:pt idx="828">59.328070927681445</cx:pt>
          <cx:pt idx="829">54.258271258859693</cx:pt>
          <cx:pt idx="830">0.15577387457465389</cx:pt>
          <cx:pt idx="831">64.182941658979757</cx:pt>
          <cx:pt idx="832">76.612335821328415</cx:pt>
          <cx:pt idx="833">58.748957437557991</cx:pt>
          <cx:pt idx="834">30.806655125151121</cx:pt>
          <cx:pt idx="835">113.24089367361951</cx:pt>
          <cx:pt idx="836">20.794278059120014</cx:pt>
          <cx:pt idx="837">37.039303449174092</cx:pt>
          <cx:pt idx="838">60.807976450462483</cx:pt>
          <cx:pt idx="839">58.492221705112215</cx:pt>
          <cx:pt idx="840">66.698800588916143</cx:pt>
          <cx:pt idx="841">65.915324470110889</cx:pt>
          <cx:pt idx="842">54.258271258859693</cx:pt>
          <cx:pt idx="843">11.938174064738712</cx:pt>
          <cx:pt idx="844">70.541477160603876</cx:pt>
          <cx:pt idx="845">64.206152353181849</cx:pt>
          <cx:pt idx="846">23.471748976162811</cx:pt>
          <cx:pt idx="847">27.451520905042763</cx:pt>
          <cx:pt idx="848">50.636449322597656</cx:pt>
          <cx:pt idx="849">0.011466778100233735</cx:pt>
          <cx:pt idx="850">0.17787242619360652</cx:pt>
          <cx:pt idx="851">59.688273555196758</cx:pt>
          <cx:pt idx="852">52.227483186536951</cx:pt>
          <cx:pt idx="853">0.061171153332269287</cx:pt>
          <cx:pt idx="854">58.162960722439159</cx:pt>
          <cx:pt idx="855">62.195417837651021</cx:pt>
          <cx:pt idx="856">75.199601062771606</cx:pt>
          <cx:pt idx="857">14.409059650095143</cx:pt>
          <cx:pt idx="858">72.274130918330656</cx:pt>
          <cx:pt idx="859">7.6751938086278972</cx:pt>
          <cx:pt idx="860">54.258271258859693</cx:pt>
          <cx:pt idx="861">52.227866125278368</cx:pt>
          <cx:pt idx="862">58.208075041183072</cx:pt>
          <cx:pt idx="863">79.398425677087587</cx:pt>
          <cx:pt idx="864">60.549896779433077</cx:pt>
          <cx:pt idx="865">95.772960693506803</cx:pt>
          <cx:pt idx="866">74.817711806764038</cx:pt>
          <cx:pt idx="867">63.78988948101415</cx:pt>
          <cx:pt idx="868">0.017097485195197566</cx:pt>
          <cx:pt idx="869">19.444022217637997</cx:pt>
          <cx:pt idx="870">0.012545676546125362</cx:pt>
          <cx:pt idx="871">38.833104434232396</cx:pt>
          <cx:pt idx="872">92.208351031780197</cx:pt>
          <cx:pt idx="873">58.088294862218149</cx:pt>
          <cx:pt idx="874">0.022788681401081548</cx:pt>
          <cx:pt idx="875">55.130572280722788</cx:pt>
          <cx:pt idx="876">0.088416118440022007</cx:pt>
          <cx:pt idx="877">31.316385487472846</cx:pt>
          <cx:pt idx="878">5.4039152472998682</cx:pt>
          <cx:pt idx="879">0.50761796658510816</cx:pt>
          <cx:pt idx="880">75.764833531131046</cx:pt>
          <cx:pt idx="881">4.4371049119893482e-05</cx:pt>
          <cx:pt idx="882">39.079278396613212</cx:pt>
          <cx:pt idx="883">28.268710617925251</cx:pt>
          <cx:pt idx="884">105.76814265174556</cx:pt>
          <cx:pt idx="885">14.291780854743049</cx:pt>
          <cx:pt idx="886">66.468789668535408</cx:pt>
          <cx:pt idx="887">83.398621091718297</cx:pt>
          <cx:pt idx="888">0.18056383912622148</cx:pt>
          <cx:pt idx="889">22.743724409163949</cx:pt>
          <cx:pt idx="890">57.406619827333508</cx:pt>
          <cx:pt idx="891">62.702392298858896</cx:pt>
          <cx:pt idx="892">68.105579800776965</cx:pt>
          <cx:pt idx="893">54.258271258859693</cx:pt>
          <cx:pt idx="894">0.83532029784987272</cx:pt>
          <cx:pt idx="895">10.91833320612629</cx:pt>
          <cx:pt idx="896">54.258271258859693</cx:pt>
          <cx:pt idx="897">81.695409907778782</cx:pt>
          <cx:pt idx="898">61.02450327532376</cx:pt>
          <cx:pt idx="899">0.088967971765124554</cx:pt>
          <cx:pt idx="900">28.427627407154471</cx:pt>
          <cx:pt idx="901">0.0095632996397686937</cx:pt>
          <cx:pt idx="902">27.213029967278544</cx:pt>
          <cx:pt idx="903">0.035359298635578171</cx:pt>
          <cx:pt idx="904">95.244999868759521</cx:pt>
          <cx:pt idx="905">63.093898278676676</cx:pt>
          <cx:pt idx="906">49.941866204618343</cx:pt>
          <cx:pt idx="907">38.94470438968564</cx:pt>
          <cx:pt idx="908">92.630070711405594</cx:pt>
          <cx:pt idx="909">95.531094414331918</cx:pt>
          <cx:pt idx="910">0.096848593175120526</cx:pt>
          <cx:pt idx="911">72.235240707012252</cx:pt>
          <cx:pt idx="912">11.001636241941469</cx:pt>
          <cx:pt idx="913">48.347492179015866</cx:pt>
          <cx:pt idx="914">13.237220252001549</cx:pt>
          <cx:pt idx="915">63.09429451226157</cx:pt>
          <cx:pt idx="916">60.45700951916163</cx:pt>
          <cx:pt idx="917">24.365200594290208</cx:pt>
          <cx:pt idx="918">24.563387388550463</cx:pt>
          <cx:pt idx="919">53.066938860273453</cx:pt>
          <cx:pt idx="920">10.591506030777682</cx:pt>
          <cx:pt idx="921">53.853133613560502</cx:pt>
          <cx:pt idx="922">0.033174236991979182</cx:pt>
          <cx:pt idx="923">0.0015408925984636307</cx:pt>
          <cx:pt idx="924">53.857961342776427</cx:pt>
          <cx:pt idx="925">24.166898849459358</cx:pt>
          <cx:pt idx="926">26.853007280377373</cx:pt>
          <cx:pt idx="927">43.576025518626636</cx:pt>
          <cx:pt idx="928">77.868735703104875</cx:pt>
          <cx:pt idx="929">0.021394298305857099</cx:pt>
          <cx:pt idx="930">96.928375618288371</cx:pt>
          <cx:pt idx="931">9.6420589087601005</cx:pt>
          <cx:pt idx="932">62.530792414617622</cx:pt>
          <cx:pt idx="933">111.48318258822718</cx:pt>
          <cx:pt idx="934">19.012969257851335</cx:pt>
          <cx:pt idx="935">107.44673098796444</cx:pt>
          <cx:pt idx="936">37.53411781299782</cx:pt>
          <cx:pt idx="937">85.27860223995232</cx:pt>
          <cx:pt idx="938">58.226969696181165</cx:pt>
          <cx:pt idx="939">0.0034874775984943618</cx:pt>
          <cx:pt idx="940">70.865647531085187</cx:pt>
          <cx:pt idx="941">0.013760886599343807</cx:pt>
          <cx:pt idx="942">18.696256309753565</cx:pt>
          <cx:pt idx="943">86.052251568451126</cx:pt>
          <cx:pt idx="944">39.368261328130814</cx:pt>
          <cx:pt idx="945">69.318828610991403</cx:pt>
          <cx:pt idx="946">57.914419620678238</cx:pt>
          <cx:pt idx="947">43.864678273070687</cx:pt>
          <cx:pt idx="948">30.834882843948019</cx:pt>
          <cx:pt idx="949">0.0031298737993727481</cx:pt>
          <cx:pt idx="950">59.144484104606065</cx:pt>
          <cx:pt idx="951">0.078547501551608889</cx:pt>
          <cx:pt idx="952">51.604166498452429</cx:pt>
          <cx:pt idx="953">9.4519944985172319</cx:pt>
          <cx:pt idx="954">66.866807909455346</cx:pt>
          <cx:pt idx="955">70.189742840389442</cx:pt>
          <cx:pt idx="956">58.915108418808835</cx:pt>
          <cx:pt idx="957">22.150395030337496</cx:pt>
          <cx:pt idx="958">10.905549046242466</cx:pt>
          <cx:pt idx="959">32.96391966984509</cx:pt>
          <cx:pt idx="960">62.839716740290932</cx:pt>
          <cx:pt idx="961">27.175338084373486</cx:pt>
          <cx:pt idx="962">13.131526948531159</cx:pt>
          <cx:pt idx="963">75.584852979945666</cx:pt>
          <cx:pt idx="964">57.624126891433249</cx:pt>
          <cx:pt idx="965">54.258271258859693</cx:pt>
          <cx:pt idx="966">0.040796813601064484</cx:pt>
          <cx:pt idx="967">1.286363090266508</cx:pt>
          <cx:pt idx="968">54.811860030471507</cx:pt>
          <cx:pt idx="969">35.859726713961443</cx:pt>
          <cx:pt idx="970">54.620875130301606</cx:pt>
          <cx:pt idx="971">29.028951066133963</cx:pt>
          <cx:pt idx="972">70.768566468454068</cx:pt>
          <cx:pt idx="973">49.418114087852437</cx:pt>
          <cx:pt idx="974">63.386197235675844</cx:pt>
          <cx:pt idx="975">62.098067602784546</cx:pt>
          <cx:pt idx="976">29.598885114139012</cx:pt>
          <cx:pt idx="977">1.8367852351322951</cx:pt>
          <cx:pt idx="978">0.1517833983016588</cx:pt>
          <cx:pt idx="979">62.964037354667781</cx:pt>
          <cx:pt idx="980">54.258271258859693</cx:pt>
          <cx:pt idx="981">80.180858064752584</cx:pt>
          <cx:pt idx="982">62.607188085714249</cx:pt>
          <cx:pt idx="983">51.868873132158946</cx:pt>
          <cx:pt idx="984">66.215934638121666</cx:pt>
          <cx:pt idx="985">62.431402354904698</cx:pt>
          <cx:pt idx="986">54.267946340358229</cx:pt>
          <cx:pt idx="987">64.675961531313931</cx:pt>
          <cx:pt idx="988">48.456062572190078</cx:pt>
          <cx:pt idx="989">59.999916666608797</cx:pt>
          <cx:pt idx="990">31.462469705984621</cx:pt>
          <cx:pt idx="991">0.05110949031246545</cx:pt>
          <cx:pt idx="992">0.061617692264478711</cx:pt>
          <cx:pt idx="993">54.258271258859693</cx:pt>
          <cx:pt idx="994">23.164326020845071</cx:pt>
          <cx:pt idx="995">0.005111643571298766</cx:pt>
          <cx:pt idx="996">111.63108885968998</cx:pt>
          <cx:pt idx="997">20.180981145623221</cx:pt>
          <cx:pt idx="998">64.760250153933157</cx:pt>
          <cx:pt idx="999">0.034748669039259619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sz="14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l-GR" altLang="ja-JP" sz="1200" b="0" i="0" u="none" strike="noStrike" baseline="0" dirty="0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ω</a:t>
            </a:r>
            <a:r>
              <a:rPr lang="en-US" altLang="ja-JP" sz="1200" b="0" i="0" u="none" strike="noStrike" baseline="0" dirty="0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k12 </a:t>
            </a:r>
            <a:endParaRPr lang="ja-JP" altLang="en-US" sz="1200" b="0" i="0" u="none" strike="noStrike" baseline="0" dirty="0">
              <a:solidFill>
                <a:sysClr val="windowText" lastClr="000000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cx:rich>
      </cx:tx>
    </cx:title>
    <cx:plotArea>
      <cx:plotAreaRegion>
        <cx:series layoutId="clusteredColumn" uniqueId="{B5A5EBAC-DBB7-4B64-B000-E61BE438F5AC}">
          <cx:tx>
            <cx:txData>
              <cx:f>PK!$U$1</cx:f>
              <cx:v>omega nK12 %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Count val="15"/>
            </cx:binning>
          </cx:layoutPr>
        </cx:series>
      </cx:plotAreaRegion>
      <cx:axis id="0">
        <cx:catScaling gapWidth="0"/>
        <cx:tickLabels/>
        <cx:numFmt formatCode="#,##0.0_);[赤](#,##0.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7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PK!$V$2:$V$1001</cx:f>
        <cx:lvl ptCount="1000" formatCode="G/標準">
          <cx:pt idx="0">22.898799095149073</cx:pt>
          <cx:pt idx="1">86.208584259341592</cx:pt>
          <cx:pt idx="2">95.96780710217358</cx:pt>
          <cx:pt idx="3">73.643533320991594</cx:pt>
          <cx:pt idx="4">75.236227975623549</cx:pt>
          <cx:pt idx="5">96.866764166044078</cx:pt>
          <cx:pt idx="6">98.76051842715286</cx:pt>
          <cx:pt idx="7">97.594467056283477</cx:pt>
          <cx:pt idx="8">72.805562974267289</cx:pt>
          <cx:pt idx="9">91.971245506408152</cx:pt>
          <cx:pt idx="10">92.573214268491284</cx:pt>
          <cx:pt idx="11">46.50946140303067</cx:pt>
          <cx:pt idx="12">85.12978327236597</cx:pt>
          <cx:pt idx="13">101.15384322901429</cx:pt>
          <cx:pt idx="14">87.64393875220351</cx:pt>
          <cx:pt idx="15">59.379205114248535</cx:pt>
          <cx:pt idx="16">90.980822155001434</cx:pt>
          <cx:pt idx="17">79.287073347425306</cx:pt>
          <cx:pt idx="18">122.51652949704379</cx:pt>
          <cx:pt idx="19">83.210095541346433</cx:pt>
          <cx:pt idx="20">82.23247533669408</cx:pt>
          <cx:pt idx="21">124.80624984350743</cx:pt>
          <cx:pt idx="22">137.0375860849862</cx:pt>
          <cx:pt idx="23">72.391643164111159</cx:pt>
          <cx:pt idx="24">125.66105204079743</cx:pt>
          <cx:pt idx="25">101.73544121887907</cx:pt>
          <cx:pt idx="26">90.980822155001434</cx:pt>
          <cx:pt idx="27">78.757031432120399</cx:pt>
          <cx:pt idx="28">88.939811108411959</cx:pt>
          <cx:pt idx="29">75.866132101221567</cx:pt>
          <cx:pt idx="30">100.37878261863908</cx:pt>
          <cx:pt idx="31">91.239793949789259</cx:pt>
          <cx:pt idx="32">157.43189003502434</cx:pt>
          <cx:pt idx="33">58.528796331378615</cx:pt>
          <cx:pt idx="34">90.980822155001434</cx:pt>
          <cx:pt idx="35">90.980822155001434</cx:pt>
          <cx:pt idx="36">68.728523918384866</cx:pt>
          <cx:pt idx="37">88.319363675243949</cx:pt>
          <cx:pt idx="38">100.4011952120093</cx:pt>
          <cx:pt idx="39">94.52999523960635</cx:pt>
          <cx:pt idx="40">100.72288717069225</cx:pt>
          <cx:pt idx="41">69.623271971374635</cx:pt>
          <cx:pt idx="42">120.57197020866832</cx:pt>
          <cx:pt idx="43">80.189463148221662</cx:pt>
          <cx:pt idx="44">108.88709749093324</cx:pt>
          <cx:pt idx="45">90.592438978095728</cx:pt>
          <cx:pt idx="46">95.624630718241207</cx:pt>
          <cx:pt idx="47">68.53313067414912</cx:pt>
          <cx:pt idx="48">78.163802364009911</cx:pt>
          <cx:pt idx="49">92.741846002761889</cx:pt>
          <cx:pt idx="50">103.76174632300675</cx:pt>
          <cx:pt idx="51">137.4248885755415</cx:pt>
          <cx:pt idx="52">91.940252338135338</cx:pt>
          <cx:pt idx="53">131.97007236491157</cx:pt>
          <cx:pt idx="54">57.872273153903329</cx:pt>
          <cx:pt idx="55">77.189960487099611</cx:pt>
          <cx:pt idx="56">76.499542482292014</cx:pt>
          <cx:pt idx="57">123.28057430106334</cx:pt>
          <cx:pt idx="58">119.08568343843855</cx:pt>
          <cx:pt idx="59">118.7813116613889</cx:pt>
          <cx:pt idx="60">135.40199407689681</cx:pt>
          <cx:pt idx="61">66.504736673412964</cx:pt>
          <cx:pt idx="62">96.031192848990472</cx:pt>
          <cx:pt idx="63">76.452599694189601</cx:pt>
          <cx:pt idx="64">81.189285007321004</cx:pt>
          <cx:pt idx="65">98.035554774785666</cx:pt>
          <cx:pt idx="66">64.078779638816457</cx:pt>
          <cx:pt idx="67">88.061455813539666</cx:pt>
          <cx:pt idx="68">54.163825566516252</cx:pt>
          <cx:pt idx="69">79.318471997385316</cx:pt>
          <cx:pt idx="70">85.283644387420495</cx:pt>
          <cx:pt idx="71">85.913794003058669</cx:pt>
          <cx:pt idx="72">80.231726891548334</cx:pt>
          <cx:pt idx="73">87.036084470752712</cx:pt>
          <cx:pt idx="74">89.806681265928091</cx:pt>
          <cx:pt idx="75">86.984826262975318</cx:pt>
          <cx:pt idx="76">103.00048543574928</cx:pt>
          <cx:pt idx="77">98.730593029719003</cx:pt>
          <cx:pt idx="78">110.35352282550839</cx:pt>
          <cx:pt idx="79">95.775623203401821</cx:pt>
          <cx:pt idx="80">69.706025564509133</cx:pt>
          <cx:pt idx="81">100.57882480920127</cx:pt>
          <cx:pt idx="82">90.980822155001434</cx:pt>
          <cx:pt idx="83">93.705389386096684</cx:pt>
          <cx:pt idx="84">78.617809687118594</cx:pt>
          <cx:pt idx="85">58.141379412600799</cx:pt>
          <cx:pt idx="86">69.392939122074949</cx:pt>
          <cx:pt idx="87">103.6783487522829</cx:pt>
          <cx:pt idx="88">85.712367835686351</cx:pt>
          <cx:pt idx="89">88.231626982618877</cx:pt>
          <cx:pt idx="90">112.09727918196765</cx:pt>
          <cx:pt idx="91">76.407198613743205</cx:pt>
          <cx:pt idx="92">87.218977292788765</cx:pt>
          <cx:pt idx="93">114.03508232118746</cx:pt>
          <cx:pt idx="94">113.01238870141628</cx:pt>
          <cx:pt idx="95">83.503532859394639</cx:pt>
          <cx:pt idx="96">107.58020263970505</cx:pt>
          <cx:pt idx="97">77.725671434861212</cx:pt>
          <cx:pt idx="98">126.71858585069515</cx:pt>
          <cx:pt idx="99">90.980822155001434</cx:pt>
          <cx:pt idx="100">105.18412427738323</cx:pt>
          <cx:pt idx="101">90.980822155001434</cx:pt>
          <cx:pt idx="102">90.980822155001434</cx:pt>
          <cx:pt idx="103">113.50682798845186</cx:pt>
          <cx:pt idx="104">135.16582408286496</cx:pt>
          <cx:pt idx="105">67.659884717607966</cx:pt>
          <cx:pt idx="106">77.491935064237495</cx:pt>
          <cx:pt idx="107">117.21262730610556</cx:pt>
          <cx:pt idx="108">53.98360862335899</cx:pt>
          <cx:pt idx="109">122.73915430700997</cx:pt>
          <cx:pt idx="110">119.18556959632321</cx:pt>
          <cx:pt idx="111">76.295674844646342</cx:pt>
          <cx:pt idx="112">68.506350070632138</cx:pt>
          <cx:pt idx="113">100.38575596169011</cx:pt>
          <cx:pt idx="114">117.38270741467842</cx:pt>
          <cx:pt idx="115">66.150434616864004</cx:pt>
          <cx:pt idx="116">105.16368194391066</cx:pt>
          <cx:pt idx="117">77.660414626758211</cx:pt>
          <cx:pt idx="118">90.980822155001434</cx:pt>
          <cx:pt idx="119">90.720174162090316</cx:pt>
          <cx:pt idx="120">99.016160297195938</cx:pt>
          <cx:pt idx="121">106.57110302516344</cx:pt>
          <cx:pt idx="122">118.85074673724183</cx:pt>
          <cx:pt idx="123">84.121281492854109</cx:pt>
          <cx:pt idx="124">69.359354091571518</cx:pt>
          <cx:pt idx="125">68.838651933343371</cx:pt>
          <cx:pt idx="126">91.622158891831404</cx:pt>
          <cx:pt idx="127">68.653987502547878</cx:pt>
          <cx:pt idx="128">73.762456575143958</cx:pt>
          <cx:pt idx="129">91.393872879969365</cx:pt>
          <cx:pt idx="130">82.806159191209929</cx:pt>
          <cx:pt idx="131">67.239497321143034</cx:pt>
          <cx:pt idx="132">86.187934190349409</cx:pt>
          <cx:pt idx="133">114.30091863147906</cx:pt>
          <cx:pt idx="134">100.43405796840035</cx:pt>
          <cx:pt idx="135">84.455432033706387</cx:pt>
          <cx:pt idx="136">90.980822155001434</cx:pt>
          <cx:pt idx="137">97.008865574235017</cx:pt>
          <cx:pt idx="138">46.796901606837174</cx:pt>
          <cx:pt idx="139">83.703106274498566</cx:pt>
          <cx:pt idx="140">98.066762972986936</cx:pt>
          <cx:pt idx="141">59.007880829597667</cx:pt>
          <cx:pt idx="142">93.030371384833245</cx:pt>
          <cx:pt idx="143">67.320056446797494</cx:pt>
          <cx:pt idx="144">83.301500586724131</cx:pt>
          <cx:pt idx="145">90.980822155001434</cx:pt>
          <cx:pt idx="146">64.053727448135291</cx:pt>
          <cx:pt idx="147">93.315218480160027</cx:pt>
          <cx:pt idx="148">66.0381707802389</cx:pt>
          <cx:pt idx="149">80.866247594407398</cx:pt>
          <cx:pt idx="150">73.226771060862703</cx:pt>
          <cx:pt idx="151">88.323156646487675</cx:pt>
          <cx:pt idx="152">114.62416848117154</cx:pt>
          <cx:pt idx="153">78.572832454990433</cx:pt>
          <cx:pt idx="154">139.25408432071211</cx:pt>
          <cx:pt idx="155">98.355376060487913</cx:pt>
          <cx:pt idx="156">76.662702796079401</cx:pt>
          <cx:pt idx="157">121.63099933816216</cx:pt>
          <cx:pt idx="158">81.673986066556097</cx:pt>
          <cx:pt idx="159">90.385286413221039</cx:pt>
          <cx:pt idx="160">75.80824493417586</cx:pt>
          <cx:pt idx="161">121.95572967269722</cx:pt>
          <cx:pt idx="162">110.60334533819488</cx:pt>
          <cx:pt idx="163">80.098626704831844</cx:pt>
          <cx:pt idx="164">63.208701932566214</cx:pt>
          <cx:pt idx="165">126.8865635124539</cx:pt>
          <cx:pt idx="166">121.3049875314284</cx:pt>
          <cx:pt idx="167">98.910110706641106</cx:pt>
          <cx:pt idx="168">109.85535945050655</cx:pt>
          <cx:pt idx="169">70.291108968346776</cx:pt>
          <cx:pt idx="170">62.190192152782423</cx:pt>
          <cx:pt idx="171">100.80773779824641</cx:pt>
          <cx:pt idx="172">73.296316414946801</cx:pt>
          <cx:pt idx="173">57.170446910969666</cx:pt>
          <cx:pt idx="174">112.92652478492376</cx:pt>
          <cx:pt idx="175">80.711275544374843</cx:pt>
          <cx:pt idx="176">67.23280449304491</cx:pt>
          <cx:pt idx="177">108.22291809039339</cx:pt>
          <cx:pt idx="178">114.42683251755246</cx:pt>
          <cx:pt idx="179">77.491225309708454</cx:pt>
          <cx:pt idx="180">92.707712732005206</cx:pt>
          <cx:pt idx="181">86.052483985065763</cx:pt>
          <cx:pt idx="182">114.62722189776737</cx:pt>
          <cx:pt idx="183">65.224075309658474</cx:pt>
          <cx:pt idx="184">49.56208228071133</cx:pt>
          <cx:pt idx="185">90.573395652365832</cx:pt>
          <cx:pt idx="186">100.26016157976207</cx:pt>
          <cx:pt idx="187">133.76883045014634</cx:pt>
          <cx:pt idx="188">101.58247880417173</cx:pt>
          <cx:pt idx="189">111.04548617571088</cx:pt>
          <cx:pt idx="190">90.980822155001434</cx:pt>
          <cx:pt idx="191">98.311545608844952</cx:pt>
          <cx:pt idx="192">64.141094471485289</cx:pt>
          <cx:pt idx="193">96.957413331833479</cx:pt>
          <cx:pt idx="194">89.114701368517188</cx:pt>
          <cx:pt idx="195">103.54709073653399</cx:pt>
          <cx:pt idx="196">94.906691018073104</cx:pt>
          <cx:pt idx="197">126.58712414775842</cx:pt>
          <cx:pt idx="198">116.65504704040886</cx:pt>
          <cx:pt idx="199">67.189136026592863</cx:pt>
          <cx:pt idx="200">71.459568988344728</cx:pt>
          <cx:pt idx="201">114.31622806933406</cx:pt>
          <cx:pt idx="202">102.36356773774544</cx:pt>
          <cx:pt idx="203">138.77968150993863</cx:pt>
          <cx:pt idx="204">100.273127008187</cx:pt>
          <cx:pt idx="205">115.33646431202926</cx:pt>
          <cx:pt idx="206">86.610161066701636</cx:pt>
          <cx:pt idx="207">109.94089321085217</cx:pt>
          <cx:pt idx="208">76.769850853052986</cx:pt>
          <cx:pt idx="209">53.921980675787495</cx:pt>
          <cx:pt idx="210">127.65147864400161</cx:pt>
          <cx:pt idx="211">104.32545231150449</cx:pt>
          <cx:pt idx="212">103.63734848016905</cx:pt>
          <cx:pt idx="213">100.57633916582967</cx:pt>
          <cx:pt idx="214">79.792794160876454</cx:pt>
          <cx:pt idx="215">86.030459722123993</cx:pt>
          <cx:pt idx="216">20.136533961930986</cx:pt>
          <cx:pt idx="217">51.581488927715149</cx:pt>
          <cx:pt idx="218">137.62739552865193</cx:pt>
          <cx:pt idx="219">75.819522551912712</cx:pt>
          <cx:pt idx="220">54.608790501163817</cx:pt>
          <cx:pt idx="221">83.155336569579234</cx:pt>
          <cx:pt idx="222">67.907510630268291</cx:pt>
          <cx:pt idx="223">74.247693566871149</cx:pt>
          <cx:pt idx="224">91.515627080843416</cx:pt>
          <cx:pt idx="225">83.917638193647932</cx:pt>
          <cx:pt idx="226">97.991938443935283</cx:pt>
          <cx:pt idx="227">84.888927428728891</cx:pt>
          <cx:pt idx="228">90.980822155001434</cx:pt>
          <cx:pt idx="229">63.605424296989014</cx:pt>
          <cx:pt idx="230">101.09005885842583</cx:pt>
          <cx:pt idx="231">80.512794014367685</cx:pt>
          <cx:pt idx="232">89.58398294338113</cx:pt>
          <cx:pt idx="233">124.6366719709733</cx:pt>
          <cx:pt idx="234">121.7070252697025</cx:pt>
          <cx:pt idx="235">108.39418803607508</cx:pt>
          <cx:pt idx="236">70.07446039749432</cx:pt>
          <cx:pt idx="237">91.731891946040236</cx:pt>
          <cx:pt idx="238">130.46378807929807</cx:pt>
          <cx:pt idx="239">61.583682903834195</cx:pt>
          <cx:pt idx="240">99.46607461843459</cx:pt>
          <cx:pt idx="241">74.526572442317516</cx:pt>
          <cx:pt idx="242">90.348713327860963</cx:pt>
          <cx:pt idx="243">105.14989300993129</cx:pt>
          <cx:pt idx="244">63.907746009384489</cx:pt>
          <cx:pt idx="245">94.595454436246555</cx:pt>
          <cx:pt idx="246">121.0247908488174</cx:pt>
          <cx:pt idx="247">90.980822155001434</cx:pt>
          <cx:pt idx="248">108.49930875355842</cx:pt>
          <cx:pt idx="249">106.33249738438386</cx:pt>
          <cx:pt idx="250">85.069265895504245</cx:pt>
          <cx:pt idx="251">101.02276971059543</cx:pt>
          <cx:pt idx="252">82.495636248228294</cx:pt>
          <cx:pt idx="253">49.253121728475243</cx:pt>
          <cx:pt idx="254">113.10835512905312</cx:pt>
          <cx:pt idx="255">89.295072652414589</cx:pt>
          <cx:pt idx="256">90.380473554855868</cx:pt>
          <cx:pt idx="257">98.944934180583502</cx:pt>
          <cx:pt idx="258">103.25066585741712</cx:pt>
          <cx:pt idx="259">69.30064934760712</cx:pt>
          <cx:pt idx="260">87.222015569465029</cx:pt>
          <cx:pt idx="261">84.54631866616073</cx:pt>
          <cx:pt idx="262">84.191982991256367</cx:pt>
          <cx:pt idx="263">89.304759111706915</cx:pt>
          <cx:pt idx="264">79.61469713564199</cx:pt>
          <cx:pt idx="265">68.099632891815205</cx:pt>
          <cx:pt idx="266">70.255320083250638</cx:pt>
          <cx:pt idx="267">76.352799555746486</cx:pt>
          <cx:pt idx="268">75.233702554108035</cx:pt>
          <cx:pt idx="269">90.980822155001434</cx:pt>
          <cx:pt idx="270">94.596300139064638</cx:pt>
          <cx:pt idx="271">102.78180772879995</cx:pt>
          <cx:pt idx="272">113.93068067908661</cx:pt>
          <cx:pt idx="273">93.74481318985066</cx:pt>
          <cx:pt idx="274">101.29906218716933</cx:pt>
          <cx:pt idx="275">119.33314711344873</cx:pt>
          <cx:pt idx="276">46.901492513565067</cx:pt>
          <cx:pt idx="277">75.731499390940357</cx:pt>
          <cx:pt idx="278">65.940806789119591</cx:pt>
          <cx:pt idx="279">72.700206327079982</cx:pt>
          <cx:pt idx="280">108.57854299998688</cx:pt>
          <cx:pt idx="281">61.212825453494638</cx:pt>
          <cx:pt idx="282">137.29238871838453</cx:pt>
          <cx:pt idx="283">119.55500825979645</cx:pt>
          <cx:pt idx="284">85.4786523057073</cx:pt>
          <cx:pt idx="285">90.980822155001434</cx:pt>
          <cx:pt idx="286">126.25173266137777</cx:pt>
          <cx:pt idx="287">102.16212605461968</cx:pt>
          <cx:pt idx="288">79.836269952948086</cx:pt>
          <cx:pt idx="289">100.92967848953052</cx:pt>
          <cx:pt idx="290">124.45963200974042</cx:pt>
          <cx:pt idx="291">90.980822155001434</cx:pt>
          <cx:pt idx="292">96.283747330481489</cx:pt>
          <cx:pt idx="293">115.37070685403638</cx:pt>
          <cx:pt idx="294">98.874010740942424</cx:pt>
          <cx:pt idx="295">82.423540326777996</cx:pt>
          <cx:pt idx="296">83.620511837706431</cx:pt>
          <cx:pt idx="297">99.004343339067702</cx:pt>
          <cx:pt idx="298">120.01583228891096</cx:pt>
          <cx:pt idx="299">85.412177117785731</cx:pt>
          <cx:pt idx="300">101.13604698622545</cx:pt>
          <cx:pt idx="301">103.68268900833928</cx:pt>
          <cx:pt idx="302">125.00239997696043</cx:pt>
          <cx:pt idx="303">72.769155553709709</cx:pt>
          <cx:pt idx="304">90.980822155001434</cx:pt>
          <cx:pt idx="305">69.299062042714539</cx:pt>
          <cx:pt idx="306">110.49796378214396</cx:pt>
          <cx:pt idx="307">122.59853180197551</cx:pt>
          <cx:pt idx="308">132.42356285797479</cx:pt>
          <cx:pt idx="309">90.980822155001434</cx:pt>
          <cx:pt idx="310">76.487449950956005</cx:pt>
          <cx:pt idx="311">84.987940320965535</cx:pt>
          <cx:pt idx="312">110.6485426926175</cx:pt>
          <cx:pt idx="313">89.196468539959582</cx:pt>
          <cx:pt idx="314">100.49527352069848</cx:pt>
          <cx:pt idx="315">144.92515309634831</cx:pt>
          <cx:pt idx="316">137.4787256269129</cx:pt>
          <cx:pt idx="317">63.738371488452707</cx:pt>
          <cx:pt idx="318">93.39100599094111</cx:pt>
          <cx:pt idx="319">93.733665243603909</cx:pt>
          <cx:pt idx="320">132.37333568358849</cx:pt>
          <cx:pt idx="321">79.725027438063634</cx:pt>
          <cx:pt idx="322">106.03489991507513</cx:pt>
          <cx:pt idx="323">114.34290533303762</cx:pt>
          <cx:pt idx="324">101.89259050588517</cx:pt>
          <cx:pt idx="325">147.68479948864069</cx:pt>
          <cx:pt idx="326">129.49054019502736</cx:pt>
          <cx:pt idx="327">104.24682249354174</cx:pt>
          <cx:pt idx="328">125.59498397627192</cx:pt>
          <cx:pt idx="329">118.42803722092164</cx:pt>
          <cx:pt idx="330">79.259195050164365</cx:pt>
          <cx:pt idx="331">110.16986883898883</cx:pt>
          <cx:pt idx="332">96.470928263389283</cx:pt>
          <cx:pt idx="333">76.637458204196733</cx:pt>
          <cx:pt idx="334">104.14701147896659</cx:pt>
          <cx:pt idx="335">91.589573642418486</cx:pt>
          <cx:pt idx="336">118.92686828467316</cx:pt>
          <cx:pt idx="337">110.19028995333483</cx:pt>
          <cx:pt idx="338">119.64656284239845</cx:pt>
          <cx:pt idx="339">104.67951088918977</cx:pt>
          <cx:pt idx="340">92.19490224518924</cx:pt>
          <cx:pt idx="341">134.19165398786916</cx:pt>
          <cx:pt idx="342">89.788529334208391</cx:pt>
          <cx:pt idx="343">113.06502553840423</cx:pt>
          <cx:pt idx="344">108.235391623997</cx:pt>
          <cx:pt idx="345">103.47753379357279</cx:pt>
          <cx:pt idx="346">69.474527706203233</cx:pt>
          <cx:pt idx="347">95.346473453400478</cx:pt>
          <cx:pt idx="348">110.01363551851198</cx:pt>
          <cx:pt idx="349">55.407039263978</cx:pt>
          <cx:pt idx="350">83.160868201336129</cx:pt>
          <cx:pt idx="351">58.453827932822335</cx:pt>
          <cx:pt idx="352">93.948443308018682</cx:pt>
          <cx:pt idx="353">104.96380328475145</cx:pt>
          <cx:pt idx="354">85.047104595041915</cx:pt>
          <cx:pt idx="355">86.930546990111594</cx:pt>
          <cx:pt idx="356">85.023055696675584</cx:pt>
          <cx:pt idx="357">59.821233688381923</cx:pt>
          <cx:pt idx="358">93.800426438263059</cx:pt>
          <cx:pt idx="359">104.198848362158</cx:pt>
          <cx:pt idx="360">24.852464666507423</cx:pt>
          <cx:pt idx="361">96.642640692398302</cx:pt>
          <cx:pt idx="362">113.70004397536529</cx:pt>
          <cx:pt idx="363">90.980822155001434</cx:pt>
          <cx:pt idx="364">71.174012111163151</cx:pt>
          <cx:pt idx="365">146.90575209977314</cx:pt>
          <cx:pt idx="366">71.321946131608044</cx:pt>
          <cx:pt idx="367">59.735667737123357</cx:pt>
          <cx:pt idx="368">83.125327067025722</cx:pt>
          <cx:pt idx="369">90.980822155001434</cx:pt>
          <cx:pt idx="370">134.18122074269559</cx:pt>
          <cx:pt idx="371">117.41337232189525</cx:pt>
          <cx:pt idx="372">105.52061409980516</cx:pt>
          <cx:pt idx="373">88.119521106279279</cx:pt>
          <cx:pt idx="374">89.042293321769293</cx:pt>
          <cx:pt idx="375">117.89232375349974</cx:pt>
          <cx:pt idx="376">90.980822155001434</cx:pt>
          <cx:pt idx="377">92.147273426835582</cx:pt>
          <cx:pt idx="378">93.586003226978349</cx:pt>
          <cx:pt idx="379">90.980822155001434</cx:pt>
          <cx:pt idx="380">70.59589223177224</cx:pt>
          <cx:pt idx="381">164.3998175181469</cx:pt>
          <cx:pt idx="382">71.787951635354517</cx:pt>
          <cx:pt idx="383">67.564783726435479</cx:pt>
          <cx:pt idx="384">72.175826978289621</cx:pt>
          <cx:pt idx="385">106.21534729030451</cx:pt>
          <cx:pt idx="386">84.433464929493454</cx:pt>
          <cx:pt idx="387">103.89417693018217</cx:pt>
          <cx:pt idx="388">116.36193535688551</cx:pt>
          <cx:pt idx="389">91.643330362880207</cx:pt>
          <cx:pt idx="390">103.4760841934019</cx:pt>
          <cx:pt idx="391">7.708145042745369</cx:pt>
          <cx:pt idx="392">66.290119927482408</cx:pt>
          <cx:pt idx="393">69.850483176567934</cx:pt>
          <cx:pt idx="394">90.980822155001434</cx:pt>
          <cx:pt idx="395">79.230486556627937</cx:pt>
          <cx:pt idx="396">76.131399566801605</cx:pt>
          <cx:pt idx="397">97.004639064325175</cx:pt>
          <cx:pt idx="398">116.19036104600072</cx:pt>
          <cx:pt idx="399">65.243467105910298</cx:pt>
          <cx:pt idx="400">93.725130034585717</cx:pt>
          <cx:pt idx="401">90.980822155001434</cx:pt>
          <cx:pt idx="402">98.689107808308819</cx:pt>
          <cx:pt idx="403">78.290165410477968</cx:pt>
          <cx:pt idx="404">100.92918309389015</cx:pt>
          <cx:pt idx="405">67.734998339115648</cx:pt>
          <cx:pt idx="406">92.677721163179243</cx:pt>
          <cx:pt idx="407">72.135636130833419</cx:pt>
          <cx:pt idx="408">74.863809681313981</cx:pt>
          <cx:pt idx="409">109.65491325061545</cx:pt>
          <cx:pt idx="410">77.459860573073584</cx:pt>
          <cx:pt idx="411">75.103528545601634</cx:pt>
          <cx:pt idx="412">121.75302870976145</cx:pt>
          <cx:pt idx="413">46.252891801486321</cx:pt>
          <cx:pt idx="414">67.979187991619909</cx:pt>
          <cx:pt idx="415">59.734161080574324</cx:pt>
          <cx:pt idx="416">119.18515008171111</cx:pt>
          <cx:pt idx="417">86.001569753115561</cx:pt>
          <cx:pt idx="418">101.26351761616816</cx:pt>
          <cx:pt idx="419">113.6076581925708</cx:pt>
          <cx:pt idx="420">81.560652277921363</cx:pt>
          <cx:pt idx="421">86.0313896203008</cx:pt>
          <cx:pt idx="422">54.196125322757162</cx:pt>
          <cx:pt idx="423">89.411688273961147</cx:pt>
          <cx:pt idx="424">110.74113960042131</cx:pt>
          <cx:pt idx="425">102.07105368320639</cx:pt>
          <cx:pt idx="426">108.20628447553314</cx:pt>
          <cx:pt idx="427">108.32497403646124</cx:pt>
          <cx:pt idx="428">60.339539275668983</cx:pt>
          <cx:pt idx="429">63.082723466889092</cx:pt>
          <cx:pt idx="430">76.94972384615815</cx:pt>
          <cx:pt idx="431">98.031678553414565</cx:pt>
          <cx:pt idx="432">63.253458403473871</cx:pt>
          <cx:pt idx="433">89.811190839449409</cx:pt>
          <cx:pt idx="434">97.14828871369788</cx:pt>
          <cx:pt idx="435">125.00959963138831</cx:pt>
          <cx:pt idx="436">64.036317820436864</cx:pt>
          <cx:pt idx="437">78.98626462873149</cx:pt>
          <cx:pt idx="438">113.83540749696466</cx:pt>
          <cx:pt idx="439">115.54306556431675</cx:pt>
          <cx:pt idx="440">117.04230004575268</cx:pt>
          <cx:pt idx="441">55.054336795569512</cx:pt>
          <cx:pt idx="442">103.85326186499873</cx:pt>
          <cx:pt idx="443">90.980822155001434</cx:pt>
          <cx:pt idx="444">94.064127062339765</cx:pt>
          <cx:pt idx="445">123.00772333475652</cx:pt>
          <cx:pt idx="446">67.561379500421694</cx:pt>
          <cx:pt idx="447">75.862639026071321</cx:pt>
          <cx:pt idx="448">74.217787625339511</cx:pt>
          <cx:pt idx="449">67.410088265778143</cx:pt>
          <cx:pt idx="450">148.09962862883893</cx:pt>
          <cx:pt idx="451">107.66011331965055</cx:pt>
          <cx:pt idx="452">94.365088883548452</cx:pt>
          <cx:pt idx="453">86.78876655420332</cx:pt>
          <cx:pt idx="454">113.0314115633349</cx:pt>
          <cx:pt idx="455">103.1629778554303</cx:pt>
          <cx:pt idx="456">89.152341528419768</cx:pt>
          <cx:pt idx="457">81.46569830302812</cx:pt>
          <cx:pt idx="458">91.16731870577307</cx:pt>
          <cx:pt idx="459">111.71392035015153</cx:pt>
          <cx:pt idx="460">49.506565221190613</cx:pt>
          <cx:pt idx="461">112.8716084761797</cx:pt>
          <cx:pt idx="462">92.097828421738598</cx:pt>
          <cx:pt idx="463">62.850218774480012</cx:pt>
          <cx:pt idx="464">88.145901776543184</cx:pt>
          <cx:pt idx="465">54.003610990377304</cx:pt>
          <cx:pt idx="466">97.152611905187598</cx:pt>
          <cx:pt idx="467">121.4454610102823</cx:pt>
          <cx:pt idx="468">73.555829136785619</cx:pt>
          <cx:pt idx="469">112.17620068445891</cx:pt>
          <cx:pt idx="470">101.49236424480415</cx:pt>
          <cx:pt idx="471">67.984262884876529</cx:pt>
          <cx:pt idx="472">115.65119973437371</cx:pt>
          <cx:pt idx="473">94.113548440168799</cx:pt>
          <cx:pt idx="474">73.270662614719129</cx:pt>
          <cx:pt idx="475">66.898953653999698</cx:pt>
          <cx:pt idx="476">78.361342510194405</cx:pt>
          <cx:pt idx="477">102.22035022440492</cx:pt>
          <cx:pt idx="478">66.852150301991031</cx:pt>
          <cx:pt idx="479">91.617247284558829</cx:pt>
          <cx:pt idx="480">117.29066459015398</cx:pt>
          <cx:pt idx="481">108.1369502066708</cx:pt>
          <cx:pt idx="482">125.45437417643117</cx:pt>
          <cx:pt idx="483">88.43523053625178</cx:pt>
          <cx:pt idx="484">90.980822155001434</cx:pt>
          <cx:pt idx="485">92.84417052244045</cx:pt>
          <cx:pt idx="486">81.822490795624162</cx:pt>
          <cx:pt idx="487">116.90637279464282</cx:pt>
          <cx:pt idx="488">105.97735607194585</cx:pt>
          <cx:pt idx="489">82.343609345230917</cx:pt>
          <cx:pt idx="490">90.980822155001434</cx:pt>
          <cx:pt idx="491">89.441377449142635</cx:pt>
          <cx:pt idx="492">66.13198923365303</cx:pt>
          <cx:pt idx="493">95.116192102081115</cx:pt>
          <cx:pt idx="494">89.349202570588176</cx:pt>
          <cx:pt idx="495">80.55972939378583</cx:pt>
          <cx:pt idx="496">97.115601218341837</cx:pt>
          <cx:pt idx="497">114.50414839646641</cx:pt>
          <cx:pt idx="498">112.6139422984561</cx:pt>
          <cx:pt idx="499">75.45303174823394</cx:pt>
          <cx:pt idx="500">62.557573482353035</cx:pt>
          <cx:pt idx="501">124.76137222714409</cx:pt>
          <cx:pt idx="502">76.993571160194932</cx:pt>
          <cx:pt idx="503">72.273923374893656</cx:pt>
          <cx:pt idx="504">77.1495301346677</cx:pt>
          <cx:pt idx="505">101.09055346569234</cx:pt>
          <cx:pt idx="506">99.327186610715998</cx:pt>
          <cx:pt idx="507">95.512774014788207</cx:pt>
          <cx:pt idx="508">90.980822155001434</cx:pt>
          <cx:pt idx="509">74.4587805433315</cx:pt>
          <cx:pt idx="510">90.980822155001434</cx:pt>
          <cx:pt idx="511">67.641259597970233</cx:pt>
          <cx:pt idx="512">93.42751200797332</cx:pt>
          <cx:pt idx="513">130.83539276510771</cx:pt>
          <cx:pt idx="514">104.52942169552072</cx:pt>
          <cx:pt idx="515">113.02654555457316</cx:pt>
          <cx:pt idx="516">111.70854935948277</cx:pt>
          <cx:pt idx="517">86.773267772972574</cx:pt>
          <cx:pt idx="518">50.887031746801661</cx:pt>
          <cx:pt idx="519">123.61148813925023</cx:pt>
          <cx:pt idx="520">119.57591730779238</cx:pt>
          <cx:pt idx="521">90.448714750404264</cx:pt>
          <cx:pt idx="522">73.508570928837955</cx:pt>
          <cx:pt idx="523">90.980822155001434</cx:pt>
          <cx:pt idx="524">104.89947568982411</cx:pt>
          <cx:pt idx="525">90.821142912870243</cx:pt>
          <cx:pt idx="526">80.679365391653903</cx:pt>
          <cx:pt idx="527">81.757323830957191</cx:pt>
          <cx:pt idx="528">70.263859842738498</cx:pt>
          <cx:pt idx="529">105.63285473752946</cx:pt>
          <cx:pt idx="530">110.26604191681135</cx:pt>
          <cx:pt idx="531">95.850404276664378</cx:pt>
          <cx:pt idx="532">86.857814847024557</cx:pt>
          <cx:pt idx="533">127.41860146776058</cx:pt>
          <cx:pt idx="534">97.622692034178186</cx:pt>
          <cx:pt idx="535">90.172390452954048</cx:pt>
          <cx:pt idx="536">48.93659162630761</cx:pt>
          <cx:pt idx="537">81.294649270416315</cx:pt>
          <cx:pt idx="538">87.085532667602138</cx:pt>
          <cx:pt idx="539">111.25601107355951</cx:pt>
          <cx:pt idx="540">55.327841092889209</cx:pt>
          <cx:pt idx="541">95.752336786106682</cx:pt>
          <cx:pt idx="542">92.403571359552984</cx:pt>
          <cx:pt idx="543">69.597844794217593</cx:pt>
          <cx:pt idx="544">105.99716977353688</cx:pt>
          <cx:pt idx="545">103.26131899215699</cx:pt>
          <cx:pt idx="546">110.73120608030962</cx:pt>
          <cx:pt idx="547">88.842388531601287</cx:pt>
          <cx:pt idx="548">98.820240841641336</cx:pt>
          <cx:pt idx="549">130.83883215620659</cx:pt>
          <cx:pt idx="550">83.768968001283156</cx:pt>
          <cx:pt idx="551">75.993486562994335</cx:pt>
          <cx:pt idx="552">89.586550329834665</cx:pt>
          <cx:pt idx="553">102.45535613134142</cx:pt>
          <cx:pt idx="554">116.06937580602388</cx:pt>
          <cx:pt idx="555">114.39667827345336</cx:pt>
          <cx:pt idx="556">96.358652958621207</cx:pt>
          <cx:pt idx="557">118.94578596991153</cx:pt>
          <cx:pt idx="558">111.76582661976782</cx:pt>
          <cx:pt idx="559">64.864088677788416</cx:pt>
          <cx:pt idx="560">80.073216495904546</cx:pt>
          <cx:pt idx="561">73.164677269841079</cx:pt>
          <cx:pt idx="562">104.35755842295278</cx:pt>
          <cx:pt idx="563">121.68730418576952</cx:pt>
          <cx:pt idx="564">75.206382707852654</cx:pt>
          <cx:pt idx="565">77.543923037205175</cx:pt>
          <cx:pt idx="566">65.365128317781185</cx:pt>
          <cx:pt idx="567">84.173986480384784</cx:pt>
          <cx:pt idx="568">73.885316538538291</cx:pt>
          <cx:pt idx="569">77.951010256442473</cx:pt>
          <cx:pt idx="570">71.598463670668238</cx:pt>
          <cx:pt idx="571">119.27573097659054</cx:pt>
          <cx:pt idx="572">120.14865792009498</cx:pt>
          <cx:pt idx="573">87.635323928196897</cx:pt>
          <cx:pt idx="574">62.810269860907297</cx:pt>
          <cx:pt idx="575">113.58829165015206</cx:pt>
          <cx:pt idx="576">136.36311818083365</cx:pt>
          <cx:pt idx="577">121.05453316584224</cx:pt>
          <cx:pt idx="578">105.46421193940625</cx:pt>
          <cx:pt idx="579">77.414985629398643</cx:pt>
          <cx:pt idx="580">72.414017979946394</cx:pt>
          <cx:pt idx="581">103.46545317157801</cx:pt>
          <cx:pt idx="582">119.15452152562236</cx:pt>
          <cx:pt idx="583">53.90343217272904</cx:pt>
          <cx:pt idx="584">110.27964454059507</cx:pt>
          <cx:pt idx="585">91.167428394136479</cx:pt>
          <cx:pt idx="586">95.557051021889535</cx:pt>
          <cx:pt idx="587">131.41765482613056</cx:pt>
          <cx:pt idx="588">70.636534456327922</cx:pt>
          <cx:pt idx="589">72.005833097048452</cx:pt>
          <cx:pt idx="590">96.26458331078986</cx:pt>
          <cx:pt idx="591">84.160026140680358</cx:pt>
          <cx:pt idx="592">110.19346623098849</cx:pt>
          <cx:pt idx="593">100.1828328607252</cx:pt>
          <cx:pt idx="594">120.93593345238627</cx:pt>
          <cx:pt idx="595">130.69238692441115</cx:pt>
          <cx:pt idx="596">89.07631559511205</cx:pt>
          <cx:pt idx="597">65.127797444716336</cx:pt>
          <cx:pt idx="598">90.073636542553331</cx:pt>
          <cx:pt idx="599">70.792866872305709</cx:pt>
          <cx:pt idx="600">77.091179780828369</cx:pt>
          <cx:pt idx="601">109.80163933202456</cx:pt>
          <cx:pt idx="602">101.35876873758876</cx:pt>
          <cx:pt idx="603">116.32067743956792</cx:pt>
          <cx:pt idx="604">101.77769893252648</cx:pt>
          <cx:pt idx="605">106.93549457500069</cx:pt>
          <cx:pt idx="606">77.565391767205057</cx:pt>
          <cx:pt idx="607">78.420469266639813</cx:pt>
          <cx:pt idx="608">115.20546862020049</cx:pt>
          <cx:pt idx="609">105.24257693538294</cx:pt>
          <cx:pt idx="610">68.555962541561627</cx:pt>
          <cx:pt idx="611">89.415155314968828</cx:pt>
          <cx:pt idx="612">136.77865330525813</cx:pt>
          <cx:pt idx="613">95.01242024072431</cx:pt>
          <cx:pt idx="614">121.58577219395367</cx:pt>
          <cx:pt idx="615">119.61897842733819</cx:pt>
          <cx:pt idx="616">72.791070880980996</cx:pt>
          <cx:pt idx="617">65.745265989271047</cx:pt>
          <cx:pt idx="618">121.19447182111898</cx:pt>
          <cx:pt idx="619">65.922909523169565</cx:pt>
          <cx:pt idx="620">86.818316039877203</cx:pt>
          <cx:pt idx="621">99.772240628343113</cx:pt>
          <cx:pt idx="622">79.188635548290648</cx:pt>
          <cx:pt idx="623">123.55848817462926</cx:pt>
          <cx:pt idx="624">65.985149844491531</cx:pt>
          <cx:pt idx="625">108.24047302187847</cx:pt>
          <cx:pt idx="626">78.879021292102763</cx:pt>
          <cx:pt idx="627">104.06728592598155</cx:pt>
          <cx:pt idx="628">64.858384192022541</cx:pt>
          <cx:pt idx="629">107.95045159701742</cx:pt>
          <cx:pt idx="630">131.31298488725324</cx:pt>
          <cx:pt idx="631">94.41631214996697</cx:pt>
          <cx:pt idx="632">73.734252556054301</cx:pt>
          <cx:pt idx="633">84.50550277940485</cx:pt>
          <cx:pt idx="634">77.171367747371178</cx:pt>
          <cx:pt idx="635">110.37617496543355</cx:pt>
          <cx:pt idx="636">70.540626592056867</cx:pt>
          <cx:pt idx="637">93.73723913152125</cx:pt>
          <cx:pt idx="638">105.33565398287514</cx:pt>
          <cx:pt idx="639">115.24235332550268</cx:pt>
          <cx:pt idx="640">81.947971298867429</cx:pt>
          <cx:pt idx="641">145.23670335008296</cx:pt>
          <cx:pt idx="642">93.371408900155302</cx:pt>
          <cx:pt idx="643">0.22160663347472251</cx:pt>
          <cx:pt idx="644">116.89696317697906</cx:pt>
          <cx:pt idx="645">77.405749140486961</cx:pt>
          <cx:pt idx="646">61.730138506243449</cx:pt>
          <cx:pt idx="647">123.0869611291139</cx:pt>
          <cx:pt idx="648">95.221846232889234</cx:pt>
          <cx:pt idx="649">113.88502974491423</cx:pt>
          <cx:pt idx="650">70.398934651030061</cx:pt>
          <cx:pt idx="651">92.472428323257517</cx:pt>
          <cx:pt idx="652">107.34942943490664</cx:pt>
          <cx:pt idx="653">86.913692822247526</cx:pt>
          <cx:pt idx="654">93.02386790496297</cx:pt>
          <cx:pt idx="655">90.569807331140993</cx:pt>
          <cx:pt idx="656">81.052637218044921</cx:pt>
          <cx:pt idx="657">65.551125085691694</cx:pt>
          <cx:pt idx="658">114.87471436308341</cx:pt>
          <cx:pt idx="659">154.30554105410471</cx:pt>
          <cx:pt idx="660">56.202224155276994</cx:pt>
          <cx:pt idx="661">97.071674550303285</cx:pt>
          <cx:pt idx="662">86.365444478680246</cx:pt>
          <cx:pt idx="663">83.081285497998891</cx:pt>
          <cx:pt idx="664">73.146155059579172</cx:pt>
          <cx:pt idx="665">107.71954325933619</cx:pt>
          <cx:pt idx="666">119.27237735536254</cx:pt>
          <cx:pt idx="667">117.5206364856828</cx:pt>
          <cx:pt idx="668">101.27981042636287</cx:pt>
          <cx:pt idx="669">144.60878258252507</cx:pt>
          <cx:pt idx="670">137.87530598334135</cx:pt>
          <cx:pt idx="671">77.691891468801302</cx:pt>
          <cx:pt idx="672">73.399455038848899</cx:pt>
          <cx:pt idx="673">90.980822155001434</cx:pt>
          <cx:pt idx="674">103.23080935457205</cx:pt>
          <cx:pt idx="675">100.88855237339864</cx:pt>
          <cx:pt idx="676">109.26344310884588</cx:pt>
          <cx:pt idx="677">59.426088547034631</cx:pt>
          <cx:pt idx="678">90.980822155001434</cx:pt>
          <cx:pt idx="679">94.682152489262734</cx:pt>
          <cx:pt idx="680">92.535884931198439</cx:pt>
          <cx:pt idx="681">72.87537306937098</cx:pt>
          <cx:pt idx="682">80.969191671894563</cx:pt>
          <cx:pt idx="683">82.155036364181598</cx:pt>
          <cx:pt idx="684">122.44835646099952</cx:pt>
          <cx:pt idx="685">64.087752340053243</cx:pt>
          <cx:pt idx="686">105.6181802532121</cx:pt>
          <cx:pt idx="687">90.980822155001434</cx:pt>
          <cx:pt idx="688">77.310671967070618</cx:pt>
          <cx:pt idx="689">76.752850109947062</cx:pt>
          <cx:pt idx="690">90.230260999290039</cx:pt>
          <cx:pt idx="691">65.534418437947551</cx:pt>
          <cx:pt idx="692">68.620623722026892</cx:pt>
          <cx:pt idx="693">102.69615377413119</cx:pt>
          <cx:pt idx="694">120.89871794192028</cx:pt>
          <cx:pt idx="695">75.495032949194737</cx:pt>
          <cx:pt idx="696">83.76019340951882</cx:pt>
          <cx:pt idx="697">116.64475984801032</cx:pt>
          <cx:pt idx="698">1.5757537878742351</cx:pt>
          <cx:pt idx="699">94.477775164321059</cx:pt>
          <cx:pt idx="700">108.97614417843936</cx:pt>
          <cx:pt idx="701">80.833718212142145</cx:pt>
          <cx:pt idx="702">91.654623451302228</cx:pt>
          <cx:pt idx="703">77.373703543258159</cx:pt>
          <cx:pt idx="704">88.397002211613483</cx:pt>
          <cx:pt idx="705">64.598219789712473</cx:pt>
          <cx:pt idx="706">90.980822155001434</cx:pt>
          <cx:pt idx="707">90.980822155001434</cx:pt>
          <cx:pt idx="708">84.393957129642885</cx:pt>
          <cx:pt idx="709">70.798234441262736</cx:pt>
          <cx:pt idx="710">90.980822155001434</cx:pt>
          <cx:pt idx="711">90.980822155001434</cx:pt>
          <cx:pt idx="712">107.53371564304844</cx:pt>
          <cx:pt idx="713">89.256092229046189</cx:pt>
          <cx:pt idx="714">93.738145917230526</cx:pt>
          <cx:pt idx="715">115.72424119431504</cx:pt>
          <cx:pt idx="716">73.901488482979829</cx:pt>
          <cx:pt idx="717">100.28758647011105</cx:pt>
          <cx:pt idx="718">85.10616898909268</cx:pt>
          <cx:pt idx="719">93.264837961581222</cx:pt>
          <cx:pt idx="720">69.700286943455254</cx:pt>
          <cx:pt idx="721">35.895403605475728</cx:pt>
          <cx:pt idx="722">88.406560842507602</cx:pt>
          <cx:pt idx="723">141.06948642424413</cx:pt>
          <cx:pt idx="724">72.603925513707594</cx:pt>
          <cx:pt idx="725">87.141723646023891</cx:pt>
          <cx:pt idx="726">101.99852940116342</cx:pt>
          <cx:pt idx="727">134.9903700269023</cx:pt>
          <cx:pt idx="728">102.27903010881556</cx:pt>
          <cx:pt idx="729">81.855482406494914</cx:pt>
          <cx:pt idx="730">95.769201729992517</cx:pt>
          <cx:pt idx="731">67.928639026554919</cx:pt>
          <cx:pt idx="732">57.491825505892578</cx:pt>
          <cx:pt idx="733">139.16644710561522</cx:pt>
          <cx:pt idx="734">104.47870596442128</cx:pt>
          <cx:pt idx="735">84.274254668908227</cx:pt>
          <cx:pt idx="736">108.90775913588526</cx:pt>
          <cx:pt idx="737">78.042424360087637</cx:pt>
          <cx:pt idx="738">90.980822155001434</cx:pt>
          <cx:pt idx="739">69.759443805122189</cx:pt>
          <cx:pt idx="740">81.980729442961163</cx:pt>
          <cx:pt idx="741">83.36755963802706</cx:pt>
          <cx:pt idx="742">119.65575623429072</cx:pt>
          <cx:pt idx="743">91.843725969714455</cx:pt>
          <cx:pt idx="744">86.616337950758464</cx:pt>
          <cx:pt idx="745">87.915072655375766</cx:pt>
          <cx:pt idx="746">75.796042113028577</cx:pt>
          <cx:pt idx="747">113.25413899721282</cx:pt>
          <cx:pt idx="748">91.952107099293812</cx:pt>
          <cx:pt idx="749">77.20505164819204</cx:pt>
          <cx:pt idx="750">104.7482696754462</cx:pt>
          <cx:pt idx="751">96.226711468282019</cx:pt>
          <cx:pt idx="752">81.251584599932585</cx:pt>
          <cx:pt idx="753">114.60410114825734</cx:pt>
          <cx:pt idx="754">118.39214500970915</cx:pt>
          <cx:pt idx="755">125.25414164809081</cx:pt>
          <cx:pt idx="756">120.81804500984114</cx:pt>
          <cx:pt idx="757">114.01008727301283</cx:pt>
          <cx:pt idx="758">147.72034389345293</cx:pt>
          <cx:pt idx="759">65.714990679448476</cx:pt>
          <cx:pt idx="760">90.667965676968848</cx:pt>
          <cx:pt idx="761">109.29867336797825</cx:pt>
          <cx:pt idx="762">114.10784372688848</cx:pt>
          <cx:pt idx="763">98.842500980094584</cx:pt>
          <cx:pt idx="764">63.501259830022271</cx:pt>
          <cx:pt idx="765">94.540837736927202</cx:pt>
          <cx:pt idx="766">90.980822155001434</cx:pt>
          <cx:pt idx="767">75.816093278406271</cx:pt>
          <cx:pt idx="768">106.45468519515711</cx:pt>
          <cx:pt idx="769">89.48815564084444</cx:pt>
          <cx:pt idx="770">96.18341852939102</cx:pt>
          <cx:pt idx="771">80.771777249234759</cx:pt>
          <cx:pt idx="772">90.980822155001434</cx:pt>
          <cx:pt idx="773">65.259252217597464</cx:pt>
          <cx:pt idx="774">99.125728244487561</cx:pt>
          <cx:pt idx="775">79.867765713083514</cx:pt>
          <cx:pt idx="776">99.279454067797928</cx:pt>
          <cx:pt idx="777">95.380763259684613</cx:pt>
          <cx:pt idx="778">81.192241008608704</cx:pt>
          <cx:pt idx="779">74.633906503679682</cx:pt>
          <cx:pt idx="780">85.236259889791029</cx:pt>
          <cx:pt idx="781">89.055488320484784</cx:pt>
          <cx:pt idx="782">61.523003827836632</cx:pt>
          <cx:pt idx="783">106.45656391223606</cx:pt>
          <cx:pt idx="784">125.97023457944341</cx:pt>
          <cx:pt idx="785">63.91361357332255</cx:pt>
          <cx:pt idx="786">100.86079515847572</cx:pt>
          <cx:pt idx="787">50.874256751327586</cx:pt>
          <cx:pt idx="788">100.95989302688469</cx:pt>
          <cx:pt idx="789">113.96490687926702</cx:pt>
          <cx:pt idx="790">72.407251018112817</cx:pt>
          <cx:pt idx="791">105.53293324834669</cx:pt>
          <cx:pt idx="792">103.11013529231741</cx:pt>
          <cx:pt idx="793">76.6075061596447</cx:pt>
          <cx:pt idx="794">135.88818933225949</cx:pt>
          <cx:pt idx="795">90.980822155001434</cx:pt>
          <cx:pt idx="796">117.285975291166</cx:pt>
          <cx:pt idx="797">89.864898597839641</cx:pt>
          <cx:pt idx="798">81.223826553542764</cx:pt>
          <cx:pt idx="799">78.265190218896166</cx:pt>
          <cx:pt idx="800">88.613825106469704</cx:pt>
          <cx:pt idx="801">106.30898362791359</cx:pt>
          <cx:pt idx="802">80.314818059932136</cx:pt>
          <cx:pt idx="803">139.22607514399019</cx:pt>
          <cx:pt idx="804">121.46069323036157</cx:pt>
          <cx:pt idx="805">104.78597234363004</cx:pt>
          <cx:pt idx="806">120.05665329335147</cx:pt>
          <cx:pt idx="807">69.700789091659502</cx:pt>
          <cx:pt idx="808">79.749482756943308</cx:pt>
          <cx:pt idx="809">76.828119852043756</cx:pt>
          <cx:pt idx="810">135.06924150227542</cx:pt>
          <cx:pt idx="811">79.124901263761458</cx:pt>
          <cx:pt idx="812">97.760216857369954</cx:pt>
          <cx:pt idx="813">63.133350932767698</cx:pt>
          <cx:pt idx="814">95.892804735287612</cx:pt>
          <cx:pt idx="815">67.860592393523945</cx:pt>
          <cx:pt idx="816">0.0094460256192750187</cx:pt>
          <cx:pt idx="817">120.04582458378135</cx:pt>
          <cx:pt idx="818">126.05911311761638</cx:pt>
          <cx:pt idx="819">106.52135936045879</cx:pt>
          <cx:pt idx="820">93.873265629784072</cx:pt>
          <cx:pt idx="821">106.62598182431897</cx:pt>
          <cx:pt idx="822">87.513084735941064</cx:pt>
          <cx:pt idx="823">100.68564942433456</cx:pt>
          <cx:pt idx="824">86.126708981592927</cx:pt>
          <cx:pt idx="825">99.641005615158264</cx:pt>
          <cx:pt idx="826">116.34947356993068</cx:pt>
          <cx:pt idx="827">86.548599064340721</cx:pt>
          <cx:pt idx="828">83.957131918616653</cx:pt>
          <cx:pt idx="829">90.980822155001434</cx:pt>
          <cx:pt idx="830">80.855241017512284</cx:pt>
          <cx:pt idx="831">111.74837806429227</cx:pt>
          <cx:pt idx="832">61.538280768965258</cx:pt>
          <cx:pt idx="833">101.83859779081799</cx:pt>
          <cx:pt idx="834">65.622480904031661</cx:pt>
          <cx:pt idx="835">67.497703664643296</cx:pt>
          <cx:pt idx="836">134.96443976099778</cx:pt>
          <cx:pt idx="837">84.145112751721953</cx:pt>
          <cx:pt idx="838">87.370361107185545</cx:pt>
          <cx:pt idx="839">89.783406039200813</cx:pt>
          <cx:pt idx="840">95.596652661063402</cx:pt>
          <cx:pt idx="841">98.743050388369099</cx:pt>
          <cx:pt idx="842">90.980822155001434</cx:pt>
          <cx:pt idx="843">134.91627033089819</cx:pt>
          <cx:pt idx="844">106.56922632730333</cx:pt>
          <cx:pt idx="845">101.34495547386658</cx:pt>
          <cx:pt idx="846">64.893374083954058</cx:pt>
          <cx:pt idx="847">75.89038147222611</cx:pt>
          <cx:pt idx="848">72.092024524214878</cx:pt>
          <cx:pt idx="849">131.57735367455905</cx:pt>
          <cx:pt idx="850">110.37073887584516</cx:pt>
          <cx:pt idx="851">121.49320968679689</cx:pt>
          <cx:pt idx="852">43.216894844493396</cx:pt>
          <cx:pt idx="853">66.991342724265508</cx:pt>
          <cx:pt idx="854">84.477452613108539</cx:pt>
          <cx:pt idx="855">116.10943114148824</cx:pt>
          <cx:pt idx="856">98.994949366116657</cx:pt>
          <cx:pt idx="857">110.11085323436561</cx:pt>
          <cx:pt idx="858">92.561385037174119</cx:pt>
          <cx:pt idx="859">109.67223896684158</cx:pt>
          <cx:pt idx="860">90.980822155001434</cx:pt>
          <cx:pt idx="861">90.737643786909075</cx:pt>
          <cx:pt idx="862">115.50367959506744</cx:pt>
          <cx:pt idx="863">91.822273986217525</cx:pt>
          <cx:pt idx="864">105.42438048193597</cx:pt>
          <cx:pt idx="865">115.28312972850799</cx:pt>
          <cx:pt idx="866">95.579548021530215</cx:pt>
          <cx:pt idx="867">82.26329679753907</cx:pt>
          <cx:pt idx="868">147.96587444407578</cx:pt>
          <cx:pt idx="869">94.882769774074376</cx:pt>
          <cx:pt idx="870">98.899696662831076</cx:pt>
          <cx:pt idx="871">87.490513771494108</cx:pt>
          <cx:pt idx="872">85.997325539809665</cx:pt>
          <cx:pt idx="873">98.563634267411231</cx:pt>
          <cx:pt idx="874">101.80275045400296</cx:pt>
          <cx:pt idx="875">104.03893501953969</cx:pt>
          <cx:pt idx="876">59.624240037085585</cx:pt>
          <cx:pt idx="877">95.624578430443293</cx:pt>
          <cx:pt idx="878">76.565070365016979</cx:pt>
          <cx:pt idx="879">69.958344748857513</cx:pt>
          <cx:pt idx="880">96.638967295806708</cx:pt>
          <cx:pt idx="881">43.790752448433672</cx:pt>
          <cx:pt idx="882">57.954292334563107</cx:pt>
          <cx:pt idx="883">0.21913603081191371</cx:pt>
          <cx:pt idx="884">88.235763724240527</cx:pt>
          <cx:pt idx="885">76.692046523743258</cx:pt>
          <cx:pt idx="886">77.404328044367134</cx:pt>
          <cx:pt idx="887">101.02326464730784</cx:pt>
          <cx:pt idx="888">123.56739052031487</cx:pt>
          <cx:pt idx="889">44.186083782114025</cx:pt>
          <cx:pt idx="890">49.720317778550047</cx:pt>
          <cx:pt idx="891">113.62042069980203</cx:pt>
          <cx:pt idx="892">47.906471379136242</cx:pt>
          <cx:pt idx="893">90.980822155001434</cx:pt>
          <cx:pt idx="894">80.541355836613519</cx:pt>
          <cx:pt idx="895">78.197058768217104</cx:pt>
          <cx:pt idx="896">90.980822155001434</cx:pt>
          <cx:pt idx="897">106.78342568020562</cx:pt>
          <cx:pt idx="898">85.093478010949823</cx:pt>
          <cx:pt idx="899">129.43569832159903</cx:pt>
          <cx:pt idx="900">88.301868609899756</cx:pt>
          <cx:pt idx="901">146.02773709128002</cx:pt>
          <cx:pt idx="902">67.294279103055999</cx:pt>
          <cx:pt idx="903">74.556287461219526</cx:pt>
          <cx:pt idx="904">93.767744987282271</cx:pt>
          <cx:pt idx="905">116.53454423474612</cx:pt>
          <cx:pt idx="906">88.510394869755274</cx:pt>
          <cx:pt idx="907">116.18562733832442</cx:pt>
          <cx:pt idx="908">110.82283158266621</cx:pt>
          <cx:pt idx="909">60.881524291035952</cx:pt>
          <cx:pt idx="910">95.595240467295227</cx:pt>
          <cx:pt idx="911">109.19203267638167</cx:pt>
          <cx:pt idx="912">83.251186177735633</cx:pt>
          <cx:pt idx="913">99.234167502932181</cx:pt>
          <cx:pt idx="914">54.692869736374227</cx:pt>
          <cx:pt idx="915">87.502514249591712</cx:pt>
          <cx:pt idx="916">104.4116851698123</cx:pt>
          <cx:pt idx="917">81.699143202361682</cx:pt>
          <cx:pt idx="918">79.503773495350515</cx:pt>
          <cx:pt idx="919">72.126416797176333</cx:pt>
          <cx:pt idx="920">54.257534039062264</cx:pt>
          <cx:pt idx="921">65.069270781222059</cx:pt>
          <cx:pt idx="922">118.21125157953452</cx:pt>
          <cx:pt idx="923">118.39003336429971</cx:pt>
          <cx:pt idx="924">82.893425553538322</cx:pt>
          <cx:pt idx="925">72.481790816728591</cx:pt>
          <cx:pt idx="926">89.301063823450605</cx:pt>
          <cx:pt idx="927">73.915154061937798</cx:pt>
          <cx:pt idx="928">88.083426363873926</cx:pt>
          <cx:pt idx="929">63.9404410369525</cx:pt>
          <cx:pt idx="930">93.13935795355259</cx:pt>
          <cx:pt idx="931">63.887400948856886</cx:pt>
          <cx:pt idx="932">72.749707903193666</cx:pt>
          <cx:pt idx="933">108.71568424105145</cx:pt>
          <cx:pt idx="934">52.589637762585895</cx:pt>
          <cx:pt idx="935">115.18767295157932</cx:pt>
          <cx:pt idx="936">71.449142752030269</cx:pt>
          <cx:pt idx="937">104.77786025683098</cx:pt>
          <cx:pt idx="938">94.173297701630901</cx:pt>
          <cx:pt idx="939">106.06460295499154</cx:pt>
          <cx:pt idx="940">79.362522641357614</cx:pt>
          <cx:pt idx="941">71.645865198209449</cx:pt>
          <cx:pt idx="942">133.21336269308722</cx:pt>
          <cx:pt idx="943">67.215400021126115</cx:pt>
          <cx:pt idx="944">53.598787299714154</cx:pt>
          <cx:pt idx="945">56.936719259191605</cx:pt>
          <cx:pt idx="946">108.53018013437551</cx:pt>
          <cx:pt idx="947">76.663746321191468</cx:pt>
          <cx:pt idx="948">62.893322380042861</cx:pt>
          <cx:pt idx="949">142.12846301849603</cx:pt>
          <cx:pt idx="950">113.27003134103919</cx:pt>
          <cx:pt idx="951">119.14948594098087</cx:pt>
          <cx:pt idx="952">114.43644524363729</cx:pt>
          <cx:pt idx="953">68.836690797858665</cx:pt>
          <cx:pt idx="954">75.246793951636235</cx:pt>
          <cx:pt idx="955">73.209971998355513</cx:pt>
          <cx:pt idx="956">135.5429821126863</cx:pt>
          <cx:pt idx="957">94.75141159898358</cx:pt>
          <cx:pt idx="958">117.57805917772244</cx:pt>
          <cx:pt idx="959">79.312420212725826</cx:pt>
          <cx:pt idx="960">101.93870707439838</cx:pt>
          <cx:pt idx="961">58.225681619024442</cx:pt>
          <cx:pt idx="962">126.30993626789619</cx:pt>
          <cx:pt idx="963">95.259697669056251</cx:pt>
          <cx:pt idx="964">93.240656368346094</cx:pt>
          <cx:pt idx="965">90.980822155001434</cx:pt>
          <cx:pt idx="966">131.99469686316948</cx:pt>
          <cx:pt idx="967">68.414837571977031</cx:pt>
          <cx:pt idx="968">61.876732298982951</cx:pt>
          <cx:pt idx="969">84.552646321685287</cx:pt>
          <cx:pt idx="970">137.72145802306918</cx:pt>
          <cx:pt idx="971">42.677863114265691</cx:pt>
          <cx:pt idx="972">112.74484467149706</cx:pt>
          <cx:pt idx="973">130.41779019750334</cx:pt>
          <cx:pt idx="974">120.17196012381591</cx:pt>
          <cx:pt idx="975">63.98054391766297</cx:pt>
          <cx:pt idx="976">66.901943170583621</cx:pt>
          <cx:pt idx="977">92.276432527487756</cx:pt>
          <cx:pt idx="978">131.37655803072329</cx:pt>
          <cx:pt idx="979">71.342904342338059</cx:pt>
          <cx:pt idx="980">90.980822155001434</cx:pt>
          <cx:pt idx="981">67.491777276939445</cx:pt>
          <cx:pt idx="982">72.375479273024496</cx:pt>
          <cx:pt idx="983">67.523699543197424</cx:pt>
          <cx:pt idx="984">92.269388206490248</cx:pt>
          <cx:pt idx="985">60.31268523287617</cx:pt>
          <cx:pt idx="986">78.479487765912438</cx:pt>
          <cx:pt idx="987">102.90723978418623</cx:pt>
          <cx:pt idx="988">75.685071183160019</cx:pt>
          <cx:pt idx="989">69.108537822761079</cx:pt>
          <cx:pt idx="990">71.385782898277441</cx:pt>
          <cx:pt idx="991">80.172189691937447</cx:pt>
          <cx:pt idx="992">87.660538442334484</cx:pt>
          <cx:pt idx="993">90.980822155001434</cx:pt>
          <cx:pt idx="994">70.712870115700994</cx:pt>
          <cx:pt idx="995">141.4552932908486</cx:pt>
          <cx:pt idx="996">98.805667853620633</cx:pt>
          <cx:pt idx="997">64.772061878559967</cx:pt>
          <cx:pt idx="998">101.55688061377231</cx:pt>
          <cx:pt idx="999">111.47107248071133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sz="14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l-GR" altLang="ja-JP" sz="1200" b="0" i="0" u="none" strike="noStrike" baseline="0" dirty="0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ω</a:t>
            </a:r>
            <a:r>
              <a:rPr lang="en-US" altLang="ja-JP" sz="1200" b="0" i="0" u="none" strike="noStrike" baseline="0" dirty="0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k21 </a:t>
            </a:r>
            <a:endParaRPr lang="ja-JP" altLang="en-US" sz="1200" b="0" i="0" u="none" strike="noStrike" baseline="0" dirty="0">
              <a:solidFill>
                <a:sysClr val="windowText" lastClr="000000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cx:rich>
      </cx:tx>
    </cx:title>
    <cx:plotArea>
      <cx:plotAreaRegion>
        <cx:series layoutId="clusteredColumn" uniqueId="{E249A16F-716F-4C4F-9D3C-7F059509CC26}">
          <cx:tx>
            <cx:txData>
              <cx:f>PK!$V$1</cx:f>
              <cx:v>omega nK21 %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>
              <cx:binCount val="15"/>
            </cx:binning>
          </cx:layoutPr>
        </cx:series>
      </cx:plotAreaRegion>
      <cx:axis id="0">
        <cx:catScaling gapWidth="0"/>
        <cx:tickLabels/>
        <cx:numFmt formatCode="#,##0.0_);[赤](#,##0.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8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PK!$S$2:$S$1001</cx:f>
        <cx:lvl ptCount="1000" formatCode="G/標準">
          <cx:pt idx="0">49.167367226647393</cx:pt>
          <cx:pt idx="1">44.74237365183032</cx:pt>
          <cx:pt idx="2">37.282703764614503</cx:pt>
          <cx:pt idx="3">47.345115904388699</cx:pt>
          <cx:pt idx="4">48.370135414323578</cx:pt>
          <cx:pt idx="5">37.520660974988168</cx:pt>
          <cx:pt idx="6">45.224219175127836</cx:pt>
          <cx:pt idx="7">51.979226619871902</cx:pt>
          <cx:pt idx="8">49.30395521659495</cx:pt>
          <cx:pt idx="9">34.144545684486708</cx:pt>
          <cx:pt idx="10">52.813918620000166</cx:pt>
          <cx:pt idx="11">43.462512582684404</cx:pt>
          <cx:pt idx="12">39.479108399253391</cx:pt>
          <cx:pt idx="13">35.563323804166565</cx:pt>
          <cx:pt idx="14">53.248474156542734</cx:pt>
          <cx:pt idx="15">47.067610944257623</cx:pt>
          <cx:pt idx="16">42.413441265711981</cx:pt>
          <cx:pt idx="17">44.971880103015486</cx:pt>
          <cx:pt idx="18">0.095618931179970848</cx:pt>
          <cx:pt idx="19">47.544295136220079</cx:pt>
          <cx:pt idx="20">17.499742855253615</cx:pt>
          <cx:pt idx="21">31.361505065924373</cx:pt>
          <cx:pt idx="22">47.686895474543107</cx:pt>
          <cx:pt idx="23">35.765206556093034</cx:pt>
          <cx:pt idx="24">37.878621939030467</cx:pt>
          <cx:pt idx="25">40.801225471791902</cx:pt>
          <cx:pt idx="26">42.413441265711981</cx:pt>
          <cx:pt idx="27">45.303973335679956</cx:pt>
          <cx:pt idx="28">39.960480477591858</cx:pt>
          <cx:pt idx="29">39.378547459244864</cx:pt>
          <cx:pt idx="30">46.114965033056244</cx:pt>
          <cx:pt idx="31">43.174413719238849</cx:pt>
          <cx:pt idx="32">35.653751555761986</cx:pt>
          <cx:pt idx="33">26.115014838211369</cx:pt>
          <cx:pt idx="34">42.413441265711981</cx:pt>
          <cx:pt idx="35">42.413441265711981</cx:pt>
          <cx:pt idx="36">38.735513421148816</cx:pt>
          <cx:pt idx="37">30.898300924160861</cx:pt>
          <cx:pt idx="38">18.473440394252499</cx:pt>
          <cx:pt idx="39">37.939161825216964</cx:pt>
          <cx:pt idx="40">41.135507776129373</cx:pt>
          <cx:pt idx="41">38.910538418274299</cx:pt>
          <cx:pt idx="42">45.313132754202726</cx:pt>
          <cx:pt idx="43">40.64480286580315</cx:pt>
          <cx:pt idx="44">37.478794004076491</cx:pt>
          <cx:pt idx="45">36.858241954819277</cx:pt>
          <cx:pt idx="46">42.578867998104414</cx:pt>
          <cx:pt idx="47">43.956455726093296</cx:pt>
          <cx:pt idx="48">48.552239907135075</cx:pt>
          <cx:pt idx="49">49.459680548907713</cx:pt>
          <cx:pt idx="50">38.711238678192665</cx:pt>
          <cx:pt idx="51">47.901670117022014</cx:pt>
          <cx:pt idx="52">34.508694556589646</cx:pt>
          <cx:pt idx="53">35.993332715935047</cx:pt>
          <cx:pt idx="54">37.919124462466165</cx:pt>
          <cx:pt idx="55">33.302702593032897</cx:pt>
          <cx:pt idx="56">44.672922447496092</cx:pt>
          <cx:pt idx="57">37.373386252786887</cx:pt>
          <cx:pt idx="58">38.631981569678764</cx:pt>
          <cx:pt idx="59">30.048793652990462</cx:pt>
          <cx:pt idx="60">43.351931906202289</cx:pt>
          <cx:pt idx="61">42.953812403557386</cx:pt>
          <cx:pt idx="62">36.193369558525497</cx:pt>
          <cx:pt idx="63">42.036531731340538</cx:pt>
          <cx:pt idx="64">47.393353964453709</cx:pt>
          <cx:pt idx="65">41.632319176332224</cx:pt>
          <cx:pt idx="66">44.74594953736036</cx:pt>
          <cx:pt idx="67">40.102992407051126</cx:pt>
          <cx:pt idx="68">47.875672319039033</cx:pt>
          <cx:pt idx="69">35.968736424845396</cx:pt>
          <cx:pt idx="70">33.749518515084034</cx:pt>
          <cx:pt idx="71">24.027192928013879</cx:pt>
          <cx:pt idx="72">45.617211664019976</cx:pt>
          <cx:pt idx="73">43.007789992046789</cx:pt>
          <cx:pt idx="74">38.909638908630342</cx:pt>
          <cx:pt idx="75">38.185075618623564</cx:pt>
          <cx:pt idx="76">34.881513728621357</cx:pt>
          <cx:pt idx="77">44.649188122517977</cx:pt>
          <cx:pt idx="78">41.073470756681864</cx:pt>
          <cx:pt idx="79">44.411597584414821</cx:pt>
          <cx:pt idx="80">41.106082275011325</cx:pt>
          <cx:pt idx="81">34.138248344049529</cx:pt>
          <cx:pt idx="82">42.413441265711981</cx:pt>
          <cx:pt idx="83">24.426420122482131</cx:pt>
          <cx:pt idx="84">45.938328223826339</cx:pt>
          <cx:pt idx="85">48.842809092025</cx:pt>
          <cx:pt idx="86">47.417401868934157</cx:pt>
          <cx:pt idx="87">36.870584481399263</cx:pt>
          <cx:pt idx="88">43.703089135666374</cx:pt>
          <cx:pt idx="89">38.958439393795025</cx:pt>
          <cx:pt idx="90">37.073440628029118</cx:pt>
          <cx:pt idx="91">41.690646432983023</cx:pt>
          <cx:pt idx="92">38.775249838008783</cx:pt>
          <cx:pt idx="93">36.120631223720331</cx:pt>
          <cx:pt idx="94">33.377836958077431</cx:pt>
          <cx:pt idx="95">27.442703948408582</cx:pt>
          <cx:pt idx="96">41.374267365114761</cx:pt>
          <cx:pt idx="97">49.461500179432491</cx:pt>
          <cx:pt idx="98">42.571821666449743</cx:pt>
          <cx:pt idx="99">42.413441265711981</cx:pt>
          <cx:pt idx="100">35.431624292431188</cx:pt>
          <cx:pt idx="101">42.413441265711981</cx:pt>
          <cx:pt idx="102">42.413441265711981</cx:pt>
          <cx:pt idx="103">42.839817926783958</cx:pt>
          <cx:pt idx="104">41.334005370880767</cx:pt>
          <cx:pt idx="105">49.416394040844381</cx:pt>
          <cx:pt idx="106">49.216460661043072</cx:pt>
          <cx:pt idx="107">47.361798952320214</cx:pt>
          <cx:pt idx="108">35.942593117358683</cx:pt>
          <cx:pt idx="109">40.878967697337956</cx:pt>
          <cx:pt idx="110">42.520112887902826</cx:pt>
          <cx:pt idx="111">43.467689149528063</cx:pt>
          <cx:pt idx="112">48.16357544867283</cx:pt>
          <cx:pt idx="113">18.462475456991136</cx:pt>
          <cx:pt idx="114">28.881395395652198</cx:pt>
          <cx:pt idx="115">49.687221697333811</cx:pt>
          <cx:pt idx="116">43.860574551640333</cx:pt>
          <cx:pt idx="117">43.575796034037062</cx:pt>
          <cx:pt idx="118">42.413441265711981</cx:pt>
          <cx:pt idx="119">33.578564591119736</cx:pt>
          <cx:pt idx="120">27.221645798885856</cx:pt>
          <cx:pt idx="121">32.36649502185864</cx:pt>
          <cx:pt idx="122">31.180250159355683</cx:pt>
          <cx:pt idx="123">22.176226008949314</cx:pt>
          <cx:pt idx="124">39.625623023493276</cx:pt>
          <cx:pt idx="125">38.921973228499091</cx:pt>
          <cx:pt idx="126">41.224143411355442</cx:pt>
          <cx:pt idx="127">44.380063091437805</cx:pt>
          <cx:pt idx="128">38.707880334629536</cx:pt>
          <cx:pt idx="129">34.953111449483295</cx:pt>
          <cx:pt idx="130">41.729605797323323</cx:pt>
          <cx:pt idx="131">39.441095319476105</cx:pt>
          <cx:pt idx="132">44.92549387597203</cx:pt>
          <cx:pt idx="133">41.671573044462818</cx:pt>
          <cx:pt idx="134">22.451859611176978</cx:pt>
          <cx:pt idx="135">44.301241517591805</cx:pt>
          <cx:pt idx="136">42.413441265711981</cx:pt>
          <cx:pt idx="137">34.088414454180764</cx:pt>
          <cx:pt idx="138">42.125051928751375</cx:pt>
          <cx:pt idx="139">44.961427913268061</cx:pt>
          <cx:pt idx="140">47.938606571322033</cx:pt>
          <cx:pt idx="141">53.437159355639409</cx:pt>
          <cx:pt idx="142">37.408688830270435</cx:pt>
          <cx:pt idx="143">46.867366045042466</cx:pt>
          <cx:pt idx="144">36.988376552641505</cx:pt>
          <cx:pt idx="145">42.413441265711981</cx:pt>
          <cx:pt idx="146">46.969138804112646</cx:pt>
          <cx:pt idx="147">48.357315889118574</cx:pt>
          <cx:pt idx="148">49.936860133572672</cx:pt>
          <cx:pt idx="149">45.136902862292175</cx:pt>
          <cx:pt idx="150">45.413654334351911</cx:pt>
          <cx:pt idx="151">50.747807834427682</cx:pt>
          <cx:pt idx="152">49.43490669557292</cx:pt>
          <cx:pt idx="153">39.365975156218347</cx:pt>
          <cx:pt idx="154">46.627781418377609</cx:pt>
          <cx:pt idx="155">36.630724808553815</cx:pt>
          <cx:pt idx="156">44.555022163612492</cx:pt>
          <cx:pt idx="157">33.121141284684022</cx:pt>
          <cx:pt idx="158">23.618467350782947</cx:pt>
          <cx:pt idx="159">41.512648674831624</cx:pt>
          <cx:pt idx="160">48.051742944455199</cx:pt>
          <cx:pt idx="161">46.311445669510256</cx:pt>
          <cx:pt idx="162">47.872434657117658</cx:pt>
          <cx:pt idx="163">46.93793774762586</cx:pt>
          <cx:pt idx="164">24.116633264201699</cx:pt>
          <cx:pt idx="165">27.870109436455394</cx:pt>
          <cx:pt idx="166">44.435008720602276</cx:pt>
          <cx:pt idx="167">32.024053459860454</cx:pt>
          <cx:pt idx="168">36.98567290181429</cx:pt>
          <cx:pt idx="169">51.381611496721277</cx:pt>
          <cx:pt idx="170">39.587245420716002</cx:pt>
          <cx:pt idx="171">45.112747644097226</cx:pt>
          <cx:pt idx="172">44.06801561223287</cx:pt>
          <cx:pt idx="173">43.964531158651063</cx:pt>
          <cx:pt idx="174">40.339930589925409</cx:pt>
          <cx:pt idx="175">51.035477856095369</cx:pt>
          <cx:pt idx="176">43.429598202147808</cx:pt>
          <cx:pt idx="177">37.43714732722033</cx:pt>
          <cx:pt idx="178">37.221096168705188</cx:pt>
          <cx:pt idx="179">28.418866972488537</cx:pt>
          <cx:pt idx="180">40.137638196585506</cx:pt>
          <cx:pt idx="181">42.38667243367896</cx:pt>
          <cx:pt idx="182">16.308157467966762</cx:pt>
          <cx:pt idx="183">45.839611691200005</cx:pt>
          <cx:pt idx="184">34.701152718605762</cx:pt>
          <cx:pt idx="185">46.842929028829957</cx:pt>
          <cx:pt idx="186">25.658409927351304</cx:pt>
          <cx:pt idx="187">38.044579114507229</cx:pt>
          <cx:pt idx="188">40.031362704759374</cx:pt>
          <cx:pt idx="189">30.271934196545814</cx:pt>
          <cx:pt idx="190">42.413441265711981</cx:pt>
          <cx:pt idx="191">19.020804399393835</cx:pt>
          <cx:pt idx="192">46.347383960694053</cx:pt>
          <cx:pt idx="193">34.869757670508697</cx:pt>
          <cx:pt idx="194">48.004687271140511</cx:pt>
          <cx:pt idx="195">43.96316640097708</cx:pt>
          <cx:pt idx="196">37.91793770763384</cx:pt>
          <cx:pt idx="197">38.986279637841818</cx:pt>
          <cx:pt idx="198">43.30265580769845</cx:pt>
          <cx:pt idx="199">42.55373074126404</cx:pt>
          <cx:pt idx="200">42.182697874839633</cx:pt>
          <cx:pt idx="201">35.131609698389852</cx:pt>
          <cx:pt idx="202">36.162549688870115</cx:pt>
          <cx:pt idx="203">38.532453853861945</cx:pt>
          <cx:pt idx="204">29.600962822178605</cx:pt>
          <cx:pt idx="205">39.830013808684527</cx:pt>
          <cx:pt idx="206">30.866956442124323</cx:pt>
          <cx:pt idx="207">36.421559549255988</cx:pt>
          <cx:pt idx="208">35.669174366671285</cx:pt>
          <cx:pt idx="209">38.296213912082749</cx:pt>
          <cx:pt idx="210">33.637033162869763</cx:pt>
          <cx:pt idx="211">39.342597778997771</cx:pt>
          <cx:pt idx="212">46.921849920905714</cx:pt>
          <cx:pt idx="213">32.366186058910309</cx:pt>
          <cx:pt idx="214">44.907794423685516</cx:pt>
          <cx:pt idx="215">40.813968197174852</cx:pt>
          <cx:pt idx="216">40.205347902984251</cx:pt>
          <cx:pt idx="217">40.894009341222585</cx:pt>
          <cx:pt idx="218">38.796262706606157</cx:pt>
          <cx:pt idx="219">43.745856946686963</cx:pt>
          <cx:pt idx="220">47.656164344185321</cx:pt>
          <cx:pt idx="221">51.995384410541668</cx:pt>
          <cx:pt idx="222">46.214824461421465</cx:pt>
          <cx:pt idx="223">14.905535884361889</cx:pt>
          <cx:pt idx="224">35.330157089942297</cx:pt>
          <cx:pt idx="225">42.791938493132093</cx:pt>
          <cx:pt idx="226">34.977421288597021</cx:pt>
          <cx:pt idx="227">47.436378445239683</cx:pt>
          <cx:pt idx="228">42.413441265711981</cx:pt>
          <cx:pt idx="229">47.462511522253017</cx:pt>
          <cx:pt idx="230">30.263360685819414</cx:pt>
          <cx:pt idx="231">49.080444170769276</cx:pt>
          <cx:pt idx="232">27.446894177666074</cx:pt>
          <cx:pt idx="233">41.796291701537349</cx:pt>
          <cx:pt idx="234">36.406867484033832</cx:pt>
          <cx:pt idx="235">35.199431813596085</cx:pt>
          <cx:pt idx="236">38.077158507430674</cx:pt>
          <cx:pt idx="237">47.272296326707043</cx:pt>
          <cx:pt idx="238">40.15943226690338</cx:pt>
          <cx:pt idx="239">50.134219850317805</cx:pt>
          <cx:pt idx="240">43.408754877328604</cx:pt>
          <cx:pt idx="241">55.982765205016449</cx:pt>
          <cx:pt idx="242">48.947522919959901</cx:pt>
          <cx:pt idx="243">32.893312390210873</cx:pt>
          <cx:pt idx="244">40.618345608850191</cx:pt>
          <cx:pt idx="245">34.060093951720098</cx:pt>
          <cx:pt idx="246">38.919275430048792</cx:pt>
          <cx:pt idx="247">42.413441265711981</cx:pt>
          <cx:pt idx="248">31.541686701887077</cx:pt>
          <cx:pt idx="249">35.253084971389384</cx:pt>
          <cx:pt idx="250">40.378088117195446</cx:pt>
          <cx:pt idx="251">40.902811639299323</cx:pt>
          <cx:pt idx="252">39.678583644076816</cx:pt>
          <cx:pt idx="253">48.159007464855421</cx:pt>
          <cx:pt idx="254">35.543775826436899</cx:pt>
          <cx:pt idx="255">42.686414700698393</cx:pt>
          <cx:pt idx="256">9.3897550553781759</cx:pt>
          <cx:pt idx="257">37.865947763128815</cx:pt>
          <cx:pt idx="258">35.512814588539726</cx:pt>
          <cx:pt idx="259">38.127942509398537</cx:pt>
          <cx:pt idx="260">45.521753041815074</cx:pt>
          <cx:pt idx="261">31.827189634022041</cx:pt>
          <cx:pt idx="262">18.479989177486008</cx:pt>
          <cx:pt idx="263">44.683889714303078</cx:pt>
          <cx:pt idx="264">46.814527659691279</cx:pt>
          <cx:pt idx="265">49.55562531136097</cx:pt>
          <cx:pt idx="266">36.614751125741655</cx:pt>
          <cx:pt idx="267">45.864801318658301</cx:pt>
          <cx:pt idx="268">53.542880012192093</cx:pt>
          <cx:pt idx="269">42.413441265711981</cx:pt>
          <cx:pt idx="270">43.464353210418302</cx:pt>
          <cx:pt idx="271">42.092042003210061</cx:pt>
          <cx:pt idx="272">35.441077861712955</cx:pt>
          <cx:pt idx="273">38.238331553560236</cx:pt>
          <cx:pt idx="274">46.617271477425618</cx:pt>
          <cx:pt idx="275">40.512096958809721</cx:pt>
          <cx:pt idx="276">46.807264393467818</cx:pt>
          <cx:pt idx="277">44.950305894398539</cx:pt>
          <cx:pt idx="278">30.979105861854695</cx:pt>
          <cx:pt idx="279">40.832952379175325</cx:pt>
          <cx:pt idx="280">44.095237838115807</cx:pt>
          <cx:pt idx="281">51.132866143019996</cx:pt>
          <cx:pt idx="282">49.130235090013564</cx:pt>
          <cx:pt idx="283">23.402264847659509</cx:pt>
          <cx:pt idx="284">45.877336452762819</cx:pt>
          <cx:pt idx="285">42.413441265711981</cx:pt>
          <cx:pt idx="286">39.237482080276251</cx:pt>
          <cx:pt idx="287">37.081396953189341</cx:pt>
          <cx:pt idx="288">46.180407100847432</cx:pt>
          <cx:pt idx="289">37.334836279271407</cx:pt>
          <cx:pt idx="290">45.876791518152181</cx:pt>
          <cx:pt idx="291">42.413441265711981</cx:pt>
          <cx:pt idx="292">30.654787554311969</cx:pt>
          <cx:pt idx="293">45.944749427981428</cx:pt>
          <cx:pt idx="294">25.85627583392473</cx:pt>
          <cx:pt idx="295">29.115442637885479</cx:pt>
          <cx:pt idx="296">43.228694174124669</cx:pt>
          <cx:pt idx="297">41.257120597540492</cx:pt>
          <cx:pt idx="298">40.886061194495127</cx:pt>
          <cx:pt idx="299">40.776095938674658</cx:pt>
          <cx:pt idx="300">36.278230386831162</cx:pt>
          <cx:pt idx="301">35.2362029736463</cx:pt>
          <cx:pt idx="302">32.594324659363629</cx:pt>
          <cx:pt idx="303">54.691955532783801</cx:pt>
          <cx:pt idx="304">42.413441265711981</cx:pt>
          <cx:pt idx="305">46.714023590352397</cx:pt>
          <cx:pt idx="306">44.550308640906181</cx:pt>
          <cx:pt idx="307">42.081468605551301</cx:pt>
          <cx:pt idx="308">44.485053669743955</cx:pt>
          <cx:pt idx="309">42.413441265711981</cx:pt>
          <cx:pt idx="310">50.038884879661339</cx:pt>
          <cx:pt idx="311">44.475386451384544</cx:pt>
          <cx:pt idx="312">31.248759975397423</cx:pt>
          <cx:pt idx="313">40.858781185933587</cx:pt>
          <cx:pt idx="314">38.893701289540445</cx:pt>
          <cx:pt idx="315">36.431716951030459</cx:pt>
          <cx:pt idx="316">44.018405241444178</cx:pt>
          <cx:pt idx="317">37.881525840441007</cx:pt>
          <cx:pt idx="318">38.131089677584619</cx:pt>
          <cx:pt idx="319">41.357707866853552</cx:pt>
          <cx:pt idx="320">47.136397825883982</cx:pt>
          <cx:pt idx="321">50.990881537780851</cx:pt>
          <cx:pt idx="322">37.276668306059754</cx:pt>
          <cx:pt idx="323">43.950426619089832</cx:pt>
          <cx:pt idx="324">41.983330025142124</cx:pt>
          <cx:pt idx="325">45.104656078946</cx:pt>
          <cx:pt idx="326">37.123308042252916</cx:pt>
          <cx:pt idx="327">38.112333961593066</cx:pt>
          <cx:pt idx="328">40.036982903310779</cx:pt>
          <cx:pt idx="329">41.735356713462991</cx:pt>
          <cx:pt idx="330">35.438397254954971</cx:pt>
          <cx:pt idx="331">44.814841291697107</cx:pt>
          <cx:pt idx="332">45.868289699965928</cx:pt>
          <cx:pt idx="333">36.362618167563241</cx:pt>
          <cx:pt idx="334">40.068191873355104</cx:pt>
          <cx:pt idx="335">30.121620142349581</cx:pt>
          <cx:pt idx="336">38.287987672375785</cx:pt>
          <cx:pt idx="337">48.351835539098204</cx:pt>
          <cx:pt idx="338">33.961301506273287</cx:pt>
          <cx:pt idx="339">41.88376773882694</cx:pt>
          <cx:pt idx="340">49.394534110567335</cx:pt>
          <cx:pt idx="341">44.703355578748223</cx:pt>
          <cx:pt idx="342">21.34738859907694</cx:pt>
          <cx:pt idx="343">30.285590633170749</cx:pt>
          <cx:pt idx="344">41.897613297179589</cx:pt>
          <cx:pt idx="345">44.394031130322013</cx:pt>
          <cx:pt idx="346">46.869926392090697</cx:pt>
          <cx:pt idx="347">45.545471783702055</cx:pt>
          <cx:pt idx="348">35.540821599957425</cx:pt>
          <cx:pt idx="349">46.303455594588186</cx:pt>
          <cx:pt idx="350">44.310495370735815</cx:pt>
          <cx:pt idx="351">48.18589005092673</cx:pt>
          <cx:pt idx="352">44.82365446948743</cx:pt>
          <cx:pt idx="353">33.052987762076818</cx:pt>
          <cx:pt idx="354">37.965510664285809</cx:pt>
          <cx:pt idx="355">36.967553340733815</cx:pt>
          <cx:pt idx="356">24.913971983607912</cx:pt>
          <cx:pt idx="357">47.13820106877224</cx:pt>
          <cx:pt idx="358">35.487885256802777</cx:pt>
          <cx:pt idx="359">38.144855485373121</cx:pt>
          <cx:pt idx="360">51.702901272559167</cx:pt>
          <cx:pt idx="361">44.170804837584747</cx:pt>
          <cx:pt idx="362">32.701529016240208</cx:pt>
          <cx:pt idx="363">42.413441265711981</cx:pt>
          <cx:pt idx="364">43.324819676485674</cx:pt>
          <cx:pt idx="365">41.230207372750385</cx:pt>
          <cx:pt idx="366">58.102839861748578</cx:pt>
          <cx:pt idx="367">40.791788389331494</cx:pt>
          <cx:pt idx="368">37.490132034976888</cx:pt>
          <cx:pt idx="369">42.413441265711981</cx:pt>
          <cx:pt idx="370">37.149293398394541</cx:pt>
          <cx:pt idx="371">42.801518664645535</cx:pt>
          <cx:pt idx="372">42.012498140434353</cx:pt>
          <cx:pt idx="373">42.297517657659299</cx:pt>
          <cx:pt idx="374">17.992970849751298</cx:pt>
          <cx:pt idx="375">39.319969481168215</cx:pt>
          <cx:pt idx="376">42.413441265711981</cx:pt>
          <cx:pt idx="377">35.959977753052073</cx:pt>
          <cx:pt idx="378">30.865206948925518</cx:pt>
          <cx:pt idx="379">42.413441265711981</cx:pt>
          <cx:pt idx="380">51.573636676115832</cx:pt>
          <cx:pt idx="381">43.21423376620254</cx:pt>
          <cx:pt idx="382">47.780016743404346</cx:pt>
          <cx:pt idx="383">43.933927664164059</cx:pt>
          <cx:pt idx="384">43.53343542611816</cx:pt>
          <cx:pt idx="385">47.814955819283156</cx:pt>
          <cx:pt idx="386">40.153829207187698</cx:pt>
          <cx:pt idx="387">36.134609448560525</cx:pt>
          <cx:pt idx="388">39.039595284787474</cx:pt>
          <cx:pt idx="389">42.923070719602528</cx:pt>
          <cx:pt idx="390">37.018103679145966</cx:pt>
          <cx:pt idx="391">54.762395857011228</cx:pt>
          <cx:pt idx="392">29.197414269075267</cx:pt>
          <cx:pt idx="393">43.920268669487896</cx:pt>
          <cx:pt idx="394">42.413441265711981</cx:pt>
          <cx:pt idx="395">41.599879807518676</cx:pt>
          <cx:pt idx="396">42.275761376940331</cx:pt>
          <cx:pt idx="397">52.289100202623494</cx:pt>
          <cx:pt idx="398">28.367234620244535</cx:pt>
          <cx:pt idx="399">57.896804747757891</cx:pt>
          <cx:pt idx="400">43.443411468253736</cx:pt>
          <cx:pt idx="401">42.413441265711981</cx:pt>
          <cx:pt idx="402">40.348358083074459</cx:pt>
          <cx:pt idx="403">46.747085470647256</cx:pt>
          <cx:pt idx="404">40.660668956621954</cx:pt>
          <cx:pt idx="405">46.02705725983359</cx:pt>
          <cx:pt idx="406">35.739054268405035</cx:pt>
          <cx:pt idx="407">39.618430054710643</cx:pt>
          <cx:pt idx="408">44.991554763088594</cx:pt>
          <cx:pt idx="409">30.68152538580831</cx:pt>
          <cx:pt idx="410">52.06793639083461</cx:pt>
          <cx:pt idx="411">40.739047607915431</cx:pt>
          <cx:pt idx="412">32.148094811357019</cx:pt>
          <cx:pt idx="413">46.301187889729135</cx:pt>
          <cx:pt idx="414">37.350368137409298</cx:pt>
          <cx:pt idx="415">46.690041764813188</cx:pt>
          <cx:pt idx="416">44.440747068428095</cx:pt>
          <cx:pt idx="417">32.161778557785013</cx:pt>
          <cx:pt idx="418">33.96733725213091</cx:pt>
          <cx:pt idx="419">33.256578296631787</cx:pt>
          <cx:pt idx="420">44.85799817200941</cx:pt>
          <cx:pt idx="421">46.792948186665903</cx:pt>
          <cx:pt idx="422">49.410120420820668</cx:pt>
          <cx:pt idx="423">40.639266725668165</cx:pt>
          <cx:pt idx="424">31.102925907380481</cx:pt>
          <cx:pt idx="425">31.824047511276753</cx:pt>
          <cx:pt idx="426">39.188901490090281</cx:pt>
          <cx:pt idx="427">48.647713204219578</cx:pt>
          <cx:pt idx="428">44.58699361921591</cx:pt>
          <cx:pt idx="429">42.614082179486161</cx:pt>
          <cx:pt idx="430">43.741170537606791</cx:pt>
          <cx:pt idx="431">30.258602082713605</cx:pt>
          <cx:pt idx="432">46.135344368499084</cx:pt>
          <cx:pt idx="433">36.079772726556911</cx:pt>
          <cx:pt idx="434">44.388849951310974</cx:pt>
          <cx:pt idx="435">46.949760382775118</cx:pt>
          <cx:pt idx="436">36.541072781186926</cx:pt>
          <cx:pt idx="437">38.914778683682627</cx:pt>
          <cx:pt idx="438">46.599141622995589</cx:pt>
          <cx:pt idx="439">40.27753716403226</cx:pt>
          <cx:pt idx="440">29.733970471499426</cx:pt>
          <cx:pt idx="441">39.084523791393444</cx:pt>
          <cx:pt idx="442">39.965985537704434</cx:pt>
          <cx:pt idx="443">42.413441265711981</cx:pt>
          <cx:pt idx="444">39.394035081468871</cx:pt>
          <cx:pt idx="445">30.247694126990904</cx:pt>
          <cx:pt idx="446">45.430826538816127</cx:pt>
          <cx:pt idx="447">49.801807196124919</cx:pt>
          <cx:pt idx="448">41.596514277040086</cx:pt>
          <cx:pt idx="449">43.840164233269022</cx:pt>
          <cx:pt idx="450">38.660315570362329</cx:pt>
          <cx:pt idx="451">44.695972972964803</cx:pt>
          <cx:pt idx="452">31.602531544165892</cx:pt>
          <cx:pt idx="453">28.459479967139245</cx:pt>
          <cx:pt idx="454">35.975130298582656</cx:pt>
          <cx:pt idx="455">31.049814814262579</cx:pt>
          <cx:pt idx="456">48.43882740116652</cx:pt>
          <cx:pt idx="457">51.637970525573529</cx:pt>
          <cx:pt idx="458">19.901356737669921</cx:pt>
          <cx:pt idx="459">48.546369586200775</cx:pt>
          <cx:pt idx="460">45.99358650942542</cx:pt>
          <cx:pt idx="461">33.697922784646536</cx:pt>
          <cx:pt idx="462">26.63706064865266</cx:pt>
          <cx:pt idx="463">45.501977978984613</cx:pt>
          <cx:pt idx="464">45.077045156043674</cx:pt>
          <cx:pt idx="465">47.247751269240318</cx:pt>
          <cx:pt idx="466">45.449202413243732</cx:pt>
          <cx:pt idx="467">42.802336384828344</cx:pt>
          <cx:pt idx="468">37.104447172812051</cx:pt>
          <cx:pt idx="469">32.52445233973971</cx:pt>
          <cx:pt idx="470">46.387713890641344</cx:pt>
          <cx:pt idx="471">48.277013163616488</cx:pt>
          <cx:pt idx="472">39.125694882008169</cx:pt>
          <cx:pt idx="473">27.544037467299525</cx:pt>
          <cx:pt idx="474">46.465363444182813</cx:pt>
          <cx:pt idx="475">42.660403186092836</cx:pt>
          <cx:pt idx="476">28.90112454559511</cx:pt>
          <cx:pt idx="477">33.517010606556184</cx:pt>
          <cx:pt idx="478">39.543899655951989</cx:pt>
          <cx:pt idx="479">39.013971856246577</cx:pt>
          <cx:pt idx="480">39.984997186444815</cx:pt>
          <cx:pt idx="481">42.750789466394657</cx:pt>
          <cx:pt idx="482">39.746320584426428</cx:pt>
          <cx:pt idx="483">49.25322324477861</cx:pt>
          <cx:pt idx="484">42.413441265711981</cx:pt>
          <cx:pt idx="485">35.129617134264358</cx:pt>
          <cx:pt idx="486">42.199407578780054</cx:pt>
          <cx:pt idx="487">41.201213574359677</cx:pt>
          <cx:pt idx="488">32.064466313974414</cx:pt>
          <cx:pt idx="489">35.242587873196825</cx:pt>
          <cx:pt idx="490">42.413441265711981</cx:pt>
          <cx:pt idx="491">33.857643154832857</cx:pt>
          <cx:pt idx="492">47.064423931458037</cx:pt>
          <cx:pt idx="493">51.173626019659778</cx:pt>
          <cx:pt idx="494">39.167588641630722</cx:pt>
          <cx:pt idx="495">50.13721172941311</cx:pt>
          <cx:pt idx="496">45.809824273838906</cx:pt>
          <cx:pt idx="497">37.487464571507104</cx:pt>
          <cx:pt idx="498">33.820112359363918</cx:pt>
          <cx:pt idx="499">38.403775856027487</cx:pt>
          <cx:pt idx="500">47.455558157079977</cx:pt>
          <cx:pt idx="501">39.160822258987359</cx:pt>
          <cx:pt idx="502">41.472521022961701</cx:pt>
          <cx:pt idx="503">50.002899915904877</cx:pt>
          <cx:pt idx="504">46.580468009671179</cx:pt>
          <cx:pt idx="505">40.927130366054257</cx:pt>
          <cx:pt idx="506">32.711007321695249</cx:pt>
          <cx:pt idx="507">38.212170836004596</cx:pt>
          <cx:pt idx="508">42.413441265711981</cx:pt>
          <cx:pt idx="509">41.885558370397789</cx:pt>
          <cx:pt idx="510">42.413441265711981</cx:pt>
          <cx:pt idx="511">44.819861668684339</cx:pt>
          <cx:pt idx="512">39.850219572795332</cx:pt>
          <cx:pt idx="513">42.651846384418107</cx:pt>
          <cx:pt idx="514">34.885527085024812</cx:pt>
          <cx:pt idx="515">30.728797568404786</cx:pt>
          <cx:pt idx="516">37.00824232519021</cx:pt>
          <cx:pt idx="517">42.332020977033444</cx:pt>
          <cx:pt idx="518">49.862811793961235</cx:pt>
          <cx:pt idx="519">36.132810574324274</cx:pt>
          <cx:pt idx="520">33.357008259134993</cx:pt>
          <cx:pt idx="521">44.345574751039138</cx:pt>
          <cx:pt idx="522">47.657633176648631</cx:pt>
          <cx:pt idx="523">42.413441265711981</cx:pt>
          <cx:pt idx="524">40.027365639022513</cx:pt>
          <cx:pt idx="525">46.599785407231224</cx:pt>
          <cx:pt idx="526">42.069228659437051</cx:pt>
          <cx:pt idx="527">41.27808135076048</cx:pt>
          <cx:pt idx="528">17.200494178947302</cx:pt>
          <cx:pt idx="529">32.901975624573069</cx:pt>
          <cx:pt idx="530">19.66298553119541</cx:pt>
          <cx:pt idx="531">38.29229687548137</cx:pt>
          <cx:pt idx="532">39.956476321117208</cx:pt>
          <cx:pt idx="533">38.970758268219519</cx:pt>
          <cx:pt idx="534">47.473676916792527</cx:pt>
          <cx:pt idx="535">24.86415090044299</cx:pt>
          <cx:pt idx="536">34.691641644638267</cx:pt>
          <cx:pt idx="537">46.992339801291017</cx:pt>
          <cx:pt idx="538">44.957980381685296</cx:pt>
          <cx:pt idx="539">27.69212884557632</cx:pt>
          <cx:pt idx="540">46.539445634859042</cx:pt>
          <cx:pt idx="541">45.400330395273556</cx:pt>
          <cx:pt idx="542">39.950093867223892</cx:pt>
          <cx:pt idx="543">44.732873817808752</cx:pt>
          <cx:pt idx="544">42.556198138461568</cx:pt>
          <cx:pt idx="545">38.416402746743479</cx:pt>
          <cx:pt idx="546">42.407782304666675</cx:pt>
          <cx:pt idx="547">40.646525066726184</cx:pt>
          <cx:pt idx="548">38.885858612097024</cx:pt>
          <cx:pt idx="549">43.677225186588949</cx:pt>
          <cx:pt idx="550">45.770514526275541</cx:pt>
          <cx:pt idx="551">46.519995700773656</cx:pt>
          <cx:pt idx="552">44.351888347622811</cx:pt>
          <cx:pt idx="553">37.422720371453487</cx:pt>
          <cx:pt idx="554">39.791079402298202</cx:pt>
          <cx:pt idx="555">41.747574779859967</cx:pt>
          <cx:pt idx="556">38.764029718283936</cx:pt>
          <cx:pt idx="557">38.099737531904339</cx:pt>
          <cx:pt idx="558">31.245207632531425</cx:pt>
          <cx:pt idx="559">36.961466421125664</cx:pt>
          <cx:pt idx="560">40.902078186810996</cx:pt>
          <cx:pt idx="561">49.621970940300223</cx:pt>
          <cx:pt idx="562">44.292888819764286</cx:pt>
          <cx:pt idx="563">42.118167101620173</cx:pt>
          <cx:pt idx="564">42.731019178109946</cx:pt>
          <cx:pt idx="565">47.691928038191115</cx:pt>
          <cx:pt idx="566">44.187102190571402</cx:pt>
          <cx:pt idx="567">38.108529229032179</cx:pt>
          <cx:pt idx="568">48.109562459037186</cx:pt>
          <cx:pt idx="569">47.837851122306908</cx:pt>
          <cx:pt idx="570">41.400603860330349</cx:pt>
          <cx:pt idx="571">38.976018267647603</cx:pt>
          <cx:pt idx="572">37.5141306709885</cx:pt>
          <cx:pt idx="573">41.118973722601588</cx:pt>
          <cx:pt idx="574">42.482113883374495</cx:pt>
          <cx:pt idx="575">37.871493236998191</cx:pt>
          <cx:pt idx="576">32.969379733322249</cx:pt>
          <cx:pt idx="577">41.990713259005261</cx:pt>
          <cx:pt idx="578">40.134772953138778</cx:pt>
          <cx:pt idx="579">47.4282616168883</cx:pt>
          <cx:pt idx="580">35.525343066605288</cx:pt>
          <cx:pt idx="581">38.402473878644848</cx:pt>
          <cx:pt idx="582">40.513454555246213</cx:pt>
          <cx:pt idx="583">43.978403790951759</cx:pt>
          <cx:pt idx="584">30.776549514199932</cx:pt>
          <cx:pt idx="585">49.733087577587618</cx:pt>
          <cx:pt idx="586">35.666791277040886</cx:pt>
          <cx:pt idx="587">48.812088666640769</cx:pt>
          <cx:pt idx="588">46.024993210211342</cx:pt>
          <cx:pt idx="589">46.669368969378624</cx:pt>
          <cx:pt idx="590">43.255519878970361</cx:pt>
          <cx:pt idx="591">45.567642028088308</cx:pt>
          <cx:pt idx="592">39.663585314492181</cx:pt>
          <cx:pt idx="593">37.327737675889225</cx:pt>
          <cx:pt idx="594">32.893008375641166</cx:pt>
          <cx:pt idx="595">33.230106831004925</cx:pt>
          <cx:pt idx="596">44.949860956403413</cx:pt>
          <cx:pt idx="597">51.983362723086699</cx:pt>
          <cx:pt idx="598">46.6871502664277</cx:pt>
          <cx:pt idx="599">38.439562952770416</cx:pt>
          <cx:pt idx="600">39.403680031184898</cx:pt>
          <cx:pt idx="601">34.178794595479815</cx:pt>
          <cx:pt idx="602">26.489412979528254</cx:pt>
          <cx:pt idx="603">14.98966310495336</cx:pt>
          <cx:pt idx="604">43.452387736463919</cx:pt>
          <cx:pt idx="605">33.274164151785989</cx:pt>
          <cx:pt idx="606">37.144582377515029</cx:pt>
          <cx:pt idx="607">47.035624796530549</cx:pt>
          <cx:pt idx="608">44.131054825372125</cx:pt>
          <cx:pt idx="609">43.715900997234399</cx:pt>
          <cx:pt idx="610">46.137511853154805</cx:pt>
          <cx:pt idx="611">46.99478694493677</cx:pt>
          <cx:pt idx="612">37.904749042831028</cx:pt>
          <cx:pt idx="613">37.469320783809252</cx:pt>
          <cx:pt idx="614">43.57900870832195</cx:pt>
          <cx:pt idx="615">40.55465448009636</cx:pt>
          <cx:pt idx="616">39.418016185495688</cx:pt>
          <cx:pt idx="617">46.804273309175521</cx:pt>
          <cx:pt idx="618">43.210415411101984</cx:pt>
          <cx:pt idx="619">35.489716820510139</cx:pt>
          <cx:pt idx="620">37.090295226649253</cx:pt>
          <cx:pt idx="621">37.299329752691271</cx:pt>
          <cx:pt idx="622">35.227404105326862</cx:pt>
          <cx:pt idx="623">32.352125123397997</cx:pt>
          <cx:pt idx="624">46.44932722871237</cx:pt>
          <cx:pt idx="625">31.603860523676534</cx:pt>
          <cx:pt idx="626">39.832398873279026</cx:pt>
          <cx:pt idx="627">49.508080148597969</cx:pt>
          <cx:pt idx="628">41.603365248498825</cx:pt>
          <cx:pt idx="629">39.832398873279026</cx:pt>
          <cx:pt idx="630">42.869569626951005</cx:pt>
          <cx:pt idx="631">31.171349024384554</cx:pt>
          <cx:pt idx="632">48.141769805440262</cx:pt>
          <cx:pt idx="633">50.982055666675507</cx:pt>
          <cx:pt idx="634">48.675969430510577</cx:pt>
          <cx:pt idx="635">35.84550180985056</cx:pt>
          <cx:pt idx="636">48.016976164685751</cx:pt>
          <cx:pt idx="637">32.800000000000004</cx:pt>
          <cx:pt idx="638">33.24334519870105</cx:pt>
          <cx:pt idx="639">43.174992762014448</cx:pt>
          <cx:pt idx="640">32.293342967243262</cx:pt>
          <cx:pt idx="641">44.980551352779123</cx:pt>
          <cx:pt idx="642">46.300647943630338</cx:pt>
          <cx:pt idx="643">48.69558501548164</cx:pt>
          <cx:pt idx="644">44.885632445137723</cx:pt>
          <cx:pt idx="645">27.109758390660733</cx:pt>
          <cx:pt idx="646">52.886293120240524</cx:pt>
          <cx:pt idx="647">49.23281426040969</cx:pt>
          <cx:pt idx="648">43.631066913381801</cx:pt>
          <cx:pt idx="649">33.729215822488371</cx:pt>
          <cx:pt idx="650">42.830713279141172</cx:pt>
          <cx:pt idx="651">46.523757371906235</cx:pt>
          <cx:pt idx="652">35.326901930398598</cx:pt>
          <cx:pt idx="653">51.732581609658723</cx:pt>
          <cx:pt idx="654">32.575297389279498</cx:pt>
          <cx:pt idx="655">42.785394704267951</cx:pt>
          <cx:pt idx="656">42.592722383055062</cx:pt>
          <cx:pt idx="657">38.896015220071064</cx:pt>
          <cx:pt idx="658">39.747578542598042</cx:pt>
          <cx:pt idx="659">45.403193720265975</cx:pt>
          <cx:pt idx="660">40.12492990648083</cx:pt>
          <cx:pt idx="661">42.519642519663783</cx:pt>
          <cx:pt idx="662">47.526624117435482</cx:pt>
          <cx:pt idx="663">45.290948323036915</cx:pt>
          <cx:pt idx="664">41.988688953097828</cx:pt>
          <cx:pt idx="665">35.86572179672396</cx:pt>
          <cx:pt idx="666">44.227480145267151</cx:pt>
          <cx:pt idx="667">43.007557475401924</cx:pt>
          <cx:pt idx="668">35.794552658190881</cx:pt>
          <cx:pt idx="669">44.605717122359998</cx:pt>
          <cx:pt idx="670">43.11704999185357</cx:pt>
          <cx:pt idx="671">45.369593341796659</cx:pt>
          <cx:pt idx="672">50.669813498768669</cx:pt>
          <cx:pt idx="673">42.413441265711981</cx:pt>
          <cx:pt idx="674">32.961644376456704</cx:pt>
          <cx:pt idx="675">47.694339286753937</cx:pt>
          <cx:pt idx="676">42.45385730413669</cx:pt>
          <cx:pt idx="677">47.247010487437194</cx:pt>
          <cx:pt idx="678">42.413441265711981</cx:pt>
          <cx:pt idx="679">31.051022527446658</cx:pt>
          <cx:pt idx="680">36.665106027393399</cx:pt>
          <cx:pt idx="681">45.044866522168761</cx:pt>
          <cx:pt idx="682">48.225304560987482</cx:pt>
          <cx:pt idx="683">47.871912433074989</cx:pt>
          <cx:pt idx="684">39.977743808274127</cx:pt>
          <cx:pt idx="685">32.873545595204661</cx:pt>
          <cx:pt idx="686">30.239626320442518</cx:pt>
          <cx:pt idx="687">42.413441265711981</cx:pt>
          <cx:pt idx="688">36.178999433372951</cx:pt>
          <cx:pt idx="689">44.021926354942714</cx:pt>
          <cx:pt idx="690">49.322205952288876</cx:pt>
          <cx:pt idx="691">10.602405387458075</cx:pt>
          <cx:pt idx="692">51.738863536030635</cx:pt>
          <cx:pt idx="693">33.561585183063094</cx:pt>
          <cx:pt idx="694">43.77567817864162</cx:pt>
          <cx:pt idx="695">37.578052104918903</cx:pt>
          <cx:pt idx="696">41.247666600669668</cx:pt>
          <cx:pt idx="697">38.626804164983675</cx:pt>
          <cx:pt idx="698">54.219369232775108</cx:pt>
          <cx:pt idx="699">44.723260167389405</cx:pt>
          <cx:pt idx="700">36.626083601717504</cx:pt>
          <cx:pt idx="701">47.825202560992878</cx:pt>
          <cx:pt idx="702">28.866641647410251</cx:pt>
          <cx:pt idx="703">48.064435916798196</cx:pt>
          <cx:pt idx="704">43.320203138951229</cx:pt>
          <cx:pt idx="705">56.213610451562346</cx:pt>
          <cx:pt idx="706">42.413441265711981</cx:pt>
          <cx:pt idx="707">42.413441265711981</cx:pt>
          <cx:pt idx="708">48.892432952349587</cx:pt>
          <cx:pt idx="709">31.475895539285297</cx:pt>
          <cx:pt idx="710">42.413441265711981</cx:pt>
          <cx:pt idx="711">42.413441265711981</cx:pt>
          <cx:pt idx="712">47.333708918697674</cx:pt>
          <cx:pt idx="713">36.944688386830386</cx:pt>
          <cx:pt idx="714">44.300564330491319</cx:pt>
          <cx:pt idx="715">29.596232868390533</cx:pt>
          <cx:pt idx="716">37.479727853867885</cx:pt>
          <cx:pt idx="717">31.915826794867776</cx:pt>
          <cx:pt idx="718">48.19356803557919</cx:pt>
          <cx:pt idx="719">32.313464685793136</cx:pt>
          <cx:pt idx="720">18.117781321122077</cx:pt>
          <cx:pt idx="721">46.250621617444232</cx:pt>
          <cx:pt idx="722">46.377365168797589</cx:pt>
          <cx:pt idx="723">42.864554121091707</cx:pt>
          <cx:pt idx="724">40.325550213233299</cx:pt>
          <cx:pt idx="725">23.13694016070405</cx:pt>
          <cx:pt idx="726">40.362234824152146</cx:pt>
          <cx:pt idx="727">42.399764150287439</cx:pt>
          <cx:pt idx="728">37.600000000000001</cx:pt>
          <cx:pt idx="729">46.760132591770954</cx:pt>
          <cx:pt idx="730">43.199768517898335</cx:pt>
          <cx:pt idx="731">41.703237284412339</cx:pt>
          <cx:pt idx="732">49.245202812050636</cx:pt>
          <cx:pt idx="733">41.743382709119295</cx:pt>
          <cx:pt idx="734">29.63745940528641</cx:pt>
          <cx:pt idx="735">39.783287948584636</cx:pt>
          <cx:pt idx="736">33.134724987541389</cx:pt>
          <cx:pt idx="737">49.818671198658038</cx:pt>
          <cx:pt idx="738">42.413441265711981</cx:pt>
          <cx:pt idx="739">55.723244700932483</cx:pt>
          <cx:pt idx="740">41.058129523883572</cx:pt>
          <cx:pt idx="741">41.454794656348263</cx:pt>
          <cx:pt idx="742">27.282870083625731</cx:pt>
          <cx:pt idx="743">41.822123332035645</cx:pt>
          <cx:pt idx="744">43.586695217692288</cx:pt>
          <cx:pt idx="745">39.157757852052768</cx:pt>
          <cx:pt idx="746">45.641757196672437</cx:pt>
          <cx:pt idx="747">38.564361786499205</cx:pt>
          <cx:pt idx="748">45.253508151302476</cx:pt>
          <cx:pt idx="749">45.672201611045644</cx:pt>
          <cx:pt idx="750">38.115482418565819</cx:pt>
          <cx:pt idx="751">26.715931576495699</cx:pt>
          <cx:pt idx="752">43.312123014232398</cx:pt>
          <cx:pt idx="753">29.440618200031061</cx:pt>
          <cx:pt idx="754">34.95840385372307</cx:pt>
          <cx:pt idx="755">41.340537006671788</cx:pt>
          <cx:pt idx="756">30.746349376795941</cx:pt>
          <cx:pt idx="757">33.8323809389762</cx:pt>
          <cx:pt idx="758">33.674916480965472</cx:pt>
          <cx:pt idx="759">17.574953769498229</cx:pt>
          <cx:pt idx="760">53.519248873652927</cx:pt>
          <cx:pt idx="761">33.559946364677046</cx:pt>
          <cx:pt idx="762">38.179968569918962</cx:pt>
          <cx:pt idx="763">35.927009338379392</cx:pt>
          <cx:pt idx="764">53.236077992278886</cx:pt>
          <cx:pt idx="765">42.231149640993678</cx:pt>
          <cx:pt idx="766">42.413441265711981</cx:pt>
          <cx:pt idx="767">50.347194559379375</cx:pt>
          <cx:pt idx="768">33.467745666536906</cx:pt>
          <cx:pt idx="769">46.959237642874911</cx:pt>
          <cx:pt idx="770">43.606880191089111</cx:pt>
          <cx:pt idx="771">50.752536882406183</cx:pt>
          <cx:pt idx="772">42.413441265711981</cx:pt>
          <cx:pt idx="773">46.504515909747944</cx:pt>
          <cx:pt idx="774">47.785353404573669</cx:pt>
          <cx:pt idx="775">50.504950252425751</cx:pt>
          <cx:pt idx="776">39.797738629223645</cx:pt>
          <cx:pt idx="777">27.369234552687072</cx:pt>
          <cx:pt idx="778">46.261106774481739</cx:pt>
          <cx:pt idx="779">43.095127334769529</cx:pt>
          <cx:pt idx="780">48.62550770943168</cx:pt>
          <cx:pt idx="781">44.660609041973444</cx:pt>
          <cx:pt idx="782">46.424239358335207</cx:pt>
          <cx:pt idx="783">39.519109301703651</cx:pt>
          <cx:pt idx="784">45.086250675788072</cx:pt>
          <cx:pt idx="785">42.954860027708158</cx:pt>
          <cx:pt idx="786">37.323049178758161</cx:pt>
          <cx:pt idx="787">25.204047294035931</cx:pt>
          <cx:pt idx="788">32.327078432793769</cx:pt>
          <cx:pt idx="789">33.259885748450792</cx:pt>
          <cx:pt idx="790">37.687796433328387</cx:pt>
          <cx:pt idx="791">40.249472046226892</cx:pt>
          <cx:pt idx="792">39.187880779649205</cx:pt>
          <cx:pt idx="793">42.454799493107963</cx:pt>
          <cx:pt idx="794">41.521319824880329</cx:pt>
          <cx:pt idx="795">42.413441265711981</cx:pt>
          <cx:pt idx="796">45.887035206036138</cx:pt>
          <cx:pt idx="797">45.032543787798616</cx:pt>
          <cx:pt idx="798">38.640522770790767</cx:pt>
          <cx:pt idx="799">37.748112535595737</cx:pt>
          <cx:pt idx="800">37.360139186036236</cx:pt>
          <cx:pt idx="801">37.702121956197637</cx:pt>
          <cx:pt idx="802">27.676217227070609</cx:pt>
          <cx:pt idx="803">41.434164647063895</cx:pt>
          <cx:pt idx="804">35.08931461285615</cx:pt>
          <cx:pt idx="805">42.411083457039858</cx:pt>
          <cx:pt idx="806">37.045512548755482</cx:pt>
          <cx:pt idx="807">46.119952298327455</cx:pt>
          <cx:pt idx="808">50.410217218337792</cx:pt>
          <cx:pt idx="809">50.721198724004935</cx:pt>
          <cx:pt idx="810">43.682490771475017</cx:pt>
          <cx:pt idx="811">26.312259500088548</cx:pt>
          <cx:pt idx="812">51.156329031704374</cx:pt>
          <cx:pt idx="813">42.123983667264895</cx:pt>
          <cx:pt idx="814">35.623166619490753</cx:pt>
          <cx:pt idx="815">41.103527829129213</cx:pt>
          <cx:pt idx="816">45.951278545868554</cx:pt>
          <cx:pt idx="817">32.061347445171421</cx:pt>
          <cx:pt idx="818">38.48960898736177</cx:pt>
          <cx:pt idx="819">35.153947146799887</cx:pt>
          <cx:pt idx="820">43.950995438101288</cx:pt>
          <cx:pt idx="821">34.151573902237651</cx:pt>
          <cx:pt idx="822">49.840044141232461</cx:pt>
          <cx:pt idx="823">41.982734546477559</cx:pt>
          <cx:pt idx="824">45.450412539381865</cx:pt>
          <cx:pt idx="825">40.414972473082301</cx:pt>
          <cx:pt idx="826">42.158154608568907</cx:pt>
          <cx:pt idx="827">43.155764389012965</cx:pt>
          <cx:pt idx="828">40.78798842796737</cx:pt>
          <cx:pt idx="829">42.413441265711981</cx:pt>
          <cx:pt idx="830">39.142815432720219</cx:pt>
          <cx:pt idx="831">38.492596690792375</cx:pt>
          <cx:pt idx="832">36.404807374850925</cx:pt>
          <cx:pt idx="833">40.995853448855044</cx:pt>
          <cx:pt idx="834">40.949969474958095</cx:pt>
          <cx:pt idx="835">19.898065232579771</cx:pt>
          <cx:pt idx="836">39.417762493576419</cx:pt>
          <cx:pt idx="837">48.941700011340025</cx:pt>
          <cx:pt idx="838">48.165859278123548</cx:pt>
          <cx:pt idx="839">35.837271101466413</cx:pt>
          <cx:pt idx="840">42.586030573416913</cx:pt>
          <cx:pt idx="841">32.807468661876371</cx:pt>
          <cx:pt idx="842">42.413441265711981</cx:pt>
          <cx:pt idx="843">38.5635838583501</cx:pt>
          <cx:pt idx="844">38.718212768669993</cx:pt>
          <cx:pt idx="845">31.51610699309164</cx:pt>
          <cx:pt idx="846">48.372202761503431</cx:pt>
          <cx:pt idx="847">42.077903940191696</cx:pt>
          <cx:pt idx="848">43.81803281755127</cx:pt>
          <cx:pt idx="849">38.658375547868019</cx:pt>
          <cx:pt idx="850">41.994404389156422</cx:pt>
          <cx:pt idx="851">35.832387584418655</cx:pt>
          <cx:pt idx="852">36.200414362269392</cx:pt>
          <cx:pt idx="853">41.261362071555517</cx:pt>
          <cx:pt idx="854">27.198823503967962</cx:pt>
          <cx:pt idx="855">44.347716964912635</cx:pt>
          <cx:pt idx="856">34.836905717930804</cx:pt>
          <cx:pt idx="857">41.21710809845834</cx:pt>
          <cx:pt idx="858">38.664841910966089</cx:pt>
          <cx:pt idx="859">31.33221983837085</cx:pt>
          <cx:pt idx="860">42.413441265711981</cx:pt>
          <cx:pt idx="861">39.903884522687768</cx:pt>
          <cx:pt idx="862">39.794346332111047</cx:pt>
          <cx:pt idx="863">35.131182729876883</cx:pt>
          <cx:pt idx="864">40.865511131025876</cx:pt>
          <cx:pt idx="865">15.426114222317947</cx:pt>
          <cx:pt idx="866">29.55790926300438</cx:pt>
          <cx:pt idx="867">37.795899248463449</cx:pt>
          <cx:pt idx="868">31.416826701625993</cx:pt>
          <cx:pt idx="869">34.202631477709431</cx:pt>
          <cx:pt idx="870">45.211281777892566</cx:pt>
          <cx:pt idx="871">42.035699113967404</cx:pt>
          <cx:pt idx="872">19.806892739650003</cx:pt>
          <cx:pt idx="873">38.085430285084087</cx:pt>
          <cx:pt idx="874">32.861527657733745</cx:pt>
          <cx:pt idx="875">33.226044001656291</cx:pt>
          <cx:pt idx="876">31.035785796399612</cx:pt>
          <cx:pt idx="877">47.192372265017575</cx:pt>
          <cx:pt idx="878">49.905009768559303</cx:pt>
          <cx:pt idx="879">37.211960442846873</cx:pt>
          <cx:pt idx="880">20.235661590370597</cx:pt>
          <cx:pt idx="881">56.162086855814039</cx:pt>
          <cx:pt idx="882">45.812443724385624</cx:pt>
          <cx:pt idx="883">46.367337641922035</cx:pt>
          <cx:pt idx="884">17.803763647049465</cx:pt>
          <cx:pt idx="885">44.17952014225596</cx:pt>
          <cx:pt idx="886">38.5871740349044</cx:pt>
          <cx:pt idx="887">47.942152642533685</cx:pt>
          <cx:pt idx="888">45.20630487000679</cx:pt>
          <cx:pt idx="889">54.516602975607356</cx:pt>
          <cx:pt idx="890">19.808987859050244</cx:pt>
          <cx:pt idx="891">36.944823724034734</cx:pt>
          <cx:pt idx="892">46.82307123630401</cx:pt>
          <cx:pt idx="893">42.413441265711981</cx:pt>
          <cx:pt idx="894">40.178974601151779</cx:pt>
          <cx:pt idx="895">36.537788657771834</cx:pt>
          <cx:pt idx="896">42.413441265711981</cx:pt>
          <cx:pt idx="897">21.652990555579155</cx:pt>
          <cx:pt idx="898">32.967256482758764</cx:pt>
          <cx:pt idx="899">37.89525036201767</cx:pt>
          <cx:pt idx="900">41.300363194528934</cx:pt>
          <cx:pt idx="901">43.389053919162606</cx:pt>
          <cx:pt idx="902">45.804039123203971</cx:pt>
          <cx:pt idx="903">34.891259650519928</cx:pt>
          <cx:pt idx="904">23.236716635531792</cx:pt>
          <cx:pt idx="905">37.34742293652937</cx:pt>
          <cx:pt idx="906">42.208411483968455</cx:pt>
          <cx:pt idx="907">41.169284667091318</cx:pt>
          <cx:pt idx="908">32.508921852316178</cx:pt>
          <cx:pt idx="909">37.718695629621131</cx:pt>
          <cx:pt idx="910">41.551052934913699</cx:pt>
          <cx:pt idx="911">37.232781255232602</cx:pt>
          <cx:pt idx="912">46.010324928215837</cx:pt>
          <cx:pt idx="913">37.641200831004319</cx:pt>
          <cx:pt idx="914">41.226083976046041</cx:pt>
          <cx:pt idx="915">35.911279565061449</cx:pt>
          <cx:pt idx="916">36.32519786594424</cx:pt>
          <cx:pt idx="917">47.548606709345329</cx:pt>
          <cx:pt idx="918">36.88170278064721</cx:pt>
          <cx:pt idx="919">47.255687488385988</cx:pt>
          <cx:pt idx="920">53.841712454192994</cx:pt>
          <cx:pt idx="921">48.759511892552823</cx:pt>
          <cx:pt idx="922">49.437030655167788</cx:pt>
          <cx:pt idx="923">44.840272077675891</cx:pt>
          <cx:pt idx="924">50.063959092345058</cx:pt>
          <cx:pt idx="925">41.658012434584542</cx:pt>
          <cx:pt idx="926">49.113847334534888</cx:pt>
          <cx:pt idx="927">43.491838314791892</cx:pt>
          <cx:pt idx="928">41.006828699620264</cx:pt>
          <cx:pt idx="929">41.461066074089317</cx:pt>
          <cx:pt idx="930">36.472318270162098</cx:pt>
          <cx:pt idx="931">56.344831173764284</cx:pt>
          <cx:pt idx="932">45.019884495631487</cx:pt>
          <cx:pt idx="933">26.554340511487005</cx:pt>
          <cx:pt idx="934">56.555813140648951</cx:pt>
          <cx:pt idx="935">32.119308834406759</cx:pt>
          <cx:pt idx="936">46.398168067284722</cx:pt>
          <cx:pt idx="937">31.594667271550748</cx:pt>
          <cx:pt idx="938">30.631976756324431</cx:pt>
          <cx:pt idx="939">35.754580126188031</cx:pt>
          <cx:pt idx="940">39.915410557828409</cx:pt>
          <cx:pt idx="941">44.238331794949048</cx:pt>
          <cx:pt idx="942">41.004633884477009</cx:pt>
          <cx:pt idx="943">25.132886821851564</cx:pt>
          <cx:pt idx="944">52.43338631063228</cx:pt>
          <cx:pt idx="945">34.0715423777674</cx:pt>
          <cx:pt idx="946">41.719659634277939</cx:pt>
          <cx:pt idx="947">42.51564417952526</cx:pt>
          <cx:pt idx="948">41.293704120604147</cx:pt>
          <cx:pt idx="949">56.635854368059114</cx:pt>
          <cx:pt idx="950">46.942944091737573</cx:pt>
          <cx:pt idx="951">34.157136882355928</cx:pt>
          <cx:pt idx="952">36.023464575190431</cx:pt>
          <cx:pt idx="953">49.41244782440959</cx:pt>
          <cx:pt idx="954">51.36613670503165</cx:pt>
          <cx:pt idx="955">30.80740170803114</cx:pt>
          <cx:pt idx="956">48.605863843779176</cx:pt>
          <cx:pt idx="957">37.574326341266584</cx:pt>
          <cx:pt idx="958">47.969990619136041</cx:pt>
          <cx:pt idx="959">48.790572859928588</cx:pt>
          <cx:pt idx="960">42.949854481709252</cx:pt>
          <cx:pt idx="961">50.200398404793567</cx:pt>
          <cx:pt idx="962">38.228131003228498</cx:pt>
          <cx:pt idx="963">30.99783863433062</cx:pt>
          <cx:pt idx="964">39.564883419517365</cx:pt>
          <cx:pt idx="965">42.413441265711981</cx:pt>
          <cx:pt idx="966">43.131311132401251</cx:pt>
          <cx:pt idx="967">55.587678490831038</cx:pt>
          <cx:pt idx="968">35.130328777283026</cx:pt>
          <cx:pt idx="969">42.403419673417844</cx:pt>
          <cx:pt idx="970">40.959614255996115</cx:pt>
          <cx:pt idx="971">45.871886815346933</cx:pt>
          <cx:pt idx="972">37.010674135984068</cx:pt>
          <cx:pt idx="973">46.941772442037163</cx:pt>
          <cx:pt idx="974">31.036591307680677</cx:pt>
          <cx:pt idx="975">38.083460977174852</cx:pt>
          <cx:pt idx="976">53.370216413276793</cx:pt>
          <cx:pt idx="977">49.242867503832471</cx:pt>
          <cx:pt idx="978">40.548859416757956</cx:pt>
          <cx:pt idx="979">41.561761271630445</cx:pt>
          <cx:pt idx="980">42.413441265711981</cx:pt>
          <cx:pt idx="981">46.240782865345174</cx:pt>
          <cx:pt idx="982">39.169886392482681</cx:pt>
          <cx:pt idx="983">40.250093167594038</cx:pt>
          <cx:pt idx="984">52.559490104071592</cx:pt>
          <cx:pt idx="985">50.386704595557738</cx:pt>
          <cx:pt idx="986">25.563372234507721</cx:pt>
          <cx:pt idx="987">27.078995550056874</cx:pt>
          <cx:pt idx="988">41.01158372947819</cx:pt>
          <cx:pt idx="989">44.375669009041431</cx:pt>
          <cx:pt idx="990">43.715329119200277</cx:pt>
          <cx:pt idx="991">40.396905822104742</cx:pt>
          <cx:pt idx="992">41.844593438101413</cx:pt>
          <cx:pt idx="993">42.413441265711981</cx:pt>
          <cx:pt idx="994">43.24187785006567</cx:pt>
          <cx:pt idx="995">38.234147041617135</cx:pt>
          <cx:pt idx="996">27.119752948727243</cx:pt>
          <cx:pt idx="997">41.160660830458006</cx:pt>
          <cx:pt idx="998">31.365442767478989</cx:pt>
          <cx:pt idx="999">44.346702244924593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sz="14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l-GR" altLang="ja-JP" sz="1200" b="0" i="0" u="none" strike="noStrike" baseline="0" dirty="0">
                <a:solidFill>
                  <a:schemeClr val="tx1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ω</a:t>
            </a:r>
            <a:r>
              <a:rPr lang="en-US" altLang="ja-JP" sz="1200" b="0" i="0" u="none" strike="noStrike" baseline="0" dirty="0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V</a:t>
            </a:r>
            <a:r>
              <a:rPr lang="en-US" altLang="ja-JP" sz="1400" b="0" i="0" u="none" strike="noStrike" baseline="0" dirty="0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endParaRPr lang="ja-JP" altLang="en-US" sz="1400" b="0" i="0" u="none" strike="noStrike" baseline="0" dirty="0">
              <a:solidFill>
                <a:sysClr val="windowText" lastClr="000000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cx:rich>
      </cx:tx>
    </cx:title>
    <cx:plotArea>
      <cx:plotAreaRegion>
        <cx:series layoutId="clusteredColumn" uniqueId="{3BEFE4FD-A25F-4A44-B21F-E3751BC3EE86}">
          <cx:tx>
            <cx:txData>
              <cx:f>PK!$S$1</cx:f>
              <cx:v>omega nV %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/>
          </cx:layoutPr>
        </cx:series>
      </cx:plotAreaRegion>
      <cx:axis id="0">
        <cx:catScaling gapWidth="0"/>
        <cx:tickLabels/>
        <cx:numFmt formatCode="#,##0.0_);[赤](#,##0.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hartEx9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PK!$W$2:$W$1001</cx:f>
        <cx:lvl ptCount="1000" formatCode="G/標準">
          <cx:pt idx="0">24.174300000000002</cx:pt>
          <cx:pt idx="1">20.018799999999999</cx:pt>
          <cx:pt idx="2">13.900000000000002</cx:pt>
          <cx:pt idx="3">22.415599999999998</cx:pt>
          <cx:pt idx="4">23.396699999999999</cx:pt>
          <cx:pt idx="5">14.077999999999999</cx:pt>
          <cx:pt idx="6">20.452300000000001</cx:pt>
          <cx:pt idx="7">27.0184</cx:pt>
          <cx:pt idx="8">24.308800000000002</cx:pt>
          <cx:pt idx="9">11.6585</cx:pt>
          <cx:pt idx="10">27.893099999999997</cx:pt>
          <cx:pt idx="11">18.889900000000001</cx:pt>
          <cx:pt idx="12">15.586</cx:pt>
          <cx:pt idx="13">12.647500000000001</cx:pt>
          <cx:pt idx="14">28.354000000000003</cx:pt>
          <cx:pt idx="15">22.153600000000001</cx:pt>
          <cx:pt idx="16">17.989000000000001</cx:pt>
          <cx:pt idx="17">20.224700000000002</cx:pt>
          <cx:pt idx="18">9.1429799999999997e-05</cx:pt>
          <cx:pt idx="19">22.604600000000001</cx:pt>
          <cx:pt idx="20">3.0624100000000003</cx:pt>
          <cx:pt idx="21">9.8354400000000002</cx:pt>
          <cx:pt idx="22">22.740400000000001</cx:pt>
          <cx:pt idx="23">12.791499999999999</cx:pt>
          <cx:pt idx="24">14.347899999999999</cx:pt>
          <cx:pt idx="25">16.647400000000001</cx:pt>
          <cx:pt idx="26">17.989000000000001</cx:pt>
          <cx:pt idx="27">20.5245</cx:pt>
          <cx:pt idx="28">15.968399999999999</cx:pt>
          <cx:pt idx="29">15.5067</cx:pt>
          <cx:pt idx="30">21.265899999999998</cx:pt>
          <cx:pt idx="31">18.6403</cx:pt>
          <cx:pt idx="32">12.711900000000002</cx:pt>
          <cx:pt idx="33">6.819939999999999</cx:pt>
          <cx:pt idx="34">17.989000000000001</cx:pt>
          <cx:pt idx="35">17.989000000000001</cx:pt>
          <cx:pt idx="36">15.0044</cx:pt>
          <cx:pt idx="37">9.5470500000000005</cx:pt>
          <cx:pt idx="38">3.4126799999999999</cx:pt>
          <cx:pt idx="39">14.393800000000001</cx:pt>
          <cx:pt idx="40">16.921299999999999</cx:pt>
          <cx:pt idx="41">15.140300000000002</cx:pt>
          <cx:pt idx="42">20.532800000000002</cx:pt>
          <cx:pt idx="43">16.520000000000003</cx:pt>
          <cx:pt idx="44">14.046600000000002</cx:pt>
          <cx:pt idx="45">13.5853</cx:pt>
          <cx:pt idx="46">18.1296</cx:pt>
          <cx:pt idx="47">19.3217</cx:pt>
          <cx:pt idx="48">23.5732</cx:pt>
          <cx:pt idx="49">24.462600000000002</cx:pt>
          <cx:pt idx="50">14.985599999999998</cx:pt>
          <cx:pt idx="51">22.945699999999999</cx:pt>
          <cx:pt idx="52">11.9085</cx:pt>
          <cx:pt idx="53">12.9552</cx:pt>
          <cx:pt idx="54">14.3786</cx:pt>
          <cx:pt idx="55">11.0907</cx:pt>
          <cx:pt idx="56">19.956699999999998</cx:pt>
          <cx:pt idx="57">13.967699999999999</cx:pt>
          <cx:pt idx="58">14.924299999999999</cx:pt>
          <cx:pt idx="59">9.0292999999999992</cx:pt>
          <cx:pt idx="60">18.793900000000001</cx:pt>
          <cx:pt idx="61">18.450299999999999</cx:pt>
          <cx:pt idx="62">13.099600000000001</cx:pt>
          <cx:pt idx="63">17.6707</cx:pt>
          <cx:pt idx="64">22.461300000000001</cx:pt>
          <cx:pt idx="65">17.3325</cx:pt>
          <cx:pt idx="66">20.022000000000002</cx:pt>
          <cx:pt idx="67">16.0825</cx:pt>
          <cx:pt idx="68">22.9208</cx:pt>
          <cx:pt idx="69">12.937499999999998</cx:pt>
          <cx:pt idx="70">11.3903</cx:pt>
          <cx:pt idx="71">5.7730600000000001</cx:pt>
          <cx:pt idx="72">20.8093</cx:pt>
          <cx:pt idx="73">18.496700000000001</cx:pt>
          <cx:pt idx="74">15.1396</cx:pt>
          <cx:pt idx="75">14.581</cx:pt>
          <cx:pt idx="76">12.167200000000001</cx:pt>
          <cx:pt idx="77">19.935500000000001</cx:pt>
          <cx:pt idx="78">16.8703</cx:pt>
          <cx:pt idx="79">19.7239</cx:pt>
          <cx:pt idx="80">16.897100000000002</cx:pt>
          <cx:pt idx="81">11.654200000000001</cx:pt>
          <cx:pt idx="82">17.989000000000001</cx:pt>
          <cx:pt idx="83">5.9664999999999999</cx:pt>
          <cx:pt idx="84">21.103300000000001</cx:pt>
          <cx:pt idx="85">23.856200000000001</cx:pt>
          <cx:pt idx="86">22.484100000000002</cx:pt>
          <cx:pt idx="87">13.5944</cx:pt>
          <cx:pt idx="88">19.099599999999999</cx:pt>
          <cx:pt idx="89">15.1776</cx:pt>
          <cx:pt idx="90">13.744400000000001</cx:pt>
          <cx:pt idx="91">17.3811</cx:pt>
          <cx:pt idx="92">15.035200000000001</cx:pt>
          <cx:pt idx="93">13.047000000000001</cx:pt>
          <cx:pt idx="94">11.140799999999999</cx:pt>
          <cx:pt idx="95">7.5310199999999998</cx:pt>
          <cx:pt idx="96">17.118300000000001</cx:pt>
          <cx:pt idx="97">24.464400000000001</cx:pt>
          <cx:pt idx="98">18.1236</cx:pt>
          <cx:pt idx="99">17.989000000000001</cx:pt>
          <cx:pt idx="100">12.554000000000002</cx:pt>
          <cx:pt idx="101">17.989000000000001</cx:pt>
          <cx:pt idx="102">17.989000000000001</cx:pt>
          <cx:pt idx="103">18.352499999999999</cx:pt>
          <cx:pt idx="104">17.085000000000001</cx:pt>
          <cx:pt idx="105">24.419799999999999</cx:pt>
          <cx:pt idx="106">24.2226</cx:pt>
          <cx:pt idx="107">22.4314</cx:pt>
          <cx:pt idx="108">12.918699999999999</cx:pt>
          <cx:pt idx="109">16.710900000000002</cx:pt>
          <cx:pt idx="110">18.079600000000003</cx:pt>
          <cx:pt idx="111">18.894400000000001</cx:pt>
          <cx:pt idx="112">23.197300000000002</cx:pt>
          <cx:pt idx="113">3.40863</cx:pt>
          <cx:pt idx="114">8.3413500000000003</cx:pt>
          <cx:pt idx="115">24.688199999999998</cx:pt>
          <cx:pt idx="116">19.237500000000001</cx:pt>
          <cx:pt idx="117">18.988499999999998</cx:pt>
          <cx:pt idx="118">17.989000000000001</cx:pt>
          <cx:pt idx="119">11.2752</cx:pt>
          <cx:pt idx="120">7.4101799999999995</cx:pt>
          <cx:pt idx="121">10.475900000000001</cx:pt>
          <cx:pt idx="122">9.7220800000000001</cx:pt>
          <cx:pt idx="123">4.9178499999999996</cx:pt>
          <cx:pt idx="124">15.701899999999998</cx:pt>
          <cx:pt idx="125">15.149199999999999</cx:pt>
          <cx:pt idx="126">16.994300000000003</cx:pt>
          <cx:pt idx="127">19.695899999999998</cx:pt>
          <cx:pt idx="128">14.982999999999999</cx:pt>
          <cx:pt idx="129">12.2172</cx:pt>
          <cx:pt idx="130">17.413600000000002</cx:pt>
          <cx:pt idx="131">15.556000000000001</cx:pt>
          <cx:pt idx="132">20.183</cx:pt>
          <cx:pt idx="133">17.365200000000002</cx:pt>
          <cx:pt idx="134">5.0408599999999995</cx:pt>
          <cx:pt idx="135">19.625999999999998</cx:pt>
          <cx:pt idx="136">17.989000000000001</cx:pt>
          <cx:pt idx="137">11.620200000000001</cx:pt>
          <cx:pt idx="138">17.745200000000001</cx:pt>
          <cx:pt idx="139">20.215299999999999</cx:pt>
          <cx:pt idx="140">22.981099999999998</cx:pt>
          <cx:pt idx="141">28.555299999999999</cx:pt>
          <cx:pt idx="142">13.994100000000001</cx:pt>
          <cx:pt idx="143">21.965499999999999</cx:pt>
          <cx:pt idx="144">13.6814</cx:pt>
          <cx:pt idx="145">17.989000000000001</cx:pt>
          <cx:pt idx="146">22.061</cx:pt>
          <cx:pt idx="147">23.3843</cx:pt>
          <cx:pt idx="148">24.936900000000001</cx:pt>
          <cx:pt idx="149">20.3734</cx:pt>
          <cx:pt idx="150">20.624000000000002</cx:pt>
          <cx:pt idx="151">25.753399999999999</cx:pt>
          <cx:pt idx="152">24.438099999999999</cx:pt>
          <cx:pt idx="153">15.4968</cx:pt>
          <cx:pt idx="154">21.741499999999998</cx:pt>
          <cx:pt idx="155">13.418099999999999</cx:pt>
          <cx:pt idx="156">19.851500000000001</cx:pt>
          <cx:pt idx="157">10.9701</cx:pt>
          <cx:pt idx="158">5.5783199999999997</cx:pt>
          <cx:pt idx="159">17.233000000000001</cx:pt>
          <cx:pt idx="160">23.089700000000001</cx:pt>
          <cx:pt idx="161">21.447500000000002</cx:pt>
          <cx:pt idx="162">22.9177</cx:pt>
          <cx:pt idx="163">22.031700000000001</cx:pt>
          <cx:pt idx="164">5.8161200000000006</cx:pt>
          <cx:pt idx="165">7.7674300000000001</cx:pt>
          <cx:pt idx="166">19.744700000000002</cx:pt>
          <cx:pt idx="167">10.2554</cx:pt>
          <cx:pt idx="168">13.679399999999999</cx:pt>
          <cx:pt idx="169">26.400700000000001</cx:pt>
          <cx:pt idx="170">15.6715</cx:pt>
          <cx:pt idx="171">20.351600000000001</cx:pt>
          <cx:pt idx="172">19.419900000000002</cx:pt>
          <cx:pt idx="173">19.328799999999998</cx:pt>
          <cx:pt idx="174">16.273099999999999</cx:pt>
          <cx:pt idx="175">26.046200000000002</cx:pt>
          <cx:pt idx="176">18.8613</cx:pt>
          <cx:pt idx="177">14.0154</cx:pt>
          <cx:pt idx="178">13.854099999999999</cx:pt>
          <cx:pt idx="179">8.0763199999999991</cx:pt>
          <cx:pt idx="180">16.110299999999999</cx:pt>
          <cx:pt idx="181">17.9663</cx:pt>
          <cx:pt idx="182">2.6595599999999999</cx:pt>
          <cx:pt idx="183">21.012700000000002</cx:pt>
          <cx:pt idx="184">12.041699999999999</cx:pt>
          <cx:pt idx="185">21.942600000000002</cx:pt>
          <cx:pt idx="186">6.5835400000000002</cx:pt>
          <cx:pt idx="187">14.4739</cx:pt>
          <cx:pt idx="188">16.025100000000002</cx:pt>
          <cx:pt idx="189">9.1638999999999999</cx:pt>
          <cx:pt idx="190">17.989000000000001</cx:pt>
          <cx:pt idx="191">3.6179099999999997</cx:pt>
          <cx:pt idx="192">21.480799999999999</cx:pt>
          <cx:pt idx="193">12.159000000000001</cx:pt>
          <cx:pt idx="194">23.044499999999999</cx:pt>
          <cx:pt idx="195">19.3276</cx:pt>
          <cx:pt idx="196">14.377699999999999</cx:pt>
          <cx:pt idx="197">15.199299999999999</cx:pt>
          <cx:pt idx="198">18.751200000000001</cx:pt>
          <cx:pt idx="199">18.1082</cx:pt>
          <cx:pt idx="200">17.793800000000001</cx:pt>
          <cx:pt idx="201">12.3423</cx:pt>
          <cx:pt idx="202">13.077299999999999</cx:pt>
          <cx:pt idx="203">14.8475</cx:pt>
          <cx:pt idx="204">8.7621699999999993</cx:pt>
          <cx:pt idx="205">15.8643</cx:pt>
          <cx:pt idx="206">9.5276899999999998</cx:pt>
          <cx:pt idx="207">13.2653</cx:pt>
          <cx:pt idx="208">12.722900000000001</cx:pt>
          <cx:pt idx="209">14.666</cx:pt>
          <cx:pt idx="210">11.314499999999999</cx:pt>
          <cx:pt idx="211">15.478400000000001</cx:pt>
          <cx:pt idx="212">22.0166</cx:pt>
          <cx:pt idx="213">10.4757</cx:pt>
          <cx:pt idx="214">20.167099999999998</cx:pt>
          <cx:pt idx="215">16.657800000000002</cx:pt>
          <cx:pt idx="216">16.1647</cx:pt>
          <cx:pt idx="217">16.723199999999999</cx:pt>
          <cx:pt idx="218">15.051500000000001</cx:pt>
          <cx:pt idx="219">19.137</cx:pt>
          <cx:pt idx="220">22.711100000000002</cx:pt>
          <cx:pt idx="221">27.0352</cx:pt>
          <cx:pt idx="222">21.3581</cx:pt>
          <cx:pt idx="223">2.2217500000000001</cx:pt>
          <cx:pt idx="224">12.482200000000001</cx:pt>
          <cx:pt idx="225">18.311499999999999</cx:pt>
          <cx:pt idx="226">12.234200000000001</cx:pt>
          <cx:pt idx="227">22.502099999999999</cx:pt>
          <cx:pt idx="228">17.989000000000001</cx:pt>
          <cx:pt idx="229">22.526900000000001</cx:pt>
          <cx:pt idx="230">9.158710000000001</cx:pt>
          <cx:pt idx="231">24.088899999999999</cx:pt>
          <cx:pt idx="232">7.5333200000000007</cx:pt>
          <cx:pt idx="233">17.469299999999997</cx:pt>
          <cx:pt idx="234">13.2546</cx:pt>
          <cx:pt idx="235">12.389999999999999</cx:pt>
          <cx:pt idx="236">14.498700000000001</cx:pt>
          <cx:pt idx="237">22.346699999999998</cx:pt>
          <cx:pt idx="238">16.127800000000001</cx:pt>
          <cx:pt idx="239">25.134399999999999</cx:pt>
          <cx:pt idx="240">18.8432</cx:pt>
          <cx:pt idx="241">31.340699999999998</cx:pt>
          <cx:pt idx="242">23.958600000000001</cx:pt>
          <cx:pt idx="243">10.819700000000001</cx:pt>
          <cx:pt idx="244">16.4985</cx:pt>
          <cx:pt idx="245">11.600899999999999</cx:pt>
          <cx:pt idx="246">15.1471</cx:pt>
          <cx:pt idx="247">17.989000000000001</cx:pt>
          <cx:pt idx="248">9.9487799999999993</cx:pt>
          <cx:pt idx="249">12.4278</cx:pt>
          <cx:pt idx="250">16.303899999999999</cx:pt>
          <cx:pt idx="251">16.730399999999999</cx:pt>
          <cx:pt idx="252">15.7439</cx:pt>
          <cx:pt idx="253">23.192899999999998</cx:pt>
          <cx:pt idx="254">12.633600000000001</cx:pt>
          <cx:pt idx="255">18.221300000000003</cx:pt>
          <cx:pt idx="256">0.88167499999999999</cx:pt>
          <cx:pt idx="257">14.3383</cx:pt>
          <cx:pt idx="258">12.611600000000001</cx:pt>
          <cx:pt idx="259">14.5374</cx:pt>
          <cx:pt idx="260">20.722300000000001</cx:pt>
          <cx:pt idx="261">10.1297</cx:pt>
          <cx:pt idx="262">3.4151000000000002</cx:pt>
          <cx:pt idx="263">19.9665</cx:pt>
          <cx:pt idx="264">21.916</cx:pt>
          <cx:pt idx="265">24.557599999999997</cx:pt>
          <cx:pt idx="266">13.4064</cx:pt>
          <cx:pt idx="267">21.035799999999998</cx:pt>
          <cx:pt idx="268">28.668399999999998</cx:pt>
          <cx:pt idx="269">17.989000000000001</cx:pt>
          <cx:pt idx="270">18.891500000000001</cx:pt>
          <cx:pt idx="271">17.717400000000001</cx:pt>
          <cx:pt idx="272">12.560699999999999</cx:pt>
          <cx:pt idx="273">14.621700000000001</cx:pt>
          <cx:pt idx="274">21.7317</cx:pt>
          <cx:pt idx="275">16.412299999999998</cx:pt>
          <cx:pt idx="276">21.909200000000002</cx:pt>
          <cx:pt idx="277">20.205300000000001</cx:pt>
          <cx:pt idx="278">9.5970499999999994</cx:pt>
          <cx:pt idx="279">16.673299999999998</cx:pt>
          <cx:pt idx="280">19.443899999999999</cx:pt>
          <cx:pt idx="281">26.145699999999998</cx:pt>
          <cx:pt idx="282">24.137800000000002</cx:pt>
          <cx:pt idx="283">5.4766599999999999</cx:pt>
          <cx:pt idx="284">21.0473</cx:pt>
          <cx:pt idx="285">17.989000000000001</cx:pt>
          <cx:pt idx="286">15.395800000000001</cx:pt>
          <cx:pt idx="287">13.750299999999999</cx:pt>
          <cx:pt idx="288">21.3263</cx:pt>
          <cx:pt idx="289">13.938900000000002</cx:pt>
          <cx:pt idx="290">21.046799999999998</cx:pt>
          <cx:pt idx="291">17.989000000000001</cx:pt>
          <cx:pt idx="292">9.3971599999999995</cx:pt>
          <cx:pt idx="293">21.109200000000001</cx:pt>
          <cx:pt idx="294">6.6854700000000005</cx:pt>
          <cx:pt idx="295">8.4770900000000005</cx:pt>
          <cx:pt idx="296">18.687200000000001</cx:pt>
          <cx:pt idx="297">17.0215</cx:pt>
          <cx:pt idx="298">16.716699999999999</cx:pt>
          <cx:pt idx="299">16.626899999999999</cx:pt>
          <cx:pt idx="300">13.161100000000001</cx:pt>
          <cx:pt idx="301">12.415900000000001</cx:pt>
          <cx:pt idx="302">10.623900000000001</cx:pt>
          <cx:pt idx="303">29.912100000000002</cx:pt>
          <cx:pt idx="304">17.989000000000001</cx:pt>
          <cx:pt idx="305">21.821999999999999</cx:pt>
          <cx:pt idx="306">19.847300000000001</cx:pt>
          <cx:pt idx="307">17.708500000000001</cx:pt>
          <cx:pt idx="308">19.789200000000001</cx:pt>
          <cx:pt idx="309">17.989000000000001</cx:pt>
          <cx:pt idx="310">25.038899999999998</cx:pt>
          <cx:pt idx="311">19.7806</cx:pt>
          <cx:pt idx="312">9.7648499999999991</cx:pt>
          <cx:pt idx="313">16.694400000000002</cx:pt>
          <cx:pt idx="314">15.127199999999998</cx:pt>
          <cx:pt idx="315">13.2727</cx:pt>
          <cx:pt idx="316">19.376199999999997</cx:pt>
          <cx:pt idx="317">14.350099999999999</cx:pt>
          <cx:pt idx="318">14.5398</cx:pt>
          <cx:pt idx="319">17.104600000000001</cx:pt>
          <cx:pt idx="320">22.218399999999999</cx:pt>
          <cx:pt idx="321">26.000699999999998</cx:pt>
          <cx:pt idx="322">13.8955</cx:pt>
          <cx:pt idx="323">19.316400000000002</cx:pt>
          <cx:pt idx="324">17.626000000000001</cx:pt>
          <cx:pt idx="325">20.3443</cx:pt>
          <cx:pt idx="326">13.7814</cx:pt>
          <cx:pt idx="327">14.525499999999999</cx:pt>
          <cx:pt idx="328">16.029599999999999</cx:pt>
          <cx:pt idx="329">17.418400000000002</cx:pt>
          <cx:pt idx="330">12.5588</cx:pt>
          <cx:pt idx="331">20.0837</cx:pt>
          <cx:pt idx="332">21.038999999999998</cx:pt>
          <cx:pt idx="333">13.2224</cx:pt>
          <cx:pt idx="334">16.054600000000001</cx:pt>
          <cx:pt idx="335">9.0731199999999994</cx:pt>
          <cx:pt idx="336">14.659700000000001</cx:pt>
          <cx:pt idx="337">23.379000000000001</cx:pt>
          <cx:pt idx="338">11.5337</cx:pt>
          <cx:pt idx="339">17.5425</cx:pt>
          <cx:pt idx="340">24.398199999999999</cx:pt>
          <cx:pt idx="341">19.983899999999998</cx:pt>
          <cx:pt idx="342">4.5571100000000007</cx:pt>
          <cx:pt idx="343">9.1721699999999995</cx:pt>
          <cx:pt idx="344">17.554100000000002</cx:pt>
          <cx:pt idx="345">19.708300000000001</cx:pt>
          <cx:pt idx="346">21.9679</cx:pt>
          <cx:pt idx="347">20.7439</cx:pt>
          <cx:pt idx="348">12.631500000000001</cx:pt>
          <cx:pt idx="349">21.440100000000001</cx:pt>
          <cx:pt idx="350">19.6342</cx:pt>
          <cx:pt idx="351">23.218800000000002</cx:pt>
          <cx:pt idx="352">20.0916</cx:pt>
          <cx:pt idx="353">10.925000000000001</cx:pt>
          <cx:pt idx="354">14.413799999999998</cx:pt>
          <cx:pt idx="355">13.666</cx:pt>
          <cx:pt idx="356">6.2070599999999994</cx:pt>
          <cx:pt idx="357">22.220100000000002</cx:pt>
          <cx:pt idx="358">12.5939</cx:pt>
          <cx:pt idx="359">14.5503</cx:pt>
          <cx:pt idx="360">26.731899999999996</cx:pt>
          <cx:pt idx="361">19.5106</cx:pt>
          <cx:pt idx="362">10.693900000000001</cx:pt>
          <cx:pt idx="363">17.989000000000001</cx:pt>
          <cx:pt idx="364">18.770400000000002</cx:pt>
          <cx:pt idx="365">16.999300000000002</cx:pt>
          <cx:pt idx="366">33.759399999999999</cx:pt>
          <cx:pt idx="367">16.639699999999998</cx:pt>
          <cx:pt idx="368">14.055100000000001</cx:pt>
          <cx:pt idx="369">17.989000000000001</cx:pt>
          <cx:pt idx="370">13.800699999999999</cx:pt>
          <cx:pt idx="371">18.319700000000001</cx:pt>
          <cx:pt idx="372">17.650500000000001</cx:pt>
          <cx:pt idx="373">17.890800000000002</cx:pt>
          <cx:pt idx="374">3.2374700000000001</cx:pt>
          <cx:pt idx="375">15.460599999999999</cx:pt>
          <cx:pt idx="376">17.989000000000001</cx:pt>
          <cx:pt idx="377">12.9312</cx:pt>
          <cx:pt idx="378">9.5266099999999998</cx:pt>
          <cx:pt idx="379">17.989000000000001</cx:pt>
          <cx:pt idx="380">26.598399999999998</cx:pt>
          <cx:pt idx="381">18.674700000000001</cx:pt>
          <cx:pt idx="382">22.8293</cx:pt>
          <cx:pt idx="383">19.3019</cx:pt>
          <cx:pt idx="384">18.951599999999999</cx:pt>
          <cx:pt idx="385">22.8627</cx:pt>
          <cx:pt idx="386">16.1233</cx:pt>
          <cx:pt idx="387">13.057099999999998</cx:pt>
          <cx:pt idx="388">15.240899999999998</cx:pt>
          <cx:pt idx="389">18.4239</cx:pt>
          <cx:pt idx="390">13.703399999999998</cx:pt>
          <cx:pt idx="391">29.9892</cx:pt>
          <cx:pt idx="392">8.524890000000001</cx:pt>
          <cx:pt idx="393">19.289899999999999</cx:pt>
          <cx:pt idx="394">17.989000000000001</cx:pt>
          <cx:pt idx="395">17.305499999999999</cx:pt>
          <cx:pt idx="396">17.872399999999999</cx:pt>
          <cx:pt idx="397">27.341500000000003</cx:pt>
          <cx:pt idx="398">8.0470000000000006</cx:pt>
          <cx:pt idx="399">33.520400000000002</cx:pt>
          <cx:pt idx="400">18.8733</cx:pt>
          <cx:pt idx="401">17.989000000000001</cx:pt>
          <cx:pt idx="402">16.279900000000001</cx:pt>
          <cx:pt idx="403">21.852900000000002</cx:pt>
          <cx:pt idx="404">16.532900000000001</cx:pt>
          <cx:pt idx="405">21.184900000000003</cx:pt>
          <cx:pt idx="406">12.7728</cx:pt>
          <cx:pt idx="407">15.696199999999999</cx:pt>
          <cx:pt idx="408">20.2424</cx:pt>
          <cx:pt idx="409">9.4135600000000004</cx:pt>
          <cx:pt idx="410">27.110699999999998</cx:pt>
          <cx:pt idx="411">16.596700000000002</cx:pt>
          <cx:pt idx="412">10.334999999999999</cx:pt>
          <cx:pt idx="413">21.437999999999999</cx:pt>
          <cx:pt idx="414">13.950499999999998</cx:pt>
          <cx:pt idx="415">21.799599999999998</cx:pt>
          <cx:pt idx="416">19.7498</cx:pt>
          <cx:pt idx="417">10.3438</cx:pt>
          <cx:pt idx="418">11.537799999999999</cx:pt>
          <cx:pt idx="419">11.06</cx:pt>
          <cx:pt idx="420">20.122399999999999</cx:pt>
          <cx:pt idx="421">21.895800000000001</cx:pt>
          <cx:pt idx="422">24.413599999999999</cx:pt>
          <cx:pt idx="423">16.515499999999999</cx:pt>
          <cx:pt idx="424">9.673919999999999</cx:pt>
          <cx:pt idx="425">10.127700000000001</cx:pt>
          <cx:pt idx="426">15.357699999999999</cx:pt>
          <cx:pt idx="427">23.666</cx:pt>
          <cx:pt idx="428">19.879999999999999</cx:pt>
          <cx:pt idx="429">18.159600000000001</cx:pt>
          <cx:pt idx="430">19.132899999999999</cx:pt>
          <cx:pt idx="431">9.1558299999999999</cx:pt>
          <cx:pt idx="432">21.284700000000001</cx:pt>
          <cx:pt idx="433">13.017500000000002</cx:pt>
          <cx:pt idx="434">19.703699999999998</cx:pt>
          <cx:pt idx="435">22.0428</cx:pt>
          <cx:pt idx="436">13.352500000000001</cx:pt>
          <cx:pt idx="437">15.143599999999999</cx:pt>
          <cx:pt idx="438">21.7148</cx:pt>
          <cx:pt idx="439">16.222799999999999</cx:pt>
          <cx:pt idx="440">8.8410899999999994</cx:pt>
          <cx:pt idx="441">15.276</cx:pt>
          <cx:pt idx="442">15.972800000000001</cx:pt>
          <cx:pt idx="443">17.989000000000001</cx:pt>
          <cx:pt idx="444">15.518899999999999</cx:pt>
          <cx:pt idx="445">9.1492299999999993</cx:pt>
          <cx:pt idx="446">20.639599999999998</cx:pt>
          <cx:pt idx="447">24.802199999999999</cx:pt>
          <cx:pt idx="448">17.302699999999998</cx:pt>
          <cx:pt idx="449">19.2196</cx:pt>
          <cx:pt idx="450">14.946200000000001</cx:pt>
          <cx:pt idx="451">19.9773</cx:pt>
          <cx:pt idx="452">9.9871999999999996</cx:pt>
          <cx:pt idx="453">8.0994200000000003</cx:pt>
          <cx:pt idx="454">12.9421</cx:pt>
          <cx:pt idx="455">9.6409099999999999</cx:pt>
          <cx:pt idx="456">23.463200000000001</cx:pt>
          <cx:pt idx="457">26.6648</cx:pt>
          <cx:pt idx="458">3.9606400000000002</cx:pt>
          <cx:pt idx="459">23.567499999999999</cx:pt>
          <cx:pt idx="460">21.1541</cx:pt>
          <cx:pt idx="461">11.355500000000001</cx:pt>
          <cx:pt idx="462">7.0953299999999997</cx:pt>
          <cx:pt idx="463">20.7043</cx:pt>
          <cx:pt idx="464">20.319400000000002</cx:pt>
          <cx:pt idx="465">22.323499999999999</cx:pt>
          <cx:pt idx="466">20.656299999999998</cx:pt>
          <cx:pt idx="467">18.320399999999999</cx:pt>
          <cx:pt idx="468">13.767399999999999</cx:pt>
          <cx:pt idx="469">10.5784</cx:pt>
          <cx:pt idx="470">21.5182</cx:pt>
          <cx:pt idx="471">23.306699999999999</cx:pt>
          <cx:pt idx="472">15.308199999999999</cx:pt>
          <cx:pt idx="473">7.5867399999999998</cx:pt>
          <cx:pt idx="474">21.590300000000003</cx:pt>
          <cx:pt idx="475">18.199100000000001</cx:pt>
          <cx:pt idx="476">8.3527500000000003</cx:pt>
          <cx:pt idx="477">11.2339</cx:pt>
          <cx:pt idx="478">15.637200000000002</cx:pt>
          <cx:pt idx="479">15.2209</cx:pt>
          <cx:pt idx="480">15.988</cx:pt>
          <cx:pt idx="481">18.276299999999999</cx:pt>
          <cx:pt idx="482">15.797700000000001</cx:pt>
          <cx:pt idx="483">24.258800000000001</cx:pt>
          <cx:pt idx="484">17.989000000000001</cx:pt>
          <cx:pt idx="485">12.340900000000001</cx:pt>
          <cx:pt idx="486">17.8079</cx:pt>
          <cx:pt idx="487">16.9754</cx:pt>
          <cx:pt idx="488">10.2813</cx:pt>
          <cx:pt idx="489">12.420399999999999</cx:pt>
          <cx:pt idx="490">17.989000000000001</cx:pt>
          <cx:pt idx="491">11.4634</cx:pt>
          <cx:pt idx="492">22.150600000000001</cx:pt>
          <cx:pt idx="493">26.1874</cx:pt>
          <cx:pt idx="494">15.340999999999999</cx:pt>
          <cx:pt idx="495">25.1374</cx:pt>
          <cx:pt idx="496">20.985400000000002</cx:pt>
          <cx:pt idx="497">14.053099999999999</cx:pt>
          <cx:pt idx="498">11.437999999999999</cx:pt>
          <cx:pt idx="499">14.7485</cx:pt>
          <cx:pt idx="500">22.520299999999999</cx:pt>
          <cx:pt idx="501">15.335699999999999</cx:pt>
          <cx:pt idx="502">17.1997</cx:pt>
          <cx:pt idx="503">25.0029</cx:pt>
          <cx:pt idx="504">21.697400000000002</cx:pt>
          <cx:pt idx="505">16.750300000000003</cx:pt>
          <cx:pt idx="506">10.700099999999999</cx:pt>
          <cx:pt idx="507">14.601700000000001</cx:pt>
          <cx:pt idx="508">17.989000000000001</cx:pt>
          <cx:pt idx="509">17.544</cx:pt>
          <cx:pt idx="510">17.989000000000001</cx:pt>
          <cx:pt idx="511">20.088200000000001</cx:pt>
          <cx:pt idx="512">15.8804</cx:pt>
          <cx:pt idx="513">18.191800000000001</cx:pt>
          <cx:pt idx="514">12.17</cx:pt>
          <cx:pt idx="515">9.4425899999999992</cx:pt>
          <cx:pt idx="516">13.696099999999999</cx:pt>
          <cx:pt idx="517">17.919999999999998</cx:pt>
          <cx:pt idx="518">24.863</cx:pt>
          <cx:pt idx="519">13.055800000000001</cx:pt>
          <cx:pt idx="520">11.126900000000001</cx:pt>
          <cx:pt idx="521">19.665299999999998</cx:pt>
          <cx:pt idx="522">22.712499999999999</cx:pt>
          <cx:pt idx="523">17.989000000000001</cx:pt>
          <cx:pt idx="524">16.021899999999999</cx:pt>
          <cx:pt idx="525">21.715400000000002</cx:pt>
          <cx:pt idx="526">17.6982</cx:pt>
          <cx:pt idx="527">17.038800000000002</cx:pt>
          <cx:pt idx="528">2.9585699999999999</cx:pt>
          <cx:pt idx="529">10.8254</cx:pt>
          <cx:pt idx="530">3.8663299999999996</cx:pt>
          <cx:pt idx="531">14.663</cx:pt>
          <cx:pt idx="532">15.965199999999999</cx:pt>
          <cx:pt idx="533">15.187200000000001</cx:pt>
          <cx:pt idx="534">22.537499999999998</cx:pt>
          <cx:pt idx="535">6.1822599999999994</cx:pt>
          <cx:pt idx="536">12.0351</cx:pt>
          <cx:pt idx="537">22.082799999999999</cx:pt>
          <cx:pt idx="538">20.212199999999999</cx:pt>
          <cx:pt idx="539">7.6685400000000001</cx:pt>
          <cx:pt idx="540">21.659200000000002</cx:pt>
          <cx:pt idx="541">20.611899999999999</cx:pt>
          <cx:pt idx="542">15.960099999999999</cx:pt>
          <cx:pt idx="543">20.010300000000001</cx:pt>
          <cx:pt idx="544">18.110299999999999</cx:pt>
          <cx:pt idx="545">14.758199999999999</cx:pt>
          <cx:pt idx="546">17.984200000000001</cx:pt>
          <cx:pt idx="547">16.5214</cx:pt>
          <cx:pt idx="548">15.121100000000002</cx:pt>
          <cx:pt idx="549">19.076999999999998</cx:pt>
          <cx:pt idx="550">20.949400000000001</cx:pt>
          <cx:pt idx="551">21.641099999999998</cx:pt>
          <cx:pt idx="552">19.6709</cx:pt>
          <cx:pt idx="553">14.0046</cx:pt>
          <cx:pt idx="554">15.833299999999999</cx:pt>
          <cx:pt idx="555">17.428599999999999</cx:pt>
          <cx:pt idx="556">15.0265</cx:pt>
          <cx:pt idx="557">14.5159</cx:pt>
          <cx:pt idx="558">9.7626299999999997</cx:pt>
          <cx:pt idx="559">13.661499999999998</cx:pt>
          <cx:pt idx="560">16.729800000000001</cx:pt>
          <cx:pt idx="561">24.6234</cx:pt>
          <cx:pt idx="562">19.618600000000001</cx:pt>
          <cx:pt idx="563">17.7394</cx:pt>
          <cx:pt idx="564">18.259399999999999</cx:pt>
          <cx:pt idx="565">22.745199999999997</cx:pt>
          <cx:pt idx="566">19.525000000000002</cx:pt>
          <cx:pt idx="567">14.522599999999999</cx:pt>
          <cx:pt idx="568">23.145299999999999</cx:pt>
          <cx:pt idx="569">22.884599999999999</cx:pt>
          <cx:pt idx="570">17.1401</cx:pt>
          <cx:pt idx="571">15.1913</cx:pt>
          <cx:pt idx="572">14.0731</cx:pt>
          <cx:pt idx="573">16.907700000000002</cx:pt>
          <cx:pt idx="574">18.0473</cx:pt>
          <cx:pt idx="575">14.342499999999999</cx:pt>
          <cx:pt idx="576">10.8698</cx:pt>
          <cx:pt idx="577">17.632200000000001</cx:pt>
          <cx:pt idx="578">16.108000000000001</cx:pt>
          <cx:pt idx="579">22.494399999999999</cx:pt>
          <cx:pt idx="580">12.620500000000002</cx:pt>
          <cx:pt idx="581">14.747499999999999</cx:pt>
          <cx:pt idx="582">16.413399999999999</cx:pt>
          <cx:pt idx="583">19.341000000000001</cx:pt>
          <cx:pt idx="584">9.4719599999999993</cx:pt>
          <cx:pt idx="585">24.733799999999999</cx:pt>
          <cx:pt idx="586">12.7212</cx:pt>
          <cx:pt idx="587">23.8262</cx:pt>
          <cx:pt idx="588">21.183</cx:pt>
          <cx:pt idx="589">21.7803</cx:pt>
          <cx:pt idx="590">18.7104</cx:pt>
          <cx:pt idx="591">20.764099999999999</cx:pt>
          <cx:pt idx="592">15.731999999999999</cx:pt>
          <cx:pt idx="593">13.933599999999998</cx:pt>
          <cx:pt idx="594">10.8195</cx:pt>
          <cx:pt idx="595">11.042399999999999</cx:pt>
          <cx:pt idx="596">20.204900000000002</cx:pt>
          <cx:pt idx="597">27.0227</cx:pt>
          <cx:pt idx="598">21.796900000000001</cx:pt>
          <cx:pt idx="599">14.776</cx:pt>
          <cx:pt idx="600">15.526499999999999</cx:pt>
          <cx:pt idx="601">11.681900000000001</cx:pt>
          <cx:pt idx="602">7.016890000000001</cx:pt>
          <cx:pt idx="603">2.2469000000000001</cx:pt>
          <cx:pt idx="604">18.8811</cx:pt>
          <cx:pt idx="605">11.0717</cx:pt>
          <cx:pt idx="606">13.797200000000002</cx:pt>
          <cx:pt idx="607">22.1235</cx:pt>
          <cx:pt idx="608">19.4755</cx:pt>
          <cx:pt idx="609">19.110800000000001</cx:pt>
          <cx:pt idx="610">21.2867</cx:pt>
          <cx:pt idx="611">22.085100000000001</cx:pt>
          <cx:pt idx="612">14.367699999999999</cx:pt>
          <cx:pt idx="613">14.039499999999999</cx:pt>
          <cx:pt idx="614">18.991299999999999</cx:pt>
          <cx:pt idx="615">16.4468</cx:pt>
          <cx:pt idx="616">15.537799999999999</cx:pt>
          <cx:pt idx="617">21.906400000000001</cx:pt>
          <cx:pt idx="618">18.671399999999998</cx:pt>
          <cx:pt idx="619">12.5952</cx:pt>
          <cx:pt idx="620">13.7569</cx:pt>
          <cx:pt idx="621">13.9124</cx:pt>
          <cx:pt idx="622">12.409699999999999</cx:pt>
          <cx:pt idx="623">10.4666</cx:pt>
          <cx:pt idx="624">21.575400000000002</cx:pt>
          <cx:pt idx="625">9.9880399999999998</cx:pt>
          <cx:pt idx="626">15.866199999999999</cx:pt>
          <cx:pt idx="627">24.5105</cx:pt>
          <cx:pt idx="628">17.308399999999999</cx:pt>
          <cx:pt idx="629">15.866199999999999</cx:pt>
          <cx:pt idx="630">18.378</cx:pt>
          <cx:pt idx="631">9.7165299999999988</cx:pt>
          <cx:pt idx="632">23.176300000000001</cx:pt>
          <cx:pt idx="633">25.991700000000002</cx:pt>
          <cx:pt idx="634">23.6935</cx:pt>
          <cx:pt idx="635">12.849</cx:pt>
          <cx:pt idx="636">23.0563</cx:pt>
          <cx:pt idx="637">10.7584</cx:pt>
          <cx:pt idx="638">11.0512</cx:pt>
          <cx:pt idx="639">18.640799999999999</cx:pt>
          <cx:pt idx="640">10.428600000000001</cx:pt>
          <cx:pt idx="641">20.232500000000002</cx:pt>
          <cx:pt idx="642">21.4375</cx:pt>
          <cx:pt idx="643">23.712600000000002</cx:pt>
          <cx:pt idx="644">20.147200000000002</cx:pt>
          <cx:pt idx="645">7.3493899999999996</cx:pt>
          <cx:pt idx="646">27.9696</cx:pt>
          <cx:pt idx="647">24.238699999999998</cx:pt>
          <cx:pt idx="648">19.0367</cx:pt>
          <cx:pt idx="649">11.3766</cx:pt>
          <cx:pt idx="650">18.3447</cx:pt>
          <cx:pt idx="651">21.644600000000001</cx:pt>
          <cx:pt idx="652">12.479899999999999</cx:pt>
          <cx:pt idx="653">26.762599999999999</cx:pt>
          <cx:pt idx="654">10.611499999999999</cx:pt>
          <cx:pt idx="655">18.305900000000001</cx:pt>
          <cx:pt idx="656">18.141400000000001</cx:pt>
          <cx:pt idx="657">15.129000000000001</cx:pt>
          <cx:pt idx="658">15.798699999999998</cx:pt>
          <cx:pt idx="659">20.6145</cx:pt>
          <cx:pt idx="660">16.100100000000001</cx:pt>
          <cx:pt idx="661">18.0792</cx:pt>
          <cx:pt idx="662">22.587799999999998</cx:pt>
          <cx:pt idx="663">20.512699999999999</cx:pt>
          <cx:pt idx="664">17.630499999999998</cx:pt>
          <cx:pt idx="665">12.8635</cx:pt>
          <cx:pt idx="666">19.560700000000001</cx:pt>
          <cx:pt idx="667">18.496499999999997</cx:pt>
          <cx:pt idx="668">12.812499999999998</cx:pt>
          <cx:pt idx="669">19.896699999999999</cx:pt>
          <cx:pt idx="670">18.590799999999998</cx:pt>
          <cx:pt idx="671">20.584</cx:pt>
          <cx:pt idx="672">25.674299999999999</cx:pt>
          <cx:pt idx="673">17.989000000000001</cx:pt>
          <cx:pt idx="674">10.864699999999999</cx:pt>
          <cx:pt idx="675">22.747500000000002</cx:pt>
          <cx:pt idx="676">18.023299999999999</cx:pt>
          <cx:pt idx="677">22.322800000000001</cx:pt>
          <cx:pt idx="678">17.989000000000001</cx:pt>
          <cx:pt idx="679">9.6416599999999999</cx:pt>
          <cx:pt idx="680">13.443299999999999</cx:pt>
          <cx:pt idx="681">20.290400000000002</cx:pt>
          <cx:pt idx="682">23.256799999999998</cx:pt>
          <cx:pt idx="683">22.917199999999998</cx:pt>
          <cx:pt idx="684">15.982199999999999</cx:pt>
          <cx:pt idx="685">10.806699999999999</cx:pt>
          <cx:pt idx="686">9.1443499999999993</cx:pt>
          <cx:pt idx="687">17.989000000000001</cx:pt>
          <cx:pt idx="688">13.089200000000002</cx:pt>
          <cx:pt idx="689">19.379300000000001</cx:pt>
          <cx:pt idx="690">24.326800000000002</cx:pt>
          <cx:pt idx="691">1.1241099999999999</cx:pt>
          <cx:pt idx="692">26.769100000000002</cx:pt>
          <cx:pt idx="693">11.2638</cx:pt>
          <cx:pt idx="694">19.1631</cx:pt>
          <cx:pt idx="695">14.1211</cx:pt>
          <cx:pt idx="696">17.0137</cx:pt>
          <cx:pt idx="697">14.920300000000001</cx:pt>
          <cx:pt idx="698">29.397400000000001</cx:pt>
          <cx:pt idx="699">20.0017</cx:pt>
          <cx:pt idx="700">13.414699999999998</cx:pt>
          <cx:pt idx="701">22.872500000000002</cx:pt>
          <cx:pt idx="702">8.3328299999999995</cx:pt>
          <cx:pt idx="703">23.101900000000001</cx:pt>
          <cx:pt idx="704">18.766400000000001</cx:pt>
          <cx:pt idx="705">31.599699999999999</cx:pt>
          <cx:pt idx="706">17.989000000000001</cx:pt>
          <cx:pt idx="707">17.989000000000001</cx:pt>
          <cx:pt idx="708">23.904700000000002</cx:pt>
          <cx:pt idx="709">9.9073200000000003</cx:pt>
          <cx:pt idx="710">17.989000000000001</cx:pt>
          <cx:pt idx="711">17.989000000000001</cx:pt>
          <cx:pt idx="712">22.404799999999998</cx:pt>
          <cx:pt idx="713">13.649100000000001</cx:pt>
          <cx:pt idx="714">19.625400000000003</cx:pt>
          <cx:pt idx="715">8.7593700000000005</cx:pt>
          <cx:pt idx="716">14.047299999999998</cx:pt>
          <cx:pt idx="717">10.186199999999999</cx:pt>
          <cx:pt idx="718">23.226199999999999</cx:pt>
          <cx:pt idx="719">10.441599999999999</cx:pt>
          <cx:pt idx="720">3.2825399999999996</cx:pt>
          <cx:pt idx="721">21.391199999999998</cx:pt>
          <cx:pt idx="722">21.508600000000001</cx:pt>
          <cx:pt idx="723">18.373699999999999</cx:pt>
          <cx:pt idx="724">16.261500000000002</cx:pt>
          <cx:pt idx="725">5.35318</cx:pt>
          <cx:pt idx="726">16.2911</cx:pt>
          <cx:pt idx="727">17.977399999999999</cx:pt>
          <cx:pt idx="728">14.137600000000001</cx:pt>
          <cx:pt idx="729">21.865100000000002</cx:pt>
          <cx:pt idx="730">18.662200000000002</cx:pt>
          <cx:pt idx="731">17.3916</cx:pt>
          <cx:pt idx="732">24.250900000000001</cx:pt>
          <cx:pt idx="733">17.4251</cx:pt>
          <cx:pt idx="734">8.7837899999999998</cx:pt>
          <cx:pt idx="735">15.8271</cx:pt>
          <cx:pt idx="736">10.979100000000001</cx:pt>
          <cx:pt idx="737">24.818999999999999</cx:pt>
          <cx:pt idx="738">17.989000000000001</cx:pt>
          <cx:pt idx="739">31.050800000000002</cx:pt>
          <cx:pt idx="740">16.857700000000001</cx:pt>
          <cx:pt idx="741">17.184999999999999</cx:pt>
          <cx:pt idx="742">7.4435500000000001</cx:pt>
          <cx:pt idx="743">17.4909</cx:pt>
          <cx:pt idx="744">18.998000000000001</cx:pt>
          <cx:pt idx="745">15.333299999999999</cx:pt>
          <cx:pt idx="746">20.831700000000001</cx:pt>
          <cx:pt idx="747">14.8721</cx:pt>
          <cx:pt idx="748">20.4788</cx:pt>
          <cx:pt idx="749">20.859500000000001</cx:pt>
          <cx:pt idx="750">14.527899999999999</cx:pt>
          <cx:pt idx="751">7.1374099999999991</cx:pt>
          <cx:pt idx="752">18.759399999999999</cx:pt>
          <cx:pt idx="753">8.6675000000000004</cx:pt>
          <cx:pt idx="754">12.2209</cx:pt>
          <cx:pt idx="755">17.090399999999999</cx:pt>
          <cx:pt idx="756">9.4533799999999992</cx:pt>
          <cx:pt idx="757">11.446299999999999</cx:pt>
          <cx:pt idx="758">11.34</cx:pt>
          <cx:pt idx="759">3.0887899999999999</cx:pt>
          <cx:pt idx="760">28.6431</cx:pt>
          <cx:pt idx="761">11.262700000000001</cx:pt>
          <cx:pt idx="762">14.577100000000002</cx:pt>
          <cx:pt idx="763">12.907499999999999</cx:pt>
          <cx:pt idx="764">28.340799999999998</cx:pt>
          <cx:pt idx="765">17.834700000000002</cx:pt>
          <cx:pt idx="766">17.989000000000001</cx:pt>
          <cx:pt idx="767">25.348399999999998</cx:pt>
          <cx:pt idx="768">11.200899999999999</cx:pt>
          <cx:pt idx="769">22.0517</cx:pt>
          <cx:pt idx="770">19.015599999999999</cx:pt>
          <cx:pt idx="771">25.758199999999999</cx:pt>
          <cx:pt idx="772">17.989000000000001</cx:pt>
          <cx:pt idx="773">21.6267</cx:pt>
          <cx:pt idx="774">22.834399999999999</cx:pt>
          <cx:pt idx="775">25.5075</cx:pt>
          <cx:pt idx="776">15.8386</cx:pt>
          <cx:pt idx="777">7.4907500000000002</cx:pt>
          <cx:pt idx="778">21.4009</cx:pt>
          <cx:pt idx="779">18.571899999999999</cx:pt>
          <cx:pt idx="780">23.644399999999997</cx:pt>
          <cx:pt idx="781">19.945699999999999</cx:pt>
          <cx:pt idx="782">21.552099999999999</cx:pt>
          <cx:pt idx="783">15.617600000000001</cx:pt>
          <cx:pt idx="784">20.3277</cx:pt>
          <cx:pt idx="785">18.4512</cx:pt>
          <cx:pt idx="786">13.930100000000001</cx:pt>
          <cx:pt idx="787">6.3524399999999996</cx:pt>
          <cx:pt idx="788">10.4504</cx:pt>
          <cx:pt idx="789">11.062200000000001</cx:pt>
          <cx:pt idx="790">14.2037</cx:pt>
          <cx:pt idx="791">16.200200000000002</cx:pt>
          <cx:pt idx="792">15.356900000000001</cx:pt>
          <cx:pt idx="793">18.024100000000001</cx:pt>
          <cx:pt idx="794">17.240200000000002</cx:pt>
          <cx:pt idx="795">17.989000000000001</cx:pt>
          <cx:pt idx="796">21.0562</cx:pt>
          <cx:pt idx="797">20.279299999999999</cx:pt>
          <cx:pt idx="798">14.930899999999999</cx:pt>
          <cx:pt idx="799">14.2492</cx:pt>
          <cx:pt idx="800">13.957800000000001</cx:pt>
          <cx:pt idx="801">14.214499999999999</cx:pt>
          <cx:pt idx="802">7.6597299999999997</cx:pt>
          <cx:pt idx="803">17.167899999999999</cx:pt>
          <cx:pt idx="804">12.3126</cx:pt>
          <cx:pt idx="805">17.987000000000002</cx:pt>
          <cx:pt idx="806">13.723699999999999</cx:pt>
          <cx:pt idx="807">21.270500000000002</cx:pt>
          <cx:pt idx="808">25.411899999999999</cx:pt>
          <cx:pt idx="809">25.726399999999998</cx:pt>
          <cx:pt idx="810">19.081600000000002</cx:pt>
          <cx:pt idx="811">6.9233500000000001</cx:pt>
          <cx:pt idx="812">26.169700000000002</cx:pt>
          <cx:pt idx="813">17.744299999999999</cx:pt>
          <cx:pt idx="814">12.690100000000001</cx:pt>
          <cx:pt idx="815">16.895</cx:pt>
          <cx:pt idx="816">21.115200000000002</cx:pt>
          <cx:pt idx="817">10.279299999999999</cx:pt>
          <cx:pt idx="818">14.814500000000001</cx:pt>
          <cx:pt idx="819">12.357999999999999</cx:pt>
          <cx:pt idx="820">19.3169</cx:pt>
          <cx:pt idx="821">11.6633</cx:pt>
          <cx:pt idx="822">24.840300000000003</cx:pt>
          <cx:pt idx="823">17.625499999999999</cx:pt>
          <cx:pt idx="824">20.657399999999999</cx:pt>
          <cx:pt idx="825">16.3337</cx:pt>
          <cx:pt idx="826">17.773099999999999</cx:pt>
          <cx:pt idx="827">18.624199999999998</cx:pt>
          <cx:pt idx="828">16.636600000000001</cx:pt>
          <cx:pt idx="829">17.989000000000001</cx:pt>
          <cx:pt idx="830">15.321599999999998</cx:pt>
          <cx:pt idx="831">14.816799999999999</cx:pt>
          <cx:pt idx="832">13.253100000000002</cx:pt>
          <cx:pt idx="833">16.8066</cx:pt>
          <cx:pt idx="834">16.769000000000002</cx:pt>
          <cx:pt idx="835">3.9593299999999996</cx:pt>
          <cx:pt idx="836">15.537599999999999</cx:pt>
          <cx:pt idx="837">23.9529</cx:pt>
          <cx:pt idx="838">23.1995</cx:pt>
          <cx:pt idx="839">12.8431</cx:pt>
          <cx:pt idx="840">18.1357</cx:pt>
          <cx:pt idx="841">10.763300000000001</cx:pt>
          <cx:pt idx="842">17.989000000000001</cx:pt>
          <cx:pt idx="843">14.871500000000001</cx:pt>
          <cx:pt idx="844">14.991</cx:pt>
          <cx:pt idx="845">9.9326500000000006</cx:pt>
          <cx:pt idx="846">23.398700000000002</cx:pt>
          <cx:pt idx="847">17.705500000000001</cx:pt>
          <cx:pt idx="848">19.200200000000002</cx:pt>
          <cx:pt idx="849">14.944699999999999</cx:pt>
          <cx:pt idx="850">17.635300000000001</cx:pt>
          <cx:pt idx="851">12.839600000000001</cx:pt>
          <cx:pt idx="852">13.104699999999999</cx:pt>
          <cx:pt idx="853">17.025000000000002</cx:pt>
          <cx:pt idx="854">7.3977600000000008</cx:pt>
          <cx:pt idx="855">19.667200000000001</cx:pt>
          <cx:pt idx="856">12.136099999999999</cx:pt>
          <cx:pt idx="857">16.988500000000002</cx:pt>
          <cx:pt idx="858">14.9497</cx:pt>
          <cx:pt idx="859">9.8170800000000007</cx:pt>
          <cx:pt idx="860">17.989000000000001</cx:pt>
          <cx:pt idx="861">15.923200000000001</cx:pt>
          <cx:pt idx="862">15.835900000000001</cx:pt>
          <cx:pt idx="863">12.342000000000001</cx:pt>
          <cx:pt idx="864">16.6999</cx:pt>
          <cx:pt idx="865">2.3796500000000003</cx:pt>
          <cx:pt idx="866">8.7367000000000008</cx:pt>
          <cx:pt idx="867">14.285300000000001</cx:pt>
          <cx:pt idx="868">9.8701699999999999</cx:pt>
          <cx:pt idx="869">11.6982</cx:pt>
          <cx:pt idx="870">20.4406</cx:pt>
          <cx:pt idx="871">17.669999999999998</cx:pt>
          <cx:pt idx="872">3.9231299999999996</cx:pt>
          <cx:pt idx="873">14.505000000000001</cx:pt>
          <cx:pt idx="874">10.7988</cx:pt>
          <cx:pt idx="875">11.0397</cx:pt>
          <cx:pt idx="876">9.632200000000001</cx:pt>
          <cx:pt idx="877">22.2712</cx:pt>
          <cx:pt idx="878">24.905100000000001</cx:pt>
          <cx:pt idx="879">13.847300000000001</cx:pt>
          <cx:pt idx="880">4.0948199999999995</cx:pt>
          <cx:pt idx="881">31.541799999999999</cx:pt>
          <cx:pt idx="882">20.9878</cx:pt>
          <cx:pt idx="883">21.499299999999998</cx:pt>
          <cx:pt idx="884">3.16974</cx:pt>
          <cx:pt idx="885">19.5183</cx:pt>
          <cx:pt idx="886">14.889699999999999</cx:pt>
          <cx:pt idx="887">22.984500000000001</cx:pt>
          <cx:pt idx="888">20.4361</cx:pt>
          <cx:pt idx="889">29.720600000000001</cx:pt>
          <cx:pt idx="890">3.9239600000000001</cx:pt>
          <cx:pt idx="891">13.6492</cx:pt>
          <cx:pt idx="892">21.923999999999999</cx:pt>
          <cx:pt idx="893">17.989000000000001</cx:pt>
          <cx:pt idx="894">16.1435</cx:pt>
          <cx:pt idx="895">13.350100000000001</cx:pt>
          <cx:pt idx="896">17.989000000000001</cx:pt>
          <cx:pt idx="897">4.6885200000000005</cx:pt>
          <cx:pt idx="898">10.868400000000001</cx:pt>
          <cx:pt idx="899">14.360500000000002</cx:pt>
          <cx:pt idx="900">17.057200000000002</cx:pt>
          <cx:pt idx="901">18.8261</cx:pt>
          <cx:pt idx="902">20.9801</cx:pt>
          <cx:pt idx="903">12.173999999999999</cx:pt>
          <cx:pt idx="904">5.3994499999999999</cx:pt>
          <cx:pt idx="905">13.9483</cx:pt>
          <cx:pt idx="906">17.8155</cx:pt>
          <cx:pt idx="907">16.949100000000001</cx:pt>
          <cx:pt idx="908">10.568300000000001</cx:pt>
          <cx:pt idx="909">14.227</cx:pt>
          <cx:pt idx="910">17.264900000000001</cx:pt>
          <cx:pt idx="911">13.8628</cx:pt>
          <cx:pt idx="912">21.169499999999999</cx:pt>
          <cx:pt idx="913">14.168600000000001</cx:pt>
          <cx:pt idx="914">16.995899999999999</cx:pt>
          <cx:pt idx="915">12.896199999999999</cx:pt>
          <cx:pt idx="916">13.195200000000002</cx:pt>
          <cx:pt idx="917">22.608700000000002</cx:pt>
          <cx:pt idx="918">13.602600000000001</cx:pt>
          <cx:pt idx="919">22.331</cx:pt>
          <cx:pt idx="920">28.9893</cx:pt>
          <cx:pt idx="921">23.774899999999999</cx:pt>
          <cx:pt idx="922">24.440200000000001</cx:pt>
          <cx:pt idx="923">20.1065</cx:pt>
          <cx:pt idx="924">25.063999999999997</cx:pt>
          <cx:pt idx="925">17.353899999999999</cx:pt>
          <cx:pt idx="926">24.121699999999997</cx:pt>
          <cx:pt idx="927">18.915399999999998</cx:pt>
          <cx:pt idx="928">16.8156</cx:pt>
          <cx:pt idx="929">17.190200000000001</cx:pt>
          <cx:pt idx="930">13.302300000000001</cx:pt>
          <cx:pt idx="931">31.747399999999999</cx:pt>
          <cx:pt idx="932">20.267900000000001</cx:pt>
          <cx:pt idx="933">7.0513300000000001</cx:pt>
          <cx:pt idx="934">31.985599999999998</cx:pt>
          <cx:pt idx="935">10.316500000000001</cx:pt>
          <cx:pt idx="936">21.527899999999999</cx:pt>
          <cx:pt idx="937">9.9822299999999995</cx:pt>
          <cx:pt idx="938">9.3831800000000012</cx:pt>
          <cx:pt idx="939">12.783900000000001</cx:pt>
          <cx:pt idx="940">15.932399999999999</cx:pt>
          <cx:pt idx="941">19.5703</cx:pt>
          <cx:pt idx="942">16.813800000000001</cx:pt>
          <cx:pt idx="943">6.3166200000000003</cx:pt>
          <cx:pt idx="944">27.492599999999999</cx:pt>
          <cx:pt idx="945">11.608699999999999</cx:pt>
          <cx:pt idx="946">17.4053</cx:pt>
          <cx:pt idx="947">18.075800000000001</cx:pt>
          <cx:pt idx="948">17.0517</cx:pt>
          <cx:pt idx="949">32.0762</cx:pt>
          <cx:pt idx="950">22.0364</cx:pt>
          <cx:pt idx="951">11.6671</cx:pt>
          <cx:pt idx="952">12.976899999999999</cx:pt>
          <cx:pt idx="953">24.415899999999997</cx:pt>
          <cx:pt idx="954">26.384800000000002</cx:pt>
          <cx:pt idx="955">9.4909599999999994</cx:pt>
          <cx:pt idx="956">23.625299999999999</cx:pt>
          <cx:pt idx="957">14.1183</cx:pt>
          <cx:pt idx="958">23.011200000000002</cx:pt>
          <cx:pt idx="959">23.805200000000003</cx:pt>
          <cx:pt idx="960">18.446899999999999</cx:pt>
          <cx:pt idx="961">25.200800000000001</cx:pt>
          <cx:pt idx="962">14.613899999999999</cx:pt>
          <cx:pt idx="963">9.6086599999999986</cx:pt>
          <cx:pt idx="964">15.6538</cx:pt>
          <cx:pt idx="965">17.989000000000001</cx:pt>
          <cx:pt idx="966">18.603100000000001</cx:pt>
          <cx:pt idx="967">30.899900000000002</cx:pt>
          <cx:pt idx="968">12.3414</cx:pt>
          <cx:pt idx="969">17.980499999999999</cx:pt>
          <cx:pt idx="970">16.776900000000001</cx:pt>
          <cx:pt idx="971">21.042300000000001</cx:pt>
          <cx:pt idx="972">13.697899999999999</cx:pt>
          <cx:pt idx="973">22.035299999999999</cx:pt>
          <cx:pt idx="974">9.6326999999999998</cx:pt>
          <cx:pt idx="975">14.503499999999999</cx:pt>
          <cx:pt idx="976">28.483799999999999</cx:pt>
          <cx:pt idx="977">24.2486</cx:pt>
          <cx:pt idx="978">16.4421</cx:pt>
          <cx:pt idx="979">17.273800000000001</cx:pt>
          <cx:pt idx="980">17.989000000000001</cx:pt>
          <cx:pt idx="981">21.382100000000001</cx:pt>
          <cx:pt idx="982">15.3428</cx:pt>
          <cx:pt idx="983">16.200700000000001</cx:pt>
          <cx:pt idx="984">27.625</cx:pt>
          <cx:pt idx="985">25.388200000000001</cx:pt>
          <cx:pt idx="986">6.534860000000001</cx:pt>
          <cx:pt idx="987">7.3327199999999992</cx:pt>
          <cx:pt idx="988">16.819500000000001</cx:pt>
          <cx:pt idx="989">19.692</cx:pt>
          <cx:pt idx="990">19.110299999999999</cx:pt>
          <cx:pt idx="991">16.319099999999999</cx:pt>
          <cx:pt idx="992">17.509699999999999</cx:pt>
          <cx:pt idx="993">17.989000000000001</cx:pt>
          <cx:pt idx="994">18.698600000000003</cx:pt>
          <cx:pt idx="995">14.618500000000001</cx:pt>
          <cx:pt idx="996">7.3548100000000005</cx:pt>
          <cx:pt idx="997">16.942</cx:pt>
          <cx:pt idx="998">9.837909999999999</cx:pt>
          <cx:pt idx="999">19.6663</cx:pt>
        </cx:lvl>
      </cx:numDim>
    </cx:data>
  </cx:chartData>
  <cx:chart>
    <cx:title pos="t" align="ctr" overlay="0">
      <cx:tx>
        <cx:rich>
          <a:bodyPr spcFirstLastPara="1" vertOverflow="ellipsis" horzOverflow="overflow" wrap="square" lIns="0" tIns="0" rIns="0" bIns="0" anchor="ctr" anchorCtr="1"/>
          <a:lstStyle/>
          <a:p>
            <a:pPr algn="ctr" rtl="0">
              <a:defRPr sz="11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r>
              <a:rPr lang="el-GR" altLang="ja-JP" sz="1100" b="0" i="0" u="none" strike="noStrike" baseline="0" dirty="0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σ</a:t>
            </a:r>
            <a:r>
              <a:rPr lang="en-US" altLang="ja-JP" sz="1100" b="0" i="0" u="none" strike="noStrike" baseline="0" dirty="0">
                <a:solidFill>
                  <a:sysClr val="windowText" lastClr="000000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,C</a:t>
            </a:r>
            <a:endParaRPr lang="el-GR" altLang="ja-JP" sz="1100" b="0" i="0" u="none" strike="noStrike" baseline="0" dirty="0">
              <a:solidFill>
                <a:sysClr val="windowText" lastClr="000000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cx:rich>
      </cx:tx>
    </cx:title>
    <cx:plotArea>
      <cx:plotAreaRegion>
        <cx:series layoutId="clusteredColumn" uniqueId="{88C55D9F-5A9A-4F41-99FF-F09668A17517}">
          <cx:tx>
            <cx:txData>
              <cx:f>PK!$W$1</cx:f>
              <cx:v>CEps</cx:v>
            </cx:txData>
          </cx:tx>
          <cx:spPr>
            <a:solidFill>
              <a:schemeClr val="bg1">
                <a:lumMod val="65000"/>
              </a:schemeClr>
            </a:solidFill>
          </cx:spPr>
          <cx:dataId val="0"/>
          <cx:layoutPr>
            <cx:binning intervalClosed="r"/>
          </cx:layoutPr>
        </cx:series>
      </cx:plotAreaRegion>
      <cx:axis id="0">
        <cx:catScaling gapWidth="0"/>
        <cx:tickLabels/>
        <cx:numFmt formatCode="#,##0.00_);[赤](#,##0.0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6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6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/>
        <cx:majorTickMarks type="in"/>
        <cx:tickLabels/>
        <cx:numFmt formatCode="#,##0_);[赤](#,##0)" sourceLinked="0"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800" b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ja-JP" altLang="en-US" sz="8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10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11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12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13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14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15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16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17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18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19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20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8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9.xml><?xml version="1.0" encoding="utf-8"?>
<cs:chartStyle xmlns:cs="http://schemas.microsoft.com/office/drawing/2012/chartStyle" xmlns:a="http://schemas.openxmlformats.org/drawingml/2006/main" id="36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42950" y="2130435"/>
            <a:ext cx="84201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164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329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494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2659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582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8988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2153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5318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E5E64-896E-4087-81FA-40AF84D8094C}" type="datetimeFigureOut">
              <a:rPr lang="en-US" smtClean="0"/>
              <a:t>1/22/2020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79C5-421B-4FF9-8DAB-7525A32F9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758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E5E64-896E-4087-81FA-40AF84D8094C}" type="datetimeFigureOut">
              <a:rPr lang="en-US" smtClean="0"/>
              <a:t>1/22/2020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79C5-421B-4FF9-8DAB-7525A32F9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414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5386387" y="396875"/>
            <a:ext cx="1671638" cy="845185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71484" y="396875"/>
            <a:ext cx="4849813" cy="845185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E5E64-896E-4087-81FA-40AF84D8094C}" type="datetimeFigureOut">
              <a:rPr lang="en-US" smtClean="0"/>
              <a:t>1/22/2020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79C5-421B-4FF9-8DAB-7525A32F9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083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E5E64-896E-4087-81FA-40AF84D8094C}" type="datetimeFigureOut">
              <a:rPr lang="en-US" smtClean="0"/>
              <a:t>1/22/2020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79C5-421B-4FF9-8DAB-7525A32F9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1062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2769" b="1" cap="all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82506" y="2906723"/>
            <a:ext cx="8420100" cy="1500187"/>
          </a:xfrm>
        </p:spPr>
        <p:txBody>
          <a:bodyPr anchor="b"/>
          <a:lstStyle>
            <a:lvl1pPr marL="0" indent="0">
              <a:buNone/>
              <a:defRPr sz="1385">
                <a:solidFill>
                  <a:schemeClr val="tx1">
                    <a:tint val="75000"/>
                  </a:schemeClr>
                </a:solidFill>
              </a:defRPr>
            </a:lvl1pPr>
            <a:lvl2pPr marL="316479" indent="0">
              <a:buNone/>
              <a:defRPr sz="1246">
                <a:solidFill>
                  <a:schemeClr val="tx1">
                    <a:tint val="75000"/>
                  </a:schemeClr>
                </a:solidFill>
              </a:defRPr>
            </a:lvl2pPr>
            <a:lvl3pPr marL="632960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3pPr>
            <a:lvl4pPr marL="949439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4pPr>
            <a:lvl5pPr marL="1265919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5pPr>
            <a:lvl6pPr marL="1582400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6pPr>
            <a:lvl7pPr marL="1898879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7pPr>
            <a:lvl8pPr marL="2215358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8pPr>
            <a:lvl9pPr marL="2531838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E5E64-896E-4087-81FA-40AF84D8094C}" type="datetimeFigureOut">
              <a:rPr lang="en-US" smtClean="0"/>
              <a:t>1/22/2020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79C5-421B-4FF9-8DAB-7525A32F9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2784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71489" y="2311410"/>
            <a:ext cx="3260725" cy="6537325"/>
          </a:xfrm>
        </p:spPr>
        <p:txBody>
          <a:bodyPr/>
          <a:lstStyle>
            <a:lvl1pPr>
              <a:defRPr sz="1938"/>
            </a:lvl1pPr>
            <a:lvl2pPr>
              <a:defRPr sz="1662"/>
            </a:lvl2pPr>
            <a:lvl3pPr>
              <a:defRPr sz="1385"/>
            </a:lvl3pPr>
            <a:lvl4pPr>
              <a:defRPr sz="1246"/>
            </a:lvl4pPr>
            <a:lvl5pPr>
              <a:defRPr sz="1246"/>
            </a:lvl5pPr>
            <a:lvl6pPr>
              <a:defRPr sz="1246"/>
            </a:lvl6pPr>
            <a:lvl7pPr>
              <a:defRPr sz="1246"/>
            </a:lvl7pPr>
            <a:lvl8pPr>
              <a:defRPr sz="1246"/>
            </a:lvl8pPr>
            <a:lvl9pPr>
              <a:defRPr sz="1246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797314" y="2311410"/>
            <a:ext cx="3260725" cy="6537325"/>
          </a:xfrm>
        </p:spPr>
        <p:txBody>
          <a:bodyPr/>
          <a:lstStyle>
            <a:lvl1pPr>
              <a:defRPr sz="1938"/>
            </a:lvl1pPr>
            <a:lvl2pPr>
              <a:defRPr sz="1662"/>
            </a:lvl2pPr>
            <a:lvl3pPr>
              <a:defRPr sz="1385"/>
            </a:lvl3pPr>
            <a:lvl4pPr>
              <a:defRPr sz="1246"/>
            </a:lvl4pPr>
            <a:lvl5pPr>
              <a:defRPr sz="1246"/>
            </a:lvl5pPr>
            <a:lvl6pPr>
              <a:defRPr sz="1246"/>
            </a:lvl6pPr>
            <a:lvl7pPr>
              <a:defRPr sz="1246"/>
            </a:lvl7pPr>
            <a:lvl8pPr>
              <a:defRPr sz="1246"/>
            </a:lvl8pPr>
            <a:lvl9pPr>
              <a:defRPr sz="1246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E5E64-896E-4087-81FA-40AF84D8094C}" type="datetimeFigureOut">
              <a:rPr lang="en-US" smtClean="0"/>
              <a:t>1/22/2020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79C5-421B-4FF9-8DAB-7525A32F9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9126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2" y="1535113"/>
            <a:ext cx="4376870" cy="639762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479" indent="0">
              <a:buNone/>
              <a:defRPr sz="1385" b="1"/>
            </a:lvl2pPr>
            <a:lvl3pPr marL="632960" indent="0">
              <a:buNone/>
              <a:defRPr sz="1246" b="1"/>
            </a:lvl3pPr>
            <a:lvl4pPr marL="949439" indent="0">
              <a:buNone/>
              <a:defRPr sz="1108" b="1"/>
            </a:lvl4pPr>
            <a:lvl5pPr marL="1265919" indent="0">
              <a:buNone/>
              <a:defRPr sz="1108" b="1"/>
            </a:lvl5pPr>
            <a:lvl6pPr marL="1582400" indent="0">
              <a:buNone/>
              <a:defRPr sz="1108" b="1"/>
            </a:lvl6pPr>
            <a:lvl7pPr marL="1898879" indent="0">
              <a:buNone/>
              <a:defRPr sz="1108" b="1"/>
            </a:lvl7pPr>
            <a:lvl8pPr marL="2215358" indent="0">
              <a:buNone/>
              <a:defRPr sz="1108" b="1"/>
            </a:lvl8pPr>
            <a:lvl9pPr marL="2531838" indent="0">
              <a:buNone/>
              <a:defRPr sz="110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95302" y="2174875"/>
            <a:ext cx="4376870" cy="3951288"/>
          </a:xfrm>
        </p:spPr>
        <p:txBody>
          <a:bodyPr/>
          <a:lstStyle>
            <a:lvl1pPr>
              <a:defRPr sz="1662"/>
            </a:lvl1pPr>
            <a:lvl2pPr>
              <a:defRPr sz="1385"/>
            </a:lvl2pPr>
            <a:lvl3pPr>
              <a:defRPr sz="1246"/>
            </a:lvl3pPr>
            <a:lvl4pPr>
              <a:defRPr sz="1108"/>
            </a:lvl4pPr>
            <a:lvl5pPr>
              <a:defRPr sz="1108"/>
            </a:lvl5pPr>
            <a:lvl6pPr>
              <a:defRPr sz="1108"/>
            </a:lvl6pPr>
            <a:lvl7pPr>
              <a:defRPr sz="1108"/>
            </a:lvl7pPr>
            <a:lvl8pPr>
              <a:defRPr sz="1108"/>
            </a:lvl8pPr>
            <a:lvl9pPr>
              <a:defRPr sz="1108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032125" y="1535113"/>
            <a:ext cx="4378589" cy="639762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479" indent="0">
              <a:buNone/>
              <a:defRPr sz="1385" b="1"/>
            </a:lvl2pPr>
            <a:lvl3pPr marL="632960" indent="0">
              <a:buNone/>
              <a:defRPr sz="1246" b="1"/>
            </a:lvl3pPr>
            <a:lvl4pPr marL="949439" indent="0">
              <a:buNone/>
              <a:defRPr sz="1108" b="1"/>
            </a:lvl4pPr>
            <a:lvl5pPr marL="1265919" indent="0">
              <a:buNone/>
              <a:defRPr sz="1108" b="1"/>
            </a:lvl5pPr>
            <a:lvl6pPr marL="1582400" indent="0">
              <a:buNone/>
              <a:defRPr sz="1108" b="1"/>
            </a:lvl6pPr>
            <a:lvl7pPr marL="1898879" indent="0">
              <a:buNone/>
              <a:defRPr sz="1108" b="1"/>
            </a:lvl7pPr>
            <a:lvl8pPr marL="2215358" indent="0">
              <a:buNone/>
              <a:defRPr sz="1108" b="1"/>
            </a:lvl8pPr>
            <a:lvl9pPr marL="2531838" indent="0">
              <a:buNone/>
              <a:defRPr sz="110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032125" y="2174875"/>
            <a:ext cx="4378589" cy="3951288"/>
          </a:xfrm>
        </p:spPr>
        <p:txBody>
          <a:bodyPr/>
          <a:lstStyle>
            <a:lvl1pPr>
              <a:defRPr sz="1662"/>
            </a:lvl1pPr>
            <a:lvl2pPr>
              <a:defRPr sz="1385"/>
            </a:lvl2pPr>
            <a:lvl3pPr>
              <a:defRPr sz="1246"/>
            </a:lvl3pPr>
            <a:lvl4pPr>
              <a:defRPr sz="1108"/>
            </a:lvl4pPr>
            <a:lvl5pPr>
              <a:defRPr sz="1108"/>
            </a:lvl5pPr>
            <a:lvl6pPr>
              <a:defRPr sz="1108"/>
            </a:lvl6pPr>
            <a:lvl7pPr>
              <a:defRPr sz="1108"/>
            </a:lvl7pPr>
            <a:lvl8pPr>
              <a:defRPr sz="1108"/>
            </a:lvl8pPr>
            <a:lvl9pPr>
              <a:defRPr sz="1108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E5E64-896E-4087-81FA-40AF84D8094C}" type="datetimeFigureOut">
              <a:rPr lang="en-US" smtClean="0"/>
              <a:t>1/22/2020</a:t>
            </a:fld>
            <a:endParaRPr 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79C5-421B-4FF9-8DAB-7525A32F9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323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E5E64-896E-4087-81FA-40AF84D8094C}" type="datetimeFigureOut">
              <a:rPr lang="en-US" smtClean="0"/>
              <a:t>1/22/2020</a:t>
            </a:fld>
            <a:endParaRPr 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79C5-421B-4FF9-8DAB-7525A32F9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0763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E5E64-896E-4087-81FA-40AF84D8094C}" type="datetimeFigureOut">
              <a:rPr lang="en-US" smtClean="0"/>
              <a:t>1/22/2020</a:t>
            </a:fld>
            <a:endParaRPr 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79C5-421B-4FF9-8DAB-7525A32F9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690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1385" b="1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72972" y="273060"/>
            <a:ext cx="5537730" cy="5853113"/>
          </a:xfrm>
        </p:spPr>
        <p:txBody>
          <a:bodyPr/>
          <a:lstStyle>
            <a:lvl1pPr>
              <a:defRPr sz="2215"/>
            </a:lvl1pPr>
            <a:lvl2pPr>
              <a:defRPr sz="1938"/>
            </a:lvl2pPr>
            <a:lvl3pPr>
              <a:defRPr sz="1662"/>
            </a:lvl3pPr>
            <a:lvl4pPr>
              <a:defRPr sz="1385"/>
            </a:lvl4pPr>
            <a:lvl5pPr>
              <a:defRPr sz="1385"/>
            </a:lvl5pPr>
            <a:lvl6pPr>
              <a:defRPr sz="1385"/>
            </a:lvl6pPr>
            <a:lvl7pPr>
              <a:defRPr sz="1385"/>
            </a:lvl7pPr>
            <a:lvl8pPr>
              <a:defRPr sz="1385"/>
            </a:lvl8pPr>
            <a:lvl9pPr>
              <a:defRPr sz="138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95302" y="1435101"/>
            <a:ext cx="3259006" cy="4691063"/>
          </a:xfrm>
        </p:spPr>
        <p:txBody>
          <a:bodyPr/>
          <a:lstStyle>
            <a:lvl1pPr marL="0" indent="0">
              <a:buNone/>
              <a:defRPr sz="969"/>
            </a:lvl1pPr>
            <a:lvl2pPr marL="316479" indent="0">
              <a:buNone/>
              <a:defRPr sz="831"/>
            </a:lvl2pPr>
            <a:lvl3pPr marL="632960" indent="0">
              <a:buNone/>
              <a:defRPr sz="692"/>
            </a:lvl3pPr>
            <a:lvl4pPr marL="949439" indent="0">
              <a:buNone/>
              <a:defRPr sz="623"/>
            </a:lvl4pPr>
            <a:lvl5pPr marL="1265919" indent="0">
              <a:buNone/>
              <a:defRPr sz="623"/>
            </a:lvl5pPr>
            <a:lvl6pPr marL="1582400" indent="0">
              <a:buNone/>
              <a:defRPr sz="623"/>
            </a:lvl6pPr>
            <a:lvl7pPr marL="1898879" indent="0">
              <a:buNone/>
              <a:defRPr sz="623"/>
            </a:lvl7pPr>
            <a:lvl8pPr marL="2215358" indent="0">
              <a:buNone/>
              <a:defRPr sz="623"/>
            </a:lvl8pPr>
            <a:lvl9pPr marL="2531838" indent="0">
              <a:buNone/>
              <a:defRPr sz="62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E5E64-896E-4087-81FA-40AF84D8094C}" type="datetimeFigureOut">
              <a:rPr lang="en-US" smtClean="0"/>
              <a:t>1/22/2020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79C5-421B-4FF9-8DAB-7525A32F9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1038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1385" b="1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2215"/>
            </a:lvl1pPr>
            <a:lvl2pPr marL="316479" indent="0">
              <a:buNone/>
              <a:defRPr sz="1938"/>
            </a:lvl2pPr>
            <a:lvl3pPr marL="632960" indent="0">
              <a:buNone/>
              <a:defRPr sz="1662"/>
            </a:lvl3pPr>
            <a:lvl4pPr marL="949439" indent="0">
              <a:buNone/>
              <a:defRPr sz="1385"/>
            </a:lvl4pPr>
            <a:lvl5pPr marL="1265919" indent="0">
              <a:buNone/>
              <a:defRPr sz="1385"/>
            </a:lvl5pPr>
            <a:lvl6pPr marL="1582400" indent="0">
              <a:buNone/>
              <a:defRPr sz="1385"/>
            </a:lvl6pPr>
            <a:lvl7pPr marL="1898879" indent="0">
              <a:buNone/>
              <a:defRPr sz="1385"/>
            </a:lvl7pPr>
            <a:lvl8pPr marL="2215358" indent="0">
              <a:buNone/>
              <a:defRPr sz="1385"/>
            </a:lvl8pPr>
            <a:lvl9pPr marL="2531838" indent="0">
              <a:buNone/>
              <a:defRPr sz="1385"/>
            </a:lvl9pPr>
          </a:lstStyle>
          <a:p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969"/>
            </a:lvl1pPr>
            <a:lvl2pPr marL="316479" indent="0">
              <a:buNone/>
              <a:defRPr sz="831"/>
            </a:lvl2pPr>
            <a:lvl3pPr marL="632960" indent="0">
              <a:buNone/>
              <a:defRPr sz="692"/>
            </a:lvl3pPr>
            <a:lvl4pPr marL="949439" indent="0">
              <a:buNone/>
              <a:defRPr sz="623"/>
            </a:lvl4pPr>
            <a:lvl5pPr marL="1265919" indent="0">
              <a:buNone/>
              <a:defRPr sz="623"/>
            </a:lvl5pPr>
            <a:lvl6pPr marL="1582400" indent="0">
              <a:buNone/>
              <a:defRPr sz="623"/>
            </a:lvl6pPr>
            <a:lvl7pPr marL="1898879" indent="0">
              <a:buNone/>
              <a:defRPr sz="623"/>
            </a:lvl7pPr>
            <a:lvl8pPr marL="2215358" indent="0">
              <a:buNone/>
              <a:defRPr sz="623"/>
            </a:lvl8pPr>
            <a:lvl9pPr marL="2531838" indent="0">
              <a:buNone/>
              <a:defRPr sz="62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E5E64-896E-4087-81FA-40AF84D8094C}" type="datetimeFigureOut">
              <a:rPr lang="en-US" smtClean="0"/>
              <a:t>1/22/2020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979C5-421B-4FF9-8DAB-7525A32F9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840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95300" y="6356360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9E5E64-896E-4087-81FA-40AF84D8094C}" type="datetimeFigureOut">
              <a:rPr lang="en-US" smtClean="0"/>
              <a:t>1/22/2020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384550" y="6356360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099300" y="6356360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3979C5-421B-4FF9-8DAB-7525A32F9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7407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32960" rtl="0" eaLnBrk="1" latinLnBrk="0" hangingPunct="1">
        <a:spcBef>
          <a:spcPct val="0"/>
        </a:spcBef>
        <a:buNone/>
        <a:defRPr sz="304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7360" indent="-237360" algn="l" defTabSz="632960" rtl="0" eaLnBrk="1" latinLnBrk="0" hangingPunct="1">
        <a:spcBef>
          <a:spcPct val="20000"/>
        </a:spcBef>
        <a:buFont typeface="Arial" panose="020B0604020202020204" pitchFamily="34" charset="0"/>
        <a:buChar char="•"/>
        <a:defRPr sz="2215" kern="1200">
          <a:solidFill>
            <a:schemeClr val="tx1"/>
          </a:solidFill>
          <a:latin typeface="+mn-lt"/>
          <a:ea typeface="+mn-ea"/>
          <a:cs typeface="+mn-cs"/>
        </a:defRPr>
      </a:lvl1pPr>
      <a:lvl2pPr marL="514279" indent="-197798" algn="l" defTabSz="632960" rtl="0" eaLnBrk="1" latinLnBrk="0" hangingPunct="1">
        <a:spcBef>
          <a:spcPct val="20000"/>
        </a:spcBef>
        <a:buFont typeface="Arial" panose="020B0604020202020204" pitchFamily="34" charset="0"/>
        <a:buChar char="–"/>
        <a:defRPr sz="1938" kern="1200">
          <a:solidFill>
            <a:schemeClr val="tx1"/>
          </a:solidFill>
          <a:latin typeface="+mn-lt"/>
          <a:ea typeface="+mn-ea"/>
          <a:cs typeface="+mn-cs"/>
        </a:defRPr>
      </a:lvl2pPr>
      <a:lvl3pPr marL="791200" indent="-158240" algn="l" defTabSz="632960" rtl="0" eaLnBrk="1" latinLnBrk="0" hangingPunct="1">
        <a:spcBef>
          <a:spcPct val="20000"/>
        </a:spcBef>
        <a:buFont typeface="Arial" panose="020B0604020202020204" pitchFamily="34" charset="0"/>
        <a:buChar char="•"/>
        <a:defRPr sz="1662" kern="1200">
          <a:solidFill>
            <a:schemeClr val="tx1"/>
          </a:solidFill>
          <a:latin typeface="+mn-lt"/>
          <a:ea typeface="+mn-ea"/>
          <a:cs typeface="+mn-cs"/>
        </a:defRPr>
      </a:lvl3pPr>
      <a:lvl4pPr marL="1107678" indent="-158240" algn="l" defTabSz="632960" rtl="0" eaLnBrk="1" latinLnBrk="0" hangingPunct="1">
        <a:spcBef>
          <a:spcPct val="20000"/>
        </a:spcBef>
        <a:buFont typeface="Arial" panose="020B0604020202020204" pitchFamily="34" charset="0"/>
        <a:buChar char="–"/>
        <a:defRPr sz="1385" kern="1200">
          <a:solidFill>
            <a:schemeClr val="tx1"/>
          </a:solidFill>
          <a:latin typeface="+mn-lt"/>
          <a:ea typeface="+mn-ea"/>
          <a:cs typeface="+mn-cs"/>
        </a:defRPr>
      </a:lvl4pPr>
      <a:lvl5pPr marL="1424158" indent="-158240" algn="l" defTabSz="632960" rtl="0" eaLnBrk="1" latinLnBrk="0" hangingPunct="1">
        <a:spcBef>
          <a:spcPct val="20000"/>
        </a:spcBef>
        <a:buFont typeface="Arial" panose="020B0604020202020204" pitchFamily="34" charset="0"/>
        <a:buChar char="»"/>
        <a:defRPr sz="1385" kern="1200">
          <a:solidFill>
            <a:schemeClr val="tx1"/>
          </a:solidFill>
          <a:latin typeface="+mn-lt"/>
          <a:ea typeface="+mn-ea"/>
          <a:cs typeface="+mn-cs"/>
        </a:defRPr>
      </a:lvl5pPr>
      <a:lvl6pPr marL="1740639" indent="-158240" algn="l" defTabSz="632960" rtl="0" eaLnBrk="1" latinLnBrk="0" hangingPunct="1">
        <a:spcBef>
          <a:spcPct val="20000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6pPr>
      <a:lvl7pPr marL="2057119" indent="-158240" algn="l" defTabSz="632960" rtl="0" eaLnBrk="1" latinLnBrk="0" hangingPunct="1">
        <a:spcBef>
          <a:spcPct val="20000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7pPr>
      <a:lvl8pPr marL="2373600" indent="-158240" algn="l" defTabSz="632960" rtl="0" eaLnBrk="1" latinLnBrk="0" hangingPunct="1">
        <a:spcBef>
          <a:spcPct val="20000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8pPr>
      <a:lvl9pPr marL="2690078" indent="-158240" algn="l" defTabSz="632960" rtl="0" eaLnBrk="1" latinLnBrk="0" hangingPunct="1">
        <a:spcBef>
          <a:spcPct val="20000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2960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1pPr>
      <a:lvl2pPr marL="316479" algn="l" defTabSz="632960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2pPr>
      <a:lvl3pPr marL="632960" algn="l" defTabSz="632960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3pPr>
      <a:lvl4pPr marL="949439" algn="l" defTabSz="632960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4pPr>
      <a:lvl5pPr marL="1265919" algn="l" defTabSz="632960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5pPr>
      <a:lvl6pPr marL="1582400" algn="l" defTabSz="632960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6pPr>
      <a:lvl7pPr marL="1898879" algn="l" defTabSz="632960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7pPr>
      <a:lvl8pPr marL="2215358" algn="l" defTabSz="632960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8pPr>
      <a:lvl9pPr marL="2531838" algn="l" defTabSz="632960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9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6.xml"/><Relationship Id="rId3" Type="http://schemas.openxmlformats.org/officeDocument/2006/relationships/chart" Target="../charts/chart11.xml"/><Relationship Id="rId7" Type="http://schemas.openxmlformats.org/officeDocument/2006/relationships/chart" Target="../charts/chart15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4.xml"/><Relationship Id="rId5" Type="http://schemas.openxmlformats.org/officeDocument/2006/relationships/chart" Target="../charts/chart13.xml"/><Relationship Id="rId4" Type="http://schemas.openxmlformats.org/officeDocument/2006/relationships/chart" Target="../charts/chart12.xml"/><Relationship Id="rId9" Type="http://schemas.openxmlformats.org/officeDocument/2006/relationships/chart" Target="../charts/chart1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4.xml"/><Relationship Id="rId3" Type="http://schemas.openxmlformats.org/officeDocument/2006/relationships/chart" Target="../charts/chart19.xml"/><Relationship Id="rId7" Type="http://schemas.openxmlformats.org/officeDocument/2006/relationships/chart" Target="../charts/chart23.xml"/><Relationship Id="rId2" Type="http://schemas.openxmlformats.org/officeDocument/2006/relationships/chart" Target="../charts/chart18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2.xml"/><Relationship Id="rId5" Type="http://schemas.openxmlformats.org/officeDocument/2006/relationships/chart" Target="../charts/chart21.xml"/><Relationship Id="rId4" Type="http://schemas.openxmlformats.org/officeDocument/2006/relationships/chart" Target="../charts/chart20.xml"/><Relationship Id="rId9" Type="http://schemas.openxmlformats.org/officeDocument/2006/relationships/chart" Target="../charts/chart25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2.xml"/><Relationship Id="rId3" Type="http://schemas.openxmlformats.org/officeDocument/2006/relationships/chart" Target="../charts/chart27.xml"/><Relationship Id="rId7" Type="http://schemas.openxmlformats.org/officeDocument/2006/relationships/chart" Target="../charts/chart31.xml"/><Relationship Id="rId2" Type="http://schemas.openxmlformats.org/officeDocument/2006/relationships/chart" Target="../charts/chart26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30.xml"/><Relationship Id="rId5" Type="http://schemas.openxmlformats.org/officeDocument/2006/relationships/chart" Target="../charts/chart29.xml"/><Relationship Id="rId4" Type="http://schemas.openxmlformats.org/officeDocument/2006/relationships/chart" Target="../charts/chart28.xml"/><Relationship Id="rId9" Type="http://schemas.openxmlformats.org/officeDocument/2006/relationships/chart" Target="../charts/chart33.xml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14/relationships/chartEx" Target="../charts/chartEx4.xml"/><Relationship Id="rId13" Type="http://schemas.openxmlformats.org/officeDocument/2006/relationships/image" Target="../media/image6.png"/><Relationship Id="rId18" Type="http://schemas.microsoft.com/office/2014/relationships/chartEx" Target="../charts/chartEx9.xml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microsoft.com/office/2014/relationships/chartEx" Target="../charts/chartEx6.xml"/><Relationship Id="rId17" Type="http://schemas.openxmlformats.org/officeDocument/2006/relationships/image" Target="../media/image8.png"/><Relationship Id="rId2" Type="http://schemas.microsoft.com/office/2014/relationships/chartEx" Target="../charts/chartEx1.xml"/><Relationship Id="rId16" Type="http://schemas.microsoft.com/office/2014/relationships/chartEx" Target="../charts/chartEx8.xml"/><Relationship Id="rId1" Type="http://schemas.openxmlformats.org/officeDocument/2006/relationships/slideLayout" Target="../slideLayouts/slideLayout2.xml"/><Relationship Id="rId6" Type="http://schemas.microsoft.com/office/2014/relationships/chartEx" Target="../charts/chartEx3.xml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10" Type="http://schemas.microsoft.com/office/2014/relationships/chartEx" Target="../charts/chartEx5.xml"/><Relationship Id="rId19" Type="http://schemas.openxmlformats.org/officeDocument/2006/relationships/image" Target="../media/image9.png"/><Relationship Id="rId4" Type="http://schemas.microsoft.com/office/2014/relationships/chartEx" Target="../charts/chartEx2.xml"/><Relationship Id="rId9" Type="http://schemas.openxmlformats.org/officeDocument/2006/relationships/image" Target="../media/image4.png"/><Relationship Id="rId14" Type="http://schemas.microsoft.com/office/2014/relationships/chartEx" Target="../charts/chartEx7.xml"/></Relationships>
</file>

<file path=ppt/slides/_rels/slide7.xml.rels><?xml version="1.0" encoding="UTF-8" standalone="yes"?>
<Relationships xmlns="http://schemas.openxmlformats.org/package/2006/relationships"><Relationship Id="rId8" Type="http://schemas.microsoft.com/office/2014/relationships/chartEx" Target="../charts/chartEx13.xml"/><Relationship Id="rId13" Type="http://schemas.openxmlformats.org/officeDocument/2006/relationships/image" Target="../media/image15.png"/><Relationship Id="rId18" Type="http://schemas.microsoft.com/office/2014/relationships/chartEx" Target="../charts/chartEx18.xml"/><Relationship Id="rId3" Type="http://schemas.openxmlformats.org/officeDocument/2006/relationships/image" Target="../media/image10.png"/><Relationship Id="rId21" Type="http://schemas.openxmlformats.org/officeDocument/2006/relationships/image" Target="../media/image19.png"/><Relationship Id="rId7" Type="http://schemas.openxmlformats.org/officeDocument/2006/relationships/image" Target="../media/image12.png"/><Relationship Id="rId12" Type="http://schemas.microsoft.com/office/2014/relationships/chartEx" Target="../charts/chartEx15.xml"/><Relationship Id="rId17" Type="http://schemas.openxmlformats.org/officeDocument/2006/relationships/image" Target="../media/image17.png"/><Relationship Id="rId2" Type="http://schemas.microsoft.com/office/2014/relationships/chartEx" Target="../charts/chartEx10.xml"/><Relationship Id="rId16" Type="http://schemas.microsoft.com/office/2014/relationships/chartEx" Target="../charts/chartEx17.xml"/><Relationship Id="rId20" Type="http://schemas.microsoft.com/office/2014/relationships/chartEx" Target="../charts/chartEx19.xml"/><Relationship Id="rId1" Type="http://schemas.openxmlformats.org/officeDocument/2006/relationships/slideLayout" Target="../slideLayouts/slideLayout2.xml"/><Relationship Id="rId6" Type="http://schemas.microsoft.com/office/2014/relationships/chartEx" Target="../charts/chartEx12.xml"/><Relationship Id="rId11" Type="http://schemas.openxmlformats.org/officeDocument/2006/relationships/image" Target="../media/image14.png"/><Relationship Id="rId5" Type="http://schemas.openxmlformats.org/officeDocument/2006/relationships/image" Target="../media/image11.png"/><Relationship Id="rId15" Type="http://schemas.openxmlformats.org/officeDocument/2006/relationships/image" Target="../media/image16.png"/><Relationship Id="rId23" Type="http://schemas.openxmlformats.org/officeDocument/2006/relationships/image" Target="../media/image20.png"/><Relationship Id="rId10" Type="http://schemas.microsoft.com/office/2014/relationships/chartEx" Target="../charts/chartEx14.xml"/><Relationship Id="rId19" Type="http://schemas.openxmlformats.org/officeDocument/2006/relationships/image" Target="../media/image18.png"/><Relationship Id="rId4" Type="http://schemas.microsoft.com/office/2014/relationships/chartEx" Target="../charts/chartEx11.xml"/><Relationship Id="rId9" Type="http://schemas.openxmlformats.org/officeDocument/2006/relationships/image" Target="../media/image13.png"/><Relationship Id="rId14" Type="http://schemas.microsoft.com/office/2014/relationships/chartEx" Target="../charts/chartEx16.xml"/><Relationship Id="rId22" Type="http://schemas.microsoft.com/office/2014/relationships/chartEx" Target="../charts/chartEx2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テキスト ボックス 59"/>
          <p:cNvSpPr txBox="1"/>
          <p:nvPr/>
        </p:nvSpPr>
        <p:spPr>
          <a:xfrm>
            <a:off x="1036320" y="4427321"/>
            <a:ext cx="858700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odness-of-fit plots of final population pharmacokinetic model of oxaliplatin (L-OHP).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n predictions (PRED) vs observations (OBS), individual predictions (IPRED) vs OBS, conditional weighed residuals (CWRES) vs time, and CWRES vs IPRED.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3" name="グラフ 8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0084536"/>
              </p:ext>
            </p:extLst>
          </p:nvPr>
        </p:nvGraphicFramePr>
        <p:xfrm>
          <a:off x="1417593" y="1518920"/>
          <a:ext cx="180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2" name="グラフ 9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13872524"/>
              </p:ext>
            </p:extLst>
          </p:nvPr>
        </p:nvGraphicFramePr>
        <p:xfrm>
          <a:off x="3385036" y="1518920"/>
          <a:ext cx="180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5" name="グラフ 9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71029236"/>
              </p:ext>
            </p:extLst>
          </p:nvPr>
        </p:nvGraphicFramePr>
        <p:xfrm>
          <a:off x="5474400" y="1524000"/>
          <a:ext cx="1548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0" name="グラフ 9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0891902"/>
              </p:ext>
            </p:extLst>
          </p:nvPr>
        </p:nvGraphicFramePr>
        <p:xfrm>
          <a:off x="7362564" y="1539240"/>
          <a:ext cx="162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02" name="テキスト ボックス 101"/>
          <p:cNvSpPr txBox="1"/>
          <p:nvPr/>
        </p:nvSpPr>
        <p:spPr>
          <a:xfrm rot="16200000">
            <a:off x="816547" y="2254255"/>
            <a:ext cx="10631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BS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l-GR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</a:p>
        </p:txBody>
      </p:sp>
      <p:sp>
        <p:nvSpPr>
          <p:cNvPr id="104" name="テキスト ボックス 103"/>
          <p:cNvSpPr txBox="1"/>
          <p:nvPr/>
        </p:nvSpPr>
        <p:spPr>
          <a:xfrm>
            <a:off x="1907238" y="3437630"/>
            <a:ext cx="11592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RE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l-GR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</a:p>
        </p:txBody>
      </p:sp>
      <p:sp>
        <p:nvSpPr>
          <p:cNvPr id="105" name="テキスト ボックス 104"/>
          <p:cNvSpPr txBox="1"/>
          <p:nvPr/>
        </p:nvSpPr>
        <p:spPr>
          <a:xfrm rot="16200000">
            <a:off x="2804319" y="2254255"/>
            <a:ext cx="10631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BS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l-GR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</a:p>
        </p:txBody>
      </p:sp>
      <p:sp>
        <p:nvSpPr>
          <p:cNvPr id="110" name="テキスト ボックス 109"/>
          <p:cNvSpPr txBox="1"/>
          <p:nvPr/>
        </p:nvSpPr>
        <p:spPr>
          <a:xfrm>
            <a:off x="3934534" y="3437630"/>
            <a:ext cx="11977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PRE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l-GR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</a:p>
        </p:txBody>
      </p:sp>
      <p:sp>
        <p:nvSpPr>
          <p:cNvPr id="115" name="テキスト ボックス 114"/>
          <p:cNvSpPr txBox="1"/>
          <p:nvPr/>
        </p:nvSpPr>
        <p:spPr>
          <a:xfrm rot="16200000">
            <a:off x="4707035" y="2254253"/>
            <a:ext cx="12923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WRES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l-GR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</a:p>
        </p:txBody>
      </p:sp>
      <p:sp>
        <p:nvSpPr>
          <p:cNvPr id="122" name="テキスト ボックス 121"/>
          <p:cNvSpPr txBox="1"/>
          <p:nvPr/>
        </p:nvSpPr>
        <p:spPr>
          <a:xfrm>
            <a:off x="5981319" y="3437400"/>
            <a:ext cx="7633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</a:p>
        </p:txBody>
      </p:sp>
      <p:sp>
        <p:nvSpPr>
          <p:cNvPr id="123" name="テキスト ボックス 122"/>
          <p:cNvSpPr txBox="1"/>
          <p:nvPr/>
        </p:nvSpPr>
        <p:spPr>
          <a:xfrm rot="16200000">
            <a:off x="6541231" y="2254253"/>
            <a:ext cx="12923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WRES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l-GR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</a:p>
        </p:txBody>
      </p:sp>
      <p:sp>
        <p:nvSpPr>
          <p:cNvPr id="125" name="テキスト ボックス 124"/>
          <p:cNvSpPr txBox="1"/>
          <p:nvPr/>
        </p:nvSpPr>
        <p:spPr>
          <a:xfrm>
            <a:off x="7640294" y="3437400"/>
            <a:ext cx="11977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PRE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l-GR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</a:p>
        </p:txBody>
      </p:sp>
    </p:spTree>
    <p:extLst>
      <p:ext uri="{BB962C8B-B14F-4D97-AF65-F5344CB8AC3E}">
        <p14:creationId xmlns:p14="http://schemas.microsoft.com/office/powerpoint/2010/main" val="34416504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1C96D059-2886-4682-B288-A757808071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3431411"/>
              </p:ext>
            </p:extLst>
          </p:nvPr>
        </p:nvGraphicFramePr>
        <p:xfrm>
          <a:off x="4193394" y="885979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1CA262B-DC7E-43BA-9BD0-11439232AA66}"/>
              </a:ext>
            </a:extLst>
          </p:cNvPr>
          <p:cNvSpPr txBox="1"/>
          <p:nvPr/>
        </p:nvSpPr>
        <p:spPr>
          <a:xfrm>
            <a:off x="239654" y="66401"/>
            <a:ext cx="1992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cute neuropathy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BA1DE8F-B249-45FC-AAA0-42B64684FD2B}"/>
              </a:ext>
            </a:extLst>
          </p:cNvPr>
          <p:cNvSpPr txBox="1"/>
          <p:nvPr/>
        </p:nvSpPr>
        <p:spPr>
          <a:xfrm>
            <a:off x="787053" y="416798"/>
            <a:ext cx="2993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ontrol group data analysis</a:t>
            </a:r>
          </a:p>
        </p:txBody>
      </p:sp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75695B95-B352-404B-91EF-B8D8BFA2B6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43700234"/>
              </p:ext>
            </p:extLst>
          </p:nvPr>
        </p:nvGraphicFramePr>
        <p:xfrm>
          <a:off x="914400" y="3424310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4F53F027-7924-4095-AB03-CAA174B6611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3591169"/>
              </p:ext>
            </p:extLst>
          </p:nvPr>
        </p:nvGraphicFramePr>
        <p:xfrm>
          <a:off x="3056525" y="3424310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851E96AC-BC46-4B49-8483-340CFEDD99B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04501001"/>
              </p:ext>
            </p:extLst>
          </p:nvPr>
        </p:nvGraphicFramePr>
        <p:xfrm>
          <a:off x="5198650" y="3424310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F0C2B4A1-48AC-4B71-AAE1-7684F4D49A5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1434252"/>
              </p:ext>
            </p:extLst>
          </p:nvPr>
        </p:nvGraphicFramePr>
        <p:xfrm>
          <a:off x="7340774" y="3424310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B25AC70-7139-4370-8A87-DD36DE62BDAF}"/>
              </a:ext>
            </a:extLst>
          </p:cNvPr>
          <p:cNvSpPr txBox="1"/>
          <p:nvPr/>
        </p:nvSpPr>
        <p:spPr>
          <a:xfrm>
            <a:off x="787053" y="2895600"/>
            <a:ext cx="16979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dditive model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686B3D0-05F9-4E48-BCFA-797EA92FA08E}"/>
              </a:ext>
            </a:extLst>
          </p:cNvPr>
          <p:cNvSpPr txBox="1"/>
          <p:nvPr/>
        </p:nvSpPr>
        <p:spPr>
          <a:xfrm>
            <a:off x="867802" y="5836425"/>
            <a:ext cx="8587007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tt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sults of preliminary developed toxicodynamic (TD) model of oxaliplatin (L-OHP) for acute neuropathy. Each circle represents the observed data and solid line represent population fits. The model equations and obtained TD parameters are shown in Table S1.</a:t>
            </a:r>
          </a:p>
          <a:p>
            <a:pPr algn="just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429ACD2-DC82-4A72-8708-12273F4FBAE8}"/>
              </a:ext>
            </a:extLst>
          </p:cNvPr>
          <p:cNvSpPr txBox="1"/>
          <p:nvPr/>
        </p:nvSpPr>
        <p:spPr>
          <a:xfrm rot="16200000">
            <a:off x="2725718" y="1594139"/>
            <a:ext cx="229421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 of paw withdrawal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responses (times)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6ABCBEC-647C-4D80-91FB-B289AAFA26AF}"/>
              </a:ext>
            </a:extLst>
          </p:cNvPr>
          <p:cNvSpPr txBox="1"/>
          <p:nvPr/>
        </p:nvSpPr>
        <p:spPr>
          <a:xfrm>
            <a:off x="4788152" y="2699689"/>
            <a:ext cx="10323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day)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250FD59-4300-4D5E-866F-D3A8143525B5}"/>
              </a:ext>
            </a:extLst>
          </p:cNvPr>
          <p:cNvSpPr txBox="1"/>
          <p:nvPr/>
        </p:nvSpPr>
        <p:spPr>
          <a:xfrm rot="16200000">
            <a:off x="-563951" y="3965765"/>
            <a:ext cx="229421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 of paw withdrawal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responses (times)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2A75D65-F904-4598-886A-8212A004E7E8}"/>
              </a:ext>
            </a:extLst>
          </p:cNvPr>
          <p:cNvSpPr txBox="1"/>
          <p:nvPr/>
        </p:nvSpPr>
        <p:spPr>
          <a:xfrm>
            <a:off x="4785201" y="5324159"/>
            <a:ext cx="10323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day)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33195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1CA262B-DC7E-43BA-9BD0-11439232AA66}"/>
              </a:ext>
            </a:extLst>
          </p:cNvPr>
          <p:cNvSpPr txBox="1"/>
          <p:nvPr/>
        </p:nvSpPr>
        <p:spPr>
          <a:xfrm>
            <a:off x="239654" y="66401"/>
            <a:ext cx="2198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hronic neuropathy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BA1DE8F-B249-45FC-AAA0-42B64684FD2B}"/>
              </a:ext>
            </a:extLst>
          </p:cNvPr>
          <p:cNvSpPr txBox="1"/>
          <p:nvPr/>
        </p:nvSpPr>
        <p:spPr>
          <a:xfrm>
            <a:off x="100226" y="483672"/>
            <a:ext cx="144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asic model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686B3D0-05F9-4E48-BCFA-797EA92FA08E}"/>
              </a:ext>
            </a:extLst>
          </p:cNvPr>
          <p:cNvSpPr txBox="1"/>
          <p:nvPr/>
        </p:nvSpPr>
        <p:spPr>
          <a:xfrm>
            <a:off x="867802" y="5562600"/>
            <a:ext cx="8587007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tted results of preliminary developed toxicodynamic (TD) model of oxaliplatin (L-OHP) for chronic neuropathy. Each circle represents the observed data and solid line represent population fits. The obtained TD parameters are shown in Table S2.</a:t>
            </a:r>
          </a:p>
          <a:p>
            <a:pPr algn="just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125493D9-C3EC-41D5-8FA5-E68C62D9E3B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6629594"/>
              </p:ext>
            </p:extLst>
          </p:nvPr>
        </p:nvGraphicFramePr>
        <p:xfrm>
          <a:off x="1139956" y="853004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1A72A2D0-9E14-4BBF-BFC3-5797B62433C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1038372"/>
              </p:ext>
            </p:extLst>
          </p:nvPr>
        </p:nvGraphicFramePr>
        <p:xfrm>
          <a:off x="3215628" y="853004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9" name="グラフ 18">
            <a:extLst>
              <a:ext uri="{FF2B5EF4-FFF2-40B4-BE49-F238E27FC236}">
                <a16:creationId xmlns:a16="http://schemas.microsoft.com/office/drawing/2014/main" id="{F5709207-0B5D-4314-973C-B3C98382222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849366"/>
              </p:ext>
            </p:extLst>
          </p:nvPr>
        </p:nvGraphicFramePr>
        <p:xfrm>
          <a:off x="5291300" y="853004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0" name="グラフ 19">
            <a:extLst>
              <a:ext uri="{FF2B5EF4-FFF2-40B4-BE49-F238E27FC236}">
                <a16:creationId xmlns:a16="http://schemas.microsoft.com/office/drawing/2014/main" id="{CF138D75-819C-4A88-B485-30C3FA3F805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8073698"/>
              </p:ext>
            </p:extLst>
          </p:nvPr>
        </p:nvGraphicFramePr>
        <p:xfrm>
          <a:off x="7366972" y="853004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1" name="グラフ 20">
            <a:extLst>
              <a:ext uri="{FF2B5EF4-FFF2-40B4-BE49-F238E27FC236}">
                <a16:creationId xmlns:a16="http://schemas.microsoft.com/office/drawing/2014/main" id="{6B04E0CD-A49F-4970-8991-82987269CA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2971765"/>
              </p:ext>
            </p:extLst>
          </p:nvPr>
        </p:nvGraphicFramePr>
        <p:xfrm>
          <a:off x="1139956" y="3235096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2" name="グラフ 21">
            <a:extLst>
              <a:ext uri="{FF2B5EF4-FFF2-40B4-BE49-F238E27FC236}">
                <a16:creationId xmlns:a16="http://schemas.microsoft.com/office/drawing/2014/main" id="{2FA30619-F1B4-432A-9E52-E86825DA068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41854763"/>
              </p:ext>
            </p:extLst>
          </p:nvPr>
        </p:nvGraphicFramePr>
        <p:xfrm>
          <a:off x="3215628" y="3235096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3" name="グラフ 22">
            <a:extLst>
              <a:ext uri="{FF2B5EF4-FFF2-40B4-BE49-F238E27FC236}">
                <a16:creationId xmlns:a16="http://schemas.microsoft.com/office/drawing/2014/main" id="{3C60EB6A-D26D-4C2E-B822-8488FE3FC15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936334"/>
              </p:ext>
            </p:extLst>
          </p:nvPr>
        </p:nvGraphicFramePr>
        <p:xfrm>
          <a:off x="5291300" y="3235096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4" name="グラフ 23">
            <a:extLst>
              <a:ext uri="{FF2B5EF4-FFF2-40B4-BE49-F238E27FC236}">
                <a16:creationId xmlns:a16="http://schemas.microsoft.com/office/drawing/2014/main" id="{BCE8598C-67CB-487B-AAA2-49FF09B0841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8821755"/>
              </p:ext>
            </p:extLst>
          </p:nvPr>
        </p:nvGraphicFramePr>
        <p:xfrm>
          <a:off x="7366972" y="3235096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F2B9018-87C9-4BE0-945F-C1F27BD81777}"/>
              </a:ext>
            </a:extLst>
          </p:cNvPr>
          <p:cNvSpPr txBox="1"/>
          <p:nvPr/>
        </p:nvSpPr>
        <p:spPr>
          <a:xfrm>
            <a:off x="1828800" y="608111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2E54796F-F2D0-4CC1-AEF2-1A8B5EA2331A}"/>
              </a:ext>
            </a:extLst>
          </p:cNvPr>
          <p:cNvSpPr txBox="1"/>
          <p:nvPr/>
        </p:nvSpPr>
        <p:spPr>
          <a:xfrm>
            <a:off x="3916741" y="608111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 mg/kg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A4543FE7-479C-4A6C-87F2-85A5796DCCFC}"/>
              </a:ext>
            </a:extLst>
          </p:cNvPr>
          <p:cNvSpPr txBox="1"/>
          <p:nvPr/>
        </p:nvSpPr>
        <p:spPr>
          <a:xfrm>
            <a:off x="5929341" y="608111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 mg/kg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AD20A7C6-BC1A-44F1-9DD3-12876DC612F6}"/>
              </a:ext>
            </a:extLst>
          </p:cNvPr>
          <p:cNvSpPr txBox="1"/>
          <p:nvPr/>
        </p:nvSpPr>
        <p:spPr>
          <a:xfrm>
            <a:off x="7941941" y="608111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8 mg/kg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A3EF4FD6-C68C-47F3-862E-EBE71691FE3A}"/>
              </a:ext>
            </a:extLst>
          </p:cNvPr>
          <p:cNvSpPr txBox="1"/>
          <p:nvPr/>
        </p:nvSpPr>
        <p:spPr>
          <a:xfrm>
            <a:off x="100226" y="2774319"/>
            <a:ext cx="2218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gmoid E</a:t>
            </a:r>
            <a:r>
              <a:rPr kumimoji="1" lang="en-US" altLang="ja-JP" baseline="-25000" dirty="0">
                <a:latin typeface="Arial" panose="020B0604020202020204" pitchFamily="34" charset="0"/>
                <a:cs typeface="Arial" panose="020B0604020202020204" pitchFamily="34" charset="0"/>
              </a:rPr>
              <a:t>max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model</a:t>
            </a: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F5FC2F49-851B-4A63-BA8A-A639319DD01E}"/>
              </a:ext>
            </a:extLst>
          </p:cNvPr>
          <p:cNvSpPr txBox="1"/>
          <p:nvPr/>
        </p:nvSpPr>
        <p:spPr>
          <a:xfrm rot="16200000">
            <a:off x="55588" y="1392108"/>
            <a:ext cx="147989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w withdrawal 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hreshold (g)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B885477C-6B30-4C08-B03C-719FB6BBDBF2}"/>
              </a:ext>
            </a:extLst>
          </p:cNvPr>
          <p:cNvSpPr txBox="1"/>
          <p:nvPr/>
        </p:nvSpPr>
        <p:spPr>
          <a:xfrm rot="16200000">
            <a:off x="55589" y="3753450"/>
            <a:ext cx="147989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w withdrawal 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hreshold (g)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DAC6B3A5-8196-4684-941B-30A31913AE8E}"/>
              </a:ext>
            </a:extLst>
          </p:cNvPr>
          <p:cNvSpPr txBox="1"/>
          <p:nvPr/>
        </p:nvSpPr>
        <p:spPr>
          <a:xfrm>
            <a:off x="4785201" y="5102423"/>
            <a:ext cx="10323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day)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13E6421-33DE-4BEF-8EDE-EAA7287CD5A2}"/>
              </a:ext>
            </a:extLst>
          </p:cNvPr>
          <p:cNvSpPr txBox="1"/>
          <p:nvPr/>
        </p:nvSpPr>
        <p:spPr>
          <a:xfrm>
            <a:off x="4789025" y="2664023"/>
            <a:ext cx="10323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day)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10399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BA1DE8F-B249-45FC-AAA0-42B64684FD2B}"/>
              </a:ext>
            </a:extLst>
          </p:cNvPr>
          <p:cNvSpPr txBox="1"/>
          <p:nvPr/>
        </p:nvSpPr>
        <p:spPr>
          <a:xfrm>
            <a:off x="100226" y="39469"/>
            <a:ext cx="39100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ransit model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Number of transit compartment = 1)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686B3D0-05F9-4E48-BCFA-797EA92FA08E}"/>
              </a:ext>
            </a:extLst>
          </p:cNvPr>
          <p:cNvSpPr txBox="1"/>
          <p:nvPr/>
        </p:nvSpPr>
        <p:spPr>
          <a:xfrm>
            <a:off x="867802" y="5562600"/>
            <a:ext cx="858700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nue.</a:t>
            </a:r>
          </a:p>
          <a:p>
            <a:pPr algn="just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F2B9018-87C9-4BE0-945F-C1F27BD81777}"/>
              </a:ext>
            </a:extLst>
          </p:cNvPr>
          <p:cNvSpPr txBox="1"/>
          <p:nvPr/>
        </p:nvSpPr>
        <p:spPr>
          <a:xfrm>
            <a:off x="1828800" y="608111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2E54796F-F2D0-4CC1-AEF2-1A8B5EA2331A}"/>
              </a:ext>
            </a:extLst>
          </p:cNvPr>
          <p:cNvSpPr txBox="1"/>
          <p:nvPr/>
        </p:nvSpPr>
        <p:spPr>
          <a:xfrm>
            <a:off x="3916741" y="608111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 mg/kg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A4543FE7-479C-4A6C-87F2-85A5796DCCFC}"/>
              </a:ext>
            </a:extLst>
          </p:cNvPr>
          <p:cNvSpPr txBox="1"/>
          <p:nvPr/>
        </p:nvSpPr>
        <p:spPr>
          <a:xfrm>
            <a:off x="5929341" y="608111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 mg/kg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AD20A7C6-BC1A-44F1-9DD3-12876DC612F6}"/>
              </a:ext>
            </a:extLst>
          </p:cNvPr>
          <p:cNvSpPr txBox="1"/>
          <p:nvPr/>
        </p:nvSpPr>
        <p:spPr>
          <a:xfrm>
            <a:off x="7941941" y="608111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8 mg/kg</a:t>
            </a: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F5FC2F49-851B-4A63-BA8A-A639319DD01E}"/>
              </a:ext>
            </a:extLst>
          </p:cNvPr>
          <p:cNvSpPr txBox="1"/>
          <p:nvPr/>
        </p:nvSpPr>
        <p:spPr>
          <a:xfrm rot="16200000">
            <a:off x="55588" y="1392108"/>
            <a:ext cx="147989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w withdrawal 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hreshold (g)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B885477C-6B30-4C08-B03C-719FB6BBDBF2}"/>
              </a:ext>
            </a:extLst>
          </p:cNvPr>
          <p:cNvSpPr txBox="1"/>
          <p:nvPr/>
        </p:nvSpPr>
        <p:spPr>
          <a:xfrm rot="16200000">
            <a:off x="55589" y="3753450"/>
            <a:ext cx="147989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w withdrawal 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hreshold (g)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DAC6B3A5-8196-4684-941B-30A31913AE8E}"/>
              </a:ext>
            </a:extLst>
          </p:cNvPr>
          <p:cNvSpPr txBox="1"/>
          <p:nvPr/>
        </p:nvSpPr>
        <p:spPr>
          <a:xfrm>
            <a:off x="4785201" y="5102423"/>
            <a:ext cx="10323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day)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13E6421-33DE-4BEF-8EDE-EAA7287CD5A2}"/>
              </a:ext>
            </a:extLst>
          </p:cNvPr>
          <p:cNvSpPr txBox="1"/>
          <p:nvPr/>
        </p:nvSpPr>
        <p:spPr>
          <a:xfrm>
            <a:off x="4789025" y="2664023"/>
            <a:ext cx="10323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e (day)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5" name="グラフ 24">
            <a:extLst>
              <a:ext uri="{FF2B5EF4-FFF2-40B4-BE49-F238E27FC236}">
                <a16:creationId xmlns:a16="http://schemas.microsoft.com/office/drawing/2014/main" id="{549F9A39-E129-4735-9361-7A2998819C6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1536429"/>
              </p:ext>
            </p:extLst>
          </p:nvPr>
        </p:nvGraphicFramePr>
        <p:xfrm>
          <a:off x="1139956" y="853004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6" name="グラフ 25">
            <a:extLst>
              <a:ext uri="{FF2B5EF4-FFF2-40B4-BE49-F238E27FC236}">
                <a16:creationId xmlns:a16="http://schemas.microsoft.com/office/drawing/2014/main" id="{D2AA1A95-CB59-48AC-B864-BE40283B03D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2689357"/>
              </p:ext>
            </p:extLst>
          </p:nvPr>
        </p:nvGraphicFramePr>
        <p:xfrm>
          <a:off x="3215628" y="853004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7" name="グラフ 26">
            <a:extLst>
              <a:ext uri="{FF2B5EF4-FFF2-40B4-BE49-F238E27FC236}">
                <a16:creationId xmlns:a16="http://schemas.microsoft.com/office/drawing/2014/main" id="{9526D01A-0C99-4BF5-A919-76129B6052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1069242"/>
              </p:ext>
            </p:extLst>
          </p:nvPr>
        </p:nvGraphicFramePr>
        <p:xfrm>
          <a:off x="5291300" y="853004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8" name="グラフ 27">
            <a:extLst>
              <a:ext uri="{FF2B5EF4-FFF2-40B4-BE49-F238E27FC236}">
                <a16:creationId xmlns:a16="http://schemas.microsoft.com/office/drawing/2014/main" id="{F478665C-08F4-4534-9D24-1AF691BBDDA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2740755"/>
              </p:ext>
            </p:extLst>
          </p:nvPr>
        </p:nvGraphicFramePr>
        <p:xfrm>
          <a:off x="7366972" y="853004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9" name="グラフ 28">
            <a:extLst>
              <a:ext uri="{FF2B5EF4-FFF2-40B4-BE49-F238E27FC236}">
                <a16:creationId xmlns:a16="http://schemas.microsoft.com/office/drawing/2014/main" id="{DC92F90D-0957-4CC8-9FA9-2B896FC31F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3750669"/>
              </p:ext>
            </p:extLst>
          </p:nvPr>
        </p:nvGraphicFramePr>
        <p:xfrm>
          <a:off x="1139956" y="3236400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0" name="グラフ 29">
            <a:extLst>
              <a:ext uri="{FF2B5EF4-FFF2-40B4-BE49-F238E27FC236}">
                <a16:creationId xmlns:a16="http://schemas.microsoft.com/office/drawing/2014/main" id="{5805A579-4A84-4858-AF18-720F295C38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23768386"/>
              </p:ext>
            </p:extLst>
          </p:nvPr>
        </p:nvGraphicFramePr>
        <p:xfrm>
          <a:off x="3215628" y="3236400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1" name="グラフ 30">
            <a:extLst>
              <a:ext uri="{FF2B5EF4-FFF2-40B4-BE49-F238E27FC236}">
                <a16:creationId xmlns:a16="http://schemas.microsoft.com/office/drawing/2014/main" id="{B9CC0C7F-2914-4A9E-9198-5DD6F1B6A98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3260426"/>
              </p:ext>
            </p:extLst>
          </p:nvPr>
        </p:nvGraphicFramePr>
        <p:xfrm>
          <a:off x="5291300" y="3236400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32" name="グラフ 31">
            <a:extLst>
              <a:ext uri="{FF2B5EF4-FFF2-40B4-BE49-F238E27FC236}">
                <a16:creationId xmlns:a16="http://schemas.microsoft.com/office/drawing/2014/main" id="{EF863B64-8D4E-4A74-8A92-2BF0626D318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80180387"/>
              </p:ext>
            </p:extLst>
          </p:nvPr>
        </p:nvGraphicFramePr>
        <p:xfrm>
          <a:off x="7366972" y="3236400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FD3ED5D5-4FBB-4DB2-890A-3D7ABBFE9219}"/>
              </a:ext>
            </a:extLst>
          </p:cNvPr>
          <p:cNvSpPr txBox="1"/>
          <p:nvPr/>
        </p:nvSpPr>
        <p:spPr>
          <a:xfrm>
            <a:off x="98075" y="2610391"/>
            <a:ext cx="39100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ransit model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Number of transit compartment = 6)</a:t>
            </a:r>
          </a:p>
        </p:txBody>
      </p:sp>
    </p:spTree>
    <p:extLst>
      <p:ext uri="{BB962C8B-B14F-4D97-AF65-F5344CB8AC3E}">
        <p14:creationId xmlns:p14="http://schemas.microsoft.com/office/powerpoint/2010/main" val="21214945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テキスト ボックス 59"/>
          <p:cNvSpPr txBox="1"/>
          <p:nvPr/>
        </p:nvSpPr>
        <p:spPr>
          <a:xfrm>
            <a:off x="1036320" y="5486400"/>
            <a:ext cx="858700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odness-of-fit plots of final population pharmacokinetic-toxicodynamic model of oxaliplatin (L-OHP).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n predictions (PRED) vs observations (OBS), individual predictions (IPRED) vs OBS, conditional weighed residuals (CWRES) vs time, and CWRES vs IPRED.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テキスト ボックス 101"/>
          <p:cNvSpPr txBox="1"/>
          <p:nvPr/>
        </p:nvSpPr>
        <p:spPr>
          <a:xfrm rot="16200000">
            <a:off x="1228304" y="1344415"/>
            <a:ext cx="10054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BS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times)</a:t>
            </a:r>
          </a:p>
        </p:txBody>
      </p:sp>
      <p:sp>
        <p:nvSpPr>
          <p:cNvPr id="104" name="テキスト ボックス 103"/>
          <p:cNvSpPr txBox="1"/>
          <p:nvPr/>
        </p:nvSpPr>
        <p:spPr>
          <a:xfrm>
            <a:off x="2059303" y="2527790"/>
            <a:ext cx="11015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RE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times)</a:t>
            </a:r>
          </a:p>
        </p:txBody>
      </p:sp>
      <p:sp>
        <p:nvSpPr>
          <p:cNvPr id="105" name="テキスト ボックス 104"/>
          <p:cNvSpPr txBox="1"/>
          <p:nvPr/>
        </p:nvSpPr>
        <p:spPr>
          <a:xfrm rot="16200000">
            <a:off x="3083209" y="1344415"/>
            <a:ext cx="10054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BS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times)</a:t>
            </a:r>
          </a:p>
        </p:txBody>
      </p:sp>
      <p:sp>
        <p:nvSpPr>
          <p:cNvPr id="110" name="テキスト ボックス 109"/>
          <p:cNvSpPr txBox="1"/>
          <p:nvPr/>
        </p:nvSpPr>
        <p:spPr>
          <a:xfrm>
            <a:off x="4060036" y="2527790"/>
            <a:ext cx="114005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PRE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times)</a:t>
            </a:r>
          </a:p>
        </p:txBody>
      </p:sp>
      <p:sp>
        <p:nvSpPr>
          <p:cNvPr id="115" name="テキスト ボックス 114"/>
          <p:cNvSpPr txBox="1"/>
          <p:nvPr/>
        </p:nvSpPr>
        <p:spPr>
          <a:xfrm rot="16200000">
            <a:off x="4997179" y="1344413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WRES</a:t>
            </a:r>
          </a:p>
        </p:txBody>
      </p:sp>
      <p:sp>
        <p:nvSpPr>
          <p:cNvPr id="122" name="テキスト ボックス 121"/>
          <p:cNvSpPr txBox="1"/>
          <p:nvPr/>
        </p:nvSpPr>
        <p:spPr>
          <a:xfrm>
            <a:off x="5981319" y="2527560"/>
            <a:ext cx="9124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day)</a:t>
            </a:r>
          </a:p>
        </p:txBody>
      </p:sp>
      <p:sp>
        <p:nvSpPr>
          <p:cNvPr id="123" name="テキスト ボックス 122"/>
          <p:cNvSpPr txBox="1"/>
          <p:nvPr/>
        </p:nvSpPr>
        <p:spPr>
          <a:xfrm rot="16200000">
            <a:off x="6831375" y="1344413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WRES</a:t>
            </a:r>
          </a:p>
        </p:txBody>
      </p:sp>
      <p:sp>
        <p:nvSpPr>
          <p:cNvPr id="125" name="テキスト ボックス 124"/>
          <p:cNvSpPr txBox="1"/>
          <p:nvPr/>
        </p:nvSpPr>
        <p:spPr>
          <a:xfrm>
            <a:off x="7640294" y="2527560"/>
            <a:ext cx="114005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PRE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times)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734578" y="296853"/>
            <a:ext cx="1992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cute neuropathy</a:t>
            </a:r>
          </a:p>
        </p:txBody>
      </p:sp>
      <p:sp>
        <p:nvSpPr>
          <p:cNvPr id="20" name="テキスト ボックス 19"/>
          <p:cNvSpPr txBox="1"/>
          <p:nvPr/>
        </p:nvSpPr>
        <p:spPr>
          <a:xfrm rot="16200000">
            <a:off x="1361446" y="3829751"/>
            <a:ext cx="7473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BS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280699" y="5042390"/>
            <a:ext cx="84350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RE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</a:p>
        </p:txBody>
      </p:sp>
      <p:sp>
        <p:nvSpPr>
          <p:cNvPr id="22" name="テキスト ボックス 21"/>
          <p:cNvSpPr txBox="1"/>
          <p:nvPr/>
        </p:nvSpPr>
        <p:spPr>
          <a:xfrm rot="16200000">
            <a:off x="3217210" y="3859015"/>
            <a:ext cx="7473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BS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4147227" y="5042390"/>
            <a:ext cx="8819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PRE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</a:p>
        </p:txBody>
      </p:sp>
      <p:sp>
        <p:nvSpPr>
          <p:cNvPr id="24" name="テキスト ボックス 23"/>
          <p:cNvSpPr txBox="1"/>
          <p:nvPr/>
        </p:nvSpPr>
        <p:spPr>
          <a:xfrm rot="16200000">
            <a:off x="5002138" y="3859013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WRES</a:t>
            </a: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5986279" y="5042160"/>
            <a:ext cx="7633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</a:p>
        </p:txBody>
      </p:sp>
      <p:sp>
        <p:nvSpPr>
          <p:cNvPr id="26" name="テキスト ボックス 25"/>
          <p:cNvSpPr txBox="1"/>
          <p:nvPr/>
        </p:nvSpPr>
        <p:spPr>
          <a:xfrm rot="16200000">
            <a:off x="6836335" y="3859013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WRES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7645254" y="5042160"/>
            <a:ext cx="8819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PRED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739538" y="2789400"/>
            <a:ext cx="2198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hronic neuropathy</a:t>
            </a:r>
          </a:p>
        </p:txBody>
      </p:sp>
      <p:graphicFrame>
        <p:nvGraphicFramePr>
          <p:cNvPr id="29" name="グラフ 28">
            <a:extLst>
              <a:ext uri="{FF2B5EF4-FFF2-40B4-BE49-F238E27FC236}">
                <a16:creationId xmlns:a16="http://schemas.microsoft.com/office/drawing/2014/main" id="{00000000-0008-0000-03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9342837"/>
              </p:ext>
            </p:extLst>
          </p:nvPr>
        </p:nvGraphicFramePr>
        <p:xfrm>
          <a:off x="1800000" y="608400"/>
          <a:ext cx="1584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0" name="グラフ 29">
            <a:extLst>
              <a:ext uri="{FF2B5EF4-FFF2-40B4-BE49-F238E27FC236}">
                <a16:creationId xmlns:a16="http://schemas.microsoft.com/office/drawing/2014/main" id="{00000000-0008-0000-0300-000006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9121418"/>
              </p:ext>
            </p:extLst>
          </p:nvPr>
        </p:nvGraphicFramePr>
        <p:xfrm>
          <a:off x="5475600" y="608400"/>
          <a:ext cx="1584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1" name="グラフ 30">
            <a:extLst>
              <a:ext uri="{FF2B5EF4-FFF2-40B4-BE49-F238E27FC236}">
                <a16:creationId xmlns:a16="http://schemas.microsoft.com/office/drawing/2014/main" id="{00000000-0008-0000-0300-000008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98831882"/>
              </p:ext>
            </p:extLst>
          </p:nvPr>
        </p:nvGraphicFramePr>
        <p:xfrm>
          <a:off x="3636000" y="608400"/>
          <a:ext cx="1584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7" name="グラフ 36">
            <a:extLst>
              <a:ext uri="{FF2B5EF4-FFF2-40B4-BE49-F238E27FC236}">
                <a16:creationId xmlns:a16="http://schemas.microsoft.com/office/drawing/2014/main" id="{00000000-0008-0000-0300-000009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12190321"/>
              </p:ext>
            </p:extLst>
          </p:nvPr>
        </p:nvGraphicFramePr>
        <p:xfrm>
          <a:off x="7362000" y="608400"/>
          <a:ext cx="1584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8" name="グラフ 37">
            <a:extLst>
              <a:ext uri="{FF2B5EF4-FFF2-40B4-BE49-F238E27FC236}">
                <a16:creationId xmlns:a16="http://schemas.microsoft.com/office/drawing/2014/main" id="{D2E3A154-436D-4426-92E5-C63455673A3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0883355"/>
              </p:ext>
            </p:extLst>
          </p:nvPr>
        </p:nvGraphicFramePr>
        <p:xfrm>
          <a:off x="1796400" y="3132000"/>
          <a:ext cx="1584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9" name="グラフ 38">
            <a:extLst>
              <a:ext uri="{FF2B5EF4-FFF2-40B4-BE49-F238E27FC236}">
                <a16:creationId xmlns:a16="http://schemas.microsoft.com/office/drawing/2014/main" id="{D4FB1970-E176-4B48-A36E-58EA685B5F2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6225352"/>
              </p:ext>
            </p:extLst>
          </p:nvPr>
        </p:nvGraphicFramePr>
        <p:xfrm>
          <a:off x="5457600" y="3132000"/>
          <a:ext cx="1584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40" name="グラフ 39">
            <a:extLst>
              <a:ext uri="{FF2B5EF4-FFF2-40B4-BE49-F238E27FC236}">
                <a16:creationId xmlns:a16="http://schemas.microsoft.com/office/drawing/2014/main" id="{D5BEB6DC-D147-4D21-BA9C-5A11B62E745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3583761"/>
              </p:ext>
            </p:extLst>
          </p:nvPr>
        </p:nvGraphicFramePr>
        <p:xfrm>
          <a:off x="3639600" y="3132000"/>
          <a:ext cx="1584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41" name="グラフ 40">
            <a:extLst>
              <a:ext uri="{FF2B5EF4-FFF2-40B4-BE49-F238E27FC236}">
                <a16:creationId xmlns:a16="http://schemas.microsoft.com/office/drawing/2014/main" id="{9F35CDDB-FE06-4A9E-9947-DDB0C7B2ED5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2703164"/>
              </p:ext>
            </p:extLst>
          </p:nvPr>
        </p:nvGraphicFramePr>
        <p:xfrm>
          <a:off x="7362000" y="3132000"/>
          <a:ext cx="1584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</p:spTree>
    <p:extLst>
      <p:ext uri="{BB962C8B-B14F-4D97-AF65-F5344CB8AC3E}">
        <p14:creationId xmlns:p14="http://schemas.microsoft.com/office/powerpoint/2010/main" val="33961918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テキスト ボックス 59"/>
          <p:cNvSpPr txBox="1"/>
          <p:nvPr/>
        </p:nvSpPr>
        <p:spPr>
          <a:xfrm>
            <a:off x="937993" y="6177361"/>
            <a:ext cx="858700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5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final pharmacokinetic-toxicodynamic (PK-TD) model parameters obtained by Bootstrap procedure (n =1000). 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63794" y="77433"/>
            <a:ext cx="3121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harmacokinetic parameters</a:t>
            </a: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33" name="グラフ 32">
                <a:extLst>
                  <a:ext uri="{FF2B5EF4-FFF2-40B4-BE49-F238E27FC236}">
                    <a16:creationId xmlns:a16="http://schemas.microsoft.com/office/drawing/2014/main" id="{DE5F6578-09C1-43B0-A9CE-6FFFDCE618D6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3322664"/>
                  </p:ext>
                </p:extLst>
              </p:nvPr>
            </p:nvGraphicFramePr>
            <p:xfrm>
              <a:off x="610545" y="360000"/>
              <a:ext cx="1764000" cy="2954547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33" name="グラフ 32">
                <a:extLst>
                  <a:ext uri="{FF2B5EF4-FFF2-40B4-BE49-F238E27FC236}">
                    <a16:creationId xmlns:a16="http://schemas.microsoft.com/office/drawing/2014/main" id="{DE5F6578-09C1-43B0-A9CE-6FFFDCE618D6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10545" y="360000"/>
                <a:ext cx="1764000" cy="2954547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34" name="グラフ 33">
                <a:extLst>
                  <a:ext uri="{FF2B5EF4-FFF2-40B4-BE49-F238E27FC236}">
                    <a16:creationId xmlns:a16="http://schemas.microsoft.com/office/drawing/2014/main" id="{5595A80C-DFA6-4A89-BBD7-B72F8415C17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698944664"/>
                  </p:ext>
                </p:extLst>
              </p:nvPr>
            </p:nvGraphicFramePr>
            <p:xfrm>
              <a:off x="2294400" y="360000"/>
              <a:ext cx="1764000" cy="27828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4"/>
              </a:graphicData>
            </a:graphic>
          </p:graphicFrame>
        </mc:Choice>
        <mc:Fallback xmlns="">
          <p:pic>
            <p:nvPicPr>
              <p:cNvPr id="34" name="グラフ 33">
                <a:extLst>
                  <a:ext uri="{FF2B5EF4-FFF2-40B4-BE49-F238E27FC236}">
                    <a16:creationId xmlns:a16="http://schemas.microsoft.com/office/drawing/2014/main" id="{5595A80C-DFA6-4A89-BBD7-B72F8415C17C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294400" y="360000"/>
                <a:ext cx="1764000" cy="27828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35" name="グラフ 34">
                <a:extLst>
                  <a:ext uri="{FF2B5EF4-FFF2-40B4-BE49-F238E27FC236}">
                    <a16:creationId xmlns:a16="http://schemas.microsoft.com/office/drawing/2014/main" id="{4C5A076C-CF79-444F-8FE3-B4C02425D3D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699045244"/>
                  </p:ext>
                </p:extLst>
              </p:nvPr>
            </p:nvGraphicFramePr>
            <p:xfrm>
              <a:off x="4058400" y="360000"/>
              <a:ext cx="1764000" cy="27828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6"/>
              </a:graphicData>
            </a:graphic>
          </p:graphicFrame>
        </mc:Choice>
        <mc:Fallback xmlns="">
          <p:pic>
            <p:nvPicPr>
              <p:cNvPr id="35" name="グラフ 34">
                <a:extLst>
                  <a:ext uri="{FF2B5EF4-FFF2-40B4-BE49-F238E27FC236}">
                    <a16:creationId xmlns:a16="http://schemas.microsoft.com/office/drawing/2014/main" id="{4C5A076C-CF79-444F-8FE3-B4C02425D3D0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058400" y="360000"/>
                <a:ext cx="1764000" cy="27828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36" name="グラフ 35">
                <a:extLst>
                  <a:ext uri="{FF2B5EF4-FFF2-40B4-BE49-F238E27FC236}">
                    <a16:creationId xmlns:a16="http://schemas.microsoft.com/office/drawing/2014/main" id="{9C76A36D-6CBE-41BB-80D2-D6E7C069F2EE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37266501"/>
                  </p:ext>
                </p:extLst>
              </p:nvPr>
            </p:nvGraphicFramePr>
            <p:xfrm>
              <a:off x="5750400" y="360000"/>
              <a:ext cx="1764000" cy="28620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8"/>
              </a:graphicData>
            </a:graphic>
          </p:graphicFrame>
        </mc:Choice>
        <mc:Fallback xmlns="">
          <p:pic>
            <p:nvPicPr>
              <p:cNvPr id="36" name="グラフ 35">
                <a:extLst>
                  <a:ext uri="{FF2B5EF4-FFF2-40B4-BE49-F238E27FC236}">
                    <a16:creationId xmlns:a16="http://schemas.microsoft.com/office/drawing/2014/main" id="{9C76A36D-6CBE-41BB-80D2-D6E7C069F2EE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5750400" y="360000"/>
                <a:ext cx="1764000" cy="2862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43" name="グラフ 42">
                <a:extLst>
                  <a:ext uri="{FF2B5EF4-FFF2-40B4-BE49-F238E27FC236}">
                    <a16:creationId xmlns:a16="http://schemas.microsoft.com/office/drawing/2014/main" id="{3782CE6C-867A-4D5E-AB72-AE2D5937F13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556395532"/>
                  </p:ext>
                </p:extLst>
              </p:nvPr>
            </p:nvGraphicFramePr>
            <p:xfrm>
              <a:off x="2933400" y="3204000"/>
              <a:ext cx="1764000" cy="2954547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0"/>
              </a:graphicData>
            </a:graphic>
          </p:graphicFrame>
        </mc:Choice>
        <mc:Fallback xmlns="">
          <p:pic>
            <p:nvPicPr>
              <p:cNvPr id="43" name="グラフ 42">
                <a:extLst>
                  <a:ext uri="{FF2B5EF4-FFF2-40B4-BE49-F238E27FC236}">
                    <a16:creationId xmlns:a16="http://schemas.microsoft.com/office/drawing/2014/main" id="{3782CE6C-867A-4D5E-AB72-AE2D5937F134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2933400" y="3204000"/>
                <a:ext cx="1764000" cy="2954547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44" name="グラフ 43">
                <a:extLst>
                  <a:ext uri="{FF2B5EF4-FFF2-40B4-BE49-F238E27FC236}">
                    <a16:creationId xmlns:a16="http://schemas.microsoft.com/office/drawing/2014/main" id="{796BEA9B-D7F5-457B-A111-951F1BB8B037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20714571"/>
                  </p:ext>
                </p:extLst>
              </p:nvPr>
            </p:nvGraphicFramePr>
            <p:xfrm>
              <a:off x="4697400" y="3203999"/>
              <a:ext cx="1764000" cy="30240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2"/>
              </a:graphicData>
            </a:graphic>
          </p:graphicFrame>
        </mc:Choice>
        <mc:Fallback xmlns="">
          <p:pic>
            <p:nvPicPr>
              <p:cNvPr id="44" name="グラフ 43">
                <a:extLst>
                  <a:ext uri="{FF2B5EF4-FFF2-40B4-BE49-F238E27FC236}">
                    <a16:creationId xmlns:a16="http://schemas.microsoft.com/office/drawing/2014/main" id="{796BEA9B-D7F5-457B-A111-951F1BB8B037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4697400" y="3203999"/>
                <a:ext cx="1764000" cy="3024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45" name="グラフ 44">
                <a:extLst>
                  <a:ext uri="{FF2B5EF4-FFF2-40B4-BE49-F238E27FC236}">
                    <a16:creationId xmlns:a16="http://schemas.microsoft.com/office/drawing/2014/main" id="{C67C2AEA-BB3D-487B-9EE2-29BEB0EEE5C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48489858"/>
                  </p:ext>
                </p:extLst>
              </p:nvPr>
            </p:nvGraphicFramePr>
            <p:xfrm>
              <a:off x="6389400" y="3203999"/>
              <a:ext cx="1764000" cy="30240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4"/>
              </a:graphicData>
            </a:graphic>
          </p:graphicFrame>
        </mc:Choice>
        <mc:Fallback xmlns="">
          <p:pic>
            <p:nvPicPr>
              <p:cNvPr id="45" name="グラフ 44">
                <a:extLst>
                  <a:ext uri="{FF2B5EF4-FFF2-40B4-BE49-F238E27FC236}">
                    <a16:creationId xmlns:a16="http://schemas.microsoft.com/office/drawing/2014/main" id="{C67C2AEA-BB3D-487B-9EE2-29BEB0EEE5C8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6389400" y="3203999"/>
                <a:ext cx="1764000" cy="3024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46" name="グラフ 45">
                <a:extLst>
                  <a:ext uri="{FF2B5EF4-FFF2-40B4-BE49-F238E27FC236}">
                    <a16:creationId xmlns:a16="http://schemas.microsoft.com/office/drawing/2014/main" id="{769C0087-EAAF-48ED-B078-88C3B56FE004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823436466"/>
                  </p:ext>
                </p:extLst>
              </p:nvPr>
            </p:nvGraphicFramePr>
            <p:xfrm>
              <a:off x="1248600" y="3204000"/>
              <a:ext cx="1764000" cy="29556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6"/>
              </a:graphicData>
            </a:graphic>
          </p:graphicFrame>
        </mc:Choice>
        <mc:Fallback xmlns="">
          <p:pic>
            <p:nvPicPr>
              <p:cNvPr id="46" name="グラフ 45">
                <a:extLst>
                  <a:ext uri="{FF2B5EF4-FFF2-40B4-BE49-F238E27FC236}">
                    <a16:creationId xmlns:a16="http://schemas.microsoft.com/office/drawing/2014/main" id="{769C0087-EAAF-48ED-B078-88C3B56FE004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1248600" y="3204000"/>
                <a:ext cx="1764000" cy="29556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47" name="グラフ 46">
                <a:extLst>
                  <a:ext uri="{FF2B5EF4-FFF2-40B4-BE49-F238E27FC236}">
                    <a16:creationId xmlns:a16="http://schemas.microsoft.com/office/drawing/2014/main" id="{507B8502-706C-4AAD-88E5-01CCFAD57B01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906494328"/>
                  </p:ext>
                </p:extLst>
              </p:nvPr>
            </p:nvGraphicFramePr>
            <p:xfrm>
              <a:off x="7514400" y="360000"/>
              <a:ext cx="1764000" cy="29520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8"/>
              </a:graphicData>
            </a:graphic>
          </p:graphicFrame>
        </mc:Choice>
        <mc:Fallback xmlns="">
          <p:pic>
            <p:nvPicPr>
              <p:cNvPr id="47" name="グラフ 46">
                <a:extLst>
                  <a:ext uri="{FF2B5EF4-FFF2-40B4-BE49-F238E27FC236}">
                    <a16:creationId xmlns:a16="http://schemas.microsoft.com/office/drawing/2014/main" id="{507B8502-706C-4AAD-88E5-01CCFAD57B01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7514400" y="360000"/>
                <a:ext cx="1764000" cy="2952000"/>
              </a:xfrm>
              <a:prstGeom prst="rect">
                <a:avLst/>
              </a:prstGeom>
            </p:spPr>
          </p:pic>
        </mc:Fallback>
      </mc:AlternateContent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651E8530-9F65-4D2D-9BDD-48B240AF42DD}"/>
              </a:ext>
            </a:extLst>
          </p:cNvPr>
          <p:cNvSpPr txBox="1"/>
          <p:nvPr/>
        </p:nvSpPr>
        <p:spPr>
          <a:xfrm rot="16200000">
            <a:off x="-12612" y="1437952"/>
            <a:ext cx="8515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</a:p>
        </p:txBody>
      </p:sp>
    </p:spTree>
    <p:extLst>
      <p:ext uri="{BB962C8B-B14F-4D97-AF65-F5344CB8AC3E}">
        <p14:creationId xmlns:p14="http://schemas.microsoft.com/office/powerpoint/2010/main" val="23900303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テキスト ボックス 59"/>
          <p:cNvSpPr txBox="1"/>
          <p:nvPr/>
        </p:nvSpPr>
        <p:spPr>
          <a:xfrm>
            <a:off x="937993" y="6177361"/>
            <a:ext cx="85870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5.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tinue. 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63794" y="77433"/>
            <a:ext cx="29290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oxicodynamic parameters</a:t>
            </a: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3" name="グラフ 12">
                <a:extLst>
                  <a:ext uri="{FF2B5EF4-FFF2-40B4-BE49-F238E27FC236}">
                    <a16:creationId xmlns:a16="http://schemas.microsoft.com/office/drawing/2014/main" id="{1075E29A-0BD9-4D43-964C-E090D4A27A6B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155022410"/>
                  </p:ext>
                </p:extLst>
              </p:nvPr>
            </p:nvGraphicFramePr>
            <p:xfrm>
              <a:off x="612000" y="360000"/>
              <a:ext cx="1764000" cy="29556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13" name="グラフ 12">
                <a:extLst>
                  <a:ext uri="{FF2B5EF4-FFF2-40B4-BE49-F238E27FC236}">
                    <a16:creationId xmlns:a16="http://schemas.microsoft.com/office/drawing/2014/main" id="{1075E29A-0BD9-4D43-964C-E090D4A27A6B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12000" y="360000"/>
                <a:ext cx="1764000" cy="29556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4" name="グラフ 13">
                <a:extLst>
                  <a:ext uri="{FF2B5EF4-FFF2-40B4-BE49-F238E27FC236}">
                    <a16:creationId xmlns:a16="http://schemas.microsoft.com/office/drawing/2014/main" id="{D8349ED6-E8D3-4BD9-BA79-4FD800FC5E40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189520036"/>
                  </p:ext>
                </p:extLst>
              </p:nvPr>
            </p:nvGraphicFramePr>
            <p:xfrm>
              <a:off x="2293200" y="360000"/>
              <a:ext cx="1764000" cy="29556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4"/>
              </a:graphicData>
            </a:graphic>
          </p:graphicFrame>
        </mc:Choice>
        <mc:Fallback xmlns="">
          <p:pic>
            <p:nvPicPr>
              <p:cNvPr id="14" name="グラフ 13">
                <a:extLst>
                  <a:ext uri="{FF2B5EF4-FFF2-40B4-BE49-F238E27FC236}">
                    <a16:creationId xmlns:a16="http://schemas.microsoft.com/office/drawing/2014/main" id="{D8349ED6-E8D3-4BD9-BA79-4FD800FC5E40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293200" y="360000"/>
                <a:ext cx="1764000" cy="29556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5" name="グラフ 14">
                <a:extLst>
                  <a:ext uri="{FF2B5EF4-FFF2-40B4-BE49-F238E27FC236}">
                    <a16:creationId xmlns:a16="http://schemas.microsoft.com/office/drawing/2014/main" id="{0BFD09C2-DCCE-41BD-82A2-9072AD4EDC48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916601810"/>
                  </p:ext>
                </p:extLst>
              </p:nvPr>
            </p:nvGraphicFramePr>
            <p:xfrm>
              <a:off x="4057200" y="360000"/>
              <a:ext cx="1764000" cy="2869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6"/>
              </a:graphicData>
            </a:graphic>
          </p:graphicFrame>
        </mc:Choice>
        <mc:Fallback xmlns="">
          <p:pic>
            <p:nvPicPr>
              <p:cNvPr id="15" name="グラフ 14">
                <a:extLst>
                  <a:ext uri="{FF2B5EF4-FFF2-40B4-BE49-F238E27FC236}">
                    <a16:creationId xmlns:a16="http://schemas.microsoft.com/office/drawing/2014/main" id="{0BFD09C2-DCCE-41BD-82A2-9072AD4EDC48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057200" y="360000"/>
                <a:ext cx="1764000" cy="2869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6" name="グラフ 15">
                <a:extLst>
                  <a:ext uri="{FF2B5EF4-FFF2-40B4-BE49-F238E27FC236}">
                    <a16:creationId xmlns:a16="http://schemas.microsoft.com/office/drawing/2014/main" id="{445D1234-EB6C-4070-A63F-4A563AC76E75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9536535"/>
                  </p:ext>
                </p:extLst>
              </p:nvPr>
            </p:nvGraphicFramePr>
            <p:xfrm>
              <a:off x="5749200" y="360000"/>
              <a:ext cx="1764000" cy="28728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8"/>
              </a:graphicData>
            </a:graphic>
          </p:graphicFrame>
        </mc:Choice>
        <mc:Fallback xmlns="">
          <p:pic>
            <p:nvPicPr>
              <p:cNvPr id="16" name="グラフ 15">
                <a:extLst>
                  <a:ext uri="{FF2B5EF4-FFF2-40B4-BE49-F238E27FC236}">
                    <a16:creationId xmlns:a16="http://schemas.microsoft.com/office/drawing/2014/main" id="{445D1234-EB6C-4070-A63F-4A563AC76E75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5749200" y="360000"/>
                <a:ext cx="1764000" cy="28728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7" name="グラフ 16">
                <a:extLst>
                  <a:ext uri="{FF2B5EF4-FFF2-40B4-BE49-F238E27FC236}">
                    <a16:creationId xmlns:a16="http://schemas.microsoft.com/office/drawing/2014/main" id="{7B6DBDD6-9B9E-470B-BC66-3051581E39FB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2861767530"/>
                  </p:ext>
                </p:extLst>
              </p:nvPr>
            </p:nvGraphicFramePr>
            <p:xfrm>
              <a:off x="7513200" y="360000"/>
              <a:ext cx="1764000" cy="2869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0"/>
              </a:graphicData>
            </a:graphic>
          </p:graphicFrame>
        </mc:Choice>
        <mc:Fallback xmlns="">
          <p:pic>
            <p:nvPicPr>
              <p:cNvPr id="17" name="グラフ 16">
                <a:extLst>
                  <a:ext uri="{FF2B5EF4-FFF2-40B4-BE49-F238E27FC236}">
                    <a16:creationId xmlns:a16="http://schemas.microsoft.com/office/drawing/2014/main" id="{7B6DBDD6-9B9E-470B-BC66-3051581E39FB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7513200" y="360000"/>
                <a:ext cx="1764000" cy="2869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8" name="グラフ 17">
                <a:extLst>
                  <a:ext uri="{FF2B5EF4-FFF2-40B4-BE49-F238E27FC236}">
                    <a16:creationId xmlns:a16="http://schemas.microsoft.com/office/drawing/2014/main" id="{62488A55-6707-4C45-B341-1D1F2EAFCDF4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767695323"/>
                  </p:ext>
                </p:extLst>
              </p:nvPr>
            </p:nvGraphicFramePr>
            <p:xfrm>
              <a:off x="34104" y="3204000"/>
              <a:ext cx="1764000" cy="28440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2"/>
              </a:graphicData>
            </a:graphic>
          </p:graphicFrame>
        </mc:Choice>
        <mc:Fallback xmlns="">
          <p:pic>
            <p:nvPicPr>
              <p:cNvPr id="18" name="グラフ 17">
                <a:extLst>
                  <a:ext uri="{FF2B5EF4-FFF2-40B4-BE49-F238E27FC236}">
                    <a16:creationId xmlns:a16="http://schemas.microsoft.com/office/drawing/2014/main" id="{62488A55-6707-4C45-B341-1D1F2EAFCDF4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34104" y="3204000"/>
                <a:ext cx="1764000" cy="2844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20" name="グラフ 19">
                <a:extLst>
                  <a:ext uri="{FF2B5EF4-FFF2-40B4-BE49-F238E27FC236}">
                    <a16:creationId xmlns:a16="http://schemas.microsoft.com/office/drawing/2014/main" id="{14E73AB5-ADE6-4C2A-8384-742C8F105AD3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2925542888"/>
                  </p:ext>
                </p:extLst>
              </p:nvPr>
            </p:nvGraphicFramePr>
            <p:xfrm>
              <a:off x="1670808" y="3204000"/>
              <a:ext cx="1764000" cy="30240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4"/>
              </a:graphicData>
            </a:graphic>
          </p:graphicFrame>
        </mc:Choice>
        <mc:Fallback xmlns="">
          <p:pic>
            <p:nvPicPr>
              <p:cNvPr id="20" name="グラフ 19">
                <a:extLst>
                  <a:ext uri="{FF2B5EF4-FFF2-40B4-BE49-F238E27FC236}">
                    <a16:creationId xmlns:a16="http://schemas.microsoft.com/office/drawing/2014/main" id="{14E73AB5-ADE6-4C2A-8384-742C8F105AD3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1670808" y="3204000"/>
                <a:ext cx="1764000" cy="3024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21" name="グラフ 20">
                <a:extLst>
                  <a:ext uri="{FF2B5EF4-FFF2-40B4-BE49-F238E27FC236}">
                    <a16:creationId xmlns:a16="http://schemas.microsoft.com/office/drawing/2014/main" id="{9284473D-3162-4D71-89FC-75A472790098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2782742171"/>
                  </p:ext>
                </p:extLst>
              </p:nvPr>
            </p:nvGraphicFramePr>
            <p:xfrm>
              <a:off x="3255368" y="3204000"/>
              <a:ext cx="1764000" cy="28584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6"/>
              </a:graphicData>
            </a:graphic>
          </p:graphicFrame>
        </mc:Choice>
        <mc:Fallback xmlns="">
          <p:pic>
            <p:nvPicPr>
              <p:cNvPr id="21" name="グラフ 20">
                <a:extLst>
                  <a:ext uri="{FF2B5EF4-FFF2-40B4-BE49-F238E27FC236}">
                    <a16:creationId xmlns:a16="http://schemas.microsoft.com/office/drawing/2014/main" id="{9284473D-3162-4D71-89FC-75A472790098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3255368" y="3204000"/>
                <a:ext cx="1764000" cy="28584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22" name="グラフ 21">
                <a:extLst>
                  <a:ext uri="{FF2B5EF4-FFF2-40B4-BE49-F238E27FC236}">
                    <a16:creationId xmlns:a16="http://schemas.microsoft.com/office/drawing/2014/main" id="{81D258E7-64F0-45AB-880B-70CE4D4AAF74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3112716622"/>
                  </p:ext>
                </p:extLst>
              </p:nvPr>
            </p:nvGraphicFramePr>
            <p:xfrm>
              <a:off x="4855568" y="3204000"/>
              <a:ext cx="1764000" cy="30240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8"/>
              </a:graphicData>
            </a:graphic>
          </p:graphicFrame>
        </mc:Choice>
        <mc:Fallback xmlns="">
          <p:pic>
            <p:nvPicPr>
              <p:cNvPr id="22" name="グラフ 21">
                <a:extLst>
                  <a:ext uri="{FF2B5EF4-FFF2-40B4-BE49-F238E27FC236}">
                    <a16:creationId xmlns:a16="http://schemas.microsoft.com/office/drawing/2014/main" id="{81D258E7-64F0-45AB-880B-70CE4D4AAF74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4855568" y="3204000"/>
                <a:ext cx="1764000" cy="3024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23" name="グラフ 22">
                <a:extLst>
                  <a:ext uri="{FF2B5EF4-FFF2-40B4-BE49-F238E27FC236}">
                    <a16:creationId xmlns:a16="http://schemas.microsoft.com/office/drawing/2014/main" id="{13163E2E-9BE4-48EA-A4FD-C0EDD4BA90EB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2015918836"/>
                  </p:ext>
                </p:extLst>
              </p:nvPr>
            </p:nvGraphicFramePr>
            <p:xfrm>
              <a:off x="6455768" y="3204000"/>
              <a:ext cx="1764000" cy="30240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0"/>
              </a:graphicData>
            </a:graphic>
          </p:graphicFrame>
        </mc:Choice>
        <mc:Fallback xmlns="">
          <p:pic>
            <p:nvPicPr>
              <p:cNvPr id="23" name="グラフ 22">
                <a:extLst>
                  <a:ext uri="{FF2B5EF4-FFF2-40B4-BE49-F238E27FC236}">
                    <a16:creationId xmlns:a16="http://schemas.microsoft.com/office/drawing/2014/main" id="{13163E2E-9BE4-48EA-A4FD-C0EDD4BA90EB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6455768" y="3204000"/>
                <a:ext cx="1764000" cy="3024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24" name="グラフ 23">
                <a:extLst>
                  <a:ext uri="{FF2B5EF4-FFF2-40B4-BE49-F238E27FC236}">
                    <a16:creationId xmlns:a16="http://schemas.microsoft.com/office/drawing/2014/main" id="{71EE6462-E580-4EFB-841D-80771EAC0B34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2496447877"/>
                  </p:ext>
                </p:extLst>
              </p:nvPr>
            </p:nvGraphicFramePr>
            <p:xfrm>
              <a:off x="8065800" y="3204000"/>
              <a:ext cx="1764000" cy="29448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2"/>
              </a:graphicData>
            </a:graphic>
          </p:graphicFrame>
        </mc:Choice>
        <mc:Fallback xmlns="">
          <p:pic>
            <p:nvPicPr>
              <p:cNvPr id="24" name="グラフ 23">
                <a:extLst>
                  <a:ext uri="{FF2B5EF4-FFF2-40B4-BE49-F238E27FC236}">
                    <a16:creationId xmlns:a16="http://schemas.microsoft.com/office/drawing/2014/main" id="{71EE6462-E580-4EFB-841D-80771EAC0B34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8065800" y="3204000"/>
                <a:ext cx="1764000" cy="2944800"/>
              </a:xfrm>
              <a:prstGeom prst="rect">
                <a:avLst/>
              </a:prstGeom>
            </p:spPr>
          </p:pic>
        </mc:Fallback>
      </mc:AlternateContent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FB7EEDB6-016E-41DF-BC7B-2C41062CC391}"/>
              </a:ext>
            </a:extLst>
          </p:cNvPr>
          <p:cNvSpPr txBox="1"/>
          <p:nvPr/>
        </p:nvSpPr>
        <p:spPr>
          <a:xfrm rot="16200000">
            <a:off x="-12612" y="1437952"/>
            <a:ext cx="8515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</a:p>
        </p:txBody>
      </p:sp>
    </p:spTree>
    <p:extLst>
      <p:ext uri="{BB962C8B-B14F-4D97-AF65-F5344CB8AC3E}">
        <p14:creationId xmlns:p14="http://schemas.microsoft.com/office/powerpoint/2010/main" val="33081272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37</TotalTime>
  <Words>526</Words>
  <Application>Microsoft Office PowerPoint</Application>
  <PresentationFormat>A4 210 x 297 mm</PresentationFormat>
  <Paragraphs>100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1" baseType="lpstr">
      <vt:lpstr>Arial</vt:lpstr>
      <vt:lpstr>Calibri</vt:lpstr>
      <vt:lpstr>Times New Roman</vt:lpstr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da</dc:creator>
  <cp:lastModifiedBy>真治</cp:lastModifiedBy>
  <cp:revision>126</cp:revision>
  <cp:lastPrinted>2020-01-21T11:27:58Z</cp:lastPrinted>
  <dcterms:created xsi:type="dcterms:W3CDTF">2013-10-24T11:31:50Z</dcterms:created>
  <dcterms:modified xsi:type="dcterms:W3CDTF">2020-01-21T15:35:53Z</dcterms:modified>
</cp:coreProperties>
</file>